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drawings/drawing1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drawings/drawing2.xml" ContentType="application/vnd.openxmlformats-officedocument.drawingml.chartshapes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0440988" cy="86407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3474" autoAdjust="0"/>
    <p:restoredTop sz="94660"/>
  </p:normalViewPr>
  <p:slideViewPr>
    <p:cSldViewPr snapToGrid="0">
      <p:cViewPr>
        <p:scale>
          <a:sx n="110" d="100"/>
          <a:sy n="110" d="100"/>
        </p:scale>
        <p:origin x="750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2.xlsx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chartUserShapes" Target="../drawings/drawing1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3.xlsx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chartUserShapes" Target="../drawings/drawing2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4.xlsx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Sheet1!$C$1</c:f>
              <c:strCache>
                <c:ptCount val="1"/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xVal>
            <c:numRef>
              <c:f>Sheet1!$B$2:$B$292</c:f>
              <c:numCache>
                <c:formatCode>General</c:formatCode>
                <c:ptCount val="291"/>
                <c:pt idx="0">
                  <c:v>185.38874724170299</c:v>
                </c:pt>
                <c:pt idx="1">
                  <c:v>185.381086990184</c:v>
                </c:pt>
                <c:pt idx="2">
                  <c:v>185.37342673866601</c:v>
                </c:pt>
                <c:pt idx="3">
                  <c:v>185.365766487147</c:v>
                </c:pt>
                <c:pt idx="4">
                  <c:v>185.35810623562799</c:v>
                </c:pt>
                <c:pt idx="5">
                  <c:v>185.350445984109</c:v>
                </c:pt>
                <c:pt idx="6">
                  <c:v>185.34278573258999</c:v>
                </c:pt>
                <c:pt idx="7">
                  <c:v>185.335125481071</c:v>
                </c:pt>
                <c:pt idx="8">
                  <c:v>185.32746522955301</c:v>
                </c:pt>
                <c:pt idx="9">
                  <c:v>185.319804978034</c:v>
                </c:pt>
                <c:pt idx="10">
                  <c:v>185.31214472651499</c:v>
                </c:pt>
                <c:pt idx="11">
                  <c:v>185.304484474996</c:v>
                </c:pt>
                <c:pt idx="12">
                  <c:v>185.29682422347699</c:v>
                </c:pt>
                <c:pt idx="13">
                  <c:v>185.289163971959</c:v>
                </c:pt>
                <c:pt idx="14">
                  <c:v>185.28150372044001</c:v>
                </c:pt>
                <c:pt idx="15">
                  <c:v>185.273843468921</c:v>
                </c:pt>
                <c:pt idx="16">
                  <c:v>185.26618321740199</c:v>
                </c:pt>
                <c:pt idx="17">
                  <c:v>185.258522965883</c:v>
                </c:pt>
                <c:pt idx="18">
                  <c:v>185.25086271436399</c:v>
                </c:pt>
                <c:pt idx="19">
                  <c:v>185.243202462846</c:v>
                </c:pt>
                <c:pt idx="20">
                  <c:v>185.23554221132699</c:v>
                </c:pt>
                <c:pt idx="21">
                  <c:v>185.227881959808</c:v>
                </c:pt>
                <c:pt idx="22">
                  <c:v>185.22022170828899</c:v>
                </c:pt>
                <c:pt idx="23">
                  <c:v>185.21256145677</c:v>
                </c:pt>
                <c:pt idx="24">
                  <c:v>185.20490120525099</c:v>
                </c:pt>
                <c:pt idx="25">
                  <c:v>185.197240953733</c:v>
                </c:pt>
                <c:pt idx="26">
                  <c:v>185.18958070221399</c:v>
                </c:pt>
                <c:pt idx="27">
                  <c:v>184.048203225908</c:v>
                </c:pt>
                <c:pt idx="28">
                  <c:v>184.04054297438901</c:v>
                </c:pt>
                <c:pt idx="29">
                  <c:v>184.03288272287099</c:v>
                </c:pt>
                <c:pt idx="30">
                  <c:v>184.02522247135201</c:v>
                </c:pt>
                <c:pt idx="31">
                  <c:v>184.017562219833</c:v>
                </c:pt>
                <c:pt idx="32">
                  <c:v>184.00990196831401</c:v>
                </c:pt>
                <c:pt idx="33">
                  <c:v>184.002241716795</c:v>
                </c:pt>
                <c:pt idx="34">
                  <c:v>183.99458146527601</c:v>
                </c:pt>
                <c:pt idx="35">
                  <c:v>183.986921213758</c:v>
                </c:pt>
                <c:pt idx="36">
                  <c:v>183.97926096223901</c:v>
                </c:pt>
                <c:pt idx="37">
                  <c:v>183.97160071072</c:v>
                </c:pt>
                <c:pt idx="38">
                  <c:v>183.96394045920101</c:v>
                </c:pt>
                <c:pt idx="39">
                  <c:v>183.956280207682</c:v>
                </c:pt>
                <c:pt idx="40">
                  <c:v>183.94861995616401</c:v>
                </c:pt>
                <c:pt idx="41">
                  <c:v>183.940959704645</c:v>
                </c:pt>
                <c:pt idx="42">
                  <c:v>183.93329945312601</c:v>
                </c:pt>
                <c:pt idx="43">
                  <c:v>183.925639201607</c:v>
                </c:pt>
                <c:pt idx="44">
                  <c:v>183.91797895008801</c:v>
                </c:pt>
                <c:pt idx="45">
                  <c:v>183.910318698569</c:v>
                </c:pt>
                <c:pt idx="46">
                  <c:v>183.90265844705101</c:v>
                </c:pt>
                <c:pt idx="47">
                  <c:v>183.894998195532</c:v>
                </c:pt>
                <c:pt idx="48">
                  <c:v>180.48618626965299</c:v>
                </c:pt>
                <c:pt idx="49">
                  <c:v>180.478526018134</c:v>
                </c:pt>
                <c:pt idx="50">
                  <c:v>180.47086576661499</c:v>
                </c:pt>
                <c:pt idx="51">
                  <c:v>180.46320551509601</c:v>
                </c:pt>
                <c:pt idx="52">
                  <c:v>180.45554526357799</c:v>
                </c:pt>
                <c:pt idx="53">
                  <c:v>180.447885012059</c:v>
                </c:pt>
                <c:pt idx="54">
                  <c:v>180.44022476053999</c:v>
                </c:pt>
                <c:pt idx="55">
                  <c:v>180.43256450902101</c:v>
                </c:pt>
                <c:pt idx="56">
                  <c:v>180.42490425750199</c:v>
                </c:pt>
                <c:pt idx="57">
                  <c:v>180.417244005984</c:v>
                </c:pt>
                <c:pt idx="58">
                  <c:v>180.40958375446499</c:v>
                </c:pt>
                <c:pt idx="59">
                  <c:v>180.401923502946</c:v>
                </c:pt>
                <c:pt idx="60">
                  <c:v>180.39426325142699</c:v>
                </c:pt>
                <c:pt idx="61">
                  <c:v>180.38660299990801</c:v>
                </c:pt>
                <c:pt idx="62">
                  <c:v>180.37894274838899</c:v>
                </c:pt>
                <c:pt idx="63">
                  <c:v>180.371282496871</c:v>
                </c:pt>
                <c:pt idx="64">
                  <c:v>180.36362224535199</c:v>
                </c:pt>
                <c:pt idx="65">
                  <c:v>180.35596199383301</c:v>
                </c:pt>
                <c:pt idx="66">
                  <c:v>180.34830174231399</c:v>
                </c:pt>
                <c:pt idx="67">
                  <c:v>180.34064149079501</c:v>
                </c:pt>
                <c:pt idx="68">
                  <c:v>180.33298123927599</c:v>
                </c:pt>
                <c:pt idx="69">
                  <c:v>180.325320987758</c:v>
                </c:pt>
                <c:pt idx="70">
                  <c:v>180.31766073623899</c:v>
                </c:pt>
                <c:pt idx="71">
                  <c:v>180.31000048472001</c:v>
                </c:pt>
                <c:pt idx="72">
                  <c:v>180.30234023320099</c:v>
                </c:pt>
                <c:pt idx="73">
                  <c:v>180.29467998168201</c:v>
                </c:pt>
                <c:pt idx="74">
                  <c:v>180.287019730163</c:v>
                </c:pt>
                <c:pt idx="75">
                  <c:v>180.27935947864501</c:v>
                </c:pt>
                <c:pt idx="76">
                  <c:v>180.27169922712599</c:v>
                </c:pt>
                <c:pt idx="77">
                  <c:v>180.26403897560701</c:v>
                </c:pt>
                <c:pt idx="78">
                  <c:v>180.25637872408799</c:v>
                </c:pt>
                <c:pt idx="79">
                  <c:v>180.24871847256901</c:v>
                </c:pt>
                <c:pt idx="80">
                  <c:v>180.24105822105</c:v>
                </c:pt>
                <c:pt idx="81">
                  <c:v>180.23339796953201</c:v>
                </c:pt>
                <c:pt idx="82">
                  <c:v>180.22573771801299</c:v>
                </c:pt>
                <c:pt idx="83">
                  <c:v>180.21807746649401</c:v>
                </c:pt>
                <c:pt idx="84">
                  <c:v>180.210417214975</c:v>
                </c:pt>
                <c:pt idx="85">
                  <c:v>180.20275696345601</c:v>
                </c:pt>
                <c:pt idx="86">
                  <c:v>180.195096711937</c:v>
                </c:pt>
                <c:pt idx="87">
                  <c:v>180.18743646041901</c:v>
                </c:pt>
                <c:pt idx="88">
                  <c:v>180.17977620889999</c:v>
                </c:pt>
                <c:pt idx="89">
                  <c:v>178.724328420322</c:v>
                </c:pt>
                <c:pt idx="90">
                  <c:v>178.71666816880401</c:v>
                </c:pt>
                <c:pt idx="91">
                  <c:v>178.70900791728499</c:v>
                </c:pt>
                <c:pt idx="92">
                  <c:v>178.70134766576601</c:v>
                </c:pt>
                <c:pt idx="93">
                  <c:v>178.69368741424699</c:v>
                </c:pt>
                <c:pt idx="94">
                  <c:v>178.68602716272801</c:v>
                </c:pt>
                <c:pt idx="95">
                  <c:v>178.678366911209</c:v>
                </c:pt>
                <c:pt idx="96">
                  <c:v>178.67070665969101</c:v>
                </c:pt>
                <c:pt idx="97">
                  <c:v>178.66304640817199</c:v>
                </c:pt>
                <c:pt idx="98">
                  <c:v>178.65538615665301</c:v>
                </c:pt>
                <c:pt idx="99">
                  <c:v>178.647725905134</c:v>
                </c:pt>
                <c:pt idx="100">
                  <c:v>178.64006565361501</c:v>
                </c:pt>
                <c:pt idx="101">
                  <c:v>178.632405402096</c:v>
                </c:pt>
                <c:pt idx="102">
                  <c:v>178.62474515057801</c:v>
                </c:pt>
                <c:pt idx="103">
                  <c:v>178.61708489905899</c:v>
                </c:pt>
                <c:pt idx="104">
                  <c:v>178.60942464754001</c:v>
                </c:pt>
                <c:pt idx="105">
                  <c:v>178.601764396021</c:v>
                </c:pt>
                <c:pt idx="106">
                  <c:v>178.59410414450201</c:v>
                </c:pt>
                <c:pt idx="107">
                  <c:v>178.586443892983</c:v>
                </c:pt>
                <c:pt idx="108">
                  <c:v>178.57878364146501</c:v>
                </c:pt>
                <c:pt idx="109">
                  <c:v>178.571123389946</c:v>
                </c:pt>
                <c:pt idx="110">
                  <c:v>178.56346313842701</c:v>
                </c:pt>
                <c:pt idx="111">
                  <c:v>178.555802886908</c:v>
                </c:pt>
                <c:pt idx="112">
                  <c:v>178.54814263538901</c:v>
                </c:pt>
                <c:pt idx="113">
                  <c:v>178.54048238387</c:v>
                </c:pt>
                <c:pt idx="114">
                  <c:v>178.53282213235201</c:v>
                </c:pt>
                <c:pt idx="115">
                  <c:v>177.38378440452701</c:v>
                </c:pt>
                <c:pt idx="116">
                  <c:v>177.37612415300899</c:v>
                </c:pt>
                <c:pt idx="117">
                  <c:v>177.36846390149</c:v>
                </c:pt>
                <c:pt idx="118">
                  <c:v>177.36080364997099</c:v>
                </c:pt>
                <c:pt idx="119">
                  <c:v>177.353143398452</c:v>
                </c:pt>
                <c:pt idx="120">
                  <c:v>177.34548314693299</c:v>
                </c:pt>
                <c:pt idx="121">
                  <c:v>177.33782289541401</c:v>
                </c:pt>
                <c:pt idx="122">
                  <c:v>177.33016264389599</c:v>
                </c:pt>
                <c:pt idx="123">
                  <c:v>177.322502392377</c:v>
                </c:pt>
                <c:pt idx="124">
                  <c:v>177.31484214085799</c:v>
                </c:pt>
                <c:pt idx="125">
                  <c:v>177.30718188933901</c:v>
                </c:pt>
                <c:pt idx="126">
                  <c:v>177.29952163781999</c:v>
                </c:pt>
                <c:pt idx="127">
                  <c:v>177.29186138630101</c:v>
                </c:pt>
                <c:pt idx="128">
                  <c:v>177.28420113478299</c:v>
                </c:pt>
                <c:pt idx="129">
                  <c:v>177.276540883264</c:v>
                </c:pt>
                <c:pt idx="130">
                  <c:v>177.26888063174499</c:v>
                </c:pt>
                <c:pt idx="131">
                  <c:v>176.92416931339801</c:v>
                </c:pt>
                <c:pt idx="132">
                  <c:v>176.916509061879</c:v>
                </c:pt>
                <c:pt idx="133">
                  <c:v>176.90884881036001</c:v>
                </c:pt>
                <c:pt idx="134">
                  <c:v>176.901188558841</c:v>
                </c:pt>
                <c:pt idx="135">
                  <c:v>176.89352830732199</c:v>
                </c:pt>
                <c:pt idx="136">
                  <c:v>176.885868055803</c:v>
                </c:pt>
                <c:pt idx="137">
                  <c:v>176.87820780428501</c:v>
                </c:pt>
                <c:pt idx="138">
                  <c:v>176.870547552766</c:v>
                </c:pt>
                <c:pt idx="139">
                  <c:v>176.86288730124701</c:v>
                </c:pt>
                <c:pt idx="140">
                  <c:v>176.855227049728</c:v>
                </c:pt>
                <c:pt idx="141">
                  <c:v>176.84756679820899</c:v>
                </c:pt>
                <c:pt idx="142">
                  <c:v>176.839906546691</c:v>
                </c:pt>
                <c:pt idx="143">
                  <c:v>176.83224629517201</c:v>
                </c:pt>
                <c:pt idx="144">
                  <c:v>176.824586043653</c:v>
                </c:pt>
                <c:pt idx="145">
                  <c:v>176.81692579213399</c:v>
                </c:pt>
                <c:pt idx="146">
                  <c:v>176.809265540615</c:v>
                </c:pt>
                <c:pt idx="147">
                  <c:v>176.80160528909599</c:v>
                </c:pt>
                <c:pt idx="148">
                  <c:v>176.793945037578</c:v>
                </c:pt>
                <c:pt idx="149">
                  <c:v>176.78628478605901</c:v>
                </c:pt>
                <c:pt idx="150">
                  <c:v>176.77862453454</c:v>
                </c:pt>
                <c:pt idx="151">
                  <c:v>176.77096428302099</c:v>
                </c:pt>
                <c:pt idx="152">
                  <c:v>175.430420267226</c:v>
                </c:pt>
                <c:pt idx="153">
                  <c:v>175.42276001570701</c:v>
                </c:pt>
                <c:pt idx="154">
                  <c:v>175.415099764188</c:v>
                </c:pt>
                <c:pt idx="155">
                  <c:v>175.40743951267001</c:v>
                </c:pt>
                <c:pt idx="156">
                  <c:v>175.399779261151</c:v>
                </c:pt>
                <c:pt idx="157">
                  <c:v>175.39211900963201</c:v>
                </c:pt>
                <c:pt idx="158">
                  <c:v>175.384458758113</c:v>
                </c:pt>
                <c:pt idx="159">
                  <c:v>175.37679850659401</c:v>
                </c:pt>
                <c:pt idx="160">
                  <c:v>175.369138255075</c:v>
                </c:pt>
                <c:pt idx="161">
                  <c:v>175.36147800355701</c:v>
                </c:pt>
                <c:pt idx="162">
                  <c:v>175.353817752038</c:v>
                </c:pt>
                <c:pt idx="163">
                  <c:v>175.34615750051901</c:v>
                </c:pt>
                <c:pt idx="164">
                  <c:v>175.338497249</c:v>
                </c:pt>
                <c:pt idx="165">
                  <c:v>175.33083699748099</c:v>
                </c:pt>
                <c:pt idx="166">
                  <c:v>175.323176745962</c:v>
                </c:pt>
                <c:pt idx="167">
                  <c:v>175.31551649444401</c:v>
                </c:pt>
                <c:pt idx="168">
                  <c:v>175.307856242925</c:v>
                </c:pt>
                <c:pt idx="169">
                  <c:v>175.30019599140601</c:v>
                </c:pt>
                <c:pt idx="170">
                  <c:v>175.292535739887</c:v>
                </c:pt>
                <c:pt idx="171">
                  <c:v>175.28487548836799</c:v>
                </c:pt>
                <c:pt idx="172">
                  <c:v>175.277215236849</c:v>
                </c:pt>
                <c:pt idx="173">
                  <c:v>175.26955498533101</c:v>
                </c:pt>
                <c:pt idx="174">
                  <c:v>175.261894733812</c:v>
                </c:pt>
                <c:pt idx="175">
                  <c:v>175.25423448229299</c:v>
                </c:pt>
                <c:pt idx="176">
                  <c:v>175.246574230774</c:v>
                </c:pt>
                <c:pt idx="177">
                  <c:v>175.23891397925499</c:v>
                </c:pt>
                <c:pt idx="178">
                  <c:v>175.231253727737</c:v>
                </c:pt>
                <c:pt idx="179">
                  <c:v>175.22359347621801</c:v>
                </c:pt>
                <c:pt idx="180">
                  <c:v>175.215933224699</c:v>
                </c:pt>
                <c:pt idx="181">
                  <c:v>175.20827297317999</c:v>
                </c:pt>
                <c:pt idx="182">
                  <c:v>175.200612721661</c:v>
                </c:pt>
                <c:pt idx="183">
                  <c:v>175.19295247014199</c:v>
                </c:pt>
                <c:pt idx="184">
                  <c:v>175.185292218624</c:v>
                </c:pt>
                <c:pt idx="185">
                  <c:v>175.17763196710499</c:v>
                </c:pt>
                <c:pt idx="186">
                  <c:v>175.169971715586</c:v>
                </c:pt>
                <c:pt idx="187">
                  <c:v>175.16231146406699</c:v>
                </c:pt>
                <c:pt idx="188">
                  <c:v>175.154651212548</c:v>
                </c:pt>
                <c:pt idx="189">
                  <c:v>175.14699096102899</c:v>
                </c:pt>
                <c:pt idx="190">
                  <c:v>175.139330709511</c:v>
                </c:pt>
                <c:pt idx="191">
                  <c:v>175.13167045799199</c:v>
                </c:pt>
                <c:pt idx="192">
                  <c:v>175.124010206473</c:v>
                </c:pt>
                <c:pt idx="193">
                  <c:v>175.11634995495399</c:v>
                </c:pt>
                <c:pt idx="194">
                  <c:v>174.58779260015501</c:v>
                </c:pt>
                <c:pt idx="195">
                  <c:v>174.580132348636</c:v>
                </c:pt>
                <c:pt idx="196">
                  <c:v>174.57247209711699</c:v>
                </c:pt>
                <c:pt idx="197">
                  <c:v>174.564811845598</c:v>
                </c:pt>
                <c:pt idx="198">
                  <c:v>174.55715159408001</c:v>
                </c:pt>
                <c:pt idx="199">
                  <c:v>174.549491342561</c:v>
                </c:pt>
                <c:pt idx="200">
                  <c:v>174.54183109104201</c:v>
                </c:pt>
                <c:pt idx="201">
                  <c:v>174.534170839523</c:v>
                </c:pt>
                <c:pt idx="202">
                  <c:v>174.52651058800399</c:v>
                </c:pt>
                <c:pt idx="203">
                  <c:v>174.518850336485</c:v>
                </c:pt>
                <c:pt idx="204">
                  <c:v>174.51119008496701</c:v>
                </c:pt>
                <c:pt idx="205">
                  <c:v>174.503529833448</c:v>
                </c:pt>
                <c:pt idx="206">
                  <c:v>174.49586958192901</c:v>
                </c:pt>
                <c:pt idx="207">
                  <c:v>174.48820933041</c:v>
                </c:pt>
                <c:pt idx="208">
                  <c:v>174.48054907889099</c:v>
                </c:pt>
                <c:pt idx="209">
                  <c:v>174.472888827372</c:v>
                </c:pt>
                <c:pt idx="210">
                  <c:v>174.46522857585401</c:v>
                </c:pt>
                <c:pt idx="211">
                  <c:v>174.457568324335</c:v>
                </c:pt>
                <c:pt idx="212">
                  <c:v>174.44990807281599</c:v>
                </c:pt>
                <c:pt idx="213">
                  <c:v>174.442247821297</c:v>
                </c:pt>
                <c:pt idx="214">
                  <c:v>174.43458756977799</c:v>
                </c:pt>
                <c:pt idx="215">
                  <c:v>174.42692731826</c:v>
                </c:pt>
                <c:pt idx="216">
                  <c:v>174.41926706674101</c:v>
                </c:pt>
                <c:pt idx="217">
                  <c:v>174.411606815222</c:v>
                </c:pt>
                <c:pt idx="218">
                  <c:v>174.40394656370299</c:v>
                </c:pt>
                <c:pt idx="219">
                  <c:v>174.396286312184</c:v>
                </c:pt>
                <c:pt idx="220">
                  <c:v>174.38862606066499</c:v>
                </c:pt>
                <c:pt idx="221">
                  <c:v>174.380965809147</c:v>
                </c:pt>
                <c:pt idx="222">
                  <c:v>174.37330555762799</c:v>
                </c:pt>
                <c:pt idx="223">
                  <c:v>174.365645306109</c:v>
                </c:pt>
                <c:pt idx="224">
                  <c:v>174.35798505458999</c:v>
                </c:pt>
                <c:pt idx="225">
                  <c:v>174.350324803071</c:v>
                </c:pt>
                <c:pt idx="226">
                  <c:v>174.34266455155199</c:v>
                </c:pt>
                <c:pt idx="227">
                  <c:v>174.335004300034</c:v>
                </c:pt>
                <c:pt idx="228">
                  <c:v>174.32734404851499</c:v>
                </c:pt>
                <c:pt idx="229">
                  <c:v>174.319683796996</c:v>
                </c:pt>
                <c:pt idx="230">
                  <c:v>174.31202354547699</c:v>
                </c:pt>
                <c:pt idx="231">
                  <c:v>174.304363293958</c:v>
                </c:pt>
                <c:pt idx="232">
                  <c:v>174.29670304243899</c:v>
                </c:pt>
                <c:pt idx="233">
                  <c:v>174.289042790921</c:v>
                </c:pt>
                <c:pt idx="234">
                  <c:v>174.28138253940199</c:v>
                </c:pt>
                <c:pt idx="235">
                  <c:v>174.273722287883</c:v>
                </c:pt>
                <c:pt idx="236">
                  <c:v>174.26606203636399</c:v>
                </c:pt>
                <c:pt idx="237">
                  <c:v>174.25840178484501</c:v>
                </c:pt>
                <c:pt idx="238">
                  <c:v>174.25074153332599</c:v>
                </c:pt>
                <c:pt idx="239">
                  <c:v>174.243081281808</c:v>
                </c:pt>
                <c:pt idx="240">
                  <c:v>174.23542103028899</c:v>
                </c:pt>
                <c:pt idx="241">
                  <c:v>174.22776077877</c:v>
                </c:pt>
                <c:pt idx="242">
                  <c:v>174.22010052725099</c:v>
                </c:pt>
                <c:pt idx="243">
                  <c:v>174.21244027573201</c:v>
                </c:pt>
                <c:pt idx="244">
                  <c:v>174.20478002421299</c:v>
                </c:pt>
                <c:pt idx="245">
                  <c:v>174.197119772695</c:v>
                </c:pt>
                <c:pt idx="246">
                  <c:v>174.18945952117599</c:v>
                </c:pt>
                <c:pt idx="247">
                  <c:v>174.18179926965701</c:v>
                </c:pt>
                <c:pt idx="248">
                  <c:v>174.17413901813799</c:v>
                </c:pt>
                <c:pt idx="249">
                  <c:v>174.16647876661901</c:v>
                </c:pt>
                <c:pt idx="250">
                  <c:v>174.15881851509999</c:v>
                </c:pt>
                <c:pt idx="251">
                  <c:v>174.151158263582</c:v>
                </c:pt>
                <c:pt idx="252">
                  <c:v>174.14349801206299</c:v>
                </c:pt>
                <c:pt idx="253">
                  <c:v>174.13583776054401</c:v>
                </c:pt>
                <c:pt idx="254">
                  <c:v>174.12817750902499</c:v>
                </c:pt>
                <c:pt idx="255">
                  <c:v>173.821767448272</c:v>
                </c:pt>
                <c:pt idx="256">
                  <c:v>173.81410719675301</c:v>
                </c:pt>
                <c:pt idx="257">
                  <c:v>173.806446945234</c:v>
                </c:pt>
                <c:pt idx="258">
                  <c:v>173.79878669371601</c:v>
                </c:pt>
                <c:pt idx="259">
                  <c:v>173.791126442197</c:v>
                </c:pt>
                <c:pt idx="260">
                  <c:v>173.78346619067801</c:v>
                </c:pt>
                <c:pt idx="261">
                  <c:v>173.775805939159</c:v>
                </c:pt>
                <c:pt idx="262">
                  <c:v>173.76814568763999</c:v>
                </c:pt>
                <c:pt idx="263">
                  <c:v>173.760485436121</c:v>
                </c:pt>
                <c:pt idx="264">
                  <c:v>173.75282518460301</c:v>
                </c:pt>
                <c:pt idx="265">
                  <c:v>173.745164933084</c:v>
                </c:pt>
                <c:pt idx="266">
                  <c:v>173.73750468156501</c:v>
                </c:pt>
                <c:pt idx="267">
                  <c:v>173.729844430046</c:v>
                </c:pt>
                <c:pt idx="268">
                  <c:v>173.72218417852699</c:v>
                </c:pt>
                <c:pt idx="269">
                  <c:v>173.714523927008</c:v>
                </c:pt>
                <c:pt idx="270">
                  <c:v>173.70686367549001</c:v>
                </c:pt>
                <c:pt idx="271">
                  <c:v>173.699203423971</c:v>
                </c:pt>
                <c:pt idx="272">
                  <c:v>173.69154317245199</c:v>
                </c:pt>
                <c:pt idx="273">
                  <c:v>173.683882920933</c:v>
                </c:pt>
                <c:pt idx="274">
                  <c:v>173.67622266941399</c:v>
                </c:pt>
                <c:pt idx="275">
                  <c:v>173.668562417895</c:v>
                </c:pt>
                <c:pt idx="276">
                  <c:v>173.66090216637701</c:v>
                </c:pt>
                <c:pt idx="277">
                  <c:v>173.653241914858</c:v>
                </c:pt>
                <c:pt idx="278">
                  <c:v>173.64558166333899</c:v>
                </c:pt>
                <c:pt idx="279">
                  <c:v>173.63792141182</c:v>
                </c:pt>
                <c:pt idx="280">
                  <c:v>173.63026116030099</c:v>
                </c:pt>
                <c:pt idx="281">
                  <c:v>173.622600908783</c:v>
                </c:pt>
                <c:pt idx="282">
                  <c:v>173.61494065726399</c:v>
                </c:pt>
                <c:pt idx="283">
                  <c:v>173.607280405745</c:v>
                </c:pt>
                <c:pt idx="284">
                  <c:v>173.59962015422599</c:v>
                </c:pt>
                <c:pt idx="285">
                  <c:v>173.591959902707</c:v>
                </c:pt>
                <c:pt idx="286">
                  <c:v>173.58429965118799</c:v>
                </c:pt>
                <c:pt idx="287">
                  <c:v>173.57663939967</c:v>
                </c:pt>
                <c:pt idx="288">
                  <c:v>173.56897914815099</c:v>
                </c:pt>
                <c:pt idx="289">
                  <c:v>173.561318896632</c:v>
                </c:pt>
                <c:pt idx="290">
                  <c:v>173.55365864511299</c:v>
                </c:pt>
              </c:numCache>
            </c:numRef>
          </c:xVal>
          <c:yVal>
            <c:numRef>
              <c:f>Sheet1!$C$2:$C$292</c:f>
              <c:numCache>
                <c:formatCode>General</c:formatCode>
                <c:ptCount val="29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0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0</c:v>
                </c:pt>
                <c:pt idx="110">
                  <c:v>0</c:v>
                </c:pt>
                <c:pt idx="111">
                  <c:v>0</c:v>
                </c:pt>
                <c:pt idx="112">
                  <c:v>0</c:v>
                </c:pt>
                <c:pt idx="113">
                  <c:v>0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0</c:v>
                </c:pt>
                <c:pt idx="124">
                  <c:v>0</c:v>
                </c:pt>
                <c:pt idx="125">
                  <c:v>0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  <c:pt idx="133">
                  <c:v>0</c:v>
                </c:pt>
                <c:pt idx="134">
                  <c:v>0</c:v>
                </c:pt>
                <c:pt idx="135">
                  <c:v>0</c:v>
                </c:pt>
                <c:pt idx="136">
                  <c:v>0</c:v>
                </c:pt>
                <c:pt idx="137">
                  <c:v>0</c:v>
                </c:pt>
                <c:pt idx="138">
                  <c:v>0</c:v>
                </c:pt>
                <c:pt idx="139">
                  <c:v>0</c:v>
                </c:pt>
                <c:pt idx="140">
                  <c:v>0</c:v>
                </c:pt>
                <c:pt idx="141">
                  <c:v>0</c:v>
                </c:pt>
                <c:pt idx="142">
                  <c:v>0</c:v>
                </c:pt>
                <c:pt idx="143">
                  <c:v>0</c:v>
                </c:pt>
                <c:pt idx="144">
                  <c:v>0</c:v>
                </c:pt>
                <c:pt idx="145">
                  <c:v>0</c:v>
                </c:pt>
                <c:pt idx="146">
                  <c:v>0</c:v>
                </c:pt>
                <c:pt idx="147">
                  <c:v>0</c:v>
                </c:pt>
                <c:pt idx="148">
                  <c:v>0</c:v>
                </c:pt>
                <c:pt idx="149">
                  <c:v>0</c:v>
                </c:pt>
                <c:pt idx="150">
                  <c:v>0</c:v>
                </c:pt>
                <c:pt idx="151">
                  <c:v>0</c:v>
                </c:pt>
                <c:pt idx="152">
                  <c:v>0</c:v>
                </c:pt>
                <c:pt idx="153">
                  <c:v>0</c:v>
                </c:pt>
                <c:pt idx="154">
                  <c:v>0</c:v>
                </c:pt>
                <c:pt idx="155">
                  <c:v>0</c:v>
                </c:pt>
                <c:pt idx="156">
                  <c:v>0</c:v>
                </c:pt>
                <c:pt idx="157">
                  <c:v>0</c:v>
                </c:pt>
                <c:pt idx="158">
                  <c:v>0</c:v>
                </c:pt>
                <c:pt idx="159">
                  <c:v>0</c:v>
                </c:pt>
                <c:pt idx="160">
                  <c:v>0</c:v>
                </c:pt>
                <c:pt idx="161">
                  <c:v>0</c:v>
                </c:pt>
                <c:pt idx="162">
                  <c:v>0</c:v>
                </c:pt>
                <c:pt idx="163">
                  <c:v>0</c:v>
                </c:pt>
                <c:pt idx="164">
                  <c:v>0</c:v>
                </c:pt>
                <c:pt idx="165">
                  <c:v>0</c:v>
                </c:pt>
                <c:pt idx="166">
                  <c:v>0</c:v>
                </c:pt>
                <c:pt idx="167">
                  <c:v>0</c:v>
                </c:pt>
                <c:pt idx="168">
                  <c:v>0</c:v>
                </c:pt>
                <c:pt idx="169">
                  <c:v>0</c:v>
                </c:pt>
                <c:pt idx="170">
                  <c:v>0</c:v>
                </c:pt>
                <c:pt idx="171">
                  <c:v>0</c:v>
                </c:pt>
                <c:pt idx="172">
                  <c:v>0</c:v>
                </c:pt>
                <c:pt idx="173">
                  <c:v>0</c:v>
                </c:pt>
                <c:pt idx="174">
                  <c:v>0</c:v>
                </c:pt>
                <c:pt idx="175">
                  <c:v>0</c:v>
                </c:pt>
                <c:pt idx="176">
                  <c:v>0</c:v>
                </c:pt>
                <c:pt idx="177">
                  <c:v>0</c:v>
                </c:pt>
                <c:pt idx="178">
                  <c:v>0</c:v>
                </c:pt>
                <c:pt idx="179">
                  <c:v>0</c:v>
                </c:pt>
                <c:pt idx="180">
                  <c:v>0</c:v>
                </c:pt>
                <c:pt idx="181">
                  <c:v>0</c:v>
                </c:pt>
                <c:pt idx="182">
                  <c:v>0</c:v>
                </c:pt>
                <c:pt idx="183">
                  <c:v>0</c:v>
                </c:pt>
                <c:pt idx="184">
                  <c:v>0</c:v>
                </c:pt>
                <c:pt idx="185">
                  <c:v>0</c:v>
                </c:pt>
                <c:pt idx="186">
                  <c:v>0</c:v>
                </c:pt>
                <c:pt idx="187">
                  <c:v>0</c:v>
                </c:pt>
                <c:pt idx="188">
                  <c:v>0</c:v>
                </c:pt>
                <c:pt idx="189">
                  <c:v>0</c:v>
                </c:pt>
                <c:pt idx="190">
                  <c:v>0</c:v>
                </c:pt>
                <c:pt idx="191">
                  <c:v>0</c:v>
                </c:pt>
                <c:pt idx="192">
                  <c:v>0</c:v>
                </c:pt>
                <c:pt idx="193">
                  <c:v>0</c:v>
                </c:pt>
                <c:pt idx="194">
                  <c:v>0</c:v>
                </c:pt>
                <c:pt idx="195">
                  <c:v>0</c:v>
                </c:pt>
                <c:pt idx="196">
                  <c:v>0</c:v>
                </c:pt>
                <c:pt idx="197">
                  <c:v>0</c:v>
                </c:pt>
                <c:pt idx="198">
                  <c:v>0</c:v>
                </c:pt>
                <c:pt idx="199">
                  <c:v>0</c:v>
                </c:pt>
                <c:pt idx="200">
                  <c:v>0</c:v>
                </c:pt>
                <c:pt idx="201">
                  <c:v>0</c:v>
                </c:pt>
                <c:pt idx="202">
                  <c:v>0</c:v>
                </c:pt>
                <c:pt idx="203">
                  <c:v>0</c:v>
                </c:pt>
                <c:pt idx="204">
                  <c:v>0</c:v>
                </c:pt>
                <c:pt idx="205">
                  <c:v>0</c:v>
                </c:pt>
                <c:pt idx="206">
                  <c:v>0</c:v>
                </c:pt>
                <c:pt idx="207">
                  <c:v>0</c:v>
                </c:pt>
                <c:pt idx="208">
                  <c:v>0</c:v>
                </c:pt>
                <c:pt idx="209">
                  <c:v>0</c:v>
                </c:pt>
                <c:pt idx="210">
                  <c:v>0</c:v>
                </c:pt>
                <c:pt idx="211">
                  <c:v>0</c:v>
                </c:pt>
                <c:pt idx="212">
                  <c:v>0</c:v>
                </c:pt>
                <c:pt idx="213">
                  <c:v>0</c:v>
                </c:pt>
                <c:pt idx="214">
                  <c:v>0</c:v>
                </c:pt>
                <c:pt idx="215">
                  <c:v>0</c:v>
                </c:pt>
                <c:pt idx="216">
                  <c:v>0</c:v>
                </c:pt>
                <c:pt idx="217">
                  <c:v>0</c:v>
                </c:pt>
                <c:pt idx="218">
                  <c:v>0</c:v>
                </c:pt>
                <c:pt idx="219">
                  <c:v>0</c:v>
                </c:pt>
                <c:pt idx="220">
                  <c:v>0</c:v>
                </c:pt>
                <c:pt idx="221">
                  <c:v>0</c:v>
                </c:pt>
                <c:pt idx="222">
                  <c:v>0</c:v>
                </c:pt>
                <c:pt idx="223">
                  <c:v>0</c:v>
                </c:pt>
                <c:pt idx="224">
                  <c:v>0</c:v>
                </c:pt>
                <c:pt idx="225">
                  <c:v>0</c:v>
                </c:pt>
                <c:pt idx="226">
                  <c:v>0</c:v>
                </c:pt>
                <c:pt idx="227">
                  <c:v>0</c:v>
                </c:pt>
                <c:pt idx="228">
                  <c:v>0</c:v>
                </c:pt>
                <c:pt idx="229">
                  <c:v>0</c:v>
                </c:pt>
                <c:pt idx="230">
                  <c:v>0</c:v>
                </c:pt>
                <c:pt idx="231">
                  <c:v>0</c:v>
                </c:pt>
                <c:pt idx="232">
                  <c:v>0</c:v>
                </c:pt>
                <c:pt idx="233">
                  <c:v>0</c:v>
                </c:pt>
                <c:pt idx="234">
                  <c:v>0</c:v>
                </c:pt>
                <c:pt idx="235">
                  <c:v>0</c:v>
                </c:pt>
                <c:pt idx="236">
                  <c:v>0</c:v>
                </c:pt>
                <c:pt idx="237">
                  <c:v>0</c:v>
                </c:pt>
                <c:pt idx="238">
                  <c:v>0</c:v>
                </c:pt>
                <c:pt idx="239">
                  <c:v>0</c:v>
                </c:pt>
                <c:pt idx="240">
                  <c:v>0</c:v>
                </c:pt>
                <c:pt idx="241">
                  <c:v>0</c:v>
                </c:pt>
                <c:pt idx="242">
                  <c:v>0</c:v>
                </c:pt>
                <c:pt idx="243">
                  <c:v>0</c:v>
                </c:pt>
                <c:pt idx="244">
                  <c:v>0</c:v>
                </c:pt>
                <c:pt idx="245">
                  <c:v>0</c:v>
                </c:pt>
                <c:pt idx="246">
                  <c:v>0</c:v>
                </c:pt>
                <c:pt idx="247">
                  <c:v>0</c:v>
                </c:pt>
                <c:pt idx="248">
                  <c:v>0</c:v>
                </c:pt>
                <c:pt idx="249">
                  <c:v>0</c:v>
                </c:pt>
                <c:pt idx="250">
                  <c:v>0</c:v>
                </c:pt>
                <c:pt idx="251">
                  <c:v>0</c:v>
                </c:pt>
                <c:pt idx="252">
                  <c:v>0</c:v>
                </c:pt>
                <c:pt idx="253">
                  <c:v>0</c:v>
                </c:pt>
                <c:pt idx="254">
                  <c:v>0</c:v>
                </c:pt>
                <c:pt idx="255">
                  <c:v>0</c:v>
                </c:pt>
                <c:pt idx="256">
                  <c:v>0</c:v>
                </c:pt>
                <c:pt idx="257">
                  <c:v>0</c:v>
                </c:pt>
                <c:pt idx="258">
                  <c:v>0</c:v>
                </c:pt>
                <c:pt idx="259">
                  <c:v>0</c:v>
                </c:pt>
                <c:pt idx="260">
                  <c:v>0</c:v>
                </c:pt>
                <c:pt idx="261">
                  <c:v>0</c:v>
                </c:pt>
                <c:pt idx="262">
                  <c:v>0</c:v>
                </c:pt>
                <c:pt idx="263">
                  <c:v>0</c:v>
                </c:pt>
                <c:pt idx="264">
                  <c:v>0</c:v>
                </c:pt>
                <c:pt idx="265">
                  <c:v>0</c:v>
                </c:pt>
                <c:pt idx="266">
                  <c:v>0</c:v>
                </c:pt>
                <c:pt idx="267">
                  <c:v>0</c:v>
                </c:pt>
                <c:pt idx="268">
                  <c:v>0</c:v>
                </c:pt>
                <c:pt idx="269">
                  <c:v>0</c:v>
                </c:pt>
                <c:pt idx="270">
                  <c:v>0</c:v>
                </c:pt>
                <c:pt idx="271">
                  <c:v>0</c:v>
                </c:pt>
                <c:pt idx="272">
                  <c:v>0</c:v>
                </c:pt>
                <c:pt idx="273">
                  <c:v>0</c:v>
                </c:pt>
                <c:pt idx="274">
                  <c:v>0</c:v>
                </c:pt>
                <c:pt idx="275">
                  <c:v>0</c:v>
                </c:pt>
                <c:pt idx="276">
                  <c:v>0</c:v>
                </c:pt>
                <c:pt idx="277">
                  <c:v>0</c:v>
                </c:pt>
                <c:pt idx="278">
                  <c:v>0</c:v>
                </c:pt>
                <c:pt idx="279">
                  <c:v>0</c:v>
                </c:pt>
                <c:pt idx="280">
                  <c:v>0</c:v>
                </c:pt>
                <c:pt idx="281">
                  <c:v>0</c:v>
                </c:pt>
                <c:pt idx="282">
                  <c:v>0</c:v>
                </c:pt>
                <c:pt idx="283">
                  <c:v>0</c:v>
                </c:pt>
                <c:pt idx="284">
                  <c:v>0</c:v>
                </c:pt>
                <c:pt idx="285">
                  <c:v>0</c:v>
                </c:pt>
                <c:pt idx="286">
                  <c:v>0</c:v>
                </c:pt>
                <c:pt idx="287">
                  <c:v>0</c:v>
                </c:pt>
                <c:pt idx="288">
                  <c:v>0</c:v>
                </c:pt>
                <c:pt idx="289">
                  <c:v>0</c:v>
                </c:pt>
                <c:pt idx="290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E052-44D0-9E72-FFC11E14514F}"/>
            </c:ext>
          </c:extLst>
        </c:ser>
        <c:ser>
          <c:idx val="1"/>
          <c:order val="1"/>
          <c:tx>
            <c:strRef>
              <c:f>Sheet1!$D$1</c:f>
              <c:strCache>
                <c:ptCount val="1"/>
                <c:pt idx="0">
                  <c:v>MAS98.12</c:v>
                </c:pt>
              </c:strCache>
            </c:strRef>
          </c:tx>
          <c:spPr>
            <a:ln w="19050" cap="rnd">
              <a:solidFill>
                <a:srgbClr val="FF33CC"/>
              </a:solidFill>
              <a:round/>
            </a:ln>
            <a:effectLst/>
          </c:spPr>
          <c:marker>
            <c:symbol val="none"/>
          </c:marker>
          <c:xVal>
            <c:numRef>
              <c:f>Sheet1!$B$2:$B$292</c:f>
              <c:numCache>
                <c:formatCode>General</c:formatCode>
                <c:ptCount val="291"/>
                <c:pt idx="0">
                  <c:v>185.38874724170299</c:v>
                </c:pt>
                <c:pt idx="1">
                  <c:v>185.381086990184</c:v>
                </c:pt>
                <c:pt idx="2">
                  <c:v>185.37342673866601</c:v>
                </c:pt>
                <c:pt idx="3">
                  <c:v>185.365766487147</c:v>
                </c:pt>
                <c:pt idx="4">
                  <c:v>185.35810623562799</c:v>
                </c:pt>
                <c:pt idx="5">
                  <c:v>185.350445984109</c:v>
                </c:pt>
                <c:pt idx="6">
                  <c:v>185.34278573258999</c:v>
                </c:pt>
                <c:pt idx="7">
                  <c:v>185.335125481071</c:v>
                </c:pt>
                <c:pt idx="8">
                  <c:v>185.32746522955301</c:v>
                </c:pt>
                <c:pt idx="9">
                  <c:v>185.319804978034</c:v>
                </c:pt>
                <c:pt idx="10">
                  <c:v>185.31214472651499</c:v>
                </c:pt>
                <c:pt idx="11">
                  <c:v>185.304484474996</c:v>
                </c:pt>
                <c:pt idx="12">
                  <c:v>185.29682422347699</c:v>
                </c:pt>
                <c:pt idx="13">
                  <c:v>185.289163971959</c:v>
                </c:pt>
                <c:pt idx="14">
                  <c:v>185.28150372044001</c:v>
                </c:pt>
                <c:pt idx="15">
                  <c:v>185.273843468921</c:v>
                </c:pt>
                <c:pt idx="16">
                  <c:v>185.26618321740199</c:v>
                </c:pt>
                <c:pt idx="17">
                  <c:v>185.258522965883</c:v>
                </c:pt>
                <c:pt idx="18">
                  <c:v>185.25086271436399</c:v>
                </c:pt>
                <c:pt idx="19">
                  <c:v>185.243202462846</c:v>
                </c:pt>
                <c:pt idx="20">
                  <c:v>185.23554221132699</c:v>
                </c:pt>
                <c:pt idx="21">
                  <c:v>185.227881959808</c:v>
                </c:pt>
                <c:pt idx="22">
                  <c:v>185.22022170828899</c:v>
                </c:pt>
                <c:pt idx="23">
                  <c:v>185.21256145677</c:v>
                </c:pt>
                <c:pt idx="24">
                  <c:v>185.20490120525099</c:v>
                </c:pt>
                <c:pt idx="25">
                  <c:v>185.197240953733</c:v>
                </c:pt>
                <c:pt idx="26">
                  <c:v>185.18958070221399</c:v>
                </c:pt>
                <c:pt idx="27">
                  <c:v>184.048203225908</c:v>
                </c:pt>
                <c:pt idx="28">
                  <c:v>184.04054297438901</c:v>
                </c:pt>
                <c:pt idx="29">
                  <c:v>184.03288272287099</c:v>
                </c:pt>
                <c:pt idx="30">
                  <c:v>184.02522247135201</c:v>
                </c:pt>
                <c:pt idx="31">
                  <c:v>184.017562219833</c:v>
                </c:pt>
                <c:pt idx="32">
                  <c:v>184.00990196831401</c:v>
                </c:pt>
                <c:pt idx="33">
                  <c:v>184.002241716795</c:v>
                </c:pt>
                <c:pt idx="34">
                  <c:v>183.99458146527601</c:v>
                </c:pt>
                <c:pt idx="35">
                  <c:v>183.986921213758</c:v>
                </c:pt>
                <c:pt idx="36">
                  <c:v>183.97926096223901</c:v>
                </c:pt>
                <c:pt idx="37">
                  <c:v>183.97160071072</c:v>
                </c:pt>
                <c:pt idx="38">
                  <c:v>183.96394045920101</c:v>
                </c:pt>
                <c:pt idx="39">
                  <c:v>183.956280207682</c:v>
                </c:pt>
                <c:pt idx="40">
                  <c:v>183.94861995616401</c:v>
                </c:pt>
                <c:pt idx="41">
                  <c:v>183.940959704645</c:v>
                </c:pt>
                <c:pt idx="42">
                  <c:v>183.93329945312601</c:v>
                </c:pt>
                <c:pt idx="43">
                  <c:v>183.925639201607</c:v>
                </c:pt>
                <c:pt idx="44">
                  <c:v>183.91797895008801</c:v>
                </c:pt>
                <c:pt idx="45">
                  <c:v>183.910318698569</c:v>
                </c:pt>
                <c:pt idx="46">
                  <c:v>183.90265844705101</c:v>
                </c:pt>
                <c:pt idx="47">
                  <c:v>183.894998195532</c:v>
                </c:pt>
                <c:pt idx="48">
                  <c:v>180.48618626965299</c:v>
                </c:pt>
                <c:pt idx="49">
                  <c:v>180.478526018134</c:v>
                </c:pt>
                <c:pt idx="50">
                  <c:v>180.47086576661499</c:v>
                </c:pt>
                <c:pt idx="51">
                  <c:v>180.46320551509601</c:v>
                </c:pt>
                <c:pt idx="52">
                  <c:v>180.45554526357799</c:v>
                </c:pt>
                <c:pt idx="53">
                  <c:v>180.447885012059</c:v>
                </c:pt>
                <c:pt idx="54">
                  <c:v>180.44022476053999</c:v>
                </c:pt>
                <c:pt idx="55">
                  <c:v>180.43256450902101</c:v>
                </c:pt>
                <c:pt idx="56">
                  <c:v>180.42490425750199</c:v>
                </c:pt>
                <c:pt idx="57">
                  <c:v>180.417244005984</c:v>
                </c:pt>
                <c:pt idx="58">
                  <c:v>180.40958375446499</c:v>
                </c:pt>
                <c:pt idx="59">
                  <c:v>180.401923502946</c:v>
                </c:pt>
                <c:pt idx="60">
                  <c:v>180.39426325142699</c:v>
                </c:pt>
                <c:pt idx="61">
                  <c:v>180.38660299990801</c:v>
                </c:pt>
                <c:pt idx="62">
                  <c:v>180.37894274838899</c:v>
                </c:pt>
                <c:pt idx="63">
                  <c:v>180.371282496871</c:v>
                </c:pt>
                <c:pt idx="64">
                  <c:v>180.36362224535199</c:v>
                </c:pt>
                <c:pt idx="65">
                  <c:v>180.35596199383301</c:v>
                </c:pt>
                <c:pt idx="66">
                  <c:v>180.34830174231399</c:v>
                </c:pt>
                <c:pt idx="67">
                  <c:v>180.34064149079501</c:v>
                </c:pt>
                <c:pt idx="68">
                  <c:v>180.33298123927599</c:v>
                </c:pt>
                <c:pt idx="69">
                  <c:v>180.325320987758</c:v>
                </c:pt>
                <c:pt idx="70">
                  <c:v>180.31766073623899</c:v>
                </c:pt>
                <c:pt idx="71">
                  <c:v>180.31000048472001</c:v>
                </c:pt>
                <c:pt idx="72">
                  <c:v>180.30234023320099</c:v>
                </c:pt>
                <c:pt idx="73">
                  <c:v>180.29467998168201</c:v>
                </c:pt>
                <c:pt idx="74">
                  <c:v>180.287019730163</c:v>
                </c:pt>
                <c:pt idx="75">
                  <c:v>180.27935947864501</c:v>
                </c:pt>
                <c:pt idx="76">
                  <c:v>180.27169922712599</c:v>
                </c:pt>
                <c:pt idx="77">
                  <c:v>180.26403897560701</c:v>
                </c:pt>
                <c:pt idx="78">
                  <c:v>180.25637872408799</c:v>
                </c:pt>
                <c:pt idx="79">
                  <c:v>180.24871847256901</c:v>
                </c:pt>
                <c:pt idx="80">
                  <c:v>180.24105822105</c:v>
                </c:pt>
                <c:pt idx="81">
                  <c:v>180.23339796953201</c:v>
                </c:pt>
                <c:pt idx="82">
                  <c:v>180.22573771801299</c:v>
                </c:pt>
                <c:pt idx="83">
                  <c:v>180.21807746649401</c:v>
                </c:pt>
                <c:pt idx="84">
                  <c:v>180.210417214975</c:v>
                </c:pt>
                <c:pt idx="85">
                  <c:v>180.20275696345601</c:v>
                </c:pt>
                <c:pt idx="86">
                  <c:v>180.195096711937</c:v>
                </c:pt>
                <c:pt idx="87">
                  <c:v>180.18743646041901</c:v>
                </c:pt>
                <c:pt idx="88">
                  <c:v>180.17977620889999</c:v>
                </c:pt>
                <c:pt idx="89">
                  <c:v>178.724328420322</c:v>
                </c:pt>
                <c:pt idx="90">
                  <c:v>178.71666816880401</c:v>
                </c:pt>
                <c:pt idx="91">
                  <c:v>178.70900791728499</c:v>
                </c:pt>
                <c:pt idx="92">
                  <c:v>178.70134766576601</c:v>
                </c:pt>
                <c:pt idx="93">
                  <c:v>178.69368741424699</c:v>
                </c:pt>
                <c:pt idx="94">
                  <c:v>178.68602716272801</c:v>
                </c:pt>
                <c:pt idx="95">
                  <c:v>178.678366911209</c:v>
                </c:pt>
                <c:pt idx="96">
                  <c:v>178.67070665969101</c:v>
                </c:pt>
                <c:pt idx="97">
                  <c:v>178.66304640817199</c:v>
                </c:pt>
                <c:pt idx="98">
                  <c:v>178.65538615665301</c:v>
                </c:pt>
                <c:pt idx="99">
                  <c:v>178.647725905134</c:v>
                </c:pt>
                <c:pt idx="100">
                  <c:v>178.64006565361501</c:v>
                </c:pt>
                <c:pt idx="101">
                  <c:v>178.632405402096</c:v>
                </c:pt>
                <c:pt idx="102">
                  <c:v>178.62474515057801</c:v>
                </c:pt>
                <c:pt idx="103">
                  <c:v>178.61708489905899</c:v>
                </c:pt>
                <c:pt idx="104">
                  <c:v>178.60942464754001</c:v>
                </c:pt>
                <c:pt idx="105">
                  <c:v>178.601764396021</c:v>
                </c:pt>
                <c:pt idx="106">
                  <c:v>178.59410414450201</c:v>
                </c:pt>
                <c:pt idx="107">
                  <c:v>178.586443892983</c:v>
                </c:pt>
                <c:pt idx="108">
                  <c:v>178.57878364146501</c:v>
                </c:pt>
                <c:pt idx="109">
                  <c:v>178.571123389946</c:v>
                </c:pt>
                <c:pt idx="110">
                  <c:v>178.56346313842701</c:v>
                </c:pt>
                <c:pt idx="111">
                  <c:v>178.555802886908</c:v>
                </c:pt>
                <c:pt idx="112">
                  <c:v>178.54814263538901</c:v>
                </c:pt>
                <c:pt idx="113">
                  <c:v>178.54048238387</c:v>
                </c:pt>
                <c:pt idx="114">
                  <c:v>178.53282213235201</c:v>
                </c:pt>
                <c:pt idx="115">
                  <c:v>177.38378440452701</c:v>
                </c:pt>
                <c:pt idx="116">
                  <c:v>177.37612415300899</c:v>
                </c:pt>
                <c:pt idx="117">
                  <c:v>177.36846390149</c:v>
                </c:pt>
                <c:pt idx="118">
                  <c:v>177.36080364997099</c:v>
                </c:pt>
                <c:pt idx="119">
                  <c:v>177.353143398452</c:v>
                </c:pt>
                <c:pt idx="120">
                  <c:v>177.34548314693299</c:v>
                </c:pt>
                <c:pt idx="121">
                  <c:v>177.33782289541401</c:v>
                </c:pt>
                <c:pt idx="122">
                  <c:v>177.33016264389599</c:v>
                </c:pt>
                <c:pt idx="123">
                  <c:v>177.322502392377</c:v>
                </c:pt>
                <c:pt idx="124">
                  <c:v>177.31484214085799</c:v>
                </c:pt>
                <c:pt idx="125">
                  <c:v>177.30718188933901</c:v>
                </c:pt>
                <c:pt idx="126">
                  <c:v>177.29952163781999</c:v>
                </c:pt>
                <c:pt idx="127">
                  <c:v>177.29186138630101</c:v>
                </c:pt>
                <c:pt idx="128">
                  <c:v>177.28420113478299</c:v>
                </c:pt>
                <c:pt idx="129">
                  <c:v>177.276540883264</c:v>
                </c:pt>
                <c:pt idx="130">
                  <c:v>177.26888063174499</c:v>
                </c:pt>
                <c:pt idx="131">
                  <c:v>176.92416931339801</c:v>
                </c:pt>
                <c:pt idx="132">
                  <c:v>176.916509061879</c:v>
                </c:pt>
                <c:pt idx="133">
                  <c:v>176.90884881036001</c:v>
                </c:pt>
                <c:pt idx="134">
                  <c:v>176.901188558841</c:v>
                </c:pt>
                <c:pt idx="135">
                  <c:v>176.89352830732199</c:v>
                </c:pt>
                <c:pt idx="136">
                  <c:v>176.885868055803</c:v>
                </c:pt>
                <c:pt idx="137">
                  <c:v>176.87820780428501</c:v>
                </c:pt>
                <c:pt idx="138">
                  <c:v>176.870547552766</c:v>
                </c:pt>
                <c:pt idx="139">
                  <c:v>176.86288730124701</c:v>
                </c:pt>
                <c:pt idx="140">
                  <c:v>176.855227049728</c:v>
                </c:pt>
                <c:pt idx="141">
                  <c:v>176.84756679820899</c:v>
                </c:pt>
                <c:pt idx="142">
                  <c:v>176.839906546691</c:v>
                </c:pt>
                <c:pt idx="143">
                  <c:v>176.83224629517201</c:v>
                </c:pt>
                <c:pt idx="144">
                  <c:v>176.824586043653</c:v>
                </c:pt>
                <c:pt idx="145">
                  <c:v>176.81692579213399</c:v>
                </c:pt>
                <c:pt idx="146">
                  <c:v>176.809265540615</c:v>
                </c:pt>
                <c:pt idx="147">
                  <c:v>176.80160528909599</c:v>
                </c:pt>
                <c:pt idx="148">
                  <c:v>176.793945037578</c:v>
                </c:pt>
                <c:pt idx="149">
                  <c:v>176.78628478605901</c:v>
                </c:pt>
                <c:pt idx="150">
                  <c:v>176.77862453454</c:v>
                </c:pt>
                <c:pt idx="151">
                  <c:v>176.77096428302099</c:v>
                </c:pt>
                <c:pt idx="152">
                  <c:v>175.430420267226</c:v>
                </c:pt>
                <c:pt idx="153">
                  <c:v>175.42276001570701</c:v>
                </c:pt>
                <c:pt idx="154">
                  <c:v>175.415099764188</c:v>
                </c:pt>
                <c:pt idx="155">
                  <c:v>175.40743951267001</c:v>
                </c:pt>
                <c:pt idx="156">
                  <c:v>175.399779261151</c:v>
                </c:pt>
                <c:pt idx="157">
                  <c:v>175.39211900963201</c:v>
                </c:pt>
                <c:pt idx="158">
                  <c:v>175.384458758113</c:v>
                </c:pt>
                <c:pt idx="159">
                  <c:v>175.37679850659401</c:v>
                </c:pt>
                <c:pt idx="160">
                  <c:v>175.369138255075</c:v>
                </c:pt>
                <c:pt idx="161">
                  <c:v>175.36147800355701</c:v>
                </c:pt>
                <c:pt idx="162">
                  <c:v>175.353817752038</c:v>
                </c:pt>
                <c:pt idx="163">
                  <c:v>175.34615750051901</c:v>
                </c:pt>
                <c:pt idx="164">
                  <c:v>175.338497249</c:v>
                </c:pt>
                <c:pt idx="165">
                  <c:v>175.33083699748099</c:v>
                </c:pt>
                <c:pt idx="166">
                  <c:v>175.323176745962</c:v>
                </c:pt>
                <c:pt idx="167">
                  <c:v>175.31551649444401</c:v>
                </c:pt>
                <c:pt idx="168">
                  <c:v>175.307856242925</c:v>
                </c:pt>
                <c:pt idx="169">
                  <c:v>175.30019599140601</c:v>
                </c:pt>
                <c:pt idx="170">
                  <c:v>175.292535739887</c:v>
                </c:pt>
                <c:pt idx="171">
                  <c:v>175.28487548836799</c:v>
                </c:pt>
                <c:pt idx="172">
                  <c:v>175.277215236849</c:v>
                </c:pt>
                <c:pt idx="173">
                  <c:v>175.26955498533101</c:v>
                </c:pt>
                <c:pt idx="174">
                  <c:v>175.261894733812</c:v>
                </c:pt>
                <c:pt idx="175">
                  <c:v>175.25423448229299</c:v>
                </c:pt>
                <c:pt idx="176">
                  <c:v>175.246574230774</c:v>
                </c:pt>
                <c:pt idx="177">
                  <c:v>175.23891397925499</c:v>
                </c:pt>
                <c:pt idx="178">
                  <c:v>175.231253727737</c:v>
                </c:pt>
                <c:pt idx="179">
                  <c:v>175.22359347621801</c:v>
                </c:pt>
                <c:pt idx="180">
                  <c:v>175.215933224699</c:v>
                </c:pt>
                <c:pt idx="181">
                  <c:v>175.20827297317999</c:v>
                </c:pt>
                <c:pt idx="182">
                  <c:v>175.200612721661</c:v>
                </c:pt>
                <c:pt idx="183">
                  <c:v>175.19295247014199</c:v>
                </c:pt>
                <c:pt idx="184">
                  <c:v>175.185292218624</c:v>
                </c:pt>
                <c:pt idx="185">
                  <c:v>175.17763196710499</c:v>
                </c:pt>
                <c:pt idx="186">
                  <c:v>175.169971715586</c:v>
                </c:pt>
                <c:pt idx="187">
                  <c:v>175.16231146406699</c:v>
                </c:pt>
                <c:pt idx="188">
                  <c:v>175.154651212548</c:v>
                </c:pt>
                <c:pt idx="189">
                  <c:v>175.14699096102899</c:v>
                </c:pt>
                <c:pt idx="190">
                  <c:v>175.139330709511</c:v>
                </c:pt>
                <c:pt idx="191">
                  <c:v>175.13167045799199</c:v>
                </c:pt>
                <c:pt idx="192">
                  <c:v>175.124010206473</c:v>
                </c:pt>
                <c:pt idx="193">
                  <c:v>175.11634995495399</c:v>
                </c:pt>
                <c:pt idx="194">
                  <c:v>174.58779260015501</c:v>
                </c:pt>
                <c:pt idx="195">
                  <c:v>174.580132348636</c:v>
                </c:pt>
                <c:pt idx="196">
                  <c:v>174.57247209711699</c:v>
                </c:pt>
                <c:pt idx="197">
                  <c:v>174.564811845598</c:v>
                </c:pt>
                <c:pt idx="198">
                  <c:v>174.55715159408001</c:v>
                </c:pt>
                <c:pt idx="199">
                  <c:v>174.549491342561</c:v>
                </c:pt>
                <c:pt idx="200">
                  <c:v>174.54183109104201</c:v>
                </c:pt>
                <c:pt idx="201">
                  <c:v>174.534170839523</c:v>
                </c:pt>
                <c:pt idx="202">
                  <c:v>174.52651058800399</c:v>
                </c:pt>
                <c:pt idx="203">
                  <c:v>174.518850336485</c:v>
                </c:pt>
                <c:pt idx="204">
                  <c:v>174.51119008496701</c:v>
                </c:pt>
                <c:pt idx="205">
                  <c:v>174.503529833448</c:v>
                </c:pt>
                <c:pt idx="206">
                  <c:v>174.49586958192901</c:v>
                </c:pt>
                <c:pt idx="207">
                  <c:v>174.48820933041</c:v>
                </c:pt>
                <c:pt idx="208">
                  <c:v>174.48054907889099</c:v>
                </c:pt>
                <c:pt idx="209">
                  <c:v>174.472888827372</c:v>
                </c:pt>
                <c:pt idx="210">
                  <c:v>174.46522857585401</c:v>
                </c:pt>
                <c:pt idx="211">
                  <c:v>174.457568324335</c:v>
                </c:pt>
                <c:pt idx="212">
                  <c:v>174.44990807281599</c:v>
                </c:pt>
                <c:pt idx="213">
                  <c:v>174.442247821297</c:v>
                </c:pt>
                <c:pt idx="214">
                  <c:v>174.43458756977799</c:v>
                </c:pt>
                <c:pt idx="215">
                  <c:v>174.42692731826</c:v>
                </c:pt>
                <c:pt idx="216">
                  <c:v>174.41926706674101</c:v>
                </c:pt>
                <c:pt idx="217">
                  <c:v>174.411606815222</c:v>
                </c:pt>
                <c:pt idx="218">
                  <c:v>174.40394656370299</c:v>
                </c:pt>
                <c:pt idx="219">
                  <c:v>174.396286312184</c:v>
                </c:pt>
                <c:pt idx="220">
                  <c:v>174.38862606066499</c:v>
                </c:pt>
                <c:pt idx="221">
                  <c:v>174.380965809147</c:v>
                </c:pt>
                <c:pt idx="222">
                  <c:v>174.37330555762799</c:v>
                </c:pt>
                <c:pt idx="223">
                  <c:v>174.365645306109</c:v>
                </c:pt>
                <c:pt idx="224">
                  <c:v>174.35798505458999</c:v>
                </c:pt>
                <c:pt idx="225">
                  <c:v>174.350324803071</c:v>
                </c:pt>
                <c:pt idx="226">
                  <c:v>174.34266455155199</c:v>
                </c:pt>
                <c:pt idx="227">
                  <c:v>174.335004300034</c:v>
                </c:pt>
                <c:pt idx="228">
                  <c:v>174.32734404851499</c:v>
                </c:pt>
                <c:pt idx="229">
                  <c:v>174.319683796996</c:v>
                </c:pt>
                <c:pt idx="230">
                  <c:v>174.31202354547699</c:v>
                </c:pt>
                <c:pt idx="231">
                  <c:v>174.304363293958</c:v>
                </c:pt>
                <c:pt idx="232">
                  <c:v>174.29670304243899</c:v>
                </c:pt>
                <c:pt idx="233">
                  <c:v>174.289042790921</c:v>
                </c:pt>
                <c:pt idx="234">
                  <c:v>174.28138253940199</c:v>
                </c:pt>
                <c:pt idx="235">
                  <c:v>174.273722287883</c:v>
                </c:pt>
                <c:pt idx="236">
                  <c:v>174.26606203636399</c:v>
                </c:pt>
                <c:pt idx="237">
                  <c:v>174.25840178484501</c:v>
                </c:pt>
                <c:pt idx="238">
                  <c:v>174.25074153332599</c:v>
                </c:pt>
                <c:pt idx="239">
                  <c:v>174.243081281808</c:v>
                </c:pt>
                <c:pt idx="240">
                  <c:v>174.23542103028899</c:v>
                </c:pt>
                <c:pt idx="241">
                  <c:v>174.22776077877</c:v>
                </c:pt>
                <c:pt idx="242">
                  <c:v>174.22010052725099</c:v>
                </c:pt>
                <c:pt idx="243">
                  <c:v>174.21244027573201</c:v>
                </c:pt>
                <c:pt idx="244">
                  <c:v>174.20478002421299</c:v>
                </c:pt>
                <c:pt idx="245">
                  <c:v>174.197119772695</c:v>
                </c:pt>
                <c:pt idx="246">
                  <c:v>174.18945952117599</c:v>
                </c:pt>
                <c:pt idx="247">
                  <c:v>174.18179926965701</c:v>
                </c:pt>
                <c:pt idx="248">
                  <c:v>174.17413901813799</c:v>
                </c:pt>
                <c:pt idx="249">
                  <c:v>174.16647876661901</c:v>
                </c:pt>
                <c:pt idx="250">
                  <c:v>174.15881851509999</c:v>
                </c:pt>
                <c:pt idx="251">
                  <c:v>174.151158263582</c:v>
                </c:pt>
                <c:pt idx="252">
                  <c:v>174.14349801206299</c:v>
                </c:pt>
                <c:pt idx="253">
                  <c:v>174.13583776054401</c:v>
                </c:pt>
                <c:pt idx="254">
                  <c:v>174.12817750902499</c:v>
                </c:pt>
                <c:pt idx="255">
                  <c:v>173.821767448272</c:v>
                </c:pt>
                <c:pt idx="256">
                  <c:v>173.81410719675301</c:v>
                </c:pt>
                <c:pt idx="257">
                  <c:v>173.806446945234</c:v>
                </c:pt>
                <c:pt idx="258">
                  <c:v>173.79878669371601</c:v>
                </c:pt>
                <c:pt idx="259">
                  <c:v>173.791126442197</c:v>
                </c:pt>
                <c:pt idx="260">
                  <c:v>173.78346619067801</c:v>
                </c:pt>
                <c:pt idx="261">
                  <c:v>173.775805939159</c:v>
                </c:pt>
                <c:pt idx="262">
                  <c:v>173.76814568763999</c:v>
                </c:pt>
                <c:pt idx="263">
                  <c:v>173.760485436121</c:v>
                </c:pt>
                <c:pt idx="264">
                  <c:v>173.75282518460301</c:v>
                </c:pt>
                <c:pt idx="265">
                  <c:v>173.745164933084</c:v>
                </c:pt>
                <c:pt idx="266">
                  <c:v>173.73750468156501</c:v>
                </c:pt>
                <c:pt idx="267">
                  <c:v>173.729844430046</c:v>
                </c:pt>
                <c:pt idx="268">
                  <c:v>173.72218417852699</c:v>
                </c:pt>
                <c:pt idx="269">
                  <c:v>173.714523927008</c:v>
                </c:pt>
                <c:pt idx="270">
                  <c:v>173.70686367549001</c:v>
                </c:pt>
                <c:pt idx="271">
                  <c:v>173.699203423971</c:v>
                </c:pt>
                <c:pt idx="272">
                  <c:v>173.69154317245199</c:v>
                </c:pt>
                <c:pt idx="273">
                  <c:v>173.683882920933</c:v>
                </c:pt>
                <c:pt idx="274">
                  <c:v>173.67622266941399</c:v>
                </c:pt>
                <c:pt idx="275">
                  <c:v>173.668562417895</c:v>
                </c:pt>
                <c:pt idx="276">
                  <c:v>173.66090216637701</c:v>
                </c:pt>
                <c:pt idx="277">
                  <c:v>173.653241914858</c:v>
                </c:pt>
                <c:pt idx="278">
                  <c:v>173.64558166333899</c:v>
                </c:pt>
                <c:pt idx="279">
                  <c:v>173.63792141182</c:v>
                </c:pt>
                <c:pt idx="280">
                  <c:v>173.63026116030099</c:v>
                </c:pt>
                <c:pt idx="281">
                  <c:v>173.622600908783</c:v>
                </c:pt>
                <c:pt idx="282">
                  <c:v>173.61494065726399</c:v>
                </c:pt>
                <c:pt idx="283">
                  <c:v>173.607280405745</c:v>
                </c:pt>
                <c:pt idx="284">
                  <c:v>173.59962015422599</c:v>
                </c:pt>
                <c:pt idx="285">
                  <c:v>173.591959902707</c:v>
                </c:pt>
                <c:pt idx="286">
                  <c:v>173.58429965118799</c:v>
                </c:pt>
                <c:pt idx="287">
                  <c:v>173.57663939967</c:v>
                </c:pt>
                <c:pt idx="288">
                  <c:v>173.56897914815099</c:v>
                </c:pt>
                <c:pt idx="289">
                  <c:v>173.561318896632</c:v>
                </c:pt>
                <c:pt idx="290">
                  <c:v>173.55365864511299</c:v>
                </c:pt>
              </c:numCache>
            </c:numRef>
          </c:xVal>
          <c:yVal>
            <c:numRef>
              <c:f>Sheet1!$D$2:$D$292</c:f>
              <c:numCache>
                <c:formatCode>General</c:formatCode>
                <c:ptCount val="291"/>
                <c:pt idx="0">
                  <c:v>103988.78197681899</c:v>
                </c:pt>
                <c:pt idx="1">
                  <c:v>92489.572628633701</c:v>
                </c:pt>
                <c:pt idx="2">
                  <c:v>175771.03433360299</c:v>
                </c:pt>
                <c:pt idx="3">
                  <c:v>-32473.608782248801</c:v>
                </c:pt>
                <c:pt idx="4">
                  <c:v>-55057.534625331602</c:v>
                </c:pt>
                <c:pt idx="5">
                  <c:v>381.90348226881201</c:v>
                </c:pt>
                <c:pt idx="6">
                  <c:v>105195.40178956999</c:v>
                </c:pt>
                <c:pt idx="7">
                  <c:v>124815.672945087</c:v>
                </c:pt>
                <c:pt idx="8">
                  <c:v>238565.45452641699</c:v>
                </c:pt>
                <c:pt idx="9">
                  <c:v>254461.606202642</c:v>
                </c:pt>
                <c:pt idx="10">
                  <c:v>473390.17685080302</c:v>
                </c:pt>
                <c:pt idx="11">
                  <c:v>1074224.26332024</c:v>
                </c:pt>
                <c:pt idx="12">
                  <c:v>823107.94712449296</c:v>
                </c:pt>
                <c:pt idx="13">
                  <c:v>390483.91735262598</c:v>
                </c:pt>
                <c:pt idx="14">
                  <c:v>126599.74206729</c:v>
                </c:pt>
                <c:pt idx="15">
                  <c:v>162659.72892443099</c:v>
                </c:pt>
                <c:pt idx="16">
                  <c:v>161479.31499061099</c:v>
                </c:pt>
                <c:pt idx="17">
                  <c:v>42008.646064080902</c:v>
                </c:pt>
                <c:pt idx="18">
                  <c:v>40558.570528097996</c:v>
                </c:pt>
                <c:pt idx="19">
                  <c:v>161568.38220806699</c:v>
                </c:pt>
                <c:pt idx="20">
                  <c:v>25521.1384603841</c:v>
                </c:pt>
                <c:pt idx="21">
                  <c:v>49580.047965308397</c:v>
                </c:pt>
                <c:pt idx="22">
                  <c:v>-6191.3257021244499</c:v>
                </c:pt>
                <c:pt idx="23">
                  <c:v>-46195.024833072202</c:v>
                </c:pt>
                <c:pt idx="24">
                  <c:v>-137308.00965601401</c:v>
                </c:pt>
                <c:pt idx="25">
                  <c:v>84726.011309401496</c:v>
                </c:pt>
                <c:pt idx="26">
                  <c:v>0</c:v>
                </c:pt>
                <c:pt idx="27">
                  <c:v>0</c:v>
                </c:pt>
                <c:pt idx="28">
                  <c:v>33322.596967539299</c:v>
                </c:pt>
                <c:pt idx="29">
                  <c:v>-49740.524911694098</c:v>
                </c:pt>
                <c:pt idx="30">
                  <c:v>-100489.29325339101</c:v>
                </c:pt>
                <c:pt idx="31">
                  <c:v>23955.1311240625</c:v>
                </c:pt>
                <c:pt idx="32">
                  <c:v>82318.663328297596</c:v>
                </c:pt>
                <c:pt idx="33">
                  <c:v>255156.83859470699</c:v>
                </c:pt>
                <c:pt idx="34">
                  <c:v>403840.677746367</c:v>
                </c:pt>
                <c:pt idx="35">
                  <c:v>1102721.3516506399</c:v>
                </c:pt>
                <c:pt idx="36">
                  <c:v>1305798.16686673</c:v>
                </c:pt>
                <c:pt idx="37">
                  <c:v>765175.12578804605</c:v>
                </c:pt>
                <c:pt idx="38">
                  <c:v>357609.03180567402</c:v>
                </c:pt>
                <c:pt idx="39">
                  <c:v>151566.82554375599</c:v>
                </c:pt>
                <c:pt idx="40">
                  <c:v>149375.344615212</c:v>
                </c:pt>
                <c:pt idx="41">
                  <c:v>228178.08776563001</c:v>
                </c:pt>
                <c:pt idx="42">
                  <c:v>250515.33836405899</c:v>
                </c:pt>
                <c:pt idx="43">
                  <c:v>189822.034982326</c:v>
                </c:pt>
                <c:pt idx="44">
                  <c:v>150095.43480829001</c:v>
                </c:pt>
                <c:pt idx="45">
                  <c:v>72858.354351781702</c:v>
                </c:pt>
                <c:pt idx="46">
                  <c:v>78987.875675151197</c:v>
                </c:pt>
                <c:pt idx="47">
                  <c:v>0</c:v>
                </c:pt>
                <c:pt idx="48">
                  <c:v>0</c:v>
                </c:pt>
                <c:pt idx="49">
                  <c:v>-76764.8393885759</c:v>
                </c:pt>
                <c:pt idx="50">
                  <c:v>-14127.1156377733</c:v>
                </c:pt>
                <c:pt idx="51">
                  <c:v>-43081.999203581399</c:v>
                </c:pt>
                <c:pt idx="52">
                  <c:v>58931.188282266303</c:v>
                </c:pt>
                <c:pt idx="53">
                  <c:v>-40285.044036712301</c:v>
                </c:pt>
                <c:pt idx="54">
                  <c:v>17864.8451119743</c:v>
                </c:pt>
                <c:pt idx="55">
                  <c:v>32952.702311635599</c:v>
                </c:pt>
                <c:pt idx="56">
                  <c:v>143245.78981927101</c:v>
                </c:pt>
                <c:pt idx="57">
                  <c:v>88870.554510793299</c:v>
                </c:pt>
                <c:pt idx="58">
                  <c:v>591.42483029144898</c:v>
                </c:pt>
                <c:pt idx="59">
                  <c:v>174911.69771007399</c:v>
                </c:pt>
                <c:pt idx="60">
                  <c:v>135255.26774881501</c:v>
                </c:pt>
                <c:pt idx="61">
                  <c:v>157010.092652083</c:v>
                </c:pt>
                <c:pt idx="62">
                  <c:v>31074.546597483601</c:v>
                </c:pt>
                <c:pt idx="63">
                  <c:v>-28712.921732944102</c:v>
                </c:pt>
                <c:pt idx="64">
                  <c:v>83364.612482256896</c:v>
                </c:pt>
                <c:pt idx="65">
                  <c:v>67676.485873752506</c:v>
                </c:pt>
                <c:pt idx="66">
                  <c:v>139037.02627916401</c:v>
                </c:pt>
                <c:pt idx="67">
                  <c:v>55591.082030897102</c:v>
                </c:pt>
                <c:pt idx="68">
                  <c:v>87002.794361488195</c:v>
                </c:pt>
                <c:pt idx="69">
                  <c:v>92529.655581616506</c:v>
                </c:pt>
                <c:pt idx="70">
                  <c:v>166224.687592431</c:v>
                </c:pt>
                <c:pt idx="71">
                  <c:v>80328.931689926903</c:v>
                </c:pt>
                <c:pt idx="72">
                  <c:v>30065.8732200169</c:v>
                </c:pt>
                <c:pt idx="73">
                  <c:v>50599.780831477598</c:v>
                </c:pt>
                <c:pt idx="74">
                  <c:v>-52278.8729714699</c:v>
                </c:pt>
                <c:pt idx="75">
                  <c:v>18041.766905927099</c:v>
                </c:pt>
                <c:pt idx="76">
                  <c:v>-25661.1841178369</c:v>
                </c:pt>
                <c:pt idx="77">
                  <c:v>-813.10960423473398</c:v>
                </c:pt>
                <c:pt idx="78">
                  <c:v>70723.954658756207</c:v>
                </c:pt>
                <c:pt idx="79">
                  <c:v>105764.45130714</c:v>
                </c:pt>
                <c:pt idx="80">
                  <c:v>33538.8358179633</c:v>
                </c:pt>
                <c:pt idx="81">
                  <c:v>-3748.5405441276398</c:v>
                </c:pt>
                <c:pt idx="82">
                  <c:v>-144890.12169402701</c:v>
                </c:pt>
                <c:pt idx="83">
                  <c:v>-58434.778080252901</c:v>
                </c:pt>
                <c:pt idx="84">
                  <c:v>-7221.9440463789197</c:v>
                </c:pt>
                <c:pt idx="85">
                  <c:v>-2528.493530322</c:v>
                </c:pt>
                <c:pt idx="86">
                  <c:v>65083.866424239699</c:v>
                </c:pt>
                <c:pt idx="87">
                  <c:v>10134.0459146538</c:v>
                </c:pt>
                <c:pt idx="88">
                  <c:v>0</c:v>
                </c:pt>
                <c:pt idx="89">
                  <c:v>0</c:v>
                </c:pt>
                <c:pt idx="90">
                  <c:v>-41683.594860539401</c:v>
                </c:pt>
                <c:pt idx="91">
                  <c:v>-116083.44370495901</c:v>
                </c:pt>
                <c:pt idx="92">
                  <c:v>-84836.677818660202</c:v>
                </c:pt>
                <c:pt idx="93">
                  <c:v>-96693.652556640998</c:v>
                </c:pt>
                <c:pt idx="94">
                  <c:v>9158.3685134535008</c:v>
                </c:pt>
                <c:pt idx="95">
                  <c:v>-46650.706164436502</c:v>
                </c:pt>
                <c:pt idx="96">
                  <c:v>32661.672262433302</c:v>
                </c:pt>
                <c:pt idx="97">
                  <c:v>80181.719086988698</c:v>
                </c:pt>
                <c:pt idx="98">
                  <c:v>81224.000326388006</c:v>
                </c:pt>
                <c:pt idx="99">
                  <c:v>139618.543404311</c:v>
                </c:pt>
                <c:pt idx="100">
                  <c:v>254688.11523537801</c:v>
                </c:pt>
                <c:pt idx="101">
                  <c:v>66504.405538831095</c:v>
                </c:pt>
                <c:pt idx="102">
                  <c:v>87194.710625496504</c:v>
                </c:pt>
                <c:pt idx="103">
                  <c:v>61245.222033850798</c:v>
                </c:pt>
                <c:pt idx="104">
                  <c:v>50783.005401382499</c:v>
                </c:pt>
                <c:pt idx="105">
                  <c:v>56412.179113751597</c:v>
                </c:pt>
                <c:pt idx="106">
                  <c:v>647.94085553782497</c:v>
                </c:pt>
                <c:pt idx="107">
                  <c:v>-115182.740505316</c:v>
                </c:pt>
                <c:pt idx="108">
                  <c:v>-124246.04929251201</c:v>
                </c:pt>
                <c:pt idx="109">
                  <c:v>-77124.220586273193</c:v>
                </c:pt>
                <c:pt idx="110">
                  <c:v>-61847.960767880802</c:v>
                </c:pt>
                <c:pt idx="111">
                  <c:v>-71368.605568551895</c:v>
                </c:pt>
                <c:pt idx="112">
                  <c:v>-99456.747843565201</c:v>
                </c:pt>
                <c:pt idx="113">
                  <c:v>-184182.334363342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0</c:v>
                </c:pt>
                <c:pt idx="121">
                  <c:v>187674.33362013899</c:v>
                </c:pt>
                <c:pt idx="122">
                  <c:v>209191.156094181</c:v>
                </c:pt>
                <c:pt idx="123">
                  <c:v>128234.110081498</c:v>
                </c:pt>
                <c:pt idx="124">
                  <c:v>104241.645313644</c:v>
                </c:pt>
                <c:pt idx="125">
                  <c:v>3591.6908273292602</c:v>
                </c:pt>
                <c:pt idx="126">
                  <c:v>-22547.375683595201</c:v>
                </c:pt>
                <c:pt idx="127">
                  <c:v>-106585.22992711399</c:v>
                </c:pt>
                <c:pt idx="128">
                  <c:v>-55256.290904111796</c:v>
                </c:pt>
                <c:pt idx="129">
                  <c:v>63232.0927407118</c:v>
                </c:pt>
                <c:pt idx="130">
                  <c:v>0</c:v>
                </c:pt>
                <c:pt idx="131">
                  <c:v>0</c:v>
                </c:pt>
                <c:pt idx="132">
                  <c:v>-32420.224613945</c:v>
                </c:pt>
                <c:pt idx="133">
                  <c:v>-315.76659742287302</c:v>
                </c:pt>
                <c:pt idx="134">
                  <c:v>-102008.13639961299</c:v>
                </c:pt>
                <c:pt idx="135">
                  <c:v>-64691.532112930297</c:v>
                </c:pt>
                <c:pt idx="136">
                  <c:v>-116918.060936247</c:v>
                </c:pt>
                <c:pt idx="137">
                  <c:v>-59393.496228837401</c:v>
                </c:pt>
                <c:pt idx="138">
                  <c:v>-5192.39333321907</c:v>
                </c:pt>
                <c:pt idx="139">
                  <c:v>7633.9220608196802</c:v>
                </c:pt>
                <c:pt idx="140">
                  <c:v>26972.4708562128</c:v>
                </c:pt>
                <c:pt idx="141">
                  <c:v>47539.096857393997</c:v>
                </c:pt>
                <c:pt idx="142">
                  <c:v>28178.656794189101</c:v>
                </c:pt>
                <c:pt idx="143">
                  <c:v>-45778.131297624102</c:v>
                </c:pt>
                <c:pt idx="144">
                  <c:v>-9915.50980918204</c:v>
                </c:pt>
                <c:pt idx="145">
                  <c:v>-35437.6765409894</c:v>
                </c:pt>
                <c:pt idx="146">
                  <c:v>-2241.0229386813198</c:v>
                </c:pt>
                <c:pt idx="147">
                  <c:v>-50305.006103671898</c:v>
                </c:pt>
                <c:pt idx="148">
                  <c:v>-54148.899231218697</c:v>
                </c:pt>
                <c:pt idx="149">
                  <c:v>24855.0334162033</c:v>
                </c:pt>
                <c:pt idx="150">
                  <c:v>66901.8998949651</c:v>
                </c:pt>
                <c:pt idx="151">
                  <c:v>0</c:v>
                </c:pt>
                <c:pt idx="152">
                  <c:v>0</c:v>
                </c:pt>
                <c:pt idx="153">
                  <c:v>146346.233690052</c:v>
                </c:pt>
                <c:pt idx="154">
                  <c:v>106227.94342716</c:v>
                </c:pt>
                <c:pt idx="155">
                  <c:v>101044.650949189</c:v>
                </c:pt>
                <c:pt idx="156">
                  <c:v>57230.747003962802</c:v>
                </c:pt>
                <c:pt idx="157">
                  <c:v>11737.0810641801</c:v>
                </c:pt>
                <c:pt idx="158">
                  <c:v>75044.477492741295</c:v>
                </c:pt>
                <c:pt idx="159">
                  <c:v>48464.276072690998</c:v>
                </c:pt>
                <c:pt idx="160">
                  <c:v>-97298.270926489597</c:v>
                </c:pt>
                <c:pt idx="161">
                  <c:v>-8824.9266171829204</c:v>
                </c:pt>
                <c:pt idx="162">
                  <c:v>82748.182275115207</c:v>
                </c:pt>
                <c:pt idx="163">
                  <c:v>-29926.152569473001</c:v>
                </c:pt>
                <c:pt idx="164">
                  <c:v>61796.763096883398</c:v>
                </c:pt>
                <c:pt idx="165">
                  <c:v>75222.645047241997</c:v>
                </c:pt>
                <c:pt idx="166">
                  <c:v>37539.426442075797</c:v>
                </c:pt>
                <c:pt idx="167">
                  <c:v>-93270.468868587894</c:v>
                </c:pt>
                <c:pt idx="168">
                  <c:v>17118.921504022401</c:v>
                </c:pt>
                <c:pt idx="169">
                  <c:v>71137.039369577804</c:v>
                </c:pt>
                <c:pt idx="170">
                  <c:v>130859.32968507901</c:v>
                </c:pt>
                <c:pt idx="171">
                  <c:v>-9516.1839309459501</c:v>
                </c:pt>
                <c:pt idx="172">
                  <c:v>-31617.746212776401</c:v>
                </c:pt>
                <c:pt idx="173">
                  <c:v>23130.182459067499</c:v>
                </c:pt>
                <c:pt idx="174">
                  <c:v>81092.897948999598</c:v>
                </c:pt>
                <c:pt idx="175">
                  <c:v>10393.3270602635</c:v>
                </c:pt>
                <c:pt idx="176">
                  <c:v>52515.853554397501</c:v>
                </c:pt>
                <c:pt idx="177">
                  <c:v>68018.102322458202</c:v>
                </c:pt>
                <c:pt idx="178">
                  <c:v>149206.30806872601</c:v>
                </c:pt>
                <c:pt idx="179">
                  <c:v>59119.087065939901</c:v>
                </c:pt>
                <c:pt idx="180">
                  <c:v>-59272.612246606899</c:v>
                </c:pt>
                <c:pt idx="181">
                  <c:v>32787.084597552501</c:v>
                </c:pt>
                <c:pt idx="182">
                  <c:v>-15479.991813511</c:v>
                </c:pt>
                <c:pt idx="183">
                  <c:v>31783.926485598498</c:v>
                </c:pt>
                <c:pt idx="184">
                  <c:v>9492.9732624457993</c:v>
                </c:pt>
                <c:pt idx="185">
                  <c:v>135907.789823725</c:v>
                </c:pt>
                <c:pt idx="186">
                  <c:v>8110.4362198147601</c:v>
                </c:pt>
                <c:pt idx="187">
                  <c:v>18717.936544235301</c:v>
                </c:pt>
                <c:pt idx="188">
                  <c:v>45592.810680224502</c:v>
                </c:pt>
                <c:pt idx="189">
                  <c:v>18276.217362113999</c:v>
                </c:pt>
                <c:pt idx="190">
                  <c:v>-12526.972630866399</c:v>
                </c:pt>
                <c:pt idx="191">
                  <c:v>-2932.6043007436601</c:v>
                </c:pt>
                <c:pt idx="192">
                  <c:v>-11962.929592181799</c:v>
                </c:pt>
                <c:pt idx="193">
                  <c:v>0</c:v>
                </c:pt>
                <c:pt idx="194">
                  <c:v>0</c:v>
                </c:pt>
                <c:pt idx="195">
                  <c:v>-18095.598390008399</c:v>
                </c:pt>
                <c:pt idx="196">
                  <c:v>100069.35557762699</c:v>
                </c:pt>
                <c:pt idx="197">
                  <c:v>67187.704521867796</c:v>
                </c:pt>
                <c:pt idx="198">
                  <c:v>-64447.161103595703</c:v>
                </c:pt>
                <c:pt idx="199">
                  <c:v>-72593.3204701207</c:v>
                </c:pt>
                <c:pt idx="200">
                  <c:v>-115391.51699238201</c:v>
                </c:pt>
                <c:pt idx="201">
                  <c:v>-13695.3242391527</c:v>
                </c:pt>
                <c:pt idx="202">
                  <c:v>24006.424453292198</c:v>
                </c:pt>
                <c:pt idx="203">
                  <c:v>12125.201458875499</c:v>
                </c:pt>
                <c:pt idx="204">
                  <c:v>-28002.237794758399</c:v>
                </c:pt>
                <c:pt idx="205">
                  <c:v>-37331.616775118797</c:v>
                </c:pt>
                <c:pt idx="206">
                  <c:v>-69064.042849318503</c:v>
                </c:pt>
                <c:pt idx="207">
                  <c:v>-21226.667395118198</c:v>
                </c:pt>
                <c:pt idx="208">
                  <c:v>-100165.930377244</c:v>
                </c:pt>
                <c:pt idx="209">
                  <c:v>-62796.088781293802</c:v>
                </c:pt>
                <c:pt idx="210">
                  <c:v>54319.020192805401</c:v>
                </c:pt>
                <c:pt idx="211">
                  <c:v>75828.787220585</c:v>
                </c:pt>
                <c:pt idx="212">
                  <c:v>85194.152031821097</c:v>
                </c:pt>
                <c:pt idx="213">
                  <c:v>-11090.3697153049</c:v>
                </c:pt>
                <c:pt idx="214">
                  <c:v>-4222.5525050332699</c:v>
                </c:pt>
                <c:pt idx="215">
                  <c:v>-137393.73144577999</c:v>
                </c:pt>
                <c:pt idx="216">
                  <c:v>-27005.683046354101</c:v>
                </c:pt>
                <c:pt idx="217">
                  <c:v>-12390.5693565159</c:v>
                </c:pt>
                <c:pt idx="218">
                  <c:v>12305.087171594399</c:v>
                </c:pt>
                <c:pt idx="219">
                  <c:v>67209.133195625793</c:v>
                </c:pt>
                <c:pt idx="220">
                  <c:v>78678.793365062797</c:v>
                </c:pt>
                <c:pt idx="221">
                  <c:v>-31569.280640310499</c:v>
                </c:pt>
                <c:pt idx="222">
                  <c:v>-33330.673907543904</c:v>
                </c:pt>
                <c:pt idx="223">
                  <c:v>-22022.835518810702</c:v>
                </c:pt>
                <c:pt idx="224">
                  <c:v>136246.28302421299</c:v>
                </c:pt>
                <c:pt idx="225">
                  <c:v>34612.723059764103</c:v>
                </c:pt>
                <c:pt idx="226">
                  <c:v>-19233.083250717202</c:v>
                </c:pt>
                <c:pt idx="227">
                  <c:v>66313.057304986505</c:v>
                </c:pt>
                <c:pt idx="228">
                  <c:v>-17850.434354823901</c:v>
                </c:pt>
                <c:pt idx="229">
                  <c:v>54708.121078756201</c:v>
                </c:pt>
                <c:pt idx="230">
                  <c:v>27031.3165355112</c:v>
                </c:pt>
                <c:pt idx="231">
                  <c:v>-113369.847702486</c:v>
                </c:pt>
                <c:pt idx="232">
                  <c:v>-171148.85222007899</c:v>
                </c:pt>
                <c:pt idx="233">
                  <c:v>-167994.46283328801</c:v>
                </c:pt>
                <c:pt idx="234">
                  <c:v>-16734.486339269399</c:v>
                </c:pt>
                <c:pt idx="235">
                  <c:v>-19019.3870978296</c:v>
                </c:pt>
                <c:pt idx="236">
                  <c:v>-12975.792766426301</c:v>
                </c:pt>
                <c:pt idx="237">
                  <c:v>-95817.269630956202</c:v>
                </c:pt>
                <c:pt idx="238">
                  <c:v>8252.5685925554099</c:v>
                </c:pt>
                <c:pt idx="239">
                  <c:v>111227.920944978</c:v>
                </c:pt>
                <c:pt idx="240">
                  <c:v>92316.631321602603</c:v>
                </c:pt>
                <c:pt idx="241">
                  <c:v>33625.235146919302</c:v>
                </c:pt>
                <c:pt idx="242">
                  <c:v>-43666.0144832808</c:v>
                </c:pt>
                <c:pt idx="243">
                  <c:v>-56442.410995282698</c:v>
                </c:pt>
                <c:pt idx="244">
                  <c:v>-34639.467560199701</c:v>
                </c:pt>
                <c:pt idx="245">
                  <c:v>13828.414724145599</c:v>
                </c:pt>
                <c:pt idx="246">
                  <c:v>-17613.192632419199</c:v>
                </c:pt>
                <c:pt idx="247">
                  <c:v>62846.185710095502</c:v>
                </c:pt>
                <c:pt idx="248">
                  <c:v>-658.18456119123596</c:v>
                </c:pt>
                <c:pt idx="249">
                  <c:v>12647.8597894918</c:v>
                </c:pt>
                <c:pt idx="250">
                  <c:v>-7567.0784418171397</c:v>
                </c:pt>
                <c:pt idx="251">
                  <c:v>35833.726373996396</c:v>
                </c:pt>
                <c:pt idx="252">
                  <c:v>-78878.215623956901</c:v>
                </c:pt>
                <c:pt idx="253">
                  <c:v>-96649.241514794296</c:v>
                </c:pt>
                <c:pt idx="254">
                  <c:v>0</c:v>
                </c:pt>
                <c:pt idx="255">
                  <c:v>0</c:v>
                </c:pt>
                <c:pt idx="256">
                  <c:v>-50664.040143292099</c:v>
                </c:pt>
                <c:pt idx="257">
                  <c:v>-172254.76679200301</c:v>
                </c:pt>
                <c:pt idx="258">
                  <c:v>-19125.011393862798</c:v>
                </c:pt>
                <c:pt idx="259">
                  <c:v>146908.71633867099</c:v>
                </c:pt>
                <c:pt idx="260">
                  <c:v>43648.153872667302</c:v>
                </c:pt>
                <c:pt idx="261">
                  <c:v>-65991.230887113503</c:v>
                </c:pt>
                <c:pt idx="262">
                  <c:v>-47644.131470865403</c:v>
                </c:pt>
                <c:pt idx="263">
                  <c:v>21635.845083416199</c:v>
                </c:pt>
                <c:pt idx="264">
                  <c:v>13250.658859086599</c:v>
                </c:pt>
                <c:pt idx="265">
                  <c:v>7103.4802289008003</c:v>
                </c:pt>
                <c:pt idx="266">
                  <c:v>-35930.553245042</c:v>
                </c:pt>
                <c:pt idx="267">
                  <c:v>-45248.829062486097</c:v>
                </c:pt>
                <c:pt idx="268">
                  <c:v>-74955.788099926096</c:v>
                </c:pt>
                <c:pt idx="269">
                  <c:v>-44281.673778445802</c:v>
                </c:pt>
                <c:pt idx="270">
                  <c:v>15319.825018956601</c:v>
                </c:pt>
                <c:pt idx="271">
                  <c:v>-23040.582547101101</c:v>
                </c:pt>
                <c:pt idx="272">
                  <c:v>12745.170774489199</c:v>
                </c:pt>
                <c:pt idx="273">
                  <c:v>-77493.699229534395</c:v>
                </c:pt>
                <c:pt idx="274">
                  <c:v>-57954.342116398002</c:v>
                </c:pt>
                <c:pt idx="275">
                  <c:v>-122246.236569411</c:v>
                </c:pt>
                <c:pt idx="276">
                  <c:v>-63578.133093156699</c:v>
                </c:pt>
                <c:pt idx="277">
                  <c:v>-66755.444658858207</c:v>
                </c:pt>
                <c:pt idx="278">
                  <c:v>-46698.0076933198</c:v>
                </c:pt>
                <c:pt idx="279">
                  <c:v>-7281.8423590433204</c:v>
                </c:pt>
                <c:pt idx="280">
                  <c:v>-88321.569286334605</c:v>
                </c:pt>
                <c:pt idx="281">
                  <c:v>-40720.228232203699</c:v>
                </c:pt>
                <c:pt idx="282">
                  <c:v>29610.224047505199</c:v>
                </c:pt>
                <c:pt idx="283">
                  <c:v>-41542.694889375402</c:v>
                </c:pt>
                <c:pt idx="284">
                  <c:v>-92530.554452292694</c:v>
                </c:pt>
                <c:pt idx="285">
                  <c:v>-72418.928867154493</c:v>
                </c:pt>
                <c:pt idx="286">
                  <c:v>-96961.594774230805</c:v>
                </c:pt>
                <c:pt idx="287">
                  <c:v>43157.544565966004</c:v>
                </c:pt>
                <c:pt idx="288">
                  <c:v>19813.628157225899</c:v>
                </c:pt>
                <c:pt idx="289">
                  <c:v>-102879.108965857</c:v>
                </c:pt>
                <c:pt idx="290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E052-44D0-9E72-FFC11E1451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06643072"/>
        <c:axId val="806645368"/>
      </c:scatterChart>
      <c:valAx>
        <c:axId val="806643072"/>
        <c:scaling>
          <c:orientation val="maxMin"/>
          <c:max val="186"/>
          <c:min val="172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06645368"/>
        <c:crosses val="autoZero"/>
        <c:crossBetween val="midCat"/>
        <c:majorUnit val="2"/>
      </c:valAx>
      <c:valAx>
        <c:axId val="806645368"/>
        <c:scaling>
          <c:orientation val="minMax"/>
          <c:max val="1500000"/>
        </c:scaling>
        <c:delete val="1"/>
        <c:axPos val="r"/>
        <c:numFmt formatCode="General" sourceLinked="1"/>
        <c:majorTickMark val="none"/>
        <c:minorTickMark val="none"/>
        <c:tickLblPos val="nextTo"/>
        <c:crossAx val="80664307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  <a:prstDash val="sysDot"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220045324790399E-2"/>
          <c:y val="6.0185185185185182E-2"/>
          <c:w val="0.82037717170326596"/>
          <c:h val="0.89814814814814814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1!$C$1</c:f>
              <c:strCache>
                <c:ptCount val="1"/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xVal>
            <c:numRef>
              <c:f>Sheet1!$B$2:$B$1893</c:f>
              <c:numCache>
                <c:formatCode>General</c:formatCode>
                <c:ptCount val="1892"/>
                <c:pt idx="0">
                  <c:v>185.38874724170299</c:v>
                </c:pt>
                <c:pt idx="1">
                  <c:v>185.381086990184</c:v>
                </c:pt>
                <c:pt idx="2">
                  <c:v>185.37342673866601</c:v>
                </c:pt>
                <c:pt idx="3">
                  <c:v>185.365766487147</c:v>
                </c:pt>
                <c:pt idx="4">
                  <c:v>185.35810623562799</c:v>
                </c:pt>
                <c:pt idx="5">
                  <c:v>185.350445984109</c:v>
                </c:pt>
                <c:pt idx="6">
                  <c:v>185.34278573258999</c:v>
                </c:pt>
                <c:pt idx="7">
                  <c:v>185.335125481071</c:v>
                </c:pt>
                <c:pt idx="8">
                  <c:v>185.32746522955301</c:v>
                </c:pt>
                <c:pt idx="9">
                  <c:v>185.319804978034</c:v>
                </c:pt>
                <c:pt idx="10">
                  <c:v>185.31214472651499</c:v>
                </c:pt>
                <c:pt idx="11">
                  <c:v>185.304484474996</c:v>
                </c:pt>
                <c:pt idx="12">
                  <c:v>185.29682422347699</c:v>
                </c:pt>
                <c:pt idx="13">
                  <c:v>185.289163971959</c:v>
                </c:pt>
                <c:pt idx="14">
                  <c:v>185.28150372044001</c:v>
                </c:pt>
                <c:pt idx="15">
                  <c:v>185.273843468921</c:v>
                </c:pt>
                <c:pt idx="16">
                  <c:v>185.26618321740199</c:v>
                </c:pt>
                <c:pt idx="17">
                  <c:v>185.258522965883</c:v>
                </c:pt>
                <c:pt idx="18">
                  <c:v>185.25086271436399</c:v>
                </c:pt>
                <c:pt idx="19">
                  <c:v>185.243202462846</c:v>
                </c:pt>
                <c:pt idx="20">
                  <c:v>185.23554221132699</c:v>
                </c:pt>
                <c:pt idx="21">
                  <c:v>185.227881959808</c:v>
                </c:pt>
                <c:pt idx="22">
                  <c:v>185.22022170828899</c:v>
                </c:pt>
                <c:pt idx="23">
                  <c:v>185.21256145677</c:v>
                </c:pt>
                <c:pt idx="24">
                  <c:v>185.20490120525099</c:v>
                </c:pt>
                <c:pt idx="25">
                  <c:v>185.197240953733</c:v>
                </c:pt>
                <c:pt idx="26">
                  <c:v>185.18958070221399</c:v>
                </c:pt>
                <c:pt idx="27">
                  <c:v>184.048203225908</c:v>
                </c:pt>
                <c:pt idx="28">
                  <c:v>184.04054297438901</c:v>
                </c:pt>
                <c:pt idx="29">
                  <c:v>184.03288272287099</c:v>
                </c:pt>
                <c:pt idx="30">
                  <c:v>184.02522247135201</c:v>
                </c:pt>
                <c:pt idx="31">
                  <c:v>184.017562219833</c:v>
                </c:pt>
                <c:pt idx="32">
                  <c:v>184.00990196831401</c:v>
                </c:pt>
                <c:pt idx="33">
                  <c:v>184.002241716795</c:v>
                </c:pt>
                <c:pt idx="34">
                  <c:v>183.99458146527601</c:v>
                </c:pt>
                <c:pt idx="35">
                  <c:v>183.986921213758</c:v>
                </c:pt>
                <c:pt idx="36">
                  <c:v>183.97926096223901</c:v>
                </c:pt>
                <c:pt idx="37">
                  <c:v>183.97160071072</c:v>
                </c:pt>
                <c:pt idx="38">
                  <c:v>183.96394045920101</c:v>
                </c:pt>
                <c:pt idx="39">
                  <c:v>183.956280207682</c:v>
                </c:pt>
                <c:pt idx="40">
                  <c:v>183.94861995616401</c:v>
                </c:pt>
                <c:pt idx="41">
                  <c:v>183.940959704645</c:v>
                </c:pt>
                <c:pt idx="42">
                  <c:v>183.93329945312601</c:v>
                </c:pt>
                <c:pt idx="43">
                  <c:v>183.925639201607</c:v>
                </c:pt>
                <c:pt idx="44">
                  <c:v>183.91797895008801</c:v>
                </c:pt>
                <c:pt idx="45">
                  <c:v>183.910318698569</c:v>
                </c:pt>
                <c:pt idx="46">
                  <c:v>183.90265844705101</c:v>
                </c:pt>
                <c:pt idx="47">
                  <c:v>183.894998195532</c:v>
                </c:pt>
                <c:pt idx="48">
                  <c:v>180.48618626965299</c:v>
                </c:pt>
                <c:pt idx="49">
                  <c:v>180.478526018134</c:v>
                </c:pt>
                <c:pt idx="50">
                  <c:v>180.47086576661499</c:v>
                </c:pt>
                <c:pt idx="51">
                  <c:v>180.46320551509601</c:v>
                </c:pt>
                <c:pt idx="52">
                  <c:v>180.45554526357799</c:v>
                </c:pt>
                <c:pt idx="53">
                  <c:v>180.447885012059</c:v>
                </c:pt>
                <c:pt idx="54">
                  <c:v>180.44022476053999</c:v>
                </c:pt>
                <c:pt idx="55">
                  <c:v>180.43256450902101</c:v>
                </c:pt>
                <c:pt idx="56">
                  <c:v>180.42490425750199</c:v>
                </c:pt>
                <c:pt idx="57">
                  <c:v>180.417244005984</c:v>
                </c:pt>
                <c:pt idx="58">
                  <c:v>180.40958375446499</c:v>
                </c:pt>
                <c:pt idx="59">
                  <c:v>180.401923502946</c:v>
                </c:pt>
                <c:pt idx="60">
                  <c:v>180.39426325142699</c:v>
                </c:pt>
                <c:pt idx="61">
                  <c:v>180.38660299990801</c:v>
                </c:pt>
                <c:pt idx="62">
                  <c:v>180.37894274838899</c:v>
                </c:pt>
                <c:pt idx="63">
                  <c:v>180.371282496871</c:v>
                </c:pt>
                <c:pt idx="64">
                  <c:v>180.36362224535199</c:v>
                </c:pt>
                <c:pt idx="65">
                  <c:v>180.35596199383301</c:v>
                </c:pt>
                <c:pt idx="66">
                  <c:v>180.34830174231399</c:v>
                </c:pt>
                <c:pt idx="67">
                  <c:v>180.34064149079501</c:v>
                </c:pt>
                <c:pt idx="68">
                  <c:v>180.33298123927599</c:v>
                </c:pt>
                <c:pt idx="69">
                  <c:v>180.325320987758</c:v>
                </c:pt>
                <c:pt idx="70">
                  <c:v>180.31766073623899</c:v>
                </c:pt>
                <c:pt idx="71">
                  <c:v>180.31000048472001</c:v>
                </c:pt>
                <c:pt idx="72">
                  <c:v>180.30234023320099</c:v>
                </c:pt>
                <c:pt idx="73">
                  <c:v>180.29467998168201</c:v>
                </c:pt>
                <c:pt idx="74">
                  <c:v>180.287019730163</c:v>
                </c:pt>
                <c:pt idx="75">
                  <c:v>180.27935947864501</c:v>
                </c:pt>
                <c:pt idx="76">
                  <c:v>180.27169922712599</c:v>
                </c:pt>
                <c:pt idx="77">
                  <c:v>180.26403897560701</c:v>
                </c:pt>
                <c:pt idx="78">
                  <c:v>180.25637872408799</c:v>
                </c:pt>
                <c:pt idx="79">
                  <c:v>180.24871847256901</c:v>
                </c:pt>
                <c:pt idx="80">
                  <c:v>180.24105822105</c:v>
                </c:pt>
                <c:pt idx="81">
                  <c:v>180.23339796953201</c:v>
                </c:pt>
                <c:pt idx="82">
                  <c:v>180.22573771801299</c:v>
                </c:pt>
                <c:pt idx="83">
                  <c:v>180.21807746649401</c:v>
                </c:pt>
                <c:pt idx="84">
                  <c:v>180.210417214975</c:v>
                </c:pt>
                <c:pt idx="85">
                  <c:v>180.20275696345601</c:v>
                </c:pt>
                <c:pt idx="86">
                  <c:v>180.195096711937</c:v>
                </c:pt>
                <c:pt idx="87">
                  <c:v>180.18743646041901</c:v>
                </c:pt>
                <c:pt idx="88">
                  <c:v>180.17977620889999</c:v>
                </c:pt>
                <c:pt idx="89">
                  <c:v>178.724328420322</c:v>
                </c:pt>
                <c:pt idx="90">
                  <c:v>178.71666816880401</c:v>
                </c:pt>
                <c:pt idx="91">
                  <c:v>178.70900791728499</c:v>
                </c:pt>
                <c:pt idx="92">
                  <c:v>178.70134766576601</c:v>
                </c:pt>
                <c:pt idx="93">
                  <c:v>178.69368741424699</c:v>
                </c:pt>
                <c:pt idx="94">
                  <c:v>178.68602716272801</c:v>
                </c:pt>
                <c:pt idx="95">
                  <c:v>178.678366911209</c:v>
                </c:pt>
                <c:pt idx="96">
                  <c:v>178.67070665969101</c:v>
                </c:pt>
                <c:pt idx="97">
                  <c:v>178.66304640817199</c:v>
                </c:pt>
                <c:pt idx="98">
                  <c:v>178.65538615665301</c:v>
                </c:pt>
                <c:pt idx="99">
                  <c:v>178.647725905134</c:v>
                </c:pt>
                <c:pt idx="100">
                  <c:v>178.64006565361501</c:v>
                </c:pt>
                <c:pt idx="101">
                  <c:v>178.632405402096</c:v>
                </c:pt>
                <c:pt idx="102">
                  <c:v>178.62474515057801</c:v>
                </c:pt>
                <c:pt idx="103">
                  <c:v>178.61708489905899</c:v>
                </c:pt>
                <c:pt idx="104">
                  <c:v>178.60942464754001</c:v>
                </c:pt>
                <c:pt idx="105">
                  <c:v>178.601764396021</c:v>
                </c:pt>
                <c:pt idx="106">
                  <c:v>178.59410414450201</c:v>
                </c:pt>
                <c:pt idx="107">
                  <c:v>178.586443892983</c:v>
                </c:pt>
                <c:pt idx="108">
                  <c:v>178.57878364146501</c:v>
                </c:pt>
                <c:pt idx="109">
                  <c:v>178.571123389946</c:v>
                </c:pt>
                <c:pt idx="110">
                  <c:v>178.56346313842701</c:v>
                </c:pt>
                <c:pt idx="111">
                  <c:v>178.555802886908</c:v>
                </c:pt>
                <c:pt idx="112">
                  <c:v>178.54814263538901</c:v>
                </c:pt>
                <c:pt idx="113">
                  <c:v>178.54048238387</c:v>
                </c:pt>
                <c:pt idx="114">
                  <c:v>178.53282213235201</c:v>
                </c:pt>
                <c:pt idx="115">
                  <c:v>177.38378440452701</c:v>
                </c:pt>
                <c:pt idx="116">
                  <c:v>177.37612415300899</c:v>
                </c:pt>
                <c:pt idx="117">
                  <c:v>177.36846390149</c:v>
                </c:pt>
                <c:pt idx="118">
                  <c:v>177.36080364997099</c:v>
                </c:pt>
                <c:pt idx="119">
                  <c:v>177.353143398452</c:v>
                </c:pt>
                <c:pt idx="120">
                  <c:v>177.34548314693299</c:v>
                </c:pt>
                <c:pt idx="121">
                  <c:v>177.33782289541401</c:v>
                </c:pt>
                <c:pt idx="122">
                  <c:v>177.33016264389599</c:v>
                </c:pt>
                <c:pt idx="123">
                  <c:v>177.322502392377</c:v>
                </c:pt>
                <c:pt idx="124">
                  <c:v>177.31484214085799</c:v>
                </c:pt>
                <c:pt idx="125">
                  <c:v>177.30718188933901</c:v>
                </c:pt>
                <c:pt idx="126">
                  <c:v>177.29952163781999</c:v>
                </c:pt>
                <c:pt idx="127">
                  <c:v>177.29186138630101</c:v>
                </c:pt>
                <c:pt idx="128">
                  <c:v>177.28420113478299</c:v>
                </c:pt>
                <c:pt idx="129">
                  <c:v>177.276540883264</c:v>
                </c:pt>
                <c:pt idx="130">
                  <c:v>177.26888063174499</c:v>
                </c:pt>
                <c:pt idx="131">
                  <c:v>176.92416931339801</c:v>
                </c:pt>
                <c:pt idx="132">
                  <c:v>176.916509061879</c:v>
                </c:pt>
                <c:pt idx="133">
                  <c:v>176.90884881036001</c:v>
                </c:pt>
                <c:pt idx="134">
                  <c:v>176.901188558841</c:v>
                </c:pt>
                <c:pt idx="135">
                  <c:v>176.89352830732199</c:v>
                </c:pt>
                <c:pt idx="136">
                  <c:v>176.885868055803</c:v>
                </c:pt>
                <c:pt idx="137">
                  <c:v>176.87820780428501</c:v>
                </c:pt>
                <c:pt idx="138">
                  <c:v>176.870547552766</c:v>
                </c:pt>
                <c:pt idx="139">
                  <c:v>176.86288730124701</c:v>
                </c:pt>
                <c:pt idx="140">
                  <c:v>176.855227049728</c:v>
                </c:pt>
                <c:pt idx="141">
                  <c:v>176.84756679820899</c:v>
                </c:pt>
                <c:pt idx="142">
                  <c:v>176.839906546691</c:v>
                </c:pt>
                <c:pt idx="143">
                  <c:v>176.83224629517201</c:v>
                </c:pt>
                <c:pt idx="144">
                  <c:v>176.824586043653</c:v>
                </c:pt>
                <c:pt idx="145">
                  <c:v>176.81692579213399</c:v>
                </c:pt>
                <c:pt idx="146">
                  <c:v>176.809265540615</c:v>
                </c:pt>
                <c:pt idx="147">
                  <c:v>176.80160528909599</c:v>
                </c:pt>
                <c:pt idx="148">
                  <c:v>176.793945037578</c:v>
                </c:pt>
                <c:pt idx="149">
                  <c:v>176.78628478605901</c:v>
                </c:pt>
                <c:pt idx="150">
                  <c:v>176.77862453454</c:v>
                </c:pt>
                <c:pt idx="151">
                  <c:v>176.77096428302099</c:v>
                </c:pt>
                <c:pt idx="152">
                  <c:v>175.430420267226</c:v>
                </c:pt>
                <c:pt idx="153">
                  <c:v>175.42276001570701</c:v>
                </c:pt>
                <c:pt idx="154">
                  <c:v>175.415099764188</c:v>
                </c:pt>
                <c:pt idx="155">
                  <c:v>175.40743951267001</c:v>
                </c:pt>
                <c:pt idx="156">
                  <c:v>175.399779261151</c:v>
                </c:pt>
                <c:pt idx="157">
                  <c:v>175.39211900963201</c:v>
                </c:pt>
                <c:pt idx="158">
                  <c:v>175.384458758113</c:v>
                </c:pt>
                <c:pt idx="159">
                  <c:v>175.37679850659401</c:v>
                </c:pt>
                <c:pt idx="160">
                  <c:v>175.369138255075</c:v>
                </c:pt>
                <c:pt idx="161">
                  <c:v>175.36147800355701</c:v>
                </c:pt>
                <c:pt idx="162">
                  <c:v>175.353817752038</c:v>
                </c:pt>
                <c:pt idx="163">
                  <c:v>175.34615750051901</c:v>
                </c:pt>
                <c:pt idx="164">
                  <c:v>175.338497249</c:v>
                </c:pt>
                <c:pt idx="165">
                  <c:v>175.33083699748099</c:v>
                </c:pt>
                <c:pt idx="166">
                  <c:v>175.323176745962</c:v>
                </c:pt>
                <c:pt idx="167">
                  <c:v>175.31551649444401</c:v>
                </c:pt>
                <c:pt idx="168">
                  <c:v>175.307856242925</c:v>
                </c:pt>
                <c:pt idx="169">
                  <c:v>175.30019599140601</c:v>
                </c:pt>
                <c:pt idx="170">
                  <c:v>175.292535739887</c:v>
                </c:pt>
                <c:pt idx="171">
                  <c:v>175.28487548836799</c:v>
                </c:pt>
                <c:pt idx="172">
                  <c:v>175.277215236849</c:v>
                </c:pt>
                <c:pt idx="173">
                  <c:v>175.26955498533101</c:v>
                </c:pt>
                <c:pt idx="174">
                  <c:v>175.261894733812</c:v>
                </c:pt>
                <c:pt idx="175">
                  <c:v>175.25423448229299</c:v>
                </c:pt>
                <c:pt idx="176">
                  <c:v>175.246574230774</c:v>
                </c:pt>
                <c:pt idx="177">
                  <c:v>175.23891397925499</c:v>
                </c:pt>
                <c:pt idx="178">
                  <c:v>175.231253727737</c:v>
                </c:pt>
                <c:pt idx="179">
                  <c:v>175.22359347621801</c:v>
                </c:pt>
                <c:pt idx="180">
                  <c:v>175.215933224699</c:v>
                </c:pt>
                <c:pt idx="181">
                  <c:v>175.20827297317999</c:v>
                </c:pt>
                <c:pt idx="182">
                  <c:v>175.200612721661</c:v>
                </c:pt>
                <c:pt idx="183">
                  <c:v>175.19295247014199</c:v>
                </c:pt>
                <c:pt idx="184">
                  <c:v>175.185292218624</c:v>
                </c:pt>
                <c:pt idx="185">
                  <c:v>175.17763196710499</c:v>
                </c:pt>
                <c:pt idx="186">
                  <c:v>175.169971715586</c:v>
                </c:pt>
                <c:pt idx="187">
                  <c:v>175.16231146406699</c:v>
                </c:pt>
                <c:pt idx="188">
                  <c:v>175.154651212548</c:v>
                </c:pt>
                <c:pt idx="189">
                  <c:v>175.14699096102899</c:v>
                </c:pt>
                <c:pt idx="190">
                  <c:v>175.139330709511</c:v>
                </c:pt>
                <c:pt idx="191">
                  <c:v>175.13167045799199</c:v>
                </c:pt>
                <c:pt idx="192">
                  <c:v>175.124010206473</c:v>
                </c:pt>
                <c:pt idx="193">
                  <c:v>175.11634995495399</c:v>
                </c:pt>
                <c:pt idx="194">
                  <c:v>174.58779260015501</c:v>
                </c:pt>
                <c:pt idx="195">
                  <c:v>174.580132348636</c:v>
                </c:pt>
                <c:pt idx="196">
                  <c:v>174.57247209711699</c:v>
                </c:pt>
                <c:pt idx="197">
                  <c:v>174.564811845598</c:v>
                </c:pt>
                <c:pt idx="198">
                  <c:v>174.55715159408001</c:v>
                </c:pt>
                <c:pt idx="199">
                  <c:v>174.549491342561</c:v>
                </c:pt>
                <c:pt idx="200">
                  <c:v>174.54183109104201</c:v>
                </c:pt>
                <c:pt idx="201">
                  <c:v>174.534170839523</c:v>
                </c:pt>
                <c:pt idx="202">
                  <c:v>174.52651058800399</c:v>
                </c:pt>
                <c:pt idx="203">
                  <c:v>174.518850336485</c:v>
                </c:pt>
                <c:pt idx="204">
                  <c:v>174.51119008496701</c:v>
                </c:pt>
                <c:pt idx="205">
                  <c:v>174.503529833448</c:v>
                </c:pt>
                <c:pt idx="206">
                  <c:v>174.49586958192901</c:v>
                </c:pt>
                <c:pt idx="207">
                  <c:v>174.48820933041</c:v>
                </c:pt>
                <c:pt idx="208">
                  <c:v>174.48054907889099</c:v>
                </c:pt>
                <c:pt idx="209">
                  <c:v>174.472888827372</c:v>
                </c:pt>
                <c:pt idx="210">
                  <c:v>174.46522857585401</c:v>
                </c:pt>
                <c:pt idx="211">
                  <c:v>174.457568324335</c:v>
                </c:pt>
                <c:pt idx="212">
                  <c:v>174.44990807281599</c:v>
                </c:pt>
                <c:pt idx="213">
                  <c:v>174.442247821297</c:v>
                </c:pt>
                <c:pt idx="214">
                  <c:v>174.43458756977799</c:v>
                </c:pt>
                <c:pt idx="215">
                  <c:v>174.42692731826</c:v>
                </c:pt>
                <c:pt idx="216">
                  <c:v>174.41926706674101</c:v>
                </c:pt>
                <c:pt idx="217">
                  <c:v>174.411606815222</c:v>
                </c:pt>
                <c:pt idx="218">
                  <c:v>174.40394656370299</c:v>
                </c:pt>
                <c:pt idx="219">
                  <c:v>174.396286312184</c:v>
                </c:pt>
                <c:pt idx="220">
                  <c:v>174.38862606066499</c:v>
                </c:pt>
                <c:pt idx="221">
                  <c:v>174.380965809147</c:v>
                </c:pt>
                <c:pt idx="222">
                  <c:v>174.37330555762799</c:v>
                </c:pt>
                <c:pt idx="223">
                  <c:v>174.365645306109</c:v>
                </c:pt>
                <c:pt idx="224">
                  <c:v>174.35798505458999</c:v>
                </c:pt>
                <c:pt idx="225">
                  <c:v>174.350324803071</c:v>
                </c:pt>
                <c:pt idx="226">
                  <c:v>174.34266455155199</c:v>
                </c:pt>
                <c:pt idx="227">
                  <c:v>174.335004300034</c:v>
                </c:pt>
                <c:pt idx="228">
                  <c:v>174.32734404851499</c:v>
                </c:pt>
                <c:pt idx="229">
                  <c:v>174.319683796996</c:v>
                </c:pt>
                <c:pt idx="230">
                  <c:v>174.31202354547699</c:v>
                </c:pt>
                <c:pt idx="231">
                  <c:v>174.304363293958</c:v>
                </c:pt>
                <c:pt idx="232">
                  <c:v>174.29670304243899</c:v>
                </c:pt>
                <c:pt idx="233">
                  <c:v>174.289042790921</c:v>
                </c:pt>
                <c:pt idx="234">
                  <c:v>174.28138253940199</c:v>
                </c:pt>
                <c:pt idx="235">
                  <c:v>174.273722287883</c:v>
                </c:pt>
                <c:pt idx="236">
                  <c:v>174.26606203636399</c:v>
                </c:pt>
                <c:pt idx="237">
                  <c:v>174.25840178484501</c:v>
                </c:pt>
                <c:pt idx="238">
                  <c:v>174.25074153332599</c:v>
                </c:pt>
                <c:pt idx="239">
                  <c:v>174.243081281808</c:v>
                </c:pt>
                <c:pt idx="240">
                  <c:v>174.23542103028899</c:v>
                </c:pt>
                <c:pt idx="241">
                  <c:v>174.22776077877</c:v>
                </c:pt>
                <c:pt idx="242">
                  <c:v>174.22010052725099</c:v>
                </c:pt>
                <c:pt idx="243">
                  <c:v>174.21244027573201</c:v>
                </c:pt>
                <c:pt idx="244">
                  <c:v>174.20478002421299</c:v>
                </c:pt>
                <c:pt idx="245">
                  <c:v>174.197119772695</c:v>
                </c:pt>
                <c:pt idx="246">
                  <c:v>174.18945952117599</c:v>
                </c:pt>
                <c:pt idx="247">
                  <c:v>174.18179926965701</c:v>
                </c:pt>
                <c:pt idx="248">
                  <c:v>174.17413901813799</c:v>
                </c:pt>
                <c:pt idx="249">
                  <c:v>174.16647876661901</c:v>
                </c:pt>
                <c:pt idx="250">
                  <c:v>174.15881851509999</c:v>
                </c:pt>
                <c:pt idx="251">
                  <c:v>174.151158263582</c:v>
                </c:pt>
                <c:pt idx="252">
                  <c:v>174.14349801206299</c:v>
                </c:pt>
                <c:pt idx="253">
                  <c:v>174.13583776054401</c:v>
                </c:pt>
                <c:pt idx="254">
                  <c:v>174.12817750902499</c:v>
                </c:pt>
                <c:pt idx="255">
                  <c:v>173.821767448272</c:v>
                </c:pt>
                <c:pt idx="256">
                  <c:v>173.81410719675301</c:v>
                </c:pt>
                <c:pt idx="257">
                  <c:v>173.806446945234</c:v>
                </c:pt>
                <c:pt idx="258">
                  <c:v>173.79878669371601</c:v>
                </c:pt>
                <c:pt idx="259">
                  <c:v>173.791126442197</c:v>
                </c:pt>
                <c:pt idx="260">
                  <c:v>173.78346619067801</c:v>
                </c:pt>
                <c:pt idx="261">
                  <c:v>173.775805939159</c:v>
                </c:pt>
                <c:pt idx="262">
                  <c:v>173.76814568763999</c:v>
                </c:pt>
                <c:pt idx="263">
                  <c:v>173.760485436121</c:v>
                </c:pt>
                <c:pt idx="264">
                  <c:v>173.75282518460301</c:v>
                </c:pt>
                <c:pt idx="265">
                  <c:v>173.745164933084</c:v>
                </c:pt>
                <c:pt idx="266">
                  <c:v>173.73750468156501</c:v>
                </c:pt>
                <c:pt idx="267">
                  <c:v>173.729844430046</c:v>
                </c:pt>
                <c:pt idx="268">
                  <c:v>173.72218417852699</c:v>
                </c:pt>
                <c:pt idx="269">
                  <c:v>173.714523927008</c:v>
                </c:pt>
                <c:pt idx="270">
                  <c:v>173.70686367549001</c:v>
                </c:pt>
                <c:pt idx="271">
                  <c:v>173.699203423971</c:v>
                </c:pt>
                <c:pt idx="272">
                  <c:v>173.69154317245199</c:v>
                </c:pt>
                <c:pt idx="273">
                  <c:v>173.683882920933</c:v>
                </c:pt>
                <c:pt idx="274">
                  <c:v>173.67622266941399</c:v>
                </c:pt>
                <c:pt idx="275">
                  <c:v>173.668562417895</c:v>
                </c:pt>
                <c:pt idx="276">
                  <c:v>173.66090216637701</c:v>
                </c:pt>
                <c:pt idx="277">
                  <c:v>173.653241914858</c:v>
                </c:pt>
                <c:pt idx="278">
                  <c:v>173.64558166333899</c:v>
                </c:pt>
                <c:pt idx="279">
                  <c:v>173.63792141182</c:v>
                </c:pt>
                <c:pt idx="280">
                  <c:v>173.63026116030099</c:v>
                </c:pt>
                <c:pt idx="281">
                  <c:v>173.622600908783</c:v>
                </c:pt>
                <c:pt idx="282">
                  <c:v>173.61494065726399</c:v>
                </c:pt>
                <c:pt idx="283">
                  <c:v>173.607280405745</c:v>
                </c:pt>
                <c:pt idx="284">
                  <c:v>173.59962015422599</c:v>
                </c:pt>
                <c:pt idx="285">
                  <c:v>173.591959902707</c:v>
                </c:pt>
                <c:pt idx="286">
                  <c:v>173.58429965118799</c:v>
                </c:pt>
                <c:pt idx="287">
                  <c:v>173.57663939967</c:v>
                </c:pt>
                <c:pt idx="288">
                  <c:v>173.56897914815099</c:v>
                </c:pt>
                <c:pt idx="289">
                  <c:v>173.561318896632</c:v>
                </c:pt>
                <c:pt idx="290">
                  <c:v>173.55365864511299</c:v>
                </c:pt>
                <c:pt idx="291">
                  <c:v>163.1740178371</c:v>
                </c:pt>
                <c:pt idx="292">
                  <c:v>163.16635758558101</c:v>
                </c:pt>
                <c:pt idx="293">
                  <c:v>163.15869733406299</c:v>
                </c:pt>
                <c:pt idx="294">
                  <c:v>163.15103708254401</c:v>
                </c:pt>
                <c:pt idx="295">
                  <c:v>163.14337683102499</c:v>
                </c:pt>
                <c:pt idx="296">
                  <c:v>163.13571657950601</c:v>
                </c:pt>
                <c:pt idx="297">
                  <c:v>163.128056327987</c:v>
                </c:pt>
                <c:pt idx="298">
                  <c:v>163.12039607646801</c:v>
                </c:pt>
                <c:pt idx="299">
                  <c:v>163.11273582494999</c:v>
                </c:pt>
                <c:pt idx="300">
                  <c:v>163.10507557343101</c:v>
                </c:pt>
                <c:pt idx="301">
                  <c:v>163.097415321912</c:v>
                </c:pt>
                <c:pt idx="302">
                  <c:v>163.08975507039301</c:v>
                </c:pt>
                <c:pt idx="303">
                  <c:v>163.082094818874</c:v>
                </c:pt>
                <c:pt idx="304">
                  <c:v>163.07443456735501</c:v>
                </c:pt>
                <c:pt idx="305">
                  <c:v>163.06677431583699</c:v>
                </c:pt>
                <c:pt idx="306">
                  <c:v>163.05911406431801</c:v>
                </c:pt>
                <c:pt idx="307">
                  <c:v>163.051453812799</c:v>
                </c:pt>
                <c:pt idx="308">
                  <c:v>163.04379356128001</c:v>
                </c:pt>
                <c:pt idx="309">
                  <c:v>132.341505473815</c:v>
                </c:pt>
                <c:pt idx="310">
                  <c:v>132.33384522229599</c:v>
                </c:pt>
                <c:pt idx="311">
                  <c:v>132.32618497077701</c:v>
                </c:pt>
                <c:pt idx="312">
                  <c:v>132.31852471925799</c:v>
                </c:pt>
                <c:pt idx="313">
                  <c:v>132.31086446774</c:v>
                </c:pt>
                <c:pt idx="314">
                  <c:v>132.30320421622099</c:v>
                </c:pt>
                <c:pt idx="315">
                  <c:v>132.29554396470201</c:v>
                </c:pt>
                <c:pt idx="316">
                  <c:v>132.28788371318299</c:v>
                </c:pt>
                <c:pt idx="317">
                  <c:v>132.28022346166401</c:v>
                </c:pt>
                <c:pt idx="318">
                  <c:v>132.27256321014499</c:v>
                </c:pt>
                <c:pt idx="319">
                  <c:v>132.264902958627</c:v>
                </c:pt>
                <c:pt idx="320">
                  <c:v>132.25724270710799</c:v>
                </c:pt>
                <c:pt idx="321">
                  <c:v>132.24958245558901</c:v>
                </c:pt>
                <c:pt idx="322">
                  <c:v>132.24192220406999</c:v>
                </c:pt>
                <c:pt idx="323">
                  <c:v>132.23426195255101</c:v>
                </c:pt>
                <c:pt idx="324">
                  <c:v>132.22660170103299</c:v>
                </c:pt>
                <c:pt idx="325">
                  <c:v>132.21894144951401</c:v>
                </c:pt>
                <c:pt idx="326">
                  <c:v>132.21128119799499</c:v>
                </c:pt>
                <c:pt idx="327">
                  <c:v>132.20362094647601</c:v>
                </c:pt>
                <c:pt idx="328">
                  <c:v>132.19596069495699</c:v>
                </c:pt>
                <c:pt idx="329">
                  <c:v>132.18830044343801</c:v>
                </c:pt>
                <c:pt idx="330">
                  <c:v>132.18064019191999</c:v>
                </c:pt>
                <c:pt idx="331">
                  <c:v>132.17297994040101</c:v>
                </c:pt>
                <c:pt idx="332">
                  <c:v>132.16531968888199</c:v>
                </c:pt>
                <c:pt idx="333">
                  <c:v>132.15765943736301</c:v>
                </c:pt>
                <c:pt idx="334">
                  <c:v>132.149999185844</c:v>
                </c:pt>
                <c:pt idx="335">
                  <c:v>132.14233893432501</c:v>
                </c:pt>
                <c:pt idx="336">
                  <c:v>132.13467868280699</c:v>
                </c:pt>
                <c:pt idx="337">
                  <c:v>132.12701843128801</c:v>
                </c:pt>
                <c:pt idx="338">
                  <c:v>132.11935817976899</c:v>
                </c:pt>
                <c:pt idx="339">
                  <c:v>132.11169792825001</c:v>
                </c:pt>
                <c:pt idx="340">
                  <c:v>132.104037676731</c:v>
                </c:pt>
                <c:pt idx="341">
                  <c:v>132.09637742521201</c:v>
                </c:pt>
                <c:pt idx="342">
                  <c:v>132.08871717369399</c:v>
                </c:pt>
                <c:pt idx="343">
                  <c:v>132.08105692217501</c:v>
                </c:pt>
                <c:pt idx="344">
                  <c:v>132.073396670656</c:v>
                </c:pt>
                <c:pt idx="345">
                  <c:v>132.06573641913701</c:v>
                </c:pt>
                <c:pt idx="346">
                  <c:v>132.058076167618</c:v>
                </c:pt>
                <c:pt idx="347">
                  <c:v>132.05041591609901</c:v>
                </c:pt>
                <c:pt idx="348">
                  <c:v>132.04275566458099</c:v>
                </c:pt>
                <c:pt idx="349">
                  <c:v>132.03509541306201</c:v>
                </c:pt>
                <c:pt idx="350">
                  <c:v>130.69455139726699</c:v>
                </c:pt>
                <c:pt idx="351">
                  <c:v>130.68689114574801</c:v>
                </c:pt>
                <c:pt idx="352">
                  <c:v>130.67923089422899</c:v>
                </c:pt>
                <c:pt idx="353">
                  <c:v>130.67157064271001</c:v>
                </c:pt>
                <c:pt idx="354">
                  <c:v>130.663910391191</c:v>
                </c:pt>
                <c:pt idx="355">
                  <c:v>130.65625013967301</c:v>
                </c:pt>
                <c:pt idx="356">
                  <c:v>130.64858988815399</c:v>
                </c:pt>
                <c:pt idx="357">
                  <c:v>130.64092963663501</c:v>
                </c:pt>
                <c:pt idx="358">
                  <c:v>130.63326938511599</c:v>
                </c:pt>
                <c:pt idx="359">
                  <c:v>130.62560913359701</c:v>
                </c:pt>
                <c:pt idx="360">
                  <c:v>130.61794888207899</c:v>
                </c:pt>
                <c:pt idx="361">
                  <c:v>130.61028863056001</c:v>
                </c:pt>
                <c:pt idx="362">
                  <c:v>130.60262837904099</c:v>
                </c:pt>
                <c:pt idx="363">
                  <c:v>130.59496812752201</c:v>
                </c:pt>
                <c:pt idx="364">
                  <c:v>130.587307876003</c:v>
                </c:pt>
                <c:pt idx="365">
                  <c:v>130.57964762448401</c:v>
                </c:pt>
                <c:pt idx="366">
                  <c:v>130.57198737296599</c:v>
                </c:pt>
                <c:pt idx="367">
                  <c:v>130.56432712144701</c:v>
                </c:pt>
                <c:pt idx="368">
                  <c:v>130.55666686992799</c:v>
                </c:pt>
                <c:pt idx="369">
                  <c:v>130.54900661840901</c:v>
                </c:pt>
                <c:pt idx="370">
                  <c:v>130.54134636689</c:v>
                </c:pt>
                <c:pt idx="371">
                  <c:v>130.53368611537101</c:v>
                </c:pt>
                <c:pt idx="372">
                  <c:v>130.52602586385299</c:v>
                </c:pt>
                <c:pt idx="373">
                  <c:v>130.51836561233401</c:v>
                </c:pt>
                <c:pt idx="374">
                  <c:v>130.510705360815</c:v>
                </c:pt>
                <c:pt idx="375">
                  <c:v>130.50304510929601</c:v>
                </c:pt>
                <c:pt idx="376">
                  <c:v>130.495384857777</c:v>
                </c:pt>
                <c:pt idx="377">
                  <c:v>130.48772460625801</c:v>
                </c:pt>
                <c:pt idx="378">
                  <c:v>130.48006435473999</c:v>
                </c:pt>
                <c:pt idx="379">
                  <c:v>130.47240410322101</c:v>
                </c:pt>
                <c:pt idx="380">
                  <c:v>130.464743851702</c:v>
                </c:pt>
                <c:pt idx="381">
                  <c:v>130.45708360018301</c:v>
                </c:pt>
                <c:pt idx="382">
                  <c:v>130.449423348664</c:v>
                </c:pt>
                <c:pt idx="383">
                  <c:v>130.44176309714501</c:v>
                </c:pt>
                <c:pt idx="384">
                  <c:v>130.434102845627</c:v>
                </c:pt>
                <c:pt idx="385">
                  <c:v>130.42644259410801</c:v>
                </c:pt>
                <c:pt idx="386">
                  <c:v>130.418782342589</c:v>
                </c:pt>
                <c:pt idx="387">
                  <c:v>130.41112209107001</c:v>
                </c:pt>
                <c:pt idx="388">
                  <c:v>130.403461839551</c:v>
                </c:pt>
                <c:pt idx="389">
                  <c:v>130.39580158803199</c:v>
                </c:pt>
                <c:pt idx="390">
                  <c:v>130.388141336514</c:v>
                </c:pt>
                <c:pt idx="391">
                  <c:v>75.310932916135698</c:v>
                </c:pt>
                <c:pt idx="392">
                  <c:v>75.303272664616898</c:v>
                </c:pt>
                <c:pt idx="393">
                  <c:v>75.295612413098098</c:v>
                </c:pt>
                <c:pt idx="394">
                  <c:v>75.287952161579199</c:v>
                </c:pt>
                <c:pt idx="395">
                  <c:v>75.280291910060399</c:v>
                </c:pt>
                <c:pt idx="396">
                  <c:v>75.272631658541599</c:v>
                </c:pt>
                <c:pt idx="397">
                  <c:v>75.264971407022699</c:v>
                </c:pt>
                <c:pt idx="398">
                  <c:v>75.257311155503899</c:v>
                </c:pt>
                <c:pt idx="399">
                  <c:v>75.249650903985099</c:v>
                </c:pt>
                <c:pt idx="400">
                  <c:v>75.241990652466299</c:v>
                </c:pt>
                <c:pt idx="401">
                  <c:v>75.2343304009474</c:v>
                </c:pt>
                <c:pt idx="402">
                  <c:v>75.2266701494286</c:v>
                </c:pt>
                <c:pt idx="403">
                  <c:v>75.2190098979098</c:v>
                </c:pt>
                <c:pt idx="404">
                  <c:v>75.2113496463909</c:v>
                </c:pt>
                <c:pt idx="405">
                  <c:v>75.2036893948721</c:v>
                </c:pt>
                <c:pt idx="406">
                  <c:v>75.1960291433533</c:v>
                </c:pt>
                <c:pt idx="407">
                  <c:v>75.1883688918345</c:v>
                </c:pt>
                <c:pt idx="408">
                  <c:v>75.180708640315601</c:v>
                </c:pt>
                <c:pt idx="409">
                  <c:v>75.173048388796801</c:v>
                </c:pt>
                <c:pt idx="410">
                  <c:v>75.165388137278001</c:v>
                </c:pt>
                <c:pt idx="411">
                  <c:v>75.157727885759101</c:v>
                </c:pt>
                <c:pt idx="412">
                  <c:v>75.150067634240301</c:v>
                </c:pt>
                <c:pt idx="413">
                  <c:v>75.142407382721501</c:v>
                </c:pt>
                <c:pt idx="414">
                  <c:v>75.134747131202701</c:v>
                </c:pt>
                <c:pt idx="415">
                  <c:v>75.127086879683802</c:v>
                </c:pt>
                <c:pt idx="416">
                  <c:v>75.119426628165002</c:v>
                </c:pt>
                <c:pt idx="417">
                  <c:v>75.111766376646202</c:v>
                </c:pt>
                <c:pt idx="418">
                  <c:v>75.104106125127302</c:v>
                </c:pt>
                <c:pt idx="419">
                  <c:v>75.096445873608502</c:v>
                </c:pt>
                <c:pt idx="420">
                  <c:v>75.088785622089702</c:v>
                </c:pt>
                <c:pt idx="421">
                  <c:v>75.081125370570902</c:v>
                </c:pt>
                <c:pt idx="422">
                  <c:v>75.073465119052003</c:v>
                </c:pt>
                <c:pt idx="423">
                  <c:v>75.065804867533203</c:v>
                </c:pt>
                <c:pt idx="424">
                  <c:v>75.058144616014403</c:v>
                </c:pt>
                <c:pt idx="425">
                  <c:v>75.050484364495603</c:v>
                </c:pt>
                <c:pt idx="426">
                  <c:v>75.042824112976703</c:v>
                </c:pt>
                <c:pt idx="427">
                  <c:v>75.035163861457903</c:v>
                </c:pt>
                <c:pt idx="428">
                  <c:v>75.027503609939103</c:v>
                </c:pt>
                <c:pt idx="429">
                  <c:v>75.019843358420204</c:v>
                </c:pt>
                <c:pt idx="430">
                  <c:v>75.012183106901404</c:v>
                </c:pt>
                <c:pt idx="431">
                  <c:v>75.004522855382604</c:v>
                </c:pt>
                <c:pt idx="432">
                  <c:v>73.932087642746595</c:v>
                </c:pt>
                <c:pt idx="433">
                  <c:v>73.924427391227695</c:v>
                </c:pt>
                <c:pt idx="434">
                  <c:v>73.916767139708895</c:v>
                </c:pt>
                <c:pt idx="435">
                  <c:v>73.909106888190095</c:v>
                </c:pt>
                <c:pt idx="436">
                  <c:v>73.901446636671295</c:v>
                </c:pt>
                <c:pt idx="437">
                  <c:v>73.893786385152396</c:v>
                </c:pt>
                <c:pt idx="438">
                  <c:v>73.886126133633596</c:v>
                </c:pt>
                <c:pt idx="439">
                  <c:v>73.878465882114796</c:v>
                </c:pt>
                <c:pt idx="440">
                  <c:v>73.870805630595896</c:v>
                </c:pt>
                <c:pt idx="441">
                  <c:v>73.863145379077096</c:v>
                </c:pt>
                <c:pt idx="442">
                  <c:v>73.855485127558296</c:v>
                </c:pt>
                <c:pt idx="443">
                  <c:v>73.847824876039496</c:v>
                </c:pt>
                <c:pt idx="444">
                  <c:v>73.840164624520597</c:v>
                </c:pt>
                <c:pt idx="445">
                  <c:v>73.832504373001797</c:v>
                </c:pt>
                <c:pt idx="446">
                  <c:v>73.824844121482997</c:v>
                </c:pt>
                <c:pt idx="447">
                  <c:v>73.817183869964097</c:v>
                </c:pt>
                <c:pt idx="448">
                  <c:v>73.809523618445297</c:v>
                </c:pt>
                <c:pt idx="449">
                  <c:v>73.801863366926497</c:v>
                </c:pt>
                <c:pt idx="450">
                  <c:v>73.794203115407598</c:v>
                </c:pt>
                <c:pt idx="451">
                  <c:v>73.786542863888798</c:v>
                </c:pt>
                <c:pt idx="452">
                  <c:v>73.778882612369998</c:v>
                </c:pt>
                <c:pt idx="453">
                  <c:v>71.250999611156502</c:v>
                </c:pt>
                <c:pt idx="454">
                  <c:v>71.243339359637702</c:v>
                </c:pt>
                <c:pt idx="455">
                  <c:v>71.235679108118902</c:v>
                </c:pt>
                <c:pt idx="456">
                  <c:v>71.228018856600102</c:v>
                </c:pt>
                <c:pt idx="457">
                  <c:v>71.220358605081202</c:v>
                </c:pt>
                <c:pt idx="458">
                  <c:v>71.212698353562402</c:v>
                </c:pt>
                <c:pt idx="459">
                  <c:v>71.205038102043602</c:v>
                </c:pt>
                <c:pt idx="460">
                  <c:v>71.197377850524802</c:v>
                </c:pt>
                <c:pt idx="461">
                  <c:v>71.189717599005903</c:v>
                </c:pt>
                <c:pt idx="462">
                  <c:v>71.182057347487103</c:v>
                </c:pt>
                <c:pt idx="463">
                  <c:v>71.174397095968303</c:v>
                </c:pt>
                <c:pt idx="464">
                  <c:v>71.166736844449403</c:v>
                </c:pt>
                <c:pt idx="465">
                  <c:v>71.159076592930603</c:v>
                </c:pt>
                <c:pt idx="466">
                  <c:v>71.151416341411803</c:v>
                </c:pt>
                <c:pt idx="467">
                  <c:v>71.143756089892904</c:v>
                </c:pt>
                <c:pt idx="468">
                  <c:v>71.136095838374104</c:v>
                </c:pt>
                <c:pt idx="469">
                  <c:v>71.128435586855304</c:v>
                </c:pt>
                <c:pt idx="470">
                  <c:v>71.120775335336504</c:v>
                </c:pt>
                <c:pt idx="471">
                  <c:v>71.113115083817604</c:v>
                </c:pt>
                <c:pt idx="472">
                  <c:v>71.105454832298804</c:v>
                </c:pt>
                <c:pt idx="473">
                  <c:v>71.097794580780004</c:v>
                </c:pt>
                <c:pt idx="474">
                  <c:v>64.716805065595693</c:v>
                </c:pt>
                <c:pt idx="475">
                  <c:v>64.709144814076893</c:v>
                </c:pt>
                <c:pt idx="476">
                  <c:v>64.701484562558093</c:v>
                </c:pt>
                <c:pt idx="477">
                  <c:v>64.693824311039194</c:v>
                </c:pt>
                <c:pt idx="478">
                  <c:v>64.686164059520394</c:v>
                </c:pt>
                <c:pt idx="479">
                  <c:v>64.678503808001594</c:v>
                </c:pt>
                <c:pt idx="480">
                  <c:v>64.670843556482694</c:v>
                </c:pt>
                <c:pt idx="481">
                  <c:v>64.663183304963894</c:v>
                </c:pt>
                <c:pt idx="482">
                  <c:v>64.655523053445094</c:v>
                </c:pt>
                <c:pt idx="483">
                  <c:v>64.647862801926294</c:v>
                </c:pt>
                <c:pt idx="484">
                  <c:v>64.640202550407395</c:v>
                </c:pt>
                <c:pt idx="485">
                  <c:v>64.632542298888595</c:v>
                </c:pt>
                <c:pt idx="486">
                  <c:v>64.624882047369795</c:v>
                </c:pt>
                <c:pt idx="487">
                  <c:v>64.617221795850895</c:v>
                </c:pt>
                <c:pt idx="488">
                  <c:v>64.609561544332095</c:v>
                </c:pt>
                <c:pt idx="489">
                  <c:v>64.601901292813295</c:v>
                </c:pt>
                <c:pt idx="490">
                  <c:v>64.594241041294495</c:v>
                </c:pt>
                <c:pt idx="491">
                  <c:v>64.586580789775596</c:v>
                </c:pt>
                <c:pt idx="492">
                  <c:v>64.578920538256796</c:v>
                </c:pt>
                <c:pt idx="493">
                  <c:v>64.571260286737996</c:v>
                </c:pt>
                <c:pt idx="494">
                  <c:v>64.563600035219096</c:v>
                </c:pt>
                <c:pt idx="495">
                  <c:v>64.555939783700296</c:v>
                </c:pt>
                <c:pt idx="496">
                  <c:v>64.548279532181496</c:v>
                </c:pt>
                <c:pt idx="497">
                  <c:v>64.540619280662696</c:v>
                </c:pt>
                <c:pt idx="498">
                  <c:v>64.532959029143797</c:v>
                </c:pt>
                <c:pt idx="499">
                  <c:v>64.525298777624997</c:v>
                </c:pt>
                <c:pt idx="500">
                  <c:v>64.517638526106197</c:v>
                </c:pt>
                <c:pt idx="501">
                  <c:v>64.509978274587297</c:v>
                </c:pt>
                <c:pt idx="502">
                  <c:v>64.502318023068497</c:v>
                </c:pt>
                <c:pt idx="503">
                  <c:v>64.494657771549697</c:v>
                </c:pt>
                <c:pt idx="504">
                  <c:v>64.486997520030897</c:v>
                </c:pt>
                <c:pt idx="505">
                  <c:v>64.479337268511998</c:v>
                </c:pt>
                <c:pt idx="506">
                  <c:v>64.471677016993198</c:v>
                </c:pt>
                <c:pt idx="507">
                  <c:v>64.464016765474398</c:v>
                </c:pt>
                <c:pt idx="508">
                  <c:v>64.456356513955498</c:v>
                </c:pt>
                <c:pt idx="509">
                  <c:v>64.448696262436698</c:v>
                </c:pt>
                <c:pt idx="510">
                  <c:v>64.441036010917898</c:v>
                </c:pt>
                <c:pt idx="511">
                  <c:v>64.433375759399098</c:v>
                </c:pt>
                <c:pt idx="512">
                  <c:v>64.425715507880199</c:v>
                </c:pt>
                <c:pt idx="513">
                  <c:v>64.418055256361399</c:v>
                </c:pt>
                <c:pt idx="514">
                  <c:v>64.410395004842599</c:v>
                </c:pt>
                <c:pt idx="515">
                  <c:v>64.402734753323699</c:v>
                </c:pt>
                <c:pt idx="516">
                  <c:v>64.395074501804899</c:v>
                </c:pt>
                <c:pt idx="517">
                  <c:v>64.387414250286099</c:v>
                </c:pt>
                <c:pt idx="518">
                  <c:v>64.379753998767299</c:v>
                </c:pt>
                <c:pt idx="519">
                  <c:v>64.3720937472484</c:v>
                </c:pt>
                <c:pt idx="520">
                  <c:v>64.3644334957296</c:v>
                </c:pt>
                <c:pt idx="521">
                  <c:v>64.3567732442108</c:v>
                </c:pt>
                <c:pt idx="522">
                  <c:v>64.3491129926919</c:v>
                </c:pt>
                <c:pt idx="523">
                  <c:v>64.3414527411731</c:v>
                </c:pt>
                <c:pt idx="524">
                  <c:v>64.3337924896543</c:v>
                </c:pt>
                <c:pt idx="525">
                  <c:v>64.326132238135401</c:v>
                </c:pt>
                <c:pt idx="526">
                  <c:v>64.318471986616601</c:v>
                </c:pt>
                <c:pt idx="527">
                  <c:v>64.310811735097801</c:v>
                </c:pt>
                <c:pt idx="528">
                  <c:v>64.303151483579001</c:v>
                </c:pt>
                <c:pt idx="529">
                  <c:v>64.295491232060101</c:v>
                </c:pt>
                <c:pt idx="530">
                  <c:v>64.287830980541301</c:v>
                </c:pt>
                <c:pt idx="531">
                  <c:v>64.280170729022501</c:v>
                </c:pt>
                <c:pt idx="532">
                  <c:v>63.284338031574798</c:v>
                </c:pt>
                <c:pt idx="533">
                  <c:v>63.276677780055898</c:v>
                </c:pt>
                <c:pt idx="534">
                  <c:v>63.269017528537098</c:v>
                </c:pt>
                <c:pt idx="535">
                  <c:v>63.261357277018298</c:v>
                </c:pt>
                <c:pt idx="536">
                  <c:v>63.253697025499399</c:v>
                </c:pt>
                <c:pt idx="537">
                  <c:v>63.246036773980599</c:v>
                </c:pt>
                <c:pt idx="538">
                  <c:v>63.238376522461799</c:v>
                </c:pt>
                <c:pt idx="539">
                  <c:v>63.230716270942999</c:v>
                </c:pt>
                <c:pt idx="540">
                  <c:v>63.223056019424099</c:v>
                </c:pt>
                <c:pt idx="541">
                  <c:v>63.215395767905299</c:v>
                </c:pt>
                <c:pt idx="542">
                  <c:v>63.207735516386499</c:v>
                </c:pt>
                <c:pt idx="543">
                  <c:v>63.2000752648676</c:v>
                </c:pt>
                <c:pt idx="544">
                  <c:v>63.1924150133488</c:v>
                </c:pt>
                <c:pt idx="545">
                  <c:v>63.18475476183</c:v>
                </c:pt>
                <c:pt idx="546">
                  <c:v>63.1770945103112</c:v>
                </c:pt>
                <c:pt idx="547">
                  <c:v>63.1694342587923</c:v>
                </c:pt>
                <c:pt idx="548">
                  <c:v>63.1617740072735</c:v>
                </c:pt>
                <c:pt idx="549">
                  <c:v>63.1541137557547</c:v>
                </c:pt>
                <c:pt idx="550">
                  <c:v>63.146453504235801</c:v>
                </c:pt>
                <c:pt idx="551">
                  <c:v>63.138793252717001</c:v>
                </c:pt>
                <c:pt idx="552">
                  <c:v>63.131133001198201</c:v>
                </c:pt>
                <c:pt idx="553">
                  <c:v>63.123472749679401</c:v>
                </c:pt>
                <c:pt idx="554">
                  <c:v>63.115812498160501</c:v>
                </c:pt>
                <c:pt idx="555">
                  <c:v>63.108152246641701</c:v>
                </c:pt>
                <c:pt idx="556">
                  <c:v>63.100491995122901</c:v>
                </c:pt>
                <c:pt idx="557">
                  <c:v>63.092831743604002</c:v>
                </c:pt>
                <c:pt idx="558">
                  <c:v>63.085171492085202</c:v>
                </c:pt>
                <c:pt idx="559">
                  <c:v>63.077511240566402</c:v>
                </c:pt>
                <c:pt idx="560">
                  <c:v>63.069850989047602</c:v>
                </c:pt>
                <c:pt idx="561">
                  <c:v>63.062190737528702</c:v>
                </c:pt>
                <c:pt idx="562">
                  <c:v>63.054530486009902</c:v>
                </c:pt>
                <c:pt idx="563">
                  <c:v>63.046870234491102</c:v>
                </c:pt>
                <c:pt idx="564">
                  <c:v>63.039209982972203</c:v>
                </c:pt>
                <c:pt idx="565">
                  <c:v>63.031549731453403</c:v>
                </c:pt>
                <c:pt idx="566">
                  <c:v>63.023889479934603</c:v>
                </c:pt>
                <c:pt idx="567">
                  <c:v>63.016229228415803</c:v>
                </c:pt>
                <c:pt idx="568">
                  <c:v>63.008568976896903</c:v>
                </c:pt>
                <c:pt idx="569">
                  <c:v>63.000908725378103</c:v>
                </c:pt>
                <c:pt idx="570">
                  <c:v>62.993248473859303</c:v>
                </c:pt>
                <c:pt idx="571">
                  <c:v>62.985588222340397</c:v>
                </c:pt>
                <c:pt idx="572">
                  <c:v>62.977927970821597</c:v>
                </c:pt>
                <c:pt idx="573">
                  <c:v>62.970267719302797</c:v>
                </c:pt>
                <c:pt idx="574">
                  <c:v>62.962607467783997</c:v>
                </c:pt>
                <c:pt idx="575">
                  <c:v>62.954947216265097</c:v>
                </c:pt>
                <c:pt idx="576">
                  <c:v>62.947286964746297</c:v>
                </c:pt>
                <c:pt idx="577">
                  <c:v>62.939626713227497</c:v>
                </c:pt>
                <c:pt idx="578">
                  <c:v>62.931966461708598</c:v>
                </c:pt>
                <c:pt idx="579">
                  <c:v>62.924306210189798</c:v>
                </c:pt>
                <c:pt idx="580">
                  <c:v>62.916645958670998</c:v>
                </c:pt>
                <c:pt idx="581">
                  <c:v>62.908985707152198</c:v>
                </c:pt>
                <c:pt idx="582">
                  <c:v>62.901325455633298</c:v>
                </c:pt>
                <c:pt idx="583">
                  <c:v>62.893665204114498</c:v>
                </c:pt>
                <c:pt idx="584">
                  <c:v>62.886004952595698</c:v>
                </c:pt>
                <c:pt idx="585">
                  <c:v>62.878344701076799</c:v>
                </c:pt>
                <c:pt idx="586">
                  <c:v>62.870684449557999</c:v>
                </c:pt>
                <c:pt idx="587">
                  <c:v>62.863024198039199</c:v>
                </c:pt>
                <c:pt idx="588">
                  <c:v>62.855363946520399</c:v>
                </c:pt>
                <c:pt idx="589">
                  <c:v>62.847703695001499</c:v>
                </c:pt>
                <c:pt idx="590">
                  <c:v>62.840043443482699</c:v>
                </c:pt>
                <c:pt idx="591">
                  <c:v>62.832383191963899</c:v>
                </c:pt>
                <c:pt idx="592">
                  <c:v>62.824722940445</c:v>
                </c:pt>
                <c:pt idx="593">
                  <c:v>57.462546877264998</c:v>
                </c:pt>
                <c:pt idx="594">
                  <c:v>57.454886625746198</c:v>
                </c:pt>
                <c:pt idx="595">
                  <c:v>57.447226374227299</c:v>
                </c:pt>
                <c:pt idx="596">
                  <c:v>57.439566122708499</c:v>
                </c:pt>
                <c:pt idx="597">
                  <c:v>57.431905871189699</c:v>
                </c:pt>
                <c:pt idx="598">
                  <c:v>57.424245619670799</c:v>
                </c:pt>
                <c:pt idx="599">
                  <c:v>57.416585368151999</c:v>
                </c:pt>
                <c:pt idx="600">
                  <c:v>57.408925116633199</c:v>
                </c:pt>
                <c:pt idx="601">
                  <c:v>57.401264865114399</c:v>
                </c:pt>
                <c:pt idx="602">
                  <c:v>57.3936046135955</c:v>
                </c:pt>
                <c:pt idx="603">
                  <c:v>57.3859443620767</c:v>
                </c:pt>
                <c:pt idx="604">
                  <c:v>57.3782841105579</c:v>
                </c:pt>
                <c:pt idx="605">
                  <c:v>57.370623859039</c:v>
                </c:pt>
                <c:pt idx="606">
                  <c:v>57.3629636075202</c:v>
                </c:pt>
                <c:pt idx="607">
                  <c:v>57.3553033560014</c:v>
                </c:pt>
                <c:pt idx="608">
                  <c:v>57.3476431044826</c:v>
                </c:pt>
                <c:pt idx="609">
                  <c:v>57.339982852963701</c:v>
                </c:pt>
                <c:pt idx="610">
                  <c:v>57.332322601444901</c:v>
                </c:pt>
                <c:pt idx="611">
                  <c:v>57.324662349926101</c:v>
                </c:pt>
                <c:pt idx="612">
                  <c:v>57.317002098407201</c:v>
                </c:pt>
                <c:pt idx="613">
                  <c:v>57.309341846888401</c:v>
                </c:pt>
                <c:pt idx="614">
                  <c:v>57.301681595369601</c:v>
                </c:pt>
                <c:pt idx="615">
                  <c:v>57.294021343850801</c:v>
                </c:pt>
                <c:pt idx="616">
                  <c:v>57.286361092331902</c:v>
                </c:pt>
                <c:pt idx="617">
                  <c:v>57.278700840813102</c:v>
                </c:pt>
                <c:pt idx="618">
                  <c:v>57.271040589294302</c:v>
                </c:pt>
                <c:pt idx="619">
                  <c:v>57.263380337775402</c:v>
                </c:pt>
                <c:pt idx="620">
                  <c:v>57.255720086256602</c:v>
                </c:pt>
                <c:pt idx="621">
                  <c:v>57.248059834737802</c:v>
                </c:pt>
                <c:pt idx="622">
                  <c:v>57.240399583219002</c:v>
                </c:pt>
                <c:pt idx="623">
                  <c:v>57.232739331700103</c:v>
                </c:pt>
                <c:pt idx="624">
                  <c:v>57.225079080181303</c:v>
                </c:pt>
                <c:pt idx="625">
                  <c:v>57.217418828662503</c:v>
                </c:pt>
                <c:pt idx="626">
                  <c:v>57.209758577143603</c:v>
                </c:pt>
                <c:pt idx="627">
                  <c:v>57.202098325624803</c:v>
                </c:pt>
                <c:pt idx="628">
                  <c:v>57.194438074106003</c:v>
                </c:pt>
                <c:pt idx="629">
                  <c:v>57.186777822587203</c:v>
                </c:pt>
                <c:pt idx="630">
                  <c:v>57.179117571068304</c:v>
                </c:pt>
                <c:pt idx="631">
                  <c:v>57.171457319549503</c:v>
                </c:pt>
                <c:pt idx="632">
                  <c:v>57.163797068030703</c:v>
                </c:pt>
                <c:pt idx="633">
                  <c:v>57.156136816511903</c:v>
                </c:pt>
                <c:pt idx="634">
                  <c:v>57.002931786135299</c:v>
                </c:pt>
                <c:pt idx="635">
                  <c:v>56.995271534616499</c:v>
                </c:pt>
                <c:pt idx="636">
                  <c:v>56.9876112830976</c:v>
                </c:pt>
                <c:pt idx="637">
                  <c:v>56.9799510315788</c:v>
                </c:pt>
                <c:pt idx="638">
                  <c:v>56.97229078006</c:v>
                </c:pt>
                <c:pt idx="639">
                  <c:v>56.9646305285411</c:v>
                </c:pt>
                <c:pt idx="640">
                  <c:v>56.9569702770223</c:v>
                </c:pt>
                <c:pt idx="641">
                  <c:v>56.9493100255035</c:v>
                </c:pt>
                <c:pt idx="642">
                  <c:v>56.941649773984601</c:v>
                </c:pt>
                <c:pt idx="643">
                  <c:v>56.933989522465801</c:v>
                </c:pt>
                <c:pt idx="644">
                  <c:v>56.926329270947001</c:v>
                </c:pt>
                <c:pt idx="645">
                  <c:v>56.918669019428201</c:v>
                </c:pt>
                <c:pt idx="646">
                  <c:v>56.911008767909301</c:v>
                </c:pt>
                <c:pt idx="647">
                  <c:v>56.903348516390501</c:v>
                </c:pt>
                <c:pt idx="648">
                  <c:v>56.895688264871701</c:v>
                </c:pt>
                <c:pt idx="649">
                  <c:v>56.888028013352802</c:v>
                </c:pt>
                <c:pt idx="650">
                  <c:v>56.880367761834002</c:v>
                </c:pt>
                <c:pt idx="651">
                  <c:v>56.872707510315202</c:v>
                </c:pt>
                <c:pt idx="652">
                  <c:v>56.865047258796402</c:v>
                </c:pt>
                <c:pt idx="653">
                  <c:v>56.857387007277502</c:v>
                </c:pt>
                <c:pt idx="654">
                  <c:v>56.849726755758702</c:v>
                </c:pt>
                <c:pt idx="655">
                  <c:v>56.842066504239902</c:v>
                </c:pt>
                <c:pt idx="656">
                  <c:v>56.834406252721003</c:v>
                </c:pt>
                <c:pt idx="657">
                  <c:v>56.826746001202203</c:v>
                </c:pt>
                <c:pt idx="658">
                  <c:v>56.819085749683403</c:v>
                </c:pt>
                <c:pt idx="659">
                  <c:v>56.811425498164603</c:v>
                </c:pt>
                <c:pt idx="660">
                  <c:v>56.803765246645703</c:v>
                </c:pt>
                <c:pt idx="661">
                  <c:v>56.796104995126903</c:v>
                </c:pt>
                <c:pt idx="662">
                  <c:v>56.788444743608103</c:v>
                </c:pt>
                <c:pt idx="663">
                  <c:v>56.780784492089197</c:v>
                </c:pt>
                <c:pt idx="664">
                  <c:v>56.773124240570397</c:v>
                </c:pt>
                <c:pt idx="665">
                  <c:v>56.765463989051597</c:v>
                </c:pt>
                <c:pt idx="666">
                  <c:v>56.757803737532797</c:v>
                </c:pt>
                <c:pt idx="667">
                  <c:v>56.750143486013897</c:v>
                </c:pt>
                <c:pt idx="668">
                  <c:v>56.742483234495097</c:v>
                </c:pt>
                <c:pt idx="669">
                  <c:v>56.734822982976297</c:v>
                </c:pt>
                <c:pt idx="670">
                  <c:v>56.727162731457398</c:v>
                </c:pt>
                <c:pt idx="671">
                  <c:v>56.719502479938598</c:v>
                </c:pt>
                <c:pt idx="672">
                  <c:v>56.711842228419798</c:v>
                </c:pt>
                <c:pt idx="673">
                  <c:v>56.704181976900998</c:v>
                </c:pt>
                <c:pt idx="674">
                  <c:v>56.696521725382098</c:v>
                </c:pt>
                <c:pt idx="675">
                  <c:v>56.688861473863298</c:v>
                </c:pt>
                <c:pt idx="676">
                  <c:v>56.681201222344498</c:v>
                </c:pt>
                <c:pt idx="677">
                  <c:v>56.673540970825599</c:v>
                </c:pt>
                <c:pt idx="678">
                  <c:v>56.665880719306799</c:v>
                </c:pt>
                <c:pt idx="679">
                  <c:v>56.658220467787999</c:v>
                </c:pt>
                <c:pt idx="680">
                  <c:v>56.650560216269199</c:v>
                </c:pt>
                <c:pt idx="681">
                  <c:v>56.642899964750299</c:v>
                </c:pt>
                <c:pt idx="682">
                  <c:v>56.635239713231499</c:v>
                </c:pt>
                <c:pt idx="683">
                  <c:v>56.627579461712699</c:v>
                </c:pt>
                <c:pt idx="684">
                  <c:v>56.6199192101938</c:v>
                </c:pt>
                <c:pt idx="685">
                  <c:v>56.612258958675</c:v>
                </c:pt>
                <c:pt idx="686">
                  <c:v>56.6045987071562</c:v>
                </c:pt>
                <c:pt idx="687">
                  <c:v>56.5969384556374</c:v>
                </c:pt>
                <c:pt idx="688">
                  <c:v>56.5892782041185</c:v>
                </c:pt>
                <c:pt idx="689">
                  <c:v>56.5816179525997</c:v>
                </c:pt>
                <c:pt idx="690">
                  <c:v>56.5739577010809</c:v>
                </c:pt>
                <c:pt idx="691">
                  <c:v>56.566297449562001</c:v>
                </c:pt>
                <c:pt idx="692">
                  <c:v>56.558637198043201</c:v>
                </c:pt>
                <c:pt idx="693">
                  <c:v>56.550976946524401</c:v>
                </c:pt>
                <c:pt idx="694">
                  <c:v>56.543316695005601</c:v>
                </c:pt>
                <c:pt idx="695">
                  <c:v>56.535656443486701</c:v>
                </c:pt>
                <c:pt idx="696">
                  <c:v>56.527996191967901</c:v>
                </c:pt>
                <c:pt idx="697">
                  <c:v>56.520335940449101</c:v>
                </c:pt>
                <c:pt idx="698">
                  <c:v>56.512675688930202</c:v>
                </c:pt>
                <c:pt idx="699">
                  <c:v>56.505015437411402</c:v>
                </c:pt>
                <c:pt idx="700">
                  <c:v>56.497355185892602</c:v>
                </c:pt>
                <c:pt idx="701">
                  <c:v>56.489694934373802</c:v>
                </c:pt>
                <c:pt idx="702">
                  <c:v>56.482034682854902</c:v>
                </c:pt>
                <c:pt idx="703">
                  <c:v>56.474374431336102</c:v>
                </c:pt>
                <c:pt idx="704">
                  <c:v>56.466714179817302</c:v>
                </c:pt>
                <c:pt idx="705">
                  <c:v>56.459053928298403</c:v>
                </c:pt>
                <c:pt idx="706">
                  <c:v>56.451393676779603</c:v>
                </c:pt>
                <c:pt idx="707">
                  <c:v>56.443733425260803</c:v>
                </c:pt>
                <c:pt idx="708">
                  <c:v>56.436073173741903</c:v>
                </c:pt>
                <c:pt idx="709">
                  <c:v>56.428412922223103</c:v>
                </c:pt>
                <c:pt idx="710">
                  <c:v>56.420752670704303</c:v>
                </c:pt>
                <c:pt idx="711">
                  <c:v>56.413092419185503</c:v>
                </c:pt>
                <c:pt idx="712">
                  <c:v>56.405432167666604</c:v>
                </c:pt>
                <c:pt idx="713">
                  <c:v>56.397771916147803</c:v>
                </c:pt>
                <c:pt idx="714">
                  <c:v>56.390111664629003</c:v>
                </c:pt>
                <c:pt idx="715">
                  <c:v>56.382451413110203</c:v>
                </c:pt>
                <c:pt idx="716">
                  <c:v>56.374791161591297</c:v>
                </c:pt>
                <c:pt idx="717">
                  <c:v>56.367130910072497</c:v>
                </c:pt>
                <c:pt idx="718">
                  <c:v>56.359470658553697</c:v>
                </c:pt>
                <c:pt idx="719">
                  <c:v>56.351810407034797</c:v>
                </c:pt>
                <c:pt idx="720">
                  <c:v>56.344150155515997</c:v>
                </c:pt>
                <c:pt idx="721">
                  <c:v>56.336489903997197</c:v>
                </c:pt>
                <c:pt idx="722">
                  <c:v>56.328829652478397</c:v>
                </c:pt>
                <c:pt idx="723">
                  <c:v>56.321169400959498</c:v>
                </c:pt>
                <c:pt idx="724">
                  <c:v>56.313509149440698</c:v>
                </c:pt>
                <c:pt idx="725">
                  <c:v>56.305848897921898</c:v>
                </c:pt>
                <c:pt idx="726">
                  <c:v>56.298188646402998</c:v>
                </c:pt>
                <c:pt idx="727">
                  <c:v>56.290528394884198</c:v>
                </c:pt>
                <c:pt idx="728">
                  <c:v>56.282868143365398</c:v>
                </c:pt>
                <c:pt idx="729">
                  <c:v>56.275207891846598</c:v>
                </c:pt>
                <c:pt idx="730">
                  <c:v>56.267547640327699</c:v>
                </c:pt>
                <c:pt idx="731">
                  <c:v>56.259887388808899</c:v>
                </c:pt>
                <c:pt idx="732">
                  <c:v>56.252227137290099</c:v>
                </c:pt>
                <c:pt idx="733">
                  <c:v>56.244566885771199</c:v>
                </c:pt>
                <c:pt idx="734">
                  <c:v>56.236906634252399</c:v>
                </c:pt>
                <c:pt idx="735">
                  <c:v>53.4792160874741</c:v>
                </c:pt>
                <c:pt idx="736">
                  <c:v>53.4715558359553</c:v>
                </c:pt>
                <c:pt idx="737">
                  <c:v>53.463895584436401</c:v>
                </c:pt>
                <c:pt idx="738">
                  <c:v>53.456235332917601</c:v>
                </c:pt>
                <c:pt idx="739">
                  <c:v>53.448575081398801</c:v>
                </c:pt>
                <c:pt idx="740">
                  <c:v>53.440914829880001</c:v>
                </c:pt>
                <c:pt idx="741">
                  <c:v>53.433254578361101</c:v>
                </c:pt>
                <c:pt idx="742">
                  <c:v>53.425594326842301</c:v>
                </c:pt>
                <c:pt idx="743">
                  <c:v>53.417934075323501</c:v>
                </c:pt>
                <c:pt idx="744">
                  <c:v>53.410273823804602</c:v>
                </c:pt>
                <c:pt idx="745">
                  <c:v>53.402613572285802</c:v>
                </c:pt>
                <c:pt idx="746">
                  <c:v>53.394953320767002</c:v>
                </c:pt>
                <c:pt idx="747">
                  <c:v>53.387293069248202</c:v>
                </c:pt>
                <c:pt idx="748">
                  <c:v>53.379632817729302</c:v>
                </c:pt>
                <c:pt idx="749">
                  <c:v>53.371972566210502</c:v>
                </c:pt>
                <c:pt idx="750">
                  <c:v>53.364312314691702</c:v>
                </c:pt>
                <c:pt idx="751">
                  <c:v>53.356652063172803</c:v>
                </c:pt>
                <c:pt idx="752">
                  <c:v>53.348991811654003</c:v>
                </c:pt>
                <c:pt idx="753">
                  <c:v>53.341331560135202</c:v>
                </c:pt>
                <c:pt idx="754">
                  <c:v>53.333671308616402</c:v>
                </c:pt>
                <c:pt idx="755">
                  <c:v>53.326011057097503</c:v>
                </c:pt>
                <c:pt idx="756">
                  <c:v>53.318350805578703</c:v>
                </c:pt>
                <c:pt idx="757">
                  <c:v>53.310690554059903</c:v>
                </c:pt>
                <c:pt idx="758">
                  <c:v>53.303030302541003</c:v>
                </c:pt>
                <c:pt idx="759">
                  <c:v>53.295370051022203</c:v>
                </c:pt>
                <c:pt idx="760">
                  <c:v>53.287709799503403</c:v>
                </c:pt>
                <c:pt idx="761">
                  <c:v>53.280049547984603</c:v>
                </c:pt>
                <c:pt idx="762">
                  <c:v>53.272389296465697</c:v>
                </c:pt>
                <c:pt idx="763">
                  <c:v>53.264729044946897</c:v>
                </c:pt>
                <c:pt idx="764">
                  <c:v>53.257068793428097</c:v>
                </c:pt>
                <c:pt idx="765">
                  <c:v>53.249408541909197</c:v>
                </c:pt>
                <c:pt idx="766">
                  <c:v>53.241748290390397</c:v>
                </c:pt>
                <c:pt idx="767">
                  <c:v>53.234088038871597</c:v>
                </c:pt>
                <c:pt idx="768">
                  <c:v>53.226427787352797</c:v>
                </c:pt>
                <c:pt idx="769">
                  <c:v>53.218767535833898</c:v>
                </c:pt>
                <c:pt idx="770">
                  <c:v>53.211107284315098</c:v>
                </c:pt>
                <c:pt idx="771">
                  <c:v>53.203447032796298</c:v>
                </c:pt>
                <c:pt idx="772">
                  <c:v>53.195786781277398</c:v>
                </c:pt>
                <c:pt idx="773">
                  <c:v>53.188126529758598</c:v>
                </c:pt>
                <c:pt idx="774">
                  <c:v>53.180466278239798</c:v>
                </c:pt>
                <c:pt idx="775">
                  <c:v>53.172806026720998</c:v>
                </c:pt>
                <c:pt idx="776">
                  <c:v>53.165145775202099</c:v>
                </c:pt>
                <c:pt idx="777">
                  <c:v>53.157485523683299</c:v>
                </c:pt>
                <c:pt idx="778">
                  <c:v>53.149825272164499</c:v>
                </c:pt>
                <c:pt idx="779">
                  <c:v>53.142165020645599</c:v>
                </c:pt>
                <c:pt idx="780">
                  <c:v>53.134504769126799</c:v>
                </c:pt>
                <c:pt idx="781">
                  <c:v>53.126844517607999</c:v>
                </c:pt>
                <c:pt idx="782">
                  <c:v>53.119184266089199</c:v>
                </c:pt>
                <c:pt idx="783">
                  <c:v>53.1115240145703</c:v>
                </c:pt>
                <c:pt idx="784">
                  <c:v>53.1038637630515</c:v>
                </c:pt>
                <c:pt idx="785">
                  <c:v>53.0962035115327</c:v>
                </c:pt>
                <c:pt idx="786">
                  <c:v>50.338512964754401</c:v>
                </c:pt>
                <c:pt idx="787">
                  <c:v>50.330852713235501</c:v>
                </c:pt>
                <c:pt idx="788">
                  <c:v>50.323192461716701</c:v>
                </c:pt>
                <c:pt idx="789">
                  <c:v>50.315532210197901</c:v>
                </c:pt>
                <c:pt idx="790">
                  <c:v>50.307871958679002</c:v>
                </c:pt>
                <c:pt idx="791">
                  <c:v>50.300211707160202</c:v>
                </c:pt>
                <c:pt idx="792">
                  <c:v>50.292551455641402</c:v>
                </c:pt>
                <c:pt idx="793">
                  <c:v>50.284891204122601</c:v>
                </c:pt>
                <c:pt idx="794">
                  <c:v>50.277230952603702</c:v>
                </c:pt>
                <c:pt idx="795">
                  <c:v>50.269570701084902</c:v>
                </c:pt>
                <c:pt idx="796">
                  <c:v>50.261910449566102</c:v>
                </c:pt>
                <c:pt idx="797">
                  <c:v>50.254250198047203</c:v>
                </c:pt>
                <c:pt idx="798">
                  <c:v>50.246589946528402</c:v>
                </c:pt>
                <c:pt idx="799">
                  <c:v>50.238929695009602</c:v>
                </c:pt>
                <c:pt idx="800">
                  <c:v>50.231269443490802</c:v>
                </c:pt>
                <c:pt idx="801">
                  <c:v>50.223609191971903</c:v>
                </c:pt>
                <c:pt idx="802">
                  <c:v>50.215948940453103</c:v>
                </c:pt>
                <c:pt idx="803">
                  <c:v>50.208288688934303</c:v>
                </c:pt>
                <c:pt idx="804">
                  <c:v>50.200628437415403</c:v>
                </c:pt>
                <c:pt idx="805">
                  <c:v>50.192968185896603</c:v>
                </c:pt>
                <c:pt idx="806">
                  <c:v>50.185307934377803</c:v>
                </c:pt>
                <c:pt idx="807">
                  <c:v>50.177647682859003</c:v>
                </c:pt>
                <c:pt idx="808">
                  <c:v>50.169987431340097</c:v>
                </c:pt>
                <c:pt idx="809">
                  <c:v>50.162327179821297</c:v>
                </c:pt>
                <c:pt idx="810">
                  <c:v>50.154666928302497</c:v>
                </c:pt>
                <c:pt idx="811">
                  <c:v>50.147006676783597</c:v>
                </c:pt>
                <c:pt idx="812">
                  <c:v>50.139346425264797</c:v>
                </c:pt>
                <c:pt idx="813">
                  <c:v>50.131686173745997</c:v>
                </c:pt>
                <c:pt idx="814">
                  <c:v>50.124025922227197</c:v>
                </c:pt>
                <c:pt idx="815">
                  <c:v>50.116365670708298</c:v>
                </c:pt>
                <c:pt idx="816">
                  <c:v>50.108705419189498</c:v>
                </c:pt>
                <c:pt idx="817">
                  <c:v>50.101045167670698</c:v>
                </c:pt>
                <c:pt idx="818">
                  <c:v>50.093384916151798</c:v>
                </c:pt>
                <c:pt idx="819">
                  <c:v>50.085724664632998</c:v>
                </c:pt>
                <c:pt idx="820">
                  <c:v>50.078064413114198</c:v>
                </c:pt>
                <c:pt idx="821">
                  <c:v>50.070404161595398</c:v>
                </c:pt>
                <c:pt idx="822">
                  <c:v>50.062743910076499</c:v>
                </c:pt>
                <c:pt idx="823">
                  <c:v>50.055083658557699</c:v>
                </c:pt>
                <c:pt idx="824">
                  <c:v>50.047423407038899</c:v>
                </c:pt>
                <c:pt idx="825">
                  <c:v>50.039763155519999</c:v>
                </c:pt>
                <c:pt idx="826">
                  <c:v>50.032102904001199</c:v>
                </c:pt>
                <c:pt idx="827">
                  <c:v>48.959667691365198</c:v>
                </c:pt>
                <c:pt idx="828">
                  <c:v>48.952007439846398</c:v>
                </c:pt>
                <c:pt idx="829">
                  <c:v>48.944347188327498</c:v>
                </c:pt>
                <c:pt idx="830">
                  <c:v>48.936686936808698</c:v>
                </c:pt>
                <c:pt idx="831">
                  <c:v>48.929026685289898</c:v>
                </c:pt>
                <c:pt idx="832">
                  <c:v>48.921366433771098</c:v>
                </c:pt>
                <c:pt idx="833">
                  <c:v>48.913706182252199</c:v>
                </c:pt>
                <c:pt idx="834">
                  <c:v>48.906045930733399</c:v>
                </c:pt>
                <c:pt idx="835">
                  <c:v>48.898385679214599</c:v>
                </c:pt>
                <c:pt idx="836">
                  <c:v>48.890725427695699</c:v>
                </c:pt>
                <c:pt idx="837">
                  <c:v>48.883065176176899</c:v>
                </c:pt>
                <c:pt idx="838">
                  <c:v>48.875404924658099</c:v>
                </c:pt>
                <c:pt idx="839">
                  <c:v>48.867744673139299</c:v>
                </c:pt>
                <c:pt idx="840">
                  <c:v>48.8600844216204</c:v>
                </c:pt>
                <c:pt idx="841">
                  <c:v>48.8524241701016</c:v>
                </c:pt>
                <c:pt idx="842">
                  <c:v>48.8447639185828</c:v>
                </c:pt>
                <c:pt idx="843">
                  <c:v>48.8371036670639</c:v>
                </c:pt>
                <c:pt idx="844">
                  <c:v>48.8294434155451</c:v>
                </c:pt>
                <c:pt idx="845">
                  <c:v>48.8217831640263</c:v>
                </c:pt>
                <c:pt idx="846">
                  <c:v>48.8141229125075</c:v>
                </c:pt>
                <c:pt idx="847">
                  <c:v>48.806462660988601</c:v>
                </c:pt>
                <c:pt idx="848">
                  <c:v>48.798802409469801</c:v>
                </c:pt>
                <c:pt idx="849">
                  <c:v>48.791142157951001</c:v>
                </c:pt>
                <c:pt idx="850">
                  <c:v>48.783481906432101</c:v>
                </c:pt>
                <c:pt idx="851">
                  <c:v>48.775821654913301</c:v>
                </c:pt>
                <c:pt idx="852">
                  <c:v>48.768161403394501</c:v>
                </c:pt>
                <c:pt idx="853">
                  <c:v>48.760501151875701</c:v>
                </c:pt>
                <c:pt idx="854">
                  <c:v>48.752840900356802</c:v>
                </c:pt>
                <c:pt idx="855">
                  <c:v>48.745180648838002</c:v>
                </c:pt>
                <c:pt idx="856">
                  <c:v>48.737520397319201</c:v>
                </c:pt>
                <c:pt idx="857">
                  <c:v>48.729860145800302</c:v>
                </c:pt>
                <c:pt idx="858">
                  <c:v>48.722199894281502</c:v>
                </c:pt>
                <c:pt idx="859">
                  <c:v>48.714539642762702</c:v>
                </c:pt>
                <c:pt idx="860">
                  <c:v>48.706879391243902</c:v>
                </c:pt>
                <c:pt idx="861">
                  <c:v>48.699219139725002</c:v>
                </c:pt>
                <c:pt idx="862">
                  <c:v>48.691558888206202</c:v>
                </c:pt>
                <c:pt idx="863">
                  <c:v>48.683898636687402</c:v>
                </c:pt>
                <c:pt idx="864">
                  <c:v>48.676238385168503</c:v>
                </c:pt>
                <c:pt idx="865">
                  <c:v>48.668578133649703</c:v>
                </c:pt>
                <c:pt idx="866">
                  <c:v>48.660917882130903</c:v>
                </c:pt>
                <c:pt idx="867">
                  <c:v>48.653257630612103</c:v>
                </c:pt>
                <c:pt idx="868">
                  <c:v>48.645597379093203</c:v>
                </c:pt>
                <c:pt idx="869">
                  <c:v>48.637937127574403</c:v>
                </c:pt>
                <c:pt idx="870">
                  <c:v>48.630276876055603</c:v>
                </c:pt>
                <c:pt idx="871">
                  <c:v>48.622616624536803</c:v>
                </c:pt>
                <c:pt idx="872">
                  <c:v>48.614956373017897</c:v>
                </c:pt>
                <c:pt idx="873">
                  <c:v>48.607296121499097</c:v>
                </c:pt>
                <c:pt idx="874">
                  <c:v>48.599635869980297</c:v>
                </c:pt>
                <c:pt idx="875">
                  <c:v>48.591975618461397</c:v>
                </c:pt>
                <c:pt idx="876">
                  <c:v>48.584315366942597</c:v>
                </c:pt>
                <c:pt idx="877">
                  <c:v>48.576655115423797</c:v>
                </c:pt>
                <c:pt idx="878">
                  <c:v>44.440119295256302</c:v>
                </c:pt>
                <c:pt idx="879">
                  <c:v>44.432459043737502</c:v>
                </c:pt>
                <c:pt idx="880">
                  <c:v>44.424798792218702</c:v>
                </c:pt>
                <c:pt idx="881">
                  <c:v>44.417138540699803</c:v>
                </c:pt>
                <c:pt idx="882">
                  <c:v>44.409478289181003</c:v>
                </c:pt>
                <c:pt idx="883">
                  <c:v>44.401818037662203</c:v>
                </c:pt>
                <c:pt idx="884">
                  <c:v>44.394157786143303</c:v>
                </c:pt>
                <c:pt idx="885">
                  <c:v>44.386497534624503</c:v>
                </c:pt>
                <c:pt idx="886">
                  <c:v>44.378837283105703</c:v>
                </c:pt>
                <c:pt idx="887">
                  <c:v>44.371177031586797</c:v>
                </c:pt>
                <c:pt idx="888">
                  <c:v>44.363516780067997</c:v>
                </c:pt>
                <c:pt idx="889">
                  <c:v>44.355856528549197</c:v>
                </c:pt>
                <c:pt idx="890">
                  <c:v>44.348196277030397</c:v>
                </c:pt>
                <c:pt idx="891">
                  <c:v>44.340536025511497</c:v>
                </c:pt>
                <c:pt idx="892">
                  <c:v>44.332875773992697</c:v>
                </c:pt>
                <c:pt idx="893">
                  <c:v>44.325215522473897</c:v>
                </c:pt>
                <c:pt idx="894">
                  <c:v>44.317555270954998</c:v>
                </c:pt>
                <c:pt idx="895">
                  <c:v>44.309895019436198</c:v>
                </c:pt>
                <c:pt idx="896">
                  <c:v>44.302234767917398</c:v>
                </c:pt>
                <c:pt idx="897">
                  <c:v>44.294574516398598</c:v>
                </c:pt>
                <c:pt idx="898">
                  <c:v>44.286914264879698</c:v>
                </c:pt>
                <c:pt idx="899">
                  <c:v>44.279254013360898</c:v>
                </c:pt>
                <c:pt idx="900">
                  <c:v>44.271593761842098</c:v>
                </c:pt>
                <c:pt idx="901">
                  <c:v>44.263933510323199</c:v>
                </c:pt>
                <c:pt idx="902">
                  <c:v>44.256273258804399</c:v>
                </c:pt>
                <c:pt idx="903">
                  <c:v>44.248613007285599</c:v>
                </c:pt>
                <c:pt idx="904">
                  <c:v>44.240952755766799</c:v>
                </c:pt>
                <c:pt idx="905">
                  <c:v>44.233292504247899</c:v>
                </c:pt>
                <c:pt idx="906">
                  <c:v>44.225632252729099</c:v>
                </c:pt>
                <c:pt idx="907">
                  <c:v>44.217972001210299</c:v>
                </c:pt>
                <c:pt idx="908">
                  <c:v>44.2103117496914</c:v>
                </c:pt>
                <c:pt idx="909">
                  <c:v>44.2026514981726</c:v>
                </c:pt>
                <c:pt idx="910">
                  <c:v>44.1949912466538</c:v>
                </c:pt>
                <c:pt idx="911">
                  <c:v>44.187330995135</c:v>
                </c:pt>
                <c:pt idx="912">
                  <c:v>44.1796707436161</c:v>
                </c:pt>
                <c:pt idx="913">
                  <c:v>44.1720104920973</c:v>
                </c:pt>
                <c:pt idx="914">
                  <c:v>44.1643502405785</c:v>
                </c:pt>
                <c:pt idx="915">
                  <c:v>44.156689989059601</c:v>
                </c:pt>
                <c:pt idx="916">
                  <c:v>44.149029737540801</c:v>
                </c:pt>
                <c:pt idx="917">
                  <c:v>44.141369486022001</c:v>
                </c:pt>
                <c:pt idx="918">
                  <c:v>44.1337092345032</c:v>
                </c:pt>
                <c:pt idx="919">
                  <c:v>44.126048982984301</c:v>
                </c:pt>
                <c:pt idx="920">
                  <c:v>44.118388731465501</c:v>
                </c:pt>
                <c:pt idx="921">
                  <c:v>44.110728479946701</c:v>
                </c:pt>
                <c:pt idx="922">
                  <c:v>44.103068228427802</c:v>
                </c:pt>
                <c:pt idx="923">
                  <c:v>44.095407976909001</c:v>
                </c:pt>
                <c:pt idx="924">
                  <c:v>44.087747725390201</c:v>
                </c:pt>
                <c:pt idx="925">
                  <c:v>44.080087473871401</c:v>
                </c:pt>
                <c:pt idx="926">
                  <c:v>44.072427222352502</c:v>
                </c:pt>
                <c:pt idx="927">
                  <c:v>44.064766970833702</c:v>
                </c:pt>
                <c:pt idx="928">
                  <c:v>44.057106719314902</c:v>
                </c:pt>
                <c:pt idx="929">
                  <c:v>44.049446467796002</c:v>
                </c:pt>
                <c:pt idx="930">
                  <c:v>44.041786216277202</c:v>
                </c:pt>
                <c:pt idx="931">
                  <c:v>44.034125964758402</c:v>
                </c:pt>
                <c:pt idx="932">
                  <c:v>44.026465713239602</c:v>
                </c:pt>
                <c:pt idx="933">
                  <c:v>44.018805461720703</c:v>
                </c:pt>
                <c:pt idx="934">
                  <c:v>44.011145210201903</c:v>
                </c:pt>
                <c:pt idx="935">
                  <c:v>44.003484958683103</c:v>
                </c:pt>
                <c:pt idx="936">
                  <c:v>43.995824707164203</c:v>
                </c:pt>
                <c:pt idx="937">
                  <c:v>43.988164455645403</c:v>
                </c:pt>
                <c:pt idx="938">
                  <c:v>43.980504204126603</c:v>
                </c:pt>
                <c:pt idx="939">
                  <c:v>43.520889112996898</c:v>
                </c:pt>
                <c:pt idx="940">
                  <c:v>43.513228861477998</c:v>
                </c:pt>
                <c:pt idx="941">
                  <c:v>43.505568609959198</c:v>
                </c:pt>
                <c:pt idx="942">
                  <c:v>43.497908358440398</c:v>
                </c:pt>
                <c:pt idx="943">
                  <c:v>43.490248106921598</c:v>
                </c:pt>
                <c:pt idx="944">
                  <c:v>43.482587855402699</c:v>
                </c:pt>
                <c:pt idx="945">
                  <c:v>43.474927603883899</c:v>
                </c:pt>
                <c:pt idx="946">
                  <c:v>43.467267352365099</c:v>
                </c:pt>
                <c:pt idx="947">
                  <c:v>43.459607100846199</c:v>
                </c:pt>
                <c:pt idx="948">
                  <c:v>43.451946849327399</c:v>
                </c:pt>
                <c:pt idx="949">
                  <c:v>43.444286597808599</c:v>
                </c:pt>
                <c:pt idx="950">
                  <c:v>43.436626346289799</c:v>
                </c:pt>
                <c:pt idx="951">
                  <c:v>43.4289660947709</c:v>
                </c:pt>
                <c:pt idx="952">
                  <c:v>43.4213058432521</c:v>
                </c:pt>
                <c:pt idx="953">
                  <c:v>43.4136455917333</c:v>
                </c:pt>
                <c:pt idx="954">
                  <c:v>43.4059853402144</c:v>
                </c:pt>
                <c:pt idx="955">
                  <c:v>43.3983250886956</c:v>
                </c:pt>
                <c:pt idx="956">
                  <c:v>43.3906648371768</c:v>
                </c:pt>
                <c:pt idx="957">
                  <c:v>43.383004585658</c:v>
                </c:pt>
                <c:pt idx="958">
                  <c:v>43.375344334139101</c:v>
                </c:pt>
                <c:pt idx="959">
                  <c:v>43.367684082620301</c:v>
                </c:pt>
                <c:pt idx="960">
                  <c:v>43.3600238311015</c:v>
                </c:pt>
                <c:pt idx="961">
                  <c:v>43.352363579582601</c:v>
                </c:pt>
                <c:pt idx="962">
                  <c:v>43.344703328063801</c:v>
                </c:pt>
                <c:pt idx="963">
                  <c:v>43.337043076545001</c:v>
                </c:pt>
                <c:pt idx="964">
                  <c:v>43.329382825026102</c:v>
                </c:pt>
                <c:pt idx="965">
                  <c:v>43.321722573507301</c:v>
                </c:pt>
                <c:pt idx="966">
                  <c:v>43.314062321988501</c:v>
                </c:pt>
                <c:pt idx="967">
                  <c:v>43.306402070469701</c:v>
                </c:pt>
                <c:pt idx="968">
                  <c:v>43.298741818950802</c:v>
                </c:pt>
                <c:pt idx="969">
                  <c:v>43.291081567432002</c:v>
                </c:pt>
                <c:pt idx="970">
                  <c:v>43.283421315913202</c:v>
                </c:pt>
                <c:pt idx="971">
                  <c:v>43.275761064394302</c:v>
                </c:pt>
                <c:pt idx="972">
                  <c:v>43.268100812875502</c:v>
                </c:pt>
                <c:pt idx="973">
                  <c:v>43.260440561356702</c:v>
                </c:pt>
                <c:pt idx="974">
                  <c:v>43.252780309837902</c:v>
                </c:pt>
                <c:pt idx="975">
                  <c:v>43.245120058319003</c:v>
                </c:pt>
                <c:pt idx="976">
                  <c:v>43.237459806800203</c:v>
                </c:pt>
                <c:pt idx="977">
                  <c:v>43.229799555281403</c:v>
                </c:pt>
                <c:pt idx="978">
                  <c:v>43.222139303762503</c:v>
                </c:pt>
                <c:pt idx="979">
                  <c:v>43.214479052243703</c:v>
                </c:pt>
                <c:pt idx="980">
                  <c:v>43.206818800724903</c:v>
                </c:pt>
                <c:pt idx="981">
                  <c:v>43.199158549206103</c:v>
                </c:pt>
                <c:pt idx="982">
                  <c:v>43.191498297687197</c:v>
                </c:pt>
                <c:pt idx="983">
                  <c:v>43.183838046168397</c:v>
                </c:pt>
                <c:pt idx="984">
                  <c:v>43.176177794649597</c:v>
                </c:pt>
                <c:pt idx="985">
                  <c:v>43.168517543130797</c:v>
                </c:pt>
                <c:pt idx="986">
                  <c:v>43.160857291611897</c:v>
                </c:pt>
                <c:pt idx="987">
                  <c:v>43.153197040093097</c:v>
                </c:pt>
                <c:pt idx="988">
                  <c:v>43.145536788574297</c:v>
                </c:pt>
                <c:pt idx="989">
                  <c:v>43.137876537055398</c:v>
                </c:pt>
                <c:pt idx="990">
                  <c:v>43.130216285536598</c:v>
                </c:pt>
                <c:pt idx="991">
                  <c:v>43.122556034017798</c:v>
                </c:pt>
                <c:pt idx="992">
                  <c:v>43.114895782498998</c:v>
                </c:pt>
                <c:pt idx="993">
                  <c:v>43.107235530980098</c:v>
                </c:pt>
                <c:pt idx="994">
                  <c:v>43.099575279461298</c:v>
                </c:pt>
                <c:pt idx="995">
                  <c:v>43.091915027942498</c:v>
                </c:pt>
                <c:pt idx="996">
                  <c:v>43.084254776423599</c:v>
                </c:pt>
                <c:pt idx="997">
                  <c:v>43.076594524904799</c:v>
                </c:pt>
                <c:pt idx="998">
                  <c:v>43.068934273385999</c:v>
                </c:pt>
                <c:pt idx="999">
                  <c:v>43.061274021867199</c:v>
                </c:pt>
                <c:pt idx="1000">
                  <c:v>43.053613770348299</c:v>
                </c:pt>
                <c:pt idx="1001">
                  <c:v>43.045953518829499</c:v>
                </c:pt>
                <c:pt idx="1002">
                  <c:v>43.038293267310699</c:v>
                </c:pt>
                <c:pt idx="1003">
                  <c:v>43.0306330157918</c:v>
                </c:pt>
                <c:pt idx="1004">
                  <c:v>43.022972764273</c:v>
                </c:pt>
                <c:pt idx="1005">
                  <c:v>43.0153125127542</c:v>
                </c:pt>
                <c:pt idx="1006">
                  <c:v>43.0076522612354</c:v>
                </c:pt>
                <c:pt idx="1007">
                  <c:v>42.9999920097165</c:v>
                </c:pt>
                <c:pt idx="1008">
                  <c:v>42.9923317581977</c:v>
                </c:pt>
                <c:pt idx="1009">
                  <c:v>42.9846715066789</c:v>
                </c:pt>
                <c:pt idx="1010">
                  <c:v>38.388520595381699</c:v>
                </c:pt>
                <c:pt idx="1011">
                  <c:v>38.380860343862899</c:v>
                </c:pt>
                <c:pt idx="1012">
                  <c:v>38.373200092344</c:v>
                </c:pt>
                <c:pt idx="1013">
                  <c:v>38.3655398408252</c:v>
                </c:pt>
                <c:pt idx="1014">
                  <c:v>38.3578795893064</c:v>
                </c:pt>
                <c:pt idx="1015">
                  <c:v>38.3502193377875</c:v>
                </c:pt>
                <c:pt idx="1016">
                  <c:v>38.3425590862687</c:v>
                </c:pt>
                <c:pt idx="1017">
                  <c:v>38.3348988347499</c:v>
                </c:pt>
                <c:pt idx="1018">
                  <c:v>38.3272385832311</c:v>
                </c:pt>
                <c:pt idx="1019">
                  <c:v>38.319578331712201</c:v>
                </c:pt>
                <c:pt idx="1020">
                  <c:v>38.311918080193401</c:v>
                </c:pt>
                <c:pt idx="1021">
                  <c:v>38.304257828674601</c:v>
                </c:pt>
                <c:pt idx="1022">
                  <c:v>38.296597577155701</c:v>
                </c:pt>
                <c:pt idx="1023">
                  <c:v>38.288937325636901</c:v>
                </c:pt>
                <c:pt idx="1024">
                  <c:v>38.281277074118101</c:v>
                </c:pt>
                <c:pt idx="1025">
                  <c:v>38.273616822599301</c:v>
                </c:pt>
                <c:pt idx="1026">
                  <c:v>38.265956571080402</c:v>
                </c:pt>
                <c:pt idx="1027">
                  <c:v>38.258296319561602</c:v>
                </c:pt>
                <c:pt idx="1028">
                  <c:v>38.250636068042802</c:v>
                </c:pt>
                <c:pt idx="1029">
                  <c:v>38.242975816523902</c:v>
                </c:pt>
                <c:pt idx="1030">
                  <c:v>38.235315565005102</c:v>
                </c:pt>
                <c:pt idx="1031">
                  <c:v>38.227655313486302</c:v>
                </c:pt>
                <c:pt idx="1032">
                  <c:v>38.219995061967502</c:v>
                </c:pt>
                <c:pt idx="1033">
                  <c:v>38.212334810448603</c:v>
                </c:pt>
                <c:pt idx="1034">
                  <c:v>38.204674558929803</c:v>
                </c:pt>
                <c:pt idx="1035">
                  <c:v>38.197014307411003</c:v>
                </c:pt>
                <c:pt idx="1036">
                  <c:v>38.189354055892103</c:v>
                </c:pt>
                <c:pt idx="1037">
                  <c:v>38.181693804373303</c:v>
                </c:pt>
                <c:pt idx="1038">
                  <c:v>38.174033552854503</c:v>
                </c:pt>
                <c:pt idx="1039">
                  <c:v>38.166373301335597</c:v>
                </c:pt>
                <c:pt idx="1040">
                  <c:v>38.158713049816797</c:v>
                </c:pt>
                <c:pt idx="1041">
                  <c:v>38.151052798297997</c:v>
                </c:pt>
                <c:pt idx="1042">
                  <c:v>38.143392546779197</c:v>
                </c:pt>
                <c:pt idx="1043">
                  <c:v>38.135732295260297</c:v>
                </c:pt>
                <c:pt idx="1044">
                  <c:v>38.128072043741497</c:v>
                </c:pt>
                <c:pt idx="1045">
                  <c:v>38.120411792222697</c:v>
                </c:pt>
                <c:pt idx="1046">
                  <c:v>38.112751540703897</c:v>
                </c:pt>
                <c:pt idx="1047">
                  <c:v>38.105091289184998</c:v>
                </c:pt>
                <c:pt idx="1048">
                  <c:v>38.097431037666198</c:v>
                </c:pt>
                <c:pt idx="1049">
                  <c:v>38.089770786147398</c:v>
                </c:pt>
                <c:pt idx="1050">
                  <c:v>38.082110534628498</c:v>
                </c:pt>
                <c:pt idx="1051">
                  <c:v>38.074450283109698</c:v>
                </c:pt>
                <c:pt idx="1052">
                  <c:v>38.066790031590898</c:v>
                </c:pt>
                <c:pt idx="1053">
                  <c:v>38.059129780072098</c:v>
                </c:pt>
                <c:pt idx="1054">
                  <c:v>38.051469528553199</c:v>
                </c:pt>
                <c:pt idx="1055">
                  <c:v>38.043809277034399</c:v>
                </c:pt>
                <c:pt idx="1056">
                  <c:v>38.036149025515599</c:v>
                </c:pt>
                <c:pt idx="1057">
                  <c:v>38.028488773996699</c:v>
                </c:pt>
                <c:pt idx="1058">
                  <c:v>38.020828522477899</c:v>
                </c:pt>
                <c:pt idx="1059">
                  <c:v>38.013168270959099</c:v>
                </c:pt>
                <c:pt idx="1060">
                  <c:v>38.005508019440299</c:v>
                </c:pt>
                <c:pt idx="1061">
                  <c:v>37.9978477679214</c:v>
                </c:pt>
                <c:pt idx="1062">
                  <c:v>37.990187516402599</c:v>
                </c:pt>
                <c:pt idx="1063">
                  <c:v>37.982527264883799</c:v>
                </c:pt>
                <c:pt idx="1064">
                  <c:v>37.9748670133649</c:v>
                </c:pt>
                <c:pt idx="1065">
                  <c:v>37.9672067618461</c:v>
                </c:pt>
                <c:pt idx="1066">
                  <c:v>37.9595465103273</c:v>
                </c:pt>
                <c:pt idx="1067">
                  <c:v>37.9518862588084</c:v>
                </c:pt>
                <c:pt idx="1068">
                  <c:v>37.9442260072896</c:v>
                </c:pt>
                <c:pt idx="1069">
                  <c:v>37.9365657557708</c:v>
                </c:pt>
                <c:pt idx="1070">
                  <c:v>37.928905504252</c:v>
                </c:pt>
                <c:pt idx="1071">
                  <c:v>36.626662746051103</c:v>
                </c:pt>
                <c:pt idx="1072">
                  <c:v>36.619002494532303</c:v>
                </c:pt>
                <c:pt idx="1073">
                  <c:v>36.611342243013397</c:v>
                </c:pt>
                <c:pt idx="1074">
                  <c:v>36.603681991494597</c:v>
                </c:pt>
                <c:pt idx="1075">
                  <c:v>36.596021739975797</c:v>
                </c:pt>
                <c:pt idx="1076">
                  <c:v>36.588361488456997</c:v>
                </c:pt>
                <c:pt idx="1077">
                  <c:v>36.580701236938097</c:v>
                </c:pt>
                <c:pt idx="1078">
                  <c:v>36.573040985419297</c:v>
                </c:pt>
                <c:pt idx="1079">
                  <c:v>36.565380733900497</c:v>
                </c:pt>
                <c:pt idx="1080">
                  <c:v>36.557720482381598</c:v>
                </c:pt>
                <c:pt idx="1081">
                  <c:v>36.550060230862798</c:v>
                </c:pt>
                <c:pt idx="1082">
                  <c:v>36.542399979343998</c:v>
                </c:pt>
                <c:pt idx="1083">
                  <c:v>36.534739727825198</c:v>
                </c:pt>
                <c:pt idx="1084">
                  <c:v>36.527079476306298</c:v>
                </c:pt>
                <c:pt idx="1085">
                  <c:v>36.519419224787498</c:v>
                </c:pt>
                <c:pt idx="1086">
                  <c:v>36.511758973268698</c:v>
                </c:pt>
                <c:pt idx="1087">
                  <c:v>36.504098721749799</c:v>
                </c:pt>
                <c:pt idx="1088">
                  <c:v>36.496438470230999</c:v>
                </c:pt>
                <c:pt idx="1089">
                  <c:v>36.488778218712199</c:v>
                </c:pt>
                <c:pt idx="1090">
                  <c:v>36.481117967193398</c:v>
                </c:pt>
                <c:pt idx="1091">
                  <c:v>36.473457715674499</c:v>
                </c:pt>
                <c:pt idx="1092">
                  <c:v>36.465797464155699</c:v>
                </c:pt>
                <c:pt idx="1093">
                  <c:v>36.458137212636899</c:v>
                </c:pt>
                <c:pt idx="1094">
                  <c:v>36.450476961118</c:v>
                </c:pt>
                <c:pt idx="1095">
                  <c:v>36.442816709599199</c:v>
                </c:pt>
                <c:pt idx="1096">
                  <c:v>36.435156458080399</c:v>
                </c:pt>
                <c:pt idx="1097">
                  <c:v>36.427496206561599</c:v>
                </c:pt>
                <c:pt idx="1098">
                  <c:v>36.4198359550427</c:v>
                </c:pt>
                <c:pt idx="1099">
                  <c:v>36.4121757035239</c:v>
                </c:pt>
                <c:pt idx="1100">
                  <c:v>36.4045154520051</c:v>
                </c:pt>
                <c:pt idx="1101">
                  <c:v>36.3968552004862</c:v>
                </c:pt>
                <c:pt idx="1102">
                  <c:v>36.3891949489674</c:v>
                </c:pt>
                <c:pt idx="1103">
                  <c:v>36.3815346974486</c:v>
                </c:pt>
                <c:pt idx="1104">
                  <c:v>36.373874445929701</c:v>
                </c:pt>
                <c:pt idx="1105">
                  <c:v>36.366214194410901</c:v>
                </c:pt>
                <c:pt idx="1106">
                  <c:v>36.358553942892101</c:v>
                </c:pt>
                <c:pt idx="1107">
                  <c:v>36.350893691373301</c:v>
                </c:pt>
                <c:pt idx="1108">
                  <c:v>36.343233439854401</c:v>
                </c:pt>
                <c:pt idx="1109">
                  <c:v>36.335573188335601</c:v>
                </c:pt>
                <c:pt idx="1110">
                  <c:v>36.327912936816801</c:v>
                </c:pt>
                <c:pt idx="1111">
                  <c:v>36.320252685297902</c:v>
                </c:pt>
                <c:pt idx="1112">
                  <c:v>36.312592433779102</c:v>
                </c:pt>
                <c:pt idx="1113">
                  <c:v>36.304932182260302</c:v>
                </c:pt>
                <c:pt idx="1114">
                  <c:v>36.297271930741502</c:v>
                </c:pt>
                <c:pt idx="1115">
                  <c:v>36.289611679222602</c:v>
                </c:pt>
                <c:pt idx="1116">
                  <c:v>36.281951427703802</c:v>
                </c:pt>
                <c:pt idx="1117">
                  <c:v>36.274291176185002</c:v>
                </c:pt>
                <c:pt idx="1118">
                  <c:v>36.266630924666103</c:v>
                </c:pt>
                <c:pt idx="1119">
                  <c:v>36.258970673147303</c:v>
                </c:pt>
                <c:pt idx="1120">
                  <c:v>36.251310421628503</c:v>
                </c:pt>
                <c:pt idx="1121">
                  <c:v>36.243650170109703</c:v>
                </c:pt>
                <c:pt idx="1122">
                  <c:v>36.235989918590803</c:v>
                </c:pt>
                <c:pt idx="1123">
                  <c:v>36.228329667072003</c:v>
                </c:pt>
                <c:pt idx="1124">
                  <c:v>36.220669415553203</c:v>
                </c:pt>
                <c:pt idx="1125">
                  <c:v>36.213009164034403</c:v>
                </c:pt>
                <c:pt idx="1126">
                  <c:v>36.205348912515497</c:v>
                </c:pt>
                <c:pt idx="1127">
                  <c:v>36.197688660996697</c:v>
                </c:pt>
                <c:pt idx="1128">
                  <c:v>36.190028409477897</c:v>
                </c:pt>
                <c:pt idx="1129">
                  <c:v>36.182368157958997</c:v>
                </c:pt>
                <c:pt idx="1130">
                  <c:v>36.174707906440197</c:v>
                </c:pt>
                <c:pt idx="1131">
                  <c:v>36.167047654921397</c:v>
                </c:pt>
                <c:pt idx="1132">
                  <c:v>36.159387403402597</c:v>
                </c:pt>
                <c:pt idx="1133">
                  <c:v>36.151727151883698</c:v>
                </c:pt>
                <c:pt idx="1134">
                  <c:v>36.144066900364898</c:v>
                </c:pt>
                <c:pt idx="1135">
                  <c:v>36.136406648846098</c:v>
                </c:pt>
                <c:pt idx="1136">
                  <c:v>36.128746397327198</c:v>
                </c:pt>
                <c:pt idx="1137">
                  <c:v>36.121086145808398</c:v>
                </c:pt>
                <c:pt idx="1138">
                  <c:v>36.113425894289598</c:v>
                </c:pt>
                <c:pt idx="1139">
                  <c:v>36.105765642770699</c:v>
                </c:pt>
                <c:pt idx="1140">
                  <c:v>36.098105391251899</c:v>
                </c:pt>
                <c:pt idx="1141">
                  <c:v>36.090445139733099</c:v>
                </c:pt>
                <c:pt idx="1142">
                  <c:v>36.082784888214299</c:v>
                </c:pt>
                <c:pt idx="1143">
                  <c:v>36.075124636695399</c:v>
                </c:pt>
                <c:pt idx="1144">
                  <c:v>36.067464385176599</c:v>
                </c:pt>
                <c:pt idx="1145">
                  <c:v>36.059804133657799</c:v>
                </c:pt>
                <c:pt idx="1146">
                  <c:v>36.0521438821389</c:v>
                </c:pt>
                <c:pt idx="1147">
                  <c:v>36.0444836306201</c:v>
                </c:pt>
                <c:pt idx="1148">
                  <c:v>36.0368233791013</c:v>
                </c:pt>
                <c:pt idx="1149">
                  <c:v>36.0291631275825</c:v>
                </c:pt>
                <c:pt idx="1150">
                  <c:v>36.0215028760636</c:v>
                </c:pt>
                <c:pt idx="1151">
                  <c:v>36.0138426245448</c:v>
                </c:pt>
                <c:pt idx="1152">
                  <c:v>36.006182373026</c:v>
                </c:pt>
                <c:pt idx="1153">
                  <c:v>35.998522121507101</c:v>
                </c:pt>
                <c:pt idx="1154">
                  <c:v>35.990861869988301</c:v>
                </c:pt>
                <c:pt idx="1155">
                  <c:v>35.983201618469501</c:v>
                </c:pt>
                <c:pt idx="1156">
                  <c:v>35.975541366950701</c:v>
                </c:pt>
                <c:pt idx="1157">
                  <c:v>35.967881115431801</c:v>
                </c:pt>
                <c:pt idx="1158">
                  <c:v>35.960220863913001</c:v>
                </c:pt>
                <c:pt idx="1159">
                  <c:v>35.952560612394201</c:v>
                </c:pt>
                <c:pt idx="1160">
                  <c:v>35.944900360875302</c:v>
                </c:pt>
                <c:pt idx="1161">
                  <c:v>35.937240109356502</c:v>
                </c:pt>
                <c:pt idx="1162">
                  <c:v>35.929579857837702</c:v>
                </c:pt>
                <c:pt idx="1163">
                  <c:v>35.921919606318902</c:v>
                </c:pt>
                <c:pt idx="1164">
                  <c:v>35.914259354800002</c:v>
                </c:pt>
                <c:pt idx="1165">
                  <c:v>35.906599103281202</c:v>
                </c:pt>
                <c:pt idx="1166">
                  <c:v>35.898938851762402</c:v>
                </c:pt>
                <c:pt idx="1167">
                  <c:v>35.891278600243503</c:v>
                </c:pt>
                <c:pt idx="1168">
                  <c:v>35.883618348724703</c:v>
                </c:pt>
                <c:pt idx="1169">
                  <c:v>35.875958097205903</c:v>
                </c:pt>
                <c:pt idx="1170">
                  <c:v>35.868297845687103</c:v>
                </c:pt>
                <c:pt idx="1171">
                  <c:v>35.860637594168203</c:v>
                </c:pt>
                <c:pt idx="1172">
                  <c:v>34.8648048967205</c:v>
                </c:pt>
                <c:pt idx="1173">
                  <c:v>34.8571446452017</c:v>
                </c:pt>
                <c:pt idx="1174">
                  <c:v>34.8494843936829</c:v>
                </c:pt>
                <c:pt idx="1175">
                  <c:v>34.841824142164</c:v>
                </c:pt>
                <c:pt idx="1176">
                  <c:v>34.8341638906452</c:v>
                </c:pt>
                <c:pt idx="1177">
                  <c:v>34.8265036391264</c:v>
                </c:pt>
                <c:pt idx="1178">
                  <c:v>34.818843387607501</c:v>
                </c:pt>
                <c:pt idx="1179">
                  <c:v>34.811183136088701</c:v>
                </c:pt>
                <c:pt idx="1180">
                  <c:v>34.803522884569901</c:v>
                </c:pt>
                <c:pt idx="1181">
                  <c:v>34.795862633051001</c:v>
                </c:pt>
                <c:pt idx="1182">
                  <c:v>34.788202381532201</c:v>
                </c:pt>
                <c:pt idx="1183">
                  <c:v>34.780542130013401</c:v>
                </c:pt>
                <c:pt idx="1184">
                  <c:v>34.772881878494601</c:v>
                </c:pt>
                <c:pt idx="1185">
                  <c:v>34.765221626975702</c:v>
                </c:pt>
                <c:pt idx="1186">
                  <c:v>34.757561375456902</c:v>
                </c:pt>
                <c:pt idx="1187">
                  <c:v>34.749901123938102</c:v>
                </c:pt>
                <c:pt idx="1188">
                  <c:v>34.742240872419202</c:v>
                </c:pt>
                <c:pt idx="1189">
                  <c:v>34.734580620900402</c:v>
                </c:pt>
                <c:pt idx="1190">
                  <c:v>34.726920369381602</c:v>
                </c:pt>
                <c:pt idx="1191">
                  <c:v>34.719260117862802</c:v>
                </c:pt>
                <c:pt idx="1192">
                  <c:v>34.711599866343903</c:v>
                </c:pt>
                <c:pt idx="1193">
                  <c:v>34.703939614825103</c:v>
                </c:pt>
                <c:pt idx="1194">
                  <c:v>34.696279363306303</c:v>
                </c:pt>
                <c:pt idx="1195">
                  <c:v>34.688619111787403</c:v>
                </c:pt>
                <c:pt idx="1196">
                  <c:v>34.680958860268603</c:v>
                </c:pt>
                <c:pt idx="1197">
                  <c:v>34.673298608749803</c:v>
                </c:pt>
                <c:pt idx="1198">
                  <c:v>34.665638357231003</c:v>
                </c:pt>
                <c:pt idx="1199">
                  <c:v>34.657978105712097</c:v>
                </c:pt>
                <c:pt idx="1200">
                  <c:v>34.650317854193297</c:v>
                </c:pt>
                <c:pt idx="1201">
                  <c:v>34.642657602674497</c:v>
                </c:pt>
                <c:pt idx="1202">
                  <c:v>34.634997351155697</c:v>
                </c:pt>
                <c:pt idx="1203">
                  <c:v>34.627337099636797</c:v>
                </c:pt>
                <c:pt idx="1204">
                  <c:v>34.619676848117997</c:v>
                </c:pt>
                <c:pt idx="1205">
                  <c:v>34.612016596599197</c:v>
                </c:pt>
                <c:pt idx="1206">
                  <c:v>34.604356345080298</c:v>
                </c:pt>
                <c:pt idx="1207">
                  <c:v>34.596696093561498</c:v>
                </c:pt>
                <c:pt idx="1208">
                  <c:v>34.589035842042698</c:v>
                </c:pt>
                <c:pt idx="1209">
                  <c:v>34.581375590523898</c:v>
                </c:pt>
                <c:pt idx="1210">
                  <c:v>34.573715339004998</c:v>
                </c:pt>
                <c:pt idx="1211">
                  <c:v>34.566055087486198</c:v>
                </c:pt>
                <c:pt idx="1212">
                  <c:v>34.558394835967398</c:v>
                </c:pt>
                <c:pt idx="1213">
                  <c:v>34.550734584448499</c:v>
                </c:pt>
                <c:pt idx="1214">
                  <c:v>34.543074332929699</c:v>
                </c:pt>
                <c:pt idx="1215">
                  <c:v>34.535414081410899</c:v>
                </c:pt>
                <c:pt idx="1216">
                  <c:v>34.527753829891999</c:v>
                </c:pt>
                <c:pt idx="1217">
                  <c:v>34.520093578373199</c:v>
                </c:pt>
                <c:pt idx="1218">
                  <c:v>34.512433326854399</c:v>
                </c:pt>
                <c:pt idx="1219">
                  <c:v>34.504773075335599</c:v>
                </c:pt>
                <c:pt idx="1220">
                  <c:v>34.4971128238167</c:v>
                </c:pt>
                <c:pt idx="1221">
                  <c:v>34.4894525722979</c:v>
                </c:pt>
                <c:pt idx="1222">
                  <c:v>34.4817923207791</c:v>
                </c:pt>
                <c:pt idx="1223">
                  <c:v>34.4741320692602</c:v>
                </c:pt>
                <c:pt idx="1224">
                  <c:v>34.4664718177414</c:v>
                </c:pt>
                <c:pt idx="1225">
                  <c:v>34.4588115662226</c:v>
                </c:pt>
                <c:pt idx="1226">
                  <c:v>34.4511513147038</c:v>
                </c:pt>
                <c:pt idx="1227">
                  <c:v>34.443491063184901</c:v>
                </c:pt>
                <c:pt idx="1228">
                  <c:v>34.435830811666101</c:v>
                </c:pt>
                <c:pt idx="1229">
                  <c:v>34.428170560147301</c:v>
                </c:pt>
                <c:pt idx="1230">
                  <c:v>34.420510308628401</c:v>
                </c:pt>
                <c:pt idx="1231">
                  <c:v>34.412850057109601</c:v>
                </c:pt>
                <c:pt idx="1232">
                  <c:v>34.405189805590801</c:v>
                </c:pt>
                <c:pt idx="1233">
                  <c:v>34.397529554072001</c:v>
                </c:pt>
                <c:pt idx="1234">
                  <c:v>34.389869302553102</c:v>
                </c:pt>
                <c:pt idx="1235">
                  <c:v>34.382209051034302</c:v>
                </c:pt>
                <c:pt idx="1236">
                  <c:v>34.374548799515502</c:v>
                </c:pt>
                <c:pt idx="1237">
                  <c:v>34.366888547996602</c:v>
                </c:pt>
                <c:pt idx="1238">
                  <c:v>34.359228296477802</c:v>
                </c:pt>
                <c:pt idx="1239">
                  <c:v>34.351568044959002</c:v>
                </c:pt>
                <c:pt idx="1240">
                  <c:v>34.343907793440202</c:v>
                </c:pt>
                <c:pt idx="1241">
                  <c:v>34.336247541921303</c:v>
                </c:pt>
                <c:pt idx="1242">
                  <c:v>34.328587290402503</c:v>
                </c:pt>
                <c:pt idx="1243">
                  <c:v>34.320927038883703</c:v>
                </c:pt>
                <c:pt idx="1244">
                  <c:v>34.313266787364803</c:v>
                </c:pt>
                <c:pt idx="1245">
                  <c:v>34.305606535846003</c:v>
                </c:pt>
                <c:pt idx="1246">
                  <c:v>34.297946284327203</c:v>
                </c:pt>
                <c:pt idx="1247">
                  <c:v>34.290286032808403</c:v>
                </c:pt>
                <c:pt idx="1248">
                  <c:v>34.282625781289497</c:v>
                </c:pt>
                <c:pt idx="1249">
                  <c:v>34.274965529770697</c:v>
                </c:pt>
                <c:pt idx="1250">
                  <c:v>34.267305278251897</c:v>
                </c:pt>
                <c:pt idx="1251">
                  <c:v>34.259645026732997</c:v>
                </c:pt>
                <c:pt idx="1252">
                  <c:v>34.251984775214197</c:v>
                </c:pt>
                <c:pt idx="1253">
                  <c:v>34.244324523695397</c:v>
                </c:pt>
                <c:pt idx="1254">
                  <c:v>34.236664272176597</c:v>
                </c:pt>
                <c:pt idx="1255">
                  <c:v>34.229004020657698</c:v>
                </c:pt>
                <c:pt idx="1256">
                  <c:v>34.221343769138898</c:v>
                </c:pt>
                <c:pt idx="1257">
                  <c:v>34.213683517620098</c:v>
                </c:pt>
                <c:pt idx="1258">
                  <c:v>34.206023266101198</c:v>
                </c:pt>
                <c:pt idx="1259">
                  <c:v>34.198363014582398</c:v>
                </c:pt>
                <c:pt idx="1260">
                  <c:v>34.190702763063598</c:v>
                </c:pt>
                <c:pt idx="1261">
                  <c:v>34.183042511544798</c:v>
                </c:pt>
                <c:pt idx="1262">
                  <c:v>34.175382260025899</c:v>
                </c:pt>
                <c:pt idx="1263">
                  <c:v>32.873139501825101</c:v>
                </c:pt>
                <c:pt idx="1264">
                  <c:v>32.865479250306201</c:v>
                </c:pt>
                <c:pt idx="1265">
                  <c:v>32.857818998787401</c:v>
                </c:pt>
                <c:pt idx="1266">
                  <c:v>32.850158747268601</c:v>
                </c:pt>
                <c:pt idx="1267">
                  <c:v>32.842498495749702</c:v>
                </c:pt>
                <c:pt idx="1268">
                  <c:v>32.834838244230902</c:v>
                </c:pt>
                <c:pt idx="1269">
                  <c:v>32.827177992712102</c:v>
                </c:pt>
                <c:pt idx="1270">
                  <c:v>32.819517741193302</c:v>
                </c:pt>
                <c:pt idx="1271">
                  <c:v>32.811857489674402</c:v>
                </c:pt>
                <c:pt idx="1272">
                  <c:v>32.804197238155602</c:v>
                </c:pt>
                <c:pt idx="1273">
                  <c:v>32.796536986636802</c:v>
                </c:pt>
                <c:pt idx="1274">
                  <c:v>32.788876735117903</c:v>
                </c:pt>
                <c:pt idx="1275">
                  <c:v>32.781216483599103</c:v>
                </c:pt>
                <c:pt idx="1276">
                  <c:v>32.773556232080303</c:v>
                </c:pt>
                <c:pt idx="1277">
                  <c:v>32.765895980561503</c:v>
                </c:pt>
                <c:pt idx="1278">
                  <c:v>32.758235729042603</c:v>
                </c:pt>
                <c:pt idx="1279">
                  <c:v>32.750575477523803</c:v>
                </c:pt>
                <c:pt idx="1280">
                  <c:v>32.742915226005003</c:v>
                </c:pt>
                <c:pt idx="1281">
                  <c:v>32.735254974486097</c:v>
                </c:pt>
                <c:pt idx="1282">
                  <c:v>32.727594722967297</c:v>
                </c:pt>
                <c:pt idx="1283">
                  <c:v>32.719934471448497</c:v>
                </c:pt>
                <c:pt idx="1284">
                  <c:v>32.712274219929697</c:v>
                </c:pt>
                <c:pt idx="1285">
                  <c:v>32.704613968410797</c:v>
                </c:pt>
                <c:pt idx="1286">
                  <c:v>32.696953716891997</c:v>
                </c:pt>
                <c:pt idx="1287">
                  <c:v>32.689293465373197</c:v>
                </c:pt>
                <c:pt idx="1288">
                  <c:v>32.681633213854298</c:v>
                </c:pt>
                <c:pt idx="1289">
                  <c:v>32.673972962335498</c:v>
                </c:pt>
                <c:pt idx="1290">
                  <c:v>32.666312710816698</c:v>
                </c:pt>
                <c:pt idx="1291">
                  <c:v>32.658652459297898</c:v>
                </c:pt>
                <c:pt idx="1292">
                  <c:v>32.650992207778998</c:v>
                </c:pt>
                <c:pt idx="1293">
                  <c:v>32.643331956260198</c:v>
                </c:pt>
                <c:pt idx="1294">
                  <c:v>32.635671704741398</c:v>
                </c:pt>
                <c:pt idx="1295">
                  <c:v>32.628011453222499</c:v>
                </c:pt>
                <c:pt idx="1296">
                  <c:v>32.620351201703699</c:v>
                </c:pt>
                <c:pt idx="1297">
                  <c:v>32.612690950184898</c:v>
                </c:pt>
                <c:pt idx="1298">
                  <c:v>32.605030698666098</c:v>
                </c:pt>
                <c:pt idx="1299">
                  <c:v>32.597370447147199</c:v>
                </c:pt>
                <c:pt idx="1300">
                  <c:v>32.589710195628399</c:v>
                </c:pt>
                <c:pt idx="1301">
                  <c:v>32.582049944109599</c:v>
                </c:pt>
                <c:pt idx="1302">
                  <c:v>32.574389692590699</c:v>
                </c:pt>
                <c:pt idx="1303">
                  <c:v>32.566729441071899</c:v>
                </c:pt>
                <c:pt idx="1304">
                  <c:v>32.559069189553099</c:v>
                </c:pt>
                <c:pt idx="1305">
                  <c:v>32.551408938034299</c:v>
                </c:pt>
                <c:pt idx="1306">
                  <c:v>32.5437486865154</c:v>
                </c:pt>
                <c:pt idx="1307">
                  <c:v>32.5360884349966</c:v>
                </c:pt>
                <c:pt idx="1308">
                  <c:v>32.5284281834778</c:v>
                </c:pt>
                <c:pt idx="1309">
                  <c:v>32.5207679319589</c:v>
                </c:pt>
                <c:pt idx="1310">
                  <c:v>32.5131076804401</c:v>
                </c:pt>
                <c:pt idx="1311">
                  <c:v>32.5054474289213</c:v>
                </c:pt>
                <c:pt idx="1312">
                  <c:v>32.4977871774025</c:v>
                </c:pt>
                <c:pt idx="1313">
                  <c:v>32.490126925883601</c:v>
                </c:pt>
                <c:pt idx="1314">
                  <c:v>32.482466674364801</c:v>
                </c:pt>
                <c:pt idx="1315">
                  <c:v>32.474806422846001</c:v>
                </c:pt>
                <c:pt idx="1316">
                  <c:v>32.467146171327101</c:v>
                </c:pt>
                <c:pt idx="1317">
                  <c:v>32.459485919808301</c:v>
                </c:pt>
                <c:pt idx="1318">
                  <c:v>32.451825668289501</c:v>
                </c:pt>
                <c:pt idx="1319">
                  <c:v>32.444165416770701</c:v>
                </c:pt>
                <c:pt idx="1320">
                  <c:v>32.436505165251802</c:v>
                </c:pt>
                <c:pt idx="1321">
                  <c:v>32.428844913733002</c:v>
                </c:pt>
                <c:pt idx="1322">
                  <c:v>32.421184662214202</c:v>
                </c:pt>
                <c:pt idx="1323">
                  <c:v>32.413524410695302</c:v>
                </c:pt>
                <c:pt idx="1324">
                  <c:v>32.405864159176502</c:v>
                </c:pt>
                <c:pt idx="1325">
                  <c:v>32.398203907657702</c:v>
                </c:pt>
                <c:pt idx="1326">
                  <c:v>32.390543656138902</c:v>
                </c:pt>
                <c:pt idx="1327">
                  <c:v>32.382883404620003</c:v>
                </c:pt>
                <c:pt idx="1328">
                  <c:v>32.375223153101203</c:v>
                </c:pt>
                <c:pt idx="1329">
                  <c:v>32.367562901582403</c:v>
                </c:pt>
                <c:pt idx="1330">
                  <c:v>32.359902650063503</c:v>
                </c:pt>
                <c:pt idx="1331">
                  <c:v>32.352242398544703</c:v>
                </c:pt>
                <c:pt idx="1332">
                  <c:v>32.344582147025903</c:v>
                </c:pt>
                <c:pt idx="1333">
                  <c:v>32.336921895507103</c:v>
                </c:pt>
                <c:pt idx="1334">
                  <c:v>32.329261643988197</c:v>
                </c:pt>
                <c:pt idx="1335">
                  <c:v>32.321601392469397</c:v>
                </c:pt>
                <c:pt idx="1336">
                  <c:v>32.313941140950597</c:v>
                </c:pt>
                <c:pt idx="1337">
                  <c:v>32.306280889431697</c:v>
                </c:pt>
                <c:pt idx="1338">
                  <c:v>32.298620637912897</c:v>
                </c:pt>
                <c:pt idx="1339">
                  <c:v>32.290960386394097</c:v>
                </c:pt>
                <c:pt idx="1340">
                  <c:v>32.283300134875297</c:v>
                </c:pt>
                <c:pt idx="1341">
                  <c:v>32.275639883356398</c:v>
                </c:pt>
                <c:pt idx="1342">
                  <c:v>32.267979631837598</c:v>
                </c:pt>
                <c:pt idx="1343">
                  <c:v>32.260319380318798</c:v>
                </c:pt>
                <c:pt idx="1344">
                  <c:v>32.252659128799898</c:v>
                </c:pt>
                <c:pt idx="1345">
                  <c:v>32.244998877281098</c:v>
                </c:pt>
                <c:pt idx="1346">
                  <c:v>32.237338625762298</c:v>
                </c:pt>
                <c:pt idx="1347">
                  <c:v>32.229678374243498</c:v>
                </c:pt>
                <c:pt idx="1348">
                  <c:v>32.222018122724599</c:v>
                </c:pt>
                <c:pt idx="1349">
                  <c:v>32.214357871205799</c:v>
                </c:pt>
                <c:pt idx="1350">
                  <c:v>32.206697619686999</c:v>
                </c:pt>
                <c:pt idx="1351">
                  <c:v>32.199037368168099</c:v>
                </c:pt>
                <c:pt idx="1352">
                  <c:v>32.191377116649299</c:v>
                </c:pt>
                <c:pt idx="1353">
                  <c:v>32.183716865130499</c:v>
                </c:pt>
                <c:pt idx="1354">
                  <c:v>32.176056613611699</c:v>
                </c:pt>
                <c:pt idx="1355">
                  <c:v>32.1683963620928</c:v>
                </c:pt>
                <c:pt idx="1356">
                  <c:v>32.160736110574</c:v>
                </c:pt>
                <c:pt idx="1357">
                  <c:v>32.1530758590552</c:v>
                </c:pt>
                <c:pt idx="1358">
                  <c:v>32.1454156075363</c:v>
                </c:pt>
                <c:pt idx="1359">
                  <c:v>32.1377553560175</c:v>
                </c:pt>
                <c:pt idx="1360">
                  <c:v>32.1300951044987</c:v>
                </c:pt>
                <c:pt idx="1361">
                  <c:v>32.1224348529799</c:v>
                </c:pt>
                <c:pt idx="1362">
                  <c:v>32.114774601461001</c:v>
                </c:pt>
                <c:pt idx="1363">
                  <c:v>32.107114349942201</c:v>
                </c:pt>
                <c:pt idx="1364">
                  <c:v>32.099454098423401</c:v>
                </c:pt>
                <c:pt idx="1365">
                  <c:v>32.091793846904501</c:v>
                </c:pt>
                <c:pt idx="1366">
                  <c:v>32.084133595385701</c:v>
                </c:pt>
                <c:pt idx="1367">
                  <c:v>32.076473343866901</c:v>
                </c:pt>
                <c:pt idx="1368">
                  <c:v>32.068813092348101</c:v>
                </c:pt>
                <c:pt idx="1369">
                  <c:v>32.061152840829202</c:v>
                </c:pt>
                <c:pt idx="1370">
                  <c:v>32.053492589310402</c:v>
                </c:pt>
                <c:pt idx="1371">
                  <c:v>32.045832337791602</c:v>
                </c:pt>
                <c:pt idx="1372">
                  <c:v>32.038172086272702</c:v>
                </c:pt>
                <c:pt idx="1373">
                  <c:v>32.030511834753902</c:v>
                </c:pt>
                <c:pt idx="1374">
                  <c:v>32.022851583235102</c:v>
                </c:pt>
                <c:pt idx="1375">
                  <c:v>32.015191331716302</c:v>
                </c:pt>
                <c:pt idx="1376">
                  <c:v>32.007531080197403</c:v>
                </c:pt>
                <c:pt idx="1377">
                  <c:v>31.999870828678599</c:v>
                </c:pt>
                <c:pt idx="1378">
                  <c:v>31.992210577159799</c:v>
                </c:pt>
                <c:pt idx="1379">
                  <c:v>31.9845503256409</c:v>
                </c:pt>
                <c:pt idx="1380">
                  <c:v>31.9768900741221</c:v>
                </c:pt>
                <c:pt idx="1381">
                  <c:v>31.9692298226033</c:v>
                </c:pt>
                <c:pt idx="1382">
                  <c:v>31.9615695710845</c:v>
                </c:pt>
                <c:pt idx="1383">
                  <c:v>31.9539093195656</c:v>
                </c:pt>
                <c:pt idx="1384">
                  <c:v>31.9462490680468</c:v>
                </c:pt>
                <c:pt idx="1385">
                  <c:v>31.938588816528</c:v>
                </c:pt>
                <c:pt idx="1386">
                  <c:v>31.930928565009101</c:v>
                </c:pt>
                <c:pt idx="1387">
                  <c:v>31.923268313490301</c:v>
                </c:pt>
                <c:pt idx="1388">
                  <c:v>31.915608061971501</c:v>
                </c:pt>
                <c:pt idx="1389">
                  <c:v>31.907947810452601</c:v>
                </c:pt>
                <c:pt idx="1390">
                  <c:v>31.900287558933801</c:v>
                </c:pt>
                <c:pt idx="1391">
                  <c:v>31.892627307415001</c:v>
                </c:pt>
                <c:pt idx="1392">
                  <c:v>31.884967055896201</c:v>
                </c:pt>
                <c:pt idx="1393">
                  <c:v>31.877306804377302</c:v>
                </c:pt>
                <c:pt idx="1394">
                  <c:v>31.869646552858502</c:v>
                </c:pt>
                <c:pt idx="1395">
                  <c:v>31.861986301339702</c:v>
                </c:pt>
                <c:pt idx="1396">
                  <c:v>31.854326049820902</c:v>
                </c:pt>
                <c:pt idx="1397">
                  <c:v>31.846665798301999</c:v>
                </c:pt>
                <c:pt idx="1398">
                  <c:v>31.839005546783198</c:v>
                </c:pt>
                <c:pt idx="1399">
                  <c:v>31.831345295264398</c:v>
                </c:pt>
                <c:pt idx="1400">
                  <c:v>31.823685043745499</c:v>
                </c:pt>
                <c:pt idx="1401">
                  <c:v>31.816024792226699</c:v>
                </c:pt>
                <c:pt idx="1402">
                  <c:v>31.808364540707899</c:v>
                </c:pt>
                <c:pt idx="1403">
                  <c:v>31.800704289189099</c:v>
                </c:pt>
                <c:pt idx="1404">
                  <c:v>31.793044037670199</c:v>
                </c:pt>
                <c:pt idx="1405">
                  <c:v>31.785383786151399</c:v>
                </c:pt>
                <c:pt idx="1406">
                  <c:v>31.777723534632599</c:v>
                </c:pt>
                <c:pt idx="1407">
                  <c:v>31.7700632831137</c:v>
                </c:pt>
                <c:pt idx="1408">
                  <c:v>31.7624030315949</c:v>
                </c:pt>
                <c:pt idx="1409">
                  <c:v>31.7547427800761</c:v>
                </c:pt>
                <c:pt idx="1410">
                  <c:v>31.7470825285573</c:v>
                </c:pt>
                <c:pt idx="1411">
                  <c:v>31.7394222770384</c:v>
                </c:pt>
                <c:pt idx="1412">
                  <c:v>31.7317620255196</c:v>
                </c:pt>
                <c:pt idx="1413">
                  <c:v>31.7241017740008</c:v>
                </c:pt>
                <c:pt idx="1414">
                  <c:v>31.716441522481901</c:v>
                </c:pt>
                <c:pt idx="1415">
                  <c:v>31.708781270963101</c:v>
                </c:pt>
                <c:pt idx="1416">
                  <c:v>31.701121019444301</c:v>
                </c:pt>
                <c:pt idx="1417">
                  <c:v>31.693460767925501</c:v>
                </c:pt>
                <c:pt idx="1418">
                  <c:v>31.685800516406601</c:v>
                </c:pt>
                <c:pt idx="1419">
                  <c:v>31.678140264887801</c:v>
                </c:pt>
                <c:pt idx="1420">
                  <c:v>31.670480013369001</c:v>
                </c:pt>
                <c:pt idx="1421">
                  <c:v>31.662819761850098</c:v>
                </c:pt>
                <c:pt idx="1422">
                  <c:v>31.655159510331298</c:v>
                </c:pt>
                <c:pt idx="1423">
                  <c:v>31.647499258812498</c:v>
                </c:pt>
                <c:pt idx="1424">
                  <c:v>29.962243924670201</c:v>
                </c:pt>
                <c:pt idx="1425">
                  <c:v>29.954583673151301</c:v>
                </c:pt>
                <c:pt idx="1426">
                  <c:v>29.946923421632501</c:v>
                </c:pt>
                <c:pt idx="1427">
                  <c:v>29.939263170113701</c:v>
                </c:pt>
                <c:pt idx="1428">
                  <c:v>29.931602918594901</c:v>
                </c:pt>
                <c:pt idx="1429">
                  <c:v>29.923942667075998</c:v>
                </c:pt>
                <c:pt idx="1430">
                  <c:v>29.916282415557198</c:v>
                </c:pt>
                <c:pt idx="1431">
                  <c:v>29.908622164038398</c:v>
                </c:pt>
                <c:pt idx="1432">
                  <c:v>29.900961912519598</c:v>
                </c:pt>
                <c:pt idx="1433">
                  <c:v>29.893301661000699</c:v>
                </c:pt>
                <c:pt idx="1434">
                  <c:v>29.885641409481899</c:v>
                </c:pt>
                <c:pt idx="1435">
                  <c:v>29.877981157963099</c:v>
                </c:pt>
                <c:pt idx="1436">
                  <c:v>29.870320906444199</c:v>
                </c:pt>
                <c:pt idx="1437">
                  <c:v>29.862660654925399</c:v>
                </c:pt>
                <c:pt idx="1438">
                  <c:v>29.855000403406599</c:v>
                </c:pt>
                <c:pt idx="1439">
                  <c:v>29.847340151887799</c:v>
                </c:pt>
                <c:pt idx="1440">
                  <c:v>29.8396799003689</c:v>
                </c:pt>
                <c:pt idx="1441">
                  <c:v>29.8320196488501</c:v>
                </c:pt>
                <c:pt idx="1442">
                  <c:v>29.8243593973313</c:v>
                </c:pt>
                <c:pt idx="1443">
                  <c:v>29.8166991458124</c:v>
                </c:pt>
                <c:pt idx="1444">
                  <c:v>29.8090388942936</c:v>
                </c:pt>
                <c:pt idx="1445">
                  <c:v>29.8013786427748</c:v>
                </c:pt>
                <c:pt idx="1446">
                  <c:v>29.793718391255901</c:v>
                </c:pt>
                <c:pt idx="1447">
                  <c:v>29.786058139737101</c:v>
                </c:pt>
                <c:pt idx="1448">
                  <c:v>29.778397888218301</c:v>
                </c:pt>
                <c:pt idx="1449">
                  <c:v>29.770737636699501</c:v>
                </c:pt>
                <c:pt idx="1450">
                  <c:v>29.763077385180601</c:v>
                </c:pt>
                <c:pt idx="1451">
                  <c:v>29.755417133661801</c:v>
                </c:pt>
                <c:pt idx="1452">
                  <c:v>29.747756882143001</c:v>
                </c:pt>
                <c:pt idx="1453">
                  <c:v>29.740096630624102</c:v>
                </c:pt>
                <c:pt idx="1454">
                  <c:v>29.732436379105302</c:v>
                </c:pt>
                <c:pt idx="1455">
                  <c:v>29.724776127586502</c:v>
                </c:pt>
                <c:pt idx="1456">
                  <c:v>29.717115876067702</c:v>
                </c:pt>
                <c:pt idx="1457">
                  <c:v>29.709455624548799</c:v>
                </c:pt>
                <c:pt idx="1458">
                  <c:v>29.701795373029999</c:v>
                </c:pt>
                <c:pt idx="1459">
                  <c:v>29.694135121511199</c:v>
                </c:pt>
                <c:pt idx="1460">
                  <c:v>29.686474869992299</c:v>
                </c:pt>
                <c:pt idx="1461">
                  <c:v>29.678814618473499</c:v>
                </c:pt>
                <c:pt idx="1462">
                  <c:v>29.671154366954699</c:v>
                </c:pt>
                <c:pt idx="1463">
                  <c:v>29.663494115435899</c:v>
                </c:pt>
                <c:pt idx="1464">
                  <c:v>29.655833863917</c:v>
                </c:pt>
                <c:pt idx="1465">
                  <c:v>29.6481736123982</c:v>
                </c:pt>
                <c:pt idx="1466">
                  <c:v>29.6405133608794</c:v>
                </c:pt>
                <c:pt idx="1467">
                  <c:v>29.6328531093605</c:v>
                </c:pt>
                <c:pt idx="1468">
                  <c:v>29.6251928578417</c:v>
                </c:pt>
                <c:pt idx="1469">
                  <c:v>29.6175326063229</c:v>
                </c:pt>
                <c:pt idx="1470">
                  <c:v>29.6098723548041</c:v>
                </c:pt>
                <c:pt idx="1471">
                  <c:v>29.602212103285201</c:v>
                </c:pt>
                <c:pt idx="1472">
                  <c:v>29.594551851766401</c:v>
                </c:pt>
                <c:pt idx="1473">
                  <c:v>29.586891600247601</c:v>
                </c:pt>
                <c:pt idx="1474">
                  <c:v>29.579231348728701</c:v>
                </c:pt>
                <c:pt idx="1475">
                  <c:v>29.119616257598999</c:v>
                </c:pt>
                <c:pt idx="1476">
                  <c:v>29.111956006080199</c:v>
                </c:pt>
                <c:pt idx="1477">
                  <c:v>29.104295754561399</c:v>
                </c:pt>
                <c:pt idx="1478">
                  <c:v>29.096635503042499</c:v>
                </c:pt>
                <c:pt idx="1479">
                  <c:v>29.088975251523699</c:v>
                </c:pt>
                <c:pt idx="1480">
                  <c:v>29.081315000004899</c:v>
                </c:pt>
                <c:pt idx="1481">
                  <c:v>29.073654748486099</c:v>
                </c:pt>
                <c:pt idx="1482">
                  <c:v>29.0659944969672</c:v>
                </c:pt>
                <c:pt idx="1483">
                  <c:v>29.0583342454484</c:v>
                </c:pt>
                <c:pt idx="1484">
                  <c:v>29.0506739939296</c:v>
                </c:pt>
                <c:pt idx="1485">
                  <c:v>29.0430137424107</c:v>
                </c:pt>
                <c:pt idx="1486">
                  <c:v>29.0353534908919</c:v>
                </c:pt>
                <c:pt idx="1487">
                  <c:v>29.0276932393731</c:v>
                </c:pt>
                <c:pt idx="1488">
                  <c:v>29.0200329878543</c:v>
                </c:pt>
                <c:pt idx="1489">
                  <c:v>29.012372736335401</c:v>
                </c:pt>
                <c:pt idx="1490">
                  <c:v>29.004712484816601</c:v>
                </c:pt>
                <c:pt idx="1491">
                  <c:v>28.997052233297801</c:v>
                </c:pt>
                <c:pt idx="1492">
                  <c:v>28.989391981778901</c:v>
                </c:pt>
                <c:pt idx="1493">
                  <c:v>28.981731730260101</c:v>
                </c:pt>
                <c:pt idx="1494">
                  <c:v>28.974071478741301</c:v>
                </c:pt>
                <c:pt idx="1495">
                  <c:v>28.966411227222501</c:v>
                </c:pt>
                <c:pt idx="1496">
                  <c:v>28.958750975703602</c:v>
                </c:pt>
                <c:pt idx="1497">
                  <c:v>28.951090724184802</c:v>
                </c:pt>
                <c:pt idx="1498">
                  <c:v>28.943430472666002</c:v>
                </c:pt>
                <c:pt idx="1499">
                  <c:v>28.935770221147099</c:v>
                </c:pt>
                <c:pt idx="1500">
                  <c:v>28.928109969628299</c:v>
                </c:pt>
                <c:pt idx="1501">
                  <c:v>28.920449718109499</c:v>
                </c:pt>
                <c:pt idx="1502">
                  <c:v>28.912789466590699</c:v>
                </c:pt>
                <c:pt idx="1503">
                  <c:v>28.905129215071799</c:v>
                </c:pt>
                <c:pt idx="1504">
                  <c:v>28.897468963552999</c:v>
                </c:pt>
                <c:pt idx="1505">
                  <c:v>28.889808712034199</c:v>
                </c:pt>
                <c:pt idx="1506">
                  <c:v>28.8821484605153</c:v>
                </c:pt>
                <c:pt idx="1507">
                  <c:v>28.8744882089965</c:v>
                </c:pt>
                <c:pt idx="1508">
                  <c:v>28.8668279574777</c:v>
                </c:pt>
                <c:pt idx="1509">
                  <c:v>28.8591677059589</c:v>
                </c:pt>
                <c:pt idx="1510">
                  <c:v>28.85150745444</c:v>
                </c:pt>
                <c:pt idx="1511">
                  <c:v>28.8438472029212</c:v>
                </c:pt>
                <c:pt idx="1512">
                  <c:v>28.8361869514024</c:v>
                </c:pt>
                <c:pt idx="1513">
                  <c:v>28.828526699883501</c:v>
                </c:pt>
                <c:pt idx="1514">
                  <c:v>28.820866448364701</c:v>
                </c:pt>
                <c:pt idx="1515">
                  <c:v>28.813206196845901</c:v>
                </c:pt>
                <c:pt idx="1516">
                  <c:v>28.353591105716198</c:v>
                </c:pt>
                <c:pt idx="1517">
                  <c:v>28.345930854197299</c:v>
                </c:pt>
                <c:pt idx="1518">
                  <c:v>28.338270602678499</c:v>
                </c:pt>
                <c:pt idx="1519">
                  <c:v>28.330610351159699</c:v>
                </c:pt>
                <c:pt idx="1520">
                  <c:v>28.322950099640899</c:v>
                </c:pt>
                <c:pt idx="1521">
                  <c:v>28.315289848121999</c:v>
                </c:pt>
                <c:pt idx="1522">
                  <c:v>28.307629596603199</c:v>
                </c:pt>
                <c:pt idx="1523">
                  <c:v>28.299969345084399</c:v>
                </c:pt>
                <c:pt idx="1524">
                  <c:v>28.2923090935655</c:v>
                </c:pt>
                <c:pt idx="1525">
                  <c:v>28.2846488420467</c:v>
                </c:pt>
                <c:pt idx="1526">
                  <c:v>28.2769885905279</c:v>
                </c:pt>
                <c:pt idx="1527">
                  <c:v>28.2693283390091</c:v>
                </c:pt>
                <c:pt idx="1528">
                  <c:v>28.2616680874902</c:v>
                </c:pt>
                <c:pt idx="1529">
                  <c:v>28.2540078359714</c:v>
                </c:pt>
                <c:pt idx="1530">
                  <c:v>28.2463475844526</c:v>
                </c:pt>
                <c:pt idx="1531">
                  <c:v>28.238687332933701</c:v>
                </c:pt>
                <c:pt idx="1532">
                  <c:v>28.231027081414901</c:v>
                </c:pt>
                <c:pt idx="1533">
                  <c:v>28.223366829896101</c:v>
                </c:pt>
                <c:pt idx="1534">
                  <c:v>28.215706578377201</c:v>
                </c:pt>
                <c:pt idx="1535">
                  <c:v>28.208046326858401</c:v>
                </c:pt>
                <c:pt idx="1536">
                  <c:v>28.200386075339601</c:v>
                </c:pt>
                <c:pt idx="1537">
                  <c:v>28.192725823820801</c:v>
                </c:pt>
                <c:pt idx="1538">
                  <c:v>28.185065572301902</c:v>
                </c:pt>
                <c:pt idx="1539">
                  <c:v>28.177405320783102</c:v>
                </c:pt>
                <c:pt idx="1540">
                  <c:v>28.169745069264302</c:v>
                </c:pt>
                <c:pt idx="1541">
                  <c:v>28.162084817745399</c:v>
                </c:pt>
                <c:pt idx="1542">
                  <c:v>28.154424566226599</c:v>
                </c:pt>
                <c:pt idx="1543">
                  <c:v>28.146764314707799</c:v>
                </c:pt>
                <c:pt idx="1544">
                  <c:v>28.139104063188999</c:v>
                </c:pt>
                <c:pt idx="1545">
                  <c:v>28.131443811670099</c:v>
                </c:pt>
                <c:pt idx="1546">
                  <c:v>28.123783560151299</c:v>
                </c:pt>
                <c:pt idx="1547">
                  <c:v>28.116123308632499</c:v>
                </c:pt>
                <c:pt idx="1548">
                  <c:v>28.1084630571136</c:v>
                </c:pt>
                <c:pt idx="1549">
                  <c:v>28.1008028055948</c:v>
                </c:pt>
                <c:pt idx="1550">
                  <c:v>28.093142554076</c:v>
                </c:pt>
                <c:pt idx="1551">
                  <c:v>28.0854823025572</c:v>
                </c:pt>
                <c:pt idx="1552">
                  <c:v>28.0778220510383</c:v>
                </c:pt>
                <c:pt idx="1553">
                  <c:v>28.0701617995195</c:v>
                </c:pt>
                <c:pt idx="1554">
                  <c:v>28.0625015480007</c:v>
                </c:pt>
                <c:pt idx="1555">
                  <c:v>28.054841296481801</c:v>
                </c:pt>
                <c:pt idx="1556">
                  <c:v>28.047181044963001</c:v>
                </c:pt>
                <c:pt idx="1557">
                  <c:v>27.6641684690216</c:v>
                </c:pt>
                <c:pt idx="1558">
                  <c:v>27.6565082175028</c:v>
                </c:pt>
                <c:pt idx="1559">
                  <c:v>27.648847965983901</c:v>
                </c:pt>
                <c:pt idx="1560">
                  <c:v>27.641187714465101</c:v>
                </c:pt>
                <c:pt idx="1561">
                  <c:v>27.633527462946301</c:v>
                </c:pt>
                <c:pt idx="1562">
                  <c:v>27.625867211427401</c:v>
                </c:pt>
                <c:pt idx="1563">
                  <c:v>27.618206959908601</c:v>
                </c:pt>
                <c:pt idx="1564">
                  <c:v>27.610546708389801</c:v>
                </c:pt>
                <c:pt idx="1565">
                  <c:v>27.602886456871001</c:v>
                </c:pt>
                <c:pt idx="1566">
                  <c:v>27.595226205352098</c:v>
                </c:pt>
                <c:pt idx="1567">
                  <c:v>27.587565953833298</c:v>
                </c:pt>
                <c:pt idx="1568">
                  <c:v>27.579905702314498</c:v>
                </c:pt>
                <c:pt idx="1569">
                  <c:v>27.572245450795599</c:v>
                </c:pt>
                <c:pt idx="1570">
                  <c:v>27.564585199276799</c:v>
                </c:pt>
                <c:pt idx="1571">
                  <c:v>27.556924947757999</c:v>
                </c:pt>
                <c:pt idx="1572">
                  <c:v>27.549264696239199</c:v>
                </c:pt>
                <c:pt idx="1573">
                  <c:v>27.541604444720299</c:v>
                </c:pt>
                <c:pt idx="1574">
                  <c:v>27.533944193201499</c:v>
                </c:pt>
                <c:pt idx="1575">
                  <c:v>27.526283941682699</c:v>
                </c:pt>
                <c:pt idx="1576">
                  <c:v>27.5186236901638</c:v>
                </c:pt>
                <c:pt idx="1577">
                  <c:v>27.510963438645</c:v>
                </c:pt>
                <c:pt idx="1578">
                  <c:v>27.5033031871262</c:v>
                </c:pt>
                <c:pt idx="1579">
                  <c:v>27.4956429356074</c:v>
                </c:pt>
                <c:pt idx="1580">
                  <c:v>27.4879826840885</c:v>
                </c:pt>
                <c:pt idx="1581">
                  <c:v>27.4803224325697</c:v>
                </c:pt>
                <c:pt idx="1582">
                  <c:v>27.4726621810509</c:v>
                </c:pt>
                <c:pt idx="1583">
                  <c:v>27.465001929532001</c:v>
                </c:pt>
                <c:pt idx="1584">
                  <c:v>27.457341678013201</c:v>
                </c:pt>
                <c:pt idx="1585">
                  <c:v>27.449681426494401</c:v>
                </c:pt>
                <c:pt idx="1586">
                  <c:v>27.442021174975601</c:v>
                </c:pt>
                <c:pt idx="1587">
                  <c:v>27.434360923456701</c:v>
                </c:pt>
                <c:pt idx="1588">
                  <c:v>27.426700671937901</c:v>
                </c:pt>
                <c:pt idx="1589">
                  <c:v>27.419040420419101</c:v>
                </c:pt>
                <c:pt idx="1590">
                  <c:v>27.411380168900202</c:v>
                </c:pt>
                <c:pt idx="1591">
                  <c:v>27.403719917381402</c:v>
                </c:pt>
                <c:pt idx="1592">
                  <c:v>27.396059665862602</c:v>
                </c:pt>
                <c:pt idx="1593">
                  <c:v>27.388399414343802</c:v>
                </c:pt>
                <c:pt idx="1594">
                  <c:v>27.380739162824899</c:v>
                </c:pt>
                <c:pt idx="1595">
                  <c:v>27.373078911306099</c:v>
                </c:pt>
                <c:pt idx="1596">
                  <c:v>27.365418659787299</c:v>
                </c:pt>
                <c:pt idx="1597">
                  <c:v>27.357758408268399</c:v>
                </c:pt>
                <c:pt idx="1598">
                  <c:v>27.350098156749599</c:v>
                </c:pt>
                <c:pt idx="1599">
                  <c:v>27.342437905230799</c:v>
                </c:pt>
                <c:pt idx="1600">
                  <c:v>27.334777653711999</c:v>
                </c:pt>
                <c:pt idx="1601">
                  <c:v>27.3271174021931</c:v>
                </c:pt>
                <c:pt idx="1602">
                  <c:v>27.3194571506743</c:v>
                </c:pt>
                <c:pt idx="1603">
                  <c:v>27.3117968991555</c:v>
                </c:pt>
                <c:pt idx="1604">
                  <c:v>27.3041366476366</c:v>
                </c:pt>
                <c:pt idx="1605">
                  <c:v>27.2964763961178</c:v>
                </c:pt>
                <c:pt idx="1606">
                  <c:v>27.288816144599</c:v>
                </c:pt>
                <c:pt idx="1607">
                  <c:v>27.2811558930802</c:v>
                </c:pt>
                <c:pt idx="1608">
                  <c:v>25.672503074126102</c:v>
                </c:pt>
                <c:pt idx="1609">
                  <c:v>25.664842822607302</c:v>
                </c:pt>
                <c:pt idx="1610">
                  <c:v>25.657182571088502</c:v>
                </c:pt>
                <c:pt idx="1611">
                  <c:v>25.649522319569702</c:v>
                </c:pt>
                <c:pt idx="1612">
                  <c:v>25.641862068050798</c:v>
                </c:pt>
                <c:pt idx="1613">
                  <c:v>25.634201816531998</c:v>
                </c:pt>
                <c:pt idx="1614">
                  <c:v>25.626541565013198</c:v>
                </c:pt>
                <c:pt idx="1615">
                  <c:v>25.618881313494299</c:v>
                </c:pt>
                <c:pt idx="1616">
                  <c:v>25.611221061975499</c:v>
                </c:pt>
                <c:pt idx="1617">
                  <c:v>25.603560810456699</c:v>
                </c:pt>
                <c:pt idx="1618">
                  <c:v>25.595900558937899</c:v>
                </c:pt>
                <c:pt idx="1619">
                  <c:v>25.588240307418999</c:v>
                </c:pt>
                <c:pt idx="1620">
                  <c:v>25.580580055900199</c:v>
                </c:pt>
                <c:pt idx="1621">
                  <c:v>25.572919804381399</c:v>
                </c:pt>
                <c:pt idx="1622">
                  <c:v>25.5652595528625</c:v>
                </c:pt>
                <c:pt idx="1623">
                  <c:v>25.5575993013437</c:v>
                </c:pt>
                <c:pt idx="1624">
                  <c:v>25.5499390498249</c:v>
                </c:pt>
                <c:pt idx="1625">
                  <c:v>25.5422787983061</c:v>
                </c:pt>
                <c:pt idx="1626">
                  <c:v>25.5346185467872</c:v>
                </c:pt>
                <c:pt idx="1627">
                  <c:v>25.5269582952684</c:v>
                </c:pt>
                <c:pt idx="1628">
                  <c:v>25.5192980437496</c:v>
                </c:pt>
                <c:pt idx="1629">
                  <c:v>25.511637792230701</c:v>
                </c:pt>
                <c:pt idx="1630">
                  <c:v>25.503977540711901</c:v>
                </c:pt>
                <c:pt idx="1631">
                  <c:v>25.496317289193101</c:v>
                </c:pt>
                <c:pt idx="1632">
                  <c:v>25.488657037674301</c:v>
                </c:pt>
                <c:pt idx="1633">
                  <c:v>25.480996786155401</c:v>
                </c:pt>
                <c:pt idx="1634">
                  <c:v>25.473336534636601</c:v>
                </c:pt>
                <c:pt idx="1635">
                  <c:v>25.465676283117801</c:v>
                </c:pt>
                <c:pt idx="1636">
                  <c:v>25.458016031598898</c:v>
                </c:pt>
                <c:pt idx="1637">
                  <c:v>25.450355780080098</c:v>
                </c:pt>
                <c:pt idx="1638">
                  <c:v>25.442695528561298</c:v>
                </c:pt>
                <c:pt idx="1639">
                  <c:v>25.435035277042498</c:v>
                </c:pt>
                <c:pt idx="1640">
                  <c:v>25.427375025523599</c:v>
                </c:pt>
                <c:pt idx="1641">
                  <c:v>25.419714774004799</c:v>
                </c:pt>
                <c:pt idx="1642">
                  <c:v>25.412054522485999</c:v>
                </c:pt>
                <c:pt idx="1643">
                  <c:v>25.404394270967099</c:v>
                </c:pt>
                <c:pt idx="1644">
                  <c:v>25.396734019448299</c:v>
                </c:pt>
                <c:pt idx="1645">
                  <c:v>25.389073767929499</c:v>
                </c:pt>
                <c:pt idx="1646">
                  <c:v>25.381413516410699</c:v>
                </c:pt>
                <c:pt idx="1647">
                  <c:v>25.3737532648918</c:v>
                </c:pt>
                <c:pt idx="1648">
                  <c:v>25.366093013373</c:v>
                </c:pt>
                <c:pt idx="1649">
                  <c:v>25.3584327618542</c:v>
                </c:pt>
                <c:pt idx="1650">
                  <c:v>25.3507725103353</c:v>
                </c:pt>
                <c:pt idx="1651">
                  <c:v>25.3431122588165</c:v>
                </c:pt>
                <c:pt idx="1652">
                  <c:v>25.3354520072977</c:v>
                </c:pt>
                <c:pt idx="1653">
                  <c:v>25.327791755778801</c:v>
                </c:pt>
                <c:pt idx="1654">
                  <c:v>25.320131504260001</c:v>
                </c:pt>
                <c:pt idx="1655">
                  <c:v>25.312471252741201</c:v>
                </c:pt>
                <c:pt idx="1656">
                  <c:v>25.304811001222401</c:v>
                </c:pt>
                <c:pt idx="1657">
                  <c:v>25.297150749703501</c:v>
                </c:pt>
                <c:pt idx="1658">
                  <c:v>25.289490498184701</c:v>
                </c:pt>
                <c:pt idx="1659">
                  <c:v>25.281830246665901</c:v>
                </c:pt>
                <c:pt idx="1660">
                  <c:v>25.274169995146998</c:v>
                </c:pt>
                <c:pt idx="1661">
                  <c:v>25.266509743628198</c:v>
                </c:pt>
                <c:pt idx="1662">
                  <c:v>25.258849492109398</c:v>
                </c:pt>
                <c:pt idx="1663">
                  <c:v>25.251189240590602</c:v>
                </c:pt>
                <c:pt idx="1664">
                  <c:v>25.243528989071699</c:v>
                </c:pt>
                <c:pt idx="1665">
                  <c:v>25.235868737552899</c:v>
                </c:pt>
                <c:pt idx="1666">
                  <c:v>25.228208486034099</c:v>
                </c:pt>
                <c:pt idx="1667">
                  <c:v>25.220548234515299</c:v>
                </c:pt>
                <c:pt idx="1668">
                  <c:v>25.212887982996399</c:v>
                </c:pt>
                <c:pt idx="1669">
                  <c:v>25.205227731477599</c:v>
                </c:pt>
                <c:pt idx="1670">
                  <c:v>25.197567479958799</c:v>
                </c:pt>
                <c:pt idx="1671">
                  <c:v>25.1899072284399</c:v>
                </c:pt>
                <c:pt idx="1672">
                  <c:v>25.1822469769211</c:v>
                </c:pt>
                <c:pt idx="1673">
                  <c:v>25.1745867254023</c:v>
                </c:pt>
                <c:pt idx="1674">
                  <c:v>25.1669264738835</c:v>
                </c:pt>
                <c:pt idx="1675">
                  <c:v>25.1592662223646</c:v>
                </c:pt>
                <c:pt idx="1676">
                  <c:v>25.1516059708458</c:v>
                </c:pt>
                <c:pt idx="1677">
                  <c:v>25.143945719327</c:v>
                </c:pt>
                <c:pt idx="1678">
                  <c:v>25.136285467808101</c:v>
                </c:pt>
                <c:pt idx="1679">
                  <c:v>25.128625216289301</c:v>
                </c:pt>
                <c:pt idx="1680">
                  <c:v>25.120964964770501</c:v>
                </c:pt>
                <c:pt idx="1681">
                  <c:v>25.113304713251701</c:v>
                </c:pt>
                <c:pt idx="1682">
                  <c:v>25.105644461732801</c:v>
                </c:pt>
                <c:pt idx="1683">
                  <c:v>25.097984210214001</c:v>
                </c:pt>
                <c:pt idx="1684">
                  <c:v>25.090323958695201</c:v>
                </c:pt>
                <c:pt idx="1685">
                  <c:v>25.082663707176302</c:v>
                </c:pt>
                <c:pt idx="1686">
                  <c:v>25.075003455657502</c:v>
                </c:pt>
                <c:pt idx="1687">
                  <c:v>25.067343204138702</c:v>
                </c:pt>
                <c:pt idx="1688">
                  <c:v>25.059682952619799</c:v>
                </c:pt>
                <c:pt idx="1689">
                  <c:v>23.068017557724399</c:v>
                </c:pt>
                <c:pt idx="1690">
                  <c:v>23.060357306205599</c:v>
                </c:pt>
                <c:pt idx="1691">
                  <c:v>23.0526970546867</c:v>
                </c:pt>
                <c:pt idx="1692">
                  <c:v>23.0450368031679</c:v>
                </c:pt>
                <c:pt idx="1693">
                  <c:v>23.0373765516491</c:v>
                </c:pt>
                <c:pt idx="1694">
                  <c:v>23.0297163001303</c:v>
                </c:pt>
                <c:pt idx="1695">
                  <c:v>23.0220560486114</c:v>
                </c:pt>
                <c:pt idx="1696">
                  <c:v>23.0143957970926</c:v>
                </c:pt>
                <c:pt idx="1697">
                  <c:v>23.0067355455738</c:v>
                </c:pt>
                <c:pt idx="1698">
                  <c:v>22.999075294054901</c:v>
                </c:pt>
                <c:pt idx="1699">
                  <c:v>22.991415042536101</c:v>
                </c:pt>
                <c:pt idx="1700">
                  <c:v>22.983754791017301</c:v>
                </c:pt>
                <c:pt idx="1701">
                  <c:v>22.976094539498501</c:v>
                </c:pt>
                <c:pt idx="1702">
                  <c:v>22.968434287979601</c:v>
                </c:pt>
                <c:pt idx="1703">
                  <c:v>22.960774036460801</c:v>
                </c:pt>
                <c:pt idx="1704">
                  <c:v>22.953113784942001</c:v>
                </c:pt>
                <c:pt idx="1705">
                  <c:v>22.945453533423098</c:v>
                </c:pt>
                <c:pt idx="1706">
                  <c:v>22.937793281904298</c:v>
                </c:pt>
                <c:pt idx="1707">
                  <c:v>22.930133030385502</c:v>
                </c:pt>
                <c:pt idx="1708">
                  <c:v>22.922472778866702</c:v>
                </c:pt>
                <c:pt idx="1709">
                  <c:v>22.914812527347799</c:v>
                </c:pt>
                <c:pt idx="1710">
                  <c:v>22.907152275828999</c:v>
                </c:pt>
                <c:pt idx="1711">
                  <c:v>22.899492024310199</c:v>
                </c:pt>
                <c:pt idx="1712">
                  <c:v>22.891831772791299</c:v>
                </c:pt>
                <c:pt idx="1713">
                  <c:v>22.884171521272499</c:v>
                </c:pt>
                <c:pt idx="1714">
                  <c:v>22.876511269753699</c:v>
                </c:pt>
                <c:pt idx="1715">
                  <c:v>22.868851018234899</c:v>
                </c:pt>
                <c:pt idx="1716">
                  <c:v>22.861190766716</c:v>
                </c:pt>
                <c:pt idx="1717">
                  <c:v>22.8535305151972</c:v>
                </c:pt>
                <c:pt idx="1718">
                  <c:v>22.8458702636784</c:v>
                </c:pt>
                <c:pt idx="1719">
                  <c:v>22.8382100121595</c:v>
                </c:pt>
                <c:pt idx="1720">
                  <c:v>22.8305497606407</c:v>
                </c:pt>
                <c:pt idx="1721">
                  <c:v>22.8228895091219</c:v>
                </c:pt>
                <c:pt idx="1722">
                  <c:v>22.8152292576031</c:v>
                </c:pt>
                <c:pt idx="1723">
                  <c:v>22.807569006084201</c:v>
                </c:pt>
                <c:pt idx="1724">
                  <c:v>22.799908754565401</c:v>
                </c:pt>
                <c:pt idx="1725">
                  <c:v>22.792248503046601</c:v>
                </c:pt>
                <c:pt idx="1726">
                  <c:v>22.784588251527701</c:v>
                </c:pt>
                <c:pt idx="1727">
                  <c:v>22.776928000008901</c:v>
                </c:pt>
                <c:pt idx="1728">
                  <c:v>22.769267748490101</c:v>
                </c:pt>
                <c:pt idx="1729">
                  <c:v>22.761607496971301</c:v>
                </c:pt>
                <c:pt idx="1730">
                  <c:v>22.753947245452402</c:v>
                </c:pt>
                <c:pt idx="1731">
                  <c:v>22.746286993933602</c:v>
                </c:pt>
                <c:pt idx="1732">
                  <c:v>22.738626742414802</c:v>
                </c:pt>
                <c:pt idx="1733">
                  <c:v>22.730966490895899</c:v>
                </c:pt>
                <c:pt idx="1734">
                  <c:v>22.723306239377099</c:v>
                </c:pt>
                <c:pt idx="1735">
                  <c:v>22.715645987858299</c:v>
                </c:pt>
                <c:pt idx="1736">
                  <c:v>22.707985736339499</c:v>
                </c:pt>
                <c:pt idx="1737">
                  <c:v>22.700325484820599</c:v>
                </c:pt>
                <c:pt idx="1738">
                  <c:v>22.692665233301799</c:v>
                </c:pt>
                <c:pt idx="1739">
                  <c:v>22.685004981782999</c:v>
                </c:pt>
                <c:pt idx="1740">
                  <c:v>22.6773447302641</c:v>
                </c:pt>
                <c:pt idx="1741">
                  <c:v>22.6696844787453</c:v>
                </c:pt>
                <c:pt idx="1742">
                  <c:v>22.6620242272265</c:v>
                </c:pt>
                <c:pt idx="1743">
                  <c:v>22.6543639757077</c:v>
                </c:pt>
                <c:pt idx="1744">
                  <c:v>22.6467037241888</c:v>
                </c:pt>
                <c:pt idx="1745">
                  <c:v>22.63904347267</c:v>
                </c:pt>
                <c:pt idx="1746">
                  <c:v>22.6313832211512</c:v>
                </c:pt>
                <c:pt idx="1747">
                  <c:v>22.623722969632301</c:v>
                </c:pt>
                <c:pt idx="1748">
                  <c:v>22.616062718113501</c:v>
                </c:pt>
                <c:pt idx="1749">
                  <c:v>22.608402466594701</c:v>
                </c:pt>
                <c:pt idx="1750">
                  <c:v>19.084686767933501</c:v>
                </c:pt>
                <c:pt idx="1751">
                  <c:v>19.077026516414701</c:v>
                </c:pt>
                <c:pt idx="1752">
                  <c:v>19.069366264895901</c:v>
                </c:pt>
                <c:pt idx="1753">
                  <c:v>19.061706013377002</c:v>
                </c:pt>
                <c:pt idx="1754">
                  <c:v>19.054045761858202</c:v>
                </c:pt>
                <c:pt idx="1755">
                  <c:v>19.046385510339402</c:v>
                </c:pt>
                <c:pt idx="1756">
                  <c:v>19.038725258820499</c:v>
                </c:pt>
                <c:pt idx="1757">
                  <c:v>19.031065007301699</c:v>
                </c:pt>
                <c:pt idx="1758">
                  <c:v>19.023404755782899</c:v>
                </c:pt>
                <c:pt idx="1759">
                  <c:v>19.015744504264099</c:v>
                </c:pt>
                <c:pt idx="1760">
                  <c:v>19.008084252745199</c:v>
                </c:pt>
                <c:pt idx="1761">
                  <c:v>19.000424001226399</c:v>
                </c:pt>
                <c:pt idx="1762">
                  <c:v>18.992763749707599</c:v>
                </c:pt>
                <c:pt idx="1763">
                  <c:v>18.9851034981887</c:v>
                </c:pt>
                <c:pt idx="1764">
                  <c:v>18.9774432466699</c:v>
                </c:pt>
                <c:pt idx="1765">
                  <c:v>18.9697829951511</c:v>
                </c:pt>
                <c:pt idx="1766">
                  <c:v>18.9621227436323</c:v>
                </c:pt>
                <c:pt idx="1767">
                  <c:v>18.9544624921134</c:v>
                </c:pt>
                <c:pt idx="1768">
                  <c:v>18.9468022405946</c:v>
                </c:pt>
                <c:pt idx="1769">
                  <c:v>18.9391419890758</c:v>
                </c:pt>
                <c:pt idx="1770">
                  <c:v>18.931481737556901</c:v>
                </c:pt>
                <c:pt idx="1771">
                  <c:v>18.923821486038101</c:v>
                </c:pt>
                <c:pt idx="1772">
                  <c:v>18.916161234519301</c:v>
                </c:pt>
                <c:pt idx="1773">
                  <c:v>18.908500983000501</c:v>
                </c:pt>
                <c:pt idx="1774">
                  <c:v>18.900840731481601</c:v>
                </c:pt>
                <c:pt idx="1775">
                  <c:v>18.893180479962801</c:v>
                </c:pt>
                <c:pt idx="1776">
                  <c:v>18.885520228444001</c:v>
                </c:pt>
                <c:pt idx="1777">
                  <c:v>18.877859976925102</c:v>
                </c:pt>
                <c:pt idx="1778">
                  <c:v>18.870199725406302</c:v>
                </c:pt>
                <c:pt idx="1779">
                  <c:v>18.862539473887502</c:v>
                </c:pt>
                <c:pt idx="1780">
                  <c:v>18.854879222368702</c:v>
                </c:pt>
                <c:pt idx="1781">
                  <c:v>18.847218970849799</c:v>
                </c:pt>
                <c:pt idx="1782">
                  <c:v>18.839558719330999</c:v>
                </c:pt>
                <c:pt idx="1783">
                  <c:v>18.831898467812199</c:v>
                </c:pt>
                <c:pt idx="1784">
                  <c:v>18.824238216293299</c:v>
                </c:pt>
                <c:pt idx="1785">
                  <c:v>18.816577964774499</c:v>
                </c:pt>
                <c:pt idx="1786">
                  <c:v>18.808917713255699</c:v>
                </c:pt>
                <c:pt idx="1787">
                  <c:v>18.801257461736899</c:v>
                </c:pt>
                <c:pt idx="1788">
                  <c:v>18.793597210218</c:v>
                </c:pt>
                <c:pt idx="1789">
                  <c:v>18.7859369586992</c:v>
                </c:pt>
                <c:pt idx="1790">
                  <c:v>18.7782767071804</c:v>
                </c:pt>
                <c:pt idx="1791">
                  <c:v>17.0164188578498</c:v>
                </c:pt>
                <c:pt idx="1792">
                  <c:v>17.008758606331</c:v>
                </c:pt>
                <c:pt idx="1793">
                  <c:v>17.0010983548121</c:v>
                </c:pt>
                <c:pt idx="1794">
                  <c:v>16.9934381032933</c:v>
                </c:pt>
                <c:pt idx="1795">
                  <c:v>16.9857778517745</c:v>
                </c:pt>
                <c:pt idx="1796">
                  <c:v>16.978117600255601</c:v>
                </c:pt>
                <c:pt idx="1797">
                  <c:v>16.970457348736801</c:v>
                </c:pt>
                <c:pt idx="1798">
                  <c:v>16.962797097218001</c:v>
                </c:pt>
                <c:pt idx="1799">
                  <c:v>16.955136845699201</c:v>
                </c:pt>
                <c:pt idx="1800">
                  <c:v>16.947476594180301</c:v>
                </c:pt>
                <c:pt idx="1801">
                  <c:v>16.939816342661501</c:v>
                </c:pt>
                <c:pt idx="1802">
                  <c:v>16.932156091142701</c:v>
                </c:pt>
                <c:pt idx="1803">
                  <c:v>16.924495839623798</c:v>
                </c:pt>
                <c:pt idx="1804">
                  <c:v>16.916835588104998</c:v>
                </c:pt>
                <c:pt idx="1805">
                  <c:v>16.909175336586198</c:v>
                </c:pt>
                <c:pt idx="1806">
                  <c:v>16.901515085067299</c:v>
                </c:pt>
                <c:pt idx="1807">
                  <c:v>16.893854833548499</c:v>
                </c:pt>
                <c:pt idx="1808">
                  <c:v>16.886194582029699</c:v>
                </c:pt>
                <c:pt idx="1809">
                  <c:v>16.878534330510899</c:v>
                </c:pt>
                <c:pt idx="1810">
                  <c:v>16.870874078991999</c:v>
                </c:pt>
                <c:pt idx="1811">
                  <c:v>16.863213827473199</c:v>
                </c:pt>
                <c:pt idx="1812">
                  <c:v>16.855553575954399</c:v>
                </c:pt>
                <c:pt idx="1813">
                  <c:v>16.8478933244355</c:v>
                </c:pt>
                <c:pt idx="1814">
                  <c:v>16.8402330729167</c:v>
                </c:pt>
                <c:pt idx="1815">
                  <c:v>16.8325728213979</c:v>
                </c:pt>
                <c:pt idx="1816">
                  <c:v>16.8249125698791</c:v>
                </c:pt>
                <c:pt idx="1817">
                  <c:v>16.8172523183602</c:v>
                </c:pt>
                <c:pt idx="1818">
                  <c:v>16.8095920668414</c:v>
                </c:pt>
                <c:pt idx="1819">
                  <c:v>16.8019318153226</c:v>
                </c:pt>
                <c:pt idx="1820">
                  <c:v>16.794271563803701</c:v>
                </c:pt>
                <c:pt idx="1821">
                  <c:v>16.786611312284901</c:v>
                </c:pt>
                <c:pt idx="1822">
                  <c:v>16.778951060766101</c:v>
                </c:pt>
                <c:pt idx="1823">
                  <c:v>16.771290809247301</c:v>
                </c:pt>
                <c:pt idx="1824">
                  <c:v>16.763630557728401</c:v>
                </c:pt>
                <c:pt idx="1825">
                  <c:v>16.755970306209601</c:v>
                </c:pt>
                <c:pt idx="1826">
                  <c:v>16.748310054690801</c:v>
                </c:pt>
                <c:pt idx="1827">
                  <c:v>16.740649803171902</c:v>
                </c:pt>
                <c:pt idx="1828">
                  <c:v>16.732989551653102</c:v>
                </c:pt>
                <c:pt idx="1829">
                  <c:v>16.725329300134302</c:v>
                </c:pt>
                <c:pt idx="1830">
                  <c:v>16.717669048615502</c:v>
                </c:pt>
                <c:pt idx="1831">
                  <c:v>16.710008797096599</c:v>
                </c:pt>
                <c:pt idx="1832">
                  <c:v>16.702348545577799</c:v>
                </c:pt>
                <c:pt idx="1833">
                  <c:v>16.694688294058999</c:v>
                </c:pt>
                <c:pt idx="1834">
                  <c:v>16.687028042540099</c:v>
                </c:pt>
                <c:pt idx="1835">
                  <c:v>16.679367791021299</c:v>
                </c:pt>
                <c:pt idx="1836">
                  <c:v>16.671707539502499</c:v>
                </c:pt>
                <c:pt idx="1837">
                  <c:v>16.664047287983699</c:v>
                </c:pt>
                <c:pt idx="1838">
                  <c:v>16.6563870364648</c:v>
                </c:pt>
                <c:pt idx="1839">
                  <c:v>16.648726784946</c:v>
                </c:pt>
                <c:pt idx="1840">
                  <c:v>16.6410665334272</c:v>
                </c:pt>
                <c:pt idx="1841">
                  <c:v>16.6334062819083</c:v>
                </c:pt>
                <c:pt idx="1842">
                  <c:v>16.6257460303895</c:v>
                </c:pt>
                <c:pt idx="1843">
                  <c:v>16.6180857788707</c:v>
                </c:pt>
                <c:pt idx="1844">
                  <c:v>16.6104255273519</c:v>
                </c:pt>
                <c:pt idx="1845">
                  <c:v>16.602765275833001</c:v>
                </c:pt>
                <c:pt idx="1846">
                  <c:v>16.595105024314201</c:v>
                </c:pt>
                <c:pt idx="1847">
                  <c:v>16.587444772795401</c:v>
                </c:pt>
                <c:pt idx="1848">
                  <c:v>16.579784521276501</c:v>
                </c:pt>
                <c:pt idx="1849">
                  <c:v>16.572124269757701</c:v>
                </c:pt>
                <c:pt idx="1850">
                  <c:v>16.564464018238901</c:v>
                </c:pt>
                <c:pt idx="1851">
                  <c:v>16.556803766720101</c:v>
                </c:pt>
                <c:pt idx="1852">
                  <c:v>16.549143515201202</c:v>
                </c:pt>
                <c:pt idx="1853">
                  <c:v>16.541483263682402</c:v>
                </c:pt>
                <c:pt idx="1854">
                  <c:v>16.533823012163602</c:v>
                </c:pt>
                <c:pt idx="1855">
                  <c:v>16.526162760644699</c:v>
                </c:pt>
                <c:pt idx="1856">
                  <c:v>16.518502509125899</c:v>
                </c:pt>
                <c:pt idx="1857">
                  <c:v>16.510842257607099</c:v>
                </c:pt>
                <c:pt idx="1858">
                  <c:v>16.503182006088299</c:v>
                </c:pt>
                <c:pt idx="1859">
                  <c:v>16.495521754569399</c:v>
                </c:pt>
                <c:pt idx="1860">
                  <c:v>16.487861503050599</c:v>
                </c:pt>
                <c:pt idx="1861">
                  <c:v>16.480201251531799</c:v>
                </c:pt>
                <c:pt idx="1862">
                  <c:v>16.4725410000129</c:v>
                </c:pt>
                <c:pt idx="1863">
                  <c:v>16.4648807484941</c:v>
                </c:pt>
                <c:pt idx="1864">
                  <c:v>16.4572204969753</c:v>
                </c:pt>
                <c:pt idx="1865">
                  <c:v>16.4495602454565</c:v>
                </c:pt>
                <c:pt idx="1866">
                  <c:v>16.4418999939376</c:v>
                </c:pt>
                <c:pt idx="1867">
                  <c:v>16.4342397424188</c:v>
                </c:pt>
                <c:pt idx="1868">
                  <c:v>16.4265794909</c:v>
                </c:pt>
                <c:pt idx="1869">
                  <c:v>16.418919239381101</c:v>
                </c:pt>
                <c:pt idx="1870">
                  <c:v>16.411258987862301</c:v>
                </c:pt>
                <c:pt idx="1871">
                  <c:v>16.403598736343501</c:v>
                </c:pt>
                <c:pt idx="1872">
                  <c:v>16.395938484824701</c:v>
                </c:pt>
                <c:pt idx="1873">
                  <c:v>16.388278233305801</c:v>
                </c:pt>
                <c:pt idx="1874">
                  <c:v>16.380617981787001</c:v>
                </c:pt>
                <c:pt idx="1875">
                  <c:v>16.372957730268201</c:v>
                </c:pt>
                <c:pt idx="1876">
                  <c:v>16.365297478749302</c:v>
                </c:pt>
                <c:pt idx="1877">
                  <c:v>16.357637227230502</c:v>
                </c:pt>
                <c:pt idx="1878">
                  <c:v>16.349976975711701</c:v>
                </c:pt>
                <c:pt idx="1879">
                  <c:v>16.342316724192901</c:v>
                </c:pt>
                <c:pt idx="1880">
                  <c:v>16.334656472673998</c:v>
                </c:pt>
                <c:pt idx="1881">
                  <c:v>16.326996221155198</c:v>
                </c:pt>
                <c:pt idx="1882">
                  <c:v>16.319335969636398</c:v>
                </c:pt>
                <c:pt idx="1883">
                  <c:v>16.311675718117499</c:v>
                </c:pt>
                <c:pt idx="1884">
                  <c:v>16.304015466598699</c:v>
                </c:pt>
                <c:pt idx="1885">
                  <c:v>16.296355215079899</c:v>
                </c:pt>
                <c:pt idx="1886">
                  <c:v>16.288694963561099</c:v>
                </c:pt>
                <c:pt idx="1887">
                  <c:v>16.281034712042199</c:v>
                </c:pt>
                <c:pt idx="1888">
                  <c:v>16.273374460523399</c:v>
                </c:pt>
                <c:pt idx="1889">
                  <c:v>16.265714209004599</c:v>
                </c:pt>
                <c:pt idx="1890">
                  <c:v>16.2580539574857</c:v>
                </c:pt>
                <c:pt idx="1891">
                  <c:v>16.2503937059669</c:v>
                </c:pt>
              </c:numCache>
            </c:numRef>
          </c:xVal>
          <c:yVal>
            <c:numRef>
              <c:f>Sheet1!$C$2:$C$1893</c:f>
              <c:numCache>
                <c:formatCode>General</c:formatCode>
                <c:ptCount val="189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0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0</c:v>
                </c:pt>
                <c:pt idx="110">
                  <c:v>0</c:v>
                </c:pt>
                <c:pt idx="111">
                  <c:v>0</c:v>
                </c:pt>
                <c:pt idx="112">
                  <c:v>0</c:v>
                </c:pt>
                <c:pt idx="113">
                  <c:v>0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0</c:v>
                </c:pt>
                <c:pt idx="124">
                  <c:v>0</c:v>
                </c:pt>
                <c:pt idx="125">
                  <c:v>0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  <c:pt idx="133">
                  <c:v>0</c:v>
                </c:pt>
                <c:pt idx="134">
                  <c:v>0</c:v>
                </c:pt>
                <c:pt idx="135">
                  <c:v>0</c:v>
                </c:pt>
                <c:pt idx="136">
                  <c:v>0</c:v>
                </c:pt>
                <c:pt idx="137">
                  <c:v>0</c:v>
                </c:pt>
                <c:pt idx="138">
                  <c:v>0</c:v>
                </c:pt>
                <c:pt idx="139">
                  <c:v>0</c:v>
                </c:pt>
                <c:pt idx="140">
                  <c:v>0</c:v>
                </c:pt>
                <c:pt idx="141">
                  <c:v>0</c:v>
                </c:pt>
                <c:pt idx="142">
                  <c:v>0</c:v>
                </c:pt>
                <c:pt idx="143">
                  <c:v>0</c:v>
                </c:pt>
                <c:pt idx="144">
                  <c:v>0</c:v>
                </c:pt>
                <c:pt idx="145">
                  <c:v>0</c:v>
                </c:pt>
                <c:pt idx="146">
                  <c:v>0</c:v>
                </c:pt>
                <c:pt idx="147">
                  <c:v>0</c:v>
                </c:pt>
                <c:pt idx="148">
                  <c:v>0</c:v>
                </c:pt>
                <c:pt idx="149">
                  <c:v>0</c:v>
                </c:pt>
                <c:pt idx="150">
                  <c:v>0</c:v>
                </c:pt>
                <c:pt idx="151">
                  <c:v>0</c:v>
                </c:pt>
                <c:pt idx="152">
                  <c:v>0</c:v>
                </c:pt>
                <c:pt idx="153">
                  <c:v>0</c:v>
                </c:pt>
                <c:pt idx="154">
                  <c:v>0</c:v>
                </c:pt>
                <c:pt idx="155">
                  <c:v>0</c:v>
                </c:pt>
                <c:pt idx="156">
                  <c:v>0</c:v>
                </c:pt>
                <c:pt idx="157">
                  <c:v>0</c:v>
                </c:pt>
                <c:pt idx="158">
                  <c:v>0</c:v>
                </c:pt>
                <c:pt idx="159">
                  <c:v>0</c:v>
                </c:pt>
                <c:pt idx="160">
                  <c:v>0</c:v>
                </c:pt>
                <c:pt idx="161">
                  <c:v>0</c:v>
                </c:pt>
                <c:pt idx="162">
                  <c:v>0</c:v>
                </c:pt>
                <c:pt idx="163">
                  <c:v>0</c:v>
                </c:pt>
                <c:pt idx="164">
                  <c:v>0</c:v>
                </c:pt>
                <c:pt idx="165">
                  <c:v>0</c:v>
                </c:pt>
                <c:pt idx="166">
                  <c:v>0</c:v>
                </c:pt>
                <c:pt idx="167">
                  <c:v>0</c:v>
                </c:pt>
                <c:pt idx="168">
                  <c:v>0</c:v>
                </c:pt>
                <c:pt idx="169">
                  <c:v>0</c:v>
                </c:pt>
                <c:pt idx="170">
                  <c:v>0</c:v>
                </c:pt>
                <c:pt idx="171">
                  <c:v>0</c:v>
                </c:pt>
                <c:pt idx="172">
                  <c:v>0</c:v>
                </c:pt>
                <c:pt idx="173">
                  <c:v>0</c:v>
                </c:pt>
                <c:pt idx="174">
                  <c:v>0</c:v>
                </c:pt>
                <c:pt idx="175">
                  <c:v>0</c:v>
                </c:pt>
                <c:pt idx="176">
                  <c:v>0</c:v>
                </c:pt>
                <c:pt idx="177">
                  <c:v>0</c:v>
                </c:pt>
                <c:pt idx="178">
                  <c:v>0</c:v>
                </c:pt>
                <c:pt idx="179">
                  <c:v>0</c:v>
                </c:pt>
                <c:pt idx="180">
                  <c:v>0</c:v>
                </c:pt>
                <c:pt idx="181">
                  <c:v>0</c:v>
                </c:pt>
                <c:pt idx="182">
                  <c:v>0</c:v>
                </c:pt>
                <c:pt idx="183">
                  <c:v>0</c:v>
                </c:pt>
                <c:pt idx="184">
                  <c:v>0</c:v>
                </c:pt>
                <c:pt idx="185">
                  <c:v>0</c:v>
                </c:pt>
                <c:pt idx="186">
                  <c:v>0</c:v>
                </c:pt>
                <c:pt idx="187">
                  <c:v>0</c:v>
                </c:pt>
                <c:pt idx="188">
                  <c:v>0</c:v>
                </c:pt>
                <c:pt idx="189">
                  <c:v>0</c:v>
                </c:pt>
                <c:pt idx="190">
                  <c:v>0</c:v>
                </c:pt>
                <c:pt idx="191">
                  <c:v>0</c:v>
                </c:pt>
                <c:pt idx="192">
                  <c:v>0</c:v>
                </c:pt>
                <c:pt idx="193">
                  <c:v>0</c:v>
                </c:pt>
                <c:pt idx="194">
                  <c:v>0</c:v>
                </c:pt>
                <c:pt idx="195">
                  <c:v>0</c:v>
                </c:pt>
                <c:pt idx="196">
                  <c:v>0</c:v>
                </c:pt>
                <c:pt idx="197">
                  <c:v>0</c:v>
                </c:pt>
                <c:pt idx="198">
                  <c:v>0</c:v>
                </c:pt>
                <c:pt idx="199">
                  <c:v>0</c:v>
                </c:pt>
                <c:pt idx="200">
                  <c:v>0</c:v>
                </c:pt>
                <c:pt idx="201">
                  <c:v>0</c:v>
                </c:pt>
                <c:pt idx="202">
                  <c:v>0</c:v>
                </c:pt>
                <c:pt idx="203">
                  <c:v>0</c:v>
                </c:pt>
                <c:pt idx="204">
                  <c:v>0</c:v>
                </c:pt>
                <c:pt idx="205">
                  <c:v>0</c:v>
                </c:pt>
                <c:pt idx="206">
                  <c:v>0</c:v>
                </c:pt>
                <c:pt idx="207">
                  <c:v>0</c:v>
                </c:pt>
                <c:pt idx="208">
                  <c:v>0</c:v>
                </c:pt>
                <c:pt idx="209">
                  <c:v>0</c:v>
                </c:pt>
                <c:pt idx="210">
                  <c:v>0</c:v>
                </c:pt>
                <c:pt idx="211">
                  <c:v>0</c:v>
                </c:pt>
                <c:pt idx="212">
                  <c:v>0</c:v>
                </c:pt>
                <c:pt idx="213">
                  <c:v>0</c:v>
                </c:pt>
                <c:pt idx="214">
                  <c:v>0</c:v>
                </c:pt>
                <c:pt idx="215">
                  <c:v>0</c:v>
                </c:pt>
                <c:pt idx="216">
                  <c:v>0</c:v>
                </c:pt>
                <c:pt idx="217">
                  <c:v>0</c:v>
                </c:pt>
                <c:pt idx="218">
                  <c:v>0</c:v>
                </c:pt>
                <c:pt idx="219">
                  <c:v>0</c:v>
                </c:pt>
                <c:pt idx="220">
                  <c:v>0</c:v>
                </c:pt>
                <c:pt idx="221">
                  <c:v>0</c:v>
                </c:pt>
                <c:pt idx="222">
                  <c:v>0</c:v>
                </c:pt>
                <c:pt idx="223">
                  <c:v>0</c:v>
                </c:pt>
                <c:pt idx="224">
                  <c:v>0</c:v>
                </c:pt>
                <c:pt idx="225">
                  <c:v>0</c:v>
                </c:pt>
                <c:pt idx="226">
                  <c:v>0</c:v>
                </c:pt>
                <c:pt idx="227">
                  <c:v>0</c:v>
                </c:pt>
                <c:pt idx="228">
                  <c:v>0</c:v>
                </c:pt>
                <c:pt idx="229">
                  <c:v>0</c:v>
                </c:pt>
                <c:pt idx="230">
                  <c:v>0</c:v>
                </c:pt>
                <c:pt idx="231">
                  <c:v>0</c:v>
                </c:pt>
                <c:pt idx="232">
                  <c:v>0</c:v>
                </c:pt>
                <c:pt idx="233">
                  <c:v>0</c:v>
                </c:pt>
                <c:pt idx="234">
                  <c:v>0</c:v>
                </c:pt>
                <c:pt idx="235">
                  <c:v>0</c:v>
                </c:pt>
                <c:pt idx="236">
                  <c:v>0</c:v>
                </c:pt>
                <c:pt idx="237">
                  <c:v>0</c:v>
                </c:pt>
                <c:pt idx="238">
                  <c:v>0</c:v>
                </c:pt>
                <c:pt idx="239">
                  <c:v>0</c:v>
                </c:pt>
                <c:pt idx="240">
                  <c:v>0</c:v>
                </c:pt>
                <c:pt idx="241">
                  <c:v>0</c:v>
                </c:pt>
                <c:pt idx="242">
                  <c:v>0</c:v>
                </c:pt>
                <c:pt idx="243">
                  <c:v>0</c:v>
                </c:pt>
                <c:pt idx="244">
                  <c:v>0</c:v>
                </c:pt>
                <c:pt idx="245">
                  <c:v>0</c:v>
                </c:pt>
                <c:pt idx="246">
                  <c:v>0</c:v>
                </c:pt>
                <c:pt idx="247">
                  <c:v>0</c:v>
                </c:pt>
                <c:pt idx="248">
                  <c:v>0</c:v>
                </c:pt>
                <c:pt idx="249">
                  <c:v>0</c:v>
                </c:pt>
                <c:pt idx="250">
                  <c:v>0</c:v>
                </c:pt>
                <c:pt idx="251">
                  <c:v>0</c:v>
                </c:pt>
                <c:pt idx="252">
                  <c:v>0</c:v>
                </c:pt>
                <c:pt idx="253">
                  <c:v>0</c:v>
                </c:pt>
                <c:pt idx="254">
                  <c:v>0</c:v>
                </c:pt>
                <c:pt idx="255">
                  <c:v>0</c:v>
                </c:pt>
                <c:pt idx="256">
                  <c:v>0</c:v>
                </c:pt>
                <c:pt idx="257">
                  <c:v>0</c:v>
                </c:pt>
                <c:pt idx="258">
                  <c:v>0</c:v>
                </c:pt>
                <c:pt idx="259">
                  <c:v>0</c:v>
                </c:pt>
                <c:pt idx="260">
                  <c:v>0</c:v>
                </c:pt>
                <c:pt idx="261">
                  <c:v>0</c:v>
                </c:pt>
                <c:pt idx="262">
                  <c:v>0</c:v>
                </c:pt>
                <c:pt idx="263">
                  <c:v>0</c:v>
                </c:pt>
                <c:pt idx="264">
                  <c:v>0</c:v>
                </c:pt>
                <c:pt idx="265">
                  <c:v>0</c:v>
                </c:pt>
                <c:pt idx="266">
                  <c:v>0</c:v>
                </c:pt>
                <c:pt idx="267">
                  <c:v>0</c:v>
                </c:pt>
                <c:pt idx="268">
                  <c:v>0</c:v>
                </c:pt>
                <c:pt idx="269">
                  <c:v>0</c:v>
                </c:pt>
                <c:pt idx="270">
                  <c:v>0</c:v>
                </c:pt>
                <c:pt idx="271">
                  <c:v>0</c:v>
                </c:pt>
                <c:pt idx="272">
                  <c:v>0</c:v>
                </c:pt>
                <c:pt idx="273">
                  <c:v>0</c:v>
                </c:pt>
                <c:pt idx="274">
                  <c:v>0</c:v>
                </c:pt>
                <c:pt idx="275">
                  <c:v>0</c:v>
                </c:pt>
                <c:pt idx="276">
                  <c:v>0</c:v>
                </c:pt>
                <c:pt idx="277">
                  <c:v>0</c:v>
                </c:pt>
                <c:pt idx="278">
                  <c:v>0</c:v>
                </c:pt>
                <c:pt idx="279">
                  <c:v>0</c:v>
                </c:pt>
                <c:pt idx="280">
                  <c:v>0</c:v>
                </c:pt>
                <c:pt idx="281">
                  <c:v>0</c:v>
                </c:pt>
                <c:pt idx="282">
                  <c:v>0</c:v>
                </c:pt>
                <c:pt idx="283">
                  <c:v>0</c:v>
                </c:pt>
                <c:pt idx="284">
                  <c:v>0</c:v>
                </c:pt>
                <c:pt idx="285">
                  <c:v>0</c:v>
                </c:pt>
                <c:pt idx="286">
                  <c:v>0</c:v>
                </c:pt>
                <c:pt idx="287">
                  <c:v>0</c:v>
                </c:pt>
                <c:pt idx="288">
                  <c:v>0</c:v>
                </c:pt>
                <c:pt idx="289">
                  <c:v>0</c:v>
                </c:pt>
                <c:pt idx="290">
                  <c:v>0</c:v>
                </c:pt>
                <c:pt idx="291">
                  <c:v>0</c:v>
                </c:pt>
                <c:pt idx="292">
                  <c:v>0</c:v>
                </c:pt>
                <c:pt idx="293">
                  <c:v>0</c:v>
                </c:pt>
                <c:pt idx="294">
                  <c:v>0</c:v>
                </c:pt>
                <c:pt idx="295">
                  <c:v>0</c:v>
                </c:pt>
                <c:pt idx="296">
                  <c:v>0</c:v>
                </c:pt>
                <c:pt idx="297">
                  <c:v>0</c:v>
                </c:pt>
                <c:pt idx="298">
                  <c:v>0</c:v>
                </c:pt>
                <c:pt idx="299">
                  <c:v>0</c:v>
                </c:pt>
                <c:pt idx="300">
                  <c:v>0</c:v>
                </c:pt>
                <c:pt idx="301">
                  <c:v>0</c:v>
                </c:pt>
                <c:pt idx="302">
                  <c:v>0</c:v>
                </c:pt>
                <c:pt idx="303">
                  <c:v>0</c:v>
                </c:pt>
                <c:pt idx="304">
                  <c:v>0</c:v>
                </c:pt>
                <c:pt idx="305">
                  <c:v>0</c:v>
                </c:pt>
                <c:pt idx="306">
                  <c:v>0</c:v>
                </c:pt>
                <c:pt idx="307">
                  <c:v>0</c:v>
                </c:pt>
                <c:pt idx="308">
                  <c:v>0</c:v>
                </c:pt>
                <c:pt idx="309">
                  <c:v>0</c:v>
                </c:pt>
                <c:pt idx="310">
                  <c:v>0</c:v>
                </c:pt>
                <c:pt idx="311">
                  <c:v>0</c:v>
                </c:pt>
                <c:pt idx="312">
                  <c:v>0</c:v>
                </c:pt>
                <c:pt idx="313">
                  <c:v>0</c:v>
                </c:pt>
                <c:pt idx="314">
                  <c:v>0</c:v>
                </c:pt>
                <c:pt idx="315">
                  <c:v>0</c:v>
                </c:pt>
                <c:pt idx="316">
                  <c:v>0</c:v>
                </c:pt>
                <c:pt idx="317">
                  <c:v>0</c:v>
                </c:pt>
                <c:pt idx="318">
                  <c:v>0</c:v>
                </c:pt>
                <c:pt idx="319">
                  <c:v>0</c:v>
                </c:pt>
                <c:pt idx="320">
                  <c:v>0</c:v>
                </c:pt>
                <c:pt idx="321">
                  <c:v>0</c:v>
                </c:pt>
                <c:pt idx="322">
                  <c:v>0</c:v>
                </c:pt>
                <c:pt idx="323">
                  <c:v>0</c:v>
                </c:pt>
                <c:pt idx="324">
                  <c:v>0</c:v>
                </c:pt>
                <c:pt idx="325">
                  <c:v>0</c:v>
                </c:pt>
                <c:pt idx="326">
                  <c:v>0</c:v>
                </c:pt>
                <c:pt idx="327">
                  <c:v>0</c:v>
                </c:pt>
                <c:pt idx="328">
                  <c:v>0</c:v>
                </c:pt>
                <c:pt idx="329">
                  <c:v>0</c:v>
                </c:pt>
                <c:pt idx="330">
                  <c:v>0</c:v>
                </c:pt>
                <c:pt idx="331">
                  <c:v>0</c:v>
                </c:pt>
                <c:pt idx="332">
                  <c:v>0</c:v>
                </c:pt>
                <c:pt idx="333">
                  <c:v>0</c:v>
                </c:pt>
                <c:pt idx="334">
                  <c:v>0</c:v>
                </c:pt>
                <c:pt idx="335">
                  <c:v>0</c:v>
                </c:pt>
                <c:pt idx="336">
                  <c:v>0</c:v>
                </c:pt>
                <c:pt idx="337">
                  <c:v>0</c:v>
                </c:pt>
                <c:pt idx="338">
                  <c:v>0</c:v>
                </c:pt>
                <c:pt idx="339">
                  <c:v>0</c:v>
                </c:pt>
                <c:pt idx="340">
                  <c:v>0</c:v>
                </c:pt>
                <c:pt idx="341">
                  <c:v>0</c:v>
                </c:pt>
                <c:pt idx="342">
                  <c:v>0</c:v>
                </c:pt>
                <c:pt idx="343">
                  <c:v>0</c:v>
                </c:pt>
                <c:pt idx="344">
                  <c:v>0</c:v>
                </c:pt>
                <c:pt idx="345">
                  <c:v>0</c:v>
                </c:pt>
                <c:pt idx="346">
                  <c:v>0</c:v>
                </c:pt>
                <c:pt idx="347">
                  <c:v>0</c:v>
                </c:pt>
                <c:pt idx="348">
                  <c:v>0</c:v>
                </c:pt>
                <c:pt idx="349">
                  <c:v>0</c:v>
                </c:pt>
                <c:pt idx="350">
                  <c:v>0</c:v>
                </c:pt>
                <c:pt idx="351">
                  <c:v>0</c:v>
                </c:pt>
                <c:pt idx="352">
                  <c:v>0</c:v>
                </c:pt>
                <c:pt idx="353">
                  <c:v>0</c:v>
                </c:pt>
                <c:pt idx="354">
                  <c:v>0</c:v>
                </c:pt>
                <c:pt idx="355">
                  <c:v>0</c:v>
                </c:pt>
                <c:pt idx="356">
                  <c:v>0</c:v>
                </c:pt>
                <c:pt idx="357">
                  <c:v>0</c:v>
                </c:pt>
                <c:pt idx="358">
                  <c:v>0</c:v>
                </c:pt>
                <c:pt idx="359">
                  <c:v>0</c:v>
                </c:pt>
                <c:pt idx="360">
                  <c:v>0</c:v>
                </c:pt>
                <c:pt idx="361">
                  <c:v>0</c:v>
                </c:pt>
                <c:pt idx="362">
                  <c:v>0</c:v>
                </c:pt>
                <c:pt idx="363">
                  <c:v>0</c:v>
                </c:pt>
                <c:pt idx="364">
                  <c:v>0</c:v>
                </c:pt>
                <c:pt idx="365">
                  <c:v>0</c:v>
                </c:pt>
                <c:pt idx="366">
                  <c:v>0</c:v>
                </c:pt>
                <c:pt idx="367">
                  <c:v>0</c:v>
                </c:pt>
                <c:pt idx="368">
                  <c:v>0</c:v>
                </c:pt>
                <c:pt idx="369">
                  <c:v>0</c:v>
                </c:pt>
                <c:pt idx="370">
                  <c:v>0</c:v>
                </c:pt>
                <c:pt idx="371">
                  <c:v>0</c:v>
                </c:pt>
                <c:pt idx="372">
                  <c:v>0</c:v>
                </c:pt>
                <c:pt idx="373">
                  <c:v>0</c:v>
                </c:pt>
                <c:pt idx="374">
                  <c:v>0</c:v>
                </c:pt>
                <c:pt idx="375">
                  <c:v>0</c:v>
                </c:pt>
                <c:pt idx="376">
                  <c:v>0</c:v>
                </c:pt>
                <c:pt idx="377">
                  <c:v>0</c:v>
                </c:pt>
                <c:pt idx="378">
                  <c:v>0</c:v>
                </c:pt>
                <c:pt idx="379">
                  <c:v>0</c:v>
                </c:pt>
                <c:pt idx="380">
                  <c:v>0</c:v>
                </c:pt>
                <c:pt idx="381">
                  <c:v>0</c:v>
                </c:pt>
                <c:pt idx="382">
                  <c:v>0</c:v>
                </c:pt>
                <c:pt idx="383">
                  <c:v>0</c:v>
                </c:pt>
                <c:pt idx="384">
                  <c:v>0</c:v>
                </c:pt>
                <c:pt idx="385">
                  <c:v>0</c:v>
                </c:pt>
                <c:pt idx="386">
                  <c:v>0</c:v>
                </c:pt>
                <c:pt idx="387">
                  <c:v>0</c:v>
                </c:pt>
                <c:pt idx="388">
                  <c:v>0</c:v>
                </c:pt>
                <c:pt idx="389">
                  <c:v>0</c:v>
                </c:pt>
                <c:pt idx="390">
                  <c:v>0</c:v>
                </c:pt>
                <c:pt idx="391">
                  <c:v>0</c:v>
                </c:pt>
                <c:pt idx="392">
                  <c:v>0</c:v>
                </c:pt>
                <c:pt idx="393">
                  <c:v>0</c:v>
                </c:pt>
                <c:pt idx="394">
                  <c:v>0</c:v>
                </c:pt>
                <c:pt idx="395">
                  <c:v>0</c:v>
                </c:pt>
                <c:pt idx="396">
                  <c:v>0</c:v>
                </c:pt>
                <c:pt idx="397">
                  <c:v>0</c:v>
                </c:pt>
                <c:pt idx="398">
                  <c:v>0</c:v>
                </c:pt>
                <c:pt idx="399">
                  <c:v>0</c:v>
                </c:pt>
                <c:pt idx="400">
                  <c:v>0</c:v>
                </c:pt>
                <c:pt idx="401">
                  <c:v>0</c:v>
                </c:pt>
                <c:pt idx="402">
                  <c:v>0</c:v>
                </c:pt>
                <c:pt idx="403">
                  <c:v>0</c:v>
                </c:pt>
                <c:pt idx="404">
                  <c:v>0</c:v>
                </c:pt>
                <c:pt idx="405">
                  <c:v>0</c:v>
                </c:pt>
                <c:pt idx="406">
                  <c:v>0</c:v>
                </c:pt>
                <c:pt idx="407">
                  <c:v>0</c:v>
                </c:pt>
                <c:pt idx="408">
                  <c:v>0</c:v>
                </c:pt>
                <c:pt idx="409">
                  <c:v>0</c:v>
                </c:pt>
                <c:pt idx="410">
                  <c:v>0</c:v>
                </c:pt>
                <c:pt idx="411">
                  <c:v>0</c:v>
                </c:pt>
                <c:pt idx="412">
                  <c:v>0</c:v>
                </c:pt>
                <c:pt idx="413">
                  <c:v>0</c:v>
                </c:pt>
                <c:pt idx="414">
                  <c:v>0</c:v>
                </c:pt>
                <c:pt idx="415">
                  <c:v>0</c:v>
                </c:pt>
                <c:pt idx="416">
                  <c:v>0</c:v>
                </c:pt>
                <c:pt idx="417">
                  <c:v>0</c:v>
                </c:pt>
                <c:pt idx="418">
                  <c:v>0</c:v>
                </c:pt>
                <c:pt idx="419">
                  <c:v>0</c:v>
                </c:pt>
                <c:pt idx="420">
                  <c:v>0</c:v>
                </c:pt>
                <c:pt idx="421">
                  <c:v>0</c:v>
                </c:pt>
                <c:pt idx="422">
                  <c:v>0</c:v>
                </c:pt>
                <c:pt idx="423">
                  <c:v>0</c:v>
                </c:pt>
                <c:pt idx="424">
                  <c:v>0</c:v>
                </c:pt>
                <c:pt idx="425">
                  <c:v>0</c:v>
                </c:pt>
                <c:pt idx="426">
                  <c:v>0</c:v>
                </c:pt>
                <c:pt idx="427">
                  <c:v>0</c:v>
                </c:pt>
                <c:pt idx="428">
                  <c:v>0</c:v>
                </c:pt>
                <c:pt idx="429">
                  <c:v>0</c:v>
                </c:pt>
                <c:pt idx="430">
                  <c:v>0</c:v>
                </c:pt>
                <c:pt idx="431">
                  <c:v>0</c:v>
                </c:pt>
                <c:pt idx="432">
                  <c:v>0</c:v>
                </c:pt>
                <c:pt idx="433">
                  <c:v>0</c:v>
                </c:pt>
                <c:pt idx="434">
                  <c:v>0</c:v>
                </c:pt>
                <c:pt idx="435">
                  <c:v>0</c:v>
                </c:pt>
                <c:pt idx="436">
                  <c:v>0</c:v>
                </c:pt>
                <c:pt idx="437">
                  <c:v>0</c:v>
                </c:pt>
                <c:pt idx="438">
                  <c:v>0</c:v>
                </c:pt>
                <c:pt idx="439">
                  <c:v>0</c:v>
                </c:pt>
                <c:pt idx="440">
                  <c:v>0</c:v>
                </c:pt>
                <c:pt idx="441">
                  <c:v>0</c:v>
                </c:pt>
                <c:pt idx="442">
                  <c:v>0</c:v>
                </c:pt>
                <c:pt idx="443">
                  <c:v>0</c:v>
                </c:pt>
                <c:pt idx="444">
                  <c:v>0</c:v>
                </c:pt>
                <c:pt idx="445">
                  <c:v>0</c:v>
                </c:pt>
                <c:pt idx="446">
                  <c:v>0</c:v>
                </c:pt>
                <c:pt idx="447">
                  <c:v>0</c:v>
                </c:pt>
                <c:pt idx="448">
                  <c:v>0</c:v>
                </c:pt>
                <c:pt idx="449">
                  <c:v>0</c:v>
                </c:pt>
                <c:pt idx="450">
                  <c:v>0</c:v>
                </c:pt>
                <c:pt idx="451">
                  <c:v>0</c:v>
                </c:pt>
                <c:pt idx="452">
                  <c:v>0</c:v>
                </c:pt>
                <c:pt idx="453">
                  <c:v>0</c:v>
                </c:pt>
                <c:pt idx="454">
                  <c:v>0</c:v>
                </c:pt>
                <c:pt idx="455">
                  <c:v>0</c:v>
                </c:pt>
                <c:pt idx="456">
                  <c:v>0</c:v>
                </c:pt>
                <c:pt idx="457">
                  <c:v>0</c:v>
                </c:pt>
                <c:pt idx="458">
                  <c:v>0</c:v>
                </c:pt>
                <c:pt idx="459">
                  <c:v>0</c:v>
                </c:pt>
                <c:pt idx="460">
                  <c:v>0</c:v>
                </c:pt>
                <c:pt idx="461">
                  <c:v>0</c:v>
                </c:pt>
                <c:pt idx="462">
                  <c:v>0</c:v>
                </c:pt>
                <c:pt idx="463">
                  <c:v>0</c:v>
                </c:pt>
                <c:pt idx="464">
                  <c:v>0</c:v>
                </c:pt>
                <c:pt idx="465">
                  <c:v>0</c:v>
                </c:pt>
                <c:pt idx="466">
                  <c:v>0</c:v>
                </c:pt>
                <c:pt idx="467">
                  <c:v>0</c:v>
                </c:pt>
                <c:pt idx="468">
                  <c:v>0</c:v>
                </c:pt>
                <c:pt idx="469">
                  <c:v>0</c:v>
                </c:pt>
                <c:pt idx="470">
                  <c:v>0</c:v>
                </c:pt>
                <c:pt idx="471">
                  <c:v>0</c:v>
                </c:pt>
                <c:pt idx="472">
                  <c:v>0</c:v>
                </c:pt>
                <c:pt idx="473">
                  <c:v>0</c:v>
                </c:pt>
                <c:pt idx="474">
                  <c:v>0</c:v>
                </c:pt>
                <c:pt idx="475">
                  <c:v>0</c:v>
                </c:pt>
                <c:pt idx="476">
                  <c:v>0</c:v>
                </c:pt>
                <c:pt idx="477">
                  <c:v>0</c:v>
                </c:pt>
                <c:pt idx="478">
                  <c:v>0</c:v>
                </c:pt>
                <c:pt idx="479">
                  <c:v>0</c:v>
                </c:pt>
                <c:pt idx="480">
                  <c:v>0</c:v>
                </c:pt>
                <c:pt idx="481">
                  <c:v>0</c:v>
                </c:pt>
                <c:pt idx="482">
                  <c:v>0</c:v>
                </c:pt>
                <c:pt idx="483">
                  <c:v>0</c:v>
                </c:pt>
                <c:pt idx="484">
                  <c:v>0</c:v>
                </c:pt>
                <c:pt idx="485">
                  <c:v>0</c:v>
                </c:pt>
                <c:pt idx="486">
                  <c:v>0</c:v>
                </c:pt>
                <c:pt idx="487">
                  <c:v>0</c:v>
                </c:pt>
                <c:pt idx="488">
                  <c:v>0</c:v>
                </c:pt>
                <c:pt idx="489">
                  <c:v>0</c:v>
                </c:pt>
                <c:pt idx="490">
                  <c:v>0</c:v>
                </c:pt>
                <c:pt idx="491">
                  <c:v>0</c:v>
                </c:pt>
                <c:pt idx="492">
                  <c:v>0</c:v>
                </c:pt>
                <c:pt idx="493">
                  <c:v>0</c:v>
                </c:pt>
                <c:pt idx="494">
                  <c:v>0</c:v>
                </c:pt>
                <c:pt idx="495">
                  <c:v>0</c:v>
                </c:pt>
                <c:pt idx="496">
                  <c:v>0</c:v>
                </c:pt>
                <c:pt idx="497">
                  <c:v>0</c:v>
                </c:pt>
                <c:pt idx="498">
                  <c:v>0</c:v>
                </c:pt>
                <c:pt idx="499">
                  <c:v>0</c:v>
                </c:pt>
                <c:pt idx="500">
                  <c:v>0</c:v>
                </c:pt>
                <c:pt idx="501">
                  <c:v>0</c:v>
                </c:pt>
                <c:pt idx="502">
                  <c:v>0</c:v>
                </c:pt>
                <c:pt idx="503">
                  <c:v>0</c:v>
                </c:pt>
                <c:pt idx="504">
                  <c:v>0</c:v>
                </c:pt>
                <c:pt idx="505">
                  <c:v>0</c:v>
                </c:pt>
                <c:pt idx="506">
                  <c:v>0</c:v>
                </c:pt>
                <c:pt idx="507">
                  <c:v>0</c:v>
                </c:pt>
                <c:pt idx="508">
                  <c:v>0</c:v>
                </c:pt>
                <c:pt idx="509">
                  <c:v>0</c:v>
                </c:pt>
                <c:pt idx="510">
                  <c:v>0</c:v>
                </c:pt>
                <c:pt idx="511">
                  <c:v>0</c:v>
                </c:pt>
                <c:pt idx="512">
                  <c:v>0</c:v>
                </c:pt>
                <c:pt idx="513">
                  <c:v>0</c:v>
                </c:pt>
                <c:pt idx="514">
                  <c:v>0</c:v>
                </c:pt>
                <c:pt idx="515">
                  <c:v>0</c:v>
                </c:pt>
                <c:pt idx="516">
                  <c:v>0</c:v>
                </c:pt>
                <c:pt idx="517">
                  <c:v>0</c:v>
                </c:pt>
                <c:pt idx="518">
                  <c:v>0</c:v>
                </c:pt>
                <c:pt idx="519">
                  <c:v>0</c:v>
                </c:pt>
                <c:pt idx="520">
                  <c:v>0</c:v>
                </c:pt>
                <c:pt idx="521">
                  <c:v>0</c:v>
                </c:pt>
                <c:pt idx="522">
                  <c:v>0</c:v>
                </c:pt>
                <c:pt idx="523">
                  <c:v>0</c:v>
                </c:pt>
                <c:pt idx="524">
                  <c:v>0</c:v>
                </c:pt>
                <c:pt idx="525">
                  <c:v>0</c:v>
                </c:pt>
                <c:pt idx="526">
                  <c:v>0</c:v>
                </c:pt>
                <c:pt idx="527">
                  <c:v>0</c:v>
                </c:pt>
                <c:pt idx="528">
                  <c:v>0</c:v>
                </c:pt>
                <c:pt idx="529">
                  <c:v>0</c:v>
                </c:pt>
                <c:pt idx="530">
                  <c:v>0</c:v>
                </c:pt>
                <c:pt idx="531">
                  <c:v>0</c:v>
                </c:pt>
                <c:pt idx="532">
                  <c:v>0</c:v>
                </c:pt>
                <c:pt idx="533">
                  <c:v>0</c:v>
                </c:pt>
                <c:pt idx="534">
                  <c:v>0</c:v>
                </c:pt>
                <c:pt idx="535">
                  <c:v>0</c:v>
                </c:pt>
                <c:pt idx="536">
                  <c:v>0</c:v>
                </c:pt>
                <c:pt idx="537">
                  <c:v>0</c:v>
                </c:pt>
                <c:pt idx="538">
                  <c:v>0</c:v>
                </c:pt>
                <c:pt idx="539">
                  <c:v>0</c:v>
                </c:pt>
                <c:pt idx="540">
                  <c:v>0</c:v>
                </c:pt>
                <c:pt idx="541">
                  <c:v>0</c:v>
                </c:pt>
                <c:pt idx="542">
                  <c:v>0</c:v>
                </c:pt>
                <c:pt idx="543">
                  <c:v>0</c:v>
                </c:pt>
                <c:pt idx="544">
                  <c:v>0</c:v>
                </c:pt>
                <c:pt idx="545">
                  <c:v>0</c:v>
                </c:pt>
                <c:pt idx="546">
                  <c:v>0</c:v>
                </c:pt>
                <c:pt idx="547">
                  <c:v>0</c:v>
                </c:pt>
                <c:pt idx="548">
                  <c:v>0</c:v>
                </c:pt>
                <c:pt idx="549">
                  <c:v>0</c:v>
                </c:pt>
                <c:pt idx="550">
                  <c:v>0</c:v>
                </c:pt>
                <c:pt idx="551">
                  <c:v>0</c:v>
                </c:pt>
                <c:pt idx="552">
                  <c:v>0</c:v>
                </c:pt>
                <c:pt idx="553">
                  <c:v>0</c:v>
                </c:pt>
                <c:pt idx="554">
                  <c:v>0</c:v>
                </c:pt>
                <c:pt idx="555">
                  <c:v>0</c:v>
                </c:pt>
                <c:pt idx="556">
                  <c:v>0</c:v>
                </c:pt>
                <c:pt idx="557">
                  <c:v>0</c:v>
                </c:pt>
                <c:pt idx="558">
                  <c:v>0</c:v>
                </c:pt>
                <c:pt idx="559">
                  <c:v>0</c:v>
                </c:pt>
                <c:pt idx="560">
                  <c:v>0</c:v>
                </c:pt>
                <c:pt idx="561">
                  <c:v>0</c:v>
                </c:pt>
                <c:pt idx="562">
                  <c:v>0</c:v>
                </c:pt>
                <c:pt idx="563">
                  <c:v>0</c:v>
                </c:pt>
                <c:pt idx="564">
                  <c:v>0</c:v>
                </c:pt>
                <c:pt idx="565">
                  <c:v>0</c:v>
                </c:pt>
                <c:pt idx="566">
                  <c:v>0</c:v>
                </c:pt>
                <c:pt idx="567">
                  <c:v>0</c:v>
                </c:pt>
                <c:pt idx="568">
                  <c:v>0</c:v>
                </c:pt>
                <c:pt idx="569">
                  <c:v>0</c:v>
                </c:pt>
                <c:pt idx="570">
                  <c:v>0</c:v>
                </c:pt>
                <c:pt idx="571">
                  <c:v>0</c:v>
                </c:pt>
                <c:pt idx="572">
                  <c:v>0</c:v>
                </c:pt>
                <c:pt idx="573">
                  <c:v>0</c:v>
                </c:pt>
                <c:pt idx="574">
                  <c:v>0</c:v>
                </c:pt>
                <c:pt idx="575">
                  <c:v>0</c:v>
                </c:pt>
                <c:pt idx="576">
                  <c:v>0</c:v>
                </c:pt>
                <c:pt idx="577">
                  <c:v>0</c:v>
                </c:pt>
                <c:pt idx="578">
                  <c:v>0</c:v>
                </c:pt>
                <c:pt idx="579">
                  <c:v>0</c:v>
                </c:pt>
                <c:pt idx="580">
                  <c:v>0</c:v>
                </c:pt>
                <c:pt idx="581">
                  <c:v>0</c:v>
                </c:pt>
                <c:pt idx="582">
                  <c:v>0</c:v>
                </c:pt>
                <c:pt idx="583">
                  <c:v>0</c:v>
                </c:pt>
                <c:pt idx="584">
                  <c:v>0</c:v>
                </c:pt>
                <c:pt idx="585">
                  <c:v>0</c:v>
                </c:pt>
                <c:pt idx="586">
                  <c:v>0</c:v>
                </c:pt>
                <c:pt idx="587">
                  <c:v>0</c:v>
                </c:pt>
                <c:pt idx="588">
                  <c:v>0</c:v>
                </c:pt>
                <c:pt idx="589">
                  <c:v>0</c:v>
                </c:pt>
                <c:pt idx="590">
                  <c:v>0</c:v>
                </c:pt>
                <c:pt idx="591">
                  <c:v>0</c:v>
                </c:pt>
                <c:pt idx="592">
                  <c:v>0</c:v>
                </c:pt>
                <c:pt idx="593">
                  <c:v>0</c:v>
                </c:pt>
                <c:pt idx="594">
                  <c:v>0</c:v>
                </c:pt>
                <c:pt idx="595">
                  <c:v>0</c:v>
                </c:pt>
                <c:pt idx="596">
                  <c:v>0</c:v>
                </c:pt>
                <c:pt idx="597">
                  <c:v>0</c:v>
                </c:pt>
                <c:pt idx="598">
                  <c:v>0</c:v>
                </c:pt>
                <c:pt idx="599">
                  <c:v>0</c:v>
                </c:pt>
                <c:pt idx="600">
                  <c:v>0</c:v>
                </c:pt>
                <c:pt idx="601">
                  <c:v>0</c:v>
                </c:pt>
                <c:pt idx="602">
                  <c:v>0</c:v>
                </c:pt>
                <c:pt idx="603">
                  <c:v>0</c:v>
                </c:pt>
                <c:pt idx="604">
                  <c:v>0</c:v>
                </c:pt>
                <c:pt idx="605">
                  <c:v>0</c:v>
                </c:pt>
                <c:pt idx="606">
                  <c:v>0</c:v>
                </c:pt>
                <c:pt idx="607">
                  <c:v>0</c:v>
                </c:pt>
                <c:pt idx="608">
                  <c:v>0</c:v>
                </c:pt>
                <c:pt idx="609">
                  <c:v>0</c:v>
                </c:pt>
                <c:pt idx="610">
                  <c:v>0</c:v>
                </c:pt>
                <c:pt idx="611">
                  <c:v>0</c:v>
                </c:pt>
                <c:pt idx="612">
                  <c:v>0</c:v>
                </c:pt>
                <c:pt idx="613">
                  <c:v>0</c:v>
                </c:pt>
                <c:pt idx="614">
                  <c:v>0</c:v>
                </c:pt>
                <c:pt idx="615">
                  <c:v>0</c:v>
                </c:pt>
                <c:pt idx="616">
                  <c:v>0</c:v>
                </c:pt>
                <c:pt idx="617">
                  <c:v>0</c:v>
                </c:pt>
                <c:pt idx="618">
                  <c:v>0</c:v>
                </c:pt>
                <c:pt idx="619">
                  <c:v>0</c:v>
                </c:pt>
                <c:pt idx="620">
                  <c:v>0</c:v>
                </c:pt>
                <c:pt idx="621">
                  <c:v>0</c:v>
                </c:pt>
                <c:pt idx="622">
                  <c:v>0</c:v>
                </c:pt>
                <c:pt idx="623">
                  <c:v>0</c:v>
                </c:pt>
                <c:pt idx="624">
                  <c:v>0</c:v>
                </c:pt>
                <c:pt idx="625">
                  <c:v>0</c:v>
                </c:pt>
                <c:pt idx="626">
                  <c:v>0</c:v>
                </c:pt>
                <c:pt idx="627">
                  <c:v>0</c:v>
                </c:pt>
                <c:pt idx="628">
                  <c:v>0</c:v>
                </c:pt>
                <c:pt idx="629">
                  <c:v>0</c:v>
                </c:pt>
                <c:pt idx="630">
                  <c:v>0</c:v>
                </c:pt>
                <c:pt idx="631">
                  <c:v>0</c:v>
                </c:pt>
                <c:pt idx="632">
                  <c:v>0</c:v>
                </c:pt>
                <c:pt idx="633">
                  <c:v>0</c:v>
                </c:pt>
                <c:pt idx="634">
                  <c:v>0</c:v>
                </c:pt>
                <c:pt idx="635">
                  <c:v>0</c:v>
                </c:pt>
                <c:pt idx="636">
                  <c:v>0</c:v>
                </c:pt>
                <c:pt idx="637">
                  <c:v>0</c:v>
                </c:pt>
                <c:pt idx="638">
                  <c:v>0</c:v>
                </c:pt>
                <c:pt idx="639">
                  <c:v>0</c:v>
                </c:pt>
                <c:pt idx="640">
                  <c:v>0</c:v>
                </c:pt>
                <c:pt idx="641">
                  <c:v>0</c:v>
                </c:pt>
                <c:pt idx="642">
                  <c:v>0</c:v>
                </c:pt>
                <c:pt idx="643">
                  <c:v>0</c:v>
                </c:pt>
                <c:pt idx="644">
                  <c:v>0</c:v>
                </c:pt>
                <c:pt idx="645">
                  <c:v>0</c:v>
                </c:pt>
                <c:pt idx="646">
                  <c:v>0</c:v>
                </c:pt>
                <c:pt idx="647">
                  <c:v>0</c:v>
                </c:pt>
                <c:pt idx="648">
                  <c:v>0</c:v>
                </c:pt>
                <c:pt idx="649">
                  <c:v>0</c:v>
                </c:pt>
                <c:pt idx="650">
                  <c:v>0</c:v>
                </c:pt>
                <c:pt idx="651">
                  <c:v>0</c:v>
                </c:pt>
                <c:pt idx="652">
                  <c:v>0</c:v>
                </c:pt>
                <c:pt idx="653">
                  <c:v>0</c:v>
                </c:pt>
                <c:pt idx="654">
                  <c:v>0</c:v>
                </c:pt>
                <c:pt idx="655">
                  <c:v>0</c:v>
                </c:pt>
                <c:pt idx="656">
                  <c:v>0</c:v>
                </c:pt>
                <c:pt idx="657">
                  <c:v>0</c:v>
                </c:pt>
                <c:pt idx="658">
                  <c:v>0</c:v>
                </c:pt>
                <c:pt idx="659">
                  <c:v>0</c:v>
                </c:pt>
                <c:pt idx="660">
                  <c:v>0</c:v>
                </c:pt>
                <c:pt idx="661">
                  <c:v>0</c:v>
                </c:pt>
                <c:pt idx="662">
                  <c:v>0</c:v>
                </c:pt>
                <c:pt idx="663">
                  <c:v>0</c:v>
                </c:pt>
                <c:pt idx="664">
                  <c:v>0</c:v>
                </c:pt>
                <c:pt idx="665">
                  <c:v>0</c:v>
                </c:pt>
                <c:pt idx="666">
                  <c:v>0</c:v>
                </c:pt>
                <c:pt idx="667">
                  <c:v>0</c:v>
                </c:pt>
                <c:pt idx="668">
                  <c:v>0</c:v>
                </c:pt>
                <c:pt idx="669">
                  <c:v>0</c:v>
                </c:pt>
                <c:pt idx="670">
                  <c:v>0</c:v>
                </c:pt>
                <c:pt idx="671">
                  <c:v>0</c:v>
                </c:pt>
                <c:pt idx="672">
                  <c:v>0</c:v>
                </c:pt>
                <c:pt idx="673">
                  <c:v>0</c:v>
                </c:pt>
                <c:pt idx="674">
                  <c:v>0</c:v>
                </c:pt>
                <c:pt idx="675">
                  <c:v>0</c:v>
                </c:pt>
                <c:pt idx="676">
                  <c:v>0</c:v>
                </c:pt>
                <c:pt idx="677">
                  <c:v>0</c:v>
                </c:pt>
                <c:pt idx="678">
                  <c:v>0</c:v>
                </c:pt>
                <c:pt idx="679">
                  <c:v>0</c:v>
                </c:pt>
                <c:pt idx="680">
                  <c:v>0</c:v>
                </c:pt>
                <c:pt idx="681">
                  <c:v>0</c:v>
                </c:pt>
                <c:pt idx="682">
                  <c:v>0</c:v>
                </c:pt>
                <c:pt idx="683">
                  <c:v>0</c:v>
                </c:pt>
                <c:pt idx="684">
                  <c:v>0</c:v>
                </c:pt>
                <c:pt idx="685">
                  <c:v>0</c:v>
                </c:pt>
                <c:pt idx="686">
                  <c:v>0</c:v>
                </c:pt>
                <c:pt idx="687">
                  <c:v>0</c:v>
                </c:pt>
                <c:pt idx="688">
                  <c:v>0</c:v>
                </c:pt>
                <c:pt idx="689">
                  <c:v>0</c:v>
                </c:pt>
                <c:pt idx="690">
                  <c:v>0</c:v>
                </c:pt>
                <c:pt idx="691">
                  <c:v>0</c:v>
                </c:pt>
                <c:pt idx="692">
                  <c:v>0</c:v>
                </c:pt>
                <c:pt idx="693">
                  <c:v>0</c:v>
                </c:pt>
                <c:pt idx="694">
                  <c:v>0</c:v>
                </c:pt>
                <c:pt idx="695">
                  <c:v>0</c:v>
                </c:pt>
                <c:pt idx="696">
                  <c:v>0</c:v>
                </c:pt>
                <c:pt idx="697">
                  <c:v>0</c:v>
                </c:pt>
                <c:pt idx="698">
                  <c:v>0</c:v>
                </c:pt>
                <c:pt idx="699">
                  <c:v>0</c:v>
                </c:pt>
                <c:pt idx="700">
                  <c:v>0</c:v>
                </c:pt>
                <c:pt idx="701">
                  <c:v>0</c:v>
                </c:pt>
                <c:pt idx="702">
                  <c:v>0</c:v>
                </c:pt>
                <c:pt idx="703">
                  <c:v>0</c:v>
                </c:pt>
                <c:pt idx="704">
                  <c:v>0</c:v>
                </c:pt>
                <c:pt idx="705">
                  <c:v>0</c:v>
                </c:pt>
                <c:pt idx="706">
                  <c:v>0</c:v>
                </c:pt>
                <c:pt idx="707">
                  <c:v>0</c:v>
                </c:pt>
                <c:pt idx="708">
                  <c:v>0</c:v>
                </c:pt>
                <c:pt idx="709">
                  <c:v>0</c:v>
                </c:pt>
                <c:pt idx="710">
                  <c:v>0</c:v>
                </c:pt>
                <c:pt idx="711">
                  <c:v>0</c:v>
                </c:pt>
                <c:pt idx="712">
                  <c:v>0</c:v>
                </c:pt>
                <c:pt idx="713">
                  <c:v>0</c:v>
                </c:pt>
                <c:pt idx="714">
                  <c:v>0</c:v>
                </c:pt>
                <c:pt idx="715">
                  <c:v>0</c:v>
                </c:pt>
                <c:pt idx="716">
                  <c:v>0</c:v>
                </c:pt>
                <c:pt idx="717">
                  <c:v>0</c:v>
                </c:pt>
                <c:pt idx="718">
                  <c:v>0</c:v>
                </c:pt>
                <c:pt idx="719">
                  <c:v>0</c:v>
                </c:pt>
                <c:pt idx="720">
                  <c:v>0</c:v>
                </c:pt>
                <c:pt idx="721">
                  <c:v>0</c:v>
                </c:pt>
                <c:pt idx="722">
                  <c:v>0</c:v>
                </c:pt>
                <c:pt idx="723">
                  <c:v>0</c:v>
                </c:pt>
                <c:pt idx="724">
                  <c:v>0</c:v>
                </c:pt>
                <c:pt idx="725">
                  <c:v>0</c:v>
                </c:pt>
                <c:pt idx="726">
                  <c:v>0</c:v>
                </c:pt>
                <c:pt idx="727">
                  <c:v>0</c:v>
                </c:pt>
                <c:pt idx="728">
                  <c:v>0</c:v>
                </c:pt>
                <c:pt idx="729">
                  <c:v>0</c:v>
                </c:pt>
                <c:pt idx="730">
                  <c:v>0</c:v>
                </c:pt>
                <c:pt idx="731">
                  <c:v>0</c:v>
                </c:pt>
                <c:pt idx="732">
                  <c:v>0</c:v>
                </c:pt>
                <c:pt idx="733">
                  <c:v>0</c:v>
                </c:pt>
                <c:pt idx="734">
                  <c:v>0</c:v>
                </c:pt>
                <c:pt idx="735">
                  <c:v>0</c:v>
                </c:pt>
                <c:pt idx="736">
                  <c:v>0</c:v>
                </c:pt>
                <c:pt idx="737">
                  <c:v>0</c:v>
                </c:pt>
                <c:pt idx="738">
                  <c:v>0</c:v>
                </c:pt>
                <c:pt idx="739">
                  <c:v>0</c:v>
                </c:pt>
                <c:pt idx="740">
                  <c:v>0</c:v>
                </c:pt>
                <c:pt idx="741">
                  <c:v>0</c:v>
                </c:pt>
                <c:pt idx="742">
                  <c:v>0</c:v>
                </c:pt>
                <c:pt idx="743">
                  <c:v>0</c:v>
                </c:pt>
                <c:pt idx="744">
                  <c:v>0</c:v>
                </c:pt>
                <c:pt idx="745">
                  <c:v>0</c:v>
                </c:pt>
                <c:pt idx="746">
                  <c:v>0</c:v>
                </c:pt>
                <c:pt idx="747">
                  <c:v>0</c:v>
                </c:pt>
                <c:pt idx="748">
                  <c:v>0</c:v>
                </c:pt>
                <c:pt idx="749">
                  <c:v>0</c:v>
                </c:pt>
                <c:pt idx="750">
                  <c:v>0</c:v>
                </c:pt>
                <c:pt idx="751">
                  <c:v>0</c:v>
                </c:pt>
                <c:pt idx="752">
                  <c:v>0</c:v>
                </c:pt>
                <c:pt idx="753">
                  <c:v>0</c:v>
                </c:pt>
                <c:pt idx="754">
                  <c:v>0</c:v>
                </c:pt>
                <c:pt idx="755">
                  <c:v>0</c:v>
                </c:pt>
                <c:pt idx="756">
                  <c:v>0</c:v>
                </c:pt>
                <c:pt idx="757">
                  <c:v>0</c:v>
                </c:pt>
                <c:pt idx="758">
                  <c:v>0</c:v>
                </c:pt>
                <c:pt idx="759">
                  <c:v>0</c:v>
                </c:pt>
                <c:pt idx="760">
                  <c:v>0</c:v>
                </c:pt>
                <c:pt idx="761">
                  <c:v>0</c:v>
                </c:pt>
                <c:pt idx="762">
                  <c:v>0</c:v>
                </c:pt>
                <c:pt idx="763">
                  <c:v>0</c:v>
                </c:pt>
                <c:pt idx="764">
                  <c:v>0</c:v>
                </c:pt>
                <c:pt idx="765">
                  <c:v>0</c:v>
                </c:pt>
                <c:pt idx="766">
                  <c:v>0</c:v>
                </c:pt>
                <c:pt idx="767">
                  <c:v>0</c:v>
                </c:pt>
                <c:pt idx="768">
                  <c:v>0</c:v>
                </c:pt>
                <c:pt idx="769">
                  <c:v>0</c:v>
                </c:pt>
                <c:pt idx="770">
                  <c:v>0</c:v>
                </c:pt>
                <c:pt idx="771">
                  <c:v>0</c:v>
                </c:pt>
                <c:pt idx="772">
                  <c:v>0</c:v>
                </c:pt>
                <c:pt idx="773">
                  <c:v>0</c:v>
                </c:pt>
                <c:pt idx="774">
                  <c:v>0</c:v>
                </c:pt>
                <c:pt idx="775">
                  <c:v>0</c:v>
                </c:pt>
                <c:pt idx="776">
                  <c:v>0</c:v>
                </c:pt>
                <c:pt idx="777">
                  <c:v>0</c:v>
                </c:pt>
                <c:pt idx="778">
                  <c:v>0</c:v>
                </c:pt>
                <c:pt idx="779">
                  <c:v>0</c:v>
                </c:pt>
                <c:pt idx="780">
                  <c:v>0</c:v>
                </c:pt>
                <c:pt idx="781">
                  <c:v>0</c:v>
                </c:pt>
                <c:pt idx="782">
                  <c:v>0</c:v>
                </c:pt>
                <c:pt idx="783">
                  <c:v>0</c:v>
                </c:pt>
                <c:pt idx="784">
                  <c:v>0</c:v>
                </c:pt>
                <c:pt idx="785">
                  <c:v>0</c:v>
                </c:pt>
                <c:pt idx="786">
                  <c:v>0</c:v>
                </c:pt>
                <c:pt idx="787">
                  <c:v>0</c:v>
                </c:pt>
                <c:pt idx="788">
                  <c:v>0</c:v>
                </c:pt>
                <c:pt idx="789">
                  <c:v>0</c:v>
                </c:pt>
                <c:pt idx="790">
                  <c:v>0</c:v>
                </c:pt>
                <c:pt idx="791">
                  <c:v>0</c:v>
                </c:pt>
                <c:pt idx="792">
                  <c:v>0</c:v>
                </c:pt>
                <c:pt idx="793">
                  <c:v>0</c:v>
                </c:pt>
                <c:pt idx="794">
                  <c:v>0</c:v>
                </c:pt>
                <c:pt idx="795">
                  <c:v>0</c:v>
                </c:pt>
                <c:pt idx="796">
                  <c:v>0</c:v>
                </c:pt>
                <c:pt idx="797">
                  <c:v>0</c:v>
                </c:pt>
                <c:pt idx="798">
                  <c:v>0</c:v>
                </c:pt>
                <c:pt idx="799">
                  <c:v>0</c:v>
                </c:pt>
                <c:pt idx="800">
                  <c:v>0</c:v>
                </c:pt>
                <c:pt idx="801">
                  <c:v>0</c:v>
                </c:pt>
                <c:pt idx="802">
                  <c:v>0</c:v>
                </c:pt>
                <c:pt idx="803">
                  <c:v>0</c:v>
                </c:pt>
                <c:pt idx="804">
                  <c:v>0</c:v>
                </c:pt>
                <c:pt idx="805">
                  <c:v>0</c:v>
                </c:pt>
                <c:pt idx="806">
                  <c:v>0</c:v>
                </c:pt>
                <c:pt idx="807">
                  <c:v>0</c:v>
                </c:pt>
                <c:pt idx="808">
                  <c:v>0</c:v>
                </c:pt>
                <c:pt idx="809">
                  <c:v>0</c:v>
                </c:pt>
                <c:pt idx="810">
                  <c:v>0</c:v>
                </c:pt>
                <c:pt idx="811">
                  <c:v>0</c:v>
                </c:pt>
                <c:pt idx="812">
                  <c:v>0</c:v>
                </c:pt>
                <c:pt idx="813">
                  <c:v>0</c:v>
                </c:pt>
                <c:pt idx="814">
                  <c:v>0</c:v>
                </c:pt>
                <c:pt idx="815">
                  <c:v>0</c:v>
                </c:pt>
                <c:pt idx="816">
                  <c:v>0</c:v>
                </c:pt>
                <c:pt idx="817">
                  <c:v>0</c:v>
                </c:pt>
                <c:pt idx="818">
                  <c:v>0</c:v>
                </c:pt>
                <c:pt idx="819">
                  <c:v>0</c:v>
                </c:pt>
                <c:pt idx="820">
                  <c:v>0</c:v>
                </c:pt>
                <c:pt idx="821">
                  <c:v>0</c:v>
                </c:pt>
                <c:pt idx="822">
                  <c:v>0</c:v>
                </c:pt>
                <c:pt idx="823">
                  <c:v>0</c:v>
                </c:pt>
                <c:pt idx="824">
                  <c:v>0</c:v>
                </c:pt>
                <c:pt idx="825">
                  <c:v>0</c:v>
                </c:pt>
                <c:pt idx="826">
                  <c:v>0</c:v>
                </c:pt>
                <c:pt idx="827">
                  <c:v>0</c:v>
                </c:pt>
                <c:pt idx="828">
                  <c:v>0</c:v>
                </c:pt>
                <c:pt idx="829">
                  <c:v>0</c:v>
                </c:pt>
                <c:pt idx="830">
                  <c:v>0</c:v>
                </c:pt>
                <c:pt idx="831">
                  <c:v>0</c:v>
                </c:pt>
                <c:pt idx="832">
                  <c:v>0</c:v>
                </c:pt>
                <c:pt idx="833">
                  <c:v>0</c:v>
                </c:pt>
                <c:pt idx="834">
                  <c:v>0</c:v>
                </c:pt>
                <c:pt idx="835">
                  <c:v>0</c:v>
                </c:pt>
                <c:pt idx="836">
                  <c:v>0</c:v>
                </c:pt>
                <c:pt idx="837">
                  <c:v>0</c:v>
                </c:pt>
                <c:pt idx="838">
                  <c:v>0</c:v>
                </c:pt>
                <c:pt idx="839">
                  <c:v>0</c:v>
                </c:pt>
                <c:pt idx="840">
                  <c:v>0</c:v>
                </c:pt>
                <c:pt idx="841">
                  <c:v>0</c:v>
                </c:pt>
                <c:pt idx="842">
                  <c:v>0</c:v>
                </c:pt>
                <c:pt idx="843">
                  <c:v>0</c:v>
                </c:pt>
                <c:pt idx="844">
                  <c:v>0</c:v>
                </c:pt>
                <c:pt idx="845">
                  <c:v>0</c:v>
                </c:pt>
                <c:pt idx="846">
                  <c:v>0</c:v>
                </c:pt>
                <c:pt idx="847">
                  <c:v>0</c:v>
                </c:pt>
                <c:pt idx="848">
                  <c:v>0</c:v>
                </c:pt>
                <c:pt idx="849">
                  <c:v>0</c:v>
                </c:pt>
                <c:pt idx="850">
                  <c:v>0</c:v>
                </c:pt>
                <c:pt idx="851">
                  <c:v>0</c:v>
                </c:pt>
                <c:pt idx="852">
                  <c:v>0</c:v>
                </c:pt>
                <c:pt idx="853">
                  <c:v>0</c:v>
                </c:pt>
                <c:pt idx="854">
                  <c:v>0</c:v>
                </c:pt>
                <c:pt idx="855">
                  <c:v>0</c:v>
                </c:pt>
                <c:pt idx="856">
                  <c:v>0</c:v>
                </c:pt>
                <c:pt idx="857">
                  <c:v>0</c:v>
                </c:pt>
                <c:pt idx="858">
                  <c:v>0</c:v>
                </c:pt>
                <c:pt idx="859">
                  <c:v>0</c:v>
                </c:pt>
                <c:pt idx="860">
                  <c:v>0</c:v>
                </c:pt>
                <c:pt idx="861">
                  <c:v>0</c:v>
                </c:pt>
                <c:pt idx="862">
                  <c:v>0</c:v>
                </c:pt>
                <c:pt idx="863">
                  <c:v>0</c:v>
                </c:pt>
                <c:pt idx="864">
                  <c:v>0</c:v>
                </c:pt>
                <c:pt idx="865">
                  <c:v>0</c:v>
                </c:pt>
                <c:pt idx="866">
                  <c:v>0</c:v>
                </c:pt>
                <c:pt idx="867">
                  <c:v>0</c:v>
                </c:pt>
                <c:pt idx="868">
                  <c:v>0</c:v>
                </c:pt>
                <c:pt idx="869">
                  <c:v>0</c:v>
                </c:pt>
                <c:pt idx="870">
                  <c:v>0</c:v>
                </c:pt>
                <c:pt idx="871">
                  <c:v>0</c:v>
                </c:pt>
                <c:pt idx="872">
                  <c:v>0</c:v>
                </c:pt>
                <c:pt idx="873">
                  <c:v>0</c:v>
                </c:pt>
                <c:pt idx="874">
                  <c:v>0</c:v>
                </c:pt>
                <c:pt idx="875">
                  <c:v>0</c:v>
                </c:pt>
                <c:pt idx="876">
                  <c:v>0</c:v>
                </c:pt>
                <c:pt idx="877">
                  <c:v>0</c:v>
                </c:pt>
                <c:pt idx="878">
                  <c:v>0</c:v>
                </c:pt>
                <c:pt idx="879">
                  <c:v>0</c:v>
                </c:pt>
                <c:pt idx="880">
                  <c:v>0</c:v>
                </c:pt>
                <c:pt idx="881">
                  <c:v>0</c:v>
                </c:pt>
                <c:pt idx="882">
                  <c:v>0</c:v>
                </c:pt>
                <c:pt idx="883">
                  <c:v>0</c:v>
                </c:pt>
                <c:pt idx="884">
                  <c:v>0</c:v>
                </c:pt>
                <c:pt idx="885">
                  <c:v>0</c:v>
                </c:pt>
                <c:pt idx="886">
                  <c:v>0</c:v>
                </c:pt>
                <c:pt idx="887">
                  <c:v>0</c:v>
                </c:pt>
                <c:pt idx="888">
                  <c:v>0</c:v>
                </c:pt>
                <c:pt idx="889">
                  <c:v>0</c:v>
                </c:pt>
                <c:pt idx="890">
                  <c:v>0</c:v>
                </c:pt>
                <c:pt idx="891">
                  <c:v>0</c:v>
                </c:pt>
                <c:pt idx="892">
                  <c:v>0</c:v>
                </c:pt>
                <c:pt idx="893">
                  <c:v>0</c:v>
                </c:pt>
                <c:pt idx="894">
                  <c:v>0</c:v>
                </c:pt>
                <c:pt idx="895">
                  <c:v>0</c:v>
                </c:pt>
                <c:pt idx="896">
                  <c:v>0</c:v>
                </c:pt>
                <c:pt idx="897">
                  <c:v>0</c:v>
                </c:pt>
                <c:pt idx="898">
                  <c:v>0</c:v>
                </c:pt>
                <c:pt idx="899">
                  <c:v>0</c:v>
                </c:pt>
                <c:pt idx="900">
                  <c:v>0</c:v>
                </c:pt>
                <c:pt idx="901">
                  <c:v>0</c:v>
                </c:pt>
                <c:pt idx="902">
                  <c:v>0</c:v>
                </c:pt>
                <c:pt idx="903">
                  <c:v>0</c:v>
                </c:pt>
                <c:pt idx="904">
                  <c:v>0</c:v>
                </c:pt>
                <c:pt idx="905">
                  <c:v>0</c:v>
                </c:pt>
                <c:pt idx="906">
                  <c:v>0</c:v>
                </c:pt>
                <c:pt idx="907">
                  <c:v>0</c:v>
                </c:pt>
                <c:pt idx="908">
                  <c:v>0</c:v>
                </c:pt>
                <c:pt idx="909">
                  <c:v>0</c:v>
                </c:pt>
                <c:pt idx="910">
                  <c:v>0</c:v>
                </c:pt>
                <c:pt idx="911">
                  <c:v>0</c:v>
                </c:pt>
                <c:pt idx="912">
                  <c:v>0</c:v>
                </c:pt>
                <c:pt idx="913">
                  <c:v>0</c:v>
                </c:pt>
                <c:pt idx="914">
                  <c:v>0</c:v>
                </c:pt>
                <c:pt idx="915">
                  <c:v>0</c:v>
                </c:pt>
                <c:pt idx="916">
                  <c:v>0</c:v>
                </c:pt>
                <c:pt idx="917">
                  <c:v>0</c:v>
                </c:pt>
                <c:pt idx="918">
                  <c:v>0</c:v>
                </c:pt>
                <c:pt idx="919">
                  <c:v>0</c:v>
                </c:pt>
                <c:pt idx="920">
                  <c:v>0</c:v>
                </c:pt>
                <c:pt idx="921">
                  <c:v>0</c:v>
                </c:pt>
                <c:pt idx="922">
                  <c:v>0</c:v>
                </c:pt>
                <c:pt idx="923">
                  <c:v>0</c:v>
                </c:pt>
                <c:pt idx="924">
                  <c:v>0</c:v>
                </c:pt>
                <c:pt idx="925">
                  <c:v>0</c:v>
                </c:pt>
                <c:pt idx="926">
                  <c:v>0</c:v>
                </c:pt>
                <c:pt idx="927">
                  <c:v>0</c:v>
                </c:pt>
                <c:pt idx="928">
                  <c:v>0</c:v>
                </c:pt>
                <c:pt idx="929">
                  <c:v>0</c:v>
                </c:pt>
                <c:pt idx="930">
                  <c:v>0</c:v>
                </c:pt>
                <c:pt idx="931">
                  <c:v>0</c:v>
                </c:pt>
                <c:pt idx="932">
                  <c:v>0</c:v>
                </c:pt>
                <c:pt idx="933">
                  <c:v>0</c:v>
                </c:pt>
                <c:pt idx="934">
                  <c:v>0</c:v>
                </c:pt>
                <c:pt idx="935">
                  <c:v>0</c:v>
                </c:pt>
                <c:pt idx="936">
                  <c:v>0</c:v>
                </c:pt>
                <c:pt idx="937">
                  <c:v>0</c:v>
                </c:pt>
                <c:pt idx="938">
                  <c:v>0</c:v>
                </c:pt>
                <c:pt idx="939">
                  <c:v>0</c:v>
                </c:pt>
                <c:pt idx="940">
                  <c:v>0</c:v>
                </c:pt>
                <c:pt idx="941">
                  <c:v>0</c:v>
                </c:pt>
                <c:pt idx="942">
                  <c:v>0</c:v>
                </c:pt>
                <c:pt idx="943">
                  <c:v>0</c:v>
                </c:pt>
                <c:pt idx="944">
                  <c:v>0</c:v>
                </c:pt>
                <c:pt idx="945">
                  <c:v>0</c:v>
                </c:pt>
                <c:pt idx="946">
                  <c:v>0</c:v>
                </c:pt>
                <c:pt idx="947">
                  <c:v>0</c:v>
                </c:pt>
                <c:pt idx="948">
                  <c:v>0</c:v>
                </c:pt>
                <c:pt idx="949">
                  <c:v>0</c:v>
                </c:pt>
                <c:pt idx="950">
                  <c:v>0</c:v>
                </c:pt>
                <c:pt idx="951">
                  <c:v>0</c:v>
                </c:pt>
                <c:pt idx="952">
                  <c:v>0</c:v>
                </c:pt>
                <c:pt idx="953">
                  <c:v>0</c:v>
                </c:pt>
                <c:pt idx="954">
                  <c:v>0</c:v>
                </c:pt>
                <c:pt idx="955">
                  <c:v>0</c:v>
                </c:pt>
                <c:pt idx="956">
                  <c:v>0</c:v>
                </c:pt>
                <c:pt idx="957">
                  <c:v>0</c:v>
                </c:pt>
                <c:pt idx="958">
                  <c:v>0</c:v>
                </c:pt>
                <c:pt idx="959">
                  <c:v>0</c:v>
                </c:pt>
                <c:pt idx="960">
                  <c:v>0</c:v>
                </c:pt>
                <c:pt idx="961">
                  <c:v>0</c:v>
                </c:pt>
                <c:pt idx="962">
                  <c:v>0</c:v>
                </c:pt>
                <c:pt idx="963">
                  <c:v>0</c:v>
                </c:pt>
                <c:pt idx="964">
                  <c:v>0</c:v>
                </c:pt>
                <c:pt idx="965">
                  <c:v>0</c:v>
                </c:pt>
                <c:pt idx="966">
                  <c:v>0</c:v>
                </c:pt>
                <c:pt idx="967">
                  <c:v>0</c:v>
                </c:pt>
                <c:pt idx="968">
                  <c:v>0</c:v>
                </c:pt>
                <c:pt idx="969">
                  <c:v>0</c:v>
                </c:pt>
                <c:pt idx="970">
                  <c:v>0</c:v>
                </c:pt>
                <c:pt idx="971">
                  <c:v>0</c:v>
                </c:pt>
                <c:pt idx="972">
                  <c:v>0</c:v>
                </c:pt>
                <c:pt idx="973">
                  <c:v>0</c:v>
                </c:pt>
                <c:pt idx="974">
                  <c:v>0</c:v>
                </c:pt>
                <c:pt idx="975">
                  <c:v>0</c:v>
                </c:pt>
                <c:pt idx="976">
                  <c:v>0</c:v>
                </c:pt>
                <c:pt idx="977">
                  <c:v>0</c:v>
                </c:pt>
                <c:pt idx="978">
                  <c:v>0</c:v>
                </c:pt>
                <c:pt idx="979">
                  <c:v>0</c:v>
                </c:pt>
                <c:pt idx="980">
                  <c:v>0</c:v>
                </c:pt>
                <c:pt idx="981">
                  <c:v>0</c:v>
                </c:pt>
                <c:pt idx="982">
                  <c:v>0</c:v>
                </c:pt>
                <c:pt idx="983">
                  <c:v>0</c:v>
                </c:pt>
                <c:pt idx="984">
                  <c:v>0</c:v>
                </c:pt>
                <c:pt idx="985">
                  <c:v>0</c:v>
                </c:pt>
                <c:pt idx="986">
                  <c:v>0</c:v>
                </c:pt>
                <c:pt idx="987">
                  <c:v>0</c:v>
                </c:pt>
                <c:pt idx="988">
                  <c:v>0</c:v>
                </c:pt>
                <c:pt idx="989">
                  <c:v>0</c:v>
                </c:pt>
                <c:pt idx="990">
                  <c:v>0</c:v>
                </c:pt>
                <c:pt idx="991">
                  <c:v>0</c:v>
                </c:pt>
                <c:pt idx="992">
                  <c:v>0</c:v>
                </c:pt>
                <c:pt idx="993">
                  <c:v>0</c:v>
                </c:pt>
                <c:pt idx="994">
                  <c:v>0</c:v>
                </c:pt>
                <c:pt idx="995">
                  <c:v>0</c:v>
                </c:pt>
                <c:pt idx="996">
                  <c:v>0</c:v>
                </c:pt>
                <c:pt idx="997">
                  <c:v>0</c:v>
                </c:pt>
                <c:pt idx="998">
                  <c:v>0</c:v>
                </c:pt>
                <c:pt idx="999">
                  <c:v>0</c:v>
                </c:pt>
                <c:pt idx="1000">
                  <c:v>0</c:v>
                </c:pt>
                <c:pt idx="1001">
                  <c:v>0</c:v>
                </c:pt>
                <c:pt idx="1002">
                  <c:v>0</c:v>
                </c:pt>
                <c:pt idx="1003">
                  <c:v>0</c:v>
                </c:pt>
                <c:pt idx="1004">
                  <c:v>0</c:v>
                </c:pt>
                <c:pt idx="1005">
                  <c:v>0</c:v>
                </c:pt>
                <c:pt idx="1006">
                  <c:v>0</c:v>
                </c:pt>
                <c:pt idx="1007">
                  <c:v>0</c:v>
                </c:pt>
                <c:pt idx="1008">
                  <c:v>0</c:v>
                </c:pt>
                <c:pt idx="1009">
                  <c:v>0</c:v>
                </c:pt>
                <c:pt idx="1010">
                  <c:v>0</c:v>
                </c:pt>
                <c:pt idx="1011">
                  <c:v>0</c:v>
                </c:pt>
                <c:pt idx="1012">
                  <c:v>0</c:v>
                </c:pt>
                <c:pt idx="1013">
                  <c:v>0</c:v>
                </c:pt>
                <c:pt idx="1014">
                  <c:v>0</c:v>
                </c:pt>
                <c:pt idx="1015">
                  <c:v>0</c:v>
                </c:pt>
                <c:pt idx="1016">
                  <c:v>0</c:v>
                </c:pt>
                <c:pt idx="1017">
                  <c:v>0</c:v>
                </c:pt>
                <c:pt idx="1018">
                  <c:v>0</c:v>
                </c:pt>
                <c:pt idx="1019">
                  <c:v>0</c:v>
                </c:pt>
                <c:pt idx="1020">
                  <c:v>0</c:v>
                </c:pt>
                <c:pt idx="1021">
                  <c:v>0</c:v>
                </c:pt>
                <c:pt idx="1022">
                  <c:v>0</c:v>
                </c:pt>
                <c:pt idx="1023">
                  <c:v>0</c:v>
                </c:pt>
                <c:pt idx="1024">
                  <c:v>0</c:v>
                </c:pt>
                <c:pt idx="1025">
                  <c:v>0</c:v>
                </c:pt>
                <c:pt idx="1026">
                  <c:v>0</c:v>
                </c:pt>
                <c:pt idx="1027">
                  <c:v>0</c:v>
                </c:pt>
                <c:pt idx="1028">
                  <c:v>0</c:v>
                </c:pt>
                <c:pt idx="1029">
                  <c:v>0</c:v>
                </c:pt>
                <c:pt idx="1030">
                  <c:v>0</c:v>
                </c:pt>
                <c:pt idx="1031">
                  <c:v>0</c:v>
                </c:pt>
                <c:pt idx="1032">
                  <c:v>0</c:v>
                </c:pt>
                <c:pt idx="1033">
                  <c:v>0</c:v>
                </c:pt>
                <c:pt idx="1034">
                  <c:v>0</c:v>
                </c:pt>
                <c:pt idx="1035">
                  <c:v>0</c:v>
                </c:pt>
                <c:pt idx="1036">
                  <c:v>0</c:v>
                </c:pt>
                <c:pt idx="1037">
                  <c:v>0</c:v>
                </c:pt>
                <c:pt idx="1038">
                  <c:v>0</c:v>
                </c:pt>
                <c:pt idx="1039">
                  <c:v>0</c:v>
                </c:pt>
                <c:pt idx="1040">
                  <c:v>0</c:v>
                </c:pt>
                <c:pt idx="1041">
                  <c:v>0</c:v>
                </c:pt>
                <c:pt idx="1042">
                  <c:v>0</c:v>
                </c:pt>
                <c:pt idx="1043">
                  <c:v>0</c:v>
                </c:pt>
                <c:pt idx="1044">
                  <c:v>0</c:v>
                </c:pt>
                <c:pt idx="1045">
                  <c:v>0</c:v>
                </c:pt>
                <c:pt idx="1046">
                  <c:v>0</c:v>
                </c:pt>
                <c:pt idx="1047">
                  <c:v>0</c:v>
                </c:pt>
                <c:pt idx="1048">
                  <c:v>0</c:v>
                </c:pt>
                <c:pt idx="1049">
                  <c:v>0</c:v>
                </c:pt>
                <c:pt idx="1050">
                  <c:v>0</c:v>
                </c:pt>
                <c:pt idx="1051">
                  <c:v>0</c:v>
                </c:pt>
                <c:pt idx="1052">
                  <c:v>0</c:v>
                </c:pt>
                <c:pt idx="1053">
                  <c:v>0</c:v>
                </c:pt>
                <c:pt idx="1054">
                  <c:v>0</c:v>
                </c:pt>
                <c:pt idx="1055">
                  <c:v>0</c:v>
                </c:pt>
                <c:pt idx="1056">
                  <c:v>0</c:v>
                </c:pt>
                <c:pt idx="1057">
                  <c:v>0</c:v>
                </c:pt>
                <c:pt idx="1058">
                  <c:v>0</c:v>
                </c:pt>
                <c:pt idx="1059">
                  <c:v>0</c:v>
                </c:pt>
                <c:pt idx="1060">
                  <c:v>0</c:v>
                </c:pt>
                <c:pt idx="1061">
                  <c:v>0</c:v>
                </c:pt>
                <c:pt idx="1062">
                  <c:v>0</c:v>
                </c:pt>
                <c:pt idx="1063">
                  <c:v>0</c:v>
                </c:pt>
                <c:pt idx="1064">
                  <c:v>0</c:v>
                </c:pt>
                <c:pt idx="1065">
                  <c:v>0</c:v>
                </c:pt>
                <c:pt idx="1066">
                  <c:v>0</c:v>
                </c:pt>
                <c:pt idx="1067">
                  <c:v>0</c:v>
                </c:pt>
                <c:pt idx="1068">
                  <c:v>0</c:v>
                </c:pt>
                <c:pt idx="1069">
                  <c:v>0</c:v>
                </c:pt>
                <c:pt idx="1070">
                  <c:v>0</c:v>
                </c:pt>
                <c:pt idx="1071">
                  <c:v>0</c:v>
                </c:pt>
                <c:pt idx="1072">
                  <c:v>0</c:v>
                </c:pt>
                <c:pt idx="1073">
                  <c:v>0</c:v>
                </c:pt>
                <c:pt idx="1074">
                  <c:v>0</c:v>
                </c:pt>
                <c:pt idx="1075">
                  <c:v>0</c:v>
                </c:pt>
                <c:pt idx="1076">
                  <c:v>0</c:v>
                </c:pt>
                <c:pt idx="1077">
                  <c:v>0</c:v>
                </c:pt>
                <c:pt idx="1078">
                  <c:v>0</c:v>
                </c:pt>
                <c:pt idx="1079">
                  <c:v>0</c:v>
                </c:pt>
                <c:pt idx="1080">
                  <c:v>0</c:v>
                </c:pt>
                <c:pt idx="1081">
                  <c:v>0</c:v>
                </c:pt>
                <c:pt idx="1082">
                  <c:v>0</c:v>
                </c:pt>
                <c:pt idx="1083">
                  <c:v>0</c:v>
                </c:pt>
                <c:pt idx="1084">
                  <c:v>0</c:v>
                </c:pt>
                <c:pt idx="1085">
                  <c:v>0</c:v>
                </c:pt>
                <c:pt idx="1086">
                  <c:v>0</c:v>
                </c:pt>
                <c:pt idx="1087">
                  <c:v>0</c:v>
                </c:pt>
                <c:pt idx="1088">
                  <c:v>0</c:v>
                </c:pt>
                <c:pt idx="1089">
                  <c:v>0</c:v>
                </c:pt>
                <c:pt idx="1090">
                  <c:v>0</c:v>
                </c:pt>
                <c:pt idx="1091">
                  <c:v>0</c:v>
                </c:pt>
                <c:pt idx="1092">
                  <c:v>0</c:v>
                </c:pt>
                <c:pt idx="1093">
                  <c:v>0</c:v>
                </c:pt>
                <c:pt idx="1094">
                  <c:v>0</c:v>
                </c:pt>
                <c:pt idx="1095">
                  <c:v>0</c:v>
                </c:pt>
                <c:pt idx="1096">
                  <c:v>0</c:v>
                </c:pt>
                <c:pt idx="1097">
                  <c:v>0</c:v>
                </c:pt>
                <c:pt idx="1098">
                  <c:v>0</c:v>
                </c:pt>
                <c:pt idx="1099">
                  <c:v>0</c:v>
                </c:pt>
                <c:pt idx="1100">
                  <c:v>0</c:v>
                </c:pt>
                <c:pt idx="1101">
                  <c:v>0</c:v>
                </c:pt>
                <c:pt idx="1102">
                  <c:v>0</c:v>
                </c:pt>
                <c:pt idx="1103">
                  <c:v>0</c:v>
                </c:pt>
                <c:pt idx="1104">
                  <c:v>0</c:v>
                </c:pt>
                <c:pt idx="1105">
                  <c:v>0</c:v>
                </c:pt>
                <c:pt idx="1106">
                  <c:v>0</c:v>
                </c:pt>
                <c:pt idx="1107">
                  <c:v>0</c:v>
                </c:pt>
                <c:pt idx="1108">
                  <c:v>0</c:v>
                </c:pt>
                <c:pt idx="1109">
                  <c:v>0</c:v>
                </c:pt>
                <c:pt idx="1110">
                  <c:v>0</c:v>
                </c:pt>
                <c:pt idx="1111">
                  <c:v>0</c:v>
                </c:pt>
                <c:pt idx="1112">
                  <c:v>0</c:v>
                </c:pt>
                <c:pt idx="1113">
                  <c:v>0</c:v>
                </c:pt>
                <c:pt idx="1114">
                  <c:v>0</c:v>
                </c:pt>
                <c:pt idx="1115">
                  <c:v>0</c:v>
                </c:pt>
                <c:pt idx="1116">
                  <c:v>0</c:v>
                </c:pt>
                <c:pt idx="1117">
                  <c:v>0</c:v>
                </c:pt>
                <c:pt idx="1118">
                  <c:v>0</c:v>
                </c:pt>
                <c:pt idx="1119">
                  <c:v>0</c:v>
                </c:pt>
                <c:pt idx="1120">
                  <c:v>0</c:v>
                </c:pt>
                <c:pt idx="1121">
                  <c:v>0</c:v>
                </c:pt>
                <c:pt idx="1122">
                  <c:v>0</c:v>
                </c:pt>
                <c:pt idx="1123">
                  <c:v>0</c:v>
                </c:pt>
                <c:pt idx="1124">
                  <c:v>0</c:v>
                </c:pt>
                <c:pt idx="1125">
                  <c:v>0</c:v>
                </c:pt>
                <c:pt idx="1126">
                  <c:v>0</c:v>
                </c:pt>
                <c:pt idx="1127">
                  <c:v>0</c:v>
                </c:pt>
                <c:pt idx="1128">
                  <c:v>0</c:v>
                </c:pt>
                <c:pt idx="1129">
                  <c:v>0</c:v>
                </c:pt>
                <c:pt idx="1130">
                  <c:v>0</c:v>
                </c:pt>
                <c:pt idx="1131">
                  <c:v>0</c:v>
                </c:pt>
                <c:pt idx="1132">
                  <c:v>0</c:v>
                </c:pt>
                <c:pt idx="1133">
                  <c:v>0</c:v>
                </c:pt>
                <c:pt idx="1134">
                  <c:v>0</c:v>
                </c:pt>
                <c:pt idx="1135">
                  <c:v>0</c:v>
                </c:pt>
                <c:pt idx="1136">
                  <c:v>0</c:v>
                </c:pt>
                <c:pt idx="1137">
                  <c:v>0</c:v>
                </c:pt>
                <c:pt idx="1138">
                  <c:v>0</c:v>
                </c:pt>
                <c:pt idx="1139">
                  <c:v>0</c:v>
                </c:pt>
                <c:pt idx="1140">
                  <c:v>0</c:v>
                </c:pt>
                <c:pt idx="1141">
                  <c:v>0</c:v>
                </c:pt>
                <c:pt idx="1142">
                  <c:v>0</c:v>
                </c:pt>
                <c:pt idx="1143">
                  <c:v>0</c:v>
                </c:pt>
                <c:pt idx="1144">
                  <c:v>0</c:v>
                </c:pt>
                <c:pt idx="1145">
                  <c:v>0</c:v>
                </c:pt>
                <c:pt idx="1146">
                  <c:v>0</c:v>
                </c:pt>
                <c:pt idx="1147">
                  <c:v>0</c:v>
                </c:pt>
                <c:pt idx="1148">
                  <c:v>0</c:v>
                </c:pt>
                <c:pt idx="1149">
                  <c:v>0</c:v>
                </c:pt>
                <c:pt idx="1150">
                  <c:v>0</c:v>
                </c:pt>
                <c:pt idx="1151">
                  <c:v>0</c:v>
                </c:pt>
                <c:pt idx="1152">
                  <c:v>0</c:v>
                </c:pt>
                <c:pt idx="1153">
                  <c:v>0</c:v>
                </c:pt>
                <c:pt idx="1154">
                  <c:v>0</c:v>
                </c:pt>
                <c:pt idx="1155">
                  <c:v>0</c:v>
                </c:pt>
                <c:pt idx="1156">
                  <c:v>0</c:v>
                </c:pt>
                <c:pt idx="1157">
                  <c:v>0</c:v>
                </c:pt>
                <c:pt idx="1158">
                  <c:v>0</c:v>
                </c:pt>
                <c:pt idx="1159">
                  <c:v>0</c:v>
                </c:pt>
                <c:pt idx="1160">
                  <c:v>0</c:v>
                </c:pt>
                <c:pt idx="1161">
                  <c:v>0</c:v>
                </c:pt>
                <c:pt idx="1162">
                  <c:v>0</c:v>
                </c:pt>
                <c:pt idx="1163">
                  <c:v>0</c:v>
                </c:pt>
                <c:pt idx="1164">
                  <c:v>0</c:v>
                </c:pt>
                <c:pt idx="1165">
                  <c:v>0</c:v>
                </c:pt>
                <c:pt idx="1166">
                  <c:v>0</c:v>
                </c:pt>
                <c:pt idx="1167">
                  <c:v>0</c:v>
                </c:pt>
                <c:pt idx="1168">
                  <c:v>0</c:v>
                </c:pt>
                <c:pt idx="1169">
                  <c:v>0</c:v>
                </c:pt>
                <c:pt idx="1170">
                  <c:v>0</c:v>
                </c:pt>
                <c:pt idx="1171">
                  <c:v>0</c:v>
                </c:pt>
                <c:pt idx="1172">
                  <c:v>0</c:v>
                </c:pt>
                <c:pt idx="1173">
                  <c:v>0</c:v>
                </c:pt>
                <c:pt idx="1174">
                  <c:v>0</c:v>
                </c:pt>
                <c:pt idx="1175">
                  <c:v>0</c:v>
                </c:pt>
                <c:pt idx="1176">
                  <c:v>0</c:v>
                </c:pt>
                <c:pt idx="1177">
                  <c:v>0</c:v>
                </c:pt>
                <c:pt idx="1178">
                  <c:v>0</c:v>
                </c:pt>
                <c:pt idx="1179">
                  <c:v>0</c:v>
                </c:pt>
                <c:pt idx="1180">
                  <c:v>0</c:v>
                </c:pt>
                <c:pt idx="1181">
                  <c:v>0</c:v>
                </c:pt>
                <c:pt idx="1182">
                  <c:v>0</c:v>
                </c:pt>
                <c:pt idx="1183">
                  <c:v>0</c:v>
                </c:pt>
                <c:pt idx="1184">
                  <c:v>0</c:v>
                </c:pt>
                <c:pt idx="1185">
                  <c:v>0</c:v>
                </c:pt>
                <c:pt idx="1186">
                  <c:v>0</c:v>
                </c:pt>
                <c:pt idx="1187">
                  <c:v>0</c:v>
                </c:pt>
                <c:pt idx="1188">
                  <c:v>0</c:v>
                </c:pt>
                <c:pt idx="1189">
                  <c:v>0</c:v>
                </c:pt>
                <c:pt idx="1190">
                  <c:v>0</c:v>
                </c:pt>
                <c:pt idx="1191">
                  <c:v>0</c:v>
                </c:pt>
                <c:pt idx="1192">
                  <c:v>0</c:v>
                </c:pt>
                <c:pt idx="1193">
                  <c:v>0</c:v>
                </c:pt>
                <c:pt idx="1194">
                  <c:v>0</c:v>
                </c:pt>
                <c:pt idx="1195">
                  <c:v>0</c:v>
                </c:pt>
                <c:pt idx="1196">
                  <c:v>0</c:v>
                </c:pt>
                <c:pt idx="1197">
                  <c:v>0</c:v>
                </c:pt>
                <c:pt idx="1198">
                  <c:v>0</c:v>
                </c:pt>
                <c:pt idx="1199">
                  <c:v>0</c:v>
                </c:pt>
                <c:pt idx="1200">
                  <c:v>0</c:v>
                </c:pt>
                <c:pt idx="1201">
                  <c:v>0</c:v>
                </c:pt>
                <c:pt idx="1202">
                  <c:v>0</c:v>
                </c:pt>
                <c:pt idx="1203">
                  <c:v>0</c:v>
                </c:pt>
                <c:pt idx="1204">
                  <c:v>0</c:v>
                </c:pt>
                <c:pt idx="1205">
                  <c:v>0</c:v>
                </c:pt>
                <c:pt idx="1206">
                  <c:v>0</c:v>
                </c:pt>
                <c:pt idx="1207">
                  <c:v>0</c:v>
                </c:pt>
                <c:pt idx="1208">
                  <c:v>0</c:v>
                </c:pt>
                <c:pt idx="1209">
                  <c:v>0</c:v>
                </c:pt>
                <c:pt idx="1210">
                  <c:v>0</c:v>
                </c:pt>
                <c:pt idx="1211">
                  <c:v>0</c:v>
                </c:pt>
                <c:pt idx="1212">
                  <c:v>0</c:v>
                </c:pt>
                <c:pt idx="1213">
                  <c:v>0</c:v>
                </c:pt>
                <c:pt idx="1214">
                  <c:v>0</c:v>
                </c:pt>
                <c:pt idx="1215">
                  <c:v>0</c:v>
                </c:pt>
                <c:pt idx="1216">
                  <c:v>0</c:v>
                </c:pt>
                <c:pt idx="1217">
                  <c:v>0</c:v>
                </c:pt>
                <c:pt idx="1218">
                  <c:v>0</c:v>
                </c:pt>
                <c:pt idx="1219">
                  <c:v>0</c:v>
                </c:pt>
                <c:pt idx="1220">
                  <c:v>0</c:v>
                </c:pt>
                <c:pt idx="1221">
                  <c:v>0</c:v>
                </c:pt>
                <c:pt idx="1222">
                  <c:v>0</c:v>
                </c:pt>
                <c:pt idx="1223">
                  <c:v>0</c:v>
                </c:pt>
                <c:pt idx="1224">
                  <c:v>0</c:v>
                </c:pt>
                <c:pt idx="1225">
                  <c:v>0</c:v>
                </c:pt>
                <c:pt idx="1226">
                  <c:v>0</c:v>
                </c:pt>
                <c:pt idx="1227">
                  <c:v>0</c:v>
                </c:pt>
                <c:pt idx="1228">
                  <c:v>0</c:v>
                </c:pt>
                <c:pt idx="1229">
                  <c:v>0</c:v>
                </c:pt>
                <c:pt idx="1230">
                  <c:v>0</c:v>
                </c:pt>
                <c:pt idx="1231">
                  <c:v>0</c:v>
                </c:pt>
                <c:pt idx="1232">
                  <c:v>0</c:v>
                </c:pt>
                <c:pt idx="1233">
                  <c:v>0</c:v>
                </c:pt>
                <c:pt idx="1234">
                  <c:v>0</c:v>
                </c:pt>
                <c:pt idx="1235">
                  <c:v>0</c:v>
                </c:pt>
                <c:pt idx="1236">
                  <c:v>0</c:v>
                </c:pt>
                <c:pt idx="1237">
                  <c:v>0</c:v>
                </c:pt>
                <c:pt idx="1238">
                  <c:v>0</c:v>
                </c:pt>
                <c:pt idx="1239">
                  <c:v>0</c:v>
                </c:pt>
                <c:pt idx="1240">
                  <c:v>0</c:v>
                </c:pt>
                <c:pt idx="1241">
                  <c:v>0</c:v>
                </c:pt>
                <c:pt idx="1242">
                  <c:v>0</c:v>
                </c:pt>
                <c:pt idx="1243">
                  <c:v>0</c:v>
                </c:pt>
                <c:pt idx="1244">
                  <c:v>0</c:v>
                </c:pt>
                <c:pt idx="1245">
                  <c:v>0</c:v>
                </c:pt>
                <c:pt idx="1246">
                  <c:v>0</c:v>
                </c:pt>
                <c:pt idx="1247">
                  <c:v>0</c:v>
                </c:pt>
                <c:pt idx="1248">
                  <c:v>0</c:v>
                </c:pt>
                <c:pt idx="1249">
                  <c:v>0</c:v>
                </c:pt>
                <c:pt idx="1250">
                  <c:v>0</c:v>
                </c:pt>
                <c:pt idx="1251">
                  <c:v>0</c:v>
                </c:pt>
                <c:pt idx="1252">
                  <c:v>0</c:v>
                </c:pt>
                <c:pt idx="1253">
                  <c:v>0</c:v>
                </c:pt>
                <c:pt idx="1254">
                  <c:v>0</c:v>
                </c:pt>
                <c:pt idx="1255">
                  <c:v>0</c:v>
                </c:pt>
                <c:pt idx="1256">
                  <c:v>0</c:v>
                </c:pt>
                <c:pt idx="1257">
                  <c:v>0</c:v>
                </c:pt>
                <c:pt idx="1258">
                  <c:v>0</c:v>
                </c:pt>
                <c:pt idx="1259">
                  <c:v>0</c:v>
                </c:pt>
                <c:pt idx="1260">
                  <c:v>0</c:v>
                </c:pt>
                <c:pt idx="1261">
                  <c:v>0</c:v>
                </c:pt>
                <c:pt idx="1262">
                  <c:v>0</c:v>
                </c:pt>
                <c:pt idx="1263">
                  <c:v>0</c:v>
                </c:pt>
                <c:pt idx="1264">
                  <c:v>0</c:v>
                </c:pt>
                <c:pt idx="1265">
                  <c:v>0</c:v>
                </c:pt>
                <c:pt idx="1266">
                  <c:v>0</c:v>
                </c:pt>
                <c:pt idx="1267">
                  <c:v>0</c:v>
                </c:pt>
                <c:pt idx="1268">
                  <c:v>0</c:v>
                </c:pt>
                <c:pt idx="1269">
                  <c:v>0</c:v>
                </c:pt>
                <c:pt idx="1270">
                  <c:v>0</c:v>
                </c:pt>
                <c:pt idx="1271">
                  <c:v>0</c:v>
                </c:pt>
                <c:pt idx="1272">
                  <c:v>0</c:v>
                </c:pt>
                <c:pt idx="1273">
                  <c:v>0</c:v>
                </c:pt>
                <c:pt idx="1274">
                  <c:v>0</c:v>
                </c:pt>
                <c:pt idx="1275">
                  <c:v>0</c:v>
                </c:pt>
                <c:pt idx="1276">
                  <c:v>0</c:v>
                </c:pt>
                <c:pt idx="1277">
                  <c:v>0</c:v>
                </c:pt>
                <c:pt idx="1278">
                  <c:v>0</c:v>
                </c:pt>
                <c:pt idx="1279">
                  <c:v>0</c:v>
                </c:pt>
                <c:pt idx="1280">
                  <c:v>0</c:v>
                </c:pt>
                <c:pt idx="1281">
                  <c:v>0</c:v>
                </c:pt>
                <c:pt idx="1282">
                  <c:v>0</c:v>
                </c:pt>
                <c:pt idx="1283">
                  <c:v>0</c:v>
                </c:pt>
                <c:pt idx="1284">
                  <c:v>0</c:v>
                </c:pt>
                <c:pt idx="1285">
                  <c:v>0</c:v>
                </c:pt>
                <c:pt idx="1286">
                  <c:v>0</c:v>
                </c:pt>
                <c:pt idx="1287">
                  <c:v>0</c:v>
                </c:pt>
                <c:pt idx="1288">
                  <c:v>0</c:v>
                </c:pt>
                <c:pt idx="1289">
                  <c:v>0</c:v>
                </c:pt>
                <c:pt idx="1290">
                  <c:v>0</c:v>
                </c:pt>
                <c:pt idx="1291">
                  <c:v>0</c:v>
                </c:pt>
                <c:pt idx="1292">
                  <c:v>0</c:v>
                </c:pt>
                <c:pt idx="1293">
                  <c:v>0</c:v>
                </c:pt>
                <c:pt idx="1294">
                  <c:v>0</c:v>
                </c:pt>
                <c:pt idx="1295">
                  <c:v>0</c:v>
                </c:pt>
                <c:pt idx="1296">
                  <c:v>0</c:v>
                </c:pt>
                <c:pt idx="1297">
                  <c:v>0</c:v>
                </c:pt>
                <c:pt idx="1298">
                  <c:v>0</c:v>
                </c:pt>
                <c:pt idx="1299">
                  <c:v>0</c:v>
                </c:pt>
                <c:pt idx="1300">
                  <c:v>0</c:v>
                </c:pt>
                <c:pt idx="1301">
                  <c:v>0</c:v>
                </c:pt>
                <c:pt idx="1302">
                  <c:v>0</c:v>
                </c:pt>
                <c:pt idx="1303">
                  <c:v>0</c:v>
                </c:pt>
                <c:pt idx="1304">
                  <c:v>0</c:v>
                </c:pt>
                <c:pt idx="1305">
                  <c:v>0</c:v>
                </c:pt>
                <c:pt idx="1306">
                  <c:v>0</c:v>
                </c:pt>
                <c:pt idx="1307">
                  <c:v>0</c:v>
                </c:pt>
                <c:pt idx="1308">
                  <c:v>0</c:v>
                </c:pt>
                <c:pt idx="1309">
                  <c:v>0</c:v>
                </c:pt>
                <c:pt idx="1310">
                  <c:v>0</c:v>
                </c:pt>
                <c:pt idx="1311">
                  <c:v>0</c:v>
                </c:pt>
                <c:pt idx="1312">
                  <c:v>0</c:v>
                </c:pt>
                <c:pt idx="1313">
                  <c:v>0</c:v>
                </c:pt>
                <c:pt idx="1314">
                  <c:v>0</c:v>
                </c:pt>
                <c:pt idx="1315">
                  <c:v>0</c:v>
                </c:pt>
                <c:pt idx="1316">
                  <c:v>0</c:v>
                </c:pt>
                <c:pt idx="1317">
                  <c:v>0</c:v>
                </c:pt>
                <c:pt idx="1318">
                  <c:v>0</c:v>
                </c:pt>
                <c:pt idx="1319">
                  <c:v>0</c:v>
                </c:pt>
                <c:pt idx="1320">
                  <c:v>0</c:v>
                </c:pt>
                <c:pt idx="1321">
                  <c:v>0</c:v>
                </c:pt>
                <c:pt idx="1322">
                  <c:v>0</c:v>
                </c:pt>
                <c:pt idx="1323">
                  <c:v>0</c:v>
                </c:pt>
                <c:pt idx="1324">
                  <c:v>0</c:v>
                </c:pt>
                <c:pt idx="1325">
                  <c:v>0</c:v>
                </c:pt>
                <c:pt idx="1326">
                  <c:v>0</c:v>
                </c:pt>
                <c:pt idx="1327">
                  <c:v>0</c:v>
                </c:pt>
                <c:pt idx="1328">
                  <c:v>0</c:v>
                </c:pt>
                <c:pt idx="1329">
                  <c:v>0</c:v>
                </c:pt>
                <c:pt idx="1330">
                  <c:v>0</c:v>
                </c:pt>
                <c:pt idx="1331">
                  <c:v>0</c:v>
                </c:pt>
                <c:pt idx="1332">
                  <c:v>0</c:v>
                </c:pt>
                <c:pt idx="1333">
                  <c:v>0</c:v>
                </c:pt>
                <c:pt idx="1334">
                  <c:v>0</c:v>
                </c:pt>
                <c:pt idx="1335">
                  <c:v>0</c:v>
                </c:pt>
                <c:pt idx="1336">
                  <c:v>0</c:v>
                </c:pt>
                <c:pt idx="1337">
                  <c:v>0</c:v>
                </c:pt>
                <c:pt idx="1338">
                  <c:v>0</c:v>
                </c:pt>
                <c:pt idx="1339">
                  <c:v>0</c:v>
                </c:pt>
                <c:pt idx="1340">
                  <c:v>0</c:v>
                </c:pt>
                <c:pt idx="1341">
                  <c:v>0</c:v>
                </c:pt>
                <c:pt idx="1342">
                  <c:v>0</c:v>
                </c:pt>
                <c:pt idx="1343">
                  <c:v>0</c:v>
                </c:pt>
                <c:pt idx="1344">
                  <c:v>0</c:v>
                </c:pt>
                <c:pt idx="1345">
                  <c:v>0</c:v>
                </c:pt>
                <c:pt idx="1346">
                  <c:v>0</c:v>
                </c:pt>
                <c:pt idx="1347">
                  <c:v>0</c:v>
                </c:pt>
                <c:pt idx="1348">
                  <c:v>0</c:v>
                </c:pt>
                <c:pt idx="1349">
                  <c:v>0</c:v>
                </c:pt>
                <c:pt idx="1350">
                  <c:v>0</c:v>
                </c:pt>
                <c:pt idx="1351">
                  <c:v>0</c:v>
                </c:pt>
                <c:pt idx="1352">
                  <c:v>0</c:v>
                </c:pt>
                <c:pt idx="1353">
                  <c:v>0</c:v>
                </c:pt>
                <c:pt idx="1354">
                  <c:v>0</c:v>
                </c:pt>
                <c:pt idx="1355">
                  <c:v>0</c:v>
                </c:pt>
                <c:pt idx="1356">
                  <c:v>0</c:v>
                </c:pt>
                <c:pt idx="1357">
                  <c:v>0</c:v>
                </c:pt>
                <c:pt idx="1358">
                  <c:v>0</c:v>
                </c:pt>
                <c:pt idx="1359">
                  <c:v>0</c:v>
                </c:pt>
                <c:pt idx="1360">
                  <c:v>0</c:v>
                </c:pt>
                <c:pt idx="1361">
                  <c:v>0</c:v>
                </c:pt>
                <c:pt idx="1362">
                  <c:v>0</c:v>
                </c:pt>
                <c:pt idx="1363">
                  <c:v>0</c:v>
                </c:pt>
                <c:pt idx="1364">
                  <c:v>0</c:v>
                </c:pt>
                <c:pt idx="1365">
                  <c:v>0</c:v>
                </c:pt>
                <c:pt idx="1366">
                  <c:v>0</c:v>
                </c:pt>
                <c:pt idx="1367">
                  <c:v>0</c:v>
                </c:pt>
                <c:pt idx="1368">
                  <c:v>0</c:v>
                </c:pt>
                <c:pt idx="1369">
                  <c:v>0</c:v>
                </c:pt>
                <c:pt idx="1370">
                  <c:v>0</c:v>
                </c:pt>
                <c:pt idx="1371">
                  <c:v>0</c:v>
                </c:pt>
                <c:pt idx="1372">
                  <c:v>0</c:v>
                </c:pt>
                <c:pt idx="1373">
                  <c:v>0</c:v>
                </c:pt>
                <c:pt idx="1374">
                  <c:v>0</c:v>
                </c:pt>
                <c:pt idx="1375">
                  <c:v>0</c:v>
                </c:pt>
                <c:pt idx="1376">
                  <c:v>0</c:v>
                </c:pt>
                <c:pt idx="1377">
                  <c:v>0</c:v>
                </c:pt>
                <c:pt idx="1378">
                  <c:v>0</c:v>
                </c:pt>
                <c:pt idx="1379">
                  <c:v>0</c:v>
                </c:pt>
                <c:pt idx="1380">
                  <c:v>0</c:v>
                </c:pt>
                <c:pt idx="1381">
                  <c:v>0</c:v>
                </c:pt>
                <c:pt idx="1382">
                  <c:v>0</c:v>
                </c:pt>
                <c:pt idx="1383">
                  <c:v>0</c:v>
                </c:pt>
                <c:pt idx="1384">
                  <c:v>0</c:v>
                </c:pt>
                <c:pt idx="1385">
                  <c:v>0</c:v>
                </c:pt>
                <c:pt idx="1386">
                  <c:v>0</c:v>
                </c:pt>
                <c:pt idx="1387">
                  <c:v>0</c:v>
                </c:pt>
                <c:pt idx="1388">
                  <c:v>0</c:v>
                </c:pt>
                <c:pt idx="1389">
                  <c:v>0</c:v>
                </c:pt>
                <c:pt idx="1390">
                  <c:v>0</c:v>
                </c:pt>
                <c:pt idx="1391">
                  <c:v>0</c:v>
                </c:pt>
                <c:pt idx="1392">
                  <c:v>0</c:v>
                </c:pt>
                <c:pt idx="1393">
                  <c:v>0</c:v>
                </c:pt>
                <c:pt idx="1394">
                  <c:v>0</c:v>
                </c:pt>
                <c:pt idx="1395">
                  <c:v>0</c:v>
                </c:pt>
                <c:pt idx="1396">
                  <c:v>0</c:v>
                </c:pt>
                <c:pt idx="1397">
                  <c:v>0</c:v>
                </c:pt>
                <c:pt idx="1398">
                  <c:v>0</c:v>
                </c:pt>
                <c:pt idx="1399">
                  <c:v>0</c:v>
                </c:pt>
                <c:pt idx="1400">
                  <c:v>0</c:v>
                </c:pt>
                <c:pt idx="1401">
                  <c:v>0</c:v>
                </c:pt>
                <c:pt idx="1402">
                  <c:v>0</c:v>
                </c:pt>
                <c:pt idx="1403">
                  <c:v>0</c:v>
                </c:pt>
                <c:pt idx="1404">
                  <c:v>0</c:v>
                </c:pt>
                <c:pt idx="1405">
                  <c:v>0</c:v>
                </c:pt>
                <c:pt idx="1406">
                  <c:v>0</c:v>
                </c:pt>
                <c:pt idx="1407">
                  <c:v>0</c:v>
                </c:pt>
                <c:pt idx="1408">
                  <c:v>0</c:v>
                </c:pt>
                <c:pt idx="1409">
                  <c:v>0</c:v>
                </c:pt>
                <c:pt idx="1410">
                  <c:v>0</c:v>
                </c:pt>
                <c:pt idx="1411">
                  <c:v>0</c:v>
                </c:pt>
                <c:pt idx="1412">
                  <c:v>0</c:v>
                </c:pt>
                <c:pt idx="1413">
                  <c:v>0</c:v>
                </c:pt>
                <c:pt idx="1414">
                  <c:v>0</c:v>
                </c:pt>
                <c:pt idx="1415">
                  <c:v>0</c:v>
                </c:pt>
                <c:pt idx="1416">
                  <c:v>0</c:v>
                </c:pt>
                <c:pt idx="1417">
                  <c:v>0</c:v>
                </c:pt>
                <c:pt idx="1418">
                  <c:v>0</c:v>
                </c:pt>
                <c:pt idx="1419">
                  <c:v>0</c:v>
                </c:pt>
                <c:pt idx="1420">
                  <c:v>0</c:v>
                </c:pt>
                <c:pt idx="1421">
                  <c:v>0</c:v>
                </c:pt>
                <c:pt idx="1422">
                  <c:v>0</c:v>
                </c:pt>
                <c:pt idx="1423">
                  <c:v>0</c:v>
                </c:pt>
                <c:pt idx="1424">
                  <c:v>0</c:v>
                </c:pt>
                <c:pt idx="1425">
                  <c:v>0</c:v>
                </c:pt>
                <c:pt idx="1426">
                  <c:v>0</c:v>
                </c:pt>
                <c:pt idx="1427">
                  <c:v>0</c:v>
                </c:pt>
                <c:pt idx="1428">
                  <c:v>0</c:v>
                </c:pt>
                <c:pt idx="1429">
                  <c:v>0</c:v>
                </c:pt>
                <c:pt idx="1430">
                  <c:v>0</c:v>
                </c:pt>
                <c:pt idx="1431">
                  <c:v>0</c:v>
                </c:pt>
                <c:pt idx="1432">
                  <c:v>0</c:v>
                </c:pt>
                <c:pt idx="1433">
                  <c:v>0</c:v>
                </c:pt>
                <c:pt idx="1434">
                  <c:v>0</c:v>
                </c:pt>
                <c:pt idx="1435">
                  <c:v>0</c:v>
                </c:pt>
                <c:pt idx="1436">
                  <c:v>0</c:v>
                </c:pt>
                <c:pt idx="1437">
                  <c:v>0</c:v>
                </c:pt>
                <c:pt idx="1438">
                  <c:v>0</c:v>
                </c:pt>
                <c:pt idx="1439">
                  <c:v>0</c:v>
                </c:pt>
                <c:pt idx="1440">
                  <c:v>0</c:v>
                </c:pt>
                <c:pt idx="1441">
                  <c:v>0</c:v>
                </c:pt>
                <c:pt idx="1442">
                  <c:v>0</c:v>
                </c:pt>
                <c:pt idx="1443">
                  <c:v>0</c:v>
                </c:pt>
                <c:pt idx="1444">
                  <c:v>0</c:v>
                </c:pt>
                <c:pt idx="1445">
                  <c:v>0</c:v>
                </c:pt>
                <c:pt idx="1446">
                  <c:v>0</c:v>
                </c:pt>
                <c:pt idx="1447">
                  <c:v>0</c:v>
                </c:pt>
                <c:pt idx="1448">
                  <c:v>0</c:v>
                </c:pt>
                <c:pt idx="1449">
                  <c:v>0</c:v>
                </c:pt>
                <c:pt idx="1450">
                  <c:v>0</c:v>
                </c:pt>
                <c:pt idx="1451">
                  <c:v>0</c:v>
                </c:pt>
                <c:pt idx="1452">
                  <c:v>0</c:v>
                </c:pt>
                <c:pt idx="1453">
                  <c:v>0</c:v>
                </c:pt>
                <c:pt idx="1454">
                  <c:v>0</c:v>
                </c:pt>
                <c:pt idx="1455">
                  <c:v>0</c:v>
                </c:pt>
                <c:pt idx="1456">
                  <c:v>0</c:v>
                </c:pt>
                <c:pt idx="1457">
                  <c:v>0</c:v>
                </c:pt>
                <c:pt idx="1458">
                  <c:v>0</c:v>
                </c:pt>
                <c:pt idx="1459">
                  <c:v>0</c:v>
                </c:pt>
                <c:pt idx="1460">
                  <c:v>0</c:v>
                </c:pt>
                <c:pt idx="1461">
                  <c:v>0</c:v>
                </c:pt>
                <c:pt idx="1462">
                  <c:v>0</c:v>
                </c:pt>
                <c:pt idx="1463">
                  <c:v>0</c:v>
                </c:pt>
                <c:pt idx="1464">
                  <c:v>0</c:v>
                </c:pt>
                <c:pt idx="1465">
                  <c:v>0</c:v>
                </c:pt>
                <c:pt idx="1466">
                  <c:v>0</c:v>
                </c:pt>
                <c:pt idx="1467">
                  <c:v>0</c:v>
                </c:pt>
                <c:pt idx="1468">
                  <c:v>0</c:v>
                </c:pt>
                <c:pt idx="1469">
                  <c:v>0</c:v>
                </c:pt>
                <c:pt idx="1470">
                  <c:v>0</c:v>
                </c:pt>
                <c:pt idx="1471">
                  <c:v>0</c:v>
                </c:pt>
                <c:pt idx="1472">
                  <c:v>0</c:v>
                </c:pt>
                <c:pt idx="1473">
                  <c:v>0</c:v>
                </c:pt>
                <c:pt idx="1474">
                  <c:v>0</c:v>
                </c:pt>
                <c:pt idx="1475">
                  <c:v>0</c:v>
                </c:pt>
                <c:pt idx="1476">
                  <c:v>0</c:v>
                </c:pt>
                <c:pt idx="1477">
                  <c:v>0</c:v>
                </c:pt>
                <c:pt idx="1478">
                  <c:v>0</c:v>
                </c:pt>
                <c:pt idx="1479">
                  <c:v>0</c:v>
                </c:pt>
                <c:pt idx="1480">
                  <c:v>0</c:v>
                </c:pt>
                <c:pt idx="1481">
                  <c:v>0</c:v>
                </c:pt>
                <c:pt idx="1482">
                  <c:v>0</c:v>
                </c:pt>
                <c:pt idx="1483">
                  <c:v>0</c:v>
                </c:pt>
                <c:pt idx="1484">
                  <c:v>0</c:v>
                </c:pt>
                <c:pt idx="1485">
                  <c:v>0</c:v>
                </c:pt>
                <c:pt idx="1486">
                  <c:v>0</c:v>
                </c:pt>
                <c:pt idx="1487">
                  <c:v>0</c:v>
                </c:pt>
                <c:pt idx="1488">
                  <c:v>0</c:v>
                </c:pt>
                <c:pt idx="1489">
                  <c:v>0</c:v>
                </c:pt>
                <c:pt idx="1490">
                  <c:v>0</c:v>
                </c:pt>
                <c:pt idx="1491">
                  <c:v>0</c:v>
                </c:pt>
                <c:pt idx="1492">
                  <c:v>0</c:v>
                </c:pt>
                <c:pt idx="1493">
                  <c:v>0</c:v>
                </c:pt>
                <c:pt idx="1494">
                  <c:v>0</c:v>
                </c:pt>
                <c:pt idx="1495">
                  <c:v>0</c:v>
                </c:pt>
                <c:pt idx="1496">
                  <c:v>0</c:v>
                </c:pt>
                <c:pt idx="1497">
                  <c:v>0</c:v>
                </c:pt>
                <c:pt idx="1498">
                  <c:v>0</c:v>
                </c:pt>
                <c:pt idx="1499">
                  <c:v>0</c:v>
                </c:pt>
                <c:pt idx="1500">
                  <c:v>0</c:v>
                </c:pt>
                <c:pt idx="1501">
                  <c:v>0</c:v>
                </c:pt>
                <c:pt idx="1502">
                  <c:v>0</c:v>
                </c:pt>
                <c:pt idx="1503">
                  <c:v>0</c:v>
                </c:pt>
                <c:pt idx="1504">
                  <c:v>0</c:v>
                </c:pt>
                <c:pt idx="1505">
                  <c:v>0</c:v>
                </c:pt>
                <c:pt idx="1506">
                  <c:v>0</c:v>
                </c:pt>
                <c:pt idx="1507">
                  <c:v>0</c:v>
                </c:pt>
                <c:pt idx="1508">
                  <c:v>0</c:v>
                </c:pt>
                <c:pt idx="1509">
                  <c:v>0</c:v>
                </c:pt>
                <c:pt idx="1510">
                  <c:v>0</c:v>
                </c:pt>
                <c:pt idx="1511">
                  <c:v>0</c:v>
                </c:pt>
                <c:pt idx="1512">
                  <c:v>0</c:v>
                </c:pt>
                <c:pt idx="1513">
                  <c:v>0</c:v>
                </c:pt>
                <c:pt idx="1514">
                  <c:v>0</c:v>
                </c:pt>
                <c:pt idx="1515">
                  <c:v>0</c:v>
                </c:pt>
                <c:pt idx="1516">
                  <c:v>0</c:v>
                </c:pt>
                <c:pt idx="1517">
                  <c:v>0</c:v>
                </c:pt>
                <c:pt idx="1518">
                  <c:v>0</c:v>
                </c:pt>
                <c:pt idx="1519">
                  <c:v>0</c:v>
                </c:pt>
                <c:pt idx="1520">
                  <c:v>0</c:v>
                </c:pt>
                <c:pt idx="1521">
                  <c:v>0</c:v>
                </c:pt>
                <c:pt idx="1522">
                  <c:v>0</c:v>
                </c:pt>
                <c:pt idx="1523">
                  <c:v>0</c:v>
                </c:pt>
                <c:pt idx="1524">
                  <c:v>0</c:v>
                </c:pt>
                <c:pt idx="1525">
                  <c:v>0</c:v>
                </c:pt>
                <c:pt idx="1526">
                  <c:v>0</c:v>
                </c:pt>
                <c:pt idx="1527">
                  <c:v>0</c:v>
                </c:pt>
                <c:pt idx="1528">
                  <c:v>0</c:v>
                </c:pt>
                <c:pt idx="1529">
                  <c:v>0</c:v>
                </c:pt>
                <c:pt idx="1530">
                  <c:v>0</c:v>
                </c:pt>
                <c:pt idx="1531">
                  <c:v>0</c:v>
                </c:pt>
                <c:pt idx="1532">
                  <c:v>0</c:v>
                </c:pt>
                <c:pt idx="1533">
                  <c:v>0</c:v>
                </c:pt>
                <c:pt idx="1534">
                  <c:v>0</c:v>
                </c:pt>
                <c:pt idx="1535">
                  <c:v>0</c:v>
                </c:pt>
                <c:pt idx="1536">
                  <c:v>0</c:v>
                </c:pt>
                <c:pt idx="1537">
                  <c:v>0</c:v>
                </c:pt>
                <c:pt idx="1538">
                  <c:v>0</c:v>
                </c:pt>
                <c:pt idx="1539">
                  <c:v>0</c:v>
                </c:pt>
                <c:pt idx="1540">
                  <c:v>0</c:v>
                </c:pt>
                <c:pt idx="1541">
                  <c:v>0</c:v>
                </c:pt>
                <c:pt idx="1542">
                  <c:v>0</c:v>
                </c:pt>
                <c:pt idx="1543">
                  <c:v>0</c:v>
                </c:pt>
                <c:pt idx="1544">
                  <c:v>0</c:v>
                </c:pt>
                <c:pt idx="1545">
                  <c:v>0</c:v>
                </c:pt>
                <c:pt idx="1546">
                  <c:v>0</c:v>
                </c:pt>
                <c:pt idx="1547">
                  <c:v>0</c:v>
                </c:pt>
                <c:pt idx="1548">
                  <c:v>0</c:v>
                </c:pt>
                <c:pt idx="1549">
                  <c:v>0</c:v>
                </c:pt>
                <c:pt idx="1550">
                  <c:v>0</c:v>
                </c:pt>
                <c:pt idx="1551">
                  <c:v>0</c:v>
                </c:pt>
                <c:pt idx="1552">
                  <c:v>0</c:v>
                </c:pt>
                <c:pt idx="1553">
                  <c:v>0</c:v>
                </c:pt>
                <c:pt idx="1554">
                  <c:v>0</c:v>
                </c:pt>
                <c:pt idx="1555">
                  <c:v>0</c:v>
                </c:pt>
                <c:pt idx="1556">
                  <c:v>0</c:v>
                </c:pt>
                <c:pt idx="1557">
                  <c:v>0</c:v>
                </c:pt>
                <c:pt idx="1558">
                  <c:v>0</c:v>
                </c:pt>
                <c:pt idx="1559">
                  <c:v>0</c:v>
                </c:pt>
                <c:pt idx="1560">
                  <c:v>0</c:v>
                </c:pt>
                <c:pt idx="1561">
                  <c:v>0</c:v>
                </c:pt>
                <c:pt idx="1562">
                  <c:v>0</c:v>
                </c:pt>
                <c:pt idx="1563">
                  <c:v>0</c:v>
                </c:pt>
                <c:pt idx="1564">
                  <c:v>0</c:v>
                </c:pt>
                <c:pt idx="1565">
                  <c:v>0</c:v>
                </c:pt>
                <c:pt idx="1566">
                  <c:v>0</c:v>
                </c:pt>
                <c:pt idx="1567">
                  <c:v>0</c:v>
                </c:pt>
                <c:pt idx="1568">
                  <c:v>0</c:v>
                </c:pt>
                <c:pt idx="1569">
                  <c:v>0</c:v>
                </c:pt>
                <c:pt idx="1570">
                  <c:v>0</c:v>
                </c:pt>
                <c:pt idx="1571">
                  <c:v>0</c:v>
                </c:pt>
                <c:pt idx="1572">
                  <c:v>0</c:v>
                </c:pt>
                <c:pt idx="1573">
                  <c:v>0</c:v>
                </c:pt>
                <c:pt idx="1574">
                  <c:v>0</c:v>
                </c:pt>
                <c:pt idx="1575">
                  <c:v>0</c:v>
                </c:pt>
                <c:pt idx="1576">
                  <c:v>0</c:v>
                </c:pt>
                <c:pt idx="1577">
                  <c:v>0</c:v>
                </c:pt>
                <c:pt idx="1578">
                  <c:v>0</c:v>
                </c:pt>
                <c:pt idx="1579">
                  <c:v>0</c:v>
                </c:pt>
                <c:pt idx="1580">
                  <c:v>0</c:v>
                </c:pt>
                <c:pt idx="1581">
                  <c:v>0</c:v>
                </c:pt>
                <c:pt idx="1582">
                  <c:v>0</c:v>
                </c:pt>
                <c:pt idx="1583">
                  <c:v>0</c:v>
                </c:pt>
                <c:pt idx="1584">
                  <c:v>0</c:v>
                </c:pt>
                <c:pt idx="1585">
                  <c:v>0</c:v>
                </c:pt>
                <c:pt idx="1586">
                  <c:v>0</c:v>
                </c:pt>
                <c:pt idx="1587">
                  <c:v>0</c:v>
                </c:pt>
                <c:pt idx="1588">
                  <c:v>0</c:v>
                </c:pt>
                <c:pt idx="1589">
                  <c:v>0</c:v>
                </c:pt>
                <c:pt idx="1590">
                  <c:v>0</c:v>
                </c:pt>
                <c:pt idx="1591">
                  <c:v>0</c:v>
                </c:pt>
                <c:pt idx="1592">
                  <c:v>0</c:v>
                </c:pt>
                <c:pt idx="1593">
                  <c:v>0</c:v>
                </c:pt>
                <c:pt idx="1594">
                  <c:v>0</c:v>
                </c:pt>
                <c:pt idx="1595">
                  <c:v>0</c:v>
                </c:pt>
                <c:pt idx="1596">
                  <c:v>0</c:v>
                </c:pt>
                <c:pt idx="1597">
                  <c:v>0</c:v>
                </c:pt>
                <c:pt idx="1598">
                  <c:v>0</c:v>
                </c:pt>
                <c:pt idx="1599">
                  <c:v>0</c:v>
                </c:pt>
                <c:pt idx="1600">
                  <c:v>0</c:v>
                </c:pt>
                <c:pt idx="1601">
                  <c:v>0</c:v>
                </c:pt>
                <c:pt idx="1602">
                  <c:v>0</c:v>
                </c:pt>
                <c:pt idx="1603">
                  <c:v>0</c:v>
                </c:pt>
                <c:pt idx="1604">
                  <c:v>0</c:v>
                </c:pt>
                <c:pt idx="1605">
                  <c:v>0</c:v>
                </c:pt>
                <c:pt idx="1606">
                  <c:v>0</c:v>
                </c:pt>
                <c:pt idx="1607">
                  <c:v>0</c:v>
                </c:pt>
                <c:pt idx="1608">
                  <c:v>0</c:v>
                </c:pt>
                <c:pt idx="1609">
                  <c:v>0</c:v>
                </c:pt>
                <c:pt idx="1610">
                  <c:v>0</c:v>
                </c:pt>
                <c:pt idx="1611">
                  <c:v>0</c:v>
                </c:pt>
                <c:pt idx="1612">
                  <c:v>0</c:v>
                </c:pt>
                <c:pt idx="1613">
                  <c:v>0</c:v>
                </c:pt>
                <c:pt idx="1614">
                  <c:v>0</c:v>
                </c:pt>
                <c:pt idx="1615">
                  <c:v>0</c:v>
                </c:pt>
                <c:pt idx="1616">
                  <c:v>0</c:v>
                </c:pt>
                <c:pt idx="1617">
                  <c:v>0</c:v>
                </c:pt>
                <c:pt idx="1618">
                  <c:v>0</c:v>
                </c:pt>
                <c:pt idx="1619">
                  <c:v>0</c:v>
                </c:pt>
                <c:pt idx="1620">
                  <c:v>0</c:v>
                </c:pt>
                <c:pt idx="1621">
                  <c:v>0</c:v>
                </c:pt>
                <c:pt idx="1622">
                  <c:v>0</c:v>
                </c:pt>
                <c:pt idx="1623">
                  <c:v>0</c:v>
                </c:pt>
                <c:pt idx="1624">
                  <c:v>0</c:v>
                </c:pt>
                <c:pt idx="1625">
                  <c:v>0</c:v>
                </c:pt>
                <c:pt idx="1626">
                  <c:v>0</c:v>
                </c:pt>
                <c:pt idx="1627">
                  <c:v>0</c:v>
                </c:pt>
                <c:pt idx="1628">
                  <c:v>0</c:v>
                </c:pt>
                <c:pt idx="1629">
                  <c:v>0</c:v>
                </c:pt>
                <c:pt idx="1630">
                  <c:v>0</c:v>
                </c:pt>
                <c:pt idx="1631">
                  <c:v>0</c:v>
                </c:pt>
                <c:pt idx="1632">
                  <c:v>0</c:v>
                </c:pt>
                <c:pt idx="1633">
                  <c:v>0</c:v>
                </c:pt>
                <c:pt idx="1634">
                  <c:v>0</c:v>
                </c:pt>
                <c:pt idx="1635">
                  <c:v>0</c:v>
                </c:pt>
                <c:pt idx="1636">
                  <c:v>0</c:v>
                </c:pt>
                <c:pt idx="1637">
                  <c:v>0</c:v>
                </c:pt>
                <c:pt idx="1638">
                  <c:v>0</c:v>
                </c:pt>
                <c:pt idx="1639">
                  <c:v>0</c:v>
                </c:pt>
                <c:pt idx="1640">
                  <c:v>0</c:v>
                </c:pt>
                <c:pt idx="1641">
                  <c:v>0</c:v>
                </c:pt>
                <c:pt idx="1642">
                  <c:v>0</c:v>
                </c:pt>
                <c:pt idx="1643">
                  <c:v>0</c:v>
                </c:pt>
                <c:pt idx="1644">
                  <c:v>0</c:v>
                </c:pt>
                <c:pt idx="1645">
                  <c:v>0</c:v>
                </c:pt>
                <c:pt idx="1646">
                  <c:v>0</c:v>
                </c:pt>
                <c:pt idx="1647">
                  <c:v>0</c:v>
                </c:pt>
                <c:pt idx="1648">
                  <c:v>0</c:v>
                </c:pt>
                <c:pt idx="1649">
                  <c:v>0</c:v>
                </c:pt>
                <c:pt idx="1650">
                  <c:v>0</c:v>
                </c:pt>
                <c:pt idx="1651">
                  <c:v>0</c:v>
                </c:pt>
                <c:pt idx="1652">
                  <c:v>0</c:v>
                </c:pt>
                <c:pt idx="1653">
                  <c:v>0</c:v>
                </c:pt>
                <c:pt idx="1654">
                  <c:v>0</c:v>
                </c:pt>
                <c:pt idx="1655">
                  <c:v>0</c:v>
                </c:pt>
                <c:pt idx="1656">
                  <c:v>0</c:v>
                </c:pt>
                <c:pt idx="1657">
                  <c:v>0</c:v>
                </c:pt>
                <c:pt idx="1658">
                  <c:v>0</c:v>
                </c:pt>
                <c:pt idx="1659">
                  <c:v>0</c:v>
                </c:pt>
                <c:pt idx="1660">
                  <c:v>0</c:v>
                </c:pt>
                <c:pt idx="1661">
                  <c:v>0</c:v>
                </c:pt>
                <c:pt idx="1662">
                  <c:v>0</c:v>
                </c:pt>
                <c:pt idx="1663">
                  <c:v>0</c:v>
                </c:pt>
                <c:pt idx="1664">
                  <c:v>0</c:v>
                </c:pt>
                <c:pt idx="1665">
                  <c:v>0</c:v>
                </c:pt>
                <c:pt idx="1666">
                  <c:v>0</c:v>
                </c:pt>
                <c:pt idx="1667">
                  <c:v>0</c:v>
                </c:pt>
                <c:pt idx="1668">
                  <c:v>0</c:v>
                </c:pt>
                <c:pt idx="1669">
                  <c:v>0</c:v>
                </c:pt>
                <c:pt idx="1670">
                  <c:v>0</c:v>
                </c:pt>
                <c:pt idx="1671">
                  <c:v>0</c:v>
                </c:pt>
                <c:pt idx="1672">
                  <c:v>0</c:v>
                </c:pt>
                <c:pt idx="1673">
                  <c:v>0</c:v>
                </c:pt>
                <c:pt idx="1674">
                  <c:v>0</c:v>
                </c:pt>
                <c:pt idx="1675">
                  <c:v>0</c:v>
                </c:pt>
                <c:pt idx="1676">
                  <c:v>0</c:v>
                </c:pt>
                <c:pt idx="1677">
                  <c:v>0</c:v>
                </c:pt>
                <c:pt idx="1678">
                  <c:v>0</c:v>
                </c:pt>
                <c:pt idx="1679">
                  <c:v>0</c:v>
                </c:pt>
                <c:pt idx="1680">
                  <c:v>0</c:v>
                </c:pt>
                <c:pt idx="1681">
                  <c:v>0</c:v>
                </c:pt>
                <c:pt idx="1682">
                  <c:v>0</c:v>
                </c:pt>
                <c:pt idx="1683">
                  <c:v>0</c:v>
                </c:pt>
                <c:pt idx="1684">
                  <c:v>0</c:v>
                </c:pt>
                <c:pt idx="1685">
                  <c:v>0</c:v>
                </c:pt>
                <c:pt idx="1686">
                  <c:v>0</c:v>
                </c:pt>
                <c:pt idx="1687">
                  <c:v>0</c:v>
                </c:pt>
                <c:pt idx="1688">
                  <c:v>0</c:v>
                </c:pt>
                <c:pt idx="1689">
                  <c:v>0</c:v>
                </c:pt>
                <c:pt idx="1690">
                  <c:v>0</c:v>
                </c:pt>
                <c:pt idx="1691">
                  <c:v>0</c:v>
                </c:pt>
                <c:pt idx="1692">
                  <c:v>0</c:v>
                </c:pt>
                <c:pt idx="1693">
                  <c:v>0</c:v>
                </c:pt>
                <c:pt idx="1694">
                  <c:v>0</c:v>
                </c:pt>
                <c:pt idx="1695">
                  <c:v>0</c:v>
                </c:pt>
                <c:pt idx="1696">
                  <c:v>0</c:v>
                </c:pt>
                <c:pt idx="1697">
                  <c:v>0</c:v>
                </c:pt>
                <c:pt idx="1698">
                  <c:v>0</c:v>
                </c:pt>
                <c:pt idx="1699">
                  <c:v>0</c:v>
                </c:pt>
                <c:pt idx="1700">
                  <c:v>0</c:v>
                </c:pt>
                <c:pt idx="1701">
                  <c:v>0</c:v>
                </c:pt>
                <c:pt idx="1702">
                  <c:v>0</c:v>
                </c:pt>
                <c:pt idx="1703">
                  <c:v>0</c:v>
                </c:pt>
                <c:pt idx="1704">
                  <c:v>0</c:v>
                </c:pt>
                <c:pt idx="1705">
                  <c:v>0</c:v>
                </c:pt>
                <c:pt idx="1706">
                  <c:v>0</c:v>
                </c:pt>
                <c:pt idx="1707">
                  <c:v>0</c:v>
                </c:pt>
                <c:pt idx="1708">
                  <c:v>0</c:v>
                </c:pt>
                <c:pt idx="1709">
                  <c:v>0</c:v>
                </c:pt>
                <c:pt idx="1710">
                  <c:v>0</c:v>
                </c:pt>
                <c:pt idx="1711">
                  <c:v>0</c:v>
                </c:pt>
                <c:pt idx="1712">
                  <c:v>0</c:v>
                </c:pt>
                <c:pt idx="1713">
                  <c:v>0</c:v>
                </c:pt>
                <c:pt idx="1714">
                  <c:v>0</c:v>
                </c:pt>
                <c:pt idx="1715">
                  <c:v>0</c:v>
                </c:pt>
                <c:pt idx="1716">
                  <c:v>0</c:v>
                </c:pt>
                <c:pt idx="1717">
                  <c:v>0</c:v>
                </c:pt>
                <c:pt idx="1718">
                  <c:v>0</c:v>
                </c:pt>
                <c:pt idx="1719">
                  <c:v>0</c:v>
                </c:pt>
                <c:pt idx="1720">
                  <c:v>0</c:v>
                </c:pt>
                <c:pt idx="1721">
                  <c:v>0</c:v>
                </c:pt>
                <c:pt idx="1722">
                  <c:v>0</c:v>
                </c:pt>
                <c:pt idx="1723">
                  <c:v>0</c:v>
                </c:pt>
                <c:pt idx="1724">
                  <c:v>0</c:v>
                </c:pt>
                <c:pt idx="1725">
                  <c:v>0</c:v>
                </c:pt>
                <c:pt idx="1726">
                  <c:v>0</c:v>
                </c:pt>
                <c:pt idx="1727">
                  <c:v>0</c:v>
                </c:pt>
                <c:pt idx="1728">
                  <c:v>0</c:v>
                </c:pt>
                <c:pt idx="1729">
                  <c:v>0</c:v>
                </c:pt>
                <c:pt idx="1730">
                  <c:v>0</c:v>
                </c:pt>
                <c:pt idx="1731">
                  <c:v>0</c:v>
                </c:pt>
                <c:pt idx="1732">
                  <c:v>0</c:v>
                </c:pt>
                <c:pt idx="1733">
                  <c:v>0</c:v>
                </c:pt>
                <c:pt idx="1734">
                  <c:v>0</c:v>
                </c:pt>
                <c:pt idx="1735">
                  <c:v>0</c:v>
                </c:pt>
                <c:pt idx="1736">
                  <c:v>0</c:v>
                </c:pt>
                <c:pt idx="1737">
                  <c:v>0</c:v>
                </c:pt>
                <c:pt idx="1738">
                  <c:v>0</c:v>
                </c:pt>
                <c:pt idx="1739">
                  <c:v>0</c:v>
                </c:pt>
                <c:pt idx="1740">
                  <c:v>0</c:v>
                </c:pt>
                <c:pt idx="1741">
                  <c:v>0</c:v>
                </c:pt>
                <c:pt idx="1742">
                  <c:v>0</c:v>
                </c:pt>
                <c:pt idx="1743">
                  <c:v>0</c:v>
                </c:pt>
                <c:pt idx="1744">
                  <c:v>0</c:v>
                </c:pt>
                <c:pt idx="1745">
                  <c:v>0</c:v>
                </c:pt>
                <c:pt idx="1746">
                  <c:v>0</c:v>
                </c:pt>
                <c:pt idx="1747">
                  <c:v>0</c:v>
                </c:pt>
                <c:pt idx="1748">
                  <c:v>0</c:v>
                </c:pt>
                <c:pt idx="1749">
                  <c:v>0</c:v>
                </c:pt>
                <c:pt idx="1750">
                  <c:v>0</c:v>
                </c:pt>
                <c:pt idx="1751">
                  <c:v>0</c:v>
                </c:pt>
                <c:pt idx="1752">
                  <c:v>0</c:v>
                </c:pt>
                <c:pt idx="1753">
                  <c:v>0</c:v>
                </c:pt>
                <c:pt idx="1754">
                  <c:v>0</c:v>
                </c:pt>
                <c:pt idx="1755">
                  <c:v>0</c:v>
                </c:pt>
                <c:pt idx="1756">
                  <c:v>0</c:v>
                </c:pt>
                <c:pt idx="1757">
                  <c:v>0</c:v>
                </c:pt>
                <c:pt idx="1758">
                  <c:v>0</c:v>
                </c:pt>
                <c:pt idx="1759">
                  <c:v>0</c:v>
                </c:pt>
                <c:pt idx="1760">
                  <c:v>0</c:v>
                </c:pt>
                <c:pt idx="1761">
                  <c:v>0</c:v>
                </c:pt>
                <c:pt idx="1762">
                  <c:v>0</c:v>
                </c:pt>
                <c:pt idx="1763">
                  <c:v>0</c:v>
                </c:pt>
                <c:pt idx="1764">
                  <c:v>0</c:v>
                </c:pt>
                <c:pt idx="1765">
                  <c:v>0</c:v>
                </c:pt>
                <c:pt idx="1766">
                  <c:v>0</c:v>
                </c:pt>
                <c:pt idx="1767">
                  <c:v>0</c:v>
                </c:pt>
                <c:pt idx="1768">
                  <c:v>0</c:v>
                </c:pt>
                <c:pt idx="1769">
                  <c:v>0</c:v>
                </c:pt>
                <c:pt idx="1770">
                  <c:v>0</c:v>
                </c:pt>
                <c:pt idx="1771">
                  <c:v>0</c:v>
                </c:pt>
                <c:pt idx="1772">
                  <c:v>0</c:v>
                </c:pt>
                <c:pt idx="1773">
                  <c:v>0</c:v>
                </c:pt>
                <c:pt idx="1774">
                  <c:v>0</c:v>
                </c:pt>
                <c:pt idx="1775">
                  <c:v>0</c:v>
                </c:pt>
                <c:pt idx="1776">
                  <c:v>0</c:v>
                </c:pt>
                <c:pt idx="1777">
                  <c:v>0</c:v>
                </c:pt>
                <c:pt idx="1778">
                  <c:v>0</c:v>
                </c:pt>
                <c:pt idx="1779">
                  <c:v>0</c:v>
                </c:pt>
                <c:pt idx="1780">
                  <c:v>0</c:v>
                </c:pt>
                <c:pt idx="1781">
                  <c:v>0</c:v>
                </c:pt>
                <c:pt idx="1782">
                  <c:v>0</c:v>
                </c:pt>
                <c:pt idx="1783">
                  <c:v>0</c:v>
                </c:pt>
                <c:pt idx="1784">
                  <c:v>0</c:v>
                </c:pt>
                <c:pt idx="1785">
                  <c:v>0</c:v>
                </c:pt>
                <c:pt idx="1786">
                  <c:v>0</c:v>
                </c:pt>
                <c:pt idx="1787">
                  <c:v>0</c:v>
                </c:pt>
                <c:pt idx="1788">
                  <c:v>0</c:v>
                </c:pt>
                <c:pt idx="1789">
                  <c:v>0</c:v>
                </c:pt>
                <c:pt idx="1790">
                  <c:v>0</c:v>
                </c:pt>
                <c:pt idx="1791">
                  <c:v>0</c:v>
                </c:pt>
                <c:pt idx="1792">
                  <c:v>0</c:v>
                </c:pt>
                <c:pt idx="1793">
                  <c:v>0</c:v>
                </c:pt>
                <c:pt idx="1794">
                  <c:v>0</c:v>
                </c:pt>
                <c:pt idx="1795">
                  <c:v>0</c:v>
                </c:pt>
                <c:pt idx="1796">
                  <c:v>0</c:v>
                </c:pt>
                <c:pt idx="1797">
                  <c:v>0</c:v>
                </c:pt>
                <c:pt idx="1798">
                  <c:v>0</c:v>
                </c:pt>
                <c:pt idx="1799">
                  <c:v>0</c:v>
                </c:pt>
                <c:pt idx="1800">
                  <c:v>0</c:v>
                </c:pt>
                <c:pt idx="1801">
                  <c:v>0</c:v>
                </c:pt>
                <c:pt idx="1802">
                  <c:v>0</c:v>
                </c:pt>
                <c:pt idx="1803">
                  <c:v>0</c:v>
                </c:pt>
                <c:pt idx="1804">
                  <c:v>0</c:v>
                </c:pt>
                <c:pt idx="1805">
                  <c:v>0</c:v>
                </c:pt>
                <c:pt idx="1806">
                  <c:v>0</c:v>
                </c:pt>
                <c:pt idx="1807">
                  <c:v>0</c:v>
                </c:pt>
                <c:pt idx="1808">
                  <c:v>0</c:v>
                </c:pt>
                <c:pt idx="1809">
                  <c:v>0</c:v>
                </c:pt>
                <c:pt idx="1810">
                  <c:v>0</c:v>
                </c:pt>
                <c:pt idx="1811">
                  <c:v>0</c:v>
                </c:pt>
                <c:pt idx="1812">
                  <c:v>0</c:v>
                </c:pt>
                <c:pt idx="1813">
                  <c:v>0</c:v>
                </c:pt>
                <c:pt idx="1814">
                  <c:v>0</c:v>
                </c:pt>
                <c:pt idx="1815">
                  <c:v>0</c:v>
                </c:pt>
                <c:pt idx="1816">
                  <c:v>0</c:v>
                </c:pt>
                <c:pt idx="1817">
                  <c:v>0</c:v>
                </c:pt>
                <c:pt idx="1818">
                  <c:v>0</c:v>
                </c:pt>
                <c:pt idx="1819">
                  <c:v>0</c:v>
                </c:pt>
                <c:pt idx="1820">
                  <c:v>0</c:v>
                </c:pt>
                <c:pt idx="1821">
                  <c:v>0</c:v>
                </c:pt>
                <c:pt idx="1822">
                  <c:v>0</c:v>
                </c:pt>
                <c:pt idx="1823">
                  <c:v>0</c:v>
                </c:pt>
                <c:pt idx="1824">
                  <c:v>0</c:v>
                </c:pt>
                <c:pt idx="1825">
                  <c:v>0</c:v>
                </c:pt>
                <c:pt idx="1826">
                  <c:v>0</c:v>
                </c:pt>
                <c:pt idx="1827">
                  <c:v>0</c:v>
                </c:pt>
                <c:pt idx="1828">
                  <c:v>0</c:v>
                </c:pt>
                <c:pt idx="1829">
                  <c:v>0</c:v>
                </c:pt>
                <c:pt idx="1830">
                  <c:v>0</c:v>
                </c:pt>
                <c:pt idx="1831">
                  <c:v>0</c:v>
                </c:pt>
                <c:pt idx="1832">
                  <c:v>0</c:v>
                </c:pt>
                <c:pt idx="1833">
                  <c:v>0</c:v>
                </c:pt>
                <c:pt idx="1834">
                  <c:v>0</c:v>
                </c:pt>
                <c:pt idx="1835">
                  <c:v>0</c:v>
                </c:pt>
                <c:pt idx="1836">
                  <c:v>0</c:v>
                </c:pt>
                <c:pt idx="1837">
                  <c:v>0</c:v>
                </c:pt>
                <c:pt idx="1838">
                  <c:v>0</c:v>
                </c:pt>
                <c:pt idx="1839">
                  <c:v>0</c:v>
                </c:pt>
                <c:pt idx="1840">
                  <c:v>0</c:v>
                </c:pt>
                <c:pt idx="1841">
                  <c:v>0</c:v>
                </c:pt>
                <c:pt idx="1842">
                  <c:v>0</c:v>
                </c:pt>
                <c:pt idx="1843">
                  <c:v>0</c:v>
                </c:pt>
                <c:pt idx="1844">
                  <c:v>0</c:v>
                </c:pt>
                <c:pt idx="1845">
                  <c:v>0</c:v>
                </c:pt>
                <c:pt idx="1846">
                  <c:v>0</c:v>
                </c:pt>
                <c:pt idx="1847">
                  <c:v>0</c:v>
                </c:pt>
                <c:pt idx="1848">
                  <c:v>0</c:v>
                </c:pt>
                <c:pt idx="1849">
                  <c:v>0</c:v>
                </c:pt>
                <c:pt idx="1850">
                  <c:v>0</c:v>
                </c:pt>
                <c:pt idx="1851">
                  <c:v>0</c:v>
                </c:pt>
                <c:pt idx="1852">
                  <c:v>0</c:v>
                </c:pt>
                <c:pt idx="1853">
                  <c:v>0</c:v>
                </c:pt>
                <c:pt idx="1854">
                  <c:v>0</c:v>
                </c:pt>
                <c:pt idx="1855">
                  <c:v>0</c:v>
                </c:pt>
                <c:pt idx="1856">
                  <c:v>0</c:v>
                </c:pt>
                <c:pt idx="1857">
                  <c:v>0</c:v>
                </c:pt>
                <c:pt idx="1858">
                  <c:v>0</c:v>
                </c:pt>
                <c:pt idx="1859">
                  <c:v>0</c:v>
                </c:pt>
                <c:pt idx="1860">
                  <c:v>0</c:v>
                </c:pt>
                <c:pt idx="1861">
                  <c:v>0</c:v>
                </c:pt>
                <c:pt idx="1862">
                  <c:v>0</c:v>
                </c:pt>
                <c:pt idx="1863">
                  <c:v>0</c:v>
                </c:pt>
                <c:pt idx="1864">
                  <c:v>0</c:v>
                </c:pt>
                <c:pt idx="1865">
                  <c:v>0</c:v>
                </c:pt>
                <c:pt idx="1866">
                  <c:v>0</c:v>
                </c:pt>
                <c:pt idx="1867">
                  <c:v>0</c:v>
                </c:pt>
                <c:pt idx="1868">
                  <c:v>0</c:v>
                </c:pt>
                <c:pt idx="1869">
                  <c:v>0</c:v>
                </c:pt>
                <c:pt idx="1870">
                  <c:v>0</c:v>
                </c:pt>
                <c:pt idx="1871">
                  <c:v>0</c:v>
                </c:pt>
                <c:pt idx="1872">
                  <c:v>0</c:v>
                </c:pt>
                <c:pt idx="1873">
                  <c:v>0</c:v>
                </c:pt>
                <c:pt idx="1874">
                  <c:v>0</c:v>
                </c:pt>
                <c:pt idx="1875">
                  <c:v>0</c:v>
                </c:pt>
                <c:pt idx="1876">
                  <c:v>0</c:v>
                </c:pt>
                <c:pt idx="1877">
                  <c:v>0</c:v>
                </c:pt>
                <c:pt idx="1878">
                  <c:v>0</c:v>
                </c:pt>
                <c:pt idx="1879">
                  <c:v>0</c:v>
                </c:pt>
                <c:pt idx="1880">
                  <c:v>0</c:v>
                </c:pt>
                <c:pt idx="1881">
                  <c:v>0</c:v>
                </c:pt>
                <c:pt idx="1882">
                  <c:v>0</c:v>
                </c:pt>
                <c:pt idx="1883">
                  <c:v>0</c:v>
                </c:pt>
                <c:pt idx="1884">
                  <c:v>0</c:v>
                </c:pt>
                <c:pt idx="1885">
                  <c:v>0</c:v>
                </c:pt>
                <c:pt idx="1886">
                  <c:v>0</c:v>
                </c:pt>
                <c:pt idx="1887">
                  <c:v>0</c:v>
                </c:pt>
                <c:pt idx="1888">
                  <c:v>0</c:v>
                </c:pt>
                <c:pt idx="1889">
                  <c:v>0</c:v>
                </c:pt>
                <c:pt idx="1890">
                  <c:v>0</c:v>
                </c:pt>
                <c:pt idx="189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1B36-4F31-AA19-B2D337AE846A}"/>
            </c:ext>
          </c:extLst>
        </c:ser>
        <c:ser>
          <c:idx val="1"/>
          <c:order val="1"/>
          <c:tx>
            <c:strRef>
              <c:f>Sheet1!$D$1</c:f>
              <c:strCache>
                <c:ptCount val="1"/>
                <c:pt idx="0">
                  <c:v>MAS98.12</c:v>
                </c:pt>
              </c:strCache>
            </c:strRef>
          </c:tx>
          <c:spPr>
            <a:ln w="19050" cap="rnd">
              <a:solidFill>
                <a:srgbClr val="FF33CC"/>
              </a:solidFill>
              <a:round/>
            </a:ln>
            <a:effectLst/>
          </c:spPr>
          <c:marker>
            <c:symbol val="none"/>
          </c:marker>
          <c:xVal>
            <c:numRef>
              <c:f>Sheet1!$B$2:$B$1893</c:f>
              <c:numCache>
                <c:formatCode>General</c:formatCode>
                <c:ptCount val="1892"/>
                <c:pt idx="0">
                  <c:v>185.38874724170299</c:v>
                </c:pt>
                <c:pt idx="1">
                  <c:v>185.381086990184</c:v>
                </c:pt>
                <c:pt idx="2">
                  <c:v>185.37342673866601</c:v>
                </c:pt>
                <c:pt idx="3">
                  <c:v>185.365766487147</c:v>
                </c:pt>
                <c:pt idx="4">
                  <c:v>185.35810623562799</c:v>
                </c:pt>
                <c:pt idx="5">
                  <c:v>185.350445984109</c:v>
                </c:pt>
                <c:pt idx="6">
                  <c:v>185.34278573258999</c:v>
                </c:pt>
                <c:pt idx="7">
                  <c:v>185.335125481071</c:v>
                </c:pt>
                <c:pt idx="8">
                  <c:v>185.32746522955301</c:v>
                </c:pt>
                <c:pt idx="9">
                  <c:v>185.319804978034</c:v>
                </c:pt>
                <c:pt idx="10">
                  <c:v>185.31214472651499</c:v>
                </c:pt>
                <c:pt idx="11">
                  <c:v>185.304484474996</c:v>
                </c:pt>
                <c:pt idx="12">
                  <c:v>185.29682422347699</c:v>
                </c:pt>
                <c:pt idx="13">
                  <c:v>185.289163971959</c:v>
                </c:pt>
                <c:pt idx="14">
                  <c:v>185.28150372044001</c:v>
                </c:pt>
                <c:pt idx="15">
                  <c:v>185.273843468921</c:v>
                </c:pt>
                <c:pt idx="16">
                  <c:v>185.26618321740199</c:v>
                </c:pt>
                <c:pt idx="17">
                  <c:v>185.258522965883</c:v>
                </c:pt>
                <c:pt idx="18">
                  <c:v>185.25086271436399</c:v>
                </c:pt>
                <c:pt idx="19">
                  <c:v>185.243202462846</c:v>
                </c:pt>
                <c:pt idx="20">
                  <c:v>185.23554221132699</c:v>
                </c:pt>
                <c:pt idx="21">
                  <c:v>185.227881959808</c:v>
                </c:pt>
                <c:pt idx="22">
                  <c:v>185.22022170828899</c:v>
                </c:pt>
                <c:pt idx="23">
                  <c:v>185.21256145677</c:v>
                </c:pt>
                <c:pt idx="24">
                  <c:v>185.20490120525099</c:v>
                </c:pt>
                <c:pt idx="25">
                  <c:v>185.197240953733</c:v>
                </c:pt>
                <c:pt idx="26">
                  <c:v>185.18958070221399</c:v>
                </c:pt>
                <c:pt idx="27">
                  <c:v>184.048203225908</c:v>
                </c:pt>
                <c:pt idx="28">
                  <c:v>184.04054297438901</c:v>
                </c:pt>
                <c:pt idx="29">
                  <c:v>184.03288272287099</c:v>
                </c:pt>
                <c:pt idx="30">
                  <c:v>184.02522247135201</c:v>
                </c:pt>
                <c:pt idx="31">
                  <c:v>184.017562219833</c:v>
                </c:pt>
                <c:pt idx="32">
                  <c:v>184.00990196831401</c:v>
                </c:pt>
                <c:pt idx="33">
                  <c:v>184.002241716795</c:v>
                </c:pt>
                <c:pt idx="34">
                  <c:v>183.99458146527601</c:v>
                </c:pt>
                <c:pt idx="35">
                  <c:v>183.986921213758</c:v>
                </c:pt>
                <c:pt idx="36">
                  <c:v>183.97926096223901</c:v>
                </c:pt>
                <c:pt idx="37">
                  <c:v>183.97160071072</c:v>
                </c:pt>
                <c:pt idx="38">
                  <c:v>183.96394045920101</c:v>
                </c:pt>
                <c:pt idx="39">
                  <c:v>183.956280207682</c:v>
                </c:pt>
                <c:pt idx="40">
                  <c:v>183.94861995616401</c:v>
                </c:pt>
                <c:pt idx="41">
                  <c:v>183.940959704645</c:v>
                </c:pt>
                <c:pt idx="42">
                  <c:v>183.93329945312601</c:v>
                </c:pt>
                <c:pt idx="43">
                  <c:v>183.925639201607</c:v>
                </c:pt>
                <c:pt idx="44">
                  <c:v>183.91797895008801</c:v>
                </c:pt>
                <c:pt idx="45">
                  <c:v>183.910318698569</c:v>
                </c:pt>
                <c:pt idx="46">
                  <c:v>183.90265844705101</c:v>
                </c:pt>
                <c:pt idx="47">
                  <c:v>183.894998195532</c:v>
                </c:pt>
                <c:pt idx="48">
                  <c:v>180.48618626965299</c:v>
                </c:pt>
                <c:pt idx="49">
                  <c:v>180.478526018134</c:v>
                </c:pt>
                <c:pt idx="50">
                  <c:v>180.47086576661499</c:v>
                </c:pt>
                <c:pt idx="51">
                  <c:v>180.46320551509601</c:v>
                </c:pt>
                <c:pt idx="52">
                  <c:v>180.45554526357799</c:v>
                </c:pt>
                <c:pt idx="53">
                  <c:v>180.447885012059</c:v>
                </c:pt>
                <c:pt idx="54">
                  <c:v>180.44022476053999</c:v>
                </c:pt>
                <c:pt idx="55">
                  <c:v>180.43256450902101</c:v>
                </c:pt>
                <c:pt idx="56">
                  <c:v>180.42490425750199</c:v>
                </c:pt>
                <c:pt idx="57">
                  <c:v>180.417244005984</c:v>
                </c:pt>
                <c:pt idx="58">
                  <c:v>180.40958375446499</c:v>
                </c:pt>
                <c:pt idx="59">
                  <c:v>180.401923502946</c:v>
                </c:pt>
                <c:pt idx="60">
                  <c:v>180.39426325142699</c:v>
                </c:pt>
                <c:pt idx="61">
                  <c:v>180.38660299990801</c:v>
                </c:pt>
                <c:pt idx="62">
                  <c:v>180.37894274838899</c:v>
                </c:pt>
                <c:pt idx="63">
                  <c:v>180.371282496871</c:v>
                </c:pt>
                <c:pt idx="64">
                  <c:v>180.36362224535199</c:v>
                </c:pt>
                <c:pt idx="65">
                  <c:v>180.35596199383301</c:v>
                </c:pt>
                <c:pt idx="66">
                  <c:v>180.34830174231399</c:v>
                </c:pt>
                <c:pt idx="67">
                  <c:v>180.34064149079501</c:v>
                </c:pt>
                <c:pt idx="68">
                  <c:v>180.33298123927599</c:v>
                </c:pt>
                <c:pt idx="69">
                  <c:v>180.325320987758</c:v>
                </c:pt>
                <c:pt idx="70">
                  <c:v>180.31766073623899</c:v>
                </c:pt>
                <c:pt idx="71">
                  <c:v>180.31000048472001</c:v>
                </c:pt>
                <c:pt idx="72">
                  <c:v>180.30234023320099</c:v>
                </c:pt>
                <c:pt idx="73">
                  <c:v>180.29467998168201</c:v>
                </c:pt>
                <c:pt idx="74">
                  <c:v>180.287019730163</c:v>
                </c:pt>
                <c:pt idx="75">
                  <c:v>180.27935947864501</c:v>
                </c:pt>
                <c:pt idx="76">
                  <c:v>180.27169922712599</c:v>
                </c:pt>
                <c:pt idx="77">
                  <c:v>180.26403897560701</c:v>
                </c:pt>
                <c:pt idx="78">
                  <c:v>180.25637872408799</c:v>
                </c:pt>
                <c:pt idx="79">
                  <c:v>180.24871847256901</c:v>
                </c:pt>
                <c:pt idx="80">
                  <c:v>180.24105822105</c:v>
                </c:pt>
                <c:pt idx="81">
                  <c:v>180.23339796953201</c:v>
                </c:pt>
                <c:pt idx="82">
                  <c:v>180.22573771801299</c:v>
                </c:pt>
                <c:pt idx="83">
                  <c:v>180.21807746649401</c:v>
                </c:pt>
                <c:pt idx="84">
                  <c:v>180.210417214975</c:v>
                </c:pt>
                <c:pt idx="85">
                  <c:v>180.20275696345601</c:v>
                </c:pt>
                <c:pt idx="86">
                  <c:v>180.195096711937</c:v>
                </c:pt>
                <c:pt idx="87">
                  <c:v>180.18743646041901</c:v>
                </c:pt>
                <c:pt idx="88">
                  <c:v>180.17977620889999</c:v>
                </c:pt>
                <c:pt idx="89">
                  <c:v>178.724328420322</c:v>
                </c:pt>
                <c:pt idx="90">
                  <c:v>178.71666816880401</c:v>
                </c:pt>
                <c:pt idx="91">
                  <c:v>178.70900791728499</c:v>
                </c:pt>
                <c:pt idx="92">
                  <c:v>178.70134766576601</c:v>
                </c:pt>
                <c:pt idx="93">
                  <c:v>178.69368741424699</c:v>
                </c:pt>
                <c:pt idx="94">
                  <c:v>178.68602716272801</c:v>
                </c:pt>
                <c:pt idx="95">
                  <c:v>178.678366911209</c:v>
                </c:pt>
                <c:pt idx="96">
                  <c:v>178.67070665969101</c:v>
                </c:pt>
                <c:pt idx="97">
                  <c:v>178.66304640817199</c:v>
                </c:pt>
                <c:pt idx="98">
                  <c:v>178.65538615665301</c:v>
                </c:pt>
                <c:pt idx="99">
                  <c:v>178.647725905134</c:v>
                </c:pt>
                <c:pt idx="100">
                  <c:v>178.64006565361501</c:v>
                </c:pt>
                <c:pt idx="101">
                  <c:v>178.632405402096</c:v>
                </c:pt>
                <c:pt idx="102">
                  <c:v>178.62474515057801</c:v>
                </c:pt>
                <c:pt idx="103">
                  <c:v>178.61708489905899</c:v>
                </c:pt>
                <c:pt idx="104">
                  <c:v>178.60942464754001</c:v>
                </c:pt>
                <c:pt idx="105">
                  <c:v>178.601764396021</c:v>
                </c:pt>
                <c:pt idx="106">
                  <c:v>178.59410414450201</c:v>
                </c:pt>
                <c:pt idx="107">
                  <c:v>178.586443892983</c:v>
                </c:pt>
                <c:pt idx="108">
                  <c:v>178.57878364146501</c:v>
                </c:pt>
                <c:pt idx="109">
                  <c:v>178.571123389946</c:v>
                </c:pt>
                <c:pt idx="110">
                  <c:v>178.56346313842701</c:v>
                </c:pt>
                <c:pt idx="111">
                  <c:v>178.555802886908</c:v>
                </c:pt>
                <c:pt idx="112">
                  <c:v>178.54814263538901</c:v>
                </c:pt>
                <c:pt idx="113">
                  <c:v>178.54048238387</c:v>
                </c:pt>
                <c:pt idx="114">
                  <c:v>178.53282213235201</c:v>
                </c:pt>
                <c:pt idx="115">
                  <c:v>177.38378440452701</c:v>
                </c:pt>
                <c:pt idx="116">
                  <c:v>177.37612415300899</c:v>
                </c:pt>
                <c:pt idx="117">
                  <c:v>177.36846390149</c:v>
                </c:pt>
                <c:pt idx="118">
                  <c:v>177.36080364997099</c:v>
                </c:pt>
                <c:pt idx="119">
                  <c:v>177.353143398452</c:v>
                </c:pt>
                <c:pt idx="120">
                  <c:v>177.34548314693299</c:v>
                </c:pt>
                <c:pt idx="121">
                  <c:v>177.33782289541401</c:v>
                </c:pt>
                <c:pt idx="122">
                  <c:v>177.33016264389599</c:v>
                </c:pt>
                <c:pt idx="123">
                  <c:v>177.322502392377</c:v>
                </c:pt>
                <c:pt idx="124">
                  <c:v>177.31484214085799</c:v>
                </c:pt>
                <c:pt idx="125">
                  <c:v>177.30718188933901</c:v>
                </c:pt>
                <c:pt idx="126">
                  <c:v>177.29952163781999</c:v>
                </c:pt>
                <c:pt idx="127">
                  <c:v>177.29186138630101</c:v>
                </c:pt>
                <c:pt idx="128">
                  <c:v>177.28420113478299</c:v>
                </c:pt>
                <c:pt idx="129">
                  <c:v>177.276540883264</c:v>
                </c:pt>
                <c:pt idx="130">
                  <c:v>177.26888063174499</c:v>
                </c:pt>
                <c:pt idx="131">
                  <c:v>176.92416931339801</c:v>
                </c:pt>
                <c:pt idx="132">
                  <c:v>176.916509061879</c:v>
                </c:pt>
                <c:pt idx="133">
                  <c:v>176.90884881036001</c:v>
                </c:pt>
                <c:pt idx="134">
                  <c:v>176.901188558841</c:v>
                </c:pt>
                <c:pt idx="135">
                  <c:v>176.89352830732199</c:v>
                </c:pt>
                <c:pt idx="136">
                  <c:v>176.885868055803</c:v>
                </c:pt>
                <c:pt idx="137">
                  <c:v>176.87820780428501</c:v>
                </c:pt>
                <c:pt idx="138">
                  <c:v>176.870547552766</c:v>
                </c:pt>
                <c:pt idx="139">
                  <c:v>176.86288730124701</c:v>
                </c:pt>
                <c:pt idx="140">
                  <c:v>176.855227049728</c:v>
                </c:pt>
                <c:pt idx="141">
                  <c:v>176.84756679820899</c:v>
                </c:pt>
                <c:pt idx="142">
                  <c:v>176.839906546691</c:v>
                </c:pt>
                <c:pt idx="143">
                  <c:v>176.83224629517201</c:v>
                </c:pt>
                <c:pt idx="144">
                  <c:v>176.824586043653</c:v>
                </c:pt>
                <c:pt idx="145">
                  <c:v>176.81692579213399</c:v>
                </c:pt>
                <c:pt idx="146">
                  <c:v>176.809265540615</c:v>
                </c:pt>
                <c:pt idx="147">
                  <c:v>176.80160528909599</c:v>
                </c:pt>
                <c:pt idx="148">
                  <c:v>176.793945037578</c:v>
                </c:pt>
                <c:pt idx="149">
                  <c:v>176.78628478605901</c:v>
                </c:pt>
                <c:pt idx="150">
                  <c:v>176.77862453454</c:v>
                </c:pt>
                <c:pt idx="151">
                  <c:v>176.77096428302099</c:v>
                </c:pt>
                <c:pt idx="152">
                  <c:v>175.430420267226</c:v>
                </c:pt>
                <c:pt idx="153">
                  <c:v>175.42276001570701</c:v>
                </c:pt>
                <c:pt idx="154">
                  <c:v>175.415099764188</c:v>
                </c:pt>
                <c:pt idx="155">
                  <c:v>175.40743951267001</c:v>
                </c:pt>
                <c:pt idx="156">
                  <c:v>175.399779261151</c:v>
                </c:pt>
                <c:pt idx="157">
                  <c:v>175.39211900963201</c:v>
                </c:pt>
                <c:pt idx="158">
                  <c:v>175.384458758113</c:v>
                </c:pt>
                <c:pt idx="159">
                  <c:v>175.37679850659401</c:v>
                </c:pt>
                <c:pt idx="160">
                  <c:v>175.369138255075</c:v>
                </c:pt>
                <c:pt idx="161">
                  <c:v>175.36147800355701</c:v>
                </c:pt>
                <c:pt idx="162">
                  <c:v>175.353817752038</c:v>
                </c:pt>
                <c:pt idx="163">
                  <c:v>175.34615750051901</c:v>
                </c:pt>
                <c:pt idx="164">
                  <c:v>175.338497249</c:v>
                </c:pt>
                <c:pt idx="165">
                  <c:v>175.33083699748099</c:v>
                </c:pt>
                <c:pt idx="166">
                  <c:v>175.323176745962</c:v>
                </c:pt>
                <c:pt idx="167">
                  <c:v>175.31551649444401</c:v>
                </c:pt>
                <c:pt idx="168">
                  <c:v>175.307856242925</c:v>
                </c:pt>
                <c:pt idx="169">
                  <c:v>175.30019599140601</c:v>
                </c:pt>
                <c:pt idx="170">
                  <c:v>175.292535739887</c:v>
                </c:pt>
                <c:pt idx="171">
                  <c:v>175.28487548836799</c:v>
                </c:pt>
                <c:pt idx="172">
                  <c:v>175.277215236849</c:v>
                </c:pt>
                <c:pt idx="173">
                  <c:v>175.26955498533101</c:v>
                </c:pt>
                <c:pt idx="174">
                  <c:v>175.261894733812</c:v>
                </c:pt>
                <c:pt idx="175">
                  <c:v>175.25423448229299</c:v>
                </c:pt>
                <c:pt idx="176">
                  <c:v>175.246574230774</c:v>
                </c:pt>
                <c:pt idx="177">
                  <c:v>175.23891397925499</c:v>
                </c:pt>
                <c:pt idx="178">
                  <c:v>175.231253727737</c:v>
                </c:pt>
                <c:pt idx="179">
                  <c:v>175.22359347621801</c:v>
                </c:pt>
                <c:pt idx="180">
                  <c:v>175.215933224699</c:v>
                </c:pt>
                <c:pt idx="181">
                  <c:v>175.20827297317999</c:v>
                </c:pt>
                <c:pt idx="182">
                  <c:v>175.200612721661</c:v>
                </c:pt>
                <c:pt idx="183">
                  <c:v>175.19295247014199</c:v>
                </c:pt>
                <c:pt idx="184">
                  <c:v>175.185292218624</c:v>
                </c:pt>
                <c:pt idx="185">
                  <c:v>175.17763196710499</c:v>
                </c:pt>
                <c:pt idx="186">
                  <c:v>175.169971715586</c:v>
                </c:pt>
                <c:pt idx="187">
                  <c:v>175.16231146406699</c:v>
                </c:pt>
                <c:pt idx="188">
                  <c:v>175.154651212548</c:v>
                </c:pt>
                <c:pt idx="189">
                  <c:v>175.14699096102899</c:v>
                </c:pt>
                <c:pt idx="190">
                  <c:v>175.139330709511</c:v>
                </c:pt>
                <c:pt idx="191">
                  <c:v>175.13167045799199</c:v>
                </c:pt>
                <c:pt idx="192">
                  <c:v>175.124010206473</c:v>
                </c:pt>
                <c:pt idx="193">
                  <c:v>175.11634995495399</c:v>
                </c:pt>
                <c:pt idx="194">
                  <c:v>174.58779260015501</c:v>
                </c:pt>
                <c:pt idx="195">
                  <c:v>174.580132348636</c:v>
                </c:pt>
                <c:pt idx="196">
                  <c:v>174.57247209711699</c:v>
                </c:pt>
                <c:pt idx="197">
                  <c:v>174.564811845598</c:v>
                </c:pt>
                <c:pt idx="198">
                  <c:v>174.55715159408001</c:v>
                </c:pt>
                <c:pt idx="199">
                  <c:v>174.549491342561</c:v>
                </c:pt>
                <c:pt idx="200">
                  <c:v>174.54183109104201</c:v>
                </c:pt>
                <c:pt idx="201">
                  <c:v>174.534170839523</c:v>
                </c:pt>
                <c:pt idx="202">
                  <c:v>174.52651058800399</c:v>
                </c:pt>
                <c:pt idx="203">
                  <c:v>174.518850336485</c:v>
                </c:pt>
                <c:pt idx="204">
                  <c:v>174.51119008496701</c:v>
                </c:pt>
                <c:pt idx="205">
                  <c:v>174.503529833448</c:v>
                </c:pt>
                <c:pt idx="206">
                  <c:v>174.49586958192901</c:v>
                </c:pt>
                <c:pt idx="207">
                  <c:v>174.48820933041</c:v>
                </c:pt>
                <c:pt idx="208">
                  <c:v>174.48054907889099</c:v>
                </c:pt>
                <c:pt idx="209">
                  <c:v>174.472888827372</c:v>
                </c:pt>
                <c:pt idx="210">
                  <c:v>174.46522857585401</c:v>
                </c:pt>
                <c:pt idx="211">
                  <c:v>174.457568324335</c:v>
                </c:pt>
                <c:pt idx="212">
                  <c:v>174.44990807281599</c:v>
                </c:pt>
                <c:pt idx="213">
                  <c:v>174.442247821297</c:v>
                </c:pt>
                <c:pt idx="214">
                  <c:v>174.43458756977799</c:v>
                </c:pt>
                <c:pt idx="215">
                  <c:v>174.42692731826</c:v>
                </c:pt>
                <c:pt idx="216">
                  <c:v>174.41926706674101</c:v>
                </c:pt>
                <c:pt idx="217">
                  <c:v>174.411606815222</c:v>
                </c:pt>
                <c:pt idx="218">
                  <c:v>174.40394656370299</c:v>
                </c:pt>
                <c:pt idx="219">
                  <c:v>174.396286312184</c:v>
                </c:pt>
                <c:pt idx="220">
                  <c:v>174.38862606066499</c:v>
                </c:pt>
                <c:pt idx="221">
                  <c:v>174.380965809147</c:v>
                </c:pt>
                <c:pt idx="222">
                  <c:v>174.37330555762799</c:v>
                </c:pt>
                <c:pt idx="223">
                  <c:v>174.365645306109</c:v>
                </c:pt>
                <c:pt idx="224">
                  <c:v>174.35798505458999</c:v>
                </c:pt>
                <c:pt idx="225">
                  <c:v>174.350324803071</c:v>
                </c:pt>
                <c:pt idx="226">
                  <c:v>174.34266455155199</c:v>
                </c:pt>
                <c:pt idx="227">
                  <c:v>174.335004300034</c:v>
                </c:pt>
                <c:pt idx="228">
                  <c:v>174.32734404851499</c:v>
                </c:pt>
                <c:pt idx="229">
                  <c:v>174.319683796996</c:v>
                </c:pt>
                <c:pt idx="230">
                  <c:v>174.31202354547699</c:v>
                </c:pt>
                <c:pt idx="231">
                  <c:v>174.304363293958</c:v>
                </c:pt>
                <c:pt idx="232">
                  <c:v>174.29670304243899</c:v>
                </c:pt>
                <c:pt idx="233">
                  <c:v>174.289042790921</c:v>
                </c:pt>
                <c:pt idx="234">
                  <c:v>174.28138253940199</c:v>
                </c:pt>
                <c:pt idx="235">
                  <c:v>174.273722287883</c:v>
                </c:pt>
                <c:pt idx="236">
                  <c:v>174.26606203636399</c:v>
                </c:pt>
                <c:pt idx="237">
                  <c:v>174.25840178484501</c:v>
                </c:pt>
                <c:pt idx="238">
                  <c:v>174.25074153332599</c:v>
                </c:pt>
                <c:pt idx="239">
                  <c:v>174.243081281808</c:v>
                </c:pt>
                <c:pt idx="240">
                  <c:v>174.23542103028899</c:v>
                </c:pt>
                <c:pt idx="241">
                  <c:v>174.22776077877</c:v>
                </c:pt>
                <c:pt idx="242">
                  <c:v>174.22010052725099</c:v>
                </c:pt>
                <c:pt idx="243">
                  <c:v>174.21244027573201</c:v>
                </c:pt>
                <c:pt idx="244">
                  <c:v>174.20478002421299</c:v>
                </c:pt>
                <c:pt idx="245">
                  <c:v>174.197119772695</c:v>
                </c:pt>
                <c:pt idx="246">
                  <c:v>174.18945952117599</c:v>
                </c:pt>
                <c:pt idx="247">
                  <c:v>174.18179926965701</c:v>
                </c:pt>
                <c:pt idx="248">
                  <c:v>174.17413901813799</c:v>
                </c:pt>
                <c:pt idx="249">
                  <c:v>174.16647876661901</c:v>
                </c:pt>
                <c:pt idx="250">
                  <c:v>174.15881851509999</c:v>
                </c:pt>
                <c:pt idx="251">
                  <c:v>174.151158263582</c:v>
                </c:pt>
                <c:pt idx="252">
                  <c:v>174.14349801206299</c:v>
                </c:pt>
                <c:pt idx="253">
                  <c:v>174.13583776054401</c:v>
                </c:pt>
                <c:pt idx="254">
                  <c:v>174.12817750902499</c:v>
                </c:pt>
                <c:pt idx="255">
                  <c:v>173.821767448272</c:v>
                </c:pt>
                <c:pt idx="256">
                  <c:v>173.81410719675301</c:v>
                </c:pt>
                <c:pt idx="257">
                  <c:v>173.806446945234</c:v>
                </c:pt>
                <c:pt idx="258">
                  <c:v>173.79878669371601</c:v>
                </c:pt>
                <c:pt idx="259">
                  <c:v>173.791126442197</c:v>
                </c:pt>
                <c:pt idx="260">
                  <c:v>173.78346619067801</c:v>
                </c:pt>
                <c:pt idx="261">
                  <c:v>173.775805939159</c:v>
                </c:pt>
                <c:pt idx="262">
                  <c:v>173.76814568763999</c:v>
                </c:pt>
                <c:pt idx="263">
                  <c:v>173.760485436121</c:v>
                </c:pt>
                <c:pt idx="264">
                  <c:v>173.75282518460301</c:v>
                </c:pt>
                <c:pt idx="265">
                  <c:v>173.745164933084</c:v>
                </c:pt>
                <c:pt idx="266">
                  <c:v>173.73750468156501</c:v>
                </c:pt>
                <c:pt idx="267">
                  <c:v>173.729844430046</c:v>
                </c:pt>
                <c:pt idx="268">
                  <c:v>173.72218417852699</c:v>
                </c:pt>
                <c:pt idx="269">
                  <c:v>173.714523927008</c:v>
                </c:pt>
                <c:pt idx="270">
                  <c:v>173.70686367549001</c:v>
                </c:pt>
                <c:pt idx="271">
                  <c:v>173.699203423971</c:v>
                </c:pt>
                <c:pt idx="272">
                  <c:v>173.69154317245199</c:v>
                </c:pt>
                <c:pt idx="273">
                  <c:v>173.683882920933</c:v>
                </c:pt>
                <c:pt idx="274">
                  <c:v>173.67622266941399</c:v>
                </c:pt>
                <c:pt idx="275">
                  <c:v>173.668562417895</c:v>
                </c:pt>
                <c:pt idx="276">
                  <c:v>173.66090216637701</c:v>
                </c:pt>
                <c:pt idx="277">
                  <c:v>173.653241914858</c:v>
                </c:pt>
                <c:pt idx="278">
                  <c:v>173.64558166333899</c:v>
                </c:pt>
                <c:pt idx="279">
                  <c:v>173.63792141182</c:v>
                </c:pt>
                <c:pt idx="280">
                  <c:v>173.63026116030099</c:v>
                </c:pt>
                <c:pt idx="281">
                  <c:v>173.622600908783</c:v>
                </c:pt>
                <c:pt idx="282">
                  <c:v>173.61494065726399</c:v>
                </c:pt>
                <c:pt idx="283">
                  <c:v>173.607280405745</c:v>
                </c:pt>
                <c:pt idx="284">
                  <c:v>173.59962015422599</c:v>
                </c:pt>
                <c:pt idx="285">
                  <c:v>173.591959902707</c:v>
                </c:pt>
                <c:pt idx="286">
                  <c:v>173.58429965118799</c:v>
                </c:pt>
                <c:pt idx="287">
                  <c:v>173.57663939967</c:v>
                </c:pt>
                <c:pt idx="288">
                  <c:v>173.56897914815099</c:v>
                </c:pt>
                <c:pt idx="289">
                  <c:v>173.561318896632</c:v>
                </c:pt>
                <c:pt idx="290">
                  <c:v>173.55365864511299</c:v>
                </c:pt>
                <c:pt idx="291">
                  <c:v>163.1740178371</c:v>
                </c:pt>
                <c:pt idx="292">
                  <c:v>163.16635758558101</c:v>
                </c:pt>
                <c:pt idx="293">
                  <c:v>163.15869733406299</c:v>
                </c:pt>
                <c:pt idx="294">
                  <c:v>163.15103708254401</c:v>
                </c:pt>
                <c:pt idx="295">
                  <c:v>163.14337683102499</c:v>
                </c:pt>
                <c:pt idx="296">
                  <c:v>163.13571657950601</c:v>
                </c:pt>
                <c:pt idx="297">
                  <c:v>163.128056327987</c:v>
                </c:pt>
                <c:pt idx="298">
                  <c:v>163.12039607646801</c:v>
                </c:pt>
                <c:pt idx="299">
                  <c:v>163.11273582494999</c:v>
                </c:pt>
                <c:pt idx="300">
                  <c:v>163.10507557343101</c:v>
                </c:pt>
                <c:pt idx="301">
                  <c:v>163.097415321912</c:v>
                </c:pt>
                <c:pt idx="302">
                  <c:v>163.08975507039301</c:v>
                </c:pt>
                <c:pt idx="303">
                  <c:v>163.082094818874</c:v>
                </c:pt>
                <c:pt idx="304">
                  <c:v>163.07443456735501</c:v>
                </c:pt>
                <c:pt idx="305">
                  <c:v>163.06677431583699</c:v>
                </c:pt>
                <c:pt idx="306">
                  <c:v>163.05911406431801</c:v>
                </c:pt>
                <c:pt idx="307">
                  <c:v>163.051453812799</c:v>
                </c:pt>
                <c:pt idx="308">
                  <c:v>163.04379356128001</c:v>
                </c:pt>
                <c:pt idx="309">
                  <c:v>132.341505473815</c:v>
                </c:pt>
                <c:pt idx="310">
                  <c:v>132.33384522229599</c:v>
                </c:pt>
                <c:pt idx="311">
                  <c:v>132.32618497077701</c:v>
                </c:pt>
                <c:pt idx="312">
                  <c:v>132.31852471925799</c:v>
                </c:pt>
                <c:pt idx="313">
                  <c:v>132.31086446774</c:v>
                </c:pt>
                <c:pt idx="314">
                  <c:v>132.30320421622099</c:v>
                </c:pt>
                <c:pt idx="315">
                  <c:v>132.29554396470201</c:v>
                </c:pt>
                <c:pt idx="316">
                  <c:v>132.28788371318299</c:v>
                </c:pt>
                <c:pt idx="317">
                  <c:v>132.28022346166401</c:v>
                </c:pt>
                <c:pt idx="318">
                  <c:v>132.27256321014499</c:v>
                </c:pt>
                <c:pt idx="319">
                  <c:v>132.264902958627</c:v>
                </c:pt>
                <c:pt idx="320">
                  <c:v>132.25724270710799</c:v>
                </c:pt>
                <c:pt idx="321">
                  <c:v>132.24958245558901</c:v>
                </c:pt>
                <c:pt idx="322">
                  <c:v>132.24192220406999</c:v>
                </c:pt>
                <c:pt idx="323">
                  <c:v>132.23426195255101</c:v>
                </c:pt>
                <c:pt idx="324">
                  <c:v>132.22660170103299</c:v>
                </c:pt>
                <c:pt idx="325">
                  <c:v>132.21894144951401</c:v>
                </c:pt>
                <c:pt idx="326">
                  <c:v>132.21128119799499</c:v>
                </c:pt>
                <c:pt idx="327">
                  <c:v>132.20362094647601</c:v>
                </c:pt>
                <c:pt idx="328">
                  <c:v>132.19596069495699</c:v>
                </c:pt>
                <c:pt idx="329">
                  <c:v>132.18830044343801</c:v>
                </c:pt>
                <c:pt idx="330">
                  <c:v>132.18064019191999</c:v>
                </c:pt>
                <c:pt idx="331">
                  <c:v>132.17297994040101</c:v>
                </c:pt>
                <c:pt idx="332">
                  <c:v>132.16531968888199</c:v>
                </c:pt>
                <c:pt idx="333">
                  <c:v>132.15765943736301</c:v>
                </c:pt>
                <c:pt idx="334">
                  <c:v>132.149999185844</c:v>
                </c:pt>
                <c:pt idx="335">
                  <c:v>132.14233893432501</c:v>
                </c:pt>
                <c:pt idx="336">
                  <c:v>132.13467868280699</c:v>
                </c:pt>
                <c:pt idx="337">
                  <c:v>132.12701843128801</c:v>
                </c:pt>
                <c:pt idx="338">
                  <c:v>132.11935817976899</c:v>
                </c:pt>
                <c:pt idx="339">
                  <c:v>132.11169792825001</c:v>
                </c:pt>
                <c:pt idx="340">
                  <c:v>132.104037676731</c:v>
                </c:pt>
                <c:pt idx="341">
                  <c:v>132.09637742521201</c:v>
                </c:pt>
                <c:pt idx="342">
                  <c:v>132.08871717369399</c:v>
                </c:pt>
                <c:pt idx="343">
                  <c:v>132.08105692217501</c:v>
                </c:pt>
                <c:pt idx="344">
                  <c:v>132.073396670656</c:v>
                </c:pt>
                <c:pt idx="345">
                  <c:v>132.06573641913701</c:v>
                </c:pt>
                <c:pt idx="346">
                  <c:v>132.058076167618</c:v>
                </c:pt>
                <c:pt idx="347">
                  <c:v>132.05041591609901</c:v>
                </c:pt>
                <c:pt idx="348">
                  <c:v>132.04275566458099</c:v>
                </c:pt>
                <c:pt idx="349">
                  <c:v>132.03509541306201</c:v>
                </c:pt>
                <c:pt idx="350">
                  <c:v>130.69455139726699</c:v>
                </c:pt>
                <c:pt idx="351">
                  <c:v>130.68689114574801</c:v>
                </c:pt>
                <c:pt idx="352">
                  <c:v>130.67923089422899</c:v>
                </c:pt>
                <c:pt idx="353">
                  <c:v>130.67157064271001</c:v>
                </c:pt>
                <c:pt idx="354">
                  <c:v>130.663910391191</c:v>
                </c:pt>
                <c:pt idx="355">
                  <c:v>130.65625013967301</c:v>
                </c:pt>
                <c:pt idx="356">
                  <c:v>130.64858988815399</c:v>
                </c:pt>
                <c:pt idx="357">
                  <c:v>130.64092963663501</c:v>
                </c:pt>
                <c:pt idx="358">
                  <c:v>130.63326938511599</c:v>
                </c:pt>
                <c:pt idx="359">
                  <c:v>130.62560913359701</c:v>
                </c:pt>
                <c:pt idx="360">
                  <c:v>130.61794888207899</c:v>
                </c:pt>
                <c:pt idx="361">
                  <c:v>130.61028863056001</c:v>
                </c:pt>
                <c:pt idx="362">
                  <c:v>130.60262837904099</c:v>
                </c:pt>
                <c:pt idx="363">
                  <c:v>130.59496812752201</c:v>
                </c:pt>
                <c:pt idx="364">
                  <c:v>130.587307876003</c:v>
                </c:pt>
                <c:pt idx="365">
                  <c:v>130.57964762448401</c:v>
                </c:pt>
                <c:pt idx="366">
                  <c:v>130.57198737296599</c:v>
                </c:pt>
                <c:pt idx="367">
                  <c:v>130.56432712144701</c:v>
                </c:pt>
                <c:pt idx="368">
                  <c:v>130.55666686992799</c:v>
                </c:pt>
                <c:pt idx="369">
                  <c:v>130.54900661840901</c:v>
                </c:pt>
                <c:pt idx="370">
                  <c:v>130.54134636689</c:v>
                </c:pt>
                <c:pt idx="371">
                  <c:v>130.53368611537101</c:v>
                </c:pt>
                <c:pt idx="372">
                  <c:v>130.52602586385299</c:v>
                </c:pt>
                <c:pt idx="373">
                  <c:v>130.51836561233401</c:v>
                </c:pt>
                <c:pt idx="374">
                  <c:v>130.510705360815</c:v>
                </c:pt>
                <c:pt idx="375">
                  <c:v>130.50304510929601</c:v>
                </c:pt>
                <c:pt idx="376">
                  <c:v>130.495384857777</c:v>
                </c:pt>
                <c:pt idx="377">
                  <c:v>130.48772460625801</c:v>
                </c:pt>
                <c:pt idx="378">
                  <c:v>130.48006435473999</c:v>
                </c:pt>
                <c:pt idx="379">
                  <c:v>130.47240410322101</c:v>
                </c:pt>
                <c:pt idx="380">
                  <c:v>130.464743851702</c:v>
                </c:pt>
                <c:pt idx="381">
                  <c:v>130.45708360018301</c:v>
                </c:pt>
                <c:pt idx="382">
                  <c:v>130.449423348664</c:v>
                </c:pt>
                <c:pt idx="383">
                  <c:v>130.44176309714501</c:v>
                </c:pt>
                <c:pt idx="384">
                  <c:v>130.434102845627</c:v>
                </c:pt>
                <c:pt idx="385">
                  <c:v>130.42644259410801</c:v>
                </c:pt>
                <c:pt idx="386">
                  <c:v>130.418782342589</c:v>
                </c:pt>
                <c:pt idx="387">
                  <c:v>130.41112209107001</c:v>
                </c:pt>
                <c:pt idx="388">
                  <c:v>130.403461839551</c:v>
                </c:pt>
                <c:pt idx="389">
                  <c:v>130.39580158803199</c:v>
                </c:pt>
                <c:pt idx="390">
                  <c:v>130.388141336514</c:v>
                </c:pt>
                <c:pt idx="391">
                  <c:v>75.310932916135698</c:v>
                </c:pt>
                <c:pt idx="392">
                  <c:v>75.303272664616898</c:v>
                </c:pt>
                <c:pt idx="393">
                  <c:v>75.295612413098098</c:v>
                </c:pt>
                <c:pt idx="394">
                  <c:v>75.287952161579199</c:v>
                </c:pt>
                <c:pt idx="395">
                  <c:v>75.280291910060399</c:v>
                </c:pt>
                <c:pt idx="396">
                  <c:v>75.272631658541599</c:v>
                </c:pt>
                <c:pt idx="397">
                  <c:v>75.264971407022699</c:v>
                </c:pt>
                <c:pt idx="398">
                  <c:v>75.257311155503899</c:v>
                </c:pt>
                <c:pt idx="399">
                  <c:v>75.249650903985099</c:v>
                </c:pt>
                <c:pt idx="400">
                  <c:v>75.241990652466299</c:v>
                </c:pt>
                <c:pt idx="401">
                  <c:v>75.2343304009474</c:v>
                </c:pt>
                <c:pt idx="402">
                  <c:v>75.2266701494286</c:v>
                </c:pt>
                <c:pt idx="403">
                  <c:v>75.2190098979098</c:v>
                </c:pt>
                <c:pt idx="404">
                  <c:v>75.2113496463909</c:v>
                </c:pt>
                <c:pt idx="405">
                  <c:v>75.2036893948721</c:v>
                </c:pt>
                <c:pt idx="406">
                  <c:v>75.1960291433533</c:v>
                </c:pt>
                <c:pt idx="407">
                  <c:v>75.1883688918345</c:v>
                </c:pt>
                <c:pt idx="408">
                  <c:v>75.180708640315601</c:v>
                </c:pt>
                <c:pt idx="409">
                  <c:v>75.173048388796801</c:v>
                </c:pt>
                <c:pt idx="410">
                  <c:v>75.165388137278001</c:v>
                </c:pt>
                <c:pt idx="411">
                  <c:v>75.157727885759101</c:v>
                </c:pt>
                <c:pt idx="412">
                  <c:v>75.150067634240301</c:v>
                </c:pt>
                <c:pt idx="413">
                  <c:v>75.142407382721501</c:v>
                </c:pt>
                <c:pt idx="414">
                  <c:v>75.134747131202701</c:v>
                </c:pt>
                <c:pt idx="415">
                  <c:v>75.127086879683802</c:v>
                </c:pt>
                <c:pt idx="416">
                  <c:v>75.119426628165002</c:v>
                </c:pt>
                <c:pt idx="417">
                  <c:v>75.111766376646202</c:v>
                </c:pt>
                <c:pt idx="418">
                  <c:v>75.104106125127302</c:v>
                </c:pt>
                <c:pt idx="419">
                  <c:v>75.096445873608502</c:v>
                </c:pt>
                <c:pt idx="420">
                  <c:v>75.088785622089702</c:v>
                </c:pt>
                <c:pt idx="421">
                  <c:v>75.081125370570902</c:v>
                </c:pt>
                <c:pt idx="422">
                  <c:v>75.073465119052003</c:v>
                </c:pt>
                <c:pt idx="423">
                  <c:v>75.065804867533203</c:v>
                </c:pt>
                <c:pt idx="424">
                  <c:v>75.058144616014403</c:v>
                </c:pt>
                <c:pt idx="425">
                  <c:v>75.050484364495603</c:v>
                </c:pt>
                <c:pt idx="426">
                  <c:v>75.042824112976703</c:v>
                </c:pt>
                <c:pt idx="427">
                  <c:v>75.035163861457903</c:v>
                </c:pt>
                <c:pt idx="428">
                  <c:v>75.027503609939103</c:v>
                </c:pt>
                <c:pt idx="429">
                  <c:v>75.019843358420204</c:v>
                </c:pt>
                <c:pt idx="430">
                  <c:v>75.012183106901404</c:v>
                </c:pt>
                <c:pt idx="431">
                  <c:v>75.004522855382604</c:v>
                </c:pt>
                <c:pt idx="432">
                  <c:v>73.932087642746595</c:v>
                </c:pt>
                <c:pt idx="433">
                  <c:v>73.924427391227695</c:v>
                </c:pt>
                <c:pt idx="434">
                  <c:v>73.916767139708895</c:v>
                </c:pt>
                <c:pt idx="435">
                  <c:v>73.909106888190095</c:v>
                </c:pt>
                <c:pt idx="436">
                  <c:v>73.901446636671295</c:v>
                </c:pt>
                <c:pt idx="437">
                  <c:v>73.893786385152396</c:v>
                </c:pt>
                <c:pt idx="438">
                  <c:v>73.886126133633596</c:v>
                </c:pt>
                <c:pt idx="439">
                  <c:v>73.878465882114796</c:v>
                </c:pt>
                <c:pt idx="440">
                  <c:v>73.870805630595896</c:v>
                </c:pt>
                <c:pt idx="441">
                  <c:v>73.863145379077096</c:v>
                </c:pt>
                <c:pt idx="442">
                  <c:v>73.855485127558296</c:v>
                </c:pt>
                <c:pt idx="443">
                  <c:v>73.847824876039496</c:v>
                </c:pt>
                <c:pt idx="444">
                  <c:v>73.840164624520597</c:v>
                </c:pt>
                <c:pt idx="445">
                  <c:v>73.832504373001797</c:v>
                </c:pt>
                <c:pt idx="446">
                  <c:v>73.824844121482997</c:v>
                </c:pt>
                <c:pt idx="447">
                  <c:v>73.817183869964097</c:v>
                </c:pt>
                <c:pt idx="448">
                  <c:v>73.809523618445297</c:v>
                </c:pt>
                <c:pt idx="449">
                  <c:v>73.801863366926497</c:v>
                </c:pt>
                <c:pt idx="450">
                  <c:v>73.794203115407598</c:v>
                </c:pt>
                <c:pt idx="451">
                  <c:v>73.786542863888798</c:v>
                </c:pt>
                <c:pt idx="452">
                  <c:v>73.778882612369998</c:v>
                </c:pt>
                <c:pt idx="453">
                  <c:v>71.250999611156502</c:v>
                </c:pt>
                <c:pt idx="454">
                  <c:v>71.243339359637702</c:v>
                </c:pt>
                <c:pt idx="455">
                  <c:v>71.235679108118902</c:v>
                </c:pt>
                <c:pt idx="456">
                  <c:v>71.228018856600102</c:v>
                </c:pt>
                <c:pt idx="457">
                  <c:v>71.220358605081202</c:v>
                </c:pt>
                <c:pt idx="458">
                  <c:v>71.212698353562402</c:v>
                </c:pt>
                <c:pt idx="459">
                  <c:v>71.205038102043602</c:v>
                </c:pt>
                <c:pt idx="460">
                  <c:v>71.197377850524802</c:v>
                </c:pt>
                <c:pt idx="461">
                  <c:v>71.189717599005903</c:v>
                </c:pt>
                <c:pt idx="462">
                  <c:v>71.182057347487103</c:v>
                </c:pt>
                <c:pt idx="463">
                  <c:v>71.174397095968303</c:v>
                </c:pt>
                <c:pt idx="464">
                  <c:v>71.166736844449403</c:v>
                </c:pt>
                <c:pt idx="465">
                  <c:v>71.159076592930603</c:v>
                </c:pt>
                <c:pt idx="466">
                  <c:v>71.151416341411803</c:v>
                </c:pt>
                <c:pt idx="467">
                  <c:v>71.143756089892904</c:v>
                </c:pt>
                <c:pt idx="468">
                  <c:v>71.136095838374104</c:v>
                </c:pt>
                <c:pt idx="469">
                  <c:v>71.128435586855304</c:v>
                </c:pt>
                <c:pt idx="470">
                  <c:v>71.120775335336504</c:v>
                </c:pt>
                <c:pt idx="471">
                  <c:v>71.113115083817604</c:v>
                </c:pt>
                <c:pt idx="472">
                  <c:v>71.105454832298804</c:v>
                </c:pt>
                <c:pt idx="473">
                  <c:v>71.097794580780004</c:v>
                </c:pt>
                <c:pt idx="474">
                  <c:v>64.716805065595693</c:v>
                </c:pt>
                <c:pt idx="475">
                  <c:v>64.709144814076893</c:v>
                </c:pt>
                <c:pt idx="476">
                  <c:v>64.701484562558093</c:v>
                </c:pt>
                <c:pt idx="477">
                  <c:v>64.693824311039194</c:v>
                </c:pt>
                <c:pt idx="478">
                  <c:v>64.686164059520394</c:v>
                </c:pt>
                <c:pt idx="479">
                  <c:v>64.678503808001594</c:v>
                </c:pt>
                <c:pt idx="480">
                  <c:v>64.670843556482694</c:v>
                </c:pt>
                <c:pt idx="481">
                  <c:v>64.663183304963894</c:v>
                </c:pt>
                <c:pt idx="482">
                  <c:v>64.655523053445094</c:v>
                </c:pt>
                <c:pt idx="483">
                  <c:v>64.647862801926294</c:v>
                </c:pt>
                <c:pt idx="484">
                  <c:v>64.640202550407395</c:v>
                </c:pt>
                <c:pt idx="485">
                  <c:v>64.632542298888595</c:v>
                </c:pt>
                <c:pt idx="486">
                  <c:v>64.624882047369795</c:v>
                </c:pt>
                <c:pt idx="487">
                  <c:v>64.617221795850895</c:v>
                </c:pt>
                <c:pt idx="488">
                  <c:v>64.609561544332095</c:v>
                </c:pt>
                <c:pt idx="489">
                  <c:v>64.601901292813295</c:v>
                </c:pt>
                <c:pt idx="490">
                  <c:v>64.594241041294495</c:v>
                </c:pt>
                <c:pt idx="491">
                  <c:v>64.586580789775596</c:v>
                </c:pt>
                <c:pt idx="492">
                  <c:v>64.578920538256796</c:v>
                </c:pt>
                <c:pt idx="493">
                  <c:v>64.571260286737996</c:v>
                </c:pt>
                <c:pt idx="494">
                  <c:v>64.563600035219096</c:v>
                </c:pt>
                <c:pt idx="495">
                  <c:v>64.555939783700296</c:v>
                </c:pt>
                <c:pt idx="496">
                  <c:v>64.548279532181496</c:v>
                </c:pt>
                <c:pt idx="497">
                  <c:v>64.540619280662696</c:v>
                </c:pt>
                <c:pt idx="498">
                  <c:v>64.532959029143797</c:v>
                </c:pt>
                <c:pt idx="499">
                  <c:v>64.525298777624997</c:v>
                </c:pt>
                <c:pt idx="500">
                  <c:v>64.517638526106197</c:v>
                </c:pt>
                <c:pt idx="501">
                  <c:v>64.509978274587297</c:v>
                </c:pt>
                <c:pt idx="502">
                  <c:v>64.502318023068497</c:v>
                </c:pt>
                <c:pt idx="503">
                  <c:v>64.494657771549697</c:v>
                </c:pt>
                <c:pt idx="504">
                  <c:v>64.486997520030897</c:v>
                </c:pt>
                <c:pt idx="505">
                  <c:v>64.479337268511998</c:v>
                </c:pt>
                <c:pt idx="506">
                  <c:v>64.471677016993198</c:v>
                </c:pt>
                <c:pt idx="507">
                  <c:v>64.464016765474398</c:v>
                </c:pt>
                <c:pt idx="508">
                  <c:v>64.456356513955498</c:v>
                </c:pt>
                <c:pt idx="509">
                  <c:v>64.448696262436698</c:v>
                </c:pt>
                <c:pt idx="510">
                  <c:v>64.441036010917898</c:v>
                </c:pt>
                <c:pt idx="511">
                  <c:v>64.433375759399098</c:v>
                </c:pt>
                <c:pt idx="512">
                  <c:v>64.425715507880199</c:v>
                </c:pt>
                <c:pt idx="513">
                  <c:v>64.418055256361399</c:v>
                </c:pt>
                <c:pt idx="514">
                  <c:v>64.410395004842599</c:v>
                </c:pt>
                <c:pt idx="515">
                  <c:v>64.402734753323699</c:v>
                </c:pt>
                <c:pt idx="516">
                  <c:v>64.395074501804899</c:v>
                </c:pt>
                <c:pt idx="517">
                  <c:v>64.387414250286099</c:v>
                </c:pt>
                <c:pt idx="518">
                  <c:v>64.379753998767299</c:v>
                </c:pt>
                <c:pt idx="519">
                  <c:v>64.3720937472484</c:v>
                </c:pt>
                <c:pt idx="520">
                  <c:v>64.3644334957296</c:v>
                </c:pt>
                <c:pt idx="521">
                  <c:v>64.3567732442108</c:v>
                </c:pt>
                <c:pt idx="522">
                  <c:v>64.3491129926919</c:v>
                </c:pt>
                <c:pt idx="523">
                  <c:v>64.3414527411731</c:v>
                </c:pt>
                <c:pt idx="524">
                  <c:v>64.3337924896543</c:v>
                </c:pt>
                <c:pt idx="525">
                  <c:v>64.326132238135401</c:v>
                </c:pt>
                <c:pt idx="526">
                  <c:v>64.318471986616601</c:v>
                </c:pt>
                <c:pt idx="527">
                  <c:v>64.310811735097801</c:v>
                </c:pt>
                <c:pt idx="528">
                  <c:v>64.303151483579001</c:v>
                </c:pt>
                <c:pt idx="529">
                  <c:v>64.295491232060101</c:v>
                </c:pt>
                <c:pt idx="530">
                  <c:v>64.287830980541301</c:v>
                </c:pt>
                <c:pt idx="531">
                  <c:v>64.280170729022501</c:v>
                </c:pt>
                <c:pt idx="532">
                  <c:v>63.284338031574798</c:v>
                </c:pt>
                <c:pt idx="533">
                  <c:v>63.276677780055898</c:v>
                </c:pt>
                <c:pt idx="534">
                  <c:v>63.269017528537098</c:v>
                </c:pt>
                <c:pt idx="535">
                  <c:v>63.261357277018298</c:v>
                </c:pt>
                <c:pt idx="536">
                  <c:v>63.253697025499399</c:v>
                </c:pt>
                <c:pt idx="537">
                  <c:v>63.246036773980599</c:v>
                </c:pt>
                <c:pt idx="538">
                  <c:v>63.238376522461799</c:v>
                </c:pt>
                <c:pt idx="539">
                  <c:v>63.230716270942999</c:v>
                </c:pt>
                <c:pt idx="540">
                  <c:v>63.223056019424099</c:v>
                </c:pt>
                <c:pt idx="541">
                  <c:v>63.215395767905299</c:v>
                </c:pt>
                <c:pt idx="542">
                  <c:v>63.207735516386499</c:v>
                </c:pt>
                <c:pt idx="543">
                  <c:v>63.2000752648676</c:v>
                </c:pt>
                <c:pt idx="544">
                  <c:v>63.1924150133488</c:v>
                </c:pt>
                <c:pt idx="545">
                  <c:v>63.18475476183</c:v>
                </c:pt>
                <c:pt idx="546">
                  <c:v>63.1770945103112</c:v>
                </c:pt>
                <c:pt idx="547">
                  <c:v>63.1694342587923</c:v>
                </c:pt>
                <c:pt idx="548">
                  <c:v>63.1617740072735</c:v>
                </c:pt>
                <c:pt idx="549">
                  <c:v>63.1541137557547</c:v>
                </c:pt>
                <c:pt idx="550">
                  <c:v>63.146453504235801</c:v>
                </c:pt>
                <c:pt idx="551">
                  <c:v>63.138793252717001</c:v>
                </c:pt>
                <c:pt idx="552">
                  <c:v>63.131133001198201</c:v>
                </c:pt>
                <c:pt idx="553">
                  <c:v>63.123472749679401</c:v>
                </c:pt>
                <c:pt idx="554">
                  <c:v>63.115812498160501</c:v>
                </c:pt>
                <c:pt idx="555">
                  <c:v>63.108152246641701</c:v>
                </c:pt>
                <c:pt idx="556">
                  <c:v>63.100491995122901</c:v>
                </c:pt>
                <c:pt idx="557">
                  <c:v>63.092831743604002</c:v>
                </c:pt>
                <c:pt idx="558">
                  <c:v>63.085171492085202</c:v>
                </c:pt>
                <c:pt idx="559">
                  <c:v>63.077511240566402</c:v>
                </c:pt>
                <c:pt idx="560">
                  <c:v>63.069850989047602</c:v>
                </c:pt>
                <c:pt idx="561">
                  <c:v>63.062190737528702</c:v>
                </c:pt>
                <c:pt idx="562">
                  <c:v>63.054530486009902</c:v>
                </c:pt>
                <c:pt idx="563">
                  <c:v>63.046870234491102</c:v>
                </c:pt>
                <c:pt idx="564">
                  <c:v>63.039209982972203</c:v>
                </c:pt>
                <c:pt idx="565">
                  <c:v>63.031549731453403</c:v>
                </c:pt>
                <c:pt idx="566">
                  <c:v>63.023889479934603</c:v>
                </c:pt>
                <c:pt idx="567">
                  <c:v>63.016229228415803</c:v>
                </c:pt>
                <c:pt idx="568">
                  <c:v>63.008568976896903</c:v>
                </c:pt>
                <c:pt idx="569">
                  <c:v>63.000908725378103</c:v>
                </c:pt>
                <c:pt idx="570">
                  <c:v>62.993248473859303</c:v>
                </c:pt>
                <c:pt idx="571">
                  <c:v>62.985588222340397</c:v>
                </c:pt>
                <c:pt idx="572">
                  <c:v>62.977927970821597</c:v>
                </c:pt>
                <c:pt idx="573">
                  <c:v>62.970267719302797</c:v>
                </c:pt>
                <c:pt idx="574">
                  <c:v>62.962607467783997</c:v>
                </c:pt>
                <c:pt idx="575">
                  <c:v>62.954947216265097</c:v>
                </c:pt>
                <c:pt idx="576">
                  <c:v>62.947286964746297</c:v>
                </c:pt>
                <c:pt idx="577">
                  <c:v>62.939626713227497</c:v>
                </c:pt>
                <c:pt idx="578">
                  <c:v>62.931966461708598</c:v>
                </c:pt>
                <c:pt idx="579">
                  <c:v>62.924306210189798</c:v>
                </c:pt>
                <c:pt idx="580">
                  <c:v>62.916645958670998</c:v>
                </c:pt>
                <c:pt idx="581">
                  <c:v>62.908985707152198</c:v>
                </c:pt>
                <c:pt idx="582">
                  <c:v>62.901325455633298</c:v>
                </c:pt>
                <c:pt idx="583">
                  <c:v>62.893665204114498</c:v>
                </c:pt>
                <c:pt idx="584">
                  <c:v>62.886004952595698</c:v>
                </c:pt>
                <c:pt idx="585">
                  <c:v>62.878344701076799</c:v>
                </c:pt>
                <c:pt idx="586">
                  <c:v>62.870684449557999</c:v>
                </c:pt>
                <c:pt idx="587">
                  <c:v>62.863024198039199</c:v>
                </c:pt>
                <c:pt idx="588">
                  <c:v>62.855363946520399</c:v>
                </c:pt>
                <c:pt idx="589">
                  <c:v>62.847703695001499</c:v>
                </c:pt>
                <c:pt idx="590">
                  <c:v>62.840043443482699</c:v>
                </c:pt>
                <c:pt idx="591">
                  <c:v>62.832383191963899</c:v>
                </c:pt>
                <c:pt idx="592">
                  <c:v>62.824722940445</c:v>
                </c:pt>
                <c:pt idx="593">
                  <c:v>57.462546877264998</c:v>
                </c:pt>
                <c:pt idx="594">
                  <c:v>57.454886625746198</c:v>
                </c:pt>
                <c:pt idx="595">
                  <c:v>57.447226374227299</c:v>
                </c:pt>
                <c:pt idx="596">
                  <c:v>57.439566122708499</c:v>
                </c:pt>
                <c:pt idx="597">
                  <c:v>57.431905871189699</c:v>
                </c:pt>
                <c:pt idx="598">
                  <c:v>57.424245619670799</c:v>
                </c:pt>
                <c:pt idx="599">
                  <c:v>57.416585368151999</c:v>
                </c:pt>
                <c:pt idx="600">
                  <c:v>57.408925116633199</c:v>
                </c:pt>
                <c:pt idx="601">
                  <c:v>57.401264865114399</c:v>
                </c:pt>
                <c:pt idx="602">
                  <c:v>57.3936046135955</c:v>
                </c:pt>
                <c:pt idx="603">
                  <c:v>57.3859443620767</c:v>
                </c:pt>
                <c:pt idx="604">
                  <c:v>57.3782841105579</c:v>
                </c:pt>
                <c:pt idx="605">
                  <c:v>57.370623859039</c:v>
                </c:pt>
                <c:pt idx="606">
                  <c:v>57.3629636075202</c:v>
                </c:pt>
                <c:pt idx="607">
                  <c:v>57.3553033560014</c:v>
                </c:pt>
                <c:pt idx="608">
                  <c:v>57.3476431044826</c:v>
                </c:pt>
                <c:pt idx="609">
                  <c:v>57.339982852963701</c:v>
                </c:pt>
                <c:pt idx="610">
                  <c:v>57.332322601444901</c:v>
                </c:pt>
                <c:pt idx="611">
                  <c:v>57.324662349926101</c:v>
                </c:pt>
                <c:pt idx="612">
                  <c:v>57.317002098407201</c:v>
                </c:pt>
                <c:pt idx="613">
                  <c:v>57.309341846888401</c:v>
                </c:pt>
                <c:pt idx="614">
                  <c:v>57.301681595369601</c:v>
                </c:pt>
                <c:pt idx="615">
                  <c:v>57.294021343850801</c:v>
                </c:pt>
                <c:pt idx="616">
                  <c:v>57.286361092331902</c:v>
                </c:pt>
                <c:pt idx="617">
                  <c:v>57.278700840813102</c:v>
                </c:pt>
                <c:pt idx="618">
                  <c:v>57.271040589294302</c:v>
                </c:pt>
                <c:pt idx="619">
                  <c:v>57.263380337775402</c:v>
                </c:pt>
                <c:pt idx="620">
                  <c:v>57.255720086256602</c:v>
                </c:pt>
                <c:pt idx="621">
                  <c:v>57.248059834737802</c:v>
                </c:pt>
                <c:pt idx="622">
                  <c:v>57.240399583219002</c:v>
                </c:pt>
                <c:pt idx="623">
                  <c:v>57.232739331700103</c:v>
                </c:pt>
                <c:pt idx="624">
                  <c:v>57.225079080181303</c:v>
                </c:pt>
                <c:pt idx="625">
                  <c:v>57.217418828662503</c:v>
                </c:pt>
                <c:pt idx="626">
                  <c:v>57.209758577143603</c:v>
                </c:pt>
                <c:pt idx="627">
                  <c:v>57.202098325624803</c:v>
                </c:pt>
                <c:pt idx="628">
                  <c:v>57.194438074106003</c:v>
                </c:pt>
                <c:pt idx="629">
                  <c:v>57.186777822587203</c:v>
                </c:pt>
                <c:pt idx="630">
                  <c:v>57.179117571068304</c:v>
                </c:pt>
                <c:pt idx="631">
                  <c:v>57.171457319549503</c:v>
                </c:pt>
                <c:pt idx="632">
                  <c:v>57.163797068030703</c:v>
                </c:pt>
                <c:pt idx="633">
                  <c:v>57.156136816511903</c:v>
                </c:pt>
                <c:pt idx="634">
                  <c:v>57.002931786135299</c:v>
                </c:pt>
                <c:pt idx="635">
                  <c:v>56.995271534616499</c:v>
                </c:pt>
                <c:pt idx="636">
                  <c:v>56.9876112830976</c:v>
                </c:pt>
                <c:pt idx="637">
                  <c:v>56.9799510315788</c:v>
                </c:pt>
                <c:pt idx="638">
                  <c:v>56.97229078006</c:v>
                </c:pt>
                <c:pt idx="639">
                  <c:v>56.9646305285411</c:v>
                </c:pt>
                <c:pt idx="640">
                  <c:v>56.9569702770223</c:v>
                </c:pt>
                <c:pt idx="641">
                  <c:v>56.9493100255035</c:v>
                </c:pt>
                <c:pt idx="642">
                  <c:v>56.941649773984601</c:v>
                </c:pt>
                <c:pt idx="643">
                  <c:v>56.933989522465801</c:v>
                </c:pt>
                <c:pt idx="644">
                  <c:v>56.926329270947001</c:v>
                </c:pt>
                <c:pt idx="645">
                  <c:v>56.918669019428201</c:v>
                </c:pt>
                <c:pt idx="646">
                  <c:v>56.911008767909301</c:v>
                </c:pt>
                <c:pt idx="647">
                  <c:v>56.903348516390501</c:v>
                </c:pt>
                <c:pt idx="648">
                  <c:v>56.895688264871701</c:v>
                </c:pt>
                <c:pt idx="649">
                  <c:v>56.888028013352802</c:v>
                </c:pt>
                <c:pt idx="650">
                  <c:v>56.880367761834002</c:v>
                </c:pt>
                <c:pt idx="651">
                  <c:v>56.872707510315202</c:v>
                </c:pt>
                <c:pt idx="652">
                  <c:v>56.865047258796402</c:v>
                </c:pt>
                <c:pt idx="653">
                  <c:v>56.857387007277502</c:v>
                </c:pt>
                <c:pt idx="654">
                  <c:v>56.849726755758702</c:v>
                </c:pt>
                <c:pt idx="655">
                  <c:v>56.842066504239902</c:v>
                </c:pt>
                <c:pt idx="656">
                  <c:v>56.834406252721003</c:v>
                </c:pt>
                <c:pt idx="657">
                  <c:v>56.826746001202203</c:v>
                </c:pt>
                <c:pt idx="658">
                  <c:v>56.819085749683403</c:v>
                </c:pt>
                <c:pt idx="659">
                  <c:v>56.811425498164603</c:v>
                </c:pt>
                <c:pt idx="660">
                  <c:v>56.803765246645703</c:v>
                </c:pt>
                <c:pt idx="661">
                  <c:v>56.796104995126903</c:v>
                </c:pt>
                <c:pt idx="662">
                  <c:v>56.788444743608103</c:v>
                </c:pt>
                <c:pt idx="663">
                  <c:v>56.780784492089197</c:v>
                </c:pt>
                <c:pt idx="664">
                  <c:v>56.773124240570397</c:v>
                </c:pt>
                <c:pt idx="665">
                  <c:v>56.765463989051597</c:v>
                </c:pt>
                <c:pt idx="666">
                  <c:v>56.757803737532797</c:v>
                </c:pt>
                <c:pt idx="667">
                  <c:v>56.750143486013897</c:v>
                </c:pt>
                <c:pt idx="668">
                  <c:v>56.742483234495097</c:v>
                </c:pt>
                <c:pt idx="669">
                  <c:v>56.734822982976297</c:v>
                </c:pt>
                <c:pt idx="670">
                  <c:v>56.727162731457398</c:v>
                </c:pt>
                <c:pt idx="671">
                  <c:v>56.719502479938598</c:v>
                </c:pt>
                <c:pt idx="672">
                  <c:v>56.711842228419798</c:v>
                </c:pt>
                <c:pt idx="673">
                  <c:v>56.704181976900998</c:v>
                </c:pt>
                <c:pt idx="674">
                  <c:v>56.696521725382098</c:v>
                </c:pt>
                <c:pt idx="675">
                  <c:v>56.688861473863298</c:v>
                </c:pt>
                <c:pt idx="676">
                  <c:v>56.681201222344498</c:v>
                </c:pt>
                <c:pt idx="677">
                  <c:v>56.673540970825599</c:v>
                </c:pt>
                <c:pt idx="678">
                  <c:v>56.665880719306799</c:v>
                </c:pt>
                <c:pt idx="679">
                  <c:v>56.658220467787999</c:v>
                </c:pt>
                <c:pt idx="680">
                  <c:v>56.650560216269199</c:v>
                </c:pt>
                <c:pt idx="681">
                  <c:v>56.642899964750299</c:v>
                </c:pt>
                <c:pt idx="682">
                  <c:v>56.635239713231499</c:v>
                </c:pt>
                <c:pt idx="683">
                  <c:v>56.627579461712699</c:v>
                </c:pt>
                <c:pt idx="684">
                  <c:v>56.6199192101938</c:v>
                </c:pt>
                <c:pt idx="685">
                  <c:v>56.612258958675</c:v>
                </c:pt>
                <c:pt idx="686">
                  <c:v>56.6045987071562</c:v>
                </c:pt>
                <c:pt idx="687">
                  <c:v>56.5969384556374</c:v>
                </c:pt>
                <c:pt idx="688">
                  <c:v>56.5892782041185</c:v>
                </c:pt>
                <c:pt idx="689">
                  <c:v>56.5816179525997</c:v>
                </c:pt>
                <c:pt idx="690">
                  <c:v>56.5739577010809</c:v>
                </c:pt>
                <c:pt idx="691">
                  <c:v>56.566297449562001</c:v>
                </c:pt>
                <c:pt idx="692">
                  <c:v>56.558637198043201</c:v>
                </c:pt>
                <c:pt idx="693">
                  <c:v>56.550976946524401</c:v>
                </c:pt>
                <c:pt idx="694">
                  <c:v>56.543316695005601</c:v>
                </c:pt>
                <c:pt idx="695">
                  <c:v>56.535656443486701</c:v>
                </c:pt>
                <c:pt idx="696">
                  <c:v>56.527996191967901</c:v>
                </c:pt>
                <c:pt idx="697">
                  <c:v>56.520335940449101</c:v>
                </c:pt>
                <c:pt idx="698">
                  <c:v>56.512675688930202</c:v>
                </c:pt>
                <c:pt idx="699">
                  <c:v>56.505015437411402</c:v>
                </c:pt>
                <c:pt idx="700">
                  <c:v>56.497355185892602</c:v>
                </c:pt>
                <c:pt idx="701">
                  <c:v>56.489694934373802</c:v>
                </c:pt>
                <c:pt idx="702">
                  <c:v>56.482034682854902</c:v>
                </c:pt>
                <c:pt idx="703">
                  <c:v>56.474374431336102</c:v>
                </c:pt>
                <c:pt idx="704">
                  <c:v>56.466714179817302</c:v>
                </c:pt>
                <c:pt idx="705">
                  <c:v>56.459053928298403</c:v>
                </c:pt>
                <c:pt idx="706">
                  <c:v>56.451393676779603</c:v>
                </c:pt>
                <c:pt idx="707">
                  <c:v>56.443733425260803</c:v>
                </c:pt>
                <c:pt idx="708">
                  <c:v>56.436073173741903</c:v>
                </c:pt>
                <c:pt idx="709">
                  <c:v>56.428412922223103</c:v>
                </c:pt>
                <c:pt idx="710">
                  <c:v>56.420752670704303</c:v>
                </c:pt>
                <c:pt idx="711">
                  <c:v>56.413092419185503</c:v>
                </c:pt>
                <c:pt idx="712">
                  <c:v>56.405432167666604</c:v>
                </c:pt>
                <c:pt idx="713">
                  <c:v>56.397771916147803</c:v>
                </c:pt>
                <c:pt idx="714">
                  <c:v>56.390111664629003</c:v>
                </c:pt>
                <c:pt idx="715">
                  <c:v>56.382451413110203</c:v>
                </c:pt>
                <c:pt idx="716">
                  <c:v>56.374791161591297</c:v>
                </c:pt>
                <c:pt idx="717">
                  <c:v>56.367130910072497</c:v>
                </c:pt>
                <c:pt idx="718">
                  <c:v>56.359470658553697</c:v>
                </c:pt>
                <c:pt idx="719">
                  <c:v>56.351810407034797</c:v>
                </c:pt>
                <c:pt idx="720">
                  <c:v>56.344150155515997</c:v>
                </c:pt>
                <c:pt idx="721">
                  <c:v>56.336489903997197</c:v>
                </c:pt>
                <c:pt idx="722">
                  <c:v>56.328829652478397</c:v>
                </c:pt>
                <c:pt idx="723">
                  <c:v>56.321169400959498</c:v>
                </c:pt>
                <c:pt idx="724">
                  <c:v>56.313509149440698</c:v>
                </c:pt>
                <c:pt idx="725">
                  <c:v>56.305848897921898</c:v>
                </c:pt>
                <c:pt idx="726">
                  <c:v>56.298188646402998</c:v>
                </c:pt>
                <c:pt idx="727">
                  <c:v>56.290528394884198</c:v>
                </c:pt>
                <c:pt idx="728">
                  <c:v>56.282868143365398</c:v>
                </c:pt>
                <c:pt idx="729">
                  <c:v>56.275207891846598</c:v>
                </c:pt>
                <c:pt idx="730">
                  <c:v>56.267547640327699</c:v>
                </c:pt>
                <c:pt idx="731">
                  <c:v>56.259887388808899</c:v>
                </c:pt>
                <c:pt idx="732">
                  <c:v>56.252227137290099</c:v>
                </c:pt>
                <c:pt idx="733">
                  <c:v>56.244566885771199</c:v>
                </c:pt>
                <c:pt idx="734">
                  <c:v>56.236906634252399</c:v>
                </c:pt>
                <c:pt idx="735">
                  <c:v>53.4792160874741</c:v>
                </c:pt>
                <c:pt idx="736">
                  <c:v>53.4715558359553</c:v>
                </c:pt>
                <c:pt idx="737">
                  <c:v>53.463895584436401</c:v>
                </c:pt>
                <c:pt idx="738">
                  <c:v>53.456235332917601</c:v>
                </c:pt>
                <c:pt idx="739">
                  <c:v>53.448575081398801</c:v>
                </c:pt>
                <c:pt idx="740">
                  <c:v>53.440914829880001</c:v>
                </c:pt>
                <c:pt idx="741">
                  <c:v>53.433254578361101</c:v>
                </c:pt>
                <c:pt idx="742">
                  <c:v>53.425594326842301</c:v>
                </c:pt>
                <c:pt idx="743">
                  <c:v>53.417934075323501</c:v>
                </c:pt>
                <c:pt idx="744">
                  <c:v>53.410273823804602</c:v>
                </c:pt>
                <c:pt idx="745">
                  <c:v>53.402613572285802</c:v>
                </c:pt>
                <c:pt idx="746">
                  <c:v>53.394953320767002</c:v>
                </c:pt>
                <c:pt idx="747">
                  <c:v>53.387293069248202</c:v>
                </c:pt>
                <c:pt idx="748">
                  <c:v>53.379632817729302</c:v>
                </c:pt>
                <c:pt idx="749">
                  <c:v>53.371972566210502</c:v>
                </c:pt>
                <c:pt idx="750">
                  <c:v>53.364312314691702</c:v>
                </c:pt>
                <c:pt idx="751">
                  <c:v>53.356652063172803</c:v>
                </c:pt>
                <c:pt idx="752">
                  <c:v>53.348991811654003</c:v>
                </c:pt>
                <c:pt idx="753">
                  <c:v>53.341331560135202</c:v>
                </c:pt>
                <c:pt idx="754">
                  <c:v>53.333671308616402</c:v>
                </c:pt>
                <c:pt idx="755">
                  <c:v>53.326011057097503</c:v>
                </c:pt>
                <c:pt idx="756">
                  <c:v>53.318350805578703</c:v>
                </c:pt>
                <c:pt idx="757">
                  <c:v>53.310690554059903</c:v>
                </c:pt>
                <c:pt idx="758">
                  <c:v>53.303030302541003</c:v>
                </c:pt>
                <c:pt idx="759">
                  <c:v>53.295370051022203</c:v>
                </c:pt>
                <c:pt idx="760">
                  <c:v>53.287709799503403</c:v>
                </c:pt>
                <c:pt idx="761">
                  <c:v>53.280049547984603</c:v>
                </c:pt>
                <c:pt idx="762">
                  <c:v>53.272389296465697</c:v>
                </c:pt>
                <c:pt idx="763">
                  <c:v>53.264729044946897</c:v>
                </c:pt>
                <c:pt idx="764">
                  <c:v>53.257068793428097</c:v>
                </c:pt>
                <c:pt idx="765">
                  <c:v>53.249408541909197</c:v>
                </c:pt>
                <c:pt idx="766">
                  <c:v>53.241748290390397</c:v>
                </c:pt>
                <c:pt idx="767">
                  <c:v>53.234088038871597</c:v>
                </c:pt>
                <c:pt idx="768">
                  <c:v>53.226427787352797</c:v>
                </c:pt>
                <c:pt idx="769">
                  <c:v>53.218767535833898</c:v>
                </c:pt>
                <c:pt idx="770">
                  <c:v>53.211107284315098</c:v>
                </c:pt>
                <c:pt idx="771">
                  <c:v>53.203447032796298</c:v>
                </c:pt>
                <c:pt idx="772">
                  <c:v>53.195786781277398</c:v>
                </c:pt>
                <c:pt idx="773">
                  <c:v>53.188126529758598</c:v>
                </c:pt>
                <c:pt idx="774">
                  <c:v>53.180466278239798</c:v>
                </c:pt>
                <c:pt idx="775">
                  <c:v>53.172806026720998</c:v>
                </c:pt>
                <c:pt idx="776">
                  <c:v>53.165145775202099</c:v>
                </c:pt>
                <c:pt idx="777">
                  <c:v>53.157485523683299</c:v>
                </c:pt>
                <c:pt idx="778">
                  <c:v>53.149825272164499</c:v>
                </c:pt>
                <c:pt idx="779">
                  <c:v>53.142165020645599</c:v>
                </c:pt>
                <c:pt idx="780">
                  <c:v>53.134504769126799</c:v>
                </c:pt>
                <c:pt idx="781">
                  <c:v>53.126844517607999</c:v>
                </c:pt>
                <c:pt idx="782">
                  <c:v>53.119184266089199</c:v>
                </c:pt>
                <c:pt idx="783">
                  <c:v>53.1115240145703</c:v>
                </c:pt>
                <c:pt idx="784">
                  <c:v>53.1038637630515</c:v>
                </c:pt>
                <c:pt idx="785">
                  <c:v>53.0962035115327</c:v>
                </c:pt>
                <c:pt idx="786">
                  <c:v>50.338512964754401</c:v>
                </c:pt>
                <c:pt idx="787">
                  <c:v>50.330852713235501</c:v>
                </c:pt>
                <c:pt idx="788">
                  <c:v>50.323192461716701</c:v>
                </c:pt>
                <c:pt idx="789">
                  <c:v>50.315532210197901</c:v>
                </c:pt>
                <c:pt idx="790">
                  <c:v>50.307871958679002</c:v>
                </c:pt>
                <c:pt idx="791">
                  <c:v>50.300211707160202</c:v>
                </c:pt>
                <c:pt idx="792">
                  <c:v>50.292551455641402</c:v>
                </c:pt>
                <c:pt idx="793">
                  <c:v>50.284891204122601</c:v>
                </c:pt>
                <c:pt idx="794">
                  <c:v>50.277230952603702</c:v>
                </c:pt>
                <c:pt idx="795">
                  <c:v>50.269570701084902</c:v>
                </c:pt>
                <c:pt idx="796">
                  <c:v>50.261910449566102</c:v>
                </c:pt>
                <c:pt idx="797">
                  <c:v>50.254250198047203</c:v>
                </c:pt>
                <c:pt idx="798">
                  <c:v>50.246589946528402</c:v>
                </c:pt>
                <c:pt idx="799">
                  <c:v>50.238929695009602</c:v>
                </c:pt>
                <c:pt idx="800">
                  <c:v>50.231269443490802</c:v>
                </c:pt>
                <c:pt idx="801">
                  <c:v>50.223609191971903</c:v>
                </c:pt>
                <c:pt idx="802">
                  <c:v>50.215948940453103</c:v>
                </c:pt>
                <c:pt idx="803">
                  <c:v>50.208288688934303</c:v>
                </c:pt>
                <c:pt idx="804">
                  <c:v>50.200628437415403</c:v>
                </c:pt>
                <c:pt idx="805">
                  <c:v>50.192968185896603</c:v>
                </c:pt>
                <c:pt idx="806">
                  <c:v>50.185307934377803</c:v>
                </c:pt>
                <c:pt idx="807">
                  <c:v>50.177647682859003</c:v>
                </c:pt>
                <c:pt idx="808">
                  <c:v>50.169987431340097</c:v>
                </c:pt>
                <c:pt idx="809">
                  <c:v>50.162327179821297</c:v>
                </c:pt>
                <c:pt idx="810">
                  <c:v>50.154666928302497</c:v>
                </c:pt>
                <c:pt idx="811">
                  <c:v>50.147006676783597</c:v>
                </c:pt>
                <c:pt idx="812">
                  <c:v>50.139346425264797</c:v>
                </c:pt>
                <c:pt idx="813">
                  <c:v>50.131686173745997</c:v>
                </c:pt>
                <c:pt idx="814">
                  <c:v>50.124025922227197</c:v>
                </c:pt>
                <c:pt idx="815">
                  <c:v>50.116365670708298</c:v>
                </c:pt>
                <c:pt idx="816">
                  <c:v>50.108705419189498</c:v>
                </c:pt>
                <c:pt idx="817">
                  <c:v>50.101045167670698</c:v>
                </c:pt>
                <c:pt idx="818">
                  <c:v>50.093384916151798</c:v>
                </c:pt>
                <c:pt idx="819">
                  <c:v>50.085724664632998</c:v>
                </c:pt>
                <c:pt idx="820">
                  <c:v>50.078064413114198</c:v>
                </c:pt>
                <c:pt idx="821">
                  <c:v>50.070404161595398</c:v>
                </c:pt>
                <c:pt idx="822">
                  <c:v>50.062743910076499</c:v>
                </c:pt>
                <c:pt idx="823">
                  <c:v>50.055083658557699</c:v>
                </c:pt>
                <c:pt idx="824">
                  <c:v>50.047423407038899</c:v>
                </c:pt>
                <c:pt idx="825">
                  <c:v>50.039763155519999</c:v>
                </c:pt>
                <c:pt idx="826">
                  <c:v>50.032102904001199</c:v>
                </c:pt>
                <c:pt idx="827">
                  <c:v>48.959667691365198</c:v>
                </c:pt>
                <c:pt idx="828">
                  <c:v>48.952007439846398</c:v>
                </c:pt>
                <c:pt idx="829">
                  <c:v>48.944347188327498</c:v>
                </c:pt>
                <c:pt idx="830">
                  <c:v>48.936686936808698</c:v>
                </c:pt>
                <c:pt idx="831">
                  <c:v>48.929026685289898</c:v>
                </c:pt>
                <c:pt idx="832">
                  <c:v>48.921366433771098</c:v>
                </c:pt>
                <c:pt idx="833">
                  <c:v>48.913706182252199</c:v>
                </c:pt>
                <c:pt idx="834">
                  <c:v>48.906045930733399</c:v>
                </c:pt>
                <c:pt idx="835">
                  <c:v>48.898385679214599</c:v>
                </c:pt>
                <c:pt idx="836">
                  <c:v>48.890725427695699</c:v>
                </c:pt>
                <c:pt idx="837">
                  <c:v>48.883065176176899</c:v>
                </c:pt>
                <c:pt idx="838">
                  <c:v>48.875404924658099</c:v>
                </c:pt>
                <c:pt idx="839">
                  <c:v>48.867744673139299</c:v>
                </c:pt>
                <c:pt idx="840">
                  <c:v>48.8600844216204</c:v>
                </c:pt>
                <c:pt idx="841">
                  <c:v>48.8524241701016</c:v>
                </c:pt>
                <c:pt idx="842">
                  <c:v>48.8447639185828</c:v>
                </c:pt>
                <c:pt idx="843">
                  <c:v>48.8371036670639</c:v>
                </c:pt>
                <c:pt idx="844">
                  <c:v>48.8294434155451</c:v>
                </c:pt>
                <c:pt idx="845">
                  <c:v>48.8217831640263</c:v>
                </c:pt>
                <c:pt idx="846">
                  <c:v>48.8141229125075</c:v>
                </c:pt>
                <c:pt idx="847">
                  <c:v>48.806462660988601</c:v>
                </c:pt>
                <c:pt idx="848">
                  <c:v>48.798802409469801</c:v>
                </c:pt>
                <c:pt idx="849">
                  <c:v>48.791142157951001</c:v>
                </c:pt>
                <c:pt idx="850">
                  <c:v>48.783481906432101</c:v>
                </c:pt>
                <c:pt idx="851">
                  <c:v>48.775821654913301</c:v>
                </c:pt>
                <c:pt idx="852">
                  <c:v>48.768161403394501</c:v>
                </c:pt>
                <c:pt idx="853">
                  <c:v>48.760501151875701</c:v>
                </c:pt>
                <c:pt idx="854">
                  <c:v>48.752840900356802</c:v>
                </c:pt>
                <c:pt idx="855">
                  <c:v>48.745180648838002</c:v>
                </c:pt>
                <c:pt idx="856">
                  <c:v>48.737520397319201</c:v>
                </c:pt>
                <c:pt idx="857">
                  <c:v>48.729860145800302</c:v>
                </c:pt>
                <c:pt idx="858">
                  <c:v>48.722199894281502</c:v>
                </c:pt>
                <c:pt idx="859">
                  <c:v>48.714539642762702</c:v>
                </c:pt>
                <c:pt idx="860">
                  <c:v>48.706879391243902</c:v>
                </c:pt>
                <c:pt idx="861">
                  <c:v>48.699219139725002</c:v>
                </c:pt>
                <c:pt idx="862">
                  <c:v>48.691558888206202</c:v>
                </c:pt>
                <c:pt idx="863">
                  <c:v>48.683898636687402</c:v>
                </c:pt>
                <c:pt idx="864">
                  <c:v>48.676238385168503</c:v>
                </c:pt>
                <c:pt idx="865">
                  <c:v>48.668578133649703</c:v>
                </c:pt>
                <c:pt idx="866">
                  <c:v>48.660917882130903</c:v>
                </c:pt>
                <c:pt idx="867">
                  <c:v>48.653257630612103</c:v>
                </c:pt>
                <c:pt idx="868">
                  <c:v>48.645597379093203</c:v>
                </c:pt>
                <c:pt idx="869">
                  <c:v>48.637937127574403</c:v>
                </c:pt>
                <c:pt idx="870">
                  <c:v>48.630276876055603</c:v>
                </c:pt>
                <c:pt idx="871">
                  <c:v>48.622616624536803</c:v>
                </c:pt>
                <c:pt idx="872">
                  <c:v>48.614956373017897</c:v>
                </c:pt>
                <c:pt idx="873">
                  <c:v>48.607296121499097</c:v>
                </c:pt>
                <c:pt idx="874">
                  <c:v>48.599635869980297</c:v>
                </c:pt>
                <c:pt idx="875">
                  <c:v>48.591975618461397</c:v>
                </c:pt>
                <c:pt idx="876">
                  <c:v>48.584315366942597</c:v>
                </c:pt>
                <c:pt idx="877">
                  <c:v>48.576655115423797</c:v>
                </c:pt>
                <c:pt idx="878">
                  <c:v>44.440119295256302</c:v>
                </c:pt>
                <c:pt idx="879">
                  <c:v>44.432459043737502</c:v>
                </c:pt>
                <c:pt idx="880">
                  <c:v>44.424798792218702</c:v>
                </c:pt>
                <c:pt idx="881">
                  <c:v>44.417138540699803</c:v>
                </c:pt>
                <c:pt idx="882">
                  <c:v>44.409478289181003</c:v>
                </c:pt>
                <c:pt idx="883">
                  <c:v>44.401818037662203</c:v>
                </c:pt>
                <c:pt idx="884">
                  <c:v>44.394157786143303</c:v>
                </c:pt>
                <c:pt idx="885">
                  <c:v>44.386497534624503</c:v>
                </c:pt>
                <c:pt idx="886">
                  <c:v>44.378837283105703</c:v>
                </c:pt>
                <c:pt idx="887">
                  <c:v>44.371177031586797</c:v>
                </c:pt>
                <c:pt idx="888">
                  <c:v>44.363516780067997</c:v>
                </c:pt>
                <c:pt idx="889">
                  <c:v>44.355856528549197</c:v>
                </c:pt>
                <c:pt idx="890">
                  <c:v>44.348196277030397</c:v>
                </c:pt>
                <c:pt idx="891">
                  <c:v>44.340536025511497</c:v>
                </c:pt>
                <c:pt idx="892">
                  <c:v>44.332875773992697</c:v>
                </c:pt>
                <c:pt idx="893">
                  <c:v>44.325215522473897</c:v>
                </c:pt>
                <c:pt idx="894">
                  <c:v>44.317555270954998</c:v>
                </c:pt>
                <c:pt idx="895">
                  <c:v>44.309895019436198</c:v>
                </c:pt>
                <c:pt idx="896">
                  <c:v>44.302234767917398</c:v>
                </c:pt>
                <c:pt idx="897">
                  <c:v>44.294574516398598</c:v>
                </c:pt>
                <c:pt idx="898">
                  <c:v>44.286914264879698</c:v>
                </c:pt>
                <c:pt idx="899">
                  <c:v>44.279254013360898</c:v>
                </c:pt>
                <c:pt idx="900">
                  <c:v>44.271593761842098</c:v>
                </c:pt>
                <c:pt idx="901">
                  <c:v>44.263933510323199</c:v>
                </c:pt>
                <c:pt idx="902">
                  <c:v>44.256273258804399</c:v>
                </c:pt>
                <c:pt idx="903">
                  <c:v>44.248613007285599</c:v>
                </c:pt>
                <c:pt idx="904">
                  <c:v>44.240952755766799</c:v>
                </c:pt>
                <c:pt idx="905">
                  <c:v>44.233292504247899</c:v>
                </c:pt>
                <c:pt idx="906">
                  <c:v>44.225632252729099</c:v>
                </c:pt>
                <c:pt idx="907">
                  <c:v>44.217972001210299</c:v>
                </c:pt>
                <c:pt idx="908">
                  <c:v>44.2103117496914</c:v>
                </c:pt>
                <c:pt idx="909">
                  <c:v>44.2026514981726</c:v>
                </c:pt>
                <c:pt idx="910">
                  <c:v>44.1949912466538</c:v>
                </c:pt>
                <c:pt idx="911">
                  <c:v>44.187330995135</c:v>
                </c:pt>
                <c:pt idx="912">
                  <c:v>44.1796707436161</c:v>
                </c:pt>
                <c:pt idx="913">
                  <c:v>44.1720104920973</c:v>
                </c:pt>
                <c:pt idx="914">
                  <c:v>44.1643502405785</c:v>
                </c:pt>
                <c:pt idx="915">
                  <c:v>44.156689989059601</c:v>
                </c:pt>
                <c:pt idx="916">
                  <c:v>44.149029737540801</c:v>
                </c:pt>
                <c:pt idx="917">
                  <c:v>44.141369486022001</c:v>
                </c:pt>
                <c:pt idx="918">
                  <c:v>44.1337092345032</c:v>
                </c:pt>
                <c:pt idx="919">
                  <c:v>44.126048982984301</c:v>
                </c:pt>
                <c:pt idx="920">
                  <c:v>44.118388731465501</c:v>
                </c:pt>
                <c:pt idx="921">
                  <c:v>44.110728479946701</c:v>
                </c:pt>
                <c:pt idx="922">
                  <c:v>44.103068228427802</c:v>
                </c:pt>
                <c:pt idx="923">
                  <c:v>44.095407976909001</c:v>
                </c:pt>
                <c:pt idx="924">
                  <c:v>44.087747725390201</c:v>
                </c:pt>
                <c:pt idx="925">
                  <c:v>44.080087473871401</c:v>
                </c:pt>
                <c:pt idx="926">
                  <c:v>44.072427222352502</c:v>
                </c:pt>
                <c:pt idx="927">
                  <c:v>44.064766970833702</c:v>
                </c:pt>
                <c:pt idx="928">
                  <c:v>44.057106719314902</c:v>
                </c:pt>
                <c:pt idx="929">
                  <c:v>44.049446467796002</c:v>
                </c:pt>
                <c:pt idx="930">
                  <c:v>44.041786216277202</c:v>
                </c:pt>
                <c:pt idx="931">
                  <c:v>44.034125964758402</c:v>
                </c:pt>
                <c:pt idx="932">
                  <c:v>44.026465713239602</c:v>
                </c:pt>
                <c:pt idx="933">
                  <c:v>44.018805461720703</c:v>
                </c:pt>
                <c:pt idx="934">
                  <c:v>44.011145210201903</c:v>
                </c:pt>
                <c:pt idx="935">
                  <c:v>44.003484958683103</c:v>
                </c:pt>
                <c:pt idx="936">
                  <c:v>43.995824707164203</c:v>
                </c:pt>
                <c:pt idx="937">
                  <c:v>43.988164455645403</c:v>
                </c:pt>
                <c:pt idx="938">
                  <c:v>43.980504204126603</c:v>
                </c:pt>
                <c:pt idx="939">
                  <c:v>43.520889112996898</c:v>
                </c:pt>
                <c:pt idx="940">
                  <c:v>43.513228861477998</c:v>
                </c:pt>
                <c:pt idx="941">
                  <c:v>43.505568609959198</c:v>
                </c:pt>
                <c:pt idx="942">
                  <c:v>43.497908358440398</c:v>
                </c:pt>
                <c:pt idx="943">
                  <c:v>43.490248106921598</c:v>
                </c:pt>
                <c:pt idx="944">
                  <c:v>43.482587855402699</c:v>
                </c:pt>
                <c:pt idx="945">
                  <c:v>43.474927603883899</c:v>
                </c:pt>
                <c:pt idx="946">
                  <c:v>43.467267352365099</c:v>
                </c:pt>
                <c:pt idx="947">
                  <c:v>43.459607100846199</c:v>
                </c:pt>
                <c:pt idx="948">
                  <c:v>43.451946849327399</c:v>
                </c:pt>
                <c:pt idx="949">
                  <c:v>43.444286597808599</c:v>
                </c:pt>
                <c:pt idx="950">
                  <c:v>43.436626346289799</c:v>
                </c:pt>
                <c:pt idx="951">
                  <c:v>43.4289660947709</c:v>
                </c:pt>
                <c:pt idx="952">
                  <c:v>43.4213058432521</c:v>
                </c:pt>
                <c:pt idx="953">
                  <c:v>43.4136455917333</c:v>
                </c:pt>
                <c:pt idx="954">
                  <c:v>43.4059853402144</c:v>
                </c:pt>
                <c:pt idx="955">
                  <c:v>43.3983250886956</c:v>
                </c:pt>
                <c:pt idx="956">
                  <c:v>43.3906648371768</c:v>
                </c:pt>
                <c:pt idx="957">
                  <c:v>43.383004585658</c:v>
                </c:pt>
                <c:pt idx="958">
                  <c:v>43.375344334139101</c:v>
                </c:pt>
                <c:pt idx="959">
                  <c:v>43.367684082620301</c:v>
                </c:pt>
                <c:pt idx="960">
                  <c:v>43.3600238311015</c:v>
                </c:pt>
                <c:pt idx="961">
                  <c:v>43.352363579582601</c:v>
                </c:pt>
                <c:pt idx="962">
                  <c:v>43.344703328063801</c:v>
                </c:pt>
                <c:pt idx="963">
                  <c:v>43.337043076545001</c:v>
                </c:pt>
                <c:pt idx="964">
                  <c:v>43.329382825026102</c:v>
                </c:pt>
                <c:pt idx="965">
                  <c:v>43.321722573507301</c:v>
                </c:pt>
                <c:pt idx="966">
                  <c:v>43.314062321988501</c:v>
                </c:pt>
                <c:pt idx="967">
                  <c:v>43.306402070469701</c:v>
                </c:pt>
                <c:pt idx="968">
                  <c:v>43.298741818950802</c:v>
                </c:pt>
                <c:pt idx="969">
                  <c:v>43.291081567432002</c:v>
                </c:pt>
                <c:pt idx="970">
                  <c:v>43.283421315913202</c:v>
                </c:pt>
                <c:pt idx="971">
                  <c:v>43.275761064394302</c:v>
                </c:pt>
                <c:pt idx="972">
                  <c:v>43.268100812875502</c:v>
                </c:pt>
                <c:pt idx="973">
                  <c:v>43.260440561356702</c:v>
                </c:pt>
                <c:pt idx="974">
                  <c:v>43.252780309837902</c:v>
                </c:pt>
                <c:pt idx="975">
                  <c:v>43.245120058319003</c:v>
                </c:pt>
                <c:pt idx="976">
                  <c:v>43.237459806800203</c:v>
                </c:pt>
                <c:pt idx="977">
                  <c:v>43.229799555281403</c:v>
                </c:pt>
                <c:pt idx="978">
                  <c:v>43.222139303762503</c:v>
                </c:pt>
                <c:pt idx="979">
                  <c:v>43.214479052243703</c:v>
                </c:pt>
                <c:pt idx="980">
                  <c:v>43.206818800724903</c:v>
                </c:pt>
                <c:pt idx="981">
                  <c:v>43.199158549206103</c:v>
                </c:pt>
                <c:pt idx="982">
                  <c:v>43.191498297687197</c:v>
                </c:pt>
                <c:pt idx="983">
                  <c:v>43.183838046168397</c:v>
                </c:pt>
                <c:pt idx="984">
                  <c:v>43.176177794649597</c:v>
                </c:pt>
                <c:pt idx="985">
                  <c:v>43.168517543130797</c:v>
                </c:pt>
                <c:pt idx="986">
                  <c:v>43.160857291611897</c:v>
                </c:pt>
                <c:pt idx="987">
                  <c:v>43.153197040093097</c:v>
                </c:pt>
                <c:pt idx="988">
                  <c:v>43.145536788574297</c:v>
                </c:pt>
                <c:pt idx="989">
                  <c:v>43.137876537055398</c:v>
                </c:pt>
                <c:pt idx="990">
                  <c:v>43.130216285536598</c:v>
                </c:pt>
                <c:pt idx="991">
                  <c:v>43.122556034017798</c:v>
                </c:pt>
                <c:pt idx="992">
                  <c:v>43.114895782498998</c:v>
                </c:pt>
                <c:pt idx="993">
                  <c:v>43.107235530980098</c:v>
                </c:pt>
                <c:pt idx="994">
                  <c:v>43.099575279461298</c:v>
                </c:pt>
                <c:pt idx="995">
                  <c:v>43.091915027942498</c:v>
                </c:pt>
                <c:pt idx="996">
                  <c:v>43.084254776423599</c:v>
                </c:pt>
                <c:pt idx="997">
                  <c:v>43.076594524904799</c:v>
                </c:pt>
                <c:pt idx="998">
                  <c:v>43.068934273385999</c:v>
                </c:pt>
                <c:pt idx="999">
                  <c:v>43.061274021867199</c:v>
                </c:pt>
                <c:pt idx="1000">
                  <c:v>43.053613770348299</c:v>
                </c:pt>
                <c:pt idx="1001">
                  <c:v>43.045953518829499</c:v>
                </c:pt>
                <c:pt idx="1002">
                  <c:v>43.038293267310699</c:v>
                </c:pt>
                <c:pt idx="1003">
                  <c:v>43.0306330157918</c:v>
                </c:pt>
                <c:pt idx="1004">
                  <c:v>43.022972764273</c:v>
                </c:pt>
                <c:pt idx="1005">
                  <c:v>43.0153125127542</c:v>
                </c:pt>
                <c:pt idx="1006">
                  <c:v>43.0076522612354</c:v>
                </c:pt>
                <c:pt idx="1007">
                  <c:v>42.9999920097165</c:v>
                </c:pt>
                <c:pt idx="1008">
                  <c:v>42.9923317581977</c:v>
                </c:pt>
                <c:pt idx="1009">
                  <c:v>42.9846715066789</c:v>
                </c:pt>
                <c:pt idx="1010">
                  <c:v>38.388520595381699</c:v>
                </c:pt>
                <c:pt idx="1011">
                  <c:v>38.380860343862899</c:v>
                </c:pt>
                <c:pt idx="1012">
                  <c:v>38.373200092344</c:v>
                </c:pt>
                <c:pt idx="1013">
                  <c:v>38.3655398408252</c:v>
                </c:pt>
                <c:pt idx="1014">
                  <c:v>38.3578795893064</c:v>
                </c:pt>
                <c:pt idx="1015">
                  <c:v>38.3502193377875</c:v>
                </c:pt>
                <c:pt idx="1016">
                  <c:v>38.3425590862687</c:v>
                </c:pt>
                <c:pt idx="1017">
                  <c:v>38.3348988347499</c:v>
                </c:pt>
                <c:pt idx="1018">
                  <c:v>38.3272385832311</c:v>
                </c:pt>
                <c:pt idx="1019">
                  <c:v>38.319578331712201</c:v>
                </c:pt>
                <c:pt idx="1020">
                  <c:v>38.311918080193401</c:v>
                </c:pt>
                <c:pt idx="1021">
                  <c:v>38.304257828674601</c:v>
                </c:pt>
                <c:pt idx="1022">
                  <c:v>38.296597577155701</c:v>
                </c:pt>
                <c:pt idx="1023">
                  <c:v>38.288937325636901</c:v>
                </c:pt>
                <c:pt idx="1024">
                  <c:v>38.281277074118101</c:v>
                </c:pt>
                <c:pt idx="1025">
                  <c:v>38.273616822599301</c:v>
                </c:pt>
                <c:pt idx="1026">
                  <c:v>38.265956571080402</c:v>
                </c:pt>
                <c:pt idx="1027">
                  <c:v>38.258296319561602</c:v>
                </c:pt>
                <c:pt idx="1028">
                  <c:v>38.250636068042802</c:v>
                </c:pt>
                <c:pt idx="1029">
                  <c:v>38.242975816523902</c:v>
                </c:pt>
                <c:pt idx="1030">
                  <c:v>38.235315565005102</c:v>
                </c:pt>
                <c:pt idx="1031">
                  <c:v>38.227655313486302</c:v>
                </c:pt>
                <c:pt idx="1032">
                  <c:v>38.219995061967502</c:v>
                </c:pt>
                <c:pt idx="1033">
                  <c:v>38.212334810448603</c:v>
                </c:pt>
                <c:pt idx="1034">
                  <c:v>38.204674558929803</c:v>
                </c:pt>
                <c:pt idx="1035">
                  <c:v>38.197014307411003</c:v>
                </c:pt>
                <c:pt idx="1036">
                  <c:v>38.189354055892103</c:v>
                </c:pt>
                <c:pt idx="1037">
                  <c:v>38.181693804373303</c:v>
                </c:pt>
                <c:pt idx="1038">
                  <c:v>38.174033552854503</c:v>
                </c:pt>
                <c:pt idx="1039">
                  <c:v>38.166373301335597</c:v>
                </c:pt>
                <c:pt idx="1040">
                  <c:v>38.158713049816797</c:v>
                </c:pt>
                <c:pt idx="1041">
                  <c:v>38.151052798297997</c:v>
                </c:pt>
                <c:pt idx="1042">
                  <c:v>38.143392546779197</c:v>
                </c:pt>
                <c:pt idx="1043">
                  <c:v>38.135732295260297</c:v>
                </c:pt>
                <c:pt idx="1044">
                  <c:v>38.128072043741497</c:v>
                </c:pt>
                <c:pt idx="1045">
                  <c:v>38.120411792222697</c:v>
                </c:pt>
                <c:pt idx="1046">
                  <c:v>38.112751540703897</c:v>
                </c:pt>
                <c:pt idx="1047">
                  <c:v>38.105091289184998</c:v>
                </c:pt>
                <c:pt idx="1048">
                  <c:v>38.097431037666198</c:v>
                </c:pt>
                <c:pt idx="1049">
                  <c:v>38.089770786147398</c:v>
                </c:pt>
                <c:pt idx="1050">
                  <c:v>38.082110534628498</c:v>
                </c:pt>
                <c:pt idx="1051">
                  <c:v>38.074450283109698</c:v>
                </c:pt>
                <c:pt idx="1052">
                  <c:v>38.066790031590898</c:v>
                </c:pt>
                <c:pt idx="1053">
                  <c:v>38.059129780072098</c:v>
                </c:pt>
                <c:pt idx="1054">
                  <c:v>38.051469528553199</c:v>
                </c:pt>
                <c:pt idx="1055">
                  <c:v>38.043809277034399</c:v>
                </c:pt>
                <c:pt idx="1056">
                  <c:v>38.036149025515599</c:v>
                </c:pt>
                <c:pt idx="1057">
                  <c:v>38.028488773996699</c:v>
                </c:pt>
                <c:pt idx="1058">
                  <c:v>38.020828522477899</c:v>
                </c:pt>
                <c:pt idx="1059">
                  <c:v>38.013168270959099</c:v>
                </c:pt>
                <c:pt idx="1060">
                  <c:v>38.005508019440299</c:v>
                </c:pt>
                <c:pt idx="1061">
                  <c:v>37.9978477679214</c:v>
                </c:pt>
                <c:pt idx="1062">
                  <c:v>37.990187516402599</c:v>
                </c:pt>
                <c:pt idx="1063">
                  <c:v>37.982527264883799</c:v>
                </c:pt>
                <c:pt idx="1064">
                  <c:v>37.9748670133649</c:v>
                </c:pt>
                <c:pt idx="1065">
                  <c:v>37.9672067618461</c:v>
                </c:pt>
                <c:pt idx="1066">
                  <c:v>37.9595465103273</c:v>
                </c:pt>
                <c:pt idx="1067">
                  <c:v>37.9518862588084</c:v>
                </c:pt>
                <c:pt idx="1068">
                  <c:v>37.9442260072896</c:v>
                </c:pt>
                <c:pt idx="1069">
                  <c:v>37.9365657557708</c:v>
                </c:pt>
                <c:pt idx="1070">
                  <c:v>37.928905504252</c:v>
                </c:pt>
                <c:pt idx="1071">
                  <c:v>36.626662746051103</c:v>
                </c:pt>
                <c:pt idx="1072">
                  <c:v>36.619002494532303</c:v>
                </c:pt>
                <c:pt idx="1073">
                  <c:v>36.611342243013397</c:v>
                </c:pt>
                <c:pt idx="1074">
                  <c:v>36.603681991494597</c:v>
                </c:pt>
                <c:pt idx="1075">
                  <c:v>36.596021739975797</c:v>
                </c:pt>
                <c:pt idx="1076">
                  <c:v>36.588361488456997</c:v>
                </c:pt>
                <c:pt idx="1077">
                  <c:v>36.580701236938097</c:v>
                </c:pt>
                <c:pt idx="1078">
                  <c:v>36.573040985419297</c:v>
                </c:pt>
                <c:pt idx="1079">
                  <c:v>36.565380733900497</c:v>
                </c:pt>
                <c:pt idx="1080">
                  <c:v>36.557720482381598</c:v>
                </c:pt>
                <c:pt idx="1081">
                  <c:v>36.550060230862798</c:v>
                </c:pt>
                <c:pt idx="1082">
                  <c:v>36.542399979343998</c:v>
                </c:pt>
                <c:pt idx="1083">
                  <c:v>36.534739727825198</c:v>
                </c:pt>
                <c:pt idx="1084">
                  <c:v>36.527079476306298</c:v>
                </c:pt>
                <c:pt idx="1085">
                  <c:v>36.519419224787498</c:v>
                </c:pt>
                <c:pt idx="1086">
                  <c:v>36.511758973268698</c:v>
                </c:pt>
                <c:pt idx="1087">
                  <c:v>36.504098721749799</c:v>
                </c:pt>
                <c:pt idx="1088">
                  <c:v>36.496438470230999</c:v>
                </c:pt>
                <c:pt idx="1089">
                  <c:v>36.488778218712199</c:v>
                </c:pt>
                <c:pt idx="1090">
                  <c:v>36.481117967193398</c:v>
                </c:pt>
                <c:pt idx="1091">
                  <c:v>36.473457715674499</c:v>
                </c:pt>
                <c:pt idx="1092">
                  <c:v>36.465797464155699</c:v>
                </c:pt>
                <c:pt idx="1093">
                  <c:v>36.458137212636899</c:v>
                </c:pt>
                <c:pt idx="1094">
                  <c:v>36.450476961118</c:v>
                </c:pt>
                <c:pt idx="1095">
                  <c:v>36.442816709599199</c:v>
                </c:pt>
                <c:pt idx="1096">
                  <c:v>36.435156458080399</c:v>
                </c:pt>
                <c:pt idx="1097">
                  <c:v>36.427496206561599</c:v>
                </c:pt>
                <c:pt idx="1098">
                  <c:v>36.4198359550427</c:v>
                </c:pt>
                <c:pt idx="1099">
                  <c:v>36.4121757035239</c:v>
                </c:pt>
                <c:pt idx="1100">
                  <c:v>36.4045154520051</c:v>
                </c:pt>
                <c:pt idx="1101">
                  <c:v>36.3968552004862</c:v>
                </c:pt>
                <c:pt idx="1102">
                  <c:v>36.3891949489674</c:v>
                </c:pt>
                <c:pt idx="1103">
                  <c:v>36.3815346974486</c:v>
                </c:pt>
                <c:pt idx="1104">
                  <c:v>36.373874445929701</c:v>
                </c:pt>
                <c:pt idx="1105">
                  <c:v>36.366214194410901</c:v>
                </c:pt>
                <c:pt idx="1106">
                  <c:v>36.358553942892101</c:v>
                </c:pt>
                <c:pt idx="1107">
                  <c:v>36.350893691373301</c:v>
                </c:pt>
                <c:pt idx="1108">
                  <c:v>36.343233439854401</c:v>
                </c:pt>
                <c:pt idx="1109">
                  <c:v>36.335573188335601</c:v>
                </c:pt>
                <c:pt idx="1110">
                  <c:v>36.327912936816801</c:v>
                </c:pt>
                <c:pt idx="1111">
                  <c:v>36.320252685297902</c:v>
                </c:pt>
                <c:pt idx="1112">
                  <c:v>36.312592433779102</c:v>
                </c:pt>
                <c:pt idx="1113">
                  <c:v>36.304932182260302</c:v>
                </c:pt>
                <c:pt idx="1114">
                  <c:v>36.297271930741502</c:v>
                </c:pt>
                <c:pt idx="1115">
                  <c:v>36.289611679222602</c:v>
                </c:pt>
                <c:pt idx="1116">
                  <c:v>36.281951427703802</c:v>
                </c:pt>
                <c:pt idx="1117">
                  <c:v>36.274291176185002</c:v>
                </c:pt>
                <c:pt idx="1118">
                  <c:v>36.266630924666103</c:v>
                </c:pt>
                <c:pt idx="1119">
                  <c:v>36.258970673147303</c:v>
                </c:pt>
                <c:pt idx="1120">
                  <c:v>36.251310421628503</c:v>
                </c:pt>
                <c:pt idx="1121">
                  <c:v>36.243650170109703</c:v>
                </c:pt>
                <c:pt idx="1122">
                  <c:v>36.235989918590803</c:v>
                </c:pt>
                <c:pt idx="1123">
                  <c:v>36.228329667072003</c:v>
                </c:pt>
                <c:pt idx="1124">
                  <c:v>36.220669415553203</c:v>
                </c:pt>
                <c:pt idx="1125">
                  <c:v>36.213009164034403</c:v>
                </c:pt>
                <c:pt idx="1126">
                  <c:v>36.205348912515497</c:v>
                </c:pt>
                <c:pt idx="1127">
                  <c:v>36.197688660996697</c:v>
                </c:pt>
                <c:pt idx="1128">
                  <c:v>36.190028409477897</c:v>
                </c:pt>
                <c:pt idx="1129">
                  <c:v>36.182368157958997</c:v>
                </c:pt>
                <c:pt idx="1130">
                  <c:v>36.174707906440197</c:v>
                </c:pt>
                <c:pt idx="1131">
                  <c:v>36.167047654921397</c:v>
                </c:pt>
                <c:pt idx="1132">
                  <c:v>36.159387403402597</c:v>
                </c:pt>
                <c:pt idx="1133">
                  <c:v>36.151727151883698</c:v>
                </c:pt>
                <c:pt idx="1134">
                  <c:v>36.144066900364898</c:v>
                </c:pt>
                <c:pt idx="1135">
                  <c:v>36.136406648846098</c:v>
                </c:pt>
                <c:pt idx="1136">
                  <c:v>36.128746397327198</c:v>
                </c:pt>
                <c:pt idx="1137">
                  <c:v>36.121086145808398</c:v>
                </c:pt>
                <c:pt idx="1138">
                  <c:v>36.113425894289598</c:v>
                </c:pt>
                <c:pt idx="1139">
                  <c:v>36.105765642770699</c:v>
                </c:pt>
                <c:pt idx="1140">
                  <c:v>36.098105391251899</c:v>
                </c:pt>
                <c:pt idx="1141">
                  <c:v>36.090445139733099</c:v>
                </c:pt>
                <c:pt idx="1142">
                  <c:v>36.082784888214299</c:v>
                </c:pt>
                <c:pt idx="1143">
                  <c:v>36.075124636695399</c:v>
                </c:pt>
                <c:pt idx="1144">
                  <c:v>36.067464385176599</c:v>
                </c:pt>
                <c:pt idx="1145">
                  <c:v>36.059804133657799</c:v>
                </c:pt>
                <c:pt idx="1146">
                  <c:v>36.0521438821389</c:v>
                </c:pt>
                <c:pt idx="1147">
                  <c:v>36.0444836306201</c:v>
                </c:pt>
                <c:pt idx="1148">
                  <c:v>36.0368233791013</c:v>
                </c:pt>
                <c:pt idx="1149">
                  <c:v>36.0291631275825</c:v>
                </c:pt>
                <c:pt idx="1150">
                  <c:v>36.0215028760636</c:v>
                </c:pt>
                <c:pt idx="1151">
                  <c:v>36.0138426245448</c:v>
                </c:pt>
                <c:pt idx="1152">
                  <c:v>36.006182373026</c:v>
                </c:pt>
                <c:pt idx="1153">
                  <c:v>35.998522121507101</c:v>
                </c:pt>
                <c:pt idx="1154">
                  <c:v>35.990861869988301</c:v>
                </c:pt>
                <c:pt idx="1155">
                  <c:v>35.983201618469501</c:v>
                </c:pt>
                <c:pt idx="1156">
                  <c:v>35.975541366950701</c:v>
                </c:pt>
                <c:pt idx="1157">
                  <c:v>35.967881115431801</c:v>
                </c:pt>
                <c:pt idx="1158">
                  <c:v>35.960220863913001</c:v>
                </c:pt>
                <c:pt idx="1159">
                  <c:v>35.952560612394201</c:v>
                </c:pt>
                <c:pt idx="1160">
                  <c:v>35.944900360875302</c:v>
                </c:pt>
                <c:pt idx="1161">
                  <c:v>35.937240109356502</c:v>
                </c:pt>
                <c:pt idx="1162">
                  <c:v>35.929579857837702</c:v>
                </c:pt>
                <c:pt idx="1163">
                  <c:v>35.921919606318902</c:v>
                </c:pt>
                <c:pt idx="1164">
                  <c:v>35.914259354800002</c:v>
                </c:pt>
                <c:pt idx="1165">
                  <c:v>35.906599103281202</c:v>
                </c:pt>
                <c:pt idx="1166">
                  <c:v>35.898938851762402</c:v>
                </c:pt>
                <c:pt idx="1167">
                  <c:v>35.891278600243503</c:v>
                </c:pt>
                <c:pt idx="1168">
                  <c:v>35.883618348724703</c:v>
                </c:pt>
                <c:pt idx="1169">
                  <c:v>35.875958097205903</c:v>
                </c:pt>
                <c:pt idx="1170">
                  <c:v>35.868297845687103</c:v>
                </c:pt>
                <c:pt idx="1171">
                  <c:v>35.860637594168203</c:v>
                </c:pt>
                <c:pt idx="1172">
                  <c:v>34.8648048967205</c:v>
                </c:pt>
                <c:pt idx="1173">
                  <c:v>34.8571446452017</c:v>
                </c:pt>
                <c:pt idx="1174">
                  <c:v>34.8494843936829</c:v>
                </c:pt>
                <c:pt idx="1175">
                  <c:v>34.841824142164</c:v>
                </c:pt>
                <c:pt idx="1176">
                  <c:v>34.8341638906452</c:v>
                </c:pt>
                <c:pt idx="1177">
                  <c:v>34.8265036391264</c:v>
                </c:pt>
                <c:pt idx="1178">
                  <c:v>34.818843387607501</c:v>
                </c:pt>
                <c:pt idx="1179">
                  <c:v>34.811183136088701</c:v>
                </c:pt>
                <c:pt idx="1180">
                  <c:v>34.803522884569901</c:v>
                </c:pt>
                <c:pt idx="1181">
                  <c:v>34.795862633051001</c:v>
                </c:pt>
                <c:pt idx="1182">
                  <c:v>34.788202381532201</c:v>
                </c:pt>
                <c:pt idx="1183">
                  <c:v>34.780542130013401</c:v>
                </c:pt>
                <c:pt idx="1184">
                  <c:v>34.772881878494601</c:v>
                </c:pt>
                <c:pt idx="1185">
                  <c:v>34.765221626975702</c:v>
                </c:pt>
                <c:pt idx="1186">
                  <c:v>34.757561375456902</c:v>
                </c:pt>
                <c:pt idx="1187">
                  <c:v>34.749901123938102</c:v>
                </c:pt>
                <c:pt idx="1188">
                  <c:v>34.742240872419202</c:v>
                </c:pt>
                <c:pt idx="1189">
                  <c:v>34.734580620900402</c:v>
                </c:pt>
                <c:pt idx="1190">
                  <c:v>34.726920369381602</c:v>
                </c:pt>
                <c:pt idx="1191">
                  <c:v>34.719260117862802</c:v>
                </c:pt>
                <c:pt idx="1192">
                  <c:v>34.711599866343903</c:v>
                </c:pt>
                <c:pt idx="1193">
                  <c:v>34.703939614825103</c:v>
                </c:pt>
                <c:pt idx="1194">
                  <c:v>34.696279363306303</c:v>
                </c:pt>
                <c:pt idx="1195">
                  <c:v>34.688619111787403</c:v>
                </c:pt>
                <c:pt idx="1196">
                  <c:v>34.680958860268603</c:v>
                </c:pt>
                <c:pt idx="1197">
                  <c:v>34.673298608749803</c:v>
                </c:pt>
                <c:pt idx="1198">
                  <c:v>34.665638357231003</c:v>
                </c:pt>
                <c:pt idx="1199">
                  <c:v>34.657978105712097</c:v>
                </c:pt>
                <c:pt idx="1200">
                  <c:v>34.650317854193297</c:v>
                </c:pt>
                <c:pt idx="1201">
                  <c:v>34.642657602674497</c:v>
                </c:pt>
                <c:pt idx="1202">
                  <c:v>34.634997351155697</c:v>
                </c:pt>
                <c:pt idx="1203">
                  <c:v>34.627337099636797</c:v>
                </c:pt>
                <c:pt idx="1204">
                  <c:v>34.619676848117997</c:v>
                </c:pt>
                <c:pt idx="1205">
                  <c:v>34.612016596599197</c:v>
                </c:pt>
                <c:pt idx="1206">
                  <c:v>34.604356345080298</c:v>
                </c:pt>
                <c:pt idx="1207">
                  <c:v>34.596696093561498</c:v>
                </c:pt>
                <c:pt idx="1208">
                  <c:v>34.589035842042698</c:v>
                </c:pt>
                <c:pt idx="1209">
                  <c:v>34.581375590523898</c:v>
                </c:pt>
                <c:pt idx="1210">
                  <c:v>34.573715339004998</c:v>
                </c:pt>
                <c:pt idx="1211">
                  <c:v>34.566055087486198</c:v>
                </c:pt>
                <c:pt idx="1212">
                  <c:v>34.558394835967398</c:v>
                </c:pt>
                <c:pt idx="1213">
                  <c:v>34.550734584448499</c:v>
                </c:pt>
                <c:pt idx="1214">
                  <c:v>34.543074332929699</c:v>
                </c:pt>
                <c:pt idx="1215">
                  <c:v>34.535414081410899</c:v>
                </c:pt>
                <c:pt idx="1216">
                  <c:v>34.527753829891999</c:v>
                </c:pt>
                <c:pt idx="1217">
                  <c:v>34.520093578373199</c:v>
                </c:pt>
                <c:pt idx="1218">
                  <c:v>34.512433326854399</c:v>
                </c:pt>
                <c:pt idx="1219">
                  <c:v>34.504773075335599</c:v>
                </c:pt>
                <c:pt idx="1220">
                  <c:v>34.4971128238167</c:v>
                </c:pt>
                <c:pt idx="1221">
                  <c:v>34.4894525722979</c:v>
                </c:pt>
                <c:pt idx="1222">
                  <c:v>34.4817923207791</c:v>
                </c:pt>
                <c:pt idx="1223">
                  <c:v>34.4741320692602</c:v>
                </c:pt>
                <c:pt idx="1224">
                  <c:v>34.4664718177414</c:v>
                </c:pt>
                <c:pt idx="1225">
                  <c:v>34.4588115662226</c:v>
                </c:pt>
                <c:pt idx="1226">
                  <c:v>34.4511513147038</c:v>
                </c:pt>
                <c:pt idx="1227">
                  <c:v>34.443491063184901</c:v>
                </c:pt>
                <c:pt idx="1228">
                  <c:v>34.435830811666101</c:v>
                </c:pt>
                <c:pt idx="1229">
                  <c:v>34.428170560147301</c:v>
                </c:pt>
                <c:pt idx="1230">
                  <c:v>34.420510308628401</c:v>
                </c:pt>
                <c:pt idx="1231">
                  <c:v>34.412850057109601</c:v>
                </c:pt>
                <c:pt idx="1232">
                  <c:v>34.405189805590801</c:v>
                </c:pt>
                <c:pt idx="1233">
                  <c:v>34.397529554072001</c:v>
                </c:pt>
                <c:pt idx="1234">
                  <c:v>34.389869302553102</c:v>
                </c:pt>
                <c:pt idx="1235">
                  <c:v>34.382209051034302</c:v>
                </c:pt>
                <c:pt idx="1236">
                  <c:v>34.374548799515502</c:v>
                </c:pt>
                <c:pt idx="1237">
                  <c:v>34.366888547996602</c:v>
                </c:pt>
                <c:pt idx="1238">
                  <c:v>34.359228296477802</c:v>
                </c:pt>
                <c:pt idx="1239">
                  <c:v>34.351568044959002</c:v>
                </c:pt>
                <c:pt idx="1240">
                  <c:v>34.343907793440202</c:v>
                </c:pt>
                <c:pt idx="1241">
                  <c:v>34.336247541921303</c:v>
                </c:pt>
                <c:pt idx="1242">
                  <c:v>34.328587290402503</c:v>
                </c:pt>
                <c:pt idx="1243">
                  <c:v>34.320927038883703</c:v>
                </c:pt>
                <c:pt idx="1244">
                  <c:v>34.313266787364803</c:v>
                </c:pt>
                <c:pt idx="1245">
                  <c:v>34.305606535846003</c:v>
                </c:pt>
                <c:pt idx="1246">
                  <c:v>34.297946284327203</c:v>
                </c:pt>
                <c:pt idx="1247">
                  <c:v>34.290286032808403</c:v>
                </c:pt>
                <c:pt idx="1248">
                  <c:v>34.282625781289497</c:v>
                </c:pt>
                <c:pt idx="1249">
                  <c:v>34.274965529770697</c:v>
                </c:pt>
                <c:pt idx="1250">
                  <c:v>34.267305278251897</c:v>
                </c:pt>
                <c:pt idx="1251">
                  <c:v>34.259645026732997</c:v>
                </c:pt>
                <c:pt idx="1252">
                  <c:v>34.251984775214197</c:v>
                </c:pt>
                <c:pt idx="1253">
                  <c:v>34.244324523695397</c:v>
                </c:pt>
                <c:pt idx="1254">
                  <c:v>34.236664272176597</c:v>
                </c:pt>
                <c:pt idx="1255">
                  <c:v>34.229004020657698</c:v>
                </c:pt>
                <c:pt idx="1256">
                  <c:v>34.221343769138898</c:v>
                </c:pt>
                <c:pt idx="1257">
                  <c:v>34.213683517620098</c:v>
                </c:pt>
                <c:pt idx="1258">
                  <c:v>34.206023266101198</c:v>
                </c:pt>
                <c:pt idx="1259">
                  <c:v>34.198363014582398</c:v>
                </c:pt>
                <c:pt idx="1260">
                  <c:v>34.190702763063598</c:v>
                </c:pt>
                <c:pt idx="1261">
                  <c:v>34.183042511544798</c:v>
                </c:pt>
                <c:pt idx="1262">
                  <c:v>34.175382260025899</c:v>
                </c:pt>
                <c:pt idx="1263">
                  <c:v>32.873139501825101</c:v>
                </c:pt>
                <c:pt idx="1264">
                  <c:v>32.865479250306201</c:v>
                </c:pt>
                <c:pt idx="1265">
                  <c:v>32.857818998787401</c:v>
                </c:pt>
                <c:pt idx="1266">
                  <c:v>32.850158747268601</c:v>
                </c:pt>
                <c:pt idx="1267">
                  <c:v>32.842498495749702</c:v>
                </c:pt>
                <c:pt idx="1268">
                  <c:v>32.834838244230902</c:v>
                </c:pt>
                <c:pt idx="1269">
                  <c:v>32.827177992712102</c:v>
                </c:pt>
                <c:pt idx="1270">
                  <c:v>32.819517741193302</c:v>
                </c:pt>
                <c:pt idx="1271">
                  <c:v>32.811857489674402</c:v>
                </c:pt>
                <c:pt idx="1272">
                  <c:v>32.804197238155602</c:v>
                </c:pt>
                <c:pt idx="1273">
                  <c:v>32.796536986636802</c:v>
                </c:pt>
                <c:pt idx="1274">
                  <c:v>32.788876735117903</c:v>
                </c:pt>
                <c:pt idx="1275">
                  <c:v>32.781216483599103</c:v>
                </c:pt>
                <c:pt idx="1276">
                  <c:v>32.773556232080303</c:v>
                </c:pt>
                <c:pt idx="1277">
                  <c:v>32.765895980561503</c:v>
                </c:pt>
                <c:pt idx="1278">
                  <c:v>32.758235729042603</c:v>
                </c:pt>
                <c:pt idx="1279">
                  <c:v>32.750575477523803</c:v>
                </c:pt>
                <c:pt idx="1280">
                  <c:v>32.742915226005003</c:v>
                </c:pt>
                <c:pt idx="1281">
                  <c:v>32.735254974486097</c:v>
                </c:pt>
                <c:pt idx="1282">
                  <c:v>32.727594722967297</c:v>
                </c:pt>
                <c:pt idx="1283">
                  <c:v>32.719934471448497</c:v>
                </c:pt>
                <c:pt idx="1284">
                  <c:v>32.712274219929697</c:v>
                </c:pt>
                <c:pt idx="1285">
                  <c:v>32.704613968410797</c:v>
                </c:pt>
                <c:pt idx="1286">
                  <c:v>32.696953716891997</c:v>
                </c:pt>
                <c:pt idx="1287">
                  <c:v>32.689293465373197</c:v>
                </c:pt>
                <c:pt idx="1288">
                  <c:v>32.681633213854298</c:v>
                </c:pt>
                <c:pt idx="1289">
                  <c:v>32.673972962335498</c:v>
                </c:pt>
                <c:pt idx="1290">
                  <c:v>32.666312710816698</c:v>
                </c:pt>
                <c:pt idx="1291">
                  <c:v>32.658652459297898</c:v>
                </c:pt>
                <c:pt idx="1292">
                  <c:v>32.650992207778998</c:v>
                </c:pt>
                <c:pt idx="1293">
                  <c:v>32.643331956260198</c:v>
                </c:pt>
                <c:pt idx="1294">
                  <c:v>32.635671704741398</c:v>
                </c:pt>
                <c:pt idx="1295">
                  <c:v>32.628011453222499</c:v>
                </c:pt>
                <c:pt idx="1296">
                  <c:v>32.620351201703699</c:v>
                </c:pt>
                <c:pt idx="1297">
                  <c:v>32.612690950184898</c:v>
                </c:pt>
                <c:pt idx="1298">
                  <c:v>32.605030698666098</c:v>
                </c:pt>
                <c:pt idx="1299">
                  <c:v>32.597370447147199</c:v>
                </c:pt>
                <c:pt idx="1300">
                  <c:v>32.589710195628399</c:v>
                </c:pt>
                <c:pt idx="1301">
                  <c:v>32.582049944109599</c:v>
                </c:pt>
                <c:pt idx="1302">
                  <c:v>32.574389692590699</c:v>
                </c:pt>
                <c:pt idx="1303">
                  <c:v>32.566729441071899</c:v>
                </c:pt>
                <c:pt idx="1304">
                  <c:v>32.559069189553099</c:v>
                </c:pt>
                <c:pt idx="1305">
                  <c:v>32.551408938034299</c:v>
                </c:pt>
                <c:pt idx="1306">
                  <c:v>32.5437486865154</c:v>
                </c:pt>
                <c:pt idx="1307">
                  <c:v>32.5360884349966</c:v>
                </c:pt>
                <c:pt idx="1308">
                  <c:v>32.5284281834778</c:v>
                </c:pt>
                <c:pt idx="1309">
                  <c:v>32.5207679319589</c:v>
                </c:pt>
                <c:pt idx="1310">
                  <c:v>32.5131076804401</c:v>
                </c:pt>
                <c:pt idx="1311">
                  <c:v>32.5054474289213</c:v>
                </c:pt>
                <c:pt idx="1312">
                  <c:v>32.4977871774025</c:v>
                </c:pt>
                <c:pt idx="1313">
                  <c:v>32.490126925883601</c:v>
                </c:pt>
                <c:pt idx="1314">
                  <c:v>32.482466674364801</c:v>
                </c:pt>
                <c:pt idx="1315">
                  <c:v>32.474806422846001</c:v>
                </c:pt>
                <c:pt idx="1316">
                  <c:v>32.467146171327101</c:v>
                </c:pt>
                <c:pt idx="1317">
                  <c:v>32.459485919808301</c:v>
                </c:pt>
                <c:pt idx="1318">
                  <c:v>32.451825668289501</c:v>
                </c:pt>
                <c:pt idx="1319">
                  <c:v>32.444165416770701</c:v>
                </c:pt>
                <c:pt idx="1320">
                  <c:v>32.436505165251802</c:v>
                </c:pt>
                <c:pt idx="1321">
                  <c:v>32.428844913733002</c:v>
                </c:pt>
                <c:pt idx="1322">
                  <c:v>32.421184662214202</c:v>
                </c:pt>
                <c:pt idx="1323">
                  <c:v>32.413524410695302</c:v>
                </c:pt>
                <c:pt idx="1324">
                  <c:v>32.405864159176502</c:v>
                </c:pt>
                <c:pt idx="1325">
                  <c:v>32.398203907657702</c:v>
                </c:pt>
                <c:pt idx="1326">
                  <c:v>32.390543656138902</c:v>
                </c:pt>
                <c:pt idx="1327">
                  <c:v>32.382883404620003</c:v>
                </c:pt>
                <c:pt idx="1328">
                  <c:v>32.375223153101203</c:v>
                </c:pt>
                <c:pt idx="1329">
                  <c:v>32.367562901582403</c:v>
                </c:pt>
                <c:pt idx="1330">
                  <c:v>32.359902650063503</c:v>
                </c:pt>
                <c:pt idx="1331">
                  <c:v>32.352242398544703</c:v>
                </c:pt>
                <c:pt idx="1332">
                  <c:v>32.344582147025903</c:v>
                </c:pt>
                <c:pt idx="1333">
                  <c:v>32.336921895507103</c:v>
                </c:pt>
                <c:pt idx="1334">
                  <c:v>32.329261643988197</c:v>
                </c:pt>
                <c:pt idx="1335">
                  <c:v>32.321601392469397</c:v>
                </c:pt>
                <c:pt idx="1336">
                  <c:v>32.313941140950597</c:v>
                </c:pt>
                <c:pt idx="1337">
                  <c:v>32.306280889431697</c:v>
                </c:pt>
                <c:pt idx="1338">
                  <c:v>32.298620637912897</c:v>
                </c:pt>
                <c:pt idx="1339">
                  <c:v>32.290960386394097</c:v>
                </c:pt>
                <c:pt idx="1340">
                  <c:v>32.283300134875297</c:v>
                </c:pt>
                <c:pt idx="1341">
                  <c:v>32.275639883356398</c:v>
                </c:pt>
                <c:pt idx="1342">
                  <c:v>32.267979631837598</c:v>
                </c:pt>
                <c:pt idx="1343">
                  <c:v>32.260319380318798</c:v>
                </c:pt>
                <c:pt idx="1344">
                  <c:v>32.252659128799898</c:v>
                </c:pt>
                <c:pt idx="1345">
                  <c:v>32.244998877281098</c:v>
                </c:pt>
                <c:pt idx="1346">
                  <c:v>32.237338625762298</c:v>
                </c:pt>
                <c:pt idx="1347">
                  <c:v>32.229678374243498</c:v>
                </c:pt>
                <c:pt idx="1348">
                  <c:v>32.222018122724599</c:v>
                </c:pt>
                <c:pt idx="1349">
                  <c:v>32.214357871205799</c:v>
                </c:pt>
                <c:pt idx="1350">
                  <c:v>32.206697619686999</c:v>
                </c:pt>
                <c:pt idx="1351">
                  <c:v>32.199037368168099</c:v>
                </c:pt>
                <c:pt idx="1352">
                  <c:v>32.191377116649299</c:v>
                </c:pt>
                <c:pt idx="1353">
                  <c:v>32.183716865130499</c:v>
                </c:pt>
                <c:pt idx="1354">
                  <c:v>32.176056613611699</c:v>
                </c:pt>
                <c:pt idx="1355">
                  <c:v>32.1683963620928</c:v>
                </c:pt>
                <c:pt idx="1356">
                  <c:v>32.160736110574</c:v>
                </c:pt>
                <c:pt idx="1357">
                  <c:v>32.1530758590552</c:v>
                </c:pt>
                <c:pt idx="1358">
                  <c:v>32.1454156075363</c:v>
                </c:pt>
                <c:pt idx="1359">
                  <c:v>32.1377553560175</c:v>
                </c:pt>
                <c:pt idx="1360">
                  <c:v>32.1300951044987</c:v>
                </c:pt>
                <c:pt idx="1361">
                  <c:v>32.1224348529799</c:v>
                </c:pt>
                <c:pt idx="1362">
                  <c:v>32.114774601461001</c:v>
                </c:pt>
                <c:pt idx="1363">
                  <c:v>32.107114349942201</c:v>
                </c:pt>
                <c:pt idx="1364">
                  <c:v>32.099454098423401</c:v>
                </c:pt>
                <c:pt idx="1365">
                  <c:v>32.091793846904501</c:v>
                </c:pt>
                <c:pt idx="1366">
                  <c:v>32.084133595385701</c:v>
                </c:pt>
                <c:pt idx="1367">
                  <c:v>32.076473343866901</c:v>
                </c:pt>
                <c:pt idx="1368">
                  <c:v>32.068813092348101</c:v>
                </c:pt>
                <c:pt idx="1369">
                  <c:v>32.061152840829202</c:v>
                </c:pt>
                <c:pt idx="1370">
                  <c:v>32.053492589310402</c:v>
                </c:pt>
                <c:pt idx="1371">
                  <c:v>32.045832337791602</c:v>
                </c:pt>
                <c:pt idx="1372">
                  <c:v>32.038172086272702</c:v>
                </c:pt>
                <c:pt idx="1373">
                  <c:v>32.030511834753902</c:v>
                </c:pt>
                <c:pt idx="1374">
                  <c:v>32.022851583235102</c:v>
                </c:pt>
                <c:pt idx="1375">
                  <c:v>32.015191331716302</c:v>
                </c:pt>
                <c:pt idx="1376">
                  <c:v>32.007531080197403</c:v>
                </c:pt>
                <c:pt idx="1377">
                  <c:v>31.999870828678599</c:v>
                </c:pt>
                <c:pt idx="1378">
                  <c:v>31.992210577159799</c:v>
                </c:pt>
                <c:pt idx="1379">
                  <c:v>31.9845503256409</c:v>
                </c:pt>
                <c:pt idx="1380">
                  <c:v>31.9768900741221</c:v>
                </c:pt>
                <c:pt idx="1381">
                  <c:v>31.9692298226033</c:v>
                </c:pt>
                <c:pt idx="1382">
                  <c:v>31.9615695710845</c:v>
                </c:pt>
                <c:pt idx="1383">
                  <c:v>31.9539093195656</c:v>
                </c:pt>
                <c:pt idx="1384">
                  <c:v>31.9462490680468</c:v>
                </c:pt>
                <c:pt idx="1385">
                  <c:v>31.938588816528</c:v>
                </c:pt>
                <c:pt idx="1386">
                  <c:v>31.930928565009101</c:v>
                </c:pt>
                <c:pt idx="1387">
                  <c:v>31.923268313490301</c:v>
                </c:pt>
                <c:pt idx="1388">
                  <c:v>31.915608061971501</c:v>
                </c:pt>
                <c:pt idx="1389">
                  <c:v>31.907947810452601</c:v>
                </c:pt>
                <c:pt idx="1390">
                  <c:v>31.900287558933801</c:v>
                </c:pt>
                <c:pt idx="1391">
                  <c:v>31.892627307415001</c:v>
                </c:pt>
                <c:pt idx="1392">
                  <c:v>31.884967055896201</c:v>
                </c:pt>
                <c:pt idx="1393">
                  <c:v>31.877306804377302</c:v>
                </c:pt>
                <c:pt idx="1394">
                  <c:v>31.869646552858502</c:v>
                </c:pt>
                <c:pt idx="1395">
                  <c:v>31.861986301339702</c:v>
                </c:pt>
                <c:pt idx="1396">
                  <c:v>31.854326049820902</c:v>
                </c:pt>
                <c:pt idx="1397">
                  <c:v>31.846665798301999</c:v>
                </c:pt>
                <c:pt idx="1398">
                  <c:v>31.839005546783198</c:v>
                </c:pt>
                <c:pt idx="1399">
                  <c:v>31.831345295264398</c:v>
                </c:pt>
                <c:pt idx="1400">
                  <c:v>31.823685043745499</c:v>
                </c:pt>
                <c:pt idx="1401">
                  <c:v>31.816024792226699</c:v>
                </c:pt>
                <c:pt idx="1402">
                  <c:v>31.808364540707899</c:v>
                </c:pt>
                <c:pt idx="1403">
                  <c:v>31.800704289189099</c:v>
                </c:pt>
                <c:pt idx="1404">
                  <c:v>31.793044037670199</c:v>
                </c:pt>
                <c:pt idx="1405">
                  <c:v>31.785383786151399</c:v>
                </c:pt>
                <c:pt idx="1406">
                  <c:v>31.777723534632599</c:v>
                </c:pt>
                <c:pt idx="1407">
                  <c:v>31.7700632831137</c:v>
                </c:pt>
                <c:pt idx="1408">
                  <c:v>31.7624030315949</c:v>
                </c:pt>
                <c:pt idx="1409">
                  <c:v>31.7547427800761</c:v>
                </c:pt>
                <c:pt idx="1410">
                  <c:v>31.7470825285573</c:v>
                </c:pt>
                <c:pt idx="1411">
                  <c:v>31.7394222770384</c:v>
                </c:pt>
                <c:pt idx="1412">
                  <c:v>31.7317620255196</c:v>
                </c:pt>
                <c:pt idx="1413">
                  <c:v>31.7241017740008</c:v>
                </c:pt>
                <c:pt idx="1414">
                  <c:v>31.716441522481901</c:v>
                </c:pt>
                <c:pt idx="1415">
                  <c:v>31.708781270963101</c:v>
                </c:pt>
                <c:pt idx="1416">
                  <c:v>31.701121019444301</c:v>
                </c:pt>
                <c:pt idx="1417">
                  <c:v>31.693460767925501</c:v>
                </c:pt>
                <c:pt idx="1418">
                  <c:v>31.685800516406601</c:v>
                </c:pt>
                <c:pt idx="1419">
                  <c:v>31.678140264887801</c:v>
                </c:pt>
                <c:pt idx="1420">
                  <c:v>31.670480013369001</c:v>
                </c:pt>
                <c:pt idx="1421">
                  <c:v>31.662819761850098</c:v>
                </c:pt>
                <c:pt idx="1422">
                  <c:v>31.655159510331298</c:v>
                </c:pt>
                <c:pt idx="1423">
                  <c:v>31.647499258812498</c:v>
                </c:pt>
                <c:pt idx="1424">
                  <c:v>29.962243924670201</c:v>
                </c:pt>
                <c:pt idx="1425">
                  <c:v>29.954583673151301</c:v>
                </c:pt>
                <c:pt idx="1426">
                  <c:v>29.946923421632501</c:v>
                </c:pt>
                <c:pt idx="1427">
                  <c:v>29.939263170113701</c:v>
                </c:pt>
                <c:pt idx="1428">
                  <c:v>29.931602918594901</c:v>
                </c:pt>
                <c:pt idx="1429">
                  <c:v>29.923942667075998</c:v>
                </c:pt>
                <c:pt idx="1430">
                  <c:v>29.916282415557198</c:v>
                </c:pt>
                <c:pt idx="1431">
                  <c:v>29.908622164038398</c:v>
                </c:pt>
                <c:pt idx="1432">
                  <c:v>29.900961912519598</c:v>
                </c:pt>
                <c:pt idx="1433">
                  <c:v>29.893301661000699</c:v>
                </c:pt>
                <c:pt idx="1434">
                  <c:v>29.885641409481899</c:v>
                </c:pt>
                <c:pt idx="1435">
                  <c:v>29.877981157963099</c:v>
                </c:pt>
                <c:pt idx="1436">
                  <c:v>29.870320906444199</c:v>
                </c:pt>
                <c:pt idx="1437">
                  <c:v>29.862660654925399</c:v>
                </c:pt>
                <c:pt idx="1438">
                  <c:v>29.855000403406599</c:v>
                </c:pt>
                <c:pt idx="1439">
                  <c:v>29.847340151887799</c:v>
                </c:pt>
                <c:pt idx="1440">
                  <c:v>29.8396799003689</c:v>
                </c:pt>
                <c:pt idx="1441">
                  <c:v>29.8320196488501</c:v>
                </c:pt>
                <c:pt idx="1442">
                  <c:v>29.8243593973313</c:v>
                </c:pt>
                <c:pt idx="1443">
                  <c:v>29.8166991458124</c:v>
                </c:pt>
                <c:pt idx="1444">
                  <c:v>29.8090388942936</c:v>
                </c:pt>
                <c:pt idx="1445">
                  <c:v>29.8013786427748</c:v>
                </c:pt>
                <c:pt idx="1446">
                  <c:v>29.793718391255901</c:v>
                </c:pt>
                <c:pt idx="1447">
                  <c:v>29.786058139737101</c:v>
                </c:pt>
                <c:pt idx="1448">
                  <c:v>29.778397888218301</c:v>
                </c:pt>
                <c:pt idx="1449">
                  <c:v>29.770737636699501</c:v>
                </c:pt>
                <c:pt idx="1450">
                  <c:v>29.763077385180601</c:v>
                </c:pt>
                <c:pt idx="1451">
                  <c:v>29.755417133661801</c:v>
                </c:pt>
                <c:pt idx="1452">
                  <c:v>29.747756882143001</c:v>
                </c:pt>
                <c:pt idx="1453">
                  <c:v>29.740096630624102</c:v>
                </c:pt>
                <c:pt idx="1454">
                  <c:v>29.732436379105302</c:v>
                </c:pt>
                <c:pt idx="1455">
                  <c:v>29.724776127586502</c:v>
                </c:pt>
                <c:pt idx="1456">
                  <c:v>29.717115876067702</c:v>
                </c:pt>
                <c:pt idx="1457">
                  <c:v>29.709455624548799</c:v>
                </c:pt>
                <c:pt idx="1458">
                  <c:v>29.701795373029999</c:v>
                </c:pt>
                <c:pt idx="1459">
                  <c:v>29.694135121511199</c:v>
                </c:pt>
                <c:pt idx="1460">
                  <c:v>29.686474869992299</c:v>
                </c:pt>
                <c:pt idx="1461">
                  <c:v>29.678814618473499</c:v>
                </c:pt>
                <c:pt idx="1462">
                  <c:v>29.671154366954699</c:v>
                </c:pt>
                <c:pt idx="1463">
                  <c:v>29.663494115435899</c:v>
                </c:pt>
                <c:pt idx="1464">
                  <c:v>29.655833863917</c:v>
                </c:pt>
                <c:pt idx="1465">
                  <c:v>29.6481736123982</c:v>
                </c:pt>
                <c:pt idx="1466">
                  <c:v>29.6405133608794</c:v>
                </c:pt>
                <c:pt idx="1467">
                  <c:v>29.6328531093605</c:v>
                </c:pt>
                <c:pt idx="1468">
                  <c:v>29.6251928578417</c:v>
                </c:pt>
                <c:pt idx="1469">
                  <c:v>29.6175326063229</c:v>
                </c:pt>
                <c:pt idx="1470">
                  <c:v>29.6098723548041</c:v>
                </c:pt>
                <c:pt idx="1471">
                  <c:v>29.602212103285201</c:v>
                </c:pt>
                <c:pt idx="1472">
                  <c:v>29.594551851766401</c:v>
                </c:pt>
                <c:pt idx="1473">
                  <c:v>29.586891600247601</c:v>
                </c:pt>
                <c:pt idx="1474">
                  <c:v>29.579231348728701</c:v>
                </c:pt>
                <c:pt idx="1475">
                  <c:v>29.119616257598999</c:v>
                </c:pt>
                <c:pt idx="1476">
                  <c:v>29.111956006080199</c:v>
                </c:pt>
                <c:pt idx="1477">
                  <c:v>29.104295754561399</c:v>
                </c:pt>
                <c:pt idx="1478">
                  <c:v>29.096635503042499</c:v>
                </c:pt>
                <c:pt idx="1479">
                  <c:v>29.088975251523699</c:v>
                </c:pt>
                <c:pt idx="1480">
                  <c:v>29.081315000004899</c:v>
                </c:pt>
                <c:pt idx="1481">
                  <c:v>29.073654748486099</c:v>
                </c:pt>
                <c:pt idx="1482">
                  <c:v>29.0659944969672</c:v>
                </c:pt>
                <c:pt idx="1483">
                  <c:v>29.0583342454484</c:v>
                </c:pt>
                <c:pt idx="1484">
                  <c:v>29.0506739939296</c:v>
                </c:pt>
                <c:pt idx="1485">
                  <c:v>29.0430137424107</c:v>
                </c:pt>
                <c:pt idx="1486">
                  <c:v>29.0353534908919</c:v>
                </c:pt>
                <c:pt idx="1487">
                  <c:v>29.0276932393731</c:v>
                </c:pt>
                <c:pt idx="1488">
                  <c:v>29.0200329878543</c:v>
                </c:pt>
                <c:pt idx="1489">
                  <c:v>29.012372736335401</c:v>
                </c:pt>
                <c:pt idx="1490">
                  <c:v>29.004712484816601</c:v>
                </c:pt>
                <c:pt idx="1491">
                  <c:v>28.997052233297801</c:v>
                </c:pt>
                <c:pt idx="1492">
                  <c:v>28.989391981778901</c:v>
                </c:pt>
                <c:pt idx="1493">
                  <c:v>28.981731730260101</c:v>
                </c:pt>
                <c:pt idx="1494">
                  <c:v>28.974071478741301</c:v>
                </c:pt>
                <c:pt idx="1495">
                  <c:v>28.966411227222501</c:v>
                </c:pt>
                <c:pt idx="1496">
                  <c:v>28.958750975703602</c:v>
                </c:pt>
                <c:pt idx="1497">
                  <c:v>28.951090724184802</c:v>
                </c:pt>
                <c:pt idx="1498">
                  <c:v>28.943430472666002</c:v>
                </c:pt>
                <c:pt idx="1499">
                  <c:v>28.935770221147099</c:v>
                </c:pt>
                <c:pt idx="1500">
                  <c:v>28.928109969628299</c:v>
                </c:pt>
                <c:pt idx="1501">
                  <c:v>28.920449718109499</c:v>
                </c:pt>
                <c:pt idx="1502">
                  <c:v>28.912789466590699</c:v>
                </c:pt>
                <c:pt idx="1503">
                  <c:v>28.905129215071799</c:v>
                </c:pt>
                <c:pt idx="1504">
                  <c:v>28.897468963552999</c:v>
                </c:pt>
                <c:pt idx="1505">
                  <c:v>28.889808712034199</c:v>
                </c:pt>
                <c:pt idx="1506">
                  <c:v>28.8821484605153</c:v>
                </c:pt>
                <c:pt idx="1507">
                  <c:v>28.8744882089965</c:v>
                </c:pt>
                <c:pt idx="1508">
                  <c:v>28.8668279574777</c:v>
                </c:pt>
                <c:pt idx="1509">
                  <c:v>28.8591677059589</c:v>
                </c:pt>
                <c:pt idx="1510">
                  <c:v>28.85150745444</c:v>
                </c:pt>
                <c:pt idx="1511">
                  <c:v>28.8438472029212</c:v>
                </c:pt>
                <c:pt idx="1512">
                  <c:v>28.8361869514024</c:v>
                </c:pt>
                <c:pt idx="1513">
                  <c:v>28.828526699883501</c:v>
                </c:pt>
                <c:pt idx="1514">
                  <c:v>28.820866448364701</c:v>
                </c:pt>
                <c:pt idx="1515">
                  <c:v>28.813206196845901</c:v>
                </c:pt>
                <c:pt idx="1516">
                  <c:v>28.353591105716198</c:v>
                </c:pt>
                <c:pt idx="1517">
                  <c:v>28.345930854197299</c:v>
                </c:pt>
                <c:pt idx="1518">
                  <c:v>28.338270602678499</c:v>
                </c:pt>
                <c:pt idx="1519">
                  <c:v>28.330610351159699</c:v>
                </c:pt>
                <c:pt idx="1520">
                  <c:v>28.322950099640899</c:v>
                </c:pt>
                <c:pt idx="1521">
                  <c:v>28.315289848121999</c:v>
                </c:pt>
                <c:pt idx="1522">
                  <c:v>28.307629596603199</c:v>
                </c:pt>
                <c:pt idx="1523">
                  <c:v>28.299969345084399</c:v>
                </c:pt>
                <c:pt idx="1524">
                  <c:v>28.2923090935655</c:v>
                </c:pt>
                <c:pt idx="1525">
                  <c:v>28.2846488420467</c:v>
                </c:pt>
                <c:pt idx="1526">
                  <c:v>28.2769885905279</c:v>
                </c:pt>
                <c:pt idx="1527">
                  <c:v>28.2693283390091</c:v>
                </c:pt>
                <c:pt idx="1528">
                  <c:v>28.2616680874902</c:v>
                </c:pt>
                <c:pt idx="1529">
                  <c:v>28.2540078359714</c:v>
                </c:pt>
                <c:pt idx="1530">
                  <c:v>28.2463475844526</c:v>
                </c:pt>
                <c:pt idx="1531">
                  <c:v>28.238687332933701</c:v>
                </c:pt>
                <c:pt idx="1532">
                  <c:v>28.231027081414901</c:v>
                </c:pt>
                <c:pt idx="1533">
                  <c:v>28.223366829896101</c:v>
                </c:pt>
                <c:pt idx="1534">
                  <c:v>28.215706578377201</c:v>
                </c:pt>
                <c:pt idx="1535">
                  <c:v>28.208046326858401</c:v>
                </c:pt>
                <c:pt idx="1536">
                  <c:v>28.200386075339601</c:v>
                </c:pt>
                <c:pt idx="1537">
                  <c:v>28.192725823820801</c:v>
                </c:pt>
                <c:pt idx="1538">
                  <c:v>28.185065572301902</c:v>
                </c:pt>
                <c:pt idx="1539">
                  <c:v>28.177405320783102</c:v>
                </c:pt>
                <c:pt idx="1540">
                  <c:v>28.169745069264302</c:v>
                </c:pt>
                <c:pt idx="1541">
                  <c:v>28.162084817745399</c:v>
                </c:pt>
                <c:pt idx="1542">
                  <c:v>28.154424566226599</c:v>
                </c:pt>
                <c:pt idx="1543">
                  <c:v>28.146764314707799</c:v>
                </c:pt>
                <c:pt idx="1544">
                  <c:v>28.139104063188999</c:v>
                </c:pt>
                <c:pt idx="1545">
                  <c:v>28.131443811670099</c:v>
                </c:pt>
                <c:pt idx="1546">
                  <c:v>28.123783560151299</c:v>
                </c:pt>
                <c:pt idx="1547">
                  <c:v>28.116123308632499</c:v>
                </c:pt>
                <c:pt idx="1548">
                  <c:v>28.1084630571136</c:v>
                </c:pt>
                <c:pt idx="1549">
                  <c:v>28.1008028055948</c:v>
                </c:pt>
                <c:pt idx="1550">
                  <c:v>28.093142554076</c:v>
                </c:pt>
                <c:pt idx="1551">
                  <c:v>28.0854823025572</c:v>
                </c:pt>
                <c:pt idx="1552">
                  <c:v>28.0778220510383</c:v>
                </c:pt>
                <c:pt idx="1553">
                  <c:v>28.0701617995195</c:v>
                </c:pt>
                <c:pt idx="1554">
                  <c:v>28.0625015480007</c:v>
                </c:pt>
                <c:pt idx="1555">
                  <c:v>28.054841296481801</c:v>
                </c:pt>
                <c:pt idx="1556">
                  <c:v>28.047181044963001</c:v>
                </c:pt>
                <c:pt idx="1557">
                  <c:v>27.6641684690216</c:v>
                </c:pt>
                <c:pt idx="1558">
                  <c:v>27.6565082175028</c:v>
                </c:pt>
                <c:pt idx="1559">
                  <c:v>27.648847965983901</c:v>
                </c:pt>
                <c:pt idx="1560">
                  <c:v>27.641187714465101</c:v>
                </c:pt>
                <c:pt idx="1561">
                  <c:v>27.633527462946301</c:v>
                </c:pt>
                <c:pt idx="1562">
                  <c:v>27.625867211427401</c:v>
                </c:pt>
                <c:pt idx="1563">
                  <c:v>27.618206959908601</c:v>
                </c:pt>
                <c:pt idx="1564">
                  <c:v>27.610546708389801</c:v>
                </c:pt>
                <c:pt idx="1565">
                  <c:v>27.602886456871001</c:v>
                </c:pt>
                <c:pt idx="1566">
                  <c:v>27.595226205352098</c:v>
                </c:pt>
                <c:pt idx="1567">
                  <c:v>27.587565953833298</c:v>
                </c:pt>
                <c:pt idx="1568">
                  <c:v>27.579905702314498</c:v>
                </c:pt>
                <c:pt idx="1569">
                  <c:v>27.572245450795599</c:v>
                </c:pt>
                <c:pt idx="1570">
                  <c:v>27.564585199276799</c:v>
                </c:pt>
                <c:pt idx="1571">
                  <c:v>27.556924947757999</c:v>
                </c:pt>
                <c:pt idx="1572">
                  <c:v>27.549264696239199</c:v>
                </c:pt>
                <c:pt idx="1573">
                  <c:v>27.541604444720299</c:v>
                </c:pt>
                <c:pt idx="1574">
                  <c:v>27.533944193201499</c:v>
                </c:pt>
                <c:pt idx="1575">
                  <c:v>27.526283941682699</c:v>
                </c:pt>
                <c:pt idx="1576">
                  <c:v>27.5186236901638</c:v>
                </c:pt>
                <c:pt idx="1577">
                  <c:v>27.510963438645</c:v>
                </c:pt>
                <c:pt idx="1578">
                  <c:v>27.5033031871262</c:v>
                </c:pt>
                <c:pt idx="1579">
                  <c:v>27.4956429356074</c:v>
                </c:pt>
                <c:pt idx="1580">
                  <c:v>27.4879826840885</c:v>
                </c:pt>
                <c:pt idx="1581">
                  <c:v>27.4803224325697</c:v>
                </c:pt>
                <c:pt idx="1582">
                  <c:v>27.4726621810509</c:v>
                </c:pt>
                <c:pt idx="1583">
                  <c:v>27.465001929532001</c:v>
                </c:pt>
                <c:pt idx="1584">
                  <c:v>27.457341678013201</c:v>
                </c:pt>
                <c:pt idx="1585">
                  <c:v>27.449681426494401</c:v>
                </c:pt>
                <c:pt idx="1586">
                  <c:v>27.442021174975601</c:v>
                </c:pt>
                <c:pt idx="1587">
                  <c:v>27.434360923456701</c:v>
                </c:pt>
                <c:pt idx="1588">
                  <c:v>27.426700671937901</c:v>
                </c:pt>
                <c:pt idx="1589">
                  <c:v>27.419040420419101</c:v>
                </c:pt>
                <c:pt idx="1590">
                  <c:v>27.411380168900202</c:v>
                </c:pt>
                <c:pt idx="1591">
                  <c:v>27.403719917381402</c:v>
                </c:pt>
                <c:pt idx="1592">
                  <c:v>27.396059665862602</c:v>
                </c:pt>
                <c:pt idx="1593">
                  <c:v>27.388399414343802</c:v>
                </c:pt>
                <c:pt idx="1594">
                  <c:v>27.380739162824899</c:v>
                </c:pt>
                <c:pt idx="1595">
                  <c:v>27.373078911306099</c:v>
                </c:pt>
                <c:pt idx="1596">
                  <c:v>27.365418659787299</c:v>
                </c:pt>
                <c:pt idx="1597">
                  <c:v>27.357758408268399</c:v>
                </c:pt>
                <c:pt idx="1598">
                  <c:v>27.350098156749599</c:v>
                </c:pt>
                <c:pt idx="1599">
                  <c:v>27.342437905230799</c:v>
                </c:pt>
                <c:pt idx="1600">
                  <c:v>27.334777653711999</c:v>
                </c:pt>
                <c:pt idx="1601">
                  <c:v>27.3271174021931</c:v>
                </c:pt>
                <c:pt idx="1602">
                  <c:v>27.3194571506743</c:v>
                </c:pt>
                <c:pt idx="1603">
                  <c:v>27.3117968991555</c:v>
                </c:pt>
                <c:pt idx="1604">
                  <c:v>27.3041366476366</c:v>
                </c:pt>
                <c:pt idx="1605">
                  <c:v>27.2964763961178</c:v>
                </c:pt>
                <c:pt idx="1606">
                  <c:v>27.288816144599</c:v>
                </c:pt>
                <c:pt idx="1607">
                  <c:v>27.2811558930802</c:v>
                </c:pt>
                <c:pt idx="1608">
                  <c:v>25.672503074126102</c:v>
                </c:pt>
                <c:pt idx="1609">
                  <c:v>25.664842822607302</c:v>
                </c:pt>
                <c:pt idx="1610">
                  <c:v>25.657182571088502</c:v>
                </c:pt>
                <c:pt idx="1611">
                  <c:v>25.649522319569702</c:v>
                </c:pt>
                <c:pt idx="1612">
                  <c:v>25.641862068050798</c:v>
                </c:pt>
                <c:pt idx="1613">
                  <c:v>25.634201816531998</c:v>
                </c:pt>
                <c:pt idx="1614">
                  <c:v>25.626541565013198</c:v>
                </c:pt>
                <c:pt idx="1615">
                  <c:v>25.618881313494299</c:v>
                </c:pt>
                <c:pt idx="1616">
                  <c:v>25.611221061975499</c:v>
                </c:pt>
                <c:pt idx="1617">
                  <c:v>25.603560810456699</c:v>
                </c:pt>
                <c:pt idx="1618">
                  <c:v>25.595900558937899</c:v>
                </c:pt>
                <c:pt idx="1619">
                  <c:v>25.588240307418999</c:v>
                </c:pt>
                <c:pt idx="1620">
                  <c:v>25.580580055900199</c:v>
                </c:pt>
                <c:pt idx="1621">
                  <c:v>25.572919804381399</c:v>
                </c:pt>
                <c:pt idx="1622">
                  <c:v>25.5652595528625</c:v>
                </c:pt>
                <c:pt idx="1623">
                  <c:v>25.5575993013437</c:v>
                </c:pt>
                <c:pt idx="1624">
                  <c:v>25.5499390498249</c:v>
                </c:pt>
                <c:pt idx="1625">
                  <c:v>25.5422787983061</c:v>
                </c:pt>
                <c:pt idx="1626">
                  <c:v>25.5346185467872</c:v>
                </c:pt>
                <c:pt idx="1627">
                  <c:v>25.5269582952684</c:v>
                </c:pt>
                <c:pt idx="1628">
                  <c:v>25.5192980437496</c:v>
                </c:pt>
                <c:pt idx="1629">
                  <c:v>25.511637792230701</c:v>
                </c:pt>
                <c:pt idx="1630">
                  <c:v>25.503977540711901</c:v>
                </c:pt>
                <c:pt idx="1631">
                  <c:v>25.496317289193101</c:v>
                </c:pt>
                <c:pt idx="1632">
                  <c:v>25.488657037674301</c:v>
                </c:pt>
                <c:pt idx="1633">
                  <c:v>25.480996786155401</c:v>
                </c:pt>
                <c:pt idx="1634">
                  <c:v>25.473336534636601</c:v>
                </c:pt>
                <c:pt idx="1635">
                  <c:v>25.465676283117801</c:v>
                </c:pt>
                <c:pt idx="1636">
                  <c:v>25.458016031598898</c:v>
                </c:pt>
                <c:pt idx="1637">
                  <c:v>25.450355780080098</c:v>
                </c:pt>
                <c:pt idx="1638">
                  <c:v>25.442695528561298</c:v>
                </c:pt>
                <c:pt idx="1639">
                  <c:v>25.435035277042498</c:v>
                </c:pt>
                <c:pt idx="1640">
                  <c:v>25.427375025523599</c:v>
                </c:pt>
                <c:pt idx="1641">
                  <c:v>25.419714774004799</c:v>
                </c:pt>
                <c:pt idx="1642">
                  <c:v>25.412054522485999</c:v>
                </c:pt>
                <c:pt idx="1643">
                  <c:v>25.404394270967099</c:v>
                </c:pt>
                <c:pt idx="1644">
                  <c:v>25.396734019448299</c:v>
                </c:pt>
                <c:pt idx="1645">
                  <c:v>25.389073767929499</c:v>
                </c:pt>
                <c:pt idx="1646">
                  <c:v>25.381413516410699</c:v>
                </c:pt>
                <c:pt idx="1647">
                  <c:v>25.3737532648918</c:v>
                </c:pt>
                <c:pt idx="1648">
                  <c:v>25.366093013373</c:v>
                </c:pt>
                <c:pt idx="1649">
                  <c:v>25.3584327618542</c:v>
                </c:pt>
                <c:pt idx="1650">
                  <c:v>25.3507725103353</c:v>
                </c:pt>
                <c:pt idx="1651">
                  <c:v>25.3431122588165</c:v>
                </c:pt>
                <c:pt idx="1652">
                  <c:v>25.3354520072977</c:v>
                </c:pt>
                <c:pt idx="1653">
                  <c:v>25.327791755778801</c:v>
                </c:pt>
                <c:pt idx="1654">
                  <c:v>25.320131504260001</c:v>
                </c:pt>
                <c:pt idx="1655">
                  <c:v>25.312471252741201</c:v>
                </c:pt>
                <c:pt idx="1656">
                  <c:v>25.304811001222401</c:v>
                </c:pt>
                <c:pt idx="1657">
                  <c:v>25.297150749703501</c:v>
                </c:pt>
                <c:pt idx="1658">
                  <c:v>25.289490498184701</c:v>
                </c:pt>
                <c:pt idx="1659">
                  <c:v>25.281830246665901</c:v>
                </c:pt>
                <c:pt idx="1660">
                  <c:v>25.274169995146998</c:v>
                </c:pt>
                <c:pt idx="1661">
                  <c:v>25.266509743628198</c:v>
                </c:pt>
                <c:pt idx="1662">
                  <c:v>25.258849492109398</c:v>
                </c:pt>
                <c:pt idx="1663">
                  <c:v>25.251189240590602</c:v>
                </c:pt>
                <c:pt idx="1664">
                  <c:v>25.243528989071699</c:v>
                </c:pt>
                <c:pt idx="1665">
                  <c:v>25.235868737552899</c:v>
                </c:pt>
                <c:pt idx="1666">
                  <c:v>25.228208486034099</c:v>
                </c:pt>
                <c:pt idx="1667">
                  <c:v>25.220548234515299</c:v>
                </c:pt>
                <c:pt idx="1668">
                  <c:v>25.212887982996399</c:v>
                </c:pt>
                <c:pt idx="1669">
                  <c:v>25.205227731477599</c:v>
                </c:pt>
                <c:pt idx="1670">
                  <c:v>25.197567479958799</c:v>
                </c:pt>
                <c:pt idx="1671">
                  <c:v>25.1899072284399</c:v>
                </c:pt>
                <c:pt idx="1672">
                  <c:v>25.1822469769211</c:v>
                </c:pt>
                <c:pt idx="1673">
                  <c:v>25.1745867254023</c:v>
                </c:pt>
                <c:pt idx="1674">
                  <c:v>25.1669264738835</c:v>
                </c:pt>
                <c:pt idx="1675">
                  <c:v>25.1592662223646</c:v>
                </c:pt>
                <c:pt idx="1676">
                  <c:v>25.1516059708458</c:v>
                </c:pt>
                <c:pt idx="1677">
                  <c:v>25.143945719327</c:v>
                </c:pt>
                <c:pt idx="1678">
                  <c:v>25.136285467808101</c:v>
                </c:pt>
                <c:pt idx="1679">
                  <c:v>25.128625216289301</c:v>
                </c:pt>
                <c:pt idx="1680">
                  <c:v>25.120964964770501</c:v>
                </c:pt>
                <c:pt idx="1681">
                  <c:v>25.113304713251701</c:v>
                </c:pt>
                <c:pt idx="1682">
                  <c:v>25.105644461732801</c:v>
                </c:pt>
                <c:pt idx="1683">
                  <c:v>25.097984210214001</c:v>
                </c:pt>
                <c:pt idx="1684">
                  <c:v>25.090323958695201</c:v>
                </c:pt>
                <c:pt idx="1685">
                  <c:v>25.082663707176302</c:v>
                </c:pt>
                <c:pt idx="1686">
                  <c:v>25.075003455657502</c:v>
                </c:pt>
                <c:pt idx="1687">
                  <c:v>25.067343204138702</c:v>
                </c:pt>
                <c:pt idx="1688">
                  <c:v>25.059682952619799</c:v>
                </c:pt>
                <c:pt idx="1689">
                  <c:v>23.068017557724399</c:v>
                </c:pt>
                <c:pt idx="1690">
                  <c:v>23.060357306205599</c:v>
                </c:pt>
                <c:pt idx="1691">
                  <c:v>23.0526970546867</c:v>
                </c:pt>
                <c:pt idx="1692">
                  <c:v>23.0450368031679</c:v>
                </c:pt>
                <c:pt idx="1693">
                  <c:v>23.0373765516491</c:v>
                </c:pt>
                <c:pt idx="1694">
                  <c:v>23.0297163001303</c:v>
                </c:pt>
                <c:pt idx="1695">
                  <c:v>23.0220560486114</c:v>
                </c:pt>
                <c:pt idx="1696">
                  <c:v>23.0143957970926</c:v>
                </c:pt>
                <c:pt idx="1697">
                  <c:v>23.0067355455738</c:v>
                </c:pt>
                <c:pt idx="1698">
                  <c:v>22.999075294054901</c:v>
                </c:pt>
                <c:pt idx="1699">
                  <c:v>22.991415042536101</c:v>
                </c:pt>
                <c:pt idx="1700">
                  <c:v>22.983754791017301</c:v>
                </c:pt>
                <c:pt idx="1701">
                  <c:v>22.976094539498501</c:v>
                </c:pt>
                <c:pt idx="1702">
                  <c:v>22.968434287979601</c:v>
                </c:pt>
                <c:pt idx="1703">
                  <c:v>22.960774036460801</c:v>
                </c:pt>
                <c:pt idx="1704">
                  <c:v>22.953113784942001</c:v>
                </c:pt>
                <c:pt idx="1705">
                  <c:v>22.945453533423098</c:v>
                </c:pt>
                <c:pt idx="1706">
                  <c:v>22.937793281904298</c:v>
                </c:pt>
                <c:pt idx="1707">
                  <c:v>22.930133030385502</c:v>
                </c:pt>
                <c:pt idx="1708">
                  <c:v>22.922472778866702</c:v>
                </c:pt>
                <c:pt idx="1709">
                  <c:v>22.914812527347799</c:v>
                </c:pt>
                <c:pt idx="1710">
                  <c:v>22.907152275828999</c:v>
                </c:pt>
                <c:pt idx="1711">
                  <c:v>22.899492024310199</c:v>
                </c:pt>
                <c:pt idx="1712">
                  <c:v>22.891831772791299</c:v>
                </c:pt>
                <c:pt idx="1713">
                  <c:v>22.884171521272499</c:v>
                </c:pt>
                <c:pt idx="1714">
                  <c:v>22.876511269753699</c:v>
                </c:pt>
                <c:pt idx="1715">
                  <c:v>22.868851018234899</c:v>
                </c:pt>
                <c:pt idx="1716">
                  <c:v>22.861190766716</c:v>
                </c:pt>
                <c:pt idx="1717">
                  <c:v>22.8535305151972</c:v>
                </c:pt>
                <c:pt idx="1718">
                  <c:v>22.8458702636784</c:v>
                </c:pt>
                <c:pt idx="1719">
                  <c:v>22.8382100121595</c:v>
                </c:pt>
                <c:pt idx="1720">
                  <c:v>22.8305497606407</c:v>
                </c:pt>
                <c:pt idx="1721">
                  <c:v>22.8228895091219</c:v>
                </c:pt>
                <c:pt idx="1722">
                  <c:v>22.8152292576031</c:v>
                </c:pt>
                <c:pt idx="1723">
                  <c:v>22.807569006084201</c:v>
                </c:pt>
                <c:pt idx="1724">
                  <c:v>22.799908754565401</c:v>
                </c:pt>
                <c:pt idx="1725">
                  <c:v>22.792248503046601</c:v>
                </c:pt>
                <c:pt idx="1726">
                  <c:v>22.784588251527701</c:v>
                </c:pt>
                <c:pt idx="1727">
                  <c:v>22.776928000008901</c:v>
                </c:pt>
                <c:pt idx="1728">
                  <c:v>22.769267748490101</c:v>
                </c:pt>
                <c:pt idx="1729">
                  <c:v>22.761607496971301</c:v>
                </c:pt>
                <c:pt idx="1730">
                  <c:v>22.753947245452402</c:v>
                </c:pt>
                <c:pt idx="1731">
                  <c:v>22.746286993933602</c:v>
                </c:pt>
                <c:pt idx="1732">
                  <c:v>22.738626742414802</c:v>
                </c:pt>
                <c:pt idx="1733">
                  <c:v>22.730966490895899</c:v>
                </c:pt>
                <c:pt idx="1734">
                  <c:v>22.723306239377099</c:v>
                </c:pt>
                <c:pt idx="1735">
                  <c:v>22.715645987858299</c:v>
                </c:pt>
                <c:pt idx="1736">
                  <c:v>22.707985736339499</c:v>
                </c:pt>
                <c:pt idx="1737">
                  <c:v>22.700325484820599</c:v>
                </c:pt>
                <c:pt idx="1738">
                  <c:v>22.692665233301799</c:v>
                </c:pt>
                <c:pt idx="1739">
                  <c:v>22.685004981782999</c:v>
                </c:pt>
                <c:pt idx="1740">
                  <c:v>22.6773447302641</c:v>
                </c:pt>
                <c:pt idx="1741">
                  <c:v>22.6696844787453</c:v>
                </c:pt>
                <c:pt idx="1742">
                  <c:v>22.6620242272265</c:v>
                </c:pt>
                <c:pt idx="1743">
                  <c:v>22.6543639757077</c:v>
                </c:pt>
                <c:pt idx="1744">
                  <c:v>22.6467037241888</c:v>
                </c:pt>
                <c:pt idx="1745">
                  <c:v>22.63904347267</c:v>
                </c:pt>
                <c:pt idx="1746">
                  <c:v>22.6313832211512</c:v>
                </c:pt>
                <c:pt idx="1747">
                  <c:v>22.623722969632301</c:v>
                </c:pt>
                <c:pt idx="1748">
                  <c:v>22.616062718113501</c:v>
                </c:pt>
                <c:pt idx="1749">
                  <c:v>22.608402466594701</c:v>
                </c:pt>
                <c:pt idx="1750">
                  <c:v>19.084686767933501</c:v>
                </c:pt>
                <c:pt idx="1751">
                  <c:v>19.077026516414701</c:v>
                </c:pt>
                <c:pt idx="1752">
                  <c:v>19.069366264895901</c:v>
                </c:pt>
                <c:pt idx="1753">
                  <c:v>19.061706013377002</c:v>
                </c:pt>
                <c:pt idx="1754">
                  <c:v>19.054045761858202</c:v>
                </c:pt>
                <c:pt idx="1755">
                  <c:v>19.046385510339402</c:v>
                </c:pt>
                <c:pt idx="1756">
                  <c:v>19.038725258820499</c:v>
                </c:pt>
                <c:pt idx="1757">
                  <c:v>19.031065007301699</c:v>
                </c:pt>
                <c:pt idx="1758">
                  <c:v>19.023404755782899</c:v>
                </c:pt>
                <c:pt idx="1759">
                  <c:v>19.015744504264099</c:v>
                </c:pt>
                <c:pt idx="1760">
                  <c:v>19.008084252745199</c:v>
                </c:pt>
                <c:pt idx="1761">
                  <c:v>19.000424001226399</c:v>
                </c:pt>
                <c:pt idx="1762">
                  <c:v>18.992763749707599</c:v>
                </c:pt>
                <c:pt idx="1763">
                  <c:v>18.9851034981887</c:v>
                </c:pt>
                <c:pt idx="1764">
                  <c:v>18.9774432466699</c:v>
                </c:pt>
                <c:pt idx="1765">
                  <c:v>18.9697829951511</c:v>
                </c:pt>
                <c:pt idx="1766">
                  <c:v>18.9621227436323</c:v>
                </c:pt>
                <c:pt idx="1767">
                  <c:v>18.9544624921134</c:v>
                </c:pt>
                <c:pt idx="1768">
                  <c:v>18.9468022405946</c:v>
                </c:pt>
                <c:pt idx="1769">
                  <c:v>18.9391419890758</c:v>
                </c:pt>
                <c:pt idx="1770">
                  <c:v>18.931481737556901</c:v>
                </c:pt>
                <c:pt idx="1771">
                  <c:v>18.923821486038101</c:v>
                </c:pt>
                <c:pt idx="1772">
                  <c:v>18.916161234519301</c:v>
                </c:pt>
                <c:pt idx="1773">
                  <c:v>18.908500983000501</c:v>
                </c:pt>
                <c:pt idx="1774">
                  <c:v>18.900840731481601</c:v>
                </c:pt>
                <c:pt idx="1775">
                  <c:v>18.893180479962801</c:v>
                </c:pt>
                <c:pt idx="1776">
                  <c:v>18.885520228444001</c:v>
                </c:pt>
                <c:pt idx="1777">
                  <c:v>18.877859976925102</c:v>
                </c:pt>
                <c:pt idx="1778">
                  <c:v>18.870199725406302</c:v>
                </c:pt>
                <c:pt idx="1779">
                  <c:v>18.862539473887502</c:v>
                </c:pt>
                <c:pt idx="1780">
                  <c:v>18.854879222368702</c:v>
                </c:pt>
                <c:pt idx="1781">
                  <c:v>18.847218970849799</c:v>
                </c:pt>
                <c:pt idx="1782">
                  <c:v>18.839558719330999</c:v>
                </c:pt>
                <c:pt idx="1783">
                  <c:v>18.831898467812199</c:v>
                </c:pt>
                <c:pt idx="1784">
                  <c:v>18.824238216293299</c:v>
                </c:pt>
                <c:pt idx="1785">
                  <c:v>18.816577964774499</c:v>
                </c:pt>
                <c:pt idx="1786">
                  <c:v>18.808917713255699</c:v>
                </c:pt>
                <c:pt idx="1787">
                  <c:v>18.801257461736899</c:v>
                </c:pt>
                <c:pt idx="1788">
                  <c:v>18.793597210218</c:v>
                </c:pt>
                <c:pt idx="1789">
                  <c:v>18.7859369586992</c:v>
                </c:pt>
                <c:pt idx="1790">
                  <c:v>18.7782767071804</c:v>
                </c:pt>
                <c:pt idx="1791">
                  <c:v>17.0164188578498</c:v>
                </c:pt>
                <c:pt idx="1792">
                  <c:v>17.008758606331</c:v>
                </c:pt>
                <c:pt idx="1793">
                  <c:v>17.0010983548121</c:v>
                </c:pt>
                <c:pt idx="1794">
                  <c:v>16.9934381032933</c:v>
                </c:pt>
                <c:pt idx="1795">
                  <c:v>16.9857778517745</c:v>
                </c:pt>
                <c:pt idx="1796">
                  <c:v>16.978117600255601</c:v>
                </c:pt>
                <c:pt idx="1797">
                  <c:v>16.970457348736801</c:v>
                </c:pt>
                <c:pt idx="1798">
                  <c:v>16.962797097218001</c:v>
                </c:pt>
                <c:pt idx="1799">
                  <c:v>16.955136845699201</c:v>
                </c:pt>
                <c:pt idx="1800">
                  <c:v>16.947476594180301</c:v>
                </c:pt>
                <c:pt idx="1801">
                  <c:v>16.939816342661501</c:v>
                </c:pt>
                <c:pt idx="1802">
                  <c:v>16.932156091142701</c:v>
                </c:pt>
                <c:pt idx="1803">
                  <c:v>16.924495839623798</c:v>
                </c:pt>
                <c:pt idx="1804">
                  <c:v>16.916835588104998</c:v>
                </c:pt>
                <c:pt idx="1805">
                  <c:v>16.909175336586198</c:v>
                </c:pt>
                <c:pt idx="1806">
                  <c:v>16.901515085067299</c:v>
                </c:pt>
                <c:pt idx="1807">
                  <c:v>16.893854833548499</c:v>
                </c:pt>
                <c:pt idx="1808">
                  <c:v>16.886194582029699</c:v>
                </c:pt>
                <c:pt idx="1809">
                  <c:v>16.878534330510899</c:v>
                </c:pt>
                <c:pt idx="1810">
                  <c:v>16.870874078991999</c:v>
                </c:pt>
                <c:pt idx="1811">
                  <c:v>16.863213827473199</c:v>
                </c:pt>
                <c:pt idx="1812">
                  <c:v>16.855553575954399</c:v>
                </c:pt>
                <c:pt idx="1813">
                  <c:v>16.8478933244355</c:v>
                </c:pt>
                <c:pt idx="1814">
                  <c:v>16.8402330729167</c:v>
                </c:pt>
                <c:pt idx="1815">
                  <c:v>16.8325728213979</c:v>
                </c:pt>
                <c:pt idx="1816">
                  <c:v>16.8249125698791</c:v>
                </c:pt>
                <c:pt idx="1817">
                  <c:v>16.8172523183602</c:v>
                </c:pt>
                <c:pt idx="1818">
                  <c:v>16.8095920668414</c:v>
                </c:pt>
                <c:pt idx="1819">
                  <c:v>16.8019318153226</c:v>
                </c:pt>
                <c:pt idx="1820">
                  <c:v>16.794271563803701</c:v>
                </c:pt>
                <c:pt idx="1821">
                  <c:v>16.786611312284901</c:v>
                </c:pt>
                <c:pt idx="1822">
                  <c:v>16.778951060766101</c:v>
                </c:pt>
                <c:pt idx="1823">
                  <c:v>16.771290809247301</c:v>
                </c:pt>
                <c:pt idx="1824">
                  <c:v>16.763630557728401</c:v>
                </c:pt>
                <c:pt idx="1825">
                  <c:v>16.755970306209601</c:v>
                </c:pt>
                <c:pt idx="1826">
                  <c:v>16.748310054690801</c:v>
                </c:pt>
                <c:pt idx="1827">
                  <c:v>16.740649803171902</c:v>
                </c:pt>
                <c:pt idx="1828">
                  <c:v>16.732989551653102</c:v>
                </c:pt>
                <c:pt idx="1829">
                  <c:v>16.725329300134302</c:v>
                </c:pt>
                <c:pt idx="1830">
                  <c:v>16.717669048615502</c:v>
                </c:pt>
                <c:pt idx="1831">
                  <c:v>16.710008797096599</c:v>
                </c:pt>
                <c:pt idx="1832">
                  <c:v>16.702348545577799</c:v>
                </c:pt>
                <c:pt idx="1833">
                  <c:v>16.694688294058999</c:v>
                </c:pt>
                <c:pt idx="1834">
                  <c:v>16.687028042540099</c:v>
                </c:pt>
                <c:pt idx="1835">
                  <c:v>16.679367791021299</c:v>
                </c:pt>
                <c:pt idx="1836">
                  <c:v>16.671707539502499</c:v>
                </c:pt>
                <c:pt idx="1837">
                  <c:v>16.664047287983699</c:v>
                </c:pt>
                <c:pt idx="1838">
                  <c:v>16.6563870364648</c:v>
                </c:pt>
                <c:pt idx="1839">
                  <c:v>16.648726784946</c:v>
                </c:pt>
                <c:pt idx="1840">
                  <c:v>16.6410665334272</c:v>
                </c:pt>
                <c:pt idx="1841">
                  <c:v>16.6334062819083</c:v>
                </c:pt>
                <c:pt idx="1842">
                  <c:v>16.6257460303895</c:v>
                </c:pt>
                <c:pt idx="1843">
                  <c:v>16.6180857788707</c:v>
                </c:pt>
                <c:pt idx="1844">
                  <c:v>16.6104255273519</c:v>
                </c:pt>
                <c:pt idx="1845">
                  <c:v>16.602765275833001</c:v>
                </c:pt>
                <c:pt idx="1846">
                  <c:v>16.595105024314201</c:v>
                </c:pt>
                <c:pt idx="1847">
                  <c:v>16.587444772795401</c:v>
                </c:pt>
                <c:pt idx="1848">
                  <c:v>16.579784521276501</c:v>
                </c:pt>
                <c:pt idx="1849">
                  <c:v>16.572124269757701</c:v>
                </c:pt>
                <c:pt idx="1850">
                  <c:v>16.564464018238901</c:v>
                </c:pt>
                <c:pt idx="1851">
                  <c:v>16.556803766720101</c:v>
                </c:pt>
                <c:pt idx="1852">
                  <c:v>16.549143515201202</c:v>
                </c:pt>
                <c:pt idx="1853">
                  <c:v>16.541483263682402</c:v>
                </c:pt>
                <c:pt idx="1854">
                  <c:v>16.533823012163602</c:v>
                </c:pt>
                <c:pt idx="1855">
                  <c:v>16.526162760644699</c:v>
                </c:pt>
                <c:pt idx="1856">
                  <c:v>16.518502509125899</c:v>
                </c:pt>
                <c:pt idx="1857">
                  <c:v>16.510842257607099</c:v>
                </c:pt>
                <c:pt idx="1858">
                  <c:v>16.503182006088299</c:v>
                </c:pt>
                <c:pt idx="1859">
                  <c:v>16.495521754569399</c:v>
                </c:pt>
                <c:pt idx="1860">
                  <c:v>16.487861503050599</c:v>
                </c:pt>
                <c:pt idx="1861">
                  <c:v>16.480201251531799</c:v>
                </c:pt>
                <c:pt idx="1862">
                  <c:v>16.4725410000129</c:v>
                </c:pt>
                <c:pt idx="1863">
                  <c:v>16.4648807484941</c:v>
                </c:pt>
                <c:pt idx="1864">
                  <c:v>16.4572204969753</c:v>
                </c:pt>
                <c:pt idx="1865">
                  <c:v>16.4495602454565</c:v>
                </c:pt>
                <c:pt idx="1866">
                  <c:v>16.4418999939376</c:v>
                </c:pt>
                <c:pt idx="1867">
                  <c:v>16.4342397424188</c:v>
                </c:pt>
                <c:pt idx="1868">
                  <c:v>16.4265794909</c:v>
                </c:pt>
                <c:pt idx="1869">
                  <c:v>16.418919239381101</c:v>
                </c:pt>
                <c:pt idx="1870">
                  <c:v>16.411258987862301</c:v>
                </c:pt>
                <c:pt idx="1871">
                  <c:v>16.403598736343501</c:v>
                </c:pt>
                <c:pt idx="1872">
                  <c:v>16.395938484824701</c:v>
                </c:pt>
                <c:pt idx="1873">
                  <c:v>16.388278233305801</c:v>
                </c:pt>
                <c:pt idx="1874">
                  <c:v>16.380617981787001</c:v>
                </c:pt>
                <c:pt idx="1875">
                  <c:v>16.372957730268201</c:v>
                </c:pt>
                <c:pt idx="1876">
                  <c:v>16.365297478749302</c:v>
                </c:pt>
                <c:pt idx="1877">
                  <c:v>16.357637227230502</c:v>
                </c:pt>
                <c:pt idx="1878">
                  <c:v>16.349976975711701</c:v>
                </c:pt>
                <c:pt idx="1879">
                  <c:v>16.342316724192901</c:v>
                </c:pt>
                <c:pt idx="1880">
                  <c:v>16.334656472673998</c:v>
                </c:pt>
                <c:pt idx="1881">
                  <c:v>16.326996221155198</c:v>
                </c:pt>
                <c:pt idx="1882">
                  <c:v>16.319335969636398</c:v>
                </c:pt>
                <c:pt idx="1883">
                  <c:v>16.311675718117499</c:v>
                </c:pt>
                <c:pt idx="1884">
                  <c:v>16.304015466598699</c:v>
                </c:pt>
                <c:pt idx="1885">
                  <c:v>16.296355215079899</c:v>
                </c:pt>
                <c:pt idx="1886">
                  <c:v>16.288694963561099</c:v>
                </c:pt>
                <c:pt idx="1887">
                  <c:v>16.281034712042199</c:v>
                </c:pt>
                <c:pt idx="1888">
                  <c:v>16.273374460523399</c:v>
                </c:pt>
                <c:pt idx="1889">
                  <c:v>16.265714209004599</c:v>
                </c:pt>
                <c:pt idx="1890">
                  <c:v>16.2580539574857</c:v>
                </c:pt>
                <c:pt idx="1891">
                  <c:v>16.2503937059669</c:v>
                </c:pt>
              </c:numCache>
            </c:numRef>
          </c:xVal>
          <c:yVal>
            <c:numRef>
              <c:f>Sheet1!$D$2:$D$1893</c:f>
              <c:numCache>
                <c:formatCode>General</c:formatCode>
                <c:ptCount val="1892"/>
                <c:pt idx="0">
                  <c:v>103988.78197681899</c:v>
                </c:pt>
                <c:pt idx="1">
                  <c:v>92489.572628633701</c:v>
                </c:pt>
                <c:pt idx="2">
                  <c:v>175771.03433360299</c:v>
                </c:pt>
                <c:pt idx="3">
                  <c:v>-32473.608782248801</c:v>
                </c:pt>
                <c:pt idx="4">
                  <c:v>-55057.534625331602</c:v>
                </c:pt>
                <c:pt idx="5">
                  <c:v>381.90348226881201</c:v>
                </c:pt>
                <c:pt idx="6">
                  <c:v>105195.40178956999</c:v>
                </c:pt>
                <c:pt idx="7">
                  <c:v>124815.672945087</c:v>
                </c:pt>
                <c:pt idx="8">
                  <c:v>238565.45452641699</c:v>
                </c:pt>
                <c:pt idx="9">
                  <c:v>254461.606202642</c:v>
                </c:pt>
                <c:pt idx="10">
                  <c:v>473390.17685080302</c:v>
                </c:pt>
                <c:pt idx="11">
                  <c:v>1074224.26332024</c:v>
                </c:pt>
                <c:pt idx="12">
                  <c:v>823107.94712449296</c:v>
                </c:pt>
                <c:pt idx="13">
                  <c:v>390483.91735262598</c:v>
                </c:pt>
                <c:pt idx="14">
                  <c:v>126599.74206729</c:v>
                </c:pt>
                <c:pt idx="15">
                  <c:v>162659.72892443099</c:v>
                </c:pt>
                <c:pt idx="16">
                  <c:v>161479.31499061099</c:v>
                </c:pt>
                <c:pt idx="17">
                  <c:v>42008.646064080902</c:v>
                </c:pt>
                <c:pt idx="18">
                  <c:v>40558.570528097996</c:v>
                </c:pt>
                <c:pt idx="19">
                  <c:v>161568.38220806699</c:v>
                </c:pt>
                <c:pt idx="20">
                  <c:v>25521.1384603841</c:v>
                </c:pt>
                <c:pt idx="21">
                  <c:v>49580.047965308397</c:v>
                </c:pt>
                <c:pt idx="22">
                  <c:v>-6191.3257021244499</c:v>
                </c:pt>
                <c:pt idx="23">
                  <c:v>-46195.024833072202</c:v>
                </c:pt>
                <c:pt idx="24">
                  <c:v>-137308.00965601401</c:v>
                </c:pt>
                <c:pt idx="25">
                  <c:v>84726.011309401496</c:v>
                </c:pt>
                <c:pt idx="26">
                  <c:v>0</c:v>
                </c:pt>
                <c:pt idx="27">
                  <c:v>0</c:v>
                </c:pt>
                <c:pt idx="28">
                  <c:v>33322.596967539299</c:v>
                </c:pt>
                <c:pt idx="29">
                  <c:v>-49740.524911694098</c:v>
                </c:pt>
                <c:pt idx="30">
                  <c:v>-100489.29325339101</c:v>
                </c:pt>
                <c:pt idx="31">
                  <c:v>23955.1311240625</c:v>
                </c:pt>
                <c:pt idx="32">
                  <c:v>82318.663328297596</c:v>
                </c:pt>
                <c:pt idx="33">
                  <c:v>255156.83859470699</c:v>
                </c:pt>
                <c:pt idx="34">
                  <c:v>403840.677746367</c:v>
                </c:pt>
                <c:pt idx="35">
                  <c:v>1102721.3516506399</c:v>
                </c:pt>
                <c:pt idx="36">
                  <c:v>1305798.16686673</c:v>
                </c:pt>
                <c:pt idx="37">
                  <c:v>765175.12578804605</c:v>
                </c:pt>
                <c:pt idx="38">
                  <c:v>357609.03180567402</c:v>
                </c:pt>
                <c:pt idx="39">
                  <c:v>151566.82554375599</c:v>
                </c:pt>
                <c:pt idx="40">
                  <c:v>149375.344615212</c:v>
                </c:pt>
                <c:pt idx="41">
                  <c:v>228178.08776563001</c:v>
                </c:pt>
                <c:pt idx="42">
                  <c:v>250515.33836405899</c:v>
                </c:pt>
                <c:pt idx="43">
                  <c:v>189822.034982326</c:v>
                </c:pt>
                <c:pt idx="44">
                  <c:v>150095.43480829001</c:v>
                </c:pt>
                <c:pt idx="45">
                  <c:v>72858.354351781702</c:v>
                </c:pt>
                <c:pt idx="46">
                  <c:v>78987.875675151197</c:v>
                </c:pt>
                <c:pt idx="47">
                  <c:v>0</c:v>
                </c:pt>
                <c:pt idx="48">
                  <c:v>0</c:v>
                </c:pt>
                <c:pt idx="49">
                  <c:v>-76764.8393885759</c:v>
                </c:pt>
                <c:pt idx="50">
                  <c:v>-14127.1156377733</c:v>
                </c:pt>
                <c:pt idx="51">
                  <c:v>-43081.999203581399</c:v>
                </c:pt>
                <c:pt idx="52">
                  <c:v>58931.188282266303</c:v>
                </c:pt>
                <c:pt idx="53">
                  <c:v>-40285.044036712301</c:v>
                </c:pt>
                <c:pt idx="54">
                  <c:v>17864.8451119743</c:v>
                </c:pt>
                <c:pt idx="55">
                  <c:v>32952.702311635599</c:v>
                </c:pt>
                <c:pt idx="56">
                  <c:v>143245.78981927101</c:v>
                </c:pt>
                <c:pt idx="57">
                  <c:v>88870.554510793299</c:v>
                </c:pt>
                <c:pt idx="58">
                  <c:v>591.42483029144898</c:v>
                </c:pt>
                <c:pt idx="59">
                  <c:v>174911.69771007399</c:v>
                </c:pt>
                <c:pt idx="60">
                  <c:v>135255.26774881501</c:v>
                </c:pt>
                <c:pt idx="61">
                  <c:v>157010.092652083</c:v>
                </c:pt>
                <c:pt idx="62">
                  <c:v>31074.546597483601</c:v>
                </c:pt>
                <c:pt idx="63">
                  <c:v>-28712.921732944102</c:v>
                </c:pt>
                <c:pt idx="64">
                  <c:v>83364.612482256896</c:v>
                </c:pt>
                <c:pt idx="65">
                  <c:v>67676.485873752506</c:v>
                </c:pt>
                <c:pt idx="66">
                  <c:v>139037.02627916401</c:v>
                </c:pt>
                <c:pt idx="67">
                  <c:v>55591.082030897102</c:v>
                </c:pt>
                <c:pt idx="68">
                  <c:v>87002.794361488195</c:v>
                </c:pt>
                <c:pt idx="69">
                  <c:v>92529.655581616506</c:v>
                </c:pt>
                <c:pt idx="70">
                  <c:v>166224.687592431</c:v>
                </c:pt>
                <c:pt idx="71">
                  <c:v>80328.931689926903</c:v>
                </c:pt>
                <c:pt idx="72">
                  <c:v>30065.8732200169</c:v>
                </c:pt>
                <c:pt idx="73">
                  <c:v>50599.780831477598</c:v>
                </c:pt>
                <c:pt idx="74">
                  <c:v>-52278.8729714699</c:v>
                </c:pt>
                <c:pt idx="75">
                  <c:v>18041.766905927099</c:v>
                </c:pt>
                <c:pt idx="76">
                  <c:v>-25661.1841178369</c:v>
                </c:pt>
                <c:pt idx="77">
                  <c:v>-813.10960423473398</c:v>
                </c:pt>
                <c:pt idx="78">
                  <c:v>70723.954658756207</c:v>
                </c:pt>
                <c:pt idx="79">
                  <c:v>105764.45130714</c:v>
                </c:pt>
                <c:pt idx="80">
                  <c:v>33538.8358179633</c:v>
                </c:pt>
                <c:pt idx="81">
                  <c:v>-3748.5405441276398</c:v>
                </c:pt>
                <c:pt idx="82">
                  <c:v>-144890.12169402701</c:v>
                </c:pt>
                <c:pt idx="83">
                  <c:v>-58434.778080252901</c:v>
                </c:pt>
                <c:pt idx="84">
                  <c:v>-7221.9440463789197</c:v>
                </c:pt>
                <c:pt idx="85">
                  <c:v>-2528.493530322</c:v>
                </c:pt>
                <c:pt idx="86">
                  <c:v>65083.866424239699</c:v>
                </c:pt>
                <c:pt idx="87">
                  <c:v>10134.0459146538</c:v>
                </c:pt>
                <c:pt idx="88">
                  <c:v>0</c:v>
                </c:pt>
                <c:pt idx="89">
                  <c:v>0</c:v>
                </c:pt>
                <c:pt idx="90">
                  <c:v>-41683.594860539401</c:v>
                </c:pt>
                <c:pt idx="91">
                  <c:v>-116083.44370495901</c:v>
                </c:pt>
                <c:pt idx="92">
                  <c:v>-84836.677818660202</c:v>
                </c:pt>
                <c:pt idx="93">
                  <c:v>-96693.652556640998</c:v>
                </c:pt>
                <c:pt idx="94">
                  <c:v>9158.3685134535008</c:v>
                </c:pt>
                <c:pt idx="95">
                  <c:v>-46650.706164436502</c:v>
                </c:pt>
                <c:pt idx="96">
                  <c:v>32661.672262433302</c:v>
                </c:pt>
                <c:pt idx="97">
                  <c:v>80181.719086988698</c:v>
                </c:pt>
                <c:pt idx="98">
                  <c:v>81224.000326388006</c:v>
                </c:pt>
                <c:pt idx="99">
                  <c:v>139618.543404311</c:v>
                </c:pt>
                <c:pt idx="100">
                  <c:v>254688.11523537801</c:v>
                </c:pt>
                <c:pt idx="101">
                  <c:v>66504.405538831095</c:v>
                </c:pt>
                <c:pt idx="102">
                  <c:v>87194.710625496504</c:v>
                </c:pt>
                <c:pt idx="103">
                  <c:v>61245.222033850798</c:v>
                </c:pt>
                <c:pt idx="104">
                  <c:v>50783.005401382499</c:v>
                </c:pt>
                <c:pt idx="105">
                  <c:v>56412.179113751597</c:v>
                </c:pt>
                <c:pt idx="106">
                  <c:v>647.94085553782497</c:v>
                </c:pt>
                <c:pt idx="107">
                  <c:v>-115182.740505316</c:v>
                </c:pt>
                <c:pt idx="108">
                  <c:v>-124246.04929251201</c:v>
                </c:pt>
                <c:pt idx="109">
                  <c:v>-77124.220586273193</c:v>
                </c:pt>
                <c:pt idx="110">
                  <c:v>-61847.960767880802</c:v>
                </c:pt>
                <c:pt idx="111">
                  <c:v>-71368.605568551895</c:v>
                </c:pt>
                <c:pt idx="112">
                  <c:v>-99456.747843565201</c:v>
                </c:pt>
                <c:pt idx="113">
                  <c:v>-184182.334363342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0</c:v>
                </c:pt>
                <c:pt idx="121">
                  <c:v>187674.33362013899</c:v>
                </c:pt>
                <c:pt idx="122">
                  <c:v>209191.156094181</c:v>
                </c:pt>
                <c:pt idx="123">
                  <c:v>128234.110081498</c:v>
                </c:pt>
                <c:pt idx="124">
                  <c:v>104241.645313644</c:v>
                </c:pt>
                <c:pt idx="125">
                  <c:v>3591.6908273292602</c:v>
                </c:pt>
                <c:pt idx="126">
                  <c:v>-22547.375683595201</c:v>
                </c:pt>
                <c:pt idx="127">
                  <c:v>-106585.22992711399</c:v>
                </c:pt>
                <c:pt idx="128">
                  <c:v>-55256.290904111796</c:v>
                </c:pt>
                <c:pt idx="129">
                  <c:v>63232.0927407118</c:v>
                </c:pt>
                <c:pt idx="130">
                  <c:v>0</c:v>
                </c:pt>
                <c:pt idx="131">
                  <c:v>0</c:v>
                </c:pt>
                <c:pt idx="132">
                  <c:v>-32420.224613945</c:v>
                </c:pt>
                <c:pt idx="133">
                  <c:v>-315.76659742287302</c:v>
                </c:pt>
                <c:pt idx="134">
                  <c:v>-102008.13639961299</c:v>
                </c:pt>
                <c:pt idx="135">
                  <c:v>-64691.532112930297</c:v>
                </c:pt>
                <c:pt idx="136">
                  <c:v>-116918.060936247</c:v>
                </c:pt>
                <c:pt idx="137">
                  <c:v>-59393.496228837401</c:v>
                </c:pt>
                <c:pt idx="138">
                  <c:v>-5192.39333321907</c:v>
                </c:pt>
                <c:pt idx="139">
                  <c:v>7633.9220608196802</c:v>
                </c:pt>
                <c:pt idx="140">
                  <c:v>26972.4708562128</c:v>
                </c:pt>
                <c:pt idx="141">
                  <c:v>47539.096857393997</c:v>
                </c:pt>
                <c:pt idx="142">
                  <c:v>28178.656794189101</c:v>
                </c:pt>
                <c:pt idx="143">
                  <c:v>-45778.131297624102</c:v>
                </c:pt>
                <c:pt idx="144">
                  <c:v>-9915.50980918204</c:v>
                </c:pt>
                <c:pt idx="145">
                  <c:v>-35437.6765409894</c:v>
                </c:pt>
                <c:pt idx="146">
                  <c:v>-2241.0229386813198</c:v>
                </c:pt>
                <c:pt idx="147">
                  <c:v>-50305.006103671898</c:v>
                </c:pt>
                <c:pt idx="148">
                  <c:v>-54148.899231218697</c:v>
                </c:pt>
                <c:pt idx="149">
                  <c:v>24855.0334162033</c:v>
                </c:pt>
                <c:pt idx="150">
                  <c:v>66901.8998949651</c:v>
                </c:pt>
                <c:pt idx="151">
                  <c:v>0</c:v>
                </c:pt>
                <c:pt idx="152">
                  <c:v>0</c:v>
                </c:pt>
                <c:pt idx="153">
                  <c:v>146346.233690052</c:v>
                </c:pt>
                <c:pt idx="154">
                  <c:v>106227.94342716</c:v>
                </c:pt>
                <c:pt idx="155">
                  <c:v>101044.650949189</c:v>
                </c:pt>
                <c:pt idx="156">
                  <c:v>57230.747003962802</c:v>
                </c:pt>
                <c:pt idx="157">
                  <c:v>11737.0810641801</c:v>
                </c:pt>
                <c:pt idx="158">
                  <c:v>75044.477492741295</c:v>
                </c:pt>
                <c:pt idx="159">
                  <c:v>48464.276072690998</c:v>
                </c:pt>
                <c:pt idx="160">
                  <c:v>-97298.270926489597</c:v>
                </c:pt>
                <c:pt idx="161">
                  <c:v>-8824.9266171829204</c:v>
                </c:pt>
                <c:pt idx="162">
                  <c:v>82748.182275115207</c:v>
                </c:pt>
                <c:pt idx="163">
                  <c:v>-29926.152569473001</c:v>
                </c:pt>
                <c:pt idx="164">
                  <c:v>61796.763096883398</c:v>
                </c:pt>
                <c:pt idx="165">
                  <c:v>75222.645047241997</c:v>
                </c:pt>
                <c:pt idx="166">
                  <c:v>37539.426442075797</c:v>
                </c:pt>
                <c:pt idx="167">
                  <c:v>-93270.468868587894</c:v>
                </c:pt>
                <c:pt idx="168">
                  <c:v>17118.921504022401</c:v>
                </c:pt>
                <c:pt idx="169">
                  <c:v>71137.039369577804</c:v>
                </c:pt>
                <c:pt idx="170">
                  <c:v>130859.32968507901</c:v>
                </c:pt>
                <c:pt idx="171">
                  <c:v>-9516.1839309459501</c:v>
                </c:pt>
                <c:pt idx="172">
                  <c:v>-31617.746212776401</c:v>
                </c:pt>
                <c:pt idx="173">
                  <c:v>23130.182459067499</c:v>
                </c:pt>
                <c:pt idx="174">
                  <c:v>81092.897948999598</c:v>
                </c:pt>
                <c:pt idx="175">
                  <c:v>10393.3270602635</c:v>
                </c:pt>
                <c:pt idx="176">
                  <c:v>52515.853554397501</c:v>
                </c:pt>
                <c:pt idx="177">
                  <c:v>68018.102322458202</c:v>
                </c:pt>
                <c:pt idx="178">
                  <c:v>149206.30806872601</c:v>
                </c:pt>
                <c:pt idx="179">
                  <c:v>59119.087065939901</c:v>
                </c:pt>
                <c:pt idx="180">
                  <c:v>-59272.612246606899</c:v>
                </c:pt>
                <c:pt idx="181">
                  <c:v>32787.084597552501</c:v>
                </c:pt>
                <c:pt idx="182">
                  <c:v>-15479.991813511</c:v>
                </c:pt>
                <c:pt idx="183">
                  <c:v>31783.926485598498</c:v>
                </c:pt>
                <c:pt idx="184">
                  <c:v>9492.9732624457993</c:v>
                </c:pt>
                <c:pt idx="185">
                  <c:v>135907.789823725</c:v>
                </c:pt>
                <c:pt idx="186">
                  <c:v>8110.4362198147601</c:v>
                </c:pt>
                <c:pt idx="187">
                  <c:v>18717.936544235301</c:v>
                </c:pt>
                <c:pt idx="188">
                  <c:v>45592.810680224502</c:v>
                </c:pt>
                <c:pt idx="189">
                  <c:v>18276.217362113999</c:v>
                </c:pt>
                <c:pt idx="190">
                  <c:v>-12526.972630866399</c:v>
                </c:pt>
                <c:pt idx="191">
                  <c:v>-2932.6043007436601</c:v>
                </c:pt>
                <c:pt idx="192">
                  <c:v>-11962.929592181799</c:v>
                </c:pt>
                <c:pt idx="193">
                  <c:v>0</c:v>
                </c:pt>
                <c:pt idx="194">
                  <c:v>0</c:v>
                </c:pt>
                <c:pt idx="195">
                  <c:v>-18095.598390008399</c:v>
                </c:pt>
                <c:pt idx="196">
                  <c:v>100069.35557762699</c:v>
                </c:pt>
                <c:pt idx="197">
                  <c:v>67187.704521867796</c:v>
                </c:pt>
                <c:pt idx="198">
                  <c:v>-64447.161103595703</c:v>
                </c:pt>
                <c:pt idx="199">
                  <c:v>-72593.3204701207</c:v>
                </c:pt>
                <c:pt idx="200">
                  <c:v>-115391.51699238201</c:v>
                </c:pt>
                <c:pt idx="201">
                  <c:v>-13695.3242391527</c:v>
                </c:pt>
                <c:pt idx="202">
                  <c:v>24006.424453292198</c:v>
                </c:pt>
                <c:pt idx="203">
                  <c:v>12125.201458875499</c:v>
                </c:pt>
                <c:pt idx="204">
                  <c:v>-28002.237794758399</c:v>
                </c:pt>
                <c:pt idx="205">
                  <c:v>-37331.616775118797</c:v>
                </c:pt>
                <c:pt idx="206">
                  <c:v>-69064.042849318503</c:v>
                </c:pt>
                <c:pt idx="207">
                  <c:v>-21226.667395118198</c:v>
                </c:pt>
                <c:pt idx="208">
                  <c:v>-100165.930377244</c:v>
                </c:pt>
                <c:pt idx="209">
                  <c:v>-62796.088781293802</c:v>
                </c:pt>
                <c:pt idx="210">
                  <c:v>54319.020192805401</c:v>
                </c:pt>
                <c:pt idx="211">
                  <c:v>75828.787220585</c:v>
                </c:pt>
                <c:pt idx="212">
                  <c:v>85194.152031821097</c:v>
                </c:pt>
                <c:pt idx="213">
                  <c:v>-11090.3697153049</c:v>
                </c:pt>
                <c:pt idx="214">
                  <c:v>-4222.5525050332699</c:v>
                </c:pt>
                <c:pt idx="215">
                  <c:v>-137393.73144577999</c:v>
                </c:pt>
                <c:pt idx="216">
                  <c:v>-27005.683046354101</c:v>
                </c:pt>
                <c:pt idx="217">
                  <c:v>-12390.5693565159</c:v>
                </c:pt>
                <c:pt idx="218">
                  <c:v>12305.087171594399</c:v>
                </c:pt>
                <c:pt idx="219">
                  <c:v>67209.133195625793</c:v>
                </c:pt>
                <c:pt idx="220">
                  <c:v>78678.793365062797</c:v>
                </c:pt>
                <c:pt idx="221">
                  <c:v>-31569.280640310499</c:v>
                </c:pt>
                <c:pt idx="222">
                  <c:v>-33330.673907543904</c:v>
                </c:pt>
                <c:pt idx="223">
                  <c:v>-22022.835518810702</c:v>
                </c:pt>
                <c:pt idx="224">
                  <c:v>136246.28302421299</c:v>
                </c:pt>
                <c:pt idx="225">
                  <c:v>34612.723059764103</c:v>
                </c:pt>
                <c:pt idx="226">
                  <c:v>-19233.083250717202</c:v>
                </c:pt>
                <c:pt idx="227">
                  <c:v>66313.057304986505</c:v>
                </c:pt>
                <c:pt idx="228">
                  <c:v>-17850.434354823901</c:v>
                </c:pt>
                <c:pt idx="229">
                  <c:v>54708.121078756201</c:v>
                </c:pt>
                <c:pt idx="230">
                  <c:v>27031.3165355112</c:v>
                </c:pt>
                <c:pt idx="231">
                  <c:v>-113369.847702486</c:v>
                </c:pt>
                <c:pt idx="232">
                  <c:v>-171148.85222007899</c:v>
                </c:pt>
                <c:pt idx="233">
                  <c:v>-167994.46283328801</c:v>
                </c:pt>
                <c:pt idx="234">
                  <c:v>-16734.486339269399</c:v>
                </c:pt>
                <c:pt idx="235">
                  <c:v>-19019.3870978296</c:v>
                </c:pt>
                <c:pt idx="236">
                  <c:v>-12975.792766426301</c:v>
                </c:pt>
                <c:pt idx="237">
                  <c:v>-95817.269630956202</c:v>
                </c:pt>
                <c:pt idx="238">
                  <c:v>8252.5685925554099</c:v>
                </c:pt>
                <c:pt idx="239">
                  <c:v>111227.920944978</c:v>
                </c:pt>
                <c:pt idx="240">
                  <c:v>92316.631321602603</c:v>
                </c:pt>
                <c:pt idx="241">
                  <c:v>33625.235146919302</c:v>
                </c:pt>
                <c:pt idx="242">
                  <c:v>-43666.0144832808</c:v>
                </c:pt>
                <c:pt idx="243">
                  <c:v>-56442.410995282698</c:v>
                </c:pt>
                <c:pt idx="244">
                  <c:v>-34639.467560199701</c:v>
                </c:pt>
                <c:pt idx="245">
                  <c:v>13828.414724145599</c:v>
                </c:pt>
                <c:pt idx="246">
                  <c:v>-17613.192632419199</c:v>
                </c:pt>
                <c:pt idx="247">
                  <c:v>62846.185710095502</c:v>
                </c:pt>
                <c:pt idx="248">
                  <c:v>-658.18456119123596</c:v>
                </c:pt>
                <c:pt idx="249">
                  <c:v>12647.8597894918</c:v>
                </c:pt>
                <c:pt idx="250">
                  <c:v>-7567.0784418171397</c:v>
                </c:pt>
                <c:pt idx="251">
                  <c:v>35833.726373996396</c:v>
                </c:pt>
                <c:pt idx="252">
                  <c:v>-78878.215623956901</c:v>
                </c:pt>
                <c:pt idx="253">
                  <c:v>-96649.241514794296</c:v>
                </c:pt>
                <c:pt idx="254">
                  <c:v>0</c:v>
                </c:pt>
                <c:pt idx="255">
                  <c:v>0</c:v>
                </c:pt>
                <c:pt idx="256">
                  <c:v>-50664.040143292099</c:v>
                </c:pt>
                <c:pt idx="257">
                  <c:v>-172254.76679200301</c:v>
                </c:pt>
                <c:pt idx="258">
                  <c:v>-19125.011393862798</c:v>
                </c:pt>
                <c:pt idx="259">
                  <c:v>146908.71633867099</c:v>
                </c:pt>
                <c:pt idx="260">
                  <c:v>43648.153872667302</c:v>
                </c:pt>
                <c:pt idx="261">
                  <c:v>-65991.230887113503</c:v>
                </c:pt>
                <c:pt idx="262">
                  <c:v>-47644.131470865403</c:v>
                </c:pt>
                <c:pt idx="263">
                  <c:v>21635.845083416199</c:v>
                </c:pt>
                <c:pt idx="264">
                  <c:v>13250.658859086599</c:v>
                </c:pt>
                <c:pt idx="265">
                  <c:v>7103.4802289008003</c:v>
                </c:pt>
                <c:pt idx="266">
                  <c:v>-35930.553245042</c:v>
                </c:pt>
                <c:pt idx="267">
                  <c:v>-45248.829062486097</c:v>
                </c:pt>
                <c:pt idx="268">
                  <c:v>-74955.788099926096</c:v>
                </c:pt>
                <c:pt idx="269">
                  <c:v>-44281.673778445802</c:v>
                </c:pt>
                <c:pt idx="270">
                  <c:v>15319.825018956601</c:v>
                </c:pt>
                <c:pt idx="271">
                  <c:v>-23040.582547101101</c:v>
                </c:pt>
                <c:pt idx="272">
                  <c:v>12745.170774489199</c:v>
                </c:pt>
                <c:pt idx="273">
                  <c:v>-77493.699229534395</c:v>
                </c:pt>
                <c:pt idx="274">
                  <c:v>-57954.342116398002</c:v>
                </c:pt>
                <c:pt idx="275">
                  <c:v>-122246.236569411</c:v>
                </c:pt>
                <c:pt idx="276">
                  <c:v>-63578.133093156699</c:v>
                </c:pt>
                <c:pt idx="277">
                  <c:v>-66755.444658858207</c:v>
                </c:pt>
                <c:pt idx="278">
                  <c:v>-46698.0076933198</c:v>
                </c:pt>
                <c:pt idx="279">
                  <c:v>-7281.8423590433204</c:v>
                </c:pt>
                <c:pt idx="280">
                  <c:v>-88321.569286334605</c:v>
                </c:pt>
                <c:pt idx="281">
                  <c:v>-40720.228232203699</c:v>
                </c:pt>
                <c:pt idx="282">
                  <c:v>29610.224047505199</c:v>
                </c:pt>
                <c:pt idx="283">
                  <c:v>-41542.694889375402</c:v>
                </c:pt>
                <c:pt idx="284">
                  <c:v>-92530.554452292694</c:v>
                </c:pt>
                <c:pt idx="285">
                  <c:v>-72418.928867154493</c:v>
                </c:pt>
                <c:pt idx="286">
                  <c:v>-96961.594774230805</c:v>
                </c:pt>
                <c:pt idx="287">
                  <c:v>43157.544565966004</c:v>
                </c:pt>
                <c:pt idx="288">
                  <c:v>19813.628157225899</c:v>
                </c:pt>
                <c:pt idx="289">
                  <c:v>-102879.108965857</c:v>
                </c:pt>
                <c:pt idx="290">
                  <c:v>0</c:v>
                </c:pt>
                <c:pt idx="291">
                  <c:v>0</c:v>
                </c:pt>
                <c:pt idx="292">
                  <c:v>-63910.989548812402</c:v>
                </c:pt>
                <c:pt idx="293">
                  <c:v>-95364.403824772206</c:v>
                </c:pt>
                <c:pt idx="294">
                  <c:v>-68841.2868779321</c:v>
                </c:pt>
                <c:pt idx="295">
                  <c:v>-3446.71794542923</c:v>
                </c:pt>
                <c:pt idx="296">
                  <c:v>11645.093541313199</c:v>
                </c:pt>
                <c:pt idx="297">
                  <c:v>-15309.263478115099</c:v>
                </c:pt>
                <c:pt idx="298">
                  <c:v>25174.8387158312</c:v>
                </c:pt>
                <c:pt idx="299">
                  <c:v>37005.043503428402</c:v>
                </c:pt>
                <c:pt idx="300">
                  <c:v>17956.577884017901</c:v>
                </c:pt>
                <c:pt idx="301">
                  <c:v>164146.52046107099</c:v>
                </c:pt>
                <c:pt idx="302">
                  <c:v>71550.060052494096</c:v>
                </c:pt>
                <c:pt idx="303">
                  <c:v>24591.878204937599</c:v>
                </c:pt>
                <c:pt idx="304">
                  <c:v>19092.0444039633</c:v>
                </c:pt>
                <c:pt idx="305">
                  <c:v>-33238.827826468798</c:v>
                </c:pt>
                <c:pt idx="306">
                  <c:v>18043.432898198898</c:v>
                </c:pt>
                <c:pt idx="307">
                  <c:v>38190.686219419898</c:v>
                </c:pt>
                <c:pt idx="308">
                  <c:v>0</c:v>
                </c:pt>
                <c:pt idx="309">
                  <c:v>0</c:v>
                </c:pt>
                <c:pt idx="310">
                  <c:v>2142.1513404012799</c:v>
                </c:pt>
                <c:pt idx="311">
                  <c:v>-112451.69182239199</c:v>
                </c:pt>
                <c:pt idx="312">
                  <c:v>-3143.8666663561198</c:v>
                </c:pt>
                <c:pt idx="313">
                  <c:v>35176.826292491103</c:v>
                </c:pt>
                <c:pt idx="314">
                  <c:v>-14025.0039754502</c:v>
                </c:pt>
                <c:pt idx="315">
                  <c:v>28060.406188208199</c:v>
                </c:pt>
                <c:pt idx="316">
                  <c:v>34.493294909552802</c:v>
                </c:pt>
                <c:pt idx="317">
                  <c:v>-21871.6389771625</c:v>
                </c:pt>
                <c:pt idx="318">
                  <c:v>200494.779093711</c:v>
                </c:pt>
                <c:pt idx="319">
                  <c:v>-25486.241409698901</c:v>
                </c:pt>
                <c:pt idx="320">
                  <c:v>130083.16619053</c:v>
                </c:pt>
                <c:pt idx="321">
                  <c:v>38257.259352383597</c:v>
                </c:pt>
                <c:pt idx="322">
                  <c:v>43836.750151552304</c:v>
                </c:pt>
                <c:pt idx="323">
                  <c:v>-76750.741736463198</c:v>
                </c:pt>
                <c:pt idx="324">
                  <c:v>-55191.142526534299</c:v>
                </c:pt>
                <c:pt idx="325">
                  <c:v>-110418.946215353</c:v>
                </c:pt>
                <c:pt idx="326">
                  <c:v>-76429.932781502299</c:v>
                </c:pt>
                <c:pt idx="327">
                  <c:v>-45409.238761970897</c:v>
                </c:pt>
                <c:pt idx="328">
                  <c:v>-49457.403939800402</c:v>
                </c:pt>
                <c:pt idx="329">
                  <c:v>-14310.723107600101</c:v>
                </c:pt>
                <c:pt idx="330">
                  <c:v>44111.832799297503</c:v>
                </c:pt>
                <c:pt idx="331">
                  <c:v>983.59527308296697</c:v>
                </c:pt>
                <c:pt idx="332">
                  <c:v>-33185.939025736203</c:v>
                </c:pt>
                <c:pt idx="333">
                  <c:v>19720.252400925499</c:v>
                </c:pt>
                <c:pt idx="334">
                  <c:v>-50638.516288806699</c:v>
                </c:pt>
                <c:pt idx="335">
                  <c:v>26759.6260226665</c:v>
                </c:pt>
                <c:pt idx="336">
                  <c:v>-57097.877408588502</c:v>
                </c:pt>
                <c:pt idx="337">
                  <c:v>-14864.0786120181</c:v>
                </c:pt>
                <c:pt idx="338">
                  <c:v>-77675.701304425296</c:v>
                </c:pt>
                <c:pt idx="339">
                  <c:v>-101245.784022597</c:v>
                </c:pt>
                <c:pt idx="340">
                  <c:v>-74305.799617692304</c:v>
                </c:pt>
                <c:pt idx="341">
                  <c:v>-90838.459181972794</c:v>
                </c:pt>
                <c:pt idx="342">
                  <c:v>-16866.357881664</c:v>
                </c:pt>
                <c:pt idx="343">
                  <c:v>-85995.993674154495</c:v>
                </c:pt>
                <c:pt idx="344">
                  <c:v>-21398.589672306902</c:v>
                </c:pt>
                <c:pt idx="345">
                  <c:v>-24069.6683311507</c:v>
                </c:pt>
                <c:pt idx="346">
                  <c:v>-42823.013681713201</c:v>
                </c:pt>
                <c:pt idx="347">
                  <c:v>50110.8349335198</c:v>
                </c:pt>
                <c:pt idx="348">
                  <c:v>-433.526609217138</c:v>
                </c:pt>
                <c:pt idx="349">
                  <c:v>0</c:v>
                </c:pt>
                <c:pt idx="350">
                  <c:v>0</c:v>
                </c:pt>
                <c:pt idx="351">
                  <c:v>6404.4232740832003</c:v>
                </c:pt>
                <c:pt idx="352">
                  <c:v>8196.60131217253</c:v>
                </c:pt>
                <c:pt idx="353">
                  <c:v>18271.976086893101</c:v>
                </c:pt>
                <c:pt idx="354">
                  <c:v>38951.1423070335</c:v>
                </c:pt>
                <c:pt idx="355">
                  <c:v>81414.052176318204</c:v>
                </c:pt>
                <c:pt idx="356">
                  <c:v>81035.393616248199</c:v>
                </c:pt>
                <c:pt idx="357">
                  <c:v>130870.73042937199</c:v>
                </c:pt>
                <c:pt idx="358">
                  <c:v>35999.251288368498</c:v>
                </c:pt>
                <c:pt idx="359">
                  <c:v>13378.6490034207</c:v>
                </c:pt>
                <c:pt idx="360">
                  <c:v>-27062.161505829401</c:v>
                </c:pt>
                <c:pt idx="361">
                  <c:v>81611.641103043803</c:v>
                </c:pt>
                <c:pt idx="362">
                  <c:v>-17017.501846761901</c:v>
                </c:pt>
                <c:pt idx="363">
                  <c:v>-70687.685284577194</c:v>
                </c:pt>
                <c:pt idx="364">
                  <c:v>-69161.953337016996</c:v>
                </c:pt>
                <c:pt idx="365">
                  <c:v>-109273.463412293</c:v>
                </c:pt>
                <c:pt idx="366">
                  <c:v>4067.3870242222301</c:v>
                </c:pt>
                <c:pt idx="367">
                  <c:v>19633.677873711498</c:v>
                </c:pt>
                <c:pt idx="368">
                  <c:v>32542.774787434901</c:v>
                </c:pt>
                <c:pt idx="369">
                  <c:v>34305.423698312603</c:v>
                </c:pt>
                <c:pt idx="370">
                  <c:v>4963.01253448636</c:v>
                </c:pt>
                <c:pt idx="371">
                  <c:v>-3518.2725259125</c:v>
                </c:pt>
                <c:pt idx="372">
                  <c:v>105635.958724282</c:v>
                </c:pt>
                <c:pt idx="373">
                  <c:v>-9970.2303116286294</c:v>
                </c:pt>
                <c:pt idx="374">
                  <c:v>61063.643154814403</c:v>
                </c:pt>
                <c:pt idx="375">
                  <c:v>136128.69822517701</c:v>
                </c:pt>
                <c:pt idx="376">
                  <c:v>54880.498393864102</c:v>
                </c:pt>
                <c:pt idx="377">
                  <c:v>34562.233763656601</c:v>
                </c:pt>
                <c:pt idx="378">
                  <c:v>-10626.0688360566</c:v>
                </c:pt>
                <c:pt idx="379">
                  <c:v>3121.0729595128901</c:v>
                </c:pt>
                <c:pt idx="380">
                  <c:v>-10166.363507542899</c:v>
                </c:pt>
                <c:pt idx="381">
                  <c:v>28167.9995441799</c:v>
                </c:pt>
                <c:pt idx="382">
                  <c:v>69286.747434117293</c:v>
                </c:pt>
                <c:pt idx="383">
                  <c:v>106219.26634129</c:v>
                </c:pt>
                <c:pt idx="384">
                  <c:v>42208.876719008098</c:v>
                </c:pt>
                <c:pt idx="385">
                  <c:v>-14718.094737961899</c:v>
                </c:pt>
                <c:pt idx="386">
                  <c:v>-100065.07467697001</c:v>
                </c:pt>
                <c:pt idx="387">
                  <c:v>-98482.055608903407</c:v>
                </c:pt>
                <c:pt idx="388">
                  <c:v>38446.3408828178</c:v>
                </c:pt>
                <c:pt idx="389">
                  <c:v>-62481.248643903498</c:v>
                </c:pt>
                <c:pt idx="390">
                  <c:v>0</c:v>
                </c:pt>
                <c:pt idx="391">
                  <c:v>0</c:v>
                </c:pt>
                <c:pt idx="392">
                  <c:v>16944.147050790001</c:v>
                </c:pt>
                <c:pt idx="393">
                  <c:v>-55131.510937252002</c:v>
                </c:pt>
                <c:pt idx="394">
                  <c:v>-50773.410532500697</c:v>
                </c:pt>
                <c:pt idx="395">
                  <c:v>11578.8218052715</c:v>
                </c:pt>
                <c:pt idx="396">
                  <c:v>-114932.63156901</c:v>
                </c:pt>
                <c:pt idx="397">
                  <c:v>-107876.500267822</c:v>
                </c:pt>
                <c:pt idx="398">
                  <c:v>-9583.1640315325894</c:v>
                </c:pt>
                <c:pt idx="399">
                  <c:v>-155.431732657868</c:v>
                </c:pt>
                <c:pt idx="400">
                  <c:v>10595.8883622389</c:v>
                </c:pt>
                <c:pt idx="401">
                  <c:v>92821.300883363801</c:v>
                </c:pt>
                <c:pt idx="402">
                  <c:v>147002.70133206699</c:v>
                </c:pt>
                <c:pt idx="403">
                  <c:v>17200.119192372698</c:v>
                </c:pt>
                <c:pt idx="404">
                  <c:v>13578.009731177001</c:v>
                </c:pt>
                <c:pt idx="405">
                  <c:v>-18460.247089789798</c:v>
                </c:pt>
                <c:pt idx="406">
                  <c:v>-45697.815154567303</c:v>
                </c:pt>
                <c:pt idx="407">
                  <c:v>-60639.039364962897</c:v>
                </c:pt>
                <c:pt idx="408">
                  <c:v>17305.9107863912</c:v>
                </c:pt>
                <c:pt idx="409">
                  <c:v>-15431.387458146301</c:v>
                </c:pt>
                <c:pt idx="410">
                  <c:v>64575.067345827702</c:v>
                </c:pt>
                <c:pt idx="411">
                  <c:v>76080.535539458695</c:v>
                </c:pt>
                <c:pt idx="412">
                  <c:v>118384.11336059999</c:v>
                </c:pt>
                <c:pt idx="413">
                  <c:v>79607.109610013402</c:v>
                </c:pt>
                <c:pt idx="414">
                  <c:v>-191313.34477472599</c:v>
                </c:pt>
                <c:pt idx="415">
                  <c:v>-200900.77738495101</c:v>
                </c:pt>
                <c:pt idx="416">
                  <c:v>-73853.360433701804</c:v>
                </c:pt>
                <c:pt idx="417">
                  <c:v>-36706.422299033104</c:v>
                </c:pt>
                <c:pt idx="418">
                  <c:v>-69545.193485217897</c:v>
                </c:pt>
                <c:pt idx="419">
                  <c:v>20952.217625977199</c:v>
                </c:pt>
                <c:pt idx="420">
                  <c:v>6546.1660911323997</c:v>
                </c:pt>
                <c:pt idx="421">
                  <c:v>-37498.756183913603</c:v>
                </c:pt>
                <c:pt idx="422">
                  <c:v>-9689.3789328723906</c:v>
                </c:pt>
                <c:pt idx="423">
                  <c:v>-53181.898843636802</c:v>
                </c:pt>
                <c:pt idx="424">
                  <c:v>36848.0256035774</c:v>
                </c:pt>
                <c:pt idx="425">
                  <c:v>23419.9822728992</c:v>
                </c:pt>
                <c:pt idx="426">
                  <c:v>105914.28418806</c:v>
                </c:pt>
                <c:pt idx="427">
                  <c:v>55061.337984601203</c:v>
                </c:pt>
                <c:pt idx="428">
                  <c:v>14340.2198507998</c:v>
                </c:pt>
                <c:pt idx="429">
                  <c:v>10825.258339521</c:v>
                </c:pt>
                <c:pt idx="430">
                  <c:v>-84064.4637402035</c:v>
                </c:pt>
                <c:pt idx="431">
                  <c:v>0</c:v>
                </c:pt>
                <c:pt idx="432">
                  <c:v>0</c:v>
                </c:pt>
                <c:pt idx="433">
                  <c:v>-34253.807758956202</c:v>
                </c:pt>
                <c:pt idx="434">
                  <c:v>83664.411311128395</c:v>
                </c:pt>
                <c:pt idx="435">
                  <c:v>-19357.781603783202</c:v>
                </c:pt>
                <c:pt idx="436">
                  <c:v>-54032.667332111101</c:v>
                </c:pt>
                <c:pt idx="437">
                  <c:v>3398.3101585382501</c:v>
                </c:pt>
                <c:pt idx="438">
                  <c:v>2563.2259779769702</c:v>
                </c:pt>
                <c:pt idx="439">
                  <c:v>-26504.421438011101</c:v>
                </c:pt>
                <c:pt idx="440">
                  <c:v>-60539.748254557097</c:v>
                </c:pt>
                <c:pt idx="441">
                  <c:v>-78825.151882501596</c:v>
                </c:pt>
                <c:pt idx="442">
                  <c:v>-82252.408437769205</c:v>
                </c:pt>
                <c:pt idx="443">
                  <c:v>-138294.949560101</c:v>
                </c:pt>
                <c:pt idx="444">
                  <c:v>-131785.070180062</c:v>
                </c:pt>
                <c:pt idx="445">
                  <c:v>-102734.674815725</c:v>
                </c:pt>
                <c:pt idx="446">
                  <c:v>65547.694513462804</c:v>
                </c:pt>
                <c:pt idx="447">
                  <c:v>146356.761092901</c:v>
                </c:pt>
                <c:pt idx="448">
                  <c:v>7430.6870855561101</c:v>
                </c:pt>
                <c:pt idx="449">
                  <c:v>87822.664890614295</c:v>
                </c:pt>
                <c:pt idx="450">
                  <c:v>82796.033858837996</c:v>
                </c:pt>
                <c:pt idx="451">
                  <c:v>-41899.974440019003</c:v>
                </c:pt>
                <c:pt idx="452">
                  <c:v>0</c:v>
                </c:pt>
                <c:pt idx="453">
                  <c:v>0</c:v>
                </c:pt>
                <c:pt idx="454">
                  <c:v>70205.556525134307</c:v>
                </c:pt>
                <c:pt idx="455">
                  <c:v>159834.14403726801</c:v>
                </c:pt>
                <c:pt idx="456">
                  <c:v>200985.88256554201</c:v>
                </c:pt>
                <c:pt idx="457">
                  <c:v>261610.886328761</c:v>
                </c:pt>
                <c:pt idx="458">
                  <c:v>254684.34006376099</c:v>
                </c:pt>
                <c:pt idx="459">
                  <c:v>264638.30168602499</c:v>
                </c:pt>
                <c:pt idx="460">
                  <c:v>320044.40898883401</c:v>
                </c:pt>
                <c:pt idx="461">
                  <c:v>315945.39751204301</c:v>
                </c:pt>
                <c:pt idx="462">
                  <c:v>256487.58063368799</c:v>
                </c:pt>
                <c:pt idx="463">
                  <c:v>246545.35960377299</c:v>
                </c:pt>
                <c:pt idx="464">
                  <c:v>231302.291816857</c:v>
                </c:pt>
                <c:pt idx="465">
                  <c:v>178055.43250313701</c:v>
                </c:pt>
                <c:pt idx="466">
                  <c:v>82964.358458030401</c:v>
                </c:pt>
                <c:pt idx="467">
                  <c:v>38288.374191137598</c:v>
                </c:pt>
                <c:pt idx="468">
                  <c:v>101535.91831112</c:v>
                </c:pt>
                <c:pt idx="469">
                  <c:v>-29786.630983773601</c:v>
                </c:pt>
                <c:pt idx="470">
                  <c:v>-45116.623376443997</c:v>
                </c:pt>
                <c:pt idx="471">
                  <c:v>26188.524380636401</c:v>
                </c:pt>
                <c:pt idx="472">
                  <c:v>83046.440195065705</c:v>
                </c:pt>
                <c:pt idx="473">
                  <c:v>0</c:v>
                </c:pt>
                <c:pt idx="474">
                  <c:v>0</c:v>
                </c:pt>
                <c:pt idx="475">
                  <c:v>-18159.593935715198</c:v>
                </c:pt>
                <c:pt idx="476">
                  <c:v>-102219.973775276</c:v>
                </c:pt>
                <c:pt idx="477">
                  <c:v>-92175.041116831504</c:v>
                </c:pt>
                <c:pt idx="478">
                  <c:v>-25773.022786021</c:v>
                </c:pt>
                <c:pt idx="479">
                  <c:v>39078.349045814801</c:v>
                </c:pt>
                <c:pt idx="480">
                  <c:v>103494.374634133</c:v>
                </c:pt>
                <c:pt idx="481">
                  <c:v>81970.959435575394</c:v>
                </c:pt>
                <c:pt idx="482">
                  <c:v>41879.910460576502</c:v>
                </c:pt>
                <c:pt idx="483">
                  <c:v>72474.402682013504</c:v>
                </c:pt>
                <c:pt idx="484">
                  <c:v>-2984.4998074232999</c:v>
                </c:pt>
                <c:pt idx="485">
                  <c:v>-2522.9137280260602</c:v>
                </c:pt>
                <c:pt idx="486">
                  <c:v>-136315.611736725</c:v>
                </c:pt>
                <c:pt idx="487">
                  <c:v>-31832.365867709399</c:v>
                </c:pt>
                <c:pt idx="488">
                  <c:v>59500.106496016</c:v>
                </c:pt>
                <c:pt idx="489">
                  <c:v>-2118.4366248454398</c:v>
                </c:pt>
                <c:pt idx="490">
                  <c:v>8175.0312125334704</c:v>
                </c:pt>
                <c:pt idx="491">
                  <c:v>-103293.44542384399</c:v>
                </c:pt>
                <c:pt idx="492">
                  <c:v>10006.4185730644</c:v>
                </c:pt>
                <c:pt idx="493">
                  <c:v>-8726.5698005895592</c:v>
                </c:pt>
                <c:pt idx="494">
                  <c:v>-54595.6757240402</c:v>
                </c:pt>
                <c:pt idx="495">
                  <c:v>18971.557688038702</c:v>
                </c:pt>
                <c:pt idx="496">
                  <c:v>75066.789762699496</c:v>
                </c:pt>
                <c:pt idx="497">
                  <c:v>26646.576910301301</c:v>
                </c:pt>
                <c:pt idx="498">
                  <c:v>44973.254726443003</c:v>
                </c:pt>
                <c:pt idx="499">
                  <c:v>51070.956060480203</c:v>
                </c:pt>
                <c:pt idx="500">
                  <c:v>17701.258431104001</c:v>
                </c:pt>
                <c:pt idx="501">
                  <c:v>2961.5131713443802</c:v>
                </c:pt>
                <c:pt idx="502">
                  <c:v>114613.44334102199</c:v>
                </c:pt>
                <c:pt idx="503">
                  <c:v>-14079.691991604401</c:v>
                </c:pt>
                <c:pt idx="504">
                  <c:v>-33978.220628500698</c:v>
                </c:pt>
                <c:pt idx="505">
                  <c:v>-30693.288195619501</c:v>
                </c:pt>
                <c:pt idx="506">
                  <c:v>-14133.5419600729</c:v>
                </c:pt>
                <c:pt idx="507">
                  <c:v>23628.8680544528</c:v>
                </c:pt>
                <c:pt idx="508">
                  <c:v>52167.076550046302</c:v>
                </c:pt>
                <c:pt idx="509">
                  <c:v>-2039.41235076156</c:v>
                </c:pt>
                <c:pt idx="510">
                  <c:v>77149.929958843903</c:v>
                </c:pt>
                <c:pt idx="511">
                  <c:v>88707.904512610898</c:v>
                </c:pt>
                <c:pt idx="512">
                  <c:v>30917.899292722701</c:v>
                </c:pt>
                <c:pt idx="513">
                  <c:v>11341.8137806752</c:v>
                </c:pt>
                <c:pt idx="514">
                  <c:v>5432.7768187581796</c:v>
                </c:pt>
                <c:pt idx="515">
                  <c:v>-16109.362232371101</c:v>
                </c:pt>
                <c:pt idx="516">
                  <c:v>34423.093176371098</c:v>
                </c:pt>
                <c:pt idx="517">
                  <c:v>38499.178537306201</c:v>
                </c:pt>
                <c:pt idx="518">
                  <c:v>44774.134939215503</c:v>
                </c:pt>
                <c:pt idx="519">
                  <c:v>-4992.1487739739396</c:v>
                </c:pt>
                <c:pt idx="520">
                  <c:v>-6503.1602870453698</c:v>
                </c:pt>
                <c:pt idx="521">
                  <c:v>-1715.37862253976</c:v>
                </c:pt>
                <c:pt idx="522">
                  <c:v>-10300.3939898353</c:v>
                </c:pt>
                <c:pt idx="523">
                  <c:v>31302.620279656399</c:v>
                </c:pt>
                <c:pt idx="524">
                  <c:v>79853.634529461298</c:v>
                </c:pt>
                <c:pt idx="525">
                  <c:v>14436.776568510801</c:v>
                </c:pt>
                <c:pt idx="526">
                  <c:v>-85498.078182054305</c:v>
                </c:pt>
                <c:pt idx="527">
                  <c:v>-93273.107125828697</c:v>
                </c:pt>
                <c:pt idx="528">
                  <c:v>-3441.3151739847499</c:v>
                </c:pt>
                <c:pt idx="529">
                  <c:v>-55625.082839337498</c:v>
                </c:pt>
                <c:pt idx="530">
                  <c:v>-34067.959623164097</c:v>
                </c:pt>
                <c:pt idx="531">
                  <c:v>0</c:v>
                </c:pt>
                <c:pt idx="532">
                  <c:v>0</c:v>
                </c:pt>
                <c:pt idx="533">
                  <c:v>-53781.791683745098</c:v>
                </c:pt>
                <c:pt idx="534">
                  <c:v>73196.164814108706</c:v>
                </c:pt>
                <c:pt idx="535">
                  <c:v>-12396.5632280233</c:v>
                </c:pt>
                <c:pt idx="536">
                  <c:v>-51816.693329484398</c:v>
                </c:pt>
                <c:pt idx="537">
                  <c:v>-26011.437716898999</c:v>
                </c:pt>
                <c:pt idx="538">
                  <c:v>-70472.244180276306</c:v>
                </c:pt>
                <c:pt idx="539">
                  <c:v>-45525.289787065303</c:v>
                </c:pt>
                <c:pt idx="540">
                  <c:v>-74209.965933587999</c:v>
                </c:pt>
                <c:pt idx="541">
                  <c:v>-78210.627095303207</c:v>
                </c:pt>
                <c:pt idx="542">
                  <c:v>-43343.2379667079</c:v>
                </c:pt>
                <c:pt idx="543">
                  <c:v>-100460.191647068</c:v>
                </c:pt>
                <c:pt idx="544">
                  <c:v>-4998.6746630881498</c:v>
                </c:pt>
                <c:pt idx="545">
                  <c:v>92826.693219128807</c:v>
                </c:pt>
                <c:pt idx="546">
                  <c:v>68610.3604451602</c:v>
                </c:pt>
                <c:pt idx="547">
                  <c:v>-35773.808493769</c:v>
                </c:pt>
                <c:pt idx="548">
                  <c:v>-78739.154738373996</c:v>
                </c:pt>
                <c:pt idx="549">
                  <c:v>-65435.076109103502</c:v>
                </c:pt>
                <c:pt idx="550">
                  <c:v>12554.1041658585</c:v>
                </c:pt>
                <c:pt idx="551">
                  <c:v>-10831.0766665876</c:v>
                </c:pt>
                <c:pt idx="552">
                  <c:v>-29983.1321414171</c:v>
                </c:pt>
                <c:pt idx="553">
                  <c:v>-100215.96885269901</c:v>
                </c:pt>
                <c:pt idx="554">
                  <c:v>6908.5169754203698</c:v>
                </c:pt>
                <c:pt idx="555">
                  <c:v>-104876.847326694</c:v>
                </c:pt>
                <c:pt idx="556">
                  <c:v>-97716.668392964595</c:v>
                </c:pt>
                <c:pt idx="557">
                  <c:v>-58759.570966167201</c:v>
                </c:pt>
                <c:pt idx="558">
                  <c:v>-42028.0396340679</c:v>
                </c:pt>
                <c:pt idx="559">
                  <c:v>-97968.818329899601</c:v>
                </c:pt>
                <c:pt idx="560">
                  <c:v>-53693.540556276603</c:v>
                </c:pt>
                <c:pt idx="561">
                  <c:v>-155561.79884270701</c:v>
                </c:pt>
                <c:pt idx="562">
                  <c:v>-140715.05145440399</c:v>
                </c:pt>
                <c:pt idx="563">
                  <c:v>-132116.520889515</c:v>
                </c:pt>
                <c:pt idx="564">
                  <c:v>12771.0555121043</c:v>
                </c:pt>
                <c:pt idx="565">
                  <c:v>123987.364130827</c:v>
                </c:pt>
                <c:pt idx="566">
                  <c:v>149726.105320267</c:v>
                </c:pt>
                <c:pt idx="567">
                  <c:v>40945.879144837701</c:v>
                </c:pt>
                <c:pt idx="568">
                  <c:v>74997.937869729896</c:v>
                </c:pt>
                <c:pt idx="569">
                  <c:v>72789.603482316699</c:v>
                </c:pt>
                <c:pt idx="570">
                  <c:v>-81131.5822978254</c:v>
                </c:pt>
                <c:pt idx="571">
                  <c:v>36532.831532402197</c:v>
                </c:pt>
                <c:pt idx="572">
                  <c:v>-8239.5880455056504</c:v>
                </c:pt>
                <c:pt idx="573">
                  <c:v>63057.564351182999</c:v>
                </c:pt>
                <c:pt idx="574">
                  <c:v>47678.124801460603</c:v>
                </c:pt>
                <c:pt idx="575">
                  <c:v>58615.453619579799</c:v>
                </c:pt>
                <c:pt idx="576">
                  <c:v>57678.718521898198</c:v>
                </c:pt>
                <c:pt idx="577">
                  <c:v>55545.298037954599</c:v>
                </c:pt>
                <c:pt idx="578">
                  <c:v>-13512.0056379446</c:v>
                </c:pt>
                <c:pt idx="579">
                  <c:v>-57689.183360919502</c:v>
                </c:pt>
                <c:pt idx="580">
                  <c:v>-26395.0392648944</c:v>
                </c:pt>
                <c:pt idx="581">
                  <c:v>-76403.372191096001</c:v>
                </c:pt>
                <c:pt idx="582">
                  <c:v>26854.736154647198</c:v>
                </c:pt>
                <c:pt idx="583">
                  <c:v>63839.490829615701</c:v>
                </c:pt>
                <c:pt idx="584">
                  <c:v>38342.129103973202</c:v>
                </c:pt>
                <c:pt idx="585">
                  <c:v>29731.0211535329</c:v>
                </c:pt>
                <c:pt idx="586">
                  <c:v>51966.985100976599</c:v>
                </c:pt>
                <c:pt idx="587">
                  <c:v>78650.626043254306</c:v>
                </c:pt>
                <c:pt idx="588">
                  <c:v>69650.942032114297</c:v>
                </c:pt>
                <c:pt idx="589">
                  <c:v>14212.528785324501</c:v>
                </c:pt>
                <c:pt idx="590">
                  <c:v>-40822.271800627197</c:v>
                </c:pt>
                <c:pt idx="591">
                  <c:v>77000.848134029395</c:v>
                </c:pt>
                <c:pt idx="592">
                  <c:v>0</c:v>
                </c:pt>
                <c:pt idx="593">
                  <c:v>0</c:v>
                </c:pt>
                <c:pt idx="594">
                  <c:v>31841.6781319367</c:v>
                </c:pt>
                <c:pt idx="595">
                  <c:v>81196.802165122499</c:v>
                </c:pt>
                <c:pt idx="596">
                  <c:v>-13233.0400945484</c:v>
                </c:pt>
                <c:pt idx="597">
                  <c:v>-91528.2126934759</c:v>
                </c:pt>
                <c:pt idx="598">
                  <c:v>-26061.5779821211</c:v>
                </c:pt>
                <c:pt idx="599">
                  <c:v>-60189.398216615104</c:v>
                </c:pt>
                <c:pt idx="600">
                  <c:v>-126207.33231847201</c:v>
                </c:pt>
                <c:pt idx="601">
                  <c:v>-133390.148764185</c:v>
                </c:pt>
                <c:pt idx="602">
                  <c:v>-41532.716287679301</c:v>
                </c:pt>
                <c:pt idx="603">
                  <c:v>4935.4016922575702</c:v>
                </c:pt>
                <c:pt idx="604">
                  <c:v>-31748.384739344299</c:v>
                </c:pt>
                <c:pt idx="605">
                  <c:v>-44675.811132875999</c:v>
                </c:pt>
                <c:pt idx="606">
                  <c:v>-70106.168091396699</c:v>
                </c:pt>
                <c:pt idx="607">
                  <c:v>-34299.389722928703</c:v>
                </c:pt>
                <c:pt idx="608">
                  <c:v>57559.311560764298</c:v>
                </c:pt>
                <c:pt idx="609">
                  <c:v>-36864.231097931799</c:v>
                </c:pt>
                <c:pt idx="610">
                  <c:v>-91625.726802612306</c:v>
                </c:pt>
                <c:pt idx="611">
                  <c:v>-131752.18560785399</c:v>
                </c:pt>
                <c:pt idx="612">
                  <c:v>-152816.71185075899</c:v>
                </c:pt>
                <c:pt idx="613">
                  <c:v>27438.881760701301</c:v>
                </c:pt>
                <c:pt idx="614">
                  <c:v>-26137.602655164599</c:v>
                </c:pt>
                <c:pt idx="615">
                  <c:v>-97584.484128078606</c:v>
                </c:pt>
                <c:pt idx="616">
                  <c:v>-43968.994507905503</c:v>
                </c:pt>
                <c:pt idx="617">
                  <c:v>-139524.170093783</c:v>
                </c:pt>
                <c:pt idx="618">
                  <c:v>-152049.58229567899</c:v>
                </c:pt>
                <c:pt idx="619">
                  <c:v>-6492.5153072430803</c:v>
                </c:pt>
                <c:pt idx="620">
                  <c:v>-9243.8631234875793</c:v>
                </c:pt>
                <c:pt idx="621">
                  <c:v>-36202.801722915501</c:v>
                </c:pt>
                <c:pt idx="622">
                  <c:v>20369.143312016098</c:v>
                </c:pt>
                <c:pt idx="623">
                  <c:v>-70561.002622783097</c:v>
                </c:pt>
                <c:pt idx="624">
                  <c:v>-99060.143310650601</c:v>
                </c:pt>
                <c:pt idx="625">
                  <c:v>-112080.81110364701</c:v>
                </c:pt>
                <c:pt idx="626">
                  <c:v>-19353.464305479702</c:v>
                </c:pt>
                <c:pt idx="627">
                  <c:v>-29661.300282231001</c:v>
                </c:pt>
                <c:pt idx="628">
                  <c:v>44239.068641766498</c:v>
                </c:pt>
                <c:pt idx="629">
                  <c:v>24258.027299515099</c:v>
                </c:pt>
                <c:pt idx="630">
                  <c:v>50159.697948211098</c:v>
                </c:pt>
                <c:pt idx="631">
                  <c:v>-8393.4817669166096</c:v>
                </c:pt>
                <c:pt idx="632">
                  <c:v>-18889.916147490901</c:v>
                </c:pt>
                <c:pt idx="633">
                  <c:v>0</c:v>
                </c:pt>
                <c:pt idx="634">
                  <c:v>0</c:v>
                </c:pt>
                <c:pt idx="635">
                  <c:v>-127330.402713951</c:v>
                </c:pt>
                <c:pt idx="636">
                  <c:v>-1535.3884014785001</c:v>
                </c:pt>
                <c:pt idx="637">
                  <c:v>35840.040213217399</c:v>
                </c:pt>
                <c:pt idx="638">
                  <c:v>49909.908366308002</c:v>
                </c:pt>
                <c:pt idx="639">
                  <c:v>26911.608127137701</c:v>
                </c:pt>
                <c:pt idx="640">
                  <c:v>-34792.052809510198</c:v>
                </c:pt>
                <c:pt idx="641">
                  <c:v>-30155.092372963401</c:v>
                </c:pt>
                <c:pt idx="642">
                  <c:v>-30321.3030844842</c:v>
                </c:pt>
                <c:pt idx="643">
                  <c:v>-47085.994580201303</c:v>
                </c:pt>
                <c:pt idx="644">
                  <c:v>93529.2454663752</c:v>
                </c:pt>
                <c:pt idx="645">
                  <c:v>14140.960985047301</c:v>
                </c:pt>
                <c:pt idx="646">
                  <c:v>50282.218894049103</c:v>
                </c:pt>
                <c:pt idx="647">
                  <c:v>107296.29953957</c:v>
                </c:pt>
                <c:pt idx="648">
                  <c:v>125254.479937353</c:v>
                </c:pt>
                <c:pt idx="649">
                  <c:v>124636.02231729</c:v>
                </c:pt>
                <c:pt idx="650">
                  <c:v>24112.968891471799</c:v>
                </c:pt>
                <c:pt idx="651">
                  <c:v>-27898.219331227301</c:v>
                </c:pt>
                <c:pt idx="652">
                  <c:v>-88748.0895328201</c:v>
                </c:pt>
                <c:pt idx="653">
                  <c:v>12573.5056679644</c:v>
                </c:pt>
                <c:pt idx="654">
                  <c:v>48494.956890707203</c:v>
                </c:pt>
                <c:pt idx="655">
                  <c:v>875.80888456273897</c:v>
                </c:pt>
                <c:pt idx="656">
                  <c:v>-37204.547544050198</c:v>
                </c:pt>
                <c:pt idx="657">
                  <c:v>67808.8398919139</c:v>
                </c:pt>
                <c:pt idx="658">
                  <c:v>53228.261796229097</c:v>
                </c:pt>
                <c:pt idx="659">
                  <c:v>59816.142478421301</c:v>
                </c:pt>
                <c:pt idx="660">
                  <c:v>36563.987366401299</c:v>
                </c:pt>
                <c:pt idx="661">
                  <c:v>-57126.375710906199</c:v>
                </c:pt>
                <c:pt idx="662">
                  <c:v>97192.786030409203</c:v>
                </c:pt>
                <c:pt idx="663">
                  <c:v>135168.318822336</c:v>
                </c:pt>
                <c:pt idx="664">
                  <c:v>50814.330157214499</c:v>
                </c:pt>
                <c:pt idx="665">
                  <c:v>-39193.8694878729</c:v>
                </c:pt>
                <c:pt idx="666">
                  <c:v>-50763.275250318999</c:v>
                </c:pt>
                <c:pt idx="667">
                  <c:v>-24371.068657653501</c:v>
                </c:pt>
                <c:pt idx="668">
                  <c:v>-136174.72155199799</c:v>
                </c:pt>
                <c:pt idx="669">
                  <c:v>-110570.292623075</c:v>
                </c:pt>
                <c:pt idx="670">
                  <c:v>-86141.941945110506</c:v>
                </c:pt>
                <c:pt idx="671">
                  <c:v>-65289.817788339104</c:v>
                </c:pt>
                <c:pt idx="672">
                  <c:v>-37142.8746312937</c:v>
                </c:pt>
                <c:pt idx="673">
                  <c:v>8427.6282535578102</c:v>
                </c:pt>
                <c:pt idx="674">
                  <c:v>58465.693780649301</c:v>
                </c:pt>
                <c:pt idx="675">
                  <c:v>-49762.421862164898</c:v>
                </c:pt>
                <c:pt idx="676">
                  <c:v>-165089.93091506601</c:v>
                </c:pt>
                <c:pt idx="677">
                  <c:v>-55743.159723259101</c:v>
                </c:pt>
                <c:pt idx="678">
                  <c:v>-109309.920968911</c:v>
                </c:pt>
                <c:pt idx="679">
                  <c:v>-90078.917551823499</c:v>
                </c:pt>
                <c:pt idx="680">
                  <c:v>-6258.0897056598897</c:v>
                </c:pt>
                <c:pt idx="681">
                  <c:v>35333.236272197399</c:v>
                </c:pt>
                <c:pt idx="682">
                  <c:v>-78858.028440591894</c:v>
                </c:pt>
                <c:pt idx="683">
                  <c:v>-3630.6042417203998</c:v>
                </c:pt>
                <c:pt idx="684">
                  <c:v>148950.28295760401</c:v>
                </c:pt>
                <c:pt idx="685">
                  <c:v>128277.81458978201</c:v>
                </c:pt>
                <c:pt idx="686">
                  <c:v>-106443.379407015</c:v>
                </c:pt>
                <c:pt idx="687">
                  <c:v>13308.0901458724</c:v>
                </c:pt>
                <c:pt idx="688">
                  <c:v>24491.365313908002</c:v>
                </c:pt>
                <c:pt idx="689">
                  <c:v>53058.9178994416</c:v>
                </c:pt>
                <c:pt idx="690">
                  <c:v>-146723.70126868499</c:v>
                </c:pt>
                <c:pt idx="691">
                  <c:v>-35757.663727843297</c:v>
                </c:pt>
                <c:pt idx="692">
                  <c:v>-2616.3233217356601</c:v>
                </c:pt>
                <c:pt idx="693">
                  <c:v>4218.8503386861403</c:v>
                </c:pt>
                <c:pt idx="694">
                  <c:v>-27285.7422337151</c:v>
                </c:pt>
                <c:pt idx="695">
                  <c:v>-96900.572870655698</c:v>
                </c:pt>
                <c:pt idx="696">
                  <c:v>27766.945080421599</c:v>
                </c:pt>
                <c:pt idx="697">
                  <c:v>-121681.525586555</c:v>
                </c:pt>
                <c:pt idx="698">
                  <c:v>-55158.099557542897</c:v>
                </c:pt>
                <c:pt idx="699">
                  <c:v>-103096.26878024099</c:v>
                </c:pt>
                <c:pt idx="700">
                  <c:v>-101384.652792368</c:v>
                </c:pt>
                <c:pt idx="701">
                  <c:v>-51498.905158827401</c:v>
                </c:pt>
                <c:pt idx="702">
                  <c:v>-86474.934778031195</c:v>
                </c:pt>
                <c:pt idx="703">
                  <c:v>-150524.806360519</c:v>
                </c:pt>
                <c:pt idx="704">
                  <c:v>-137746.10946223201</c:v>
                </c:pt>
                <c:pt idx="705">
                  <c:v>-81664.485755809103</c:v>
                </c:pt>
                <c:pt idx="706">
                  <c:v>-43349.835707933802</c:v>
                </c:pt>
                <c:pt idx="707">
                  <c:v>-78398.015370877998</c:v>
                </c:pt>
                <c:pt idx="708">
                  <c:v>-104824.620322915</c:v>
                </c:pt>
                <c:pt idx="709">
                  <c:v>-26755.591030732401</c:v>
                </c:pt>
                <c:pt idx="710">
                  <c:v>3503.1788572086998</c:v>
                </c:pt>
                <c:pt idx="711">
                  <c:v>3256.0477152509602</c:v>
                </c:pt>
                <c:pt idx="712">
                  <c:v>8638.0889815664596</c:v>
                </c:pt>
                <c:pt idx="713">
                  <c:v>-92457.526309952402</c:v>
                </c:pt>
                <c:pt idx="714">
                  <c:v>-234137.77863363901</c:v>
                </c:pt>
                <c:pt idx="715">
                  <c:v>-148217.842864796</c:v>
                </c:pt>
                <c:pt idx="716">
                  <c:v>-123065.177948378</c:v>
                </c:pt>
                <c:pt idx="717">
                  <c:v>-77451.024969018603</c:v>
                </c:pt>
                <c:pt idx="718">
                  <c:v>-93769.175616999695</c:v>
                </c:pt>
                <c:pt idx="719">
                  <c:v>3748.9363187887202</c:v>
                </c:pt>
                <c:pt idx="720">
                  <c:v>12630.180551253199</c:v>
                </c:pt>
                <c:pt idx="721">
                  <c:v>46283.568544530397</c:v>
                </c:pt>
                <c:pt idx="722">
                  <c:v>-59654.343475670001</c:v>
                </c:pt>
                <c:pt idx="723">
                  <c:v>-3228.3535665472</c:v>
                </c:pt>
                <c:pt idx="724">
                  <c:v>-49542.4987217179</c:v>
                </c:pt>
                <c:pt idx="725">
                  <c:v>-2426.5902310812698</c:v>
                </c:pt>
                <c:pt idx="726">
                  <c:v>-65103.481082701801</c:v>
                </c:pt>
                <c:pt idx="727">
                  <c:v>-110127.982724794</c:v>
                </c:pt>
                <c:pt idx="728">
                  <c:v>-55858.923438433798</c:v>
                </c:pt>
                <c:pt idx="729">
                  <c:v>-93611.7955261139</c:v>
                </c:pt>
                <c:pt idx="730">
                  <c:v>-55512.951623023597</c:v>
                </c:pt>
                <c:pt idx="731">
                  <c:v>-63591.720119860001</c:v>
                </c:pt>
                <c:pt idx="732">
                  <c:v>-94235.186114818498</c:v>
                </c:pt>
                <c:pt idx="733">
                  <c:v>-161932.54980474399</c:v>
                </c:pt>
                <c:pt idx="734">
                  <c:v>0</c:v>
                </c:pt>
                <c:pt idx="735">
                  <c:v>0</c:v>
                </c:pt>
                <c:pt idx="736">
                  <c:v>-30984.534978493</c:v>
                </c:pt>
                <c:pt idx="737">
                  <c:v>-53132.691956629998</c:v>
                </c:pt>
                <c:pt idx="738">
                  <c:v>10597.0239135637</c:v>
                </c:pt>
                <c:pt idx="739">
                  <c:v>26736.889672140001</c:v>
                </c:pt>
                <c:pt idx="740">
                  <c:v>-50110.606984677797</c:v>
                </c:pt>
                <c:pt idx="741">
                  <c:v>-3975.41675838116</c:v>
                </c:pt>
                <c:pt idx="742">
                  <c:v>89547.987690584399</c:v>
                </c:pt>
                <c:pt idx="743">
                  <c:v>73754.620514603404</c:v>
                </c:pt>
                <c:pt idx="744">
                  <c:v>22770.354517219199</c:v>
                </c:pt>
                <c:pt idx="745">
                  <c:v>63360.550904071701</c:v>
                </c:pt>
                <c:pt idx="746">
                  <c:v>44044.549560197898</c:v>
                </c:pt>
                <c:pt idx="747">
                  <c:v>70240.111992599501</c:v>
                </c:pt>
                <c:pt idx="748">
                  <c:v>164354.255309664</c:v>
                </c:pt>
                <c:pt idx="749">
                  <c:v>168820.548521524</c:v>
                </c:pt>
                <c:pt idx="750">
                  <c:v>21171.066844892401</c:v>
                </c:pt>
                <c:pt idx="751">
                  <c:v>-31694.138831881799</c:v>
                </c:pt>
                <c:pt idx="752">
                  <c:v>38953.898731927402</c:v>
                </c:pt>
                <c:pt idx="753">
                  <c:v>18870.666959970898</c:v>
                </c:pt>
                <c:pt idx="754">
                  <c:v>-18063.567646571399</c:v>
                </c:pt>
                <c:pt idx="755">
                  <c:v>-32815.048212456</c:v>
                </c:pt>
                <c:pt idx="756">
                  <c:v>-23076.256894190701</c:v>
                </c:pt>
                <c:pt idx="757">
                  <c:v>-17364.361037003</c:v>
                </c:pt>
                <c:pt idx="758">
                  <c:v>75927.374432132303</c:v>
                </c:pt>
                <c:pt idx="759">
                  <c:v>47702.396480648204</c:v>
                </c:pt>
                <c:pt idx="760">
                  <c:v>24623.354486614298</c:v>
                </c:pt>
                <c:pt idx="761">
                  <c:v>100001.22679195</c:v>
                </c:pt>
                <c:pt idx="762">
                  <c:v>237056.59684614401</c:v>
                </c:pt>
                <c:pt idx="763">
                  <c:v>167316.43843563399</c:v>
                </c:pt>
                <c:pt idx="764">
                  <c:v>131999.78254330199</c:v>
                </c:pt>
                <c:pt idx="765">
                  <c:v>-9193.4043602945003</c:v>
                </c:pt>
                <c:pt idx="766">
                  <c:v>74394.449852081496</c:v>
                </c:pt>
                <c:pt idx="767">
                  <c:v>9996.4228028242997</c:v>
                </c:pt>
                <c:pt idx="768">
                  <c:v>9868.8604196582401</c:v>
                </c:pt>
                <c:pt idx="769">
                  <c:v>-18272.233645432301</c:v>
                </c:pt>
                <c:pt idx="770">
                  <c:v>21137.491961367701</c:v>
                </c:pt>
                <c:pt idx="771">
                  <c:v>33109.264076412001</c:v>
                </c:pt>
                <c:pt idx="772">
                  <c:v>-45135.540469522901</c:v>
                </c:pt>
                <c:pt idx="773">
                  <c:v>-18675.298294415399</c:v>
                </c:pt>
                <c:pt idx="774">
                  <c:v>4320.83785833617</c:v>
                </c:pt>
                <c:pt idx="775">
                  <c:v>-29290.382906588002</c:v>
                </c:pt>
                <c:pt idx="776">
                  <c:v>-69842.346578096694</c:v>
                </c:pt>
                <c:pt idx="777">
                  <c:v>-48140.936209259999</c:v>
                </c:pt>
                <c:pt idx="778">
                  <c:v>-108153.439074997</c:v>
                </c:pt>
                <c:pt idx="779">
                  <c:v>-57567.407775694097</c:v>
                </c:pt>
                <c:pt idx="780">
                  <c:v>-20630.3601026574</c:v>
                </c:pt>
                <c:pt idx="781">
                  <c:v>-89300.771131913396</c:v>
                </c:pt>
                <c:pt idx="782">
                  <c:v>-15087.897396067399</c:v>
                </c:pt>
                <c:pt idx="783">
                  <c:v>40401.3456709046</c:v>
                </c:pt>
                <c:pt idx="784">
                  <c:v>-39766.239124760097</c:v>
                </c:pt>
                <c:pt idx="785">
                  <c:v>0</c:v>
                </c:pt>
                <c:pt idx="786">
                  <c:v>0</c:v>
                </c:pt>
                <c:pt idx="787">
                  <c:v>-71916.681510352893</c:v>
                </c:pt>
                <c:pt idx="788">
                  <c:v>4612.0633719102298</c:v>
                </c:pt>
                <c:pt idx="789">
                  <c:v>-174204.40297791801</c:v>
                </c:pt>
                <c:pt idx="790">
                  <c:v>-102513.85397150301</c:v>
                </c:pt>
                <c:pt idx="791">
                  <c:v>-28493.148660286799</c:v>
                </c:pt>
                <c:pt idx="792">
                  <c:v>-105650.940753035</c:v>
                </c:pt>
                <c:pt idx="793">
                  <c:v>-29236.527207729199</c:v>
                </c:pt>
                <c:pt idx="794">
                  <c:v>11851.0352031326</c:v>
                </c:pt>
                <c:pt idx="795">
                  <c:v>34423.500087553301</c:v>
                </c:pt>
                <c:pt idx="796">
                  <c:v>11719.0977811661</c:v>
                </c:pt>
                <c:pt idx="797">
                  <c:v>-22300.5935851422</c:v>
                </c:pt>
                <c:pt idx="798">
                  <c:v>-15143.692827724</c:v>
                </c:pt>
                <c:pt idx="799">
                  <c:v>-36358.107134190301</c:v>
                </c:pt>
                <c:pt idx="800">
                  <c:v>23490.0242263746</c:v>
                </c:pt>
                <c:pt idx="801">
                  <c:v>39418.154691439297</c:v>
                </c:pt>
                <c:pt idx="802">
                  <c:v>9556.0245269035804</c:v>
                </c:pt>
                <c:pt idx="803">
                  <c:v>-97828.244859746104</c:v>
                </c:pt>
                <c:pt idx="804">
                  <c:v>-132216.52400711901</c:v>
                </c:pt>
                <c:pt idx="805">
                  <c:v>-105037.99499700101</c:v>
                </c:pt>
                <c:pt idx="806">
                  <c:v>-92707.967194262499</c:v>
                </c:pt>
                <c:pt idx="807">
                  <c:v>86125.777681326595</c:v>
                </c:pt>
                <c:pt idx="808">
                  <c:v>16438.085411174299</c:v>
                </c:pt>
                <c:pt idx="809">
                  <c:v>30032.933830703401</c:v>
                </c:pt>
                <c:pt idx="810">
                  <c:v>9897.6948487299705</c:v>
                </c:pt>
                <c:pt idx="811">
                  <c:v>-39086.155082141398</c:v>
                </c:pt>
                <c:pt idx="812">
                  <c:v>-28258.1487824082</c:v>
                </c:pt>
                <c:pt idx="813">
                  <c:v>-14160.693962753399</c:v>
                </c:pt>
                <c:pt idx="814">
                  <c:v>-8567.9171142190698</c:v>
                </c:pt>
                <c:pt idx="815">
                  <c:v>-94399.193676901501</c:v>
                </c:pt>
                <c:pt idx="816">
                  <c:v>-53345.079784429399</c:v>
                </c:pt>
                <c:pt idx="817">
                  <c:v>-27594.797841892301</c:v>
                </c:pt>
                <c:pt idx="818">
                  <c:v>-78534.863788902003</c:v>
                </c:pt>
                <c:pt idx="819">
                  <c:v>-83948.472259018905</c:v>
                </c:pt>
                <c:pt idx="820">
                  <c:v>44035.2671177089</c:v>
                </c:pt>
                <c:pt idx="821">
                  <c:v>-39774.900861352602</c:v>
                </c:pt>
                <c:pt idx="822">
                  <c:v>-13949.2173679316</c:v>
                </c:pt>
                <c:pt idx="823">
                  <c:v>-51682.3636477338</c:v>
                </c:pt>
                <c:pt idx="824">
                  <c:v>-91411.445629653404</c:v>
                </c:pt>
                <c:pt idx="825">
                  <c:v>-102390.84297259799</c:v>
                </c:pt>
                <c:pt idx="826">
                  <c:v>0</c:v>
                </c:pt>
                <c:pt idx="827">
                  <c:v>0</c:v>
                </c:pt>
                <c:pt idx="828">
                  <c:v>62639.549059225501</c:v>
                </c:pt>
                <c:pt idx="829">
                  <c:v>1273.07241862553</c:v>
                </c:pt>
                <c:pt idx="830">
                  <c:v>14821.7929688944</c:v>
                </c:pt>
                <c:pt idx="831">
                  <c:v>109744.36343353501</c:v>
                </c:pt>
                <c:pt idx="832">
                  <c:v>-3364.9697238994299</c:v>
                </c:pt>
                <c:pt idx="833">
                  <c:v>-90915.305965840307</c:v>
                </c:pt>
                <c:pt idx="834">
                  <c:v>-42514.593702429796</c:v>
                </c:pt>
                <c:pt idx="835">
                  <c:v>-64658.938526348997</c:v>
                </c:pt>
                <c:pt idx="836">
                  <c:v>-3364.23666391283</c:v>
                </c:pt>
                <c:pt idx="837">
                  <c:v>-34610.5005119118</c:v>
                </c:pt>
                <c:pt idx="838">
                  <c:v>-99303.384871030299</c:v>
                </c:pt>
                <c:pt idx="839">
                  <c:v>-173083.693826164</c:v>
                </c:pt>
                <c:pt idx="840">
                  <c:v>-135560.674455236</c:v>
                </c:pt>
                <c:pt idx="841">
                  <c:v>-74668.161836564701</c:v>
                </c:pt>
                <c:pt idx="842">
                  <c:v>39030.482328953403</c:v>
                </c:pt>
                <c:pt idx="843">
                  <c:v>56756.013835534002</c:v>
                </c:pt>
                <c:pt idx="844">
                  <c:v>32142.939973071301</c:v>
                </c:pt>
                <c:pt idx="845">
                  <c:v>10857.6356193668</c:v>
                </c:pt>
                <c:pt idx="846">
                  <c:v>49586.791256768403</c:v>
                </c:pt>
                <c:pt idx="847">
                  <c:v>135863.72646920101</c:v>
                </c:pt>
                <c:pt idx="848">
                  <c:v>60006.080526985701</c:v>
                </c:pt>
                <c:pt idx="849">
                  <c:v>33030.798598398796</c:v>
                </c:pt>
                <c:pt idx="850">
                  <c:v>122392.41509366401</c:v>
                </c:pt>
                <c:pt idx="851">
                  <c:v>93122.650295423999</c:v>
                </c:pt>
                <c:pt idx="852">
                  <c:v>89870.261651756795</c:v>
                </c:pt>
                <c:pt idx="853">
                  <c:v>42236.879855047497</c:v>
                </c:pt>
                <c:pt idx="854">
                  <c:v>8129.2096114729102</c:v>
                </c:pt>
                <c:pt idx="855">
                  <c:v>66029.960270933007</c:v>
                </c:pt>
                <c:pt idx="856">
                  <c:v>-7894.6335502591501</c:v>
                </c:pt>
                <c:pt idx="857">
                  <c:v>-57753.741445343199</c:v>
                </c:pt>
                <c:pt idx="858">
                  <c:v>-39497.747259666801</c:v>
                </c:pt>
                <c:pt idx="859">
                  <c:v>100984.364777172</c:v>
                </c:pt>
                <c:pt idx="860">
                  <c:v>-8669.6210168408707</c:v>
                </c:pt>
                <c:pt idx="861">
                  <c:v>26042.829531355201</c:v>
                </c:pt>
                <c:pt idx="862">
                  <c:v>-83532.477049438006</c:v>
                </c:pt>
                <c:pt idx="863">
                  <c:v>1255.4057241379601</c:v>
                </c:pt>
                <c:pt idx="864">
                  <c:v>-49460.108360507002</c:v>
                </c:pt>
                <c:pt idx="865">
                  <c:v>14994.3906028944</c:v>
                </c:pt>
                <c:pt idx="866">
                  <c:v>4569.2754792485803</c:v>
                </c:pt>
                <c:pt idx="867">
                  <c:v>64592.834132998003</c:v>
                </c:pt>
                <c:pt idx="868">
                  <c:v>-128409.456671899</c:v>
                </c:pt>
                <c:pt idx="869">
                  <c:v>-35759.4126772401</c:v>
                </c:pt>
                <c:pt idx="870">
                  <c:v>-29217.9143991331</c:v>
                </c:pt>
                <c:pt idx="871">
                  <c:v>-126574.029550897</c:v>
                </c:pt>
                <c:pt idx="872">
                  <c:v>-149521.77186769099</c:v>
                </c:pt>
                <c:pt idx="873">
                  <c:v>-110003.53829010901</c:v>
                </c:pt>
                <c:pt idx="874">
                  <c:v>-94172.540429083005</c:v>
                </c:pt>
                <c:pt idx="875">
                  <c:v>92759.964743412798</c:v>
                </c:pt>
                <c:pt idx="876">
                  <c:v>-43925.027123051499</c:v>
                </c:pt>
                <c:pt idx="877">
                  <c:v>0</c:v>
                </c:pt>
                <c:pt idx="878">
                  <c:v>0</c:v>
                </c:pt>
                <c:pt idx="879">
                  <c:v>95217.332615347506</c:v>
                </c:pt>
                <c:pt idx="880">
                  <c:v>13789.379915052999</c:v>
                </c:pt>
                <c:pt idx="881">
                  <c:v>-115809.114053575</c:v>
                </c:pt>
                <c:pt idx="882">
                  <c:v>-141534.271878022</c:v>
                </c:pt>
                <c:pt idx="883">
                  <c:v>6804.7457767793403</c:v>
                </c:pt>
                <c:pt idx="884">
                  <c:v>49732.811071212796</c:v>
                </c:pt>
                <c:pt idx="885">
                  <c:v>-18593.445348855199</c:v>
                </c:pt>
                <c:pt idx="886">
                  <c:v>-62745.040159272801</c:v>
                </c:pt>
                <c:pt idx="887">
                  <c:v>-110631.02631338401</c:v>
                </c:pt>
                <c:pt idx="888">
                  <c:v>-87314.143827753302</c:v>
                </c:pt>
                <c:pt idx="889">
                  <c:v>-64855.9885168537</c:v>
                </c:pt>
                <c:pt idx="890">
                  <c:v>-12016.307008627</c:v>
                </c:pt>
                <c:pt idx="891">
                  <c:v>3524.5498126279299</c:v>
                </c:pt>
                <c:pt idx="892">
                  <c:v>-98681.1060689601</c:v>
                </c:pt>
                <c:pt idx="893">
                  <c:v>49599.613234429598</c:v>
                </c:pt>
                <c:pt idx="894">
                  <c:v>60882.693442273398</c:v>
                </c:pt>
                <c:pt idx="895">
                  <c:v>31678.830427962501</c:v>
                </c:pt>
                <c:pt idx="896">
                  <c:v>77751.113519936305</c:v>
                </c:pt>
                <c:pt idx="897">
                  <c:v>3381.5594454123002</c:v>
                </c:pt>
                <c:pt idx="898">
                  <c:v>-66984.867527656694</c:v>
                </c:pt>
                <c:pt idx="899">
                  <c:v>-7612.4419446142801</c:v>
                </c:pt>
                <c:pt idx="900">
                  <c:v>-21774.054060322302</c:v>
                </c:pt>
                <c:pt idx="901">
                  <c:v>4075.8156404680199</c:v>
                </c:pt>
                <c:pt idx="902">
                  <c:v>106496.79567969299</c:v>
                </c:pt>
                <c:pt idx="903">
                  <c:v>161962.254785811</c:v>
                </c:pt>
                <c:pt idx="904">
                  <c:v>49510.640133471097</c:v>
                </c:pt>
                <c:pt idx="905">
                  <c:v>22805.5887267219</c:v>
                </c:pt>
                <c:pt idx="906">
                  <c:v>31781.503441936598</c:v>
                </c:pt>
                <c:pt idx="907">
                  <c:v>-3376.3926002282201</c:v>
                </c:pt>
                <c:pt idx="908">
                  <c:v>-63816.462974236303</c:v>
                </c:pt>
                <c:pt idx="909">
                  <c:v>-7366.5676568478502</c:v>
                </c:pt>
                <c:pt idx="910">
                  <c:v>99338.396467912302</c:v>
                </c:pt>
                <c:pt idx="911">
                  <c:v>146860.06460262599</c:v>
                </c:pt>
                <c:pt idx="912">
                  <c:v>166458.715242812</c:v>
                </c:pt>
                <c:pt idx="913">
                  <c:v>19436.8992175481</c:v>
                </c:pt>
                <c:pt idx="914">
                  <c:v>25854.106416767499</c:v>
                </c:pt>
                <c:pt idx="915">
                  <c:v>-24534.674641459598</c:v>
                </c:pt>
                <c:pt idx="916">
                  <c:v>-89760.510188348693</c:v>
                </c:pt>
                <c:pt idx="917">
                  <c:v>-15014.4272719359</c:v>
                </c:pt>
                <c:pt idx="918">
                  <c:v>-21092.641510368499</c:v>
                </c:pt>
                <c:pt idx="919">
                  <c:v>58887.860340871703</c:v>
                </c:pt>
                <c:pt idx="920">
                  <c:v>9479.6137362523605</c:v>
                </c:pt>
                <c:pt idx="921">
                  <c:v>-3434.0907869176599</c:v>
                </c:pt>
                <c:pt idx="922">
                  <c:v>52010.763848990697</c:v>
                </c:pt>
                <c:pt idx="923">
                  <c:v>-21540.261552737498</c:v>
                </c:pt>
                <c:pt idx="924">
                  <c:v>-12741.277236271</c:v>
                </c:pt>
                <c:pt idx="925">
                  <c:v>-131408.21156398999</c:v>
                </c:pt>
                <c:pt idx="926">
                  <c:v>-143557.86725894999</c:v>
                </c:pt>
                <c:pt idx="927">
                  <c:v>-94356.836173511605</c:v>
                </c:pt>
                <c:pt idx="928">
                  <c:v>-34111.097984891101</c:v>
                </c:pt>
                <c:pt idx="929">
                  <c:v>-36015.372754349199</c:v>
                </c:pt>
                <c:pt idx="930">
                  <c:v>-20523.475945083199</c:v>
                </c:pt>
                <c:pt idx="931">
                  <c:v>43695.753092755498</c:v>
                </c:pt>
                <c:pt idx="932">
                  <c:v>45702.378443927402</c:v>
                </c:pt>
                <c:pt idx="933">
                  <c:v>20291.738088966002</c:v>
                </c:pt>
                <c:pt idx="934">
                  <c:v>104855.779618884</c:v>
                </c:pt>
                <c:pt idx="935">
                  <c:v>-5697.5023648523102</c:v>
                </c:pt>
                <c:pt idx="936">
                  <c:v>26350.024968469501</c:v>
                </c:pt>
                <c:pt idx="937">
                  <c:v>-71164.249352997693</c:v>
                </c:pt>
                <c:pt idx="938">
                  <c:v>0</c:v>
                </c:pt>
                <c:pt idx="939">
                  <c:v>0</c:v>
                </c:pt>
                <c:pt idx="940">
                  <c:v>60971.1612654575</c:v>
                </c:pt>
                <c:pt idx="941">
                  <c:v>7274.8110359955599</c:v>
                </c:pt>
                <c:pt idx="942">
                  <c:v>17056.2918057516</c:v>
                </c:pt>
                <c:pt idx="943">
                  <c:v>66997.475809218799</c:v>
                </c:pt>
                <c:pt idx="944">
                  <c:v>22940.519979285498</c:v>
                </c:pt>
                <c:pt idx="945">
                  <c:v>42464.889446920199</c:v>
                </c:pt>
                <c:pt idx="946">
                  <c:v>44384.209603780502</c:v>
                </c:pt>
                <c:pt idx="947">
                  <c:v>-104171.301424566</c:v>
                </c:pt>
                <c:pt idx="948">
                  <c:v>34419.029669992902</c:v>
                </c:pt>
                <c:pt idx="949">
                  <c:v>61220.307484393903</c:v>
                </c:pt>
                <c:pt idx="950">
                  <c:v>56193.975322011604</c:v>
                </c:pt>
                <c:pt idx="951">
                  <c:v>89480.357234095994</c:v>
                </c:pt>
                <c:pt idx="952">
                  <c:v>78362.406135153797</c:v>
                </c:pt>
                <c:pt idx="953">
                  <c:v>116501.92829796</c:v>
                </c:pt>
                <c:pt idx="954">
                  <c:v>88325.679470778297</c:v>
                </c:pt>
                <c:pt idx="955">
                  <c:v>-74083.480676271996</c:v>
                </c:pt>
                <c:pt idx="956">
                  <c:v>59996.5663480476</c:v>
                </c:pt>
                <c:pt idx="957">
                  <c:v>131621.400784028</c:v>
                </c:pt>
                <c:pt idx="958">
                  <c:v>99179.038767839593</c:v>
                </c:pt>
                <c:pt idx="959">
                  <c:v>-31195.689998914098</c:v>
                </c:pt>
                <c:pt idx="960">
                  <c:v>-41340.421486173298</c:v>
                </c:pt>
                <c:pt idx="961">
                  <c:v>-49572.724132397401</c:v>
                </c:pt>
                <c:pt idx="962">
                  <c:v>51959.8453238152</c:v>
                </c:pt>
                <c:pt idx="963">
                  <c:v>36153.777820411102</c:v>
                </c:pt>
                <c:pt idx="964">
                  <c:v>55014.8473401827</c:v>
                </c:pt>
                <c:pt idx="965">
                  <c:v>-83481.034205756398</c:v>
                </c:pt>
                <c:pt idx="966">
                  <c:v>-55090.942003393597</c:v>
                </c:pt>
                <c:pt idx="967">
                  <c:v>-42668.421988399401</c:v>
                </c:pt>
                <c:pt idx="968">
                  <c:v>-57516.369460328002</c:v>
                </c:pt>
                <c:pt idx="969">
                  <c:v>-121717.248450785</c:v>
                </c:pt>
                <c:pt idx="970">
                  <c:v>79975.1765129509</c:v>
                </c:pt>
                <c:pt idx="971">
                  <c:v>109376.30828032699</c:v>
                </c:pt>
                <c:pt idx="972">
                  <c:v>-17156.4817817984</c:v>
                </c:pt>
                <c:pt idx="973">
                  <c:v>-27384.1730804295</c:v>
                </c:pt>
                <c:pt idx="974">
                  <c:v>-1170.08245943825</c:v>
                </c:pt>
                <c:pt idx="975">
                  <c:v>82880.949124010804</c:v>
                </c:pt>
                <c:pt idx="976">
                  <c:v>71380.373953786795</c:v>
                </c:pt>
                <c:pt idx="977">
                  <c:v>-71294.916641049698</c:v>
                </c:pt>
                <c:pt idx="978">
                  <c:v>111701.251703456</c:v>
                </c:pt>
                <c:pt idx="979">
                  <c:v>-8044.71384839861</c:v>
                </c:pt>
                <c:pt idx="980">
                  <c:v>-21002.1640518477</c:v>
                </c:pt>
                <c:pt idx="981">
                  <c:v>-42404.010415245102</c:v>
                </c:pt>
                <c:pt idx="982">
                  <c:v>-38711.928941893399</c:v>
                </c:pt>
                <c:pt idx="983">
                  <c:v>-139142.01905830301</c:v>
                </c:pt>
                <c:pt idx="984">
                  <c:v>71273.185855994307</c:v>
                </c:pt>
                <c:pt idx="985">
                  <c:v>-8647.2825132521702</c:v>
                </c:pt>
                <c:pt idx="986">
                  <c:v>16671.318534385198</c:v>
                </c:pt>
                <c:pt idx="987">
                  <c:v>64301.537049466999</c:v>
                </c:pt>
                <c:pt idx="988">
                  <c:v>-10065.206194591299</c:v>
                </c:pt>
                <c:pt idx="989">
                  <c:v>51575.916014527997</c:v>
                </c:pt>
                <c:pt idx="990">
                  <c:v>-7970.6939067326002</c:v>
                </c:pt>
                <c:pt idx="991">
                  <c:v>-6953.3973481041303</c:v>
                </c:pt>
                <c:pt idx="992">
                  <c:v>-2080.5016307660499</c:v>
                </c:pt>
                <c:pt idx="993">
                  <c:v>69042.301458407397</c:v>
                </c:pt>
                <c:pt idx="994">
                  <c:v>8441.3045750416495</c:v>
                </c:pt>
                <c:pt idx="995">
                  <c:v>136045.950815269</c:v>
                </c:pt>
                <c:pt idx="996">
                  <c:v>130375.04143702</c:v>
                </c:pt>
                <c:pt idx="997">
                  <c:v>57651.269229510697</c:v>
                </c:pt>
                <c:pt idx="998">
                  <c:v>61941.866027066499</c:v>
                </c:pt>
                <c:pt idx="999">
                  <c:v>66299.489506453596</c:v>
                </c:pt>
                <c:pt idx="1000">
                  <c:v>82228.246596185505</c:v>
                </c:pt>
                <c:pt idx="1001">
                  <c:v>76280.867690896295</c:v>
                </c:pt>
                <c:pt idx="1002">
                  <c:v>95991.451163823993</c:v>
                </c:pt>
                <c:pt idx="1003">
                  <c:v>221899.07294599299</c:v>
                </c:pt>
                <c:pt idx="1004">
                  <c:v>106904.404481045</c:v>
                </c:pt>
                <c:pt idx="1005">
                  <c:v>-22805.7569381459</c:v>
                </c:pt>
                <c:pt idx="1006">
                  <c:v>102678.5283675</c:v>
                </c:pt>
                <c:pt idx="1007">
                  <c:v>-40418.819926283999</c:v>
                </c:pt>
                <c:pt idx="1008">
                  <c:v>-19677.7883804312</c:v>
                </c:pt>
                <c:pt idx="1009">
                  <c:v>0</c:v>
                </c:pt>
                <c:pt idx="1010">
                  <c:v>0</c:v>
                </c:pt>
                <c:pt idx="1011">
                  <c:v>58865.943789074598</c:v>
                </c:pt>
                <c:pt idx="1012">
                  <c:v>-59972.934445900399</c:v>
                </c:pt>
                <c:pt idx="1013">
                  <c:v>-32335.924581048101</c:v>
                </c:pt>
                <c:pt idx="1014">
                  <c:v>6097.9715801991597</c:v>
                </c:pt>
                <c:pt idx="1015">
                  <c:v>-55090.799770725302</c:v>
                </c:pt>
                <c:pt idx="1016">
                  <c:v>80373.983311923395</c:v>
                </c:pt>
                <c:pt idx="1017">
                  <c:v>23651.755910885899</c:v>
                </c:pt>
                <c:pt idx="1018">
                  <c:v>50866.402669758398</c:v>
                </c:pt>
                <c:pt idx="1019">
                  <c:v>-45236.836365489798</c:v>
                </c:pt>
                <c:pt idx="1020">
                  <c:v>110384.019425565</c:v>
                </c:pt>
                <c:pt idx="1021">
                  <c:v>67641.159718646799</c:v>
                </c:pt>
                <c:pt idx="1022">
                  <c:v>62032.156362622904</c:v>
                </c:pt>
                <c:pt idx="1023">
                  <c:v>-37163.030296597899</c:v>
                </c:pt>
                <c:pt idx="1024">
                  <c:v>-31088.0080626954</c:v>
                </c:pt>
                <c:pt idx="1025">
                  <c:v>48539.162835242299</c:v>
                </c:pt>
                <c:pt idx="1026">
                  <c:v>-31358.067306078901</c:v>
                </c:pt>
                <c:pt idx="1027">
                  <c:v>-87129.147115573796</c:v>
                </c:pt>
                <c:pt idx="1028">
                  <c:v>21339.733376471999</c:v>
                </c:pt>
                <c:pt idx="1029">
                  <c:v>-91777.913982700004</c:v>
                </c:pt>
                <c:pt idx="1030">
                  <c:v>-30452.778443637901</c:v>
                </c:pt>
                <c:pt idx="1031">
                  <c:v>-3202.3858213260601</c:v>
                </c:pt>
                <c:pt idx="1032">
                  <c:v>106135.66927583001</c:v>
                </c:pt>
                <c:pt idx="1033">
                  <c:v>-20933.073297339201</c:v>
                </c:pt>
                <c:pt idx="1034">
                  <c:v>-81467.970947941096</c:v>
                </c:pt>
                <c:pt idx="1035">
                  <c:v>25187.3129475694</c:v>
                </c:pt>
                <c:pt idx="1036">
                  <c:v>135564.262453904</c:v>
                </c:pt>
                <c:pt idx="1037">
                  <c:v>43875.515747375102</c:v>
                </c:pt>
                <c:pt idx="1038">
                  <c:v>-17433.810674553501</c:v>
                </c:pt>
                <c:pt idx="1039">
                  <c:v>10630.2236386393</c:v>
                </c:pt>
                <c:pt idx="1040">
                  <c:v>47294.924809796503</c:v>
                </c:pt>
                <c:pt idx="1041">
                  <c:v>67779.437260566905</c:v>
                </c:pt>
                <c:pt idx="1042">
                  <c:v>-41297.699571571997</c:v>
                </c:pt>
                <c:pt idx="1043">
                  <c:v>-90589.6578683556</c:v>
                </c:pt>
                <c:pt idx="1044">
                  <c:v>-72535.725524570997</c:v>
                </c:pt>
                <c:pt idx="1045">
                  <c:v>-3782.0348222156199</c:v>
                </c:pt>
                <c:pt idx="1046">
                  <c:v>-56277.041919545598</c:v>
                </c:pt>
                <c:pt idx="1047">
                  <c:v>-27484.075563007402</c:v>
                </c:pt>
                <c:pt idx="1048">
                  <c:v>-91026.847581693597</c:v>
                </c:pt>
                <c:pt idx="1049">
                  <c:v>5843.50787201405</c:v>
                </c:pt>
                <c:pt idx="1050">
                  <c:v>-29785.436523140201</c:v>
                </c:pt>
                <c:pt idx="1051">
                  <c:v>-37853.979057896802</c:v>
                </c:pt>
                <c:pt idx="1052">
                  <c:v>-56498.802043723801</c:v>
                </c:pt>
                <c:pt idx="1053">
                  <c:v>109951.18026903299</c:v>
                </c:pt>
                <c:pt idx="1054">
                  <c:v>-7615.1759545533296</c:v>
                </c:pt>
                <c:pt idx="1055">
                  <c:v>-55041.791343531797</c:v>
                </c:pt>
                <c:pt idx="1056">
                  <c:v>22122.012371963301</c:v>
                </c:pt>
                <c:pt idx="1057">
                  <c:v>-58102.705785647697</c:v>
                </c:pt>
                <c:pt idx="1058">
                  <c:v>-119005.900589489</c:v>
                </c:pt>
                <c:pt idx="1059">
                  <c:v>-44765.527232550303</c:v>
                </c:pt>
                <c:pt idx="1060">
                  <c:v>21163.520832866001</c:v>
                </c:pt>
                <c:pt idx="1061">
                  <c:v>-10699.778808507701</c:v>
                </c:pt>
                <c:pt idx="1062">
                  <c:v>-74234.657420197298</c:v>
                </c:pt>
                <c:pt idx="1063">
                  <c:v>-35803.649563716601</c:v>
                </c:pt>
                <c:pt idx="1064">
                  <c:v>-67323.530862242304</c:v>
                </c:pt>
                <c:pt idx="1065">
                  <c:v>-125579.672290595</c:v>
                </c:pt>
                <c:pt idx="1066">
                  <c:v>-33721.1483031768</c:v>
                </c:pt>
                <c:pt idx="1067">
                  <c:v>-40838.891300795804</c:v>
                </c:pt>
                <c:pt idx="1068">
                  <c:v>-135750.37643803601</c:v>
                </c:pt>
                <c:pt idx="1069">
                  <c:v>-53913.834747089102</c:v>
                </c:pt>
                <c:pt idx="1070">
                  <c:v>0</c:v>
                </c:pt>
                <c:pt idx="1071">
                  <c:v>0</c:v>
                </c:pt>
                <c:pt idx="1072">
                  <c:v>50740.702788012197</c:v>
                </c:pt>
                <c:pt idx="1073">
                  <c:v>-56023.685770791497</c:v>
                </c:pt>
                <c:pt idx="1074">
                  <c:v>-47864.592225181899</c:v>
                </c:pt>
                <c:pt idx="1075">
                  <c:v>-60479.578664866902</c:v>
                </c:pt>
                <c:pt idx="1076">
                  <c:v>-92151.053683512102</c:v>
                </c:pt>
                <c:pt idx="1077">
                  <c:v>34298.105762730302</c:v>
                </c:pt>
                <c:pt idx="1078">
                  <c:v>165686.625072294</c:v>
                </c:pt>
                <c:pt idx="1079">
                  <c:v>13959.0793210761</c:v>
                </c:pt>
                <c:pt idx="1080">
                  <c:v>-1501.5524109021601</c:v>
                </c:pt>
                <c:pt idx="1081">
                  <c:v>24008.848748524699</c:v>
                </c:pt>
                <c:pt idx="1082">
                  <c:v>-46064.122165859801</c:v>
                </c:pt>
                <c:pt idx="1083">
                  <c:v>23694.5719493447</c:v>
                </c:pt>
                <c:pt idx="1084">
                  <c:v>29325.768249160799</c:v>
                </c:pt>
                <c:pt idx="1085">
                  <c:v>-2466.2106371343002</c:v>
                </c:pt>
                <c:pt idx="1086">
                  <c:v>-66565.077434443694</c:v>
                </c:pt>
                <c:pt idx="1087">
                  <c:v>-20310.167944884299</c:v>
                </c:pt>
                <c:pt idx="1088">
                  <c:v>-254280.969379666</c:v>
                </c:pt>
                <c:pt idx="1089">
                  <c:v>-114496.263737831</c:v>
                </c:pt>
                <c:pt idx="1090">
                  <c:v>-102036.65542172</c:v>
                </c:pt>
                <c:pt idx="1091">
                  <c:v>-97642.635086600494</c:v>
                </c:pt>
                <c:pt idx="1092">
                  <c:v>-112533.621801202</c:v>
                </c:pt>
                <c:pt idx="1093">
                  <c:v>-31412.159495043299</c:v>
                </c:pt>
                <c:pt idx="1094">
                  <c:v>-6642.3236945765602</c:v>
                </c:pt>
                <c:pt idx="1095">
                  <c:v>13703.781487513799</c:v>
                </c:pt>
                <c:pt idx="1096">
                  <c:v>152033.02028373501</c:v>
                </c:pt>
                <c:pt idx="1097">
                  <c:v>25611.816874781402</c:v>
                </c:pt>
                <c:pt idx="1098">
                  <c:v>-26616.670486074399</c:v>
                </c:pt>
                <c:pt idx="1099">
                  <c:v>3155.4049508314802</c:v>
                </c:pt>
                <c:pt idx="1100">
                  <c:v>66626.631972873103</c:v>
                </c:pt>
                <c:pt idx="1101">
                  <c:v>56133.684679800797</c:v>
                </c:pt>
                <c:pt idx="1102">
                  <c:v>54527.114590712998</c:v>
                </c:pt>
                <c:pt idx="1103">
                  <c:v>11575.9034750315</c:v>
                </c:pt>
                <c:pt idx="1104">
                  <c:v>8944.0088202712705</c:v>
                </c:pt>
                <c:pt idx="1105">
                  <c:v>-19902.625583775702</c:v>
                </c:pt>
                <c:pt idx="1106">
                  <c:v>36266.792026344599</c:v>
                </c:pt>
                <c:pt idx="1107">
                  <c:v>52712.322732512701</c:v>
                </c:pt>
                <c:pt idx="1108">
                  <c:v>-20985.199552366299</c:v>
                </c:pt>
                <c:pt idx="1109">
                  <c:v>-126349.79817152</c:v>
                </c:pt>
                <c:pt idx="1110">
                  <c:v>2031.485334797</c:v>
                </c:pt>
                <c:pt idx="1111">
                  <c:v>-51371.930083940199</c:v>
                </c:pt>
                <c:pt idx="1112">
                  <c:v>30025.881432639901</c:v>
                </c:pt>
                <c:pt idx="1113">
                  <c:v>14345.935913462001</c:v>
                </c:pt>
                <c:pt idx="1114">
                  <c:v>59100.293774994097</c:v>
                </c:pt>
                <c:pt idx="1115">
                  <c:v>-16430.799764804098</c:v>
                </c:pt>
                <c:pt idx="1116">
                  <c:v>-90012.109169214105</c:v>
                </c:pt>
                <c:pt idx="1117">
                  <c:v>-135459.49714202699</c:v>
                </c:pt>
                <c:pt idx="1118">
                  <c:v>30026.875197056001</c:v>
                </c:pt>
                <c:pt idx="1119">
                  <c:v>50628.107957904103</c:v>
                </c:pt>
                <c:pt idx="1120">
                  <c:v>-30191.3882051949</c:v>
                </c:pt>
                <c:pt idx="1121">
                  <c:v>122192.28668279501</c:v>
                </c:pt>
                <c:pt idx="1122">
                  <c:v>70180.153470918303</c:v>
                </c:pt>
                <c:pt idx="1123">
                  <c:v>96108.619582279498</c:v>
                </c:pt>
                <c:pt idx="1124">
                  <c:v>42520.5288178255</c:v>
                </c:pt>
                <c:pt idx="1125">
                  <c:v>30420.345865926101</c:v>
                </c:pt>
                <c:pt idx="1126">
                  <c:v>-6984.3509710914796</c:v>
                </c:pt>
                <c:pt idx="1127">
                  <c:v>63148.669646090901</c:v>
                </c:pt>
                <c:pt idx="1128">
                  <c:v>67360.235569537399</c:v>
                </c:pt>
                <c:pt idx="1129">
                  <c:v>5488.5205905347502</c:v>
                </c:pt>
                <c:pt idx="1130">
                  <c:v>-7349.6550908264398</c:v>
                </c:pt>
                <c:pt idx="1131">
                  <c:v>104479.08307832701</c:v>
                </c:pt>
                <c:pt idx="1132">
                  <c:v>9157.9602048782599</c:v>
                </c:pt>
                <c:pt idx="1133">
                  <c:v>104630.558706225</c:v>
                </c:pt>
                <c:pt idx="1134">
                  <c:v>5337.1152699207496</c:v>
                </c:pt>
                <c:pt idx="1135">
                  <c:v>-137305.88166816</c:v>
                </c:pt>
                <c:pt idx="1136">
                  <c:v>-149702.30949828401</c:v>
                </c:pt>
                <c:pt idx="1137">
                  <c:v>-51921.843030049902</c:v>
                </c:pt>
                <c:pt idx="1138">
                  <c:v>-62915.815444536704</c:v>
                </c:pt>
                <c:pt idx="1139">
                  <c:v>-6028.3997704824696</c:v>
                </c:pt>
                <c:pt idx="1140">
                  <c:v>50603.320146775899</c:v>
                </c:pt>
                <c:pt idx="1141">
                  <c:v>69265.254356392004</c:v>
                </c:pt>
                <c:pt idx="1142">
                  <c:v>6207.8939371773104</c:v>
                </c:pt>
                <c:pt idx="1143">
                  <c:v>-68664.632878495002</c:v>
                </c:pt>
                <c:pt idx="1144">
                  <c:v>33410.309644568297</c:v>
                </c:pt>
                <c:pt idx="1145">
                  <c:v>-22864.807792216099</c:v>
                </c:pt>
                <c:pt idx="1146">
                  <c:v>-71994.988931149594</c:v>
                </c:pt>
                <c:pt idx="1147">
                  <c:v>-124383.454813174</c:v>
                </c:pt>
                <c:pt idx="1148">
                  <c:v>-145985.62058148099</c:v>
                </c:pt>
                <c:pt idx="1149">
                  <c:v>-192990.07657288099</c:v>
                </c:pt>
                <c:pt idx="1150">
                  <c:v>-66688.526323250495</c:v>
                </c:pt>
                <c:pt idx="1151">
                  <c:v>-43516.514076579697</c:v>
                </c:pt>
                <c:pt idx="1152">
                  <c:v>-69231.126334670102</c:v>
                </c:pt>
                <c:pt idx="1153">
                  <c:v>-71195.054327620295</c:v>
                </c:pt>
                <c:pt idx="1154">
                  <c:v>-98787.218706521395</c:v>
                </c:pt>
                <c:pt idx="1155">
                  <c:v>-81855.936797217597</c:v>
                </c:pt>
                <c:pt idx="1156">
                  <c:v>31036.909795403601</c:v>
                </c:pt>
                <c:pt idx="1157">
                  <c:v>41143.380236427904</c:v>
                </c:pt>
                <c:pt idx="1158">
                  <c:v>14640.128561773599</c:v>
                </c:pt>
                <c:pt idx="1159">
                  <c:v>26834.547309807502</c:v>
                </c:pt>
                <c:pt idx="1160">
                  <c:v>30074.0604936571</c:v>
                </c:pt>
                <c:pt idx="1161">
                  <c:v>-9927.5243768371092</c:v>
                </c:pt>
                <c:pt idx="1162">
                  <c:v>-16994.929625160301</c:v>
                </c:pt>
                <c:pt idx="1163">
                  <c:v>69749.052866290003</c:v>
                </c:pt>
                <c:pt idx="1164">
                  <c:v>-57917.037546103202</c:v>
                </c:pt>
                <c:pt idx="1165">
                  <c:v>-26700.0312678185</c:v>
                </c:pt>
                <c:pt idx="1166">
                  <c:v>-48417.897881493504</c:v>
                </c:pt>
                <c:pt idx="1167">
                  <c:v>-197047.92147567999</c:v>
                </c:pt>
                <c:pt idx="1168">
                  <c:v>34906.0845974443</c:v>
                </c:pt>
                <c:pt idx="1169">
                  <c:v>-20879.5096128689</c:v>
                </c:pt>
                <c:pt idx="1170">
                  <c:v>-170965.87090736101</c:v>
                </c:pt>
                <c:pt idx="1171">
                  <c:v>0</c:v>
                </c:pt>
                <c:pt idx="1172">
                  <c:v>0</c:v>
                </c:pt>
                <c:pt idx="1173">
                  <c:v>-123682.962365662</c:v>
                </c:pt>
                <c:pt idx="1174">
                  <c:v>-163784.85449539</c:v>
                </c:pt>
                <c:pt idx="1175">
                  <c:v>12458.2257738098</c:v>
                </c:pt>
                <c:pt idx="1176">
                  <c:v>21800.9125476474</c:v>
                </c:pt>
                <c:pt idx="1177">
                  <c:v>49098.625400504403</c:v>
                </c:pt>
                <c:pt idx="1178">
                  <c:v>2665.5395725089002</c:v>
                </c:pt>
                <c:pt idx="1179">
                  <c:v>102133.010260346</c:v>
                </c:pt>
                <c:pt idx="1180">
                  <c:v>104700.579786649</c:v>
                </c:pt>
                <c:pt idx="1181">
                  <c:v>-5090.51986881006</c:v>
                </c:pt>
                <c:pt idx="1182">
                  <c:v>-130808.091585206</c:v>
                </c:pt>
                <c:pt idx="1183">
                  <c:v>-113686.505544694</c:v>
                </c:pt>
                <c:pt idx="1184">
                  <c:v>-128651.20183873099</c:v>
                </c:pt>
                <c:pt idx="1185">
                  <c:v>-91053.000465889898</c:v>
                </c:pt>
                <c:pt idx="1186">
                  <c:v>-66367.625906024899</c:v>
                </c:pt>
                <c:pt idx="1187">
                  <c:v>-43330.947050413</c:v>
                </c:pt>
                <c:pt idx="1188">
                  <c:v>16988.568874132001</c:v>
                </c:pt>
                <c:pt idx="1189">
                  <c:v>-67970.283807592801</c:v>
                </c:pt>
                <c:pt idx="1190">
                  <c:v>-93031.585422356497</c:v>
                </c:pt>
                <c:pt idx="1191">
                  <c:v>-106193.36002897601</c:v>
                </c:pt>
                <c:pt idx="1192">
                  <c:v>-154997.58404391599</c:v>
                </c:pt>
                <c:pt idx="1193">
                  <c:v>-81304.568079314806</c:v>
                </c:pt>
                <c:pt idx="1194">
                  <c:v>-45433.319122864697</c:v>
                </c:pt>
                <c:pt idx="1195">
                  <c:v>21290.3006059953</c:v>
                </c:pt>
                <c:pt idx="1196">
                  <c:v>-37052.890682531499</c:v>
                </c:pt>
                <c:pt idx="1197">
                  <c:v>-203216.20017398201</c:v>
                </c:pt>
                <c:pt idx="1198">
                  <c:v>-120942.349372097</c:v>
                </c:pt>
                <c:pt idx="1199">
                  <c:v>-11820.2976405714</c:v>
                </c:pt>
                <c:pt idx="1200">
                  <c:v>-73215.317672223493</c:v>
                </c:pt>
                <c:pt idx="1201">
                  <c:v>-70457.679289579799</c:v>
                </c:pt>
                <c:pt idx="1202">
                  <c:v>-99708.741282073694</c:v>
                </c:pt>
                <c:pt idx="1203">
                  <c:v>60103.664168890697</c:v>
                </c:pt>
                <c:pt idx="1204">
                  <c:v>1685.5570461617699</c:v>
                </c:pt>
                <c:pt idx="1205">
                  <c:v>93024.750046522895</c:v>
                </c:pt>
                <c:pt idx="1206">
                  <c:v>-78718.062376102796</c:v>
                </c:pt>
                <c:pt idx="1207">
                  <c:v>-157192.032822913</c:v>
                </c:pt>
                <c:pt idx="1208">
                  <c:v>-119559.19536851499</c:v>
                </c:pt>
                <c:pt idx="1209">
                  <c:v>-156010.319250022</c:v>
                </c:pt>
                <c:pt idx="1210">
                  <c:v>-155215.490284745</c:v>
                </c:pt>
                <c:pt idx="1211">
                  <c:v>-143578.45557778</c:v>
                </c:pt>
                <c:pt idx="1212">
                  <c:v>-93209.168815081197</c:v>
                </c:pt>
                <c:pt idx="1213">
                  <c:v>-65413.585838665902</c:v>
                </c:pt>
                <c:pt idx="1214">
                  <c:v>-36369.887540132797</c:v>
                </c:pt>
                <c:pt idx="1215">
                  <c:v>-37809.318364031998</c:v>
                </c:pt>
                <c:pt idx="1216">
                  <c:v>-23396.826737379299</c:v>
                </c:pt>
                <c:pt idx="1217">
                  <c:v>25914.390411746401</c:v>
                </c:pt>
                <c:pt idx="1218">
                  <c:v>-19295.2518166267</c:v>
                </c:pt>
                <c:pt idx="1219">
                  <c:v>-71135.633998445497</c:v>
                </c:pt>
                <c:pt idx="1220">
                  <c:v>2243.2623422771399</c:v>
                </c:pt>
                <c:pt idx="1221">
                  <c:v>-25036.260468453402</c:v>
                </c:pt>
                <c:pt idx="1222">
                  <c:v>-51392.996737572998</c:v>
                </c:pt>
                <c:pt idx="1223">
                  <c:v>-17404.525883328701</c:v>
                </c:pt>
                <c:pt idx="1224">
                  <c:v>50052.230243537699</c:v>
                </c:pt>
                <c:pt idx="1225">
                  <c:v>37939.372413014898</c:v>
                </c:pt>
                <c:pt idx="1226">
                  <c:v>52374.095612407102</c:v>
                </c:pt>
                <c:pt idx="1227">
                  <c:v>61371.995094998099</c:v>
                </c:pt>
                <c:pt idx="1228">
                  <c:v>86685.4802698782</c:v>
                </c:pt>
                <c:pt idx="1229">
                  <c:v>62359.043258112302</c:v>
                </c:pt>
                <c:pt idx="1230">
                  <c:v>17645.362306896801</c:v>
                </c:pt>
                <c:pt idx="1231">
                  <c:v>-29582.7385241343</c:v>
                </c:pt>
                <c:pt idx="1232">
                  <c:v>-109503.950143943</c:v>
                </c:pt>
                <c:pt idx="1233">
                  <c:v>-39429.823684801297</c:v>
                </c:pt>
                <c:pt idx="1234">
                  <c:v>-115726.501882739</c:v>
                </c:pt>
                <c:pt idx="1235">
                  <c:v>-27781.501177802002</c:v>
                </c:pt>
                <c:pt idx="1236">
                  <c:v>37737.6614407862</c:v>
                </c:pt>
                <c:pt idx="1237">
                  <c:v>-58461.056006943603</c:v>
                </c:pt>
                <c:pt idx="1238">
                  <c:v>26117.1020116365</c:v>
                </c:pt>
                <c:pt idx="1239">
                  <c:v>-76371.981856186598</c:v>
                </c:pt>
                <c:pt idx="1240">
                  <c:v>44097.570631966402</c:v>
                </c:pt>
                <c:pt idx="1241">
                  <c:v>15145.1965258036</c:v>
                </c:pt>
                <c:pt idx="1242">
                  <c:v>-38571.390783367497</c:v>
                </c:pt>
                <c:pt idx="1243">
                  <c:v>-123665.73908498</c:v>
                </c:pt>
                <c:pt idx="1244">
                  <c:v>7362.5830057784697</c:v>
                </c:pt>
                <c:pt idx="1245">
                  <c:v>76144.720886333307</c:v>
                </c:pt>
                <c:pt idx="1246">
                  <c:v>16642.320074024101</c:v>
                </c:pt>
                <c:pt idx="1247">
                  <c:v>-116849.003719275</c:v>
                </c:pt>
                <c:pt idx="1248">
                  <c:v>-167363.73837784701</c:v>
                </c:pt>
                <c:pt idx="1249">
                  <c:v>-65038.388028410896</c:v>
                </c:pt>
                <c:pt idx="1250">
                  <c:v>-15784.6842435495</c:v>
                </c:pt>
                <c:pt idx="1251">
                  <c:v>57265.681419943801</c:v>
                </c:pt>
                <c:pt idx="1252">
                  <c:v>24504.418791927299</c:v>
                </c:pt>
                <c:pt idx="1253">
                  <c:v>-74136.063267095102</c:v>
                </c:pt>
                <c:pt idx="1254">
                  <c:v>-94033.986506932895</c:v>
                </c:pt>
                <c:pt idx="1255">
                  <c:v>-38328.0908351662</c:v>
                </c:pt>
                <c:pt idx="1256">
                  <c:v>24827.3401838381</c:v>
                </c:pt>
                <c:pt idx="1257">
                  <c:v>-90175.491502472898</c:v>
                </c:pt>
                <c:pt idx="1258">
                  <c:v>-9917.3965501327893</c:v>
                </c:pt>
                <c:pt idx="1259">
                  <c:v>-64210.038675165502</c:v>
                </c:pt>
                <c:pt idx="1260">
                  <c:v>-55091.948251494301</c:v>
                </c:pt>
                <c:pt idx="1261">
                  <c:v>-69845.262304901</c:v>
                </c:pt>
                <c:pt idx="1262">
                  <c:v>0</c:v>
                </c:pt>
                <c:pt idx="1263">
                  <c:v>0</c:v>
                </c:pt>
                <c:pt idx="1264">
                  <c:v>24049.995715692501</c:v>
                </c:pt>
                <c:pt idx="1265">
                  <c:v>-81484.253509334099</c:v>
                </c:pt>
                <c:pt idx="1266">
                  <c:v>-23156.950328505998</c:v>
                </c:pt>
                <c:pt idx="1267">
                  <c:v>35370.014174559503</c:v>
                </c:pt>
                <c:pt idx="1268">
                  <c:v>54008.964653770898</c:v>
                </c:pt>
                <c:pt idx="1269">
                  <c:v>31700.378078295202</c:v>
                </c:pt>
                <c:pt idx="1270">
                  <c:v>-38634.189292638497</c:v>
                </c:pt>
                <c:pt idx="1271">
                  <c:v>11927.585348275101</c:v>
                </c:pt>
                <c:pt idx="1272">
                  <c:v>-31483.302687633099</c:v>
                </c:pt>
                <c:pt idx="1273">
                  <c:v>60038.003597547897</c:v>
                </c:pt>
                <c:pt idx="1274">
                  <c:v>81427.137937791704</c:v>
                </c:pt>
                <c:pt idx="1275">
                  <c:v>26562.907040843402</c:v>
                </c:pt>
                <c:pt idx="1276">
                  <c:v>17572.567402031302</c:v>
                </c:pt>
                <c:pt idx="1277">
                  <c:v>17761.088973394599</c:v>
                </c:pt>
                <c:pt idx="1278">
                  <c:v>16999.9729905807</c:v>
                </c:pt>
                <c:pt idx="1279">
                  <c:v>58176.830522376898</c:v>
                </c:pt>
                <c:pt idx="1280">
                  <c:v>-13432.432484044901</c:v>
                </c:pt>
                <c:pt idx="1281">
                  <c:v>-14259.266839259601</c:v>
                </c:pt>
                <c:pt idx="1282">
                  <c:v>-16439.467200067698</c:v>
                </c:pt>
                <c:pt idx="1283">
                  <c:v>49530.8669760228</c:v>
                </c:pt>
                <c:pt idx="1284">
                  <c:v>135995.232023722</c:v>
                </c:pt>
                <c:pt idx="1285">
                  <c:v>16891.086360028599</c:v>
                </c:pt>
                <c:pt idx="1286">
                  <c:v>39490.114011868798</c:v>
                </c:pt>
                <c:pt idx="1287">
                  <c:v>34781.616577610497</c:v>
                </c:pt>
                <c:pt idx="1288">
                  <c:v>67421.084825324695</c:v>
                </c:pt>
                <c:pt idx="1289">
                  <c:v>-15523.091273949</c:v>
                </c:pt>
                <c:pt idx="1290">
                  <c:v>28905.920540210001</c:v>
                </c:pt>
                <c:pt idx="1291">
                  <c:v>77810.656386649396</c:v>
                </c:pt>
                <c:pt idx="1292">
                  <c:v>148058.06160752001</c:v>
                </c:pt>
                <c:pt idx="1293">
                  <c:v>-24382.961069269</c:v>
                </c:pt>
                <c:pt idx="1294">
                  <c:v>104694.84800672501</c:v>
                </c:pt>
                <c:pt idx="1295">
                  <c:v>73891.738367253507</c:v>
                </c:pt>
                <c:pt idx="1296">
                  <c:v>128736.62321479</c:v>
                </c:pt>
                <c:pt idx="1297">
                  <c:v>95032.992096246293</c:v>
                </c:pt>
                <c:pt idx="1298">
                  <c:v>66149.404730871698</c:v>
                </c:pt>
                <c:pt idx="1299">
                  <c:v>78428.679068085898</c:v>
                </c:pt>
                <c:pt idx="1300">
                  <c:v>-12827.8280139486</c:v>
                </c:pt>
                <c:pt idx="1301">
                  <c:v>37130.336285852398</c:v>
                </c:pt>
                <c:pt idx="1302">
                  <c:v>-3367.4274339477101</c:v>
                </c:pt>
                <c:pt idx="1303">
                  <c:v>63531.223620355202</c:v>
                </c:pt>
                <c:pt idx="1304">
                  <c:v>38646.095655575104</c:v>
                </c:pt>
                <c:pt idx="1305">
                  <c:v>-79989.631297784901</c:v>
                </c:pt>
                <c:pt idx="1306">
                  <c:v>-3393.4903914750598</c:v>
                </c:pt>
                <c:pt idx="1307">
                  <c:v>-11853.7654344825</c:v>
                </c:pt>
                <c:pt idx="1308">
                  <c:v>4398.02556153762</c:v>
                </c:pt>
                <c:pt idx="1309">
                  <c:v>41141.184275204403</c:v>
                </c:pt>
                <c:pt idx="1310">
                  <c:v>-53300.622475705197</c:v>
                </c:pt>
                <c:pt idx="1311">
                  <c:v>-143938.18415517101</c:v>
                </c:pt>
                <c:pt idx="1312">
                  <c:v>-74648.595324649796</c:v>
                </c:pt>
                <c:pt idx="1313">
                  <c:v>-205.38494742714099</c:v>
                </c:pt>
                <c:pt idx="1314">
                  <c:v>44027.119350683497</c:v>
                </c:pt>
                <c:pt idx="1315">
                  <c:v>30025.248172977899</c:v>
                </c:pt>
                <c:pt idx="1316">
                  <c:v>32152.9982933258</c:v>
                </c:pt>
                <c:pt idx="1317">
                  <c:v>88572.498696295006</c:v>
                </c:pt>
                <c:pt idx="1318">
                  <c:v>59464.670948815998</c:v>
                </c:pt>
                <c:pt idx="1319">
                  <c:v>-55958.302342608004</c:v>
                </c:pt>
                <c:pt idx="1320">
                  <c:v>-102909.529767082</c:v>
                </c:pt>
                <c:pt idx="1321">
                  <c:v>-95479.319795154894</c:v>
                </c:pt>
                <c:pt idx="1322">
                  <c:v>-35121.230062600996</c:v>
                </c:pt>
                <c:pt idx="1323">
                  <c:v>-8853.5042160428693</c:v>
                </c:pt>
                <c:pt idx="1324">
                  <c:v>-31071.442230946799</c:v>
                </c:pt>
                <c:pt idx="1325">
                  <c:v>-91491.187350927707</c:v>
                </c:pt>
                <c:pt idx="1326">
                  <c:v>-61722.875843534799</c:v>
                </c:pt>
                <c:pt idx="1327">
                  <c:v>-195811.71285287099</c:v>
                </c:pt>
                <c:pt idx="1328">
                  <c:v>-228843.32806864</c:v>
                </c:pt>
                <c:pt idx="1329">
                  <c:v>-48191.648990614303</c:v>
                </c:pt>
                <c:pt idx="1330">
                  <c:v>-123238.717283223</c:v>
                </c:pt>
                <c:pt idx="1331">
                  <c:v>-23868.921453130501</c:v>
                </c:pt>
                <c:pt idx="1332">
                  <c:v>106586.564781215</c:v>
                </c:pt>
                <c:pt idx="1333">
                  <c:v>137645.75329668101</c:v>
                </c:pt>
                <c:pt idx="1334">
                  <c:v>17379.719884444101</c:v>
                </c:pt>
                <c:pt idx="1335">
                  <c:v>42693.207542971002</c:v>
                </c:pt>
                <c:pt idx="1336">
                  <c:v>-44878.133002869501</c:v>
                </c:pt>
                <c:pt idx="1337">
                  <c:v>-26418.2801357764</c:v>
                </c:pt>
                <c:pt idx="1338">
                  <c:v>50321.221173288999</c:v>
                </c:pt>
                <c:pt idx="1339">
                  <c:v>46092.709242613797</c:v>
                </c:pt>
                <c:pt idx="1340">
                  <c:v>9824.8991310950405</c:v>
                </c:pt>
                <c:pt idx="1341">
                  <c:v>59681.624944982002</c:v>
                </c:pt>
                <c:pt idx="1342">
                  <c:v>-2796.9673567377299</c:v>
                </c:pt>
                <c:pt idx="1343">
                  <c:v>-46042.388344477302</c:v>
                </c:pt>
                <c:pt idx="1344">
                  <c:v>-126091.55784362</c:v>
                </c:pt>
                <c:pt idx="1345">
                  <c:v>-79879.313097067497</c:v>
                </c:pt>
                <c:pt idx="1346">
                  <c:v>-129279.067257872</c:v>
                </c:pt>
                <c:pt idx="1347">
                  <c:v>22283.1353157474</c:v>
                </c:pt>
                <c:pt idx="1348">
                  <c:v>57523.7710217274</c:v>
                </c:pt>
                <c:pt idx="1349">
                  <c:v>-100591.41521346</c:v>
                </c:pt>
                <c:pt idx="1350">
                  <c:v>-42742.660678158303</c:v>
                </c:pt>
                <c:pt idx="1351">
                  <c:v>-26678.8944926033</c:v>
                </c:pt>
                <c:pt idx="1352">
                  <c:v>-125300.991672527</c:v>
                </c:pt>
                <c:pt idx="1353">
                  <c:v>-53188.762058365297</c:v>
                </c:pt>
                <c:pt idx="1354">
                  <c:v>-26165.686905823899</c:v>
                </c:pt>
                <c:pt idx="1355">
                  <c:v>-23890.527618595901</c:v>
                </c:pt>
                <c:pt idx="1356">
                  <c:v>-80986.659724958794</c:v>
                </c:pt>
                <c:pt idx="1357">
                  <c:v>12535.3535121764</c:v>
                </c:pt>
                <c:pt idx="1358">
                  <c:v>-113107.99684832701</c:v>
                </c:pt>
                <c:pt idx="1359">
                  <c:v>-204430.03259338101</c:v>
                </c:pt>
                <c:pt idx="1360">
                  <c:v>-15527.588149064701</c:v>
                </c:pt>
                <c:pt idx="1361">
                  <c:v>-8469.6682105914806</c:v>
                </c:pt>
                <c:pt idx="1362">
                  <c:v>-77163.083926277701</c:v>
                </c:pt>
                <c:pt idx="1363">
                  <c:v>-124375.636931081</c:v>
                </c:pt>
                <c:pt idx="1364">
                  <c:v>-122098.808422166</c:v>
                </c:pt>
                <c:pt idx="1365">
                  <c:v>-160864.63868646699</c:v>
                </c:pt>
                <c:pt idx="1366">
                  <c:v>-37141.500268265103</c:v>
                </c:pt>
                <c:pt idx="1367">
                  <c:v>-92901.8175716447</c:v>
                </c:pt>
                <c:pt idx="1368">
                  <c:v>-5339.4785685634997</c:v>
                </c:pt>
                <c:pt idx="1369">
                  <c:v>-65696.409689367996</c:v>
                </c:pt>
                <c:pt idx="1370">
                  <c:v>-100741.145394551</c:v>
                </c:pt>
                <c:pt idx="1371">
                  <c:v>-141392.52276809001</c:v>
                </c:pt>
                <c:pt idx="1372">
                  <c:v>-99133.1694156335</c:v>
                </c:pt>
                <c:pt idx="1373">
                  <c:v>-83912.472006435899</c:v>
                </c:pt>
                <c:pt idx="1374">
                  <c:v>-129449.31178189701</c:v>
                </c:pt>
                <c:pt idx="1375">
                  <c:v>-35746.367370911001</c:v>
                </c:pt>
                <c:pt idx="1376">
                  <c:v>-19213.6271486187</c:v>
                </c:pt>
                <c:pt idx="1377">
                  <c:v>-90237.642892146396</c:v>
                </c:pt>
                <c:pt idx="1378">
                  <c:v>-46917.907826468399</c:v>
                </c:pt>
                <c:pt idx="1379">
                  <c:v>-101572.055025676</c:v>
                </c:pt>
                <c:pt idx="1380">
                  <c:v>-2259.01398312316</c:v>
                </c:pt>
                <c:pt idx="1381">
                  <c:v>-34576.995923093004</c:v>
                </c:pt>
                <c:pt idx="1382">
                  <c:v>-98832.660446060705</c:v>
                </c:pt>
                <c:pt idx="1383">
                  <c:v>-161714.15083450099</c:v>
                </c:pt>
                <c:pt idx="1384">
                  <c:v>-45880.989425526197</c:v>
                </c:pt>
                <c:pt idx="1385">
                  <c:v>-133852.63398430499</c:v>
                </c:pt>
                <c:pt idx="1386">
                  <c:v>-22140.644015258498</c:v>
                </c:pt>
                <c:pt idx="1387">
                  <c:v>-44676.677284779304</c:v>
                </c:pt>
                <c:pt idx="1388">
                  <c:v>-149417.88769583299</c:v>
                </c:pt>
                <c:pt idx="1389">
                  <c:v>-107193.8654692</c:v>
                </c:pt>
                <c:pt idx="1390">
                  <c:v>-131252.70362485899</c:v>
                </c:pt>
                <c:pt idx="1391">
                  <c:v>-105610.5903772</c:v>
                </c:pt>
                <c:pt idx="1392">
                  <c:v>-215120.35186686201</c:v>
                </c:pt>
                <c:pt idx="1393">
                  <c:v>-155842.70637405201</c:v>
                </c:pt>
                <c:pt idx="1394">
                  <c:v>-85670.596403152507</c:v>
                </c:pt>
                <c:pt idx="1395">
                  <c:v>16081.6906630553</c:v>
                </c:pt>
                <c:pt idx="1396">
                  <c:v>-23359.887471580299</c:v>
                </c:pt>
                <c:pt idx="1397">
                  <c:v>-100118.490261981</c:v>
                </c:pt>
                <c:pt idx="1398">
                  <c:v>-110306.15050457801</c:v>
                </c:pt>
                <c:pt idx="1399">
                  <c:v>-67790.086444296001</c:v>
                </c:pt>
                <c:pt idx="1400">
                  <c:v>-145115.92828328299</c:v>
                </c:pt>
                <c:pt idx="1401">
                  <c:v>-31232.6847204859</c:v>
                </c:pt>
                <c:pt idx="1402">
                  <c:v>-80129.788792598396</c:v>
                </c:pt>
                <c:pt idx="1403">
                  <c:v>-169905.29762470801</c:v>
                </c:pt>
                <c:pt idx="1404">
                  <c:v>-16983.490266762201</c:v>
                </c:pt>
                <c:pt idx="1405">
                  <c:v>-9266.0171640175795</c:v>
                </c:pt>
                <c:pt idx="1406">
                  <c:v>23783.351739985199</c:v>
                </c:pt>
                <c:pt idx="1407">
                  <c:v>-24265.148554683401</c:v>
                </c:pt>
                <c:pt idx="1408">
                  <c:v>-3216.2940055917602</c:v>
                </c:pt>
                <c:pt idx="1409">
                  <c:v>-59912.697298228602</c:v>
                </c:pt>
                <c:pt idx="1410">
                  <c:v>-72474.918458236396</c:v>
                </c:pt>
                <c:pt idx="1411">
                  <c:v>-81604.903890171903</c:v>
                </c:pt>
                <c:pt idx="1412">
                  <c:v>-196308.76424671701</c:v>
                </c:pt>
                <c:pt idx="1413">
                  <c:v>-144396.97498067701</c:v>
                </c:pt>
                <c:pt idx="1414">
                  <c:v>-251481.89695435</c:v>
                </c:pt>
                <c:pt idx="1415">
                  <c:v>-44188.2444747872</c:v>
                </c:pt>
                <c:pt idx="1416">
                  <c:v>-69057.420651617504</c:v>
                </c:pt>
                <c:pt idx="1417">
                  <c:v>-213020.48664131499</c:v>
                </c:pt>
                <c:pt idx="1418">
                  <c:v>-183695.56454755101</c:v>
                </c:pt>
                <c:pt idx="1419">
                  <c:v>-97435.547579825405</c:v>
                </c:pt>
                <c:pt idx="1420">
                  <c:v>-80223.7131117057</c:v>
                </c:pt>
                <c:pt idx="1421">
                  <c:v>5075.3491513163599</c:v>
                </c:pt>
                <c:pt idx="1422">
                  <c:v>-5485.53167752844</c:v>
                </c:pt>
                <c:pt idx="1423">
                  <c:v>0</c:v>
                </c:pt>
                <c:pt idx="1424">
                  <c:v>0</c:v>
                </c:pt>
                <c:pt idx="1425">
                  <c:v>-1623.2334025653499</c:v>
                </c:pt>
                <c:pt idx="1426">
                  <c:v>78923.6794616017</c:v>
                </c:pt>
                <c:pt idx="1427">
                  <c:v>43954.040625467103</c:v>
                </c:pt>
                <c:pt idx="1428">
                  <c:v>43570.267904674598</c:v>
                </c:pt>
                <c:pt idx="1429">
                  <c:v>2947.4607947965701</c:v>
                </c:pt>
                <c:pt idx="1430">
                  <c:v>-20666.7737828235</c:v>
                </c:pt>
                <c:pt idx="1431">
                  <c:v>-12846.1359576677</c:v>
                </c:pt>
                <c:pt idx="1432">
                  <c:v>-162796.411378119</c:v>
                </c:pt>
                <c:pt idx="1433">
                  <c:v>-101752.78522572901</c:v>
                </c:pt>
                <c:pt idx="1434">
                  <c:v>-186951.844343759</c:v>
                </c:pt>
                <c:pt idx="1435">
                  <c:v>-228470.97931569401</c:v>
                </c:pt>
                <c:pt idx="1436">
                  <c:v>-128684.626612589</c:v>
                </c:pt>
                <c:pt idx="1437">
                  <c:v>-159015.063128259</c:v>
                </c:pt>
                <c:pt idx="1438">
                  <c:v>-221737.21740895801</c:v>
                </c:pt>
                <c:pt idx="1439">
                  <c:v>-116391.223188127</c:v>
                </c:pt>
                <c:pt idx="1440">
                  <c:v>-53994.627813923304</c:v>
                </c:pt>
                <c:pt idx="1441">
                  <c:v>91049.398130815694</c:v>
                </c:pt>
                <c:pt idx="1442">
                  <c:v>16790.559872220401</c:v>
                </c:pt>
                <c:pt idx="1443">
                  <c:v>-63243.994018107798</c:v>
                </c:pt>
                <c:pt idx="1444">
                  <c:v>-53321.233376437798</c:v>
                </c:pt>
                <c:pt idx="1445">
                  <c:v>15651.828328465601</c:v>
                </c:pt>
                <c:pt idx="1446">
                  <c:v>-104727.874737511</c:v>
                </c:pt>
                <c:pt idx="1447">
                  <c:v>-130759.509984399</c:v>
                </c:pt>
                <c:pt idx="1448">
                  <c:v>-14954.9717512069</c:v>
                </c:pt>
                <c:pt idx="1449">
                  <c:v>-125956.301139431</c:v>
                </c:pt>
                <c:pt idx="1450">
                  <c:v>-71799.425905822398</c:v>
                </c:pt>
                <c:pt idx="1451">
                  <c:v>-51235.4103228436</c:v>
                </c:pt>
                <c:pt idx="1452">
                  <c:v>-68233.467993379396</c:v>
                </c:pt>
                <c:pt idx="1453">
                  <c:v>-93253.638193262304</c:v>
                </c:pt>
                <c:pt idx="1454">
                  <c:v>-74468.729232692305</c:v>
                </c:pt>
                <c:pt idx="1455">
                  <c:v>-44825.485525324897</c:v>
                </c:pt>
                <c:pt idx="1456">
                  <c:v>-27113.582586325301</c:v>
                </c:pt>
                <c:pt idx="1457">
                  <c:v>-58601.506697113997</c:v>
                </c:pt>
                <c:pt idx="1458">
                  <c:v>-78321.831169277604</c:v>
                </c:pt>
                <c:pt idx="1459">
                  <c:v>-59332.324627456299</c:v>
                </c:pt>
                <c:pt idx="1460">
                  <c:v>-111923.813786668</c:v>
                </c:pt>
                <c:pt idx="1461">
                  <c:v>-5359.4523770551496</c:v>
                </c:pt>
                <c:pt idx="1462">
                  <c:v>-111173.538417674</c:v>
                </c:pt>
                <c:pt idx="1463">
                  <c:v>7970.2296050368705</c:v>
                </c:pt>
                <c:pt idx="1464">
                  <c:v>-46422.598854075302</c:v>
                </c:pt>
                <c:pt idx="1465">
                  <c:v>-24130.9068601381</c:v>
                </c:pt>
                <c:pt idx="1466">
                  <c:v>95470.967918337497</c:v>
                </c:pt>
                <c:pt idx="1467">
                  <c:v>109312.447342965</c:v>
                </c:pt>
                <c:pt idx="1468">
                  <c:v>-40160.119557399099</c:v>
                </c:pt>
                <c:pt idx="1469">
                  <c:v>-37089.781250615597</c:v>
                </c:pt>
                <c:pt idx="1470">
                  <c:v>-155897.579302992</c:v>
                </c:pt>
                <c:pt idx="1471">
                  <c:v>-39444.136222148198</c:v>
                </c:pt>
                <c:pt idx="1472">
                  <c:v>-66492.265061666694</c:v>
                </c:pt>
                <c:pt idx="1473">
                  <c:v>-55302.393601103002</c:v>
                </c:pt>
                <c:pt idx="1474">
                  <c:v>0</c:v>
                </c:pt>
                <c:pt idx="1475">
                  <c:v>0</c:v>
                </c:pt>
                <c:pt idx="1476">
                  <c:v>53924.754789777799</c:v>
                </c:pt>
                <c:pt idx="1477">
                  <c:v>-13032.460410679199</c:v>
                </c:pt>
                <c:pt idx="1478">
                  <c:v>-173811.22792524501</c:v>
                </c:pt>
                <c:pt idx="1479">
                  <c:v>-51843.080976881</c:v>
                </c:pt>
                <c:pt idx="1480">
                  <c:v>31986.191827485301</c:v>
                </c:pt>
                <c:pt idx="1481">
                  <c:v>70054.168731403406</c:v>
                </c:pt>
                <c:pt idx="1482">
                  <c:v>-24558.073276817398</c:v>
                </c:pt>
                <c:pt idx="1483">
                  <c:v>-21719.899551532199</c:v>
                </c:pt>
                <c:pt idx="1484">
                  <c:v>-1946.15057958382</c:v>
                </c:pt>
                <c:pt idx="1485">
                  <c:v>-34651.963806080799</c:v>
                </c:pt>
                <c:pt idx="1486">
                  <c:v>-1969.3539982402999</c:v>
                </c:pt>
                <c:pt idx="1487">
                  <c:v>32277.671157389901</c:v>
                </c:pt>
                <c:pt idx="1488">
                  <c:v>-115455.13456429599</c:v>
                </c:pt>
                <c:pt idx="1489">
                  <c:v>-153612.85310168401</c:v>
                </c:pt>
                <c:pt idx="1490">
                  <c:v>-76701.016242805694</c:v>
                </c:pt>
                <c:pt idx="1491">
                  <c:v>-16592.070278409799</c:v>
                </c:pt>
                <c:pt idx="1492">
                  <c:v>51390.411828419899</c:v>
                </c:pt>
                <c:pt idx="1493">
                  <c:v>-11936.0641209652</c:v>
                </c:pt>
                <c:pt idx="1494">
                  <c:v>-3274.6643245192399</c:v>
                </c:pt>
                <c:pt idx="1495">
                  <c:v>-32728.908390938501</c:v>
                </c:pt>
                <c:pt idx="1496">
                  <c:v>-45449.021585809998</c:v>
                </c:pt>
                <c:pt idx="1497">
                  <c:v>-117446.997173183</c:v>
                </c:pt>
                <c:pt idx="1498">
                  <c:v>-18229.385035970401</c:v>
                </c:pt>
                <c:pt idx="1499">
                  <c:v>3736.6039381318401</c:v>
                </c:pt>
                <c:pt idx="1500">
                  <c:v>-47470.430836233398</c:v>
                </c:pt>
                <c:pt idx="1501">
                  <c:v>-40308.682181112898</c:v>
                </c:pt>
                <c:pt idx="1502">
                  <c:v>-27149.290910663101</c:v>
                </c:pt>
                <c:pt idx="1503">
                  <c:v>59202.132141112801</c:v>
                </c:pt>
                <c:pt idx="1504">
                  <c:v>1795.51323151515</c:v>
                </c:pt>
                <c:pt idx="1505">
                  <c:v>84543.015763420306</c:v>
                </c:pt>
                <c:pt idx="1506">
                  <c:v>28726.020645890701</c:v>
                </c:pt>
                <c:pt idx="1507">
                  <c:v>20809.273704955001</c:v>
                </c:pt>
                <c:pt idx="1508">
                  <c:v>47100.870474218602</c:v>
                </c:pt>
                <c:pt idx="1509">
                  <c:v>10042.7931984029</c:v>
                </c:pt>
                <c:pt idx="1510">
                  <c:v>26347.9651000513</c:v>
                </c:pt>
                <c:pt idx="1511">
                  <c:v>-33731.689445687</c:v>
                </c:pt>
                <c:pt idx="1512">
                  <c:v>34648.642988133201</c:v>
                </c:pt>
                <c:pt idx="1513">
                  <c:v>9588.8644803009192</c:v>
                </c:pt>
                <c:pt idx="1514">
                  <c:v>52772.427425479596</c:v>
                </c:pt>
                <c:pt idx="1515">
                  <c:v>0</c:v>
                </c:pt>
                <c:pt idx="1516">
                  <c:v>0</c:v>
                </c:pt>
                <c:pt idx="1517">
                  <c:v>55543.502506551398</c:v>
                </c:pt>
                <c:pt idx="1518">
                  <c:v>137917.188921514</c:v>
                </c:pt>
                <c:pt idx="1519">
                  <c:v>59569.629950778501</c:v>
                </c:pt>
                <c:pt idx="1520">
                  <c:v>-55890.050829106302</c:v>
                </c:pt>
                <c:pt idx="1521">
                  <c:v>-60041.825681665498</c:v>
                </c:pt>
                <c:pt idx="1522">
                  <c:v>-116469.133354406</c:v>
                </c:pt>
                <c:pt idx="1523">
                  <c:v>-72134.214040075603</c:v>
                </c:pt>
                <c:pt idx="1524">
                  <c:v>-12595.837874492699</c:v>
                </c:pt>
                <c:pt idx="1525">
                  <c:v>69918.420429626305</c:v>
                </c:pt>
                <c:pt idx="1526">
                  <c:v>157324.10680616301</c:v>
                </c:pt>
                <c:pt idx="1527">
                  <c:v>30365.847725616099</c:v>
                </c:pt>
                <c:pt idx="1528">
                  <c:v>-40577.229384657301</c:v>
                </c:pt>
                <c:pt idx="1529">
                  <c:v>43478.1843440999</c:v>
                </c:pt>
                <c:pt idx="1530">
                  <c:v>48335.927779111997</c:v>
                </c:pt>
                <c:pt idx="1531">
                  <c:v>45008.955358659601</c:v>
                </c:pt>
                <c:pt idx="1532">
                  <c:v>64086.851033500898</c:v>
                </c:pt>
                <c:pt idx="1533">
                  <c:v>-28697.0184589768</c:v>
                </c:pt>
                <c:pt idx="1534">
                  <c:v>-13889.443117825</c:v>
                </c:pt>
                <c:pt idx="1535">
                  <c:v>102018.910182331</c:v>
                </c:pt>
                <c:pt idx="1536">
                  <c:v>60783.887512706402</c:v>
                </c:pt>
                <c:pt idx="1537">
                  <c:v>33849.624987652198</c:v>
                </c:pt>
                <c:pt idx="1538">
                  <c:v>129753.535258723</c:v>
                </c:pt>
                <c:pt idx="1539">
                  <c:v>74337.8380166813</c:v>
                </c:pt>
                <c:pt idx="1540">
                  <c:v>89608.205548168</c:v>
                </c:pt>
                <c:pt idx="1541">
                  <c:v>106613.79897630701</c:v>
                </c:pt>
                <c:pt idx="1542">
                  <c:v>75398.236050706793</c:v>
                </c:pt>
                <c:pt idx="1543">
                  <c:v>38676.036928307702</c:v>
                </c:pt>
                <c:pt idx="1544">
                  <c:v>-50696.641150609699</c:v>
                </c:pt>
                <c:pt idx="1545">
                  <c:v>-37098.6313470799</c:v>
                </c:pt>
                <c:pt idx="1546">
                  <c:v>-73399.673537886702</c:v>
                </c:pt>
                <c:pt idx="1547">
                  <c:v>-15151.2030186836</c:v>
                </c:pt>
                <c:pt idx="1548">
                  <c:v>30028.944894337899</c:v>
                </c:pt>
                <c:pt idx="1549">
                  <c:v>679.11010816147802</c:v>
                </c:pt>
                <c:pt idx="1550">
                  <c:v>14139.253889576999</c:v>
                </c:pt>
                <c:pt idx="1551">
                  <c:v>-23524.6270941644</c:v>
                </c:pt>
                <c:pt idx="1552">
                  <c:v>63613.147063086799</c:v>
                </c:pt>
                <c:pt idx="1553">
                  <c:v>79841.2741652556</c:v>
                </c:pt>
                <c:pt idx="1554">
                  <c:v>-36490.141831821202</c:v>
                </c:pt>
                <c:pt idx="1555">
                  <c:v>22472.0713830719</c:v>
                </c:pt>
                <c:pt idx="1556">
                  <c:v>0</c:v>
                </c:pt>
                <c:pt idx="1557">
                  <c:v>0</c:v>
                </c:pt>
                <c:pt idx="1558">
                  <c:v>44171.244939821197</c:v>
                </c:pt>
                <c:pt idx="1559">
                  <c:v>16423.027754389401</c:v>
                </c:pt>
                <c:pt idx="1560">
                  <c:v>13101.425469481799</c:v>
                </c:pt>
                <c:pt idx="1561">
                  <c:v>93807.472789092004</c:v>
                </c:pt>
                <c:pt idx="1562">
                  <c:v>97966.384152450104</c:v>
                </c:pt>
                <c:pt idx="1563">
                  <c:v>80516.919538816102</c:v>
                </c:pt>
                <c:pt idx="1564">
                  <c:v>12822.8250472909</c:v>
                </c:pt>
                <c:pt idx="1565">
                  <c:v>79525.203104698594</c:v>
                </c:pt>
                <c:pt idx="1566">
                  <c:v>76625.749247355707</c:v>
                </c:pt>
                <c:pt idx="1567">
                  <c:v>58465.335916523502</c:v>
                </c:pt>
                <c:pt idx="1568">
                  <c:v>45366.582346788498</c:v>
                </c:pt>
                <c:pt idx="1569">
                  <c:v>67647.2863429633</c:v>
                </c:pt>
                <c:pt idx="1570">
                  <c:v>131825.46975574599</c:v>
                </c:pt>
                <c:pt idx="1571">
                  <c:v>99568.275541689101</c:v>
                </c:pt>
                <c:pt idx="1572">
                  <c:v>79925.325353627501</c:v>
                </c:pt>
                <c:pt idx="1573">
                  <c:v>106846.908912695</c:v>
                </c:pt>
                <c:pt idx="1574">
                  <c:v>-12806.7702451369</c:v>
                </c:pt>
                <c:pt idx="1575">
                  <c:v>-53703.804047712103</c:v>
                </c:pt>
                <c:pt idx="1576">
                  <c:v>-4775.3058057457602</c:v>
                </c:pt>
                <c:pt idx="1577">
                  <c:v>-64196.0185660075</c:v>
                </c:pt>
                <c:pt idx="1578">
                  <c:v>76494.656412875906</c:v>
                </c:pt>
                <c:pt idx="1579">
                  <c:v>68701.4109092812</c:v>
                </c:pt>
                <c:pt idx="1580">
                  <c:v>57046.904848517101</c:v>
                </c:pt>
                <c:pt idx="1581">
                  <c:v>-6847.6811775741098</c:v>
                </c:pt>
                <c:pt idx="1582">
                  <c:v>-42799.143863920901</c:v>
                </c:pt>
                <c:pt idx="1583">
                  <c:v>46488.896525230797</c:v>
                </c:pt>
                <c:pt idx="1584">
                  <c:v>118646.11809586</c:v>
                </c:pt>
                <c:pt idx="1585">
                  <c:v>83133.690439907296</c:v>
                </c:pt>
                <c:pt idx="1586">
                  <c:v>44063.086385186201</c:v>
                </c:pt>
                <c:pt idx="1587">
                  <c:v>-18600.138278924402</c:v>
                </c:pt>
                <c:pt idx="1588">
                  <c:v>39975.5087226162</c:v>
                </c:pt>
                <c:pt idx="1589">
                  <c:v>-7195.1607719285603</c:v>
                </c:pt>
                <c:pt idx="1590">
                  <c:v>80215.924107814193</c:v>
                </c:pt>
                <c:pt idx="1591">
                  <c:v>55337.583499509798</c:v>
                </c:pt>
                <c:pt idx="1592">
                  <c:v>-30014.650058363099</c:v>
                </c:pt>
                <c:pt idx="1593">
                  <c:v>120911.18654686501</c:v>
                </c:pt>
                <c:pt idx="1594">
                  <c:v>62630.484329850202</c:v>
                </c:pt>
                <c:pt idx="1595">
                  <c:v>-21923.057827668301</c:v>
                </c:pt>
                <c:pt idx="1596">
                  <c:v>11445.044268682001</c:v>
                </c:pt>
                <c:pt idx="1597">
                  <c:v>-34065.601126827598</c:v>
                </c:pt>
                <c:pt idx="1598">
                  <c:v>100077.171424663</c:v>
                </c:pt>
                <c:pt idx="1599">
                  <c:v>-20030.004555490999</c:v>
                </c:pt>
                <c:pt idx="1600">
                  <c:v>84606.023950835297</c:v>
                </c:pt>
                <c:pt idx="1601">
                  <c:v>66215.967865711107</c:v>
                </c:pt>
                <c:pt idx="1602">
                  <c:v>121647.662506978</c:v>
                </c:pt>
                <c:pt idx="1603">
                  <c:v>84218.126917958405</c:v>
                </c:pt>
                <c:pt idx="1604">
                  <c:v>126669.644670675</c:v>
                </c:pt>
                <c:pt idx="1605">
                  <c:v>168171.339719401</c:v>
                </c:pt>
                <c:pt idx="1606">
                  <c:v>50208.377693983901</c:v>
                </c:pt>
                <c:pt idx="1607">
                  <c:v>0</c:v>
                </c:pt>
                <c:pt idx="1608">
                  <c:v>0</c:v>
                </c:pt>
                <c:pt idx="1609">
                  <c:v>86422.935907428197</c:v>
                </c:pt>
                <c:pt idx="1610">
                  <c:v>57922.755383910102</c:v>
                </c:pt>
                <c:pt idx="1611">
                  <c:v>82363.582538265196</c:v>
                </c:pt>
                <c:pt idx="1612">
                  <c:v>122846.868108332</c:v>
                </c:pt>
                <c:pt idx="1613">
                  <c:v>28351.9033032599</c:v>
                </c:pt>
                <c:pt idx="1614">
                  <c:v>94394.662689493605</c:v>
                </c:pt>
                <c:pt idx="1615">
                  <c:v>103379.60052388</c:v>
                </c:pt>
                <c:pt idx="1616">
                  <c:v>92251.166253646094</c:v>
                </c:pt>
                <c:pt idx="1617">
                  <c:v>56297.243839736002</c:v>
                </c:pt>
                <c:pt idx="1618">
                  <c:v>65430.272617226401</c:v>
                </c:pt>
                <c:pt idx="1619">
                  <c:v>52879.4185603921</c:v>
                </c:pt>
                <c:pt idx="1620">
                  <c:v>116352.31647270299</c:v>
                </c:pt>
                <c:pt idx="1621">
                  <c:v>89052.065982211396</c:v>
                </c:pt>
                <c:pt idx="1622">
                  <c:v>141337.092884093</c:v>
                </c:pt>
                <c:pt idx="1623">
                  <c:v>83418.345621605898</c:v>
                </c:pt>
                <c:pt idx="1624">
                  <c:v>149195.908808459</c:v>
                </c:pt>
                <c:pt idx="1625">
                  <c:v>34645.270328520703</c:v>
                </c:pt>
                <c:pt idx="1626">
                  <c:v>129068.307139746</c:v>
                </c:pt>
                <c:pt idx="1627">
                  <c:v>55886.930294164798</c:v>
                </c:pt>
                <c:pt idx="1628">
                  <c:v>31225.021434156501</c:v>
                </c:pt>
                <c:pt idx="1629">
                  <c:v>16115.097402949999</c:v>
                </c:pt>
                <c:pt idx="1630">
                  <c:v>-5613.6316873462101</c:v>
                </c:pt>
                <c:pt idx="1631">
                  <c:v>16282.478674027099</c:v>
                </c:pt>
                <c:pt idx="1632">
                  <c:v>106964.031918248</c:v>
                </c:pt>
                <c:pt idx="1633">
                  <c:v>-3993.3835680015</c:v>
                </c:pt>
                <c:pt idx="1634">
                  <c:v>-48295.977901168197</c:v>
                </c:pt>
                <c:pt idx="1635">
                  <c:v>8360.2286822420392</c:v>
                </c:pt>
                <c:pt idx="1636">
                  <c:v>68870.099605337993</c:v>
                </c:pt>
                <c:pt idx="1637">
                  <c:v>-10270.4377716485</c:v>
                </c:pt>
                <c:pt idx="1638">
                  <c:v>158302.03354089899</c:v>
                </c:pt>
                <c:pt idx="1639">
                  <c:v>150619.03432508599</c:v>
                </c:pt>
                <c:pt idx="1640">
                  <c:v>174209.82593534599</c:v>
                </c:pt>
                <c:pt idx="1641">
                  <c:v>52450.499029950297</c:v>
                </c:pt>
                <c:pt idx="1642">
                  <c:v>-26600.498907234101</c:v>
                </c:pt>
                <c:pt idx="1643">
                  <c:v>44389.392973764901</c:v>
                </c:pt>
                <c:pt idx="1644">
                  <c:v>53297.675941010297</c:v>
                </c:pt>
                <c:pt idx="1645">
                  <c:v>24628.5735529054</c:v>
                </c:pt>
                <c:pt idx="1646">
                  <c:v>5181.9913667560904</c:v>
                </c:pt>
                <c:pt idx="1647">
                  <c:v>25643.6641124216</c:v>
                </c:pt>
                <c:pt idx="1648">
                  <c:v>65247.551650994799</c:v>
                </c:pt>
                <c:pt idx="1649">
                  <c:v>93616.233207885802</c:v>
                </c:pt>
                <c:pt idx="1650">
                  <c:v>56337.730322812102</c:v>
                </c:pt>
                <c:pt idx="1651">
                  <c:v>130474.809068963</c:v>
                </c:pt>
                <c:pt idx="1652">
                  <c:v>110260.52543353</c:v>
                </c:pt>
                <c:pt idx="1653">
                  <c:v>50014.0504896973</c:v>
                </c:pt>
                <c:pt idx="1654">
                  <c:v>26790.8537340084</c:v>
                </c:pt>
                <c:pt idx="1655">
                  <c:v>31174.710470947299</c:v>
                </c:pt>
                <c:pt idx="1656">
                  <c:v>-11221.7672077154</c:v>
                </c:pt>
                <c:pt idx="1657">
                  <c:v>528.66235082013702</c:v>
                </c:pt>
                <c:pt idx="1658">
                  <c:v>40542.199714565097</c:v>
                </c:pt>
                <c:pt idx="1659">
                  <c:v>-23530.8326376685</c:v>
                </c:pt>
                <c:pt idx="1660">
                  <c:v>69713.234477285805</c:v>
                </c:pt>
                <c:pt idx="1661">
                  <c:v>2496.6200841343798</c:v>
                </c:pt>
                <c:pt idx="1662">
                  <c:v>-16274.926620210401</c:v>
                </c:pt>
                <c:pt idx="1663">
                  <c:v>96391.017920790997</c:v>
                </c:pt>
                <c:pt idx="1664">
                  <c:v>135992.56256777799</c:v>
                </c:pt>
                <c:pt idx="1665">
                  <c:v>126744.279738217</c:v>
                </c:pt>
                <c:pt idx="1666">
                  <c:v>72181.221619325501</c:v>
                </c:pt>
                <c:pt idx="1667">
                  <c:v>12369.1361500531</c:v>
                </c:pt>
                <c:pt idx="1668">
                  <c:v>-63980.296428945599</c:v>
                </c:pt>
                <c:pt idx="1669">
                  <c:v>4109.1399209082902</c:v>
                </c:pt>
                <c:pt idx="1670">
                  <c:v>-96110.892670903297</c:v>
                </c:pt>
                <c:pt idx="1671">
                  <c:v>1116.2848258962799</c:v>
                </c:pt>
                <c:pt idx="1672">
                  <c:v>32737.8196582417</c:v>
                </c:pt>
                <c:pt idx="1673">
                  <c:v>48389.742115169603</c:v>
                </c:pt>
                <c:pt idx="1674">
                  <c:v>28867.883563338</c:v>
                </c:pt>
                <c:pt idx="1675">
                  <c:v>-9689.5473421998504</c:v>
                </c:pt>
                <c:pt idx="1676">
                  <c:v>39965.948523601</c:v>
                </c:pt>
                <c:pt idx="1677">
                  <c:v>129962.340190502</c:v>
                </c:pt>
                <c:pt idx="1678">
                  <c:v>50102.581218187399</c:v>
                </c:pt>
                <c:pt idx="1679">
                  <c:v>-67707.231364805702</c:v>
                </c:pt>
                <c:pt idx="1680">
                  <c:v>44050.3547505565</c:v>
                </c:pt>
                <c:pt idx="1681">
                  <c:v>-10903.2468388492</c:v>
                </c:pt>
                <c:pt idx="1682">
                  <c:v>-38258.287716859901</c:v>
                </c:pt>
                <c:pt idx="1683">
                  <c:v>-67327.609371908096</c:v>
                </c:pt>
                <c:pt idx="1684">
                  <c:v>-38391.696172376804</c:v>
                </c:pt>
                <c:pt idx="1685">
                  <c:v>-57373.067950659803</c:v>
                </c:pt>
                <c:pt idx="1686">
                  <c:v>2272.30480473228</c:v>
                </c:pt>
                <c:pt idx="1687">
                  <c:v>53600.175533760499</c:v>
                </c:pt>
                <c:pt idx="1688">
                  <c:v>0</c:v>
                </c:pt>
                <c:pt idx="1689">
                  <c:v>0</c:v>
                </c:pt>
                <c:pt idx="1690">
                  <c:v>-231821.172454869</c:v>
                </c:pt>
                <c:pt idx="1691">
                  <c:v>-79012.528005157394</c:v>
                </c:pt>
                <c:pt idx="1692">
                  <c:v>-45397.943073663497</c:v>
                </c:pt>
                <c:pt idx="1693">
                  <c:v>-2192.4728760182802</c:v>
                </c:pt>
                <c:pt idx="1694">
                  <c:v>-28650.927183015701</c:v>
                </c:pt>
                <c:pt idx="1695">
                  <c:v>-124962.65608840001</c:v>
                </c:pt>
                <c:pt idx="1696">
                  <c:v>-54941.275659637002</c:v>
                </c:pt>
                <c:pt idx="1697">
                  <c:v>-84460.730957608903</c:v>
                </c:pt>
                <c:pt idx="1698">
                  <c:v>-103953.710361009</c:v>
                </c:pt>
                <c:pt idx="1699">
                  <c:v>-47637.3862445696</c:v>
                </c:pt>
                <c:pt idx="1700">
                  <c:v>6583.7483847942203</c:v>
                </c:pt>
                <c:pt idx="1701">
                  <c:v>41492.663719382101</c:v>
                </c:pt>
                <c:pt idx="1702">
                  <c:v>5377.5175932599604</c:v>
                </c:pt>
                <c:pt idx="1703">
                  <c:v>-10089.550136667</c:v>
                </c:pt>
                <c:pt idx="1704">
                  <c:v>13288.152790104201</c:v>
                </c:pt>
                <c:pt idx="1705">
                  <c:v>-14145.7998204942</c:v>
                </c:pt>
                <c:pt idx="1706">
                  <c:v>-44552.976161149803</c:v>
                </c:pt>
                <c:pt idx="1707">
                  <c:v>14891.089333098</c:v>
                </c:pt>
                <c:pt idx="1708">
                  <c:v>136249.15171424201</c:v>
                </c:pt>
                <c:pt idx="1709">
                  <c:v>85932.339843852606</c:v>
                </c:pt>
                <c:pt idx="1710">
                  <c:v>105553.25774010899</c:v>
                </c:pt>
                <c:pt idx="1711">
                  <c:v>53273.668839546699</c:v>
                </c:pt>
                <c:pt idx="1712">
                  <c:v>55956.834200123201</c:v>
                </c:pt>
                <c:pt idx="1713">
                  <c:v>24919.858372510898</c:v>
                </c:pt>
                <c:pt idx="1714">
                  <c:v>33040.009115478497</c:v>
                </c:pt>
                <c:pt idx="1715">
                  <c:v>-46083.775986404602</c:v>
                </c:pt>
                <c:pt idx="1716">
                  <c:v>-26286.295691217201</c:v>
                </c:pt>
                <c:pt idx="1717">
                  <c:v>7050.1358332903601</c:v>
                </c:pt>
                <c:pt idx="1718">
                  <c:v>41821.935817865997</c:v>
                </c:pt>
                <c:pt idx="1719">
                  <c:v>43533.7790360004</c:v>
                </c:pt>
                <c:pt idx="1720">
                  <c:v>84170.717629569102</c:v>
                </c:pt>
                <c:pt idx="1721">
                  <c:v>56024.131869729499</c:v>
                </c:pt>
                <c:pt idx="1722">
                  <c:v>99143.988069905696</c:v>
                </c:pt>
                <c:pt idx="1723">
                  <c:v>74983.155690754007</c:v>
                </c:pt>
                <c:pt idx="1724">
                  <c:v>164665.38924916601</c:v>
                </c:pt>
                <c:pt idx="1725">
                  <c:v>75001.257931793007</c:v>
                </c:pt>
                <c:pt idx="1726">
                  <c:v>122913.348256055</c:v>
                </c:pt>
                <c:pt idx="1727">
                  <c:v>78067.277543071104</c:v>
                </c:pt>
                <c:pt idx="1728">
                  <c:v>172612.79429673299</c:v>
                </c:pt>
                <c:pt idx="1729">
                  <c:v>445847.951735863</c:v>
                </c:pt>
                <c:pt idx="1730">
                  <c:v>297917.106282208</c:v>
                </c:pt>
                <c:pt idx="1731">
                  <c:v>164491.56716425001</c:v>
                </c:pt>
                <c:pt idx="1732">
                  <c:v>116875.87675871501</c:v>
                </c:pt>
                <c:pt idx="1733">
                  <c:v>-27393.384511700398</c:v>
                </c:pt>
                <c:pt idx="1734">
                  <c:v>-64288.106921034203</c:v>
                </c:pt>
                <c:pt idx="1735">
                  <c:v>-7130.67696727977</c:v>
                </c:pt>
                <c:pt idx="1736">
                  <c:v>-33407.771280552399</c:v>
                </c:pt>
                <c:pt idx="1737">
                  <c:v>-36477.718301438101</c:v>
                </c:pt>
                <c:pt idx="1738">
                  <c:v>-103762.390581271</c:v>
                </c:pt>
                <c:pt idx="1739">
                  <c:v>-49147.152459565099</c:v>
                </c:pt>
                <c:pt idx="1740">
                  <c:v>12572.0851925764</c:v>
                </c:pt>
                <c:pt idx="1741">
                  <c:v>61028.134541005798</c:v>
                </c:pt>
                <c:pt idx="1742">
                  <c:v>-71357.667963939894</c:v>
                </c:pt>
                <c:pt idx="1743">
                  <c:v>-110913.675335166</c:v>
                </c:pt>
                <c:pt idx="1744">
                  <c:v>16956.489108587601</c:v>
                </c:pt>
                <c:pt idx="1745">
                  <c:v>-71051.506572487604</c:v>
                </c:pt>
                <c:pt idx="1746">
                  <c:v>1902.6299554611801</c:v>
                </c:pt>
                <c:pt idx="1747">
                  <c:v>-32089.909777029501</c:v>
                </c:pt>
                <c:pt idx="1748">
                  <c:v>22512.633365268401</c:v>
                </c:pt>
                <c:pt idx="1749">
                  <c:v>0</c:v>
                </c:pt>
                <c:pt idx="1750">
                  <c:v>0</c:v>
                </c:pt>
                <c:pt idx="1751">
                  <c:v>-49716.458986815</c:v>
                </c:pt>
                <c:pt idx="1752">
                  <c:v>-70177.523173157097</c:v>
                </c:pt>
                <c:pt idx="1753">
                  <c:v>-21099.534186241501</c:v>
                </c:pt>
                <c:pt idx="1754">
                  <c:v>-14256.526688907201</c:v>
                </c:pt>
                <c:pt idx="1755">
                  <c:v>163282.11180510899</c:v>
                </c:pt>
                <c:pt idx="1756">
                  <c:v>-73136.694178963502</c:v>
                </c:pt>
                <c:pt idx="1757">
                  <c:v>-16959.3444439632</c:v>
                </c:pt>
                <c:pt idx="1758">
                  <c:v>-50632.351684779598</c:v>
                </c:pt>
                <c:pt idx="1759">
                  <c:v>-73538.338717376697</c:v>
                </c:pt>
                <c:pt idx="1760">
                  <c:v>-67980.339342997104</c:v>
                </c:pt>
                <c:pt idx="1761">
                  <c:v>-4952.9462121935403</c:v>
                </c:pt>
                <c:pt idx="1762">
                  <c:v>-49258.877595103302</c:v>
                </c:pt>
                <c:pt idx="1763">
                  <c:v>39563.121364001498</c:v>
                </c:pt>
                <c:pt idx="1764">
                  <c:v>75971.953500204094</c:v>
                </c:pt>
                <c:pt idx="1765">
                  <c:v>55329.687782374698</c:v>
                </c:pt>
                <c:pt idx="1766">
                  <c:v>-80924.227367480198</c:v>
                </c:pt>
                <c:pt idx="1767">
                  <c:v>17845.694634289099</c:v>
                </c:pt>
                <c:pt idx="1768">
                  <c:v>-1933.6659419136199</c:v>
                </c:pt>
                <c:pt idx="1769">
                  <c:v>-88377.664893640496</c:v>
                </c:pt>
                <c:pt idx="1770">
                  <c:v>48374.954486823903</c:v>
                </c:pt>
                <c:pt idx="1771">
                  <c:v>39794.590705385002</c:v>
                </c:pt>
                <c:pt idx="1772">
                  <c:v>142243.40013555699</c:v>
                </c:pt>
                <c:pt idx="1773">
                  <c:v>123448.120803453</c:v>
                </c:pt>
                <c:pt idx="1774">
                  <c:v>123312.167686042</c:v>
                </c:pt>
                <c:pt idx="1775">
                  <c:v>108237.865517279</c:v>
                </c:pt>
                <c:pt idx="1776">
                  <c:v>128091.184146517</c:v>
                </c:pt>
                <c:pt idx="1777">
                  <c:v>-41244.374956597203</c:v>
                </c:pt>
                <c:pt idx="1778">
                  <c:v>-2360.3961964281598</c:v>
                </c:pt>
                <c:pt idx="1779">
                  <c:v>-91056.006202332093</c:v>
                </c:pt>
                <c:pt idx="1780">
                  <c:v>-77241.744956765004</c:v>
                </c:pt>
                <c:pt idx="1781">
                  <c:v>-70511.3608725628</c:v>
                </c:pt>
                <c:pt idx="1782">
                  <c:v>-36977.065699140003</c:v>
                </c:pt>
                <c:pt idx="1783">
                  <c:v>-76302.357751987103</c:v>
                </c:pt>
                <c:pt idx="1784">
                  <c:v>-123342.093522404</c:v>
                </c:pt>
                <c:pt idx="1785">
                  <c:v>-93375.126238129596</c:v>
                </c:pt>
                <c:pt idx="1786">
                  <c:v>-11984.9300839636</c:v>
                </c:pt>
                <c:pt idx="1787">
                  <c:v>-177616.51175827501</c:v>
                </c:pt>
                <c:pt idx="1788">
                  <c:v>-133174.25422751601</c:v>
                </c:pt>
                <c:pt idx="1789">
                  <c:v>-60516.718823708601</c:v>
                </c:pt>
                <c:pt idx="1790">
                  <c:v>0</c:v>
                </c:pt>
                <c:pt idx="1791">
                  <c:v>0</c:v>
                </c:pt>
                <c:pt idx="1792">
                  <c:v>-145584.25939466301</c:v>
                </c:pt>
                <c:pt idx="1793">
                  <c:v>-151351.52051426499</c:v>
                </c:pt>
                <c:pt idx="1794">
                  <c:v>220.98938579093399</c:v>
                </c:pt>
                <c:pt idx="1795">
                  <c:v>-11795.422387070401</c:v>
                </c:pt>
                <c:pt idx="1796">
                  <c:v>-11209.7444109362</c:v>
                </c:pt>
                <c:pt idx="1797">
                  <c:v>45368.969829485402</c:v>
                </c:pt>
                <c:pt idx="1798">
                  <c:v>94944.224519743802</c:v>
                </c:pt>
                <c:pt idx="1799">
                  <c:v>125723.65875019001</c:v>
                </c:pt>
                <c:pt idx="1800">
                  <c:v>83616.884133916799</c:v>
                </c:pt>
                <c:pt idx="1801">
                  <c:v>66442.871193875399</c:v>
                </c:pt>
                <c:pt idx="1802">
                  <c:v>-13226.9586365492</c:v>
                </c:pt>
                <c:pt idx="1803">
                  <c:v>-22717.7667032668</c:v>
                </c:pt>
                <c:pt idx="1804">
                  <c:v>154060.604966963</c:v>
                </c:pt>
                <c:pt idx="1805">
                  <c:v>32219.5730448018</c:v>
                </c:pt>
                <c:pt idx="1806">
                  <c:v>37355.635941332803</c:v>
                </c:pt>
                <c:pt idx="1807">
                  <c:v>-14609.4948913484</c:v>
                </c:pt>
                <c:pt idx="1808">
                  <c:v>-41603.569568208397</c:v>
                </c:pt>
                <c:pt idx="1809">
                  <c:v>140056.39021245699</c:v>
                </c:pt>
                <c:pt idx="1810">
                  <c:v>60140.034489660102</c:v>
                </c:pt>
                <c:pt idx="1811">
                  <c:v>10285.4515981612</c:v>
                </c:pt>
                <c:pt idx="1812">
                  <c:v>44815.153454980202</c:v>
                </c:pt>
                <c:pt idx="1813">
                  <c:v>-4430.5510684871997</c:v>
                </c:pt>
                <c:pt idx="1814">
                  <c:v>-36025.730211814902</c:v>
                </c:pt>
                <c:pt idx="1815">
                  <c:v>119300.52432710399</c:v>
                </c:pt>
                <c:pt idx="1816">
                  <c:v>156551.485176961</c:v>
                </c:pt>
                <c:pt idx="1817">
                  <c:v>105987.524286277</c:v>
                </c:pt>
                <c:pt idx="1818">
                  <c:v>-13249.248456781001</c:v>
                </c:pt>
                <c:pt idx="1819">
                  <c:v>2965.5752427746502</c:v>
                </c:pt>
                <c:pt idx="1820">
                  <c:v>5556.2086530553897</c:v>
                </c:pt>
                <c:pt idx="1821">
                  <c:v>133790.81022129199</c:v>
                </c:pt>
                <c:pt idx="1822">
                  <c:v>125983.976271605</c:v>
                </c:pt>
                <c:pt idx="1823">
                  <c:v>-26935.8407383866</c:v>
                </c:pt>
                <c:pt idx="1824">
                  <c:v>58204.427835609597</c:v>
                </c:pt>
                <c:pt idx="1825">
                  <c:v>28971.319350616199</c:v>
                </c:pt>
                <c:pt idx="1826">
                  <c:v>-40052.342091742401</c:v>
                </c:pt>
                <c:pt idx="1827">
                  <c:v>150046.061520344</c:v>
                </c:pt>
                <c:pt idx="1828">
                  <c:v>137750.253691277</c:v>
                </c:pt>
                <c:pt idx="1829">
                  <c:v>52790.109818269899</c:v>
                </c:pt>
                <c:pt idx="1830">
                  <c:v>11720.1872459642</c:v>
                </c:pt>
                <c:pt idx="1831">
                  <c:v>-51999.120551478998</c:v>
                </c:pt>
                <c:pt idx="1832">
                  <c:v>-126282.66373067501</c:v>
                </c:pt>
                <c:pt idx="1833">
                  <c:v>-19342.0029791126</c:v>
                </c:pt>
                <c:pt idx="1834">
                  <c:v>-24330.630683235901</c:v>
                </c:pt>
                <c:pt idx="1835">
                  <c:v>-41366.099536386202</c:v>
                </c:pt>
                <c:pt idx="1836">
                  <c:v>-73638.685696700704</c:v>
                </c:pt>
                <c:pt idx="1837">
                  <c:v>-35978.167726352003</c:v>
                </c:pt>
                <c:pt idx="1838">
                  <c:v>-25922.966978955599</c:v>
                </c:pt>
                <c:pt idx="1839">
                  <c:v>36726.090063639902</c:v>
                </c:pt>
                <c:pt idx="1840">
                  <c:v>-10819.809493685099</c:v>
                </c:pt>
                <c:pt idx="1841">
                  <c:v>-101666.172451195</c:v>
                </c:pt>
                <c:pt idx="1842">
                  <c:v>-134003.552928694</c:v>
                </c:pt>
                <c:pt idx="1843">
                  <c:v>-124236.159133526</c:v>
                </c:pt>
                <c:pt idx="1844">
                  <c:v>-49707.008302212002</c:v>
                </c:pt>
                <c:pt idx="1845">
                  <c:v>-73715.143639907299</c:v>
                </c:pt>
                <c:pt idx="1846">
                  <c:v>-93308.502919593404</c:v>
                </c:pt>
                <c:pt idx="1847">
                  <c:v>-124643.68204915999</c:v>
                </c:pt>
                <c:pt idx="1848">
                  <c:v>-17456.622944250201</c:v>
                </c:pt>
                <c:pt idx="1849">
                  <c:v>-6732.1361889028303</c:v>
                </c:pt>
                <c:pt idx="1850">
                  <c:v>-75031.302643042203</c:v>
                </c:pt>
                <c:pt idx="1851">
                  <c:v>-7341.3022454071897</c:v>
                </c:pt>
                <c:pt idx="1852">
                  <c:v>40504.710674238697</c:v>
                </c:pt>
                <c:pt idx="1853">
                  <c:v>-44872.550530455803</c:v>
                </c:pt>
                <c:pt idx="1854">
                  <c:v>-36870.489286674201</c:v>
                </c:pt>
                <c:pt idx="1855">
                  <c:v>-13062.731868479599</c:v>
                </c:pt>
                <c:pt idx="1856">
                  <c:v>-72326.877944170206</c:v>
                </c:pt>
                <c:pt idx="1857">
                  <c:v>-123522.59963842299</c:v>
                </c:pt>
                <c:pt idx="1858">
                  <c:v>2564.2243068449802</c:v>
                </c:pt>
                <c:pt idx="1859">
                  <c:v>37737.181937770802</c:v>
                </c:pt>
                <c:pt idx="1860">
                  <c:v>81456.172669473002</c:v>
                </c:pt>
                <c:pt idx="1861">
                  <c:v>-138373.67429685101</c:v>
                </c:pt>
                <c:pt idx="1862">
                  <c:v>55671.6303488798</c:v>
                </c:pt>
                <c:pt idx="1863">
                  <c:v>-13668.485625502401</c:v>
                </c:pt>
                <c:pt idx="1864">
                  <c:v>27988.756148018401</c:v>
                </c:pt>
                <c:pt idx="1865">
                  <c:v>-9343.9406578297403</c:v>
                </c:pt>
                <c:pt idx="1866">
                  <c:v>128803.43713844501</c:v>
                </c:pt>
                <c:pt idx="1867">
                  <c:v>-35307.913415663497</c:v>
                </c:pt>
                <c:pt idx="1868">
                  <c:v>-67824.524761049295</c:v>
                </c:pt>
                <c:pt idx="1869">
                  <c:v>29615.496863767999</c:v>
                </c:pt>
                <c:pt idx="1870">
                  <c:v>25526.9984088159</c:v>
                </c:pt>
                <c:pt idx="1871">
                  <c:v>-39626.631721590296</c:v>
                </c:pt>
                <c:pt idx="1872">
                  <c:v>-88462.131871636302</c:v>
                </c:pt>
                <c:pt idx="1873">
                  <c:v>-73365.521119994504</c:v>
                </c:pt>
                <c:pt idx="1874">
                  <c:v>6251.9987969807298</c:v>
                </c:pt>
                <c:pt idx="1875">
                  <c:v>38727.446734739198</c:v>
                </c:pt>
                <c:pt idx="1876">
                  <c:v>123426.229743351</c:v>
                </c:pt>
                <c:pt idx="1877">
                  <c:v>29461.683153305101</c:v>
                </c:pt>
                <c:pt idx="1878">
                  <c:v>12313.424943297199</c:v>
                </c:pt>
                <c:pt idx="1879">
                  <c:v>7187.99210929727</c:v>
                </c:pt>
                <c:pt idx="1880">
                  <c:v>76953.791611578607</c:v>
                </c:pt>
                <c:pt idx="1881">
                  <c:v>30633.496083424201</c:v>
                </c:pt>
                <c:pt idx="1882">
                  <c:v>-8309.0825399547102</c:v>
                </c:pt>
                <c:pt idx="1883">
                  <c:v>-54050.606161085598</c:v>
                </c:pt>
                <c:pt idx="1884">
                  <c:v>29224.121188792698</c:v>
                </c:pt>
                <c:pt idx="1885">
                  <c:v>31700.6501327648</c:v>
                </c:pt>
                <c:pt idx="1886">
                  <c:v>123985.11500530801</c:v>
                </c:pt>
                <c:pt idx="1887">
                  <c:v>16474.114466385301</c:v>
                </c:pt>
                <c:pt idx="1888">
                  <c:v>-6648.1542417868604</c:v>
                </c:pt>
                <c:pt idx="1889">
                  <c:v>-43701.752515675398</c:v>
                </c:pt>
                <c:pt idx="1890">
                  <c:v>-71849.428538783701</c:v>
                </c:pt>
                <c:pt idx="1891">
                  <c:v>24382.981144602501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1B36-4F31-AA19-B2D337AE846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06643072"/>
        <c:axId val="806645368"/>
      </c:scatterChart>
      <c:valAx>
        <c:axId val="806643072"/>
        <c:scaling>
          <c:orientation val="maxMin"/>
          <c:max val="190"/>
          <c:min val="1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806645368"/>
        <c:crosses val="autoZero"/>
        <c:crossBetween val="midCat"/>
        <c:majorUnit val="20"/>
      </c:valAx>
      <c:valAx>
        <c:axId val="806645368"/>
        <c:scaling>
          <c:orientation val="minMax"/>
          <c:max val="1750000.0000000002"/>
          <c:min val="-750000"/>
        </c:scaling>
        <c:delete val="0"/>
        <c:axPos val="r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0664307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scatterChart>
        <c:scatterStyle val="smoothMarker"/>
        <c:varyColors val="0"/>
        <c:ser>
          <c:idx val="0"/>
          <c:order val="0"/>
          <c:tx>
            <c:strRef>
              <c:f>Sheet1!$C$1</c:f>
              <c:strCache>
                <c:ptCount val="1"/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xVal>
            <c:numRef>
              <c:f>Sheet1!$B$2:$B$292</c:f>
              <c:numCache>
                <c:formatCode>General</c:formatCode>
                <c:ptCount val="291"/>
                <c:pt idx="0">
                  <c:v>185.38874724170299</c:v>
                </c:pt>
                <c:pt idx="1">
                  <c:v>185.381086990184</c:v>
                </c:pt>
                <c:pt idx="2">
                  <c:v>185.37342673866601</c:v>
                </c:pt>
                <c:pt idx="3">
                  <c:v>185.365766487147</c:v>
                </c:pt>
                <c:pt idx="4">
                  <c:v>185.35810623562799</c:v>
                </c:pt>
                <c:pt idx="5">
                  <c:v>185.350445984109</c:v>
                </c:pt>
                <c:pt idx="6">
                  <c:v>185.34278573258999</c:v>
                </c:pt>
                <c:pt idx="7">
                  <c:v>185.335125481071</c:v>
                </c:pt>
                <c:pt idx="8">
                  <c:v>185.32746522955301</c:v>
                </c:pt>
                <c:pt idx="9">
                  <c:v>185.319804978034</c:v>
                </c:pt>
                <c:pt idx="10">
                  <c:v>185.31214472651499</c:v>
                </c:pt>
                <c:pt idx="11">
                  <c:v>185.304484474996</c:v>
                </c:pt>
                <c:pt idx="12">
                  <c:v>185.29682422347699</c:v>
                </c:pt>
                <c:pt idx="13">
                  <c:v>185.289163971959</c:v>
                </c:pt>
                <c:pt idx="14">
                  <c:v>185.28150372044001</c:v>
                </c:pt>
                <c:pt idx="15">
                  <c:v>185.273843468921</c:v>
                </c:pt>
                <c:pt idx="16">
                  <c:v>185.26618321740199</c:v>
                </c:pt>
                <c:pt idx="17">
                  <c:v>185.258522965883</c:v>
                </c:pt>
                <c:pt idx="18">
                  <c:v>185.25086271436399</c:v>
                </c:pt>
                <c:pt idx="19">
                  <c:v>185.243202462846</c:v>
                </c:pt>
                <c:pt idx="20">
                  <c:v>185.23554221132699</c:v>
                </c:pt>
                <c:pt idx="21">
                  <c:v>185.227881959808</c:v>
                </c:pt>
                <c:pt idx="22">
                  <c:v>185.22022170828899</c:v>
                </c:pt>
                <c:pt idx="23">
                  <c:v>185.21256145677</c:v>
                </c:pt>
                <c:pt idx="24">
                  <c:v>185.20490120525099</c:v>
                </c:pt>
                <c:pt idx="25">
                  <c:v>185.197240953733</c:v>
                </c:pt>
                <c:pt idx="26">
                  <c:v>185.18958070221399</c:v>
                </c:pt>
                <c:pt idx="27">
                  <c:v>184.048203225908</c:v>
                </c:pt>
                <c:pt idx="28">
                  <c:v>184.04054297438901</c:v>
                </c:pt>
                <c:pt idx="29">
                  <c:v>184.03288272287099</c:v>
                </c:pt>
                <c:pt idx="30">
                  <c:v>184.02522247135201</c:v>
                </c:pt>
                <c:pt idx="31">
                  <c:v>184.017562219833</c:v>
                </c:pt>
                <c:pt idx="32">
                  <c:v>184.00990196831401</c:v>
                </c:pt>
                <c:pt idx="33">
                  <c:v>184.002241716795</c:v>
                </c:pt>
                <c:pt idx="34">
                  <c:v>183.99458146527601</c:v>
                </c:pt>
                <c:pt idx="35">
                  <c:v>183.986921213758</c:v>
                </c:pt>
                <c:pt idx="36">
                  <c:v>183.97926096223901</c:v>
                </c:pt>
                <c:pt idx="37">
                  <c:v>183.97160071072</c:v>
                </c:pt>
                <c:pt idx="38">
                  <c:v>183.96394045920101</c:v>
                </c:pt>
                <c:pt idx="39">
                  <c:v>183.956280207682</c:v>
                </c:pt>
                <c:pt idx="40">
                  <c:v>183.94861995616401</c:v>
                </c:pt>
                <c:pt idx="41">
                  <c:v>183.940959704645</c:v>
                </c:pt>
                <c:pt idx="42">
                  <c:v>183.93329945312601</c:v>
                </c:pt>
                <c:pt idx="43">
                  <c:v>183.925639201607</c:v>
                </c:pt>
                <c:pt idx="44">
                  <c:v>183.91797895008801</c:v>
                </c:pt>
                <c:pt idx="45">
                  <c:v>183.910318698569</c:v>
                </c:pt>
                <c:pt idx="46">
                  <c:v>183.90265844705101</c:v>
                </c:pt>
                <c:pt idx="47">
                  <c:v>183.894998195532</c:v>
                </c:pt>
                <c:pt idx="48">
                  <c:v>180.48618626965299</c:v>
                </c:pt>
                <c:pt idx="49">
                  <c:v>180.478526018134</c:v>
                </c:pt>
                <c:pt idx="50">
                  <c:v>180.47086576661499</c:v>
                </c:pt>
                <c:pt idx="51">
                  <c:v>180.46320551509601</c:v>
                </c:pt>
                <c:pt idx="52">
                  <c:v>180.45554526357799</c:v>
                </c:pt>
                <c:pt idx="53">
                  <c:v>180.447885012059</c:v>
                </c:pt>
                <c:pt idx="54">
                  <c:v>180.44022476053999</c:v>
                </c:pt>
                <c:pt idx="55">
                  <c:v>180.43256450902101</c:v>
                </c:pt>
                <c:pt idx="56">
                  <c:v>180.42490425750199</c:v>
                </c:pt>
                <c:pt idx="57">
                  <c:v>180.417244005984</c:v>
                </c:pt>
                <c:pt idx="58">
                  <c:v>180.40958375446499</c:v>
                </c:pt>
                <c:pt idx="59">
                  <c:v>180.401923502946</c:v>
                </c:pt>
                <c:pt idx="60">
                  <c:v>180.39426325142699</c:v>
                </c:pt>
                <c:pt idx="61">
                  <c:v>180.38660299990801</c:v>
                </c:pt>
                <c:pt idx="62">
                  <c:v>180.37894274838899</c:v>
                </c:pt>
                <c:pt idx="63">
                  <c:v>180.371282496871</c:v>
                </c:pt>
                <c:pt idx="64">
                  <c:v>180.36362224535199</c:v>
                </c:pt>
                <c:pt idx="65">
                  <c:v>180.35596199383301</c:v>
                </c:pt>
                <c:pt idx="66">
                  <c:v>180.34830174231399</c:v>
                </c:pt>
                <c:pt idx="67">
                  <c:v>180.34064149079501</c:v>
                </c:pt>
                <c:pt idx="68">
                  <c:v>180.33298123927599</c:v>
                </c:pt>
                <c:pt idx="69">
                  <c:v>180.325320987758</c:v>
                </c:pt>
                <c:pt idx="70">
                  <c:v>180.31766073623899</c:v>
                </c:pt>
                <c:pt idx="71">
                  <c:v>180.31000048472001</c:v>
                </c:pt>
                <c:pt idx="72">
                  <c:v>180.30234023320099</c:v>
                </c:pt>
                <c:pt idx="73">
                  <c:v>180.29467998168201</c:v>
                </c:pt>
                <c:pt idx="74">
                  <c:v>180.287019730163</c:v>
                </c:pt>
                <c:pt idx="75">
                  <c:v>180.27935947864501</c:v>
                </c:pt>
                <c:pt idx="76">
                  <c:v>180.27169922712599</c:v>
                </c:pt>
                <c:pt idx="77">
                  <c:v>180.26403897560701</c:v>
                </c:pt>
                <c:pt idx="78">
                  <c:v>180.25637872408799</c:v>
                </c:pt>
                <c:pt idx="79">
                  <c:v>180.24871847256901</c:v>
                </c:pt>
                <c:pt idx="80">
                  <c:v>180.24105822105</c:v>
                </c:pt>
                <c:pt idx="81">
                  <c:v>180.23339796953201</c:v>
                </c:pt>
                <c:pt idx="82">
                  <c:v>180.22573771801299</c:v>
                </c:pt>
                <c:pt idx="83">
                  <c:v>180.21807746649401</c:v>
                </c:pt>
                <c:pt idx="84">
                  <c:v>180.210417214975</c:v>
                </c:pt>
                <c:pt idx="85">
                  <c:v>180.20275696345601</c:v>
                </c:pt>
                <c:pt idx="86">
                  <c:v>180.195096711937</c:v>
                </c:pt>
                <c:pt idx="87">
                  <c:v>180.18743646041901</c:v>
                </c:pt>
                <c:pt idx="88">
                  <c:v>180.17977620889999</c:v>
                </c:pt>
                <c:pt idx="89">
                  <c:v>178.724328420322</c:v>
                </c:pt>
                <c:pt idx="90">
                  <c:v>178.71666816880401</c:v>
                </c:pt>
                <c:pt idx="91">
                  <c:v>178.70900791728499</c:v>
                </c:pt>
                <c:pt idx="92">
                  <c:v>178.70134766576601</c:v>
                </c:pt>
                <c:pt idx="93">
                  <c:v>178.69368741424699</c:v>
                </c:pt>
                <c:pt idx="94">
                  <c:v>178.68602716272801</c:v>
                </c:pt>
                <c:pt idx="95">
                  <c:v>178.678366911209</c:v>
                </c:pt>
                <c:pt idx="96">
                  <c:v>178.67070665969101</c:v>
                </c:pt>
                <c:pt idx="97">
                  <c:v>178.66304640817199</c:v>
                </c:pt>
                <c:pt idx="98">
                  <c:v>178.65538615665301</c:v>
                </c:pt>
                <c:pt idx="99">
                  <c:v>178.647725905134</c:v>
                </c:pt>
                <c:pt idx="100">
                  <c:v>178.64006565361501</c:v>
                </c:pt>
                <c:pt idx="101">
                  <c:v>178.632405402096</c:v>
                </c:pt>
                <c:pt idx="102">
                  <c:v>178.62474515057801</c:v>
                </c:pt>
                <c:pt idx="103">
                  <c:v>178.61708489905899</c:v>
                </c:pt>
                <c:pt idx="104">
                  <c:v>178.60942464754001</c:v>
                </c:pt>
                <c:pt idx="105">
                  <c:v>178.601764396021</c:v>
                </c:pt>
                <c:pt idx="106">
                  <c:v>178.59410414450201</c:v>
                </c:pt>
                <c:pt idx="107">
                  <c:v>178.586443892983</c:v>
                </c:pt>
                <c:pt idx="108">
                  <c:v>178.57878364146501</c:v>
                </c:pt>
                <c:pt idx="109">
                  <c:v>178.571123389946</c:v>
                </c:pt>
                <c:pt idx="110">
                  <c:v>178.56346313842701</c:v>
                </c:pt>
                <c:pt idx="111">
                  <c:v>178.555802886908</c:v>
                </c:pt>
                <c:pt idx="112">
                  <c:v>178.54814263538901</c:v>
                </c:pt>
                <c:pt idx="113">
                  <c:v>178.54048238387</c:v>
                </c:pt>
                <c:pt idx="114">
                  <c:v>178.53282213235201</c:v>
                </c:pt>
                <c:pt idx="115">
                  <c:v>177.38378440452701</c:v>
                </c:pt>
                <c:pt idx="116">
                  <c:v>177.37612415300899</c:v>
                </c:pt>
                <c:pt idx="117">
                  <c:v>177.36846390149</c:v>
                </c:pt>
                <c:pt idx="118">
                  <c:v>177.36080364997099</c:v>
                </c:pt>
                <c:pt idx="119">
                  <c:v>177.353143398452</c:v>
                </c:pt>
                <c:pt idx="120">
                  <c:v>177.34548314693299</c:v>
                </c:pt>
                <c:pt idx="121">
                  <c:v>177.33782289541401</c:v>
                </c:pt>
                <c:pt idx="122">
                  <c:v>177.33016264389599</c:v>
                </c:pt>
                <c:pt idx="123">
                  <c:v>177.322502392377</c:v>
                </c:pt>
                <c:pt idx="124">
                  <c:v>177.31484214085799</c:v>
                </c:pt>
                <c:pt idx="125">
                  <c:v>177.30718188933901</c:v>
                </c:pt>
                <c:pt idx="126">
                  <c:v>177.29952163781999</c:v>
                </c:pt>
                <c:pt idx="127">
                  <c:v>177.29186138630101</c:v>
                </c:pt>
                <c:pt idx="128">
                  <c:v>177.28420113478299</c:v>
                </c:pt>
                <c:pt idx="129">
                  <c:v>177.276540883264</c:v>
                </c:pt>
                <c:pt idx="130">
                  <c:v>177.26888063174499</c:v>
                </c:pt>
                <c:pt idx="131">
                  <c:v>176.92416931339801</c:v>
                </c:pt>
                <c:pt idx="132">
                  <c:v>176.916509061879</c:v>
                </c:pt>
                <c:pt idx="133">
                  <c:v>176.90884881036001</c:v>
                </c:pt>
                <c:pt idx="134">
                  <c:v>176.901188558841</c:v>
                </c:pt>
                <c:pt idx="135">
                  <c:v>176.89352830732199</c:v>
                </c:pt>
                <c:pt idx="136">
                  <c:v>176.885868055803</c:v>
                </c:pt>
                <c:pt idx="137">
                  <c:v>176.87820780428501</c:v>
                </c:pt>
                <c:pt idx="138">
                  <c:v>176.870547552766</c:v>
                </c:pt>
                <c:pt idx="139">
                  <c:v>176.86288730124701</c:v>
                </c:pt>
                <c:pt idx="140">
                  <c:v>176.855227049728</c:v>
                </c:pt>
                <c:pt idx="141">
                  <c:v>176.84756679820899</c:v>
                </c:pt>
                <c:pt idx="142">
                  <c:v>176.839906546691</c:v>
                </c:pt>
                <c:pt idx="143">
                  <c:v>176.83224629517201</c:v>
                </c:pt>
                <c:pt idx="144">
                  <c:v>176.824586043653</c:v>
                </c:pt>
                <c:pt idx="145">
                  <c:v>176.81692579213399</c:v>
                </c:pt>
                <c:pt idx="146">
                  <c:v>176.809265540615</c:v>
                </c:pt>
                <c:pt idx="147">
                  <c:v>176.80160528909599</c:v>
                </c:pt>
                <c:pt idx="148">
                  <c:v>176.793945037578</c:v>
                </c:pt>
                <c:pt idx="149">
                  <c:v>176.78628478605901</c:v>
                </c:pt>
                <c:pt idx="150">
                  <c:v>176.77862453454</c:v>
                </c:pt>
                <c:pt idx="151">
                  <c:v>176.77096428302099</c:v>
                </c:pt>
                <c:pt idx="152">
                  <c:v>175.430420267226</c:v>
                </c:pt>
                <c:pt idx="153">
                  <c:v>175.42276001570701</c:v>
                </c:pt>
                <c:pt idx="154">
                  <c:v>175.415099764188</c:v>
                </c:pt>
                <c:pt idx="155">
                  <c:v>175.40743951267001</c:v>
                </c:pt>
                <c:pt idx="156">
                  <c:v>175.399779261151</c:v>
                </c:pt>
                <c:pt idx="157">
                  <c:v>175.39211900963201</c:v>
                </c:pt>
                <c:pt idx="158">
                  <c:v>175.384458758113</c:v>
                </c:pt>
                <c:pt idx="159">
                  <c:v>175.37679850659401</c:v>
                </c:pt>
                <c:pt idx="160">
                  <c:v>175.369138255075</c:v>
                </c:pt>
                <c:pt idx="161">
                  <c:v>175.36147800355701</c:v>
                </c:pt>
                <c:pt idx="162">
                  <c:v>175.353817752038</c:v>
                </c:pt>
                <c:pt idx="163">
                  <c:v>175.34615750051901</c:v>
                </c:pt>
                <c:pt idx="164">
                  <c:v>175.338497249</c:v>
                </c:pt>
                <c:pt idx="165">
                  <c:v>175.33083699748099</c:v>
                </c:pt>
                <c:pt idx="166">
                  <c:v>175.323176745962</c:v>
                </c:pt>
                <c:pt idx="167">
                  <c:v>175.31551649444401</c:v>
                </c:pt>
                <c:pt idx="168">
                  <c:v>175.307856242925</c:v>
                </c:pt>
                <c:pt idx="169">
                  <c:v>175.30019599140601</c:v>
                </c:pt>
                <c:pt idx="170">
                  <c:v>175.292535739887</c:v>
                </c:pt>
                <c:pt idx="171">
                  <c:v>175.28487548836799</c:v>
                </c:pt>
                <c:pt idx="172">
                  <c:v>175.277215236849</c:v>
                </c:pt>
                <c:pt idx="173">
                  <c:v>175.26955498533101</c:v>
                </c:pt>
                <c:pt idx="174">
                  <c:v>175.261894733812</c:v>
                </c:pt>
                <c:pt idx="175">
                  <c:v>175.25423448229299</c:v>
                </c:pt>
                <c:pt idx="176">
                  <c:v>175.246574230774</c:v>
                </c:pt>
                <c:pt idx="177">
                  <c:v>175.23891397925499</c:v>
                </c:pt>
                <c:pt idx="178">
                  <c:v>175.231253727737</c:v>
                </c:pt>
                <c:pt idx="179">
                  <c:v>175.22359347621801</c:v>
                </c:pt>
                <c:pt idx="180">
                  <c:v>175.215933224699</c:v>
                </c:pt>
                <c:pt idx="181">
                  <c:v>175.20827297317999</c:v>
                </c:pt>
                <c:pt idx="182">
                  <c:v>175.200612721661</c:v>
                </c:pt>
                <c:pt idx="183">
                  <c:v>175.19295247014199</c:v>
                </c:pt>
                <c:pt idx="184">
                  <c:v>175.185292218624</c:v>
                </c:pt>
                <c:pt idx="185">
                  <c:v>175.17763196710499</c:v>
                </c:pt>
                <c:pt idx="186">
                  <c:v>175.169971715586</c:v>
                </c:pt>
                <c:pt idx="187">
                  <c:v>175.16231146406699</c:v>
                </c:pt>
                <c:pt idx="188">
                  <c:v>175.154651212548</c:v>
                </c:pt>
                <c:pt idx="189">
                  <c:v>175.14699096102899</c:v>
                </c:pt>
                <c:pt idx="190">
                  <c:v>175.139330709511</c:v>
                </c:pt>
                <c:pt idx="191">
                  <c:v>175.13167045799199</c:v>
                </c:pt>
                <c:pt idx="192">
                  <c:v>175.124010206473</c:v>
                </c:pt>
                <c:pt idx="193">
                  <c:v>175.11634995495399</c:v>
                </c:pt>
                <c:pt idx="194">
                  <c:v>174.58779260015501</c:v>
                </c:pt>
                <c:pt idx="195">
                  <c:v>174.580132348636</c:v>
                </c:pt>
                <c:pt idx="196">
                  <c:v>174.57247209711699</c:v>
                </c:pt>
                <c:pt idx="197">
                  <c:v>174.564811845598</c:v>
                </c:pt>
                <c:pt idx="198">
                  <c:v>174.55715159408001</c:v>
                </c:pt>
                <c:pt idx="199">
                  <c:v>174.549491342561</c:v>
                </c:pt>
                <c:pt idx="200">
                  <c:v>174.54183109104201</c:v>
                </c:pt>
                <c:pt idx="201">
                  <c:v>174.534170839523</c:v>
                </c:pt>
                <c:pt idx="202">
                  <c:v>174.52651058800399</c:v>
                </c:pt>
                <c:pt idx="203">
                  <c:v>174.518850336485</c:v>
                </c:pt>
                <c:pt idx="204">
                  <c:v>174.51119008496701</c:v>
                </c:pt>
                <c:pt idx="205">
                  <c:v>174.503529833448</c:v>
                </c:pt>
                <c:pt idx="206">
                  <c:v>174.49586958192901</c:v>
                </c:pt>
                <c:pt idx="207">
                  <c:v>174.48820933041</c:v>
                </c:pt>
                <c:pt idx="208">
                  <c:v>174.48054907889099</c:v>
                </c:pt>
                <c:pt idx="209">
                  <c:v>174.472888827372</c:v>
                </c:pt>
                <c:pt idx="210">
                  <c:v>174.46522857585401</c:v>
                </c:pt>
                <c:pt idx="211">
                  <c:v>174.457568324335</c:v>
                </c:pt>
                <c:pt idx="212">
                  <c:v>174.44990807281599</c:v>
                </c:pt>
                <c:pt idx="213">
                  <c:v>174.442247821297</c:v>
                </c:pt>
                <c:pt idx="214">
                  <c:v>174.43458756977799</c:v>
                </c:pt>
                <c:pt idx="215">
                  <c:v>174.42692731826</c:v>
                </c:pt>
                <c:pt idx="216">
                  <c:v>174.41926706674101</c:v>
                </c:pt>
                <c:pt idx="217">
                  <c:v>174.411606815222</c:v>
                </c:pt>
                <c:pt idx="218">
                  <c:v>174.40394656370299</c:v>
                </c:pt>
                <c:pt idx="219">
                  <c:v>174.396286312184</c:v>
                </c:pt>
                <c:pt idx="220">
                  <c:v>174.38862606066499</c:v>
                </c:pt>
                <c:pt idx="221">
                  <c:v>174.380965809147</c:v>
                </c:pt>
                <c:pt idx="222">
                  <c:v>174.37330555762799</c:v>
                </c:pt>
                <c:pt idx="223">
                  <c:v>174.365645306109</c:v>
                </c:pt>
                <c:pt idx="224">
                  <c:v>174.35798505458999</c:v>
                </c:pt>
                <c:pt idx="225">
                  <c:v>174.350324803071</c:v>
                </c:pt>
                <c:pt idx="226">
                  <c:v>174.34266455155199</c:v>
                </c:pt>
                <c:pt idx="227">
                  <c:v>174.335004300034</c:v>
                </c:pt>
                <c:pt idx="228">
                  <c:v>174.32734404851499</c:v>
                </c:pt>
                <c:pt idx="229">
                  <c:v>174.319683796996</c:v>
                </c:pt>
                <c:pt idx="230">
                  <c:v>174.31202354547699</c:v>
                </c:pt>
                <c:pt idx="231">
                  <c:v>174.304363293958</c:v>
                </c:pt>
                <c:pt idx="232">
                  <c:v>174.29670304243899</c:v>
                </c:pt>
                <c:pt idx="233">
                  <c:v>174.289042790921</c:v>
                </c:pt>
                <c:pt idx="234">
                  <c:v>174.28138253940199</c:v>
                </c:pt>
                <c:pt idx="235">
                  <c:v>174.273722287883</c:v>
                </c:pt>
                <c:pt idx="236">
                  <c:v>174.26606203636399</c:v>
                </c:pt>
                <c:pt idx="237">
                  <c:v>174.25840178484501</c:v>
                </c:pt>
                <c:pt idx="238">
                  <c:v>174.25074153332599</c:v>
                </c:pt>
                <c:pt idx="239">
                  <c:v>174.243081281808</c:v>
                </c:pt>
                <c:pt idx="240">
                  <c:v>174.23542103028899</c:v>
                </c:pt>
                <c:pt idx="241">
                  <c:v>174.22776077877</c:v>
                </c:pt>
                <c:pt idx="242">
                  <c:v>174.22010052725099</c:v>
                </c:pt>
                <c:pt idx="243">
                  <c:v>174.21244027573201</c:v>
                </c:pt>
                <c:pt idx="244">
                  <c:v>174.20478002421299</c:v>
                </c:pt>
                <c:pt idx="245">
                  <c:v>174.197119772695</c:v>
                </c:pt>
                <c:pt idx="246">
                  <c:v>174.18945952117599</c:v>
                </c:pt>
                <c:pt idx="247">
                  <c:v>174.18179926965701</c:v>
                </c:pt>
                <c:pt idx="248">
                  <c:v>174.17413901813799</c:v>
                </c:pt>
                <c:pt idx="249">
                  <c:v>174.16647876661901</c:v>
                </c:pt>
                <c:pt idx="250">
                  <c:v>174.15881851509999</c:v>
                </c:pt>
                <c:pt idx="251">
                  <c:v>174.151158263582</c:v>
                </c:pt>
                <c:pt idx="252">
                  <c:v>174.14349801206299</c:v>
                </c:pt>
                <c:pt idx="253">
                  <c:v>174.13583776054401</c:v>
                </c:pt>
                <c:pt idx="254">
                  <c:v>174.12817750902499</c:v>
                </c:pt>
                <c:pt idx="255">
                  <c:v>173.821767448272</c:v>
                </c:pt>
                <c:pt idx="256">
                  <c:v>173.81410719675301</c:v>
                </c:pt>
                <c:pt idx="257">
                  <c:v>173.806446945234</c:v>
                </c:pt>
                <c:pt idx="258">
                  <c:v>173.79878669371601</c:v>
                </c:pt>
                <c:pt idx="259">
                  <c:v>173.791126442197</c:v>
                </c:pt>
                <c:pt idx="260">
                  <c:v>173.78346619067801</c:v>
                </c:pt>
                <c:pt idx="261">
                  <c:v>173.775805939159</c:v>
                </c:pt>
                <c:pt idx="262">
                  <c:v>173.76814568763999</c:v>
                </c:pt>
                <c:pt idx="263">
                  <c:v>173.760485436121</c:v>
                </c:pt>
                <c:pt idx="264">
                  <c:v>173.75282518460301</c:v>
                </c:pt>
                <c:pt idx="265">
                  <c:v>173.745164933084</c:v>
                </c:pt>
                <c:pt idx="266">
                  <c:v>173.73750468156501</c:v>
                </c:pt>
                <c:pt idx="267">
                  <c:v>173.729844430046</c:v>
                </c:pt>
                <c:pt idx="268">
                  <c:v>173.72218417852699</c:v>
                </c:pt>
                <c:pt idx="269">
                  <c:v>173.714523927008</c:v>
                </c:pt>
                <c:pt idx="270">
                  <c:v>173.70686367549001</c:v>
                </c:pt>
                <c:pt idx="271">
                  <c:v>173.699203423971</c:v>
                </c:pt>
                <c:pt idx="272">
                  <c:v>173.69154317245199</c:v>
                </c:pt>
                <c:pt idx="273">
                  <c:v>173.683882920933</c:v>
                </c:pt>
                <c:pt idx="274">
                  <c:v>173.67622266941399</c:v>
                </c:pt>
                <c:pt idx="275">
                  <c:v>173.668562417895</c:v>
                </c:pt>
                <c:pt idx="276">
                  <c:v>173.66090216637701</c:v>
                </c:pt>
                <c:pt idx="277">
                  <c:v>173.653241914858</c:v>
                </c:pt>
                <c:pt idx="278">
                  <c:v>173.64558166333899</c:v>
                </c:pt>
                <c:pt idx="279">
                  <c:v>173.63792141182</c:v>
                </c:pt>
                <c:pt idx="280">
                  <c:v>173.63026116030099</c:v>
                </c:pt>
                <c:pt idx="281">
                  <c:v>173.622600908783</c:v>
                </c:pt>
                <c:pt idx="282">
                  <c:v>173.61494065726399</c:v>
                </c:pt>
                <c:pt idx="283">
                  <c:v>173.607280405745</c:v>
                </c:pt>
                <c:pt idx="284">
                  <c:v>173.59962015422599</c:v>
                </c:pt>
                <c:pt idx="285">
                  <c:v>173.591959902707</c:v>
                </c:pt>
                <c:pt idx="286">
                  <c:v>173.58429965118799</c:v>
                </c:pt>
                <c:pt idx="287">
                  <c:v>173.57663939967</c:v>
                </c:pt>
                <c:pt idx="288">
                  <c:v>173.56897914815099</c:v>
                </c:pt>
                <c:pt idx="289">
                  <c:v>173.561318896632</c:v>
                </c:pt>
                <c:pt idx="290">
                  <c:v>173.55365864511299</c:v>
                </c:pt>
              </c:numCache>
            </c:numRef>
          </c:xVal>
          <c:yVal>
            <c:numRef>
              <c:f>Sheet1!$C$2:$C$292</c:f>
              <c:numCache>
                <c:formatCode>General</c:formatCode>
                <c:ptCount val="291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0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0</c:v>
                </c:pt>
                <c:pt idx="110">
                  <c:v>0</c:v>
                </c:pt>
                <c:pt idx="111">
                  <c:v>0</c:v>
                </c:pt>
                <c:pt idx="112">
                  <c:v>0</c:v>
                </c:pt>
                <c:pt idx="113">
                  <c:v>0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0</c:v>
                </c:pt>
                <c:pt idx="124">
                  <c:v>0</c:v>
                </c:pt>
                <c:pt idx="125">
                  <c:v>0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  <c:pt idx="133">
                  <c:v>0</c:v>
                </c:pt>
                <c:pt idx="134">
                  <c:v>0</c:v>
                </c:pt>
                <c:pt idx="135">
                  <c:v>0</c:v>
                </c:pt>
                <c:pt idx="136">
                  <c:v>0</c:v>
                </c:pt>
                <c:pt idx="137">
                  <c:v>0</c:v>
                </c:pt>
                <c:pt idx="138">
                  <c:v>0</c:v>
                </c:pt>
                <c:pt idx="139">
                  <c:v>0</c:v>
                </c:pt>
                <c:pt idx="140">
                  <c:v>0</c:v>
                </c:pt>
                <c:pt idx="141">
                  <c:v>0</c:v>
                </c:pt>
                <c:pt idx="142">
                  <c:v>0</c:v>
                </c:pt>
                <c:pt idx="143">
                  <c:v>0</c:v>
                </c:pt>
                <c:pt idx="144">
                  <c:v>0</c:v>
                </c:pt>
                <c:pt idx="145">
                  <c:v>0</c:v>
                </c:pt>
                <c:pt idx="146">
                  <c:v>0</c:v>
                </c:pt>
                <c:pt idx="147">
                  <c:v>0</c:v>
                </c:pt>
                <c:pt idx="148">
                  <c:v>0</c:v>
                </c:pt>
                <c:pt idx="149">
                  <c:v>0</c:v>
                </c:pt>
                <c:pt idx="150">
                  <c:v>0</c:v>
                </c:pt>
                <c:pt idx="151">
                  <c:v>0</c:v>
                </c:pt>
                <c:pt idx="152">
                  <c:v>0</c:v>
                </c:pt>
                <c:pt idx="153">
                  <c:v>0</c:v>
                </c:pt>
                <c:pt idx="154">
                  <c:v>0</c:v>
                </c:pt>
                <c:pt idx="155">
                  <c:v>0</c:v>
                </c:pt>
                <c:pt idx="156">
                  <c:v>0</c:v>
                </c:pt>
                <c:pt idx="157">
                  <c:v>0</c:v>
                </c:pt>
                <c:pt idx="158">
                  <c:v>0</c:v>
                </c:pt>
                <c:pt idx="159">
                  <c:v>0</c:v>
                </c:pt>
                <c:pt idx="160">
                  <c:v>0</c:v>
                </c:pt>
                <c:pt idx="161">
                  <c:v>0</c:v>
                </c:pt>
                <c:pt idx="162">
                  <c:v>0</c:v>
                </c:pt>
                <c:pt idx="163">
                  <c:v>0</c:v>
                </c:pt>
                <c:pt idx="164">
                  <c:v>0</c:v>
                </c:pt>
                <c:pt idx="165">
                  <c:v>0</c:v>
                </c:pt>
                <c:pt idx="166">
                  <c:v>0</c:v>
                </c:pt>
                <c:pt idx="167">
                  <c:v>0</c:v>
                </c:pt>
                <c:pt idx="168">
                  <c:v>0</c:v>
                </c:pt>
                <c:pt idx="169">
                  <c:v>0</c:v>
                </c:pt>
                <c:pt idx="170">
                  <c:v>0</c:v>
                </c:pt>
                <c:pt idx="171">
                  <c:v>0</c:v>
                </c:pt>
                <c:pt idx="172">
                  <c:v>0</c:v>
                </c:pt>
                <c:pt idx="173">
                  <c:v>0</c:v>
                </c:pt>
                <c:pt idx="174">
                  <c:v>0</c:v>
                </c:pt>
                <c:pt idx="175">
                  <c:v>0</c:v>
                </c:pt>
                <c:pt idx="176">
                  <c:v>0</c:v>
                </c:pt>
                <c:pt idx="177">
                  <c:v>0</c:v>
                </c:pt>
                <c:pt idx="178">
                  <c:v>0</c:v>
                </c:pt>
                <c:pt idx="179">
                  <c:v>0</c:v>
                </c:pt>
                <c:pt idx="180">
                  <c:v>0</c:v>
                </c:pt>
                <c:pt idx="181">
                  <c:v>0</c:v>
                </c:pt>
                <c:pt idx="182">
                  <c:v>0</c:v>
                </c:pt>
                <c:pt idx="183">
                  <c:v>0</c:v>
                </c:pt>
                <c:pt idx="184">
                  <c:v>0</c:v>
                </c:pt>
                <c:pt idx="185">
                  <c:v>0</c:v>
                </c:pt>
                <c:pt idx="186">
                  <c:v>0</c:v>
                </c:pt>
                <c:pt idx="187">
                  <c:v>0</c:v>
                </c:pt>
                <c:pt idx="188">
                  <c:v>0</c:v>
                </c:pt>
                <c:pt idx="189">
                  <c:v>0</c:v>
                </c:pt>
                <c:pt idx="190">
                  <c:v>0</c:v>
                </c:pt>
                <c:pt idx="191">
                  <c:v>0</c:v>
                </c:pt>
                <c:pt idx="192">
                  <c:v>0</c:v>
                </c:pt>
                <c:pt idx="193">
                  <c:v>0</c:v>
                </c:pt>
                <c:pt idx="194">
                  <c:v>0</c:v>
                </c:pt>
                <c:pt idx="195">
                  <c:v>0</c:v>
                </c:pt>
                <c:pt idx="196">
                  <c:v>0</c:v>
                </c:pt>
                <c:pt idx="197">
                  <c:v>0</c:v>
                </c:pt>
                <c:pt idx="198">
                  <c:v>0</c:v>
                </c:pt>
                <c:pt idx="199">
                  <c:v>0</c:v>
                </c:pt>
                <c:pt idx="200">
                  <c:v>0</c:v>
                </c:pt>
                <c:pt idx="201">
                  <c:v>0</c:v>
                </c:pt>
                <c:pt idx="202">
                  <c:v>0</c:v>
                </c:pt>
                <c:pt idx="203">
                  <c:v>0</c:v>
                </c:pt>
                <c:pt idx="204">
                  <c:v>0</c:v>
                </c:pt>
                <c:pt idx="205">
                  <c:v>0</c:v>
                </c:pt>
                <c:pt idx="206">
                  <c:v>0</c:v>
                </c:pt>
                <c:pt idx="207">
                  <c:v>0</c:v>
                </c:pt>
                <c:pt idx="208">
                  <c:v>0</c:v>
                </c:pt>
                <c:pt idx="209">
                  <c:v>0</c:v>
                </c:pt>
                <c:pt idx="210">
                  <c:v>0</c:v>
                </c:pt>
                <c:pt idx="211">
                  <c:v>0</c:v>
                </c:pt>
                <c:pt idx="212">
                  <c:v>0</c:v>
                </c:pt>
                <c:pt idx="213">
                  <c:v>0</c:v>
                </c:pt>
                <c:pt idx="214">
                  <c:v>0</c:v>
                </c:pt>
                <c:pt idx="215">
                  <c:v>0</c:v>
                </c:pt>
                <c:pt idx="216">
                  <c:v>0</c:v>
                </c:pt>
                <c:pt idx="217">
                  <c:v>0</c:v>
                </c:pt>
                <c:pt idx="218">
                  <c:v>0</c:v>
                </c:pt>
                <c:pt idx="219">
                  <c:v>0</c:v>
                </c:pt>
                <c:pt idx="220">
                  <c:v>0</c:v>
                </c:pt>
                <c:pt idx="221">
                  <c:v>0</c:v>
                </c:pt>
                <c:pt idx="222">
                  <c:v>0</c:v>
                </c:pt>
                <c:pt idx="223">
                  <c:v>0</c:v>
                </c:pt>
                <c:pt idx="224">
                  <c:v>0</c:v>
                </c:pt>
                <c:pt idx="225">
                  <c:v>0</c:v>
                </c:pt>
                <c:pt idx="226">
                  <c:v>0</c:v>
                </c:pt>
                <c:pt idx="227">
                  <c:v>0</c:v>
                </c:pt>
                <c:pt idx="228">
                  <c:v>0</c:v>
                </c:pt>
                <c:pt idx="229">
                  <c:v>0</c:v>
                </c:pt>
                <c:pt idx="230">
                  <c:v>0</c:v>
                </c:pt>
                <c:pt idx="231">
                  <c:v>0</c:v>
                </c:pt>
                <c:pt idx="232">
                  <c:v>0</c:v>
                </c:pt>
                <c:pt idx="233">
                  <c:v>0</c:v>
                </c:pt>
                <c:pt idx="234">
                  <c:v>0</c:v>
                </c:pt>
                <c:pt idx="235">
                  <c:v>0</c:v>
                </c:pt>
                <c:pt idx="236">
                  <c:v>0</c:v>
                </c:pt>
                <c:pt idx="237">
                  <c:v>0</c:v>
                </c:pt>
                <c:pt idx="238">
                  <c:v>0</c:v>
                </c:pt>
                <c:pt idx="239">
                  <c:v>0</c:v>
                </c:pt>
                <c:pt idx="240">
                  <c:v>0</c:v>
                </c:pt>
                <c:pt idx="241">
                  <c:v>0</c:v>
                </c:pt>
                <c:pt idx="242">
                  <c:v>0</c:v>
                </c:pt>
                <c:pt idx="243">
                  <c:v>0</c:v>
                </c:pt>
                <c:pt idx="244">
                  <c:v>0</c:v>
                </c:pt>
                <c:pt idx="245">
                  <c:v>0</c:v>
                </c:pt>
                <c:pt idx="246">
                  <c:v>0</c:v>
                </c:pt>
                <c:pt idx="247">
                  <c:v>0</c:v>
                </c:pt>
                <c:pt idx="248">
                  <c:v>0</c:v>
                </c:pt>
                <c:pt idx="249">
                  <c:v>0</c:v>
                </c:pt>
                <c:pt idx="250">
                  <c:v>0</c:v>
                </c:pt>
                <c:pt idx="251">
                  <c:v>0</c:v>
                </c:pt>
                <c:pt idx="252">
                  <c:v>0</c:v>
                </c:pt>
                <c:pt idx="253">
                  <c:v>0</c:v>
                </c:pt>
                <c:pt idx="254">
                  <c:v>0</c:v>
                </c:pt>
                <c:pt idx="255">
                  <c:v>0</c:v>
                </c:pt>
                <c:pt idx="256">
                  <c:v>0</c:v>
                </c:pt>
                <c:pt idx="257">
                  <c:v>0</c:v>
                </c:pt>
                <c:pt idx="258">
                  <c:v>0</c:v>
                </c:pt>
                <c:pt idx="259">
                  <c:v>0</c:v>
                </c:pt>
                <c:pt idx="260">
                  <c:v>0</c:v>
                </c:pt>
                <c:pt idx="261">
                  <c:v>0</c:v>
                </c:pt>
                <c:pt idx="262">
                  <c:v>0</c:v>
                </c:pt>
                <c:pt idx="263">
                  <c:v>0</c:v>
                </c:pt>
                <c:pt idx="264">
                  <c:v>0</c:v>
                </c:pt>
                <c:pt idx="265">
                  <c:v>0</c:v>
                </c:pt>
                <c:pt idx="266">
                  <c:v>0</c:v>
                </c:pt>
                <c:pt idx="267">
                  <c:v>0</c:v>
                </c:pt>
                <c:pt idx="268">
                  <c:v>0</c:v>
                </c:pt>
                <c:pt idx="269">
                  <c:v>0</c:v>
                </c:pt>
                <c:pt idx="270">
                  <c:v>0</c:v>
                </c:pt>
                <c:pt idx="271">
                  <c:v>0</c:v>
                </c:pt>
                <c:pt idx="272">
                  <c:v>0</c:v>
                </c:pt>
                <c:pt idx="273">
                  <c:v>0</c:v>
                </c:pt>
                <c:pt idx="274">
                  <c:v>0</c:v>
                </c:pt>
                <c:pt idx="275">
                  <c:v>0</c:v>
                </c:pt>
                <c:pt idx="276">
                  <c:v>0</c:v>
                </c:pt>
                <c:pt idx="277">
                  <c:v>0</c:v>
                </c:pt>
                <c:pt idx="278">
                  <c:v>0</c:v>
                </c:pt>
                <c:pt idx="279">
                  <c:v>0</c:v>
                </c:pt>
                <c:pt idx="280">
                  <c:v>0</c:v>
                </c:pt>
                <c:pt idx="281">
                  <c:v>0</c:v>
                </c:pt>
                <c:pt idx="282">
                  <c:v>0</c:v>
                </c:pt>
                <c:pt idx="283">
                  <c:v>0</c:v>
                </c:pt>
                <c:pt idx="284">
                  <c:v>0</c:v>
                </c:pt>
                <c:pt idx="285">
                  <c:v>0</c:v>
                </c:pt>
                <c:pt idx="286">
                  <c:v>0</c:v>
                </c:pt>
                <c:pt idx="287">
                  <c:v>0</c:v>
                </c:pt>
                <c:pt idx="288">
                  <c:v>0</c:v>
                </c:pt>
                <c:pt idx="289">
                  <c:v>0</c:v>
                </c:pt>
                <c:pt idx="290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8E14-401E-9648-FEF4D823B12D}"/>
            </c:ext>
          </c:extLst>
        </c:ser>
        <c:ser>
          <c:idx val="1"/>
          <c:order val="1"/>
          <c:tx>
            <c:strRef>
              <c:f>Sheet1!$D$1</c:f>
              <c:strCache>
                <c:ptCount val="1"/>
                <c:pt idx="0">
                  <c:v>MAS98.12</c:v>
                </c:pt>
              </c:strCache>
            </c:strRef>
          </c:tx>
          <c:spPr>
            <a:ln w="19050" cap="rnd">
              <a:solidFill>
                <a:schemeClr val="accent1">
                  <a:lumMod val="75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Sheet1!$B$2:$B$292</c:f>
              <c:numCache>
                <c:formatCode>General</c:formatCode>
                <c:ptCount val="291"/>
                <c:pt idx="0">
                  <c:v>185.38874724170299</c:v>
                </c:pt>
                <c:pt idx="1">
                  <c:v>185.381086990184</c:v>
                </c:pt>
                <c:pt idx="2">
                  <c:v>185.37342673866601</c:v>
                </c:pt>
                <c:pt idx="3">
                  <c:v>185.365766487147</c:v>
                </c:pt>
                <c:pt idx="4">
                  <c:v>185.35810623562799</c:v>
                </c:pt>
                <c:pt idx="5">
                  <c:v>185.350445984109</c:v>
                </c:pt>
                <c:pt idx="6">
                  <c:v>185.34278573258999</c:v>
                </c:pt>
                <c:pt idx="7">
                  <c:v>185.335125481071</c:v>
                </c:pt>
                <c:pt idx="8">
                  <c:v>185.32746522955301</c:v>
                </c:pt>
                <c:pt idx="9">
                  <c:v>185.319804978034</c:v>
                </c:pt>
                <c:pt idx="10">
                  <c:v>185.31214472651499</c:v>
                </c:pt>
                <c:pt idx="11">
                  <c:v>185.304484474996</c:v>
                </c:pt>
                <c:pt idx="12">
                  <c:v>185.29682422347699</c:v>
                </c:pt>
                <c:pt idx="13">
                  <c:v>185.289163971959</c:v>
                </c:pt>
                <c:pt idx="14">
                  <c:v>185.28150372044001</c:v>
                </c:pt>
                <c:pt idx="15">
                  <c:v>185.273843468921</c:v>
                </c:pt>
                <c:pt idx="16">
                  <c:v>185.26618321740199</c:v>
                </c:pt>
                <c:pt idx="17">
                  <c:v>185.258522965883</c:v>
                </c:pt>
                <c:pt idx="18">
                  <c:v>185.25086271436399</c:v>
                </c:pt>
                <c:pt idx="19">
                  <c:v>185.243202462846</c:v>
                </c:pt>
                <c:pt idx="20">
                  <c:v>185.23554221132699</c:v>
                </c:pt>
                <c:pt idx="21">
                  <c:v>185.227881959808</c:v>
                </c:pt>
                <c:pt idx="22">
                  <c:v>185.22022170828899</c:v>
                </c:pt>
                <c:pt idx="23">
                  <c:v>185.21256145677</c:v>
                </c:pt>
                <c:pt idx="24">
                  <c:v>185.20490120525099</c:v>
                </c:pt>
                <c:pt idx="25">
                  <c:v>185.197240953733</c:v>
                </c:pt>
                <c:pt idx="26">
                  <c:v>185.18958070221399</c:v>
                </c:pt>
                <c:pt idx="27">
                  <c:v>184.048203225908</c:v>
                </c:pt>
                <c:pt idx="28">
                  <c:v>184.04054297438901</c:v>
                </c:pt>
                <c:pt idx="29">
                  <c:v>184.03288272287099</c:v>
                </c:pt>
                <c:pt idx="30">
                  <c:v>184.02522247135201</c:v>
                </c:pt>
                <c:pt idx="31">
                  <c:v>184.017562219833</c:v>
                </c:pt>
                <c:pt idx="32">
                  <c:v>184.00990196831401</c:v>
                </c:pt>
                <c:pt idx="33">
                  <c:v>184.002241716795</c:v>
                </c:pt>
                <c:pt idx="34">
                  <c:v>183.99458146527601</c:v>
                </c:pt>
                <c:pt idx="35">
                  <c:v>183.986921213758</c:v>
                </c:pt>
                <c:pt idx="36">
                  <c:v>183.97926096223901</c:v>
                </c:pt>
                <c:pt idx="37">
                  <c:v>183.97160071072</c:v>
                </c:pt>
                <c:pt idx="38">
                  <c:v>183.96394045920101</c:v>
                </c:pt>
                <c:pt idx="39">
                  <c:v>183.956280207682</c:v>
                </c:pt>
                <c:pt idx="40">
                  <c:v>183.94861995616401</c:v>
                </c:pt>
                <c:pt idx="41">
                  <c:v>183.940959704645</c:v>
                </c:pt>
                <c:pt idx="42">
                  <c:v>183.93329945312601</c:v>
                </c:pt>
                <c:pt idx="43">
                  <c:v>183.925639201607</c:v>
                </c:pt>
                <c:pt idx="44">
                  <c:v>183.91797895008801</c:v>
                </c:pt>
                <c:pt idx="45">
                  <c:v>183.910318698569</c:v>
                </c:pt>
                <c:pt idx="46">
                  <c:v>183.90265844705101</c:v>
                </c:pt>
                <c:pt idx="47">
                  <c:v>183.894998195532</c:v>
                </c:pt>
                <c:pt idx="48">
                  <c:v>180.48618626965299</c:v>
                </c:pt>
                <c:pt idx="49">
                  <c:v>180.478526018134</c:v>
                </c:pt>
                <c:pt idx="50">
                  <c:v>180.47086576661499</c:v>
                </c:pt>
                <c:pt idx="51">
                  <c:v>180.46320551509601</c:v>
                </c:pt>
                <c:pt idx="52">
                  <c:v>180.45554526357799</c:v>
                </c:pt>
                <c:pt idx="53">
                  <c:v>180.447885012059</c:v>
                </c:pt>
                <c:pt idx="54">
                  <c:v>180.44022476053999</c:v>
                </c:pt>
                <c:pt idx="55">
                  <c:v>180.43256450902101</c:v>
                </c:pt>
                <c:pt idx="56">
                  <c:v>180.42490425750199</c:v>
                </c:pt>
                <c:pt idx="57">
                  <c:v>180.417244005984</c:v>
                </c:pt>
                <c:pt idx="58">
                  <c:v>180.40958375446499</c:v>
                </c:pt>
                <c:pt idx="59">
                  <c:v>180.401923502946</c:v>
                </c:pt>
                <c:pt idx="60">
                  <c:v>180.39426325142699</c:v>
                </c:pt>
                <c:pt idx="61">
                  <c:v>180.38660299990801</c:v>
                </c:pt>
                <c:pt idx="62">
                  <c:v>180.37894274838899</c:v>
                </c:pt>
                <c:pt idx="63">
                  <c:v>180.371282496871</c:v>
                </c:pt>
                <c:pt idx="64">
                  <c:v>180.36362224535199</c:v>
                </c:pt>
                <c:pt idx="65">
                  <c:v>180.35596199383301</c:v>
                </c:pt>
                <c:pt idx="66">
                  <c:v>180.34830174231399</c:v>
                </c:pt>
                <c:pt idx="67">
                  <c:v>180.34064149079501</c:v>
                </c:pt>
                <c:pt idx="68">
                  <c:v>180.33298123927599</c:v>
                </c:pt>
                <c:pt idx="69">
                  <c:v>180.325320987758</c:v>
                </c:pt>
                <c:pt idx="70">
                  <c:v>180.31766073623899</c:v>
                </c:pt>
                <c:pt idx="71">
                  <c:v>180.31000048472001</c:v>
                </c:pt>
                <c:pt idx="72">
                  <c:v>180.30234023320099</c:v>
                </c:pt>
                <c:pt idx="73">
                  <c:v>180.29467998168201</c:v>
                </c:pt>
                <c:pt idx="74">
                  <c:v>180.287019730163</c:v>
                </c:pt>
                <c:pt idx="75">
                  <c:v>180.27935947864501</c:v>
                </c:pt>
                <c:pt idx="76">
                  <c:v>180.27169922712599</c:v>
                </c:pt>
                <c:pt idx="77">
                  <c:v>180.26403897560701</c:v>
                </c:pt>
                <c:pt idx="78">
                  <c:v>180.25637872408799</c:v>
                </c:pt>
                <c:pt idx="79">
                  <c:v>180.24871847256901</c:v>
                </c:pt>
                <c:pt idx="80">
                  <c:v>180.24105822105</c:v>
                </c:pt>
                <c:pt idx="81">
                  <c:v>180.23339796953201</c:v>
                </c:pt>
                <c:pt idx="82">
                  <c:v>180.22573771801299</c:v>
                </c:pt>
                <c:pt idx="83">
                  <c:v>180.21807746649401</c:v>
                </c:pt>
                <c:pt idx="84">
                  <c:v>180.210417214975</c:v>
                </c:pt>
                <c:pt idx="85">
                  <c:v>180.20275696345601</c:v>
                </c:pt>
                <c:pt idx="86">
                  <c:v>180.195096711937</c:v>
                </c:pt>
                <c:pt idx="87">
                  <c:v>180.18743646041901</c:v>
                </c:pt>
                <c:pt idx="88">
                  <c:v>180.17977620889999</c:v>
                </c:pt>
                <c:pt idx="89">
                  <c:v>178.724328420322</c:v>
                </c:pt>
                <c:pt idx="90">
                  <c:v>178.71666816880401</c:v>
                </c:pt>
                <c:pt idx="91">
                  <c:v>178.70900791728499</c:v>
                </c:pt>
                <c:pt idx="92">
                  <c:v>178.70134766576601</c:v>
                </c:pt>
                <c:pt idx="93">
                  <c:v>178.69368741424699</c:v>
                </c:pt>
                <c:pt idx="94">
                  <c:v>178.68602716272801</c:v>
                </c:pt>
                <c:pt idx="95">
                  <c:v>178.678366911209</c:v>
                </c:pt>
                <c:pt idx="96">
                  <c:v>178.67070665969101</c:v>
                </c:pt>
                <c:pt idx="97">
                  <c:v>178.66304640817199</c:v>
                </c:pt>
                <c:pt idx="98">
                  <c:v>178.65538615665301</c:v>
                </c:pt>
                <c:pt idx="99">
                  <c:v>178.647725905134</c:v>
                </c:pt>
                <c:pt idx="100">
                  <c:v>178.64006565361501</c:v>
                </c:pt>
                <c:pt idx="101">
                  <c:v>178.632405402096</c:v>
                </c:pt>
                <c:pt idx="102">
                  <c:v>178.62474515057801</c:v>
                </c:pt>
                <c:pt idx="103">
                  <c:v>178.61708489905899</c:v>
                </c:pt>
                <c:pt idx="104">
                  <c:v>178.60942464754001</c:v>
                </c:pt>
                <c:pt idx="105">
                  <c:v>178.601764396021</c:v>
                </c:pt>
                <c:pt idx="106">
                  <c:v>178.59410414450201</c:v>
                </c:pt>
                <c:pt idx="107">
                  <c:v>178.586443892983</c:v>
                </c:pt>
                <c:pt idx="108">
                  <c:v>178.57878364146501</c:v>
                </c:pt>
                <c:pt idx="109">
                  <c:v>178.571123389946</c:v>
                </c:pt>
                <c:pt idx="110">
                  <c:v>178.56346313842701</c:v>
                </c:pt>
                <c:pt idx="111">
                  <c:v>178.555802886908</c:v>
                </c:pt>
                <c:pt idx="112">
                  <c:v>178.54814263538901</c:v>
                </c:pt>
                <c:pt idx="113">
                  <c:v>178.54048238387</c:v>
                </c:pt>
                <c:pt idx="114">
                  <c:v>178.53282213235201</c:v>
                </c:pt>
                <c:pt idx="115">
                  <c:v>177.38378440452701</c:v>
                </c:pt>
                <c:pt idx="116">
                  <c:v>177.37612415300899</c:v>
                </c:pt>
                <c:pt idx="117">
                  <c:v>177.36846390149</c:v>
                </c:pt>
                <c:pt idx="118">
                  <c:v>177.36080364997099</c:v>
                </c:pt>
                <c:pt idx="119">
                  <c:v>177.353143398452</c:v>
                </c:pt>
                <c:pt idx="120">
                  <c:v>177.34548314693299</c:v>
                </c:pt>
                <c:pt idx="121">
                  <c:v>177.33782289541401</c:v>
                </c:pt>
                <c:pt idx="122">
                  <c:v>177.33016264389599</c:v>
                </c:pt>
                <c:pt idx="123">
                  <c:v>177.322502392377</c:v>
                </c:pt>
                <c:pt idx="124">
                  <c:v>177.31484214085799</c:v>
                </c:pt>
                <c:pt idx="125">
                  <c:v>177.30718188933901</c:v>
                </c:pt>
                <c:pt idx="126">
                  <c:v>177.29952163781999</c:v>
                </c:pt>
                <c:pt idx="127">
                  <c:v>177.29186138630101</c:v>
                </c:pt>
                <c:pt idx="128">
                  <c:v>177.28420113478299</c:v>
                </c:pt>
                <c:pt idx="129">
                  <c:v>177.276540883264</c:v>
                </c:pt>
                <c:pt idx="130">
                  <c:v>177.26888063174499</c:v>
                </c:pt>
                <c:pt idx="131">
                  <c:v>176.92416931339801</c:v>
                </c:pt>
                <c:pt idx="132">
                  <c:v>176.916509061879</c:v>
                </c:pt>
                <c:pt idx="133">
                  <c:v>176.90884881036001</c:v>
                </c:pt>
                <c:pt idx="134">
                  <c:v>176.901188558841</c:v>
                </c:pt>
                <c:pt idx="135">
                  <c:v>176.89352830732199</c:v>
                </c:pt>
                <c:pt idx="136">
                  <c:v>176.885868055803</c:v>
                </c:pt>
                <c:pt idx="137">
                  <c:v>176.87820780428501</c:v>
                </c:pt>
                <c:pt idx="138">
                  <c:v>176.870547552766</c:v>
                </c:pt>
                <c:pt idx="139">
                  <c:v>176.86288730124701</c:v>
                </c:pt>
                <c:pt idx="140">
                  <c:v>176.855227049728</c:v>
                </c:pt>
                <c:pt idx="141">
                  <c:v>176.84756679820899</c:v>
                </c:pt>
                <c:pt idx="142">
                  <c:v>176.839906546691</c:v>
                </c:pt>
                <c:pt idx="143">
                  <c:v>176.83224629517201</c:v>
                </c:pt>
                <c:pt idx="144">
                  <c:v>176.824586043653</c:v>
                </c:pt>
                <c:pt idx="145">
                  <c:v>176.81692579213399</c:v>
                </c:pt>
                <c:pt idx="146">
                  <c:v>176.809265540615</c:v>
                </c:pt>
                <c:pt idx="147">
                  <c:v>176.80160528909599</c:v>
                </c:pt>
                <c:pt idx="148">
                  <c:v>176.793945037578</c:v>
                </c:pt>
                <c:pt idx="149">
                  <c:v>176.78628478605901</c:v>
                </c:pt>
                <c:pt idx="150">
                  <c:v>176.77862453454</c:v>
                </c:pt>
                <c:pt idx="151">
                  <c:v>176.77096428302099</c:v>
                </c:pt>
                <c:pt idx="152">
                  <c:v>175.430420267226</c:v>
                </c:pt>
                <c:pt idx="153">
                  <c:v>175.42276001570701</c:v>
                </c:pt>
                <c:pt idx="154">
                  <c:v>175.415099764188</c:v>
                </c:pt>
                <c:pt idx="155">
                  <c:v>175.40743951267001</c:v>
                </c:pt>
                <c:pt idx="156">
                  <c:v>175.399779261151</c:v>
                </c:pt>
                <c:pt idx="157">
                  <c:v>175.39211900963201</c:v>
                </c:pt>
                <c:pt idx="158">
                  <c:v>175.384458758113</c:v>
                </c:pt>
                <c:pt idx="159">
                  <c:v>175.37679850659401</c:v>
                </c:pt>
                <c:pt idx="160">
                  <c:v>175.369138255075</c:v>
                </c:pt>
                <c:pt idx="161">
                  <c:v>175.36147800355701</c:v>
                </c:pt>
                <c:pt idx="162">
                  <c:v>175.353817752038</c:v>
                </c:pt>
                <c:pt idx="163">
                  <c:v>175.34615750051901</c:v>
                </c:pt>
                <c:pt idx="164">
                  <c:v>175.338497249</c:v>
                </c:pt>
                <c:pt idx="165">
                  <c:v>175.33083699748099</c:v>
                </c:pt>
                <c:pt idx="166">
                  <c:v>175.323176745962</c:v>
                </c:pt>
                <c:pt idx="167">
                  <c:v>175.31551649444401</c:v>
                </c:pt>
                <c:pt idx="168">
                  <c:v>175.307856242925</c:v>
                </c:pt>
                <c:pt idx="169">
                  <c:v>175.30019599140601</c:v>
                </c:pt>
                <c:pt idx="170">
                  <c:v>175.292535739887</c:v>
                </c:pt>
                <c:pt idx="171">
                  <c:v>175.28487548836799</c:v>
                </c:pt>
                <c:pt idx="172">
                  <c:v>175.277215236849</c:v>
                </c:pt>
                <c:pt idx="173">
                  <c:v>175.26955498533101</c:v>
                </c:pt>
                <c:pt idx="174">
                  <c:v>175.261894733812</c:v>
                </c:pt>
                <c:pt idx="175">
                  <c:v>175.25423448229299</c:v>
                </c:pt>
                <c:pt idx="176">
                  <c:v>175.246574230774</c:v>
                </c:pt>
                <c:pt idx="177">
                  <c:v>175.23891397925499</c:v>
                </c:pt>
                <c:pt idx="178">
                  <c:v>175.231253727737</c:v>
                </c:pt>
                <c:pt idx="179">
                  <c:v>175.22359347621801</c:v>
                </c:pt>
                <c:pt idx="180">
                  <c:v>175.215933224699</c:v>
                </c:pt>
                <c:pt idx="181">
                  <c:v>175.20827297317999</c:v>
                </c:pt>
                <c:pt idx="182">
                  <c:v>175.200612721661</c:v>
                </c:pt>
                <c:pt idx="183">
                  <c:v>175.19295247014199</c:v>
                </c:pt>
                <c:pt idx="184">
                  <c:v>175.185292218624</c:v>
                </c:pt>
                <c:pt idx="185">
                  <c:v>175.17763196710499</c:v>
                </c:pt>
                <c:pt idx="186">
                  <c:v>175.169971715586</c:v>
                </c:pt>
                <c:pt idx="187">
                  <c:v>175.16231146406699</c:v>
                </c:pt>
                <c:pt idx="188">
                  <c:v>175.154651212548</c:v>
                </c:pt>
                <c:pt idx="189">
                  <c:v>175.14699096102899</c:v>
                </c:pt>
                <c:pt idx="190">
                  <c:v>175.139330709511</c:v>
                </c:pt>
                <c:pt idx="191">
                  <c:v>175.13167045799199</c:v>
                </c:pt>
                <c:pt idx="192">
                  <c:v>175.124010206473</c:v>
                </c:pt>
                <c:pt idx="193">
                  <c:v>175.11634995495399</c:v>
                </c:pt>
                <c:pt idx="194">
                  <c:v>174.58779260015501</c:v>
                </c:pt>
                <c:pt idx="195">
                  <c:v>174.580132348636</c:v>
                </c:pt>
                <c:pt idx="196">
                  <c:v>174.57247209711699</c:v>
                </c:pt>
                <c:pt idx="197">
                  <c:v>174.564811845598</c:v>
                </c:pt>
                <c:pt idx="198">
                  <c:v>174.55715159408001</c:v>
                </c:pt>
                <c:pt idx="199">
                  <c:v>174.549491342561</c:v>
                </c:pt>
                <c:pt idx="200">
                  <c:v>174.54183109104201</c:v>
                </c:pt>
                <c:pt idx="201">
                  <c:v>174.534170839523</c:v>
                </c:pt>
                <c:pt idx="202">
                  <c:v>174.52651058800399</c:v>
                </c:pt>
                <c:pt idx="203">
                  <c:v>174.518850336485</c:v>
                </c:pt>
                <c:pt idx="204">
                  <c:v>174.51119008496701</c:v>
                </c:pt>
                <c:pt idx="205">
                  <c:v>174.503529833448</c:v>
                </c:pt>
                <c:pt idx="206">
                  <c:v>174.49586958192901</c:v>
                </c:pt>
                <c:pt idx="207">
                  <c:v>174.48820933041</c:v>
                </c:pt>
                <c:pt idx="208">
                  <c:v>174.48054907889099</c:v>
                </c:pt>
                <c:pt idx="209">
                  <c:v>174.472888827372</c:v>
                </c:pt>
                <c:pt idx="210">
                  <c:v>174.46522857585401</c:v>
                </c:pt>
                <c:pt idx="211">
                  <c:v>174.457568324335</c:v>
                </c:pt>
                <c:pt idx="212">
                  <c:v>174.44990807281599</c:v>
                </c:pt>
                <c:pt idx="213">
                  <c:v>174.442247821297</c:v>
                </c:pt>
                <c:pt idx="214">
                  <c:v>174.43458756977799</c:v>
                </c:pt>
                <c:pt idx="215">
                  <c:v>174.42692731826</c:v>
                </c:pt>
                <c:pt idx="216">
                  <c:v>174.41926706674101</c:v>
                </c:pt>
                <c:pt idx="217">
                  <c:v>174.411606815222</c:v>
                </c:pt>
                <c:pt idx="218">
                  <c:v>174.40394656370299</c:v>
                </c:pt>
                <c:pt idx="219">
                  <c:v>174.396286312184</c:v>
                </c:pt>
                <c:pt idx="220">
                  <c:v>174.38862606066499</c:v>
                </c:pt>
                <c:pt idx="221">
                  <c:v>174.380965809147</c:v>
                </c:pt>
                <c:pt idx="222">
                  <c:v>174.37330555762799</c:v>
                </c:pt>
                <c:pt idx="223">
                  <c:v>174.365645306109</c:v>
                </c:pt>
                <c:pt idx="224">
                  <c:v>174.35798505458999</c:v>
                </c:pt>
                <c:pt idx="225">
                  <c:v>174.350324803071</c:v>
                </c:pt>
                <c:pt idx="226">
                  <c:v>174.34266455155199</c:v>
                </c:pt>
                <c:pt idx="227">
                  <c:v>174.335004300034</c:v>
                </c:pt>
                <c:pt idx="228">
                  <c:v>174.32734404851499</c:v>
                </c:pt>
                <c:pt idx="229">
                  <c:v>174.319683796996</c:v>
                </c:pt>
                <c:pt idx="230">
                  <c:v>174.31202354547699</c:v>
                </c:pt>
                <c:pt idx="231">
                  <c:v>174.304363293958</c:v>
                </c:pt>
                <c:pt idx="232">
                  <c:v>174.29670304243899</c:v>
                </c:pt>
                <c:pt idx="233">
                  <c:v>174.289042790921</c:v>
                </c:pt>
                <c:pt idx="234">
                  <c:v>174.28138253940199</c:v>
                </c:pt>
                <c:pt idx="235">
                  <c:v>174.273722287883</c:v>
                </c:pt>
                <c:pt idx="236">
                  <c:v>174.26606203636399</c:v>
                </c:pt>
                <c:pt idx="237">
                  <c:v>174.25840178484501</c:v>
                </c:pt>
                <c:pt idx="238">
                  <c:v>174.25074153332599</c:v>
                </c:pt>
                <c:pt idx="239">
                  <c:v>174.243081281808</c:v>
                </c:pt>
                <c:pt idx="240">
                  <c:v>174.23542103028899</c:v>
                </c:pt>
                <c:pt idx="241">
                  <c:v>174.22776077877</c:v>
                </c:pt>
                <c:pt idx="242">
                  <c:v>174.22010052725099</c:v>
                </c:pt>
                <c:pt idx="243">
                  <c:v>174.21244027573201</c:v>
                </c:pt>
                <c:pt idx="244">
                  <c:v>174.20478002421299</c:v>
                </c:pt>
                <c:pt idx="245">
                  <c:v>174.197119772695</c:v>
                </c:pt>
                <c:pt idx="246">
                  <c:v>174.18945952117599</c:v>
                </c:pt>
                <c:pt idx="247">
                  <c:v>174.18179926965701</c:v>
                </c:pt>
                <c:pt idx="248">
                  <c:v>174.17413901813799</c:v>
                </c:pt>
                <c:pt idx="249">
                  <c:v>174.16647876661901</c:v>
                </c:pt>
                <c:pt idx="250">
                  <c:v>174.15881851509999</c:v>
                </c:pt>
                <c:pt idx="251">
                  <c:v>174.151158263582</c:v>
                </c:pt>
                <c:pt idx="252">
                  <c:v>174.14349801206299</c:v>
                </c:pt>
                <c:pt idx="253">
                  <c:v>174.13583776054401</c:v>
                </c:pt>
                <c:pt idx="254">
                  <c:v>174.12817750902499</c:v>
                </c:pt>
                <c:pt idx="255">
                  <c:v>173.821767448272</c:v>
                </c:pt>
                <c:pt idx="256">
                  <c:v>173.81410719675301</c:v>
                </c:pt>
                <c:pt idx="257">
                  <c:v>173.806446945234</c:v>
                </c:pt>
                <c:pt idx="258">
                  <c:v>173.79878669371601</c:v>
                </c:pt>
                <c:pt idx="259">
                  <c:v>173.791126442197</c:v>
                </c:pt>
                <c:pt idx="260">
                  <c:v>173.78346619067801</c:v>
                </c:pt>
                <c:pt idx="261">
                  <c:v>173.775805939159</c:v>
                </c:pt>
                <c:pt idx="262">
                  <c:v>173.76814568763999</c:v>
                </c:pt>
                <c:pt idx="263">
                  <c:v>173.760485436121</c:v>
                </c:pt>
                <c:pt idx="264">
                  <c:v>173.75282518460301</c:v>
                </c:pt>
                <c:pt idx="265">
                  <c:v>173.745164933084</c:v>
                </c:pt>
                <c:pt idx="266">
                  <c:v>173.73750468156501</c:v>
                </c:pt>
                <c:pt idx="267">
                  <c:v>173.729844430046</c:v>
                </c:pt>
                <c:pt idx="268">
                  <c:v>173.72218417852699</c:v>
                </c:pt>
                <c:pt idx="269">
                  <c:v>173.714523927008</c:v>
                </c:pt>
                <c:pt idx="270">
                  <c:v>173.70686367549001</c:v>
                </c:pt>
                <c:pt idx="271">
                  <c:v>173.699203423971</c:v>
                </c:pt>
                <c:pt idx="272">
                  <c:v>173.69154317245199</c:v>
                </c:pt>
                <c:pt idx="273">
                  <c:v>173.683882920933</c:v>
                </c:pt>
                <c:pt idx="274">
                  <c:v>173.67622266941399</c:v>
                </c:pt>
                <c:pt idx="275">
                  <c:v>173.668562417895</c:v>
                </c:pt>
                <c:pt idx="276">
                  <c:v>173.66090216637701</c:v>
                </c:pt>
                <c:pt idx="277">
                  <c:v>173.653241914858</c:v>
                </c:pt>
                <c:pt idx="278">
                  <c:v>173.64558166333899</c:v>
                </c:pt>
                <c:pt idx="279">
                  <c:v>173.63792141182</c:v>
                </c:pt>
                <c:pt idx="280">
                  <c:v>173.63026116030099</c:v>
                </c:pt>
                <c:pt idx="281">
                  <c:v>173.622600908783</c:v>
                </c:pt>
                <c:pt idx="282">
                  <c:v>173.61494065726399</c:v>
                </c:pt>
                <c:pt idx="283">
                  <c:v>173.607280405745</c:v>
                </c:pt>
                <c:pt idx="284">
                  <c:v>173.59962015422599</c:v>
                </c:pt>
                <c:pt idx="285">
                  <c:v>173.591959902707</c:v>
                </c:pt>
                <c:pt idx="286">
                  <c:v>173.58429965118799</c:v>
                </c:pt>
                <c:pt idx="287">
                  <c:v>173.57663939967</c:v>
                </c:pt>
                <c:pt idx="288">
                  <c:v>173.56897914815099</c:v>
                </c:pt>
                <c:pt idx="289">
                  <c:v>173.561318896632</c:v>
                </c:pt>
                <c:pt idx="290">
                  <c:v>173.55365864511299</c:v>
                </c:pt>
              </c:numCache>
            </c:numRef>
          </c:xVal>
          <c:yVal>
            <c:numRef>
              <c:f>Sheet1!$E$2:$E$292</c:f>
              <c:numCache>
                <c:formatCode>General</c:formatCode>
                <c:ptCount val="291"/>
                <c:pt idx="0">
                  <c:v>2551.2410720560902</c:v>
                </c:pt>
                <c:pt idx="1">
                  <c:v>8885.1038468381903</c:v>
                </c:pt>
                <c:pt idx="2">
                  <c:v>11482.292351446</c:v>
                </c:pt>
                <c:pt idx="3">
                  <c:v>-13987.887198492001</c:v>
                </c:pt>
                <c:pt idx="4">
                  <c:v>-51776.526729452002</c:v>
                </c:pt>
                <c:pt idx="5">
                  <c:v>-43825.966876346603</c:v>
                </c:pt>
                <c:pt idx="6">
                  <c:v>7404.6804291324297</c:v>
                </c:pt>
                <c:pt idx="7">
                  <c:v>-101149.836590536</c:v>
                </c:pt>
                <c:pt idx="8">
                  <c:v>-76391.231853566205</c:v>
                </c:pt>
                <c:pt idx="9">
                  <c:v>63255.756110186201</c:v>
                </c:pt>
                <c:pt idx="10">
                  <c:v>287606.872742882</c:v>
                </c:pt>
                <c:pt idx="11">
                  <c:v>565497.42504928797</c:v>
                </c:pt>
                <c:pt idx="12">
                  <c:v>335532.89935580501</c:v>
                </c:pt>
                <c:pt idx="13">
                  <c:v>233225.04518717399</c:v>
                </c:pt>
                <c:pt idx="14">
                  <c:v>95086.988208773197</c:v>
                </c:pt>
                <c:pt idx="15">
                  <c:v>45675.447674701798</c:v>
                </c:pt>
                <c:pt idx="16">
                  <c:v>59837.617275881697</c:v>
                </c:pt>
                <c:pt idx="17">
                  <c:v>93585.750173198103</c:v>
                </c:pt>
                <c:pt idx="18">
                  <c:v>166372.56065425399</c:v>
                </c:pt>
                <c:pt idx="19">
                  <c:v>123138.42414813</c:v>
                </c:pt>
                <c:pt idx="20">
                  <c:v>39955.483720636803</c:v>
                </c:pt>
                <c:pt idx="21">
                  <c:v>21610.416124187701</c:v>
                </c:pt>
                <c:pt idx="22">
                  <c:v>-82011.364073392193</c:v>
                </c:pt>
                <c:pt idx="23">
                  <c:v>-28794.771196928599</c:v>
                </c:pt>
                <c:pt idx="24">
                  <c:v>-30291.675412182802</c:v>
                </c:pt>
                <c:pt idx="25">
                  <c:v>49466.774089513397</c:v>
                </c:pt>
                <c:pt idx="26">
                  <c:v>0</c:v>
                </c:pt>
                <c:pt idx="27">
                  <c:v>0</c:v>
                </c:pt>
                <c:pt idx="28">
                  <c:v>31147.913501220901</c:v>
                </c:pt>
                <c:pt idx="29">
                  <c:v>-87601.415002501701</c:v>
                </c:pt>
                <c:pt idx="30">
                  <c:v>-54415.555519002199</c:v>
                </c:pt>
                <c:pt idx="31">
                  <c:v>11889.9638775781</c:v>
                </c:pt>
                <c:pt idx="32">
                  <c:v>10939.6663473316</c:v>
                </c:pt>
                <c:pt idx="33">
                  <c:v>17737.019246233602</c:v>
                </c:pt>
                <c:pt idx="34">
                  <c:v>294778.50179071701</c:v>
                </c:pt>
                <c:pt idx="35">
                  <c:v>648054.901607904</c:v>
                </c:pt>
                <c:pt idx="36">
                  <c:v>555661.42128777504</c:v>
                </c:pt>
                <c:pt idx="37">
                  <c:v>393355.625400258</c:v>
                </c:pt>
                <c:pt idx="38">
                  <c:v>187156.61698352601</c:v>
                </c:pt>
                <c:pt idx="39">
                  <c:v>184435.15199626001</c:v>
                </c:pt>
                <c:pt idx="40">
                  <c:v>189556.27959059301</c:v>
                </c:pt>
                <c:pt idx="41">
                  <c:v>99551.5492777498</c:v>
                </c:pt>
                <c:pt idx="42">
                  <c:v>94936.363146845397</c:v>
                </c:pt>
                <c:pt idx="43">
                  <c:v>111278.357663773</c:v>
                </c:pt>
                <c:pt idx="44">
                  <c:v>80055.709218652497</c:v>
                </c:pt>
                <c:pt idx="45">
                  <c:v>1831.86717279456</c:v>
                </c:pt>
                <c:pt idx="46">
                  <c:v>19728.956967148901</c:v>
                </c:pt>
                <c:pt idx="47">
                  <c:v>0</c:v>
                </c:pt>
                <c:pt idx="48">
                  <c:v>0</c:v>
                </c:pt>
                <c:pt idx="49">
                  <c:v>-19282.111472475401</c:v>
                </c:pt>
                <c:pt idx="50">
                  <c:v>35050.4604976954</c:v>
                </c:pt>
                <c:pt idx="51">
                  <c:v>19291.838323567001</c:v>
                </c:pt>
                <c:pt idx="52">
                  <c:v>25580.165702081598</c:v>
                </c:pt>
                <c:pt idx="53">
                  <c:v>-21825.5078742724</c:v>
                </c:pt>
                <c:pt idx="54">
                  <c:v>57633.292056010199</c:v>
                </c:pt>
                <c:pt idx="55">
                  <c:v>84175.777554290806</c:v>
                </c:pt>
                <c:pt idx="56">
                  <c:v>88174.903783949703</c:v>
                </c:pt>
                <c:pt idx="57">
                  <c:v>152206.984377927</c:v>
                </c:pt>
                <c:pt idx="58">
                  <c:v>571185.61505183706</c:v>
                </c:pt>
                <c:pt idx="59">
                  <c:v>1188035.46593246</c:v>
                </c:pt>
                <c:pt idx="60">
                  <c:v>897195.47479815199</c:v>
                </c:pt>
                <c:pt idx="61">
                  <c:v>567533.805349153</c:v>
                </c:pt>
                <c:pt idx="62">
                  <c:v>471616.06220427202</c:v>
                </c:pt>
                <c:pt idx="63">
                  <c:v>368330.85008327698</c:v>
                </c:pt>
                <c:pt idx="64">
                  <c:v>340330.88583133603</c:v>
                </c:pt>
                <c:pt idx="65">
                  <c:v>382282.34861833201</c:v>
                </c:pt>
                <c:pt idx="66">
                  <c:v>531300.32003108703</c:v>
                </c:pt>
                <c:pt idx="67">
                  <c:v>588143.49457888096</c:v>
                </c:pt>
                <c:pt idx="68">
                  <c:v>472281.440932289</c:v>
                </c:pt>
                <c:pt idx="69">
                  <c:v>570591.96452009596</c:v>
                </c:pt>
                <c:pt idx="70">
                  <c:v>539082.58153434005</c:v>
                </c:pt>
                <c:pt idx="71">
                  <c:v>461732.613602005</c:v>
                </c:pt>
                <c:pt idx="72">
                  <c:v>329695.40955754399</c:v>
                </c:pt>
                <c:pt idx="73">
                  <c:v>300250.94167533901</c:v>
                </c:pt>
                <c:pt idx="74">
                  <c:v>204252.57408867701</c:v>
                </c:pt>
                <c:pt idx="75">
                  <c:v>115417.330552826</c:v>
                </c:pt>
                <c:pt idx="76">
                  <c:v>275148.36694759299</c:v>
                </c:pt>
                <c:pt idx="77">
                  <c:v>331408.05904628302</c:v>
                </c:pt>
                <c:pt idx="78">
                  <c:v>255215.10968980001</c:v>
                </c:pt>
                <c:pt idx="79">
                  <c:v>297474.21457973903</c:v>
                </c:pt>
                <c:pt idx="80">
                  <c:v>282820.46313699801</c:v>
                </c:pt>
                <c:pt idx="81">
                  <c:v>220724.50685986801</c:v>
                </c:pt>
                <c:pt idx="82">
                  <c:v>126923.414020781</c:v>
                </c:pt>
                <c:pt idx="83">
                  <c:v>100529.71704436</c:v>
                </c:pt>
                <c:pt idx="84">
                  <c:v>105155.52760364101</c:v>
                </c:pt>
                <c:pt idx="85">
                  <c:v>133441.93679552601</c:v>
                </c:pt>
                <c:pt idx="86">
                  <c:v>156758.249895243</c:v>
                </c:pt>
                <c:pt idx="87">
                  <c:v>121825.37206328999</c:v>
                </c:pt>
                <c:pt idx="88">
                  <c:v>0</c:v>
                </c:pt>
                <c:pt idx="89">
                  <c:v>0</c:v>
                </c:pt>
                <c:pt idx="90">
                  <c:v>83394.705141320097</c:v>
                </c:pt>
                <c:pt idx="91">
                  <c:v>120905.344524154</c:v>
                </c:pt>
                <c:pt idx="92">
                  <c:v>78035.091094225398</c:v>
                </c:pt>
                <c:pt idx="93">
                  <c:v>18880.493674302099</c:v>
                </c:pt>
                <c:pt idx="94">
                  <c:v>122924.33955862001</c:v>
                </c:pt>
                <c:pt idx="95">
                  <c:v>19601.077448008498</c:v>
                </c:pt>
                <c:pt idx="96">
                  <c:v>-3492.8709174422702</c:v>
                </c:pt>
                <c:pt idx="97">
                  <c:v>101219.67693045401</c:v>
                </c:pt>
                <c:pt idx="98">
                  <c:v>101588.388571802</c:v>
                </c:pt>
                <c:pt idx="99">
                  <c:v>256760.045890746</c:v>
                </c:pt>
                <c:pt idx="100">
                  <c:v>334339.053160802</c:v>
                </c:pt>
                <c:pt idx="101">
                  <c:v>186624.49316541399</c:v>
                </c:pt>
                <c:pt idx="102">
                  <c:v>117180.060373824</c:v>
                </c:pt>
                <c:pt idx="103">
                  <c:v>18154.477435037301</c:v>
                </c:pt>
                <c:pt idx="104">
                  <c:v>54560.202764183297</c:v>
                </c:pt>
                <c:pt idx="105">
                  <c:v>90848.520470543997</c:v>
                </c:pt>
                <c:pt idx="106">
                  <c:v>58305.8458527482</c:v>
                </c:pt>
                <c:pt idx="107">
                  <c:v>-7196.9788916650105</c:v>
                </c:pt>
                <c:pt idx="108">
                  <c:v>-35904.553721212797</c:v>
                </c:pt>
                <c:pt idx="109">
                  <c:v>5771.8380716342599</c:v>
                </c:pt>
                <c:pt idx="110">
                  <c:v>85801.473457751097</c:v>
                </c:pt>
                <c:pt idx="111">
                  <c:v>84120.653362935904</c:v>
                </c:pt>
                <c:pt idx="112">
                  <c:v>16270.7148919469</c:v>
                </c:pt>
                <c:pt idx="113">
                  <c:v>-27799.693650946199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0</c:v>
                </c:pt>
                <c:pt idx="121">
                  <c:v>112845.76580548999</c:v>
                </c:pt>
                <c:pt idx="122">
                  <c:v>159777.80133359399</c:v>
                </c:pt>
                <c:pt idx="123">
                  <c:v>-9700.6437404267908</c:v>
                </c:pt>
                <c:pt idx="124">
                  <c:v>82877.562305016007</c:v>
                </c:pt>
                <c:pt idx="125">
                  <c:v>57451.846490663098</c:v>
                </c:pt>
                <c:pt idx="126">
                  <c:v>76935.616823878998</c:v>
                </c:pt>
                <c:pt idx="127">
                  <c:v>94532.402313971499</c:v>
                </c:pt>
                <c:pt idx="128">
                  <c:v>61248.217057766298</c:v>
                </c:pt>
                <c:pt idx="129">
                  <c:v>5758.8182113820703</c:v>
                </c:pt>
                <c:pt idx="130">
                  <c:v>0</c:v>
                </c:pt>
                <c:pt idx="131">
                  <c:v>0</c:v>
                </c:pt>
                <c:pt idx="132">
                  <c:v>-69707.460253742</c:v>
                </c:pt>
                <c:pt idx="133">
                  <c:v>12097.864021555401</c:v>
                </c:pt>
                <c:pt idx="134">
                  <c:v>46950.9163417077</c:v>
                </c:pt>
                <c:pt idx="135">
                  <c:v>17743.132369064901</c:v>
                </c:pt>
                <c:pt idx="136">
                  <c:v>9018.6779865262797</c:v>
                </c:pt>
                <c:pt idx="137">
                  <c:v>57802.795111073501</c:v>
                </c:pt>
                <c:pt idx="138">
                  <c:v>41897.354921187398</c:v>
                </c:pt>
                <c:pt idx="139">
                  <c:v>63793.412469633498</c:v>
                </c:pt>
                <c:pt idx="140">
                  <c:v>48394.587220581401</c:v>
                </c:pt>
                <c:pt idx="141">
                  <c:v>57612.996797714302</c:v>
                </c:pt>
                <c:pt idx="142">
                  <c:v>142144.53528401701</c:v>
                </c:pt>
                <c:pt idx="143">
                  <c:v>101002.342788373</c:v>
                </c:pt>
                <c:pt idx="144">
                  <c:v>59799.683396998596</c:v>
                </c:pt>
                <c:pt idx="145">
                  <c:v>97558.838431240598</c:v>
                </c:pt>
                <c:pt idx="146">
                  <c:v>122893.96193809</c:v>
                </c:pt>
                <c:pt idx="147">
                  <c:v>74370.722369795199</c:v>
                </c:pt>
                <c:pt idx="148">
                  <c:v>7364.4115730065496</c:v>
                </c:pt>
                <c:pt idx="149">
                  <c:v>-68470.820128463994</c:v>
                </c:pt>
                <c:pt idx="150">
                  <c:v>-16284.9639142091</c:v>
                </c:pt>
                <c:pt idx="151">
                  <c:v>0</c:v>
                </c:pt>
                <c:pt idx="152">
                  <c:v>0</c:v>
                </c:pt>
                <c:pt idx="153">
                  <c:v>22302.3358554486</c:v>
                </c:pt>
                <c:pt idx="154">
                  <c:v>-44445.317112848497</c:v>
                </c:pt>
                <c:pt idx="155">
                  <c:v>49317.176756266403</c:v>
                </c:pt>
                <c:pt idx="156">
                  <c:v>88343.1094887863</c:v>
                </c:pt>
                <c:pt idx="157">
                  <c:v>12692.110715769801</c:v>
                </c:pt>
                <c:pt idx="158">
                  <c:v>15280.0885917408</c:v>
                </c:pt>
                <c:pt idx="159">
                  <c:v>74243.744765234602</c:v>
                </c:pt>
                <c:pt idx="160">
                  <c:v>-45583.2819087026</c:v>
                </c:pt>
                <c:pt idx="161">
                  <c:v>-21678.1746120096</c:v>
                </c:pt>
                <c:pt idx="162">
                  <c:v>15733.761000427699</c:v>
                </c:pt>
                <c:pt idx="163">
                  <c:v>53072.266476956502</c:v>
                </c:pt>
                <c:pt idx="164">
                  <c:v>-29442.653993445299</c:v>
                </c:pt>
                <c:pt idx="165">
                  <c:v>-98598.383564602205</c:v>
                </c:pt>
                <c:pt idx="166">
                  <c:v>27164.263976360999</c:v>
                </c:pt>
                <c:pt idx="167">
                  <c:v>-8937.3435095742207</c:v>
                </c:pt>
                <c:pt idx="168">
                  <c:v>36486.282141136297</c:v>
                </c:pt>
                <c:pt idx="169">
                  <c:v>48848.829615062903</c:v>
                </c:pt>
                <c:pt idx="170">
                  <c:v>24217.167256656001</c:v>
                </c:pt>
                <c:pt idx="171">
                  <c:v>29896.993795230301</c:v>
                </c:pt>
                <c:pt idx="172">
                  <c:v>70372.770211002295</c:v>
                </c:pt>
                <c:pt idx="173">
                  <c:v>6772.4189440969203</c:v>
                </c:pt>
                <c:pt idx="174">
                  <c:v>-41436.647535780401</c:v>
                </c:pt>
                <c:pt idx="175">
                  <c:v>29511.246678714899</c:v>
                </c:pt>
                <c:pt idx="176">
                  <c:v>87481.137371935401</c:v>
                </c:pt>
                <c:pt idx="177">
                  <c:v>95508.032319819205</c:v>
                </c:pt>
                <c:pt idx="178">
                  <c:v>30827.414586921601</c:v>
                </c:pt>
                <c:pt idx="179">
                  <c:v>-22862.810511385898</c:v>
                </c:pt>
                <c:pt idx="180">
                  <c:v>10621.0239122929</c:v>
                </c:pt>
                <c:pt idx="181">
                  <c:v>35110.661857530802</c:v>
                </c:pt>
                <c:pt idx="182">
                  <c:v>47517.323318814102</c:v>
                </c:pt>
                <c:pt idx="183">
                  <c:v>71494.695653971503</c:v>
                </c:pt>
                <c:pt idx="184">
                  <c:v>94338.474090787699</c:v>
                </c:pt>
                <c:pt idx="185">
                  <c:v>100397.380084651</c:v>
                </c:pt>
                <c:pt idx="186">
                  <c:v>58927.611418128901</c:v>
                </c:pt>
                <c:pt idx="187">
                  <c:v>27215.0220853629</c:v>
                </c:pt>
                <c:pt idx="188">
                  <c:v>6678.1466159009897</c:v>
                </c:pt>
                <c:pt idx="189">
                  <c:v>-33585.601854494802</c:v>
                </c:pt>
                <c:pt idx="190">
                  <c:v>-17208.315775814401</c:v>
                </c:pt>
                <c:pt idx="191">
                  <c:v>35246.154797878698</c:v>
                </c:pt>
                <c:pt idx="192">
                  <c:v>-12322.288779222599</c:v>
                </c:pt>
                <c:pt idx="193">
                  <c:v>0</c:v>
                </c:pt>
                <c:pt idx="194">
                  <c:v>0</c:v>
                </c:pt>
                <c:pt idx="195">
                  <c:v>-20018.098232381799</c:v>
                </c:pt>
                <c:pt idx="196">
                  <c:v>-13144.4098936387</c:v>
                </c:pt>
                <c:pt idx="197">
                  <c:v>-26143.513098193402</c:v>
                </c:pt>
                <c:pt idx="198">
                  <c:v>-38100.287507289999</c:v>
                </c:pt>
                <c:pt idx="199">
                  <c:v>-34171.739323973103</c:v>
                </c:pt>
                <c:pt idx="200">
                  <c:v>40970.066912502298</c:v>
                </c:pt>
                <c:pt idx="201">
                  <c:v>108464.30533478899</c:v>
                </c:pt>
                <c:pt idx="202">
                  <c:v>117082.50622644799</c:v>
                </c:pt>
                <c:pt idx="203">
                  <c:v>90671.024939527502</c:v>
                </c:pt>
                <c:pt idx="204">
                  <c:v>39970.605102968198</c:v>
                </c:pt>
                <c:pt idx="205">
                  <c:v>11206.5361239452</c:v>
                </c:pt>
                <c:pt idx="206">
                  <c:v>46212.911066601097</c:v>
                </c:pt>
                <c:pt idx="207">
                  <c:v>-56243.527774222901</c:v>
                </c:pt>
                <c:pt idx="208">
                  <c:v>30264.157925816398</c:v>
                </c:pt>
                <c:pt idx="209">
                  <c:v>87100.097549952407</c:v>
                </c:pt>
                <c:pt idx="210">
                  <c:v>117280.31796447599</c:v>
                </c:pt>
                <c:pt idx="211">
                  <c:v>63360.275103270498</c:v>
                </c:pt>
                <c:pt idx="212">
                  <c:v>43950.499989050099</c:v>
                </c:pt>
                <c:pt idx="213">
                  <c:v>28095.892647402499</c:v>
                </c:pt>
                <c:pt idx="214">
                  <c:v>22886.792962781499</c:v>
                </c:pt>
                <c:pt idx="215">
                  <c:v>-2.1659711566026099</c:v>
                </c:pt>
                <c:pt idx="216">
                  <c:v>13680.4430396637</c:v>
                </c:pt>
                <c:pt idx="217">
                  <c:v>353.67516445936099</c:v>
                </c:pt>
                <c:pt idx="218">
                  <c:v>-39836.107403212198</c:v>
                </c:pt>
                <c:pt idx="219">
                  <c:v>-49732.075172862002</c:v>
                </c:pt>
                <c:pt idx="220">
                  <c:v>-43412.810889011598</c:v>
                </c:pt>
                <c:pt idx="221">
                  <c:v>-900.36425383557798</c:v>
                </c:pt>
                <c:pt idx="222">
                  <c:v>58631.402238325099</c:v>
                </c:pt>
                <c:pt idx="223">
                  <c:v>10513.997132929</c:v>
                </c:pt>
                <c:pt idx="224">
                  <c:v>-55915.9186347578</c:v>
                </c:pt>
                <c:pt idx="225">
                  <c:v>-42125.139014288703</c:v>
                </c:pt>
                <c:pt idx="226">
                  <c:v>-34599.980506497501</c:v>
                </c:pt>
                <c:pt idx="227">
                  <c:v>-100588.26931104199</c:v>
                </c:pt>
                <c:pt idx="228">
                  <c:v>-60323.636965625199</c:v>
                </c:pt>
                <c:pt idx="229">
                  <c:v>-70465.729127496001</c:v>
                </c:pt>
                <c:pt idx="230">
                  <c:v>-40576.7142816665</c:v>
                </c:pt>
                <c:pt idx="231">
                  <c:v>-79527.593449556894</c:v>
                </c:pt>
                <c:pt idx="232">
                  <c:v>-88347.305318491795</c:v>
                </c:pt>
                <c:pt idx="233">
                  <c:v>-33505.2605517134</c:v>
                </c:pt>
                <c:pt idx="234">
                  <c:v>-7444.2684463280602</c:v>
                </c:pt>
                <c:pt idx="235">
                  <c:v>41732.588273108602</c:v>
                </c:pt>
                <c:pt idx="236">
                  <c:v>25334.8663047273</c:v>
                </c:pt>
                <c:pt idx="237">
                  <c:v>89201.769137657204</c:v>
                </c:pt>
                <c:pt idx="238">
                  <c:v>61368.042128996298</c:v>
                </c:pt>
                <c:pt idx="239">
                  <c:v>-40742.4536400406</c:v>
                </c:pt>
                <c:pt idx="240">
                  <c:v>27336.411683204398</c:v>
                </c:pt>
                <c:pt idx="241">
                  <c:v>-8772.8332871565599</c:v>
                </c:pt>
                <c:pt idx="242">
                  <c:v>-566.53293067980496</c:v>
                </c:pt>
                <c:pt idx="243">
                  <c:v>-29614.148495652302</c:v>
                </c:pt>
                <c:pt idx="244">
                  <c:v>-18687.491075082002</c:v>
                </c:pt>
                <c:pt idx="245">
                  <c:v>58433.688746498803</c:v>
                </c:pt>
                <c:pt idx="246">
                  <c:v>64746.805516061802</c:v>
                </c:pt>
                <c:pt idx="247">
                  <c:v>37977.210274361001</c:v>
                </c:pt>
                <c:pt idx="248">
                  <c:v>-50258.588909119499</c:v>
                </c:pt>
                <c:pt idx="249">
                  <c:v>39882.069777513403</c:v>
                </c:pt>
                <c:pt idx="250">
                  <c:v>-12468.165040464901</c:v>
                </c:pt>
                <c:pt idx="251">
                  <c:v>22148.793402118299</c:v>
                </c:pt>
                <c:pt idx="252">
                  <c:v>-23221.645538430799</c:v>
                </c:pt>
                <c:pt idx="253">
                  <c:v>-25578.947119118799</c:v>
                </c:pt>
                <c:pt idx="254">
                  <c:v>0</c:v>
                </c:pt>
                <c:pt idx="255">
                  <c:v>0</c:v>
                </c:pt>
                <c:pt idx="256">
                  <c:v>-11161.63690949</c:v>
                </c:pt>
                <c:pt idx="257">
                  <c:v>-85004.418140985494</c:v>
                </c:pt>
                <c:pt idx="258">
                  <c:v>-109972.341799175</c:v>
                </c:pt>
                <c:pt idx="259">
                  <c:v>-37017.775069534699</c:v>
                </c:pt>
                <c:pt idx="260">
                  <c:v>-10301.8507917406</c:v>
                </c:pt>
                <c:pt idx="261">
                  <c:v>6488.4069322088799</c:v>
                </c:pt>
                <c:pt idx="262">
                  <c:v>-60041.293099620103</c:v>
                </c:pt>
                <c:pt idx="263">
                  <c:v>-39287.4584419085</c:v>
                </c:pt>
                <c:pt idx="264">
                  <c:v>-93636.401222574103</c:v>
                </c:pt>
                <c:pt idx="265">
                  <c:v>-38152.088568744097</c:v>
                </c:pt>
                <c:pt idx="266">
                  <c:v>85467.726539538504</c:v>
                </c:pt>
                <c:pt idx="267">
                  <c:v>31109.576586211198</c:v>
                </c:pt>
                <c:pt idx="268">
                  <c:v>-14142.1223972018</c:v>
                </c:pt>
                <c:pt idx="269">
                  <c:v>-27277.371517974701</c:v>
                </c:pt>
                <c:pt idx="270">
                  <c:v>-28049.3771791459</c:v>
                </c:pt>
                <c:pt idx="271">
                  <c:v>29504.189683229899</c:v>
                </c:pt>
                <c:pt idx="272">
                  <c:v>62241.877028421797</c:v>
                </c:pt>
                <c:pt idx="273">
                  <c:v>23957.848303942399</c:v>
                </c:pt>
                <c:pt idx="274">
                  <c:v>10525.260903566599</c:v>
                </c:pt>
                <c:pt idx="275">
                  <c:v>130479.565929112</c:v>
                </c:pt>
                <c:pt idx="276">
                  <c:v>98286.6925578511</c:v>
                </c:pt>
                <c:pt idx="277">
                  <c:v>112357.00352531001</c:v>
                </c:pt>
                <c:pt idx="278">
                  <c:v>143974.118588146</c:v>
                </c:pt>
                <c:pt idx="279">
                  <c:v>87882.311802748605</c:v>
                </c:pt>
                <c:pt idx="280">
                  <c:v>88407.245071744706</c:v>
                </c:pt>
                <c:pt idx="281">
                  <c:v>86277.372360346897</c:v>
                </c:pt>
                <c:pt idx="282">
                  <c:v>133029.230152125</c:v>
                </c:pt>
                <c:pt idx="283">
                  <c:v>2696.8093269768301</c:v>
                </c:pt>
                <c:pt idx="284">
                  <c:v>13973.0278996571</c:v>
                </c:pt>
                <c:pt idx="285">
                  <c:v>-18957.632855133401</c:v>
                </c:pt>
                <c:pt idx="286">
                  <c:v>41191.894244271003</c:v>
                </c:pt>
                <c:pt idx="287">
                  <c:v>24012.290257291599</c:v>
                </c:pt>
                <c:pt idx="288">
                  <c:v>-27558.938592991301</c:v>
                </c:pt>
                <c:pt idx="289">
                  <c:v>452.347517116745</c:v>
                </c:pt>
                <c:pt idx="290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8E14-401E-9648-FEF4D823B1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06643072"/>
        <c:axId val="806645368"/>
      </c:scatterChart>
      <c:valAx>
        <c:axId val="806643072"/>
        <c:scaling>
          <c:orientation val="maxMin"/>
          <c:max val="186"/>
          <c:min val="172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806645368"/>
        <c:crosses val="autoZero"/>
        <c:crossBetween val="midCat"/>
        <c:majorUnit val="2"/>
      </c:valAx>
      <c:valAx>
        <c:axId val="806645368"/>
        <c:scaling>
          <c:orientation val="minMax"/>
          <c:max val="1500000"/>
        </c:scaling>
        <c:delete val="1"/>
        <c:axPos val="r"/>
        <c:numFmt formatCode="General" sourceLinked="1"/>
        <c:majorTickMark val="none"/>
        <c:minorTickMark val="none"/>
        <c:tickLblPos val="nextTo"/>
        <c:crossAx val="80664307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  <a:prstDash val="sysDot"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  <c:userShapes r:id="rId4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5.208334472514102E-2"/>
          <c:y val="4.6296296296296294E-2"/>
          <c:w val="0.82387266488903432"/>
          <c:h val="0.89814814814814814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1!$C$1</c:f>
              <c:strCache>
                <c:ptCount val="1"/>
              </c:strCache>
            </c:strRef>
          </c:tx>
          <c:spPr>
            <a:ln w="19050" cap="rnd">
              <a:solidFill>
                <a:schemeClr val="accent1"/>
              </a:solidFill>
              <a:round/>
            </a:ln>
            <a:effectLst/>
          </c:spPr>
          <c:marker>
            <c:symbol val="none"/>
          </c:marker>
          <c:xVal>
            <c:numRef>
              <c:f>Sheet1!$B$2:$B$1893</c:f>
              <c:numCache>
                <c:formatCode>General</c:formatCode>
                <c:ptCount val="1892"/>
                <c:pt idx="0">
                  <c:v>185.38874724170299</c:v>
                </c:pt>
                <c:pt idx="1">
                  <c:v>185.381086990184</c:v>
                </c:pt>
                <c:pt idx="2">
                  <c:v>185.37342673866601</c:v>
                </c:pt>
                <c:pt idx="3">
                  <c:v>185.365766487147</c:v>
                </c:pt>
                <c:pt idx="4">
                  <c:v>185.35810623562799</c:v>
                </c:pt>
                <c:pt idx="5">
                  <c:v>185.350445984109</c:v>
                </c:pt>
                <c:pt idx="6">
                  <c:v>185.34278573258999</c:v>
                </c:pt>
                <c:pt idx="7">
                  <c:v>185.335125481071</c:v>
                </c:pt>
                <c:pt idx="8">
                  <c:v>185.32746522955301</c:v>
                </c:pt>
                <c:pt idx="9">
                  <c:v>185.319804978034</c:v>
                </c:pt>
                <c:pt idx="10">
                  <c:v>185.31214472651499</c:v>
                </c:pt>
                <c:pt idx="11">
                  <c:v>185.304484474996</c:v>
                </c:pt>
                <c:pt idx="12">
                  <c:v>185.29682422347699</c:v>
                </c:pt>
                <c:pt idx="13">
                  <c:v>185.289163971959</c:v>
                </c:pt>
                <c:pt idx="14">
                  <c:v>185.28150372044001</c:v>
                </c:pt>
                <c:pt idx="15">
                  <c:v>185.273843468921</c:v>
                </c:pt>
                <c:pt idx="16">
                  <c:v>185.26618321740199</c:v>
                </c:pt>
                <c:pt idx="17">
                  <c:v>185.258522965883</c:v>
                </c:pt>
                <c:pt idx="18">
                  <c:v>185.25086271436399</c:v>
                </c:pt>
                <c:pt idx="19">
                  <c:v>185.243202462846</c:v>
                </c:pt>
                <c:pt idx="20">
                  <c:v>185.23554221132699</c:v>
                </c:pt>
                <c:pt idx="21">
                  <c:v>185.227881959808</c:v>
                </c:pt>
                <c:pt idx="22">
                  <c:v>185.22022170828899</c:v>
                </c:pt>
                <c:pt idx="23">
                  <c:v>185.21256145677</c:v>
                </c:pt>
                <c:pt idx="24">
                  <c:v>185.20490120525099</c:v>
                </c:pt>
                <c:pt idx="25">
                  <c:v>185.197240953733</c:v>
                </c:pt>
                <c:pt idx="26">
                  <c:v>185.18958070221399</c:v>
                </c:pt>
                <c:pt idx="27">
                  <c:v>184.048203225908</c:v>
                </c:pt>
                <c:pt idx="28">
                  <c:v>184.04054297438901</c:v>
                </c:pt>
                <c:pt idx="29">
                  <c:v>184.03288272287099</c:v>
                </c:pt>
                <c:pt idx="30">
                  <c:v>184.02522247135201</c:v>
                </c:pt>
                <c:pt idx="31">
                  <c:v>184.017562219833</c:v>
                </c:pt>
                <c:pt idx="32">
                  <c:v>184.00990196831401</c:v>
                </c:pt>
                <c:pt idx="33">
                  <c:v>184.002241716795</c:v>
                </c:pt>
                <c:pt idx="34">
                  <c:v>183.99458146527601</c:v>
                </c:pt>
                <c:pt idx="35">
                  <c:v>183.986921213758</c:v>
                </c:pt>
                <c:pt idx="36">
                  <c:v>183.97926096223901</c:v>
                </c:pt>
                <c:pt idx="37">
                  <c:v>183.97160071072</c:v>
                </c:pt>
                <c:pt idx="38">
                  <c:v>183.96394045920101</c:v>
                </c:pt>
                <c:pt idx="39">
                  <c:v>183.956280207682</c:v>
                </c:pt>
                <c:pt idx="40">
                  <c:v>183.94861995616401</c:v>
                </c:pt>
                <c:pt idx="41">
                  <c:v>183.940959704645</c:v>
                </c:pt>
                <c:pt idx="42">
                  <c:v>183.93329945312601</c:v>
                </c:pt>
                <c:pt idx="43">
                  <c:v>183.925639201607</c:v>
                </c:pt>
                <c:pt idx="44">
                  <c:v>183.91797895008801</c:v>
                </c:pt>
                <c:pt idx="45">
                  <c:v>183.910318698569</c:v>
                </c:pt>
                <c:pt idx="46">
                  <c:v>183.90265844705101</c:v>
                </c:pt>
                <c:pt idx="47">
                  <c:v>183.894998195532</c:v>
                </c:pt>
                <c:pt idx="48">
                  <c:v>180.48618626965299</c:v>
                </c:pt>
                <c:pt idx="49">
                  <c:v>180.478526018134</c:v>
                </c:pt>
                <c:pt idx="50">
                  <c:v>180.47086576661499</c:v>
                </c:pt>
                <c:pt idx="51">
                  <c:v>180.46320551509601</c:v>
                </c:pt>
                <c:pt idx="52">
                  <c:v>180.45554526357799</c:v>
                </c:pt>
                <c:pt idx="53">
                  <c:v>180.447885012059</c:v>
                </c:pt>
                <c:pt idx="54">
                  <c:v>180.44022476053999</c:v>
                </c:pt>
                <c:pt idx="55">
                  <c:v>180.43256450902101</c:v>
                </c:pt>
                <c:pt idx="56">
                  <c:v>180.42490425750199</c:v>
                </c:pt>
                <c:pt idx="57">
                  <c:v>180.417244005984</c:v>
                </c:pt>
                <c:pt idx="58">
                  <c:v>180.40958375446499</c:v>
                </c:pt>
                <c:pt idx="59">
                  <c:v>180.401923502946</c:v>
                </c:pt>
                <c:pt idx="60">
                  <c:v>180.39426325142699</c:v>
                </c:pt>
                <c:pt idx="61">
                  <c:v>180.38660299990801</c:v>
                </c:pt>
                <c:pt idx="62">
                  <c:v>180.37894274838899</c:v>
                </c:pt>
                <c:pt idx="63">
                  <c:v>180.371282496871</c:v>
                </c:pt>
                <c:pt idx="64">
                  <c:v>180.36362224535199</c:v>
                </c:pt>
                <c:pt idx="65">
                  <c:v>180.35596199383301</c:v>
                </c:pt>
                <c:pt idx="66">
                  <c:v>180.34830174231399</c:v>
                </c:pt>
                <c:pt idx="67">
                  <c:v>180.34064149079501</c:v>
                </c:pt>
                <c:pt idx="68">
                  <c:v>180.33298123927599</c:v>
                </c:pt>
                <c:pt idx="69">
                  <c:v>180.325320987758</c:v>
                </c:pt>
                <c:pt idx="70">
                  <c:v>180.31766073623899</c:v>
                </c:pt>
                <c:pt idx="71">
                  <c:v>180.31000048472001</c:v>
                </c:pt>
                <c:pt idx="72">
                  <c:v>180.30234023320099</c:v>
                </c:pt>
                <c:pt idx="73">
                  <c:v>180.29467998168201</c:v>
                </c:pt>
                <c:pt idx="74">
                  <c:v>180.287019730163</c:v>
                </c:pt>
                <c:pt idx="75">
                  <c:v>180.27935947864501</c:v>
                </c:pt>
                <c:pt idx="76">
                  <c:v>180.27169922712599</c:v>
                </c:pt>
                <c:pt idx="77">
                  <c:v>180.26403897560701</c:v>
                </c:pt>
                <c:pt idx="78">
                  <c:v>180.25637872408799</c:v>
                </c:pt>
                <c:pt idx="79">
                  <c:v>180.24871847256901</c:v>
                </c:pt>
                <c:pt idx="80">
                  <c:v>180.24105822105</c:v>
                </c:pt>
                <c:pt idx="81">
                  <c:v>180.23339796953201</c:v>
                </c:pt>
                <c:pt idx="82">
                  <c:v>180.22573771801299</c:v>
                </c:pt>
                <c:pt idx="83">
                  <c:v>180.21807746649401</c:v>
                </c:pt>
                <c:pt idx="84">
                  <c:v>180.210417214975</c:v>
                </c:pt>
                <c:pt idx="85">
                  <c:v>180.20275696345601</c:v>
                </c:pt>
                <c:pt idx="86">
                  <c:v>180.195096711937</c:v>
                </c:pt>
                <c:pt idx="87">
                  <c:v>180.18743646041901</c:v>
                </c:pt>
                <c:pt idx="88">
                  <c:v>180.17977620889999</c:v>
                </c:pt>
                <c:pt idx="89">
                  <c:v>178.724328420322</c:v>
                </c:pt>
                <c:pt idx="90">
                  <c:v>178.71666816880401</c:v>
                </c:pt>
                <c:pt idx="91">
                  <c:v>178.70900791728499</c:v>
                </c:pt>
                <c:pt idx="92">
                  <c:v>178.70134766576601</c:v>
                </c:pt>
                <c:pt idx="93">
                  <c:v>178.69368741424699</c:v>
                </c:pt>
                <c:pt idx="94">
                  <c:v>178.68602716272801</c:v>
                </c:pt>
                <c:pt idx="95">
                  <c:v>178.678366911209</c:v>
                </c:pt>
                <c:pt idx="96">
                  <c:v>178.67070665969101</c:v>
                </c:pt>
                <c:pt idx="97">
                  <c:v>178.66304640817199</c:v>
                </c:pt>
                <c:pt idx="98">
                  <c:v>178.65538615665301</c:v>
                </c:pt>
                <c:pt idx="99">
                  <c:v>178.647725905134</c:v>
                </c:pt>
                <c:pt idx="100">
                  <c:v>178.64006565361501</c:v>
                </c:pt>
                <c:pt idx="101">
                  <c:v>178.632405402096</c:v>
                </c:pt>
                <c:pt idx="102">
                  <c:v>178.62474515057801</c:v>
                </c:pt>
                <c:pt idx="103">
                  <c:v>178.61708489905899</c:v>
                </c:pt>
                <c:pt idx="104">
                  <c:v>178.60942464754001</c:v>
                </c:pt>
                <c:pt idx="105">
                  <c:v>178.601764396021</c:v>
                </c:pt>
                <c:pt idx="106">
                  <c:v>178.59410414450201</c:v>
                </c:pt>
                <c:pt idx="107">
                  <c:v>178.586443892983</c:v>
                </c:pt>
                <c:pt idx="108">
                  <c:v>178.57878364146501</c:v>
                </c:pt>
                <c:pt idx="109">
                  <c:v>178.571123389946</c:v>
                </c:pt>
                <c:pt idx="110">
                  <c:v>178.56346313842701</c:v>
                </c:pt>
                <c:pt idx="111">
                  <c:v>178.555802886908</c:v>
                </c:pt>
                <c:pt idx="112">
                  <c:v>178.54814263538901</c:v>
                </c:pt>
                <c:pt idx="113">
                  <c:v>178.54048238387</c:v>
                </c:pt>
                <c:pt idx="114">
                  <c:v>178.53282213235201</c:v>
                </c:pt>
                <c:pt idx="115">
                  <c:v>177.38378440452701</c:v>
                </c:pt>
                <c:pt idx="116">
                  <c:v>177.37612415300899</c:v>
                </c:pt>
                <c:pt idx="117">
                  <c:v>177.36846390149</c:v>
                </c:pt>
                <c:pt idx="118">
                  <c:v>177.36080364997099</c:v>
                </c:pt>
                <c:pt idx="119">
                  <c:v>177.353143398452</c:v>
                </c:pt>
                <c:pt idx="120">
                  <c:v>177.34548314693299</c:v>
                </c:pt>
                <c:pt idx="121">
                  <c:v>177.33782289541401</c:v>
                </c:pt>
                <c:pt idx="122">
                  <c:v>177.33016264389599</c:v>
                </c:pt>
                <c:pt idx="123">
                  <c:v>177.322502392377</c:v>
                </c:pt>
                <c:pt idx="124">
                  <c:v>177.31484214085799</c:v>
                </c:pt>
                <c:pt idx="125">
                  <c:v>177.30718188933901</c:v>
                </c:pt>
                <c:pt idx="126">
                  <c:v>177.29952163781999</c:v>
                </c:pt>
                <c:pt idx="127">
                  <c:v>177.29186138630101</c:v>
                </c:pt>
                <c:pt idx="128">
                  <c:v>177.28420113478299</c:v>
                </c:pt>
                <c:pt idx="129">
                  <c:v>177.276540883264</c:v>
                </c:pt>
                <c:pt idx="130">
                  <c:v>177.26888063174499</c:v>
                </c:pt>
                <c:pt idx="131">
                  <c:v>176.92416931339801</c:v>
                </c:pt>
                <c:pt idx="132">
                  <c:v>176.916509061879</c:v>
                </c:pt>
                <c:pt idx="133">
                  <c:v>176.90884881036001</c:v>
                </c:pt>
                <c:pt idx="134">
                  <c:v>176.901188558841</c:v>
                </c:pt>
                <c:pt idx="135">
                  <c:v>176.89352830732199</c:v>
                </c:pt>
                <c:pt idx="136">
                  <c:v>176.885868055803</c:v>
                </c:pt>
                <c:pt idx="137">
                  <c:v>176.87820780428501</c:v>
                </c:pt>
                <c:pt idx="138">
                  <c:v>176.870547552766</c:v>
                </c:pt>
                <c:pt idx="139">
                  <c:v>176.86288730124701</c:v>
                </c:pt>
                <c:pt idx="140">
                  <c:v>176.855227049728</c:v>
                </c:pt>
                <c:pt idx="141">
                  <c:v>176.84756679820899</c:v>
                </c:pt>
                <c:pt idx="142">
                  <c:v>176.839906546691</c:v>
                </c:pt>
                <c:pt idx="143">
                  <c:v>176.83224629517201</c:v>
                </c:pt>
                <c:pt idx="144">
                  <c:v>176.824586043653</c:v>
                </c:pt>
                <c:pt idx="145">
                  <c:v>176.81692579213399</c:v>
                </c:pt>
                <c:pt idx="146">
                  <c:v>176.809265540615</c:v>
                </c:pt>
                <c:pt idx="147">
                  <c:v>176.80160528909599</c:v>
                </c:pt>
                <c:pt idx="148">
                  <c:v>176.793945037578</c:v>
                </c:pt>
                <c:pt idx="149">
                  <c:v>176.78628478605901</c:v>
                </c:pt>
                <c:pt idx="150">
                  <c:v>176.77862453454</c:v>
                </c:pt>
                <c:pt idx="151">
                  <c:v>176.77096428302099</c:v>
                </c:pt>
                <c:pt idx="152">
                  <c:v>175.430420267226</c:v>
                </c:pt>
                <c:pt idx="153">
                  <c:v>175.42276001570701</c:v>
                </c:pt>
                <c:pt idx="154">
                  <c:v>175.415099764188</c:v>
                </c:pt>
                <c:pt idx="155">
                  <c:v>175.40743951267001</c:v>
                </c:pt>
                <c:pt idx="156">
                  <c:v>175.399779261151</c:v>
                </c:pt>
                <c:pt idx="157">
                  <c:v>175.39211900963201</c:v>
                </c:pt>
                <c:pt idx="158">
                  <c:v>175.384458758113</c:v>
                </c:pt>
                <c:pt idx="159">
                  <c:v>175.37679850659401</c:v>
                </c:pt>
                <c:pt idx="160">
                  <c:v>175.369138255075</c:v>
                </c:pt>
                <c:pt idx="161">
                  <c:v>175.36147800355701</c:v>
                </c:pt>
                <c:pt idx="162">
                  <c:v>175.353817752038</c:v>
                </c:pt>
                <c:pt idx="163">
                  <c:v>175.34615750051901</c:v>
                </c:pt>
                <c:pt idx="164">
                  <c:v>175.338497249</c:v>
                </c:pt>
                <c:pt idx="165">
                  <c:v>175.33083699748099</c:v>
                </c:pt>
                <c:pt idx="166">
                  <c:v>175.323176745962</c:v>
                </c:pt>
                <c:pt idx="167">
                  <c:v>175.31551649444401</c:v>
                </c:pt>
                <c:pt idx="168">
                  <c:v>175.307856242925</c:v>
                </c:pt>
                <c:pt idx="169">
                  <c:v>175.30019599140601</c:v>
                </c:pt>
                <c:pt idx="170">
                  <c:v>175.292535739887</c:v>
                </c:pt>
                <c:pt idx="171">
                  <c:v>175.28487548836799</c:v>
                </c:pt>
                <c:pt idx="172">
                  <c:v>175.277215236849</c:v>
                </c:pt>
                <c:pt idx="173">
                  <c:v>175.26955498533101</c:v>
                </c:pt>
                <c:pt idx="174">
                  <c:v>175.261894733812</c:v>
                </c:pt>
                <c:pt idx="175">
                  <c:v>175.25423448229299</c:v>
                </c:pt>
                <c:pt idx="176">
                  <c:v>175.246574230774</c:v>
                </c:pt>
                <c:pt idx="177">
                  <c:v>175.23891397925499</c:v>
                </c:pt>
                <c:pt idx="178">
                  <c:v>175.231253727737</c:v>
                </c:pt>
                <c:pt idx="179">
                  <c:v>175.22359347621801</c:v>
                </c:pt>
                <c:pt idx="180">
                  <c:v>175.215933224699</c:v>
                </c:pt>
                <c:pt idx="181">
                  <c:v>175.20827297317999</c:v>
                </c:pt>
                <c:pt idx="182">
                  <c:v>175.200612721661</c:v>
                </c:pt>
                <c:pt idx="183">
                  <c:v>175.19295247014199</c:v>
                </c:pt>
                <c:pt idx="184">
                  <c:v>175.185292218624</c:v>
                </c:pt>
                <c:pt idx="185">
                  <c:v>175.17763196710499</c:v>
                </c:pt>
                <c:pt idx="186">
                  <c:v>175.169971715586</c:v>
                </c:pt>
                <c:pt idx="187">
                  <c:v>175.16231146406699</c:v>
                </c:pt>
                <c:pt idx="188">
                  <c:v>175.154651212548</c:v>
                </c:pt>
                <c:pt idx="189">
                  <c:v>175.14699096102899</c:v>
                </c:pt>
                <c:pt idx="190">
                  <c:v>175.139330709511</c:v>
                </c:pt>
                <c:pt idx="191">
                  <c:v>175.13167045799199</c:v>
                </c:pt>
                <c:pt idx="192">
                  <c:v>175.124010206473</c:v>
                </c:pt>
                <c:pt idx="193">
                  <c:v>175.11634995495399</c:v>
                </c:pt>
                <c:pt idx="194">
                  <c:v>174.58779260015501</c:v>
                </c:pt>
                <c:pt idx="195">
                  <c:v>174.580132348636</c:v>
                </c:pt>
                <c:pt idx="196">
                  <c:v>174.57247209711699</c:v>
                </c:pt>
                <c:pt idx="197">
                  <c:v>174.564811845598</c:v>
                </c:pt>
                <c:pt idx="198">
                  <c:v>174.55715159408001</c:v>
                </c:pt>
                <c:pt idx="199">
                  <c:v>174.549491342561</c:v>
                </c:pt>
                <c:pt idx="200">
                  <c:v>174.54183109104201</c:v>
                </c:pt>
                <c:pt idx="201">
                  <c:v>174.534170839523</c:v>
                </c:pt>
                <c:pt idx="202">
                  <c:v>174.52651058800399</c:v>
                </c:pt>
                <c:pt idx="203">
                  <c:v>174.518850336485</c:v>
                </c:pt>
                <c:pt idx="204">
                  <c:v>174.51119008496701</c:v>
                </c:pt>
                <c:pt idx="205">
                  <c:v>174.503529833448</c:v>
                </c:pt>
                <c:pt idx="206">
                  <c:v>174.49586958192901</c:v>
                </c:pt>
                <c:pt idx="207">
                  <c:v>174.48820933041</c:v>
                </c:pt>
                <c:pt idx="208">
                  <c:v>174.48054907889099</c:v>
                </c:pt>
                <c:pt idx="209">
                  <c:v>174.472888827372</c:v>
                </c:pt>
                <c:pt idx="210">
                  <c:v>174.46522857585401</c:v>
                </c:pt>
                <c:pt idx="211">
                  <c:v>174.457568324335</c:v>
                </c:pt>
                <c:pt idx="212">
                  <c:v>174.44990807281599</c:v>
                </c:pt>
                <c:pt idx="213">
                  <c:v>174.442247821297</c:v>
                </c:pt>
                <c:pt idx="214">
                  <c:v>174.43458756977799</c:v>
                </c:pt>
                <c:pt idx="215">
                  <c:v>174.42692731826</c:v>
                </c:pt>
                <c:pt idx="216">
                  <c:v>174.41926706674101</c:v>
                </c:pt>
                <c:pt idx="217">
                  <c:v>174.411606815222</c:v>
                </c:pt>
                <c:pt idx="218">
                  <c:v>174.40394656370299</c:v>
                </c:pt>
                <c:pt idx="219">
                  <c:v>174.396286312184</c:v>
                </c:pt>
                <c:pt idx="220">
                  <c:v>174.38862606066499</c:v>
                </c:pt>
                <c:pt idx="221">
                  <c:v>174.380965809147</c:v>
                </c:pt>
                <c:pt idx="222">
                  <c:v>174.37330555762799</c:v>
                </c:pt>
                <c:pt idx="223">
                  <c:v>174.365645306109</c:v>
                </c:pt>
                <c:pt idx="224">
                  <c:v>174.35798505458999</c:v>
                </c:pt>
                <c:pt idx="225">
                  <c:v>174.350324803071</c:v>
                </c:pt>
                <c:pt idx="226">
                  <c:v>174.34266455155199</c:v>
                </c:pt>
                <c:pt idx="227">
                  <c:v>174.335004300034</c:v>
                </c:pt>
                <c:pt idx="228">
                  <c:v>174.32734404851499</c:v>
                </c:pt>
                <c:pt idx="229">
                  <c:v>174.319683796996</c:v>
                </c:pt>
                <c:pt idx="230">
                  <c:v>174.31202354547699</c:v>
                </c:pt>
                <c:pt idx="231">
                  <c:v>174.304363293958</c:v>
                </c:pt>
                <c:pt idx="232">
                  <c:v>174.29670304243899</c:v>
                </c:pt>
                <c:pt idx="233">
                  <c:v>174.289042790921</c:v>
                </c:pt>
                <c:pt idx="234">
                  <c:v>174.28138253940199</c:v>
                </c:pt>
                <c:pt idx="235">
                  <c:v>174.273722287883</c:v>
                </c:pt>
                <c:pt idx="236">
                  <c:v>174.26606203636399</c:v>
                </c:pt>
                <c:pt idx="237">
                  <c:v>174.25840178484501</c:v>
                </c:pt>
                <c:pt idx="238">
                  <c:v>174.25074153332599</c:v>
                </c:pt>
                <c:pt idx="239">
                  <c:v>174.243081281808</c:v>
                </c:pt>
                <c:pt idx="240">
                  <c:v>174.23542103028899</c:v>
                </c:pt>
                <c:pt idx="241">
                  <c:v>174.22776077877</c:v>
                </c:pt>
                <c:pt idx="242">
                  <c:v>174.22010052725099</c:v>
                </c:pt>
                <c:pt idx="243">
                  <c:v>174.21244027573201</c:v>
                </c:pt>
                <c:pt idx="244">
                  <c:v>174.20478002421299</c:v>
                </c:pt>
                <c:pt idx="245">
                  <c:v>174.197119772695</c:v>
                </c:pt>
                <c:pt idx="246">
                  <c:v>174.18945952117599</c:v>
                </c:pt>
                <c:pt idx="247">
                  <c:v>174.18179926965701</c:v>
                </c:pt>
                <c:pt idx="248">
                  <c:v>174.17413901813799</c:v>
                </c:pt>
                <c:pt idx="249">
                  <c:v>174.16647876661901</c:v>
                </c:pt>
                <c:pt idx="250">
                  <c:v>174.15881851509999</c:v>
                </c:pt>
                <c:pt idx="251">
                  <c:v>174.151158263582</c:v>
                </c:pt>
                <c:pt idx="252">
                  <c:v>174.14349801206299</c:v>
                </c:pt>
                <c:pt idx="253">
                  <c:v>174.13583776054401</c:v>
                </c:pt>
                <c:pt idx="254">
                  <c:v>174.12817750902499</c:v>
                </c:pt>
                <c:pt idx="255">
                  <c:v>173.821767448272</c:v>
                </c:pt>
                <c:pt idx="256">
                  <c:v>173.81410719675301</c:v>
                </c:pt>
                <c:pt idx="257">
                  <c:v>173.806446945234</c:v>
                </c:pt>
                <c:pt idx="258">
                  <c:v>173.79878669371601</c:v>
                </c:pt>
                <c:pt idx="259">
                  <c:v>173.791126442197</c:v>
                </c:pt>
                <c:pt idx="260">
                  <c:v>173.78346619067801</c:v>
                </c:pt>
                <c:pt idx="261">
                  <c:v>173.775805939159</c:v>
                </c:pt>
                <c:pt idx="262">
                  <c:v>173.76814568763999</c:v>
                </c:pt>
                <c:pt idx="263">
                  <c:v>173.760485436121</c:v>
                </c:pt>
                <c:pt idx="264">
                  <c:v>173.75282518460301</c:v>
                </c:pt>
                <c:pt idx="265">
                  <c:v>173.745164933084</c:v>
                </c:pt>
                <c:pt idx="266">
                  <c:v>173.73750468156501</c:v>
                </c:pt>
                <c:pt idx="267">
                  <c:v>173.729844430046</c:v>
                </c:pt>
                <c:pt idx="268">
                  <c:v>173.72218417852699</c:v>
                </c:pt>
                <c:pt idx="269">
                  <c:v>173.714523927008</c:v>
                </c:pt>
                <c:pt idx="270">
                  <c:v>173.70686367549001</c:v>
                </c:pt>
                <c:pt idx="271">
                  <c:v>173.699203423971</c:v>
                </c:pt>
                <c:pt idx="272">
                  <c:v>173.69154317245199</c:v>
                </c:pt>
                <c:pt idx="273">
                  <c:v>173.683882920933</c:v>
                </c:pt>
                <c:pt idx="274">
                  <c:v>173.67622266941399</c:v>
                </c:pt>
                <c:pt idx="275">
                  <c:v>173.668562417895</c:v>
                </c:pt>
                <c:pt idx="276">
                  <c:v>173.66090216637701</c:v>
                </c:pt>
                <c:pt idx="277">
                  <c:v>173.653241914858</c:v>
                </c:pt>
                <c:pt idx="278">
                  <c:v>173.64558166333899</c:v>
                </c:pt>
                <c:pt idx="279">
                  <c:v>173.63792141182</c:v>
                </c:pt>
                <c:pt idx="280">
                  <c:v>173.63026116030099</c:v>
                </c:pt>
                <c:pt idx="281">
                  <c:v>173.622600908783</c:v>
                </c:pt>
                <c:pt idx="282">
                  <c:v>173.61494065726399</c:v>
                </c:pt>
                <c:pt idx="283">
                  <c:v>173.607280405745</c:v>
                </c:pt>
                <c:pt idx="284">
                  <c:v>173.59962015422599</c:v>
                </c:pt>
                <c:pt idx="285">
                  <c:v>173.591959902707</c:v>
                </c:pt>
                <c:pt idx="286">
                  <c:v>173.58429965118799</c:v>
                </c:pt>
                <c:pt idx="287">
                  <c:v>173.57663939967</c:v>
                </c:pt>
                <c:pt idx="288">
                  <c:v>173.56897914815099</c:v>
                </c:pt>
                <c:pt idx="289">
                  <c:v>173.561318896632</c:v>
                </c:pt>
                <c:pt idx="290">
                  <c:v>173.55365864511299</c:v>
                </c:pt>
                <c:pt idx="291">
                  <c:v>163.1740178371</c:v>
                </c:pt>
                <c:pt idx="292">
                  <c:v>163.16635758558101</c:v>
                </c:pt>
                <c:pt idx="293">
                  <c:v>163.15869733406299</c:v>
                </c:pt>
                <c:pt idx="294">
                  <c:v>163.15103708254401</c:v>
                </c:pt>
                <c:pt idx="295">
                  <c:v>163.14337683102499</c:v>
                </c:pt>
                <c:pt idx="296">
                  <c:v>163.13571657950601</c:v>
                </c:pt>
                <c:pt idx="297">
                  <c:v>163.128056327987</c:v>
                </c:pt>
                <c:pt idx="298">
                  <c:v>163.12039607646801</c:v>
                </c:pt>
                <c:pt idx="299">
                  <c:v>163.11273582494999</c:v>
                </c:pt>
                <c:pt idx="300">
                  <c:v>163.10507557343101</c:v>
                </c:pt>
                <c:pt idx="301">
                  <c:v>163.097415321912</c:v>
                </c:pt>
                <c:pt idx="302">
                  <c:v>163.08975507039301</c:v>
                </c:pt>
                <c:pt idx="303">
                  <c:v>163.082094818874</c:v>
                </c:pt>
                <c:pt idx="304">
                  <c:v>163.07443456735501</c:v>
                </c:pt>
                <c:pt idx="305">
                  <c:v>163.06677431583699</c:v>
                </c:pt>
                <c:pt idx="306">
                  <c:v>163.05911406431801</c:v>
                </c:pt>
                <c:pt idx="307">
                  <c:v>163.051453812799</c:v>
                </c:pt>
                <c:pt idx="308">
                  <c:v>163.04379356128001</c:v>
                </c:pt>
                <c:pt idx="309">
                  <c:v>132.341505473815</c:v>
                </c:pt>
                <c:pt idx="310">
                  <c:v>132.33384522229599</c:v>
                </c:pt>
                <c:pt idx="311">
                  <c:v>132.32618497077701</c:v>
                </c:pt>
                <c:pt idx="312">
                  <c:v>132.31852471925799</c:v>
                </c:pt>
                <c:pt idx="313">
                  <c:v>132.31086446774</c:v>
                </c:pt>
                <c:pt idx="314">
                  <c:v>132.30320421622099</c:v>
                </c:pt>
                <c:pt idx="315">
                  <c:v>132.29554396470201</c:v>
                </c:pt>
                <c:pt idx="316">
                  <c:v>132.28788371318299</c:v>
                </c:pt>
                <c:pt idx="317">
                  <c:v>132.28022346166401</c:v>
                </c:pt>
                <c:pt idx="318">
                  <c:v>132.27256321014499</c:v>
                </c:pt>
                <c:pt idx="319">
                  <c:v>132.264902958627</c:v>
                </c:pt>
                <c:pt idx="320">
                  <c:v>132.25724270710799</c:v>
                </c:pt>
                <c:pt idx="321">
                  <c:v>132.24958245558901</c:v>
                </c:pt>
                <c:pt idx="322">
                  <c:v>132.24192220406999</c:v>
                </c:pt>
                <c:pt idx="323">
                  <c:v>132.23426195255101</c:v>
                </c:pt>
                <c:pt idx="324">
                  <c:v>132.22660170103299</c:v>
                </c:pt>
                <c:pt idx="325">
                  <c:v>132.21894144951401</c:v>
                </c:pt>
                <c:pt idx="326">
                  <c:v>132.21128119799499</c:v>
                </c:pt>
                <c:pt idx="327">
                  <c:v>132.20362094647601</c:v>
                </c:pt>
                <c:pt idx="328">
                  <c:v>132.19596069495699</c:v>
                </c:pt>
                <c:pt idx="329">
                  <c:v>132.18830044343801</c:v>
                </c:pt>
                <c:pt idx="330">
                  <c:v>132.18064019191999</c:v>
                </c:pt>
                <c:pt idx="331">
                  <c:v>132.17297994040101</c:v>
                </c:pt>
                <c:pt idx="332">
                  <c:v>132.16531968888199</c:v>
                </c:pt>
                <c:pt idx="333">
                  <c:v>132.15765943736301</c:v>
                </c:pt>
                <c:pt idx="334">
                  <c:v>132.149999185844</c:v>
                </c:pt>
                <c:pt idx="335">
                  <c:v>132.14233893432501</c:v>
                </c:pt>
                <c:pt idx="336">
                  <c:v>132.13467868280699</c:v>
                </c:pt>
                <c:pt idx="337">
                  <c:v>132.12701843128801</c:v>
                </c:pt>
                <c:pt idx="338">
                  <c:v>132.11935817976899</c:v>
                </c:pt>
                <c:pt idx="339">
                  <c:v>132.11169792825001</c:v>
                </c:pt>
                <c:pt idx="340">
                  <c:v>132.104037676731</c:v>
                </c:pt>
                <c:pt idx="341">
                  <c:v>132.09637742521201</c:v>
                </c:pt>
                <c:pt idx="342">
                  <c:v>132.08871717369399</c:v>
                </c:pt>
                <c:pt idx="343">
                  <c:v>132.08105692217501</c:v>
                </c:pt>
                <c:pt idx="344">
                  <c:v>132.073396670656</c:v>
                </c:pt>
                <c:pt idx="345">
                  <c:v>132.06573641913701</c:v>
                </c:pt>
                <c:pt idx="346">
                  <c:v>132.058076167618</c:v>
                </c:pt>
                <c:pt idx="347">
                  <c:v>132.05041591609901</c:v>
                </c:pt>
                <c:pt idx="348">
                  <c:v>132.04275566458099</c:v>
                </c:pt>
                <c:pt idx="349">
                  <c:v>132.03509541306201</c:v>
                </c:pt>
                <c:pt idx="350">
                  <c:v>130.69455139726699</c:v>
                </c:pt>
                <c:pt idx="351">
                  <c:v>130.68689114574801</c:v>
                </c:pt>
                <c:pt idx="352">
                  <c:v>130.67923089422899</c:v>
                </c:pt>
                <c:pt idx="353">
                  <c:v>130.67157064271001</c:v>
                </c:pt>
                <c:pt idx="354">
                  <c:v>130.663910391191</c:v>
                </c:pt>
                <c:pt idx="355">
                  <c:v>130.65625013967301</c:v>
                </c:pt>
                <c:pt idx="356">
                  <c:v>130.64858988815399</c:v>
                </c:pt>
                <c:pt idx="357">
                  <c:v>130.64092963663501</c:v>
                </c:pt>
                <c:pt idx="358">
                  <c:v>130.63326938511599</c:v>
                </c:pt>
                <c:pt idx="359">
                  <c:v>130.62560913359701</c:v>
                </c:pt>
                <c:pt idx="360">
                  <c:v>130.61794888207899</c:v>
                </c:pt>
                <c:pt idx="361">
                  <c:v>130.61028863056001</c:v>
                </c:pt>
                <c:pt idx="362">
                  <c:v>130.60262837904099</c:v>
                </c:pt>
                <c:pt idx="363">
                  <c:v>130.59496812752201</c:v>
                </c:pt>
                <c:pt idx="364">
                  <c:v>130.587307876003</c:v>
                </c:pt>
                <c:pt idx="365">
                  <c:v>130.57964762448401</c:v>
                </c:pt>
                <c:pt idx="366">
                  <c:v>130.57198737296599</c:v>
                </c:pt>
                <c:pt idx="367">
                  <c:v>130.56432712144701</c:v>
                </c:pt>
                <c:pt idx="368">
                  <c:v>130.55666686992799</c:v>
                </c:pt>
                <c:pt idx="369">
                  <c:v>130.54900661840901</c:v>
                </c:pt>
                <c:pt idx="370">
                  <c:v>130.54134636689</c:v>
                </c:pt>
                <c:pt idx="371">
                  <c:v>130.53368611537101</c:v>
                </c:pt>
                <c:pt idx="372">
                  <c:v>130.52602586385299</c:v>
                </c:pt>
                <c:pt idx="373">
                  <c:v>130.51836561233401</c:v>
                </c:pt>
                <c:pt idx="374">
                  <c:v>130.510705360815</c:v>
                </c:pt>
                <c:pt idx="375">
                  <c:v>130.50304510929601</c:v>
                </c:pt>
                <c:pt idx="376">
                  <c:v>130.495384857777</c:v>
                </c:pt>
                <c:pt idx="377">
                  <c:v>130.48772460625801</c:v>
                </c:pt>
                <c:pt idx="378">
                  <c:v>130.48006435473999</c:v>
                </c:pt>
                <c:pt idx="379">
                  <c:v>130.47240410322101</c:v>
                </c:pt>
                <c:pt idx="380">
                  <c:v>130.464743851702</c:v>
                </c:pt>
                <c:pt idx="381">
                  <c:v>130.45708360018301</c:v>
                </c:pt>
                <c:pt idx="382">
                  <c:v>130.449423348664</c:v>
                </c:pt>
                <c:pt idx="383">
                  <c:v>130.44176309714501</c:v>
                </c:pt>
                <c:pt idx="384">
                  <c:v>130.434102845627</c:v>
                </c:pt>
                <c:pt idx="385">
                  <c:v>130.42644259410801</c:v>
                </c:pt>
                <c:pt idx="386">
                  <c:v>130.418782342589</c:v>
                </c:pt>
                <c:pt idx="387">
                  <c:v>130.41112209107001</c:v>
                </c:pt>
                <c:pt idx="388">
                  <c:v>130.403461839551</c:v>
                </c:pt>
                <c:pt idx="389">
                  <c:v>130.39580158803199</c:v>
                </c:pt>
                <c:pt idx="390">
                  <c:v>130.388141336514</c:v>
                </c:pt>
                <c:pt idx="391">
                  <c:v>75.310932916135698</c:v>
                </c:pt>
                <c:pt idx="392">
                  <c:v>75.303272664616898</c:v>
                </c:pt>
                <c:pt idx="393">
                  <c:v>75.295612413098098</c:v>
                </c:pt>
                <c:pt idx="394">
                  <c:v>75.287952161579199</c:v>
                </c:pt>
                <c:pt idx="395">
                  <c:v>75.280291910060399</c:v>
                </c:pt>
                <c:pt idx="396">
                  <c:v>75.272631658541599</c:v>
                </c:pt>
                <c:pt idx="397">
                  <c:v>75.264971407022699</c:v>
                </c:pt>
                <c:pt idx="398">
                  <c:v>75.257311155503899</c:v>
                </c:pt>
                <c:pt idx="399">
                  <c:v>75.249650903985099</c:v>
                </c:pt>
                <c:pt idx="400">
                  <c:v>75.241990652466299</c:v>
                </c:pt>
                <c:pt idx="401">
                  <c:v>75.2343304009474</c:v>
                </c:pt>
                <c:pt idx="402">
                  <c:v>75.2266701494286</c:v>
                </c:pt>
                <c:pt idx="403">
                  <c:v>75.2190098979098</c:v>
                </c:pt>
                <c:pt idx="404">
                  <c:v>75.2113496463909</c:v>
                </c:pt>
                <c:pt idx="405">
                  <c:v>75.2036893948721</c:v>
                </c:pt>
                <c:pt idx="406">
                  <c:v>75.1960291433533</c:v>
                </c:pt>
                <c:pt idx="407">
                  <c:v>75.1883688918345</c:v>
                </c:pt>
                <c:pt idx="408">
                  <c:v>75.180708640315601</c:v>
                </c:pt>
                <c:pt idx="409">
                  <c:v>75.173048388796801</c:v>
                </c:pt>
                <c:pt idx="410">
                  <c:v>75.165388137278001</c:v>
                </c:pt>
                <c:pt idx="411">
                  <c:v>75.157727885759101</c:v>
                </c:pt>
                <c:pt idx="412">
                  <c:v>75.150067634240301</c:v>
                </c:pt>
                <c:pt idx="413">
                  <c:v>75.142407382721501</c:v>
                </c:pt>
                <c:pt idx="414">
                  <c:v>75.134747131202701</c:v>
                </c:pt>
                <c:pt idx="415">
                  <c:v>75.127086879683802</c:v>
                </c:pt>
                <c:pt idx="416">
                  <c:v>75.119426628165002</c:v>
                </c:pt>
                <c:pt idx="417">
                  <c:v>75.111766376646202</c:v>
                </c:pt>
                <c:pt idx="418">
                  <c:v>75.104106125127302</c:v>
                </c:pt>
                <c:pt idx="419">
                  <c:v>75.096445873608502</c:v>
                </c:pt>
                <c:pt idx="420">
                  <c:v>75.088785622089702</c:v>
                </c:pt>
                <c:pt idx="421">
                  <c:v>75.081125370570902</c:v>
                </c:pt>
                <c:pt idx="422">
                  <c:v>75.073465119052003</c:v>
                </c:pt>
                <c:pt idx="423">
                  <c:v>75.065804867533203</c:v>
                </c:pt>
                <c:pt idx="424">
                  <c:v>75.058144616014403</c:v>
                </c:pt>
                <c:pt idx="425">
                  <c:v>75.050484364495603</c:v>
                </c:pt>
                <c:pt idx="426">
                  <c:v>75.042824112976703</c:v>
                </c:pt>
                <c:pt idx="427">
                  <c:v>75.035163861457903</c:v>
                </c:pt>
                <c:pt idx="428">
                  <c:v>75.027503609939103</c:v>
                </c:pt>
                <c:pt idx="429">
                  <c:v>75.019843358420204</c:v>
                </c:pt>
                <c:pt idx="430">
                  <c:v>75.012183106901404</c:v>
                </c:pt>
                <c:pt idx="431">
                  <c:v>75.004522855382604</c:v>
                </c:pt>
                <c:pt idx="432">
                  <c:v>73.932087642746595</c:v>
                </c:pt>
                <c:pt idx="433">
                  <c:v>73.924427391227695</c:v>
                </c:pt>
                <c:pt idx="434">
                  <c:v>73.916767139708895</c:v>
                </c:pt>
                <c:pt idx="435">
                  <c:v>73.909106888190095</c:v>
                </c:pt>
                <c:pt idx="436">
                  <c:v>73.901446636671295</c:v>
                </c:pt>
                <c:pt idx="437">
                  <c:v>73.893786385152396</c:v>
                </c:pt>
                <c:pt idx="438">
                  <c:v>73.886126133633596</c:v>
                </c:pt>
                <c:pt idx="439">
                  <c:v>73.878465882114796</c:v>
                </c:pt>
                <c:pt idx="440">
                  <c:v>73.870805630595896</c:v>
                </c:pt>
                <c:pt idx="441">
                  <c:v>73.863145379077096</c:v>
                </c:pt>
                <c:pt idx="442">
                  <c:v>73.855485127558296</c:v>
                </c:pt>
                <c:pt idx="443">
                  <c:v>73.847824876039496</c:v>
                </c:pt>
                <c:pt idx="444">
                  <c:v>73.840164624520597</c:v>
                </c:pt>
                <c:pt idx="445">
                  <c:v>73.832504373001797</c:v>
                </c:pt>
                <c:pt idx="446">
                  <c:v>73.824844121482997</c:v>
                </c:pt>
                <c:pt idx="447">
                  <c:v>73.817183869964097</c:v>
                </c:pt>
                <c:pt idx="448">
                  <c:v>73.809523618445297</c:v>
                </c:pt>
                <c:pt idx="449">
                  <c:v>73.801863366926497</c:v>
                </c:pt>
                <c:pt idx="450">
                  <c:v>73.794203115407598</c:v>
                </c:pt>
                <c:pt idx="451">
                  <c:v>73.786542863888798</c:v>
                </c:pt>
                <c:pt idx="452">
                  <c:v>73.778882612369998</c:v>
                </c:pt>
                <c:pt idx="453">
                  <c:v>71.250999611156502</c:v>
                </c:pt>
                <c:pt idx="454">
                  <c:v>71.243339359637702</c:v>
                </c:pt>
                <c:pt idx="455">
                  <c:v>71.235679108118902</c:v>
                </c:pt>
                <c:pt idx="456">
                  <c:v>71.228018856600102</c:v>
                </c:pt>
                <c:pt idx="457">
                  <c:v>71.220358605081202</c:v>
                </c:pt>
                <c:pt idx="458">
                  <c:v>71.212698353562402</c:v>
                </c:pt>
                <c:pt idx="459">
                  <c:v>71.205038102043602</c:v>
                </c:pt>
                <c:pt idx="460">
                  <c:v>71.197377850524802</c:v>
                </c:pt>
                <c:pt idx="461">
                  <c:v>71.189717599005903</c:v>
                </c:pt>
                <c:pt idx="462">
                  <c:v>71.182057347487103</c:v>
                </c:pt>
                <c:pt idx="463">
                  <c:v>71.174397095968303</c:v>
                </c:pt>
                <c:pt idx="464">
                  <c:v>71.166736844449403</c:v>
                </c:pt>
                <c:pt idx="465">
                  <c:v>71.159076592930603</c:v>
                </c:pt>
                <c:pt idx="466">
                  <c:v>71.151416341411803</c:v>
                </c:pt>
                <c:pt idx="467">
                  <c:v>71.143756089892904</c:v>
                </c:pt>
                <c:pt idx="468">
                  <c:v>71.136095838374104</c:v>
                </c:pt>
                <c:pt idx="469">
                  <c:v>71.128435586855304</c:v>
                </c:pt>
                <c:pt idx="470">
                  <c:v>71.120775335336504</c:v>
                </c:pt>
                <c:pt idx="471">
                  <c:v>71.113115083817604</c:v>
                </c:pt>
                <c:pt idx="472">
                  <c:v>71.105454832298804</c:v>
                </c:pt>
                <c:pt idx="473">
                  <c:v>71.097794580780004</c:v>
                </c:pt>
                <c:pt idx="474">
                  <c:v>64.716805065595693</c:v>
                </c:pt>
                <c:pt idx="475">
                  <c:v>64.709144814076893</c:v>
                </c:pt>
                <c:pt idx="476">
                  <c:v>64.701484562558093</c:v>
                </c:pt>
                <c:pt idx="477">
                  <c:v>64.693824311039194</c:v>
                </c:pt>
                <c:pt idx="478">
                  <c:v>64.686164059520394</c:v>
                </c:pt>
                <c:pt idx="479">
                  <c:v>64.678503808001594</c:v>
                </c:pt>
                <c:pt idx="480">
                  <c:v>64.670843556482694</c:v>
                </c:pt>
                <c:pt idx="481">
                  <c:v>64.663183304963894</c:v>
                </c:pt>
                <c:pt idx="482">
                  <c:v>64.655523053445094</c:v>
                </c:pt>
                <c:pt idx="483">
                  <c:v>64.647862801926294</c:v>
                </c:pt>
                <c:pt idx="484">
                  <c:v>64.640202550407395</c:v>
                </c:pt>
                <c:pt idx="485">
                  <c:v>64.632542298888595</c:v>
                </c:pt>
                <c:pt idx="486">
                  <c:v>64.624882047369795</c:v>
                </c:pt>
                <c:pt idx="487">
                  <c:v>64.617221795850895</c:v>
                </c:pt>
                <c:pt idx="488">
                  <c:v>64.609561544332095</c:v>
                </c:pt>
                <c:pt idx="489">
                  <c:v>64.601901292813295</c:v>
                </c:pt>
                <c:pt idx="490">
                  <c:v>64.594241041294495</c:v>
                </c:pt>
                <c:pt idx="491">
                  <c:v>64.586580789775596</c:v>
                </c:pt>
                <c:pt idx="492">
                  <c:v>64.578920538256796</c:v>
                </c:pt>
                <c:pt idx="493">
                  <c:v>64.571260286737996</c:v>
                </c:pt>
                <c:pt idx="494">
                  <c:v>64.563600035219096</c:v>
                </c:pt>
                <c:pt idx="495">
                  <c:v>64.555939783700296</c:v>
                </c:pt>
                <c:pt idx="496">
                  <c:v>64.548279532181496</c:v>
                </c:pt>
                <c:pt idx="497">
                  <c:v>64.540619280662696</c:v>
                </c:pt>
                <c:pt idx="498">
                  <c:v>64.532959029143797</c:v>
                </c:pt>
                <c:pt idx="499">
                  <c:v>64.525298777624997</c:v>
                </c:pt>
                <c:pt idx="500">
                  <c:v>64.517638526106197</c:v>
                </c:pt>
                <c:pt idx="501">
                  <c:v>64.509978274587297</c:v>
                </c:pt>
                <c:pt idx="502">
                  <c:v>64.502318023068497</c:v>
                </c:pt>
                <c:pt idx="503">
                  <c:v>64.494657771549697</c:v>
                </c:pt>
                <c:pt idx="504">
                  <c:v>64.486997520030897</c:v>
                </c:pt>
                <c:pt idx="505">
                  <c:v>64.479337268511998</c:v>
                </c:pt>
                <c:pt idx="506">
                  <c:v>64.471677016993198</c:v>
                </c:pt>
                <c:pt idx="507">
                  <c:v>64.464016765474398</c:v>
                </c:pt>
                <c:pt idx="508">
                  <c:v>64.456356513955498</c:v>
                </c:pt>
                <c:pt idx="509">
                  <c:v>64.448696262436698</c:v>
                </c:pt>
                <c:pt idx="510">
                  <c:v>64.441036010917898</c:v>
                </c:pt>
                <c:pt idx="511">
                  <c:v>64.433375759399098</c:v>
                </c:pt>
                <c:pt idx="512">
                  <c:v>64.425715507880199</c:v>
                </c:pt>
                <c:pt idx="513">
                  <c:v>64.418055256361399</c:v>
                </c:pt>
                <c:pt idx="514">
                  <c:v>64.410395004842599</c:v>
                </c:pt>
                <c:pt idx="515">
                  <c:v>64.402734753323699</c:v>
                </c:pt>
                <c:pt idx="516">
                  <c:v>64.395074501804899</c:v>
                </c:pt>
                <c:pt idx="517">
                  <c:v>64.387414250286099</c:v>
                </c:pt>
                <c:pt idx="518">
                  <c:v>64.379753998767299</c:v>
                </c:pt>
                <c:pt idx="519">
                  <c:v>64.3720937472484</c:v>
                </c:pt>
                <c:pt idx="520">
                  <c:v>64.3644334957296</c:v>
                </c:pt>
                <c:pt idx="521">
                  <c:v>64.3567732442108</c:v>
                </c:pt>
                <c:pt idx="522">
                  <c:v>64.3491129926919</c:v>
                </c:pt>
                <c:pt idx="523">
                  <c:v>64.3414527411731</c:v>
                </c:pt>
                <c:pt idx="524">
                  <c:v>64.3337924896543</c:v>
                </c:pt>
                <c:pt idx="525">
                  <c:v>64.326132238135401</c:v>
                </c:pt>
                <c:pt idx="526">
                  <c:v>64.318471986616601</c:v>
                </c:pt>
                <c:pt idx="527">
                  <c:v>64.310811735097801</c:v>
                </c:pt>
                <c:pt idx="528">
                  <c:v>64.303151483579001</c:v>
                </c:pt>
                <c:pt idx="529">
                  <c:v>64.295491232060101</c:v>
                </c:pt>
                <c:pt idx="530">
                  <c:v>64.287830980541301</c:v>
                </c:pt>
                <c:pt idx="531">
                  <c:v>64.280170729022501</c:v>
                </c:pt>
                <c:pt idx="532">
                  <c:v>63.284338031574798</c:v>
                </c:pt>
                <c:pt idx="533">
                  <c:v>63.276677780055898</c:v>
                </c:pt>
                <c:pt idx="534">
                  <c:v>63.269017528537098</c:v>
                </c:pt>
                <c:pt idx="535">
                  <c:v>63.261357277018298</c:v>
                </c:pt>
                <c:pt idx="536">
                  <c:v>63.253697025499399</c:v>
                </c:pt>
                <c:pt idx="537">
                  <c:v>63.246036773980599</c:v>
                </c:pt>
                <c:pt idx="538">
                  <c:v>63.238376522461799</c:v>
                </c:pt>
                <c:pt idx="539">
                  <c:v>63.230716270942999</c:v>
                </c:pt>
                <c:pt idx="540">
                  <c:v>63.223056019424099</c:v>
                </c:pt>
                <c:pt idx="541">
                  <c:v>63.215395767905299</c:v>
                </c:pt>
                <c:pt idx="542">
                  <c:v>63.207735516386499</c:v>
                </c:pt>
                <c:pt idx="543">
                  <c:v>63.2000752648676</c:v>
                </c:pt>
                <c:pt idx="544">
                  <c:v>63.1924150133488</c:v>
                </c:pt>
                <c:pt idx="545">
                  <c:v>63.18475476183</c:v>
                </c:pt>
                <c:pt idx="546">
                  <c:v>63.1770945103112</c:v>
                </c:pt>
                <c:pt idx="547">
                  <c:v>63.1694342587923</c:v>
                </c:pt>
                <c:pt idx="548">
                  <c:v>63.1617740072735</c:v>
                </c:pt>
                <c:pt idx="549">
                  <c:v>63.1541137557547</c:v>
                </c:pt>
                <c:pt idx="550">
                  <c:v>63.146453504235801</c:v>
                </c:pt>
                <c:pt idx="551">
                  <c:v>63.138793252717001</c:v>
                </c:pt>
                <c:pt idx="552">
                  <c:v>63.131133001198201</c:v>
                </c:pt>
                <c:pt idx="553">
                  <c:v>63.123472749679401</c:v>
                </c:pt>
                <c:pt idx="554">
                  <c:v>63.115812498160501</c:v>
                </c:pt>
                <c:pt idx="555">
                  <c:v>63.108152246641701</c:v>
                </c:pt>
                <c:pt idx="556">
                  <c:v>63.100491995122901</c:v>
                </c:pt>
                <c:pt idx="557">
                  <c:v>63.092831743604002</c:v>
                </c:pt>
                <c:pt idx="558">
                  <c:v>63.085171492085202</c:v>
                </c:pt>
                <c:pt idx="559">
                  <c:v>63.077511240566402</c:v>
                </c:pt>
                <c:pt idx="560">
                  <c:v>63.069850989047602</c:v>
                </c:pt>
                <c:pt idx="561">
                  <c:v>63.062190737528702</c:v>
                </c:pt>
                <c:pt idx="562">
                  <c:v>63.054530486009902</c:v>
                </c:pt>
                <c:pt idx="563">
                  <c:v>63.046870234491102</c:v>
                </c:pt>
                <c:pt idx="564">
                  <c:v>63.039209982972203</c:v>
                </c:pt>
                <c:pt idx="565">
                  <c:v>63.031549731453403</c:v>
                </c:pt>
                <c:pt idx="566">
                  <c:v>63.023889479934603</c:v>
                </c:pt>
                <c:pt idx="567">
                  <c:v>63.016229228415803</c:v>
                </c:pt>
                <c:pt idx="568">
                  <c:v>63.008568976896903</c:v>
                </c:pt>
                <c:pt idx="569">
                  <c:v>63.000908725378103</c:v>
                </c:pt>
                <c:pt idx="570">
                  <c:v>62.993248473859303</c:v>
                </c:pt>
                <c:pt idx="571">
                  <c:v>62.985588222340397</c:v>
                </c:pt>
                <c:pt idx="572">
                  <c:v>62.977927970821597</c:v>
                </c:pt>
                <c:pt idx="573">
                  <c:v>62.970267719302797</c:v>
                </c:pt>
                <c:pt idx="574">
                  <c:v>62.962607467783997</c:v>
                </c:pt>
                <c:pt idx="575">
                  <c:v>62.954947216265097</c:v>
                </c:pt>
                <c:pt idx="576">
                  <c:v>62.947286964746297</c:v>
                </c:pt>
                <c:pt idx="577">
                  <c:v>62.939626713227497</c:v>
                </c:pt>
                <c:pt idx="578">
                  <c:v>62.931966461708598</c:v>
                </c:pt>
                <c:pt idx="579">
                  <c:v>62.924306210189798</c:v>
                </c:pt>
                <c:pt idx="580">
                  <c:v>62.916645958670998</c:v>
                </c:pt>
                <c:pt idx="581">
                  <c:v>62.908985707152198</c:v>
                </c:pt>
                <c:pt idx="582">
                  <c:v>62.901325455633298</c:v>
                </c:pt>
                <c:pt idx="583">
                  <c:v>62.893665204114498</c:v>
                </c:pt>
                <c:pt idx="584">
                  <c:v>62.886004952595698</c:v>
                </c:pt>
                <c:pt idx="585">
                  <c:v>62.878344701076799</c:v>
                </c:pt>
                <c:pt idx="586">
                  <c:v>62.870684449557999</c:v>
                </c:pt>
                <c:pt idx="587">
                  <c:v>62.863024198039199</c:v>
                </c:pt>
                <c:pt idx="588">
                  <c:v>62.855363946520399</c:v>
                </c:pt>
                <c:pt idx="589">
                  <c:v>62.847703695001499</c:v>
                </c:pt>
                <c:pt idx="590">
                  <c:v>62.840043443482699</c:v>
                </c:pt>
                <c:pt idx="591">
                  <c:v>62.832383191963899</c:v>
                </c:pt>
                <c:pt idx="592">
                  <c:v>62.824722940445</c:v>
                </c:pt>
                <c:pt idx="593">
                  <c:v>57.462546877264998</c:v>
                </c:pt>
                <c:pt idx="594">
                  <c:v>57.454886625746198</c:v>
                </c:pt>
                <c:pt idx="595">
                  <c:v>57.447226374227299</c:v>
                </c:pt>
                <c:pt idx="596">
                  <c:v>57.439566122708499</c:v>
                </c:pt>
                <c:pt idx="597">
                  <c:v>57.431905871189699</c:v>
                </c:pt>
                <c:pt idx="598">
                  <c:v>57.424245619670799</c:v>
                </c:pt>
                <c:pt idx="599">
                  <c:v>57.416585368151999</c:v>
                </c:pt>
                <c:pt idx="600">
                  <c:v>57.408925116633199</c:v>
                </c:pt>
                <c:pt idx="601">
                  <c:v>57.401264865114399</c:v>
                </c:pt>
                <c:pt idx="602">
                  <c:v>57.3936046135955</c:v>
                </c:pt>
                <c:pt idx="603">
                  <c:v>57.3859443620767</c:v>
                </c:pt>
                <c:pt idx="604">
                  <c:v>57.3782841105579</c:v>
                </c:pt>
                <c:pt idx="605">
                  <c:v>57.370623859039</c:v>
                </c:pt>
                <c:pt idx="606">
                  <c:v>57.3629636075202</c:v>
                </c:pt>
                <c:pt idx="607">
                  <c:v>57.3553033560014</c:v>
                </c:pt>
                <c:pt idx="608">
                  <c:v>57.3476431044826</c:v>
                </c:pt>
                <c:pt idx="609">
                  <c:v>57.339982852963701</c:v>
                </c:pt>
                <c:pt idx="610">
                  <c:v>57.332322601444901</c:v>
                </c:pt>
                <c:pt idx="611">
                  <c:v>57.324662349926101</c:v>
                </c:pt>
                <c:pt idx="612">
                  <c:v>57.317002098407201</c:v>
                </c:pt>
                <c:pt idx="613">
                  <c:v>57.309341846888401</c:v>
                </c:pt>
                <c:pt idx="614">
                  <c:v>57.301681595369601</c:v>
                </c:pt>
                <c:pt idx="615">
                  <c:v>57.294021343850801</c:v>
                </c:pt>
                <c:pt idx="616">
                  <c:v>57.286361092331902</c:v>
                </c:pt>
                <c:pt idx="617">
                  <c:v>57.278700840813102</c:v>
                </c:pt>
                <c:pt idx="618">
                  <c:v>57.271040589294302</c:v>
                </c:pt>
                <c:pt idx="619">
                  <c:v>57.263380337775402</c:v>
                </c:pt>
                <c:pt idx="620">
                  <c:v>57.255720086256602</c:v>
                </c:pt>
                <c:pt idx="621">
                  <c:v>57.248059834737802</c:v>
                </c:pt>
                <c:pt idx="622">
                  <c:v>57.240399583219002</c:v>
                </c:pt>
                <c:pt idx="623">
                  <c:v>57.232739331700103</c:v>
                </c:pt>
                <c:pt idx="624">
                  <c:v>57.225079080181303</c:v>
                </c:pt>
                <c:pt idx="625">
                  <c:v>57.217418828662503</c:v>
                </c:pt>
                <c:pt idx="626">
                  <c:v>57.209758577143603</c:v>
                </c:pt>
                <c:pt idx="627">
                  <c:v>57.202098325624803</c:v>
                </c:pt>
                <c:pt idx="628">
                  <c:v>57.194438074106003</c:v>
                </c:pt>
                <c:pt idx="629">
                  <c:v>57.186777822587203</c:v>
                </c:pt>
                <c:pt idx="630">
                  <c:v>57.179117571068304</c:v>
                </c:pt>
                <c:pt idx="631">
                  <c:v>57.171457319549503</c:v>
                </c:pt>
                <c:pt idx="632">
                  <c:v>57.163797068030703</c:v>
                </c:pt>
                <c:pt idx="633">
                  <c:v>57.156136816511903</c:v>
                </c:pt>
                <c:pt idx="634">
                  <c:v>57.002931786135299</c:v>
                </c:pt>
                <c:pt idx="635">
                  <c:v>56.995271534616499</c:v>
                </c:pt>
                <c:pt idx="636">
                  <c:v>56.9876112830976</c:v>
                </c:pt>
                <c:pt idx="637">
                  <c:v>56.9799510315788</c:v>
                </c:pt>
                <c:pt idx="638">
                  <c:v>56.97229078006</c:v>
                </c:pt>
                <c:pt idx="639">
                  <c:v>56.9646305285411</c:v>
                </c:pt>
                <c:pt idx="640">
                  <c:v>56.9569702770223</c:v>
                </c:pt>
                <c:pt idx="641">
                  <c:v>56.9493100255035</c:v>
                </c:pt>
                <c:pt idx="642">
                  <c:v>56.941649773984601</c:v>
                </c:pt>
                <c:pt idx="643">
                  <c:v>56.933989522465801</c:v>
                </c:pt>
                <c:pt idx="644">
                  <c:v>56.926329270947001</c:v>
                </c:pt>
                <c:pt idx="645">
                  <c:v>56.918669019428201</c:v>
                </c:pt>
                <c:pt idx="646">
                  <c:v>56.911008767909301</c:v>
                </c:pt>
                <c:pt idx="647">
                  <c:v>56.903348516390501</c:v>
                </c:pt>
                <c:pt idx="648">
                  <c:v>56.895688264871701</c:v>
                </c:pt>
                <c:pt idx="649">
                  <c:v>56.888028013352802</c:v>
                </c:pt>
                <c:pt idx="650">
                  <c:v>56.880367761834002</c:v>
                </c:pt>
                <c:pt idx="651">
                  <c:v>56.872707510315202</c:v>
                </c:pt>
                <c:pt idx="652">
                  <c:v>56.865047258796402</c:v>
                </c:pt>
                <c:pt idx="653">
                  <c:v>56.857387007277502</c:v>
                </c:pt>
                <c:pt idx="654">
                  <c:v>56.849726755758702</c:v>
                </c:pt>
                <c:pt idx="655">
                  <c:v>56.842066504239902</c:v>
                </c:pt>
                <c:pt idx="656">
                  <c:v>56.834406252721003</c:v>
                </c:pt>
                <c:pt idx="657">
                  <c:v>56.826746001202203</c:v>
                </c:pt>
                <c:pt idx="658">
                  <c:v>56.819085749683403</c:v>
                </c:pt>
                <c:pt idx="659">
                  <c:v>56.811425498164603</c:v>
                </c:pt>
                <c:pt idx="660">
                  <c:v>56.803765246645703</c:v>
                </c:pt>
                <c:pt idx="661">
                  <c:v>56.796104995126903</c:v>
                </c:pt>
                <c:pt idx="662">
                  <c:v>56.788444743608103</c:v>
                </c:pt>
                <c:pt idx="663">
                  <c:v>56.780784492089197</c:v>
                </c:pt>
                <c:pt idx="664">
                  <c:v>56.773124240570397</c:v>
                </c:pt>
                <c:pt idx="665">
                  <c:v>56.765463989051597</c:v>
                </c:pt>
                <c:pt idx="666">
                  <c:v>56.757803737532797</c:v>
                </c:pt>
                <c:pt idx="667">
                  <c:v>56.750143486013897</c:v>
                </c:pt>
                <c:pt idx="668">
                  <c:v>56.742483234495097</c:v>
                </c:pt>
                <c:pt idx="669">
                  <c:v>56.734822982976297</c:v>
                </c:pt>
                <c:pt idx="670">
                  <c:v>56.727162731457398</c:v>
                </c:pt>
                <c:pt idx="671">
                  <c:v>56.719502479938598</c:v>
                </c:pt>
                <c:pt idx="672">
                  <c:v>56.711842228419798</c:v>
                </c:pt>
                <c:pt idx="673">
                  <c:v>56.704181976900998</c:v>
                </c:pt>
                <c:pt idx="674">
                  <c:v>56.696521725382098</c:v>
                </c:pt>
                <c:pt idx="675">
                  <c:v>56.688861473863298</c:v>
                </c:pt>
                <c:pt idx="676">
                  <c:v>56.681201222344498</c:v>
                </c:pt>
                <c:pt idx="677">
                  <c:v>56.673540970825599</c:v>
                </c:pt>
                <c:pt idx="678">
                  <c:v>56.665880719306799</c:v>
                </c:pt>
                <c:pt idx="679">
                  <c:v>56.658220467787999</c:v>
                </c:pt>
                <c:pt idx="680">
                  <c:v>56.650560216269199</c:v>
                </c:pt>
                <c:pt idx="681">
                  <c:v>56.642899964750299</c:v>
                </c:pt>
                <c:pt idx="682">
                  <c:v>56.635239713231499</c:v>
                </c:pt>
                <c:pt idx="683">
                  <c:v>56.627579461712699</c:v>
                </c:pt>
                <c:pt idx="684">
                  <c:v>56.6199192101938</c:v>
                </c:pt>
                <c:pt idx="685">
                  <c:v>56.612258958675</c:v>
                </c:pt>
                <c:pt idx="686">
                  <c:v>56.6045987071562</c:v>
                </c:pt>
                <c:pt idx="687">
                  <c:v>56.5969384556374</c:v>
                </c:pt>
                <c:pt idx="688">
                  <c:v>56.5892782041185</c:v>
                </c:pt>
                <c:pt idx="689">
                  <c:v>56.5816179525997</c:v>
                </c:pt>
                <c:pt idx="690">
                  <c:v>56.5739577010809</c:v>
                </c:pt>
                <c:pt idx="691">
                  <c:v>56.566297449562001</c:v>
                </c:pt>
                <c:pt idx="692">
                  <c:v>56.558637198043201</c:v>
                </c:pt>
                <c:pt idx="693">
                  <c:v>56.550976946524401</c:v>
                </c:pt>
                <c:pt idx="694">
                  <c:v>56.543316695005601</c:v>
                </c:pt>
                <c:pt idx="695">
                  <c:v>56.535656443486701</c:v>
                </c:pt>
                <c:pt idx="696">
                  <c:v>56.527996191967901</c:v>
                </c:pt>
                <c:pt idx="697">
                  <c:v>56.520335940449101</c:v>
                </c:pt>
                <c:pt idx="698">
                  <c:v>56.512675688930202</c:v>
                </c:pt>
                <c:pt idx="699">
                  <c:v>56.505015437411402</c:v>
                </c:pt>
                <c:pt idx="700">
                  <c:v>56.497355185892602</c:v>
                </c:pt>
                <c:pt idx="701">
                  <c:v>56.489694934373802</c:v>
                </c:pt>
                <c:pt idx="702">
                  <c:v>56.482034682854902</c:v>
                </c:pt>
                <c:pt idx="703">
                  <c:v>56.474374431336102</c:v>
                </c:pt>
                <c:pt idx="704">
                  <c:v>56.466714179817302</c:v>
                </c:pt>
                <c:pt idx="705">
                  <c:v>56.459053928298403</c:v>
                </c:pt>
                <c:pt idx="706">
                  <c:v>56.451393676779603</c:v>
                </c:pt>
                <c:pt idx="707">
                  <c:v>56.443733425260803</c:v>
                </c:pt>
                <c:pt idx="708">
                  <c:v>56.436073173741903</c:v>
                </c:pt>
                <c:pt idx="709">
                  <c:v>56.428412922223103</c:v>
                </c:pt>
                <c:pt idx="710">
                  <c:v>56.420752670704303</c:v>
                </c:pt>
                <c:pt idx="711">
                  <c:v>56.413092419185503</c:v>
                </c:pt>
                <c:pt idx="712">
                  <c:v>56.405432167666604</c:v>
                </c:pt>
                <c:pt idx="713">
                  <c:v>56.397771916147803</c:v>
                </c:pt>
                <c:pt idx="714">
                  <c:v>56.390111664629003</c:v>
                </c:pt>
                <c:pt idx="715">
                  <c:v>56.382451413110203</c:v>
                </c:pt>
                <c:pt idx="716">
                  <c:v>56.374791161591297</c:v>
                </c:pt>
                <c:pt idx="717">
                  <c:v>56.367130910072497</c:v>
                </c:pt>
                <c:pt idx="718">
                  <c:v>56.359470658553697</c:v>
                </c:pt>
                <c:pt idx="719">
                  <c:v>56.351810407034797</c:v>
                </c:pt>
                <c:pt idx="720">
                  <c:v>56.344150155515997</c:v>
                </c:pt>
                <c:pt idx="721">
                  <c:v>56.336489903997197</c:v>
                </c:pt>
                <c:pt idx="722">
                  <c:v>56.328829652478397</c:v>
                </c:pt>
                <c:pt idx="723">
                  <c:v>56.321169400959498</c:v>
                </c:pt>
                <c:pt idx="724">
                  <c:v>56.313509149440698</c:v>
                </c:pt>
                <c:pt idx="725">
                  <c:v>56.305848897921898</c:v>
                </c:pt>
                <c:pt idx="726">
                  <c:v>56.298188646402998</c:v>
                </c:pt>
                <c:pt idx="727">
                  <c:v>56.290528394884198</c:v>
                </c:pt>
                <c:pt idx="728">
                  <c:v>56.282868143365398</c:v>
                </c:pt>
                <c:pt idx="729">
                  <c:v>56.275207891846598</c:v>
                </c:pt>
                <c:pt idx="730">
                  <c:v>56.267547640327699</c:v>
                </c:pt>
                <c:pt idx="731">
                  <c:v>56.259887388808899</c:v>
                </c:pt>
                <c:pt idx="732">
                  <c:v>56.252227137290099</c:v>
                </c:pt>
                <c:pt idx="733">
                  <c:v>56.244566885771199</c:v>
                </c:pt>
                <c:pt idx="734">
                  <c:v>56.236906634252399</c:v>
                </c:pt>
                <c:pt idx="735">
                  <c:v>53.4792160874741</c:v>
                </c:pt>
                <c:pt idx="736">
                  <c:v>53.4715558359553</c:v>
                </c:pt>
                <c:pt idx="737">
                  <c:v>53.463895584436401</c:v>
                </c:pt>
                <c:pt idx="738">
                  <c:v>53.456235332917601</c:v>
                </c:pt>
                <c:pt idx="739">
                  <c:v>53.448575081398801</c:v>
                </c:pt>
                <c:pt idx="740">
                  <c:v>53.440914829880001</c:v>
                </c:pt>
                <c:pt idx="741">
                  <c:v>53.433254578361101</c:v>
                </c:pt>
                <c:pt idx="742">
                  <c:v>53.425594326842301</c:v>
                </c:pt>
                <c:pt idx="743">
                  <c:v>53.417934075323501</c:v>
                </c:pt>
                <c:pt idx="744">
                  <c:v>53.410273823804602</c:v>
                </c:pt>
                <c:pt idx="745">
                  <c:v>53.402613572285802</c:v>
                </c:pt>
                <c:pt idx="746">
                  <c:v>53.394953320767002</c:v>
                </c:pt>
                <c:pt idx="747">
                  <c:v>53.387293069248202</c:v>
                </c:pt>
                <c:pt idx="748">
                  <c:v>53.379632817729302</c:v>
                </c:pt>
                <c:pt idx="749">
                  <c:v>53.371972566210502</c:v>
                </c:pt>
                <c:pt idx="750">
                  <c:v>53.364312314691702</c:v>
                </c:pt>
                <c:pt idx="751">
                  <c:v>53.356652063172803</c:v>
                </c:pt>
                <c:pt idx="752">
                  <c:v>53.348991811654003</c:v>
                </c:pt>
                <c:pt idx="753">
                  <c:v>53.341331560135202</c:v>
                </c:pt>
                <c:pt idx="754">
                  <c:v>53.333671308616402</c:v>
                </c:pt>
                <c:pt idx="755">
                  <c:v>53.326011057097503</c:v>
                </c:pt>
                <c:pt idx="756">
                  <c:v>53.318350805578703</c:v>
                </c:pt>
                <c:pt idx="757">
                  <c:v>53.310690554059903</c:v>
                </c:pt>
                <c:pt idx="758">
                  <c:v>53.303030302541003</c:v>
                </c:pt>
                <c:pt idx="759">
                  <c:v>53.295370051022203</c:v>
                </c:pt>
                <c:pt idx="760">
                  <c:v>53.287709799503403</c:v>
                </c:pt>
                <c:pt idx="761">
                  <c:v>53.280049547984603</c:v>
                </c:pt>
                <c:pt idx="762">
                  <c:v>53.272389296465697</c:v>
                </c:pt>
                <c:pt idx="763">
                  <c:v>53.264729044946897</c:v>
                </c:pt>
                <c:pt idx="764">
                  <c:v>53.257068793428097</c:v>
                </c:pt>
                <c:pt idx="765">
                  <c:v>53.249408541909197</c:v>
                </c:pt>
                <c:pt idx="766">
                  <c:v>53.241748290390397</c:v>
                </c:pt>
                <c:pt idx="767">
                  <c:v>53.234088038871597</c:v>
                </c:pt>
                <c:pt idx="768">
                  <c:v>53.226427787352797</c:v>
                </c:pt>
                <c:pt idx="769">
                  <c:v>53.218767535833898</c:v>
                </c:pt>
                <c:pt idx="770">
                  <c:v>53.211107284315098</c:v>
                </c:pt>
                <c:pt idx="771">
                  <c:v>53.203447032796298</c:v>
                </c:pt>
                <c:pt idx="772">
                  <c:v>53.195786781277398</c:v>
                </c:pt>
                <c:pt idx="773">
                  <c:v>53.188126529758598</c:v>
                </c:pt>
                <c:pt idx="774">
                  <c:v>53.180466278239798</c:v>
                </c:pt>
                <c:pt idx="775">
                  <c:v>53.172806026720998</c:v>
                </c:pt>
                <c:pt idx="776">
                  <c:v>53.165145775202099</c:v>
                </c:pt>
                <c:pt idx="777">
                  <c:v>53.157485523683299</c:v>
                </c:pt>
                <c:pt idx="778">
                  <c:v>53.149825272164499</c:v>
                </c:pt>
                <c:pt idx="779">
                  <c:v>53.142165020645599</c:v>
                </c:pt>
                <c:pt idx="780">
                  <c:v>53.134504769126799</c:v>
                </c:pt>
                <c:pt idx="781">
                  <c:v>53.126844517607999</c:v>
                </c:pt>
                <c:pt idx="782">
                  <c:v>53.119184266089199</c:v>
                </c:pt>
                <c:pt idx="783">
                  <c:v>53.1115240145703</c:v>
                </c:pt>
                <c:pt idx="784">
                  <c:v>53.1038637630515</c:v>
                </c:pt>
                <c:pt idx="785">
                  <c:v>53.0962035115327</c:v>
                </c:pt>
                <c:pt idx="786">
                  <c:v>50.338512964754401</c:v>
                </c:pt>
                <c:pt idx="787">
                  <c:v>50.330852713235501</c:v>
                </c:pt>
                <c:pt idx="788">
                  <c:v>50.323192461716701</c:v>
                </c:pt>
                <c:pt idx="789">
                  <c:v>50.315532210197901</c:v>
                </c:pt>
                <c:pt idx="790">
                  <c:v>50.307871958679002</c:v>
                </c:pt>
                <c:pt idx="791">
                  <c:v>50.300211707160202</c:v>
                </c:pt>
                <c:pt idx="792">
                  <c:v>50.292551455641402</c:v>
                </c:pt>
                <c:pt idx="793">
                  <c:v>50.284891204122601</c:v>
                </c:pt>
                <c:pt idx="794">
                  <c:v>50.277230952603702</c:v>
                </c:pt>
                <c:pt idx="795">
                  <c:v>50.269570701084902</c:v>
                </c:pt>
                <c:pt idx="796">
                  <c:v>50.261910449566102</c:v>
                </c:pt>
                <c:pt idx="797">
                  <c:v>50.254250198047203</c:v>
                </c:pt>
                <c:pt idx="798">
                  <c:v>50.246589946528402</c:v>
                </c:pt>
                <c:pt idx="799">
                  <c:v>50.238929695009602</c:v>
                </c:pt>
                <c:pt idx="800">
                  <c:v>50.231269443490802</c:v>
                </c:pt>
                <c:pt idx="801">
                  <c:v>50.223609191971903</c:v>
                </c:pt>
                <c:pt idx="802">
                  <c:v>50.215948940453103</c:v>
                </c:pt>
                <c:pt idx="803">
                  <c:v>50.208288688934303</c:v>
                </c:pt>
                <c:pt idx="804">
                  <c:v>50.200628437415403</c:v>
                </c:pt>
                <c:pt idx="805">
                  <c:v>50.192968185896603</c:v>
                </c:pt>
                <c:pt idx="806">
                  <c:v>50.185307934377803</c:v>
                </c:pt>
                <c:pt idx="807">
                  <c:v>50.177647682859003</c:v>
                </c:pt>
                <c:pt idx="808">
                  <c:v>50.169987431340097</c:v>
                </c:pt>
                <c:pt idx="809">
                  <c:v>50.162327179821297</c:v>
                </c:pt>
                <c:pt idx="810">
                  <c:v>50.154666928302497</c:v>
                </c:pt>
                <c:pt idx="811">
                  <c:v>50.147006676783597</c:v>
                </c:pt>
                <c:pt idx="812">
                  <c:v>50.139346425264797</c:v>
                </c:pt>
                <c:pt idx="813">
                  <c:v>50.131686173745997</c:v>
                </c:pt>
                <c:pt idx="814">
                  <c:v>50.124025922227197</c:v>
                </c:pt>
                <c:pt idx="815">
                  <c:v>50.116365670708298</c:v>
                </c:pt>
                <c:pt idx="816">
                  <c:v>50.108705419189498</c:v>
                </c:pt>
                <c:pt idx="817">
                  <c:v>50.101045167670698</c:v>
                </c:pt>
                <c:pt idx="818">
                  <c:v>50.093384916151798</c:v>
                </c:pt>
                <c:pt idx="819">
                  <c:v>50.085724664632998</c:v>
                </c:pt>
                <c:pt idx="820">
                  <c:v>50.078064413114198</c:v>
                </c:pt>
                <c:pt idx="821">
                  <c:v>50.070404161595398</c:v>
                </c:pt>
                <c:pt idx="822">
                  <c:v>50.062743910076499</c:v>
                </c:pt>
                <c:pt idx="823">
                  <c:v>50.055083658557699</c:v>
                </c:pt>
                <c:pt idx="824">
                  <c:v>50.047423407038899</c:v>
                </c:pt>
                <c:pt idx="825">
                  <c:v>50.039763155519999</c:v>
                </c:pt>
                <c:pt idx="826">
                  <c:v>50.032102904001199</c:v>
                </c:pt>
                <c:pt idx="827">
                  <c:v>48.959667691365198</c:v>
                </c:pt>
                <c:pt idx="828">
                  <c:v>48.952007439846398</c:v>
                </c:pt>
                <c:pt idx="829">
                  <c:v>48.944347188327498</c:v>
                </c:pt>
                <c:pt idx="830">
                  <c:v>48.936686936808698</c:v>
                </c:pt>
                <c:pt idx="831">
                  <c:v>48.929026685289898</c:v>
                </c:pt>
                <c:pt idx="832">
                  <c:v>48.921366433771098</c:v>
                </c:pt>
                <c:pt idx="833">
                  <c:v>48.913706182252199</c:v>
                </c:pt>
                <c:pt idx="834">
                  <c:v>48.906045930733399</c:v>
                </c:pt>
                <c:pt idx="835">
                  <c:v>48.898385679214599</c:v>
                </c:pt>
                <c:pt idx="836">
                  <c:v>48.890725427695699</c:v>
                </c:pt>
                <c:pt idx="837">
                  <c:v>48.883065176176899</c:v>
                </c:pt>
                <c:pt idx="838">
                  <c:v>48.875404924658099</c:v>
                </c:pt>
                <c:pt idx="839">
                  <c:v>48.867744673139299</c:v>
                </c:pt>
                <c:pt idx="840">
                  <c:v>48.8600844216204</c:v>
                </c:pt>
                <c:pt idx="841">
                  <c:v>48.8524241701016</c:v>
                </c:pt>
                <c:pt idx="842">
                  <c:v>48.8447639185828</c:v>
                </c:pt>
                <c:pt idx="843">
                  <c:v>48.8371036670639</c:v>
                </c:pt>
                <c:pt idx="844">
                  <c:v>48.8294434155451</c:v>
                </c:pt>
                <c:pt idx="845">
                  <c:v>48.8217831640263</c:v>
                </c:pt>
                <c:pt idx="846">
                  <c:v>48.8141229125075</c:v>
                </c:pt>
                <c:pt idx="847">
                  <c:v>48.806462660988601</c:v>
                </c:pt>
                <c:pt idx="848">
                  <c:v>48.798802409469801</c:v>
                </c:pt>
                <c:pt idx="849">
                  <c:v>48.791142157951001</c:v>
                </c:pt>
                <c:pt idx="850">
                  <c:v>48.783481906432101</c:v>
                </c:pt>
                <c:pt idx="851">
                  <c:v>48.775821654913301</c:v>
                </c:pt>
                <c:pt idx="852">
                  <c:v>48.768161403394501</c:v>
                </c:pt>
                <c:pt idx="853">
                  <c:v>48.760501151875701</c:v>
                </c:pt>
                <c:pt idx="854">
                  <c:v>48.752840900356802</c:v>
                </c:pt>
                <c:pt idx="855">
                  <c:v>48.745180648838002</c:v>
                </c:pt>
                <c:pt idx="856">
                  <c:v>48.737520397319201</c:v>
                </c:pt>
                <c:pt idx="857">
                  <c:v>48.729860145800302</c:v>
                </c:pt>
                <c:pt idx="858">
                  <c:v>48.722199894281502</c:v>
                </c:pt>
                <c:pt idx="859">
                  <c:v>48.714539642762702</c:v>
                </c:pt>
                <c:pt idx="860">
                  <c:v>48.706879391243902</c:v>
                </c:pt>
                <c:pt idx="861">
                  <c:v>48.699219139725002</c:v>
                </c:pt>
                <c:pt idx="862">
                  <c:v>48.691558888206202</c:v>
                </c:pt>
                <c:pt idx="863">
                  <c:v>48.683898636687402</c:v>
                </c:pt>
                <c:pt idx="864">
                  <c:v>48.676238385168503</c:v>
                </c:pt>
                <c:pt idx="865">
                  <c:v>48.668578133649703</c:v>
                </c:pt>
                <c:pt idx="866">
                  <c:v>48.660917882130903</c:v>
                </c:pt>
                <c:pt idx="867">
                  <c:v>48.653257630612103</c:v>
                </c:pt>
                <c:pt idx="868">
                  <c:v>48.645597379093203</c:v>
                </c:pt>
                <c:pt idx="869">
                  <c:v>48.637937127574403</c:v>
                </c:pt>
                <c:pt idx="870">
                  <c:v>48.630276876055603</c:v>
                </c:pt>
                <c:pt idx="871">
                  <c:v>48.622616624536803</c:v>
                </c:pt>
                <c:pt idx="872">
                  <c:v>48.614956373017897</c:v>
                </c:pt>
                <c:pt idx="873">
                  <c:v>48.607296121499097</c:v>
                </c:pt>
                <c:pt idx="874">
                  <c:v>48.599635869980297</c:v>
                </c:pt>
                <c:pt idx="875">
                  <c:v>48.591975618461397</c:v>
                </c:pt>
                <c:pt idx="876">
                  <c:v>48.584315366942597</c:v>
                </c:pt>
                <c:pt idx="877">
                  <c:v>48.576655115423797</c:v>
                </c:pt>
                <c:pt idx="878">
                  <c:v>44.440119295256302</c:v>
                </c:pt>
                <c:pt idx="879">
                  <c:v>44.432459043737502</c:v>
                </c:pt>
                <c:pt idx="880">
                  <c:v>44.424798792218702</c:v>
                </c:pt>
                <c:pt idx="881">
                  <c:v>44.417138540699803</c:v>
                </c:pt>
                <c:pt idx="882">
                  <c:v>44.409478289181003</c:v>
                </c:pt>
                <c:pt idx="883">
                  <c:v>44.401818037662203</c:v>
                </c:pt>
                <c:pt idx="884">
                  <c:v>44.394157786143303</c:v>
                </c:pt>
                <c:pt idx="885">
                  <c:v>44.386497534624503</c:v>
                </c:pt>
                <c:pt idx="886">
                  <c:v>44.378837283105703</c:v>
                </c:pt>
                <c:pt idx="887">
                  <c:v>44.371177031586797</c:v>
                </c:pt>
                <c:pt idx="888">
                  <c:v>44.363516780067997</c:v>
                </c:pt>
                <c:pt idx="889">
                  <c:v>44.355856528549197</c:v>
                </c:pt>
                <c:pt idx="890">
                  <c:v>44.348196277030397</c:v>
                </c:pt>
                <c:pt idx="891">
                  <c:v>44.340536025511497</c:v>
                </c:pt>
                <c:pt idx="892">
                  <c:v>44.332875773992697</c:v>
                </c:pt>
                <c:pt idx="893">
                  <c:v>44.325215522473897</c:v>
                </c:pt>
                <c:pt idx="894">
                  <c:v>44.317555270954998</c:v>
                </c:pt>
                <c:pt idx="895">
                  <c:v>44.309895019436198</c:v>
                </c:pt>
                <c:pt idx="896">
                  <c:v>44.302234767917398</c:v>
                </c:pt>
                <c:pt idx="897">
                  <c:v>44.294574516398598</c:v>
                </c:pt>
                <c:pt idx="898">
                  <c:v>44.286914264879698</c:v>
                </c:pt>
                <c:pt idx="899">
                  <c:v>44.279254013360898</c:v>
                </c:pt>
                <c:pt idx="900">
                  <c:v>44.271593761842098</c:v>
                </c:pt>
                <c:pt idx="901">
                  <c:v>44.263933510323199</c:v>
                </c:pt>
                <c:pt idx="902">
                  <c:v>44.256273258804399</c:v>
                </c:pt>
                <c:pt idx="903">
                  <c:v>44.248613007285599</c:v>
                </c:pt>
                <c:pt idx="904">
                  <c:v>44.240952755766799</c:v>
                </c:pt>
                <c:pt idx="905">
                  <c:v>44.233292504247899</c:v>
                </c:pt>
                <c:pt idx="906">
                  <c:v>44.225632252729099</c:v>
                </c:pt>
                <c:pt idx="907">
                  <c:v>44.217972001210299</c:v>
                </c:pt>
                <c:pt idx="908">
                  <c:v>44.2103117496914</c:v>
                </c:pt>
                <c:pt idx="909">
                  <c:v>44.2026514981726</c:v>
                </c:pt>
                <c:pt idx="910">
                  <c:v>44.1949912466538</c:v>
                </c:pt>
                <c:pt idx="911">
                  <c:v>44.187330995135</c:v>
                </c:pt>
                <c:pt idx="912">
                  <c:v>44.1796707436161</c:v>
                </c:pt>
                <c:pt idx="913">
                  <c:v>44.1720104920973</c:v>
                </c:pt>
                <c:pt idx="914">
                  <c:v>44.1643502405785</c:v>
                </c:pt>
                <c:pt idx="915">
                  <c:v>44.156689989059601</c:v>
                </c:pt>
                <c:pt idx="916">
                  <c:v>44.149029737540801</c:v>
                </c:pt>
                <c:pt idx="917">
                  <c:v>44.141369486022001</c:v>
                </c:pt>
                <c:pt idx="918">
                  <c:v>44.1337092345032</c:v>
                </c:pt>
                <c:pt idx="919">
                  <c:v>44.126048982984301</c:v>
                </c:pt>
                <c:pt idx="920">
                  <c:v>44.118388731465501</c:v>
                </c:pt>
                <c:pt idx="921">
                  <c:v>44.110728479946701</c:v>
                </c:pt>
                <c:pt idx="922">
                  <c:v>44.103068228427802</c:v>
                </c:pt>
                <c:pt idx="923">
                  <c:v>44.095407976909001</c:v>
                </c:pt>
                <c:pt idx="924">
                  <c:v>44.087747725390201</c:v>
                </c:pt>
                <c:pt idx="925">
                  <c:v>44.080087473871401</c:v>
                </c:pt>
                <c:pt idx="926">
                  <c:v>44.072427222352502</c:v>
                </c:pt>
                <c:pt idx="927">
                  <c:v>44.064766970833702</c:v>
                </c:pt>
                <c:pt idx="928">
                  <c:v>44.057106719314902</c:v>
                </c:pt>
                <c:pt idx="929">
                  <c:v>44.049446467796002</c:v>
                </c:pt>
                <c:pt idx="930">
                  <c:v>44.041786216277202</c:v>
                </c:pt>
                <c:pt idx="931">
                  <c:v>44.034125964758402</c:v>
                </c:pt>
                <c:pt idx="932">
                  <c:v>44.026465713239602</c:v>
                </c:pt>
                <c:pt idx="933">
                  <c:v>44.018805461720703</c:v>
                </c:pt>
                <c:pt idx="934">
                  <c:v>44.011145210201903</c:v>
                </c:pt>
                <c:pt idx="935">
                  <c:v>44.003484958683103</c:v>
                </c:pt>
                <c:pt idx="936">
                  <c:v>43.995824707164203</c:v>
                </c:pt>
                <c:pt idx="937">
                  <c:v>43.988164455645403</c:v>
                </c:pt>
                <c:pt idx="938">
                  <c:v>43.980504204126603</c:v>
                </c:pt>
                <c:pt idx="939">
                  <c:v>43.520889112996898</c:v>
                </c:pt>
                <c:pt idx="940">
                  <c:v>43.513228861477998</c:v>
                </c:pt>
                <c:pt idx="941">
                  <c:v>43.505568609959198</c:v>
                </c:pt>
                <c:pt idx="942">
                  <c:v>43.497908358440398</c:v>
                </c:pt>
                <c:pt idx="943">
                  <c:v>43.490248106921598</c:v>
                </c:pt>
                <c:pt idx="944">
                  <c:v>43.482587855402699</c:v>
                </c:pt>
                <c:pt idx="945">
                  <c:v>43.474927603883899</c:v>
                </c:pt>
                <c:pt idx="946">
                  <c:v>43.467267352365099</c:v>
                </c:pt>
                <c:pt idx="947">
                  <c:v>43.459607100846199</c:v>
                </c:pt>
                <c:pt idx="948">
                  <c:v>43.451946849327399</c:v>
                </c:pt>
                <c:pt idx="949">
                  <c:v>43.444286597808599</c:v>
                </c:pt>
                <c:pt idx="950">
                  <c:v>43.436626346289799</c:v>
                </c:pt>
                <c:pt idx="951">
                  <c:v>43.4289660947709</c:v>
                </c:pt>
                <c:pt idx="952">
                  <c:v>43.4213058432521</c:v>
                </c:pt>
                <c:pt idx="953">
                  <c:v>43.4136455917333</c:v>
                </c:pt>
                <c:pt idx="954">
                  <c:v>43.4059853402144</c:v>
                </c:pt>
                <c:pt idx="955">
                  <c:v>43.3983250886956</c:v>
                </c:pt>
                <c:pt idx="956">
                  <c:v>43.3906648371768</c:v>
                </c:pt>
                <c:pt idx="957">
                  <c:v>43.383004585658</c:v>
                </c:pt>
                <c:pt idx="958">
                  <c:v>43.375344334139101</c:v>
                </c:pt>
                <c:pt idx="959">
                  <c:v>43.367684082620301</c:v>
                </c:pt>
                <c:pt idx="960">
                  <c:v>43.3600238311015</c:v>
                </c:pt>
                <c:pt idx="961">
                  <c:v>43.352363579582601</c:v>
                </c:pt>
                <c:pt idx="962">
                  <c:v>43.344703328063801</c:v>
                </c:pt>
                <c:pt idx="963">
                  <c:v>43.337043076545001</c:v>
                </c:pt>
                <c:pt idx="964">
                  <c:v>43.329382825026102</c:v>
                </c:pt>
                <c:pt idx="965">
                  <c:v>43.321722573507301</c:v>
                </c:pt>
                <c:pt idx="966">
                  <c:v>43.314062321988501</c:v>
                </c:pt>
                <c:pt idx="967">
                  <c:v>43.306402070469701</c:v>
                </c:pt>
                <c:pt idx="968">
                  <c:v>43.298741818950802</c:v>
                </c:pt>
                <c:pt idx="969">
                  <c:v>43.291081567432002</c:v>
                </c:pt>
                <c:pt idx="970">
                  <c:v>43.283421315913202</c:v>
                </c:pt>
                <c:pt idx="971">
                  <c:v>43.275761064394302</c:v>
                </c:pt>
                <c:pt idx="972">
                  <c:v>43.268100812875502</c:v>
                </c:pt>
                <c:pt idx="973">
                  <c:v>43.260440561356702</c:v>
                </c:pt>
                <c:pt idx="974">
                  <c:v>43.252780309837902</c:v>
                </c:pt>
                <c:pt idx="975">
                  <c:v>43.245120058319003</c:v>
                </c:pt>
                <c:pt idx="976">
                  <c:v>43.237459806800203</c:v>
                </c:pt>
                <c:pt idx="977">
                  <c:v>43.229799555281403</c:v>
                </c:pt>
                <c:pt idx="978">
                  <c:v>43.222139303762503</c:v>
                </c:pt>
                <c:pt idx="979">
                  <c:v>43.214479052243703</c:v>
                </c:pt>
                <c:pt idx="980">
                  <c:v>43.206818800724903</c:v>
                </c:pt>
                <c:pt idx="981">
                  <c:v>43.199158549206103</c:v>
                </c:pt>
                <c:pt idx="982">
                  <c:v>43.191498297687197</c:v>
                </c:pt>
                <c:pt idx="983">
                  <c:v>43.183838046168397</c:v>
                </c:pt>
                <c:pt idx="984">
                  <c:v>43.176177794649597</c:v>
                </c:pt>
                <c:pt idx="985">
                  <c:v>43.168517543130797</c:v>
                </c:pt>
                <c:pt idx="986">
                  <c:v>43.160857291611897</c:v>
                </c:pt>
                <c:pt idx="987">
                  <c:v>43.153197040093097</c:v>
                </c:pt>
                <c:pt idx="988">
                  <c:v>43.145536788574297</c:v>
                </c:pt>
                <c:pt idx="989">
                  <c:v>43.137876537055398</c:v>
                </c:pt>
                <c:pt idx="990">
                  <c:v>43.130216285536598</c:v>
                </c:pt>
                <c:pt idx="991">
                  <c:v>43.122556034017798</c:v>
                </c:pt>
                <c:pt idx="992">
                  <c:v>43.114895782498998</c:v>
                </c:pt>
                <c:pt idx="993">
                  <c:v>43.107235530980098</c:v>
                </c:pt>
                <c:pt idx="994">
                  <c:v>43.099575279461298</c:v>
                </c:pt>
                <c:pt idx="995">
                  <c:v>43.091915027942498</c:v>
                </c:pt>
                <c:pt idx="996">
                  <c:v>43.084254776423599</c:v>
                </c:pt>
                <c:pt idx="997">
                  <c:v>43.076594524904799</c:v>
                </c:pt>
                <c:pt idx="998">
                  <c:v>43.068934273385999</c:v>
                </c:pt>
                <c:pt idx="999">
                  <c:v>43.061274021867199</c:v>
                </c:pt>
                <c:pt idx="1000">
                  <c:v>43.053613770348299</c:v>
                </c:pt>
                <c:pt idx="1001">
                  <c:v>43.045953518829499</c:v>
                </c:pt>
                <c:pt idx="1002">
                  <c:v>43.038293267310699</c:v>
                </c:pt>
                <c:pt idx="1003">
                  <c:v>43.0306330157918</c:v>
                </c:pt>
                <c:pt idx="1004">
                  <c:v>43.022972764273</c:v>
                </c:pt>
                <c:pt idx="1005">
                  <c:v>43.0153125127542</c:v>
                </c:pt>
                <c:pt idx="1006">
                  <c:v>43.0076522612354</c:v>
                </c:pt>
                <c:pt idx="1007">
                  <c:v>42.9999920097165</c:v>
                </c:pt>
                <c:pt idx="1008">
                  <c:v>42.9923317581977</c:v>
                </c:pt>
                <c:pt idx="1009">
                  <c:v>42.9846715066789</c:v>
                </c:pt>
                <c:pt idx="1010">
                  <c:v>38.388520595381699</c:v>
                </c:pt>
                <c:pt idx="1011">
                  <c:v>38.380860343862899</c:v>
                </c:pt>
                <c:pt idx="1012">
                  <c:v>38.373200092344</c:v>
                </c:pt>
                <c:pt idx="1013">
                  <c:v>38.3655398408252</c:v>
                </c:pt>
                <c:pt idx="1014">
                  <c:v>38.3578795893064</c:v>
                </c:pt>
                <c:pt idx="1015">
                  <c:v>38.3502193377875</c:v>
                </c:pt>
                <c:pt idx="1016">
                  <c:v>38.3425590862687</c:v>
                </c:pt>
                <c:pt idx="1017">
                  <c:v>38.3348988347499</c:v>
                </c:pt>
                <c:pt idx="1018">
                  <c:v>38.3272385832311</c:v>
                </c:pt>
                <c:pt idx="1019">
                  <c:v>38.319578331712201</c:v>
                </c:pt>
                <c:pt idx="1020">
                  <c:v>38.311918080193401</c:v>
                </c:pt>
                <c:pt idx="1021">
                  <c:v>38.304257828674601</c:v>
                </c:pt>
                <c:pt idx="1022">
                  <c:v>38.296597577155701</c:v>
                </c:pt>
                <c:pt idx="1023">
                  <c:v>38.288937325636901</c:v>
                </c:pt>
                <c:pt idx="1024">
                  <c:v>38.281277074118101</c:v>
                </c:pt>
                <c:pt idx="1025">
                  <c:v>38.273616822599301</c:v>
                </c:pt>
                <c:pt idx="1026">
                  <c:v>38.265956571080402</c:v>
                </c:pt>
                <c:pt idx="1027">
                  <c:v>38.258296319561602</c:v>
                </c:pt>
                <c:pt idx="1028">
                  <c:v>38.250636068042802</c:v>
                </c:pt>
                <c:pt idx="1029">
                  <c:v>38.242975816523902</c:v>
                </c:pt>
                <c:pt idx="1030">
                  <c:v>38.235315565005102</c:v>
                </c:pt>
                <c:pt idx="1031">
                  <c:v>38.227655313486302</c:v>
                </c:pt>
                <c:pt idx="1032">
                  <c:v>38.219995061967502</c:v>
                </c:pt>
                <c:pt idx="1033">
                  <c:v>38.212334810448603</c:v>
                </c:pt>
                <c:pt idx="1034">
                  <c:v>38.204674558929803</c:v>
                </c:pt>
                <c:pt idx="1035">
                  <c:v>38.197014307411003</c:v>
                </c:pt>
                <c:pt idx="1036">
                  <c:v>38.189354055892103</c:v>
                </c:pt>
                <c:pt idx="1037">
                  <c:v>38.181693804373303</c:v>
                </c:pt>
                <c:pt idx="1038">
                  <c:v>38.174033552854503</c:v>
                </c:pt>
                <c:pt idx="1039">
                  <c:v>38.166373301335597</c:v>
                </c:pt>
                <c:pt idx="1040">
                  <c:v>38.158713049816797</c:v>
                </c:pt>
                <c:pt idx="1041">
                  <c:v>38.151052798297997</c:v>
                </c:pt>
                <c:pt idx="1042">
                  <c:v>38.143392546779197</c:v>
                </c:pt>
                <c:pt idx="1043">
                  <c:v>38.135732295260297</c:v>
                </c:pt>
                <c:pt idx="1044">
                  <c:v>38.128072043741497</c:v>
                </c:pt>
                <c:pt idx="1045">
                  <c:v>38.120411792222697</c:v>
                </c:pt>
                <c:pt idx="1046">
                  <c:v>38.112751540703897</c:v>
                </c:pt>
                <c:pt idx="1047">
                  <c:v>38.105091289184998</c:v>
                </c:pt>
                <c:pt idx="1048">
                  <c:v>38.097431037666198</c:v>
                </c:pt>
                <c:pt idx="1049">
                  <c:v>38.089770786147398</c:v>
                </c:pt>
                <c:pt idx="1050">
                  <c:v>38.082110534628498</c:v>
                </c:pt>
                <c:pt idx="1051">
                  <c:v>38.074450283109698</c:v>
                </c:pt>
                <c:pt idx="1052">
                  <c:v>38.066790031590898</c:v>
                </c:pt>
                <c:pt idx="1053">
                  <c:v>38.059129780072098</c:v>
                </c:pt>
                <c:pt idx="1054">
                  <c:v>38.051469528553199</c:v>
                </c:pt>
                <c:pt idx="1055">
                  <c:v>38.043809277034399</c:v>
                </c:pt>
                <c:pt idx="1056">
                  <c:v>38.036149025515599</c:v>
                </c:pt>
                <c:pt idx="1057">
                  <c:v>38.028488773996699</c:v>
                </c:pt>
                <c:pt idx="1058">
                  <c:v>38.020828522477899</c:v>
                </c:pt>
                <c:pt idx="1059">
                  <c:v>38.013168270959099</c:v>
                </c:pt>
                <c:pt idx="1060">
                  <c:v>38.005508019440299</c:v>
                </c:pt>
                <c:pt idx="1061">
                  <c:v>37.9978477679214</c:v>
                </c:pt>
                <c:pt idx="1062">
                  <c:v>37.990187516402599</c:v>
                </c:pt>
                <c:pt idx="1063">
                  <c:v>37.982527264883799</c:v>
                </c:pt>
                <c:pt idx="1064">
                  <c:v>37.9748670133649</c:v>
                </c:pt>
                <c:pt idx="1065">
                  <c:v>37.9672067618461</c:v>
                </c:pt>
                <c:pt idx="1066">
                  <c:v>37.9595465103273</c:v>
                </c:pt>
                <c:pt idx="1067">
                  <c:v>37.9518862588084</c:v>
                </c:pt>
                <c:pt idx="1068">
                  <c:v>37.9442260072896</c:v>
                </c:pt>
                <c:pt idx="1069">
                  <c:v>37.9365657557708</c:v>
                </c:pt>
                <c:pt idx="1070">
                  <c:v>37.928905504252</c:v>
                </c:pt>
                <c:pt idx="1071">
                  <c:v>36.626662746051103</c:v>
                </c:pt>
                <c:pt idx="1072">
                  <c:v>36.619002494532303</c:v>
                </c:pt>
                <c:pt idx="1073">
                  <c:v>36.611342243013397</c:v>
                </c:pt>
                <c:pt idx="1074">
                  <c:v>36.603681991494597</c:v>
                </c:pt>
                <c:pt idx="1075">
                  <c:v>36.596021739975797</c:v>
                </c:pt>
                <c:pt idx="1076">
                  <c:v>36.588361488456997</c:v>
                </c:pt>
                <c:pt idx="1077">
                  <c:v>36.580701236938097</c:v>
                </c:pt>
                <c:pt idx="1078">
                  <c:v>36.573040985419297</c:v>
                </c:pt>
                <c:pt idx="1079">
                  <c:v>36.565380733900497</c:v>
                </c:pt>
                <c:pt idx="1080">
                  <c:v>36.557720482381598</c:v>
                </c:pt>
                <c:pt idx="1081">
                  <c:v>36.550060230862798</c:v>
                </c:pt>
                <c:pt idx="1082">
                  <c:v>36.542399979343998</c:v>
                </c:pt>
                <c:pt idx="1083">
                  <c:v>36.534739727825198</c:v>
                </c:pt>
                <c:pt idx="1084">
                  <c:v>36.527079476306298</c:v>
                </c:pt>
                <c:pt idx="1085">
                  <c:v>36.519419224787498</c:v>
                </c:pt>
                <c:pt idx="1086">
                  <c:v>36.511758973268698</c:v>
                </c:pt>
                <c:pt idx="1087">
                  <c:v>36.504098721749799</c:v>
                </c:pt>
                <c:pt idx="1088">
                  <c:v>36.496438470230999</c:v>
                </c:pt>
                <c:pt idx="1089">
                  <c:v>36.488778218712199</c:v>
                </c:pt>
                <c:pt idx="1090">
                  <c:v>36.481117967193398</c:v>
                </c:pt>
                <c:pt idx="1091">
                  <c:v>36.473457715674499</c:v>
                </c:pt>
                <c:pt idx="1092">
                  <c:v>36.465797464155699</c:v>
                </c:pt>
                <c:pt idx="1093">
                  <c:v>36.458137212636899</c:v>
                </c:pt>
                <c:pt idx="1094">
                  <c:v>36.450476961118</c:v>
                </c:pt>
                <c:pt idx="1095">
                  <c:v>36.442816709599199</c:v>
                </c:pt>
                <c:pt idx="1096">
                  <c:v>36.435156458080399</c:v>
                </c:pt>
                <c:pt idx="1097">
                  <c:v>36.427496206561599</c:v>
                </c:pt>
                <c:pt idx="1098">
                  <c:v>36.4198359550427</c:v>
                </c:pt>
                <c:pt idx="1099">
                  <c:v>36.4121757035239</c:v>
                </c:pt>
                <c:pt idx="1100">
                  <c:v>36.4045154520051</c:v>
                </c:pt>
                <c:pt idx="1101">
                  <c:v>36.3968552004862</c:v>
                </c:pt>
                <c:pt idx="1102">
                  <c:v>36.3891949489674</c:v>
                </c:pt>
                <c:pt idx="1103">
                  <c:v>36.3815346974486</c:v>
                </c:pt>
                <c:pt idx="1104">
                  <c:v>36.373874445929701</c:v>
                </c:pt>
                <c:pt idx="1105">
                  <c:v>36.366214194410901</c:v>
                </c:pt>
                <c:pt idx="1106">
                  <c:v>36.358553942892101</c:v>
                </c:pt>
                <c:pt idx="1107">
                  <c:v>36.350893691373301</c:v>
                </c:pt>
                <c:pt idx="1108">
                  <c:v>36.343233439854401</c:v>
                </c:pt>
                <c:pt idx="1109">
                  <c:v>36.335573188335601</c:v>
                </c:pt>
                <c:pt idx="1110">
                  <c:v>36.327912936816801</c:v>
                </c:pt>
                <c:pt idx="1111">
                  <c:v>36.320252685297902</c:v>
                </c:pt>
                <c:pt idx="1112">
                  <c:v>36.312592433779102</c:v>
                </c:pt>
                <c:pt idx="1113">
                  <c:v>36.304932182260302</c:v>
                </c:pt>
                <c:pt idx="1114">
                  <c:v>36.297271930741502</c:v>
                </c:pt>
                <c:pt idx="1115">
                  <c:v>36.289611679222602</c:v>
                </c:pt>
                <c:pt idx="1116">
                  <c:v>36.281951427703802</c:v>
                </c:pt>
                <c:pt idx="1117">
                  <c:v>36.274291176185002</c:v>
                </c:pt>
                <c:pt idx="1118">
                  <c:v>36.266630924666103</c:v>
                </c:pt>
                <c:pt idx="1119">
                  <c:v>36.258970673147303</c:v>
                </c:pt>
                <c:pt idx="1120">
                  <c:v>36.251310421628503</c:v>
                </c:pt>
                <c:pt idx="1121">
                  <c:v>36.243650170109703</c:v>
                </c:pt>
                <c:pt idx="1122">
                  <c:v>36.235989918590803</c:v>
                </c:pt>
                <c:pt idx="1123">
                  <c:v>36.228329667072003</c:v>
                </c:pt>
                <c:pt idx="1124">
                  <c:v>36.220669415553203</c:v>
                </c:pt>
                <c:pt idx="1125">
                  <c:v>36.213009164034403</c:v>
                </c:pt>
                <c:pt idx="1126">
                  <c:v>36.205348912515497</c:v>
                </c:pt>
                <c:pt idx="1127">
                  <c:v>36.197688660996697</c:v>
                </c:pt>
                <c:pt idx="1128">
                  <c:v>36.190028409477897</c:v>
                </c:pt>
                <c:pt idx="1129">
                  <c:v>36.182368157958997</c:v>
                </c:pt>
                <c:pt idx="1130">
                  <c:v>36.174707906440197</c:v>
                </c:pt>
                <c:pt idx="1131">
                  <c:v>36.167047654921397</c:v>
                </c:pt>
                <c:pt idx="1132">
                  <c:v>36.159387403402597</c:v>
                </c:pt>
                <c:pt idx="1133">
                  <c:v>36.151727151883698</c:v>
                </c:pt>
                <c:pt idx="1134">
                  <c:v>36.144066900364898</c:v>
                </c:pt>
                <c:pt idx="1135">
                  <c:v>36.136406648846098</c:v>
                </c:pt>
                <c:pt idx="1136">
                  <c:v>36.128746397327198</c:v>
                </c:pt>
                <c:pt idx="1137">
                  <c:v>36.121086145808398</c:v>
                </c:pt>
                <c:pt idx="1138">
                  <c:v>36.113425894289598</c:v>
                </c:pt>
                <c:pt idx="1139">
                  <c:v>36.105765642770699</c:v>
                </c:pt>
                <c:pt idx="1140">
                  <c:v>36.098105391251899</c:v>
                </c:pt>
                <c:pt idx="1141">
                  <c:v>36.090445139733099</c:v>
                </c:pt>
                <c:pt idx="1142">
                  <c:v>36.082784888214299</c:v>
                </c:pt>
                <c:pt idx="1143">
                  <c:v>36.075124636695399</c:v>
                </c:pt>
                <c:pt idx="1144">
                  <c:v>36.067464385176599</c:v>
                </c:pt>
                <c:pt idx="1145">
                  <c:v>36.059804133657799</c:v>
                </c:pt>
                <c:pt idx="1146">
                  <c:v>36.0521438821389</c:v>
                </c:pt>
                <c:pt idx="1147">
                  <c:v>36.0444836306201</c:v>
                </c:pt>
                <c:pt idx="1148">
                  <c:v>36.0368233791013</c:v>
                </c:pt>
                <c:pt idx="1149">
                  <c:v>36.0291631275825</c:v>
                </c:pt>
                <c:pt idx="1150">
                  <c:v>36.0215028760636</c:v>
                </c:pt>
                <c:pt idx="1151">
                  <c:v>36.0138426245448</c:v>
                </c:pt>
                <c:pt idx="1152">
                  <c:v>36.006182373026</c:v>
                </c:pt>
                <c:pt idx="1153">
                  <c:v>35.998522121507101</c:v>
                </c:pt>
                <c:pt idx="1154">
                  <c:v>35.990861869988301</c:v>
                </c:pt>
                <c:pt idx="1155">
                  <c:v>35.983201618469501</c:v>
                </c:pt>
                <c:pt idx="1156">
                  <c:v>35.975541366950701</c:v>
                </c:pt>
                <c:pt idx="1157">
                  <c:v>35.967881115431801</c:v>
                </c:pt>
                <c:pt idx="1158">
                  <c:v>35.960220863913001</c:v>
                </c:pt>
                <c:pt idx="1159">
                  <c:v>35.952560612394201</c:v>
                </c:pt>
                <c:pt idx="1160">
                  <c:v>35.944900360875302</c:v>
                </c:pt>
                <c:pt idx="1161">
                  <c:v>35.937240109356502</c:v>
                </c:pt>
                <c:pt idx="1162">
                  <c:v>35.929579857837702</c:v>
                </c:pt>
                <c:pt idx="1163">
                  <c:v>35.921919606318902</c:v>
                </c:pt>
                <c:pt idx="1164">
                  <c:v>35.914259354800002</c:v>
                </c:pt>
                <c:pt idx="1165">
                  <c:v>35.906599103281202</c:v>
                </c:pt>
                <c:pt idx="1166">
                  <c:v>35.898938851762402</c:v>
                </c:pt>
                <c:pt idx="1167">
                  <c:v>35.891278600243503</c:v>
                </c:pt>
                <c:pt idx="1168">
                  <c:v>35.883618348724703</c:v>
                </c:pt>
                <c:pt idx="1169">
                  <c:v>35.875958097205903</c:v>
                </c:pt>
                <c:pt idx="1170">
                  <c:v>35.868297845687103</c:v>
                </c:pt>
                <c:pt idx="1171">
                  <c:v>35.860637594168203</c:v>
                </c:pt>
                <c:pt idx="1172">
                  <c:v>34.8648048967205</c:v>
                </c:pt>
                <c:pt idx="1173">
                  <c:v>34.8571446452017</c:v>
                </c:pt>
                <c:pt idx="1174">
                  <c:v>34.8494843936829</c:v>
                </c:pt>
                <c:pt idx="1175">
                  <c:v>34.841824142164</c:v>
                </c:pt>
                <c:pt idx="1176">
                  <c:v>34.8341638906452</c:v>
                </c:pt>
                <c:pt idx="1177">
                  <c:v>34.8265036391264</c:v>
                </c:pt>
                <c:pt idx="1178">
                  <c:v>34.818843387607501</c:v>
                </c:pt>
                <c:pt idx="1179">
                  <c:v>34.811183136088701</c:v>
                </c:pt>
                <c:pt idx="1180">
                  <c:v>34.803522884569901</c:v>
                </c:pt>
                <c:pt idx="1181">
                  <c:v>34.795862633051001</c:v>
                </c:pt>
                <c:pt idx="1182">
                  <c:v>34.788202381532201</c:v>
                </c:pt>
                <c:pt idx="1183">
                  <c:v>34.780542130013401</c:v>
                </c:pt>
                <c:pt idx="1184">
                  <c:v>34.772881878494601</c:v>
                </c:pt>
                <c:pt idx="1185">
                  <c:v>34.765221626975702</c:v>
                </c:pt>
                <c:pt idx="1186">
                  <c:v>34.757561375456902</c:v>
                </c:pt>
                <c:pt idx="1187">
                  <c:v>34.749901123938102</c:v>
                </c:pt>
                <c:pt idx="1188">
                  <c:v>34.742240872419202</c:v>
                </c:pt>
                <c:pt idx="1189">
                  <c:v>34.734580620900402</c:v>
                </c:pt>
                <c:pt idx="1190">
                  <c:v>34.726920369381602</c:v>
                </c:pt>
                <c:pt idx="1191">
                  <c:v>34.719260117862802</c:v>
                </c:pt>
                <c:pt idx="1192">
                  <c:v>34.711599866343903</c:v>
                </c:pt>
                <c:pt idx="1193">
                  <c:v>34.703939614825103</c:v>
                </c:pt>
                <c:pt idx="1194">
                  <c:v>34.696279363306303</c:v>
                </c:pt>
                <c:pt idx="1195">
                  <c:v>34.688619111787403</c:v>
                </c:pt>
                <c:pt idx="1196">
                  <c:v>34.680958860268603</c:v>
                </c:pt>
                <c:pt idx="1197">
                  <c:v>34.673298608749803</c:v>
                </c:pt>
                <c:pt idx="1198">
                  <c:v>34.665638357231003</c:v>
                </c:pt>
                <c:pt idx="1199">
                  <c:v>34.657978105712097</c:v>
                </c:pt>
                <c:pt idx="1200">
                  <c:v>34.650317854193297</c:v>
                </c:pt>
                <c:pt idx="1201">
                  <c:v>34.642657602674497</c:v>
                </c:pt>
                <c:pt idx="1202">
                  <c:v>34.634997351155697</c:v>
                </c:pt>
                <c:pt idx="1203">
                  <c:v>34.627337099636797</c:v>
                </c:pt>
                <c:pt idx="1204">
                  <c:v>34.619676848117997</c:v>
                </c:pt>
                <c:pt idx="1205">
                  <c:v>34.612016596599197</c:v>
                </c:pt>
                <c:pt idx="1206">
                  <c:v>34.604356345080298</c:v>
                </c:pt>
                <c:pt idx="1207">
                  <c:v>34.596696093561498</c:v>
                </c:pt>
                <c:pt idx="1208">
                  <c:v>34.589035842042698</c:v>
                </c:pt>
                <c:pt idx="1209">
                  <c:v>34.581375590523898</c:v>
                </c:pt>
                <c:pt idx="1210">
                  <c:v>34.573715339004998</c:v>
                </c:pt>
                <c:pt idx="1211">
                  <c:v>34.566055087486198</c:v>
                </c:pt>
                <c:pt idx="1212">
                  <c:v>34.558394835967398</c:v>
                </c:pt>
                <c:pt idx="1213">
                  <c:v>34.550734584448499</c:v>
                </c:pt>
                <c:pt idx="1214">
                  <c:v>34.543074332929699</c:v>
                </c:pt>
                <c:pt idx="1215">
                  <c:v>34.535414081410899</c:v>
                </c:pt>
                <c:pt idx="1216">
                  <c:v>34.527753829891999</c:v>
                </c:pt>
                <c:pt idx="1217">
                  <c:v>34.520093578373199</c:v>
                </c:pt>
                <c:pt idx="1218">
                  <c:v>34.512433326854399</c:v>
                </c:pt>
                <c:pt idx="1219">
                  <c:v>34.504773075335599</c:v>
                </c:pt>
                <c:pt idx="1220">
                  <c:v>34.4971128238167</c:v>
                </c:pt>
                <c:pt idx="1221">
                  <c:v>34.4894525722979</c:v>
                </c:pt>
                <c:pt idx="1222">
                  <c:v>34.4817923207791</c:v>
                </c:pt>
                <c:pt idx="1223">
                  <c:v>34.4741320692602</c:v>
                </c:pt>
                <c:pt idx="1224">
                  <c:v>34.4664718177414</c:v>
                </c:pt>
                <c:pt idx="1225">
                  <c:v>34.4588115662226</c:v>
                </c:pt>
                <c:pt idx="1226">
                  <c:v>34.4511513147038</c:v>
                </c:pt>
                <c:pt idx="1227">
                  <c:v>34.443491063184901</c:v>
                </c:pt>
                <c:pt idx="1228">
                  <c:v>34.435830811666101</c:v>
                </c:pt>
                <c:pt idx="1229">
                  <c:v>34.428170560147301</c:v>
                </c:pt>
                <c:pt idx="1230">
                  <c:v>34.420510308628401</c:v>
                </c:pt>
                <c:pt idx="1231">
                  <c:v>34.412850057109601</c:v>
                </c:pt>
                <c:pt idx="1232">
                  <c:v>34.405189805590801</c:v>
                </c:pt>
                <c:pt idx="1233">
                  <c:v>34.397529554072001</c:v>
                </c:pt>
                <c:pt idx="1234">
                  <c:v>34.389869302553102</c:v>
                </c:pt>
                <c:pt idx="1235">
                  <c:v>34.382209051034302</c:v>
                </c:pt>
                <c:pt idx="1236">
                  <c:v>34.374548799515502</c:v>
                </c:pt>
                <c:pt idx="1237">
                  <c:v>34.366888547996602</c:v>
                </c:pt>
                <c:pt idx="1238">
                  <c:v>34.359228296477802</c:v>
                </c:pt>
                <c:pt idx="1239">
                  <c:v>34.351568044959002</c:v>
                </c:pt>
                <c:pt idx="1240">
                  <c:v>34.343907793440202</c:v>
                </c:pt>
                <c:pt idx="1241">
                  <c:v>34.336247541921303</c:v>
                </c:pt>
                <c:pt idx="1242">
                  <c:v>34.328587290402503</c:v>
                </c:pt>
                <c:pt idx="1243">
                  <c:v>34.320927038883703</c:v>
                </c:pt>
                <c:pt idx="1244">
                  <c:v>34.313266787364803</c:v>
                </c:pt>
                <c:pt idx="1245">
                  <c:v>34.305606535846003</c:v>
                </c:pt>
                <c:pt idx="1246">
                  <c:v>34.297946284327203</c:v>
                </c:pt>
                <c:pt idx="1247">
                  <c:v>34.290286032808403</c:v>
                </c:pt>
                <c:pt idx="1248">
                  <c:v>34.282625781289497</c:v>
                </c:pt>
                <c:pt idx="1249">
                  <c:v>34.274965529770697</c:v>
                </c:pt>
                <c:pt idx="1250">
                  <c:v>34.267305278251897</c:v>
                </c:pt>
                <c:pt idx="1251">
                  <c:v>34.259645026732997</c:v>
                </c:pt>
                <c:pt idx="1252">
                  <c:v>34.251984775214197</c:v>
                </c:pt>
                <c:pt idx="1253">
                  <c:v>34.244324523695397</c:v>
                </c:pt>
                <c:pt idx="1254">
                  <c:v>34.236664272176597</c:v>
                </c:pt>
                <c:pt idx="1255">
                  <c:v>34.229004020657698</c:v>
                </c:pt>
                <c:pt idx="1256">
                  <c:v>34.221343769138898</c:v>
                </c:pt>
                <c:pt idx="1257">
                  <c:v>34.213683517620098</c:v>
                </c:pt>
                <c:pt idx="1258">
                  <c:v>34.206023266101198</c:v>
                </c:pt>
                <c:pt idx="1259">
                  <c:v>34.198363014582398</c:v>
                </c:pt>
                <c:pt idx="1260">
                  <c:v>34.190702763063598</c:v>
                </c:pt>
                <c:pt idx="1261">
                  <c:v>34.183042511544798</c:v>
                </c:pt>
                <c:pt idx="1262">
                  <c:v>34.175382260025899</c:v>
                </c:pt>
                <c:pt idx="1263">
                  <c:v>32.873139501825101</c:v>
                </c:pt>
                <c:pt idx="1264">
                  <c:v>32.865479250306201</c:v>
                </c:pt>
                <c:pt idx="1265">
                  <c:v>32.857818998787401</c:v>
                </c:pt>
                <c:pt idx="1266">
                  <c:v>32.850158747268601</c:v>
                </c:pt>
                <c:pt idx="1267">
                  <c:v>32.842498495749702</c:v>
                </c:pt>
                <c:pt idx="1268">
                  <c:v>32.834838244230902</c:v>
                </c:pt>
                <c:pt idx="1269">
                  <c:v>32.827177992712102</c:v>
                </c:pt>
                <c:pt idx="1270">
                  <c:v>32.819517741193302</c:v>
                </c:pt>
                <c:pt idx="1271">
                  <c:v>32.811857489674402</c:v>
                </c:pt>
                <c:pt idx="1272">
                  <c:v>32.804197238155602</c:v>
                </c:pt>
                <c:pt idx="1273">
                  <c:v>32.796536986636802</c:v>
                </c:pt>
                <c:pt idx="1274">
                  <c:v>32.788876735117903</c:v>
                </c:pt>
                <c:pt idx="1275">
                  <c:v>32.781216483599103</c:v>
                </c:pt>
                <c:pt idx="1276">
                  <c:v>32.773556232080303</c:v>
                </c:pt>
                <c:pt idx="1277">
                  <c:v>32.765895980561503</c:v>
                </c:pt>
                <c:pt idx="1278">
                  <c:v>32.758235729042603</c:v>
                </c:pt>
                <c:pt idx="1279">
                  <c:v>32.750575477523803</c:v>
                </c:pt>
                <c:pt idx="1280">
                  <c:v>32.742915226005003</c:v>
                </c:pt>
                <c:pt idx="1281">
                  <c:v>32.735254974486097</c:v>
                </c:pt>
                <c:pt idx="1282">
                  <c:v>32.727594722967297</c:v>
                </c:pt>
                <c:pt idx="1283">
                  <c:v>32.719934471448497</c:v>
                </c:pt>
                <c:pt idx="1284">
                  <c:v>32.712274219929697</c:v>
                </c:pt>
                <c:pt idx="1285">
                  <c:v>32.704613968410797</c:v>
                </c:pt>
                <c:pt idx="1286">
                  <c:v>32.696953716891997</c:v>
                </c:pt>
                <c:pt idx="1287">
                  <c:v>32.689293465373197</c:v>
                </c:pt>
                <c:pt idx="1288">
                  <c:v>32.681633213854298</c:v>
                </c:pt>
                <c:pt idx="1289">
                  <c:v>32.673972962335498</c:v>
                </c:pt>
                <c:pt idx="1290">
                  <c:v>32.666312710816698</c:v>
                </c:pt>
                <c:pt idx="1291">
                  <c:v>32.658652459297898</c:v>
                </c:pt>
                <c:pt idx="1292">
                  <c:v>32.650992207778998</c:v>
                </c:pt>
                <c:pt idx="1293">
                  <c:v>32.643331956260198</c:v>
                </c:pt>
                <c:pt idx="1294">
                  <c:v>32.635671704741398</c:v>
                </c:pt>
                <c:pt idx="1295">
                  <c:v>32.628011453222499</c:v>
                </c:pt>
                <c:pt idx="1296">
                  <c:v>32.620351201703699</c:v>
                </c:pt>
                <c:pt idx="1297">
                  <c:v>32.612690950184898</c:v>
                </c:pt>
                <c:pt idx="1298">
                  <c:v>32.605030698666098</c:v>
                </c:pt>
                <c:pt idx="1299">
                  <c:v>32.597370447147199</c:v>
                </c:pt>
                <c:pt idx="1300">
                  <c:v>32.589710195628399</c:v>
                </c:pt>
                <c:pt idx="1301">
                  <c:v>32.582049944109599</c:v>
                </c:pt>
                <c:pt idx="1302">
                  <c:v>32.574389692590699</c:v>
                </c:pt>
                <c:pt idx="1303">
                  <c:v>32.566729441071899</c:v>
                </c:pt>
                <c:pt idx="1304">
                  <c:v>32.559069189553099</c:v>
                </c:pt>
                <c:pt idx="1305">
                  <c:v>32.551408938034299</c:v>
                </c:pt>
                <c:pt idx="1306">
                  <c:v>32.5437486865154</c:v>
                </c:pt>
                <c:pt idx="1307">
                  <c:v>32.5360884349966</c:v>
                </c:pt>
                <c:pt idx="1308">
                  <c:v>32.5284281834778</c:v>
                </c:pt>
                <c:pt idx="1309">
                  <c:v>32.5207679319589</c:v>
                </c:pt>
                <c:pt idx="1310">
                  <c:v>32.5131076804401</c:v>
                </c:pt>
                <c:pt idx="1311">
                  <c:v>32.5054474289213</c:v>
                </c:pt>
                <c:pt idx="1312">
                  <c:v>32.4977871774025</c:v>
                </c:pt>
                <c:pt idx="1313">
                  <c:v>32.490126925883601</c:v>
                </c:pt>
                <c:pt idx="1314">
                  <c:v>32.482466674364801</c:v>
                </c:pt>
                <c:pt idx="1315">
                  <c:v>32.474806422846001</c:v>
                </c:pt>
                <c:pt idx="1316">
                  <c:v>32.467146171327101</c:v>
                </c:pt>
                <c:pt idx="1317">
                  <c:v>32.459485919808301</c:v>
                </c:pt>
                <c:pt idx="1318">
                  <c:v>32.451825668289501</c:v>
                </c:pt>
                <c:pt idx="1319">
                  <c:v>32.444165416770701</c:v>
                </c:pt>
                <c:pt idx="1320">
                  <c:v>32.436505165251802</c:v>
                </c:pt>
                <c:pt idx="1321">
                  <c:v>32.428844913733002</c:v>
                </c:pt>
                <c:pt idx="1322">
                  <c:v>32.421184662214202</c:v>
                </c:pt>
                <c:pt idx="1323">
                  <c:v>32.413524410695302</c:v>
                </c:pt>
                <c:pt idx="1324">
                  <c:v>32.405864159176502</c:v>
                </c:pt>
                <c:pt idx="1325">
                  <c:v>32.398203907657702</c:v>
                </c:pt>
                <c:pt idx="1326">
                  <c:v>32.390543656138902</c:v>
                </c:pt>
                <c:pt idx="1327">
                  <c:v>32.382883404620003</c:v>
                </c:pt>
                <c:pt idx="1328">
                  <c:v>32.375223153101203</c:v>
                </c:pt>
                <c:pt idx="1329">
                  <c:v>32.367562901582403</c:v>
                </c:pt>
                <c:pt idx="1330">
                  <c:v>32.359902650063503</c:v>
                </c:pt>
                <c:pt idx="1331">
                  <c:v>32.352242398544703</c:v>
                </c:pt>
                <c:pt idx="1332">
                  <c:v>32.344582147025903</c:v>
                </c:pt>
                <c:pt idx="1333">
                  <c:v>32.336921895507103</c:v>
                </c:pt>
                <c:pt idx="1334">
                  <c:v>32.329261643988197</c:v>
                </c:pt>
                <c:pt idx="1335">
                  <c:v>32.321601392469397</c:v>
                </c:pt>
                <c:pt idx="1336">
                  <c:v>32.313941140950597</c:v>
                </c:pt>
                <c:pt idx="1337">
                  <c:v>32.306280889431697</c:v>
                </c:pt>
                <c:pt idx="1338">
                  <c:v>32.298620637912897</c:v>
                </c:pt>
                <c:pt idx="1339">
                  <c:v>32.290960386394097</c:v>
                </c:pt>
                <c:pt idx="1340">
                  <c:v>32.283300134875297</c:v>
                </c:pt>
                <c:pt idx="1341">
                  <c:v>32.275639883356398</c:v>
                </c:pt>
                <c:pt idx="1342">
                  <c:v>32.267979631837598</c:v>
                </c:pt>
                <c:pt idx="1343">
                  <c:v>32.260319380318798</c:v>
                </c:pt>
                <c:pt idx="1344">
                  <c:v>32.252659128799898</c:v>
                </c:pt>
                <c:pt idx="1345">
                  <c:v>32.244998877281098</c:v>
                </c:pt>
                <c:pt idx="1346">
                  <c:v>32.237338625762298</c:v>
                </c:pt>
                <c:pt idx="1347">
                  <c:v>32.229678374243498</c:v>
                </c:pt>
                <c:pt idx="1348">
                  <c:v>32.222018122724599</c:v>
                </c:pt>
                <c:pt idx="1349">
                  <c:v>32.214357871205799</c:v>
                </c:pt>
                <c:pt idx="1350">
                  <c:v>32.206697619686999</c:v>
                </c:pt>
                <c:pt idx="1351">
                  <c:v>32.199037368168099</c:v>
                </c:pt>
                <c:pt idx="1352">
                  <c:v>32.191377116649299</c:v>
                </c:pt>
                <c:pt idx="1353">
                  <c:v>32.183716865130499</c:v>
                </c:pt>
                <c:pt idx="1354">
                  <c:v>32.176056613611699</c:v>
                </c:pt>
                <c:pt idx="1355">
                  <c:v>32.1683963620928</c:v>
                </c:pt>
                <c:pt idx="1356">
                  <c:v>32.160736110574</c:v>
                </c:pt>
                <c:pt idx="1357">
                  <c:v>32.1530758590552</c:v>
                </c:pt>
                <c:pt idx="1358">
                  <c:v>32.1454156075363</c:v>
                </c:pt>
                <c:pt idx="1359">
                  <c:v>32.1377553560175</c:v>
                </c:pt>
                <c:pt idx="1360">
                  <c:v>32.1300951044987</c:v>
                </c:pt>
                <c:pt idx="1361">
                  <c:v>32.1224348529799</c:v>
                </c:pt>
                <c:pt idx="1362">
                  <c:v>32.114774601461001</c:v>
                </c:pt>
                <c:pt idx="1363">
                  <c:v>32.107114349942201</c:v>
                </c:pt>
                <c:pt idx="1364">
                  <c:v>32.099454098423401</c:v>
                </c:pt>
                <c:pt idx="1365">
                  <c:v>32.091793846904501</c:v>
                </c:pt>
                <c:pt idx="1366">
                  <c:v>32.084133595385701</c:v>
                </c:pt>
                <c:pt idx="1367">
                  <c:v>32.076473343866901</c:v>
                </c:pt>
                <c:pt idx="1368">
                  <c:v>32.068813092348101</c:v>
                </c:pt>
                <c:pt idx="1369">
                  <c:v>32.061152840829202</c:v>
                </c:pt>
                <c:pt idx="1370">
                  <c:v>32.053492589310402</c:v>
                </c:pt>
                <c:pt idx="1371">
                  <c:v>32.045832337791602</c:v>
                </c:pt>
                <c:pt idx="1372">
                  <c:v>32.038172086272702</c:v>
                </c:pt>
                <c:pt idx="1373">
                  <c:v>32.030511834753902</c:v>
                </c:pt>
                <c:pt idx="1374">
                  <c:v>32.022851583235102</c:v>
                </c:pt>
                <c:pt idx="1375">
                  <c:v>32.015191331716302</c:v>
                </c:pt>
                <c:pt idx="1376">
                  <c:v>32.007531080197403</c:v>
                </c:pt>
                <c:pt idx="1377">
                  <c:v>31.999870828678599</c:v>
                </c:pt>
                <c:pt idx="1378">
                  <c:v>31.992210577159799</c:v>
                </c:pt>
                <c:pt idx="1379">
                  <c:v>31.9845503256409</c:v>
                </c:pt>
                <c:pt idx="1380">
                  <c:v>31.9768900741221</c:v>
                </c:pt>
                <c:pt idx="1381">
                  <c:v>31.9692298226033</c:v>
                </c:pt>
                <c:pt idx="1382">
                  <c:v>31.9615695710845</c:v>
                </c:pt>
                <c:pt idx="1383">
                  <c:v>31.9539093195656</c:v>
                </c:pt>
                <c:pt idx="1384">
                  <c:v>31.9462490680468</c:v>
                </c:pt>
                <c:pt idx="1385">
                  <c:v>31.938588816528</c:v>
                </c:pt>
                <c:pt idx="1386">
                  <c:v>31.930928565009101</c:v>
                </c:pt>
                <c:pt idx="1387">
                  <c:v>31.923268313490301</c:v>
                </c:pt>
                <c:pt idx="1388">
                  <c:v>31.915608061971501</c:v>
                </c:pt>
                <c:pt idx="1389">
                  <c:v>31.907947810452601</c:v>
                </c:pt>
                <c:pt idx="1390">
                  <c:v>31.900287558933801</c:v>
                </c:pt>
                <c:pt idx="1391">
                  <c:v>31.892627307415001</c:v>
                </c:pt>
                <c:pt idx="1392">
                  <c:v>31.884967055896201</c:v>
                </c:pt>
                <c:pt idx="1393">
                  <c:v>31.877306804377302</c:v>
                </c:pt>
                <c:pt idx="1394">
                  <c:v>31.869646552858502</c:v>
                </c:pt>
                <c:pt idx="1395">
                  <c:v>31.861986301339702</c:v>
                </c:pt>
                <c:pt idx="1396">
                  <c:v>31.854326049820902</c:v>
                </c:pt>
                <c:pt idx="1397">
                  <c:v>31.846665798301999</c:v>
                </c:pt>
                <c:pt idx="1398">
                  <c:v>31.839005546783198</c:v>
                </c:pt>
                <c:pt idx="1399">
                  <c:v>31.831345295264398</c:v>
                </c:pt>
                <c:pt idx="1400">
                  <c:v>31.823685043745499</c:v>
                </c:pt>
                <c:pt idx="1401">
                  <c:v>31.816024792226699</c:v>
                </c:pt>
                <c:pt idx="1402">
                  <c:v>31.808364540707899</c:v>
                </c:pt>
                <c:pt idx="1403">
                  <c:v>31.800704289189099</c:v>
                </c:pt>
                <c:pt idx="1404">
                  <c:v>31.793044037670199</c:v>
                </c:pt>
                <c:pt idx="1405">
                  <c:v>31.785383786151399</c:v>
                </c:pt>
                <c:pt idx="1406">
                  <c:v>31.777723534632599</c:v>
                </c:pt>
                <c:pt idx="1407">
                  <c:v>31.7700632831137</c:v>
                </c:pt>
                <c:pt idx="1408">
                  <c:v>31.7624030315949</c:v>
                </c:pt>
                <c:pt idx="1409">
                  <c:v>31.7547427800761</c:v>
                </c:pt>
                <c:pt idx="1410">
                  <c:v>31.7470825285573</c:v>
                </c:pt>
                <c:pt idx="1411">
                  <c:v>31.7394222770384</c:v>
                </c:pt>
                <c:pt idx="1412">
                  <c:v>31.7317620255196</c:v>
                </c:pt>
                <c:pt idx="1413">
                  <c:v>31.7241017740008</c:v>
                </c:pt>
                <c:pt idx="1414">
                  <c:v>31.716441522481901</c:v>
                </c:pt>
                <c:pt idx="1415">
                  <c:v>31.708781270963101</c:v>
                </c:pt>
                <c:pt idx="1416">
                  <c:v>31.701121019444301</c:v>
                </c:pt>
                <c:pt idx="1417">
                  <c:v>31.693460767925501</c:v>
                </c:pt>
                <c:pt idx="1418">
                  <c:v>31.685800516406601</c:v>
                </c:pt>
                <c:pt idx="1419">
                  <c:v>31.678140264887801</c:v>
                </c:pt>
                <c:pt idx="1420">
                  <c:v>31.670480013369001</c:v>
                </c:pt>
                <c:pt idx="1421">
                  <c:v>31.662819761850098</c:v>
                </c:pt>
                <c:pt idx="1422">
                  <c:v>31.655159510331298</c:v>
                </c:pt>
                <c:pt idx="1423">
                  <c:v>31.647499258812498</c:v>
                </c:pt>
                <c:pt idx="1424">
                  <c:v>29.962243924670201</c:v>
                </c:pt>
                <c:pt idx="1425">
                  <c:v>29.954583673151301</c:v>
                </c:pt>
                <c:pt idx="1426">
                  <c:v>29.946923421632501</c:v>
                </c:pt>
                <c:pt idx="1427">
                  <c:v>29.939263170113701</c:v>
                </c:pt>
                <c:pt idx="1428">
                  <c:v>29.931602918594901</c:v>
                </c:pt>
                <c:pt idx="1429">
                  <c:v>29.923942667075998</c:v>
                </c:pt>
                <c:pt idx="1430">
                  <c:v>29.916282415557198</c:v>
                </c:pt>
                <c:pt idx="1431">
                  <c:v>29.908622164038398</c:v>
                </c:pt>
                <c:pt idx="1432">
                  <c:v>29.900961912519598</c:v>
                </c:pt>
                <c:pt idx="1433">
                  <c:v>29.893301661000699</c:v>
                </c:pt>
                <c:pt idx="1434">
                  <c:v>29.885641409481899</c:v>
                </c:pt>
                <c:pt idx="1435">
                  <c:v>29.877981157963099</c:v>
                </c:pt>
                <c:pt idx="1436">
                  <c:v>29.870320906444199</c:v>
                </c:pt>
                <c:pt idx="1437">
                  <c:v>29.862660654925399</c:v>
                </c:pt>
                <c:pt idx="1438">
                  <c:v>29.855000403406599</c:v>
                </c:pt>
                <c:pt idx="1439">
                  <c:v>29.847340151887799</c:v>
                </c:pt>
                <c:pt idx="1440">
                  <c:v>29.8396799003689</c:v>
                </c:pt>
                <c:pt idx="1441">
                  <c:v>29.8320196488501</c:v>
                </c:pt>
                <c:pt idx="1442">
                  <c:v>29.8243593973313</c:v>
                </c:pt>
                <c:pt idx="1443">
                  <c:v>29.8166991458124</c:v>
                </c:pt>
                <c:pt idx="1444">
                  <c:v>29.8090388942936</c:v>
                </c:pt>
                <c:pt idx="1445">
                  <c:v>29.8013786427748</c:v>
                </c:pt>
                <c:pt idx="1446">
                  <c:v>29.793718391255901</c:v>
                </c:pt>
                <c:pt idx="1447">
                  <c:v>29.786058139737101</c:v>
                </c:pt>
                <c:pt idx="1448">
                  <c:v>29.778397888218301</c:v>
                </c:pt>
                <c:pt idx="1449">
                  <c:v>29.770737636699501</c:v>
                </c:pt>
                <c:pt idx="1450">
                  <c:v>29.763077385180601</c:v>
                </c:pt>
                <c:pt idx="1451">
                  <c:v>29.755417133661801</c:v>
                </c:pt>
                <c:pt idx="1452">
                  <c:v>29.747756882143001</c:v>
                </c:pt>
                <c:pt idx="1453">
                  <c:v>29.740096630624102</c:v>
                </c:pt>
                <c:pt idx="1454">
                  <c:v>29.732436379105302</c:v>
                </c:pt>
                <c:pt idx="1455">
                  <c:v>29.724776127586502</c:v>
                </c:pt>
                <c:pt idx="1456">
                  <c:v>29.717115876067702</c:v>
                </c:pt>
                <c:pt idx="1457">
                  <c:v>29.709455624548799</c:v>
                </c:pt>
                <c:pt idx="1458">
                  <c:v>29.701795373029999</c:v>
                </c:pt>
                <c:pt idx="1459">
                  <c:v>29.694135121511199</c:v>
                </c:pt>
                <c:pt idx="1460">
                  <c:v>29.686474869992299</c:v>
                </c:pt>
                <c:pt idx="1461">
                  <c:v>29.678814618473499</c:v>
                </c:pt>
                <c:pt idx="1462">
                  <c:v>29.671154366954699</c:v>
                </c:pt>
                <c:pt idx="1463">
                  <c:v>29.663494115435899</c:v>
                </c:pt>
                <c:pt idx="1464">
                  <c:v>29.655833863917</c:v>
                </c:pt>
                <c:pt idx="1465">
                  <c:v>29.6481736123982</c:v>
                </c:pt>
                <c:pt idx="1466">
                  <c:v>29.6405133608794</c:v>
                </c:pt>
                <c:pt idx="1467">
                  <c:v>29.6328531093605</c:v>
                </c:pt>
                <c:pt idx="1468">
                  <c:v>29.6251928578417</c:v>
                </c:pt>
                <c:pt idx="1469">
                  <c:v>29.6175326063229</c:v>
                </c:pt>
                <c:pt idx="1470">
                  <c:v>29.6098723548041</c:v>
                </c:pt>
                <c:pt idx="1471">
                  <c:v>29.602212103285201</c:v>
                </c:pt>
                <c:pt idx="1472">
                  <c:v>29.594551851766401</c:v>
                </c:pt>
                <c:pt idx="1473">
                  <c:v>29.586891600247601</c:v>
                </c:pt>
                <c:pt idx="1474">
                  <c:v>29.579231348728701</c:v>
                </c:pt>
                <c:pt idx="1475">
                  <c:v>29.119616257598999</c:v>
                </c:pt>
                <c:pt idx="1476">
                  <c:v>29.111956006080199</c:v>
                </c:pt>
                <c:pt idx="1477">
                  <c:v>29.104295754561399</c:v>
                </c:pt>
                <c:pt idx="1478">
                  <c:v>29.096635503042499</c:v>
                </c:pt>
                <c:pt idx="1479">
                  <c:v>29.088975251523699</c:v>
                </c:pt>
                <c:pt idx="1480">
                  <c:v>29.081315000004899</c:v>
                </c:pt>
                <c:pt idx="1481">
                  <c:v>29.073654748486099</c:v>
                </c:pt>
                <c:pt idx="1482">
                  <c:v>29.0659944969672</c:v>
                </c:pt>
                <c:pt idx="1483">
                  <c:v>29.0583342454484</c:v>
                </c:pt>
                <c:pt idx="1484">
                  <c:v>29.0506739939296</c:v>
                </c:pt>
                <c:pt idx="1485">
                  <c:v>29.0430137424107</c:v>
                </c:pt>
                <c:pt idx="1486">
                  <c:v>29.0353534908919</c:v>
                </c:pt>
                <c:pt idx="1487">
                  <c:v>29.0276932393731</c:v>
                </c:pt>
                <c:pt idx="1488">
                  <c:v>29.0200329878543</c:v>
                </c:pt>
                <c:pt idx="1489">
                  <c:v>29.012372736335401</c:v>
                </c:pt>
                <c:pt idx="1490">
                  <c:v>29.004712484816601</c:v>
                </c:pt>
                <c:pt idx="1491">
                  <c:v>28.997052233297801</c:v>
                </c:pt>
                <c:pt idx="1492">
                  <c:v>28.989391981778901</c:v>
                </c:pt>
                <c:pt idx="1493">
                  <c:v>28.981731730260101</c:v>
                </c:pt>
                <c:pt idx="1494">
                  <c:v>28.974071478741301</c:v>
                </c:pt>
                <c:pt idx="1495">
                  <c:v>28.966411227222501</c:v>
                </c:pt>
                <c:pt idx="1496">
                  <c:v>28.958750975703602</c:v>
                </c:pt>
                <c:pt idx="1497">
                  <c:v>28.951090724184802</c:v>
                </c:pt>
                <c:pt idx="1498">
                  <c:v>28.943430472666002</c:v>
                </c:pt>
                <c:pt idx="1499">
                  <c:v>28.935770221147099</c:v>
                </c:pt>
                <c:pt idx="1500">
                  <c:v>28.928109969628299</c:v>
                </c:pt>
                <c:pt idx="1501">
                  <c:v>28.920449718109499</c:v>
                </c:pt>
                <c:pt idx="1502">
                  <c:v>28.912789466590699</c:v>
                </c:pt>
                <c:pt idx="1503">
                  <c:v>28.905129215071799</c:v>
                </c:pt>
                <c:pt idx="1504">
                  <c:v>28.897468963552999</c:v>
                </c:pt>
                <c:pt idx="1505">
                  <c:v>28.889808712034199</c:v>
                </c:pt>
                <c:pt idx="1506">
                  <c:v>28.8821484605153</c:v>
                </c:pt>
                <c:pt idx="1507">
                  <c:v>28.8744882089965</c:v>
                </c:pt>
                <c:pt idx="1508">
                  <c:v>28.8668279574777</c:v>
                </c:pt>
                <c:pt idx="1509">
                  <c:v>28.8591677059589</c:v>
                </c:pt>
                <c:pt idx="1510">
                  <c:v>28.85150745444</c:v>
                </c:pt>
                <c:pt idx="1511">
                  <c:v>28.8438472029212</c:v>
                </c:pt>
                <c:pt idx="1512">
                  <c:v>28.8361869514024</c:v>
                </c:pt>
                <c:pt idx="1513">
                  <c:v>28.828526699883501</c:v>
                </c:pt>
                <c:pt idx="1514">
                  <c:v>28.820866448364701</c:v>
                </c:pt>
                <c:pt idx="1515">
                  <c:v>28.813206196845901</c:v>
                </c:pt>
                <c:pt idx="1516">
                  <c:v>28.353591105716198</c:v>
                </c:pt>
                <c:pt idx="1517">
                  <c:v>28.345930854197299</c:v>
                </c:pt>
                <c:pt idx="1518">
                  <c:v>28.338270602678499</c:v>
                </c:pt>
                <c:pt idx="1519">
                  <c:v>28.330610351159699</c:v>
                </c:pt>
                <c:pt idx="1520">
                  <c:v>28.322950099640899</c:v>
                </c:pt>
                <c:pt idx="1521">
                  <c:v>28.315289848121999</c:v>
                </c:pt>
                <c:pt idx="1522">
                  <c:v>28.307629596603199</c:v>
                </c:pt>
                <c:pt idx="1523">
                  <c:v>28.299969345084399</c:v>
                </c:pt>
                <c:pt idx="1524">
                  <c:v>28.2923090935655</c:v>
                </c:pt>
                <c:pt idx="1525">
                  <c:v>28.2846488420467</c:v>
                </c:pt>
                <c:pt idx="1526">
                  <c:v>28.2769885905279</c:v>
                </c:pt>
                <c:pt idx="1527">
                  <c:v>28.2693283390091</c:v>
                </c:pt>
                <c:pt idx="1528">
                  <c:v>28.2616680874902</c:v>
                </c:pt>
                <c:pt idx="1529">
                  <c:v>28.2540078359714</c:v>
                </c:pt>
                <c:pt idx="1530">
                  <c:v>28.2463475844526</c:v>
                </c:pt>
                <c:pt idx="1531">
                  <c:v>28.238687332933701</c:v>
                </c:pt>
                <c:pt idx="1532">
                  <c:v>28.231027081414901</c:v>
                </c:pt>
                <c:pt idx="1533">
                  <c:v>28.223366829896101</c:v>
                </c:pt>
                <c:pt idx="1534">
                  <c:v>28.215706578377201</c:v>
                </c:pt>
                <c:pt idx="1535">
                  <c:v>28.208046326858401</c:v>
                </c:pt>
                <c:pt idx="1536">
                  <c:v>28.200386075339601</c:v>
                </c:pt>
                <c:pt idx="1537">
                  <c:v>28.192725823820801</c:v>
                </c:pt>
                <c:pt idx="1538">
                  <c:v>28.185065572301902</c:v>
                </c:pt>
                <c:pt idx="1539">
                  <c:v>28.177405320783102</c:v>
                </c:pt>
                <c:pt idx="1540">
                  <c:v>28.169745069264302</c:v>
                </c:pt>
                <c:pt idx="1541">
                  <c:v>28.162084817745399</c:v>
                </c:pt>
                <c:pt idx="1542">
                  <c:v>28.154424566226599</c:v>
                </c:pt>
                <c:pt idx="1543">
                  <c:v>28.146764314707799</c:v>
                </c:pt>
                <c:pt idx="1544">
                  <c:v>28.139104063188999</c:v>
                </c:pt>
                <c:pt idx="1545">
                  <c:v>28.131443811670099</c:v>
                </c:pt>
                <c:pt idx="1546">
                  <c:v>28.123783560151299</c:v>
                </c:pt>
                <c:pt idx="1547">
                  <c:v>28.116123308632499</c:v>
                </c:pt>
                <c:pt idx="1548">
                  <c:v>28.1084630571136</c:v>
                </c:pt>
                <c:pt idx="1549">
                  <c:v>28.1008028055948</c:v>
                </c:pt>
                <c:pt idx="1550">
                  <c:v>28.093142554076</c:v>
                </c:pt>
                <c:pt idx="1551">
                  <c:v>28.0854823025572</c:v>
                </c:pt>
                <c:pt idx="1552">
                  <c:v>28.0778220510383</c:v>
                </c:pt>
                <c:pt idx="1553">
                  <c:v>28.0701617995195</c:v>
                </c:pt>
                <c:pt idx="1554">
                  <c:v>28.0625015480007</c:v>
                </c:pt>
                <c:pt idx="1555">
                  <c:v>28.054841296481801</c:v>
                </c:pt>
                <c:pt idx="1556">
                  <c:v>28.047181044963001</c:v>
                </c:pt>
                <c:pt idx="1557">
                  <c:v>27.6641684690216</c:v>
                </c:pt>
                <c:pt idx="1558">
                  <c:v>27.6565082175028</c:v>
                </c:pt>
                <c:pt idx="1559">
                  <c:v>27.648847965983901</c:v>
                </c:pt>
                <c:pt idx="1560">
                  <c:v>27.641187714465101</c:v>
                </c:pt>
                <c:pt idx="1561">
                  <c:v>27.633527462946301</c:v>
                </c:pt>
                <c:pt idx="1562">
                  <c:v>27.625867211427401</c:v>
                </c:pt>
                <c:pt idx="1563">
                  <c:v>27.618206959908601</c:v>
                </c:pt>
                <c:pt idx="1564">
                  <c:v>27.610546708389801</c:v>
                </c:pt>
                <c:pt idx="1565">
                  <c:v>27.602886456871001</c:v>
                </c:pt>
                <c:pt idx="1566">
                  <c:v>27.595226205352098</c:v>
                </c:pt>
                <c:pt idx="1567">
                  <c:v>27.587565953833298</c:v>
                </c:pt>
                <c:pt idx="1568">
                  <c:v>27.579905702314498</c:v>
                </c:pt>
                <c:pt idx="1569">
                  <c:v>27.572245450795599</c:v>
                </c:pt>
                <c:pt idx="1570">
                  <c:v>27.564585199276799</c:v>
                </c:pt>
                <c:pt idx="1571">
                  <c:v>27.556924947757999</c:v>
                </c:pt>
                <c:pt idx="1572">
                  <c:v>27.549264696239199</c:v>
                </c:pt>
                <c:pt idx="1573">
                  <c:v>27.541604444720299</c:v>
                </c:pt>
                <c:pt idx="1574">
                  <c:v>27.533944193201499</c:v>
                </c:pt>
                <c:pt idx="1575">
                  <c:v>27.526283941682699</c:v>
                </c:pt>
                <c:pt idx="1576">
                  <c:v>27.5186236901638</c:v>
                </c:pt>
                <c:pt idx="1577">
                  <c:v>27.510963438645</c:v>
                </c:pt>
                <c:pt idx="1578">
                  <c:v>27.5033031871262</c:v>
                </c:pt>
                <c:pt idx="1579">
                  <c:v>27.4956429356074</c:v>
                </c:pt>
                <c:pt idx="1580">
                  <c:v>27.4879826840885</c:v>
                </c:pt>
                <c:pt idx="1581">
                  <c:v>27.4803224325697</c:v>
                </c:pt>
                <c:pt idx="1582">
                  <c:v>27.4726621810509</c:v>
                </c:pt>
                <c:pt idx="1583">
                  <c:v>27.465001929532001</c:v>
                </c:pt>
                <c:pt idx="1584">
                  <c:v>27.457341678013201</c:v>
                </c:pt>
                <c:pt idx="1585">
                  <c:v>27.449681426494401</c:v>
                </c:pt>
                <c:pt idx="1586">
                  <c:v>27.442021174975601</c:v>
                </c:pt>
                <c:pt idx="1587">
                  <c:v>27.434360923456701</c:v>
                </c:pt>
                <c:pt idx="1588">
                  <c:v>27.426700671937901</c:v>
                </c:pt>
                <c:pt idx="1589">
                  <c:v>27.419040420419101</c:v>
                </c:pt>
                <c:pt idx="1590">
                  <c:v>27.411380168900202</c:v>
                </c:pt>
                <c:pt idx="1591">
                  <c:v>27.403719917381402</c:v>
                </c:pt>
                <c:pt idx="1592">
                  <c:v>27.396059665862602</c:v>
                </c:pt>
                <c:pt idx="1593">
                  <c:v>27.388399414343802</c:v>
                </c:pt>
                <c:pt idx="1594">
                  <c:v>27.380739162824899</c:v>
                </c:pt>
                <c:pt idx="1595">
                  <c:v>27.373078911306099</c:v>
                </c:pt>
                <c:pt idx="1596">
                  <c:v>27.365418659787299</c:v>
                </c:pt>
                <c:pt idx="1597">
                  <c:v>27.357758408268399</c:v>
                </c:pt>
                <c:pt idx="1598">
                  <c:v>27.350098156749599</c:v>
                </c:pt>
                <c:pt idx="1599">
                  <c:v>27.342437905230799</c:v>
                </c:pt>
                <c:pt idx="1600">
                  <c:v>27.334777653711999</c:v>
                </c:pt>
                <c:pt idx="1601">
                  <c:v>27.3271174021931</c:v>
                </c:pt>
                <c:pt idx="1602">
                  <c:v>27.3194571506743</c:v>
                </c:pt>
                <c:pt idx="1603">
                  <c:v>27.3117968991555</c:v>
                </c:pt>
                <c:pt idx="1604">
                  <c:v>27.3041366476366</c:v>
                </c:pt>
                <c:pt idx="1605">
                  <c:v>27.2964763961178</c:v>
                </c:pt>
                <c:pt idx="1606">
                  <c:v>27.288816144599</c:v>
                </c:pt>
                <c:pt idx="1607">
                  <c:v>27.2811558930802</c:v>
                </c:pt>
                <c:pt idx="1608">
                  <c:v>25.672503074126102</c:v>
                </c:pt>
                <c:pt idx="1609">
                  <c:v>25.664842822607302</c:v>
                </c:pt>
                <c:pt idx="1610">
                  <c:v>25.657182571088502</c:v>
                </c:pt>
                <c:pt idx="1611">
                  <c:v>25.649522319569702</c:v>
                </c:pt>
                <c:pt idx="1612">
                  <c:v>25.641862068050798</c:v>
                </c:pt>
                <c:pt idx="1613">
                  <c:v>25.634201816531998</c:v>
                </c:pt>
                <c:pt idx="1614">
                  <c:v>25.626541565013198</c:v>
                </c:pt>
                <c:pt idx="1615">
                  <c:v>25.618881313494299</c:v>
                </c:pt>
                <c:pt idx="1616">
                  <c:v>25.611221061975499</c:v>
                </c:pt>
                <c:pt idx="1617">
                  <c:v>25.603560810456699</c:v>
                </c:pt>
                <c:pt idx="1618">
                  <c:v>25.595900558937899</c:v>
                </c:pt>
                <c:pt idx="1619">
                  <c:v>25.588240307418999</c:v>
                </c:pt>
                <c:pt idx="1620">
                  <c:v>25.580580055900199</c:v>
                </c:pt>
                <c:pt idx="1621">
                  <c:v>25.572919804381399</c:v>
                </c:pt>
                <c:pt idx="1622">
                  <c:v>25.5652595528625</c:v>
                </c:pt>
                <c:pt idx="1623">
                  <c:v>25.5575993013437</c:v>
                </c:pt>
                <c:pt idx="1624">
                  <c:v>25.5499390498249</c:v>
                </c:pt>
                <c:pt idx="1625">
                  <c:v>25.5422787983061</c:v>
                </c:pt>
                <c:pt idx="1626">
                  <c:v>25.5346185467872</c:v>
                </c:pt>
                <c:pt idx="1627">
                  <c:v>25.5269582952684</c:v>
                </c:pt>
                <c:pt idx="1628">
                  <c:v>25.5192980437496</c:v>
                </c:pt>
                <c:pt idx="1629">
                  <c:v>25.511637792230701</c:v>
                </c:pt>
                <c:pt idx="1630">
                  <c:v>25.503977540711901</c:v>
                </c:pt>
                <c:pt idx="1631">
                  <c:v>25.496317289193101</c:v>
                </c:pt>
                <c:pt idx="1632">
                  <c:v>25.488657037674301</c:v>
                </c:pt>
                <c:pt idx="1633">
                  <c:v>25.480996786155401</c:v>
                </c:pt>
                <c:pt idx="1634">
                  <c:v>25.473336534636601</c:v>
                </c:pt>
                <c:pt idx="1635">
                  <c:v>25.465676283117801</c:v>
                </c:pt>
                <c:pt idx="1636">
                  <c:v>25.458016031598898</c:v>
                </c:pt>
                <c:pt idx="1637">
                  <c:v>25.450355780080098</c:v>
                </c:pt>
                <c:pt idx="1638">
                  <c:v>25.442695528561298</c:v>
                </c:pt>
                <c:pt idx="1639">
                  <c:v>25.435035277042498</c:v>
                </c:pt>
                <c:pt idx="1640">
                  <c:v>25.427375025523599</c:v>
                </c:pt>
                <c:pt idx="1641">
                  <c:v>25.419714774004799</c:v>
                </c:pt>
                <c:pt idx="1642">
                  <c:v>25.412054522485999</c:v>
                </c:pt>
                <c:pt idx="1643">
                  <c:v>25.404394270967099</c:v>
                </c:pt>
                <c:pt idx="1644">
                  <c:v>25.396734019448299</c:v>
                </c:pt>
                <c:pt idx="1645">
                  <c:v>25.389073767929499</c:v>
                </c:pt>
                <c:pt idx="1646">
                  <c:v>25.381413516410699</c:v>
                </c:pt>
                <c:pt idx="1647">
                  <c:v>25.3737532648918</c:v>
                </c:pt>
                <c:pt idx="1648">
                  <c:v>25.366093013373</c:v>
                </c:pt>
                <c:pt idx="1649">
                  <c:v>25.3584327618542</c:v>
                </c:pt>
                <c:pt idx="1650">
                  <c:v>25.3507725103353</c:v>
                </c:pt>
                <c:pt idx="1651">
                  <c:v>25.3431122588165</c:v>
                </c:pt>
                <c:pt idx="1652">
                  <c:v>25.3354520072977</c:v>
                </c:pt>
                <c:pt idx="1653">
                  <c:v>25.327791755778801</c:v>
                </c:pt>
                <c:pt idx="1654">
                  <c:v>25.320131504260001</c:v>
                </c:pt>
                <c:pt idx="1655">
                  <c:v>25.312471252741201</c:v>
                </c:pt>
                <c:pt idx="1656">
                  <c:v>25.304811001222401</c:v>
                </c:pt>
                <c:pt idx="1657">
                  <c:v>25.297150749703501</c:v>
                </c:pt>
                <c:pt idx="1658">
                  <c:v>25.289490498184701</c:v>
                </c:pt>
                <c:pt idx="1659">
                  <c:v>25.281830246665901</c:v>
                </c:pt>
                <c:pt idx="1660">
                  <c:v>25.274169995146998</c:v>
                </c:pt>
                <c:pt idx="1661">
                  <c:v>25.266509743628198</c:v>
                </c:pt>
                <c:pt idx="1662">
                  <c:v>25.258849492109398</c:v>
                </c:pt>
                <c:pt idx="1663">
                  <c:v>25.251189240590602</c:v>
                </c:pt>
                <c:pt idx="1664">
                  <c:v>25.243528989071699</c:v>
                </c:pt>
                <c:pt idx="1665">
                  <c:v>25.235868737552899</c:v>
                </c:pt>
                <c:pt idx="1666">
                  <c:v>25.228208486034099</c:v>
                </c:pt>
                <c:pt idx="1667">
                  <c:v>25.220548234515299</c:v>
                </c:pt>
                <c:pt idx="1668">
                  <c:v>25.212887982996399</c:v>
                </c:pt>
                <c:pt idx="1669">
                  <c:v>25.205227731477599</c:v>
                </c:pt>
                <c:pt idx="1670">
                  <c:v>25.197567479958799</c:v>
                </c:pt>
                <c:pt idx="1671">
                  <c:v>25.1899072284399</c:v>
                </c:pt>
                <c:pt idx="1672">
                  <c:v>25.1822469769211</c:v>
                </c:pt>
                <c:pt idx="1673">
                  <c:v>25.1745867254023</c:v>
                </c:pt>
                <c:pt idx="1674">
                  <c:v>25.1669264738835</c:v>
                </c:pt>
                <c:pt idx="1675">
                  <c:v>25.1592662223646</c:v>
                </c:pt>
                <c:pt idx="1676">
                  <c:v>25.1516059708458</c:v>
                </c:pt>
                <c:pt idx="1677">
                  <c:v>25.143945719327</c:v>
                </c:pt>
                <c:pt idx="1678">
                  <c:v>25.136285467808101</c:v>
                </c:pt>
                <c:pt idx="1679">
                  <c:v>25.128625216289301</c:v>
                </c:pt>
                <c:pt idx="1680">
                  <c:v>25.120964964770501</c:v>
                </c:pt>
                <c:pt idx="1681">
                  <c:v>25.113304713251701</c:v>
                </c:pt>
                <c:pt idx="1682">
                  <c:v>25.105644461732801</c:v>
                </c:pt>
                <c:pt idx="1683">
                  <c:v>25.097984210214001</c:v>
                </c:pt>
                <c:pt idx="1684">
                  <c:v>25.090323958695201</c:v>
                </c:pt>
                <c:pt idx="1685">
                  <c:v>25.082663707176302</c:v>
                </c:pt>
                <c:pt idx="1686">
                  <c:v>25.075003455657502</c:v>
                </c:pt>
                <c:pt idx="1687">
                  <c:v>25.067343204138702</c:v>
                </c:pt>
                <c:pt idx="1688">
                  <c:v>25.059682952619799</c:v>
                </c:pt>
                <c:pt idx="1689">
                  <c:v>23.068017557724399</c:v>
                </c:pt>
                <c:pt idx="1690">
                  <c:v>23.060357306205599</c:v>
                </c:pt>
                <c:pt idx="1691">
                  <c:v>23.0526970546867</c:v>
                </c:pt>
                <c:pt idx="1692">
                  <c:v>23.0450368031679</c:v>
                </c:pt>
                <c:pt idx="1693">
                  <c:v>23.0373765516491</c:v>
                </c:pt>
                <c:pt idx="1694">
                  <c:v>23.0297163001303</c:v>
                </c:pt>
                <c:pt idx="1695">
                  <c:v>23.0220560486114</c:v>
                </c:pt>
                <c:pt idx="1696">
                  <c:v>23.0143957970926</c:v>
                </c:pt>
                <c:pt idx="1697">
                  <c:v>23.0067355455738</c:v>
                </c:pt>
                <c:pt idx="1698">
                  <c:v>22.999075294054901</c:v>
                </c:pt>
                <c:pt idx="1699">
                  <c:v>22.991415042536101</c:v>
                </c:pt>
                <c:pt idx="1700">
                  <c:v>22.983754791017301</c:v>
                </c:pt>
                <c:pt idx="1701">
                  <c:v>22.976094539498501</c:v>
                </c:pt>
                <c:pt idx="1702">
                  <c:v>22.968434287979601</c:v>
                </c:pt>
                <c:pt idx="1703">
                  <c:v>22.960774036460801</c:v>
                </c:pt>
                <c:pt idx="1704">
                  <c:v>22.953113784942001</c:v>
                </c:pt>
                <c:pt idx="1705">
                  <c:v>22.945453533423098</c:v>
                </c:pt>
                <c:pt idx="1706">
                  <c:v>22.937793281904298</c:v>
                </c:pt>
                <c:pt idx="1707">
                  <c:v>22.930133030385502</c:v>
                </c:pt>
                <c:pt idx="1708">
                  <c:v>22.922472778866702</c:v>
                </c:pt>
                <c:pt idx="1709">
                  <c:v>22.914812527347799</c:v>
                </c:pt>
                <c:pt idx="1710">
                  <c:v>22.907152275828999</c:v>
                </c:pt>
                <c:pt idx="1711">
                  <c:v>22.899492024310199</c:v>
                </c:pt>
                <c:pt idx="1712">
                  <c:v>22.891831772791299</c:v>
                </c:pt>
                <c:pt idx="1713">
                  <c:v>22.884171521272499</c:v>
                </c:pt>
                <c:pt idx="1714">
                  <c:v>22.876511269753699</c:v>
                </c:pt>
                <c:pt idx="1715">
                  <c:v>22.868851018234899</c:v>
                </c:pt>
                <c:pt idx="1716">
                  <c:v>22.861190766716</c:v>
                </c:pt>
                <c:pt idx="1717">
                  <c:v>22.8535305151972</c:v>
                </c:pt>
                <c:pt idx="1718">
                  <c:v>22.8458702636784</c:v>
                </c:pt>
                <c:pt idx="1719">
                  <c:v>22.8382100121595</c:v>
                </c:pt>
                <c:pt idx="1720">
                  <c:v>22.8305497606407</c:v>
                </c:pt>
                <c:pt idx="1721">
                  <c:v>22.8228895091219</c:v>
                </c:pt>
                <c:pt idx="1722">
                  <c:v>22.8152292576031</c:v>
                </c:pt>
                <c:pt idx="1723">
                  <c:v>22.807569006084201</c:v>
                </c:pt>
                <c:pt idx="1724">
                  <c:v>22.799908754565401</c:v>
                </c:pt>
                <c:pt idx="1725">
                  <c:v>22.792248503046601</c:v>
                </c:pt>
                <c:pt idx="1726">
                  <c:v>22.784588251527701</c:v>
                </c:pt>
                <c:pt idx="1727">
                  <c:v>22.776928000008901</c:v>
                </c:pt>
                <c:pt idx="1728">
                  <c:v>22.769267748490101</c:v>
                </c:pt>
                <c:pt idx="1729">
                  <c:v>22.761607496971301</c:v>
                </c:pt>
                <c:pt idx="1730">
                  <c:v>22.753947245452402</c:v>
                </c:pt>
                <c:pt idx="1731">
                  <c:v>22.746286993933602</c:v>
                </c:pt>
                <c:pt idx="1732">
                  <c:v>22.738626742414802</c:v>
                </c:pt>
                <c:pt idx="1733">
                  <c:v>22.730966490895899</c:v>
                </c:pt>
                <c:pt idx="1734">
                  <c:v>22.723306239377099</c:v>
                </c:pt>
                <c:pt idx="1735">
                  <c:v>22.715645987858299</c:v>
                </c:pt>
                <c:pt idx="1736">
                  <c:v>22.707985736339499</c:v>
                </c:pt>
                <c:pt idx="1737">
                  <c:v>22.700325484820599</c:v>
                </c:pt>
                <c:pt idx="1738">
                  <c:v>22.692665233301799</c:v>
                </c:pt>
                <c:pt idx="1739">
                  <c:v>22.685004981782999</c:v>
                </c:pt>
                <c:pt idx="1740">
                  <c:v>22.6773447302641</c:v>
                </c:pt>
                <c:pt idx="1741">
                  <c:v>22.6696844787453</c:v>
                </c:pt>
                <c:pt idx="1742">
                  <c:v>22.6620242272265</c:v>
                </c:pt>
                <c:pt idx="1743">
                  <c:v>22.6543639757077</c:v>
                </c:pt>
                <c:pt idx="1744">
                  <c:v>22.6467037241888</c:v>
                </c:pt>
                <c:pt idx="1745">
                  <c:v>22.63904347267</c:v>
                </c:pt>
                <c:pt idx="1746">
                  <c:v>22.6313832211512</c:v>
                </c:pt>
                <c:pt idx="1747">
                  <c:v>22.623722969632301</c:v>
                </c:pt>
                <c:pt idx="1748">
                  <c:v>22.616062718113501</c:v>
                </c:pt>
                <c:pt idx="1749">
                  <c:v>22.608402466594701</c:v>
                </c:pt>
                <c:pt idx="1750">
                  <c:v>19.084686767933501</c:v>
                </c:pt>
                <c:pt idx="1751">
                  <c:v>19.077026516414701</c:v>
                </c:pt>
                <c:pt idx="1752">
                  <c:v>19.069366264895901</c:v>
                </c:pt>
                <c:pt idx="1753">
                  <c:v>19.061706013377002</c:v>
                </c:pt>
                <c:pt idx="1754">
                  <c:v>19.054045761858202</c:v>
                </c:pt>
                <c:pt idx="1755">
                  <c:v>19.046385510339402</c:v>
                </c:pt>
                <c:pt idx="1756">
                  <c:v>19.038725258820499</c:v>
                </c:pt>
                <c:pt idx="1757">
                  <c:v>19.031065007301699</c:v>
                </c:pt>
                <c:pt idx="1758">
                  <c:v>19.023404755782899</c:v>
                </c:pt>
                <c:pt idx="1759">
                  <c:v>19.015744504264099</c:v>
                </c:pt>
                <c:pt idx="1760">
                  <c:v>19.008084252745199</c:v>
                </c:pt>
                <c:pt idx="1761">
                  <c:v>19.000424001226399</c:v>
                </c:pt>
                <c:pt idx="1762">
                  <c:v>18.992763749707599</c:v>
                </c:pt>
                <c:pt idx="1763">
                  <c:v>18.9851034981887</c:v>
                </c:pt>
                <c:pt idx="1764">
                  <c:v>18.9774432466699</c:v>
                </c:pt>
                <c:pt idx="1765">
                  <c:v>18.9697829951511</c:v>
                </c:pt>
                <c:pt idx="1766">
                  <c:v>18.9621227436323</c:v>
                </c:pt>
                <c:pt idx="1767">
                  <c:v>18.9544624921134</c:v>
                </c:pt>
                <c:pt idx="1768">
                  <c:v>18.9468022405946</c:v>
                </c:pt>
                <c:pt idx="1769">
                  <c:v>18.9391419890758</c:v>
                </c:pt>
                <c:pt idx="1770">
                  <c:v>18.931481737556901</c:v>
                </c:pt>
                <c:pt idx="1771">
                  <c:v>18.923821486038101</c:v>
                </c:pt>
                <c:pt idx="1772">
                  <c:v>18.916161234519301</c:v>
                </c:pt>
                <c:pt idx="1773">
                  <c:v>18.908500983000501</c:v>
                </c:pt>
                <c:pt idx="1774">
                  <c:v>18.900840731481601</c:v>
                </c:pt>
                <c:pt idx="1775">
                  <c:v>18.893180479962801</c:v>
                </c:pt>
                <c:pt idx="1776">
                  <c:v>18.885520228444001</c:v>
                </c:pt>
                <c:pt idx="1777">
                  <c:v>18.877859976925102</c:v>
                </c:pt>
                <c:pt idx="1778">
                  <c:v>18.870199725406302</c:v>
                </c:pt>
                <c:pt idx="1779">
                  <c:v>18.862539473887502</c:v>
                </c:pt>
                <c:pt idx="1780">
                  <c:v>18.854879222368702</c:v>
                </c:pt>
                <c:pt idx="1781">
                  <c:v>18.847218970849799</c:v>
                </c:pt>
                <c:pt idx="1782">
                  <c:v>18.839558719330999</c:v>
                </c:pt>
                <c:pt idx="1783">
                  <c:v>18.831898467812199</c:v>
                </c:pt>
                <c:pt idx="1784">
                  <c:v>18.824238216293299</c:v>
                </c:pt>
                <c:pt idx="1785">
                  <c:v>18.816577964774499</c:v>
                </c:pt>
                <c:pt idx="1786">
                  <c:v>18.808917713255699</c:v>
                </c:pt>
                <c:pt idx="1787">
                  <c:v>18.801257461736899</c:v>
                </c:pt>
                <c:pt idx="1788">
                  <c:v>18.793597210218</c:v>
                </c:pt>
                <c:pt idx="1789">
                  <c:v>18.7859369586992</c:v>
                </c:pt>
                <c:pt idx="1790">
                  <c:v>18.7782767071804</c:v>
                </c:pt>
                <c:pt idx="1791">
                  <c:v>17.0164188578498</c:v>
                </c:pt>
                <c:pt idx="1792">
                  <c:v>17.008758606331</c:v>
                </c:pt>
                <c:pt idx="1793">
                  <c:v>17.0010983548121</c:v>
                </c:pt>
                <c:pt idx="1794">
                  <c:v>16.9934381032933</c:v>
                </c:pt>
                <c:pt idx="1795">
                  <c:v>16.9857778517745</c:v>
                </c:pt>
                <c:pt idx="1796">
                  <c:v>16.978117600255601</c:v>
                </c:pt>
                <c:pt idx="1797">
                  <c:v>16.970457348736801</c:v>
                </c:pt>
                <c:pt idx="1798">
                  <c:v>16.962797097218001</c:v>
                </c:pt>
                <c:pt idx="1799">
                  <c:v>16.955136845699201</c:v>
                </c:pt>
                <c:pt idx="1800">
                  <c:v>16.947476594180301</c:v>
                </c:pt>
                <c:pt idx="1801">
                  <c:v>16.939816342661501</c:v>
                </c:pt>
                <c:pt idx="1802">
                  <c:v>16.932156091142701</c:v>
                </c:pt>
                <c:pt idx="1803">
                  <c:v>16.924495839623798</c:v>
                </c:pt>
                <c:pt idx="1804">
                  <c:v>16.916835588104998</c:v>
                </c:pt>
                <c:pt idx="1805">
                  <c:v>16.909175336586198</c:v>
                </c:pt>
                <c:pt idx="1806">
                  <c:v>16.901515085067299</c:v>
                </c:pt>
                <c:pt idx="1807">
                  <c:v>16.893854833548499</c:v>
                </c:pt>
                <c:pt idx="1808">
                  <c:v>16.886194582029699</c:v>
                </c:pt>
                <c:pt idx="1809">
                  <c:v>16.878534330510899</c:v>
                </c:pt>
                <c:pt idx="1810">
                  <c:v>16.870874078991999</c:v>
                </c:pt>
                <c:pt idx="1811">
                  <c:v>16.863213827473199</c:v>
                </c:pt>
                <c:pt idx="1812">
                  <c:v>16.855553575954399</c:v>
                </c:pt>
                <c:pt idx="1813">
                  <c:v>16.8478933244355</c:v>
                </c:pt>
                <c:pt idx="1814">
                  <c:v>16.8402330729167</c:v>
                </c:pt>
                <c:pt idx="1815">
                  <c:v>16.8325728213979</c:v>
                </c:pt>
                <c:pt idx="1816">
                  <c:v>16.8249125698791</c:v>
                </c:pt>
                <c:pt idx="1817">
                  <c:v>16.8172523183602</c:v>
                </c:pt>
                <c:pt idx="1818">
                  <c:v>16.8095920668414</c:v>
                </c:pt>
                <c:pt idx="1819">
                  <c:v>16.8019318153226</c:v>
                </c:pt>
                <c:pt idx="1820">
                  <c:v>16.794271563803701</c:v>
                </c:pt>
                <c:pt idx="1821">
                  <c:v>16.786611312284901</c:v>
                </c:pt>
                <c:pt idx="1822">
                  <c:v>16.778951060766101</c:v>
                </c:pt>
                <c:pt idx="1823">
                  <c:v>16.771290809247301</c:v>
                </c:pt>
                <c:pt idx="1824">
                  <c:v>16.763630557728401</c:v>
                </c:pt>
                <c:pt idx="1825">
                  <c:v>16.755970306209601</c:v>
                </c:pt>
                <c:pt idx="1826">
                  <c:v>16.748310054690801</c:v>
                </c:pt>
                <c:pt idx="1827">
                  <c:v>16.740649803171902</c:v>
                </c:pt>
                <c:pt idx="1828">
                  <c:v>16.732989551653102</c:v>
                </c:pt>
                <c:pt idx="1829">
                  <c:v>16.725329300134302</c:v>
                </c:pt>
                <c:pt idx="1830">
                  <c:v>16.717669048615502</c:v>
                </c:pt>
                <c:pt idx="1831">
                  <c:v>16.710008797096599</c:v>
                </c:pt>
                <c:pt idx="1832">
                  <c:v>16.702348545577799</c:v>
                </c:pt>
                <c:pt idx="1833">
                  <c:v>16.694688294058999</c:v>
                </c:pt>
                <c:pt idx="1834">
                  <c:v>16.687028042540099</c:v>
                </c:pt>
                <c:pt idx="1835">
                  <c:v>16.679367791021299</c:v>
                </c:pt>
                <c:pt idx="1836">
                  <c:v>16.671707539502499</c:v>
                </c:pt>
                <c:pt idx="1837">
                  <c:v>16.664047287983699</c:v>
                </c:pt>
                <c:pt idx="1838">
                  <c:v>16.6563870364648</c:v>
                </c:pt>
                <c:pt idx="1839">
                  <c:v>16.648726784946</c:v>
                </c:pt>
                <c:pt idx="1840">
                  <c:v>16.6410665334272</c:v>
                </c:pt>
                <c:pt idx="1841">
                  <c:v>16.6334062819083</c:v>
                </c:pt>
                <c:pt idx="1842">
                  <c:v>16.6257460303895</c:v>
                </c:pt>
                <c:pt idx="1843">
                  <c:v>16.6180857788707</c:v>
                </c:pt>
                <c:pt idx="1844">
                  <c:v>16.6104255273519</c:v>
                </c:pt>
                <c:pt idx="1845">
                  <c:v>16.602765275833001</c:v>
                </c:pt>
                <c:pt idx="1846">
                  <c:v>16.595105024314201</c:v>
                </c:pt>
                <c:pt idx="1847">
                  <c:v>16.587444772795401</c:v>
                </c:pt>
                <c:pt idx="1848">
                  <c:v>16.579784521276501</c:v>
                </c:pt>
                <c:pt idx="1849">
                  <c:v>16.572124269757701</c:v>
                </c:pt>
                <c:pt idx="1850">
                  <c:v>16.564464018238901</c:v>
                </c:pt>
                <c:pt idx="1851">
                  <c:v>16.556803766720101</c:v>
                </c:pt>
                <c:pt idx="1852">
                  <c:v>16.549143515201202</c:v>
                </c:pt>
                <c:pt idx="1853">
                  <c:v>16.541483263682402</c:v>
                </c:pt>
                <c:pt idx="1854">
                  <c:v>16.533823012163602</c:v>
                </c:pt>
                <c:pt idx="1855">
                  <c:v>16.526162760644699</c:v>
                </c:pt>
                <c:pt idx="1856">
                  <c:v>16.518502509125899</c:v>
                </c:pt>
                <c:pt idx="1857">
                  <c:v>16.510842257607099</c:v>
                </c:pt>
                <c:pt idx="1858">
                  <c:v>16.503182006088299</c:v>
                </c:pt>
                <c:pt idx="1859">
                  <c:v>16.495521754569399</c:v>
                </c:pt>
                <c:pt idx="1860">
                  <c:v>16.487861503050599</c:v>
                </c:pt>
                <c:pt idx="1861">
                  <c:v>16.480201251531799</c:v>
                </c:pt>
                <c:pt idx="1862">
                  <c:v>16.4725410000129</c:v>
                </c:pt>
                <c:pt idx="1863">
                  <c:v>16.4648807484941</c:v>
                </c:pt>
                <c:pt idx="1864">
                  <c:v>16.4572204969753</c:v>
                </c:pt>
                <c:pt idx="1865">
                  <c:v>16.4495602454565</c:v>
                </c:pt>
                <c:pt idx="1866">
                  <c:v>16.4418999939376</c:v>
                </c:pt>
                <c:pt idx="1867">
                  <c:v>16.4342397424188</c:v>
                </c:pt>
                <c:pt idx="1868">
                  <c:v>16.4265794909</c:v>
                </c:pt>
                <c:pt idx="1869">
                  <c:v>16.418919239381101</c:v>
                </c:pt>
                <c:pt idx="1870">
                  <c:v>16.411258987862301</c:v>
                </c:pt>
                <c:pt idx="1871">
                  <c:v>16.403598736343501</c:v>
                </c:pt>
                <c:pt idx="1872">
                  <c:v>16.395938484824701</c:v>
                </c:pt>
                <c:pt idx="1873">
                  <c:v>16.388278233305801</c:v>
                </c:pt>
                <c:pt idx="1874">
                  <c:v>16.380617981787001</c:v>
                </c:pt>
                <c:pt idx="1875">
                  <c:v>16.372957730268201</c:v>
                </c:pt>
                <c:pt idx="1876">
                  <c:v>16.365297478749302</c:v>
                </c:pt>
                <c:pt idx="1877">
                  <c:v>16.357637227230502</c:v>
                </c:pt>
                <c:pt idx="1878">
                  <c:v>16.349976975711701</c:v>
                </c:pt>
                <c:pt idx="1879">
                  <c:v>16.342316724192901</c:v>
                </c:pt>
                <c:pt idx="1880">
                  <c:v>16.334656472673998</c:v>
                </c:pt>
                <c:pt idx="1881">
                  <c:v>16.326996221155198</c:v>
                </c:pt>
                <c:pt idx="1882">
                  <c:v>16.319335969636398</c:v>
                </c:pt>
                <c:pt idx="1883">
                  <c:v>16.311675718117499</c:v>
                </c:pt>
                <c:pt idx="1884">
                  <c:v>16.304015466598699</c:v>
                </c:pt>
                <c:pt idx="1885">
                  <c:v>16.296355215079899</c:v>
                </c:pt>
                <c:pt idx="1886">
                  <c:v>16.288694963561099</c:v>
                </c:pt>
                <c:pt idx="1887">
                  <c:v>16.281034712042199</c:v>
                </c:pt>
                <c:pt idx="1888">
                  <c:v>16.273374460523399</c:v>
                </c:pt>
                <c:pt idx="1889">
                  <c:v>16.265714209004599</c:v>
                </c:pt>
                <c:pt idx="1890">
                  <c:v>16.2580539574857</c:v>
                </c:pt>
                <c:pt idx="1891">
                  <c:v>16.2503937059669</c:v>
                </c:pt>
              </c:numCache>
            </c:numRef>
          </c:xVal>
          <c:yVal>
            <c:numRef>
              <c:f>Sheet1!$C$2:$C$1893</c:f>
              <c:numCache>
                <c:formatCode>General</c:formatCode>
                <c:ptCount val="189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  <c:pt idx="25">
                  <c:v>0</c:v>
                </c:pt>
                <c:pt idx="26">
                  <c:v>0</c:v>
                </c:pt>
                <c:pt idx="27">
                  <c:v>0</c:v>
                </c:pt>
                <c:pt idx="28">
                  <c:v>0</c:v>
                </c:pt>
                <c:pt idx="29">
                  <c:v>0</c:v>
                </c:pt>
                <c:pt idx="30">
                  <c:v>0</c:v>
                </c:pt>
                <c:pt idx="31">
                  <c:v>0</c:v>
                </c:pt>
                <c:pt idx="32">
                  <c:v>0</c:v>
                </c:pt>
                <c:pt idx="33">
                  <c:v>0</c:v>
                </c:pt>
                <c:pt idx="34">
                  <c:v>0</c:v>
                </c:pt>
                <c:pt idx="35">
                  <c:v>0</c:v>
                </c:pt>
                <c:pt idx="36">
                  <c:v>0</c:v>
                </c:pt>
                <c:pt idx="37">
                  <c:v>0</c:v>
                </c:pt>
                <c:pt idx="38">
                  <c:v>0</c:v>
                </c:pt>
                <c:pt idx="39">
                  <c:v>0</c:v>
                </c:pt>
                <c:pt idx="40">
                  <c:v>0</c:v>
                </c:pt>
                <c:pt idx="41">
                  <c:v>0</c:v>
                </c:pt>
                <c:pt idx="42">
                  <c:v>0</c:v>
                </c:pt>
                <c:pt idx="43">
                  <c:v>0</c:v>
                </c:pt>
                <c:pt idx="44">
                  <c:v>0</c:v>
                </c:pt>
                <c:pt idx="45">
                  <c:v>0</c:v>
                </c:pt>
                <c:pt idx="46">
                  <c:v>0</c:v>
                </c:pt>
                <c:pt idx="47">
                  <c:v>0</c:v>
                </c:pt>
                <c:pt idx="48">
                  <c:v>0</c:v>
                </c:pt>
                <c:pt idx="49">
                  <c:v>0</c:v>
                </c:pt>
                <c:pt idx="50">
                  <c:v>0</c:v>
                </c:pt>
                <c:pt idx="51">
                  <c:v>0</c:v>
                </c:pt>
                <c:pt idx="52">
                  <c:v>0</c:v>
                </c:pt>
                <c:pt idx="53">
                  <c:v>0</c:v>
                </c:pt>
                <c:pt idx="54">
                  <c:v>0</c:v>
                </c:pt>
                <c:pt idx="55">
                  <c:v>0</c:v>
                </c:pt>
                <c:pt idx="56">
                  <c:v>0</c:v>
                </c:pt>
                <c:pt idx="57">
                  <c:v>0</c:v>
                </c:pt>
                <c:pt idx="58">
                  <c:v>0</c:v>
                </c:pt>
                <c:pt idx="59">
                  <c:v>0</c:v>
                </c:pt>
                <c:pt idx="60">
                  <c:v>0</c:v>
                </c:pt>
                <c:pt idx="61">
                  <c:v>0</c:v>
                </c:pt>
                <c:pt idx="62">
                  <c:v>0</c:v>
                </c:pt>
                <c:pt idx="63">
                  <c:v>0</c:v>
                </c:pt>
                <c:pt idx="64">
                  <c:v>0</c:v>
                </c:pt>
                <c:pt idx="65">
                  <c:v>0</c:v>
                </c:pt>
                <c:pt idx="66">
                  <c:v>0</c:v>
                </c:pt>
                <c:pt idx="67">
                  <c:v>0</c:v>
                </c:pt>
                <c:pt idx="68">
                  <c:v>0</c:v>
                </c:pt>
                <c:pt idx="69">
                  <c:v>0</c:v>
                </c:pt>
                <c:pt idx="70">
                  <c:v>0</c:v>
                </c:pt>
                <c:pt idx="71">
                  <c:v>0</c:v>
                </c:pt>
                <c:pt idx="72">
                  <c:v>0</c:v>
                </c:pt>
                <c:pt idx="73">
                  <c:v>0</c:v>
                </c:pt>
                <c:pt idx="74">
                  <c:v>0</c:v>
                </c:pt>
                <c:pt idx="75">
                  <c:v>0</c:v>
                </c:pt>
                <c:pt idx="76">
                  <c:v>0</c:v>
                </c:pt>
                <c:pt idx="77">
                  <c:v>0</c:v>
                </c:pt>
                <c:pt idx="78">
                  <c:v>0</c:v>
                </c:pt>
                <c:pt idx="79">
                  <c:v>0</c:v>
                </c:pt>
                <c:pt idx="80">
                  <c:v>0</c:v>
                </c:pt>
                <c:pt idx="81">
                  <c:v>0</c:v>
                </c:pt>
                <c:pt idx="82">
                  <c:v>0</c:v>
                </c:pt>
                <c:pt idx="83">
                  <c:v>0</c:v>
                </c:pt>
                <c:pt idx="84">
                  <c:v>0</c:v>
                </c:pt>
                <c:pt idx="85">
                  <c:v>0</c:v>
                </c:pt>
                <c:pt idx="86">
                  <c:v>0</c:v>
                </c:pt>
                <c:pt idx="87">
                  <c:v>0</c:v>
                </c:pt>
                <c:pt idx="88">
                  <c:v>0</c:v>
                </c:pt>
                <c:pt idx="89">
                  <c:v>0</c:v>
                </c:pt>
                <c:pt idx="90">
                  <c:v>0</c:v>
                </c:pt>
                <c:pt idx="91">
                  <c:v>0</c:v>
                </c:pt>
                <c:pt idx="92">
                  <c:v>0</c:v>
                </c:pt>
                <c:pt idx="93">
                  <c:v>0</c:v>
                </c:pt>
                <c:pt idx="94">
                  <c:v>0</c:v>
                </c:pt>
                <c:pt idx="95">
                  <c:v>0</c:v>
                </c:pt>
                <c:pt idx="96">
                  <c:v>0</c:v>
                </c:pt>
                <c:pt idx="97">
                  <c:v>0</c:v>
                </c:pt>
                <c:pt idx="98">
                  <c:v>0</c:v>
                </c:pt>
                <c:pt idx="99">
                  <c:v>0</c:v>
                </c:pt>
                <c:pt idx="100">
                  <c:v>0</c:v>
                </c:pt>
                <c:pt idx="101">
                  <c:v>0</c:v>
                </c:pt>
                <c:pt idx="102">
                  <c:v>0</c:v>
                </c:pt>
                <c:pt idx="103">
                  <c:v>0</c:v>
                </c:pt>
                <c:pt idx="104">
                  <c:v>0</c:v>
                </c:pt>
                <c:pt idx="105">
                  <c:v>0</c:v>
                </c:pt>
                <c:pt idx="106">
                  <c:v>0</c:v>
                </c:pt>
                <c:pt idx="107">
                  <c:v>0</c:v>
                </c:pt>
                <c:pt idx="108">
                  <c:v>0</c:v>
                </c:pt>
                <c:pt idx="109">
                  <c:v>0</c:v>
                </c:pt>
                <c:pt idx="110">
                  <c:v>0</c:v>
                </c:pt>
                <c:pt idx="111">
                  <c:v>0</c:v>
                </c:pt>
                <c:pt idx="112">
                  <c:v>0</c:v>
                </c:pt>
                <c:pt idx="113">
                  <c:v>0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0</c:v>
                </c:pt>
                <c:pt idx="121">
                  <c:v>0</c:v>
                </c:pt>
                <c:pt idx="122">
                  <c:v>0</c:v>
                </c:pt>
                <c:pt idx="123">
                  <c:v>0</c:v>
                </c:pt>
                <c:pt idx="124">
                  <c:v>0</c:v>
                </c:pt>
                <c:pt idx="125">
                  <c:v>0</c:v>
                </c:pt>
                <c:pt idx="126">
                  <c:v>0</c:v>
                </c:pt>
                <c:pt idx="127">
                  <c:v>0</c:v>
                </c:pt>
                <c:pt idx="128">
                  <c:v>0</c:v>
                </c:pt>
                <c:pt idx="129">
                  <c:v>0</c:v>
                </c:pt>
                <c:pt idx="130">
                  <c:v>0</c:v>
                </c:pt>
                <c:pt idx="131">
                  <c:v>0</c:v>
                </c:pt>
                <c:pt idx="132">
                  <c:v>0</c:v>
                </c:pt>
                <c:pt idx="133">
                  <c:v>0</c:v>
                </c:pt>
                <c:pt idx="134">
                  <c:v>0</c:v>
                </c:pt>
                <c:pt idx="135">
                  <c:v>0</c:v>
                </c:pt>
                <c:pt idx="136">
                  <c:v>0</c:v>
                </c:pt>
                <c:pt idx="137">
                  <c:v>0</c:v>
                </c:pt>
                <c:pt idx="138">
                  <c:v>0</c:v>
                </c:pt>
                <c:pt idx="139">
                  <c:v>0</c:v>
                </c:pt>
                <c:pt idx="140">
                  <c:v>0</c:v>
                </c:pt>
                <c:pt idx="141">
                  <c:v>0</c:v>
                </c:pt>
                <c:pt idx="142">
                  <c:v>0</c:v>
                </c:pt>
                <c:pt idx="143">
                  <c:v>0</c:v>
                </c:pt>
                <c:pt idx="144">
                  <c:v>0</c:v>
                </c:pt>
                <c:pt idx="145">
                  <c:v>0</c:v>
                </c:pt>
                <c:pt idx="146">
                  <c:v>0</c:v>
                </c:pt>
                <c:pt idx="147">
                  <c:v>0</c:v>
                </c:pt>
                <c:pt idx="148">
                  <c:v>0</c:v>
                </c:pt>
                <c:pt idx="149">
                  <c:v>0</c:v>
                </c:pt>
                <c:pt idx="150">
                  <c:v>0</c:v>
                </c:pt>
                <c:pt idx="151">
                  <c:v>0</c:v>
                </c:pt>
                <c:pt idx="152">
                  <c:v>0</c:v>
                </c:pt>
                <c:pt idx="153">
                  <c:v>0</c:v>
                </c:pt>
                <c:pt idx="154">
                  <c:v>0</c:v>
                </c:pt>
                <c:pt idx="155">
                  <c:v>0</c:v>
                </c:pt>
                <c:pt idx="156">
                  <c:v>0</c:v>
                </c:pt>
                <c:pt idx="157">
                  <c:v>0</c:v>
                </c:pt>
                <c:pt idx="158">
                  <c:v>0</c:v>
                </c:pt>
                <c:pt idx="159">
                  <c:v>0</c:v>
                </c:pt>
                <c:pt idx="160">
                  <c:v>0</c:v>
                </c:pt>
                <c:pt idx="161">
                  <c:v>0</c:v>
                </c:pt>
                <c:pt idx="162">
                  <c:v>0</c:v>
                </c:pt>
                <c:pt idx="163">
                  <c:v>0</c:v>
                </c:pt>
                <c:pt idx="164">
                  <c:v>0</c:v>
                </c:pt>
                <c:pt idx="165">
                  <c:v>0</c:v>
                </c:pt>
                <c:pt idx="166">
                  <c:v>0</c:v>
                </c:pt>
                <c:pt idx="167">
                  <c:v>0</c:v>
                </c:pt>
                <c:pt idx="168">
                  <c:v>0</c:v>
                </c:pt>
                <c:pt idx="169">
                  <c:v>0</c:v>
                </c:pt>
                <c:pt idx="170">
                  <c:v>0</c:v>
                </c:pt>
                <c:pt idx="171">
                  <c:v>0</c:v>
                </c:pt>
                <c:pt idx="172">
                  <c:v>0</c:v>
                </c:pt>
                <c:pt idx="173">
                  <c:v>0</c:v>
                </c:pt>
                <c:pt idx="174">
                  <c:v>0</c:v>
                </c:pt>
                <c:pt idx="175">
                  <c:v>0</c:v>
                </c:pt>
                <c:pt idx="176">
                  <c:v>0</c:v>
                </c:pt>
                <c:pt idx="177">
                  <c:v>0</c:v>
                </c:pt>
                <c:pt idx="178">
                  <c:v>0</c:v>
                </c:pt>
                <c:pt idx="179">
                  <c:v>0</c:v>
                </c:pt>
                <c:pt idx="180">
                  <c:v>0</c:v>
                </c:pt>
                <c:pt idx="181">
                  <c:v>0</c:v>
                </c:pt>
                <c:pt idx="182">
                  <c:v>0</c:v>
                </c:pt>
                <c:pt idx="183">
                  <c:v>0</c:v>
                </c:pt>
                <c:pt idx="184">
                  <c:v>0</c:v>
                </c:pt>
                <c:pt idx="185">
                  <c:v>0</c:v>
                </c:pt>
                <c:pt idx="186">
                  <c:v>0</c:v>
                </c:pt>
                <c:pt idx="187">
                  <c:v>0</c:v>
                </c:pt>
                <c:pt idx="188">
                  <c:v>0</c:v>
                </c:pt>
                <c:pt idx="189">
                  <c:v>0</c:v>
                </c:pt>
                <c:pt idx="190">
                  <c:v>0</c:v>
                </c:pt>
                <c:pt idx="191">
                  <c:v>0</c:v>
                </c:pt>
                <c:pt idx="192">
                  <c:v>0</c:v>
                </c:pt>
                <c:pt idx="193">
                  <c:v>0</c:v>
                </c:pt>
                <c:pt idx="194">
                  <c:v>0</c:v>
                </c:pt>
                <c:pt idx="195">
                  <c:v>0</c:v>
                </c:pt>
                <c:pt idx="196">
                  <c:v>0</c:v>
                </c:pt>
                <c:pt idx="197">
                  <c:v>0</c:v>
                </c:pt>
                <c:pt idx="198">
                  <c:v>0</c:v>
                </c:pt>
                <c:pt idx="199">
                  <c:v>0</c:v>
                </c:pt>
                <c:pt idx="200">
                  <c:v>0</c:v>
                </c:pt>
                <c:pt idx="201">
                  <c:v>0</c:v>
                </c:pt>
                <c:pt idx="202">
                  <c:v>0</c:v>
                </c:pt>
                <c:pt idx="203">
                  <c:v>0</c:v>
                </c:pt>
                <c:pt idx="204">
                  <c:v>0</c:v>
                </c:pt>
                <c:pt idx="205">
                  <c:v>0</c:v>
                </c:pt>
                <c:pt idx="206">
                  <c:v>0</c:v>
                </c:pt>
                <c:pt idx="207">
                  <c:v>0</c:v>
                </c:pt>
                <c:pt idx="208">
                  <c:v>0</c:v>
                </c:pt>
                <c:pt idx="209">
                  <c:v>0</c:v>
                </c:pt>
                <c:pt idx="210">
                  <c:v>0</c:v>
                </c:pt>
                <c:pt idx="211">
                  <c:v>0</c:v>
                </c:pt>
                <c:pt idx="212">
                  <c:v>0</c:v>
                </c:pt>
                <c:pt idx="213">
                  <c:v>0</c:v>
                </c:pt>
                <c:pt idx="214">
                  <c:v>0</c:v>
                </c:pt>
                <c:pt idx="215">
                  <c:v>0</c:v>
                </c:pt>
                <c:pt idx="216">
                  <c:v>0</c:v>
                </c:pt>
                <c:pt idx="217">
                  <c:v>0</c:v>
                </c:pt>
                <c:pt idx="218">
                  <c:v>0</c:v>
                </c:pt>
                <c:pt idx="219">
                  <c:v>0</c:v>
                </c:pt>
                <c:pt idx="220">
                  <c:v>0</c:v>
                </c:pt>
                <c:pt idx="221">
                  <c:v>0</c:v>
                </c:pt>
                <c:pt idx="222">
                  <c:v>0</c:v>
                </c:pt>
                <c:pt idx="223">
                  <c:v>0</c:v>
                </c:pt>
                <c:pt idx="224">
                  <c:v>0</c:v>
                </c:pt>
                <c:pt idx="225">
                  <c:v>0</c:v>
                </c:pt>
                <c:pt idx="226">
                  <c:v>0</c:v>
                </c:pt>
                <c:pt idx="227">
                  <c:v>0</c:v>
                </c:pt>
                <c:pt idx="228">
                  <c:v>0</c:v>
                </c:pt>
                <c:pt idx="229">
                  <c:v>0</c:v>
                </c:pt>
                <c:pt idx="230">
                  <c:v>0</c:v>
                </c:pt>
                <c:pt idx="231">
                  <c:v>0</c:v>
                </c:pt>
                <c:pt idx="232">
                  <c:v>0</c:v>
                </c:pt>
                <c:pt idx="233">
                  <c:v>0</c:v>
                </c:pt>
                <c:pt idx="234">
                  <c:v>0</c:v>
                </c:pt>
                <c:pt idx="235">
                  <c:v>0</c:v>
                </c:pt>
                <c:pt idx="236">
                  <c:v>0</c:v>
                </c:pt>
                <c:pt idx="237">
                  <c:v>0</c:v>
                </c:pt>
                <c:pt idx="238">
                  <c:v>0</c:v>
                </c:pt>
                <c:pt idx="239">
                  <c:v>0</c:v>
                </c:pt>
                <c:pt idx="240">
                  <c:v>0</c:v>
                </c:pt>
                <c:pt idx="241">
                  <c:v>0</c:v>
                </c:pt>
                <c:pt idx="242">
                  <c:v>0</c:v>
                </c:pt>
                <c:pt idx="243">
                  <c:v>0</c:v>
                </c:pt>
                <c:pt idx="244">
                  <c:v>0</c:v>
                </c:pt>
                <c:pt idx="245">
                  <c:v>0</c:v>
                </c:pt>
                <c:pt idx="246">
                  <c:v>0</c:v>
                </c:pt>
                <c:pt idx="247">
                  <c:v>0</c:v>
                </c:pt>
                <c:pt idx="248">
                  <c:v>0</c:v>
                </c:pt>
                <c:pt idx="249">
                  <c:v>0</c:v>
                </c:pt>
                <c:pt idx="250">
                  <c:v>0</c:v>
                </c:pt>
                <c:pt idx="251">
                  <c:v>0</c:v>
                </c:pt>
                <c:pt idx="252">
                  <c:v>0</c:v>
                </c:pt>
                <c:pt idx="253">
                  <c:v>0</c:v>
                </c:pt>
                <c:pt idx="254">
                  <c:v>0</c:v>
                </c:pt>
                <c:pt idx="255">
                  <c:v>0</c:v>
                </c:pt>
                <c:pt idx="256">
                  <c:v>0</c:v>
                </c:pt>
                <c:pt idx="257">
                  <c:v>0</c:v>
                </c:pt>
                <c:pt idx="258">
                  <c:v>0</c:v>
                </c:pt>
                <c:pt idx="259">
                  <c:v>0</c:v>
                </c:pt>
                <c:pt idx="260">
                  <c:v>0</c:v>
                </c:pt>
                <c:pt idx="261">
                  <c:v>0</c:v>
                </c:pt>
                <c:pt idx="262">
                  <c:v>0</c:v>
                </c:pt>
                <c:pt idx="263">
                  <c:v>0</c:v>
                </c:pt>
                <c:pt idx="264">
                  <c:v>0</c:v>
                </c:pt>
                <c:pt idx="265">
                  <c:v>0</c:v>
                </c:pt>
                <c:pt idx="266">
                  <c:v>0</c:v>
                </c:pt>
                <c:pt idx="267">
                  <c:v>0</c:v>
                </c:pt>
                <c:pt idx="268">
                  <c:v>0</c:v>
                </c:pt>
                <c:pt idx="269">
                  <c:v>0</c:v>
                </c:pt>
                <c:pt idx="270">
                  <c:v>0</c:v>
                </c:pt>
                <c:pt idx="271">
                  <c:v>0</c:v>
                </c:pt>
                <c:pt idx="272">
                  <c:v>0</c:v>
                </c:pt>
                <c:pt idx="273">
                  <c:v>0</c:v>
                </c:pt>
                <c:pt idx="274">
                  <c:v>0</c:v>
                </c:pt>
                <c:pt idx="275">
                  <c:v>0</c:v>
                </c:pt>
                <c:pt idx="276">
                  <c:v>0</c:v>
                </c:pt>
                <c:pt idx="277">
                  <c:v>0</c:v>
                </c:pt>
                <c:pt idx="278">
                  <c:v>0</c:v>
                </c:pt>
                <c:pt idx="279">
                  <c:v>0</c:v>
                </c:pt>
                <c:pt idx="280">
                  <c:v>0</c:v>
                </c:pt>
                <c:pt idx="281">
                  <c:v>0</c:v>
                </c:pt>
                <c:pt idx="282">
                  <c:v>0</c:v>
                </c:pt>
                <c:pt idx="283">
                  <c:v>0</c:v>
                </c:pt>
                <c:pt idx="284">
                  <c:v>0</c:v>
                </c:pt>
                <c:pt idx="285">
                  <c:v>0</c:v>
                </c:pt>
                <c:pt idx="286">
                  <c:v>0</c:v>
                </c:pt>
                <c:pt idx="287">
                  <c:v>0</c:v>
                </c:pt>
                <c:pt idx="288">
                  <c:v>0</c:v>
                </c:pt>
                <c:pt idx="289">
                  <c:v>0</c:v>
                </c:pt>
                <c:pt idx="290">
                  <c:v>0</c:v>
                </c:pt>
                <c:pt idx="291">
                  <c:v>0</c:v>
                </c:pt>
                <c:pt idx="292">
                  <c:v>0</c:v>
                </c:pt>
                <c:pt idx="293">
                  <c:v>0</c:v>
                </c:pt>
                <c:pt idx="294">
                  <c:v>0</c:v>
                </c:pt>
                <c:pt idx="295">
                  <c:v>0</c:v>
                </c:pt>
                <c:pt idx="296">
                  <c:v>0</c:v>
                </c:pt>
                <c:pt idx="297">
                  <c:v>0</c:v>
                </c:pt>
                <c:pt idx="298">
                  <c:v>0</c:v>
                </c:pt>
                <c:pt idx="299">
                  <c:v>0</c:v>
                </c:pt>
                <c:pt idx="300">
                  <c:v>0</c:v>
                </c:pt>
                <c:pt idx="301">
                  <c:v>0</c:v>
                </c:pt>
                <c:pt idx="302">
                  <c:v>0</c:v>
                </c:pt>
                <c:pt idx="303">
                  <c:v>0</c:v>
                </c:pt>
                <c:pt idx="304">
                  <c:v>0</c:v>
                </c:pt>
                <c:pt idx="305">
                  <c:v>0</c:v>
                </c:pt>
                <c:pt idx="306">
                  <c:v>0</c:v>
                </c:pt>
                <c:pt idx="307">
                  <c:v>0</c:v>
                </c:pt>
                <c:pt idx="308">
                  <c:v>0</c:v>
                </c:pt>
                <c:pt idx="309">
                  <c:v>0</c:v>
                </c:pt>
                <c:pt idx="310">
                  <c:v>0</c:v>
                </c:pt>
                <c:pt idx="311">
                  <c:v>0</c:v>
                </c:pt>
                <c:pt idx="312">
                  <c:v>0</c:v>
                </c:pt>
                <c:pt idx="313">
                  <c:v>0</c:v>
                </c:pt>
                <c:pt idx="314">
                  <c:v>0</c:v>
                </c:pt>
                <c:pt idx="315">
                  <c:v>0</c:v>
                </c:pt>
                <c:pt idx="316">
                  <c:v>0</c:v>
                </c:pt>
                <c:pt idx="317">
                  <c:v>0</c:v>
                </c:pt>
                <c:pt idx="318">
                  <c:v>0</c:v>
                </c:pt>
                <c:pt idx="319">
                  <c:v>0</c:v>
                </c:pt>
                <c:pt idx="320">
                  <c:v>0</c:v>
                </c:pt>
                <c:pt idx="321">
                  <c:v>0</c:v>
                </c:pt>
                <c:pt idx="322">
                  <c:v>0</c:v>
                </c:pt>
                <c:pt idx="323">
                  <c:v>0</c:v>
                </c:pt>
                <c:pt idx="324">
                  <c:v>0</c:v>
                </c:pt>
                <c:pt idx="325">
                  <c:v>0</c:v>
                </c:pt>
                <c:pt idx="326">
                  <c:v>0</c:v>
                </c:pt>
                <c:pt idx="327">
                  <c:v>0</c:v>
                </c:pt>
                <c:pt idx="328">
                  <c:v>0</c:v>
                </c:pt>
                <c:pt idx="329">
                  <c:v>0</c:v>
                </c:pt>
                <c:pt idx="330">
                  <c:v>0</c:v>
                </c:pt>
                <c:pt idx="331">
                  <c:v>0</c:v>
                </c:pt>
                <c:pt idx="332">
                  <c:v>0</c:v>
                </c:pt>
                <c:pt idx="333">
                  <c:v>0</c:v>
                </c:pt>
                <c:pt idx="334">
                  <c:v>0</c:v>
                </c:pt>
                <c:pt idx="335">
                  <c:v>0</c:v>
                </c:pt>
                <c:pt idx="336">
                  <c:v>0</c:v>
                </c:pt>
                <c:pt idx="337">
                  <c:v>0</c:v>
                </c:pt>
                <c:pt idx="338">
                  <c:v>0</c:v>
                </c:pt>
                <c:pt idx="339">
                  <c:v>0</c:v>
                </c:pt>
                <c:pt idx="340">
                  <c:v>0</c:v>
                </c:pt>
                <c:pt idx="341">
                  <c:v>0</c:v>
                </c:pt>
                <c:pt idx="342">
                  <c:v>0</c:v>
                </c:pt>
                <c:pt idx="343">
                  <c:v>0</c:v>
                </c:pt>
                <c:pt idx="344">
                  <c:v>0</c:v>
                </c:pt>
                <c:pt idx="345">
                  <c:v>0</c:v>
                </c:pt>
                <c:pt idx="346">
                  <c:v>0</c:v>
                </c:pt>
                <c:pt idx="347">
                  <c:v>0</c:v>
                </c:pt>
                <c:pt idx="348">
                  <c:v>0</c:v>
                </c:pt>
                <c:pt idx="349">
                  <c:v>0</c:v>
                </c:pt>
                <c:pt idx="350">
                  <c:v>0</c:v>
                </c:pt>
                <c:pt idx="351">
                  <c:v>0</c:v>
                </c:pt>
                <c:pt idx="352">
                  <c:v>0</c:v>
                </c:pt>
                <c:pt idx="353">
                  <c:v>0</c:v>
                </c:pt>
                <c:pt idx="354">
                  <c:v>0</c:v>
                </c:pt>
                <c:pt idx="355">
                  <c:v>0</c:v>
                </c:pt>
                <c:pt idx="356">
                  <c:v>0</c:v>
                </c:pt>
                <c:pt idx="357">
                  <c:v>0</c:v>
                </c:pt>
                <c:pt idx="358">
                  <c:v>0</c:v>
                </c:pt>
                <c:pt idx="359">
                  <c:v>0</c:v>
                </c:pt>
                <c:pt idx="360">
                  <c:v>0</c:v>
                </c:pt>
                <c:pt idx="361">
                  <c:v>0</c:v>
                </c:pt>
                <c:pt idx="362">
                  <c:v>0</c:v>
                </c:pt>
                <c:pt idx="363">
                  <c:v>0</c:v>
                </c:pt>
                <c:pt idx="364">
                  <c:v>0</c:v>
                </c:pt>
                <c:pt idx="365">
                  <c:v>0</c:v>
                </c:pt>
                <c:pt idx="366">
                  <c:v>0</c:v>
                </c:pt>
                <c:pt idx="367">
                  <c:v>0</c:v>
                </c:pt>
                <c:pt idx="368">
                  <c:v>0</c:v>
                </c:pt>
                <c:pt idx="369">
                  <c:v>0</c:v>
                </c:pt>
                <c:pt idx="370">
                  <c:v>0</c:v>
                </c:pt>
                <c:pt idx="371">
                  <c:v>0</c:v>
                </c:pt>
                <c:pt idx="372">
                  <c:v>0</c:v>
                </c:pt>
                <c:pt idx="373">
                  <c:v>0</c:v>
                </c:pt>
                <c:pt idx="374">
                  <c:v>0</c:v>
                </c:pt>
                <c:pt idx="375">
                  <c:v>0</c:v>
                </c:pt>
                <c:pt idx="376">
                  <c:v>0</c:v>
                </c:pt>
                <c:pt idx="377">
                  <c:v>0</c:v>
                </c:pt>
                <c:pt idx="378">
                  <c:v>0</c:v>
                </c:pt>
                <c:pt idx="379">
                  <c:v>0</c:v>
                </c:pt>
                <c:pt idx="380">
                  <c:v>0</c:v>
                </c:pt>
                <c:pt idx="381">
                  <c:v>0</c:v>
                </c:pt>
                <c:pt idx="382">
                  <c:v>0</c:v>
                </c:pt>
                <c:pt idx="383">
                  <c:v>0</c:v>
                </c:pt>
                <c:pt idx="384">
                  <c:v>0</c:v>
                </c:pt>
                <c:pt idx="385">
                  <c:v>0</c:v>
                </c:pt>
                <c:pt idx="386">
                  <c:v>0</c:v>
                </c:pt>
                <c:pt idx="387">
                  <c:v>0</c:v>
                </c:pt>
                <c:pt idx="388">
                  <c:v>0</c:v>
                </c:pt>
                <c:pt idx="389">
                  <c:v>0</c:v>
                </c:pt>
                <c:pt idx="390">
                  <c:v>0</c:v>
                </c:pt>
                <c:pt idx="391">
                  <c:v>0</c:v>
                </c:pt>
                <c:pt idx="392">
                  <c:v>0</c:v>
                </c:pt>
                <c:pt idx="393">
                  <c:v>0</c:v>
                </c:pt>
                <c:pt idx="394">
                  <c:v>0</c:v>
                </c:pt>
                <c:pt idx="395">
                  <c:v>0</c:v>
                </c:pt>
                <c:pt idx="396">
                  <c:v>0</c:v>
                </c:pt>
                <c:pt idx="397">
                  <c:v>0</c:v>
                </c:pt>
                <c:pt idx="398">
                  <c:v>0</c:v>
                </c:pt>
                <c:pt idx="399">
                  <c:v>0</c:v>
                </c:pt>
                <c:pt idx="400">
                  <c:v>0</c:v>
                </c:pt>
                <c:pt idx="401">
                  <c:v>0</c:v>
                </c:pt>
                <c:pt idx="402">
                  <c:v>0</c:v>
                </c:pt>
                <c:pt idx="403">
                  <c:v>0</c:v>
                </c:pt>
                <c:pt idx="404">
                  <c:v>0</c:v>
                </c:pt>
                <c:pt idx="405">
                  <c:v>0</c:v>
                </c:pt>
                <c:pt idx="406">
                  <c:v>0</c:v>
                </c:pt>
                <c:pt idx="407">
                  <c:v>0</c:v>
                </c:pt>
                <c:pt idx="408">
                  <c:v>0</c:v>
                </c:pt>
                <c:pt idx="409">
                  <c:v>0</c:v>
                </c:pt>
                <c:pt idx="410">
                  <c:v>0</c:v>
                </c:pt>
                <c:pt idx="411">
                  <c:v>0</c:v>
                </c:pt>
                <c:pt idx="412">
                  <c:v>0</c:v>
                </c:pt>
                <c:pt idx="413">
                  <c:v>0</c:v>
                </c:pt>
                <c:pt idx="414">
                  <c:v>0</c:v>
                </c:pt>
                <c:pt idx="415">
                  <c:v>0</c:v>
                </c:pt>
                <c:pt idx="416">
                  <c:v>0</c:v>
                </c:pt>
                <c:pt idx="417">
                  <c:v>0</c:v>
                </c:pt>
                <c:pt idx="418">
                  <c:v>0</c:v>
                </c:pt>
                <c:pt idx="419">
                  <c:v>0</c:v>
                </c:pt>
                <c:pt idx="420">
                  <c:v>0</c:v>
                </c:pt>
                <c:pt idx="421">
                  <c:v>0</c:v>
                </c:pt>
                <c:pt idx="422">
                  <c:v>0</c:v>
                </c:pt>
                <c:pt idx="423">
                  <c:v>0</c:v>
                </c:pt>
                <c:pt idx="424">
                  <c:v>0</c:v>
                </c:pt>
                <c:pt idx="425">
                  <c:v>0</c:v>
                </c:pt>
                <c:pt idx="426">
                  <c:v>0</c:v>
                </c:pt>
                <c:pt idx="427">
                  <c:v>0</c:v>
                </c:pt>
                <c:pt idx="428">
                  <c:v>0</c:v>
                </c:pt>
                <c:pt idx="429">
                  <c:v>0</c:v>
                </c:pt>
                <c:pt idx="430">
                  <c:v>0</c:v>
                </c:pt>
                <c:pt idx="431">
                  <c:v>0</c:v>
                </c:pt>
                <c:pt idx="432">
                  <c:v>0</c:v>
                </c:pt>
                <c:pt idx="433">
                  <c:v>0</c:v>
                </c:pt>
                <c:pt idx="434">
                  <c:v>0</c:v>
                </c:pt>
                <c:pt idx="435">
                  <c:v>0</c:v>
                </c:pt>
                <c:pt idx="436">
                  <c:v>0</c:v>
                </c:pt>
                <c:pt idx="437">
                  <c:v>0</c:v>
                </c:pt>
                <c:pt idx="438">
                  <c:v>0</c:v>
                </c:pt>
                <c:pt idx="439">
                  <c:v>0</c:v>
                </c:pt>
                <c:pt idx="440">
                  <c:v>0</c:v>
                </c:pt>
                <c:pt idx="441">
                  <c:v>0</c:v>
                </c:pt>
                <c:pt idx="442">
                  <c:v>0</c:v>
                </c:pt>
                <c:pt idx="443">
                  <c:v>0</c:v>
                </c:pt>
                <c:pt idx="444">
                  <c:v>0</c:v>
                </c:pt>
                <c:pt idx="445">
                  <c:v>0</c:v>
                </c:pt>
                <c:pt idx="446">
                  <c:v>0</c:v>
                </c:pt>
                <c:pt idx="447">
                  <c:v>0</c:v>
                </c:pt>
                <c:pt idx="448">
                  <c:v>0</c:v>
                </c:pt>
                <c:pt idx="449">
                  <c:v>0</c:v>
                </c:pt>
                <c:pt idx="450">
                  <c:v>0</c:v>
                </c:pt>
                <c:pt idx="451">
                  <c:v>0</c:v>
                </c:pt>
                <c:pt idx="452">
                  <c:v>0</c:v>
                </c:pt>
                <c:pt idx="453">
                  <c:v>0</c:v>
                </c:pt>
                <c:pt idx="454">
                  <c:v>0</c:v>
                </c:pt>
                <c:pt idx="455">
                  <c:v>0</c:v>
                </c:pt>
                <c:pt idx="456">
                  <c:v>0</c:v>
                </c:pt>
                <c:pt idx="457">
                  <c:v>0</c:v>
                </c:pt>
                <c:pt idx="458">
                  <c:v>0</c:v>
                </c:pt>
                <c:pt idx="459">
                  <c:v>0</c:v>
                </c:pt>
                <c:pt idx="460">
                  <c:v>0</c:v>
                </c:pt>
                <c:pt idx="461">
                  <c:v>0</c:v>
                </c:pt>
                <c:pt idx="462">
                  <c:v>0</c:v>
                </c:pt>
                <c:pt idx="463">
                  <c:v>0</c:v>
                </c:pt>
                <c:pt idx="464">
                  <c:v>0</c:v>
                </c:pt>
                <c:pt idx="465">
                  <c:v>0</c:v>
                </c:pt>
                <c:pt idx="466">
                  <c:v>0</c:v>
                </c:pt>
                <c:pt idx="467">
                  <c:v>0</c:v>
                </c:pt>
                <c:pt idx="468">
                  <c:v>0</c:v>
                </c:pt>
                <c:pt idx="469">
                  <c:v>0</c:v>
                </c:pt>
                <c:pt idx="470">
                  <c:v>0</c:v>
                </c:pt>
                <c:pt idx="471">
                  <c:v>0</c:v>
                </c:pt>
                <c:pt idx="472">
                  <c:v>0</c:v>
                </c:pt>
                <c:pt idx="473">
                  <c:v>0</c:v>
                </c:pt>
                <c:pt idx="474">
                  <c:v>0</c:v>
                </c:pt>
                <c:pt idx="475">
                  <c:v>0</c:v>
                </c:pt>
                <c:pt idx="476">
                  <c:v>0</c:v>
                </c:pt>
                <c:pt idx="477">
                  <c:v>0</c:v>
                </c:pt>
                <c:pt idx="478">
                  <c:v>0</c:v>
                </c:pt>
                <c:pt idx="479">
                  <c:v>0</c:v>
                </c:pt>
                <c:pt idx="480">
                  <c:v>0</c:v>
                </c:pt>
                <c:pt idx="481">
                  <c:v>0</c:v>
                </c:pt>
                <c:pt idx="482">
                  <c:v>0</c:v>
                </c:pt>
                <c:pt idx="483">
                  <c:v>0</c:v>
                </c:pt>
                <c:pt idx="484">
                  <c:v>0</c:v>
                </c:pt>
                <c:pt idx="485">
                  <c:v>0</c:v>
                </c:pt>
                <c:pt idx="486">
                  <c:v>0</c:v>
                </c:pt>
                <c:pt idx="487">
                  <c:v>0</c:v>
                </c:pt>
                <c:pt idx="488">
                  <c:v>0</c:v>
                </c:pt>
                <c:pt idx="489">
                  <c:v>0</c:v>
                </c:pt>
                <c:pt idx="490">
                  <c:v>0</c:v>
                </c:pt>
                <c:pt idx="491">
                  <c:v>0</c:v>
                </c:pt>
                <c:pt idx="492">
                  <c:v>0</c:v>
                </c:pt>
                <c:pt idx="493">
                  <c:v>0</c:v>
                </c:pt>
                <c:pt idx="494">
                  <c:v>0</c:v>
                </c:pt>
                <c:pt idx="495">
                  <c:v>0</c:v>
                </c:pt>
                <c:pt idx="496">
                  <c:v>0</c:v>
                </c:pt>
                <c:pt idx="497">
                  <c:v>0</c:v>
                </c:pt>
                <c:pt idx="498">
                  <c:v>0</c:v>
                </c:pt>
                <c:pt idx="499">
                  <c:v>0</c:v>
                </c:pt>
                <c:pt idx="500">
                  <c:v>0</c:v>
                </c:pt>
                <c:pt idx="501">
                  <c:v>0</c:v>
                </c:pt>
                <c:pt idx="502">
                  <c:v>0</c:v>
                </c:pt>
                <c:pt idx="503">
                  <c:v>0</c:v>
                </c:pt>
                <c:pt idx="504">
                  <c:v>0</c:v>
                </c:pt>
                <c:pt idx="505">
                  <c:v>0</c:v>
                </c:pt>
                <c:pt idx="506">
                  <c:v>0</c:v>
                </c:pt>
                <c:pt idx="507">
                  <c:v>0</c:v>
                </c:pt>
                <c:pt idx="508">
                  <c:v>0</c:v>
                </c:pt>
                <c:pt idx="509">
                  <c:v>0</c:v>
                </c:pt>
                <c:pt idx="510">
                  <c:v>0</c:v>
                </c:pt>
                <c:pt idx="511">
                  <c:v>0</c:v>
                </c:pt>
                <c:pt idx="512">
                  <c:v>0</c:v>
                </c:pt>
                <c:pt idx="513">
                  <c:v>0</c:v>
                </c:pt>
                <c:pt idx="514">
                  <c:v>0</c:v>
                </c:pt>
                <c:pt idx="515">
                  <c:v>0</c:v>
                </c:pt>
                <c:pt idx="516">
                  <c:v>0</c:v>
                </c:pt>
                <c:pt idx="517">
                  <c:v>0</c:v>
                </c:pt>
                <c:pt idx="518">
                  <c:v>0</c:v>
                </c:pt>
                <c:pt idx="519">
                  <c:v>0</c:v>
                </c:pt>
                <c:pt idx="520">
                  <c:v>0</c:v>
                </c:pt>
                <c:pt idx="521">
                  <c:v>0</c:v>
                </c:pt>
                <c:pt idx="522">
                  <c:v>0</c:v>
                </c:pt>
                <c:pt idx="523">
                  <c:v>0</c:v>
                </c:pt>
                <c:pt idx="524">
                  <c:v>0</c:v>
                </c:pt>
                <c:pt idx="525">
                  <c:v>0</c:v>
                </c:pt>
                <c:pt idx="526">
                  <c:v>0</c:v>
                </c:pt>
                <c:pt idx="527">
                  <c:v>0</c:v>
                </c:pt>
                <c:pt idx="528">
                  <c:v>0</c:v>
                </c:pt>
                <c:pt idx="529">
                  <c:v>0</c:v>
                </c:pt>
                <c:pt idx="530">
                  <c:v>0</c:v>
                </c:pt>
                <c:pt idx="531">
                  <c:v>0</c:v>
                </c:pt>
                <c:pt idx="532">
                  <c:v>0</c:v>
                </c:pt>
                <c:pt idx="533">
                  <c:v>0</c:v>
                </c:pt>
                <c:pt idx="534">
                  <c:v>0</c:v>
                </c:pt>
                <c:pt idx="535">
                  <c:v>0</c:v>
                </c:pt>
                <c:pt idx="536">
                  <c:v>0</c:v>
                </c:pt>
                <c:pt idx="537">
                  <c:v>0</c:v>
                </c:pt>
                <c:pt idx="538">
                  <c:v>0</c:v>
                </c:pt>
                <c:pt idx="539">
                  <c:v>0</c:v>
                </c:pt>
                <c:pt idx="540">
                  <c:v>0</c:v>
                </c:pt>
                <c:pt idx="541">
                  <c:v>0</c:v>
                </c:pt>
                <c:pt idx="542">
                  <c:v>0</c:v>
                </c:pt>
                <c:pt idx="543">
                  <c:v>0</c:v>
                </c:pt>
                <c:pt idx="544">
                  <c:v>0</c:v>
                </c:pt>
                <c:pt idx="545">
                  <c:v>0</c:v>
                </c:pt>
                <c:pt idx="546">
                  <c:v>0</c:v>
                </c:pt>
                <c:pt idx="547">
                  <c:v>0</c:v>
                </c:pt>
                <c:pt idx="548">
                  <c:v>0</c:v>
                </c:pt>
                <c:pt idx="549">
                  <c:v>0</c:v>
                </c:pt>
                <c:pt idx="550">
                  <c:v>0</c:v>
                </c:pt>
                <c:pt idx="551">
                  <c:v>0</c:v>
                </c:pt>
                <c:pt idx="552">
                  <c:v>0</c:v>
                </c:pt>
                <c:pt idx="553">
                  <c:v>0</c:v>
                </c:pt>
                <c:pt idx="554">
                  <c:v>0</c:v>
                </c:pt>
                <c:pt idx="555">
                  <c:v>0</c:v>
                </c:pt>
                <c:pt idx="556">
                  <c:v>0</c:v>
                </c:pt>
                <c:pt idx="557">
                  <c:v>0</c:v>
                </c:pt>
                <c:pt idx="558">
                  <c:v>0</c:v>
                </c:pt>
                <c:pt idx="559">
                  <c:v>0</c:v>
                </c:pt>
                <c:pt idx="560">
                  <c:v>0</c:v>
                </c:pt>
                <c:pt idx="561">
                  <c:v>0</c:v>
                </c:pt>
                <c:pt idx="562">
                  <c:v>0</c:v>
                </c:pt>
                <c:pt idx="563">
                  <c:v>0</c:v>
                </c:pt>
                <c:pt idx="564">
                  <c:v>0</c:v>
                </c:pt>
                <c:pt idx="565">
                  <c:v>0</c:v>
                </c:pt>
                <c:pt idx="566">
                  <c:v>0</c:v>
                </c:pt>
                <c:pt idx="567">
                  <c:v>0</c:v>
                </c:pt>
                <c:pt idx="568">
                  <c:v>0</c:v>
                </c:pt>
                <c:pt idx="569">
                  <c:v>0</c:v>
                </c:pt>
                <c:pt idx="570">
                  <c:v>0</c:v>
                </c:pt>
                <c:pt idx="571">
                  <c:v>0</c:v>
                </c:pt>
                <c:pt idx="572">
                  <c:v>0</c:v>
                </c:pt>
                <c:pt idx="573">
                  <c:v>0</c:v>
                </c:pt>
                <c:pt idx="574">
                  <c:v>0</c:v>
                </c:pt>
                <c:pt idx="575">
                  <c:v>0</c:v>
                </c:pt>
                <c:pt idx="576">
                  <c:v>0</c:v>
                </c:pt>
                <c:pt idx="577">
                  <c:v>0</c:v>
                </c:pt>
                <c:pt idx="578">
                  <c:v>0</c:v>
                </c:pt>
                <c:pt idx="579">
                  <c:v>0</c:v>
                </c:pt>
                <c:pt idx="580">
                  <c:v>0</c:v>
                </c:pt>
                <c:pt idx="581">
                  <c:v>0</c:v>
                </c:pt>
                <c:pt idx="582">
                  <c:v>0</c:v>
                </c:pt>
                <c:pt idx="583">
                  <c:v>0</c:v>
                </c:pt>
                <c:pt idx="584">
                  <c:v>0</c:v>
                </c:pt>
                <c:pt idx="585">
                  <c:v>0</c:v>
                </c:pt>
                <c:pt idx="586">
                  <c:v>0</c:v>
                </c:pt>
                <c:pt idx="587">
                  <c:v>0</c:v>
                </c:pt>
                <c:pt idx="588">
                  <c:v>0</c:v>
                </c:pt>
                <c:pt idx="589">
                  <c:v>0</c:v>
                </c:pt>
                <c:pt idx="590">
                  <c:v>0</c:v>
                </c:pt>
                <c:pt idx="591">
                  <c:v>0</c:v>
                </c:pt>
                <c:pt idx="592">
                  <c:v>0</c:v>
                </c:pt>
                <c:pt idx="593">
                  <c:v>0</c:v>
                </c:pt>
                <c:pt idx="594">
                  <c:v>0</c:v>
                </c:pt>
                <c:pt idx="595">
                  <c:v>0</c:v>
                </c:pt>
                <c:pt idx="596">
                  <c:v>0</c:v>
                </c:pt>
                <c:pt idx="597">
                  <c:v>0</c:v>
                </c:pt>
                <c:pt idx="598">
                  <c:v>0</c:v>
                </c:pt>
                <c:pt idx="599">
                  <c:v>0</c:v>
                </c:pt>
                <c:pt idx="600">
                  <c:v>0</c:v>
                </c:pt>
                <c:pt idx="601">
                  <c:v>0</c:v>
                </c:pt>
                <c:pt idx="602">
                  <c:v>0</c:v>
                </c:pt>
                <c:pt idx="603">
                  <c:v>0</c:v>
                </c:pt>
                <c:pt idx="604">
                  <c:v>0</c:v>
                </c:pt>
                <c:pt idx="605">
                  <c:v>0</c:v>
                </c:pt>
                <c:pt idx="606">
                  <c:v>0</c:v>
                </c:pt>
                <c:pt idx="607">
                  <c:v>0</c:v>
                </c:pt>
                <c:pt idx="608">
                  <c:v>0</c:v>
                </c:pt>
                <c:pt idx="609">
                  <c:v>0</c:v>
                </c:pt>
                <c:pt idx="610">
                  <c:v>0</c:v>
                </c:pt>
                <c:pt idx="611">
                  <c:v>0</c:v>
                </c:pt>
                <c:pt idx="612">
                  <c:v>0</c:v>
                </c:pt>
                <c:pt idx="613">
                  <c:v>0</c:v>
                </c:pt>
                <c:pt idx="614">
                  <c:v>0</c:v>
                </c:pt>
                <c:pt idx="615">
                  <c:v>0</c:v>
                </c:pt>
                <c:pt idx="616">
                  <c:v>0</c:v>
                </c:pt>
                <c:pt idx="617">
                  <c:v>0</c:v>
                </c:pt>
                <c:pt idx="618">
                  <c:v>0</c:v>
                </c:pt>
                <c:pt idx="619">
                  <c:v>0</c:v>
                </c:pt>
                <c:pt idx="620">
                  <c:v>0</c:v>
                </c:pt>
                <c:pt idx="621">
                  <c:v>0</c:v>
                </c:pt>
                <c:pt idx="622">
                  <c:v>0</c:v>
                </c:pt>
                <c:pt idx="623">
                  <c:v>0</c:v>
                </c:pt>
                <c:pt idx="624">
                  <c:v>0</c:v>
                </c:pt>
                <c:pt idx="625">
                  <c:v>0</c:v>
                </c:pt>
                <c:pt idx="626">
                  <c:v>0</c:v>
                </c:pt>
                <c:pt idx="627">
                  <c:v>0</c:v>
                </c:pt>
                <c:pt idx="628">
                  <c:v>0</c:v>
                </c:pt>
                <c:pt idx="629">
                  <c:v>0</c:v>
                </c:pt>
                <c:pt idx="630">
                  <c:v>0</c:v>
                </c:pt>
                <c:pt idx="631">
                  <c:v>0</c:v>
                </c:pt>
                <c:pt idx="632">
                  <c:v>0</c:v>
                </c:pt>
                <c:pt idx="633">
                  <c:v>0</c:v>
                </c:pt>
                <c:pt idx="634">
                  <c:v>0</c:v>
                </c:pt>
                <c:pt idx="635">
                  <c:v>0</c:v>
                </c:pt>
                <c:pt idx="636">
                  <c:v>0</c:v>
                </c:pt>
                <c:pt idx="637">
                  <c:v>0</c:v>
                </c:pt>
                <c:pt idx="638">
                  <c:v>0</c:v>
                </c:pt>
                <c:pt idx="639">
                  <c:v>0</c:v>
                </c:pt>
                <c:pt idx="640">
                  <c:v>0</c:v>
                </c:pt>
                <c:pt idx="641">
                  <c:v>0</c:v>
                </c:pt>
                <c:pt idx="642">
                  <c:v>0</c:v>
                </c:pt>
                <c:pt idx="643">
                  <c:v>0</c:v>
                </c:pt>
                <c:pt idx="644">
                  <c:v>0</c:v>
                </c:pt>
                <c:pt idx="645">
                  <c:v>0</c:v>
                </c:pt>
                <c:pt idx="646">
                  <c:v>0</c:v>
                </c:pt>
                <c:pt idx="647">
                  <c:v>0</c:v>
                </c:pt>
                <c:pt idx="648">
                  <c:v>0</c:v>
                </c:pt>
                <c:pt idx="649">
                  <c:v>0</c:v>
                </c:pt>
                <c:pt idx="650">
                  <c:v>0</c:v>
                </c:pt>
                <c:pt idx="651">
                  <c:v>0</c:v>
                </c:pt>
                <c:pt idx="652">
                  <c:v>0</c:v>
                </c:pt>
                <c:pt idx="653">
                  <c:v>0</c:v>
                </c:pt>
                <c:pt idx="654">
                  <c:v>0</c:v>
                </c:pt>
                <c:pt idx="655">
                  <c:v>0</c:v>
                </c:pt>
                <c:pt idx="656">
                  <c:v>0</c:v>
                </c:pt>
                <c:pt idx="657">
                  <c:v>0</c:v>
                </c:pt>
                <c:pt idx="658">
                  <c:v>0</c:v>
                </c:pt>
                <c:pt idx="659">
                  <c:v>0</c:v>
                </c:pt>
                <c:pt idx="660">
                  <c:v>0</c:v>
                </c:pt>
                <c:pt idx="661">
                  <c:v>0</c:v>
                </c:pt>
                <c:pt idx="662">
                  <c:v>0</c:v>
                </c:pt>
                <c:pt idx="663">
                  <c:v>0</c:v>
                </c:pt>
                <c:pt idx="664">
                  <c:v>0</c:v>
                </c:pt>
                <c:pt idx="665">
                  <c:v>0</c:v>
                </c:pt>
                <c:pt idx="666">
                  <c:v>0</c:v>
                </c:pt>
                <c:pt idx="667">
                  <c:v>0</c:v>
                </c:pt>
                <c:pt idx="668">
                  <c:v>0</c:v>
                </c:pt>
                <c:pt idx="669">
                  <c:v>0</c:v>
                </c:pt>
                <c:pt idx="670">
                  <c:v>0</c:v>
                </c:pt>
                <c:pt idx="671">
                  <c:v>0</c:v>
                </c:pt>
                <c:pt idx="672">
                  <c:v>0</c:v>
                </c:pt>
                <c:pt idx="673">
                  <c:v>0</c:v>
                </c:pt>
                <c:pt idx="674">
                  <c:v>0</c:v>
                </c:pt>
                <c:pt idx="675">
                  <c:v>0</c:v>
                </c:pt>
                <c:pt idx="676">
                  <c:v>0</c:v>
                </c:pt>
                <c:pt idx="677">
                  <c:v>0</c:v>
                </c:pt>
                <c:pt idx="678">
                  <c:v>0</c:v>
                </c:pt>
                <c:pt idx="679">
                  <c:v>0</c:v>
                </c:pt>
                <c:pt idx="680">
                  <c:v>0</c:v>
                </c:pt>
                <c:pt idx="681">
                  <c:v>0</c:v>
                </c:pt>
                <c:pt idx="682">
                  <c:v>0</c:v>
                </c:pt>
                <c:pt idx="683">
                  <c:v>0</c:v>
                </c:pt>
                <c:pt idx="684">
                  <c:v>0</c:v>
                </c:pt>
                <c:pt idx="685">
                  <c:v>0</c:v>
                </c:pt>
                <c:pt idx="686">
                  <c:v>0</c:v>
                </c:pt>
                <c:pt idx="687">
                  <c:v>0</c:v>
                </c:pt>
                <c:pt idx="688">
                  <c:v>0</c:v>
                </c:pt>
                <c:pt idx="689">
                  <c:v>0</c:v>
                </c:pt>
                <c:pt idx="690">
                  <c:v>0</c:v>
                </c:pt>
                <c:pt idx="691">
                  <c:v>0</c:v>
                </c:pt>
                <c:pt idx="692">
                  <c:v>0</c:v>
                </c:pt>
                <c:pt idx="693">
                  <c:v>0</c:v>
                </c:pt>
                <c:pt idx="694">
                  <c:v>0</c:v>
                </c:pt>
                <c:pt idx="695">
                  <c:v>0</c:v>
                </c:pt>
                <c:pt idx="696">
                  <c:v>0</c:v>
                </c:pt>
                <c:pt idx="697">
                  <c:v>0</c:v>
                </c:pt>
                <c:pt idx="698">
                  <c:v>0</c:v>
                </c:pt>
                <c:pt idx="699">
                  <c:v>0</c:v>
                </c:pt>
                <c:pt idx="700">
                  <c:v>0</c:v>
                </c:pt>
                <c:pt idx="701">
                  <c:v>0</c:v>
                </c:pt>
                <c:pt idx="702">
                  <c:v>0</c:v>
                </c:pt>
                <c:pt idx="703">
                  <c:v>0</c:v>
                </c:pt>
                <c:pt idx="704">
                  <c:v>0</c:v>
                </c:pt>
                <c:pt idx="705">
                  <c:v>0</c:v>
                </c:pt>
                <c:pt idx="706">
                  <c:v>0</c:v>
                </c:pt>
                <c:pt idx="707">
                  <c:v>0</c:v>
                </c:pt>
                <c:pt idx="708">
                  <c:v>0</c:v>
                </c:pt>
                <c:pt idx="709">
                  <c:v>0</c:v>
                </c:pt>
                <c:pt idx="710">
                  <c:v>0</c:v>
                </c:pt>
                <c:pt idx="711">
                  <c:v>0</c:v>
                </c:pt>
                <c:pt idx="712">
                  <c:v>0</c:v>
                </c:pt>
                <c:pt idx="713">
                  <c:v>0</c:v>
                </c:pt>
                <c:pt idx="714">
                  <c:v>0</c:v>
                </c:pt>
                <c:pt idx="715">
                  <c:v>0</c:v>
                </c:pt>
                <c:pt idx="716">
                  <c:v>0</c:v>
                </c:pt>
                <c:pt idx="717">
                  <c:v>0</c:v>
                </c:pt>
                <c:pt idx="718">
                  <c:v>0</c:v>
                </c:pt>
                <c:pt idx="719">
                  <c:v>0</c:v>
                </c:pt>
                <c:pt idx="720">
                  <c:v>0</c:v>
                </c:pt>
                <c:pt idx="721">
                  <c:v>0</c:v>
                </c:pt>
                <c:pt idx="722">
                  <c:v>0</c:v>
                </c:pt>
                <c:pt idx="723">
                  <c:v>0</c:v>
                </c:pt>
                <c:pt idx="724">
                  <c:v>0</c:v>
                </c:pt>
                <c:pt idx="725">
                  <c:v>0</c:v>
                </c:pt>
                <c:pt idx="726">
                  <c:v>0</c:v>
                </c:pt>
                <c:pt idx="727">
                  <c:v>0</c:v>
                </c:pt>
                <c:pt idx="728">
                  <c:v>0</c:v>
                </c:pt>
                <c:pt idx="729">
                  <c:v>0</c:v>
                </c:pt>
                <c:pt idx="730">
                  <c:v>0</c:v>
                </c:pt>
                <c:pt idx="731">
                  <c:v>0</c:v>
                </c:pt>
                <c:pt idx="732">
                  <c:v>0</c:v>
                </c:pt>
                <c:pt idx="733">
                  <c:v>0</c:v>
                </c:pt>
                <c:pt idx="734">
                  <c:v>0</c:v>
                </c:pt>
                <c:pt idx="735">
                  <c:v>0</c:v>
                </c:pt>
                <c:pt idx="736">
                  <c:v>0</c:v>
                </c:pt>
                <c:pt idx="737">
                  <c:v>0</c:v>
                </c:pt>
                <c:pt idx="738">
                  <c:v>0</c:v>
                </c:pt>
                <c:pt idx="739">
                  <c:v>0</c:v>
                </c:pt>
                <c:pt idx="740">
                  <c:v>0</c:v>
                </c:pt>
                <c:pt idx="741">
                  <c:v>0</c:v>
                </c:pt>
                <c:pt idx="742">
                  <c:v>0</c:v>
                </c:pt>
                <c:pt idx="743">
                  <c:v>0</c:v>
                </c:pt>
                <c:pt idx="744">
                  <c:v>0</c:v>
                </c:pt>
                <c:pt idx="745">
                  <c:v>0</c:v>
                </c:pt>
                <c:pt idx="746">
                  <c:v>0</c:v>
                </c:pt>
                <c:pt idx="747">
                  <c:v>0</c:v>
                </c:pt>
                <c:pt idx="748">
                  <c:v>0</c:v>
                </c:pt>
                <c:pt idx="749">
                  <c:v>0</c:v>
                </c:pt>
                <c:pt idx="750">
                  <c:v>0</c:v>
                </c:pt>
                <c:pt idx="751">
                  <c:v>0</c:v>
                </c:pt>
                <c:pt idx="752">
                  <c:v>0</c:v>
                </c:pt>
                <c:pt idx="753">
                  <c:v>0</c:v>
                </c:pt>
                <c:pt idx="754">
                  <c:v>0</c:v>
                </c:pt>
                <c:pt idx="755">
                  <c:v>0</c:v>
                </c:pt>
                <c:pt idx="756">
                  <c:v>0</c:v>
                </c:pt>
                <c:pt idx="757">
                  <c:v>0</c:v>
                </c:pt>
                <c:pt idx="758">
                  <c:v>0</c:v>
                </c:pt>
                <c:pt idx="759">
                  <c:v>0</c:v>
                </c:pt>
                <c:pt idx="760">
                  <c:v>0</c:v>
                </c:pt>
                <c:pt idx="761">
                  <c:v>0</c:v>
                </c:pt>
                <c:pt idx="762">
                  <c:v>0</c:v>
                </c:pt>
                <c:pt idx="763">
                  <c:v>0</c:v>
                </c:pt>
                <c:pt idx="764">
                  <c:v>0</c:v>
                </c:pt>
                <c:pt idx="765">
                  <c:v>0</c:v>
                </c:pt>
                <c:pt idx="766">
                  <c:v>0</c:v>
                </c:pt>
                <c:pt idx="767">
                  <c:v>0</c:v>
                </c:pt>
                <c:pt idx="768">
                  <c:v>0</c:v>
                </c:pt>
                <c:pt idx="769">
                  <c:v>0</c:v>
                </c:pt>
                <c:pt idx="770">
                  <c:v>0</c:v>
                </c:pt>
                <c:pt idx="771">
                  <c:v>0</c:v>
                </c:pt>
                <c:pt idx="772">
                  <c:v>0</c:v>
                </c:pt>
                <c:pt idx="773">
                  <c:v>0</c:v>
                </c:pt>
                <c:pt idx="774">
                  <c:v>0</c:v>
                </c:pt>
                <c:pt idx="775">
                  <c:v>0</c:v>
                </c:pt>
                <c:pt idx="776">
                  <c:v>0</c:v>
                </c:pt>
                <c:pt idx="777">
                  <c:v>0</c:v>
                </c:pt>
                <c:pt idx="778">
                  <c:v>0</c:v>
                </c:pt>
                <c:pt idx="779">
                  <c:v>0</c:v>
                </c:pt>
                <c:pt idx="780">
                  <c:v>0</c:v>
                </c:pt>
                <c:pt idx="781">
                  <c:v>0</c:v>
                </c:pt>
                <c:pt idx="782">
                  <c:v>0</c:v>
                </c:pt>
                <c:pt idx="783">
                  <c:v>0</c:v>
                </c:pt>
                <c:pt idx="784">
                  <c:v>0</c:v>
                </c:pt>
                <c:pt idx="785">
                  <c:v>0</c:v>
                </c:pt>
                <c:pt idx="786">
                  <c:v>0</c:v>
                </c:pt>
                <c:pt idx="787">
                  <c:v>0</c:v>
                </c:pt>
                <c:pt idx="788">
                  <c:v>0</c:v>
                </c:pt>
                <c:pt idx="789">
                  <c:v>0</c:v>
                </c:pt>
                <c:pt idx="790">
                  <c:v>0</c:v>
                </c:pt>
                <c:pt idx="791">
                  <c:v>0</c:v>
                </c:pt>
                <c:pt idx="792">
                  <c:v>0</c:v>
                </c:pt>
                <c:pt idx="793">
                  <c:v>0</c:v>
                </c:pt>
                <c:pt idx="794">
                  <c:v>0</c:v>
                </c:pt>
                <c:pt idx="795">
                  <c:v>0</c:v>
                </c:pt>
                <c:pt idx="796">
                  <c:v>0</c:v>
                </c:pt>
                <c:pt idx="797">
                  <c:v>0</c:v>
                </c:pt>
                <c:pt idx="798">
                  <c:v>0</c:v>
                </c:pt>
                <c:pt idx="799">
                  <c:v>0</c:v>
                </c:pt>
                <c:pt idx="800">
                  <c:v>0</c:v>
                </c:pt>
                <c:pt idx="801">
                  <c:v>0</c:v>
                </c:pt>
                <c:pt idx="802">
                  <c:v>0</c:v>
                </c:pt>
                <c:pt idx="803">
                  <c:v>0</c:v>
                </c:pt>
                <c:pt idx="804">
                  <c:v>0</c:v>
                </c:pt>
                <c:pt idx="805">
                  <c:v>0</c:v>
                </c:pt>
                <c:pt idx="806">
                  <c:v>0</c:v>
                </c:pt>
                <c:pt idx="807">
                  <c:v>0</c:v>
                </c:pt>
                <c:pt idx="808">
                  <c:v>0</c:v>
                </c:pt>
                <c:pt idx="809">
                  <c:v>0</c:v>
                </c:pt>
                <c:pt idx="810">
                  <c:v>0</c:v>
                </c:pt>
                <c:pt idx="811">
                  <c:v>0</c:v>
                </c:pt>
                <c:pt idx="812">
                  <c:v>0</c:v>
                </c:pt>
                <c:pt idx="813">
                  <c:v>0</c:v>
                </c:pt>
                <c:pt idx="814">
                  <c:v>0</c:v>
                </c:pt>
                <c:pt idx="815">
                  <c:v>0</c:v>
                </c:pt>
                <c:pt idx="816">
                  <c:v>0</c:v>
                </c:pt>
                <c:pt idx="817">
                  <c:v>0</c:v>
                </c:pt>
                <c:pt idx="818">
                  <c:v>0</c:v>
                </c:pt>
                <c:pt idx="819">
                  <c:v>0</c:v>
                </c:pt>
                <c:pt idx="820">
                  <c:v>0</c:v>
                </c:pt>
                <c:pt idx="821">
                  <c:v>0</c:v>
                </c:pt>
                <c:pt idx="822">
                  <c:v>0</c:v>
                </c:pt>
                <c:pt idx="823">
                  <c:v>0</c:v>
                </c:pt>
                <c:pt idx="824">
                  <c:v>0</c:v>
                </c:pt>
                <c:pt idx="825">
                  <c:v>0</c:v>
                </c:pt>
                <c:pt idx="826">
                  <c:v>0</c:v>
                </c:pt>
                <c:pt idx="827">
                  <c:v>0</c:v>
                </c:pt>
                <c:pt idx="828">
                  <c:v>0</c:v>
                </c:pt>
                <c:pt idx="829">
                  <c:v>0</c:v>
                </c:pt>
                <c:pt idx="830">
                  <c:v>0</c:v>
                </c:pt>
                <c:pt idx="831">
                  <c:v>0</c:v>
                </c:pt>
                <c:pt idx="832">
                  <c:v>0</c:v>
                </c:pt>
                <c:pt idx="833">
                  <c:v>0</c:v>
                </c:pt>
                <c:pt idx="834">
                  <c:v>0</c:v>
                </c:pt>
                <c:pt idx="835">
                  <c:v>0</c:v>
                </c:pt>
                <c:pt idx="836">
                  <c:v>0</c:v>
                </c:pt>
                <c:pt idx="837">
                  <c:v>0</c:v>
                </c:pt>
                <c:pt idx="838">
                  <c:v>0</c:v>
                </c:pt>
                <c:pt idx="839">
                  <c:v>0</c:v>
                </c:pt>
                <c:pt idx="840">
                  <c:v>0</c:v>
                </c:pt>
                <c:pt idx="841">
                  <c:v>0</c:v>
                </c:pt>
                <c:pt idx="842">
                  <c:v>0</c:v>
                </c:pt>
                <c:pt idx="843">
                  <c:v>0</c:v>
                </c:pt>
                <c:pt idx="844">
                  <c:v>0</c:v>
                </c:pt>
                <c:pt idx="845">
                  <c:v>0</c:v>
                </c:pt>
                <c:pt idx="846">
                  <c:v>0</c:v>
                </c:pt>
                <c:pt idx="847">
                  <c:v>0</c:v>
                </c:pt>
                <c:pt idx="848">
                  <c:v>0</c:v>
                </c:pt>
                <c:pt idx="849">
                  <c:v>0</c:v>
                </c:pt>
                <c:pt idx="850">
                  <c:v>0</c:v>
                </c:pt>
                <c:pt idx="851">
                  <c:v>0</c:v>
                </c:pt>
                <c:pt idx="852">
                  <c:v>0</c:v>
                </c:pt>
                <c:pt idx="853">
                  <c:v>0</c:v>
                </c:pt>
                <c:pt idx="854">
                  <c:v>0</c:v>
                </c:pt>
                <c:pt idx="855">
                  <c:v>0</c:v>
                </c:pt>
                <c:pt idx="856">
                  <c:v>0</c:v>
                </c:pt>
                <c:pt idx="857">
                  <c:v>0</c:v>
                </c:pt>
                <c:pt idx="858">
                  <c:v>0</c:v>
                </c:pt>
                <c:pt idx="859">
                  <c:v>0</c:v>
                </c:pt>
                <c:pt idx="860">
                  <c:v>0</c:v>
                </c:pt>
                <c:pt idx="861">
                  <c:v>0</c:v>
                </c:pt>
                <c:pt idx="862">
                  <c:v>0</c:v>
                </c:pt>
                <c:pt idx="863">
                  <c:v>0</c:v>
                </c:pt>
                <c:pt idx="864">
                  <c:v>0</c:v>
                </c:pt>
                <c:pt idx="865">
                  <c:v>0</c:v>
                </c:pt>
                <c:pt idx="866">
                  <c:v>0</c:v>
                </c:pt>
                <c:pt idx="867">
                  <c:v>0</c:v>
                </c:pt>
                <c:pt idx="868">
                  <c:v>0</c:v>
                </c:pt>
                <c:pt idx="869">
                  <c:v>0</c:v>
                </c:pt>
                <c:pt idx="870">
                  <c:v>0</c:v>
                </c:pt>
                <c:pt idx="871">
                  <c:v>0</c:v>
                </c:pt>
                <c:pt idx="872">
                  <c:v>0</c:v>
                </c:pt>
                <c:pt idx="873">
                  <c:v>0</c:v>
                </c:pt>
                <c:pt idx="874">
                  <c:v>0</c:v>
                </c:pt>
                <c:pt idx="875">
                  <c:v>0</c:v>
                </c:pt>
                <c:pt idx="876">
                  <c:v>0</c:v>
                </c:pt>
                <c:pt idx="877">
                  <c:v>0</c:v>
                </c:pt>
                <c:pt idx="878">
                  <c:v>0</c:v>
                </c:pt>
                <c:pt idx="879">
                  <c:v>0</c:v>
                </c:pt>
                <c:pt idx="880">
                  <c:v>0</c:v>
                </c:pt>
                <c:pt idx="881">
                  <c:v>0</c:v>
                </c:pt>
                <c:pt idx="882">
                  <c:v>0</c:v>
                </c:pt>
                <c:pt idx="883">
                  <c:v>0</c:v>
                </c:pt>
                <c:pt idx="884">
                  <c:v>0</c:v>
                </c:pt>
                <c:pt idx="885">
                  <c:v>0</c:v>
                </c:pt>
                <c:pt idx="886">
                  <c:v>0</c:v>
                </c:pt>
                <c:pt idx="887">
                  <c:v>0</c:v>
                </c:pt>
                <c:pt idx="888">
                  <c:v>0</c:v>
                </c:pt>
                <c:pt idx="889">
                  <c:v>0</c:v>
                </c:pt>
                <c:pt idx="890">
                  <c:v>0</c:v>
                </c:pt>
                <c:pt idx="891">
                  <c:v>0</c:v>
                </c:pt>
                <c:pt idx="892">
                  <c:v>0</c:v>
                </c:pt>
                <c:pt idx="893">
                  <c:v>0</c:v>
                </c:pt>
                <c:pt idx="894">
                  <c:v>0</c:v>
                </c:pt>
                <c:pt idx="895">
                  <c:v>0</c:v>
                </c:pt>
                <c:pt idx="896">
                  <c:v>0</c:v>
                </c:pt>
                <c:pt idx="897">
                  <c:v>0</c:v>
                </c:pt>
                <c:pt idx="898">
                  <c:v>0</c:v>
                </c:pt>
                <c:pt idx="899">
                  <c:v>0</c:v>
                </c:pt>
                <c:pt idx="900">
                  <c:v>0</c:v>
                </c:pt>
                <c:pt idx="901">
                  <c:v>0</c:v>
                </c:pt>
                <c:pt idx="902">
                  <c:v>0</c:v>
                </c:pt>
                <c:pt idx="903">
                  <c:v>0</c:v>
                </c:pt>
                <c:pt idx="904">
                  <c:v>0</c:v>
                </c:pt>
                <c:pt idx="905">
                  <c:v>0</c:v>
                </c:pt>
                <c:pt idx="906">
                  <c:v>0</c:v>
                </c:pt>
                <c:pt idx="907">
                  <c:v>0</c:v>
                </c:pt>
                <c:pt idx="908">
                  <c:v>0</c:v>
                </c:pt>
                <c:pt idx="909">
                  <c:v>0</c:v>
                </c:pt>
                <c:pt idx="910">
                  <c:v>0</c:v>
                </c:pt>
                <c:pt idx="911">
                  <c:v>0</c:v>
                </c:pt>
                <c:pt idx="912">
                  <c:v>0</c:v>
                </c:pt>
                <c:pt idx="913">
                  <c:v>0</c:v>
                </c:pt>
                <c:pt idx="914">
                  <c:v>0</c:v>
                </c:pt>
                <c:pt idx="915">
                  <c:v>0</c:v>
                </c:pt>
                <c:pt idx="916">
                  <c:v>0</c:v>
                </c:pt>
                <c:pt idx="917">
                  <c:v>0</c:v>
                </c:pt>
                <c:pt idx="918">
                  <c:v>0</c:v>
                </c:pt>
                <c:pt idx="919">
                  <c:v>0</c:v>
                </c:pt>
                <c:pt idx="920">
                  <c:v>0</c:v>
                </c:pt>
                <c:pt idx="921">
                  <c:v>0</c:v>
                </c:pt>
                <c:pt idx="922">
                  <c:v>0</c:v>
                </c:pt>
                <c:pt idx="923">
                  <c:v>0</c:v>
                </c:pt>
                <c:pt idx="924">
                  <c:v>0</c:v>
                </c:pt>
                <c:pt idx="925">
                  <c:v>0</c:v>
                </c:pt>
                <c:pt idx="926">
                  <c:v>0</c:v>
                </c:pt>
                <c:pt idx="927">
                  <c:v>0</c:v>
                </c:pt>
                <c:pt idx="928">
                  <c:v>0</c:v>
                </c:pt>
                <c:pt idx="929">
                  <c:v>0</c:v>
                </c:pt>
                <c:pt idx="930">
                  <c:v>0</c:v>
                </c:pt>
                <c:pt idx="931">
                  <c:v>0</c:v>
                </c:pt>
                <c:pt idx="932">
                  <c:v>0</c:v>
                </c:pt>
                <c:pt idx="933">
                  <c:v>0</c:v>
                </c:pt>
                <c:pt idx="934">
                  <c:v>0</c:v>
                </c:pt>
                <c:pt idx="935">
                  <c:v>0</c:v>
                </c:pt>
                <c:pt idx="936">
                  <c:v>0</c:v>
                </c:pt>
                <c:pt idx="937">
                  <c:v>0</c:v>
                </c:pt>
                <c:pt idx="938">
                  <c:v>0</c:v>
                </c:pt>
                <c:pt idx="939">
                  <c:v>0</c:v>
                </c:pt>
                <c:pt idx="940">
                  <c:v>0</c:v>
                </c:pt>
                <c:pt idx="941">
                  <c:v>0</c:v>
                </c:pt>
                <c:pt idx="942">
                  <c:v>0</c:v>
                </c:pt>
                <c:pt idx="943">
                  <c:v>0</c:v>
                </c:pt>
                <c:pt idx="944">
                  <c:v>0</c:v>
                </c:pt>
                <c:pt idx="945">
                  <c:v>0</c:v>
                </c:pt>
                <c:pt idx="946">
                  <c:v>0</c:v>
                </c:pt>
                <c:pt idx="947">
                  <c:v>0</c:v>
                </c:pt>
                <c:pt idx="948">
                  <c:v>0</c:v>
                </c:pt>
                <c:pt idx="949">
                  <c:v>0</c:v>
                </c:pt>
                <c:pt idx="950">
                  <c:v>0</c:v>
                </c:pt>
                <c:pt idx="951">
                  <c:v>0</c:v>
                </c:pt>
                <c:pt idx="952">
                  <c:v>0</c:v>
                </c:pt>
                <c:pt idx="953">
                  <c:v>0</c:v>
                </c:pt>
                <c:pt idx="954">
                  <c:v>0</c:v>
                </c:pt>
                <c:pt idx="955">
                  <c:v>0</c:v>
                </c:pt>
                <c:pt idx="956">
                  <c:v>0</c:v>
                </c:pt>
                <c:pt idx="957">
                  <c:v>0</c:v>
                </c:pt>
                <c:pt idx="958">
                  <c:v>0</c:v>
                </c:pt>
                <c:pt idx="959">
                  <c:v>0</c:v>
                </c:pt>
                <c:pt idx="960">
                  <c:v>0</c:v>
                </c:pt>
                <c:pt idx="961">
                  <c:v>0</c:v>
                </c:pt>
                <c:pt idx="962">
                  <c:v>0</c:v>
                </c:pt>
                <c:pt idx="963">
                  <c:v>0</c:v>
                </c:pt>
                <c:pt idx="964">
                  <c:v>0</c:v>
                </c:pt>
                <c:pt idx="965">
                  <c:v>0</c:v>
                </c:pt>
                <c:pt idx="966">
                  <c:v>0</c:v>
                </c:pt>
                <c:pt idx="967">
                  <c:v>0</c:v>
                </c:pt>
                <c:pt idx="968">
                  <c:v>0</c:v>
                </c:pt>
                <c:pt idx="969">
                  <c:v>0</c:v>
                </c:pt>
                <c:pt idx="970">
                  <c:v>0</c:v>
                </c:pt>
                <c:pt idx="971">
                  <c:v>0</c:v>
                </c:pt>
                <c:pt idx="972">
                  <c:v>0</c:v>
                </c:pt>
                <c:pt idx="973">
                  <c:v>0</c:v>
                </c:pt>
                <c:pt idx="974">
                  <c:v>0</c:v>
                </c:pt>
                <c:pt idx="975">
                  <c:v>0</c:v>
                </c:pt>
                <c:pt idx="976">
                  <c:v>0</c:v>
                </c:pt>
                <c:pt idx="977">
                  <c:v>0</c:v>
                </c:pt>
                <c:pt idx="978">
                  <c:v>0</c:v>
                </c:pt>
                <c:pt idx="979">
                  <c:v>0</c:v>
                </c:pt>
                <c:pt idx="980">
                  <c:v>0</c:v>
                </c:pt>
                <c:pt idx="981">
                  <c:v>0</c:v>
                </c:pt>
                <c:pt idx="982">
                  <c:v>0</c:v>
                </c:pt>
                <c:pt idx="983">
                  <c:v>0</c:v>
                </c:pt>
                <c:pt idx="984">
                  <c:v>0</c:v>
                </c:pt>
                <c:pt idx="985">
                  <c:v>0</c:v>
                </c:pt>
                <c:pt idx="986">
                  <c:v>0</c:v>
                </c:pt>
                <c:pt idx="987">
                  <c:v>0</c:v>
                </c:pt>
                <c:pt idx="988">
                  <c:v>0</c:v>
                </c:pt>
                <c:pt idx="989">
                  <c:v>0</c:v>
                </c:pt>
                <c:pt idx="990">
                  <c:v>0</c:v>
                </c:pt>
                <c:pt idx="991">
                  <c:v>0</c:v>
                </c:pt>
                <c:pt idx="992">
                  <c:v>0</c:v>
                </c:pt>
                <c:pt idx="993">
                  <c:v>0</c:v>
                </c:pt>
                <c:pt idx="994">
                  <c:v>0</c:v>
                </c:pt>
                <c:pt idx="995">
                  <c:v>0</c:v>
                </c:pt>
                <c:pt idx="996">
                  <c:v>0</c:v>
                </c:pt>
                <c:pt idx="997">
                  <c:v>0</c:v>
                </c:pt>
                <c:pt idx="998">
                  <c:v>0</c:v>
                </c:pt>
                <c:pt idx="999">
                  <c:v>0</c:v>
                </c:pt>
                <c:pt idx="1000">
                  <c:v>0</c:v>
                </c:pt>
                <c:pt idx="1001">
                  <c:v>0</c:v>
                </c:pt>
                <c:pt idx="1002">
                  <c:v>0</c:v>
                </c:pt>
                <c:pt idx="1003">
                  <c:v>0</c:v>
                </c:pt>
                <c:pt idx="1004">
                  <c:v>0</c:v>
                </c:pt>
                <c:pt idx="1005">
                  <c:v>0</c:v>
                </c:pt>
                <c:pt idx="1006">
                  <c:v>0</c:v>
                </c:pt>
                <c:pt idx="1007">
                  <c:v>0</c:v>
                </c:pt>
                <c:pt idx="1008">
                  <c:v>0</c:v>
                </c:pt>
                <c:pt idx="1009">
                  <c:v>0</c:v>
                </c:pt>
                <c:pt idx="1010">
                  <c:v>0</c:v>
                </c:pt>
                <c:pt idx="1011">
                  <c:v>0</c:v>
                </c:pt>
                <c:pt idx="1012">
                  <c:v>0</c:v>
                </c:pt>
                <c:pt idx="1013">
                  <c:v>0</c:v>
                </c:pt>
                <c:pt idx="1014">
                  <c:v>0</c:v>
                </c:pt>
                <c:pt idx="1015">
                  <c:v>0</c:v>
                </c:pt>
                <c:pt idx="1016">
                  <c:v>0</c:v>
                </c:pt>
                <c:pt idx="1017">
                  <c:v>0</c:v>
                </c:pt>
                <c:pt idx="1018">
                  <c:v>0</c:v>
                </c:pt>
                <c:pt idx="1019">
                  <c:v>0</c:v>
                </c:pt>
                <c:pt idx="1020">
                  <c:v>0</c:v>
                </c:pt>
                <c:pt idx="1021">
                  <c:v>0</c:v>
                </c:pt>
                <c:pt idx="1022">
                  <c:v>0</c:v>
                </c:pt>
                <c:pt idx="1023">
                  <c:v>0</c:v>
                </c:pt>
                <c:pt idx="1024">
                  <c:v>0</c:v>
                </c:pt>
                <c:pt idx="1025">
                  <c:v>0</c:v>
                </c:pt>
                <c:pt idx="1026">
                  <c:v>0</c:v>
                </c:pt>
                <c:pt idx="1027">
                  <c:v>0</c:v>
                </c:pt>
                <c:pt idx="1028">
                  <c:v>0</c:v>
                </c:pt>
                <c:pt idx="1029">
                  <c:v>0</c:v>
                </c:pt>
                <c:pt idx="1030">
                  <c:v>0</c:v>
                </c:pt>
                <c:pt idx="1031">
                  <c:v>0</c:v>
                </c:pt>
                <c:pt idx="1032">
                  <c:v>0</c:v>
                </c:pt>
                <c:pt idx="1033">
                  <c:v>0</c:v>
                </c:pt>
                <c:pt idx="1034">
                  <c:v>0</c:v>
                </c:pt>
                <c:pt idx="1035">
                  <c:v>0</c:v>
                </c:pt>
                <c:pt idx="1036">
                  <c:v>0</c:v>
                </c:pt>
                <c:pt idx="1037">
                  <c:v>0</c:v>
                </c:pt>
                <c:pt idx="1038">
                  <c:v>0</c:v>
                </c:pt>
                <c:pt idx="1039">
                  <c:v>0</c:v>
                </c:pt>
                <c:pt idx="1040">
                  <c:v>0</c:v>
                </c:pt>
                <c:pt idx="1041">
                  <c:v>0</c:v>
                </c:pt>
                <c:pt idx="1042">
                  <c:v>0</c:v>
                </c:pt>
                <c:pt idx="1043">
                  <c:v>0</c:v>
                </c:pt>
                <c:pt idx="1044">
                  <c:v>0</c:v>
                </c:pt>
                <c:pt idx="1045">
                  <c:v>0</c:v>
                </c:pt>
                <c:pt idx="1046">
                  <c:v>0</c:v>
                </c:pt>
                <c:pt idx="1047">
                  <c:v>0</c:v>
                </c:pt>
                <c:pt idx="1048">
                  <c:v>0</c:v>
                </c:pt>
                <c:pt idx="1049">
                  <c:v>0</c:v>
                </c:pt>
                <c:pt idx="1050">
                  <c:v>0</c:v>
                </c:pt>
                <c:pt idx="1051">
                  <c:v>0</c:v>
                </c:pt>
                <c:pt idx="1052">
                  <c:v>0</c:v>
                </c:pt>
                <c:pt idx="1053">
                  <c:v>0</c:v>
                </c:pt>
                <c:pt idx="1054">
                  <c:v>0</c:v>
                </c:pt>
                <c:pt idx="1055">
                  <c:v>0</c:v>
                </c:pt>
                <c:pt idx="1056">
                  <c:v>0</c:v>
                </c:pt>
                <c:pt idx="1057">
                  <c:v>0</c:v>
                </c:pt>
                <c:pt idx="1058">
                  <c:v>0</c:v>
                </c:pt>
                <c:pt idx="1059">
                  <c:v>0</c:v>
                </c:pt>
                <c:pt idx="1060">
                  <c:v>0</c:v>
                </c:pt>
                <c:pt idx="1061">
                  <c:v>0</c:v>
                </c:pt>
                <c:pt idx="1062">
                  <c:v>0</c:v>
                </c:pt>
                <c:pt idx="1063">
                  <c:v>0</c:v>
                </c:pt>
                <c:pt idx="1064">
                  <c:v>0</c:v>
                </c:pt>
                <c:pt idx="1065">
                  <c:v>0</c:v>
                </c:pt>
                <c:pt idx="1066">
                  <c:v>0</c:v>
                </c:pt>
                <c:pt idx="1067">
                  <c:v>0</c:v>
                </c:pt>
                <c:pt idx="1068">
                  <c:v>0</c:v>
                </c:pt>
                <c:pt idx="1069">
                  <c:v>0</c:v>
                </c:pt>
                <c:pt idx="1070">
                  <c:v>0</c:v>
                </c:pt>
                <c:pt idx="1071">
                  <c:v>0</c:v>
                </c:pt>
                <c:pt idx="1072">
                  <c:v>0</c:v>
                </c:pt>
                <c:pt idx="1073">
                  <c:v>0</c:v>
                </c:pt>
                <c:pt idx="1074">
                  <c:v>0</c:v>
                </c:pt>
                <c:pt idx="1075">
                  <c:v>0</c:v>
                </c:pt>
                <c:pt idx="1076">
                  <c:v>0</c:v>
                </c:pt>
                <c:pt idx="1077">
                  <c:v>0</c:v>
                </c:pt>
                <c:pt idx="1078">
                  <c:v>0</c:v>
                </c:pt>
                <c:pt idx="1079">
                  <c:v>0</c:v>
                </c:pt>
                <c:pt idx="1080">
                  <c:v>0</c:v>
                </c:pt>
                <c:pt idx="1081">
                  <c:v>0</c:v>
                </c:pt>
                <c:pt idx="1082">
                  <c:v>0</c:v>
                </c:pt>
                <c:pt idx="1083">
                  <c:v>0</c:v>
                </c:pt>
                <c:pt idx="1084">
                  <c:v>0</c:v>
                </c:pt>
                <c:pt idx="1085">
                  <c:v>0</c:v>
                </c:pt>
                <c:pt idx="1086">
                  <c:v>0</c:v>
                </c:pt>
                <c:pt idx="1087">
                  <c:v>0</c:v>
                </c:pt>
                <c:pt idx="1088">
                  <c:v>0</c:v>
                </c:pt>
                <c:pt idx="1089">
                  <c:v>0</c:v>
                </c:pt>
                <c:pt idx="1090">
                  <c:v>0</c:v>
                </c:pt>
                <c:pt idx="1091">
                  <c:v>0</c:v>
                </c:pt>
                <c:pt idx="1092">
                  <c:v>0</c:v>
                </c:pt>
                <c:pt idx="1093">
                  <c:v>0</c:v>
                </c:pt>
                <c:pt idx="1094">
                  <c:v>0</c:v>
                </c:pt>
                <c:pt idx="1095">
                  <c:v>0</c:v>
                </c:pt>
                <c:pt idx="1096">
                  <c:v>0</c:v>
                </c:pt>
                <c:pt idx="1097">
                  <c:v>0</c:v>
                </c:pt>
                <c:pt idx="1098">
                  <c:v>0</c:v>
                </c:pt>
                <c:pt idx="1099">
                  <c:v>0</c:v>
                </c:pt>
                <c:pt idx="1100">
                  <c:v>0</c:v>
                </c:pt>
                <c:pt idx="1101">
                  <c:v>0</c:v>
                </c:pt>
                <c:pt idx="1102">
                  <c:v>0</c:v>
                </c:pt>
                <c:pt idx="1103">
                  <c:v>0</c:v>
                </c:pt>
                <c:pt idx="1104">
                  <c:v>0</c:v>
                </c:pt>
                <c:pt idx="1105">
                  <c:v>0</c:v>
                </c:pt>
                <c:pt idx="1106">
                  <c:v>0</c:v>
                </c:pt>
                <c:pt idx="1107">
                  <c:v>0</c:v>
                </c:pt>
                <c:pt idx="1108">
                  <c:v>0</c:v>
                </c:pt>
                <c:pt idx="1109">
                  <c:v>0</c:v>
                </c:pt>
                <c:pt idx="1110">
                  <c:v>0</c:v>
                </c:pt>
                <c:pt idx="1111">
                  <c:v>0</c:v>
                </c:pt>
                <c:pt idx="1112">
                  <c:v>0</c:v>
                </c:pt>
                <c:pt idx="1113">
                  <c:v>0</c:v>
                </c:pt>
                <c:pt idx="1114">
                  <c:v>0</c:v>
                </c:pt>
                <c:pt idx="1115">
                  <c:v>0</c:v>
                </c:pt>
                <c:pt idx="1116">
                  <c:v>0</c:v>
                </c:pt>
                <c:pt idx="1117">
                  <c:v>0</c:v>
                </c:pt>
                <c:pt idx="1118">
                  <c:v>0</c:v>
                </c:pt>
                <c:pt idx="1119">
                  <c:v>0</c:v>
                </c:pt>
                <c:pt idx="1120">
                  <c:v>0</c:v>
                </c:pt>
                <c:pt idx="1121">
                  <c:v>0</c:v>
                </c:pt>
                <c:pt idx="1122">
                  <c:v>0</c:v>
                </c:pt>
                <c:pt idx="1123">
                  <c:v>0</c:v>
                </c:pt>
                <c:pt idx="1124">
                  <c:v>0</c:v>
                </c:pt>
                <c:pt idx="1125">
                  <c:v>0</c:v>
                </c:pt>
                <c:pt idx="1126">
                  <c:v>0</c:v>
                </c:pt>
                <c:pt idx="1127">
                  <c:v>0</c:v>
                </c:pt>
                <c:pt idx="1128">
                  <c:v>0</c:v>
                </c:pt>
                <c:pt idx="1129">
                  <c:v>0</c:v>
                </c:pt>
                <c:pt idx="1130">
                  <c:v>0</c:v>
                </c:pt>
                <c:pt idx="1131">
                  <c:v>0</c:v>
                </c:pt>
                <c:pt idx="1132">
                  <c:v>0</c:v>
                </c:pt>
                <c:pt idx="1133">
                  <c:v>0</c:v>
                </c:pt>
                <c:pt idx="1134">
                  <c:v>0</c:v>
                </c:pt>
                <c:pt idx="1135">
                  <c:v>0</c:v>
                </c:pt>
                <c:pt idx="1136">
                  <c:v>0</c:v>
                </c:pt>
                <c:pt idx="1137">
                  <c:v>0</c:v>
                </c:pt>
                <c:pt idx="1138">
                  <c:v>0</c:v>
                </c:pt>
                <c:pt idx="1139">
                  <c:v>0</c:v>
                </c:pt>
                <c:pt idx="1140">
                  <c:v>0</c:v>
                </c:pt>
                <c:pt idx="1141">
                  <c:v>0</c:v>
                </c:pt>
                <c:pt idx="1142">
                  <c:v>0</c:v>
                </c:pt>
                <c:pt idx="1143">
                  <c:v>0</c:v>
                </c:pt>
                <c:pt idx="1144">
                  <c:v>0</c:v>
                </c:pt>
                <c:pt idx="1145">
                  <c:v>0</c:v>
                </c:pt>
                <c:pt idx="1146">
                  <c:v>0</c:v>
                </c:pt>
                <c:pt idx="1147">
                  <c:v>0</c:v>
                </c:pt>
                <c:pt idx="1148">
                  <c:v>0</c:v>
                </c:pt>
                <c:pt idx="1149">
                  <c:v>0</c:v>
                </c:pt>
                <c:pt idx="1150">
                  <c:v>0</c:v>
                </c:pt>
                <c:pt idx="1151">
                  <c:v>0</c:v>
                </c:pt>
                <c:pt idx="1152">
                  <c:v>0</c:v>
                </c:pt>
                <c:pt idx="1153">
                  <c:v>0</c:v>
                </c:pt>
                <c:pt idx="1154">
                  <c:v>0</c:v>
                </c:pt>
                <c:pt idx="1155">
                  <c:v>0</c:v>
                </c:pt>
                <c:pt idx="1156">
                  <c:v>0</c:v>
                </c:pt>
                <c:pt idx="1157">
                  <c:v>0</c:v>
                </c:pt>
                <c:pt idx="1158">
                  <c:v>0</c:v>
                </c:pt>
                <c:pt idx="1159">
                  <c:v>0</c:v>
                </c:pt>
                <c:pt idx="1160">
                  <c:v>0</c:v>
                </c:pt>
                <c:pt idx="1161">
                  <c:v>0</c:v>
                </c:pt>
                <c:pt idx="1162">
                  <c:v>0</c:v>
                </c:pt>
                <c:pt idx="1163">
                  <c:v>0</c:v>
                </c:pt>
                <c:pt idx="1164">
                  <c:v>0</c:v>
                </c:pt>
                <c:pt idx="1165">
                  <c:v>0</c:v>
                </c:pt>
                <c:pt idx="1166">
                  <c:v>0</c:v>
                </c:pt>
                <c:pt idx="1167">
                  <c:v>0</c:v>
                </c:pt>
                <c:pt idx="1168">
                  <c:v>0</c:v>
                </c:pt>
                <c:pt idx="1169">
                  <c:v>0</c:v>
                </c:pt>
                <c:pt idx="1170">
                  <c:v>0</c:v>
                </c:pt>
                <c:pt idx="1171">
                  <c:v>0</c:v>
                </c:pt>
                <c:pt idx="1172">
                  <c:v>0</c:v>
                </c:pt>
                <c:pt idx="1173">
                  <c:v>0</c:v>
                </c:pt>
                <c:pt idx="1174">
                  <c:v>0</c:v>
                </c:pt>
                <c:pt idx="1175">
                  <c:v>0</c:v>
                </c:pt>
                <c:pt idx="1176">
                  <c:v>0</c:v>
                </c:pt>
                <c:pt idx="1177">
                  <c:v>0</c:v>
                </c:pt>
                <c:pt idx="1178">
                  <c:v>0</c:v>
                </c:pt>
                <c:pt idx="1179">
                  <c:v>0</c:v>
                </c:pt>
                <c:pt idx="1180">
                  <c:v>0</c:v>
                </c:pt>
                <c:pt idx="1181">
                  <c:v>0</c:v>
                </c:pt>
                <c:pt idx="1182">
                  <c:v>0</c:v>
                </c:pt>
                <c:pt idx="1183">
                  <c:v>0</c:v>
                </c:pt>
                <c:pt idx="1184">
                  <c:v>0</c:v>
                </c:pt>
                <c:pt idx="1185">
                  <c:v>0</c:v>
                </c:pt>
                <c:pt idx="1186">
                  <c:v>0</c:v>
                </c:pt>
                <c:pt idx="1187">
                  <c:v>0</c:v>
                </c:pt>
                <c:pt idx="1188">
                  <c:v>0</c:v>
                </c:pt>
                <c:pt idx="1189">
                  <c:v>0</c:v>
                </c:pt>
                <c:pt idx="1190">
                  <c:v>0</c:v>
                </c:pt>
                <c:pt idx="1191">
                  <c:v>0</c:v>
                </c:pt>
                <c:pt idx="1192">
                  <c:v>0</c:v>
                </c:pt>
                <c:pt idx="1193">
                  <c:v>0</c:v>
                </c:pt>
                <c:pt idx="1194">
                  <c:v>0</c:v>
                </c:pt>
                <c:pt idx="1195">
                  <c:v>0</c:v>
                </c:pt>
                <c:pt idx="1196">
                  <c:v>0</c:v>
                </c:pt>
                <c:pt idx="1197">
                  <c:v>0</c:v>
                </c:pt>
                <c:pt idx="1198">
                  <c:v>0</c:v>
                </c:pt>
                <c:pt idx="1199">
                  <c:v>0</c:v>
                </c:pt>
                <c:pt idx="1200">
                  <c:v>0</c:v>
                </c:pt>
                <c:pt idx="1201">
                  <c:v>0</c:v>
                </c:pt>
                <c:pt idx="1202">
                  <c:v>0</c:v>
                </c:pt>
                <c:pt idx="1203">
                  <c:v>0</c:v>
                </c:pt>
                <c:pt idx="1204">
                  <c:v>0</c:v>
                </c:pt>
                <c:pt idx="1205">
                  <c:v>0</c:v>
                </c:pt>
                <c:pt idx="1206">
                  <c:v>0</c:v>
                </c:pt>
                <c:pt idx="1207">
                  <c:v>0</c:v>
                </c:pt>
                <c:pt idx="1208">
                  <c:v>0</c:v>
                </c:pt>
                <c:pt idx="1209">
                  <c:v>0</c:v>
                </c:pt>
                <c:pt idx="1210">
                  <c:v>0</c:v>
                </c:pt>
                <c:pt idx="1211">
                  <c:v>0</c:v>
                </c:pt>
                <c:pt idx="1212">
                  <c:v>0</c:v>
                </c:pt>
                <c:pt idx="1213">
                  <c:v>0</c:v>
                </c:pt>
                <c:pt idx="1214">
                  <c:v>0</c:v>
                </c:pt>
                <c:pt idx="1215">
                  <c:v>0</c:v>
                </c:pt>
                <c:pt idx="1216">
                  <c:v>0</c:v>
                </c:pt>
                <c:pt idx="1217">
                  <c:v>0</c:v>
                </c:pt>
                <c:pt idx="1218">
                  <c:v>0</c:v>
                </c:pt>
                <c:pt idx="1219">
                  <c:v>0</c:v>
                </c:pt>
                <c:pt idx="1220">
                  <c:v>0</c:v>
                </c:pt>
                <c:pt idx="1221">
                  <c:v>0</c:v>
                </c:pt>
                <c:pt idx="1222">
                  <c:v>0</c:v>
                </c:pt>
                <c:pt idx="1223">
                  <c:v>0</c:v>
                </c:pt>
                <c:pt idx="1224">
                  <c:v>0</c:v>
                </c:pt>
                <c:pt idx="1225">
                  <c:v>0</c:v>
                </c:pt>
                <c:pt idx="1226">
                  <c:v>0</c:v>
                </c:pt>
                <c:pt idx="1227">
                  <c:v>0</c:v>
                </c:pt>
                <c:pt idx="1228">
                  <c:v>0</c:v>
                </c:pt>
                <c:pt idx="1229">
                  <c:v>0</c:v>
                </c:pt>
                <c:pt idx="1230">
                  <c:v>0</c:v>
                </c:pt>
                <c:pt idx="1231">
                  <c:v>0</c:v>
                </c:pt>
                <c:pt idx="1232">
                  <c:v>0</c:v>
                </c:pt>
                <c:pt idx="1233">
                  <c:v>0</c:v>
                </c:pt>
                <c:pt idx="1234">
                  <c:v>0</c:v>
                </c:pt>
                <c:pt idx="1235">
                  <c:v>0</c:v>
                </c:pt>
                <c:pt idx="1236">
                  <c:v>0</c:v>
                </c:pt>
                <c:pt idx="1237">
                  <c:v>0</c:v>
                </c:pt>
                <c:pt idx="1238">
                  <c:v>0</c:v>
                </c:pt>
                <c:pt idx="1239">
                  <c:v>0</c:v>
                </c:pt>
                <c:pt idx="1240">
                  <c:v>0</c:v>
                </c:pt>
                <c:pt idx="1241">
                  <c:v>0</c:v>
                </c:pt>
                <c:pt idx="1242">
                  <c:v>0</c:v>
                </c:pt>
                <c:pt idx="1243">
                  <c:v>0</c:v>
                </c:pt>
                <c:pt idx="1244">
                  <c:v>0</c:v>
                </c:pt>
                <c:pt idx="1245">
                  <c:v>0</c:v>
                </c:pt>
                <c:pt idx="1246">
                  <c:v>0</c:v>
                </c:pt>
                <c:pt idx="1247">
                  <c:v>0</c:v>
                </c:pt>
                <c:pt idx="1248">
                  <c:v>0</c:v>
                </c:pt>
                <c:pt idx="1249">
                  <c:v>0</c:v>
                </c:pt>
                <c:pt idx="1250">
                  <c:v>0</c:v>
                </c:pt>
                <c:pt idx="1251">
                  <c:v>0</c:v>
                </c:pt>
                <c:pt idx="1252">
                  <c:v>0</c:v>
                </c:pt>
                <c:pt idx="1253">
                  <c:v>0</c:v>
                </c:pt>
                <c:pt idx="1254">
                  <c:v>0</c:v>
                </c:pt>
                <c:pt idx="1255">
                  <c:v>0</c:v>
                </c:pt>
                <c:pt idx="1256">
                  <c:v>0</c:v>
                </c:pt>
                <c:pt idx="1257">
                  <c:v>0</c:v>
                </c:pt>
                <c:pt idx="1258">
                  <c:v>0</c:v>
                </c:pt>
                <c:pt idx="1259">
                  <c:v>0</c:v>
                </c:pt>
                <c:pt idx="1260">
                  <c:v>0</c:v>
                </c:pt>
                <c:pt idx="1261">
                  <c:v>0</c:v>
                </c:pt>
                <c:pt idx="1262">
                  <c:v>0</c:v>
                </c:pt>
                <c:pt idx="1263">
                  <c:v>0</c:v>
                </c:pt>
                <c:pt idx="1264">
                  <c:v>0</c:v>
                </c:pt>
                <c:pt idx="1265">
                  <c:v>0</c:v>
                </c:pt>
                <c:pt idx="1266">
                  <c:v>0</c:v>
                </c:pt>
                <c:pt idx="1267">
                  <c:v>0</c:v>
                </c:pt>
                <c:pt idx="1268">
                  <c:v>0</c:v>
                </c:pt>
                <c:pt idx="1269">
                  <c:v>0</c:v>
                </c:pt>
                <c:pt idx="1270">
                  <c:v>0</c:v>
                </c:pt>
                <c:pt idx="1271">
                  <c:v>0</c:v>
                </c:pt>
                <c:pt idx="1272">
                  <c:v>0</c:v>
                </c:pt>
                <c:pt idx="1273">
                  <c:v>0</c:v>
                </c:pt>
                <c:pt idx="1274">
                  <c:v>0</c:v>
                </c:pt>
                <c:pt idx="1275">
                  <c:v>0</c:v>
                </c:pt>
                <c:pt idx="1276">
                  <c:v>0</c:v>
                </c:pt>
                <c:pt idx="1277">
                  <c:v>0</c:v>
                </c:pt>
                <c:pt idx="1278">
                  <c:v>0</c:v>
                </c:pt>
                <c:pt idx="1279">
                  <c:v>0</c:v>
                </c:pt>
                <c:pt idx="1280">
                  <c:v>0</c:v>
                </c:pt>
                <c:pt idx="1281">
                  <c:v>0</c:v>
                </c:pt>
                <c:pt idx="1282">
                  <c:v>0</c:v>
                </c:pt>
                <c:pt idx="1283">
                  <c:v>0</c:v>
                </c:pt>
                <c:pt idx="1284">
                  <c:v>0</c:v>
                </c:pt>
                <c:pt idx="1285">
                  <c:v>0</c:v>
                </c:pt>
                <c:pt idx="1286">
                  <c:v>0</c:v>
                </c:pt>
                <c:pt idx="1287">
                  <c:v>0</c:v>
                </c:pt>
                <c:pt idx="1288">
                  <c:v>0</c:v>
                </c:pt>
                <c:pt idx="1289">
                  <c:v>0</c:v>
                </c:pt>
                <c:pt idx="1290">
                  <c:v>0</c:v>
                </c:pt>
                <c:pt idx="1291">
                  <c:v>0</c:v>
                </c:pt>
                <c:pt idx="1292">
                  <c:v>0</c:v>
                </c:pt>
                <c:pt idx="1293">
                  <c:v>0</c:v>
                </c:pt>
                <c:pt idx="1294">
                  <c:v>0</c:v>
                </c:pt>
                <c:pt idx="1295">
                  <c:v>0</c:v>
                </c:pt>
                <c:pt idx="1296">
                  <c:v>0</c:v>
                </c:pt>
                <c:pt idx="1297">
                  <c:v>0</c:v>
                </c:pt>
                <c:pt idx="1298">
                  <c:v>0</c:v>
                </c:pt>
                <c:pt idx="1299">
                  <c:v>0</c:v>
                </c:pt>
                <c:pt idx="1300">
                  <c:v>0</c:v>
                </c:pt>
                <c:pt idx="1301">
                  <c:v>0</c:v>
                </c:pt>
                <c:pt idx="1302">
                  <c:v>0</c:v>
                </c:pt>
                <c:pt idx="1303">
                  <c:v>0</c:v>
                </c:pt>
                <c:pt idx="1304">
                  <c:v>0</c:v>
                </c:pt>
                <c:pt idx="1305">
                  <c:v>0</c:v>
                </c:pt>
                <c:pt idx="1306">
                  <c:v>0</c:v>
                </c:pt>
                <c:pt idx="1307">
                  <c:v>0</c:v>
                </c:pt>
                <c:pt idx="1308">
                  <c:v>0</c:v>
                </c:pt>
                <c:pt idx="1309">
                  <c:v>0</c:v>
                </c:pt>
                <c:pt idx="1310">
                  <c:v>0</c:v>
                </c:pt>
                <c:pt idx="1311">
                  <c:v>0</c:v>
                </c:pt>
                <c:pt idx="1312">
                  <c:v>0</c:v>
                </c:pt>
                <c:pt idx="1313">
                  <c:v>0</c:v>
                </c:pt>
                <c:pt idx="1314">
                  <c:v>0</c:v>
                </c:pt>
                <c:pt idx="1315">
                  <c:v>0</c:v>
                </c:pt>
                <c:pt idx="1316">
                  <c:v>0</c:v>
                </c:pt>
                <c:pt idx="1317">
                  <c:v>0</c:v>
                </c:pt>
                <c:pt idx="1318">
                  <c:v>0</c:v>
                </c:pt>
                <c:pt idx="1319">
                  <c:v>0</c:v>
                </c:pt>
                <c:pt idx="1320">
                  <c:v>0</c:v>
                </c:pt>
                <c:pt idx="1321">
                  <c:v>0</c:v>
                </c:pt>
                <c:pt idx="1322">
                  <c:v>0</c:v>
                </c:pt>
                <c:pt idx="1323">
                  <c:v>0</c:v>
                </c:pt>
                <c:pt idx="1324">
                  <c:v>0</c:v>
                </c:pt>
                <c:pt idx="1325">
                  <c:v>0</c:v>
                </c:pt>
                <c:pt idx="1326">
                  <c:v>0</c:v>
                </c:pt>
                <c:pt idx="1327">
                  <c:v>0</c:v>
                </c:pt>
                <c:pt idx="1328">
                  <c:v>0</c:v>
                </c:pt>
                <c:pt idx="1329">
                  <c:v>0</c:v>
                </c:pt>
                <c:pt idx="1330">
                  <c:v>0</c:v>
                </c:pt>
                <c:pt idx="1331">
                  <c:v>0</c:v>
                </c:pt>
                <c:pt idx="1332">
                  <c:v>0</c:v>
                </c:pt>
                <c:pt idx="1333">
                  <c:v>0</c:v>
                </c:pt>
                <c:pt idx="1334">
                  <c:v>0</c:v>
                </c:pt>
                <c:pt idx="1335">
                  <c:v>0</c:v>
                </c:pt>
                <c:pt idx="1336">
                  <c:v>0</c:v>
                </c:pt>
                <c:pt idx="1337">
                  <c:v>0</c:v>
                </c:pt>
                <c:pt idx="1338">
                  <c:v>0</c:v>
                </c:pt>
                <c:pt idx="1339">
                  <c:v>0</c:v>
                </c:pt>
                <c:pt idx="1340">
                  <c:v>0</c:v>
                </c:pt>
                <c:pt idx="1341">
                  <c:v>0</c:v>
                </c:pt>
                <c:pt idx="1342">
                  <c:v>0</c:v>
                </c:pt>
                <c:pt idx="1343">
                  <c:v>0</c:v>
                </c:pt>
                <c:pt idx="1344">
                  <c:v>0</c:v>
                </c:pt>
                <c:pt idx="1345">
                  <c:v>0</c:v>
                </c:pt>
                <c:pt idx="1346">
                  <c:v>0</c:v>
                </c:pt>
                <c:pt idx="1347">
                  <c:v>0</c:v>
                </c:pt>
                <c:pt idx="1348">
                  <c:v>0</c:v>
                </c:pt>
                <c:pt idx="1349">
                  <c:v>0</c:v>
                </c:pt>
                <c:pt idx="1350">
                  <c:v>0</c:v>
                </c:pt>
                <c:pt idx="1351">
                  <c:v>0</c:v>
                </c:pt>
                <c:pt idx="1352">
                  <c:v>0</c:v>
                </c:pt>
                <c:pt idx="1353">
                  <c:v>0</c:v>
                </c:pt>
                <c:pt idx="1354">
                  <c:v>0</c:v>
                </c:pt>
                <c:pt idx="1355">
                  <c:v>0</c:v>
                </c:pt>
                <c:pt idx="1356">
                  <c:v>0</c:v>
                </c:pt>
                <c:pt idx="1357">
                  <c:v>0</c:v>
                </c:pt>
                <c:pt idx="1358">
                  <c:v>0</c:v>
                </c:pt>
                <c:pt idx="1359">
                  <c:v>0</c:v>
                </c:pt>
                <c:pt idx="1360">
                  <c:v>0</c:v>
                </c:pt>
                <c:pt idx="1361">
                  <c:v>0</c:v>
                </c:pt>
                <c:pt idx="1362">
                  <c:v>0</c:v>
                </c:pt>
                <c:pt idx="1363">
                  <c:v>0</c:v>
                </c:pt>
                <c:pt idx="1364">
                  <c:v>0</c:v>
                </c:pt>
                <c:pt idx="1365">
                  <c:v>0</c:v>
                </c:pt>
                <c:pt idx="1366">
                  <c:v>0</c:v>
                </c:pt>
                <c:pt idx="1367">
                  <c:v>0</c:v>
                </c:pt>
                <c:pt idx="1368">
                  <c:v>0</c:v>
                </c:pt>
                <c:pt idx="1369">
                  <c:v>0</c:v>
                </c:pt>
                <c:pt idx="1370">
                  <c:v>0</c:v>
                </c:pt>
                <c:pt idx="1371">
                  <c:v>0</c:v>
                </c:pt>
                <c:pt idx="1372">
                  <c:v>0</c:v>
                </c:pt>
                <c:pt idx="1373">
                  <c:v>0</c:v>
                </c:pt>
                <c:pt idx="1374">
                  <c:v>0</c:v>
                </c:pt>
                <c:pt idx="1375">
                  <c:v>0</c:v>
                </c:pt>
                <c:pt idx="1376">
                  <c:v>0</c:v>
                </c:pt>
                <c:pt idx="1377">
                  <c:v>0</c:v>
                </c:pt>
                <c:pt idx="1378">
                  <c:v>0</c:v>
                </c:pt>
                <c:pt idx="1379">
                  <c:v>0</c:v>
                </c:pt>
                <c:pt idx="1380">
                  <c:v>0</c:v>
                </c:pt>
                <c:pt idx="1381">
                  <c:v>0</c:v>
                </c:pt>
                <c:pt idx="1382">
                  <c:v>0</c:v>
                </c:pt>
                <c:pt idx="1383">
                  <c:v>0</c:v>
                </c:pt>
                <c:pt idx="1384">
                  <c:v>0</c:v>
                </c:pt>
                <c:pt idx="1385">
                  <c:v>0</c:v>
                </c:pt>
                <c:pt idx="1386">
                  <c:v>0</c:v>
                </c:pt>
                <c:pt idx="1387">
                  <c:v>0</c:v>
                </c:pt>
                <c:pt idx="1388">
                  <c:v>0</c:v>
                </c:pt>
                <c:pt idx="1389">
                  <c:v>0</c:v>
                </c:pt>
                <c:pt idx="1390">
                  <c:v>0</c:v>
                </c:pt>
                <c:pt idx="1391">
                  <c:v>0</c:v>
                </c:pt>
                <c:pt idx="1392">
                  <c:v>0</c:v>
                </c:pt>
                <c:pt idx="1393">
                  <c:v>0</c:v>
                </c:pt>
                <c:pt idx="1394">
                  <c:v>0</c:v>
                </c:pt>
                <c:pt idx="1395">
                  <c:v>0</c:v>
                </c:pt>
                <c:pt idx="1396">
                  <c:v>0</c:v>
                </c:pt>
                <c:pt idx="1397">
                  <c:v>0</c:v>
                </c:pt>
                <c:pt idx="1398">
                  <c:v>0</c:v>
                </c:pt>
                <c:pt idx="1399">
                  <c:v>0</c:v>
                </c:pt>
                <c:pt idx="1400">
                  <c:v>0</c:v>
                </c:pt>
                <c:pt idx="1401">
                  <c:v>0</c:v>
                </c:pt>
                <c:pt idx="1402">
                  <c:v>0</c:v>
                </c:pt>
                <c:pt idx="1403">
                  <c:v>0</c:v>
                </c:pt>
                <c:pt idx="1404">
                  <c:v>0</c:v>
                </c:pt>
                <c:pt idx="1405">
                  <c:v>0</c:v>
                </c:pt>
                <c:pt idx="1406">
                  <c:v>0</c:v>
                </c:pt>
                <c:pt idx="1407">
                  <c:v>0</c:v>
                </c:pt>
                <c:pt idx="1408">
                  <c:v>0</c:v>
                </c:pt>
                <c:pt idx="1409">
                  <c:v>0</c:v>
                </c:pt>
                <c:pt idx="1410">
                  <c:v>0</c:v>
                </c:pt>
                <c:pt idx="1411">
                  <c:v>0</c:v>
                </c:pt>
                <c:pt idx="1412">
                  <c:v>0</c:v>
                </c:pt>
                <c:pt idx="1413">
                  <c:v>0</c:v>
                </c:pt>
                <c:pt idx="1414">
                  <c:v>0</c:v>
                </c:pt>
                <c:pt idx="1415">
                  <c:v>0</c:v>
                </c:pt>
                <c:pt idx="1416">
                  <c:v>0</c:v>
                </c:pt>
                <c:pt idx="1417">
                  <c:v>0</c:v>
                </c:pt>
                <c:pt idx="1418">
                  <c:v>0</c:v>
                </c:pt>
                <c:pt idx="1419">
                  <c:v>0</c:v>
                </c:pt>
                <c:pt idx="1420">
                  <c:v>0</c:v>
                </c:pt>
                <c:pt idx="1421">
                  <c:v>0</c:v>
                </c:pt>
                <c:pt idx="1422">
                  <c:v>0</c:v>
                </c:pt>
                <c:pt idx="1423">
                  <c:v>0</c:v>
                </c:pt>
                <c:pt idx="1424">
                  <c:v>0</c:v>
                </c:pt>
                <c:pt idx="1425">
                  <c:v>0</c:v>
                </c:pt>
                <c:pt idx="1426">
                  <c:v>0</c:v>
                </c:pt>
                <c:pt idx="1427">
                  <c:v>0</c:v>
                </c:pt>
                <c:pt idx="1428">
                  <c:v>0</c:v>
                </c:pt>
                <c:pt idx="1429">
                  <c:v>0</c:v>
                </c:pt>
                <c:pt idx="1430">
                  <c:v>0</c:v>
                </c:pt>
                <c:pt idx="1431">
                  <c:v>0</c:v>
                </c:pt>
                <c:pt idx="1432">
                  <c:v>0</c:v>
                </c:pt>
                <c:pt idx="1433">
                  <c:v>0</c:v>
                </c:pt>
                <c:pt idx="1434">
                  <c:v>0</c:v>
                </c:pt>
                <c:pt idx="1435">
                  <c:v>0</c:v>
                </c:pt>
                <c:pt idx="1436">
                  <c:v>0</c:v>
                </c:pt>
                <c:pt idx="1437">
                  <c:v>0</c:v>
                </c:pt>
                <c:pt idx="1438">
                  <c:v>0</c:v>
                </c:pt>
                <c:pt idx="1439">
                  <c:v>0</c:v>
                </c:pt>
                <c:pt idx="1440">
                  <c:v>0</c:v>
                </c:pt>
                <c:pt idx="1441">
                  <c:v>0</c:v>
                </c:pt>
                <c:pt idx="1442">
                  <c:v>0</c:v>
                </c:pt>
                <c:pt idx="1443">
                  <c:v>0</c:v>
                </c:pt>
                <c:pt idx="1444">
                  <c:v>0</c:v>
                </c:pt>
                <c:pt idx="1445">
                  <c:v>0</c:v>
                </c:pt>
                <c:pt idx="1446">
                  <c:v>0</c:v>
                </c:pt>
                <c:pt idx="1447">
                  <c:v>0</c:v>
                </c:pt>
                <c:pt idx="1448">
                  <c:v>0</c:v>
                </c:pt>
                <c:pt idx="1449">
                  <c:v>0</c:v>
                </c:pt>
                <c:pt idx="1450">
                  <c:v>0</c:v>
                </c:pt>
                <c:pt idx="1451">
                  <c:v>0</c:v>
                </c:pt>
                <c:pt idx="1452">
                  <c:v>0</c:v>
                </c:pt>
                <c:pt idx="1453">
                  <c:v>0</c:v>
                </c:pt>
                <c:pt idx="1454">
                  <c:v>0</c:v>
                </c:pt>
                <c:pt idx="1455">
                  <c:v>0</c:v>
                </c:pt>
                <c:pt idx="1456">
                  <c:v>0</c:v>
                </c:pt>
                <c:pt idx="1457">
                  <c:v>0</c:v>
                </c:pt>
                <c:pt idx="1458">
                  <c:v>0</c:v>
                </c:pt>
                <c:pt idx="1459">
                  <c:v>0</c:v>
                </c:pt>
                <c:pt idx="1460">
                  <c:v>0</c:v>
                </c:pt>
                <c:pt idx="1461">
                  <c:v>0</c:v>
                </c:pt>
                <c:pt idx="1462">
                  <c:v>0</c:v>
                </c:pt>
                <c:pt idx="1463">
                  <c:v>0</c:v>
                </c:pt>
                <c:pt idx="1464">
                  <c:v>0</c:v>
                </c:pt>
                <c:pt idx="1465">
                  <c:v>0</c:v>
                </c:pt>
                <c:pt idx="1466">
                  <c:v>0</c:v>
                </c:pt>
                <c:pt idx="1467">
                  <c:v>0</c:v>
                </c:pt>
                <c:pt idx="1468">
                  <c:v>0</c:v>
                </c:pt>
                <c:pt idx="1469">
                  <c:v>0</c:v>
                </c:pt>
                <c:pt idx="1470">
                  <c:v>0</c:v>
                </c:pt>
                <c:pt idx="1471">
                  <c:v>0</c:v>
                </c:pt>
                <c:pt idx="1472">
                  <c:v>0</c:v>
                </c:pt>
                <c:pt idx="1473">
                  <c:v>0</c:v>
                </c:pt>
                <c:pt idx="1474">
                  <c:v>0</c:v>
                </c:pt>
                <c:pt idx="1475">
                  <c:v>0</c:v>
                </c:pt>
                <c:pt idx="1476">
                  <c:v>0</c:v>
                </c:pt>
                <c:pt idx="1477">
                  <c:v>0</c:v>
                </c:pt>
                <c:pt idx="1478">
                  <c:v>0</c:v>
                </c:pt>
                <c:pt idx="1479">
                  <c:v>0</c:v>
                </c:pt>
                <c:pt idx="1480">
                  <c:v>0</c:v>
                </c:pt>
                <c:pt idx="1481">
                  <c:v>0</c:v>
                </c:pt>
                <c:pt idx="1482">
                  <c:v>0</c:v>
                </c:pt>
                <c:pt idx="1483">
                  <c:v>0</c:v>
                </c:pt>
                <c:pt idx="1484">
                  <c:v>0</c:v>
                </c:pt>
                <c:pt idx="1485">
                  <c:v>0</c:v>
                </c:pt>
                <c:pt idx="1486">
                  <c:v>0</c:v>
                </c:pt>
                <c:pt idx="1487">
                  <c:v>0</c:v>
                </c:pt>
                <c:pt idx="1488">
                  <c:v>0</c:v>
                </c:pt>
                <c:pt idx="1489">
                  <c:v>0</c:v>
                </c:pt>
                <c:pt idx="1490">
                  <c:v>0</c:v>
                </c:pt>
                <c:pt idx="1491">
                  <c:v>0</c:v>
                </c:pt>
                <c:pt idx="1492">
                  <c:v>0</c:v>
                </c:pt>
                <c:pt idx="1493">
                  <c:v>0</c:v>
                </c:pt>
                <c:pt idx="1494">
                  <c:v>0</c:v>
                </c:pt>
                <c:pt idx="1495">
                  <c:v>0</c:v>
                </c:pt>
                <c:pt idx="1496">
                  <c:v>0</c:v>
                </c:pt>
                <c:pt idx="1497">
                  <c:v>0</c:v>
                </c:pt>
                <c:pt idx="1498">
                  <c:v>0</c:v>
                </c:pt>
                <c:pt idx="1499">
                  <c:v>0</c:v>
                </c:pt>
                <c:pt idx="1500">
                  <c:v>0</c:v>
                </c:pt>
                <c:pt idx="1501">
                  <c:v>0</c:v>
                </c:pt>
                <c:pt idx="1502">
                  <c:v>0</c:v>
                </c:pt>
                <c:pt idx="1503">
                  <c:v>0</c:v>
                </c:pt>
                <c:pt idx="1504">
                  <c:v>0</c:v>
                </c:pt>
                <c:pt idx="1505">
                  <c:v>0</c:v>
                </c:pt>
                <c:pt idx="1506">
                  <c:v>0</c:v>
                </c:pt>
                <c:pt idx="1507">
                  <c:v>0</c:v>
                </c:pt>
                <c:pt idx="1508">
                  <c:v>0</c:v>
                </c:pt>
                <c:pt idx="1509">
                  <c:v>0</c:v>
                </c:pt>
                <c:pt idx="1510">
                  <c:v>0</c:v>
                </c:pt>
                <c:pt idx="1511">
                  <c:v>0</c:v>
                </c:pt>
                <c:pt idx="1512">
                  <c:v>0</c:v>
                </c:pt>
                <c:pt idx="1513">
                  <c:v>0</c:v>
                </c:pt>
                <c:pt idx="1514">
                  <c:v>0</c:v>
                </c:pt>
                <c:pt idx="1515">
                  <c:v>0</c:v>
                </c:pt>
                <c:pt idx="1516">
                  <c:v>0</c:v>
                </c:pt>
                <c:pt idx="1517">
                  <c:v>0</c:v>
                </c:pt>
                <c:pt idx="1518">
                  <c:v>0</c:v>
                </c:pt>
                <c:pt idx="1519">
                  <c:v>0</c:v>
                </c:pt>
                <c:pt idx="1520">
                  <c:v>0</c:v>
                </c:pt>
                <c:pt idx="1521">
                  <c:v>0</c:v>
                </c:pt>
                <c:pt idx="1522">
                  <c:v>0</c:v>
                </c:pt>
                <c:pt idx="1523">
                  <c:v>0</c:v>
                </c:pt>
                <c:pt idx="1524">
                  <c:v>0</c:v>
                </c:pt>
                <c:pt idx="1525">
                  <c:v>0</c:v>
                </c:pt>
                <c:pt idx="1526">
                  <c:v>0</c:v>
                </c:pt>
                <c:pt idx="1527">
                  <c:v>0</c:v>
                </c:pt>
                <c:pt idx="1528">
                  <c:v>0</c:v>
                </c:pt>
                <c:pt idx="1529">
                  <c:v>0</c:v>
                </c:pt>
                <c:pt idx="1530">
                  <c:v>0</c:v>
                </c:pt>
                <c:pt idx="1531">
                  <c:v>0</c:v>
                </c:pt>
                <c:pt idx="1532">
                  <c:v>0</c:v>
                </c:pt>
                <c:pt idx="1533">
                  <c:v>0</c:v>
                </c:pt>
                <c:pt idx="1534">
                  <c:v>0</c:v>
                </c:pt>
                <c:pt idx="1535">
                  <c:v>0</c:v>
                </c:pt>
                <c:pt idx="1536">
                  <c:v>0</c:v>
                </c:pt>
                <c:pt idx="1537">
                  <c:v>0</c:v>
                </c:pt>
                <c:pt idx="1538">
                  <c:v>0</c:v>
                </c:pt>
                <c:pt idx="1539">
                  <c:v>0</c:v>
                </c:pt>
                <c:pt idx="1540">
                  <c:v>0</c:v>
                </c:pt>
                <c:pt idx="1541">
                  <c:v>0</c:v>
                </c:pt>
                <c:pt idx="1542">
                  <c:v>0</c:v>
                </c:pt>
                <c:pt idx="1543">
                  <c:v>0</c:v>
                </c:pt>
                <c:pt idx="1544">
                  <c:v>0</c:v>
                </c:pt>
                <c:pt idx="1545">
                  <c:v>0</c:v>
                </c:pt>
                <c:pt idx="1546">
                  <c:v>0</c:v>
                </c:pt>
                <c:pt idx="1547">
                  <c:v>0</c:v>
                </c:pt>
                <c:pt idx="1548">
                  <c:v>0</c:v>
                </c:pt>
                <c:pt idx="1549">
                  <c:v>0</c:v>
                </c:pt>
                <c:pt idx="1550">
                  <c:v>0</c:v>
                </c:pt>
                <c:pt idx="1551">
                  <c:v>0</c:v>
                </c:pt>
                <c:pt idx="1552">
                  <c:v>0</c:v>
                </c:pt>
                <c:pt idx="1553">
                  <c:v>0</c:v>
                </c:pt>
                <c:pt idx="1554">
                  <c:v>0</c:v>
                </c:pt>
                <c:pt idx="1555">
                  <c:v>0</c:v>
                </c:pt>
                <c:pt idx="1556">
                  <c:v>0</c:v>
                </c:pt>
                <c:pt idx="1557">
                  <c:v>0</c:v>
                </c:pt>
                <c:pt idx="1558">
                  <c:v>0</c:v>
                </c:pt>
                <c:pt idx="1559">
                  <c:v>0</c:v>
                </c:pt>
                <c:pt idx="1560">
                  <c:v>0</c:v>
                </c:pt>
                <c:pt idx="1561">
                  <c:v>0</c:v>
                </c:pt>
                <c:pt idx="1562">
                  <c:v>0</c:v>
                </c:pt>
                <c:pt idx="1563">
                  <c:v>0</c:v>
                </c:pt>
                <c:pt idx="1564">
                  <c:v>0</c:v>
                </c:pt>
                <c:pt idx="1565">
                  <c:v>0</c:v>
                </c:pt>
                <c:pt idx="1566">
                  <c:v>0</c:v>
                </c:pt>
                <c:pt idx="1567">
                  <c:v>0</c:v>
                </c:pt>
                <c:pt idx="1568">
                  <c:v>0</c:v>
                </c:pt>
                <c:pt idx="1569">
                  <c:v>0</c:v>
                </c:pt>
                <c:pt idx="1570">
                  <c:v>0</c:v>
                </c:pt>
                <c:pt idx="1571">
                  <c:v>0</c:v>
                </c:pt>
                <c:pt idx="1572">
                  <c:v>0</c:v>
                </c:pt>
                <c:pt idx="1573">
                  <c:v>0</c:v>
                </c:pt>
                <c:pt idx="1574">
                  <c:v>0</c:v>
                </c:pt>
                <c:pt idx="1575">
                  <c:v>0</c:v>
                </c:pt>
                <c:pt idx="1576">
                  <c:v>0</c:v>
                </c:pt>
                <c:pt idx="1577">
                  <c:v>0</c:v>
                </c:pt>
                <c:pt idx="1578">
                  <c:v>0</c:v>
                </c:pt>
                <c:pt idx="1579">
                  <c:v>0</c:v>
                </c:pt>
                <c:pt idx="1580">
                  <c:v>0</c:v>
                </c:pt>
                <c:pt idx="1581">
                  <c:v>0</c:v>
                </c:pt>
                <c:pt idx="1582">
                  <c:v>0</c:v>
                </c:pt>
                <c:pt idx="1583">
                  <c:v>0</c:v>
                </c:pt>
                <c:pt idx="1584">
                  <c:v>0</c:v>
                </c:pt>
                <c:pt idx="1585">
                  <c:v>0</c:v>
                </c:pt>
                <c:pt idx="1586">
                  <c:v>0</c:v>
                </c:pt>
                <c:pt idx="1587">
                  <c:v>0</c:v>
                </c:pt>
                <c:pt idx="1588">
                  <c:v>0</c:v>
                </c:pt>
                <c:pt idx="1589">
                  <c:v>0</c:v>
                </c:pt>
                <c:pt idx="1590">
                  <c:v>0</c:v>
                </c:pt>
                <c:pt idx="1591">
                  <c:v>0</c:v>
                </c:pt>
                <c:pt idx="1592">
                  <c:v>0</c:v>
                </c:pt>
                <c:pt idx="1593">
                  <c:v>0</c:v>
                </c:pt>
                <c:pt idx="1594">
                  <c:v>0</c:v>
                </c:pt>
                <c:pt idx="1595">
                  <c:v>0</c:v>
                </c:pt>
                <c:pt idx="1596">
                  <c:v>0</c:v>
                </c:pt>
                <c:pt idx="1597">
                  <c:v>0</c:v>
                </c:pt>
                <c:pt idx="1598">
                  <c:v>0</c:v>
                </c:pt>
                <c:pt idx="1599">
                  <c:v>0</c:v>
                </c:pt>
                <c:pt idx="1600">
                  <c:v>0</c:v>
                </c:pt>
                <c:pt idx="1601">
                  <c:v>0</c:v>
                </c:pt>
                <c:pt idx="1602">
                  <c:v>0</c:v>
                </c:pt>
                <c:pt idx="1603">
                  <c:v>0</c:v>
                </c:pt>
                <c:pt idx="1604">
                  <c:v>0</c:v>
                </c:pt>
                <c:pt idx="1605">
                  <c:v>0</c:v>
                </c:pt>
                <c:pt idx="1606">
                  <c:v>0</c:v>
                </c:pt>
                <c:pt idx="1607">
                  <c:v>0</c:v>
                </c:pt>
                <c:pt idx="1608">
                  <c:v>0</c:v>
                </c:pt>
                <c:pt idx="1609">
                  <c:v>0</c:v>
                </c:pt>
                <c:pt idx="1610">
                  <c:v>0</c:v>
                </c:pt>
                <c:pt idx="1611">
                  <c:v>0</c:v>
                </c:pt>
                <c:pt idx="1612">
                  <c:v>0</c:v>
                </c:pt>
                <c:pt idx="1613">
                  <c:v>0</c:v>
                </c:pt>
                <c:pt idx="1614">
                  <c:v>0</c:v>
                </c:pt>
                <c:pt idx="1615">
                  <c:v>0</c:v>
                </c:pt>
                <c:pt idx="1616">
                  <c:v>0</c:v>
                </c:pt>
                <c:pt idx="1617">
                  <c:v>0</c:v>
                </c:pt>
                <c:pt idx="1618">
                  <c:v>0</c:v>
                </c:pt>
                <c:pt idx="1619">
                  <c:v>0</c:v>
                </c:pt>
                <c:pt idx="1620">
                  <c:v>0</c:v>
                </c:pt>
                <c:pt idx="1621">
                  <c:v>0</c:v>
                </c:pt>
                <c:pt idx="1622">
                  <c:v>0</c:v>
                </c:pt>
                <c:pt idx="1623">
                  <c:v>0</c:v>
                </c:pt>
                <c:pt idx="1624">
                  <c:v>0</c:v>
                </c:pt>
                <c:pt idx="1625">
                  <c:v>0</c:v>
                </c:pt>
                <c:pt idx="1626">
                  <c:v>0</c:v>
                </c:pt>
                <c:pt idx="1627">
                  <c:v>0</c:v>
                </c:pt>
                <c:pt idx="1628">
                  <c:v>0</c:v>
                </c:pt>
                <c:pt idx="1629">
                  <c:v>0</c:v>
                </c:pt>
                <c:pt idx="1630">
                  <c:v>0</c:v>
                </c:pt>
                <c:pt idx="1631">
                  <c:v>0</c:v>
                </c:pt>
                <c:pt idx="1632">
                  <c:v>0</c:v>
                </c:pt>
                <c:pt idx="1633">
                  <c:v>0</c:v>
                </c:pt>
                <c:pt idx="1634">
                  <c:v>0</c:v>
                </c:pt>
                <c:pt idx="1635">
                  <c:v>0</c:v>
                </c:pt>
                <c:pt idx="1636">
                  <c:v>0</c:v>
                </c:pt>
                <c:pt idx="1637">
                  <c:v>0</c:v>
                </c:pt>
                <c:pt idx="1638">
                  <c:v>0</c:v>
                </c:pt>
                <c:pt idx="1639">
                  <c:v>0</c:v>
                </c:pt>
                <c:pt idx="1640">
                  <c:v>0</c:v>
                </c:pt>
                <c:pt idx="1641">
                  <c:v>0</c:v>
                </c:pt>
                <c:pt idx="1642">
                  <c:v>0</c:v>
                </c:pt>
                <c:pt idx="1643">
                  <c:v>0</c:v>
                </c:pt>
                <c:pt idx="1644">
                  <c:v>0</c:v>
                </c:pt>
                <c:pt idx="1645">
                  <c:v>0</c:v>
                </c:pt>
                <c:pt idx="1646">
                  <c:v>0</c:v>
                </c:pt>
                <c:pt idx="1647">
                  <c:v>0</c:v>
                </c:pt>
                <c:pt idx="1648">
                  <c:v>0</c:v>
                </c:pt>
                <c:pt idx="1649">
                  <c:v>0</c:v>
                </c:pt>
                <c:pt idx="1650">
                  <c:v>0</c:v>
                </c:pt>
                <c:pt idx="1651">
                  <c:v>0</c:v>
                </c:pt>
                <c:pt idx="1652">
                  <c:v>0</c:v>
                </c:pt>
                <c:pt idx="1653">
                  <c:v>0</c:v>
                </c:pt>
                <c:pt idx="1654">
                  <c:v>0</c:v>
                </c:pt>
                <c:pt idx="1655">
                  <c:v>0</c:v>
                </c:pt>
                <c:pt idx="1656">
                  <c:v>0</c:v>
                </c:pt>
                <c:pt idx="1657">
                  <c:v>0</c:v>
                </c:pt>
                <c:pt idx="1658">
                  <c:v>0</c:v>
                </c:pt>
                <c:pt idx="1659">
                  <c:v>0</c:v>
                </c:pt>
                <c:pt idx="1660">
                  <c:v>0</c:v>
                </c:pt>
                <c:pt idx="1661">
                  <c:v>0</c:v>
                </c:pt>
                <c:pt idx="1662">
                  <c:v>0</c:v>
                </c:pt>
                <c:pt idx="1663">
                  <c:v>0</c:v>
                </c:pt>
                <c:pt idx="1664">
                  <c:v>0</c:v>
                </c:pt>
                <c:pt idx="1665">
                  <c:v>0</c:v>
                </c:pt>
                <c:pt idx="1666">
                  <c:v>0</c:v>
                </c:pt>
                <c:pt idx="1667">
                  <c:v>0</c:v>
                </c:pt>
                <c:pt idx="1668">
                  <c:v>0</c:v>
                </c:pt>
                <c:pt idx="1669">
                  <c:v>0</c:v>
                </c:pt>
                <c:pt idx="1670">
                  <c:v>0</c:v>
                </c:pt>
                <c:pt idx="1671">
                  <c:v>0</c:v>
                </c:pt>
                <c:pt idx="1672">
                  <c:v>0</c:v>
                </c:pt>
                <c:pt idx="1673">
                  <c:v>0</c:v>
                </c:pt>
                <c:pt idx="1674">
                  <c:v>0</c:v>
                </c:pt>
                <c:pt idx="1675">
                  <c:v>0</c:v>
                </c:pt>
                <c:pt idx="1676">
                  <c:v>0</c:v>
                </c:pt>
                <c:pt idx="1677">
                  <c:v>0</c:v>
                </c:pt>
                <c:pt idx="1678">
                  <c:v>0</c:v>
                </c:pt>
                <c:pt idx="1679">
                  <c:v>0</c:v>
                </c:pt>
                <c:pt idx="1680">
                  <c:v>0</c:v>
                </c:pt>
                <c:pt idx="1681">
                  <c:v>0</c:v>
                </c:pt>
                <c:pt idx="1682">
                  <c:v>0</c:v>
                </c:pt>
                <c:pt idx="1683">
                  <c:v>0</c:v>
                </c:pt>
                <c:pt idx="1684">
                  <c:v>0</c:v>
                </c:pt>
                <c:pt idx="1685">
                  <c:v>0</c:v>
                </c:pt>
                <c:pt idx="1686">
                  <c:v>0</c:v>
                </c:pt>
                <c:pt idx="1687">
                  <c:v>0</c:v>
                </c:pt>
                <c:pt idx="1688">
                  <c:v>0</c:v>
                </c:pt>
                <c:pt idx="1689">
                  <c:v>0</c:v>
                </c:pt>
                <c:pt idx="1690">
                  <c:v>0</c:v>
                </c:pt>
                <c:pt idx="1691">
                  <c:v>0</c:v>
                </c:pt>
                <c:pt idx="1692">
                  <c:v>0</c:v>
                </c:pt>
                <c:pt idx="1693">
                  <c:v>0</c:v>
                </c:pt>
                <c:pt idx="1694">
                  <c:v>0</c:v>
                </c:pt>
                <c:pt idx="1695">
                  <c:v>0</c:v>
                </c:pt>
                <c:pt idx="1696">
                  <c:v>0</c:v>
                </c:pt>
                <c:pt idx="1697">
                  <c:v>0</c:v>
                </c:pt>
                <c:pt idx="1698">
                  <c:v>0</c:v>
                </c:pt>
                <c:pt idx="1699">
                  <c:v>0</c:v>
                </c:pt>
                <c:pt idx="1700">
                  <c:v>0</c:v>
                </c:pt>
                <c:pt idx="1701">
                  <c:v>0</c:v>
                </c:pt>
                <c:pt idx="1702">
                  <c:v>0</c:v>
                </c:pt>
                <c:pt idx="1703">
                  <c:v>0</c:v>
                </c:pt>
                <c:pt idx="1704">
                  <c:v>0</c:v>
                </c:pt>
                <c:pt idx="1705">
                  <c:v>0</c:v>
                </c:pt>
                <c:pt idx="1706">
                  <c:v>0</c:v>
                </c:pt>
                <c:pt idx="1707">
                  <c:v>0</c:v>
                </c:pt>
                <c:pt idx="1708">
                  <c:v>0</c:v>
                </c:pt>
                <c:pt idx="1709">
                  <c:v>0</c:v>
                </c:pt>
                <c:pt idx="1710">
                  <c:v>0</c:v>
                </c:pt>
                <c:pt idx="1711">
                  <c:v>0</c:v>
                </c:pt>
                <c:pt idx="1712">
                  <c:v>0</c:v>
                </c:pt>
                <c:pt idx="1713">
                  <c:v>0</c:v>
                </c:pt>
                <c:pt idx="1714">
                  <c:v>0</c:v>
                </c:pt>
                <c:pt idx="1715">
                  <c:v>0</c:v>
                </c:pt>
                <c:pt idx="1716">
                  <c:v>0</c:v>
                </c:pt>
                <c:pt idx="1717">
                  <c:v>0</c:v>
                </c:pt>
                <c:pt idx="1718">
                  <c:v>0</c:v>
                </c:pt>
                <c:pt idx="1719">
                  <c:v>0</c:v>
                </c:pt>
                <c:pt idx="1720">
                  <c:v>0</c:v>
                </c:pt>
                <c:pt idx="1721">
                  <c:v>0</c:v>
                </c:pt>
                <c:pt idx="1722">
                  <c:v>0</c:v>
                </c:pt>
                <c:pt idx="1723">
                  <c:v>0</c:v>
                </c:pt>
                <c:pt idx="1724">
                  <c:v>0</c:v>
                </c:pt>
                <c:pt idx="1725">
                  <c:v>0</c:v>
                </c:pt>
                <c:pt idx="1726">
                  <c:v>0</c:v>
                </c:pt>
                <c:pt idx="1727">
                  <c:v>0</c:v>
                </c:pt>
                <c:pt idx="1728">
                  <c:v>0</c:v>
                </c:pt>
                <c:pt idx="1729">
                  <c:v>0</c:v>
                </c:pt>
                <c:pt idx="1730">
                  <c:v>0</c:v>
                </c:pt>
                <c:pt idx="1731">
                  <c:v>0</c:v>
                </c:pt>
                <c:pt idx="1732">
                  <c:v>0</c:v>
                </c:pt>
                <c:pt idx="1733">
                  <c:v>0</c:v>
                </c:pt>
                <c:pt idx="1734">
                  <c:v>0</c:v>
                </c:pt>
                <c:pt idx="1735">
                  <c:v>0</c:v>
                </c:pt>
                <c:pt idx="1736">
                  <c:v>0</c:v>
                </c:pt>
                <c:pt idx="1737">
                  <c:v>0</c:v>
                </c:pt>
                <c:pt idx="1738">
                  <c:v>0</c:v>
                </c:pt>
                <c:pt idx="1739">
                  <c:v>0</c:v>
                </c:pt>
                <c:pt idx="1740">
                  <c:v>0</c:v>
                </c:pt>
                <c:pt idx="1741">
                  <c:v>0</c:v>
                </c:pt>
                <c:pt idx="1742">
                  <c:v>0</c:v>
                </c:pt>
                <c:pt idx="1743">
                  <c:v>0</c:v>
                </c:pt>
                <c:pt idx="1744">
                  <c:v>0</c:v>
                </c:pt>
                <c:pt idx="1745">
                  <c:v>0</c:v>
                </c:pt>
                <c:pt idx="1746">
                  <c:v>0</c:v>
                </c:pt>
                <c:pt idx="1747">
                  <c:v>0</c:v>
                </c:pt>
                <c:pt idx="1748">
                  <c:v>0</c:v>
                </c:pt>
                <c:pt idx="1749">
                  <c:v>0</c:v>
                </c:pt>
                <c:pt idx="1750">
                  <c:v>0</c:v>
                </c:pt>
                <c:pt idx="1751">
                  <c:v>0</c:v>
                </c:pt>
                <c:pt idx="1752">
                  <c:v>0</c:v>
                </c:pt>
                <c:pt idx="1753">
                  <c:v>0</c:v>
                </c:pt>
                <c:pt idx="1754">
                  <c:v>0</c:v>
                </c:pt>
                <c:pt idx="1755">
                  <c:v>0</c:v>
                </c:pt>
                <c:pt idx="1756">
                  <c:v>0</c:v>
                </c:pt>
                <c:pt idx="1757">
                  <c:v>0</c:v>
                </c:pt>
                <c:pt idx="1758">
                  <c:v>0</c:v>
                </c:pt>
                <c:pt idx="1759">
                  <c:v>0</c:v>
                </c:pt>
                <c:pt idx="1760">
                  <c:v>0</c:v>
                </c:pt>
                <c:pt idx="1761">
                  <c:v>0</c:v>
                </c:pt>
                <c:pt idx="1762">
                  <c:v>0</c:v>
                </c:pt>
                <c:pt idx="1763">
                  <c:v>0</c:v>
                </c:pt>
                <c:pt idx="1764">
                  <c:v>0</c:v>
                </c:pt>
                <c:pt idx="1765">
                  <c:v>0</c:v>
                </c:pt>
                <c:pt idx="1766">
                  <c:v>0</c:v>
                </c:pt>
                <c:pt idx="1767">
                  <c:v>0</c:v>
                </c:pt>
                <c:pt idx="1768">
                  <c:v>0</c:v>
                </c:pt>
                <c:pt idx="1769">
                  <c:v>0</c:v>
                </c:pt>
                <c:pt idx="1770">
                  <c:v>0</c:v>
                </c:pt>
                <c:pt idx="1771">
                  <c:v>0</c:v>
                </c:pt>
                <c:pt idx="1772">
                  <c:v>0</c:v>
                </c:pt>
                <c:pt idx="1773">
                  <c:v>0</c:v>
                </c:pt>
                <c:pt idx="1774">
                  <c:v>0</c:v>
                </c:pt>
                <c:pt idx="1775">
                  <c:v>0</c:v>
                </c:pt>
                <c:pt idx="1776">
                  <c:v>0</c:v>
                </c:pt>
                <c:pt idx="1777">
                  <c:v>0</c:v>
                </c:pt>
                <c:pt idx="1778">
                  <c:v>0</c:v>
                </c:pt>
                <c:pt idx="1779">
                  <c:v>0</c:v>
                </c:pt>
                <c:pt idx="1780">
                  <c:v>0</c:v>
                </c:pt>
                <c:pt idx="1781">
                  <c:v>0</c:v>
                </c:pt>
                <c:pt idx="1782">
                  <c:v>0</c:v>
                </c:pt>
                <c:pt idx="1783">
                  <c:v>0</c:v>
                </c:pt>
                <c:pt idx="1784">
                  <c:v>0</c:v>
                </c:pt>
                <c:pt idx="1785">
                  <c:v>0</c:v>
                </c:pt>
                <c:pt idx="1786">
                  <c:v>0</c:v>
                </c:pt>
                <c:pt idx="1787">
                  <c:v>0</c:v>
                </c:pt>
                <c:pt idx="1788">
                  <c:v>0</c:v>
                </c:pt>
                <c:pt idx="1789">
                  <c:v>0</c:v>
                </c:pt>
                <c:pt idx="1790">
                  <c:v>0</c:v>
                </c:pt>
                <c:pt idx="1791">
                  <c:v>0</c:v>
                </c:pt>
                <c:pt idx="1792">
                  <c:v>0</c:v>
                </c:pt>
                <c:pt idx="1793">
                  <c:v>0</c:v>
                </c:pt>
                <c:pt idx="1794">
                  <c:v>0</c:v>
                </c:pt>
                <c:pt idx="1795">
                  <c:v>0</c:v>
                </c:pt>
                <c:pt idx="1796">
                  <c:v>0</c:v>
                </c:pt>
                <c:pt idx="1797">
                  <c:v>0</c:v>
                </c:pt>
                <c:pt idx="1798">
                  <c:v>0</c:v>
                </c:pt>
                <c:pt idx="1799">
                  <c:v>0</c:v>
                </c:pt>
                <c:pt idx="1800">
                  <c:v>0</c:v>
                </c:pt>
                <c:pt idx="1801">
                  <c:v>0</c:v>
                </c:pt>
                <c:pt idx="1802">
                  <c:v>0</c:v>
                </c:pt>
                <c:pt idx="1803">
                  <c:v>0</c:v>
                </c:pt>
                <c:pt idx="1804">
                  <c:v>0</c:v>
                </c:pt>
                <c:pt idx="1805">
                  <c:v>0</c:v>
                </c:pt>
                <c:pt idx="1806">
                  <c:v>0</c:v>
                </c:pt>
                <c:pt idx="1807">
                  <c:v>0</c:v>
                </c:pt>
                <c:pt idx="1808">
                  <c:v>0</c:v>
                </c:pt>
                <c:pt idx="1809">
                  <c:v>0</c:v>
                </c:pt>
                <c:pt idx="1810">
                  <c:v>0</c:v>
                </c:pt>
                <c:pt idx="1811">
                  <c:v>0</c:v>
                </c:pt>
                <c:pt idx="1812">
                  <c:v>0</c:v>
                </c:pt>
                <c:pt idx="1813">
                  <c:v>0</c:v>
                </c:pt>
                <c:pt idx="1814">
                  <c:v>0</c:v>
                </c:pt>
                <c:pt idx="1815">
                  <c:v>0</c:v>
                </c:pt>
                <c:pt idx="1816">
                  <c:v>0</c:v>
                </c:pt>
                <c:pt idx="1817">
                  <c:v>0</c:v>
                </c:pt>
                <c:pt idx="1818">
                  <c:v>0</c:v>
                </c:pt>
                <c:pt idx="1819">
                  <c:v>0</c:v>
                </c:pt>
                <c:pt idx="1820">
                  <c:v>0</c:v>
                </c:pt>
                <c:pt idx="1821">
                  <c:v>0</c:v>
                </c:pt>
                <c:pt idx="1822">
                  <c:v>0</c:v>
                </c:pt>
                <c:pt idx="1823">
                  <c:v>0</c:v>
                </c:pt>
                <c:pt idx="1824">
                  <c:v>0</c:v>
                </c:pt>
                <c:pt idx="1825">
                  <c:v>0</c:v>
                </c:pt>
                <c:pt idx="1826">
                  <c:v>0</c:v>
                </c:pt>
                <c:pt idx="1827">
                  <c:v>0</c:v>
                </c:pt>
                <c:pt idx="1828">
                  <c:v>0</c:v>
                </c:pt>
                <c:pt idx="1829">
                  <c:v>0</c:v>
                </c:pt>
                <c:pt idx="1830">
                  <c:v>0</c:v>
                </c:pt>
                <c:pt idx="1831">
                  <c:v>0</c:v>
                </c:pt>
                <c:pt idx="1832">
                  <c:v>0</c:v>
                </c:pt>
                <c:pt idx="1833">
                  <c:v>0</c:v>
                </c:pt>
                <c:pt idx="1834">
                  <c:v>0</c:v>
                </c:pt>
                <c:pt idx="1835">
                  <c:v>0</c:v>
                </c:pt>
                <c:pt idx="1836">
                  <c:v>0</c:v>
                </c:pt>
                <c:pt idx="1837">
                  <c:v>0</c:v>
                </c:pt>
                <c:pt idx="1838">
                  <c:v>0</c:v>
                </c:pt>
                <c:pt idx="1839">
                  <c:v>0</c:v>
                </c:pt>
                <c:pt idx="1840">
                  <c:v>0</c:v>
                </c:pt>
                <c:pt idx="1841">
                  <c:v>0</c:v>
                </c:pt>
                <c:pt idx="1842">
                  <c:v>0</c:v>
                </c:pt>
                <c:pt idx="1843">
                  <c:v>0</c:v>
                </c:pt>
                <c:pt idx="1844">
                  <c:v>0</c:v>
                </c:pt>
                <c:pt idx="1845">
                  <c:v>0</c:v>
                </c:pt>
                <c:pt idx="1846">
                  <c:v>0</c:v>
                </c:pt>
                <c:pt idx="1847">
                  <c:v>0</c:v>
                </c:pt>
                <c:pt idx="1848">
                  <c:v>0</c:v>
                </c:pt>
                <c:pt idx="1849">
                  <c:v>0</c:v>
                </c:pt>
                <c:pt idx="1850">
                  <c:v>0</c:v>
                </c:pt>
                <c:pt idx="1851">
                  <c:v>0</c:v>
                </c:pt>
                <c:pt idx="1852">
                  <c:v>0</c:v>
                </c:pt>
                <c:pt idx="1853">
                  <c:v>0</c:v>
                </c:pt>
                <c:pt idx="1854">
                  <c:v>0</c:v>
                </c:pt>
                <c:pt idx="1855">
                  <c:v>0</c:v>
                </c:pt>
                <c:pt idx="1856">
                  <c:v>0</c:v>
                </c:pt>
                <c:pt idx="1857">
                  <c:v>0</c:v>
                </c:pt>
                <c:pt idx="1858">
                  <c:v>0</c:v>
                </c:pt>
                <c:pt idx="1859">
                  <c:v>0</c:v>
                </c:pt>
                <c:pt idx="1860">
                  <c:v>0</c:v>
                </c:pt>
                <c:pt idx="1861">
                  <c:v>0</c:v>
                </c:pt>
                <c:pt idx="1862">
                  <c:v>0</c:v>
                </c:pt>
                <c:pt idx="1863">
                  <c:v>0</c:v>
                </c:pt>
                <c:pt idx="1864">
                  <c:v>0</c:v>
                </c:pt>
                <c:pt idx="1865">
                  <c:v>0</c:v>
                </c:pt>
                <c:pt idx="1866">
                  <c:v>0</c:v>
                </c:pt>
                <c:pt idx="1867">
                  <c:v>0</c:v>
                </c:pt>
                <c:pt idx="1868">
                  <c:v>0</c:v>
                </c:pt>
                <c:pt idx="1869">
                  <c:v>0</c:v>
                </c:pt>
                <c:pt idx="1870">
                  <c:v>0</c:v>
                </c:pt>
                <c:pt idx="1871">
                  <c:v>0</c:v>
                </c:pt>
                <c:pt idx="1872">
                  <c:v>0</c:v>
                </c:pt>
                <c:pt idx="1873">
                  <c:v>0</c:v>
                </c:pt>
                <c:pt idx="1874">
                  <c:v>0</c:v>
                </c:pt>
                <c:pt idx="1875">
                  <c:v>0</c:v>
                </c:pt>
                <c:pt idx="1876">
                  <c:v>0</c:v>
                </c:pt>
                <c:pt idx="1877">
                  <c:v>0</c:v>
                </c:pt>
                <c:pt idx="1878">
                  <c:v>0</c:v>
                </c:pt>
                <c:pt idx="1879">
                  <c:v>0</c:v>
                </c:pt>
                <c:pt idx="1880">
                  <c:v>0</c:v>
                </c:pt>
                <c:pt idx="1881">
                  <c:v>0</c:v>
                </c:pt>
                <c:pt idx="1882">
                  <c:v>0</c:v>
                </c:pt>
                <c:pt idx="1883">
                  <c:v>0</c:v>
                </c:pt>
                <c:pt idx="1884">
                  <c:v>0</c:v>
                </c:pt>
                <c:pt idx="1885">
                  <c:v>0</c:v>
                </c:pt>
                <c:pt idx="1886">
                  <c:v>0</c:v>
                </c:pt>
                <c:pt idx="1887">
                  <c:v>0</c:v>
                </c:pt>
                <c:pt idx="1888">
                  <c:v>0</c:v>
                </c:pt>
                <c:pt idx="1889">
                  <c:v>0</c:v>
                </c:pt>
                <c:pt idx="1890">
                  <c:v>0</c:v>
                </c:pt>
                <c:pt idx="1891">
                  <c:v>0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546D-485A-824E-7A2263221CE5}"/>
            </c:ext>
          </c:extLst>
        </c:ser>
        <c:ser>
          <c:idx val="1"/>
          <c:order val="1"/>
          <c:tx>
            <c:strRef>
              <c:f>Sheet1!$D$1</c:f>
              <c:strCache>
                <c:ptCount val="1"/>
                <c:pt idx="0">
                  <c:v>MAS98.12</c:v>
                </c:pt>
              </c:strCache>
            </c:strRef>
          </c:tx>
          <c:spPr>
            <a:ln w="19050" cap="rnd">
              <a:solidFill>
                <a:schemeClr val="accent1">
                  <a:lumMod val="75000"/>
                </a:schemeClr>
              </a:solidFill>
              <a:round/>
            </a:ln>
            <a:effectLst/>
          </c:spPr>
          <c:marker>
            <c:symbol val="none"/>
          </c:marker>
          <c:xVal>
            <c:numRef>
              <c:f>Sheet1!$B$2:$B$1893</c:f>
              <c:numCache>
                <c:formatCode>General</c:formatCode>
                <c:ptCount val="1892"/>
                <c:pt idx="0">
                  <c:v>185.38874724170299</c:v>
                </c:pt>
                <c:pt idx="1">
                  <c:v>185.381086990184</c:v>
                </c:pt>
                <c:pt idx="2">
                  <c:v>185.37342673866601</c:v>
                </c:pt>
                <c:pt idx="3">
                  <c:v>185.365766487147</c:v>
                </c:pt>
                <c:pt idx="4">
                  <c:v>185.35810623562799</c:v>
                </c:pt>
                <c:pt idx="5">
                  <c:v>185.350445984109</c:v>
                </c:pt>
                <c:pt idx="6">
                  <c:v>185.34278573258999</c:v>
                </c:pt>
                <c:pt idx="7">
                  <c:v>185.335125481071</c:v>
                </c:pt>
                <c:pt idx="8">
                  <c:v>185.32746522955301</c:v>
                </c:pt>
                <c:pt idx="9">
                  <c:v>185.319804978034</c:v>
                </c:pt>
                <c:pt idx="10">
                  <c:v>185.31214472651499</c:v>
                </c:pt>
                <c:pt idx="11">
                  <c:v>185.304484474996</c:v>
                </c:pt>
                <c:pt idx="12">
                  <c:v>185.29682422347699</c:v>
                </c:pt>
                <c:pt idx="13">
                  <c:v>185.289163971959</c:v>
                </c:pt>
                <c:pt idx="14">
                  <c:v>185.28150372044001</c:v>
                </c:pt>
                <c:pt idx="15">
                  <c:v>185.273843468921</c:v>
                </c:pt>
                <c:pt idx="16">
                  <c:v>185.26618321740199</c:v>
                </c:pt>
                <c:pt idx="17">
                  <c:v>185.258522965883</c:v>
                </c:pt>
                <c:pt idx="18">
                  <c:v>185.25086271436399</c:v>
                </c:pt>
                <c:pt idx="19">
                  <c:v>185.243202462846</c:v>
                </c:pt>
                <c:pt idx="20">
                  <c:v>185.23554221132699</c:v>
                </c:pt>
                <c:pt idx="21">
                  <c:v>185.227881959808</c:v>
                </c:pt>
                <c:pt idx="22">
                  <c:v>185.22022170828899</c:v>
                </c:pt>
                <c:pt idx="23">
                  <c:v>185.21256145677</c:v>
                </c:pt>
                <c:pt idx="24">
                  <c:v>185.20490120525099</c:v>
                </c:pt>
                <c:pt idx="25">
                  <c:v>185.197240953733</c:v>
                </c:pt>
                <c:pt idx="26">
                  <c:v>185.18958070221399</c:v>
                </c:pt>
                <c:pt idx="27">
                  <c:v>184.048203225908</c:v>
                </c:pt>
                <c:pt idx="28">
                  <c:v>184.04054297438901</c:v>
                </c:pt>
                <c:pt idx="29">
                  <c:v>184.03288272287099</c:v>
                </c:pt>
                <c:pt idx="30">
                  <c:v>184.02522247135201</c:v>
                </c:pt>
                <c:pt idx="31">
                  <c:v>184.017562219833</c:v>
                </c:pt>
                <c:pt idx="32">
                  <c:v>184.00990196831401</c:v>
                </c:pt>
                <c:pt idx="33">
                  <c:v>184.002241716795</c:v>
                </c:pt>
                <c:pt idx="34">
                  <c:v>183.99458146527601</c:v>
                </c:pt>
                <c:pt idx="35">
                  <c:v>183.986921213758</c:v>
                </c:pt>
                <c:pt idx="36">
                  <c:v>183.97926096223901</c:v>
                </c:pt>
                <c:pt idx="37">
                  <c:v>183.97160071072</c:v>
                </c:pt>
                <c:pt idx="38">
                  <c:v>183.96394045920101</c:v>
                </c:pt>
                <c:pt idx="39">
                  <c:v>183.956280207682</c:v>
                </c:pt>
                <c:pt idx="40">
                  <c:v>183.94861995616401</c:v>
                </c:pt>
                <c:pt idx="41">
                  <c:v>183.940959704645</c:v>
                </c:pt>
                <c:pt idx="42">
                  <c:v>183.93329945312601</c:v>
                </c:pt>
                <c:pt idx="43">
                  <c:v>183.925639201607</c:v>
                </c:pt>
                <c:pt idx="44">
                  <c:v>183.91797895008801</c:v>
                </c:pt>
                <c:pt idx="45">
                  <c:v>183.910318698569</c:v>
                </c:pt>
                <c:pt idx="46">
                  <c:v>183.90265844705101</c:v>
                </c:pt>
                <c:pt idx="47">
                  <c:v>183.894998195532</c:v>
                </c:pt>
                <c:pt idx="48">
                  <c:v>180.48618626965299</c:v>
                </c:pt>
                <c:pt idx="49">
                  <c:v>180.478526018134</c:v>
                </c:pt>
                <c:pt idx="50">
                  <c:v>180.47086576661499</c:v>
                </c:pt>
                <c:pt idx="51">
                  <c:v>180.46320551509601</c:v>
                </c:pt>
                <c:pt idx="52">
                  <c:v>180.45554526357799</c:v>
                </c:pt>
                <c:pt idx="53">
                  <c:v>180.447885012059</c:v>
                </c:pt>
                <c:pt idx="54">
                  <c:v>180.44022476053999</c:v>
                </c:pt>
                <c:pt idx="55">
                  <c:v>180.43256450902101</c:v>
                </c:pt>
                <c:pt idx="56">
                  <c:v>180.42490425750199</c:v>
                </c:pt>
                <c:pt idx="57">
                  <c:v>180.417244005984</c:v>
                </c:pt>
                <c:pt idx="58">
                  <c:v>180.40958375446499</c:v>
                </c:pt>
                <c:pt idx="59">
                  <c:v>180.401923502946</c:v>
                </c:pt>
                <c:pt idx="60">
                  <c:v>180.39426325142699</c:v>
                </c:pt>
                <c:pt idx="61">
                  <c:v>180.38660299990801</c:v>
                </c:pt>
                <c:pt idx="62">
                  <c:v>180.37894274838899</c:v>
                </c:pt>
                <c:pt idx="63">
                  <c:v>180.371282496871</c:v>
                </c:pt>
                <c:pt idx="64">
                  <c:v>180.36362224535199</c:v>
                </c:pt>
                <c:pt idx="65">
                  <c:v>180.35596199383301</c:v>
                </c:pt>
                <c:pt idx="66">
                  <c:v>180.34830174231399</c:v>
                </c:pt>
                <c:pt idx="67">
                  <c:v>180.34064149079501</c:v>
                </c:pt>
                <c:pt idx="68">
                  <c:v>180.33298123927599</c:v>
                </c:pt>
                <c:pt idx="69">
                  <c:v>180.325320987758</c:v>
                </c:pt>
                <c:pt idx="70">
                  <c:v>180.31766073623899</c:v>
                </c:pt>
                <c:pt idx="71">
                  <c:v>180.31000048472001</c:v>
                </c:pt>
                <c:pt idx="72">
                  <c:v>180.30234023320099</c:v>
                </c:pt>
                <c:pt idx="73">
                  <c:v>180.29467998168201</c:v>
                </c:pt>
                <c:pt idx="74">
                  <c:v>180.287019730163</c:v>
                </c:pt>
                <c:pt idx="75">
                  <c:v>180.27935947864501</c:v>
                </c:pt>
                <c:pt idx="76">
                  <c:v>180.27169922712599</c:v>
                </c:pt>
                <c:pt idx="77">
                  <c:v>180.26403897560701</c:v>
                </c:pt>
                <c:pt idx="78">
                  <c:v>180.25637872408799</c:v>
                </c:pt>
                <c:pt idx="79">
                  <c:v>180.24871847256901</c:v>
                </c:pt>
                <c:pt idx="80">
                  <c:v>180.24105822105</c:v>
                </c:pt>
                <c:pt idx="81">
                  <c:v>180.23339796953201</c:v>
                </c:pt>
                <c:pt idx="82">
                  <c:v>180.22573771801299</c:v>
                </c:pt>
                <c:pt idx="83">
                  <c:v>180.21807746649401</c:v>
                </c:pt>
                <c:pt idx="84">
                  <c:v>180.210417214975</c:v>
                </c:pt>
                <c:pt idx="85">
                  <c:v>180.20275696345601</c:v>
                </c:pt>
                <c:pt idx="86">
                  <c:v>180.195096711937</c:v>
                </c:pt>
                <c:pt idx="87">
                  <c:v>180.18743646041901</c:v>
                </c:pt>
                <c:pt idx="88">
                  <c:v>180.17977620889999</c:v>
                </c:pt>
                <c:pt idx="89">
                  <c:v>178.724328420322</c:v>
                </c:pt>
                <c:pt idx="90">
                  <c:v>178.71666816880401</c:v>
                </c:pt>
                <c:pt idx="91">
                  <c:v>178.70900791728499</c:v>
                </c:pt>
                <c:pt idx="92">
                  <c:v>178.70134766576601</c:v>
                </c:pt>
                <c:pt idx="93">
                  <c:v>178.69368741424699</c:v>
                </c:pt>
                <c:pt idx="94">
                  <c:v>178.68602716272801</c:v>
                </c:pt>
                <c:pt idx="95">
                  <c:v>178.678366911209</c:v>
                </c:pt>
                <c:pt idx="96">
                  <c:v>178.67070665969101</c:v>
                </c:pt>
                <c:pt idx="97">
                  <c:v>178.66304640817199</c:v>
                </c:pt>
                <c:pt idx="98">
                  <c:v>178.65538615665301</c:v>
                </c:pt>
                <c:pt idx="99">
                  <c:v>178.647725905134</c:v>
                </c:pt>
                <c:pt idx="100">
                  <c:v>178.64006565361501</c:v>
                </c:pt>
                <c:pt idx="101">
                  <c:v>178.632405402096</c:v>
                </c:pt>
                <c:pt idx="102">
                  <c:v>178.62474515057801</c:v>
                </c:pt>
                <c:pt idx="103">
                  <c:v>178.61708489905899</c:v>
                </c:pt>
                <c:pt idx="104">
                  <c:v>178.60942464754001</c:v>
                </c:pt>
                <c:pt idx="105">
                  <c:v>178.601764396021</c:v>
                </c:pt>
                <c:pt idx="106">
                  <c:v>178.59410414450201</c:v>
                </c:pt>
                <c:pt idx="107">
                  <c:v>178.586443892983</c:v>
                </c:pt>
                <c:pt idx="108">
                  <c:v>178.57878364146501</c:v>
                </c:pt>
                <c:pt idx="109">
                  <c:v>178.571123389946</c:v>
                </c:pt>
                <c:pt idx="110">
                  <c:v>178.56346313842701</c:v>
                </c:pt>
                <c:pt idx="111">
                  <c:v>178.555802886908</c:v>
                </c:pt>
                <c:pt idx="112">
                  <c:v>178.54814263538901</c:v>
                </c:pt>
                <c:pt idx="113">
                  <c:v>178.54048238387</c:v>
                </c:pt>
                <c:pt idx="114">
                  <c:v>178.53282213235201</c:v>
                </c:pt>
                <c:pt idx="115">
                  <c:v>177.38378440452701</c:v>
                </c:pt>
                <c:pt idx="116">
                  <c:v>177.37612415300899</c:v>
                </c:pt>
                <c:pt idx="117">
                  <c:v>177.36846390149</c:v>
                </c:pt>
                <c:pt idx="118">
                  <c:v>177.36080364997099</c:v>
                </c:pt>
                <c:pt idx="119">
                  <c:v>177.353143398452</c:v>
                </c:pt>
                <c:pt idx="120">
                  <c:v>177.34548314693299</c:v>
                </c:pt>
                <c:pt idx="121">
                  <c:v>177.33782289541401</c:v>
                </c:pt>
                <c:pt idx="122">
                  <c:v>177.33016264389599</c:v>
                </c:pt>
                <c:pt idx="123">
                  <c:v>177.322502392377</c:v>
                </c:pt>
                <c:pt idx="124">
                  <c:v>177.31484214085799</c:v>
                </c:pt>
                <c:pt idx="125">
                  <c:v>177.30718188933901</c:v>
                </c:pt>
                <c:pt idx="126">
                  <c:v>177.29952163781999</c:v>
                </c:pt>
                <c:pt idx="127">
                  <c:v>177.29186138630101</c:v>
                </c:pt>
                <c:pt idx="128">
                  <c:v>177.28420113478299</c:v>
                </c:pt>
                <c:pt idx="129">
                  <c:v>177.276540883264</c:v>
                </c:pt>
                <c:pt idx="130">
                  <c:v>177.26888063174499</c:v>
                </c:pt>
                <c:pt idx="131">
                  <c:v>176.92416931339801</c:v>
                </c:pt>
                <c:pt idx="132">
                  <c:v>176.916509061879</c:v>
                </c:pt>
                <c:pt idx="133">
                  <c:v>176.90884881036001</c:v>
                </c:pt>
                <c:pt idx="134">
                  <c:v>176.901188558841</c:v>
                </c:pt>
                <c:pt idx="135">
                  <c:v>176.89352830732199</c:v>
                </c:pt>
                <c:pt idx="136">
                  <c:v>176.885868055803</c:v>
                </c:pt>
                <c:pt idx="137">
                  <c:v>176.87820780428501</c:v>
                </c:pt>
                <c:pt idx="138">
                  <c:v>176.870547552766</c:v>
                </c:pt>
                <c:pt idx="139">
                  <c:v>176.86288730124701</c:v>
                </c:pt>
                <c:pt idx="140">
                  <c:v>176.855227049728</c:v>
                </c:pt>
                <c:pt idx="141">
                  <c:v>176.84756679820899</c:v>
                </c:pt>
                <c:pt idx="142">
                  <c:v>176.839906546691</c:v>
                </c:pt>
                <c:pt idx="143">
                  <c:v>176.83224629517201</c:v>
                </c:pt>
                <c:pt idx="144">
                  <c:v>176.824586043653</c:v>
                </c:pt>
                <c:pt idx="145">
                  <c:v>176.81692579213399</c:v>
                </c:pt>
                <c:pt idx="146">
                  <c:v>176.809265540615</c:v>
                </c:pt>
                <c:pt idx="147">
                  <c:v>176.80160528909599</c:v>
                </c:pt>
                <c:pt idx="148">
                  <c:v>176.793945037578</c:v>
                </c:pt>
                <c:pt idx="149">
                  <c:v>176.78628478605901</c:v>
                </c:pt>
                <c:pt idx="150">
                  <c:v>176.77862453454</c:v>
                </c:pt>
                <c:pt idx="151">
                  <c:v>176.77096428302099</c:v>
                </c:pt>
                <c:pt idx="152">
                  <c:v>175.430420267226</c:v>
                </c:pt>
                <c:pt idx="153">
                  <c:v>175.42276001570701</c:v>
                </c:pt>
                <c:pt idx="154">
                  <c:v>175.415099764188</c:v>
                </c:pt>
                <c:pt idx="155">
                  <c:v>175.40743951267001</c:v>
                </c:pt>
                <c:pt idx="156">
                  <c:v>175.399779261151</c:v>
                </c:pt>
                <c:pt idx="157">
                  <c:v>175.39211900963201</c:v>
                </c:pt>
                <c:pt idx="158">
                  <c:v>175.384458758113</c:v>
                </c:pt>
                <c:pt idx="159">
                  <c:v>175.37679850659401</c:v>
                </c:pt>
                <c:pt idx="160">
                  <c:v>175.369138255075</c:v>
                </c:pt>
                <c:pt idx="161">
                  <c:v>175.36147800355701</c:v>
                </c:pt>
                <c:pt idx="162">
                  <c:v>175.353817752038</c:v>
                </c:pt>
                <c:pt idx="163">
                  <c:v>175.34615750051901</c:v>
                </c:pt>
                <c:pt idx="164">
                  <c:v>175.338497249</c:v>
                </c:pt>
                <c:pt idx="165">
                  <c:v>175.33083699748099</c:v>
                </c:pt>
                <c:pt idx="166">
                  <c:v>175.323176745962</c:v>
                </c:pt>
                <c:pt idx="167">
                  <c:v>175.31551649444401</c:v>
                </c:pt>
                <c:pt idx="168">
                  <c:v>175.307856242925</c:v>
                </c:pt>
                <c:pt idx="169">
                  <c:v>175.30019599140601</c:v>
                </c:pt>
                <c:pt idx="170">
                  <c:v>175.292535739887</c:v>
                </c:pt>
                <c:pt idx="171">
                  <c:v>175.28487548836799</c:v>
                </c:pt>
                <c:pt idx="172">
                  <c:v>175.277215236849</c:v>
                </c:pt>
                <c:pt idx="173">
                  <c:v>175.26955498533101</c:v>
                </c:pt>
                <c:pt idx="174">
                  <c:v>175.261894733812</c:v>
                </c:pt>
                <c:pt idx="175">
                  <c:v>175.25423448229299</c:v>
                </c:pt>
                <c:pt idx="176">
                  <c:v>175.246574230774</c:v>
                </c:pt>
                <c:pt idx="177">
                  <c:v>175.23891397925499</c:v>
                </c:pt>
                <c:pt idx="178">
                  <c:v>175.231253727737</c:v>
                </c:pt>
                <c:pt idx="179">
                  <c:v>175.22359347621801</c:v>
                </c:pt>
                <c:pt idx="180">
                  <c:v>175.215933224699</c:v>
                </c:pt>
                <c:pt idx="181">
                  <c:v>175.20827297317999</c:v>
                </c:pt>
                <c:pt idx="182">
                  <c:v>175.200612721661</c:v>
                </c:pt>
                <c:pt idx="183">
                  <c:v>175.19295247014199</c:v>
                </c:pt>
                <c:pt idx="184">
                  <c:v>175.185292218624</c:v>
                </c:pt>
                <c:pt idx="185">
                  <c:v>175.17763196710499</c:v>
                </c:pt>
                <c:pt idx="186">
                  <c:v>175.169971715586</c:v>
                </c:pt>
                <c:pt idx="187">
                  <c:v>175.16231146406699</c:v>
                </c:pt>
                <c:pt idx="188">
                  <c:v>175.154651212548</c:v>
                </c:pt>
                <c:pt idx="189">
                  <c:v>175.14699096102899</c:v>
                </c:pt>
                <c:pt idx="190">
                  <c:v>175.139330709511</c:v>
                </c:pt>
                <c:pt idx="191">
                  <c:v>175.13167045799199</c:v>
                </c:pt>
                <c:pt idx="192">
                  <c:v>175.124010206473</c:v>
                </c:pt>
                <c:pt idx="193">
                  <c:v>175.11634995495399</c:v>
                </c:pt>
                <c:pt idx="194">
                  <c:v>174.58779260015501</c:v>
                </c:pt>
                <c:pt idx="195">
                  <c:v>174.580132348636</c:v>
                </c:pt>
                <c:pt idx="196">
                  <c:v>174.57247209711699</c:v>
                </c:pt>
                <c:pt idx="197">
                  <c:v>174.564811845598</c:v>
                </c:pt>
                <c:pt idx="198">
                  <c:v>174.55715159408001</c:v>
                </c:pt>
                <c:pt idx="199">
                  <c:v>174.549491342561</c:v>
                </c:pt>
                <c:pt idx="200">
                  <c:v>174.54183109104201</c:v>
                </c:pt>
                <c:pt idx="201">
                  <c:v>174.534170839523</c:v>
                </c:pt>
                <c:pt idx="202">
                  <c:v>174.52651058800399</c:v>
                </c:pt>
                <c:pt idx="203">
                  <c:v>174.518850336485</c:v>
                </c:pt>
                <c:pt idx="204">
                  <c:v>174.51119008496701</c:v>
                </c:pt>
                <c:pt idx="205">
                  <c:v>174.503529833448</c:v>
                </c:pt>
                <c:pt idx="206">
                  <c:v>174.49586958192901</c:v>
                </c:pt>
                <c:pt idx="207">
                  <c:v>174.48820933041</c:v>
                </c:pt>
                <c:pt idx="208">
                  <c:v>174.48054907889099</c:v>
                </c:pt>
                <c:pt idx="209">
                  <c:v>174.472888827372</c:v>
                </c:pt>
                <c:pt idx="210">
                  <c:v>174.46522857585401</c:v>
                </c:pt>
                <c:pt idx="211">
                  <c:v>174.457568324335</c:v>
                </c:pt>
                <c:pt idx="212">
                  <c:v>174.44990807281599</c:v>
                </c:pt>
                <c:pt idx="213">
                  <c:v>174.442247821297</c:v>
                </c:pt>
                <c:pt idx="214">
                  <c:v>174.43458756977799</c:v>
                </c:pt>
                <c:pt idx="215">
                  <c:v>174.42692731826</c:v>
                </c:pt>
                <c:pt idx="216">
                  <c:v>174.41926706674101</c:v>
                </c:pt>
                <c:pt idx="217">
                  <c:v>174.411606815222</c:v>
                </c:pt>
                <c:pt idx="218">
                  <c:v>174.40394656370299</c:v>
                </c:pt>
                <c:pt idx="219">
                  <c:v>174.396286312184</c:v>
                </c:pt>
                <c:pt idx="220">
                  <c:v>174.38862606066499</c:v>
                </c:pt>
                <c:pt idx="221">
                  <c:v>174.380965809147</c:v>
                </c:pt>
                <c:pt idx="222">
                  <c:v>174.37330555762799</c:v>
                </c:pt>
                <c:pt idx="223">
                  <c:v>174.365645306109</c:v>
                </c:pt>
                <c:pt idx="224">
                  <c:v>174.35798505458999</c:v>
                </c:pt>
                <c:pt idx="225">
                  <c:v>174.350324803071</c:v>
                </c:pt>
                <c:pt idx="226">
                  <c:v>174.34266455155199</c:v>
                </c:pt>
                <c:pt idx="227">
                  <c:v>174.335004300034</c:v>
                </c:pt>
                <c:pt idx="228">
                  <c:v>174.32734404851499</c:v>
                </c:pt>
                <c:pt idx="229">
                  <c:v>174.319683796996</c:v>
                </c:pt>
                <c:pt idx="230">
                  <c:v>174.31202354547699</c:v>
                </c:pt>
                <c:pt idx="231">
                  <c:v>174.304363293958</c:v>
                </c:pt>
                <c:pt idx="232">
                  <c:v>174.29670304243899</c:v>
                </c:pt>
                <c:pt idx="233">
                  <c:v>174.289042790921</c:v>
                </c:pt>
                <c:pt idx="234">
                  <c:v>174.28138253940199</c:v>
                </c:pt>
                <c:pt idx="235">
                  <c:v>174.273722287883</c:v>
                </c:pt>
                <c:pt idx="236">
                  <c:v>174.26606203636399</c:v>
                </c:pt>
                <c:pt idx="237">
                  <c:v>174.25840178484501</c:v>
                </c:pt>
                <c:pt idx="238">
                  <c:v>174.25074153332599</c:v>
                </c:pt>
                <c:pt idx="239">
                  <c:v>174.243081281808</c:v>
                </c:pt>
                <c:pt idx="240">
                  <c:v>174.23542103028899</c:v>
                </c:pt>
                <c:pt idx="241">
                  <c:v>174.22776077877</c:v>
                </c:pt>
                <c:pt idx="242">
                  <c:v>174.22010052725099</c:v>
                </c:pt>
                <c:pt idx="243">
                  <c:v>174.21244027573201</c:v>
                </c:pt>
                <c:pt idx="244">
                  <c:v>174.20478002421299</c:v>
                </c:pt>
                <c:pt idx="245">
                  <c:v>174.197119772695</c:v>
                </c:pt>
                <c:pt idx="246">
                  <c:v>174.18945952117599</c:v>
                </c:pt>
                <c:pt idx="247">
                  <c:v>174.18179926965701</c:v>
                </c:pt>
                <c:pt idx="248">
                  <c:v>174.17413901813799</c:v>
                </c:pt>
                <c:pt idx="249">
                  <c:v>174.16647876661901</c:v>
                </c:pt>
                <c:pt idx="250">
                  <c:v>174.15881851509999</c:v>
                </c:pt>
                <c:pt idx="251">
                  <c:v>174.151158263582</c:v>
                </c:pt>
                <c:pt idx="252">
                  <c:v>174.14349801206299</c:v>
                </c:pt>
                <c:pt idx="253">
                  <c:v>174.13583776054401</c:v>
                </c:pt>
                <c:pt idx="254">
                  <c:v>174.12817750902499</c:v>
                </c:pt>
                <c:pt idx="255">
                  <c:v>173.821767448272</c:v>
                </c:pt>
                <c:pt idx="256">
                  <c:v>173.81410719675301</c:v>
                </c:pt>
                <c:pt idx="257">
                  <c:v>173.806446945234</c:v>
                </c:pt>
                <c:pt idx="258">
                  <c:v>173.79878669371601</c:v>
                </c:pt>
                <c:pt idx="259">
                  <c:v>173.791126442197</c:v>
                </c:pt>
                <c:pt idx="260">
                  <c:v>173.78346619067801</c:v>
                </c:pt>
                <c:pt idx="261">
                  <c:v>173.775805939159</c:v>
                </c:pt>
                <c:pt idx="262">
                  <c:v>173.76814568763999</c:v>
                </c:pt>
                <c:pt idx="263">
                  <c:v>173.760485436121</c:v>
                </c:pt>
                <c:pt idx="264">
                  <c:v>173.75282518460301</c:v>
                </c:pt>
                <c:pt idx="265">
                  <c:v>173.745164933084</c:v>
                </c:pt>
                <c:pt idx="266">
                  <c:v>173.73750468156501</c:v>
                </c:pt>
                <c:pt idx="267">
                  <c:v>173.729844430046</c:v>
                </c:pt>
                <c:pt idx="268">
                  <c:v>173.72218417852699</c:v>
                </c:pt>
                <c:pt idx="269">
                  <c:v>173.714523927008</c:v>
                </c:pt>
                <c:pt idx="270">
                  <c:v>173.70686367549001</c:v>
                </c:pt>
                <c:pt idx="271">
                  <c:v>173.699203423971</c:v>
                </c:pt>
                <c:pt idx="272">
                  <c:v>173.69154317245199</c:v>
                </c:pt>
                <c:pt idx="273">
                  <c:v>173.683882920933</c:v>
                </c:pt>
                <c:pt idx="274">
                  <c:v>173.67622266941399</c:v>
                </c:pt>
                <c:pt idx="275">
                  <c:v>173.668562417895</c:v>
                </c:pt>
                <c:pt idx="276">
                  <c:v>173.66090216637701</c:v>
                </c:pt>
                <c:pt idx="277">
                  <c:v>173.653241914858</c:v>
                </c:pt>
                <c:pt idx="278">
                  <c:v>173.64558166333899</c:v>
                </c:pt>
                <c:pt idx="279">
                  <c:v>173.63792141182</c:v>
                </c:pt>
                <c:pt idx="280">
                  <c:v>173.63026116030099</c:v>
                </c:pt>
                <c:pt idx="281">
                  <c:v>173.622600908783</c:v>
                </c:pt>
                <c:pt idx="282">
                  <c:v>173.61494065726399</c:v>
                </c:pt>
                <c:pt idx="283">
                  <c:v>173.607280405745</c:v>
                </c:pt>
                <c:pt idx="284">
                  <c:v>173.59962015422599</c:v>
                </c:pt>
                <c:pt idx="285">
                  <c:v>173.591959902707</c:v>
                </c:pt>
                <c:pt idx="286">
                  <c:v>173.58429965118799</c:v>
                </c:pt>
                <c:pt idx="287">
                  <c:v>173.57663939967</c:v>
                </c:pt>
                <c:pt idx="288">
                  <c:v>173.56897914815099</c:v>
                </c:pt>
                <c:pt idx="289">
                  <c:v>173.561318896632</c:v>
                </c:pt>
                <c:pt idx="290">
                  <c:v>173.55365864511299</c:v>
                </c:pt>
                <c:pt idx="291">
                  <c:v>163.1740178371</c:v>
                </c:pt>
                <c:pt idx="292">
                  <c:v>163.16635758558101</c:v>
                </c:pt>
                <c:pt idx="293">
                  <c:v>163.15869733406299</c:v>
                </c:pt>
                <c:pt idx="294">
                  <c:v>163.15103708254401</c:v>
                </c:pt>
                <c:pt idx="295">
                  <c:v>163.14337683102499</c:v>
                </c:pt>
                <c:pt idx="296">
                  <c:v>163.13571657950601</c:v>
                </c:pt>
                <c:pt idx="297">
                  <c:v>163.128056327987</c:v>
                </c:pt>
                <c:pt idx="298">
                  <c:v>163.12039607646801</c:v>
                </c:pt>
                <c:pt idx="299">
                  <c:v>163.11273582494999</c:v>
                </c:pt>
                <c:pt idx="300">
                  <c:v>163.10507557343101</c:v>
                </c:pt>
                <c:pt idx="301">
                  <c:v>163.097415321912</c:v>
                </c:pt>
                <c:pt idx="302">
                  <c:v>163.08975507039301</c:v>
                </c:pt>
                <c:pt idx="303">
                  <c:v>163.082094818874</c:v>
                </c:pt>
                <c:pt idx="304">
                  <c:v>163.07443456735501</c:v>
                </c:pt>
                <c:pt idx="305">
                  <c:v>163.06677431583699</c:v>
                </c:pt>
                <c:pt idx="306">
                  <c:v>163.05911406431801</c:v>
                </c:pt>
                <c:pt idx="307">
                  <c:v>163.051453812799</c:v>
                </c:pt>
                <c:pt idx="308">
                  <c:v>163.04379356128001</c:v>
                </c:pt>
                <c:pt idx="309">
                  <c:v>132.341505473815</c:v>
                </c:pt>
                <c:pt idx="310">
                  <c:v>132.33384522229599</c:v>
                </c:pt>
                <c:pt idx="311">
                  <c:v>132.32618497077701</c:v>
                </c:pt>
                <c:pt idx="312">
                  <c:v>132.31852471925799</c:v>
                </c:pt>
                <c:pt idx="313">
                  <c:v>132.31086446774</c:v>
                </c:pt>
                <c:pt idx="314">
                  <c:v>132.30320421622099</c:v>
                </c:pt>
                <c:pt idx="315">
                  <c:v>132.29554396470201</c:v>
                </c:pt>
                <c:pt idx="316">
                  <c:v>132.28788371318299</c:v>
                </c:pt>
                <c:pt idx="317">
                  <c:v>132.28022346166401</c:v>
                </c:pt>
                <c:pt idx="318">
                  <c:v>132.27256321014499</c:v>
                </c:pt>
                <c:pt idx="319">
                  <c:v>132.264902958627</c:v>
                </c:pt>
                <c:pt idx="320">
                  <c:v>132.25724270710799</c:v>
                </c:pt>
                <c:pt idx="321">
                  <c:v>132.24958245558901</c:v>
                </c:pt>
                <c:pt idx="322">
                  <c:v>132.24192220406999</c:v>
                </c:pt>
                <c:pt idx="323">
                  <c:v>132.23426195255101</c:v>
                </c:pt>
                <c:pt idx="324">
                  <c:v>132.22660170103299</c:v>
                </c:pt>
                <c:pt idx="325">
                  <c:v>132.21894144951401</c:v>
                </c:pt>
                <c:pt idx="326">
                  <c:v>132.21128119799499</c:v>
                </c:pt>
                <c:pt idx="327">
                  <c:v>132.20362094647601</c:v>
                </c:pt>
                <c:pt idx="328">
                  <c:v>132.19596069495699</c:v>
                </c:pt>
                <c:pt idx="329">
                  <c:v>132.18830044343801</c:v>
                </c:pt>
                <c:pt idx="330">
                  <c:v>132.18064019191999</c:v>
                </c:pt>
                <c:pt idx="331">
                  <c:v>132.17297994040101</c:v>
                </c:pt>
                <c:pt idx="332">
                  <c:v>132.16531968888199</c:v>
                </c:pt>
                <c:pt idx="333">
                  <c:v>132.15765943736301</c:v>
                </c:pt>
                <c:pt idx="334">
                  <c:v>132.149999185844</c:v>
                </c:pt>
                <c:pt idx="335">
                  <c:v>132.14233893432501</c:v>
                </c:pt>
                <c:pt idx="336">
                  <c:v>132.13467868280699</c:v>
                </c:pt>
                <c:pt idx="337">
                  <c:v>132.12701843128801</c:v>
                </c:pt>
                <c:pt idx="338">
                  <c:v>132.11935817976899</c:v>
                </c:pt>
                <c:pt idx="339">
                  <c:v>132.11169792825001</c:v>
                </c:pt>
                <c:pt idx="340">
                  <c:v>132.104037676731</c:v>
                </c:pt>
                <c:pt idx="341">
                  <c:v>132.09637742521201</c:v>
                </c:pt>
                <c:pt idx="342">
                  <c:v>132.08871717369399</c:v>
                </c:pt>
                <c:pt idx="343">
                  <c:v>132.08105692217501</c:v>
                </c:pt>
                <c:pt idx="344">
                  <c:v>132.073396670656</c:v>
                </c:pt>
                <c:pt idx="345">
                  <c:v>132.06573641913701</c:v>
                </c:pt>
                <c:pt idx="346">
                  <c:v>132.058076167618</c:v>
                </c:pt>
                <c:pt idx="347">
                  <c:v>132.05041591609901</c:v>
                </c:pt>
                <c:pt idx="348">
                  <c:v>132.04275566458099</c:v>
                </c:pt>
                <c:pt idx="349">
                  <c:v>132.03509541306201</c:v>
                </c:pt>
                <c:pt idx="350">
                  <c:v>130.69455139726699</c:v>
                </c:pt>
                <c:pt idx="351">
                  <c:v>130.68689114574801</c:v>
                </c:pt>
                <c:pt idx="352">
                  <c:v>130.67923089422899</c:v>
                </c:pt>
                <c:pt idx="353">
                  <c:v>130.67157064271001</c:v>
                </c:pt>
                <c:pt idx="354">
                  <c:v>130.663910391191</c:v>
                </c:pt>
                <c:pt idx="355">
                  <c:v>130.65625013967301</c:v>
                </c:pt>
                <c:pt idx="356">
                  <c:v>130.64858988815399</c:v>
                </c:pt>
                <c:pt idx="357">
                  <c:v>130.64092963663501</c:v>
                </c:pt>
                <c:pt idx="358">
                  <c:v>130.63326938511599</c:v>
                </c:pt>
                <c:pt idx="359">
                  <c:v>130.62560913359701</c:v>
                </c:pt>
                <c:pt idx="360">
                  <c:v>130.61794888207899</c:v>
                </c:pt>
                <c:pt idx="361">
                  <c:v>130.61028863056001</c:v>
                </c:pt>
                <c:pt idx="362">
                  <c:v>130.60262837904099</c:v>
                </c:pt>
                <c:pt idx="363">
                  <c:v>130.59496812752201</c:v>
                </c:pt>
                <c:pt idx="364">
                  <c:v>130.587307876003</c:v>
                </c:pt>
                <c:pt idx="365">
                  <c:v>130.57964762448401</c:v>
                </c:pt>
                <c:pt idx="366">
                  <c:v>130.57198737296599</c:v>
                </c:pt>
                <c:pt idx="367">
                  <c:v>130.56432712144701</c:v>
                </c:pt>
                <c:pt idx="368">
                  <c:v>130.55666686992799</c:v>
                </c:pt>
                <c:pt idx="369">
                  <c:v>130.54900661840901</c:v>
                </c:pt>
                <c:pt idx="370">
                  <c:v>130.54134636689</c:v>
                </c:pt>
                <c:pt idx="371">
                  <c:v>130.53368611537101</c:v>
                </c:pt>
                <c:pt idx="372">
                  <c:v>130.52602586385299</c:v>
                </c:pt>
                <c:pt idx="373">
                  <c:v>130.51836561233401</c:v>
                </c:pt>
                <c:pt idx="374">
                  <c:v>130.510705360815</c:v>
                </c:pt>
                <c:pt idx="375">
                  <c:v>130.50304510929601</c:v>
                </c:pt>
                <c:pt idx="376">
                  <c:v>130.495384857777</c:v>
                </c:pt>
                <c:pt idx="377">
                  <c:v>130.48772460625801</c:v>
                </c:pt>
                <c:pt idx="378">
                  <c:v>130.48006435473999</c:v>
                </c:pt>
                <c:pt idx="379">
                  <c:v>130.47240410322101</c:v>
                </c:pt>
                <c:pt idx="380">
                  <c:v>130.464743851702</c:v>
                </c:pt>
                <c:pt idx="381">
                  <c:v>130.45708360018301</c:v>
                </c:pt>
                <c:pt idx="382">
                  <c:v>130.449423348664</c:v>
                </c:pt>
                <c:pt idx="383">
                  <c:v>130.44176309714501</c:v>
                </c:pt>
                <c:pt idx="384">
                  <c:v>130.434102845627</c:v>
                </c:pt>
                <c:pt idx="385">
                  <c:v>130.42644259410801</c:v>
                </c:pt>
                <c:pt idx="386">
                  <c:v>130.418782342589</c:v>
                </c:pt>
                <c:pt idx="387">
                  <c:v>130.41112209107001</c:v>
                </c:pt>
                <c:pt idx="388">
                  <c:v>130.403461839551</c:v>
                </c:pt>
                <c:pt idx="389">
                  <c:v>130.39580158803199</c:v>
                </c:pt>
                <c:pt idx="390">
                  <c:v>130.388141336514</c:v>
                </c:pt>
                <c:pt idx="391">
                  <c:v>75.310932916135698</c:v>
                </c:pt>
                <c:pt idx="392">
                  <c:v>75.303272664616898</c:v>
                </c:pt>
                <c:pt idx="393">
                  <c:v>75.295612413098098</c:v>
                </c:pt>
                <c:pt idx="394">
                  <c:v>75.287952161579199</c:v>
                </c:pt>
                <c:pt idx="395">
                  <c:v>75.280291910060399</c:v>
                </c:pt>
                <c:pt idx="396">
                  <c:v>75.272631658541599</c:v>
                </c:pt>
                <c:pt idx="397">
                  <c:v>75.264971407022699</c:v>
                </c:pt>
                <c:pt idx="398">
                  <c:v>75.257311155503899</c:v>
                </c:pt>
                <c:pt idx="399">
                  <c:v>75.249650903985099</c:v>
                </c:pt>
                <c:pt idx="400">
                  <c:v>75.241990652466299</c:v>
                </c:pt>
                <c:pt idx="401">
                  <c:v>75.2343304009474</c:v>
                </c:pt>
                <c:pt idx="402">
                  <c:v>75.2266701494286</c:v>
                </c:pt>
                <c:pt idx="403">
                  <c:v>75.2190098979098</c:v>
                </c:pt>
                <c:pt idx="404">
                  <c:v>75.2113496463909</c:v>
                </c:pt>
                <c:pt idx="405">
                  <c:v>75.2036893948721</c:v>
                </c:pt>
                <c:pt idx="406">
                  <c:v>75.1960291433533</c:v>
                </c:pt>
                <c:pt idx="407">
                  <c:v>75.1883688918345</c:v>
                </c:pt>
                <c:pt idx="408">
                  <c:v>75.180708640315601</c:v>
                </c:pt>
                <c:pt idx="409">
                  <c:v>75.173048388796801</c:v>
                </c:pt>
                <c:pt idx="410">
                  <c:v>75.165388137278001</c:v>
                </c:pt>
                <c:pt idx="411">
                  <c:v>75.157727885759101</c:v>
                </c:pt>
                <c:pt idx="412">
                  <c:v>75.150067634240301</c:v>
                </c:pt>
                <c:pt idx="413">
                  <c:v>75.142407382721501</c:v>
                </c:pt>
                <c:pt idx="414">
                  <c:v>75.134747131202701</c:v>
                </c:pt>
                <c:pt idx="415">
                  <c:v>75.127086879683802</c:v>
                </c:pt>
                <c:pt idx="416">
                  <c:v>75.119426628165002</c:v>
                </c:pt>
                <c:pt idx="417">
                  <c:v>75.111766376646202</c:v>
                </c:pt>
                <c:pt idx="418">
                  <c:v>75.104106125127302</c:v>
                </c:pt>
                <c:pt idx="419">
                  <c:v>75.096445873608502</c:v>
                </c:pt>
                <c:pt idx="420">
                  <c:v>75.088785622089702</c:v>
                </c:pt>
                <c:pt idx="421">
                  <c:v>75.081125370570902</c:v>
                </c:pt>
                <c:pt idx="422">
                  <c:v>75.073465119052003</c:v>
                </c:pt>
                <c:pt idx="423">
                  <c:v>75.065804867533203</c:v>
                </c:pt>
                <c:pt idx="424">
                  <c:v>75.058144616014403</c:v>
                </c:pt>
                <c:pt idx="425">
                  <c:v>75.050484364495603</c:v>
                </c:pt>
                <c:pt idx="426">
                  <c:v>75.042824112976703</c:v>
                </c:pt>
                <c:pt idx="427">
                  <c:v>75.035163861457903</c:v>
                </c:pt>
                <c:pt idx="428">
                  <c:v>75.027503609939103</c:v>
                </c:pt>
                <c:pt idx="429">
                  <c:v>75.019843358420204</c:v>
                </c:pt>
                <c:pt idx="430">
                  <c:v>75.012183106901404</c:v>
                </c:pt>
                <c:pt idx="431">
                  <c:v>75.004522855382604</c:v>
                </c:pt>
                <c:pt idx="432">
                  <c:v>73.932087642746595</c:v>
                </c:pt>
                <c:pt idx="433">
                  <c:v>73.924427391227695</c:v>
                </c:pt>
                <c:pt idx="434">
                  <c:v>73.916767139708895</c:v>
                </c:pt>
                <c:pt idx="435">
                  <c:v>73.909106888190095</c:v>
                </c:pt>
                <c:pt idx="436">
                  <c:v>73.901446636671295</c:v>
                </c:pt>
                <c:pt idx="437">
                  <c:v>73.893786385152396</c:v>
                </c:pt>
                <c:pt idx="438">
                  <c:v>73.886126133633596</c:v>
                </c:pt>
                <c:pt idx="439">
                  <c:v>73.878465882114796</c:v>
                </c:pt>
                <c:pt idx="440">
                  <c:v>73.870805630595896</c:v>
                </c:pt>
                <c:pt idx="441">
                  <c:v>73.863145379077096</c:v>
                </c:pt>
                <c:pt idx="442">
                  <c:v>73.855485127558296</c:v>
                </c:pt>
                <c:pt idx="443">
                  <c:v>73.847824876039496</c:v>
                </c:pt>
                <c:pt idx="444">
                  <c:v>73.840164624520597</c:v>
                </c:pt>
                <c:pt idx="445">
                  <c:v>73.832504373001797</c:v>
                </c:pt>
                <c:pt idx="446">
                  <c:v>73.824844121482997</c:v>
                </c:pt>
                <c:pt idx="447">
                  <c:v>73.817183869964097</c:v>
                </c:pt>
                <c:pt idx="448">
                  <c:v>73.809523618445297</c:v>
                </c:pt>
                <c:pt idx="449">
                  <c:v>73.801863366926497</c:v>
                </c:pt>
                <c:pt idx="450">
                  <c:v>73.794203115407598</c:v>
                </c:pt>
                <c:pt idx="451">
                  <c:v>73.786542863888798</c:v>
                </c:pt>
                <c:pt idx="452">
                  <c:v>73.778882612369998</c:v>
                </c:pt>
                <c:pt idx="453">
                  <c:v>71.250999611156502</c:v>
                </c:pt>
                <c:pt idx="454">
                  <c:v>71.243339359637702</c:v>
                </c:pt>
                <c:pt idx="455">
                  <c:v>71.235679108118902</c:v>
                </c:pt>
                <c:pt idx="456">
                  <c:v>71.228018856600102</c:v>
                </c:pt>
                <c:pt idx="457">
                  <c:v>71.220358605081202</c:v>
                </c:pt>
                <c:pt idx="458">
                  <c:v>71.212698353562402</c:v>
                </c:pt>
                <c:pt idx="459">
                  <c:v>71.205038102043602</c:v>
                </c:pt>
                <c:pt idx="460">
                  <c:v>71.197377850524802</c:v>
                </c:pt>
                <c:pt idx="461">
                  <c:v>71.189717599005903</c:v>
                </c:pt>
                <c:pt idx="462">
                  <c:v>71.182057347487103</c:v>
                </c:pt>
                <c:pt idx="463">
                  <c:v>71.174397095968303</c:v>
                </c:pt>
                <c:pt idx="464">
                  <c:v>71.166736844449403</c:v>
                </c:pt>
                <c:pt idx="465">
                  <c:v>71.159076592930603</c:v>
                </c:pt>
                <c:pt idx="466">
                  <c:v>71.151416341411803</c:v>
                </c:pt>
                <c:pt idx="467">
                  <c:v>71.143756089892904</c:v>
                </c:pt>
                <c:pt idx="468">
                  <c:v>71.136095838374104</c:v>
                </c:pt>
                <c:pt idx="469">
                  <c:v>71.128435586855304</c:v>
                </c:pt>
                <c:pt idx="470">
                  <c:v>71.120775335336504</c:v>
                </c:pt>
                <c:pt idx="471">
                  <c:v>71.113115083817604</c:v>
                </c:pt>
                <c:pt idx="472">
                  <c:v>71.105454832298804</c:v>
                </c:pt>
                <c:pt idx="473">
                  <c:v>71.097794580780004</c:v>
                </c:pt>
                <c:pt idx="474">
                  <c:v>64.716805065595693</c:v>
                </c:pt>
                <c:pt idx="475">
                  <c:v>64.709144814076893</c:v>
                </c:pt>
                <c:pt idx="476">
                  <c:v>64.701484562558093</c:v>
                </c:pt>
                <c:pt idx="477">
                  <c:v>64.693824311039194</c:v>
                </c:pt>
                <c:pt idx="478">
                  <c:v>64.686164059520394</c:v>
                </c:pt>
                <c:pt idx="479">
                  <c:v>64.678503808001594</c:v>
                </c:pt>
                <c:pt idx="480">
                  <c:v>64.670843556482694</c:v>
                </c:pt>
                <c:pt idx="481">
                  <c:v>64.663183304963894</c:v>
                </c:pt>
                <c:pt idx="482">
                  <c:v>64.655523053445094</c:v>
                </c:pt>
                <c:pt idx="483">
                  <c:v>64.647862801926294</c:v>
                </c:pt>
                <c:pt idx="484">
                  <c:v>64.640202550407395</c:v>
                </c:pt>
                <c:pt idx="485">
                  <c:v>64.632542298888595</c:v>
                </c:pt>
                <c:pt idx="486">
                  <c:v>64.624882047369795</c:v>
                </c:pt>
                <c:pt idx="487">
                  <c:v>64.617221795850895</c:v>
                </c:pt>
                <c:pt idx="488">
                  <c:v>64.609561544332095</c:v>
                </c:pt>
                <c:pt idx="489">
                  <c:v>64.601901292813295</c:v>
                </c:pt>
                <c:pt idx="490">
                  <c:v>64.594241041294495</c:v>
                </c:pt>
                <c:pt idx="491">
                  <c:v>64.586580789775596</c:v>
                </c:pt>
                <c:pt idx="492">
                  <c:v>64.578920538256796</c:v>
                </c:pt>
                <c:pt idx="493">
                  <c:v>64.571260286737996</c:v>
                </c:pt>
                <c:pt idx="494">
                  <c:v>64.563600035219096</c:v>
                </c:pt>
                <c:pt idx="495">
                  <c:v>64.555939783700296</c:v>
                </c:pt>
                <c:pt idx="496">
                  <c:v>64.548279532181496</c:v>
                </c:pt>
                <c:pt idx="497">
                  <c:v>64.540619280662696</c:v>
                </c:pt>
                <c:pt idx="498">
                  <c:v>64.532959029143797</c:v>
                </c:pt>
                <c:pt idx="499">
                  <c:v>64.525298777624997</c:v>
                </c:pt>
                <c:pt idx="500">
                  <c:v>64.517638526106197</c:v>
                </c:pt>
                <c:pt idx="501">
                  <c:v>64.509978274587297</c:v>
                </c:pt>
                <c:pt idx="502">
                  <c:v>64.502318023068497</c:v>
                </c:pt>
                <c:pt idx="503">
                  <c:v>64.494657771549697</c:v>
                </c:pt>
                <c:pt idx="504">
                  <c:v>64.486997520030897</c:v>
                </c:pt>
                <c:pt idx="505">
                  <c:v>64.479337268511998</c:v>
                </c:pt>
                <c:pt idx="506">
                  <c:v>64.471677016993198</c:v>
                </c:pt>
                <c:pt idx="507">
                  <c:v>64.464016765474398</c:v>
                </c:pt>
                <c:pt idx="508">
                  <c:v>64.456356513955498</c:v>
                </c:pt>
                <c:pt idx="509">
                  <c:v>64.448696262436698</c:v>
                </c:pt>
                <c:pt idx="510">
                  <c:v>64.441036010917898</c:v>
                </c:pt>
                <c:pt idx="511">
                  <c:v>64.433375759399098</c:v>
                </c:pt>
                <c:pt idx="512">
                  <c:v>64.425715507880199</c:v>
                </c:pt>
                <c:pt idx="513">
                  <c:v>64.418055256361399</c:v>
                </c:pt>
                <c:pt idx="514">
                  <c:v>64.410395004842599</c:v>
                </c:pt>
                <c:pt idx="515">
                  <c:v>64.402734753323699</c:v>
                </c:pt>
                <c:pt idx="516">
                  <c:v>64.395074501804899</c:v>
                </c:pt>
                <c:pt idx="517">
                  <c:v>64.387414250286099</c:v>
                </c:pt>
                <c:pt idx="518">
                  <c:v>64.379753998767299</c:v>
                </c:pt>
                <c:pt idx="519">
                  <c:v>64.3720937472484</c:v>
                </c:pt>
                <c:pt idx="520">
                  <c:v>64.3644334957296</c:v>
                </c:pt>
                <c:pt idx="521">
                  <c:v>64.3567732442108</c:v>
                </c:pt>
                <c:pt idx="522">
                  <c:v>64.3491129926919</c:v>
                </c:pt>
                <c:pt idx="523">
                  <c:v>64.3414527411731</c:v>
                </c:pt>
                <c:pt idx="524">
                  <c:v>64.3337924896543</c:v>
                </c:pt>
                <c:pt idx="525">
                  <c:v>64.326132238135401</c:v>
                </c:pt>
                <c:pt idx="526">
                  <c:v>64.318471986616601</c:v>
                </c:pt>
                <c:pt idx="527">
                  <c:v>64.310811735097801</c:v>
                </c:pt>
                <c:pt idx="528">
                  <c:v>64.303151483579001</c:v>
                </c:pt>
                <c:pt idx="529">
                  <c:v>64.295491232060101</c:v>
                </c:pt>
                <c:pt idx="530">
                  <c:v>64.287830980541301</c:v>
                </c:pt>
                <c:pt idx="531">
                  <c:v>64.280170729022501</c:v>
                </c:pt>
                <c:pt idx="532">
                  <c:v>63.284338031574798</c:v>
                </c:pt>
                <c:pt idx="533">
                  <c:v>63.276677780055898</c:v>
                </c:pt>
                <c:pt idx="534">
                  <c:v>63.269017528537098</c:v>
                </c:pt>
                <c:pt idx="535">
                  <c:v>63.261357277018298</c:v>
                </c:pt>
                <c:pt idx="536">
                  <c:v>63.253697025499399</c:v>
                </c:pt>
                <c:pt idx="537">
                  <c:v>63.246036773980599</c:v>
                </c:pt>
                <c:pt idx="538">
                  <c:v>63.238376522461799</c:v>
                </c:pt>
                <c:pt idx="539">
                  <c:v>63.230716270942999</c:v>
                </c:pt>
                <c:pt idx="540">
                  <c:v>63.223056019424099</c:v>
                </c:pt>
                <c:pt idx="541">
                  <c:v>63.215395767905299</c:v>
                </c:pt>
                <c:pt idx="542">
                  <c:v>63.207735516386499</c:v>
                </c:pt>
                <c:pt idx="543">
                  <c:v>63.2000752648676</c:v>
                </c:pt>
                <c:pt idx="544">
                  <c:v>63.1924150133488</c:v>
                </c:pt>
                <c:pt idx="545">
                  <c:v>63.18475476183</c:v>
                </c:pt>
                <c:pt idx="546">
                  <c:v>63.1770945103112</c:v>
                </c:pt>
                <c:pt idx="547">
                  <c:v>63.1694342587923</c:v>
                </c:pt>
                <c:pt idx="548">
                  <c:v>63.1617740072735</c:v>
                </c:pt>
                <c:pt idx="549">
                  <c:v>63.1541137557547</c:v>
                </c:pt>
                <c:pt idx="550">
                  <c:v>63.146453504235801</c:v>
                </c:pt>
                <c:pt idx="551">
                  <c:v>63.138793252717001</c:v>
                </c:pt>
                <c:pt idx="552">
                  <c:v>63.131133001198201</c:v>
                </c:pt>
                <c:pt idx="553">
                  <c:v>63.123472749679401</c:v>
                </c:pt>
                <c:pt idx="554">
                  <c:v>63.115812498160501</c:v>
                </c:pt>
                <c:pt idx="555">
                  <c:v>63.108152246641701</c:v>
                </c:pt>
                <c:pt idx="556">
                  <c:v>63.100491995122901</c:v>
                </c:pt>
                <c:pt idx="557">
                  <c:v>63.092831743604002</c:v>
                </c:pt>
                <c:pt idx="558">
                  <c:v>63.085171492085202</c:v>
                </c:pt>
                <c:pt idx="559">
                  <c:v>63.077511240566402</c:v>
                </c:pt>
                <c:pt idx="560">
                  <c:v>63.069850989047602</c:v>
                </c:pt>
                <c:pt idx="561">
                  <c:v>63.062190737528702</c:v>
                </c:pt>
                <c:pt idx="562">
                  <c:v>63.054530486009902</c:v>
                </c:pt>
                <c:pt idx="563">
                  <c:v>63.046870234491102</c:v>
                </c:pt>
                <c:pt idx="564">
                  <c:v>63.039209982972203</c:v>
                </c:pt>
                <c:pt idx="565">
                  <c:v>63.031549731453403</c:v>
                </c:pt>
                <c:pt idx="566">
                  <c:v>63.023889479934603</c:v>
                </c:pt>
                <c:pt idx="567">
                  <c:v>63.016229228415803</c:v>
                </c:pt>
                <c:pt idx="568">
                  <c:v>63.008568976896903</c:v>
                </c:pt>
                <c:pt idx="569">
                  <c:v>63.000908725378103</c:v>
                </c:pt>
                <c:pt idx="570">
                  <c:v>62.993248473859303</c:v>
                </c:pt>
                <c:pt idx="571">
                  <c:v>62.985588222340397</c:v>
                </c:pt>
                <c:pt idx="572">
                  <c:v>62.977927970821597</c:v>
                </c:pt>
                <c:pt idx="573">
                  <c:v>62.970267719302797</c:v>
                </c:pt>
                <c:pt idx="574">
                  <c:v>62.962607467783997</c:v>
                </c:pt>
                <c:pt idx="575">
                  <c:v>62.954947216265097</c:v>
                </c:pt>
                <c:pt idx="576">
                  <c:v>62.947286964746297</c:v>
                </c:pt>
                <c:pt idx="577">
                  <c:v>62.939626713227497</c:v>
                </c:pt>
                <c:pt idx="578">
                  <c:v>62.931966461708598</c:v>
                </c:pt>
                <c:pt idx="579">
                  <c:v>62.924306210189798</c:v>
                </c:pt>
                <c:pt idx="580">
                  <c:v>62.916645958670998</c:v>
                </c:pt>
                <c:pt idx="581">
                  <c:v>62.908985707152198</c:v>
                </c:pt>
                <c:pt idx="582">
                  <c:v>62.901325455633298</c:v>
                </c:pt>
                <c:pt idx="583">
                  <c:v>62.893665204114498</c:v>
                </c:pt>
                <c:pt idx="584">
                  <c:v>62.886004952595698</c:v>
                </c:pt>
                <c:pt idx="585">
                  <c:v>62.878344701076799</c:v>
                </c:pt>
                <c:pt idx="586">
                  <c:v>62.870684449557999</c:v>
                </c:pt>
                <c:pt idx="587">
                  <c:v>62.863024198039199</c:v>
                </c:pt>
                <c:pt idx="588">
                  <c:v>62.855363946520399</c:v>
                </c:pt>
                <c:pt idx="589">
                  <c:v>62.847703695001499</c:v>
                </c:pt>
                <c:pt idx="590">
                  <c:v>62.840043443482699</c:v>
                </c:pt>
                <c:pt idx="591">
                  <c:v>62.832383191963899</c:v>
                </c:pt>
                <c:pt idx="592">
                  <c:v>62.824722940445</c:v>
                </c:pt>
                <c:pt idx="593">
                  <c:v>57.462546877264998</c:v>
                </c:pt>
                <c:pt idx="594">
                  <c:v>57.454886625746198</c:v>
                </c:pt>
                <c:pt idx="595">
                  <c:v>57.447226374227299</c:v>
                </c:pt>
                <c:pt idx="596">
                  <c:v>57.439566122708499</c:v>
                </c:pt>
                <c:pt idx="597">
                  <c:v>57.431905871189699</c:v>
                </c:pt>
                <c:pt idx="598">
                  <c:v>57.424245619670799</c:v>
                </c:pt>
                <c:pt idx="599">
                  <c:v>57.416585368151999</c:v>
                </c:pt>
                <c:pt idx="600">
                  <c:v>57.408925116633199</c:v>
                </c:pt>
                <c:pt idx="601">
                  <c:v>57.401264865114399</c:v>
                </c:pt>
                <c:pt idx="602">
                  <c:v>57.3936046135955</c:v>
                </c:pt>
                <c:pt idx="603">
                  <c:v>57.3859443620767</c:v>
                </c:pt>
                <c:pt idx="604">
                  <c:v>57.3782841105579</c:v>
                </c:pt>
                <c:pt idx="605">
                  <c:v>57.370623859039</c:v>
                </c:pt>
                <c:pt idx="606">
                  <c:v>57.3629636075202</c:v>
                </c:pt>
                <c:pt idx="607">
                  <c:v>57.3553033560014</c:v>
                </c:pt>
                <c:pt idx="608">
                  <c:v>57.3476431044826</c:v>
                </c:pt>
                <c:pt idx="609">
                  <c:v>57.339982852963701</c:v>
                </c:pt>
                <c:pt idx="610">
                  <c:v>57.332322601444901</c:v>
                </c:pt>
                <c:pt idx="611">
                  <c:v>57.324662349926101</c:v>
                </c:pt>
                <c:pt idx="612">
                  <c:v>57.317002098407201</c:v>
                </c:pt>
                <c:pt idx="613">
                  <c:v>57.309341846888401</c:v>
                </c:pt>
                <c:pt idx="614">
                  <c:v>57.301681595369601</c:v>
                </c:pt>
                <c:pt idx="615">
                  <c:v>57.294021343850801</c:v>
                </c:pt>
                <c:pt idx="616">
                  <c:v>57.286361092331902</c:v>
                </c:pt>
                <c:pt idx="617">
                  <c:v>57.278700840813102</c:v>
                </c:pt>
                <c:pt idx="618">
                  <c:v>57.271040589294302</c:v>
                </c:pt>
                <c:pt idx="619">
                  <c:v>57.263380337775402</c:v>
                </c:pt>
                <c:pt idx="620">
                  <c:v>57.255720086256602</c:v>
                </c:pt>
                <c:pt idx="621">
                  <c:v>57.248059834737802</c:v>
                </c:pt>
                <c:pt idx="622">
                  <c:v>57.240399583219002</c:v>
                </c:pt>
                <c:pt idx="623">
                  <c:v>57.232739331700103</c:v>
                </c:pt>
                <c:pt idx="624">
                  <c:v>57.225079080181303</c:v>
                </c:pt>
                <c:pt idx="625">
                  <c:v>57.217418828662503</c:v>
                </c:pt>
                <c:pt idx="626">
                  <c:v>57.209758577143603</c:v>
                </c:pt>
                <c:pt idx="627">
                  <c:v>57.202098325624803</c:v>
                </c:pt>
                <c:pt idx="628">
                  <c:v>57.194438074106003</c:v>
                </c:pt>
                <c:pt idx="629">
                  <c:v>57.186777822587203</c:v>
                </c:pt>
                <c:pt idx="630">
                  <c:v>57.179117571068304</c:v>
                </c:pt>
                <c:pt idx="631">
                  <c:v>57.171457319549503</c:v>
                </c:pt>
                <c:pt idx="632">
                  <c:v>57.163797068030703</c:v>
                </c:pt>
                <c:pt idx="633">
                  <c:v>57.156136816511903</c:v>
                </c:pt>
                <c:pt idx="634">
                  <c:v>57.002931786135299</c:v>
                </c:pt>
                <c:pt idx="635">
                  <c:v>56.995271534616499</c:v>
                </c:pt>
                <c:pt idx="636">
                  <c:v>56.9876112830976</c:v>
                </c:pt>
                <c:pt idx="637">
                  <c:v>56.9799510315788</c:v>
                </c:pt>
                <c:pt idx="638">
                  <c:v>56.97229078006</c:v>
                </c:pt>
                <c:pt idx="639">
                  <c:v>56.9646305285411</c:v>
                </c:pt>
                <c:pt idx="640">
                  <c:v>56.9569702770223</c:v>
                </c:pt>
                <c:pt idx="641">
                  <c:v>56.9493100255035</c:v>
                </c:pt>
                <c:pt idx="642">
                  <c:v>56.941649773984601</c:v>
                </c:pt>
                <c:pt idx="643">
                  <c:v>56.933989522465801</c:v>
                </c:pt>
                <c:pt idx="644">
                  <c:v>56.926329270947001</c:v>
                </c:pt>
                <c:pt idx="645">
                  <c:v>56.918669019428201</c:v>
                </c:pt>
                <c:pt idx="646">
                  <c:v>56.911008767909301</c:v>
                </c:pt>
                <c:pt idx="647">
                  <c:v>56.903348516390501</c:v>
                </c:pt>
                <c:pt idx="648">
                  <c:v>56.895688264871701</c:v>
                </c:pt>
                <c:pt idx="649">
                  <c:v>56.888028013352802</c:v>
                </c:pt>
                <c:pt idx="650">
                  <c:v>56.880367761834002</c:v>
                </c:pt>
                <c:pt idx="651">
                  <c:v>56.872707510315202</c:v>
                </c:pt>
                <c:pt idx="652">
                  <c:v>56.865047258796402</c:v>
                </c:pt>
                <c:pt idx="653">
                  <c:v>56.857387007277502</c:v>
                </c:pt>
                <c:pt idx="654">
                  <c:v>56.849726755758702</c:v>
                </c:pt>
                <c:pt idx="655">
                  <c:v>56.842066504239902</c:v>
                </c:pt>
                <c:pt idx="656">
                  <c:v>56.834406252721003</c:v>
                </c:pt>
                <c:pt idx="657">
                  <c:v>56.826746001202203</c:v>
                </c:pt>
                <c:pt idx="658">
                  <c:v>56.819085749683403</c:v>
                </c:pt>
                <c:pt idx="659">
                  <c:v>56.811425498164603</c:v>
                </c:pt>
                <c:pt idx="660">
                  <c:v>56.803765246645703</c:v>
                </c:pt>
                <c:pt idx="661">
                  <c:v>56.796104995126903</c:v>
                </c:pt>
                <c:pt idx="662">
                  <c:v>56.788444743608103</c:v>
                </c:pt>
                <c:pt idx="663">
                  <c:v>56.780784492089197</c:v>
                </c:pt>
                <c:pt idx="664">
                  <c:v>56.773124240570397</c:v>
                </c:pt>
                <c:pt idx="665">
                  <c:v>56.765463989051597</c:v>
                </c:pt>
                <c:pt idx="666">
                  <c:v>56.757803737532797</c:v>
                </c:pt>
                <c:pt idx="667">
                  <c:v>56.750143486013897</c:v>
                </c:pt>
                <c:pt idx="668">
                  <c:v>56.742483234495097</c:v>
                </c:pt>
                <c:pt idx="669">
                  <c:v>56.734822982976297</c:v>
                </c:pt>
                <c:pt idx="670">
                  <c:v>56.727162731457398</c:v>
                </c:pt>
                <c:pt idx="671">
                  <c:v>56.719502479938598</c:v>
                </c:pt>
                <c:pt idx="672">
                  <c:v>56.711842228419798</c:v>
                </c:pt>
                <c:pt idx="673">
                  <c:v>56.704181976900998</c:v>
                </c:pt>
                <c:pt idx="674">
                  <c:v>56.696521725382098</c:v>
                </c:pt>
                <c:pt idx="675">
                  <c:v>56.688861473863298</c:v>
                </c:pt>
                <c:pt idx="676">
                  <c:v>56.681201222344498</c:v>
                </c:pt>
                <c:pt idx="677">
                  <c:v>56.673540970825599</c:v>
                </c:pt>
                <c:pt idx="678">
                  <c:v>56.665880719306799</c:v>
                </c:pt>
                <c:pt idx="679">
                  <c:v>56.658220467787999</c:v>
                </c:pt>
                <c:pt idx="680">
                  <c:v>56.650560216269199</c:v>
                </c:pt>
                <c:pt idx="681">
                  <c:v>56.642899964750299</c:v>
                </c:pt>
                <c:pt idx="682">
                  <c:v>56.635239713231499</c:v>
                </c:pt>
                <c:pt idx="683">
                  <c:v>56.627579461712699</c:v>
                </c:pt>
                <c:pt idx="684">
                  <c:v>56.6199192101938</c:v>
                </c:pt>
                <c:pt idx="685">
                  <c:v>56.612258958675</c:v>
                </c:pt>
                <c:pt idx="686">
                  <c:v>56.6045987071562</c:v>
                </c:pt>
                <c:pt idx="687">
                  <c:v>56.5969384556374</c:v>
                </c:pt>
                <c:pt idx="688">
                  <c:v>56.5892782041185</c:v>
                </c:pt>
                <c:pt idx="689">
                  <c:v>56.5816179525997</c:v>
                </c:pt>
                <c:pt idx="690">
                  <c:v>56.5739577010809</c:v>
                </c:pt>
                <c:pt idx="691">
                  <c:v>56.566297449562001</c:v>
                </c:pt>
                <c:pt idx="692">
                  <c:v>56.558637198043201</c:v>
                </c:pt>
                <c:pt idx="693">
                  <c:v>56.550976946524401</c:v>
                </c:pt>
                <c:pt idx="694">
                  <c:v>56.543316695005601</c:v>
                </c:pt>
                <c:pt idx="695">
                  <c:v>56.535656443486701</c:v>
                </c:pt>
                <c:pt idx="696">
                  <c:v>56.527996191967901</c:v>
                </c:pt>
                <c:pt idx="697">
                  <c:v>56.520335940449101</c:v>
                </c:pt>
                <c:pt idx="698">
                  <c:v>56.512675688930202</c:v>
                </c:pt>
                <c:pt idx="699">
                  <c:v>56.505015437411402</c:v>
                </c:pt>
                <c:pt idx="700">
                  <c:v>56.497355185892602</c:v>
                </c:pt>
                <c:pt idx="701">
                  <c:v>56.489694934373802</c:v>
                </c:pt>
                <c:pt idx="702">
                  <c:v>56.482034682854902</c:v>
                </c:pt>
                <c:pt idx="703">
                  <c:v>56.474374431336102</c:v>
                </c:pt>
                <c:pt idx="704">
                  <c:v>56.466714179817302</c:v>
                </c:pt>
                <c:pt idx="705">
                  <c:v>56.459053928298403</c:v>
                </c:pt>
                <c:pt idx="706">
                  <c:v>56.451393676779603</c:v>
                </c:pt>
                <c:pt idx="707">
                  <c:v>56.443733425260803</c:v>
                </c:pt>
                <c:pt idx="708">
                  <c:v>56.436073173741903</c:v>
                </c:pt>
                <c:pt idx="709">
                  <c:v>56.428412922223103</c:v>
                </c:pt>
                <c:pt idx="710">
                  <c:v>56.420752670704303</c:v>
                </c:pt>
                <c:pt idx="711">
                  <c:v>56.413092419185503</c:v>
                </c:pt>
                <c:pt idx="712">
                  <c:v>56.405432167666604</c:v>
                </c:pt>
                <c:pt idx="713">
                  <c:v>56.397771916147803</c:v>
                </c:pt>
                <c:pt idx="714">
                  <c:v>56.390111664629003</c:v>
                </c:pt>
                <c:pt idx="715">
                  <c:v>56.382451413110203</c:v>
                </c:pt>
                <c:pt idx="716">
                  <c:v>56.374791161591297</c:v>
                </c:pt>
                <c:pt idx="717">
                  <c:v>56.367130910072497</c:v>
                </c:pt>
                <c:pt idx="718">
                  <c:v>56.359470658553697</c:v>
                </c:pt>
                <c:pt idx="719">
                  <c:v>56.351810407034797</c:v>
                </c:pt>
                <c:pt idx="720">
                  <c:v>56.344150155515997</c:v>
                </c:pt>
                <c:pt idx="721">
                  <c:v>56.336489903997197</c:v>
                </c:pt>
                <c:pt idx="722">
                  <c:v>56.328829652478397</c:v>
                </c:pt>
                <c:pt idx="723">
                  <c:v>56.321169400959498</c:v>
                </c:pt>
                <c:pt idx="724">
                  <c:v>56.313509149440698</c:v>
                </c:pt>
                <c:pt idx="725">
                  <c:v>56.305848897921898</c:v>
                </c:pt>
                <c:pt idx="726">
                  <c:v>56.298188646402998</c:v>
                </c:pt>
                <c:pt idx="727">
                  <c:v>56.290528394884198</c:v>
                </c:pt>
                <c:pt idx="728">
                  <c:v>56.282868143365398</c:v>
                </c:pt>
                <c:pt idx="729">
                  <c:v>56.275207891846598</c:v>
                </c:pt>
                <c:pt idx="730">
                  <c:v>56.267547640327699</c:v>
                </c:pt>
                <c:pt idx="731">
                  <c:v>56.259887388808899</c:v>
                </c:pt>
                <c:pt idx="732">
                  <c:v>56.252227137290099</c:v>
                </c:pt>
                <c:pt idx="733">
                  <c:v>56.244566885771199</c:v>
                </c:pt>
                <c:pt idx="734">
                  <c:v>56.236906634252399</c:v>
                </c:pt>
                <c:pt idx="735">
                  <c:v>53.4792160874741</c:v>
                </c:pt>
                <c:pt idx="736">
                  <c:v>53.4715558359553</c:v>
                </c:pt>
                <c:pt idx="737">
                  <c:v>53.463895584436401</c:v>
                </c:pt>
                <c:pt idx="738">
                  <c:v>53.456235332917601</c:v>
                </c:pt>
                <c:pt idx="739">
                  <c:v>53.448575081398801</c:v>
                </c:pt>
                <c:pt idx="740">
                  <c:v>53.440914829880001</c:v>
                </c:pt>
                <c:pt idx="741">
                  <c:v>53.433254578361101</c:v>
                </c:pt>
                <c:pt idx="742">
                  <c:v>53.425594326842301</c:v>
                </c:pt>
                <c:pt idx="743">
                  <c:v>53.417934075323501</c:v>
                </c:pt>
                <c:pt idx="744">
                  <c:v>53.410273823804602</c:v>
                </c:pt>
                <c:pt idx="745">
                  <c:v>53.402613572285802</c:v>
                </c:pt>
                <c:pt idx="746">
                  <c:v>53.394953320767002</c:v>
                </c:pt>
                <c:pt idx="747">
                  <c:v>53.387293069248202</c:v>
                </c:pt>
                <c:pt idx="748">
                  <c:v>53.379632817729302</c:v>
                </c:pt>
                <c:pt idx="749">
                  <c:v>53.371972566210502</c:v>
                </c:pt>
                <c:pt idx="750">
                  <c:v>53.364312314691702</c:v>
                </c:pt>
                <c:pt idx="751">
                  <c:v>53.356652063172803</c:v>
                </c:pt>
                <c:pt idx="752">
                  <c:v>53.348991811654003</c:v>
                </c:pt>
                <c:pt idx="753">
                  <c:v>53.341331560135202</c:v>
                </c:pt>
                <c:pt idx="754">
                  <c:v>53.333671308616402</c:v>
                </c:pt>
                <c:pt idx="755">
                  <c:v>53.326011057097503</c:v>
                </c:pt>
                <c:pt idx="756">
                  <c:v>53.318350805578703</c:v>
                </c:pt>
                <c:pt idx="757">
                  <c:v>53.310690554059903</c:v>
                </c:pt>
                <c:pt idx="758">
                  <c:v>53.303030302541003</c:v>
                </c:pt>
                <c:pt idx="759">
                  <c:v>53.295370051022203</c:v>
                </c:pt>
                <c:pt idx="760">
                  <c:v>53.287709799503403</c:v>
                </c:pt>
                <c:pt idx="761">
                  <c:v>53.280049547984603</c:v>
                </c:pt>
                <c:pt idx="762">
                  <c:v>53.272389296465697</c:v>
                </c:pt>
                <c:pt idx="763">
                  <c:v>53.264729044946897</c:v>
                </c:pt>
                <c:pt idx="764">
                  <c:v>53.257068793428097</c:v>
                </c:pt>
                <c:pt idx="765">
                  <c:v>53.249408541909197</c:v>
                </c:pt>
                <c:pt idx="766">
                  <c:v>53.241748290390397</c:v>
                </c:pt>
                <c:pt idx="767">
                  <c:v>53.234088038871597</c:v>
                </c:pt>
                <c:pt idx="768">
                  <c:v>53.226427787352797</c:v>
                </c:pt>
                <c:pt idx="769">
                  <c:v>53.218767535833898</c:v>
                </c:pt>
                <c:pt idx="770">
                  <c:v>53.211107284315098</c:v>
                </c:pt>
                <c:pt idx="771">
                  <c:v>53.203447032796298</c:v>
                </c:pt>
                <c:pt idx="772">
                  <c:v>53.195786781277398</c:v>
                </c:pt>
                <c:pt idx="773">
                  <c:v>53.188126529758598</c:v>
                </c:pt>
                <c:pt idx="774">
                  <c:v>53.180466278239798</c:v>
                </c:pt>
                <c:pt idx="775">
                  <c:v>53.172806026720998</c:v>
                </c:pt>
                <c:pt idx="776">
                  <c:v>53.165145775202099</c:v>
                </c:pt>
                <c:pt idx="777">
                  <c:v>53.157485523683299</c:v>
                </c:pt>
                <c:pt idx="778">
                  <c:v>53.149825272164499</c:v>
                </c:pt>
                <c:pt idx="779">
                  <c:v>53.142165020645599</c:v>
                </c:pt>
                <c:pt idx="780">
                  <c:v>53.134504769126799</c:v>
                </c:pt>
                <c:pt idx="781">
                  <c:v>53.126844517607999</c:v>
                </c:pt>
                <c:pt idx="782">
                  <c:v>53.119184266089199</c:v>
                </c:pt>
                <c:pt idx="783">
                  <c:v>53.1115240145703</c:v>
                </c:pt>
                <c:pt idx="784">
                  <c:v>53.1038637630515</c:v>
                </c:pt>
                <c:pt idx="785">
                  <c:v>53.0962035115327</c:v>
                </c:pt>
                <c:pt idx="786">
                  <c:v>50.338512964754401</c:v>
                </c:pt>
                <c:pt idx="787">
                  <c:v>50.330852713235501</c:v>
                </c:pt>
                <c:pt idx="788">
                  <c:v>50.323192461716701</c:v>
                </c:pt>
                <c:pt idx="789">
                  <c:v>50.315532210197901</c:v>
                </c:pt>
                <c:pt idx="790">
                  <c:v>50.307871958679002</c:v>
                </c:pt>
                <c:pt idx="791">
                  <c:v>50.300211707160202</c:v>
                </c:pt>
                <c:pt idx="792">
                  <c:v>50.292551455641402</c:v>
                </c:pt>
                <c:pt idx="793">
                  <c:v>50.284891204122601</c:v>
                </c:pt>
                <c:pt idx="794">
                  <c:v>50.277230952603702</c:v>
                </c:pt>
                <c:pt idx="795">
                  <c:v>50.269570701084902</c:v>
                </c:pt>
                <c:pt idx="796">
                  <c:v>50.261910449566102</c:v>
                </c:pt>
                <c:pt idx="797">
                  <c:v>50.254250198047203</c:v>
                </c:pt>
                <c:pt idx="798">
                  <c:v>50.246589946528402</c:v>
                </c:pt>
                <c:pt idx="799">
                  <c:v>50.238929695009602</c:v>
                </c:pt>
                <c:pt idx="800">
                  <c:v>50.231269443490802</c:v>
                </c:pt>
                <c:pt idx="801">
                  <c:v>50.223609191971903</c:v>
                </c:pt>
                <c:pt idx="802">
                  <c:v>50.215948940453103</c:v>
                </c:pt>
                <c:pt idx="803">
                  <c:v>50.208288688934303</c:v>
                </c:pt>
                <c:pt idx="804">
                  <c:v>50.200628437415403</c:v>
                </c:pt>
                <c:pt idx="805">
                  <c:v>50.192968185896603</c:v>
                </c:pt>
                <c:pt idx="806">
                  <c:v>50.185307934377803</c:v>
                </c:pt>
                <c:pt idx="807">
                  <c:v>50.177647682859003</c:v>
                </c:pt>
                <c:pt idx="808">
                  <c:v>50.169987431340097</c:v>
                </c:pt>
                <c:pt idx="809">
                  <c:v>50.162327179821297</c:v>
                </c:pt>
                <c:pt idx="810">
                  <c:v>50.154666928302497</c:v>
                </c:pt>
                <c:pt idx="811">
                  <c:v>50.147006676783597</c:v>
                </c:pt>
                <c:pt idx="812">
                  <c:v>50.139346425264797</c:v>
                </c:pt>
                <c:pt idx="813">
                  <c:v>50.131686173745997</c:v>
                </c:pt>
                <c:pt idx="814">
                  <c:v>50.124025922227197</c:v>
                </c:pt>
                <c:pt idx="815">
                  <c:v>50.116365670708298</c:v>
                </c:pt>
                <c:pt idx="816">
                  <c:v>50.108705419189498</c:v>
                </c:pt>
                <c:pt idx="817">
                  <c:v>50.101045167670698</c:v>
                </c:pt>
                <c:pt idx="818">
                  <c:v>50.093384916151798</c:v>
                </c:pt>
                <c:pt idx="819">
                  <c:v>50.085724664632998</c:v>
                </c:pt>
                <c:pt idx="820">
                  <c:v>50.078064413114198</c:v>
                </c:pt>
                <c:pt idx="821">
                  <c:v>50.070404161595398</c:v>
                </c:pt>
                <c:pt idx="822">
                  <c:v>50.062743910076499</c:v>
                </c:pt>
                <c:pt idx="823">
                  <c:v>50.055083658557699</c:v>
                </c:pt>
                <c:pt idx="824">
                  <c:v>50.047423407038899</c:v>
                </c:pt>
                <c:pt idx="825">
                  <c:v>50.039763155519999</c:v>
                </c:pt>
                <c:pt idx="826">
                  <c:v>50.032102904001199</c:v>
                </c:pt>
                <c:pt idx="827">
                  <c:v>48.959667691365198</c:v>
                </c:pt>
                <c:pt idx="828">
                  <c:v>48.952007439846398</c:v>
                </c:pt>
                <c:pt idx="829">
                  <c:v>48.944347188327498</c:v>
                </c:pt>
                <c:pt idx="830">
                  <c:v>48.936686936808698</c:v>
                </c:pt>
                <c:pt idx="831">
                  <c:v>48.929026685289898</c:v>
                </c:pt>
                <c:pt idx="832">
                  <c:v>48.921366433771098</c:v>
                </c:pt>
                <c:pt idx="833">
                  <c:v>48.913706182252199</c:v>
                </c:pt>
                <c:pt idx="834">
                  <c:v>48.906045930733399</c:v>
                </c:pt>
                <c:pt idx="835">
                  <c:v>48.898385679214599</c:v>
                </c:pt>
                <c:pt idx="836">
                  <c:v>48.890725427695699</c:v>
                </c:pt>
                <c:pt idx="837">
                  <c:v>48.883065176176899</c:v>
                </c:pt>
                <c:pt idx="838">
                  <c:v>48.875404924658099</c:v>
                </c:pt>
                <c:pt idx="839">
                  <c:v>48.867744673139299</c:v>
                </c:pt>
                <c:pt idx="840">
                  <c:v>48.8600844216204</c:v>
                </c:pt>
                <c:pt idx="841">
                  <c:v>48.8524241701016</c:v>
                </c:pt>
                <c:pt idx="842">
                  <c:v>48.8447639185828</c:v>
                </c:pt>
                <c:pt idx="843">
                  <c:v>48.8371036670639</c:v>
                </c:pt>
                <c:pt idx="844">
                  <c:v>48.8294434155451</c:v>
                </c:pt>
                <c:pt idx="845">
                  <c:v>48.8217831640263</c:v>
                </c:pt>
                <c:pt idx="846">
                  <c:v>48.8141229125075</c:v>
                </c:pt>
                <c:pt idx="847">
                  <c:v>48.806462660988601</c:v>
                </c:pt>
                <c:pt idx="848">
                  <c:v>48.798802409469801</c:v>
                </c:pt>
                <c:pt idx="849">
                  <c:v>48.791142157951001</c:v>
                </c:pt>
                <c:pt idx="850">
                  <c:v>48.783481906432101</c:v>
                </c:pt>
                <c:pt idx="851">
                  <c:v>48.775821654913301</c:v>
                </c:pt>
                <c:pt idx="852">
                  <c:v>48.768161403394501</c:v>
                </c:pt>
                <c:pt idx="853">
                  <c:v>48.760501151875701</c:v>
                </c:pt>
                <c:pt idx="854">
                  <c:v>48.752840900356802</c:v>
                </c:pt>
                <c:pt idx="855">
                  <c:v>48.745180648838002</c:v>
                </c:pt>
                <c:pt idx="856">
                  <c:v>48.737520397319201</c:v>
                </c:pt>
                <c:pt idx="857">
                  <c:v>48.729860145800302</c:v>
                </c:pt>
                <c:pt idx="858">
                  <c:v>48.722199894281502</c:v>
                </c:pt>
                <c:pt idx="859">
                  <c:v>48.714539642762702</c:v>
                </c:pt>
                <c:pt idx="860">
                  <c:v>48.706879391243902</c:v>
                </c:pt>
                <c:pt idx="861">
                  <c:v>48.699219139725002</c:v>
                </c:pt>
                <c:pt idx="862">
                  <c:v>48.691558888206202</c:v>
                </c:pt>
                <c:pt idx="863">
                  <c:v>48.683898636687402</c:v>
                </c:pt>
                <c:pt idx="864">
                  <c:v>48.676238385168503</c:v>
                </c:pt>
                <c:pt idx="865">
                  <c:v>48.668578133649703</c:v>
                </c:pt>
                <c:pt idx="866">
                  <c:v>48.660917882130903</c:v>
                </c:pt>
                <c:pt idx="867">
                  <c:v>48.653257630612103</c:v>
                </c:pt>
                <c:pt idx="868">
                  <c:v>48.645597379093203</c:v>
                </c:pt>
                <c:pt idx="869">
                  <c:v>48.637937127574403</c:v>
                </c:pt>
                <c:pt idx="870">
                  <c:v>48.630276876055603</c:v>
                </c:pt>
                <c:pt idx="871">
                  <c:v>48.622616624536803</c:v>
                </c:pt>
                <c:pt idx="872">
                  <c:v>48.614956373017897</c:v>
                </c:pt>
                <c:pt idx="873">
                  <c:v>48.607296121499097</c:v>
                </c:pt>
                <c:pt idx="874">
                  <c:v>48.599635869980297</c:v>
                </c:pt>
                <c:pt idx="875">
                  <c:v>48.591975618461397</c:v>
                </c:pt>
                <c:pt idx="876">
                  <c:v>48.584315366942597</c:v>
                </c:pt>
                <c:pt idx="877">
                  <c:v>48.576655115423797</c:v>
                </c:pt>
                <c:pt idx="878">
                  <c:v>44.440119295256302</c:v>
                </c:pt>
                <c:pt idx="879">
                  <c:v>44.432459043737502</c:v>
                </c:pt>
                <c:pt idx="880">
                  <c:v>44.424798792218702</c:v>
                </c:pt>
                <c:pt idx="881">
                  <c:v>44.417138540699803</c:v>
                </c:pt>
                <c:pt idx="882">
                  <c:v>44.409478289181003</c:v>
                </c:pt>
                <c:pt idx="883">
                  <c:v>44.401818037662203</c:v>
                </c:pt>
                <c:pt idx="884">
                  <c:v>44.394157786143303</c:v>
                </c:pt>
                <c:pt idx="885">
                  <c:v>44.386497534624503</c:v>
                </c:pt>
                <c:pt idx="886">
                  <c:v>44.378837283105703</c:v>
                </c:pt>
                <c:pt idx="887">
                  <c:v>44.371177031586797</c:v>
                </c:pt>
                <c:pt idx="888">
                  <c:v>44.363516780067997</c:v>
                </c:pt>
                <c:pt idx="889">
                  <c:v>44.355856528549197</c:v>
                </c:pt>
                <c:pt idx="890">
                  <c:v>44.348196277030397</c:v>
                </c:pt>
                <c:pt idx="891">
                  <c:v>44.340536025511497</c:v>
                </c:pt>
                <c:pt idx="892">
                  <c:v>44.332875773992697</c:v>
                </c:pt>
                <c:pt idx="893">
                  <c:v>44.325215522473897</c:v>
                </c:pt>
                <c:pt idx="894">
                  <c:v>44.317555270954998</c:v>
                </c:pt>
                <c:pt idx="895">
                  <c:v>44.309895019436198</c:v>
                </c:pt>
                <c:pt idx="896">
                  <c:v>44.302234767917398</c:v>
                </c:pt>
                <c:pt idx="897">
                  <c:v>44.294574516398598</c:v>
                </c:pt>
                <c:pt idx="898">
                  <c:v>44.286914264879698</c:v>
                </c:pt>
                <c:pt idx="899">
                  <c:v>44.279254013360898</c:v>
                </c:pt>
                <c:pt idx="900">
                  <c:v>44.271593761842098</c:v>
                </c:pt>
                <c:pt idx="901">
                  <c:v>44.263933510323199</c:v>
                </c:pt>
                <c:pt idx="902">
                  <c:v>44.256273258804399</c:v>
                </c:pt>
                <c:pt idx="903">
                  <c:v>44.248613007285599</c:v>
                </c:pt>
                <c:pt idx="904">
                  <c:v>44.240952755766799</c:v>
                </c:pt>
                <c:pt idx="905">
                  <c:v>44.233292504247899</c:v>
                </c:pt>
                <c:pt idx="906">
                  <c:v>44.225632252729099</c:v>
                </c:pt>
                <c:pt idx="907">
                  <c:v>44.217972001210299</c:v>
                </c:pt>
                <c:pt idx="908">
                  <c:v>44.2103117496914</c:v>
                </c:pt>
                <c:pt idx="909">
                  <c:v>44.2026514981726</c:v>
                </c:pt>
                <c:pt idx="910">
                  <c:v>44.1949912466538</c:v>
                </c:pt>
                <c:pt idx="911">
                  <c:v>44.187330995135</c:v>
                </c:pt>
                <c:pt idx="912">
                  <c:v>44.1796707436161</c:v>
                </c:pt>
                <c:pt idx="913">
                  <c:v>44.1720104920973</c:v>
                </c:pt>
                <c:pt idx="914">
                  <c:v>44.1643502405785</c:v>
                </c:pt>
                <c:pt idx="915">
                  <c:v>44.156689989059601</c:v>
                </c:pt>
                <c:pt idx="916">
                  <c:v>44.149029737540801</c:v>
                </c:pt>
                <c:pt idx="917">
                  <c:v>44.141369486022001</c:v>
                </c:pt>
                <c:pt idx="918">
                  <c:v>44.1337092345032</c:v>
                </c:pt>
                <c:pt idx="919">
                  <c:v>44.126048982984301</c:v>
                </c:pt>
                <c:pt idx="920">
                  <c:v>44.118388731465501</c:v>
                </c:pt>
                <c:pt idx="921">
                  <c:v>44.110728479946701</c:v>
                </c:pt>
                <c:pt idx="922">
                  <c:v>44.103068228427802</c:v>
                </c:pt>
                <c:pt idx="923">
                  <c:v>44.095407976909001</c:v>
                </c:pt>
                <c:pt idx="924">
                  <c:v>44.087747725390201</c:v>
                </c:pt>
                <c:pt idx="925">
                  <c:v>44.080087473871401</c:v>
                </c:pt>
                <c:pt idx="926">
                  <c:v>44.072427222352502</c:v>
                </c:pt>
                <c:pt idx="927">
                  <c:v>44.064766970833702</c:v>
                </c:pt>
                <c:pt idx="928">
                  <c:v>44.057106719314902</c:v>
                </c:pt>
                <c:pt idx="929">
                  <c:v>44.049446467796002</c:v>
                </c:pt>
                <c:pt idx="930">
                  <c:v>44.041786216277202</c:v>
                </c:pt>
                <c:pt idx="931">
                  <c:v>44.034125964758402</c:v>
                </c:pt>
                <c:pt idx="932">
                  <c:v>44.026465713239602</c:v>
                </c:pt>
                <c:pt idx="933">
                  <c:v>44.018805461720703</c:v>
                </c:pt>
                <c:pt idx="934">
                  <c:v>44.011145210201903</c:v>
                </c:pt>
                <c:pt idx="935">
                  <c:v>44.003484958683103</c:v>
                </c:pt>
                <c:pt idx="936">
                  <c:v>43.995824707164203</c:v>
                </c:pt>
                <c:pt idx="937">
                  <c:v>43.988164455645403</c:v>
                </c:pt>
                <c:pt idx="938">
                  <c:v>43.980504204126603</c:v>
                </c:pt>
                <c:pt idx="939">
                  <c:v>43.520889112996898</c:v>
                </c:pt>
                <c:pt idx="940">
                  <c:v>43.513228861477998</c:v>
                </c:pt>
                <c:pt idx="941">
                  <c:v>43.505568609959198</c:v>
                </c:pt>
                <c:pt idx="942">
                  <c:v>43.497908358440398</c:v>
                </c:pt>
                <c:pt idx="943">
                  <c:v>43.490248106921598</c:v>
                </c:pt>
                <c:pt idx="944">
                  <c:v>43.482587855402699</c:v>
                </c:pt>
                <c:pt idx="945">
                  <c:v>43.474927603883899</c:v>
                </c:pt>
                <c:pt idx="946">
                  <c:v>43.467267352365099</c:v>
                </c:pt>
                <c:pt idx="947">
                  <c:v>43.459607100846199</c:v>
                </c:pt>
                <c:pt idx="948">
                  <c:v>43.451946849327399</c:v>
                </c:pt>
                <c:pt idx="949">
                  <c:v>43.444286597808599</c:v>
                </c:pt>
                <c:pt idx="950">
                  <c:v>43.436626346289799</c:v>
                </c:pt>
                <c:pt idx="951">
                  <c:v>43.4289660947709</c:v>
                </c:pt>
                <c:pt idx="952">
                  <c:v>43.4213058432521</c:v>
                </c:pt>
                <c:pt idx="953">
                  <c:v>43.4136455917333</c:v>
                </c:pt>
                <c:pt idx="954">
                  <c:v>43.4059853402144</c:v>
                </c:pt>
                <c:pt idx="955">
                  <c:v>43.3983250886956</c:v>
                </c:pt>
                <c:pt idx="956">
                  <c:v>43.3906648371768</c:v>
                </c:pt>
                <c:pt idx="957">
                  <c:v>43.383004585658</c:v>
                </c:pt>
                <c:pt idx="958">
                  <c:v>43.375344334139101</c:v>
                </c:pt>
                <c:pt idx="959">
                  <c:v>43.367684082620301</c:v>
                </c:pt>
                <c:pt idx="960">
                  <c:v>43.3600238311015</c:v>
                </c:pt>
                <c:pt idx="961">
                  <c:v>43.352363579582601</c:v>
                </c:pt>
                <c:pt idx="962">
                  <c:v>43.344703328063801</c:v>
                </c:pt>
                <c:pt idx="963">
                  <c:v>43.337043076545001</c:v>
                </c:pt>
                <c:pt idx="964">
                  <c:v>43.329382825026102</c:v>
                </c:pt>
                <c:pt idx="965">
                  <c:v>43.321722573507301</c:v>
                </c:pt>
                <c:pt idx="966">
                  <c:v>43.314062321988501</c:v>
                </c:pt>
                <c:pt idx="967">
                  <c:v>43.306402070469701</c:v>
                </c:pt>
                <c:pt idx="968">
                  <c:v>43.298741818950802</c:v>
                </c:pt>
                <c:pt idx="969">
                  <c:v>43.291081567432002</c:v>
                </c:pt>
                <c:pt idx="970">
                  <c:v>43.283421315913202</c:v>
                </c:pt>
                <c:pt idx="971">
                  <c:v>43.275761064394302</c:v>
                </c:pt>
                <c:pt idx="972">
                  <c:v>43.268100812875502</c:v>
                </c:pt>
                <c:pt idx="973">
                  <c:v>43.260440561356702</c:v>
                </c:pt>
                <c:pt idx="974">
                  <c:v>43.252780309837902</c:v>
                </c:pt>
                <c:pt idx="975">
                  <c:v>43.245120058319003</c:v>
                </c:pt>
                <c:pt idx="976">
                  <c:v>43.237459806800203</c:v>
                </c:pt>
                <c:pt idx="977">
                  <c:v>43.229799555281403</c:v>
                </c:pt>
                <c:pt idx="978">
                  <c:v>43.222139303762503</c:v>
                </c:pt>
                <c:pt idx="979">
                  <c:v>43.214479052243703</c:v>
                </c:pt>
                <c:pt idx="980">
                  <c:v>43.206818800724903</c:v>
                </c:pt>
                <c:pt idx="981">
                  <c:v>43.199158549206103</c:v>
                </c:pt>
                <c:pt idx="982">
                  <c:v>43.191498297687197</c:v>
                </c:pt>
                <c:pt idx="983">
                  <c:v>43.183838046168397</c:v>
                </c:pt>
                <c:pt idx="984">
                  <c:v>43.176177794649597</c:v>
                </c:pt>
                <c:pt idx="985">
                  <c:v>43.168517543130797</c:v>
                </c:pt>
                <c:pt idx="986">
                  <c:v>43.160857291611897</c:v>
                </c:pt>
                <c:pt idx="987">
                  <c:v>43.153197040093097</c:v>
                </c:pt>
                <c:pt idx="988">
                  <c:v>43.145536788574297</c:v>
                </c:pt>
                <c:pt idx="989">
                  <c:v>43.137876537055398</c:v>
                </c:pt>
                <c:pt idx="990">
                  <c:v>43.130216285536598</c:v>
                </c:pt>
                <c:pt idx="991">
                  <c:v>43.122556034017798</c:v>
                </c:pt>
                <c:pt idx="992">
                  <c:v>43.114895782498998</c:v>
                </c:pt>
                <c:pt idx="993">
                  <c:v>43.107235530980098</c:v>
                </c:pt>
                <c:pt idx="994">
                  <c:v>43.099575279461298</c:v>
                </c:pt>
                <c:pt idx="995">
                  <c:v>43.091915027942498</c:v>
                </c:pt>
                <c:pt idx="996">
                  <c:v>43.084254776423599</c:v>
                </c:pt>
                <c:pt idx="997">
                  <c:v>43.076594524904799</c:v>
                </c:pt>
                <c:pt idx="998">
                  <c:v>43.068934273385999</c:v>
                </c:pt>
                <c:pt idx="999">
                  <c:v>43.061274021867199</c:v>
                </c:pt>
                <c:pt idx="1000">
                  <c:v>43.053613770348299</c:v>
                </c:pt>
                <c:pt idx="1001">
                  <c:v>43.045953518829499</c:v>
                </c:pt>
                <c:pt idx="1002">
                  <c:v>43.038293267310699</c:v>
                </c:pt>
                <c:pt idx="1003">
                  <c:v>43.0306330157918</c:v>
                </c:pt>
                <c:pt idx="1004">
                  <c:v>43.022972764273</c:v>
                </c:pt>
                <c:pt idx="1005">
                  <c:v>43.0153125127542</c:v>
                </c:pt>
                <c:pt idx="1006">
                  <c:v>43.0076522612354</c:v>
                </c:pt>
                <c:pt idx="1007">
                  <c:v>42.9999920097165</c:v>
                </c:pt>
                <c:pt idx="1008">
                  <c:v>42.9923317581977</c:v>
                </c:pt>
                <c:pt idx="1009">
                  <c:v>42.9846715066789</c:v>
                </c:pt>
                <c:pt idx="1010">
                  <c:v>38.388520595381699</c:v>
                </c:pt>
                <c:pt idx="1011">
                  <c:v>38.380860343862899</c:v>
                </c:pt>
                <c:pt idx="1012">
                  <c:v>38.373200092344</c:v>
                </c:pt>
                <c:pt idx="1013">
                  <c:v>38.3655398408252</c:v>
                </c:pt>
                <c:pt idx="1014">
                  <c:v>38.3578795893064</c:v>
                </c:pt>
                <c:pt idx="1015">
                  <c:v>38.3502193377875</c:v>
                </c:pt>
                <c:pt idx="1016">
                  <c:v>38.3425590862687</c:v>
                </c:pt>
                <c:pt idx="1017">
                  <c:v>38.3348988347499</c:v>
                </c:pt>
                <c:pt idx="1018">
                  <c:v>38.3272385832311</c:v>
                </c:pt>
                <c:pt idx="1019">
                  <c:v>38.319578331712201</c:v>
                </c:pt>
                <c:pt idx="1020">
                  <c:v>38.311918080193401</c:v>
                </c:pt>
                <c:pt idx="1021">
                  <c:v>38.304257828674601</c:v>
                </c:pt>
                <c:pt idx="1022">
                  <c:v>38.296597577155701</c:v>
                </c:pt>
                <c:pt idx="1023">
                  <c:v>38.288937325636901</c:v>
                </c:pt>
                <c:pt idx="1024">
                  <c:v>38.281277074118101</c:v>
                </c:pt>
                <c:pt idx="1025">
                  <c:v>38.273616822599301</c:v>
                </c:pt>
                <c:pt idx="1026">
                  <c:v>38.265956571080402</c:v>
                </c:pt>
                <c:pt idx="1027">
                  <c:v>38.258296319561602</c:v>
                </c:pt>
                <c:pt idx="1028">
                  <c:v>38.250636068042802</c:v>
                </c:pt>
                <c:pt idx="1029">
                  <c:v>38.242975816523902</c:v>
                </c:pt>
                <c:pt idx="1030">
                  <c:v>38.235315565005102</c:v>
                </c:pt>
                <c:pt idx="1031">
                  <c:v>38.227655313486302</c:v>
                </c:pt>
                <c:pt idx="1032">
                  <c:v>38.219995061967502</c:v>
                </c:pt>
                <c:pt idx="1033">
                  <c:v>38.212334810448603</c:v>
                </c:pt>
                <c:pt idx="1034">
                  <c:v>38.204674558929803</c:v>
                </c:pt>
                <c:pt idx="1035">
                  <c:v>38.197014307411003</c:v>
                </c:pt>
                <c:pt idx="1036">
                  <c:v>38.189354055892103</c:v>
                </c:pt>
                <c:pt idx="1037">
                  <c:v>38.181693804373303</c:v>
                </c:pt>
                <c:pt idx="1038">
                  <c:v>38.174033552854503</c:v>
                </c:pt>
                <c:pt idx="1039">
                  <c:v>38.166373301335597</c:v>
                </c:pt>
                <c:pt idx="1040">
                  <c:v>38.158713049816797</c:v>
                </c:pt>
                <c:pt idx="1041">
                  <c:v>38.151052798297997</c:v>
                </c:pt>
                <c:pt idx="1042">
                  <c:v>38.143392546779197</c:v>
                </c:pt>
                <c:pt idx="1043">
                  <c:v>38.135732295260297</c:v>
                </c:pt>
                <c:pt idx="1044">
                  <c:v>38.128072043741497</c:v>
                </c:pt>
                <c:pt idx="1045">
                  <c:v>38.120411792222697</c:v>
                </c:pt>
                <c:pt idx="1046">
                  <c:v>38.112751540703897</c:v>
                </c:pt>
                <c:pt idx="1047">
                  <c:v>38.105091289184998</c:v>
                </c:pt>
                <c:pt idx="1048">
                  <c:v>38.097431037666198</c:v>
                </c:pt>
                <c:pt idx="1049">
                  <c:v>38.089770786147398</c:v>
                </c:pt>
                <c:pt idx="1050">
                  <c:v>38.082110534628498</c:v>
                </c:pt>
                <c:pt idx="1051">
                  <c:v>38.074450283109698</c:v>
                </c:pt>
                <c:pt idx="1052">
                  <c:v>38.066790031590898</c:v>
                </c:pt>
                <c:pt idx="1053">
                  <c:v>38.059129780072098</c:v>
                </c:pt>
                <c:pt idx="1054">
                  <c:v>38.051469528553199</c:v>
                </c:pt>
                <c:pt idx="1055">
                  <c:v>38.043809277034399</c:v>
                </c:pt>
                <c:pt idx="1056">
                  <c:v>38.036149025515599</c:v>
                </c:pt>
                <c:pt idx="1057">
                  <c:v>38.028488773996699</c:v>
                </c:pt>
                <c:pt idx="1058">
                  <c:v>38.020828522477899</c:v>
                </c:pt>
                <c:pt idx="1059">
                  <c:v>38.013168270959099</c:v>
                </c:pt>
                <c:pt idx="1060">
                  <c:v>38.005508019440299</c:v>
                </c:pt>
                <c:pt idx="1061">
                  <c:v>37.9978477679214</c:v>
                </c:pt>
                <c:pt idx="1062">
                  <c:v>37.990187516402599</c:v>
                </c:pt>
                <c:pt idx="1063">
                  <c:v>37.982527264883799</c:v>
                </c:pt>
                <c:pt idx="1064">
                  <c:v>37.9748670133649</c:v>
                </c:pt>
                <c:pt idx="1065">
                  <c:v>37.9672067618461</c:v>
                </c:pt>
                <c:pt idx="1066">
                  <c:v>37.9595465103273</c:v>
                </c:pt>
                <c:pt idx="1067">
                  <c:v>37.9518862588084</c:v>
                </c:pt>
                <c:pt idx="1068">
                  <c:v>37.9442260072896</c:v>
                </c:pt>
                <c:pt idx="1069">
                  <c:v>37.9365657557708</c:v>
                </c:pt>
                <c:pt idx="1070">
                  <c:v>37.928905504252</c:v>
                </c:pt>
                <c:pt idx="1071">
                  <c:v>36.626662746051103</c:v>
                </c:pt>
                <c:pt idx="1072">
                  <c:v>36.619002494532303</c:v>
                </c:pt>
                <c:pt idx="1073">
                  <c:v>36.611342243013397</c:v>
                </c:pt>
                <c:pt idx="1074">
                  <c:v>36.603681991494597</c:v>
                </c:pt>
                <c:pt idx="1075">
                  <c:v>36.596021739975797</c:v>
                </c:pt>
                <c:pt idx="1076">
                  <c:v>36.588361488456997</c:v>
                </c:pt>
                <c:pt idx="1077">
                  <c:v>36.580701236938097</c:v>
                </c:pt>
                <c:pt idx="1078">
                  <c:v>36.573040985419297</c:v>
                </c:pt>
                <c:pt idx="1079">
                  <c:v>36.565380733900497</c:v>
                </c:pt>
                <c:pt idx="1080">
                  <c:v>36.557720482381598</c:v>
                </c:pt>
                <c:pt idx="1081">
                  <c:v>36.550060230862798</c:v>
                </c:pt>
                <c:pt idx="1082">
                  <c:v>36.542399979343998</c:v>
                </c:pt>
                <c:pt idx="1083">
                  <c:v>36.534739727825198</c:v>
                </c:pt>
                <c:pt idx="1084">
                  <c:v>36.527079476306298</c:v>
                </c:pt>
                <c:pt idx="1085">
                  <c:v>36.519419224787498</c:v>
                </c:pt>
                <c:pt idx="1086">
                  <c:v>36.511758973268698</c:v>
                </c:pt>
                <c:pt idx="1087">
                  <c:v>36.504098721749799</c:v>
                </c:pt>
                <c:pt idx="1088">
                  <c:v>36.496438470230999</c:v>
                </c:pt>
                <c:pt idx="1089">
                  <c:v>36.488778218712199</c:v>
                </c:pt>
                <c:pt idx="1090">
                  <c:v>36.481117967193398</c:v>
                </c:pt>
                <c:pt idx="1091">
                  <c:v>36.473457715674499</c:v>
                </c:pt>
                <c:pt idx="1092">
                  <c:v>36.465797464155699</c:v>
                </c:pt>
                <c:pt idx="1093">
                  <c:v>36.458137212636899</c:v>
                </c:pt>
                <c:pt idx="1094">
                  <c:v>36.450476961118</c:v>
                </c:pt>
                <c:pt idx="1095">
                  <c:v>36.442816709599199</c:v>
                </c:pt>
                <c:pt idx="1096">
                  <c:v>36.435156458080399</c:v>
                </c:pt>
                <c:pt idx="1097">
                  <c:v>36.427496206561599</c:v>
                </c:pt>
                <c:pt idx="1098">
                  <c:v>36.4198359550427</c:v>
                </c:pt>
                <c:pt idx="1099">
                  <c:v>36.4121757035239</c:v>
                </c:pt>
                <c:pt idx="1100">
                  <c:v>36.4045154520051</c:v>
                </c:pt>
                <c:pt idx="1101">
                  <c:v>36.3968552004862</c:v>
                </c:pt>
                <c:pt idx="1102">
                  <c:v>36.3891949489674</c:v>
                </c:pt>
                <c:pt idx="1103">
                  <c:v>36.3815346974486</c:v>
                </c:pt>
                <c:pt idx="1104">
                  <c:v>36.373874445929701</c:v>
                </c:pt>
                <c:pt idx="1105">
                  <c:v>36.366214194410901</c:v>
                </c:pt>
                <c:pt idx="1106">
                  <c:v>36.358553942892101</c:v>
                </c:pt>
                <c:pt idx="1107">
                  <c:v>36.350893691373301</c:v>
                </c:pt>
                <c:pt idx="1108">
                  <c:v>36.343233439854401</c:v>
                </c:pt>
                <c:pt idx="1109">
                  <c:v>36.335573188335601</c:v>
                </c:pt>
                <c:pt idx="1110">
                  <c:v>36.327912936816801</c:v>
                </c:pt>
                <c:pt idx="1111">
                  <c:v>36.320252685297902</c:v>
                </c:pt>
                <c:pt idx="1112">
                  <c:v>36.312592433779102</c:v>
                </c:pt>
                <c:pt idx="1113">
                  <c:v>36.304932182260302</c:v>
                </c:pt>
                <c:pt idx="1114">
                  <c:v>36.297271930741502</c:v>
                </c:pt>
                <c:pt idx="1115">
                  <c:v>36.289611679222602</c:v>
                </c:pt>
                <c:pt idx="1116">
                  <c:v>36.281951427703802</c:v>
                </c:pt>
                <c:pt idx="1117">
                  <c:v>36.274291176185002</c:v>
                </c:pt>
                <c:pt idx="1118">
                  <c:v>36.266630924666103</c:v>
                </c:pt>
                <c:pt idx="1119">
                  <c:v>36.258970673147303</c:v>
                </c:pt>
                <c:pt idx="1120">
                  <c:v>36.251310421628503</c:v>
                </c:pt>
                <c:pt idx="1121">
                  <c:v>36.243650170109703</c:v>
                </c:pt>
                <c:pt idx="1122">
                  <c:v>36.235989918590803</c:v>
                </c:pt>
                <c:pt idx="1123">
                  <c:v>36.228329667072003</c:v>
                </c:pt>
                <c:pt idx="1124">
                  <c:v>36.220669415553203</c:v>
                </c:pt>
                <c:pt idx="1125">
                  <c:v>36.213009164034403</c:v>
                </c:pt>
                <c:pt idx="1126">
                  <c:v>36.205348912515497</c:v>
                </c:pt>
                <c:pt idx="1127">
                  <c:v>36.197688660996697</c:v>
                </c:pt>
                <c:pt idx="1128">
                  <c:v>36.190028409477897</c:v>
                </c:pt>
                <c:pt idx="1129">
                  <c:v>36.182368157958997</c:v>
                </c:pt>
                <c:pt idx="1130">
                  <c:v>36.174707906440197</c:v>
                </c:pt>
                <c:pt idx="1131">
                  <c:v>36.167047654921397</c:v>
                </c:pt>
                <c:pt idx="1132">
                  <c:v>36.159387403402597</c:v>
                </c:pt>
                <c:pt idx="1133">
                  <c:v>36.151727151883698</c:v>
                </c:pt>
                <c:pt idx="1134">
                  <c:v>36.144066900364898</c:v>
                </c:pt>
                <c:pt idx="1135">
                  <c:v>36.136406648846098</c:v>
                </c:pt>
                <c:pt idx="1136">
                  <c:v>36.128746397327198</c:v>
                </c:pt>
                <c:pt idx="1137">
                  <c:v>36.121086145808398</c:v>
                </c:pt>
                <c:pt idx="1138">
                  <c:v>36.113425894289598</c:v>
                </c:pt>
                <c:pt idx="1139">
                  <c:v>36.105765642770699</c:v>
                </c:pt>
                <c:pt idx="1140">
                  <c:v>36.098105391251899</c:v>
                </c:pt>
                <c:pt idx="1141">
                  <c:v>36.090445139733099</c:v>
                </c:pt>
                <c:pt idx="1142">
                  <c:v>36.082784888214299</c:v>
                </c:pt>
                <c:pt idx="1143">
                  <c:v>36.075124636695399</c:v>
                </c:pt>
                <c:pt idx="1144">
                  <c:v>36.067464385176599</c:v>
                </c:pt>
                <c:pt idx="1145">
                  <c:v>36.059804133657799</c:v>
                </c:pt>
                <c:pt idx="1146">
                  <c:v>36.0521438821389</c:v>
                </c:pt>
                <c:pt idx="1147">
                  <c:v>36.0444836306201</c:v>
                </c:pt>
                <c:pt idx="1148">
                  <c:v>36.0368233791013</c:v>
                </c:pt>
                <c:pt idx="1149">
                  <c:v>36.0291631275825</c:v>
                </c:pt>
                <c:pt idx="1150">
                  <c:v>36.0215028760636</c:v>
                </c:pt>
                <c:pt idx="1151">
                  <c:v>36.0138426245448</c:v>
                </c:pt>
                <c:pt idx="1152">
                  <c:v>36.006182373026</c:v>
                </c:pt>
                <c:pt idx="1153">
                  <c:v>35.998522121507101</c:v>
                </c:pt>
                <c:pt idx="1154">
                  <c:v>35.990861869988301</c:v>
                </c:pt>
                <c:pt idx="1155">
                  <c:v>35.983201618469501</c:v>
                </c:pt>
                <c:pt idx="1156">
                  <c:v>35.975541366950701</c:v>
                </c:pt>
                <c:pt idx="1157">
                  <c:v>35.967881115431801</c:v>
                </c:pt>
                <c:pt idx="1158">
                  <c:v>35.960220863913001</c:v>
                </c:pt>
                <c:pt idx="1159">
                  <c:v>35.952560612394201</c:v>
                </c:pt>
                <c:pt idx="1160">
                  <c:v>35.944900360875302</c:v>
                </c:pt>
                <c:pt idx="1161">
                  <c:v>35.937240109356502</c:v>
                </c:pt>
                <c:pt idx="1162">
                  <c:v>35.929579857837702</c:v>
                </c:pt>
                <c:pt idx="1163">
                  <c:v>35.921919606318902</c:v>
                </c:pt>
                <c:pt idx="1164">
                  <c:v>35.914259354800002</c:v>
                </c:pt>
                <c:pt idx="1165">
                  <c:v>35.906599103281202</c:v>
                </c:pt>
                <c:pt idx="1166">
                  <c:v>35.898938851762402</c:v>
                </c:pt>
                <c:pt idx="1167">
                  <c:v>35.891278600243503</c:v>
                </c:pt>
                <c:pt idx="1168">
                  <c:v>35.883618348724703</c:v>
                </c:pt>
                <c:pt idx="1169">
                  <c:v>35.875958097205903</c:v>
                </c:pt>
                <c:pt idx="1170">
                  <c:v>35.868297845687103</c:v>
                </c:pt>
                <c:pt idx="1171">
                  <c:v>35.860637594168203</c:v>
                </c:pt>
                <c:pt idx="1172">
                  <c:v>34.8648048967205</c:v>
                </c:pt>
                <c:pt idx="1173">
                  <c:v>34.8571446452017</c:v>
                </c:pt>
                <c:pt idx="1174">
                  <c:v>34.8494843936829</c:v>
                </c:pt>
                <c:pt idx="1175">
                  <c:v>34.841824142164</c:v>
                </c:pt>
                <c:pt idx="1176">
                  <c:v>34.8341638906452</c:v>
                </c:pt>
                <c:pt idx="1177">
                  <c:v>34.8265036391264</c:v>
                </c:pt>
                <c:pt idx="1178">
                  <c:v>34.818843387607501</c:v>
                </c:pt>
                <c:pt idx="1179">
                  <c:v>34.811183136088701</c:v>
                </c:pt>
                <c:pt idx="1180">
                  <c:v>34.803522884569901</c:v>
                </c:pt>
                <c:pt idx="1181">
                  <c:v>34.795862633051001</c:v>
                </c:pt>
                <c:pt idx="1182">
                  <c:v>34.788202381532201</c:v>
                </c:pt>
                <c:pt idx="1183">
                  <c:v>34.780542130013401</c:v>
                </c:pt>
                <c:pt idx="1184">
                  <c:v>34.772881878494601</c:v>
                </c:pt>
                <c:pt idx="1185">
                  <c:v>34.765221626975702</c:v>
                </c:pt>
                <c:pt idx="1186">
                  <c:v>34.757561375456902</c:v>
                </c:pt>
                <c:pt idx="1187">
                  <c:v>34.749901123938102</c:v>
                </c:pt>
                <c:pt idx="1188">
                  <c:v>34.742240872419202</c:v>
                </c:pt>
                <c:pt idx="1189">
                  <c:v>34.734580620900402</c:v>
                </c:pt>
                <c:pt idx="1190">
                  <c:v>34.726920369381602</c:v>
                </c:pt>
                <c:pt idx="1191">
                  <c:v>34.719260117862802</c:v>
                </c:pt>
                <c:pt idx="1192">
                  <c:v>34.711599866343903</c:v>
                </c:pt>
                <c:pt idx="1193">
                  <c:v>34.703939614825103</c:v>
                </c:pt>
                <c:pt idx="1194">
                  <c:v>34.696279363306303</c:v>
                </c:pt>
                <c:pt idx="1195">
                  <c:v>34.688619111787403</c:v>
                </c:pt>
                <c:pt idx="1196">
                  <c:v>34.680958860268603</c:v>
                </c:pt>
                <c:pt idx="1197">
                  <c:v>34.673298608749803</c:v>
                </c:pt>
                <c:pt idx="1198">
                  <c:v>34.665638357231003</c:v>
                </c:pt>
                <c:pt idx="1199">
                  <c:v>34.657978105712097</c:v>
                </c:pt>
                <c:pt idx="1200">
                  <c:v>34.650317854193297</c:v>
                </c:pt>
                <c:pt idx="1201">
                  <c:v>34.642657602674497</c:v>
                </c:pt>
                <c:pt idx="1202">
                  <c:v>34.634997351155697</c:v>
                </c:pt>
                <c:pt idx="1203">
                  <c:v>34.627337099636797</c:v>
                </c:pt>
                <c:pt idx="1204">
                  <c:v>34.619676848117997</c:v>
                </c:pt>
                <c:pt idx="1205">
                  <c:v>34.612016596599197</c:v>
                </c:pt>
                <c:pt idx="1206">
                  <c:v>34.604356345080298</c:v>
                </c:pt>
                <c:pt idx="1207">
                  <c:v>34.596696093561498</c:v>
                </c:pt>
                <c:pt idx="1208">
                  <c:v>34.589035842042698</c:v>
                </c:pt>
                <c:pt idx="1209">
                  <c:v>34.581375590523898</c:v>
                </c:pt>
                <c:pt idx="1210">
                  <c:v>34.573715339004998</c:v>
                </c:pt>
                <c:pt idx="1211">
                  <c:v>34.566055087486198</c:v>
                </c:pt>
                <c:pt idx="1212">
                  <c:v>34.558394835967398</c:v>
                </c:pt>
                <c:pt idx="1213">
                  <c:v>34.550734584448499</c:v>
                </c:pt>
                <c:pt idx="1214">
                  <c:v>34.543074332929699</c:v>
                </c:pt>
                <c:pt idx="1215">
                  <c:v>34.535414081410899</c:v>
                </c:pt>
                <c:pt idx="1216">
                  <c:v>34.527753829891999</c:v>
                </c:pt>
                <c:pt idx="1217">
                  <c:v>34.520093578373199</c:v>
                </c:pt>
                <c:pt idx="1218">
                  <c:v>34.512433326854399</c:v>
                </c:pt>
                <c:pt idx="1219">
                  <c:v>34.504773075335599</c:v>
                </c:pt>
                <c:pt idx="1220">
                  <c:v>34.4971128238167</c:v>
                </c:pt>
                <c:pt idx="1221">
                  <c:v>34.4894525722979</c:v>
                </c:pt>
                <c:pt idx="1222">
                  <c:v>34.4817923207791</c:v>
                </c:pt>
                <c:pt idx="1223">
                  <c:v>34.4741320692602</c:v>
                </c:pt>
                <c:pt idx="1224">
                  <c:v>34.4664718177414</c:v>
                </c:pt>
                <c:pt idx="1225">
                  <c:v>34.4588115662226</c:v>
                </c:pt>
                <c:pt idx="1226">
                  <c:v>34.4511513147038</c:v>
                </c:pt>
                <c:pt idx="1227">
                  <c:v>34.443491063184901</c:v>
                </c:pt>
                <c:pt idx="1228">
                  <c:v>34.435830811666101</c:v>
                </c:pt>
                <c:pt idx="1229">
                  <c:v>34.428170560147301</c:v>
                </c:pt>
                <c:pt idx="1230">
                  <c:v>34.420510308628401</c:v>
                </c:pt>
                <c:pt idx="1231">
                  <c:v>34.412850057109601</c:v>
                </c:pt>
                <c:pt idx="1232">
                  <c:v>34.405189805590801</c:v>
                </c:pt>
                <c:pt idx="1233">
                  <c:v>34.397529554072001</c:v>
                </c:pt>
                <c:pt idx="1234">
                  <c:v>34.389869302553102</c:v>
                </c:pt>
                <c:pt idx="1235">
                  <c:v>34.382209051034302</c:v>
                </c:pt>
                <c:pt idx="1236">
                  <c:v>34.374548799515502</c:v>
                </c:pt>
                <c:pt idx="1237">
                  <c:v>34.366888547996602</c:v>
                </c:pt>
                <c:pt idx="1238">
                  <c:v>34.359228296477802</c:v>
                </c:pt>
                <c:pt idx="1239">
                  <c:v>34.351568044959002</c:v>
                </c:pt>
                <c:pt idx="1240">
                  <c:v>34.343907793440202</c:v>
                </c:pt>
                <c:pt idx="1241">
                  <c:v>34.336247541921303</c:v>
                </c:pt>
                <c:pt idx="1242">
                  <c:v>34.328587290402503</c:v>
                </c:pt>
                <c:pt idx="1243">
                  <c:v>34.320927038883703</c:v>
                </c:pt>
                <c:pt idx="1244">
                  <c:v>34.313266787364803</c:v>
                </c:pt>
                <c:pt idx="1245">
                  <c:v>34.305606535846003</c:v>
                </c:pt>
                <c:pt idx="1246">
                  <c:v>34.297946284327203</c:v>
                </c:pt>
                <c:pt idx="1247">
                  <c:v>34.290286032808403</c:v>
                </c:pt>
                <c:pt idx="1248">
                  <c:v>34.282625781289497</c:v>
                </c:pt>
                <c:pt idx="1249">
                  <c:v>34.274965529770697</c:v>
                </c:pt>
                <c:pt idx="1250">
                  <c:v>34.267305278251897</c:v>
                </c:pt>
                <c:pt idx="1251">
                  <c:v>34.259645026732997</c:v>
                </c:pt>
                <c:pt idx="1252">
                  <c:v>34.251984775214197</c:v>
                </c:pt>
                <c:pt idx="1253">
                  <c:v>34.244324523695397</c:v>
                </c:pt>
                <c:pt idx="1254">
                  <c:v>34.236664272176597</c:v>
                </c:pt>
                <c:pt idx="1255">
                  <c:v>34.229004020657698</c:v>
                </c:pt>
                <c:pt idx="1256">
                  <c:v>34.221343769138898</c:v>
                </c:pt>
                <c:pt idx="1257">
                  <c:v>34.213683517620098</c:v>
                </c:pt>
                <c:pt idx="1258">
                  <c:v>34.206023266101198</c:v>
                </c:pt>
                <c:pt idx="1259">
                  <c:v>34.198363014582398</c:v>
                </c:pt>
                <c:pt idx="1260">
                  <c:v>34.190702763063598</c:v>
                </c:pt>
                <c:pt idx="1261">
                  <c:v>34.183042511544798</c:v>
                </c:pt>
                <c:pt idx="1262">
                  <c:v>34.175382260025899</c:v>
                </c:pt>
                <c:pt idx="1263">
                  <c:v>32.873139501825101</c:v>
                </c:pt>
                <c:pt idx="1264">
                  <c:v>32.865479250306201</c:v>
                </c:pt>
                <c:pt idx="1265">
                  <c:v>32.857818998787401</c:v>
                </c:pt>
                <c:pt idx="1266">
                  <c:v>32.850158747268601</c:v>
                </c:pt>
                <c:pt idx="1267">
                  <c:v>32.842498495749702</c:v>
                </c:pt>
                <c:pt idx="1268">
                  <c:v>32.834838244230902</c:v>
                </c:pt>
                <c:pt idx="1269">
                  <c:v>32.827177992712102</c:v>
                </c:pt>
                <c:pt idx="1270">
                  <c:v>32.819517741193302</c:v>
                </c:pt>
                <c:pt idx="1271">
                  <c:v>32.811857489674402</c:v>
                </c:pt>
                <c:pt idx="1272">
                  <c:v>32.804197238155602</c:v>
                </c:pt>
                <c:pt idx="1273">
                  <c:v>32.796536986636802</c:v>
                </c:pt>
                <c:pt idx="1274">
                  <c:v>32.788876735117903</c:v>
                </c:pt>
                <c:pt idx="1275">
                  <c:v>32.781216483599103</c:v>
                </c:pt>
                <c:pt idx="1276">
                  <c:v>32.773556232080303</c:v>
                </c:pt>
                <c:pt idx="1277">
                  <c:v>32.765895980561503</c:v>
                </c:pt>
                <c:pt idx="1278">
                  <c:v>32.758235729042603</c:v>
                </c:pt>
                <c:pt idx="1279">
                  <c:v>32.750575477523803</c:v>
                </c:pt>
                <c:pt idx="1280">
                  <c:v>32.742915226005003</c:v>
                </c:pt>
                <c:pt idx="1281">
                  <c:v>32.735254974486097</c:v>
                </c:pt>
                <c:pt idx="1282">
                  <c:v>32.727594722967297</c:v>
                </c:pt>
                <c:pt idx="1283">
                  <c:v>32.719934471448497</c:v>
                </c:pt>
                <c:pt idx="1284">
                  <c:v>32.712274219929697</c:v>
                </c:pt>
                <c:pt idx="1285">
                  <c:v>32.704613968410797</c:v>
                </c:pt>
                <c:pt idx="1286">
                  <c:v>32.696953716891997</c:v>
                </c:pt>
                <c:pt idx="1287">
                  <c:v>32.689293465373197</c:v>
                </c:pt>
                <c:pt idx="1288">
                  <c:v>32.681633213854298</c:v>
                </c:pt>
                <c:pt idx="1289">
                  <c:v>32.673972962335498</c:v>
                </c:pt>
                <c:pt idx="1290">
                  <c:v>32.666312710816698</c:v>
                </c:pt>
                <c:pt idx="1291">
                  <c:v>32.658652459297898</c:v>
                </c:pt>
                <c:pt idx="1292">
                  <c:v>32.650992207778998</c:v>
                </c:pt>
                <c:pt idx="1293">
                  <c:v>32.643331956260198</c:v>
                </c:pt>
                <c:pt idx="1294">
                  <c:v>32.635671704741398</c:v>
                </c:pt>
                <c:pt idx="1295">
                  <c:v>32.628011453222499</c:v>
                </c:pt>
                <c:pt idx="1296">
                  <c:v>32.620351201703699</c:v>
                </c:pt>
                <c:pt idx="1297">
                  <c:v>32.612690950184898</c:v>
                </c:pt>
                <c:pt idx="1298">
                  <c:v>32.605030698666098</c:v>
                </c:pt>
                <c:pt idx="1299">
                  <c:v>32.597370447147199</c:v>
                </c:pt>
                <c:pt idx="1300">
                  <c:v>32.589710195628399</c:v>
                </c:pt>
                <c:pt idx="1301">
                  <c:v>32.582049944109599</c:v>
                </c:pt>
                <c:pt idx="1302">
                  <c:v>32.574389692590699</c:v>
                </c:pt>
                <c:pt idx="1303">
                  <c:v>32.566729441071899</c:v>
                </c:pt>
                <c:pt idx="1304">
                  <c:v>32.559069189553099</c:v>
                </c:pt>
                <c:pt idx="1305">
                  <c:v>32.551408938034299</c:v>
                </c:pt>
                <c:pt idx="1306">
                  <c:v>32.5437486865154</c:v>
                </c:pt>
                <c:pt idx="1307">
                  <c:v>32.5360884349966</c:v>
                </c:pt>
                <c:pt idx="1308">
                  <c:v>32.5284281834778</c:v>
                </c:pt>
                <c:pt idx="1309">
                  <c:v>32.5207679319589</c:v>
                </c:pt>
                <c:pt idx="1310">
                  <c:v>32.5131076804401</c:v>
                </c:pt>
                <c:pt idx="1311">
                  <c:v>32.5054474289213</c:v>
                </c:pt>
                <c:pt idx="1312">
                  <c:v>32.4977871774025</c:v>
                </c:pt>
                <c:pt idx="1313">
                  <c:v>32.490126925883601</c:v>
                </c:pt>
                <c:pt idx="1314">
                  <c:v>32.482466674364801</c:v>
                </c:pt>
                <c:pt idx="1315">
                  <c:v>32.474806422846001</c:v>
                </c:pt>
                <c:pt idx="1316">
                  <c:v>32.467146171327101</c:v>
                </c:pt>
                <c:pt idx="1317">
                  <c:v>32.459485919808301</c:v>
                </c:pt>
                <c:pt idx="1318">
                  <c:v>32.451825668289501</c:v>
                </c:pt>
                <c:pt idx="1319">
                  <c:v>32.444165416770701</c:v>
                </c:pt>
                <c:pt idx="1320">
                  <c:v>32.436505165251802</c:v>
                </c:pt>
                <c:pt idx="1321">
                  <c:v>32.428844913733002</c:v>
                </c:pt>
                <c:pt idx="1322">
                  <c:v>32.421184662214202</c:v>
                </c:pt>
                <c:pt idx="1323">
                  <c:v>32.413524410695302</c:v>
                </c:pt>
                <c:pt idx="1324">
                  <c:v>32.405864159176502</c:v>
                </c:pt>
                <c:pt idx="1325">
                  <c:v>32.398203907657702</c:v>
                </c:pt>
                <c:pt idx="1326">
                  <c:v>32.390543656138902</c:v>
                </c:pt>
                <c:pt idx="1327">
                  <c:v>32.382883404620003</c:v>
                </c:pt>
                <c:pt idx="1328">
                  <c:v>32.375223153101203</c:v>
                </c:pt>
                <c:pt idx="1329">
                  <c:v>32.367562901582403</c:v>
                </c:pt>
                <c:pt idx="1330">
                  <c:v>32.359902650063503</c:v>
                </c:pt>
                <c:pt idx="1331">
                  <c:v>32.352242398544703</c:v>
                </c:pt>
                <c:pt idx="1332">
                  <c:v>32.344582147025903</c:v>
                </c:pt>
                <c:pt idx="1333">
                  <c:v>32.336921895507103</c:v>
                </c:pt>
                <c:pt idx="1334">
                  <c:v>32.329261643988197</c:v>
                </c:pt>
                <c:pt idx="1335">
                  <c:v>32.321601392469397</c:v>
                </c:pt>
                <c:pt idx="1336">
                  <c:v>32.313941140950597</c:v>
                </c:pt>
                <c:pt idx="1337">
                  <c:v>32.306280889431697</c:v>
                </c:pt>
                <c:pt idx="1338">
                  <c:v>32.298620637912897</c:v>
                </c:pt>
                <c:pt idx="1339">
                  <c:v>32.290960386394097</c:v>
                </c:pt>
                <c:pt idx="1340">
                  <c:v>32.283300134875297</c:v>
                </c:pt>
                <c:pt idx="1341">
                  <c:v>32.275639883356398</c:v>
                </c:pt>
                <c:pt idx="1342">
                  <c:v>32.267979631837598</c:v>
                </c:pt>
                <c:pt idx="1343">
                  <c:v>32.260319380318798</c:v>
                </c:pt>
                <c:pt idx="1344">
                  <c:v>32.252659128799898</c:v>
                </c:pt>
                <c:pt idx="1345">
                  <c:v>32.244998877281098</c:v>
                </c:pt>
                <c:pt idx="1346">
                  <c:v>32.237338625762298</c:v>
                </c:pt>
                <c:pt idx="1347">
                  <c:v>32.229678374243498</c:v>
                </c:pt>
                <c:pt idx="1348">
                  <c:v>32.222018122724599</c:v>
                </c:pt>
                <c:pt idx="1349">
                  <c:v>32.214357871205799</c:v>
                </c:pt>
                <c:pt idx="1350">
                  <c:v>32.206697619686999</c:v>
                </c:pt>
                <c:pt idx="1351">
                  <c:v>32.199037368168099</c:v>
                </c:pt>
                <c:pt idx="1352">
                  <c:v>32.191377116649299</c:v>
                </c:pt>
                <c:pt idx="1353">
                  <c:v>32.183716865130499</c:v>
                </c:pt>
                <c:pt idx="1354">
                  <c:v>32.176056613611699</c:v>
                </c:pt>
                <c:pt idx="1355">
                  <c:v>32.1683963620928</c:v>
                </c:pt>
                <c:pt idx="1356">
                  <c:v>32.160736110574</c:v>
                </c:pt>
                <c:pt idx="1357">
                  <c:v>32.1530758590552</c:v>
                </c:pt>
                <c:pt idx="1358">
                  <c:v>32.1454156075363</c:v>
                </c:pt>
                <c:pt idx="1359">
                  <c:v>32.1377553560175</c:v>
                </c:pt>
                <c:pt idx="1360">
                  <c:v>32.1300951044987</c:v>
                </c:pt>
                <c:pt idx="1361">
                  <c:v>32.1224348529799</c:v>
                </c:pt>
                <c:pt idx="1362">
                  <c:v>32.114774601461001</c:v>
                </c:pt>
                <c:pt idx="1363">
                  <c:v>32.107114349942201</c:v>
                </c:pt>
                <c:pt idx="1364">
                  <c:v>32.099454098423401</c:v>
                </c:pt>
                <c:pt idx="1365">
                  <c:v>32.091793846904501</c:v>
                </c:pt>
                <c:pt idx="1366">
                  <c:v>32.084133595385701</c:v>
                </c:pt>
                <c:pt idx="1367">
                  <c:v>32.076473343866901</c:v>
                </c:pt>
                <c:pt idx="1368">
                  <c:v>32.068813092348101</c:v>
                </c:pt>
                <c:pt idx="1369">
                  <c:v>32.061152840829202</c:v>
                </c:pt>
                <c:pt idx="1370">
                  <c:v>32.053492589310402</c:v>
                </c:pt>
                <c:pt idx="1371">
                  <c:v>32.045832337791602</c:v>
                </c:pt>
                <c:pt idx="1372">
                  <c:v>32.038172086272702</c:v>
                </c:pt>
                <c:pt idx="1373">
                  <c:v>32.030511834753902</c:v>
                </c:pt>
                <c:pt idx="1374">
                  <c:v>32.022851583235102</c:v>
                </c:pt>
                <c:pt idx="1375">
                  <c:v>32.015191331716302</c:v>
                </c:pt>
                <c:pt idx="1376">
                  <c:v>32.007531080197403</c:v>
                </c:pt>
                <c:pt idx="1377">
                  <c:v>31.999870828678599</c:v>
                </c:pt>
                <c:pt idx="1378">
                  <c:v>31.992210577159799</c:v>
                </c:pt>
                <c:pt idx="1379">
                  <c:v>31.9845503256409</c:v>
                </c:pt>
                <c:pt idx="1380">
                  <c:v>31.9768900741221</c:v>
                </c:pt>
                <c:pt idx="1381">
                  <c:v>31.9692298226033</c:v>
                </c:pt>
                <c:pt idx="1382">
                  <c:v>31.9615695710845</c:v>
                </c:pt>
                <c:pt idx="1383">
                  <c:v>31.9539093195656</c:v>
                </c:pt>
                <c:pt idx="1384">
                  <c:v>31.9462490680468</c:v>
                </c:pt>
                <c:pt idx="1385">
                  <c:v>31.938588816528</c:v>
                </c:pt>
                <c:pt idx="1386">
                  <c:v>31.930928565009101</c:v>
                </c:pt>
                <c:pt idx="1387">
                  <c:v>31.923268313490301</c:v>
                </c:pt>
                <c:pt idx="1388">
                  <c:v>31.915608061971501</c:v>
                </c:pt>
                <c:pt idx="1389">
                  <c:v>31.907947810452601</c:v>
                </c:pt>
                <c:pt idx="1390">
                  <c:v>31.900287558933801</c:v>
                </c:pt>
                <c:pt idx="1391">
                  <c:v>31.892627307415001</c:v>
                </c:pt>
                <c:pt idx="1392">
                  <c:v>31.884967055896201</c:v>
                </c:pt>
                <c:pt idx="1393">
                  <c:v>31.877306804377302</c:v>
                </c:pt>
                <c:pt idx="1394">
                  <c:v>31.869646552858502</c:v>
                </c:pt>
                <c:pt idx="1395">
                  <c:v>31.861986301339702</c:v>
                </c:pt>
                <c:pt idx="1396">
                  <c:v>31.854326049820902</c:v>
                </c:pt>
                <c:pt idx="1397">
                  <c:v>31.846665798301999</c:v>
                </c:pt>
                <c:pt idx="1398">
                  <c:v>31.839005546783198</c:v>
                </c:pt>
                <c:pt idx="1399">
                  <c:v>31.831345295264398</c:v>
                </c:pt>
                <c:pt idx="1400">
                  <c:v>31.823685043745499</c:v>
                </c:pt>
                <c:pt idx="1401">
                  <c:v>31.816024792226699</c:v>
                </c:pt>
                <c:pt idx="1402">
                  <c:v>31.808364540707899</c:v>
                </c:pt>
                <c:pt idx="1403">
                  <c:v>31.800704289189099</c:v>
                </c:pt>
                <c:pt idx="1404">
                  <c:v>31.793044037670199</c:v>
                </c:pt>
                <c:pt idx="1405">
                  <c:v>31.785383786151399</c:v>
                </c:pt>
                <c:pt idx="1406">
                  <c:v>31.777723534632599</c:v>
                </c:pt>
                <c:pt idx="1407">
                  <c:v>31.7700632831137</c:v>
                </c:pt>
                <c:pt idx="1408">
                  <c:v>31.7624030315949</c:v>
                </c:pt>
                <c:pt idx="1409">
                  <c:v>31.7547427800761</c:v>
                </c:pt>
                <c:pt idx="1410">
                  <c:v>31.7470825285573</c:v>
                </c:pt>
                <c:pt idx="1411">
                  <c:v>31.7394222770384</c:v>
                </c:pt>
                <c:pt idx="1412">
                  <c:v>31.7317620255196</c:v>
                </c:pt>
                <c:pt idx="1413">
                  <c:v>31.7241017740008</c:v>
                </c:pt>
                <c:pt idx="1414">
                  <c:v>31.716441522481901</c:v>
                </c:pt>
                <c:pt idx="1415">
                  <c:v>31.708781270963101</c:v>
                </c:pt>
                <c:pt idx="1416">
                  <c:v>31.701121019444301</c:v>
                </c:pt>
                <c:pt idx="1417">
                  <c:v>31.693460767925501</c:v>
                </c:pt>
                <c:pt idx="1418">
                  <c:v>31.685800516406601</c:v>
                </c:pt>
                <c:pt idx="1419">
                  <c:v>31.678140264887801</c:v>
                </c:pt>
                <c:pt idx="1420">
                  <c:v>31.670480013369001</c:v>
                </c:pt>
                <c:pt idx="1421">
                  <c:v>31.662819761850098</c:v>
                </c:pt>
                <c:pt idx="1422">
                  <c:v>31.655159510331298</c:v>
                </c:pt>
                <c:pt idx="1423">
                  <c:v>31.647499258812498</c:v>
                </c:pt>
                <c:pt idx="1424">
                  <c:v>29.962243924670201</c:v>
                </c:pt>
                <c:pt idx="1425">
                  <c:v>29.954583673151301</c:v>
                </c:pt>
                <c:pt idx="1426">
                  <c:v>29.946923421632501</c:v>
                </c:pt>
                <c:pt idx="1427">
                  <c:v>29.939263170113701</c:v>
                </c:pt>
                <c:pt idx="1428">
                  <c:v>29.931602918594901</c:v>
                </c:pt>
                <c:pt idx="1429">
                  <c:v>29.923942667075998</c:v>
                </c:pt>
                <c:pt idx="1430">
                  <c:v>29.916282415557198</c:v>
                </c:pt>
                <c:pt idx="1431">
                  <c:v>29.908622164038398</c:v>
                </c:pt>
                <c:pt idx="1432">
                  <c:v>29.900961912519598</c:v>
                </c:pt>
                <c:pt idx="1433">
                  <c:v>29.893301661000699</c:v>
                </c:pt>
                <c:pt idx="1434">
                  <c:v>29.885641409481899</c:v>
                </c:pt>
                <c:pt idx="1435">
                  <c:v>29.877981157963099</c:v>
                </c:pt>
                <c:pt idx="1436">
                  <c:v>29.870320906444199</c:v>
                </c:pt>
                <c:pt idx="1437">
                  <c:v>29.862660654925399</c:v>
                </c:pt>
                <c:pt idx="1438">
                  <c:v>29.855000403406599</c:v>
                </c:pt>
                <c:pt idx="1439">
                  <c:v>29.847340151887799</c:v>
                </c:pt>
                <c:pt idx="1440">
                  <c:v>29.8396799003689</c:v>
                </c:pt>
                <c:pt idx="1441">
                  <c:v>29.8320196488501</c:v>
                </c:pt>
                <c:pt idx="1442">
                  <c:v>29.8243593973313</c:v>
                </c:pt>
                <c:pt idx="1443">
                  <c:v>29.8166991458124</c:v>
                </c:pt>
                <c:pt idx="1444">
                  <c:v>29.8090388942936</c:v>
                </c:pt>
                <c:pt idx="1445">
                  <c:v>29.8013786427748</c:v>
                </c:pt>
                <c:pt idx="1446">
                  <c:v>29.793718391255901</c:v>
                </c:pt>
                <c:pt idx="1447">
                  <c:v>29.786058139737101</c:v>
                </c:pt>
                <c:pt idx="1448">
                  <c:v>29.778397888218301</c:v>
                </c:pt>
                <c:pt idx="1449">
                  <c:v>29.770737636699501</c:v>
                </c:pt>
                <c:pt idx="1450">
                  <c:v>29.763077385180601</c:v>
                </c:pt>
                <c:pt idx="1451">
                  <c:v>29.755417133661801</c:v>
                </c:pt>
                <c:pt idx="1452">
                  <c:v>29.747756882143001</c:v>
                </c:pt>
                <c:pt idx="1453">
                  <c:v>29.740096630624102</c:v>
                </c:pt>
                <c:pt idx="1454">
                  <c:v>29.732436379105302</c:v>
                </c:pt>
                <c:pt idx="1455">
                  <c:v>29.724776127586502</c:v>
                </c:pt>
                <c:pt idx="1456">
                  <c:v>29.717115876067702</c:v>
                </c:pt>
                <c:pt idx="1457">
                  <c:v>29.709455624548799</c:v>
                </c:pt>
                <c:pt idx="1458">
                  <c:v>29.701795373029999</c:v>
                </c:pt>
                <c:pt idx="1459">
                  <c:v>29.694135121511199</c:v>
                </c:pt>
                <c:pt idx="1460">
                  <c:v>29.686474869992299</c:v>
                </c:pt>
                <c:pt idx="1461">
                  <c:v>29.678814618473499</c:v>
                </c:pt>
                <c:pt idx="1462">
                  <c:v>29.671154366954699</c:v>
                </c:pt>
                <c:pt idx="1463">
                  <c:v>29.663494115435899</c:v>
                </c:pt>
                <c:pt idx="1464">
                  <c:v>29.655833863917</c:v>
                </c:pt>
                <c:pt idx="1465">
                  <c:v>29.6481736123982</c:v>
                </c:pt>
                <c:pt idx="1466">
                  <c:v>29.6405133608794</c:v>
                </c:pt>
                <c:pt idx="1467">
                  <c:v>29.6328531093605</c:v>
                </c:pt>
                <c:pt idx="1468">
                  <c:v>29.6251928578417</c:v>
                </c:pt>
                <c:pt idx="1469">
                  <c:v>29.6175326063229</c:v>
                </c:pt>
                <c:pt idx="1470">
                  <c:v>29.6098723548041</c:v>
                </c:pt>
                <c:pt idx="1471">
                  <c:v>29.602212103285201</c:v>
                </c:pt>
                <c:pt idx="1472">
                  <c:v>29.594551851766401</c:v>
                </c:pt>
                <c:pt idx="1473">
                  <c:v>29.586891600247601</c:v>
                </c:pt>
                <c:pt idx="1474">
                  <c:v>29.579231348728701</c:v>
                </c:pt>
                <c:pt idx="1475">
                  <c:v>29.119616257598999</c:v>
                </c:pt>
                <c:pt idx="1476">
                  <c:v>29.111956006080199</c:v>
                </c:pt>
                <c:pt idx="1477">
                  <c:v>29.104295754561399</c:v>
                </c:pt>
                <c:pt idx="1478">
                  <c:v>29.096635503042499</c:v>
                </c:pt>
                <c:pt idx="1479">
                  <c:v>29.088975251523699</c:v>
                </c:pt>
                <c:pt idx="1480">
                  <c:v>29.081315000004899</c:v>
                </c:pt>
                <c:pt idx="1481">
                  <c:v>29.073654748486099</c:v>
                </c:pt>
                <c:pt idx="1482">
                  <c:v>29.0659944969672</c:v>
                </c:pt>
                <c:pt idx="1483">
                  <c:v>29.0583342454484</c:v>
                </c:pt>
                <c:pt idx="1484">
                  <c:v>29.0506739939296</c:v>
                </c:pt>
                <c:pt idx="1485">
                  <c:v>29.0430137424107</c:v>
                </c:pt>
                <c:pt idx="1486">
                  <c:v>29.0353534908919</c:v>
                </c:pt>
                <c:pt idx="1487">
                  <c:v>29.0276932393731</c:v>
                </c:pt>
                <c:pt idx="1488">
                  <c:v>29.0200329878543</c:v>
                </c:pt>
                <c:pt idx="1489">
                  <c:v>29.012372736335401</c:v>
                </c:pt>
                <c:pt idx="1490">
                  <c:v>29.004712484816601</c:v>
                </c:pt>
                <c:pt idx="1491">
                  <c:v>28.997052233297801</c:v>
                </c:pt>
                <c:pt idx="1492">
                  <c:v>28.989391981778901</c:v>
                </c:pt>
                <c:pt idx="1493">
                  <c:v>28.981731730260101</c:v>
                </c:pt>
                <c:pt idx="1494">
                  <c:v>28.974071478741301</c:v>
                </c:pt>
                <c:pt idx="1495">
                  <c:v>28.966411227222501</c:v>
                </c:pt>
                <c:pt idx="1496">
                  <c:v>28.958750975703602</c:v>
                </c:pt>
                <c:pt idx="1497">
                  <c:v>28.951090724184802</c:v>
                </c:pt>
                <c:pt idx="1498">
                  <c:v>28.943430472666002</c:v>
                </c:pt>
                <c:pt idx="1499">
                  <c:v>28.935770221147099</c:v>
                </c:pt>
                <c:pt idx="1500">
                  <c:v>28.928109969628299</c:v>
                </c:pt>
                <c:pt idx="1501">
                  <c:v>28.920449718109499</c:v>
                </c:pt>
                <c:pt idx="1502">
                  <c:v>28.912789466590699</c:v>
                </c:pt>
                <c:pt idx="1503">
                  <c:v>28.905129215071799</c:v>
                </c:pt>
                <c:pt idx="1504">
                  <c:v>28.897468963552999</c:v>
                </c:pt>
                <c:pt idx="1505">
                  <c:v>28.889808712034199</c:v>
                </c:pt>
                <c:pt idx="1506">
                  <c:v>28.8821484605153</c:v>
                </c:pt>
                <c:pt idx="1507">
                  <c:v>28.8744882089965</c:v>
                </c:pt>
                <c:pt idx="1508">
                  <c:v>28.8668279574777</c:v>
                </c:pt>
                <c:pt idx="1509">
                  <c:v>28.8591677059589</c:v>
                </c:pt>
                <c:pt idx="1510">
                  <c:v>28.85150745444</c:v>
                </c:pt>
                <c:pt idx="1511">
                  <c:v>28.8438472029212</c:v>
                </c:pt>
                <c:pt idx="1512">
                  <c:v>28.8361869514024</c:v>
                </c:pt>
                <c:pt idx="1513">
                  <c:v>28.828526699883501</c:v>
                </c:pt>
                <c:pt idx="1514">
                  <c:v>28.820866448364701</c:v>
                </c:pt>
                <c:pt idx="1515">
                  <c:v>28.813206196845901</c:v>
                </c:pt>
                <c:pt idx="1516">
                  <c:v>28.353591105716198</c:v>
                </c:pt>
                <c:pt idx="1517">
                  <c:v>28.345930854197299</c:v>
                </c:pt>
                <c:pt idx="1518">
                  <c:v>28.338270602678499</c:v>
                </c:pt>
                <c:pt idx="1519">
                  <c:v>28.330610351159699</c:v>
                </c:pt>
                <c:pt idx="1520">
                  <c:v>28.322950099640899</c:v>
                </c:pt>
                <c:pt idx="1521">
                  <c:v>28.315289848121999</c:v>
                </c:pt>
                <c:pt idx="1522">
                  <c:v>28.307629596603199</c:v>
                </c:pt>
                <c:pt idx="1523">
                  <c:v>28.299969345084399</c:v>
                </c:pt>
                <c:pt idx="1524">
                  <c:v>28.2923090935655</c:v>
                </c:pt>
                <c:pt idx="1525">
                  <c:v>28.2846488420467</c:v>
                </c:pt>
                <c:pt idx="1526">
                  <c:v>28.2769885905279</c:v>
                </c:pt>
                <c:pt idx="1527">
                  <c:v>28.2693283390091</c:v>
                </c:pt>
                <c:pt idx="1528">
                  <c:v>28.2616680874902</c:v>
                </c:pt>
                <c:pt idx="1529">
                  <c:v>28.2540078359714</c:v>
                </c:pt>
                <c:pt idx="1530">
                  <c:v>28.2463475844526</c:v>
                </c:pt>
                <c:pt idx="1531">
                  <c:v>28.238687332933701</c:v>
                </c:pt>
                <c:pt idx="1532">
                  <c:v>28.231027081414901</c:v>
                </c:pt>
                <c:pt idx="1533">
                  <c:v>28.223366829896101</c:v>
                </c:pt>
                <c:pt idx="1534">
                  <c:v>28.215706578377201</c:v>
                </c:pt>
                <c:pt idx="1535">
                  <c:v>28.208046326858401</c:v>
                </c:pt>
                <c:pt idx="1536">
                  <c:v>28.200386075339601</c:v>
                </c:pt>
                <c:pt idx="1537">
                  <c:v>28.192725823820801</c:v>
                </c:pt>
                <c:pt idx="1538">
                  <c:v>28.185065572301902</c:v>
                </c:pt>
                <c:pt idx="1539">
                  <c:v>28.177405320783102</c:v>
                </c:pt>
                <c:pt idx="1540">
                  <c:v>28.169745069264302</c:v>
                </c:pt>
                <c:pt idx="1541">
                  <c:v>28.162084817745399</c:v>
                </c:pt>
                <c:pt idx="1542">
                  <c:v>28.154424566226599</c:v>
                </c:pt>
                <c:pt idx="1543">
                  <c:v>28.146764314707799</c:v>
                </c:pt>
                <c:pt idx="1544">
                  <c:v>28.139104063188999</c:v>
                </c:pt>
                <c:pt idx="1545">
                  <c:v>28.131443811670099</c:v>
                </c:pt>
                <c:pt idx="1546">
                  <c:v>28.123783560151299</c:v>
                </c:pt>
                <c:pt idx="1547">
                  <c:v>28.116123308632499</c:v>
                </c:pt>
                <c:pt idx="1548">
                  <c:v>28.1084630571136</c:v>
                </c:pt>
                <c:pt idx="1549">
                  <c:v>28.1008028055948</c:v>
                </c:pt>
                <c:pt idx="1550">
                  <c:v>28.093142554076</c:v>
                </c:pt>
                <c:pt idx="1551">
                  <c:v>28.0854823025572</c:v>
                </c:pt>
                <c:pt idx="1552">
                  <c:v>28.0778220510383</c:v>
                </c:pt>
                <c:pt idx="1553">
                  <c:v>28.0701617995195</c:v>
                </c:pt>
                <c:pt idx="1554">
                  <c:v>28.0625015480007</c:v>
                </c:pt>
                <c:pt idx="1555">
                  <c:v>28.054841296481801</c:v>
                </c:pt>
                <c:pt idx="1556">
                  <c:v>28.047181044963001</c:v>
                </c:pt>
                <c:pt idx="1557">
                  <c:v>27.6641684690216</c:v>
                </c:pt>
                <c:pt idx="1558">
                  <c:v>27.6565082175028</c:v>
                </c:pt>
                <c:pt idx="1559">
                  <c:v>27.648847965983901</c:v>
                </c:pt>
                <c:pt idx="1560">
                  <c:v>27.641187714465101</c:v>
                </c:pt>
                <c:pt idx="1561">
                  <c:v>27.633527462946301</c:v>
                </c:pt>
                <c:pt idx="1562">
                  <c:v>27.625867211427401</c:v>
                </c:pt>
                <c:pt idx="1563">
                  <c:v>27.618206959908601</c:v>
                </c:pt>
                <c:pt idx="1564">
                  <c:v>27.610546708389801</c:v>
                </c:pt>
                <c:pt idx="1565">
                  <c:v>27.602886456871001</c:v>
                </c:pt>
                <c:pt idx="1566">
                  <c:v>27.595226205352098</c:v>
                </c:pt>
                <c:pt idx="1567">
                  <c:v>27.587565953833298</c:v>
                </c:pt>
                <c:pt idx="1568">
                  <c:v>27.579905702314498</c:v>
                </c:pt>
                <c:pt idx="1569">
                  <c:v>27.572245450795599</c:v>
                </c:pt>
                <c:pt idx="1570">
                  <c:v>27.564585199276799</c:v>
                </c:pt>
                <c:pt idx="1571">
                  <c:v>27.556924947757999</c:v>
                </c:pt>
                <c:pt idx="1572">
                  <c:v>27.549264696239199</c:v>
                </c:pt>
                <c:pt idx="1573">
                  <c:v>27.541604444720299</c:v>
                </c:pt>
                <c:pt idx="1574">
                  <c:v>27.533944193201499</c:v>
                </c:pt>
                <c:pt idx="1575">
                  <c:v>27.526283941682699</c:v>
                </c:pt>
                <c:pt idx="1576">
                  <c:v>27.5186236901638</c:v>
                </c:pt>
                <c:pt idx="1577">
                  <c:v>27.510963438645</c:v>
                </c:pt>
                <c:pt idx="1578">
                  <c:v>27.5033031871262</c:v>
                </c:pt>
                <c:pt idx="1579">
                  <c:v>27.4956429356074</c:v>
                </c:pt>
                <c:pt idx="1580">
                  <c:v>27.4879826840885</c:v>
                </c:pt>
                <c:pt idx="1581">
                  <c:v>27.4803224325697</c:v>
                </c:pt>
                <c:pt idx="1582">
                  <c:v>27.4726621810509</c:v>
                </c:pt>
                <c:pt idx="1583">
                  <c:v>27.465001929532001</c:v>
                </c:pt>
                <c:pt idx="1584">
                  <c:v>27.457341678013201</c:v>
                </c:pt>
                <c:pt idx="1585">
                  <c:v>27.449681426494401</c:v>
                </c:pt>
                <c:pt idx="1586">
                  <c:v>27.442021174975601</c:v>
                </c:pt>
                <c:pt idx="1587">
                  <c:v>27.434360923456701</c:v>
                </c:pt>
                <c:pt idx="1588">
                  <c:v>27.426700671937901</c:v>
                </c:pt>
                <c:pt idx="1589">
                  <c:v>27.419040420419101</c:v>
                </c:pt>
                <c:pt idx="1590">
                  <c:v>27.411380168900202</c:v>
                </c:pt>
                <c:pt idx="1591">
                  <c:v>27.403719917381402</c:v>
                </c:pt>
                <c:pt idx="1592">
                  <c:v>27.396059665862602</c:v>
                </c:pt>
                <c:pt idx="1593">
                  <c:v>27.388399414343802</c:v>
                </c:pt>
                <c:pt idx="1594">
                  <c:v>27.380739162824899</c:v>
                </c:pt>
                <c:pt idx="1595">
                  <c:v>27.373078911306099</c:v>
                </c:pt>
                <c:pt idx="1596">
                  <c:v>27.365418659787299</c:v>
                </c:pt>
                <c:pt idx="1597">
                  <c:v>27.357758408268399</c:v>
                </c:pt>
                <c:pt idx="1598">
                  <c:v>27.350098156749599</c:v>
                </c:pt>
                <c:pt idx="1599">
                  <c:v>27.342437905230799</c:v>
                </c:pt>
                <c:pt idx="1600">
                  <c:v>27.334777653711999</c:v>
                </c:pt>
                <c:pt idx="1601">
                  <c:v>27.3271174021931</c:v>
                </c:pt>
                <c:pt idx="1602">
                  <c:v>27.3194571506743</c:v>
                </c:pt>
                <c:pt idx="1603">
                  <c:v>27.3117968991555</c:v>
                </c:pt>
                <c:pt idx="1604">
                  <c:v>27.3041366476366</c:v>
                </c:pt>
                <c:pt idx="1605">
                  <c:v>27.2964763961178</c:v>
                </c:pt>
                <c:pt idx="1606">
                  <c:v>27.288816144599</c:v>
                </c:pt>
                <c:pt idx="1607">
                  <c:v>27.2811558930802</c:v>
                </c:pt>
                <c:pt idx="1608">
                  <c:v>25.672503074126102</c:v>
                </c:pt>
                <c:pt idx="1609">
                  <c:v>25.664842822607302</c:v>
                </c:pt>
                <c:pt idx="1610">
                  <c:v>25.657182571088502</c:v>
                </c:pt>
                <c:pt idx="1611">
                  <c:v>25.649522319569702</c:v>
                </c:pt>
                <c:pt idx="1612">
                  <c:v>25.641862068050798</c:v>
                </c:pt>
                <c:pt idx="1613">
                  <c:v>25.634201816531998</c:v>
                </c:pt>
                <c:pt idx="1614">
                  <c:v>25.626541565013198</c:v>
                </c:pt>
                <c:pt idx="1615">
                  <c:v>25.618881313494299</c:v>
                </c:pt>
                <c:pt idx="1616">
                  <c:v>25.611221061975499</c:v>
                </c:pt>
                <c:pt idx="1617">
                  <c:v>25.603560810456699</c:v>
                </c:pt>
                <c:pt idx="1618">
                  <c:v>25.595900558937899</c:v>
                </c:pt>
                <c:pt idx="1619">
                  <c:v>25.588240307418999</c:v>
                </c:pt>
                <c:pt idx="1620">
                  <c:v>25.580580055900199</c:v>
                </c:pt>
                <c:pt idx="1621">
                  <c:v>25.572919804381399</c:v>
                </c:pt>
                <c:pt idx="1622">
                  <c:v>25.5652595528625</c:v>
                </c:pt>
                <c:pt idx="1623">
                  <c:v>25.5575993013437</c:v>
                </c:pt>
                <c:pt idx="1624">
                  <c:v>25.5499390498249</c:v>
                </c:pt>
                <c:pt idx="1625">
                  <c:v>25.5422787983061</c:v>
                </c:pt>
                <c:pt idx="1626">
                  <c:v>25.5346185467872</c:v>
                </c:pt>
                <c:pt idx="1627">
                  <c:v>25.5269582952684</c:v>
                </c:pt>
                <c:pt idx="1628">
                  <c:v>25.5192980437496</c:v>
                </c:pt>
                <c:pt idx="1629">
                  <c:v>25.511637792230701</c:v>
                </c:pt>
                <c:pt idx="1630">
                  <c:v>25.503977540711901</c:v>
                </c:pt>
                <c:pt idx="1631">
                  <c:v>25.496317289193101</c:v>
                </c:pt>
                <c:pt idx="1632">
                  <c:v>25.488657037674301</c:v>
                </c:pt>
                <c:pt idx="1633">
                  <c:v>25.480996786155401</c:v>
                </c:pt>
                <c:pt idx="1634">
                  <c:v>25.473336534636601</c:v>
                </c:pt>
                <c:pt idx="1635">
                  <c:v>25.465676283117801</c:v>
                </c:pt>
                <c:pt idx="1636">
                  <c:v>25.458016031598898</c:v>
                </c:pt>
                <c:pt idx="1637">
                  <c:v>25.450355780080098</c:v>
                </c:pt>
                <c:pt idx="1638">
                  <c:v>25.442695528561298</c:v>
                </c:pt>
                <c:pt idx="1639">
                  <c:v>25.435035277042498</c:v>
                </c:pt>
                <c:pt idx="1640">
                  <c:v>25.427375025523599</c:v>
                </c:pt>
                <c:pt idx="1641">
                  <c:v>25.419714774004799</c:v>
                </c:pt>
                <c:pt idx="1642">
                  <c:v>25.412054522485999</c:v>
                </c:pt>
                <c:pt idx="1643">
                  <c:v>25.404394270967099</c:v>
                </c:pt>
                <c:pt idx="1644">
                  <c:v>25.396734019448299</c:v>
                </c:pt>
                <c:pt idx="1645">
                  <c:v>25.389073767929499</c:v>
                </c:pt>
                <c:pt idx="1646">
                  <c:v>25.381413516410699</c:v>
                </c:pt>
                <c:pt idx="1647">
                  <c:v>25.3737532648918</c:v>
                </c:pt>
                <c:pt idx="1648">
                  <c:v>25.366093013373</c:v>
                </c:pt>
                <c:pt idx="1649">
                  <c:v>25.3584327618542</c:v>
                </c:pt>
                <c:pt idx="1650">
                  <c:v>25.3507725103353</c:v>
                </c:pt>
                <c:pt idx="1651">
                  <c:v>25.3431122588165</c:v>
                </c:pt>
                <c:pt idx="1652">
                  <c:v>25.3354520072977</c:v>
                </c:pt>
                <c:pt idx="1653">
                  <c:v>25.327791755778801</c:v>
                </c:pt>
                <c:pt idx="1654">
                  <c:v>25.320131504260001</c:v>
                </c:pt>
                <c:pt idx="1655">
                  <c:v>25.312471252741201</c:v>
                </c:pt>
                <c:pt idx="1656">
                  <c:v>25.304811001222401</c:v>
                </c:pt>
                <c:pt idx="1657">
                  <c:v>25.297150749703501</c:v>
                </c:pt>
                <c:pt idx="1658">
                  <c:v>25.289490498184701</c:v>
                </c:pt>
                <c:pt idx="1659">
                  <c:v>25.281830246665901</c:v>
                </c:pt>
                <c:pt idx="1660">
                  <c:v>25.274169995146998</c:v>
                </c:pt>
                <c:pt idx="1661">
                  <c:v>25.266509743628198</c:v>
                </c:pt>
                <c:pt idx="1662">
                  <c:v>25.258849492109398</c:v>
                </c:pt>
                <c:pt idx="1663">
                  <c:v>25.251189240590602</c:v>
                </c:pt>
                <c:pt idx="1664">
                  <c:v>25.243528989071699</c:v>
                </c:pt>
                <c:pt idx="1665">
                  <c:v>25.235868737552899</c:v>
                </c:pt>
                <c:pt idx="1666">
                  <c:v>25.228208486034099</c:v>
                </c:pt>
                <c:pt idx="1667">
                  <c:v>25.220548234515299</c:v>
                </c:pt>
                <c:pt idx="1668">
                  <c:v>25.212887982996399</c:v>
                </c:pt>
                <c:pt idx="1669">
                  <c:v>25.205227731477599</c:v>
                </c:pt>
                <c:pt idx="1670">
                  <c:v>25.197567479958799</c:v>
                </c:pt>
                <c:pt idx="1671">
                  <c:v>25.1899072284399</c:v>
                </c:pt>
                <c:pt idx="1672">
                  <c:v>25.1822469769211</c:v>
                </c:pt>
                <c:pt idx="1673">
                  <c:v>25.1745867254023</c:v>
                </c:pt>
                <c:pt idx="1674">
                  <c:v>25.1669264738835</c:v>
                </c:pt>
                <c:pt idx="1675">
                  <c:v>25.1592662223646</c:v>
                </c:pt>
                <c:pt idx="1676">
                  <c:v>25.1516059708458</c:v>
                </c:pt>
                <c:pt idx="1677">
                  <c:v>25.143945719327</c:v>
                </c:pt>
                <c:pt idx="1678">
                  <c:v>25.136285467808101</c:v>
                </c:pt>
                <c:pt idx="1679">
                  <c:v>25.128625216289301</c:v>
                </c:pt>
                <c:pt idx="1680">
                  <c:v>25.120964964770501</c:v>
                </c:pt>
                <c:pt idx="1681">
                  <c:v>25.113304713251701</c:v>
                </c:pt>
                <c:pt idx="1682">
                  <c:v>25.105644461732801</c:v>
                </c:pt>
                <c:pt idx="1683">
                  <c:v>25.097984210214001</c:v>
                </c:pt>
                <c:pt idx="1684">
                  <c:v>25.090323958695201</c:v>
                </c:pt>
                <c:pt idx="1685">
                  <c:v>25.082663707176302</c:v>
                </c:pt>
                <c:pt idx="1686">
                  <c:v>25.075003455657502</c:v>
                </c:pt>
                <c:pt idx="1687">
                  <c:v>25.067343204138702</c:v>
                </c:pt>
                <c:pt idx="1688">
                  <c:v>25.059682952619799</c:v>
                </c:pt>
                <c:pt idx="1689">
                  <c:v>23.068017557724399</c:v>
                </c:pt>
                <c:pt idx="1690">
                  <c:v>23.060357306205599</c:v>
                </c:pt>
                <c:pt idx="1691">
                  <c:v>23.0526970546867</c:v>
                </c:pt>
                <c:pt idx="1692">
                  <c:v>23.0450368031679</c:v>
                </c:pt>
                <c:pt idx="1693">
                  <c:v>23.0373765516491</c:v>
                </c:pt>
                <c:pt idx="1694">
                  <c:v>23.0297163001303</c:v>
                </c:pt>
                <c:pt idx="1695">
                  <c:v>23.0220560486114</c:v>
                </c:pt>
                <c:pt idx="1696">
                  <c:v>23.0143957970926</c:v>
                </c:pt>
                <c:pt idx="1697">
                  <c:v>23.0067355455738</c:v>
                </c:pt>
                <c:pt idx="1698">
                  <c:v>22.999075294054901</c:v>
                </c:pt>
                <c:pt idx="1699">
                  <c:v>22.991415042536101</c:v>
                </c:pt>
                <c:pt idx="1700">
                  <c:v>22.983754791017301</c:v>
                </c:pt>
                <c:pt idx="1701">
                  <c:v>22.976094539498501</c:v>
                </c:pt>
                <c:pt idx="1702">
                  <c:v>22.968434287979601</c:v>
                </c:pt>
                <c:pt idx="1703">
                  <c:v>22.960774036460801</c:v>
                </c:pt>
                <c:pt idx="1704">
                  <c:v>22.953113784942001</c:v>
                </c:pt>
                <c:pt idx="1705">
                  <c:v>22.945453533423098</c:v>
                </c:pt>
                <c:pt idx="1706">
                  <c:v>22.937793281904298</c:v>
                </c:pt>
                <c:pt idx="1707">
                  <c:v>22.930133030385502</c:v>
                </c:pt>
                <c:pt idx="1708">
                  <c:v>22.922472778866702</c:v>
                </c:pt>
                <c:pt idx="1709">
                  <c:v>22.914812527347799</c:v>
                </c:pt>
                <c:pt idx="1710">
                  <c:v>22.907152275828999</c:v>
                </c:pt>
                <c:pt idx="1711">
                  <c:v>22.899492024310199</c:v>
                </c:pt>
                <c:pt idx="1712">
                  <c:v>22.891831772791299</c:v>
                </c:pt>
                <c:pt idx="1713">
                  <c:v>22.884171521272499</c:v>
                </c:pt>
                <c:pt idx="1714">
                  <c:v>22.876511269753699</c:v>
                </c:pt>
                <c:pt idx="1715">
                  <c:v>22.868851018234899</c:v>
                </c:pt>
                <c:pt idx="1716">
                  <c:v>22.861190766716</c:v>
                </c:pt>
                <c:pt idx="1717">
                  <c:v>22.8535305151972</c:v>
                </c:pt>
                <c:pt idx="1718">
                  <c:v>22.8458702636784</c:v>
                </c:pt>
                <c:pt idx="1719">
                  <c:v>22.8382100121595</c:v>
                </c:pt>
                <c:pt idx="1720">
                  <c:v>22.8305497606407</c:v>
                </c:pt>
                <c:pt idx="1721">
                  <c:v>22.8228895091219</c:v>
                </c:pt>
                <c:pt idx="1722">
                  <c:v>22.8152292576031</c:v>
                </c:pt>
                <c:pt idx="1723">
                  <c:v>22.807569006084201</c:v>
                </c:pt>
                <c:pt idx="1724">
                  <c:v>22.799908754565401</c:v>
                </c:pt>
                <c:pt idx="1725">
                  <c:v>22.792248503046601</c:v>
                </c:pt>
                <c:pt idx="1726">
                  <c:v>22.784588251527701</c:v>
                </c:pt>
                <c:pt idx="1727">
                  <c:v>22.776928000008901</c:v>
                </c:pt>
                <c:pt idx="1728">
                  <c:v>22.769267748490101</c:v>
                </c:pt>
                <c:pt idx="1729">
                  <c:v>22.761607496971301</c:v>
                </c:pt>
                <c:pt idx="1730">
                  <c:v>22.753947245452402</c:v>
                </c:pt>
                <c:pt idx="1731">
                  <c:v>22.746286993933602</c:v>
                </c:pt>
                <c:pt idx="1732">
                  <c:v>22.738626742414802</c:v>
                </c:pt>
                <c:pt idx="1733">
                  <c:v>22.730966490895899</c:v>
                </c:pt>
                <c:pt idx="1734">
                  <c:v>22.723306239377099</c:v>
                </c:pt>
                <c:pt idx="1735">
                  <c:v>22.715645987858299</c:v>
                </c:pt>
                <c:pt idx="1736">
                  <c:v>22.707985736339499</c:v>
                </c:pt>
                <c:pt idx="1737">
                  <c:v>22.700325484820599</c:v>
                </c:pt>
                <c:pt idx="1738">
                  <c:v>22.692665233301799</c:v>
                </c:pt>
                <c:pt idx="1739">
                  <c:v>22.685004981782999</c:v>
                </c:pt>
                <c:pt idx="1740">
                  <c:v>22.6773447302641</c:v>
                </c:pt>
                <c:pt idx="1741">
                  <c:v>22.6696844787453</c:v>
                </c:pt>
                <c:pt idx="1742">
                  <c:v>22.6620242272265</c:v>
                </c:pt>
                <c:pt idx="1743">
                  <c:v>22.6543639757077</c:v>
                </c:pt>
                <c:pt idx="1744">
                  <c:v>22.6467037241888</c:v>
                </c:pt>
                <c:pt idx="1745">
                  <c:v>22.63904347267</c:v>
                </c:pt>
                <c:pt idx="1746">
                  <c:v>22.6313832211512</c:v>
                </c:pt>
                <c:pt idx="1747">
                  <c:v>22.623722969632301</c:v>
                </c:pt>
                <c:pt idx="1748">
                  <c:v>22.616062718113501</c:v>
                </c:pt>
                <c:pt idx="1749">
                  <c:v>22.608402466594701</c:v>
                </c:pt>
                <c:pt idx="1750">
                  <c:v>19.084686767933501</c:v>
                </c:pt>
                <c:pt idx="1751">
                  <c:v>19.077026516414701</c:v>
                </c:pt>
                <c:pt idx="1752">
                  <c:v>19.069366264895901</c:v>
                </c:pt>
                <c:pt idx="1753">
                  <c:v>19.061706013377002</c:v>
                </c:pt>
                <c:pt idx="1754">
                  <c:v>19.054045761858202</c:v>
                </c:pt>
                <c:pt idx="1755">
                  <c:v>19.046385510339402</c:v>
                </c:pt>
                <c:pt idx="1756">
                  <c:v>19.038725258820499</c:v>
                </c:pt>
                <c:pt idx="1757">
                  <c:v>19.031065007301699</c:v>
                </c:pt>
                <c:pt idx="1758">
                  <c:v>19.023404755782899</c:v>
                </c:pt>
                <c:pt idx="1759">
                  <c:v>19.015744504264099</c:v>
                </c:pt>
                <c:pt idx="1760">
                  <c:v>19.008084252745199</c:v>
                </c:pt>
                <c:pt idx="1761">
                  <c:v>19.000424001226399</c:v>
                </c:pt>
                <c:pt idx="1762">
                  <c:v>18.992763749707599</c:v>
                </c:pt>
                <c:pt idx="1763">
                  <c:v>18.9851034981887</c:v>
                </c:pt>
                <c:pt idx="1764">
                  <c:v>18.9774432466699</c:v>
                </c:pt>
                <c:pt idx="1765">
                  <c:v>18.9697829951511</c:v>
                </c:pt>
                <c:pt idx="1766">
                  <c:v>18.9621227436323</c:v>
                </c:pt>
                <c:pt idx="1767">
                  <c:v>18.9544624921134</c:v>
                </c:pt>
                <c:pt idx="1768">
                  <c:v>18.9468022405946</c:v>
                </c:pt>
                <c:pt idx="1769">
                  <c:v>18.9391419890758</c:v>
                </c:pt>
                <c:pt idx="1770">
                  <c:v>18.931481737556901</c:v>
                </c:pt>
                <c:pt idx="1771">
                  <c:v>18.923821486038101</c:v>
                </c:pt>
                <c:pt idx="1772">
                  <c:v>18.916161234519301</c:v>
                </c:pt>
                <c:pt idx="1773">
                  <c:v>18.908500983000501</c:v>
                </c:pt>
                <c:pt idx="1774">
                  <c:v>18.900840731481601</c:v>
                </c:pt>
                <c:pt idx="1775">
                  <c:v>18.893180479962801</c:v>
                </c:pt>
                <c:pt idx="1776">
                  <c:v>18.885520228444001</c:v>
                </c:pt>
                <c:pt idx="1777">
                  <c:v>18.877859976925102</c:v>
                </c:pt>
                <c:pt idx="1778">
                  <c:v>18.870199725406302</c:v>
                </c:pt>
                <c:pt idx="1779">
                  <c:v>18.862539473887502</c:v>
                </c:pt>
                <c:pt idx="1780">
                  <c:v>18.854879222368702</c:v>
                </c:pt>
                <c:pt idx="1781">
                  <c:v>18.847218970849799</c:v>
                </c:pt>
                <c:pt idx="1782">
                  <c:v>18.839558719330999</c:v>
                </c:pt>
                <c:pt idx="1783">
                  <c:v>18.831898467812199</c:v>
                </c:pt>
                <c:pt idx="1784">
                  <c:v>18.824238216293299</c:v>
                </c:pt>
                <c:pt idx="1785">
                  <c:v>18.816577964774499</c:v>
                </c:pt>
                <c:pt idx="1786">
                  <c:v>18.808917713255699</c:v>
                </c:pt>
                <c:pt idx="1787">
                  <c:v>18.801257461736899</c:v>
                </c:pt>
                <c:pt idx="1788">
                  <c:v>18.793597210218</c:v>
                </c:pt>
                <c:pt idx="1789">
                  <c:v>18.7859369586992</c:v>
                </c:pt>
                <c:pt idx="1790">
                  <c:v>18.7782767071804</c:v>
                </c:pt>
                <c:pt idx="1791">
                  <c:v>17.0164188578498</c:v>
                </c:pt>
                <c:pt idx="1792">
                  <c:v>17.008758606331</c:v>
                </c:pt>
                <c:pt idx="1793">
                  <c:v>17.0010983548121</c:v>
                </c:pt>
                <c:pt idx="1794">
                  <c:v>16.9934381032933</c:v>
                </c:pt>
                <c:pt idx="1795">
                  <c:v>16.9857778517745</c:v>
                </c:pt>
                <c:pt idx="1796">
                  <c:v>16.978117600255601</c:v>
                </c:pt>
                <c:pt idx="1797">
                  <c:v>16.970457348736801</c:v>
                </c:pt>
                <c:pt idx="1798">
                  <c:v>16.962797097218001</c:v>
                </c:pt>
                <c:pt idx="1799">
                  <c:v>16.955136845699201</c:v>
                </c:pt>
                <c:pt idx="1800">
                  <c:v>16.947476594180301</c:v>
                </c:pt>
                <c:pt idx="1801">
                  <c:v>16.939816342661501</c:v>
                </c:pt>
                <c:pt idx="1802">
                  <c:v>16.932156091142701</c:v>
                </c:pt>
                <c:pt idx="1803">
                  <c:v>16.924495839623798</c:v>
                </c:pt>
                <c:pt idx="1804">
                  <c:v>16.916835588104998</c:v>
                </c:pt>
                <c:pt idx="1805">
                  <c:v>16.909175336586198</c:v>
                </c:pt>
                <c:pt idx="1806">
                  <c:v>16.901515085067299</c:v>
                </c:pt>
                <c:pt idx="1807">
                  <c:v>16.893854833548499</c:v>
                </c:pt>
                <c:pt idx="1808">
                  <c:v>16.886194582029699</c:v>
                </c:pt>
                <c:pt idx="1809">
                  <c:v>16.878534330510899</c:v>
                </c:pt>
                <c:pt idx="1810">
                  <c:v>16.870874078991999</c:v>
                </c:pt>
                <c:pt idx="1811">
                  <c:v>16.863213827473199</c:v>
                </c:pt>
                <c:pt idx="1812">
                  <c:v>16.855553575954399</c:v>
                </c:pt>
                <c:pt idx="1813">
                  <c:v>16.8478933244355</c:v>
                </c:pt>
                <c:pt idx="1814">
                  <c:v>16.8402330729167</c:v>
                </c:pt>
                <c:pt idx="1815">
                  <c:v>16.8325728213979</c:v>
                </c:pt>
                <c:pt idx="1816">
                  <c:v>16.8249125698791</c:v>
                </c:pt>
                <c:pt idx="1817">
                  <c:v>16.8172523183602</c:v>
                </c:pt>
                <c:pt idx="1818">
                  <c:v>16.8095920668414</c:v>
                </c:pt>
                <c:pt idx="1819">
                  <c:v>16.8019318153226</c:v>
                </c:pt>
                <c:pt idx="1820">
                  <c:v>16.794271563803701</c:v>
                </c:pt>
                <c:pt idx="1821">
                  <c:v>16.786611312284901</c:v>
                </c:pt>
                <c:pt idx="1822">
                  <c:v>16.778951060766101</c:v>
                </c:pt>
                <c:pt idx="1823">
                  <c:v>16.771290809247301</c:v>
                </c:pt>
                <c:pt idx="1824">
                  <c:v>16.763630557728401</c:v>
                </c:pt>
                <c:pt idx="1825">
                  <c:v>16.755970306209601</c:v>
                </c:pt>
                <c:pt idx="1826">
                  <c:v>16.748310054690801</c:v>
                </c:pt>
                <c:pt idx="1827">
                  <c:v>16.740649803171902</c:v>
                </c:pt>
                <c:pt idx="1828">
                  <c:v>16.732989551653102</c:v>
                </c:pt>
                <c:pt idx="1829">
                  <c:v>16.725329300134302</c:v>
                </c:pt>
                <c:pt idx="1830">
                  <c:v>16.717669048615502</c:v>
                </c:pt>
                <c:pt idx="1831">
                  <c:v>16.710008797096599</c:v>
                </c:pt>
                <c:pt idx="1832">
                  <c:v>16.702348545577799</c:v>
                </c:pt>
                <c:pt idx="1833">
                  <c:v>16.694688294058999</c:v>
                </c:pt>
                <c:pt idx="1834">
                  <c:v>16.687028042540099</c:v>
                </c:pt>
                <c:pt idx="1835">
                  <c:v>16.679367791021299</c:v>
                </c:pt>
                <c:pt idx="1836">
                  <c:v>16.671707539502499</c:v>
                </c:pt>
                <c:pt idx="1837">
                  <c:v>16.664047287983699</c:v>
                </c:pt>
                <c:pt idx="1838">
                  <c:v>16.6563870364648</c:v>
                </c:pt>
                <c:pt idx="1839">
                  <c:v>16.648726784946</c:v>
                </c:pt>
                <c:pt idx="1840">
                  <c:v>16.6410665334272</c:v>
                </c:pt>
                <c:pt idx="1841">
                  <c:v>16.6334062819083</c:v>
                </c:pt>
                <c:pt idx="1842">
                  <c:v>16.6257460303895</c:v>
                </c:pt>
                <c:pt idx="1843">
                  <c:v>16.6180857788707</c:v>
                </c:pt>
                <c:pt idx="1844">
                  <c:v>16.6104255273519</c:v>
                </c:pt>
                <c:pt idx="1845">
                  <c:v>16.602765275833001</c:v>
                </c:pt>
                <c:pt idx="1846">
                  <c:v>16.595105024314201</c:v>
                </c:pt>
                <c:pt idx="1847">
                  <c:v>16.587444772795401</c:v>
                </c:pt>
                <c:pt idx="1848">
                  <c:v>16.579784521276501</c:v>
                </c:pt>
                <c:pt idx="1849">
                  <c:v>16.572124269757701</c:v>
                </c:pt>
                <c:pt idx="1850">
                  <c:v>16.564464018238901</c:v>
                </c:pt>
                <c:pt idx="1851">
                  <c:v>16.556803766720101</c:v>
                </c:pt>
                <c:pt idx="1852">
                  <c:v>16.549143515201202</c:v>
                </c:pt>
                <c:pt idx="1853">
                  <c:v>16.541483263682402</c:v>
                </c:pt>
                <c:pt idx="1854">
                  <c:v>16.533823012163602</c:v>
                </c:pt>
                <c:pt idx="1855">
                  <c:v>16.526162760644699</c:v>
                </c:pt>
                <c:pt idx="1856">
                  <c:v>16.518502509125899</c:v>
                </c:pt>
                <c:pt idx="1857">
                  <c:v>16.510842257607099</c:v>
                </c:pt>
                <c:pt idx="1858">
                  <c:v>16.503182006088299</c:v>
                </c:pt>
                <c:pt idx="1859">
                  <c:v>16.495521754569399</c:v>
                </c:pt>
                <c:pt idx="1860">
                  <c:v>16.487861503050599</c:v>
                </c:pt>
                <c:pt idx="1861">
                  <c:v>16.480201251531799</c:v>
                </c:pt>
                <c:pt idx="1862">
                  <c:v>16.4725410000129</c:v>
                </c:pt>
                <c:pt idx="1863">
                  <c:v>16.4648807484941</c:v>
                </c:pt>
                <c:pt idx="1864">
                  <c:v>16.4572204969753</c:v>
                </c:pt>
                <c:pt idx="1865">
                  <c:v>16.4495602454565</c:v>
                </c:pt>
                <c:pt idx="1866">
                  <c:v>16.4418999939376</c:v>
                </c:pt>
                <c:pt idx="1867">
                  <c:v>16.4342397424188</c:v>
                </c:pt>
                <c:pt idx="1868">
                  <c:v>16.4265794909</c:v>
                </c:pt>
                <c:pt idx="1869">
                  <c:v>16.418919239381101</c:v>
                </c:pt>
                <c:pt idx="1870">
                  <c:v>16.411258987862301</c:v>
                </c:pt>
                <c:pt idx="1871">
                  <c:v>16.403598736343501</c:v>
                </c:pt>
                <c:pt idx="1872">
                  <c:v>16.395938484824701</c:v>
                </c:pt>
                <c:pt idx="1873">
                  <c:v>16.388278233305801</c:v>
                </c:pt>
                <c:pt idx="1874">
                  <c:v>16.380617981787001</c:v>
                </c:pt>
                <c:pt idx="1875">
                  <c:v>16.372957730268201</c:v>
                </c:pt>
                <c:pt idx="1876">
                  <c:v>16.365297478749302</c:v>
                </c:pt>
                <c:pt idx="1877">
                  <c:v>16.357637227230502</c:v>
                </c:pt>
                <c:pt idx="1878">
                  <c:v>16.349976975711701</c:v>
                </c:pt>
                <c:pt idx="1879">
                  <c:v>16.342316724192901</c:v>
                </c:pt>
                <c:pt idx="1880">
                  <c:v>16.334656472673998</c:v>
                </c:pt>
                <c:pt idx="1881">
                  <c:v>16.326996221155198</c:v>
                </c:pt>
                <c:pt idx="1882">
                  <c:v>16.319335969636398</c:v>
                </c:pt>
                <c:pt idx="1883">
                  <c:v>16.311675718117499</c:v>
                </c:pt>
                <c:pt idx="1884">
                  <c:v>16.304015466598699</c:v>
                </c:pt>
                <c:pt idx="1885">
                  <c:v>16.296355215079899</c:v>
                </c:pt>
                <c:pt idx="1886">
                  <c:v>16.288694963561099</c:v>
                </c:pt>
                <c:pt idx="1887">
                  <c:v>16.281034712042199</c:v>
                </c:pt>
                <c:pt idx="1888">
                  <c:v>16.273374460523399</c:v>
                </c:pt>
                <c:pt idx="1889">
                  <c:v>16.265714209004599</c:v>
                </c:pt>
                <c:pt idx="1890">
                  <c:v>16.2580539574857</c:v>
                </c:pt>
                <c:pt idx="1891">
                  <c:v>16.2503937059669</c:v>
                </c:pt>
              </c:numCache>
            </c:numRef>
          </c:xVal>
          <c:yVal>
            <c:numRef>
              <c:f>Sheet1!$E$2:$E$1893</c:f>
              <c:numCache>
                <c:formatCode>General</c:formatCode>
                <c:ptCount val="1892"/>
                <c:pt idx="0">
                  <c:v>2551.2410720560902</c:v>
                </c:pt>
                <c:pt idx="1">
                  <c:v>8885.1038468381903</c:v>
                </c:pt>
                <c:pt idx="2">
                  <c:v>11482.292351446</c:v>
                </c:pt>
                <c:pt idx="3">
                  <c:v>-13987.887198492001</c:v>
                </c:pt>
                <c:pt idx="4">
                  <c:v>-51776.526729452002</c:v>
                </c:pt>
                <c:pt idx="5">
                  <c:v>-43825.966876346603</c:v>
                </c:pt>
                <c:pt idx="6">
                  <c:v>7404.6804291324297</c:v>
                </c:pt>
                <c:pt idx="7">
                  <c:v>-101149.836590536</c:v>
                </c:pt>
                <c:pt idx="8">
                  <c:v>-76391.231853566205</c:v>
                </c:pt>
                <c:pt idx="9">
                  <c:v>63255.756110186201</c:v>
                </c:pt>
                <c:pt idx="10">
                  <c:v>287606.872742882</c:v>
                </c:pt>
                <c:pt idx="11">
                  <c:v>565497.42504928797</c:v>
                </c:pt>
                <c:pt idx="12">
                  <c:v>335532.89935580501</c:v>
                </c:pt>
                <c:pt idx="13">
                  <c:v>233225.04518717399</c:v>
                </c:pt>
                <c:pt idx="14">
                  <c:v>95086.988208773197</c:v>
                </c:pt>
                <c:pt idx="15">
                  <c:v>45675.447674701798</c:v>
                </c:pt>
                <c:pt idx="16">
                  <c:v>59837.617275881697</c:v>
                </c:pt>
                <c:pt idx="17">
                  <c:v>93585.750173198103</c:v>
                </c:pt>
                <c:pt idx="18">
                  <c:v>166372.56065425399</c:v>
                </c:pt>
                <c:pt idx="19">
                  <c:v>123138.42414813</c:v>
                </c:pt>
                <c:pt idx="20">
                  <c:v>39955.483720636803</c:v>
                </c:pt>
                <c:pt idx="21">
                  <c:v>21610.416124187701</c:v>
                </c:pt>
                <c:pt idx="22">
                  <c:v>-82011.364073392193</c:v>
                </c:pt>
                <c:pt idx="23">
                  <c:v>-28794.771196928599</c:v>
                </c:pt>
                <c:pt idx="24">
                  <c:v>-30291.675412182802</c:v>
                </c:pt>
                <c:pt idx="25">
                  <c:v>49466.774089513397</c:v>
                </c:pt>
                <c:pt idx="26">
                  <c:v>0</c:v>
                </c:pt>
                <c:pt idx="27">
                  <c:v>0</c:v>
                </c:pt>
                <c:pt idx="28">
                  <c:v>31147.913501220901</c:v>
                </c:pt>
                <c:pt idx="29">
                  <c:v>-87601.415002501701</c:v>
                </c:pt>
                <c:pt idx="30">
                  <c:v>-54415.555519002199</c:v>
                </c:pt>
                <c:pt idx="31">
                  <c:v>11889.9638775781</c:v>
                </c:pt>
                <c:pt idx="32">
                  <c:v>10939.6663473316</c:v>
                </c:pt>
                <c:pt idx="33">
                  <c:v>17737.019246233602</c:v>
                </c:pt>
                <c:pt idx="34">
                  <c:v>294778.50179071701</c:v>
                </c:pt>
                <c:pt idx="35">
                  <c:v>648054.901607904</c:v>
                </c:pt>
                <c:pt idx="36">
                  <c:v>555661.42128777504</c:v>
                </c:pt>
                <c:pt idx="37">
                  <c:v>393355.625400258</c:v>
                </c:pt>
                <c:pt idx="38">
                  <c:v>187156.61698352601</c:v>
                </c:pt>
                <c:pt idx="39">
                  <c:v>184435.15199626001</c:v>
                </c:pt>
                <c:pt idx="40">
                  <c:v>189556.27959059301</c:v>
                </c:pt>
                <c:pt idx="41">
                  <c:v>99551.5492777498</c:v>
                </c:pt>
                <c:pt idx="42">
                  <c:v>94936.363146845397</c:v>
                </c:pt>
                <c:pt idx="43">
                  <c:v>111278.357663773</c:v>
                </c:pt>
                <c:pt idx="44">
                  <c:v>80055.709218652497</c:v>
                </c:pt>
                <c:pt idx="45">
                  <c:v>1831.86717279456</c:v>
                </c:pt>
                <c:pt idx="46">
                  <c:v>19728.956967148901</c:v>
                </c:pt>
                <c:pt idx="47">
                  <c:v>0</c:v>
                </c:pt>
                <c:pt idx="48">
                  <c:v>0</c:v>
                </c:pt>
                <c:pt idx="49">
                  <c:v>-19282.111472475401</c:v>
                </c:pt>
                <c:pt idx="50">
                  <c:v>35050.4604976954</c:v>
                </c:pt>
                <c:pt idx="51">
                  <c:v>19291.838323567001</c:v>
                </c:pt>
                <c:pt idx="52">
                  <c:v>25580.165702081598</c:v>
                </c:pt>
                <c:pt idx="53">
                  <c:v>-21825.5078742724</c:v>
                </c:pt>
                <c:pt idx="54">
                  <c:v>57633.292056010199</c:v>
                </c:pt>
                <c:pt idx="55">
                  <c:v>84175.777554290806</c:v>
                </c:pt>
                <c:pt idx="56">
                  <c:v>88174.903783949703</c:v>
                </c:pt>
                <c:pt idx="57">
                  <c:v>152206.984377927</c:v>
                </c:pt>
                <c:pt idx="58">
                  <c:v>571185.61505183706</c:v>
                </c:pt>
                <c:pt idx="59">
                  <c:v>1188035.46593246</c:v>
                </c:pt>
                <c:pt idx="60">
                  <c:v>897195.47479815199</c:v>
                </c:pt>
                <c:pt idx="61">
                  <c:v>567533.805349153</c:v>
                </c:pt>
                <c:pt idx="62">
                  <c:v>471616.06220427202</c:v>
                </c:pt>
                <c:pt idx="63">
                  <c:v>368330.85008327698</c:v>
                </c:pt>
                <c:pt idx="64">
                  <c:v>340330.88583133603</c:v>
                </c:pt>
                <c:pt idx="65">
                  <c:v>382282.34861833201</c:v>
                </c:pt>
                <c:pt idx="66">
                  <c:v>531300.32003108703</c:v>
                </c:pt>
                <c:pt idx="67">
                  <c:v>588143.49457888096</c:v>
                </c:pt>
                <c:pt idx="68">
                  <c:v>472281.440932289</c:v>
                </c:pt>
                <c:pt idx="69">
                  <c:v>570591.96452009596</c:v>
                </c:pt>
                <c:pt idx="70">
                  <c:v>539082.58153434005</c:v>
                </c:pt>
                <c:pt idx="71">
                  <c:v>461732.613602005</c:v>
                </c:pt>
                <c:pt idx="72">
                  <c:v>329695.40955754399</c:v>
                </c:pt>
                <c:pt idx="73">
                  <c:v>300250.94167533901</c:v>
                </c:pt>
                <c:pt idx="74">
                  <c:v>204252.57408867701</c:v>
                </c:pt>
                <c:pt idx="75">
                  <c:v>115417.330552826</c:v>
                </c:pt>
                <c:pt idx="76">
                  <c:v>275148.36694759299</c:v>
                </c:pt>
                <c:pt idx="77">
                  <c:v>331408.05904628302</c:v>
                </c:pt>
                <c:pt idx="78">
                  <c:v>255215.10968980001</c:v>
                </c:pt>
                <c:pt idx="79">
                  <c:v>297474.21457973903</c:v>
                </c:pt>
                <c:pt idx="80">
                  <c:v>282820.46313699801</c:v>
                </c:pt>
                <c:pt idx="81">
                  <c:v>220724.50685986801</c:v>
                </c:pt>
                <c:pt idx="82">
                  <c:v>126923.414020781</c:v>
                </c:pt>
                <c:pt idx="83">
                  <c:v>100529.71704436</c:v>
                </c:pt>
                <c:pt idx="84">
                  <c:v>105155.52760364101</c:v>
                </c:pt>
                <c:pt idx="85">
                  <c:v>133441.93679552601</c:v>
                </c:pt>
                <c:pt idx="86">
                  <c:v>156758.249895243</c:v>
                </c:pt>
                <c:pt idx="87">
                  <c:v>121825.37206328999</c:v>
                </c:pt>
                <c:pt idx="88">
                  <c:v>0</c:v>
                </c:pt>
                <c:pt idx="89">
                  <c:v>0</c:v>
                </c:pt>
                <c:pt idx="90">
                  <c:v>83394.705141320097</c:v>
                </c:pt>
                <c:pt idx="91">
                  <c:v>120905.344524154</c:v>
                </c:pt>
                <c:pt idx="92">
                  <c:v>78035.091094225398</c:v>
                </c:pt>
                <c:pt idx="93">
                  <c:v>18880.493674302099</c:v>
                </c:pt>
                <c:pt idx="94">
                  <c:v>122924.33955862001</c:v>
                </c:pt>
                <c:pt idx="95">
                  <c:v>19601.077448008498</c:v>
                </c:pt>
                <c:pt idx="96">
                  <c:v>-3492.8709174422702</c:v>
                </c:pt>
                <c:pt idx="97">
                  <c:v>101219.67693045401</c:v>
                </c:pt>
                <c:pt idx="98">
                  <c:v>101588.388571802</c:v>
                </c:pt>
                <c:pt idx="99">
                  <c:v>256760.045890746</c:v>
                </c:pt>
                <c:pt idx="100">
                  <c:v>334339.053160802</c:v>
                </c:pt>
                <c:pt idx="101">
                  <c:v>186624.49316541399</c:v>
                </c:pt>
                <c:pt idx="102">
                  <c:v>117180.060373824</c:v>
                </c:pt>
                <c:pt idx="103">
                  <c:v>18154.477435037301</c:v>
                </c:pt>
                <c:pt idx="104">
                  <c:v>54560.202764183297</c:v>
                </c:pt>
                <c:pt idx="105">
                  <c:v>90848.520470543997</c:v>
                </c:pt>
                <c:pt idx="106">
                  <c:v>58305.8458527482</c:v>
                </c:pt>
                <c:pt idx="107">
                  <c:v>-7196.9788916650105</c:v>
                </c:pt>
                <c:pt idx="108">
                  <c:v>-35904.553721212797</c:v>
                </c:pt>
                <c:pt idx="109">
                  <c:v>5771.8380716342599</c:v>
                </c:pt>
                <c:pt idx="110">
                  <c:v>85801.473457751097</c:v>
                </c:pt>
                <c:pt idx="111">
                  <c:v>84120.653362935904</c:v>
                </c:pt>
                <c:pt idx="112">
                  <c:v>16270.7148919469</c:v>
                </c:pt>
                <c:pt idx="113">
                  <c:v>-27799.693650946199</c:v>
                </c:pt>
                <c:pt idx="114">
                  <c:v>0</c:v>
                </c:pt>
                <c:pt idx="115">
                  <c:v>0</c:v>
                </c:pt>
                <c:pt idx="116">
                  <c:v>0</c:v>
                </c:pt>
                <c:pt idx="117">
                  <c:v>0</c:v>
                </c:pt>
                <c:pt idx="118">
                  <c:v>0</c:v>
                </c:pt>
                <c:pt idx="119">
                  <c:v>0</c:v>
                </c:pt>
                <c:pt idx="120">
                  <c:v>0</c:v>
                </c:pt>
                <c:pt idx="121">
                  <c:v>112845.76580548999</c:v>
                </c:pt>
                <c:pt idx="122">
                  <c:v>159777.80133359399</c:v>
                </c:pt>
                <c:pt idx="123">
                  <c:v>-9700.6437404267908</c:v>
                </c:pt>
                <c:pt idx="124">
                  <c:v>82877.562305016007</c:v>
                </c:pt>
                <c:pt idx="125">
                  <c:v>57451.846490663098</c:v>
                </c:pt>
                <c:pt idx="126">
                  <c:v>76935.616823878998</c:v>
                </c:pt>
                <c:pt idx="127">
                  <c:v>94532.402313971499</c:v>
                </c:pt>
                <c:pt idx="128">
                  <c:v>61248.217057766298</c:v>
                </c:pt>
                <c:pt idx="129">
                  <c:v>5758.8182113820703</c:v>
                </c:pt>
                <c:pt idx="130">
                  <c:v>0</c:v>
                </c:pt>
                <c:pt idx="131">
                  <c:v>0</c:v>
                </c:pt>
                <c:pt idx="132">
                  <c:v>-69707.460253742</c:v>
                </c:pt>
                <c:pt idx="133">
                  <c:v>12097.864021555401</c:v>
                </c:pt>
                <c:pt idx="134">
                  <c:v>46950.9163417077</c:v>
                </c:pt>
                <c:pt idx="135">
                  <c:v>17743.132369064901</c:v>
                </c:pt>
                <c:pt idx="136">
                  <c:v>9018.6779865262797</c:v>
                </c:pt>
                <c:pt idx="137">
                  <c:v>57802.795111073501</c:v>
                </c:pt>
                <c:pt idx="138">
                  <c:v>41897.354921187398</c:v>
                </c:pt>
                <c:pt idx="139">
                  <c:v>63793.412469633498</c:v>
                </c:pt>
                <c:pt idx="140">
                  <c:v>48394.587220581401</c:v>
                </c:pt>
                <c:pt idx="141">
                  <c:v>57612.996797714302</c:v>
                </c:pt>
                <c:pt idx="142">
                  <c:v>142144.53528401701</c:v>
                </c:pt>
                <c:pt idx="143">
                  <c:v>101002.342788373</c:v>
                </c:pt>
                <c:pt idx="144">
                  <c:v>59799.683396998596</c:v>
                </c:pt>
                <c:pt idx="145">
                  <c:v>97558.838431240598</c:v>
                </c:pt>
                <c:pt idx="146">
                  <c:v>122893.96193809</c:v>
                </c:pt>
                <c:pt idx="147">
                  <c:v>74370.722369795199</c:v>
                </c:pt>
                <c:pt idx="148">
                  <c:v>7364.4115730065496</c:v>
                </c:pt>
                <c:pt idx="149">
                  <c:v>-68470.820128463994</c:v>
                </c:pt>
                <c:pt idx="150">
                  <c:v>-16284.9639142091</c:v>
                </c:pt>
                <c:pt idx="151">
                  <c:v>0</c:v>
                </c:pt>
                <c:pt idx="152">
                  <c:v>0</c:v>
                </c:pt>
                <c:pt idx="153">
                  <c:v>22302.3358554486</c:v>
                </c:pt>
                <c:pt idx="154">
                  <c:v>-44445.317112848497</c:v>
                </c:pt>
                <c:pt idx="155">
                  <c:v>49317.176756266403</c:v>
                </c:pt>
                <c:pt idx="156">
                  <c:v>88343.1094887863</c:v>
                </c:pt>
                <c:pt idx="157">
                  <c:v>12692.110715769801</c:v>
                </c:pt>
                <c:pt idx="158">
                  <c:v>15280.0885917408</c:v>
                </c:pt>
                <c:pt idx="159">
                  <c:v>74243.744765234602</c:v>
                </c:pt>
                <c:pt idx="160">
                  <c:v>-45583.2819087026</c:v>
                </c:pt>
                <c:pt idx="161">
                  <c:v>-21678.1746120096</c:v>
                </c:pt>
                <c:pt idx="162">
                  <c:v>15733.761000427699</c:v>
                </c:pt>
                <c:pt idx="163">
                  <c:v>53072.266476956502</c:v>
                </c:pt>
                <c:pt idx="164">
                  <c:v>-29442.653993445299</c:v>
                </c:pt>
                <c:pt idx="165">
                  <c:v>-98598.383564602205</c:v>
                </c:pt>
                <c:pt idx="166">
                  <c:v>27164.263976360999</c:v>
                </c:pt>
                <c:pt idx="167">
                  <c:v>-8937.3435095742207</c:v>
                </c:pt>
                <c:pt idx="168">
                  <c:v>36486.282141136297</c:v>
                </c:pt>
                <c:pt idx="169">
                  <c:v>48848.829615062903</c:v>
                </c:pt>
                <c:pt idx="170">
                  <c:v>24217.167256656001</c:v>
                </c:pt>
                <c:pt idx="171">
                  <c:v>29896.993795230301</c:v>
                </c:pt>
                <c:pt idx="172">
                  <c:v>70372.770211002295</c:v>
                </c:pt>
                <c:pt idx="173">
                  <c:v>6772.4189440969203</c:v>
                </c:pt>
                <c:pt idx="174">
                  <c:v>-41436.647535780401</c:v>
                </c:pt>
                <c:pt idx="175">
                  <c:v>29511.246678714899</c:v>
                </c:pt>
                <c:pt idx="176">
                  <c:v>87481.137371935401</c:v>
                </c:pt>
                <c:pt idx="177">
                  <c:v>95508.032319819205</c:v>
                </c:pt>
                <c:pt idx="178">
                  <c:v>30827.414586921601</c:v>
                </c:pt>
                <c:pt idx="179">
                  <c:v>-22862.810511385898</c:v>
                </c:pt>
                <c:pt idx="180">
                  <c:v>10621.0239122929</c:v>
                </c:pt>
                <c:pt idx="181">
                  <c:v>35110.661857530802</c:v>
                </c:pt>
                <c:pt idx="182">
                  <c:v>47517.323318814102</c:v>
                </c:pt>
                <c:pt idx="183">
                  <c:v>71494.695653971503</c:v>
                </c:pt>
                <c:pt idx="184">
                  <c:v>94338.474090787699</c:v>
                </c:pt>
                <c:pt idx="185">
                  <c:v>100397.380084651</c:v>
                </c:pt>
                <c:pt idx="186">
                  <c:v>58927.611418128901</c:v>
                </c:pt>
                <c:pt idx="187">
                  <c:v>27215.0220853629</c:v>
                </c:pt>
                <c:pt idx="188">
                  <c:v>6678.1466159009897</c:v>
                </c:pt>
                <c:pt idx="189">
                  <c:v>-33585.601854494802</c:v>
                </c:pt>
                <c:pt idx="190">
                  <c:v>-17208.315775814401</c:v>
                </c:pt>
                <c:pt idx="191">
                  <c:v>35246.154797878698</c:v>
                </c:pt>
                <c:pt idx="192">
                  <c:v>-12322.288779222599</c:v>
                </c:pt>
                <c:pt idx="193">
                  <c:v>0</c:v>
                </c:pt>
                <c:pt idx="194">
                  <c:v>0</c:v>
                </c:pt>
                <c:pt idx="195">
                  <c:v>-20018.098232381799</c:v>
                </c:pt>
                <c:pt idx="196">
                  <c:v>-13144.4098936387</c:v>
                </c:pt>
                <c:pt idx="197">
                  <c:v>-26143.513098193402</c:v>
                </c:pt>
                <c:pt idx="198">
                  <c:v>-38100.287507289999</c:v>
                </c:pt>
                <c:pt idx="199">
                  <c:v>-34171.739323973103</c:v>
                </c:pt>
                <c:pt idx="200">
                  <c:v>40970.066912502298</c:v>
                </c:pt>
                <c:pt idx="201">
                  <c:v>108464.30533478899</c:v>
                </c:pt>
                <c:pt idx="202">
                  <c:v>117082.50622644799</c:v>
                </c:pt>
                <c:pt idx="203">
                  <c:v>90671.024939527502</c:v>
                </c:pt>
                <c:pt idx="204">
                  <c:v>39970.605102968198</c:v>
                </c:pt>
                <c:pt idx="205">
                  <c:v>11206.5361239452</c:v>
                </c:pt>
                <c:pt idx="206">
                  <c:v>46212.911066601097</c:v>
                </c:pt>
                <c:pt idx="207">
                  <c:v>-56243.527774222901</c:v>
                </c:pt>
                <c:pt idx="208">
                  <c:v>30264.157925816398</c:v>
                </c:pt>
                <c:pt idx="209">
                  <c:v>87100.097549952407</c:v>
                </c:pt>
                <c:pt idx="210">
                  <c:v>117280.31796447599</c:v>
                </c:pt>
                <c:pt idx="211">
                  <c:v>63360.275103270498</c:v>
                </c:pt>
                <c:pt idx="212">
                  <c:v>43950.499989050099</c:v>
                </c:pt>
                <c:pt idx="213">
                  <c:v>28095.892647402499</c:v>
                </c:pt>
                <c:pt idx="214">
                  <c:v>22886.792962781499</c:v>
                </c:pt>
                <c:pt idx="215">
                  <c:v>-2.1659711566026099</c:v>
                </c:pt>
                <c:pt idx="216">
                  <c:v>13680.4430396637</c:v>
                </c:pt>
                <c:pt idx="217">
                  <c:v>353.67516445936099</c:v>
                </c:pt>
                <c:pt idx="218">
                  <c:v>-39836.107403212198</c:v>
                </c:pt>
                <c:pt idx="219">
                  <c:v>-49732.075172862002</c:v>
                </c:pt>
                <c:pt idx="220">
                  <c:v>-43412.810889011598</c:v>
                </c:pt>
                <c:pt idx="221">
                  <c:v>-900.36425383557798</c:v>
                </c:pt>
                <c:pt idx="222">
                  <c:v>58631.402238325099</c:v>
                </c:pt>
                <c:pt idx="223">
                  <c:v>10513.997132929</c:v>
                </c:pt>
                <c:pt idx="224">
                  <c:v>-55915.9186347578</c:v>
                </c:pt>
                <c:pt idx="225">
                  <c:v>-42125.139014288703</c:v>
                </c:pt>
                <c:pt idx="226">
                  <c:v>-34599.980506497501</c:v>
                </c:pt>
                <c:pt idx="227">
                  <c:v>-100588.26931104199</c:v>
                </c:pt>
                <c:pt idx="228">
                  <c:v>-60323.636965625199</c:v>
                </c:pt>
                <c:pt idx="229">
                  <c:v>-70465.729127496001</c:v>
                </c:pt>
                <c:pt idx="230">
                  <c:v>-40576.7142816665</c:v>
                </c:pt>
                <c:pt idx="231">
                  <c:v>-79527.593449556894</c:v>
                </c:pt>
                <c:pt idx="232">
                  <c:v>-88347.305318491795</c:v>
                </c:pt>
                <c:pt idx="233">
                  <c:v>-33505.2605517134</c:v>
                </c:pt>
                <c:pt idx="234">
                  <c:v>-7444.2684463280602</c:v>
                </c:pt>
                <c:pt idx="235">
                  <c:v>41732.588273108602</c:v>
                </c:pt>
                <c:pt idx="236">
                  <c:v>25334.8663047273</c:v>
                </c:pt>
                <c:pt idx="237">
                  <c:v>89201.769137657204</c:v>
                </c:pt>
                <c:pt idx="238">
                  <c:v>61368.042128996298</c:v>
                </c:pt>
                <c:pt idx="239">
                  <c:v>-40742.4536400406</c:v>
                </c:pt>
                <c:pt idx="240">
                  <c:v>27336.411683204398</c:v>
                </c:pt>
                <c:pt idx="241">
                  <c:v>-8772.8332871565599</c:v>
                </c:pt>
                <c:pt idx="242">
                  <c:v>-566.53293067980496</c:v>
                </c:pt>
                <c:pt idx="243">
                  <c:v>-29614.148495652302</c:v>
                </c:pt>
                <c:pt idx="244">
                  <c:v>-18687.491075082002</c:v>
                </c:pt>
                <c:pt idx="245">
                  <c:v>58433.688746498803</c:v>
                </c:pt>
                <c:pt idx="246">
                  <c:v>64746.805516061802</c:v>
                </c:pt>
                <c:pt idx="247">
                  <c:v>37977.210274361001</c:v>
                </c:pt>
                <c:pt idx="248">
                  <c:v>-50258.588909119499</c:v>
                </c:pt>
                <c:pt idx="249">
                  <c:v>39882.069777513403</c:v>
                </c:pt>
                <c:pt idx="250">
                  <c:v>-12468.165040464901</c:v>
                </c:pt>
                <c:pt idx="251">
                  <c:v>22148.793402118299</c:v>
                </c:pt>
                <c:pt idx="252">
                  <c:v>-23221.645538430799</c:v>
                </c:pt>
                <c:pt idx="253">
                  <c:v>-25578.947119118799</c:v>
                </c:pt>
                <c:pt idx="254">
                  <c:v>0</c:v>
                </c:pt>
                <c:pt idx="255">
                  <c:v>0</c:v>
                </c:pt>
                <c:pt idx="256">
                  <c:v>-11161.63690949</c:v>
                </c:pt>
                <c:pt idx="257">
                  <c:v>-85004.418140985494</c:v>
                </c:pt>
                <c:pt idx="258">
                  <c:v>-109972.341799175</c:v>
                </c:pt>
                <c:pt idx="259">
                  <c:v>-37017.775069534699</c:v>
                </c:pt>
                <c:pt idx="260">
                  <c:v>-10301.8507917406</c:v>
                </c:pt>
                <c:pt idx="261">
                  <c:v>6488.4069322088799</c:v>
                </c:pt>
                <c:pt idx="262">
                  <c:v>-60041.293099620103</c:v>
                </c:pt>
                <c:pt idx="263">
                  <c:v>-39287.4584419085</c:v>
                </c:pt>
                <c:pt idx="264">
                  <c:v>-93636.401222574103</c:v>
                </c:pt>
                <c:pt idx="265">
                  <c:v>-38152.088568744097</c:v>
                </c:pt>
                <c:pt idx="266">
                  <c:v>85467.726539538504</c:v>
                </c:pt>
                <c:pt idx="267">
                  <c:v>31109.576586211198</c:v>
                </c:pt>
                <c:pt idx="268">
                  <c:v>-14142.1223972018</c:v>
                </c:pt>
                <c:pt idx="269">
                  <c:v>-27277.371517974701</c:v>
                </c:pt>
                <c:pt idx="270">
                  <c:v>-28049.3771791459</c:v>
                </c:pt>
                <c:pt idx="271">
                  <c:v>29504.189683229899</c:v>
                </c:pt>
                <c:pt idx="272">
                  <c:v>62241.877028421797</c:v>
                </c:pt>
                <c:pt idx="273">
                  <c:v>23957.848303942399</c:v>
                </c:pt>
                <c:pt idx="274">
                  <c:v>10525.260903566599</c:v>
                </c:pt>
                <c:pt idx="275">
                  <c:v>130479.565929112</c:v>
                </c:pt>
                <c:pt idx="276">
                  <c:v>98286.6925578511</c:v>
                </c:pt>
                <c:pt idx="277">
                  <c:v>112357.00352531001</c:v>
                </c:pt>
                <c:pt idx="278">
                  <c:v>143974.118588146</c:v>
                </c:pt>
                <c:pt idx="279">
                  <c:v>87882.311802748605</c:v>
                </c:pt>
                <c:pt idx="280">
                  <c:v>88407.245071744706</c:v>
                </c:pt>
                <c:pt idx="281">
                  <c:v>86277.372360346897</c:v>
                </c:pt>
                <c:pt idx="282">
                  <c:v>133029.230152125</c:v>
                </c:pt>
                <c:pt idx="283">
                  <c:v>2696.8093269768301</c:v>
                </c:pt>
                <c:pt idx="284">
                  <c:v>13973.0278996571</c:v>
                </c:pt>
                <c:pt idx="285">
                  <c:v>-18957.632855133401</c:v>
                </c:pt>
                <c:pt idx="286">
                  <c:v>41191.894244271003</c:v>
                </c:pt>
                <c:pt idx="287">
                  <c:v>24012.290257291599</c:v>
                </c:pt>
                <c:pt idx="288">
                  <c:v>-27558.938592991301</c:v>
                </c:pt>
                <c:pt idx="289">
                  <c:v>452.347517116745</c:v>
                </c:pt>
                <c:pt idx="290">
                  <c:v>0</c:v>
                </c:pt>
                <c:pt idx="291">
                  <c:v>0</c:v>
                </c:pt>
                <c:pt idx="292">
                  <c:v>-20405.482554631901</c:v>
                </c:pt>
                <c:pt idx="293">
                  <c:v>-61579.933340254502</c:v>
                </c:pt>
                <c:pt idx="294">
                  <c:v>42931.746898953897</c:v>
                </c:pt>
                <c:pt idx="295">
                  <c:v>209190.15079014201</c:v>
                </c:pt>
                <c:pt idx="296">
                  <c:v>275403.40801267</c:v>
                </c:pt>
                <c:pt idx="297">
                  <c:v>268520.223174738</c:v>
                </c:pt>
                <c:pt idx="298">
                  <c:v>249003.28927469399</c:v>
                </c:pt>
                <c:pt idx="299">
                  <c:v>107155.84541156499</c:v>
                </c:pt>
                <c:pt idx="300">
                  <c:v>160685.204701401</c:v>
                </c:pt>
                <c:pt idx="301">
                  <c:v>9407.9343864666898</c:v>
                </c:pt>
                <c:pt idx="302">
                  <c:v>-16981.866626020601</c:v>
                </c:pt>
                <c:pt idx="303">
                  <c:v>-36061.181483950801</c:v>
                </c:pt>
                <c:pt idx="304">
                  <c:v>16347.607121726</c:v>
                </c:pt>
                <c:pt idx="305">
                  <c:v>1997.4795619388799</c:v>
                </c:pt>
                <c:pt idx="306">
                  <c:v>19329.5976497431</c:v>
                </c:pt>
                <c:pt idx="307">
                  <c:v>15113.0758307293</c:v>
                </c:pt>
                <c:pt idx="308">
                  <c:v>0</c:v>
                </c:pt>
                <c:pt idx="309">
                  <c:v>0</c:v>
                </c:pt>
                <c:pt idx="310">
                  <c:v>32985.3507035777</c:v>
                </c:pt>
                <c:pt idx="311">
                  <c:v>34830.902827828198</c:v>
                </c:pt>
                <c:pt idx="312">
                  <c:v>22125.675628296802</c:v>
                </c:pt>
                <c:pt idx="313">
                  <c:v>77059.248779778398</c:v>
                </c:pt>
                <c:pt idx="314">
                  <c:v>74873.5013227897</c:v>
                </c:pt>
                <c:pt idx="315">
                  <c:v>-1934.8082683476</c:v>
                </c:pt>
                <c:pt idx="316">
                  <c:v>101745.604056218</c:v>
                </c:pt>
                <c:pt idx="317">
                  <c:v>86343.350120931995</c:v>
                </c:pt>
                <c:pt idx="318">
                  <c:v>17737.099821340998</c:v>
                </c:pt>
                <c:pt idx="319">
                  <c:v>72242.488081761403</c:v>
                </c:pt>
                <c:pt idx="320">
                  <c:v>110355.347007791</c:v>
                </c:pt>
                <c:pt idx="321">
                  <c:v>-95372.0855868246</c:v>
                </c:pt>
                <c:pt idx="322">
                  <c:v>-16895.740218296502</c:v>
                </c:pt>
                <c:pt idx="323">
                  <c:v>-20877.246983351699</c:v>
                </c:pt>
                <c:pt idx="324">
                  <c:v>-143232.40458935301</c:v>
                </c:pt>
                <c:pt idx="325">
                  <c:v>-42418.378789838098</c:v>
                </c:pt>
                <c:pt idx="326">
                  <c:v>-106622.079690538</c:v>
                </c:pt>
                <c:pt idx="327">
                  <c:v>-84506.165508738806</c:v>
                </c:pt>
                <c:pt idx="328">
                  <c:v>-121568.301488934</c:v>
                </c:pt>
                <c:pt idx="329">
                  <c:v>-125299.147435568</c:v>
                </c:pt>
                <c:pt idx="330">
                  <c:v>-89594.610852857397</c:v>
                </c:pt>
                <c:pt idx="331">
                  <c:v>-91968.468760014599</c:v>
                </c:pt>
                <c:pt idx="332">
                  <c:v>-65330.8469564771</c:v>
                </c:pt>
                <c:pt idx="333">
                  <c:v>-20285.336990572501</c:v>
                </c:pt>
                <c:pt idx="334">
                  <c:v>-81107.480791120295</c:v>
                </c:pt>
                <c:pt idx="335">
                  <c:v>-117913.584101676</c:v>
                </c:pt>
                <c:pt idx="336">
                  <c:v>-73600.331714215907</c:v>
                </c:pt>
                <c:pt idx="337">
                  <c:v>-44275.709574208697</c:v>
                </c:pt>
                <c:pt idx="338">
                  <c:v>11403.720913941601</c:v>
                </c:pt>
                <c:pt idx="339">
                  <c:v>-33296.8499149692</c:v>
                </c:pt>
                <c:pt idx="340">
                  <c:v>-88492.039102875904</c:v>
                </c:pt>
                <c:pt idx="341">
                  <c:v>-45483.067078810898</c:v>
                </c:pt>
                <c:pt idx="342">
                  <c:v>-35252.625615390898</c:v>
                </c:pt>
                <c:pt idx="343">
                  <c:v>-27343.184091831801</c:v>
                </c:pt>
                <c:pt idx="344">
                  <c:v>43169.070693171801</c:v>
                </c:pt>
                <c:pt idx="345">
                  <c:v>-27246.1678275056</c:v>
                </c:pt>
                <c:pt idx="346">
                  <c:v>-31957.2595001021</c:v>
                </c:pt>
                <c:pt idx="347">
                  <c:v>-12005.8994582083</c:v>
                </c:pt>
                <c:pt idx="348">
                  <c:v>-62206.216601584201</c:v>
                </c:pt>
                <c:pt idx="349">
                  <c:v>0</c:v>
                </c:pt>
                <c:pt idx="350">
                  <c:v>0</c:v>
                </c:pt>
                <c:pt idx="351">
                  <c:v>-83427.686731325506</c:v>
                </c:pt>
                <c:pt idx="352">
                  <c:v>-56531.172392754102</c:v>
                </c:pt>
                <c:pt idx="353">
                  <c:v>-40781.0583588277</c:v>
                </c:pt>
                <c:pt idx="354">
                  <c:v>-37407.977097824099</c:v>
                </c:pt>
                <c:pt idx="355">
                  <c:v>6785.3552966289499</c:v>
                </c:pt>
                <c:pt idx="356">
                  <c:v>61745.668981403498</c:v>
                </c:pt>
                <c:pt idx="357">
                  <c:v>-5754.3576509295399</c:v>
                </c:pt>
                <c:pt idx="358">
                  <c:v>66214.999292972207</c:v>
                </c:pt>
                <c:pt idx="359">
                  <c:v>79060.147457685496</c:v>
                </c:pt>
                <c:pt idx="360">
                  <c:v>-17564.333021008701</c:v>
                </c:pt>
                <c:pt idx="361">
                  <c:v>-101737.990271039</c:v>
                </c:pt>
                <c:pt idx="362">
                  <c:v>-126984.22770292799</c:v>
                </c:pt>
                <c:pt idx="363">
                  <c:v>-27174.9936544294</c:v>
                </c:pt>
                <c:pt idx="364">
                  <c:v>-11364.5889625132</c:v>
                </c:pt>
                <c:pt idx="365">
                  <c:v>-48745.982604013101</c:v>
                </c:pt>
                <c:pt idx="366">
                  <c:v>-53802.056537857497</c:v>
                </c:pt>
                <c:pt idx="367">
                  <c:v>-40100.098997538204</c:v>
                </c:pt>
                <c:pt idx="368">
                  <c:v>19164.085527094499</c:v>
                </c:pt>
                <c:pt idx="369">
                  <c:v>-2003.64336338674</c:v>
                </c:pt>
                <c:pt idx="370">
                  <c:v>42033.617405662299</c:v>
                </c:pt>
                <c:pt idx="371">
                  <c:v>-16466.874747440401</c:v>
                </c:pt>
                <c:pt idx="372">
                  <c:v>90145.716987565407</c:v>
                </c:pt>
                <c:pt idx="373">
                  <c:v>10089.809572267901</c:v>
                </c:pt>
                <c:pt idx="374">
                  <c:v>13174.075204093</c:v>
                </c:pt>
                <c:pt idx="375">
                  <c:v>11082.9059219746</c:v>
                </c:pt>
                <c:pt idx="376">
                  <c:v>-85138.2036351305</c:v>
                </c:pt>
                <c:pt idx="377">
                  <c:v>-55951.927313229397</c:v>
                </c:pt>
                <c:pt idx="378">
                  <c:v>50915.970632872697</c:v>
                </c:pt>
                <c:pt idx="379">
                  <c:v>-48087.525653593002</c:v>
                </c:pt>
                <c:pt idx="380">
                  <c:v>-76636.338888914994</c:v>
                </c:pt>
                <c:pt idx="381">
                  <c:v>49760.757225777197</c:v>
                </c:pt>
                <c:pt idx="382">
                  <c:v>-69239.975890335001</c:v>
                </c:pt>
                <c:pt idx="383">
                  <c:v>-74423.358777028901</c:v>
                </c:pt>
                <c:pt idx="384">
                  <c:v>-18892.547402570901</c:v>
                </c:pt>
                <c:pt idx="385">
                  <c:v>49241.728958158499</c:v>
                </c:pt>
                <c:pt idx="386">
                  <c:v>59505.647146081101</c:v>
                </c:pt>
                <c:pt idx="387">
                  <c:v>-29652.9591233069</c:v>
                </c:pt>
                <c:pt idx="388">
                  <c:v>-85008.404034053994</c:v>
                </c:pt>
                <c:pt idx="389">
                  <c:v>1538.40869716918</c:v>
                </c:pt>
                <c:pt idx="390">
                  <c:v>0</c:v>
                </c:pt>
                <c:pt idx="391">
                  <c:v>0</c:v>
                </c:pt>
                <c:pt idx="392">
                  <c:v>39598.467614431203</c:v>
                </c:pt>
                <c:pt idx="393">
                  <c:v>-14368.9027007272</c:v>
                </c:pt>
                <c:pt idx="394">
                  <c:v>7094.2920685106001</c:v>
                </c:pt>
                <c:pt idx="395">
                  <c:v>14933.7631325895</c:v>
                </c:pt>
                <c:pt idx="396">
                  <c:v>23672.7986274215</c:v>
                </c:pt>
                <c:pt idx="397">
                  <c:v>50924.9885881097</c:v>
                </c:pt>
                <c:pt idx="398">
                  <c:v>110110.793073058</c:v>
                </c:pt>
                <c:pt idx="399">
                  <c:v>48813.096645674901</c:v>
                </c:pt>
                <c:pt idx="400">
                  <c:v>142623.122983454</c:v>
                </c:pt>
                <c:pt idx="401">
                  <c:v>110611.364975691</c:v>
                </c:pt>
                <c:pt idx="402">
                  <c:v>38996.397300449396</c:v>
                </c:pt>
                <c:pt idx="403">
                  <c:v>21465.302712270401</c:v>
                </c:pt>
                <c:pt idx="404">
                  <c:v>-59333.249208552399</c:v>
                </c:pt>
                <c:pt idx="405">
                  <c:v>-57308.297118380498</c:v>
                </c:pt>
                <c:pt idx="406">
                  <c:v>-28974.7178653624</c:v>
                </c:pt>
                <c:pt idx="407">
                  <c:v>26026.487666633999</c:v>
                </c:pt>
                <c:pt idx="408">
                  <c:v>80523.397952831496</c:v>
                </c:pt>
                <c:pt idx="409">
                  <c:v>128595.330468637</c:v>
                </c:pt>
                <c:pt idx="410">
                  <c:v>3324.0291741359802</c:v>
                </c:pt>
                <c:pt idx="411">
                  <c:v>-58489.304911290499</c:v>
                </c:pt>
                <c:pt idx="412">
                  <c:v>-38805.147582121303</c:v>
                </c:pt>
                <c:pt idx="413">
                  <c:v>-23130.0410436497</c:v>
                </c:pt>
                <c:pt idx="414">
                  <c:v>24682.4553369104</c:v>
                </c:pt>
                <c:pt idx="415">
                  <c:v>9075.6432308638105</c:v>
                </c:pt>
                <c:pt idx="416">
                  <c:v>8580.70976899175</c:v>
                </c:pt>
                <c:pt idx="417">
                  <c:v>28314.622156697002</c:v>
                </c:pt>
                <c:pt idx="418">
                  <c:v>134831.62561446</c:v>
                </c:pt>
                <c:pt idx="419">
                  <c:v>-122259.477511355</c:v>
                </c:pt>
                <c:pt idx="420">
                  <c:v>-76851.152103475193</c:v>
                </c:pt>
                <c:pt idx="421">
                  <c:v>-4483.3289215397199</c:v>
                </c:pt>
                <c:pt idx="422">
                  <c:v>3301.3845076037201</c:v>
                </c:pt>
                <c:pt idx="423">
                  <c:v>67368.2242428912</c:v>
                </c:pt>
                <c:pt idx="424">
                  <c:v>971.55485205587297</c:v>
                </c:pt>
                <c:pt idx="425">
                  <c:v>-11846.866319487801</c:v>
                </c:pt>
                <c:pt idx="426">
                  <c:v>47089.9232008256</c:v>
                </c:pt>
                <c:pt idx="427">
                  <c:v>47950.154369068499</c:v>
                </c:pt>
                <c:pt idx="428">
                  <c:v>7909.2240085713502</c:v>
                </c:pt>
                <c:pt idx="429">
                  <c:v>-93068.414685379394</c:v>
                </c:pt>
                <c:pt idx="430">
                  <c:v>-21152.341148288298</c:v>
                </c:pt>
                <c:pt idx="431">
                  <c:v>0</c:v>
                </c:pt>
                <c:pt idx="432">
                  <c:v>0</c:v>
                </c:pt>
                <c:pt idx="433">
                  <c:v>15781.2606501506</c:v>
                </c:pt>
                <c:pt idx="434">
                  <c:v>-51333.679439086998</c:v>
                </c:pt>
                <c:pt idx="435">
                  <c:v>3939.6769783566301</c:v>
                </c:pt>
                <c:pt idx="436">
                  <c:v>-79046.153349030603</c:v>
                </c:pt>
                <c:pt idx="437">
                  <c:v>-37707.594657064001</c:v>
                </c:pt>
                <c:pt idx="438">
                  <c:v>-3246.87094819912</c:v>
                </c:pt>
                <c:pt idx="439">
                  <c:v>82819.685268697707</c:v>
                </c:pt>
                <c:pt idx="440">
                  <c:v>-14547.7334727586</c:v>
                </c:pt>
                <c:pt idx="441">
                  <c:v>-97818.945156208705</c:v>
                </c:pt>
                <c:pt idx="442">
                  <c:v>-9168.4896944263201</c:v>
                </c:pt>
                <c:pt idx="443">
                  <c:v>-8455.6643408017408</c:v>
                </c:pt>
                <c:pt idx="444">
                  <c:v>-116542.967857371</c:v>
                </c:pt>
                <c:pt idx="445">
                  <c:v>-43605.135168542802</c:v>
                </c:pt>
                <c:pt idx="446">
                  <c:v>-34002.951819037502</c:v>
                </c:pt>
                <c:pt idx="447">
                  <c:v>-33099.964579610103</c:v>
                </c:pt>
                <c:pt idx="448">
                  <c:v>10529.4086220315</c:v>
                </c:pt>
                <c:pt idx="449">
                  <c:v>23002.9718018639</c:v>
                </c:pt>
                <c:pt idx="450">
                  <c:v>-6588.9650225210098</c:v>
                </c:pt>
                <c:pt idx="451">
                  <c:v>-29574.645679617501</c:v>
                </c:pt>
                <c:pt idx="452">
                  <c:v>0</c:v>
                </c:pt>
                <c:pt idx="453">
                  <c:v>0</c:v>
                </c:pt>
                <c:pt idx="454">
                  <c:v>-34759.713525428298</c:v>
                </c:pt>
                <c:pt idx="455">
                  <c:v>32348.159639979702</c:v>
                </c:pt>
                <c:pt idx="456">
                  <c:v>18006.548115867899</c:v>
                </c:pt>
                <c:pt idx="457">
                  <c:v>29605.246894669199</c:v>
                </c:pt>
                <c:pt idx="458">
                  <c:v>-5435.28882413869</c:v>
                </c:pt>
                <c:pt idx="459">
                  <c:v>111327.584579943</c:v>
                </c:pt>
                <c:pt idx="460">
                  <c:v>71142.723385123303</c:v>
                </c:pt>
                <c:pt idx="461">
                  <c:v>196108.00331950301</c:v>
                </c:pt>
                <c:pt idx="462">
                  <c:v>202227.52812891701</c:v>
                </c:pt>
                <c:pt idx="463">
                  <c:v>178215.34390676601</c:v>
                </c:pt>
                <c:pt idx="464">
                  <c:v>76562.803717364295</c:v>
                </c:pt>
                <c:pt idx="465">
                  <c:v>24118.878844004001</c:v>
                </c:pt>
                <c:pt idx="466">
                  <c:v>-6359.9499589126199</c:v>
                </c:pt>
                <c:pt idx="467">
                  <c:v>19678.0209170862</c:v>
                </c:pt>
                <c:pt idx="468">
                  <c:v>1435.54458592675</c:v>
                </c:pt>
                <c:pt idx="469">
                  <c:v>-49697.030728952297</c:v>
                </c:pt>
                <c:pt idx="470">
                  <c:v>-15182.652233209999</c:v>
                </c:pt>
                <c:pt idx="471">
                  <c:v>2166.54069088601</c:v>
                </c:pt>
                <c:pt idx="472">
                  <c:v>13624.8880597764</c:v>
                </c:pt>
                <c:pt idx="473">
                  <c:v>0</c:v>
                </c:pt>
                <c:pt idx="474">
                  <c:v>0</c:v>
                </c:pt>
                <c:pt idx="475">
                  <c:v>48119.431544784602</c:v>
                </c:pt>
                <c:pt idx="476">
                  <c:v>113384.50984142099</c:v>
                </c:pt>
                <c:pt idx="477">
                  <c:v>120325.51927923399</c:v>
                </c:pt>
                <c:pt idx="478">
                  <c:v>-8222.2040836814303</c:v>
                </c:pt>
                <c:pt idx="479">
                  <c:v>9609.0984464897101</c:v>
                </c:pt>
                <c:pt idx="480">
                  <c:v>43174.271941556297</c:v>
                </c:pt>
                <c:pt idx="481">
                  <c:v>69140.823565611194</c:v>
                </c:pt>
                <c:pt idx="482">
                  <c:v>17539.7926112065</c:v>
                </c:pt>
                <c:pt idx="483">
                  <c:v>30972.9491960821</c:v>
                </c:pt>
                <c:pt idx="484">
                  <c:v>-88474.293915924005</c:v>
                </c:pt>
                <c:pt idx="485">
                  <c:v>-38625.509685463301</c:v>
                </c:pt>
                <c:pt idx="486">
                  <c:v>-22863.541743952799</c:v>
                </c:pt>
                <c:pt idx="487">
                  <c:v>5500.4382899242601</c:v>
                </c:pt>
                <c:pt idx="488">
                  <c:v>-31383.148739287</c:v>
                </c:pt>
                <c:pt idx="489">
                  <c:v>-32183.369233256599</c:v>
                </c:pt>
                <c:pt idx="490">
                  <c:v>-16225.4125261799</c:v>
                </c:pt>
                <c:pt idx="491">
                  <c:v>63286.12037189</c:v>
                </c:pt>
                <c:pt idx="492">
                  <c:v>37137.867065881997</c:v>
                </c:pt>
                <c:pt idx="493">
                  <c:v>4401.8504102253301</c:v>
                </c:pt>
                <c:pt idx="494">
                  <c:v>-27118.007677929301</c:v>
                </c:pt>
                <c:pt idx="495">
                  <c:v>-27760.890518751199</c:v>
                </c:pt>
                <c:pt idx="496">
                  <c:v>-19893.704594680301</c:v>
                </c:pt>
                <c:pt idx="497">
                  <c:v>17215.279418133799</c:v>
                </c:pt>
                <c:pt idx="498">
                  <c:v>-51692.876447193798</c:v>
                </c:pt>
                <c:pt idx="499">
                  <c:v>-30853.967116016898</c:v>
                </c:pt>
                <c:pt idx="500">
                  <c:v>-53284.589296604499</c:v>
                </c:pt>
                <c:pt idx="501">
                  <c:v>-87958.370276087793</c:v>
                </c:pt>
                <c:pt idx="502">
                  <c:v>-169903.88813442501</c:v>
                </c:pt>
                <c:pt idx="503">
                  <c:v>-77135.320079397497</c:v>
                </c:pt>
                <c:pt idx="504">
                  <c:v>-83743.961721529005</c:v>
                </c:pt>
                <c:pt idx="505">
                  <c:v>1793.4895786295201</c:v>
                </c:pt>
                <c:pt idx="506">
                  <c:v>-28603.4646835352</c:v>
                </c:pt>
                <c:pt idx="507">
                  <c:v>-71067.338288873696</c:v>
                </c:pt>
                <c:pt idx="508">
                  <c:v>-157527.39089227901</c:v>
                </c:pt>
                <c:pt idx="509">
                  <c:v>-120599.12537563901</c:v>
                </c:pt>
                <c:pt idx="510">
                  <c:v>2965.9888986009801</c:v>
                </c:pt>
                <c:pt idx="511">
                  <c:v>-92048.224150312803</c:v>
                </c:pt>
                <c:pt idx="512">
                  <c:v>-815.34230660907599</c:v>
                </c:pt>
                <c:pt idx="513">
                  <c:v>42679.3266483591</c:v>
                </c:pt>
                <c:pt idx="514">
                  <c:v>-55464.531477960401</c:v>
                </c:pt>
                <c:pt idx="515">
                  <c:v>-57937.730520450103</c:v>
                </c:pt>
                <c:pt idx="516">
                  <c:v>-65560.874191686496</c:v>
                </c:pt>
                <c:pt idx="517">
                  <c:v>-32702.351537417901</c:v>
                </c:pt>
                <c:pt idx="518">
                  <c:v>-22810.5418030494</c:v>
                </c:pt>
                <c:pt idx="519">
                  <c:v>-92753.923730509399</c:v>
                </c:pt>
                <c:pt idx="520">
                  <c:v>-81882.658314029395</c:v>
                </c:pt>
                <c:pt idx="521">
                  <c:v>-45625.711167159898</c:v>
                </c:pt>
                <c:pt idx="522">
                  <c:v>-66587.704927777304</c:v>
                </c:pt>
                <c:pt idx="523">
                  <c:v>-79246.901660614894</c:v>
                </c:pt>
                <c:pt idx="524">
                  <c:v>-38943.953422722298</c:v>
                </c:pt>
                <c:pt idx="525">
                  <c:v>-13738.4574189048</c:v>
                </c:pt>
                <c:pt idx="526">
                  <c:v>-57414.6975186704</c:v>
                </c:pt>
                <c:pt idx="527">
                  <c:v>-80775.088683352995</c:v>
                </c:pt>
                <c:pt idx="528">
                  <c:v>-47299.937552320203</c:v>
                </c:pt>
                <c:pt idx="529">
                  <c:v>-103763.135962845</c:v>
                </c:pt>
                <c:pt idx="530">
                  <c:v>-43285.870428299597</c:v>
                </c:pt>
                <c:pt idx="531">
                  <c:v>0</c:v>
                </c:pt>
                <c:pt idx="532">
                  <c:v>0</c:v>
                </c:pt>
                <c:pt idx="533">
                  <c:v>30700.610778744602</c:v>
                </c:pt>
                <c:pt idx="534">
                  <c:v>65507.899115122898</c:v>
                </c:pt>
                <c:pt idx="535">
                  <c:v>-32557.798025193399</c:v>
                </c:pt>
                <c:pt idx="536">
                  <c:v>25764.2258384651</c:v>
                </c:pt>
                <c:pt idx="537">
                  <c:v>-88114.527038604196</c:v>
                </c:pt>
                <c:pt idx="538">
                  <c:v>-60699.974747036104</c:v>
                </c:pt>
                <c:pt idx="539">
                  <c:v>-69265.364925211004</c:v>
                </c:pt>
                <c:pt idx="540">
                  <c:v>-58716.914845944302</c:v>
                </c:pt>
                <c:pt idx="541">
                  <c:v>-22067.445600490599</c:v>
                </c:pt>
                <c:pt idx="542">
                  <c:v>-9806.8264781958096</c:v>
                </c:pt>
                <c:pt idx="543">
                  <c:v>-8807.5900054977392</c:v>
                </c:pt>
                <c:pt idx="544">
                  <c:v>-48710.5588129678</c:v>
                </c:pt>
                <c:pt idx="545">
                  <c:v>-17358.7511912316</c:v>
                </c:pt>
                <c:pt idx="546">
                  <c:v>29055.84192074</c:v>
                </c:pt>
                <c:pt idx="547">
                  <c:v>34620.022185903603</c:v>
                </c:pt>
                <c:pt idx="548">
                  <c:v>-5408.6398680143502</c:v>
                </c:pt>
                <c:pt idx="549">
                  <c:v>-14426.309606189399</c:v>
                </c:pt>
                <c:pt idx="550">
                  <c:v>46790.136862296902</c:v>
                </c:pt>
                <c:pt idx="551">
                  <c:v>48512.562557794503</c:v>
                </c:pt>
                <c:pt idx="552">
                  <c:v>33919.350672517801</c:v>
                </c:pt>
                <c:pt idx="553">
                  <c:v>-73346.617983679505</c:v>
                </c:pt>
                <c:pt idx="554">
                  <c:v>-72293.318238940294</c:v>
                </c:pt>
                <c:pt idx="555">
                  <c:v>-82784.598563948399</c:v>
                </c:pt>
                <c:pt idx="556">
                  <c:v>7936.9014933061399</c:v>
                </c:pt>
                <c:pt idx="557">
                  <c:v>-15448.035514470999</c:v>
                </c:pt>
                <c:pt idx="558">
                  <c:v>-16332.3827170269</c:v>
                </c:pt>
                <c:pt idx="559">
                  <c:v>48001.427342893097</c:v>
                </c:pt>
                <c:pt idx="560">
                  <c:v>-35739.472009417601</c:v>
                </c:pt>
                <c:pt idx="561">
                  <c:v>42449.944348582503</c:v>
                </c:pt>
                <c:pt idx="562">
                  <c:v>81321.0158664919</c:v>
                </c:pt>
                <c:pt idx="563">
                  <c:v>78048.982984029601</c:v>
                </c:pt>
                <c:pt idx="564">
                  <c:v>39793.9972399283</c:v>
                </c:pt>
                <c:pt idx="565">
                  <c:v>-52605.229745790697</c:v>
                </c:pt>
                <c:pt idx="566">
                  <c:v>44361.794076450598</c:v>
                </c:pt>
                <c:pt idx="567">
                  <c:v>-12649.4556127914</c:v>
                </c:pt>
                <c:pt idx="568">
                  <c:v>28828.541114507199</c:v>
                </c:pt>
                <c:pt idx="569">
                  <c:v>142490.07280788699</c:v>
                </c:pt>
                <c:pt idx="570">
                  <c:v>93842.247228925204</c:v>
                </c:pt>
                <c:pt idx="571">
                  <c:v>9421.0220505136003</c:v>
                </c:pt>
                <c:pt idx="572">
                  <c:v>-285.91187153298199</c:v>
                </c:pt>
                <c:pt idx="573">
                  <c:v>22513.533889280399</c:v>
                </c:pt>
                <c:pt idx="574">
                  <c:v>-25308.141507459401</c:v>
                </c:pt>
                <c:pt idx="575">
                  <c:v>-30559.569162286101</c:v>
                </c:pt>
                <c:pt idx="576">
                  <c:v>-6284.6838673068296</c:v>
                </c:pt>
                <c:pt idx="577">
                  <c:v>-29564.264609587801</c:v>
                </c:pt>
                <c:pt idx="578">
                  <c:v>-73815.037339688497</c:v>
                </c:pt>
                <c:pt idx="579">
                  <c:v>-51875.920068414802</c:v>
                </c:pt>
                <c:pt idx="580">
                  <c:v>116632.981235003</c:v>
                </c:pt>
                <c:pt idx="581">
                  <c:v>4928.3728679501701</c:v>
                </c:pt>
                <c:pt idx="582">
                  <c:v>-42750.830257486603</c:v>
                </c:pt>
                <c:pt idx="583">
                  <c:v>-58865.075209870702</c:v>
                </c:pt>
                <c:pt idx="584">
                  <c:v>-40059.164405337302</c:v>
                </c:pt>
                <c:pt idx="585">
                  <c:v>-7769.8858522088703</c:v>
                </c:pt>
                <c:pt idx="586">
                  <c:v>13995.6859578236</c:v>
                </c:pt>
                <c:pt idx="587">
                  <c:v>114936.019046363</c:v>
                </c:pt>
                <c:pt idx="588">
                  <c:v>82265.0606777051</c:v>
                </c:pt>
                <c:pt idx="589">
                  <c:v>-42656.6879046881</c:v>
                </c:pt>
                <c:pt idx="590">
                  <c:v>31957.793039706401</c:v>
                </c:pt>
                <c:pt idx="591">
                  <c:v>-13979.912448392701</c:v>
                </c:pt>
                <c:pt idx="592">
                  <c:v>0</c:v>
                </c:pt>
                <c:pt idx="593">
                  <c:v>0</c:v>
                </c:pt>
                <c:pt idx="594">
                  <c:v>58660.705006990902</c:v>
                </c:pt>
                <c:pt idx="595">
                  <c:v>-60911.050346773402</c:v>
                </c:pt>
                <c:pt idx="596">
                  <c:v>9683.6166809716597</c:v>
                </c:pt>
                <c:pt idx="597">
                  <c:v>-16717.067224036</c:v>
                </c:pt>
                <c:pt idx="598">
                  <c:v>12001.7307950551</c:v>
                </c:pt>
                <c:pt idx="599">
                  <c:v>-43252.894589331299</c:v>
                </c:pt>
                <c:pt idx="600">
                  <c:v>18298.412290143398</c:v>
                </c:pt>
                <c:pt idx="601">
                  <c:v>-33705.831733209197</c:v>
                </c:pt>
                <c:pt idx="602">
                  <c:v>-45075.5175896539</c:v>
                </c:pt>
                <c:pt idx="603">
                  <c:v>-45161.8591936421</c:v>
                </c:pt>
                <c:pt idx="604">
                  <c:v>35918.7985138843</c:v>
                </c:pt>
                <c:pt idx="605">
                  <c:v>55005.939870854003</c:v>
                </c:pt>
                <c:pt idx="606">
                  <c:v>743.51493842025195</c:v>
                </c:pt>
                <c:pt idx="607">
                  <c:v>-41897.400724651197</c:v>
                </c:pt>
                <c:pt idx="608">
                  <c:v>-80082.1432361271</c:v>
                </c:pt>
                <c:pt idx="609">
                  <c:v>-89195.481695195893</c:v>
                </c:pt>
                <c:pt idx="610">
                  <c:v>-95830.812595097494</c:v>
                </c:pt>
                <c:pt idx="611">
                  <c:v>-36580.9122663573</c:v>
                </c:pt>
                <c:pt idx="612">
                  <c:v>5399.1459035497701</c:v>
                </c:pt>
                <c:pt idx="613">
                  <c:v>-43898.349028080098</c:v>
                </c:pt>
                <c:pt idx="614">
                  <c:v>-78492.034362327002</c:v>
                </c:pt>
                <c:pt idx="615">
                  <c:v>-46986.742073388203</c:v>
                </c:pt>
                <c:pt idx="616">
                  <c:v>-62376.0079508567</c:v>
                </c:pt>
                <c:pt idx="617">
                  <c:v>15480.798733302699</c:v>
                </c:pt>
                <c:pt idx="618">
                  <c:v>-47989.923247115701</c:v>
                </c:pt>
                <c:pt idx="619">
                  <c:v>-62344.974330160498</c:v>
                </c:pt>
                <c:pt idx="620">
                  <c:v>-32901.519390905298</c:v>
                </c:pt>
                <c:pt idx="621">
                  <c:v>-111273.907168841</c:v>
                </c:pt>
                <c:pt idx="622">
                  <c:v>-116337.768616671</c:v>
                </c:pt>
                <c:pt idx="623">
                  <c:v>-25301.966608231702</c:v>
                </c:pt>
                <c:pt idx="624">
                  <c:v>-32583.996742975</c:v>
                </c:pt>
                <c:pt idx="625">
                  <c:v>23180.720749249402</c:v>
                </c:pt>
                <c:pt idx="626">
                  <c:v>5070.9538786779503</c:v>
                </c:pt>
                <c:pt idx="627">
                  <c:v>-21522.359970757701</c:v>
                </c:pt>
                <c:pt idx="628">
                  <c:v>-5094.12801390816</c:v>
                </c:pt>
                <c:pt idx="629">
                  <c:v>101187.008423308</c:v>
                </c:pt>
                <c:pt idx="630">
                  <c:v>-31592.244735843102</c:v>
                </c:pt>
                <c:pt idx="631">
                  <c:v>45628.851748929803</c:v>
                </c:pt>
                <c:pt idx="632">
                  <c:v>30759.4385636476</c:v>
                </c:pt>
                <c:pt idx="633">
                  <c:v>0</c:v>
                </c:pt>
                <c:pt idx="634">
                  <c:v>0</c:v>
                </c:pt>
                <c:pt idx="635">
                  <c:v>-83246.231246120893</c:v>
                </c:pt>
                <c:pt idx="636">
                  <c:v>-56753.371593973898</c:v>
                </c:pt>
                <c:pt idx="637">
                  <c:v>-27630.1769121004</c:v>
                </c:pt>
                <c:pt idx="638">
                  <c:v>-26095.994380159002</c:v>
                </c:pt>
                <c:pt idx="639">
                  <c:v>-82950.342274397699</c:v>
                </c:pt>
                <c:pt idx="640">
                  <c:v>18991.0087228466</c:v>
                </c:pt>
                <c:pt idx="641">
                  <c:v>29702.413928864698</c:v>
                </c:pt>
                <c:pt idx="642">
                  <c:v>-50738.864925765803</c:v>
                </c:pt>
                <c:pt idx="643">
                  <c:v>-39942.465911435502</c:v>
                </c:pt>
                <c:pt idx="644">
                  <c:v>-82918.494269107294</c:v>
                </c:pt>
                <c:pt idx="645">
                  <c:v>-41511.842469354102</c:v>
                </c:pt>
                <c:pt idx="646">
                  <c:v>-96390.6143879546</c:v>
                </c:pt>
                <c:pt idx="647">
                  <c:v>18437.173672725501</c:v>
                </c:pt>
                <c:pt idx="648">
                  <c:v>-21758.887871300401</c:v>
                </c:pt>
                <c:pt idx="649">
                  <c:v>-15131.112717509999</c:v>
                </c:pt>
                <c:pt idx="650">
                  <c:v>-47701.751965301402</c:v>
                </c:pt>
                <c:pt idx="651">
                  <c:v>37615.943481623799</c:v>
                </c:pt>
                <c:pt idx="652">
                  <c:v>2413.9967504691499</c:v>
                </c:pt>
                <c:pt idx="653">
                  <c:v>108543.829962426</c:v>
                </c:pt>
                <c:pt idx="654">
                  <c:v>82482.612529809106</c:v>
                </c:pt>
                <c:pt idx="655">
                  <c:v>55887.321570816799</c:v>
                </c:pt>
                <c:pt idx="656">
                  <c:v>11512.4087473238</c:v>
                </c:pt>
                <c:pt idx="657">
                  <c:v>-9061.3125424009395</c:v>
                </c:pt>
                <c:pt idx="658">
                  <c:v>27055.431240092501</c:v>
                </c:pt>
                <c:pt idx="659">
                  <c:v>-40652.718701849102</c:v>
                </c:pt>
                <c:pt idx="660">
                  <c:v>-5697.9371703322304</c:v>
                </c:pt>
                <c:pt idx="661">
                  <c:v>-58867.709491909598</c:v>
                </c:pt>
                <c:pt idx="662">
                  <c:v>-40563.910380949099</c:v>
                </c:pt>
                <c:pt idx="663">
                  <c:v>11596.786605976</c:v>
                </c:pt>
                <c:pt idx="664">
                  <c:v>-39730.125111795001</c:v>
                </c:pt>
                <c:pt idx="665">
                  <c:v>55225.630353850996</c:v>
                </c:pt>
                <c:pt idx="666">
                  <c:v>-31296.2940330778</c:v>
                </c:pt>
                <c:pt idx="667">
                  <c:v>25693.021107647401</c:v>
                </c:pt>
                <c:pt idx="668">
                  <c:v>-28061.002072069699</c:v>
                </c:pt>
                <c:pt idx="669">
                  <c:v>35592.3947658006</c:v>
                </c:pt>
                <c:pt idx="670">
                  <c:v>52925.0966621072</c:v>
                </c:pt>
                <c:pt idx="671">
                  <c:v>12438.238269104901</c:v>
                </c:pt>
                <c:pt idx="672">
                  <c:v>-29010.994818750802</c:v>
                </c:pt>
                <c:pt idx="673">
                  <c:v>-9368.1063194367598</c:v>
                </c:pt>
                <c:pt idx="674">
                  <c:v>32973.875851534001</c:v>
                </c:pt>
                <c:pt idx="675">
                  <c:v>-16594.701637624701</c:v>
                </c:pt>
                <c:pt idx="676">
                  <c:v>-66512.373318987404</c:v>
                </c:pt>
                <c:pt idx="677">
                  <c:v>-29438.715413677401</c:v>
                </c:pt>
                <c:pt idx="678">
                  <c:v>9468.1282487780009</c:v>
                </c:pt>
                <c:pt idx="679">
                  <c:v>-34699.379878355001</c:v>
                </c:pt>
                <c:pt idx="680">
                  <c:v>24587.461263883099</c:v>
                </c:pt>
                <c:pt idx="681">
                  <c:v>34191.201265755699</c:v>
                </c:pt>
                <c:pt idx="682">
                  <c:v>3336.7429298473899</c:v>
                </c:pt>
                <c:pt idx="683">
                  <c:v>85990.609459005005</c:v>
                </c:pt>
                <c:pt idx="684">
                  <c:v>-26738.8635823107</c:v>
                </c:pt>
                <c:pt idx="685">
                  <c:v>-74838.501079235095</c:v>
                </c:pt>
                <c:pt idx="686">
                  <c:v>-5164.7051942865401</c:v>
                </c:pt>
                <c:pt idx="687">
                  <c:v>-72181.592829505302</c:v>
                </c:pt>
                <c:pt idx="688">
                  <c:v>-174040.86536468301</c:v>
                </c:pt>
                <c:pt idx="689">
                  <c:v>-136479.09670538301</c:v>
                </c:pt>
                <c:pt idx="690">
                  <c:v>-111304.673255149</c:v>
                </c:pt>
                <c:pt idx="691">
                  <c:v>-157897.861574493</c:v>
                </c:pt>
                <c:pt idx="692">
                  <c:v>-95860.985952568299</c:v>
                </c:pt>
                <c:pt idx="693">
                  <c:v>-26971.704240339201</c:v>
                </c:pt>
                <c:pt idx="694">
                  <c:v>39795.3037496943</c:v>
                </c:pt>
                <c:pt idx="695">
                  <c:v>44448.8153549606</c:v>
                </c:pt>
                <c:pt idx="696">
                  <c:v>-87722.341720324199</c:v>
                </c:pt>
                <c:pt idx="697">
                  <c:v>-21588.101678990599</c:v>
                </c:pt>
                <c:pt idx="698">
                  <c:v>-27782.350715566299</c:v>
                </c:pt>
                <c:pt idx="699">
                  <c:v>-140791.69171680399</c:v>
                </c:pt>
                <c:pt idx="700">
                  <c:v>-99407.480114744496</c:v>
                </c:pt>
                <c:pt idx="701">
                  <c:v>-25510.139249034299</c:v>
                </c:pt>
                <c:pt idx="702">
                  <c:v>43053.603884993601</c:v>
                </c:pt>
                <c:pt idx="703">
                  <c:v>106074.058345513</c:v>
                </c:pt>
                <c:pt idx="704">
                  <c:v>62964.899591153</c:v>
                </c:pt>
                <c:pt idx="705">
                  <c:v>-2890.3083742584599</c:v>
                </c:pt>
                <c:pt idx="706">
                  <c:v>18684.4109949095</c:v>
                </c:pt>
                <c:pt idx="707">
                  <c:v>15566.8100105629</c:v>
                </c:pt>
                <c:pt idx="708">
                  <c:v>-33888.3337680767</c:v>
                </c:pt>
                <c:pt idx="709">
                  <c:v>68621.392515628293</c:v>
                </c:pt>
                <c:pt idx="710">
                  <c:v>28713.962415665301</c:v>
                </c:pt>
                <c:pt idx="711">
                  <c:v>-46853.9407949706</c:v>
                </c:pt>
                <c:pt idx="712">
                  <c:v>-81565.279690964206</c:v>
                </c:pt>
                <c:pt idx="713">
                  <c:v>41965.683031938199</c:v>
                </c:pt>
                <c:pt idx="714">
                  <c:v>-27397.389395177499</c:v>
                </c:pt>
                <c:pt idx="715">
                  <c:v>-15684.1096349649</c:v>
                </c:pt>
                <c:pt idx="716">
                  <c:v>-4797.6142132093401</c:v>
                </c:pt>
                <c:pt idx="717">
                  <c:v>-48739.283962245798</c:v>
                </c:pt>
                <c:pt idx="718">
                  <c:v>-162118.329651493</c:v>
                </c:pt>
                <c:pt idx="719">
                  <c:v>-80529.8966193573</c:v>
                </c:pt>
                <c:pt idx="720">
                  <c:v>-31762.4483932976</c:v>
                </c:pt>
                <c:pt idx="721">
                  <c:v>-17552.016073098399</c:v>
                </c:pt>
                <c:pt idx="722">
                  <c:v>-23193.9114635023</c:v>
                </c:pt>
                <c:pt idx="723">
                  <c:v>-67600.167814327302</c:v>
                </c:pt>
                <c:pt idx="724">
                  <c:v>-48866.832936824903</c:v>
                </c:pt>
                <c:pt idx="725">
                  <c:v>6219.2750740025504</c:v>
                </c:pt>
                <c:pt idx="726">
                  <c:v>111395.633670778</c:v>
                </c:pt>
                <c:pt idx="727">
                  <c:v>44581.175602321702</c:v>
                </c:pt>
                <c:pt idx="728">
                  <c:v>75981.154356002095</c:v>
                </c:pt>
                <c:pt idx="729">
                  <c:v>-25220.883627451301</c:v>
                </c:pt>
                <c:pt idx="730">
                  <c:v>-69332.796764687795</c:v>
                </c:pt>
                <c:pt idx="731">
                  <c:v>-13056.1646477097</c:v>
                </c:pt>
                <c:pt idx="732">
                  <c:v>-24393.605372436101</c:v>
                </c:pt>
                <c:pt idx="733">
                  <c:v>-79207.202861217098</c:v>
                </c:pt>
                <c:pt idx="734">
                  <c:v>0</c:v>
                </c:pt>
                <c:pt idx="735">
                  <c:v>0</c:v>
                </c:pt>
                <c:pt idx="736">
                  <c:v>-13829.864905624199</c:v>
                </c:pt>
                <c:pt idx="737">
                  <c:v>-929.01701335701</c:v>
                </c:pt>
                <c:pt idx="738">
                  <c:v>21552.838844450602</c:v>
                </c:pt>
                <c:pt idx="739">
                  <c:v>-39239.151681757998</c:v>
                </c:pt>
                <c:pt idx="740">
                  <c:v>-90700.2924587866</c:v>
                </c:pt>
                <c:pt idx="741">
                  <c:v>-18575.311521975302</c:v>
                </c:pt>
                <c:pt idx="742">
                  <c:v>36062.415079921098</c:v>
                </c:pt>
                <c:pt idx="743">
                  <c:v>32054.7415750855</c:v>
                </c:pt>
                <c:pt idx="744">
                  <c:v>-15628.870876321</c:v>
                </c:pt>
                <c:pt idx="745">
                  <c:v>-63107.306607278799</c:v>
                </c:pt>
                <c:pt idx="746">
                  <c:v>25296.590170884301</c:v>
                </c:pt>
                <c:pt idx="747">
                  <c:v>-16250.8757776723</c:v>
                </c:pt>
                <c:pt idx="748">
                  <c:v>-111636.25692029099</c:v>
                </c:pt>
                <c:pt idx="749">
                  <c:v>-18439.226450566199</c:v>
                </c:pt>
                <c:pt idx="750">
                  <c:v>17236.539234666099</c:v>
                </c:pt>
                <c:pt idx="751">
                  <c:v>44871.144593339297</c:v>
                </c:pt>
                <c:pt idx="752">
                  <c:v>30385.251296468799</c:v>
                </c:pt>
                <c:pt idx="753">
                  <c:v>52444.083954363501</c:v>
                </c:pt>
                <c:pt idx="754">
                  <c:v>37300.8605061403</c:v>
                </c:pt>
                <c:pt idx="755">
                  <c:v>4542.6798269686997</c:v>
                </c:pt>
                <c:pt idx="756">
                  <c:v>16370.2377902149</c:v>
                </c:pt>
                <c:pt idx="757">
                  <c:v>-5110.7767981860698</c:v>
                </c:pt>
                <c:pt idx="758">
                  <c:v>-13401.756509494</c:v>
                </c:pt>
                <c:pt idx="759">
                  <c:v>-22661.035214879699</c:v>
                </c:pt>
                <c:pt idx="760">
                  <c:v>36420.562337436597</c:v>
                </c:pt>
                <c:pt idx="761">
                  <c:v>9446.3479101822904</c:v>
                </c:pt>
                <c:pt idx="762">
                  <c:v>88198.923056474698</c:v>
                </c:pt>
                <c:pt idx="763">
                  <c:v>74491.655015138196</c:v>
                </c:pt>
                <c:pt idx="764">
                  <c:v>12775.666094505499</c:v>
                </c:pt>
                <c:pt idx="765">
                  <c:v>63637.213999496103</c:v>
                </c:pt>
                <c:pt idx="766">
                  <c:v>97302.9594449789</c:v>
                </c:pt>
                <c:pt idx="767">
                  <c:v>32522.5001259128</c:v>
                </c:pt>
                <c:pt idx="768">
                  <c:v>59010.639731598698</c:v>
                </c:pt>
                <c:pt idx="769">
                  <c:v>-25301.656497497399</c:v>
                </c:pt>
                <c:pt idx="770">
                  <c:v>-9603.6304359095702</c:v>
                </c:pt>
                <c:pt idx="771">
                  <c:v>-31721.2382029295</c:v>
                </c:pt>
                <c:pt idx="772">
                  <c:v>-64536.232000253498</c:v>
                </c:pt>
                <c:pt idx="773">
                  <c:v>1793.1621427160401</c:v>
                </c:pt>
                <c:pt idx="774">
                  <c:v>-39075.515386432096</c:v>
                </c:pt>
                <c:pt idx="775">
                  <c:v>-24509.969916065402</c:v>
                </c:pt>
                <c:pt idx="776">
                  <c:v>-104918.617388628</c:v>
                </c:pt>
                <c:pt idx="777">
                  <c:v>39890.591213168598</c:v>
                </c:pt>
                <c:pt idx="778">
                  <c:v>35094.704494013298</c:v>
                </c:pt>
                <c:pt idx="779">
                  <c:v>51751.552345152399</c:v>
                </c:pt>
                <c:pt idx="780">
                  <c:v>13050.8699569483</c:v>
                </c:pt>
                <c:pt idx="781">
                  <c:v>-29370.5171051752</c:v>
                </c:pt>
                <c:pt idx="782">
                  <c:v>229.943444443815</c:v>
                </c:pt>
                <c:pt idx="783">
                  <c:v>-47958.150696185803</c:v>
                </c:pt>
                <c:pt idx="784">
                  <c:v>-84501.410900183997</c:v>
                </c:pt>
                <c:pt idx="785">
                  <c:v>0</c:v>
                </c:pt>
                <c:pt idx="786">
                  <c:v>0</c:v>
                </c:pt>
                <c:pt idx="787">
                  <c:v>19309.841235346201</c:v>
                </c:pt>
                <c:pt idx="788">
                  <c:v>-54588.678190041697</c:v>
                </c:pt>
                <c:pt idx="789">
                  <c:v>-72506.658188175803</c:v>
                </c:pt>
                <c:pt idx="790">
                  <c:v>-11308.816550040099</c:v>
                </c:pt>
                <c:pt idx="791">
                  <c:v>-100702.141804189</c:v>
                </c:pt>
                <c:pt idx="792">
                  <c:v>-28679.0634285503</c:v>
                </c:pt>
                <c:pt idx="793">
                  <c:v>70115.068664411505</c:v>
                </c:pt>
                <c:pt idx="794">
                  <c:v>2822.2442047261102</c:v>
                </c:pt>
                <c:pt idx="795">
                  <c:v>31315.728120354201</c:v>
                </c:pt>
                <c:pt idx="796">
                  <c:v>-20621.002995552699</c:v>
                </c:pt>
                <c:pt idx="797">
                  <c:v>-132156.30967325799</c:v>
                </c:pt>
                <c:pt idx="798">
                  <c:v>-96037.2885866219</c:v>
                </c:pt>
                <c:pt idx="799">
                  <c:v>-90431.267276366896</c:v>
                </c:pt>
                <c:pt idx="800">
                  <c:v>-88855.011210978904</c:v>
                </c:pt>
                <c:pt idx="801">
                  <c:v>-98034.132780881395</c:v>
                </c:pt>
                <c:pt idx="802">
                  <c:v>-76460.512667195799</c:v>
                </c:pt>
                <c:pt idx="803">
                  <c:v>-224555.44833312501</c:v>
                </c:pt>
                <c:pt idx="804">
                  <c:v>-114677.217659186</c:v>
                </c:pt>
                <c:pt idx="805">
                  <c:v>-102193.825251738</c:v>
                </c:pt>
                <c:pt idx="806">
                  <c:v>-44713.910957147898</c:v>
                </c:pt>
                <c:pt idx="807">
                  <c:v>-15433.850434371499</c:v>
                </c:pt>
                <c:pt idx="808">
                  <c:v>-84024.081507541297</c:v>
                </c:pt>
                <c:pt idx="809">
                  <c:v>-49523.080492670699</c:v>
                </c:pt>
                <c:pt idx="810">
                  <c:v>-44963.944816814503</c:v>
                </c:pt>
                <c:pt idx="811">
                  <c:v>58596.915025244103</c:v>
                </c:pt>
                <c:pt idx="812">
                  <c:v>24491.658256755501</c:v>
                </c:pt>
                <c:pt idx="813">
                  <c:v>19383.1752317059</c:v>
                </c:pt>
                <c:pt idx="814">
                  <c:v>-40546.014874697401</c:v>
                </c:pt>
                <c:pt idx="815">
                  <c:v>-28058.945266908398</c:v>
                </c:pt>
                <c:pt idx="816">
                  <c:v>-29096.496187310098</c:v>
                </c:pt>
                <c:pt idx="817">
                  <c:v>-7608.9952383149403</c:v>
                </c:pt>
                <c:pt idx="818">
                  <c:v>39127.702336661801</c:v>
                </c:pt>
                <c:pt idx="819">
                  <c:v>-32863.495106930503</c:v>
                </c:pt>
                <c:pt idx="820">
                  <c:v>-29972.400860785201</c:v>
                </c:pt>
                <c:pt idx="821">
                  <c:v>-28646.8887598732</c:v>
                </c:pt>
                <c:pt idx="822">
                  <c:v>-58070.367711325802</c:v>
                </c:pt>
                <c:pt idx="823">
                  <c:v>-91462.702834642507</c:v>
                </c:pt>
                <c:pt idx="824">
                  <c:v>-129928.884198069</c:v>
                </c:pt>
                <c:pt idx="825">
                  <c:v>-67597.981827053794</c:v>
                </c:pt>
                <c:pt idx="826">
                  <c:v>0</c:v>
                </c:pt>
                <c:pt idx="827">
                  <c:v>0</c:v>
                </c:pt>
                <c:pt idx="828">
                  <c:v>55671.245753440198</c:v>
                </c:pt>
                <c:pt idx="829">
                  <c:v>74611.642454027693</c:v>
                </c:pt>
                <c:pt idx="830">
                  <c:v>-6847.6288936766596</c:v>
                </c:pt>
                <c:pt idx="831">
                  <c:v>38381.986276733303</c:v>
                </c:pt>
                <c:pt idx="832">
                  <c:v>43513.830852232699</c:v>
                </c:pt>
                <c:pt idx="833">
                  <c:v>3508.3173654712</c:v>
                </c:pt>
                <c:pt idx="834">
                  <c:v>77231.753904371901</c:v>
                </c:pt>
                <c:pt idx="835">
                  <c:v>93007.511694790097</c:v>
                </c:pt>
                <c:pt idx="836">
                  <c:v>79692.978066725394</c:v>
                </c:pt>
                <c:pt idx="837">
                  <c:v>73345.339327428504</c:v>
                </c:pt>
                <c:pt idx="838">
                  <c:v>39530.505787816997</c:v>
                </c:pt>
                <c:pt idx="839">
                  <c:v>4034.7718697365499</c:v>
                </c:pt>
                <c:pt idx="840">
                  <c:v>37074.178522578499</c:v>
                </c:pt>
                <c:pt idx="841">
                  <c:v>73121.444133357203</c:v>
                </c:pt>
                <c:pt idx="842">
                  <c:v>69039.9205004861</c:v>
                </c:pt>
                <c:pt idx="843">
                  <c:v>97889.448579181801</c:v>
                </c:pt>
                <c:pt idx="844">
                  <c:v>177354.34398896</c:v>
                </c:pt>
                <c:pt idx="845">
                  <c:v>92012.840887972096</c:v>
                </c:pt>
                <c:pt idx="846">
                  <c:v>100447.94393033101</c:v>
                </c:pt>
                <c:pt idx="847">
                  <c:v>183185.60356141601</c:v>
                </c:pt>
                <c:pt idx="848">
                  <c:v>189829.65349766499</c:v>
                </c:pt>
                <c:pt idx="849">
                  <c:v>205937.511548504</c:v>
                </c:pt>
                <c:pt idx="850">
                  <c:v>150837.69824226599</c:v>
                </c:pt>
                <c:pt idx="851">
                  <c:v>106419.927990968</c:v>
                </c:pt>
                <c:pt idx="852">
                  <c:v>101966.764651609</c:v>
                </c:pt>
                <c:pt idx="853">
                  <c:v>131273.98595356499</c:v>
                </c:pt>
                <c:pt idx="854">
                  <c:v>83930.160871551896</c:v>
                </c:pt>
                <c:pt idx="855">
                  <c:v>133997.738511239</c:v>
                </c:pt>
                <c:pt idx="856">
                  <c:v>34752.962795322499</c:v>
                </c:pt>
                <c:pt idx="857">
                  <c:v>-22092.978210840101</c:v>
                </c:pt>
                <c:pt idx="858">
                  <c:v>-64350.945580793101</c:v>
                </c:pt>
                <c:pt idx="859">
                  <c:v>-54586.405968712897</c:v>
                </c:pt>
                <c:pt idx="860">
                  <c:v>72601.929119229899</c:v>
                </c:pt>
                <c:pt idx="861">
                  <c:v>43989.396850810801</c:v>
                </c:pt>
                <c:pt idx="862">
                  <c:v>82879.411526670097</c:v>
                </c:pt>
                <c:pt idx="863">
                  <c:v>40353.597980371604</c:v>
                </c:pt>
                <c:pt idx="864">
                  <c:v>9151.2353555018708</c:v>
                </c:pt>
                <c:pt idx="865">
                  <c:v>20667.397622444201</c:v>
                </c:pt>
                <c:pt idx="866">
                  <c:v>-37185.655821187</c:v>
                </c:pt>
                <c:pt idx="867">
                  <c:v>-71149.348476980304</c:v>
                </c:pt>
                <c:pt idx="868">
                  <c:v>-44877.424413668799</c:v>
                </c:pt>
                <c:pt idx="869">
                  <c:v>-6207.7056137654899</c:v>
                </c:pt>
                <c:pt idx="870">
                  <c:v>-4962.5497433768296</c:v>
                </c:pt>
                <c:pt idx="871">
                  <c:v>-24646.222100630599</c:v>
                </c:pt>
                <c:pt idx="872">
                  <c:v>36977.621156048903</c:v>
                </c:pt>
                <c:pt idx="873">
                  <c:v>77764.561109310598</c:v>
                </c:pt>
                <c:pt idx="874">
                  <c:v>48388.438363706802</c:v>
                </c:pt>
                <c:pt idx="875">
                  <c:v>67130.225147066594</c:v>
                </c:pt>
                <c:pt idx="876">
                  <c:v>18025.013481302802</c:v>
                </c:pt>
                <c:pt idx="877">
                  <c:v>0</c:v>
                </c:pt>
                <c:pt idx="878">
                  <c:v>0</c:v>
                </c:pt>
                <c:pt idx="879">
                  <c:v>15945.0075675151</c:v>
                </c:pt>
                <c:pt idx="880">
                  <c:v>-93407.624763062995</c:v>
                </c:pt>
                <c:pt idx="881">
                  <c:v>36915.440090801298</c:v>
                </c:pt>
                <c:pt idx="882">
                  <c:v>71500.255244122804</c:v>
                </c:pt>
                <c:pt idx="883">
                  <c:v>123841.456002002</c:v>
                </c:pt>
                <c:pt idx="884">
                  <c:v>-9709.7298351575701</c:v>
                </c:pt>
                <c:pt idx="885">
                  <c:v>-105680.430060304</c:v>
                </c:pt>
                <c:pt idx="886">
                  <c:v>2008.46161021022</c:v>
                </c:pt>
                <c:pt idx="887">
                  <c:v>35220.502834671999</c:v>
                </c:pt>
                <c:pt idx="888">
                  <c:v>-17538.742113781202</c:v>
                </c:pt>
                <c:pt idx="889">
                  <c:v>36343.900675145</c:v>
                </c:pt>
                <c:pt idx="890">
                  <c:v>5637.2412302824896</c:v>
                </c:pt>
                <c:pt idx="891">
                  <c:v>39400.081408070298</c:v>
                </c:pt>
                <c:pt idx="892">
                  <c:v>-2824.4123231513099</c:v>
                </c:pt>
                <c:pt idx="893">
                  <c:v>-66151.557202885801</c:v>
                </c:pt>
                <c:pt idx="894">
                  <c:v>-22371.826276378401</c:v>
                </c:pt>
                <c:pt idx="895">
                  <c:v>71468.452684773307</c:v>
                </c:pt>
                <c:pt idx="896">
                  <c:v>-34978.560461001201</c:v>
                </c:pt>
                <c:pt idx="897">
                  <c:v>-39706.565971384698</c:v>
                </c:pt>
                <c:pt idx="898">
                  <c:v>-15562.8214261592</c:v>
                </c:pt>
                <c:pt idx="899">
                  <c:v>61734.095641447799</c:v>
                </c:pt>
                <c:pt idx="900">
                  <c:v>-6991.92827795009</c:v>
                </c:pt>
                <c:pt idx="901">
                  <c:v>-16777.964748632599</c:v>
                </c:pt>
                <c:pt idx="902">
                  <c:v>15482.9129915622</c:v>
                </c:pt>
                <c:pt idx="903">
                  <c:v>-27939.898756749299</c:v>
                </c:pt>
                <c:pt idx="904">
                  <c:v>43656.115331757501</c:v>
                </c:pt>
                <c:pt idx="905">
                  <c:v>15059.054175003401</c:v>
                </c:pt>
                <c:pt idx="906">
                  <c:v>-82297.119983975499</c:v>
                </c:pt>
                <c:pt idx="907">
                  <c:v>-110023.360433326</c:v>
                </c:pt>
                <c:pt idx="908">
                  <c:v>-56822.965057674097</c:v>
                </c:pt>
                <c:pt idx="909">
                  <c:v>48379.475706370999</c:v>
                </c:pt>
                <c:pt idx="910">
                  <c:v>101293.56313515401</c:v>
                </c:pt>
                <c:pt idx="911">
                  <c:v>-60611.601787332002</c:v>
                </c:pt>
                <c:pt idx="912">
                  <c:v>-37720.798658677297</c:v>
                </c:pt>
                <c:pt idx="913">
                  <c:v>76269.422685513506</c:v>
                </c:pt>
                <c:pt idx="914">
                  <c:v>-11680.6226866337</c:v>
                </c:pt>
                <c:pt idx="915">
                  <c:v>14990.614543256699</c:v>
                </c:pt>
                <c:pt idx="916">
                  <c:v>38140.907475460001</c:v>
                </c:pt>
                <c:pt idx="917">
                  <c:v>37134.022915834998</c:v>
                </c:pt>
                <c:pt idx="918">
                  <c:v>90409.062556360906</c:v>
                </c:pt>
                <c:pt idx="919">
                  <c:v>110316.485970059</c:v>
                </c:pt>
                <c:pt idx="920">
                  <c:v>9327.6871322525803</c:v>
                </c:pt>
                <c:pt idx="921">
                  <c:v>5593.4271286898402</c:v>
                </c:pt>
                <c:pt idx="922">
                  <c:v>-14892.351501683501</c:v>
                </c:pt>
                <c:pt idx="923">
                  <c:v>404.465272066213</c:v>
                </c:pt>
                <c:pt idx="924">
                  <c:v>-19053.196389276902</c:v>
                </c:pt>
                <c:pt idx="925">
                  <c:v>6659.5803320170398</c:v>
                </c:pt>
                <c:pt idx="926">
                  <c:v>-5548.0327566799997</c:v>
                </c:pt>
                <c:pt idx="927">
                  <c:v>17548.420367554401</c:v>
                </c:pt>
                <c:pt idx="928">
                  <c:v>-14726.5671558129</c:v>
                </c:pt>
                <c:pt idx="929">
                  <c:v>9025.7282788709708</c:v>
                </c:pt>
                <c:pt idx="930">
                  <c:v>-106107.26758049399</c:v>
                </c:pt>
                <c:pt idx="931">
                  <c:v>-2159.2592661922799</c:v>
                </c:pt>
                <c:pt idx="932">
                  <c:v>17735.789183786499</c:v>
                </c:pt>
                <c:pt idx="933">
                  <c:v>-29863.410360754999</c:v>
                </c:pt>
                <c:pt idx="934">
                  <c:v>-2920.0031472368901</c:v>
                </c:pt>
                <c:pt idx="935">
                  <c:v>-18853.894482721302</c:v>
                </c:pt>
                <c:pt idx="936">
                  <c:v>25654.511921529898</c:v>
                </c:pt>
                <c:pt idx="937">
                  <c:v>27405.421764451901</c:v>
                </c:pt>
                <c:pt idx="938">
                  <c:v>0</c:v>
                </c:pt>
                <c:pt idx="939">
                  <c:v>0</c:v>
                </c:pt>
                <c:pt idx="940">
                  <c:v>-5243.6882095256997</c:v>
                </c:pt>
                <c:pt idx="941">
                  <c:v>-89561.641918760695</c:v>
                </c:pt>
                <c:pt idx="942">
                  <c:v>15994.4346336546</c:v>
                </c:pt>
                <c:pt idx="943">
                  <c:v>18908.0682190355</c:v>
                </c:pt>
                <c:pt idx="944">
                  <c:v>-1712.0778480786801</c:v>
                </c:pt>
                <c:pt idx="945">
                  <c:v>63696.326866670497</c:v>
                </c:pt>
                <c:pt idx="946">
                  <c:v>25512.190219666099</c:v>
                </c:pt>
                <c:pt idx="947">
                  <c:v>40182.670136989102</c:v>
                </c:pt>
                <c:pt idx="948">
                  <c:v>64075.854369791603</c:v>
                </c:pt>
                <c:pt idx="949">
                  <c:v>12852.5365095325</c:v>
                </c:pt>
                <c:pt idx="950">
                  <c:v>-33093.607192622301</c:v>
                </c:pt>
                <c:pt idx="951">
                  <c:v>-40368.225269925199</c:v>
                </c:pt>
                <c:pt idx="952">
                  <c:v>51426.580462102604</c:v>
                </c:pt>
                <c:pt idx="953">
                  <c:v>100922.800192164</c:v>
                </c:pt>
                <c:pt idx="954">
                  <c:v>120237.08087307699</c:v>
                </c:pt>
                <c:pt idx="955">
                  <c:v>74586.528401027201</c:v>
                </c:pt>
                <c:pt idx="956">
                  <c:v>24616.825615618702</c:v>
                </c:pt>
                <c:pt idx="957">
                  <c:v>18330.130740499699</c:v>
                </c:pt>
                <c:pt idx="958">
                  <c:v>-73977.059031751705</c:v>
                </c:pt>
                <c:pt idx="959">
                  <c:v>39816.9909052765</c:v>
                </c:pt>
                <c:pt idx="960">
                  <c:v>75985.967578890704</c:v>
                </c:pt>
                <c:pt idx="961">
                  <c:v>80527.564158392706</c:v>
                </c:pt>
                <c:pt idx="962">
                  <c:v>39415.655986355399</c:v>
                </c:pt>
                <c:pt idx="963">
                  <c:v>35590.104307283502</c:v>
                </c:pt>
                <c:pt idx="964">
                  <c:v>112847.47790275799</c:v>
                </c:pt>
                <c:pt idx="965">
                  <c:v>-82088.310144484203</c:v>
                </c:pt>
                <c:pt idx="966">
                  <c:v>54410.799848906303</c:v>
                </c:pt>
                <c:pt idx="967">
                  <c:v>168777.54726067799</c:v>
                </c:pt>
                <c:pt idx="968">
                  <c:v>71160.418609819098</c:v>
                </c:pt>
                <c:pt idx="969">
                  <c:v>63859.987364489403</c:v>
                </c:pt>
                <c:pt idx="970">
                  <c:v>60704.257211671902</c:v>
                </c:pt>
                <c:pt idx="971">
                  <c:v>-35275.785642518902</c:v>
                </c:pt>
                <c:pt idx="972">
                  <c:v>-3486.3392960575702</c:v>
                </c:pt>
                <c:pt idx="973">
                  <c:v>44252.886508256997</c:v>
                </c:pt>
                <c:pt idx="974">
                  <c:v>77124.316281986205</c:v>
                </c:pt>
                <c:pt idx="975">
                  <c:v>178300.82454304301</c:v>
                </c:pt>
                <c:pt idx="976">
                  <c:v>38221.681469110801</c:v>
                </c:pt>
                <c:pt idx="977">
                  <c:v>-15454.612305848001</c:v>
                </c:pt>
                <c:pt idx="978">
                  <c:v>-42405.964479446797</c:v>
                </c:pt>
                <c:pt idx="979">
                  <c:v>8310.5528618146</c:v>
                </c:pt>
                <c:pt idx="980">
                  <c:v>105205.25231623799</c:v>
                </c:pt>
                <c:pt idx="981">
                  <c:v>60574.720081544401</c:v>
                </c:pt>
                <c:pt idx="982">
                  <c:v>87488.353515213807</c:v>
                </c:pt>
                <c:pt idx="983">
                  <c:v>32684.6101379639</c:v>
                </c:pt>
                <c:pt idx="984">
                  <c:v>53855.479913259202</c:v>
                </c:pt>
                <c:pt idx="985">
                  <c:v>46555.586329785197</c:v>
                </c:pt>
                <c:pt idx="986">
                  <c:v>39456.376611039603</c:v>
                </c:pt>
                <c:pt idx="987">
                  <c:v>1135.8678352956099</c:v>
                </c:pt>
                <c:pt idx="988">
                  <c:v>-35457.870888935999</c:v>
                </c:pt>
                <c:pt idx="989">
                  <c:v>76672.199343851404</c:v>
                </c:pt>
                <c:pt idx="990">
                  <c:v>-9980.8196479487597</c:v>
                </c:pt>
                <c:pt idx="991">
                  <c:v>-1107.2053240180301</c:v>
                </c:pt>
                <c:pt idx="992">
                  <c:v>64070.293649028703</c:v>
                </c:pt>
                <c:pt idx="993">
                  <c:v>-15620.116045806501</c:v>
                </c:pt>
                <c:pt idx="994">
                  <c:v>-3871.8246005853098</c:v>
                </c:pt>
                <c:pt idx="995">
                  <c:v>113383.19548233799</c:v>
                </c:pt>
                <c:pt idx="996">
                  <c:v>25465.365364264198</c:v>
                </c:pt>
                <c:pt idx="997">
                  <c:v>56296.643408906602</c:v>
                </c:pt>
                <c:pt idx="998">
                  <c:v>40620.500885037203</c:v>
                </c:pt>
                <c:pt idx="999">
                  <c:v>12938.1025720658</c:v>
                </c:pt>
                <c:pt idx="1000">
                  <c:v>5631.3670055276898</c:v>
                </c:pt>
                <c:pt idx="1001">
                  <c:v>-1089.6714840395</c:v>
                </c:pt>
                <c:pt idx="1002">
                  <c:v>-5131.1483740031999</c:v>
                </c:pt>
                <c:pt idx="1003">
                  <c:v>57053.392555090999</c:v>
                </c:pt>
                <c:pt idx="1004">
                  <c:v>-75576.772898101801</c:v>
                </c:pt>
                <c:pt idx="1005">
                  <c:v>35975.625229091303</c:v>
                </c:pt>
                <c:pt idx="1006">
                  <c:v>113110.69445892599</c:v>
                </c:pt>
                <c:pt idx="1007">
                  <c:v>143000.00554573099</c:v>
                </c:pt>
                <c:pt idx="1008">
                  <c:v>20864.9068805233</c:v>
                </c:pt>
                <c:pt idx="1009">
                  <c:v>0</c:v>
                </c:pt>
                <c:pt idx="1010">
                  <c:v>0</c:v>
                </c:pt>
                <c:pt idx="1011">
                  <c:v>21756.8903779389</c:v>
                </c:pt>
                <c:pt idx="1012">
                  <c:v>-88826.824183533594</c:v>
                </c:pt>
                <c:pt idx="1013">
                  <c:v>-71906.409011690601</c:v>
                </c:pt>
                <c:pt idx="1014">
                  <c:v>-45824.826469510597</c:v>
                </c:pt>
                <c:pt idx="1015">
                  <c:v>-33364.891697624</c:v>
                </c:pt>
                <c:pt idx="1016">
                  <c:v>-40390.052263712103</c:v>
                </c:pt>
                <c:pt idx="1017">
                  <c:v>25391.2468330542</c:v>
                </c:pt>
                <c:pt idx="1018">
                  <c:v>-76836.4381415713</c:v>
                </c:pt>
                <c:pt idx="1019">
                  <c:v>-123133.48936428801</c:v>
                </c:pt>
                <c:pt idx="1020">
                  <c:v>-53785.409323545799</c:v>
                </c:pt>
                <c:pt idx="1021">
                  <c:v>-46192.266249377899</c:v>
                </c:pt>
                <c:pt idx="1022">
                  <c:v>-38195.531570524901</c:v>
                </c:pt>
                <c:pt idx="1023">
                  <c:v>16891.720217464201</c:v>
                </c:pt>
                <c:pt idx="1024">
                  <c:v>20358.969956014102</c:v>
                </c:pt>
                <c:pt idx="1025">
                  <c:v>-76531.964248795994</c:v>
                </c:pt>
                <c:pt idx="1026">
                  <c:v>-185571.05060097799</c:v>
                </c:pt>
                <c:pt idx="1027">
                  <c:v>-83532.214806599193</c:v>
                </c:pt>
                <c:pt idx="1028">
                  <c:v>-56854.3684502455</c:v>
                </c:pt>
                <c:pt idx="1029">
                  <c:v>30536.6998836167</c:v>
                </c:pt>
                <c:pt idx="1030">
                  <c:v>-66543.660400188499</c:v>
                </c:pt>
                <c:pt idx="1031">
                  <c:v>-6271.0249524928904</c:v>
                </c:pt>
                <c:pt idx="1032">
                  <c:v>57796.2459092028</c:v>
                </c:pt>
                <c:pt idx="1033">
                  <c:v>-12607.584455313499</c:v>
                </c:pt>
                <c:pt idx="1034">
                  <c:v>-133270.266650415</c:v>
                </c:pt>
                <c:pt idx="1035">
                  <c:v>-99027.240462184796</c:v>
                </c:pt>
                <c:pt idx="1036">
                  <c:v>-108736.81060732801</c:v>
                </c:pt>
                <c:pt idx="1037">
                  <c:v>22311.2068602129</c:v>
                </c:pt>
                <c:pt idx="1038">
                  <c:v>-27456.010663882102</c:v>
                </c:pt>
                <c:pt idx="1039">
                  <c:v>-79898.0325919553</c:v>
                </c:pt>
                <c:pt idx="1040">
                  <c:v>-25817.492485052298</c:v>
                </c:pt>
                <c:pt idx="1041">
                  <c:v>-47622.765836121704</c:v>
                </c:pt>
                <c:pt idx="1042">
                  <c:v>-126065.471097822</c:v>
                </c:pt>
                <c:pt idx="1043">
                  <c:v>-210093.605982123</c:v>
                </c:pt>
                <c:pt idx="1044">
                  <c:v>-87596.504942655098</c:v>
                </c:pt>
                <c:pt idx="1045">
                  <c:v>-1844.6741716110801</c:v>
                </c:pt>
                <c:pt idx="1046">
                  <c:v>-26213.845858358502</c:v>
                </c:pt>
                <c:pt idx="1047">
                  <c:v>-84997.866479221295</c:v>
                </c:pt>
                <c:pt idx="1048">
                  <c:v>-66667.898484406993</c:v>
                </c:pt>
                <c:pt idx="1049">
                  <c:v>4477.2421128384203</c:v>
                </c:pt>
                <c:pt idx="1050">
                  <c:v>-109910.63883841199</c:v>
                </c:pt>
                <c:pt idx="1051">
                  <c:v>566.53110734012398</c:v>
                </c:pt>
                <c:pt idx="1052">
                  <c:v>7412.04707137693</c:v>
                </c:pt>
                <c:pt idx="1053">
                  <c:v>1110.37102924278</c:v>
                </c:pt>
                <c:pt idx="1054">
                  <c:v>26468.159952599501</c:v>
                </c:pt>
                <c:pt idx="1055">
                  <c:v>-4380.5148319187902</c:v>
                </c:pt>
                <c:pt idx="1056">
                  <c:v>-13759.293060801299</c:v>
                </c:pt>
                <c:pt idx="1057">
                  <c:v>4682.0756603937998</c:v>
                </c:pt>
                <c:pt idx="1058">
                  <c:v>-14521.9375049136</c:v>
                </c:pt>
                <c:pt idx="1059">
                  <c:v>-28317.1423963737</c:v>
                </c:pt>
                <c:pt idx="1060">
                  <c:v>66237.938390767406</c:v>
                </c:pt>
                <c:pt idx="1061">
                  <c:v>42667.096601701604</c:v>
                </c:pt>
                <c:pt idx="1062">
                  <c:v>78748.923809244996</c:v>
                </c:pt>
                <c:pt idx="1063">
                  <c:v>-64947.752696877396</c:v>
                </c:pt>
                <c:pt idx="1064">
                  <c:v>1554.47094361874</c:v>
                </c:pt>
                <c:pt idx="1065">
                  <c:v>-64161.3738787287</c:v>
                </c:pt>
                <c:pt idx="1066">
                  <c:v>-11787.8109356083</c:v>
                </c:pt>
                <c:pt idx="1067">
                  <c:v>-375.107899220788</c:v>
                </c:pt>
                <c:pt idx="1068">
                  <c:v>-38276.431184162</c:v>
                </c:pt>
                <c:pt idx="1069">
                  <c:v>-87770.730741134394</c:v>
                </c:pt>
                <c:pt idx="1070">
                  <c:v>0</c:v>
                </c:pt>
                <c:pt idx="1071">
                  <c:v>0</c:v>
                </c:pt>
                <c:pt idx="1072">
                  <c:v>-78130.699874660699</c:v>
                </c:pt>
                <c:pt idx="1073">
                  <c:v>-75123.830360925</c:v>
                </c:pt>
                <c:pt idx="1074">
                  <c:v>-90924.435077798698</c:v>
                </c:pt>
                <c:pt idx="1075">
                  <c:v>-131313.93420645199</c:v>
                </c:pt>
                <c:pt idx="1076">
                  <c:v>-49501.501405964598</c:v>
                </c:pt>
                <c:pt idx="1077">
                  <c:v>-6060.6852277015396</c:v>
                </c:pt>
                <c:pt idx="1078">
                  <c:v>12497.7281324205</c:v>
                </c:pt>
                <c:pt idx="1079">
                  <c:v>28727.6928890208</c:v>
                </c:pt>
                <c:pt idx="1080">
                  <c:v>12398.8700776429</c:v>
                </c:pt>
                <c:pt idx="1081">
                  <c:v>10971.224720812101</c:v>
                </c:pt>
                <c:pt idx="1082">
                  <c:v>-49704.450941156203</c:v>
                </c:pt>
                <c:pt idx="1083">
                  <c:v>-65642.887949865704</c:v>
                </c:pt>
                <c:pt idx="1084">
                  <c:v>-60496.802893341301</c:v>
                </c:pt>
                <c:pt idx="1085">
                  <c:v>-28432.83010793</c:v>
                </c:pt>
                <c:pt idx="1086">
                  <c:v>4258.4608606235897</c:v>
                </c:pt>
                <c:pt idx="1087">
                  <c:v>-73422.507798224004</c:v>
                </c:pt>
                <c:pt idx="1088">
                  <c:v>-56629.612144224498</c:v>
                </c:pt>
                <c:pt idx="1089">
                  <c:v>42471.147963431198</c:v>
                </c:pt>
                <c:pt idx="1090">
                  <c:v>-45715.102263331202</c:v>
                </c:pt>
                <c:pt idx="1091">
                  <c:v>-40332.646024476198</c:v>
                </c:pt>
                <c:pt idx="1092">
                  <c:v>-39911.749464464097</c:v>
                </c:pt>
                <c:pt idx="1093">
                  <c:v>18743.77785862</c:v>
                </c:pt>
                <c:pt idx="1094">
                  <c:v>12592.689304810399</c:v>
                </c:pt>
                <c:pt idx="1095">
                  <c:v>-4522.0373670334702</c:v>
                </c:pt>
                <c:pt idx="1096">
                  <c:v>-49045.457278451897</c:v>
                </c:pt>
                <c:pt idx="1097">
                  <c:v>-107731.900926678</c:v>
                </c:pt>
                <c:pt idx="1098">
                  <c:v>-81668.972504708494</c:v>
                </c:pt>
                <c:pt idx="1099">
                  <c:v>-63442.216125910301</c:v>
                </c:pt>
                <c:pt idx="1100">
                  <c:v>-62152.845955866898</c:v>
                </c:pt>
                <c:pt idx="1101">
                  <c:v>-77384.977599656093</c:v>
                </c:pt>
                <c:pt idx="1102">
                  <c:v>-89683.556309488195</c:v>
                </c:pt>
                <c:pt idx="1103">
                  <c:v>19719.8268683067</c:v>
                </c:pt>
                <c:pt idx="1104">
                  <c:v>111367.871998199</c:v>
                </c:pt>
                <c:pt idx="1105">
                  <c:v>-12449.1615434958</c:v>
                </c:pt>
                <c:pt idx="1106">
                  <c:v>-58973.087584118402</c:v>
                </c:pt>
                <c:pt idx="1107">
                  <c:v>34894.089748619903</c:v>
                </c:pt>
                <c:pt idx="1108">
                  <c:v>-26636.013043551498</c:v>
                </c:pt>
                <c:pt idx="1109">
                  <c:v>-62410.661874996302</c:v>
                </c:pt>
                <c:pt idx="1110">
                  <c:v>14687.469753360399</c:v>
                </c:pt>
                <c:pt idx="1111">
                  <c:v>-37119.329911292203</c:v>
                </c:pt>
                <c:pt idx="1112">
                  <c:v>6235.7790509472297</c:v>
                </c:pt>
                <c:pt idx="1113">
                  <c:v>154872.247393506</c:v>
                </c:pt>
                <c:pt idx="1114">
                  <c:v>48401.240689848601</c:v>
                </c:pt>
                <c:pt idx="1115">
                  <c:v>18770.250117025</c:v>
                </c:pt>
                <c:pt idx="1116">
                  <c:v>-96940.3737196367</c:v>
                </c:pt>
                <c:pt idx="1117">
                  <c:v>-114208.35253063899</c:v>
                </c:pt>
                <c:pt idx="1118">
                  <c:v>-71542.429513150506</c:v>
                </c:pt>
                <c:pt idx="1119">
                  <c:v>-195272.70992425899</c:v>
                </c:pt>
                <c:pt idx="1120">
                  <c:v>-136994.55995840501</c:v>
                </c:pt>
                <c:pt idx="1121">
                  <c:v>-90334.133994219097</c:v>
                </c:pt>
                <c:pt idx="1122">
                  <c:v>-128921.176101121</c:v>
                </c:pt>
                <c:pt idx="1123">
                  <c:v>-93578.310394925196</c:v>
                </c:pt>
                <c:pt idx="1124">
                  <c:v>-189946.39515943901</c:v>
                </c:pt>
                <c:pt idx="1125">
                  <c:v>-123681.03921570801</c:v>
                </c:pt>
                <c:pt idx="1126">
                  <c:v>-17336.548316683798</c:v>
                </c:pt>
                <c:pt idx="1127">
                  <c:v>-13934.401967600799</c:v>
                </c:pt>
                <c:pt idx="1128">
                  <c:v>-64311.382597921001</c:v>
                </c:pt>
                <c:pt idx="1129">
                  <c:v>9846.4694378546992</c:v>
                </c:pt>
                <c:pt idx="1130">
                  <c:v>-22638.5742684914</c:v>
                </c:pt>
                <c:pt idx="1131">
                  <c:v>-30941.582283767799</c:v>
                </c:pt>
                <c:pt idx="1132">
                  <c:v>-51883.4139679605</c:v>
                </c:pt>
                <c:pt idx="1133">
                  <c:v>-84942.183000733494</c:v>
                </c:pt>
                <c:pt idx="1134">
                  <c:v>1736.2188021483901</c:v>
                </c:pt>
                <c:pt idx="1135">
                  <c:v>-25935.2659796732</c:v>
                </c:pt>
                <c:pt idx="1136">
                  <c:v>5377.4197298868003</c:v>
                </c:pt>
                <c:pt idx="1137">
                  <c:v>-44152.307458589297</c:v>
                </c:pt>
                <c:pt idx="1138">
                  <c:v>-28050.605901414499</c:v>
                </c:pt>
                <c:pt idx="1139">
                  <c:v>76452.458093340902</c:v>
                </c:pt>
                <c:pt idx="1140">
                  <c:v>67853.037000680997</c:v>
                </c:pt>
                <c:pt idx="1141">
                  <c:v>-13614.0914803674</c:v>
                </c:pt>
                <c:pt idx="1142">
                  <c:v>-10663.3812207439</c:v>
                </c:pt>
                <c:pt idx="1143">
                  <c:v>1487.62349362089</c:v>
                </c:pt>
                <c:pt idx="1144">
                  <c:v>-9320.0665706490599</c:v>
                </c:pt>
                <c:pt idx="1145">
                  <c:v>6070.7398505998599</c:v>
                </c:pt>
                <c:pt idx="1146">
                  <c:v>46981.514915068197</c:v>
                </c:pt>
                <c:pt idx="1147">
                  <c:v>126330.90229769101</c:v>
                </c:pt>
                <c:pt idx="1148">
                  <c:v>-22273.777540999501</c:v>
                </c:pt>
                <c:pt idx="1149">
                  <c:v>-51409.999096131804</c:v>
                </c:pt>
                <c:pt idx="1150">
                  <c:v>-67063.328781359596</c:v>
                </c:pt>
                <c:pt idx="1151">
                  <c:v>-74259.000353739495</c:v>
                </c:pt>
                <c:pt idx="1152">
                  <c:v>30956.058026973798</c:v>
                </c:pt>
                <c:pt idx="1153">
                  <c:v>41445.321742748703</c:v>
                </c:pt>
                <c:pt idx="1154">
                  <c:v>-31933.579358034</c:v>
                </c:pt>
                <c:pt idx="1155">
                  <c:v>-28789.232642385199</c:v>
                </c:pt>
                <c:pt idx="1156">
                  <c:v>10797.8721276694</c:v>
                </c:pt>
                <c:pt idx="1157">
                  <c:v>-59220.050025626202</c:v>
                </c:pt>
                <c:pt idx="1158">
                  <c:v>-104834.370314596</c:v>
                </c:pt>
                <c:pt idx="1159">
                  <c:v>-89181.088988733303</c:v>
                </c:pt>
                <c:pt idx="1160">
                  <c:v>19881.478098950702</c:v>
                </c:pt>
                <c:pt idx="1161">
                  <c:v>96722.686677494305</c:v>
                </c:pt>
                <c:pt idx="1162">
                  <c:v>52589.368803715297</c:v>
                </c:pt>
                <c:pt idx="1163">
                  <c:v>-26572.498225919899</c:v>
                </c:pt>
                <c:pt idx="1164">
                  <c:v>-27698.254963052801</c:v>
                </c:pt>
                <c:pt idx="1165">
                  <c:v>-7393.5839379844101</c:v>
                </c:pt>
                <c:pt idx="1166">
                  <c:v>-49371.868383798203</c:v>
                </c:pt>
                <c:pt idx="1167">
                  <c:v>27230.702907737999</c:v>
                </c:pt>
                <c:pt idx="1168">
                  <c:v>-35269.554774168399</c:v>
                </c:pt>
                <c:pt idx="1169">
                  <c:v>-34798.236094377004</c:v>
                </c:pt>
                <c:pt idx="1170">
                  <c:v>16707.988778322</c:v>
                </c:pt>
                <c:pt idx="1171">
                  <c:v>0</c:v>
                </c:pt>
                <c:pt idx="1172">
                  <c:v>0</c:v>
                </c:pt>
                <c:pt idx="1173">
                  <c:v>21523.655430496099</c:v>
                </c:pt>
                <c:pt idx="1174">
                  <c:v>27417.200407454999</c:v>
                </c:pt>
                <c:pt idx="1175">
                  <c:v>23499.9003506179</c:v>
                </c:pt>
                <c:pt idx="1176">
                  <c:v>-49565.123752879299</c:v>
                </c:pt>
                <c:pt idx="1177">
                  <c:v>-122816.361705875</c:v>
                </c:pt>
                <c:pt idx="1178">
                  <c:v>-93006.920734040206</c:v>
                </c:pt>
                <c:pt idx="1179">
                  <c:v>-60473.861862593403</c:v>
                </c:pt>
                <c:pt idx="1180">
                  <c:v>-24288.837459965202</c:v>
                </c:pt>
                <c:pt idx="1181">
                  <c:v>5123.0047662827601</c:v>
                </c:pt>
                <c:pt idx="1182">
                  <c:v>-4404.7813751491503</c:v>
                </c:pt>
                <c:pt idx="1183">
                  <c:v>-91092.4311033048</c:v>
                </c:pt>
                <c:pt idx="1184">
                  <c:v>-146932.19921967099</c:v>
                </c:pt>
                <c:pt idx="1185">
                  <c:v>-88972.541928348699</c:v>
                </c:pt>
                <c:pt idx="1186">
                  <c:v>-151369.56116027699</c:v>
                </c:pt>
                <c:pt idx="1187">
                  <c:v>-51751.6922684495</c:v>
                </c:pt>
                <c:pt idx="1188">
                  <c:v>-90856.528688801598</c:v>
                </c:pt>
                <c:pt idx="1189">
                  <c:v>-69084.931521988401</c:v>
                </c:pt>
                <c:pt idx="1190">
                  <c:v>-3213.46267702871</c:v>
                </c:pt>
                <c:pt idx="1191">
                  <c:v>14574.331001521699</c:v>
                </c:pt>
                <c:pt idx="1192">
                  <c:v>-26795.423466169199</c:v>
                </c:pt>
                <c:pt idx="1193">
                  <c:v>26698.025798922001</c:v>
                </c:pt>
                <c:pt idx="1194">
                  <c:v>35816.5974037122</c:v>
                </c:pt>
                <c:pt idx="1195">
                  <c:v>-18438.399363419299</c:v>
                </c:pt>
                <c:pt idx="1196">
                  <c:v>400.07776331307798</c:v>
                </c:pt>
                <c:pt idx="1197">
                  <c:v>-66393.550618190406</c:v>
                </c:pt>
                <c:pt idx="1198">
                  <c:v>29479.623210367899</c:v>
                </c:pt>
                <c:pt idx="1199">
                  <c:v>82666.221985956799</c:v>
                </c:pt>
                <c:pt idx="1200">
                  <c:v>50415.9950729099</c:v>
                </c:pt>
                <c:pt idx="1201">
                  <c:v>-21042.727310115999</c:v>
                </c:pt>
                <c:pt idx="1202">
                  <c:v>-9708.5909022134892</c:v>
                </c:pt>
                <c:pt idx="1203">
                  <c:v>-5143.35561001919</c:v>
                </c:pt>
                <c:pt idx="1204">
                  <c:v>-69509.261427984296</c:v>
                </c:pt>
                <c:pt idx="1205">
                  <c:v>-157824.90774033801</c:v>
                </c:pt>
                <c:pt idx="1206">
                  <c:v>-84535.042633213394</c:v>
                </c:pt>
                <c:pt idx="1207">
                  <c:v>-124902.959337393</c:v>
                </c:pt>
                <c:pt idx="1208">
                  <c:v>-69749.674534463906</c:v>
                </c:pt>
                <c:pt idx="1209">
                  <c:v>-63484.171070324199</c:v>
                </c:pt>
                <c:pt idx="1210">
                  <c:v>-44556.578661744898</c:v>
                </c:pt>
                <c:pt idx="1211">
                  <c:v>-71264.160688637101</c:v>
                </c:pt>
                <c:pt idx="1212">
                  <c:v>-47531.409716483802</c:v>
                </c:pt>
                <c:pt idx="1213">
                  <c:v>9051.6195666714302</c:v>
                </c:pt>
                <c:pt idx="1214">
                  <c:v>20899.848127481699</c:v>
                </c:pt>
                <c:pt idx="1215">
                  <c:v>-70962.664771845506</c:v>
                </c:pt>
                <c:pt idx="1216">
                  <c:v>-18821.059339187199</c:v>
                </c:pt>
                <c:pt idx="1217">
                  <c:v>-133282.420358281</c:v>
                </c:pt>
                <c:pt idx="1218">
                  <c:v>-55257.160042501499</c:v>
                </c:pt>
                <c:pt idx="1219">
                  <c:v>-34525.289398805398</c:v>
                </c:pt>
                <c:pt idx="1220">
                  <c:v>-97976.539516752295</c:v>
                </c:pt>
                <c:pt idx="1221">
                  <c:v>5880.3288248942599</c:v>
                </c:pt>
                <c:pt idx="1222">
                  <c:v>-18806.4638720697</c:v>
                </c:pt>
                <c:pt idx="1223">
                  <c:v>-42951.728059661102</c:v>
                </c:pt>
                <c:pt idx="1224">
                  <c:v>46615.328909693701</c:v>
                </c:pt>
                <c:pt idx="1225">
                  <c:v>-5266.1876961508096</c:v>
                </c:pt>
                <c:pt idx="1226">
                  <c:v>29154.328420022201</c:v>
                </c:pt>
                <c:pt idx="1227">
                  <c:v>-33335.449206911799</c:v>
                </c:pt>
                <c:pt idx="1228">
                  <c:v>-2727.57909491699</c:v>
                </c:pt>
                <c:pt idx="1229">
                  <c:v>-23680.907553202898</c:v>
                </c:pt>
                <c:pt idx="1230">
                  <c:v>-11078.720534458</c:v>
                </c:pt>
                <c:pt idx="1231">
                  <c:v>12776.268555329199</c:v>
                </c:pt>
                <c:pt idx="1232">
                  <c:v>47340.803983967402</c:v>
                </c:pt>
                <c:pt idx="1233">
                  <c:v>15497.2875106347</c:v>
                </c:pt>
                <c:pt idx="1234">
                  <c:v>-36074.994762573602</c:v>
                </c:pt>
                <c:pt idx="1235">
                  <c:v>-35159.050950070799</c:v>
                </c:pt>
                <c:pt idx="1236">
                  <c:v>-2738.24102204171</c:v>
                </c:pt>
                <c:pt idx="1237">
                  <c:v>29503.5075274232</c:v>
                </c:pt>
                <c:pt idx="1238">
                  <c:v>38075.244613917603</c:v>
                </c:pt>
                <c:pt idx="1239">
                  <c:v>-35526.163950595699</c:v>
                </c:pt>
                <c:pt idx="1240">
                  <c:v>-32832.3422166788</c:v>
                </c:pt>
                <c:pt idx="1241">
                  <c:v>-35442.851809290303</c:v>
                </c:pt>
                <c:pt idx="1242">
                  <c:v>34032.859980784502</c:v>
                </c:pt>
                <c:pt idx="1243">
                  <c:v>-78694.651530553398</c:v>
                </c:pt>
                <c:pt idx="1244">
                  <c:v>-66635.117506218594</c:v>
                </c:pt>
                <c:pt idx="1245">
                  <c:v>-1640.8059965518901</c:v>
                </c:pt>
                <c:pt idx="1246">
                  <c:v>38513.167084686102</c:v>
                </c:pt>
                <c:pt idx="1247">
                  <c:v>16651.7511041453</c:v>
                </c:pt>
                <c:pt idx="1248">
                  <c:v>-121792.187366083</c:v>
                </c:pt>
                <c:pt idx="1249">
                  <c:v>-124242.858372028</c:v>
                </c:pt>
                <c:pt idx="1250">
                  <c:v>-37131.852212430596</c:v>
                </c:pt>
                <c:pt idx="1251">
                  <c:v>13938.825553062101</c:v>
                </c:pt>
                <c:pt idx="1252">
                  <c:v>40319.869209049597</c:v>
                </c:pt>
                <c:pt idx="1253">
                  <c:v>735.23813234666795</c:v>
                </c:pt>
                <c:pt idx="1254">
                  <c:v>-118529.561975609</c:v>
                </c:pt>
                <c:pt idx="1255">
                  <c:v>-153774.68128740101</c:v>
                </c:pt>
                <c:pt idx="1256">
                  <c:v>-60023.471790734897</c:v>
                </c:pt>
                <c:pt idx="1257">
                  <c:v>-79675.181799320606</c:v>
                </c:pt>
                <c:pt idx="1258">
                  <c:v>-8967.2119819191394</c:v>
                </c:pt>
                <c:pt idx="1259">
                  <c:v>26560.548637460201</c:v>
                </c:pt>
                <c:pt idx="1260">
                  <c:v>-12219.9563969055</c:v>
                </c:pt>
                <c:pt idx="1261">
                  <c:v>-63994.941757446002</c:v>
                </c:pt>
                <c:pt idx="1262">
                  <c:v>0</c:v>
                </c:pt>
                <c:pt idx="1263">
                  <c:v>0</c:v>
                </c:pt>
                <c:pt idx="1264">
                  <c:v>-32066.6227948339</c:v>
                </c:pt>
                <c:pt idx="1265">
                  <c:v>-24509.398386715198</c:v>
                </c:pt>
                <c:pt idx="1266">
                  <c:v>-19012.551339116199</c:v>
                </c:pt>
                <c:pt idx="1267">
                  <c:v>14938.9851635368</c:v>
                </c:pt>
                <c:pt idx="1268">
                  <c:v>13151.968864719</c:v>
                </c:pt>
                <c:pt idx="1269">
                  <c:v>-40163.961216131298</c:v>
                </c:pt>
                <c:pt idx="1270">
                  <c:v>33080.938054897</c:v>
                </c:pt>
                <c:pt idx="1271">
                  <c:v>28313.4900895713</c:v>
                </c:pt>
                <c:pt idx="1272">
                  <c:v>60778.340787471097</c:v>
                </c:pt>
                <c:pt idx="1273">
                  <c:v>-33034.264885219302</c:v>
                </c:pt>
                <c:pt idx="1274">
                  <c:v>50285.889176997996</c:v>
                </c:pt>
                <c:pt idx="1275">
                  <c:v>46377.887948135998</c:v>
                </c:pt>
                <c:pt idx="1276">
                  <c:v>28544.031277848801</c:v>
                </c:pt>
                <c:pt idx="1277">
                  <c:v>50282.362869255201</c:v>
                </c:pt>
                <c:pt idx="1278">
                  <c:v>29527.453082846601</c:v>
                </c:pt>
                <c:pt idx="1279">
                  <c:v>1242.23530347312</c:v>
                </c:pt>
                <c:pt idx="1280">
                  <c:v>-31060.927113577702</c:v>
                </c:pt>
                <c:pt idx="1281">
                  <c:v>66706.377609959105</c:v>
                </c:pt>
                <c:pt idx="1282">
                  <c:v>137338.99359591701</c:v>
                </c:pt>
                <c:pt idx="1283">
                  <c:v>44272.542117806501</c:v>
                </c:pt>
                <c:pt idx="1284">
                  <c:v>31222.808245933102</c:v>
                </c:pt>
                <c:pt idx="1285">
                  <c:v>76839.803029119605</c:v>
                </c:pt>
                <c:pt idx="1286">
                  <c:v>39800.390205669501</c:v>
                </c:pt>
                <c:pt idx="1287">
                  <c:v>-67619.096244338594</c:v>
                </c:pt>
                <c:pt idx="1288">
                  <c:v>11657.3656922593</c:v>
                </c:pt>
                <c:pt idx="1289">
                  <c:v>8601.5601649677301</c:v>
                </c:pt>
                <c:pt idx="1290">
                  <c:v>-209872.05719892299</c:v>
                </c:pt>
                <c:pt idx="1291">
                  <c:v>-203465.45003421701</c:v>
                </c:pt>
                <c:pt idx="1292">
                  <c:v>-40897.142608905</c:v>
                </c:pt>
                <c:pt idx="1293">
                  <c:v>-71072.874314828703</c:v>
                </c:pt>
                <c:pt idx="1294">
                  <c:v>-151305.199474792</c:v>
                </c:pt>
                <c:pt idx="1295">
                  <c:v>-26879.3068191977</c:v>
                </c:pt>
                <c:pt idx="1296">
                  <c:v>-82178.828534101107</c:v>
                </c:pt>
                <c:pt idx="1297">
                  <c:v>-162986.731046587</c:v>
                </c:pt>
                <c:pt idx="1298">
                  <c:v>-188421.05674278701</c:v>
                </c:pt>
                <c:pt idx="1299">
                  <c:v>-105505.44116353799</c:v>
                </c:pt>
                <c:pt idx="1300">
                  <c:v>-81977.739651737298</c:v>
                </c:pt>
                <c:pt idx="1301">
                  <c:v>53490.978230701097</c:v>
                </c:pt>
                <c:pt idx="1302">
                  <c:v>31693.645608325402</c:v>
                </c:pt>
                <c:pt idx="1303">
                  <c:v>28585.014578231901</c:v>
                </c:pt>
                <c:pt idx="1304">
                  <c:v>-99525.251356245004</c:v>
                </c:pt>
                <c:pt idx="1305">
                  <c:v>-199955.60414461599</c:v>
                </c:pt>
                <c:pt idx="1306">
                  <c:v>-266118.26010979398</c:v>
                </c:pt>
                <c:pt idx="1307">
                  <c:v>-162672.483407997</c:v>
                </c:pt>
                <c:pt idx="1308">
                  <c:v>-42164.461693222103</c:v>
                </c:pt>
                <c:pt idx="1309">
                  <c:v>-109531.709229421</c:v>
                </c:pt>
                <c:pt idx="1310">
                  <c:v>-144594.79774965401</c:v>
                </c:pt>
                <c:pt idx="1311">
                  <c:v>-223070.23548444099</c:v>
                </c:pt>
                <c:pt idx="1312">
                  <c:v>-298787.680345912</c:v>
                </c:pt>
                <c:pt idx="1313">
                  <c:v>-263836.19279224798</c:v>
                </c:pt>
                <c:pt idx="1314">
                  <c:v>-186243.56372525601</c:v>
                </c:pt>
                <c:pt idx="1315">
                  <c:v>-103536.46241588</c:v>
                </c:pt>
                <c:pt idx="1316">
                  <c:v>-138142.42782634901</c:v>
                </c:pt>
                <c:pt idx="1317">
                  <c:v>-108414.62739666</c:v>
                </c:pt>
                <c:pt idx="1318">
                  <c:v>-89675.145958901398</c:v>
                </c:pt>
                <c:pt idx="1319">
                  <c:v>-145538.268908731</c:v>
                </c:pt>
                <c:pt idx="1320">
                  <c:v>-206439.98797252501</c:v>
                </c:pt>
                <c:pt idx="1321">
                  <c:v>-283030.02687337401</c:v>
                </c:pt>
                <c:pt idx="1322">
                  <c:v>-209586.90878853499</c:v>
                </c:pt>
                <c:pt idx="1323">
                  <c:v>-98032.368538302602</c:v>
                </c:pt>
                <c:pt idx="1324">
                  <c:v>-84559.8224310035</c:v>
                </c:pt>
                <c:pt idx="1325">
                  <c:v>-9499.9326260246999</c:v>
                </c:pt>
                <c:pt idx="1326">
                  <c:v>-139107.83690366699</c:v>
                </c:pt>
                <c:pt idx="1327">
                  <c:v>-122420.334538147</c:v>
                </c:pt>
                <c:pt idx="1328">
                  <c:v>-30655.8770719928</c:v>
                </c:pt>
                <c:pt idx="1329">
                  <c:v>50767.399550857001</c:v>
                </c:pt>
                <c:pt idx="1330">
                  <c:v>-11506.2521990931</c:v>
                </c:pt>
                <c:pt idx="1331">
                  <c:v>15319.914355709599</c:v>
                </c:pt>
                <c:pt idx="1332">
                  <c:v>-1669.3267777579599</c:v>
                </c:pt>
                <c:pt idx="1333">
                  <c:v>-43736.1312370101</c:v>
                </c:pt>
                <c:pt idx="1334">
                  <c:v>-77876.090594005</c:v>
                </c:pt>
                <c:pt idx="1335">
                  <c:v>-103429.705767855</c:v>
                </c:pt>
                <c:pt idx="1336">
                  <c:v>-23385.228179375401</c:v>
                </c:pt>
                <c:pt idx="1337">
                  <c:v>-182115.817174378</c:v>
                </c:pt>
                <c:pt idx="1338">
                  <c:v>-105207.756458084</c:v>
                </c:pt>
                <c:pt idx="1339">
                  <c:v>-76220.657054039693</c:v>
                </c:pt>
                <c:pt idx="1340">
                  <c:v>15904.702593047199</c:v>
                </c:pt>
                <c:pt idx="1341">
                  <c:v>-22513.321597176699</c:v>
                </c:pt>
                <c:pt idx="1342">
                  <c:v>-17936.320481168099</c:v>
                </c:pt>
                <c:pt idx="1343">
                  <c:v>70441.426347366098</c:v>
                </c:pt>
                <c:pt idx="1344">
                  <c:v>-154084.40962508399</c:v>
                </c:pt>
                <c:pt idx="1345">
                  <c:v>-278124.08280404197</c:v>
                </c:pt>
                <c:pt idx="1346">
                  <c:v>-124564.51496807</c:v>
                </c:pt>
                <c:pt idx="1347">
                  <c:v>49032.053090865498</c:v>
                </c:pt>
                <c:pt idx="1348">
                  <c:v>77115.300361461093</c:v>
                </c:pt>
                <c:pt idx="1349">
                  <c:v>27760.2829184086</c:v>
                </c:pt>
                <c:pt idx="1350">
                  <c:v>55572.772639419702</c:v>
                </c:pt>
                <c:pt idx="1351">
                  <c:v>35385.636661118697</c:v>
                </c:pt>
                <c:pt idx="1352">
                  <c:v>-126.542106817185</c:v>
                </c:pt>
                <c:pt idx="1353">
                  <c:v>25714.888282188302</c:v>
                </c:pt>
                <c:pt idx="1354">
                  <c:v>-41374.725818520099</c:v>
                </c:pt>
                <c:pt idx="1355">
                  <c:v>-57069.619293368698</c:v>
                </c:pt>
                <c:pt idx="1356">
                  <c:v>-81087.905451060898</c:v>
                </c:pt>
                <c:pt idx="1357">
                  <c:v>-98707.312345352198</c:v>
                </c:pt>
                <c:pt idx="1358">
                  <c:v>-225675.55149156001</c:v>
                </c:pt>
                <c:pt idx="1359">
                  <c:v>-206556.26678100301</c:v>
                </c:pt>
                <c:pt idx="1360">
                  <c:v>-285613.72430997598</c:v>
                </c:pt>
                <c:pt idx="1361">
                  <c:v>-273759.66623613797</c:v>
                </c:pt>
                <c:pt idx="1362">
                  <c:v>-70622.615451238104</c:v>
                </c:pt>
                <c:pt idx="1363">
                  <c:v>-94380.161901169195</c:v>
                </c:pt>
                <c:pt idx="1364">
                  <c:v>-97931.490548911999</c:v>
                </c:pt>
                <c:pt idx="1365">
                  <c:v>-97326.528455479202</c:v>
                </c:pt>
                <c:pt idx="1366">
                  <c:v>-98472.817307785896</c:v>
                </c:pt>
                <c:pt idx="1367">
                  <c:v>-69105.248140122902</c:v>
                </c:pt>
                <c:pt idx="1368">
                  <c:v>-7550.2540743197897</c:v>
                </c:pt>
                <c:pt idx="1369">
                  <c:v>-53487.319996238199</c:v>
                </c:pt>
                <c:pt idx="1370">
                  <c:v>-70554.172013477</c:v>
                </c:pt>
                <c:pt idx="1371">
                  <c:v>49557.952599115597</c:v>
                </c:pt>
                <c:pt idx="1372">
                  <c:v>-34374.167167583197</c:v>
                </c:pt>
                <c:pt idx="1373">
                  <c:v>34456.407882085601</c:v>
                </c:pt>
                <c:pt idx="1374">
                  <c:v>28620.249565124101</c:v>
                </c:pt>
                <c:pt idx="1375">
                  <c:v>44917.938527159502</c:v>
                </c:pt>
                <c:pt idx="1376">
                  <c:v>19142.506548273599</c:v>
                </c:pt>
                <c:pt idx="1377">
                  <c:v>37719.858156125701</c:v>
                </c:pt>
                <c:pt idx="1378">
                  <c:v>6463.2322377103601</c:v>
                </c:pt>
                <c:pt idx="1379">
                  <c:v>-78075.035715183403</c:v>
                </c:pt>
                <c:pt idx="1380">
                  <c:v>-162305.14503087799</c:v>
                </c:pt>
                <c:pt idx="1381">
                  <c:v>-117172.955337158</c:v>
                </c:pt>
                <c:pt idx="1382">
                  <c:v>-140309.22974996499</c:v>
                </c:pt>
                <c:pt idx="1383">
                  <c:v>-32956.4106269931</c:v>
                </c:pt>
                <c:pt idx="1384">
                  <c:v>-14606.323962164801</c:v>
                </c:pt>
                <c:pt idx="1385">
                  <c:v>-34234.693437381196</c:v>
                </c:pt>
                <c:pt idx="1386">
                  <c:v>-266975.63483169698</c:v>
                </c:pt>
                <c:pt idx="1387">
                  <c:v>-176225.32642661201</c:v>
                </c:pt>
                <c:pt idx="1388">
                  <c:v>-103032.422232247</c:v>
                </c:pt>
                <c:pt idx="1389">
                  <c:v>-82618.610598516199</c:v>
                </c:pt>
                <c:pt idx="1390">
                  <c:v>-97749.161483852993</c:v>
                </c:pt>
                <c:pt idx="1391">
                  <c:v>-70416.917126120403</c:v>
                </c:pt>
                <c:pt idx="1392">
                  <c:v>-115195.836412458</c:v>
                </c:pt>
                <c:pt idx="1393">
                  <c:v>-72259.348887800807</c:v>
                </c:pt>
                <c:pt idx="1394">
                  <c:v>-183699.624532252</c:v>
                </c:pt>
                <c:pt idx="1395">
                  <c:v>-55793.151000590202</c:v>
                </c:pt>
                <c:pt idx="1396">
                  <c:v>-49154.491628142699</c:v>
                </c:pt>
                <c:pt idx="1397">
                  <c:v>26755.0688741597</c:v>
                </c:pt>
                <c:pt idx="1398">
                  <c:v>-65002.221506594004</c:v>
                </c:pt>
                <c:pt idx="1399">
                  <c:v>-120320.702698211</c:v>
                </c:pt>
                <c:pt idx="1400">
                  <c:v>-60666.889434373697</c:v>
                </c:pt>
                <c:pt idx="1401">
                  <c:v>-101058.21779166</c:v>
                </c:pt>
                <c:pt idx="1402">
                  <c:v>-137174.18568668299</c:v>
                </c:pt>
                <c:pt idx="1403">
                  <c:v>-131087.981402003</c:v>
                </c:pt>
                <c:pt idx="1404">
                  <c:v>-203362.16569695499</c:v>
                </c:pt>
                <c:pt idx="1405">
                  <c:v>-44402.070487622703</c:v>
                </c:pt>
                <c:pt idx="1406">
                  <c:v>-7931.5042514746601</c:v>
                </c:pt>
                <c:pt idx="1407">
                  <c:v>-68995.025013297898</c:v>
                </c:pt>
                <c:pt idx="1408">
                  <c:v>-39310.614718399302</c:v>
                </c:pt>
                <c:pt idx="1409">
                  <c:v>-60904.091891942</c:v>
                </c:pt>
                <c:pt idx="1410">
                  <c:v>-32131.5750290531</c:v>
                </c:pt>
                <c:pt idx="1411">
                  <c:v>63029.394397392098</c:v>
                </c:pt>
                <c:pt idx="1412">
                  <c:v>52452.689380687698</c:v>
                </c:pt>
                <c:pt idx="1413">
                  <c:v>-25184.118664244499</c:v>
                </c:pt>
                <c:pt idx="1414">
                  <c:v>47687.485240471498</c:v>
                </c:pt>
                <c:pt idx="1415">
                  <c:v>-87472.856649714595</c:v>
                </c:pt>
                <c:pt idx="1416">
                  <c:v>14895.1651101056</c:v>
                </c:pt>
                <c:pt idx="1417">
                  <c:v>16416.101866931898</c:v>
                </c:pt>
                <c:pt idx="1418">
                  <c:v>14630.236165747299</c:v>
                </c:pt>
                <c:pt idx="1419">
                  <c:v>65313.603046303098</c:v>
                </c:pt>
                <c:pt idx="1420">
                  <c:v>51480.541221056097</c:v>
                </c:pt>
                <c:pt idx="1421">
                  <c:v>35963.967275568699</c:v>
                </c:pt>
                <c:pt idx="1422">
                  <c:v>65341.359954835301</c:v>
                </c:pt>
                <c:pt idx="1423">
                  <c:v>0</c:v>
                </c:pt>
                <c:pt idx="1424">
                  <c:v>0</c:v>
                </c:pt>
                <c:pt idx="1425">
                  <c:v>15258.3499697631</c:v>
                </c:pt>
                <c:pt idx="1426">
                  <c:v>28349.2528176589</c:v>
                </c:pt>
                <c:pt idx="1427">
                  <c:v>4545.4963343248</c:v>
                </c:pt>
                <c:pt idx="1428">
                  <c:v>52219.069626908502</c:v>
                </c:pt>
                <c:pt idx="1429">
                  <c:v>97222.206175768995</c:v>
                </c:pt>
                <c:pt idx="1430">
                  <c:v>98856.880224845503</c:v>
                </c:pt>
                <c:pt idx="1431">
                  <c:v>-17250.170808758601</c:v>
                </c:pt>
                <c:pt idx="1432">
                  <c:v>45163.918459011198</c:v>
                </c:pt>
                <c:pt idx="1433">
                  <c:v>-66693.946035680696</c:v>
                </c:pt>
                <c:pt idx="1434">
                  <c:v>-196118.08076152101</c:v>
                </c:pt>
                <c:pt idx="1435">
                  <c:v>-371793.54400520102</c:v>
                </c:pt>
                <c:pt idx="1436">
                  <c:v>-254044.25851734501</c:v>
                </c:pt>
                <c:pt idx="1437">
                  <c:v>-267134.26440977497</c:v>
                </c:pt>
                <c:pt idx="1438">
                  <c:v>-248195.04612110401</c:v>
                </c:pt>
                <c:pt idx="1439">
                  <c:v>-118901.876830198</c:v>
                </c:pt>
                <c:pt idx="1440">
                  <c:v>-38245.315282941003</c:v>
                </c:pt>
                <c:pt idx="1441">
                  <c:v>-108259.309370644</c:v>
                </c:pt>
                <c:pt idx="1442">
                  <c:v>-67102.482875970905</c:v>
                </c:pt>
                <c:pt idx="1443">
                  <c:v>37887.249220045996</c:v>
                </c:pt>
                <c:pt idx="1444">
                  <c:v>64192.5737190402</c:v>
                </c:pt>
                <c:pt idx="1445">
                  <c:v>24990.7843491149</c:v>
                </c:pt>
                <c:pt idx="1446">
                  <c:v>-79754.288011814104</c:v>
                </c:pt>
                <c:pt idx="1447">
                  <c:v>-56225.495346886499</c:v>
                </c:pt>
                <c:pt idx="1448">
                  <c:v>-89329.355344150405</c:v>
                </c:pt>
                <c:pt idx="1449">
                  <c:v>-23513.569819083099</c:v>
                </c:pt>
                <c:pt idx="1450">
                  <c:v>-33333.023943115499</c:v>
                </c:pt>
                <c:pt idx="1451">
                  <c:v>-11886.2463204696</c:v>
                </c:pt>
                <c:pt idx="1452">
                  <c:v>-6241.70239382399</c:v>
                </c:pt>
                <c:pt idx="1453">
                  <c:v>-57610.770439783497</c:v>
                </c:pt>
                <c:pt idx="1454">
                  <c:v>-73276.150459693905</c:v>
                </c:pt>
                <c:pt idx="1455">
                  <c:v>-96048.021288894801</c:v>
                </c:pt>
                <c:pt idx="1456">
                  <c:v>8612.6849820060597</c:v>
                </c:pt>
                <c:pt idx="1457">
                  <c:v>107021.44862717199</c:v>
                </c:pt>
                <c:pt idx="1458">
                  <c:v>16937.544126034401</c:v>
                </c:pt>
                <c:pt idx="1459">
                  <c:v>-53397.202437592699</c:v>
                </c:pt>
                <c:pt idx="1460">
                  <c:v>-68637.895834914001</c:v>
                </c:pt>
                <c:pt idx="1461">
                  <c:v>2902.7465190975799</c:v>
                </c:pt>
                <c:pt idx="1462">
                  <c:v>-17677.592401694499</c:v>
                </c:pt>
                <c:pt idx="1463">
                  <c:v>58118.344940813702</c:v>
                </c:pt>
                <c:pt idx="1464">
                  <c:v>140787.86062392499</c:v>
                </c:pt>
                <c:pt idx="1465">
                  <c:v>-23958.0712339042</c:v>
                </c:pt>
                <c:pt idx="1466">
                  <c:v>20999.498391132802</c:v>
                </c:pt>
                <c:pt idx="1467">
                  <c:v>9636.6625665830707</c:v>
                </c:pt>
                <c:pt idx="1468">
                  <c:v>43221.715542164202</c:v>
                </c:pt>
                <c:pt idx="1469">
                  <c:v>64133.081343047998</c:v>
                </c:pt>
                <c:pt idx="1470">
                  <c:v>87409.401613242502</c:v>
                </c:pt>
                <c:pt idx="1471">
                  <c:v>-21424.355622637901</c:v>
                </c:pt>
                <c:pt idx="1472">
                  <c:v>-22296.585678805601</c:v>
                </c:pt>
                <c:pt idx="1473">
                  <c:v>59834.935841520397</c:v>
                </c:pt>
                <c:pt idx="1474">
                  <c:v>0</c:v>
                </c:pt>
                <c:pt idx="1475">
                  <c:v>0</c:v>
                </c:pt>
                <c:pt idx="1476">
                  <c:v>-48842.4486313589</c:v>
                </c:pt>
                <c:pt idx="1477">
                  <c:v>-61803.816975592803</c:v>
                </c:pt>
                <c:pt idx="1478">
                  <c:v>-2311.0882255532701</c:v>
                </c:pt>
                <c:pt idx="1479">
                  <c:v>-37605.280514954902</c:v>
                </c:pt>
                <c:pt idx="1480">
                  <c:v>14296.996419126001</c:v>
                </c:pt>
                <c:pt idx="1481">
                  <c:v>19046.3648009479</c:v>
                </c:pt>
                <c:pt idx="1482">
                  <c:v>80383.335082993799</c:v>
                </c:pt>
                <c:pt idx="1483">
                  <c:v>79510.210431978005</c:v>
                </c:pt>
                <c:pt idx="1484">
                  <c:v>38436.680247912998</c:v>
                </c:pt>
                <c:pt idx="1485">
                  <c:v>26263.102214275001</c:v>
                </c:pt>
                <c:pt idx="1486">
                  <c:v>13573.9915466613</c:v>
                </c:pt>
                <c:pt idx="1487">
                  <c:v>-23787.427913134801</c:v>
                </c:pt>
                <c:pt idx="1488">
                  <c:v>-52777.271516808702</c:v>
                </c:pt>
                <c:pt idx="1489">
                  <c:v>-28665.705618355802</c:v>
                </c:pt>
                <c:pt idx="1490">
                  <c:v>52523.566552474796</c:v>
                </c:pt>
                <c:pt idx="1491">
                  <c:v>84233.419125006694</c:v>
                </c:pt>
                <c:pt idx="1492">
                  <c:v>113701.93889599601</c:v>
                </c:pt>
                <c:pt idx="1493">
                  <c:v>84195.300563366603</c:v>
                </c:pt>
                <c:pt idx="1494">
                  <c:v>36890.695457121401</c:v>
                </c:pt>
                <c:pt idx="1495">
                  <c:v>16009.0168066849</c:v>
                </c:pt>
                <c:pt idx="1496">
                  <c:v>11573.8677011735</c:v>
                </c:pt>
                <c:pt idx="1497">
                  <c:v>96862.747428335395</c:v>
                </c:pt>
                <c:pt idx="1498">
                  <c:v>73842.567774171694</c:v>
                </c:pt>
                <c:pt idx="1499">
                  <c:v>-38872.978431490803</c:v>
                </c:pt>
                <c:pt idx="1500">
                  <c:v>16653.0767360635</c:v>
                </c:pt>
                <c:pt idx="1501">
                  <c:v>34473.163205399003</c:v>
                </c:pt>
                <c:pt idx="1502">
                  <c:v>-77357.317155098601</c:v>
                </c:pt>
                <c:pt idx="1503">
                  <c:v>-118808.761122237</c:v>
                </c:pt>
                <c:pt idx="1504">
                  <c:v>-39832.475464380201</c:v>
                </c:pt>
                <c:pt idx="1505">
                  <c:v>-20424.809575629501</c:v>
                </c:pt>
                <c:pt idx="1506">
                  <c:v>42929.781431451302</c:v>
                </c:pt>
                <c:pt idx="1507">
                  <c:v>-20729.1781536954</c:v>
                </c:pt>
                <c:pt idx="1508">
                  <c:v>44486.176523217</c:v>
                </c:pt>
                <c:pt idx="1509">
                  <c:v>75459.729373857394</c:v>
                </c:pt>
                <c:pt idx="1510">
                  <c:v>-9091.0584242847508</c:v>
                </c:pt>
                <c:pt idx="1511">
                  <c:v>5809.8853217263804</c:v>
                </c:pt>
                <c:pt idx="1512">
                  <c:v>24360.2656522344</c:v>
                </c:pt>
                <c:pt idx="1513">
                  <c:v>1186.88596482349</c:v>
                </c:pt>
                <c:pt idx="1514">
                  <c:v>-102600.30318974001</c:v>
                </c:pt>
                <c:pt idx="1515">
                  <c:v>0</c:v>
                </c:pt>
                <c:pt idx="1516">
                  <c:v>0</c:v>
                </c:pt>
                <c:pt idx="1517">
                  <c:v>-12753.4092305553</c:v>
                </c:pt>
                <c:pt idx="1518">
                  <c:v>78502.205733852898</c:v>
                </c:pt>
                <c:pt idx="1519">
                  <c:v>62436.853672715399</c:v>
                </c:pt>
                <c:pt idx="1520">
                  <c:v>85188.321591839398</c:v>
                </c:pt>
                <c:pt idx="1521">
                  <c:v>2131.8401378272101</c:v>
                </c:pt>
                <c:pt idx="1522">
                  <c:v>-34513.2366709485</c:v>
                </c:pt>
                <c:pt idx="1523">
                  <c:v>-79681.692874718399</c:v>
                </c:pt>
                <c:pt idx="1524">
                  <c:v>-62790.540505202698</c:v>
                </c:pt>
                <c:pt idx="1525">
                  <c:v>42770.1903542527</c:v>
                </c:pt>
                <c:pt idx="1526">
                  <c:v>-11.620705775734701</c:v>
                </c:pt>
                <c:pt idx="1527">
                  <c:v>-39799.591730285298</c:v>
                </c:pt>
                <c:pt idx="1528">
                  <c:v>-27060.762773613002</c:v>
                </c:pt>
                <c:pt idx="1529">
                  <c:v>83419.156230917593</c:v>
                </c:pt>
                <c:pt idx="1530">
                  <c:v>-57048.255852105503</c:v>
                </c:pt>
                <c:pt idx="1531">
                  <c:v>-48225.860301824097</c:v>
                </c:pt>
                <c:pt idx="1532">
                  <c:v>-8308.6599761418292</c:v>
                </c:pt>
                <c:pt idx="1533">
                  <c:v>-77429.249302866199</c:v>
                </c:pt>
                <c:pt idx="1534">
                  <c:v>-19911.456521009401</c:v>
                </c:pt>
                <c:pt idx="1535">
                  <c:v>-13594.0813994858</c:v>
                </c:pt>
                <c:pt idx="1536">
                  <c:v>-3171.3190778803501</c:v>
                </c:pt>
                <c:pt idx="1537">
                  <c:v>-52776.878692466998</c:v>
                </c:pt>
                <c:pt idx="1538">
                  <c:v>-7420.4153326095602</c:v>
                </c:pt>
                <c:pt idx="1539">
                  <c:v>-44978.818637289201</c:v>
                </c:pt>
                <c:pt idx="1540">
                  <c:v>-118012.193029865</c:v>
                </c:pt>
                <c:pt idx="1541">
                  <c:v>-5096.5158239693901</c:v>
                </c:pt>
                <c:pt idx="1542">
                  <c:v>-61684.606676095202</c:v>
                </c:pt>
                <c:pt idx="1543">
                  <c:v>-57421.018807083499</c:v>
                </c:pt>
                <c:pt idx="1544">
                  <c:v>24010.199986567</c:v>
                </c:pt>
                <c:pt idx="1545">
                  <c:v>50463.7301899589</c:v>
                </c:pt>
                <c:pt idx="1546">
                  <c:v>67044.381379844694</c:v>
                </c:pt>
                <c:pt idx="1547">
                  <c:v>49765.060025024599</c:v>
                </c:pt>
                <c:pt idx="1548">
                  <c:v>59336.543302825899</c:v>
                </c:pt>
                <c:pt idx="1549">
                  <c:v>-31538.032526797</c:v>
                </c:pt>
                <c:pt idx="1550">
                  <c:v>44397.8101945038</c:v>
                </c:pt>
                <c:pt idx="1551">
                  <c:v>-5081.4419862852901</c:v>
                </c:pt>
                <c:pt idx="1552">
                  <c:v>17864.007900611799</c:v>
                </c:pt>
                <c:pt idx="1553">
                  <c:v>-53556.704381740798</c:v>
                </c:pt>
                <c:pt idx="1554">
                  <c:v>11800.855152297099</c:v>
                </c:pt>
                <c:pt idx="1555">
                  <c:v>50785.949713422197</c:v>
                </c:pt>
                <c:pt idx="1556">
                  <c:v>0</c:v>
                </c:pt>
                <c:pt idx="1557">
                  <c:v>0</c:v>
                </c:pt>
                <c:pt idx="1558">
                  <c:v>-72515.3760952218</c:v>
                </c:pt>
                <c:pt idx="1559">
                  <c:v>51584.965936957</c:v>
                </c:pt>
                <c:pt idx="1560">
                  <c:v>12500.4529849633</c:v>
                </c:pt>
                <c:pt idx="1561">
                  <c:v>-48870.9694979325</c:v>
                </c:pt>
                <c:pt idx="1562">
                  <c:v>103929.056905351</c:v>
                </c:pt>
                <c:pt idx="1563">
                  <c:v>56527.274161592803</c:v>
                </c:pt>
                <c:pt idx="1564">
                  <c:v>97630.263293041702</c:v>
                </c:pt>
                <c:pt idx="1565">
                  <c:v>30114.122180279599</c:v>
                </c:pt>
                <c:pt idx="1566">
                  <c:v>127403.12626012899</c:v>
                </c:pt>
                <c:pt idx="1567">
                  <c:v>79616.771813056403</c:v>
                </c:pt>
                <c:pt idx="1568">
                  <c:v>-20298.166043850499</c:v>
                </c:pt>
                <c:pt idx="1569">
                  <c:v>4681.0515888083301</c:v>
                </c:pt>
                <c:pt idx="1570">
                  <c:v>44024.740699495203</c:v>
                </c:pt>
                <c:pt idx="1571">
                  <c:v>1337.0435482319399</c:v>
                </c:pt>
                <c:pt idx="1572">
                  <c:v>23893.8628044162</c:v>
                </c:pt>
                <c:pt idx="1573">
                  <c:v>32210.550243066999</c:v>
                </c:pt>
                <c:pt idx="1574">
                  <c:v>-30566.6189422475</c:v>
                </c:pt>
                <c:pt idx="1575">
                  <c:v>5841.9658854601703</c:v>
                </c:pt>
                <c:pt idx="1576">
                  <c:v>29248.6566483323</c:v>
                </c:pt>
                <c:pt idx="1577">
                  <c:v>-143375.083914877</c:v>
                </c:pt>
                <c:pt idx="1578">
                  <c:v>-174929.23888867599</c:v>
                </c:pt>
                <c:pt idx="1579">
                  <c:v>-203495.35517220499</c:v>
                </c:pt>
                <c:pt idx="1580">
                  <c:v>-146337.335804881</c:v>
                </c:pt>
                <c:pt idx="1581">
                  <c:v>-106430.55313434701</c:v>
                </c:pt>
                <c:pt idx="1582">
                  <c:v>-84340.879179512194</c:v>
                </c:pt>
                <c:pt idx="1583">
                  <c:v>-49930.754076053898</c:v>
                </c:pt>
                <c:pt idx="1584">
                  <c:v>-83286.998161628595</c:v>
                </c:pt>
                <c:pt idx="1585">
                  <c:v>-79515.131579143199</c:v>
                </c:pt>
                <c:pt idx="1586">
                  <c:v>-40722.911534712002</c:v>
                </c:pt>
                <c:pt idx="1587">
                  <c:v>-20524.598477781401</c:v>
                </c:pt>
                <c:pt idx="1588">
                  <c:v>28470.370858804799</c:v>
                </c:pt>
                <c:pt idx="1589">
                  <c:v>-49583.950684834599</c:v>
                </c:pt>
                <c:pt idx="1590">
                  <c:v>-79132.068885761895</c:v>
                </c:pt>
                <c:pt idx="1591">
                  <c:v>-39731.473441928902</c:v>
                </c:pt>
                <c:pt idx="1592">
                  <c:v>-34109.900033596103</c:v>
                </c:pt>
                <c:pt idx="1593">
                  <c:v>-3715.1757129908501</c:v>
                </c:pt>
                <c:pt idx="1594">
                  <c:v>-47929.193254787999</c:v>
                </c:pt>
                <c:pt idx="1595">
                  <c:v>-83431.112062815402</c:v>
                </c:pt>
                <c:pt idx="1596">
                  <c:v>-45830.056765847199</c:v>
                </c:pt>
                <c:pt idx="1597">
                  <c:v>-100045.493372621</c:v>
                </c:pt>
                <c:pt idx="1598">
                  <c:v>5204.2537275572204</c:v>
                </c:pt>
                <c:pt idx="1599">
                  <c:v>-24629.081607138</c:v>
                </c:pt>
                <c:pt idx="1600">
                  <c:v>-77164.676699361007</c:v>
                </c:pt>
                <c:pt idx="1601">
                  <c:v>-37388.588190080503</c:v>
                </c:pt>
                <c:pt idx="1602">
                  <c:v>-71128.086419506406</c:v>
                </c:pt>
                <c:pt idx="1603">
                  <c:v>-60562.098649610904</c:v>
                </c:pt>
                <c:pt idx="1604">
                  <c:v>-47119.947163144097</c:v>
                </c:pt>
                <c:pt idx="1605">
                  <c:v>24088.5679383639</c:v>
                </c:pt>
                <c:pt idx="1606">
                  <c:v>-23029.205277462999</c:v>
                </c:pt>
                <c:pt idx="1607">
                  <c:v>0</c:v>
                </c:pt>
                <c:pt idx="1608">
                  <c:v>0</c:v>
                </c:pt>
                <c:pt idx="1609">
                  <c:v>-51261.234076077199</c:v>
                </c:pt>
                <c:pt idx="1610">
                  <c:v>-24058.291049887401</c:v>
                </c:pt>
                <c:pt idx="1611">
                  <c:v>25304.310549733498</c:v>
                </c:pt>
                <c:pt idx="1612">
                  <c:v>46372.889677084197</c:v>
                </c:pt>
                <c:pt idx="1613">
                  <c:v>102294.016375052</c:v>
                </c:pt>
                <c:pt idx="1614">
                  <c:v>-2690.6202777806998</c:v>
                </c:pt>
                <c:pt idx="1615">
                  <c:v>40366.596798462102</c:v>
                </c:pt>
                <c:pt idx="1616">
                  <c:v>-56212.095860854301</c:v>
                </c:pt>
                <c:pt idx="1617">
                  <c:v>-69998.053750533101</c:v>
                </c:pt>
                <c:pt idx="1618">
                  <c:v>63258.648827420402</c:v>
                </c:pt>
                <c:pt idx="1619">
                  <c:v>95532.152208516796</c:v>
                </c:pt>
                <c:pt idx="1620">
                  <c:v>145385.86190016501</c:v>
                </c:pt>
                <c:pt idx="1621">
                  <c:v>25555.2081891895</c:v>
                </c:pt>
                <c:pt idx="1622">
                  <c:v>-71072.567708161005</c:v>
                </c:pt>
                <c:pt idx="1623">
                  <c:v>-52256.260006693403</c:v>
                </c:pt>
                <c:pt idx="1624">
                  <c:v>-36692.640940228899</c:v>
                </c:pt>
                <c:pt idx="1625">
                  <c:v>-37521.360088614303</c:v>
                </c:pt>
                <c:pt idx="1626">
                  <c:v>-40869.545473965198</c:v>
                </c:pt>
                <c:pt idx="1627">
                  <c:v>22875.9405809862</c:v>
                </c:pt>
                <c:pt idx="1628">
                  <c:v>-16323.5190080297</c:v>
                </c:pt>
                <c:pt idx="1629">
                  <c:v>-119382.000315118</c:v>
                </c:pt>
                <c:pt idx="1630">
                  <c:v>-3926.7909233774799</c:v>
                </c:pt>
                <c:pt idx="1631">
                  <c:v>84838.916816748504</c:v>
                </c:pt>
                <c:pt idx="1632">
                  <c:v>-43058.415418569399</c:v>
                </c:pt>
                <c:pt idx="1633">
                  <c:v>-215110.837686057</c:v>
                </c:pt>
                <c:pt idx="1634">
                  <c:v>-257078.77228324901</c:v>
                </c:pt>
                <c:pt idx="1635">
                  <c:v>-305213.87764146097</c:v>
                </c:pt>
                <c:pt idx="1636">
                  <c:v>91775.497381444598</c:v>
                </c:pt>
                <c:pt idx="1637">
                  <c:v>-166491.395709495</c:v>
                </c:pt>
                <c:pt idx="1638">
                  <c:v>-170118.311223253</c:v>
                </c:pt>
                <c:pt idx="1639">
                  <c:v>-55346.326746120903</c:v>
                </c:pt>
                <c:pt idx="1640">
                  <c:v>-53318.6605559042</c:v>
                </c:pt>
                <c:pt idx="1641">
                  <c:v>-46089.704021009296</c:v>
                </c:pt>
                <c:pt idx="1642">
                  <c:v>-96344.999038807597</c:v>
                </c:pt>
                <c:pt idx="1643">
                  <c:v>-48562.361786772199</c:v>
                </c:pt>
                <c:pt idx="1644">
                  <c:v>-37218.993639403001</c:v>
                </c:pt>
                <c:pt idx="1645">
                  <c:v>-44808.316089029497</c:v>
                </c:pt>
                <c:pt idx="1646">
                  <c:v>-92468.476212210997</c:v>
                </c:pt>
                <c:pt idx="1647">
                  <c:v>-121218.793047675</c:v>
                </c:pt>
                <c:pt idx="1648">
                  <c:v>-36800.433129400699</c:v>
                </c:pt>
                <c:pt idx="1649">
                  <c:v>-33998.769566534997</c:v>
                </c:pt>
                <c:pt idx="1650">
                  <c:v>-123367.64774185899</c:v>
                </c:pt>
                <c:pt idx="1651">
                  <c:v>-140973.968452703</c:v>
                </c:pt>
                <c:pt idx="1652">
                  <c:v>93401.933394797394</c:v>
                </c:pt>
                <c:pt idx="1653">
                  <c:v>13694.9294364207</c:v>
                </c:pt>
                <c:pt idx="1654">
                  <c:v>-17907.4216478538</c:v>
                </c:pt>
                <c:pt idx="1655">
                  <c:v>7598.7296979111297</c:v>
                </c:pt>
                <c:pt idx="1656">
                  <c:v>32225.449995161202</c:v>
                </c:pt>
                <c:pt idx="1657">
                  <c:v>16058.723133118099</c:v>
                </c:pt>
                <c:pt idx="1658">
                  <c:v>-69580.7927548101</c:v>
                </c:pt>
                <c:pt idx="1659">
                  <c:v>-73359.224476713804</c:v>
                </c:pt>
                <c:pt idx="1660">
                  <c:v>-100365.856358605</c:v>
                </c:pt>
                <c:pt idx="1661">
                  <c:v>-24894.429452213401</c:v>
                </c:pt>
                <c:pt idx="1662">
                  <c:v>14729.6454536895</c:v>
                </c:pt>
                <c:pt idx="1663">
                  <c:v>-77483.451989367401</c:v>
                </c:pt>
                <c:pt idx="1664">
                  <c:v>3796.2085436130601</c:v>
                </c:pt>
                <c:pt idx="1665">
                  <c:v>-74745.901580987993</c:v>
                </c:pt>
                <c:pt idx="1666">
                  <c:v>-57728.366705443099</c:v>
                </c:pt>
                <c:pt idx="1667">
                  <c:v>-68939.222259449496</c:v>
                </c:pt>
                <c:pt idx="1668">
                  <c:v>-49138.092665308897</c:v>
                </c:pt>
                <c:pt idx="1669">
                  <c:v>50894.454355271599</c:v>
                </c:pt>
                <c:pt idx="1670">
                  <c:v>19692.7326987249</c:v>
                </c:pt>
                <c:pt idx="1671">
                  <c:v>-64833.9431713417</c:v>
                </c:pt>
                <c:pt idx="1672">
                  <c:v>-54954.964847946401</c:v>
                </c:pt>
                <c:pt idx="1673">
                  <c:v>8605.5716032027904</c:v>
                </c:pt>
                <c:pt idx="1674">
                  <c:v>20567.7280128032</c:v>
                </c:pt>
                <c:pt idx="1675">
                  <c:v>-21454.155577265199</c:v>
                </c:pt>
                <c:pt idx="1676">
                  <c:v>29918.531962836099</c:v>
                </c:pt>
                <c:pt idx="1677">
                  <c:v>-14114.894775299799</c:v>
                </c:pt>
                <c:pt idx="1678">
                  <c:v>-82327.299423326403</c:v>
                </c:pt>
                <c:pt idx="1679">
                  <c:v>-64965.075845280197</c:v>
                </c:pt>
                <c:pt idx="1680">
                  <c:v>8248.8184149409408</c:v>
                </c:pt>
                <c:pt idx="1681">
                  <c:v>1646.2387225681</c:v>
                </c:pt>
                <c:pt idx="1682">
                  <c:v>3492.9158413384998</c:v>
                </c:pt>
                <c:pt idx="1683">
                  <c:v>24872.146445628001</c:v>
                </c:pt>
                <c:pt idx="1684">
                  <c:v>50668.7525229495</c:v>
                </c:pt>
                <c:pt idx="1685">
                  <c:v>24302.686468441301</c:v>
                </c:pt>
                <c:pt idx="1686">
                  <c:v>-13594.3233188093</c:v>
                </c:pt>
                <c:pt idx="1687">
                  <c:v>28342.6430035343</c:v>
                </c:pt>
                <c:pt idx="1688">
                  <c:v>0</c:v>
                </c:pt>
                <c:pt idx="1689">
                  <c:v>0</c:v>
                </c:pt>
                <c:pt idx="1690">
                  <c:v>40630.890662105601</c:v>
                </c:pt>
                <c:pt idx="1691">
                  <c:v>-76803.673623215902</c:v>
                </c:pt>
                <c:pt idx="1692">
                  <c:v>-59607.197868027702</c:v>
                </c:pt>
                <c:pt idx="1693">
                  <c:v>3656.0099127255398</c:v>
                </c:pt>
                <c:pt idx="1694">
                  <c:v>44130.950773250297</c:v>
                </c:pt>
                <c:pt idx="1695">
                  <c:v>57195.723457781802</c:v>
                </c:pt>
                <c:pt idx="1696">
                  <c:v>63093.5799258978</c:v>
                </c:pt>
                <c:pt idx="1697">
                  <c:v>101268.370268748</c:v>
                </c:pt>
                <c:pt idx="1698">
                  <c:v>24517.628630118099</c:v>
                </c:pt>
                <c:pt idx="1699">
                  <c:v>80369.035102936905</c:v>
                </c:pt>
                <c:pt idx="1700">
                  <c:v>5460.7835188335703</c:v>
                </c:pt>
                <c:pt idx="1701">
                  <c:v>-13923.0022850313</c:v>
                </c:pt>
                <c:pt idx="1702">
                  <c:v>-72147.824738959403</c:v>
                </c:pt>
                <c:pt idx="1703">
                  <c:v>-8731.9690241261596</c:v>
                </c:pt>
                <c:pt idx="1704">
                  <c:v>-13300.754673574</c:v>
                </c:pt>
                <c:pt idx="1705">
                  <c:v>-26798.582339482102</c:v>
                </c:pt>
                <c:pt idx="1706">
                  <c:v>-102360.562858484</c:v>
                </c:pt>
                <c:pt idx="1707">
                  <c:v>-79489.9991946597</c:v>
                </c:pt>
                <c:pt idx="1708">
                  <c:v>-45727.797097322997</c:v>
                </c:pt>
                <c:pt idx="1709">
                  <c:v>98695.061212342</c:v>
                </c:pt>
                <c:pt idx="1710">
                  <c:v>14560.864569958199</c:v>
                </c:pt>
                <c:pt idx="1711">
                  <c:v>-70796.967347116894</c:v>
                </c:pt>
                <c:pt idx="1712">
                  <c:v>-54547.195052421797</c:v>
                </c:pt>
                <c:pt idx="1713">
                  <c:v>-303.27931911690399</c:v>
                </c:pt>
                <c:pt idx="1714">
                  <c:v>-26087.574598733401</c:v>
                </c:pt>
                <c:pt idx="1715">
                  <c:v>-58150.753236400597</c:v>
                </c:pt>
                <c:pt idx="1716">
                  <c:v>26567.4286231486</c:v>
                </c:pt>
                <c:pt idx="1717">
                  <c:v>-58470.684003167298</c:v>
                </c:pt>
                <c:pt idx="1718">
                  <c:v>-16273.3812484021</c:v>
                </c:pt>
                <c:pt idx="1719">
                  <c:v>-18119.5672250182</c:v>
                </c:pt>
                <c:pt idx="1720">
                  <c:v>43295.847753652801</c:v>
                </c:pt>
                <c:pt idx="1721">
                  <c:v>16564.427170602299</c:v>
                </c:pt>
                <c:pt idx="1722">
                  <c:v>38064.270633348002</c:v>
                </c:pt>
                <c:pt idx="1723">
                  <c:v>121264.96227732299</c:v>
                </c:pt>
                <c:pt idx="1724">
                  <c:v>50395.223887168999</c:v>
                </c:pt>
                <c:pt idx="1725">
                  <c:v>-10451.835785831699</c:v>
                </c:pt>
                <c:pt idx="1726">
                  <c:v>-22929.5445679523</c:v>
                </c:pt>
                <c:pt idx="1727">
                  <c:v>28154.160833170099</c:v>
                </c:pt>
                <c:pt idx="1728">
                  <c:v>23848.0485188561</c:v>
                </c:pt>
                <c:pt idx="1729">
                  <c:v>243822.111956943</c:v>
                </c:pt>
                <c:pt idx="1730">
                  <c:v>135934.429737817</c:v>
                </c:pt>
                <c:pt idx="1731">
                  <c:v>-6831.25848968024</c:v>
                </c:pt>
                <c:pt idx="1732">
                  <c:v>-8309.8867140528801</c:v>
                </c:pt>
                <c:pt idx="1733">
                  <c:v>-16247.9302674468</c:v>
                </c:pt>
                <c:pt idx="1734">
                  <c:v>-5269.3538709881504</c:v>
                </c:pt>
                <c:pt idx="1735">
                  <c:v>-15720.512380627901</c:v>
                </c:pt>
                <c:pt idx="1736">
                  <c:v>-3090.8459792447302</c:v>
                </c:pt>
                <c:pt idx="1737">
                  <c:v>-90245.500768673795</c:v>
                </c:pt>
                <c:pt idx="1738">
                  <c:v>-30787.529134740998</c:v>
                </c:pt>
                <c:pt idx="1739">
                  <c:v>40139.063274332402</c:v>
                </c:pt>
                <c:pt idx="1740">
                  <c:v>16326.892299024301</c:v>
                </c:pt>
                <c:pt idx="1741">
                  <c:v>8911.0977094534501</c:v>
                </c:pt>
                <c:pt idx="1742">
                  <c:v>-32326.293595479001</c:v>
                </c:pt>
                <c:pt idx="1743">
                  <c:v>-73084.167517497699</c:v>
                </c:pt>
                <c:pt idx="1744">
                  <c:v>-104874.68792770999</c:v>
                </c:pt>
                <c:pt idx="1745">
                  <c:v>-14945.1291300495</c:v>
                </c:pt>
                <c:pt idx="1746">
                  <c:v>15663.636865762401</c:v>
                </c:pt>
                <c:pt idx="1747">
                  <c:v>45773.1388526921</c:v>
                </c:pt>
                <c:pt idx="1748">
                  <c:v>-2956.00278770048</c:v>
                </c:pt>
                <c:pt idx="1749">
                  <c:v>0</c:v>
                </c:pt>
                <c:pt idx="1750">
                  <c:v>0</c:v>
                </c:pt>
                <c:pt idx="1751">
                  <c:v>-14255.1611035184</c:v>
                </c:pt>
                <c:pt idx="1752">
                  <c:v>-51446.464411805297</c:v>
                </c:pt>
                <c:pt idx="1753">
                  <c:v>-107712.620493879</c:v>
                </c:pt>
                <c:pt idx="1754">
                  <c:v>-21709.6043210717</c:v>
                </c:pt>
                <c:pt idx="1755">
                  <c:v>-19091.717575467901</c:v>
                </c:pt>
                <c:pt idx="1756">
                  <c:v>17692.2220064842</c:v>
                </c:pt>
                <c:pt idx="1757">
                  <c:v>89034.220679705904</c:v>
                </c:pt>
                <c:pt idx="1758">
                  <c:v>105911.52381383099</c:v>
                </c:pt>
                <c:pt idx="1759">
                  <c:v>56540.968915555903</c:v>
                </c:pt>
                <c:pt idx="1760">
                  <c:v>60993.1418986504</c:v>
                </c:pt>
                <c:pt idx="1761">
                  <c:v>4018.5895684918601</c:v>
                </c:pt>
                <c:pt idx="1762">
                  <c:v>-2761.0892090015</c:v>
                </c:pt>
                <c:pt idx="1763">
                  <c:v>-22753.263184683499</c:v>
                </c:pt>
                <c:pt idx="1764">
                  <c:v>54516.381511416599</c:v>
                </c:pt>
                <c:pt idx="1765">
                  <c:v>24248.086230241999</c:v>
                </c:pt>
                <c:pt idx="1766">
                  <c:v>15713.112573258901</c:v>
                </c:pt>
                <c:pt idx="1767">
                  <c:v>116444.428160457</c:v>
                </c:pt>
                <c:pt idx="1768">
                  <c:v>53042.513129070503</c:v>
                </c:pt>
                <c:pt idx="1769">
                  <c:v>-46498.380611394699</c:v>
                </c:pt>
                <c:pt idx="1770">
                  <c:v>49696.458464518801</c:v>
                </c:pt>
                <c:pt idx="1771">
                  <c:v>-15345.402605113601</c:v>
                </c:pt>
                <c:pt idx="1772">
                  <c:v>49715.502727959698</c:v>
                </c:pt>
                <c:pt idx="1773">
                  <c:v>43277.000198803296</c:v>
                </c:pt>
                <c:pt idx="1774">
                  <c:v>154965.57195491501</c:v>
                </c:pt>
                <c:pt idx="1775">
                  <c:v>209039.17552209899</c:v>
                </c:pt>
                <c:pt idx="1776">
                  <c:v>-43728.5670700056</c:v>
                </c:pt>
                <c:pt idx="1777">
                  <c:v>54802.291819667902</c:v>
                </c:pt>
                <c:pt idx="1778">
                  <c:v>-88793.754809229606</c:v>
                </c:pt>
                <c:pt idx="1779">
                  <c:v>-15752.007460995401</c:v>
                </c:pt>
                <c:pt idx="1780">
                  <c:v>15541.7597609522</c:v>
                </c:pt>
                <c:pt idx="1781">
                  <c:v>-103077.719270897</c:v>
                </c:pt>
                <c:pt idx="1782">
                  <c:v>-13806.463709515499</c:v>
                </c:pt>
                <c:pt idx="1783">
                  <c:v>-7208.2418710889597</c:v>
                </c:pt>
                <c:pt idx="1784">
                  <c:v>15293.7935635842</c:v>
                </c:pt>
                <c:pt idx="1785">
                  <c:v>81292.919124631298</c:v>
                </c:pt>
                <c:pt idx="1786">
                  <c:v>-100290.952311449</c:v>
                </c:pt>
                <c:pt idx="1787">
                  <c:v>-57994.073207313901</c:v>
                </c:pt>
                <c:pt idx="1788">
                  <c:v>-107324.24540351699</c:v>
                </c:pt>
                <c:pt idx="1789">
                  <c:v>6402.3427368572202</c:v>
                </c:pt>
                <c:pt idx="1790">
                  <c:v>0</c:v>
                </c:pt>
                <c:pt idx="1791">
                  <c:v>0</c:v>
                </c:pt>
                <c:pt idx="1792">
                  <c:v>-11580.1008790577</c:v>
                </c:pt>
                <c:pt idx="1793">
                  <c:v>-86992.432373560296</c:v>
                </c:pt>
                <c:pt idx="1794">
                  <c:v>-11632.597475308299</c:v>
                </c:pt>
                <c:pt idx="1795">
                  <c:v>-39924.7638279065</c:v>
                </c:pt>
                <c:pt idx="1796">
                  <c:v>82612.163059137398</c:v>
                </c:pt>
                <c:pt idx="1797">
                  <c:v>-3862.43295279418</c:v>
                </c:pt>
                <c:pt idx="1798">
                  <c:v>-1297.9147759785601</c:v>
                </c:pt>
                <c:pt idx="1799">
                  <c:v>-58449.143693994403</c:v>
                </c:pt>
                <c:pt idx="1800">
                  <c:v>116283.283931454</c:v>
                </c:pt>
                <c:pt idx="1801">
                  <c:v>53597.415033239398</c:v>
                </c:pt>
                <c:pt idx="1802">
                  <c:v>67180.127393898001</c:v>
                </c:pt>
                <c:pt idx="1803">
                  <c:v>-24893.368976528</c:v>
                </c:pt>
                <c:pt idx="1804">
                  <c:v>-19447.609345280001</c:v>
                </c:pt>
                <c:pt idx="1805">
                  <c:v>-19371.317199598201</c:v>
                </c:pt>
                <c:pt idx="1806">
                  <c:v>2937.5149579113399</c:v>
                </c:pt>
                <c:pt idx="1807">
                  <c:v>-26580.403798638199</c:v>
                </c:pt>
                <c:pt idx="1808">
                  <c:v>-73325.703419458907</c:v>
                </c:pt>
                <c:pt idx="1809">
                  <c:v>-58975.602805577102</c:v>
                </c:pt>
                <c:pt idx="1810">
                  <c:v>44063.396662867999</c:v>
                </c:pt>
                <c:pt idx="1811">
                  <c:v>19634.318686266</c:v>
                </c:pt>
                <c:pt idx="1812">
                  <c:v>-4696.4782259707899</c:v>
                </c:pt>
                <c:pt idx="1813">
                  <c:v>-112531.65506536901</c:v>
                </c:pt>
                <c:pt idx="1814">
                  <c:v>-45346.048322483999</c:v>
                </c:pt>
                <c:pt idx="1815">
                  <c:v>-75972.982819224606</c:v>
                </c:pt>
                <c:pt idx="1816">
                  <c:v>-103341.980946909</c:v>
                </c:pt>
                <c:pt idx="1817">
                  <c:v>-95543.358397522796</c:v>
                </c:pt>
                <c:pt idx="1818">
                  <c:v>-34060.192800099401</c:v>
                </c:pt>
                <c:pt idx="1819">
                  <c:v>-21515.235335484598</c:v>
                </c:pt>
                <c:pt idx="1820">
                  <c:v>-1028.6106647382301</c:v>
                </c:pt>
                <c:pt idx="1821">
                  <c:v>36860.256616115599</c:v>
                </c:pt>
                <c:pt idx="1822">
                  <c:v>-67734.122590836094</c:v>
                </c:pt>
                <c:pt idx="1823">
                  <c:v>-33933.1260717306</c:v>
                </c:pt>
                <c:pt idx="1824">
                  <c:v>-60340.924139854302</c:v>
                </c:pt>
                <c:pt idx="1825">
                  <c:v>-57605.007007633598</c:v>
                </c:pt>
                <c:pt idx="1826">
                  <c:v>-62219.741682118998</c:v>
                </c:pt>
                <c:pt idx="1827">
                  <c:v>-81101.753585631493</c:v>
                </c:pt>
                <c:pt idx="1828">
                  <c:v>-58820.579982393603</c:v>
                </c:pt>
                <c:pt idx="1829">
                  <c:v>19075.567111566001</c:v>
                </c:pt>
                <c:pt idx="1830">
                  <c:v>49426.634826130598</c:v>
                </c:pt>
                <c:pt idx="1831">
                  <c:v>-258046.762015177</c:v>
                </c:pt>
                <c:pt idx="1832">
                  <c:v>-717287.59630432003</c:v>
                </c:pt>
                <c:pt idx="1833">
                  <c:v>-321558.77805858402</c:v>
                </c:pt>
                <c:pt idx="1834">
                  <c:v>-47960.327046706101</c:v>
                </c:pt>
                <c:pt idx="1835">
                  <c:v>40661.374343137599</c:v>
                </c:pt>
                <c:pt idx="1836">
                  <c:v>-33498.159567143703</c:v>
                </c:pt>
                <c:pt idx="1837">
                  <c:v>-222520.642370671</c:v>
                </c:pt>
                <c:pt idx="1838">
                  <c:v>-24931.581430008999</c:v>
                </c:pt>
                <c:pt idx="1839">
                  <c:v>-36405.174942833197</c:v>
                </c:pt>
                <c:pt idx="1840">
                  <c:v>-8238.2906963962596</c:v>
                </c:pt>
                <c:pt idx="1841">
                  <c:v>-17998.189841143299</c:v>
                </c:pt>
                <c:pt idx="1842">
                  <c:v>30676.556954770102</c:v>
                </c:pt>
                <c:pt idx="1843">
                  <c:v>-57723.398923776302</c:v>
                </c:pt>
                <c:pt idx="1844">
                  <c:v>-22974.639260795098</c:v>
                </c:pt>
                <c:pt idx="1845">
                  <c:v>-70863.123750038896</c:v>
                </c:pt>
                <c:pt idx="1846">
                  <c:v>4386.0168557319003</c:v>
                </c:pt>
                <c:pt idx="1847">
                  <c:v>41682.854015382203</c:v>
                </c:pt>
                <c:pt idx="1848">
                  <c:v>-36387.622766812201</c:v>
                </c:pt>
                <c:pt idx="1849">
                  <c:v>-55671.021536024899</c:v>
                </c:pt>
                <c:pt idx="1850">
                  <c:v>-84017.115940911593</c:v>
                </c:pt>
                <c:pt idx="1851">
                  <c:v>-68001.758927175906</c:v>
                </c:pt>
                <c:pt idx="1852">
                  <c:v>-84384.358916878497</c:v>
                </c:pt>
                <c:pt idx="1853">
                  <c:v>-47435.012159112899</c:v>
                </c:pt>
                <c:pt idx="1854">
                  <c:v>-62889.356188083002</c:v>
                </c:pt>
                <c:pt idx="1855">
                  <c:v>-50007.423633336002</c:v>
                </c:pt>
                <c:pt idx="1856">
                  <c:v>-17935.248925481599</c:v>
                </c:pt>
                <c:pt idx="1857">
                  <c:v>-85141.272960032293</c:v>
                </c:pt>
                <c:pt idx="1858">
                  <c:v>21243.536853632999</c:v>
                </c:pt>
                <c:pt idx="1859">
                  <c:v>44154.205319298599</c:v>
                </c:pt>
                <c:pt idx="1860">
                  <c:v>-73661.035710312906</c:v>
                </c:pt>
                <c:pt idx="1861">
                  <c:v>-68659.067977844796</c:v>
                </c:pt>
                <c:pt idx="1862">
                  <c:v>-85201.129921323503</c:v>
                </c:pt>
                <c:pt idx="1863">
                  <c:v>28411.1430181129</c:v>
                </c:pt>
                <c:pt idx="1864">
                  <c:v>28779.802263162201</c:v>
                </c:pt>
                <c:pt idx="1865">
                  <c:v>65873.675472305593</c:v>
                </c:pt>
                <c:pt idx="1866">
                  <c:v>-64873.546883703602</c:v>
                </c:pt>
                <c:pt idx="1867">
                  <c:v>-116170.995908514</c:v>
                </c:pt>
                <c:pt idx="1868">
                  <c:v>474.42224014362603</c:v>
                </c:pt>
                <c:pt idx="1869">
                  <c:v>-244.43826575571401</c:v>
                </c:pt>
                <c:pt idx="1870">
                  <c:v>24174.0800876639</c:v>
                </c:pt>
                <c:pt idx="1871">
                  <c:v>2241.1114331296599</c:v>
                </c:pt>
                <c:pt idx="1872">
                  <c:v>48500.682924008797</c:v>
                </c:pt>
                <c:pt idx="1873">
                  <c:v>-1710.6881035844599</c:v>
                </c:pt>
                <c:pt idx="1874">
                  <c:v>-27760.917039000698</c:v>
                </c:pt>
                <c:pt idx="1875">
                  <c:v>-45896.562816891797</c:v>
                </c:pt>
                <c:pt idx="1876">
                  <c:v>-15182.2200923399</c:v>
                </c:pt>
                <c:pt idx="1877">
                  <c:v>-40934.111624263198</c:v>
                </c:pt>
                <c:pt idx="1878">
                  <c:v>-40835.743272412401</c:v>
                </c:pt>
                <c:pt idx="1879">
                  <c:v>-72142.0527879164</c:v>
                </c:pt>
                <c:pt idx="1880">
                  <c:v>-54599.057298018997</c:v>
                </c:pt>
                <c:pt idx="1881">
                  <c:v>-18058.872678866599</c:v>
                </c:pt>
                <c:pt idx="1882">
                  <c:v>-126364.462228841</c:v>
                </c:pt>
                <c:pt idx="1883">
                  <c:v>-89181.845719723904</c:v>
                </c:pt>
                <c:pt idx="1884">
                  <c:v>-100794.247517795</c:v>
                </c:pt>
                <c:pt idx="1885">
                  <c:v>-78437.056282003206</c:v>
                </c:pt>
                <c:pt idx="1886">
                  <c:v>6959.3837214663799</c:v>
                </c:pt>
                <c:pt idx="1887">
                  <c:v>-84393.131641216998</c:v>
                </c:pt>
                <c:pt idx="1888">
                  <c:v>-31947.613785743401</c:v>
                </c:pt>
                <c:pt idx="1889">
                  <c:v>-31948.698411190398</c:v>
                </c:pt>
                <c:pt idx="1890">
                  <c:v>-58547.076392834097</c:v>
                </c:pt>
                <c:pt idx="1891">
                  <c:v>-154647.693781295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1-546D-485A-824E-7A2263221CE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06643072"/>
        <c:axId val="806645368"/>
      </c:scatterChart>
      <c:valAx>
        <c:axId val="806643072"/>
        <c:scaling>
          <c:orientation val="maxMin"/>
          <c:max val="190"/>
          <c:min val="1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806645368"/>
        <c:crosses val="autoZero"/>
        <c:crossBetween val="midCat"/>
        <c:majorUnit val="20"/>
      </c:valAx>
      <c:valAx>
        <c:axId val="806645368"/>
        <c:scaling>
          <c:orientation val="minMax"/>
          <c:min val="-750000"/>
        </c:scaling>
        <c:delete val="0"/>
        <c:axPos val="r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ysClr val="windowText" lastClr="000000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806643072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  <c:userShapes r:id="rId4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5352288107024279"/>
          <c:y val="5.1254468714595158E-2"/>
          <c:w val="0.61173500903336075"/>
          <c:h val="0.80172529081856414"/>
        </c:manualLayout>
      </c:layout>
      <c:barChart>
        <c:barDir val="col"/>
        <c:grouping val="stacked"/>
        <c:varyColors val="0"/>
        <c:ser>
          <c:idx val="5"/>
          <c:order val="0"/>
          <c:tx>
            <c:strRef>
              <c:f>CtrlMinusNA!$E$63</c:f>
              <c:strCache>
                <c:ptCount val="1"/>
                <c:pt idx="0">
                  <c:v>13C-1-Gln</c:v>
                </c:pt>
              </c:strCache>
            </c:strRef>
          </c:tx>
          <c:spPr>
            <a:solidFill>
              <a:schemeClr val="bg1">
                <a:lumMod val="50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chemeClr val="accent1">
                  <a:lumMod val="40000"/>
                  <a:lumOff val="60000"/>
                </a:schemeClr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6EF-4CA4-B550-22AF492F3F3D}"/>
              </c:ext>
            </c:extLst>
          </c:dPt>
          <c:dPt>
            <c:idx val="1"/>
            <c:invertIfNegative val="0"/>
            <c:bubble3D val="0"/>
            <c:spPr>
              <a:solidFill>
                <a:srgbClr val="FF99FF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6EF-4CA4-B550-22AF492F3F3D}"/>
              </c:ext>
            </c:extLst>
          </c:dPt>
          <c:cat>
            <c:strRef>
              <c:f>CtrlMinusNA!$F$57:$G$57</c:f>
              <c:strCache>
                <c:ptCount val="2"/>
                <c:pt idx="0">
                  <c:v>MAS98.06</c:v>
                </c:pt>
                <c:pt idx="1">
                  <c:v>MAS98.12</c:v>
                </c:pt>
              </c:strCache>
            </c:strRef>
          </c:cat>
          <c:val>
            <c:numRef>
              <c:f>CtrlMinusNA!$F$63:$G$63</c:f>
              <c:numCache>
                <c:formatCode>0.00E+00</c:formatCode>
                <c:ptCount val="2"/>
                <c:pt idx="0">
                  <c:v>852907.9277818267</c:v>
                </c:pt>
                <c:pt idx="1">
                  <c:v>-369366.711105107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4-86EF-4CA4-B550-22AF492F3F3D}"/>
            </c:ext>
          </c:extLst>
        </c:ser>
        <c:ser>
          <c:idx val="4"/>
          <c:order val="1"/>
          <c:tx>
            <c:strRef>
              <c:f>CtrlMinusNA!$E$62</c:f>
              <c:strCache>
                <c:ptCount val="1"/>
                <c:pt idx="0">
                  <c:v>13C-1-Glu</c:v>
                </c:pt>
              </c:strCache>
            </c:strRef>
          </c:tx>
          <c:spPr>
            <a:pattFill prst="wdDnDiag">
              <a:fgClr>
                <a:schemeClr val="bg1">
                  <a:lumMod val="75000"/>
                </a:schemeClr>
              </a:fgClr>
              <a:bgClr>
                <a:schemeClr val="bg1"/>
              </a:bgClr>
            </a:pattFill>
            <a:ln>
              <a:solidFill>
                <a:schemeClr val="tx1">
                  <a:alpha val="98000"/>
                </a:schemeClr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wdDnDiag">
                <a:fgClr>
                  <a:schemeClr val="accent1">
                    <a:lumMod val="40000"/>
                    <a:lumOff val="60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>
                    <a:alpha val="98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6-86EF-4CA4-B550-22AF492F3F3D}"/>
              </c:ext>
            </c:extLst>
          </c:dPt>
          <c:dPt>
            <c:idx val="1"/>
            <c:invertIfNegative val="0"/>
            <c:bubble3D val="0"/>
            <c:spPr>
              <a:pattFill prst="wdDnDiag">
                <a:fgClr>
                  <a:srgbClr val="FF99FF"/>
                </a:fgClr>
                <a:bgClr>
                  <a:schemeClr val="bg1"/>
                </a:bgClr>
              </a:pattFill>
              <a:ln>
                <a:solidFill>
                  <a:schemeClr val="tx1">
                    <a:alpha val="98000"/>
                  </a:schemeClr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8-86EF-4CA4-B550-22AF492F3F3D}"/>
              </c:ext>
            </c:extLst>
          </c:dPt>
          <c:cat>
            <c:strRef>
              <c:f>CtrlMinusNA!$F$57:$G$57</c:f>
              <c:strCache>
                <c:ptCount val="2"/>
                <c:pt idx="0">
                  <c:v>MAS98.06</c:v>
                </c:pt>
                <c:pt idx="1">
                  <c:v>MAS98.12</c:v>
                </c:pt>
              </c:strCache>
            </c:strRef>
          </c:cat>
          <c:val>
            <c:numRef>
              <c:f>CtrlMinusNA!$F$62:$G$62</c:f>
              <c:numCache>
                <c:formatCode>0.00E+00</c:formatCode>
                <c:ptCount val="2"/>
                <c:pt idx="0">
                  <c:v>633921.84152567841</c:v>
                </c:pt>
                <c:pt idx="1">
                  <c:v>748270.0974929558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9-86EF-4CA4-B550-22AF492F3F3D}"/>
            </c:ext>
          </c:extLst>
        </c:ser>
        <c:ser>
          <c:idx val="6"/>
          <c:order val="2"/>
          <c:tx>
            <c:strRef>
              <c:f>CtrlMinusNA!$E$64</c:f>
              <c:strCache>
                <c:ptCount val="1"/>
                <c:pt idx="0">
                  <c:v>13C-2-Lac</c:v>
                </c:pt>
              </c:strCache>
            </c:strRef>
          </c:tx>
          <c:spPr>
            <a:pattFill prst="wdUpDiag">
              <a:fgClr>
                <a:schemeClr val="bg1">
                  <a:lumMod val="50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wdUpDiag">
                <a:fgClr>
                  <a:schemeClr val="accent1">
                    <a:lumMod val="40000"/>
                    <a:lumOff val="60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86EF-4CA4-B550-22AF492F3F3D}"/>
              </c:ext>
            </c:extLst>
          </c:dPt>
          <c:dPt>
            <c:idx val="1"/>
            <c:invertIfNegative val="0"/>
            <c:bubble3D val="0"/>
            <c:spPr>
              <a:pattFill prst="wdUpDiag">
                <a:fgClr>
                  <a:srgbClr val="FF99FF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86EF-4CA4-B550-22AF492F3F3D}"/>
              </c:ext>
            </c:extLst>
          </c:dPt>
          <c:cat>
            <c:strRef>
              <c:f>CtrlMinusNA!$F$57:$G$57</c:f>
              <c:strCache>
                <c:ptCount val="2"/>
                <c:pt idx="0">
                  <c:v>MAS98.06</c:v>
                </c:pt>
                <c:pt idx="1">
                  <c:v>MAS98.12</c:v>
                </c:pt>
              </c:strCache>
            </c:strRef>
          </c:cat>
          <c:val>
            <c:numRef>
              <c:f>CtrlMinusNA!$F$64:$G$64</c:f>
              <c:numCache>
                <c:formatCode>0.00E+00</c:formatCode>
                <c:ptCount val="2"/>
                <c:pt idx="0">
                  <c:v>889895.08576355001</c:v>
                </c:pt>
                <c:pt idx="1">
                  <c:v>3166838.99603230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E-86EF-4CA4-B550-22AF492F3F3D}"/>
            </c:ext>
          </c:extLst>
        </c:ser>
        <c:ser>
          <c:idx val="1"/>
          <c:order val="3"/>
          <c:tx>
            <c:strRef>
              <c:f>CtrlMinusNA!$E$58</c:f>
              <c:strCache>
                <c:ptCount val="1"/>
                <c:pt idx="0">
                  <c:v>13C-1-Lac</c:v>
                </c:pt>
              </c:strCache>
            </c:strRef>
          </c:tx>
          <c:spPr>
            <a:pattFill prst="wdUp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wdUpDiag">
                <a:fgClr>
                  <a:srgbClr val="0070C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0-86EF-4CA4-B550-22AF492F3F3D}"/>
              </c:ext>
            </c:extLst>
          </c:dPt>
          <c:dPt>
            <c:idx val="1"/>
            <c:invertIfNegative val="0"/>
            <c:bubble3D val="0"/>
            <c:spPr>
              <a:pattFill prst="wdUpDiag">
                <a:fgClr>
                  <a:srgbClr val="FF00FF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2-86EF-4CA4-B550-22AF492F3F3D}"/>
              </c:ext>
            </c:extLst>
          </c:dPt>
          <c:cat>
            <c:strRef>
              <c:f>CtrlMinusNA!$F$57:$G$57</c:f>
              <c:strCache>
                <c:ptCount val="2"/>
                <c:pt idx="0">
                  <c:v>MAS98.06</c:v>
                </c:pt>
                <c:pt idx="1">
                  <c:v>MAS98.12</c:v>
                </c:pt>
              </c:strCache>
            </c:strRef>
          </c:cat>
          <c:val>
            <c:numRef>
              <c:f>CtrlMinusNA!$F$58:$G$58</c:f>
              <c:numCache>
                <c:formatCode>0.00E+00</c:formatCode>
                <c:ptCount val="2"/>
                <c:pt idx="0">
                  <c:v>1865129.7737188039</c:v>
                </c:pt>
                <c:pt idx="1">
                  <c:v>4266248.71359754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3-86EF-4CA4-B550-22AF492F3F3D}"/>
            </c:ext>
          </c:extLst>
        </c:ser>
        <c:ser>
          <c:idx val="3"/>
          <c:order val="4"/>
          <c:tx>
            <c:strRef>
              <c:f>CtrlMinusNA!$E$61</c:f>
              <c:strCache>
                <c:ptCount val="1"/>
                <c:pt idx="0">
                  <c:v>13C-1-Ala</c:v>
                </c:pt>
              </c:strCache>
            </c:strRef>
          </c:tx>
          <c:spPr>
            <a:pattFill prst="dkVert">
              <a:fgClr>
                <a:schemeClr val="bg1">
                  <a:lumMod val="65000"/>
                </a:schemeClr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dkVert">
                <a:fgClr>
                  <a:srgbClr val="0070C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5-86EF-4CA4-B550-22AF492F3F3D}"/>
              </c:ext>
            </c:extLst>
          </c:dPt>
          <c:dPt>
            <c:idx val="1"/>
            <c:invertIfNegative val="0"/>
            <c:bubble3D val="0"/>
            <c:spPr>
              <a:pattFill prst="dkVert">
                <a:fgClr>
                  <a:srgbClr val="FF00FF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7-86EF-4CA4-B550-22AF492F3F3D}"/>
              </c:ext>
            </c:extLst>
          </c:dPt>
          <c:cat>
            <c:strRef>
              <c:f>CtrlMinusNA!$F$57:$G$57</c:f>
              <c:strCache>
                <c:ptCount val="2"/>
                <c:pt idx="0">
                  <c:v>MAS98.06</c:v>
                </c:pt>
                <c:pt idx="1">
                  <c:v>MAS98.12</c:v>
                </c:pt>
              </c:strCache>
            </c:strRef>
          </c:cat>
          <c:val>
            <c:numRef>
              <c:f>CtrlMinusNA!$F$61:$G$61</c:f>
              <c:numCache>
                <c:formatCode>0.00E+00</c:formatCode>
                <c:ptCount val="2"/>
                <c:pt idx="0">
                  <c:v>1276389.2096666868</c:v>
                </c:pt>
                <c:pt idx="1">
                  <c:v>1040030.09649735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86EF-4CA4-B550-22AF492F3F3D}"/>
            </c:ext>
          </c:extLst>
        </c:ser>
        <c:ser>
          <c:idx val="7"/>
          <c:order val="5"/>
          <c:tx>
            <c:strRef>
              <c:f>CtrlMinusNA!$E$65</c:f>
              <c:strCache>
                <c:ptCount val="1"/>
                <c:pt idx="0">
                  <c:v>13C-5-Pro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lgCheck">
                <a:fgClr>
                  <a:schemeClr val="accent1">
                    <a:lumMod val="40000"/>
                    <a:lumOff val="60000"/>
                  </a:schemeClr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A-86EF-4CA4-B550-22AF492F3F3D}"/>
              </c:ext>
            </c:extLst>
          </c:dPt>
          <c:dPt>
            <c:idx val="1"/>
            <c:invertIfNegative val="0"/>
            <c:bubble3D val="0"/>
            <c:spPr>
              <a:pattFill prst="lgCheck">
                <a:fgClr>
                  <a:srgbClr val="FF99FF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C-86EF-4CA4-B550-22AF492F3F3D}"/>
              </c:ext>
            </c:extLst>
          </c:dPt>
          <c:cat>
            <c:strRef>
              <c:f>CtrlMinusNA!$F$57:$G$57</c:f>
              <c:strCache>
                <c:ptCount val="2"/>
                <c:pt idx="0">
                  <c:v>MAS98.06</c:v>
                </c:pt>
                <c:pt idx="1">
                  <c:v>MAS98.12</c:v>
                </c:pt>
              </c:strCache>
            </c:strRef>
          </c:cat>
          <c:val>
            <c:numRef>
              <c:f>CtrlMinusNA!$F$65:$G$65</c:f>
              <c:numCache>
                <c:formatCode>0.00E+00</c:formatCode>
                <c:ptCount val="2"/>
                <c:pt idx="0">
                  <c:v>2002049.286668998</c:v>
                </c:pt>
                <c:pt idx="1">
                  <c:v>200377.1072301414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D-86EF-4CA4-B550-22AF492F3F3D}"/>
            </c:ext>
          </c:extLst>
        </c:ser>
        <c:ser>
          <c:idx val="2"/>
          <c:order val="6"/>
          <c:tx>
            <c:strRef>
              <c:f>CtrlMinusNA!$E$59</c:f>
              <c:strCache>
                <c:ptCount val="1"/>
                <c:pt idx="0">
                  <c:v>13C-5-Glu</c:v>
                </c:pt>
              </c:strCache>
            </c:strRef>
          </c:tx>
          <c:spPr>
            <a:pattFill prst="wd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wdDnDiag">
                <a:fgClr>
                  <a:srgbClr val="0070C0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F-86EF-4CA4-B550-22AF492F3F3D}"/>
              </c:ext>
            </c:extLst>
          </c:dPt>
          <c:dPt>
            <c:idx val="1"/>
            <c:invertIfNegative val="0"/>
            <c:bubble3D val="0"/>
            <c:spPr>
              <a:pattFill prst="wdDnDiag">
                <a:fgClr>
                  <a:srgbClr val="FF00FF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1-86EF-4CA4-B550-22AF492F3F3D}"/>
              </c:ext>
            </c:extLst>
          </c:dPt>
          <c:cat>
            <c:strRef>
              <c:f>CtrlMinusNA!$F$57:$G$57</c:f>
              <c:strCache>
                <c:ptCount val="2"/>
                <c:pt idx="0">
                  <c:v>MAS98.06</c:v>
                </c:pt>
                <c:pt idx="1">
                  <c:v>MAS98.12</c:v>
                </c:pt>
              </c:strCache>
            </c:strRef>
          </c:cat>
          <c:val>
            <c:numRef>
              <c:f>CtrlMinusNA!$F$59:$G$59</c:f>
              <c:numCache>
                <c:formatCode>0.00E+00</c:formatCode>
                <c:ptCount val="2"/>
                <c:pt idx="0">
                  <c:v>2764452.0072927591</c:v>
                </c:pt>
                <c:pt idx="1">
                  <c:v>5240614.69439284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2-86EF-4CA4-B550-22AF492F3F3D}"/>
            </c:ext>
          </c:extLst>
        </c:ser>
        <c:ser>
          <c:idx val="0"/>
          <c:order val="7"/>
          <c:tx>
            <c:strRef>
              <c:f>CtrlMinusNA!$E$60</c:f>
              <c:strCache>
                <c:ptCount val="1"/>
                <c:pt idx="0">
                  <c:v>13C-5-Gln</c:v>
                </c:pt>
              </c:strCache>
            </c:strRef>
          </c:tx>
          <c:spPr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70C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4-86EF-4CA4-B550-22AF492F3F3D}"/>
              </c:ext>
            </c:extLst>
          </c:dPt>
          <c:dPt>
            <c:idx val="1"/>
            <c:invertIfNegative val="0"/>
            <c:bubble3D val="0"/>
            <c:spPr>
              <a:solidFill>
                <a:srgbClr val="FF00FF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26-86EF-4CA4-B550-22AF492F3F3D}"/>
              </c:ext>
            </c:extLst>
          </c:dPt>
          <c:cat>
            <c:strRef>
              <c:f>CtrlMinusNA!$F$57:$G$57</c:f>
              <c:strCache>
                <c:ptCount val="2"/>
                <c:pt idx="0">
                  <c:v>MAS98.06</c:v>
                </c:pt>
                <c:pt idx="1">
                  <c:v>MAS98.12</c:v>
                </c:pt>
              </c:strCache>
            </c:strRef>
          </c:cat>
          <c:val>
            <c:numRef>
              <c:f>CtrlMinusNA!$F$60:$G$60</c:f>
              <c:numCache>
                <c:formatCode>0.00E+00</c:formatCode>
                <c:ptCount val="2"/>
                <c:pt idx="0">
                  <c:v>11966258.649174333</c:v>
                </c:pt>
                <c:pt idx="1">
                  <c:v>1912485.96439947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27-86EF-4CA4-B550-22AF492F3F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6"/>
        <c:overlap val="100"/>
        <c:axId val="541669440"/>
        <c:axId val="541666160"/>
      </c:barChart>
      <c:catAx>
        <c:axId val="5416694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0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41666160"/>
        <c:crosses val="autoZero"/>
        <c:auto val="1"/>
        <c:lblAlgn val="ctr"/>
        <c:lblOffset val="100"/>
        <c:tickLblSkip val="1"/>
        <c:noMultiLvlLbl val="0"/>
      </c:catAx>
      <c:valAx>
        <c:axId val="541666160"/>
        <c:scaling>
          <c:orientation val="minMax"/>
          <c:max val="23000000"/>
          <c:min val="0"/>
        </c:scaling>
        <c:delete val="0"/>
        <c:axPos val="l"/>
        <c:numFmt formatCode="0.0E+00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541669440"/>
        <c:crossesAt val="1"/>
        <c:crossBetween val="between"/>
      </c:valAx>
      <c:spPr>
        <a:noFill/>
        <a:ln w="127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rawings/_rels/vmlDrawing1.vml.rels><?xml version="1.0" encoding="UTF-8" standalone="yes"?>
<Relationships xmlns="http://schemas.openxmlformats.org/package/2006/relationships"><Relationship Id="rId8" Type="http://schemas.openxmlformats.org/officeDocument/2006/relationships/image" Target="../media/image8.emf"/><Relationship Id="rId3" Type="http://schemas.openxmlformats.org/officeDocument/2006/relationships/image" Target="../media/image3.emf"/><Relationship Id="rId7" Type="http://schemas.openxmlformats.org/officeDocument/2006/relationships/image" Target="../media/image7.emf"/><Relationship Id="rId12" Type="http://schemas.openxmlformats.org/officeDocument/2006/relationships/image" Target="../media/image12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6" Type="http://schemas.openxmlformats.org/officeDocument/2006/relationships/image" Target="../media/image6.emf"/><Relationship Id="rId11" Type="http://schemas.openxmlformats.org/officeDocument/2006/relationships/image" Target="../media/image11.emf"/><Relationship Id="rId5" Type="http://schemas.openxmlformats.org/officeDocument/2006/relationships/image" Target="../media/image5.emf"/><Relationship Id="rId10" Type="http://schemas.openxmlformats.org/officeDocument/2006/relationships/image" Target="../media/image10.emf"/><Relationship Id="rId4" Type="http://schemas.openxmlformats.org/officeDocument/2006/relationships/image" Target="../media/image4.emf"/><Relationship Id="rId9" Type="http://schemas.openxmlformats.org/officeDocument/2006/relationships/image" Target="../media/image9.emf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6695</cdr:x>
      <cdr:y>0.51079</cdr:y>
    </cdr:from>
    <cdr:to>
      <cdr:x>0.57565</cdr:x>
      <cdr:y>0.68491</cdr:y>
    </cdr:to>
    <cdr:sp macro="" textlink="">
      <cdr:nvSpPr>
        <cdr:cNvPr id="2" name="TextBox 9"/>
        <cdr:cNvSpPr txBox="1"/>
      </cdr:nvSpPr>
      <cdr:spPr>
        <a:xfrm xmlns:a="http://schemas.openxmlformats.org/drawingml/2006/main">
          <a:off x="1344159" y="722301"/>
          <a:ext cx="312906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nb-NO" sz="10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**</a:t>
          </a:r>
          <a:endParaRPr lang="en-US" sz="10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58679</cdr:x>
      <cdr:y>0.5296</cdr:y>
    </cdr:from>
    <cdr:to>
      <cdr:x>0.67321</cdr:x>
      <cdr:y>0.70372</cdr:y>
    </cdr:to>
    <cdr:sp macro="" textlink="">
      <cdr:nvSpPr>
        <cdr:cNvPr id="3" name="TextBox 9"/>
        <cdr:cNvSpPr txBox="1"/>
      </cdr:nvSpPr>
      <cdr:spPr>
        <a:xfrm xmlns:a="http://schemas.openxmlformats.org/drawingml/2006/main">
          <a:off x="1689125" y="748912"/>
          <a:ext cx="248786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nb-NO" sz="10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*</a:t>
          </a:r>
          <a:endParaRPr lang="en-US" sz="10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56499</cdr:x>
      <cdr:y>0.29108</cdr:y>
    </cdr:from>
    <cdr:to>
      <cdr:x>0.73485</cdr:x>
      <cdr:y>0.57402</cdr:y>
    </cdr:to>
    <cdr:sp macro="" textlink="">
      <cdr:nvSpPr>
        <cdr:cNvPr id="4" name="TextBox 37"/>
        <cdr:cNvSpPr txBox="1"/>
      </cdr:nvSpPr>
      <cdr:spPr>
        <a:xfrm xmlns:a="http://schemas.openxmlformats.org/drawingml/2006/main">
          <a:off x="1626388" y="411610"/>
          <a:ext cx="488950" cy="400110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9144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nb-NO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1</a:t>
          </a:r>
          <a:r>
            <a:rPr lang="nb-NO" sz="10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-</a:t>
          </a:r>
          <a:r>
            <a:rPr lang="nb-NO" sz="1000" baseline="300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13</a:t>
          </a:r>
          <a:r>
            <a:rPr lang="nb-NO" sz="10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C</a:t>
          </a:r>
        </a:p>
        <a:p xmlns:a="http://schemas.openxmlformats.org/drawingml/2006/main">
          <a:pPr algn="ctr"/>
          <a:r>
            <a:rPr lang="nb-NO" sz="1000" dirty="0" err="1" smtClean="0">
              <a:latin typeface="Times New Roman" panose="02020603050405020304" pitchFamily="18" charset="0"/>
              <a:cs typeface="Times New Roman" panose="02020603050405020304" pitchFamily="18" charset="0"/>
            </a:rPr>
            <a:t>Gln</a:t>
          </a:r>
          <a:endParaRPr lang="en-US" sz="10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63985</cdr:x>
      <cdr:y>0.48111</cdr:y>
    </cdr:from>
    <cdr:to>
      <cdr:x>0.7468</cdr:x>
      <cdr:y>0.62697</cdr:y>
    </cdr:to>
    <cdr:sp macro="" textlink="">
      <cdr:nvSpPr>
        <cdr:cNvPr id="2" name="TextBox 37"/>
        <cdr:cNvSpPr txBox="1"/>
      </cdr:nvSpPr>
      <cdr:spPr>
        <a:xfrm xmlns:a="http://schemas.openxmlformats.org/drawingml/2006/main">
          <a:off x="2925413" y="1319783"/>
          <a:ext cx="488950" cy="400110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nb-NO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5</a:t>
          </a:r>
          <a:r>
            <a:rPr lang="nb-NO" sz="10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-</a:t>
          </a:r>
          <a:r>
            <a:rPr lang="nb-NO" sz="1000" baseline="300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13</a:t>
          </a:r>
          <a:r>
            <a:rPr lang="nb-NO" sz="10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C</a:t>
          </a:r>
        </a:p>
        <a:p xmlns:a="http://schemas.openxmlformats.org/drawingml/2006/main">
          <a:pPr algn="ctr"/>
          <a:r>
            <a:rPr lang="nb-NO" sz="10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Pro</a:t>
          </a:r>
          <a:endParaRPr lang="en-US" sz="10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27132</cdr:x>
      <cdr:y>0.25037</cdr:y>
    </cdr:from>
    <cdr:to>
      <cdr:x>0.35378</cdr:x>
      <cdr:y>0.34013</cdr:y>
    </cdr:to>
    <cdr:sp macro="" textlink="">
      <cdr:nvSpPr>
        <cdr:cNvPr id="3" name="TextBox 9"/>
        <cdr:cNvSpPr txBox="1"/>
      </cdr:nvSpPr>
      <cdr:spPr>
        <a:xfrm xmlns:a="http://schemas.openxmlformats.org/drawingml/2006/main">
          <a:off x="1240468" y="686828"/>
          <a:ext cx="377027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nb-NO" sz="1000" dirty="0" smtClean="0">
              <a:latin typeface="Times New Roman" panose="02020603050405020304" pitchFamily="18" charset="0"/>
              <a:cs typeface="Times New Roman" panose="02020603050405020304" pitchFamily="18" charset="0"/>
            </a:rPr>
            <a:t>*  *</a:t>
          </a:r>
          <a:endParaRPr lang="en-US" sz="10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  <cdr:relSizeAnchor xmlns:cdr="http://schemas.openxmlformats.org/drawingml/2006/chartDrawing">
    <cdr:from>
      <cdr:x>0.23354</cdr:x>
      <cdr:y>0.21522</cdr:y>
    </cdr:from>
    <cdr:to>
      <cdr:x>0.28726</cdr:x>
      <cdr:y>0.30497</cdr:y>
    </cdr:to>
    <cdr:sp macro="" textlink="">
      <cdr:nvSpPr>
        <cdr:cNvPr id="4" name="TextBox 9"/>
        <cdr:cNvSpPr txBox="1"/>
      </cdr:nvSpPr>
      <cdr:spPr>
        <a:xfrm xmlns:a="http://schemas.openxmlformats.org/drawingml/2006/main">
          <a:off x="1067751" y="590379"/>
          <a:ext cx="245580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none" rtlCol="0">
          <a:spAutoFit/>
        </a:bodyPr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nb-NO" sz="1000" dirty="0">
              <a:latin typeface="Times New Roman" panose="02020603050405020304" pitchFamily="18" charset="0"/>
              <a:cs typeface="Times New Roman" panose="02020603050405020304" pitchFamily="18" charset="0"/>
            </a:rPr>
            <a:t>^</a:t>
          </a:r>
          <a:endParaRPr lang="en-US" sz="1000" dirty="0">
            <a:latin typeface="Times New Roman" panose="02020603050405020304" pitchFamily="18" charset="0"/>
            <a:cs typeface="Times New Roman" panose="02020603050405020304" pitchFamily="18" charset="0"/>
          </a:endParaRPr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83074" y="1414125"/>
            <a:ext cx="8874840" cy="3008266"/>
          </a:xfrm>
        </p:spPr>
        <p:txBody>
          <a:bodyPr anchor="b"/>
          <a:lstStyle>
            <a:lvl1pPr algn="ctr">
              <a:defRPr sz="6851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05124" y="4538401"/>
            <a:ext cx="7830741" cy="2086184"/>
          </a:xfrm>
        </p:spPr>
        <p:txBody>
          <a:bodyPr/>
          <a:lstStyle>
            <a:lvl1pPr marL="0" indent="0" algn="ctr">
              <a:buNone/>
              <a:defRPr sz="2740"/>
            </a:lvl1pPr>
            <a:lvl2pPr marL="522031" indent="0" algn="ctr">
              <a:buNone/>
              <a:defRPr sz="2284"/>
            </a:lvl2pPr>
            <a:lvl3pPr marL="1044062" indent="0" algn="ctr">
              <a:buNone/>
              <a:defRPr sz="2055"/>
            </a:lvl3pPr>
            <a:lvl4pPr marL="1566093" indent="0" algn="ctr">
              <a:buNone/>
              <a:defRPr sz="1827"/>
            </a:lvl4pPr>
            <a:lvl5pPr marL="2088124" indent="0" algn="ctr">
              <a:buNone/>
              <a:defRPr sz="1827"/>
            </a:lvl5pPr>
            <a:lvl6pPr marL="2610155" indent="0" algn="ctr">
              <a:buNone/>
              <a:defRPr sz="1827"/>
            </a:lvl6pPr>
            <a:lvl7pPr marL="3132186" indent="0" algn="ctr">
              <a:buNone/>
              <a:defRPr sz="1827"/>
            </a:lvl7pPr>
            <a:lvl8pPr marL="3654217" indent="0" algn="ctr">
              <a:buNone/>
              <a:defRPr sz="1827"/>
            </a:lvl8pPr>
            <a:lvl9pPr marL="4176248" indent="0" algn="ctr">
              <a:buNone/>
              <a:defRPr sz="1827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12B07E-CECC-418F-822F-7AC4C578B67A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9B5F1-BE3F-44B4-B30C-3C0C6B250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17113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12B07E-CECC-418F-822F-7AC4C578B67A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9B5F1-BE3F-44B4-B30C-3C0C6B250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95665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471833" y="460041"/>
            <a:ext cx="2251338" cy="732264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717818" y="460041"/>
            <a:ext cx="6623502" cy="7322647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12B07E-CECC-418F-822F-7AC4C578B67A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9B5F1-BE3F-44B4-B30C-3C0C6B250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68497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12B07E-CECC-418F-822F-7AC4C578B67A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9B5F1-BE3F-44B4-B30C-3C0C6B250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28867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2381" y="2154193"/>
            <a:ext cx="9005352" cy="3594317"/>
          </a:xfrm>
        </p:spPr>
        <p:txBody>
          <a:bodyPr anchor="b"/>
          <a:lstStyle>
            <a:lvl1pPr>
              <a:defRPr sz="6851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2381" y="5782513"/>
            <a:ext cx="9005352" cy="1890166"/>
          </a:xfrm>
        </p:spPr>
        <p:txBody>
          <a:bodyPr/>
          <a:lstStyle>
            <a:lvl1pPr marL="0" indent="0">
              <a:buNone/>
              <a:defRPr sz="2740">
                <a:solidFill>
                  <a:schemeClr val="tx1"/>
                </a:solidFill>
              </a:defRPr>
            </a:lvl1pPr>
            <a:lvl2pPr marL="522031" indent="0">
              <a:buNone/>
              <a:defRPr sz="2284">
                <a:solidFill>
                  <a:schemeClr val="tx1">
                    <a:tint val="75000"/>
                  </a:schemeClr>
                </a:solidFill>
              </a:defRPr>
            </a:lvl2pPr>
            <a:lvl3pPr marL="1044062" indent="0">
              <a:buNone/>
              <a:defRPr sz="2055">
                <a:solidFill>
                  <a:schemeClr val="tx1">
                    <a:tint val="75000"/>
                  </a:schemeClr>
                </a:solidFill>
              </a:defRPr>
            </a:lvl3pPr>
            <a:lvl4pPr marL="1566093" indent="0">
              <a:buNone/>
              <a:defRPr sz="1827">
                <a:solidFill>
                  <a:schemeClr val="tx1">
                    <a:tint val="75000"/>
                  </a:schemeClr>
                </a:solidFill>
              </a:defRPr>
            </a:lvl4pPr>
            <a:lvl5pPr marL="2088124" indent="0">
              <a:buNone/>
              <a:defRPr sz="1827">
                <a:solidFill>
                  <a:schemeClr val="tx1">
                    <a:tint val="75000"/>
                  </a:schemeClr>
                </a:solidFill>
              </a:defRPr>
            </a:lvl5pPr>
            <a:lvl6pPr marL="2610155" indent="0">
              <a:buNone/>
              <a:defRPr sz="1827">
                <a:solidFill>
                  <a:schemeClr val="tx1">
                    <a:tint val="75000"/>
                  </a:schemeClr>
                </a:solidFill>
              </a:defRPr>
            </a:lvl6pPr>
            <a:lvl7pPr marL="3132186" indent="0">
              <a:buNone/>
              <a:defRPr sz="1827">
                <a:solidFill>
                  <a:schemeClr val="tx1">
                    <a:tint val="75000"/>
                  </a:schemeClr>
                </a:solidFill>
              </a:defRPr>
            </a:lvl7pPr>
            <a:lvl8pPr marL="3654217" indent="0">
              <a:buNone/>
              <a:defRPr sz="1827">
                <a:solidFill>
                  <a:schemeClr val="tx1">
                    <a:tint val="75000"/>
                  </a:schemeClr>
                </a:solidFill>
              </a:defRPr>
            </a:lvl8pPr>
            <a:lvl9pPr marL="4176248" indent="0">
              <a:buNone/>
              <a:defRPr sz="182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12B07E-CECC-418F-822F-7AC4C578B67A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9B5F1-BE3F-44B4-B30C-3C0C6B250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6552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17818" y="2300203"/>
            <a:ext cx="4437420" cy="5482485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85750" y="2300203"/>
            <a:ext cx="4437420" cy="5482485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12B07E-CECC-418F-822F-7AC4C578B67A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9B5F1-BE3F-44B4-B30C-3C0C6B250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67546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9178" y="460043"/>
            <a:ext cx="9005352" cy="1670148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9179" y="2118188"/>
            <a:ext cx="4417027" cy="1038091"/>
          </a:xfrm>
        </p:spPr>
        <p:txBody>
          <a:bodyPr anchor="b"/>
          <a:lstStyle>
            <a:lvl1pPr marL="0" indent="0">
              <a:buNone/>
              <a:defRPr sz="2740" b="1"/>
            </a:lvl1pPr>
            <a:lvl2pPr marL="522031" indent="0">
              <a:buNone/>
              <a:defRPr sz="2284" b="1"/>
            </a:lvl2pPr>
            <a:lvl3pPr marL="1044062" indent="0">
              <a:buNone/>
              <a:defRPr sz="2055" b="1"/>
            </a:lvl3pPr>
            <a:lvl4pPr marL="1566093" indent="0">
              <a:buNone/>
              <a:defRPr sz="1827" b="1"/>
            </a:lvl4pPr>
            <a:lvl5pPr marL="2088124" indent="0">
              <a:buNone/>
              <a:defRPr sz="1827" b="1"/>
            </a:lvl5pPr>
            <a:lvl6pPr marL="2610155" indent="0">
              <a:buNone/>
              <a:defRPr sz="1827" b="1"/>
            </a:lvl6pPr>
            <a:lvl7pPr marL="3132186" indent="0">
              <a:buNone/>
              <a:defRPr sz="1827" b="1"/>
            </a:lvl7pPr>
            <a:lvl8pPr marL="3654217" indent="0">
              <a:buNone/>
              <a:defRPr sz="1827" b="1"/>
            </a:lvl8pPr>
            <a:lvl9pPr marL="4176248" indent="0">
              <a:buNone/>
              <a:defRPr sz="1827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19179" y="3156278"/>
            <a:ext cx="4417027" cy="4642411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285751" y="2118188"/>
            <a:ext cx="4438780" cy="1038091"/>
          </a:xfrm>
        </p:spPr>
        <p:txBody>
          <a:bodyPr anchor="b"/>
          <a:lstStyle>
            <a:lvl1pPr marL="0" indent="0">
              <a:buNone/>
              <a:defRPr sz="2740" b="1"/>
            </a:lvl1pPr>
            <a:lvl2pPr marL="522031" indent="0">
              <a:buNone/>
              <a:defRPr sz="2284" b="1"/>
            </a:lvl2pPr>
            <a:lvl3pPr marL="1044062" indent="0">
              <a:buNone/>
              <a:defRPr sz="2055" b="1"/>
            </a:lvl3pPr>
            <a:lvl4pPr marL="1566093" indent="0">
              <a:buNone/>
              <a:defRPr sz="1827" b="1"/>
            </a:lvl4pPr>
            <a:lvl5pPr marL="2088124" indent="0">
              <a:buNone/>
              <a:defRPr sz="1827" b="1"/>
            </a:lvl5pPr>
            <a:lvl6pPr marL="2610155" indent="0">
              <a:buNone/>
              <a:defRPr sz="1827" b="1"/>
            </a:lvl6pPr>
            <a:lvl7pPr marL="3132186" indent="0">
              <a:buNone/>
              <a:defRPr sz="1827" b="1"/>
            </a:lvl7pPr>
            <a:lvl8pPr marL="3654217" indent="0">
              <a:buNone/>
              <a:defRPr sz="1827" b="1"/>
            </a:lvl8pPr>
            <a:lvl9pPr marL="4176248" indent="0">
              <a:buNone/>
              <a:defRPr sz="1827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285751" y="3156278"/>
            <a:ext cx="4438780" cy="4642411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12B07E-CECC-418F-822F-7AC4C578B67A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9B5F1-BE3F-44B4-B30C-3C0C6B250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600066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12B07E-CECC-418F-822F-7AC4C578B67A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9B5F1-BE3F-44B4-B30C-3C0C6B250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57508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12B07E-CECC-418F-822F-7AC4C578B67A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9B5F1-BE3F-44B4-B30C-3C0C6B250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3918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9178" y="576051"/>
            <a:ext cx="3367490" cy="2016178"/>
          </a:xfrm>
        </p:spPr>
        <p:txBody>
          <a:bodyPr anchor="b"/>
          <a:lstStyle>
            <a:lvl1pPr>
              <a:defRPr sz="3654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438780" y="1244112"/>
            <a:ext cx="5285750" cy="6140542"/>
          </a:xfrm>
        </p:spPr>
        <p:txBody>
          <a:bodyPr/>
          <a:lstStyle>
            <a:lvl1pPr>
              <a:defRPr sz="3654"/>
            </a:lvl1pPr>
            <a:lvl2pPr>
              <a:defRPr sz="3197"/>
            </a:lvl2pPr>
            <a:lvl3pPr>
              <a:defRPr sz="2740"/>
            </a:lvl3pPr>
            <a:lvl4pPr>
              <a:defRPr sz="2284"/>
            </a:lvl4pPr>
            <a:lvl5pPr>
              <a:defRPr sz="2284"/>
            </a:lvl5pPr>
            <a:lvl6pPr>
              <a:defRPr sz="2284"/>
            </a:lvl6pPr>
            <a:lvl7pPr>
              <a:defRPr sz="2284"/>
            </a:lvl7pPr>
            <a:lvl8pPr>
              <a:defRPr sz="2284"/>
            </a:lvl8pPr>
            <a:lvl9pPr>
              <a:defRPr sz="2284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19178" y="2592229"/>
            <a:ext cx="3367490" cy="4802425"/>
          </a:xfrm>
        </p:spPr>
        <p:txBody>
          <a:bodyPr/>
          <a:lstStyle>
            <a:lvl1pPr marL="0" indent="0">
              <a:buNone/>
              <a:defRPr sz="1827"/>
            </a:lvl1pPr>
            <a:lvl2pPr marL="522031" indent="0">
              <a:buNone/>
              <a:defRPr sz="1599"/>
            </a:lvl2pPr>
            <a:lvl3pPr marL="1044062" indent="0">
              <a:buNone/>
              <a:defRPr sz="1370"/>
            </a:lvl3pPr>
            <a:lvl4pPr marL="1566093" indent="0">
              <a:buNone/>
              <a:defRPr sz="1142"/>
            </a:lvl4pPr>
            <a:lvl5pPr marL="2088124" indent="0">
              <a:buNone/>
              <a:defRPr sz="1142"/>
            </a:lvl5pPr>
            <a:lvl6pPr marL="2610155" indent="0">
              <a:buNone/>
              <a:defRPr sz="1142"/>
            </a:lvl6pPr>
            <a:lvl7pPr marL="3132186" indent="0">
              <a:buNone/>
              <a:defRPr sz="1142"/>
            </a:lvl7pPr>
            <a:lvl8pPr marL="3654217" indent="0">
              <a:buNone/>
              <a:defRPr sz="1142"/>
            </a:lvl8pPr>
            <a:lvl9pPr marL="4176248" indent="0">
              <a:buNone/>
              <a:defRPr sz="1142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12B07E-CECC-418F-822F-7AC4C578B67A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9B5F1-BE3F-44B4-B30C-3C0C6B250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52943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9178" y="576051"/>
            <a:ext cx="3367490" cy="2016178"/>
          </a:xfrm>
        </p:spPr>
        <p:txBody>
          <a:bodyPr anchor="b"/>
          <a:lstStyle>
            <a:lvl1pPr>
              <a:defRPr sz="3654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438780" y="1244112"/>
            <a:ext cx="5285750" cy="6140542"/>
          </a:xfrm>
        </p:spPr>
        <p:txBody>
          <a:bodyPr anchor="t"/>
          <a:lstStyle>
            <a:lvl1pPr marL="0" indent="0">
              <a:buNone/>
              <a:defRPr sz="3654"/>
            </a:lvl1pPr>
            <a:lvl2pPr marL="522031" indent="0">
              <a:buNone/>
              <a:defRPr sz="3197"/>
            </a:lvl2pPr>
            <a:lvl3pPr marL="1044062" indent="0">
              <a:buNone/>
              <a:defRPr sz="2740"/>
            </a:lvl3pPr>
            <a:lvl4pPr marL="1566093" indent="0">
              <a:buNone/>
              <a:defRPr sz="2284"/>
            </a:lvl4pPr>
            <a:lvl5pPr marL="2088124" indent="0">
              <a:buNone/>
              <a:defRPr sz="2284"/>
            </a:lvl5pPr>
            <a:lvl6pPr marL="2610155" indent="0">
              <a:buNone/>
              <a:defRPr sz="2284"/>
            </a:lvl6pPr>
            <a:lvl7pPr marL="3132186" indent="0">
              <a:buNone/>
              <a:defRPr sz="2284"/>
            </a:lvl7pPr>
            <a:lvl8pPr marL="3654217" indent="0">
              <a:buNone/>
              <a:defRPr sz="2284"/>
            </a:lvl8pPr>
            <a:lvl9pPr marL="4176248" indent="0">
              <a:buNone/>
              <a:defRPr sz="2284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719178" y="2592229"/>
            <a:ext cx="3367490" cy="4802425"/>
          </a:xfrm>
        </p:spPr>
        <p:txBody>
          <a:bodyPr/>
          <a:lstStyle>
            <a:lvl1pPr marL="0" indent="0">
              <a:buNone/>
              <a:defRPr sz="1827"/>
            </a:lvl1pPr>
            <a:lvl2pPr marL="522031" indent="0">
              <a:buNone/>
              <a:defRPr sz="1599"/>
            </a:lvl2pPr>
            <a:lvl3pPr marL="1044062" indent="0">
              <a:buNone/>
              <a:defRPr sz="1370"/>
            </a:lvl3pPr>
            <a:lvl4pPr marL="1566093" indent="0">
              <a:buNone/>
              <a:defRPr sz="1142"/>
            </a:lvl4pPr>
            <a:lvl5pPr marL="2088124" indent="0">
              <a:buNone/>
              <a:defRPr sz="1142"/>
            </a:lvl5pPr>
            <a:lvl6pPr marL="2610155" indent="0">
              <a:buNone/>
              <a:defRPr sz="1142"/>
            </a:lvl6pPr>
            <a:lvl7pPr marL="3132186" indent="0">
              <a:buNone/>
              <a:defRPr sz="1142"/>
            </a:lvl7pPr>
            <a:lvl8pPr marL="3654217" indent="0">
              <a:buNone/>
              <a:defRPr sz="1142"/>
            </a:lvl8pPr>
            <a:lvl9pPr marL="4176248" indent="0">
              <a:buNone/>
              <a:defRPr sz="1142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412B07E-CECC-418F-822F-7AC4C578B67A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E9B5F1-BE3F-44B4-B30C-3C0C6B250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284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717818" y="460043"/>
            <a:ext cx="9005352" cy="167014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17818" y="2300203"/>
            <a:ext cx="9005352" cy="5482485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717818" y="8008709"/>
            <a:ext cx="2349222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37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12B07E-CECC-418F-822F-7AC4C578B67A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458578" y="8008709"/>
            <a:ext cx="3523833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37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7373948" y="8008709"/>
            <a:ext cx="2349222" cy="46004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37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E9B5F1-BE3F-44B4-B30C-3C0C6B250EF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40842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044062" rtl="0" eaLnBrk="1" latinLnBrk="0" hangingPunct="1">
        <a:lnSpc>
          <a:spcPct val="90000"/>
        </a:lnSpc>
        <a:spcBef>
          <a:spcPct val="0"/>
        </a:spcBef>
        <a:buNone/>
        <a:defRPr sz="502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61015" indent="-261015" algn="l" defTabSz="1044062" rtl="0" eaLnBrk="1" latinLnBrk="0" hangingPunct="1">
        <a:lnSpc>
          <a:spcPct val="90000"/>
        </a:lnSpc>
        <a:spcBef>
          <a:spcPts val="1142"/>
        </a:spcBef>
        <a:buFont typeface="Arial" panose="020B0604020202020204" pitchFamily="34" charset="0"/>
        <a:buChar char="•"/>
        <a:defRPr sz="3197" kern="1200">
          <a:solidFill>
            <a:schemeClr val="tx1"/>
          </a:solidFill>
          <a:latin typeface="+mn-lt"/>
          <a:ea typeface="+mn-ea"/>
          <a:cs typeface="+mn-cs"/>
        </a:defRPr>
      </a:lvl1pPr>
      <a:lvl2pPr marL="783046" indent="-261015" algn="l" defTabSz="1044062" rtl="0" eaLnBrk="1" latinLnBrk="0" hangingPunct="1">
        <a:lnSpc>
          <a:spcPct val="90000"/>
        </a:lnSpc>
        <a:spcBef>
          <a:spcPts val="571"/>
        </a:spcBef>
        <a:buFont typeface="Arial" panose="020B0604020202020204" pitchFamily="34" charset="0"/>
        <a:buChar char="•"/>
        <a:defRPr sz="2740" kern="1200">
          <a:solidFill>
            <a:schemeClr val="tx1"/>
          </a:solidFill>
          <a:latin typeface="+mn-lt"/>
          <a:ea typeface="+mn-ea"/>
          <a:cs typeface="+mn-cs"/>
        </a:defRPr>
      </a:lvl2pPr>
      <a:lvl3pPr marL="1305077" indent="-261015" algn="l" defTabSz="1044062" rtl="0" eaLnBrk="1" latinLnBrk="0" hangingPunct="1">
        <a:lnSpc>
          <a:spcPct val="90000"/>
        </a:lnSpc>
        <a:spcBef>
          <a:spcPts val="571"/>
        </a:spcBef>
        <a:buFont typeface="Arial" panose="020B0604020202020204" pitchFamily="34" charset="0"/>
        <a:buChar char="•"/>
        <a:defRPr sz="2284" kern="1200">
          <a:solidFill>
            <a:schemeClr val="tx1"/>
          </a:solidFill>
          <a:latin typeface="+mn-lt"/>
          <a:ea typeface="+mn-ea"/>
          <a:cs typeface="+mn-cs"/>
        </a:defRPr>
      </a:lvl3pPr>
      <a:lvl4pPr marL="1827108" indent="-261015" algn="l" defTabSz="1044062" rtl="0" eaLnBrk="1" latinLnBrk="0" hangingPunct="1">
        <a:lnSpc>
          <a:spcPct val="90000"/>
        </a:lnSpc>
        <a:spcBef>
          <a:spcPts val="571"/>
        </a:spcBef>
        <a:buFont typeface="Arial" panose="020B0604020202020204" pitchFamily="34" charset="0"/>
        <a:buChar char="•"/>
        <a:defRPr sz="2055" kern="1200">
          <a:solidFill>
            <a:schemeClr val="tx1"/>
          </a:solidFill>
          <a:latin typeface="+mn-lt"/>
          <a:ea typeface="+mn-ea"/>
          <a:cs typeface="+mn-cs"/>
        </a:defRPr>
      </a:lvl4pPr>
      <a:lvl5pPr marL="2349139" indent="-261015" algn="l" defTabSz="1044062" rtl="0" eaLnBrk="1" latinLnBrk="0" hangingPunct="1">
        <a:lnSpc>
          <a:spcPct val="90000"/>
        </a:lnSpc>
        <a:spcBef>
          <a:spcPts val="571"/>
        </a:spcBef>
        <a:buFont typeface="Arial" panose="020B0604020202020204" pitchFamily="34" charset="0"/>
        <a:buChar char="•"/>
        <a:defRPr sz="2055" kern="1200">
          <a:solidFill>
            <a:schemeClr val="tx1"/>
          </a:solidFill>
          <a:latin typeface="+mn-lt"/>
          <a:ea typeface="+mn-ea"/>
          <a:cs typeface="+mn-cs"/>
        </a:defRPr>
      </a:lvl5pPr>
      <a:lvl6pPr marL="2871170" indent="-261015" algn="l" defTabSz="1044062" rtl="0" eaLnBrk="1" latinLnBrk="0" hangingPunct="1">
        <a:lnSpc>
          <a:spcPct val="90000"/>
        </a:lnSpc>
        <a:spcBef>
          <a:spcPts val="571"/>
        </a:spcBef>
        <a:buFont typeface="Arial" panose="020B0604020202020204" pitchFamily="34" charset="0"/>
        <a:buChar char="•"/>
        <a:defRPr sz="2055" kern="1200">
          <a:solidFill>
            <a:schemeClr val="tx1"/>
          </a:solidFill>
          <a:latin typeface="+mn-lt"/>
          <a:ea typeface="+mn-ea"/>
          <a:cs typeface="+mn-cs"/>
        </a:defRPr>
      </a:lvl6pPr>
      <a:lvl7pPr marL="3393201" indent="-261015" algn="l" defTabSz="1044062" rtl="0" eaLnBrk="1" latinLnBrk="0" hangingPunct="1">
        <a:lnSpc>
          <a:spcPct val="90000"/>
        </a:lnSpc>
        <a:spcBef>
          <a:spcPts val="571"/>
        </a:spcBef>
        <a:buFont typeface="Arial" panose="020B0604020202020204" pitchFamily="34" charset="0"/>
        <a:buChar char="•"/>
        <a:defRPr sz="2055" kern="1200">
          <a:solidFill>
            <a:schemeClr val="tx1"/>
          </a:solidFill>
          <a:latin typeface="+mn-lt"/>
          <a:ea typeface="+mn-ea"/>
          <a:cs typeface="+mn-cs"/>
        </a:defRPr>
      </a:lvl7pPr>
      <a:lvl8pPr marL="3915232" indent="-261015" algn="l" defTabSz="1044062" rtl="0" eaLnBrk="1" latinLnBrk="0" hangingPunct="1">
        <a:lnSpc>
          <a:spcPct val="90000"/>
        </a:lnSpc>
        <a:spcBef>
          <a:spcPts val="571"/>
        </a:spcBef>
        <a:buFont typeface="Arial" panose="020B0604020202020204" pitchFamily="34" charset="0"/>
        <a:buChar char="•"/>
        <a:defRPr sz="2055" kern="1200">
          <a:solidFill>
            <a:schemeClr val="tx1"/>
          </a:solidFill>
          <a:latin typeface="+mn-lt"/>
          <a:ea typeface="+mn-ea"/>
          <a:cs typeface="+mn-cs"/>
        </a:defRPr>
      </a:lvl8pPr>
      <a:lvl9pPr marL="4437263" indent="-261015" algn="l" defTabSz="1044062" rtl="0" eaLnBrk="1" latinLnBrk="0" hangingPunct="1">
        <a:lnSpc>
          <a:spcPct val="90000"/>
        </a:lnSpc>
        <a:spcBef>
          <a:spcPts val="571"/>
        </a:spcBef>
        <a:buFont typeface="Arial" panose="020B0604020202020204" pitchFamily="34" charset="0"/>
        <a:buChar char="•"/>
        <a:defRPr sz="2055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044062" rtl="0" eaLnBrk="1" latinLnBrk="0" hangingPunct="1">
        <a:defRPr sz="2055" kern="1200">
          <a:solidFill>
            <a:schemeClr val="tx1"/>
          </a:solidFill>
          <a:latin typeface="+mn-lt"/>
          <a:ea typeface="+mn-ea"/>
          <a:cs typeface="+mn-cs"/>
        </a:defRPr>
      </a:lvl1pPr>
      <a:lvl2pPr marL="522031" algn="l" defTabSz="1044062" rtl="0" eaLnBrk="1" latinLnBrk="0" hangingPunct="1">
        <a:defRPr sz="2055" kern="1200">
          <a:solidFill>
            <a:schemeClr val="tx1"/>
          </a:solidFill>
          <a:latin typeface="+mn-lt"/>
          <a:ea typeface="+mn-ea"/>
          <a:cs typeface="+mn-cs"/>
        </a:defRPr>
      </a:lvl2pPr>
      <a:lvl3pPr marL="1044062" algn="l" defTabSz="1044062" rtl="0" eaLnBrk="1" latinLnBrk="0" hangingPunct="1">
        <a:defRPr sz="2055" kern="1200">
          <a:solidFill>
            <a:schemeClr val="tx1"/>
          </a:solidFill>
          <a:latin typeface="+mn-lt"/>
          <a:ea typeface="+mn-ea"/>
          <a:cs typeface="+mn-cs"/>
        </a:defRPr>
      </a:lvl3pPr>
      <a:lvl4pPr marL="1566093" algn="l" defTabSz="1044062" rtl="0" eaLnBrk="1" latinLnBrk="0" hangingPunct="1">
        <a:defRPr sz="2055" kern="1200">
          <a:solidFill>
            <a:schemeClr val="tx1"/>
          </a:solidFill>
          <a:latin typeface="+mn-lt"/>
          <a:ea typeface="+mn-ea"/>
          <a:cs typeface="+mn-cs"/>
        </a:defRPr>
      </a:lvl4pPr>
      <a:lvl5pPr marL="2088124" algn="l" defTabSz="1044062" rtl="0" eaLnBrk="1" latinLnBrk="0" hangingPunct="1">
        <a:defRPr sz="2055" kern="1200">
          <a:solidFill>
            <a:schemeClr val="tx1"/>
          </a:solidFill>
          <a:latin typeface="+mn-lt"/>
          <a:ea typeface="+mn-ea"/>
          <a:cs typeface="+mn-cs"/>
        </a:defRPr>
      </a:lvl5pPr>
      <a:lvl6pPr marL="2610155" algn="l" defTabSz="1044062" rtl="0" eaLnBrk="1" latinLnBrk="0" hangingPunct="1">
        <a:defRPr sz="2055" kern="1200">
          <a:solidFill>
            <a:schemeClr val="tx1"/>
          </a:solidFill>
          <a:latin typeface="+mn-lt"/>
          <a:ea typeface="+mn-ea"/>
          <a:cs typeface="+mn-cs"/>
        </a:defRPr>
      </a:lvl6pPr>
      <a:lvl7pPr marL="3132186" algn="l" defTabSz="1044062" rtl="0" eaLnBrk="1" latinLnBrk="0" hangingPunct="1">
        <a:defRPr sz="2055" kern="1200">
          <a:solidFill>
            <a:schemeClr val="tx1"/>
          </a:solidFill>
          <a:latin typeface="+mn-lt"/>
          <a:ea typeface="+mn-ea"/>
          <a:cs typeface="+mn-cs"/>
        </a:defRPr>
      </a:lvl7pPr>
      <a:lvl8pPr marL="3654217" algn="l" defTabSz="1044062" rtl="0" eaLnBrk="1" latinLnBrk="0" hangingPunct="1">
        <a:defRPr sz="2055" kern="1200">
          <a:solidFill>
            <a:schemeClr val="tx1"/>
          </a:solidFill>
          <a:latin typeface="+mn-lt"/>
          <a:ea typeface="+mn-ea"/>
          <a:cs typeface="+mn-cs"/>
        </a:defRPr>
      </a:lvl8pPr>
      <a:lvl9pPr marL="4176248" algn="l" defTabSz="1044062" rtl="0" eaLnBrk="1" latinLnBrk="0" hangingPunct="1">
        <a:defRPr sz="2055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13" Type="http://schemas.openxmlformats.org/officeDocument/2006/relationships/chart" Target="../charts/chart3.xml"/><Relationship Id="rId18" Type="http://schemas.openxmlformats.org/officeDocument/2006/relationships/image" Target="../media/image6.emf"/><Relationship Id="rId26" Type="http://schemas.openxmlformats.org/officeDocument/2006/relationships/image" Target="../media/image10.emf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8.bin"/><Relationship Id="rId7" Type="http://schemas.openxmlformats.org/officeDocument/2006/relationships/oleObject" Target="../embeddings/oleObject3.bin"/><Relationship Id="rId12" Type="http://schemas.openxmlformats.org/officeDocument/2006/relationships/chart" Target="../charts/chart2.xml"/><Relationship Id="rId17" Type="http://schemas.openxmlformats.org/officeDocument/2006/relationships/oleObject" Target="../embeddings/oleObject6.bin"/><Relationship Id="rId25" Type="http://schemas.openxmlformats.org/officeDocument/2006/relationships/oleObject" Target="../embeddings/oleObject10.bin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5.emf"/><Relationship Id="rId20" Type="http://schemas.openxmlformats.org/officeDocument/2006/relationships/image" Target="../media/image7.emf"/><Relationship Id="rId29" Type="http://schemas.openxmlformats.org/officeDocument/2006/relationships/oleObject" Target="../embeddings/oleObject12.bin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chart" Target="../charts/chart1.xml"/><Relationship Id="rId24" Type="http://schemas.openxmlformats.org/officeDocument/2006/relationships/image" Target="../media/image9.emf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5.bin"/><Relationship Id="rId23" Type="http://schemas.openxmlformats.org/officeDocument/2006/relationships/oleObject" Target="../embeddings/oleObject9.bin"/><Relationship Id="rId28" Type="http://schemas.openxmlformats.org/officeDocument/2006/relationships/image" Target="../media/image11.emf"/><Relationship Id="rId10" Type="http://schemas.openxmlformats.org/officeDocument/2006/relationships/image" Target="../media/image4.emf"/><Relationship Id="rId19" Type="http://schemas.openxmlformats.org/officeDocument/2006/relationships/oleObject" Target="../embeddings/oleObject7.bin"/><Relationship Id="rId31" Type="http://schemas.openxmlformats.org/officeDocument/2006/relationships/chart" Target="../charts/chart5.xml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Relationship Id="rId14" Type="http://schemas.openxmlformats.org/officeDocument/2006/relationships/chart" Target="../charts/chart4.xml"/><Relationship Id="rId22" Type="http://schemas.openxmlformats.org/officeDocument/2006/relationships/image" Target="../media/image8.emf"/><Relationship Id="rId27" Type="http://schemas.openxmlformats.org/officeDocument/2006/relationships/oleObject" Target="../embeddings/oleObject11.bin"/><Relationship Id="rId30" Type="http://schemas.openxmlformats.org/officeDocument/2006/relationships/image" Target="../media/image1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1" name="Objec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01719239"/>
              </p:ext>
            </p:extLst>
          </p:nvPr>
        </p:nvGraphicFramePr>
        <p:xfrm>
          <a:off x="8592763" y="6268049"/>
          <a:ext cx="1829980" cy="2235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74" name="SPW 13.0 Graph" r:id="rId3" imgW="2170137" imgH="2651662" progId="SigmaPlotGraphicObject.12">
                  <p:embed/>
                </p:oleObj>
              </mc:Choice>
              <mc:Fallback>
                <p:oleObj name="SPW 13.0 Graph" r:id="rId3" imgW="2170137" imgH="2651662" progId="SigmaPlotGraphicObjec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592763" y="6268049"/>
                        <a:ext cx="1829980" cy="2235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383149750"/>
              </p:ext>
            </p:extLst>
          </p:nvPr>
        </p:nvGraphicFramePr>
        <p:xfrm>
          <a:off x="6665288" y="6271451"/>
          <a:ext cx="1888674" cy="2235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75" name="SPW 13.0 Graph" r:id="rId5" imgW="2238709" imgH="2650220" progId="SigmaPlotGraphicObject.12">
                  <p:embed/>
                </p:oleObj>
              </mc:Choice>
              <mc:Fallback>
                <p:oleObj name="SPW 13.0 Graph" r:id="rId5" imgW="2238709" imgH="2650220" progId="SigmaPlotGraphicObjec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665288" y="6271451"/>
                        <a:ext cx="1888674" cy="2235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4399070"/>
              </p:ext>
            </p:extLst>
          </p:nvPr>
        </p:nvGraphicFramePr>
        <p:xfrm>
          <a:off x="4716785" y="6272994"/>
          <a:ext cx="1841792" cy="22356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76" name="SPW 13.0 Graph" r:id="rId7" imgW="2182407" imgH="2650220" progId="SigmaPlotGraphicObject.12">
                  <p:embed/>
                </p:oleObj>
              </mc:Choice>
              <mc:Fallback>
                <p:oleObj name="SPW 13.0 Graph" r:id="rId7" imgW="2182407" imgH="2650220" progId="SigmaPlotGraphicObjec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716785" y="6272994"/>
                        <a:ext cx="1841792" cy="22356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87789042"/>
              </p:ext>
            </p:extLst>
          </p:nvPr>
        </p:nvGraphicFramePr>
        <p:xfrm>
          <a:off x="2801445" y="6271982"/>
          <a:ext cx="1882423" cy="22347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77" name="SPW 13.0 Graph" r:id="rId9" imgW="2231130" imgH="2647336" progId="SigmaPlotGraphicObject.12">
                  <p:embed/>
                </p:oleObj>
              </mc:Choice>
              <mc:Fallback>
                <p:oleObj name="SPW 13.0 Graph" r:id="rId9" imgW="2231130" imgH="2647336" progId="SigmaPlotGraphicObjec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801445" y="6271982"/>
                        <a:ext cx="1882423" cy="223479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95" name="Group 294"/>
          <p:cNvGrpSpPr/>
          <p:nvPr/>
        </p:nvGrpSpPr>
        <p:grpSpPr>
          <a:xfrm>
            <a:off x="5530645" y="240516"/>
            <a:ext cx="4561742" cy="3166463"/>
            <a:chOff x="5049263" y="-100933"/>
            <a:chExt cx="4561742" cy="3166463"/>
          </a:xfrm>
        </p:grpSpPr>
        <p:sp>
          <p:nvSpPr>
            <p:cNvPr id="398" name="Rectangle 397"/>
            <p:cNvSpPr/>
            <p:nvPr/>
          </p:nvSpPr>
          <p:spPr>
            <a:xfrm>
              <a:off x="5333941" y="500130"/>
              <a:ext cx="323850" cy="2387600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99" name="Straight Arrow Connector 398"/>
            <p:cNvCxnSpPr/>
            <p:nvPr/>
          </p:nvCxnSpPr>
          <p:spPr>
            <a:xfrm flipV="1">
              <a:off x="5589895" y="1668530"/>
              <a:ext cx="374650" cy="13970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00" name="TextBox 399"/>
            <p:cNvSpPr txBox="1"/>
            <p:nvPr/>
          </p:nvSpPr>
          <p:spPr>
            <a:xfrm>
              <a:off x="7167597" y="1693930"/>
              <a:ext cx="495650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nb-NO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nb-NO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lang="nb-NO" sz="1000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  <a:r>
                <a:rPr lang="nb-NO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 </a:t>
              </a:r>
            </a:p>
            <a:p>
              <a:pPr algn="ctr"/>
              <a:r>
                <a:rPr lang="nb-NO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Lac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1" name="TextBox 400"/>
            <p:cNvSpPr txBox="1"/>
            <p:nvPr/>
          </p:nvSpPr>
          <p:spPr>
            <a:xfrm>
              <a:off x="6712708" y="-100933"/>
              <a:ext cx="1204176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MAS98.12</a:t>
              </a:r>
              <a:endParaRPr lang="en-US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402" name="Group 401"/>
            <p:cNvGrpSpPr/>
            <p:nvPr/>
          </p:nvGrpSpPr>
          <p:grpSpPr>
            <a:xfrm>
              <a:off x="5964545" y="348492"/>
              <a:ext cx="2872734" cy="1414096"/>
              <a:chOff x="5964545" y="348492"/>
              <a:chExt cx="2872734" cy="1414096"/>
            </a:xfrm>
          </p:grpSpPr>
          <p:graphicFrame>
            <p:nvGraphicFramePr>
              <p:cNvPr id="405" name="Chart 404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212088432"/>
                  </p:ext>
                </p:extLst>
              </p:nvPr>
            </p:nvGraphicFramePr>
            <p:xfrm>
              <a:off x="5964545" y="348492"/>
              <a:ext cx="2872734" cy="1414096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1"/>
              </a:graphicData>
            </a:graphic>
          </p:graphicFrame>
          <p:sp>
            <p:nvSpPr>
              <p:cNvPr id="406" name="TextBox 405"/>
              <p:cNvSpPr txBox="1"/>
              <p:nvPr/>
            </p:nvSpPr>
            <p:spPr>
              <a:xfrm>
                <a:off x="6421568" y="433808"/>
                <a:ext cx="495649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-</a:t>
                </a:r>
                <a:r>
                  <a:rPr lang="nb-NO" sz="10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</a:t>
                </a:r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 </a:t>
                </a:r>
              </a:p>
              <a:p>
                <a:pPr algn="ctr"/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lu</a:t>
                </a:r>
                <a:endPara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7" name="TextBox 9"/>
              <p:cNvSpPr txBox="1"/>
              <p:nvPr/>
            </p:nvSpPr>
            <p:spPr>
              <a:xfrm>
                <a:off x="6192576" y="909084"/>
                <a:ext cx="2487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  <a:endPara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8" name="TextBox 9"/>
              <p:cNvSpPr txBox="1"/>
              <p:nvPr/>
            </p:nvSpPr>
            <p:spPr>
              <a:xfrm>
                <a:off x="6420607" y="898223"/>
                <a:ext cx="2487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  <a:endPara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9" name="TextBox 408"/>
              <p:cNvSpPr txBox="1"/>
              <p:nvPr/>
            </p:nvSpPr>
            <p:spPr>
              <a:xfrm>
                <a:off x="5979055" y="392878"/>
                <a:ext cx="48895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b-NO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r>
                  <a:rPr lang="nb-NO" sz="10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</a:t>
                </a:r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  <a:p>
                <a:pPr algn="ctr"/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ac</a:t>
                </a:r>
                <a:endPara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10" name="Rectangle 409"/>
              <p:cNvSpPr/>
              <p:nvPr/>
            </p:nvSpPr>
            <p:spPr>
              <a:xfrm>
                <a:off x="6050172" y="356473"/>
                <a:ext cx="2730500" cy="1275652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  <a:prstDash val="sysDot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aphicFrame>
          <p:nvGraphicFramePr>
            <p:cNvPr id="403" name="Chart 402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747736389"/>
                </p:ext>
              </p:extLst>
            </p:nvPr>
          </p:nvGraphicFramePr>
          <p:xfrm>
            <a:off x="5049263" y="322330"/>
            <a:ext cx="4561742" cy="274320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2"/>
            </a:graphicData>
          </a:graphic>
        </p:graphicFrame>
        <p:cxnSp>
          <p:nvCxnSpPr>
            <p:cNvPr id="404" name="Straight Arrow Connector 403"/>
            <p:cNvCxnSpPr/>
            <p:nvPr/>
          </p:nvCxnSpPr>
          <p:spPr>
            <a:xfrm>
              <a:off x="7548563" y="1883569"/>
              <a:ext cx="185737" cy="45244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81" name="TextBox 380"/>
          <p:cNvSpPr txBox="1"/>
          <p:nvPr/>
        </p:nvSpPr>
        <p:spPr>
          <a:xfrm>
            <a:off x="2168094" y="225635"/>
            <a:ext cx="12041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AS98.06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82" name="Group 381"/>
          <p:cNvGrpSpPr/>
          <p:nvPr/>
        </p:nvGrpSpPr>
        <p:grpSpPr>
          <a:xfrm>
            <a:off x="1376565" y="734327"/>
            <a:ext cx="2878595" cy="1449290"/>
            <a:chOff x="1152702" y="392878"/>
            <a:chExt cx="2878595" cy="1449290"/>
          </a:xfrm>
        </p:grpSpPr>
        <p:graphicFrame>
          <p:nvGraphicFramePr>
            <p:cNvPr id="387" name="Chart 38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015918179"/>
                </p:ext>
              </p:extLst>
            </p:nvPr>
          </p:nvGraphicFramePr>
          <p:xfrm>
            <a:off x="1152702" y="428072"/>
            <a:ext cx="2878595" cy="1414096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3"/>
            </a:graphicData>
          </a:graphic>
        </p:graphicFrame>
        <p:grpSp>
          <p:nvGrpSpPr>
            <p:cNvPr id="388" name="Group 387"/>
            <p:cNvGrpSpPr/>
            <p:nvPr/>
          </p:nvGrpSpPr>
          <p:grpSpPr>
            <a:xfrm>
              <a:off x="1489075" y="394134"/>
              <a:ext cx="1390093" cy="861246"/>
              <a:chOff x="1489075" y="394134"/>
              <a:chExt cx="1390093" cy="861246"/>
            </a:xfrm>
          </p:grpSpPr>
          <p:sp>
            <p:nvSpPr>
              <p:cNvPr id="393" name="TextBox 392"/>
              <p:cNvSpPr txBox="1"/>
              <p:nvPr/>
            </p:nvSpPr>
            <p:spPr>
              <a:xfrm>
                <a:off x="1489075" y="544580"/>
                <a:ext cx="48895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-</a:t>
                </a:r>
                <a:r>
                  <a:rPr lang="nb-NO" sz="10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</a:t>
                </a:r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  <a:p>
                <a:pPr algn="ctr"/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lu</a:t>
                </a:r>
                <a:endPara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4" name="TextBox 9"/>
              <p:cNvSpPr txBox="1"/>
              <p:nvPr/>
            </p:nvSpPr>
            <p:spPr>
              <a:xfrm>
                <a:off x="1609157" y="1009159"/>
                <a:ext cx="248786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</a:t>
                </a:r>
                <a:endPara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5" name="TextBox 394"/>
              <p:cNvSpPr txBox="1"/>
              <p:nvPr/>
            </p:nvSpPr>
            <p:spPr>
              <a:xfrm>
                <a:off x="2101037" y="394134"/>
                <a:ext cx="48895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-</a:t>
                </a:r>
                <a:r>
                  <a:rPr lang="nb-NO" sz="10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</a:t>
                </a:r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  <a:p>
                <a:pPr algn="ctr"/>
                <a:r>
                  <a:rPr lang="nb-NO" sz="10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ln</a:t>
                </a:r>
                <a:endPara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6" name="TextBox 9"/>
              <p:cNvSpPr txBox="1"/>
              <p:nvPr/>
            </p:nvSpPr>
            <p:spPr>
              <a:xfrm>
                <a:off x="2147124" y="815372"/>
                <a:ext cx="377027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***</a:t>
                </a:r>
                <a:endPara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7" name="TextBox 396"/>
              <p:cNvSpPr txBox="1"/>
              <p:nvPr/>
            </p:nvSpPr>
            <p:spPr>
              <a:xfrm>
                <a:off x="2390218" y="794244"/>
                <a:ext cx="488950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nb-NO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-</a:t>
                </a:r>
                <a:r>
                  <a:rPr lang="nb-NO" sz="10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</a:t>
                </a:r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</a:t>
                </a:r>
              </a:p>
              <a:p>
                <a:pPr algn="ctr"/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la</a:t>
                </a:r>
                <a:endPara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389" name="TextBox 9"/>
            <p:cNvSpPr txBox="1"/>
            <p:nvPr/>
          </p:nvSpPr>
          <p:spPr>
            <a:xfrm>
              <a:off x="2744948" y="1176985"/>
              <a:ext cx="248786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nb-NO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0" name="TextBox 389"/>
            <p:cNvSpPr txBox="1"/>
            <p:nvPr/>
          </p:nvSpPr>
          <p:spPr>
            <a:xfrm>
              <a:off x="2604497" y="428056"/>
              <a:ext cx="48895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nb-NO" sz="1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nb-NO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lang="nb-NO" sz="1000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  <a:r>
                <a:rPr lang="nb-NO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  <a:p>
              <a:pPr algn="ctr"/>
              <a:r>
                <a:rPr lang="nb-NO" sz="1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u</a:t>
              </a:r>
              <a:endParaRPr lang="en-US" sz="10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391" name="Straight Arrow Connector 390"/>
            <p:cNvCxnSpPr>
              <a:endCxn id="389" idx="0"/>
            </p:cNvCxnSpPr>
            <p:nvPr/>
          </p:nvCxnSpPr>
          <p:spPr>
            <a:xfrm>
              <a:off x="2848972" y="833918"/>
              <a:ext cx="20369" cy="343067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92" name="Rectangle 391"/>
            <p:cNvSpPr/>
            <p:nvPr/>
          </p:nvSpPr>
          <p:spPr>
            <a:xfrm>
              <a:off x="1219200" y="392878"/>
              <a:ext cx="2730500" cy="1275652"/>
            </a:xfrm>
            <a:prstGeom prst="rect">
              <a:avLst/>
            </a:prstGeom>
            <a:noFill/>
            <a:ln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graphicFrame>
        <p:nvGraphicFramePr>
          <p:cNvPr id="384" name="Chart 38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35315961"/>
              </p:ext>
            </p:extLst>
          </p:nvPr>
        </p:nvGraphicFramePr>
        <p:xfrm>
          <a:off x="527024" y="663779"/>
          <a:ext cx="4571999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sp>
        <p:nvSpPr>
          <p:cNvPr id="385" name="Rectangle 384"/>
          <p:cNvSpPr/>
          <p:nvPr/>
        </p:nvSpPr>
        <p:spPr>
          <a:xfrm>
            <a:off x="817471" y="886029"/>
            <a:ext cx="323850" cy="2387600"/>
          </a:xfrm>
          <a:prstGeom prst="rect">
            <a:avLst/>
          </a:prstGeom>
          <a:noFill/>
          <a:ln>
            <a:solidFill>
              <a:schemeClr val="tx1"/>
            </a:solidFill>
            <a:prstDash val="sysDot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6" name="TextBox 9"/>
          <p:cNvSpPr txBox="1"/>
          <p:nvPr/>
        </p:nvSpPr>
        <p:spPr>
          <a:xfrm>
            <a:off x="3587721" y="2265453"/>
            <a:ext cx="24878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nb-NO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*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97" name="Object 29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3106602"/>
              </p:ext>
            </p:extLst>
          </p:nvPr>
        </p:nvGraphicFramePr>
        <p:xfrm>
          <a:off x="6560029" y="3751852"/>
          <a:ext cx="1155700" cy="2409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78" name="SPW 13.0 Graph" r:id="rId15" imgW="1155265" imgH="2409357" progId="SigmaPlotGraphicObject.12">
                  <p:embed/>
                </p:oleObj>
              </mc:Choice>
              <mc:Fallback>
                <p:oleObj name="SPW 13.0 Graph" r:id="rId15" imgW="1155265" imgH="2409357" progId="SigmaPlotGraphicObject.12">
                  <p:embed/>
                  <p:pic>
                    <p:nvPicPr>
                      <p:cNvPr id="127" name="Object 126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6560029" y="3751852"/>
                        <a:ext cx="1155700" cy="2409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8" name="Object 29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46043227"/>
              </p:ext>
            </p:extLst>
          </p:nvPr>
        </p:nvGraphicFramePr>
        <p:xfrm>
          <a:off x="8349993" y="3752640"/>
          <a:ext cx="1187450" cy="2409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79" name="SPW 13.0 Graph" r:id="rId17" imgW="1187025" imgH="2409357" progId="SigmaPlotGraphicObject.12">
                  <p:embed/>
                </p:oleObj>
              </mc:Choice>
              <mc:Fallback>
                <p:oleObj name="SPW 13.0 Graph" r:id="rId17" imgW="1187025" imgH="2409357" progId="SigmaPlotGraphicObject.12">
                  <p:embed/>
                  <p:pic>
                    <p:nvPicPr>
                      <p:cNvPr id="128" name="Object 127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8349993" y="3752640"/>
                        <a:ext cx="1187450" cy="2409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9" name="Object 29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83172359"/>
              </p:ext>
            </p:extLst>
          </p:nvPr>
        </p:nvGraphicFramePr>
        <p:xfrm>
          <a:off x="5534834" y="3756011"/>
          <a:ext cx="1187450" cy="2409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80" name="SPW 13.0 Graph" r:id="rId19" imgW="1187025" imgH="2409357" progId="SigmaPlotGraphicObject.12">
                  <p:embed/>
                </p:oleObj>
              </mc:Choice>
              <mc:Fallback>
                <p:oleObj name="SPW 13.0 Graph" r:id="rId19" imgW="1187025" imgH="2409357" progId="SigmaPlotGraphicObject.12">
                  <p:embed/>
                  <p:pic>
                    <p:nvPicPr>
                      <p:cNvPr id="129" name="Object 128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5534834" y="3756011"/>
                        <a:ext cx="1187450" cy="2409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00" name="TextBox 299"/>
          <p:cNvSpPr txBox="1"/>
          <p:nvPr/>
        </p:nvSpPr>
        <p:spPr>
          <a:xfrm>
            <a:off x="313559" y="163923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02" name="Group 301"/>
          <p:cNvGrpSpPr/>
          <p:nvPr/>
        </p:nvGrpSpPr>
        <p:grpSpPr>
          <a:xfrm>
            <a:off x="4529870" y="3776874"/>
            <a:ext cx="1128713" cy="2409825"/>
            <a:chOff x="3180626" y="3381565"/>
            <a:chExt cx="1128713" cy="2409825"/>
          </a:xfrm>
        </p:grpSpPr>
        <p:graphicFrame>
          <p:nvGraphicFramePr>
            <p:cNvPr id="377" name="Object 376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776832934"/>
                </p:ext>
              </p:extLst>
            </p:nvPr>
          </p:nvGraphicFramePr>
          <p:xfrm>
            <a:off x="3180626" y="3381565"/>
            <a:ext cx="1128713" cy="24098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81" name="SPW 13.0 Graph" r:id="rId21" imgW="1129279" imgH="2409357" progId="SigmaPlotGraphicObject.12">
                    <p:embed/>
                  </p:oleObj>
                </mc:Choice>
                <mc:Fallback>
                  <p:oleObj name="SPW 13.0 Graph" r:id="rId21" imgW="1129279" imgH="2409357" progId="SigmaPlotGraphicObject.12">
                    <p:embed/>
                    <p:pic>
                      <p:nvPicPr>
                        <p:cNvPr id="260" name="Object 259"/>
                        <p:cNvPicPr/>
                        <p:nvPr/>
                      </p:nvPicPr>
                      <p:blipFill>
                        <a:blip r:embed="rId22"/>
                        <a:stretch>
                          <a:fillRect/>
                        </a:stretch>
                      </p:blipFill>
                      <p:spPr>
                        <a:xfrm>
                          <a:off x="3180626" y="3381565"/>
                          <a:ext cx="1128713" cy="24098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378" name="Group 377"/>
            <p:cNvGrpSpPr/>
            <p:nvPr/>
          </p:nvGrpSpPr>
          <p:grpSpPr>
            <a:xfrm>
              <a:off x="3638106" y="3577309"/>
              <a:ext cx="292022" cy="215444"/>
              <a:chOff x="3593534" y="5575668"/>
              <a:chExt cx="292022" cy="215444"/>
            </a:xfrm>
          </p:grpSpPr>
          <p:cxnSp>
            <p:nvCxnSpPr>
              <p:cNvPr id="379" name="Straight Connector 378"/>
              <p:cNvCxnSpPr/>
              <p:nvPr/>
            </p:nvCxnSpPr>
            <p:spPr>
              <a:xfrm>
                <a:off x="3593534" y="5701843"/>
                <a:ext cx="29202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0" name="TextBox 379"/>
              <p:cNvSpPr txBox="1"/>
              <p:nvPr/>
            </p:nvSpPr>
            <p:spPr>
              <a:xfrm>
                <a:off x="3622250" y="5575668"/>
                <a:ext cx="23596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800" dirty="0" smtClean="0"/>
                  <a:t>*</a:t>
                </a:r>
                <a:endParaRPr lang="en-US" sz="800" dirty="0"/>
              </a:p>
            </p:txBody>
          </p:sp>
        </p:grpSp>
      </p:grpSp>
      <p:grpSp>
        <p:nvGrpSpPr>
          <p:cNvPr id="303" name="Group 302"/>
          <p:cNvGrpSpPr/>
          <p:nvPr/>
        </p:nvGrpSpPr>
        <p:grpSpPr>
          <a:xfrm>
            <a:off x="2616567" y="3780762"/>
            <a:ext cx="1187450" cy="2409825"/>
            <a:chOff x="4076419" y="3381565"/>
            <a:chExt cx="1187450" cy="2409825"/>
          </a:xfrm>
        </p:grpSpPr>
        <p:graphicFrame>
          <p:nvGraphicFramePr>
            <p:cNvPr id="373" name="Object 372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887693083"/>
                </p:ext>
              </p:extLst>
            </p:nvPr>
          </p:nvGraphicFramePr>
          <p:xfrm>
            <a:off x="4076419" y="3381565"/>
            <a:ext cx="1187450" cy="24098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82" name="SPW 13.0 Graph" r:id="rId23" imgW="1187025" imgH="2409357" progId="SigmaPlotGraphicObject.12">
                    <p:embed/>
                  </p:oleObj>
                </mc:Choice>
                <mc:Fallback>
                  <p:oleObj name="SPW 13.0 Graph" r:id="rId23" imgW="1187025" imgH="2409357" progId="SigmaPlotGraphicObject.12">
                    <p:embed/>
                    <p:pic>
                      <p:nvPicPr>
                        <p:cNvPr id="256" name="Object 255"/>
                        <p:cNvPicPr/>
                        <p:nvPr/>
                      </p:nvPicPr>
                      <p:blipFill>
                        <a:blip r:embed="rId24"/>
                        <a:stretch>
                          <a:fillRect/>
                        </a:stretch>
                      </p:blipFill>
                      <p:spPr>
                        <a:xfrm>
                          <a:off x="4076419" y="3381565"/>
                          <a:ext cx="1187450" cy="24098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374" name="Group 373"/>
            <p:cNvGrpSpPr/>
            <p:nvPr/>
          </p:nvGrpSpPr>
          <p:grpSpPr>
            <a:xfrm>
              <a:off x="4600912" y="3547062"/>
              <a:ext cx="338554" cy="215444"/>
              <a:chOff x="3567532" y="5546567"/>
              <a:chExt cx="338554" cy="215444"/>
            </a:xfrm>
          </p:grpSpPr>
          <p:cxnSp>
            <p:nvCxnSpPr>
              <p:cNvPr id="375" name="Straight Connector 374"/>
              <p:cNvCxnSpPr/>
              <p:nvPr/>
            </p:nvCxnSpPr>
            <p:spPr>
              <a:xfrm>
                <a:off x="3593534" y="5701843"/>
                <a:ext cx="29202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6" name="TextBox 375"/>
              <p:cNvSpPr txBox="1"/>
              <p:nvPr/>
            </p:nvSpPr>
            <p:spPr>
              <a:xfrm>
                <a:off x="3567532" y="5546567"/>
                <a:ext cx="338554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800" dirty="0" smtClean="0"/>
                  <a:t>***</a:t>
                </a:r>
                <a:endParaRPr lang="en-US" sz="800" dirty="0"/>
              </a:p>
            </p:txBody>
          </p:sp>
        </p:grpSp>
      </p:grpSp>
      <p:grpSp>
        <p:nvGrpSpPr>
          <p:cNvPr id="304" name="Group 303"/>
          <p:cNvGrpSpPr/>
          <p:nvPr/>
        </p:nvGrpSpPr>
        <p:grpSpPr>
          <a:xfrm>
            <a:off x="3504599" y="3773342"/>
            <a:ext cx="1155700" cy="2409825"/>
            <a:chOff x="6952384" y="3383706"/>
            <a:chExt cx="1155700" cy="2409825"/>
          </a:xfrm>
        </p:grpSpPr>
        <p:graphicFrame>
          <p:nvGraphicFramePr>
            <p:cNvPr id="369" name="Object 368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994100896"/>
                </p:ext>
              </p:extLst>
            </p:nvPr>
          </p:nvGraphicFramePr>
          <p:xfrm>
            <a:off x="6952384" y="3383706"/>
            <a:ext cx="1155700" cy="24098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83" name="SPW 13.0 Graph" r:id="rId25" imgW="1155265" imgH="2409357" progId="SigmaPlotGraphicObject.12">
                    <p:embed/>
                  </p:oleObj>
                </mc:Choice>
                <mc:Fallback>
                  <p:oleObj name="SPW 13.0 Graph" r:id="rId25" imgW="1155265" imgH="2409357" progId="SigmaPlotGraphicObject.12">
                    <p:embed/>
                    <p:pic>
                      <p:nvPicPr>
                        <p:cNvPr id="252" name="Object 251"/>
                        <p:cNvPicPr/>
                        <p:nvPr/>
                      </p:nvPicPr>
                      <p:blipFill>
                        <a:blip r:embed="rId26"/>
                        <a:stretch>
                          <a:fillRect/>
                        </a:stretch>
                      </p:blipFill>
                      <p:spPr>
                        <a:xfrm>
                          <a:off x="6952384" y="3383706"/>
                          <a:ext cx="1155700" cy="24098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370" name="Group 369"/>
            <p:cNvGrpSpPr/>
            <p:nvPr/>
          </p:nvGrpSpPr>
          <p:grpSpPr>
            <a:xfrm>
              <a:off x="7469174" y="3573182"/>
              <a:ext cx="292022" cy="215444"/>
              <a:chOff x="3593534" y="5572243"/>
              <a:chExt cx="292022" cy="215444"/>
            </a:xfrm>
          </p:grpSpPr>
          <p:cxnSp>
            <p:nvCxnSpPr>
              <p:cNvPr id="371" name="Straight Connector 370"/>
              <p:cNvCxnSpPr/>
              <p:nvPr/>
            </p:nvCxnSpPr>
            <p:spPr>
              <a:xfrm>
                <a:off x="3593534" y="5701843"/>
                <a:ext cx="29202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72" name="TextBox 371"/>
              <p:cNvSpPr txBox="1"/>
              <p:nvPr/>
            </p:nvSpPr>
            <p:spPr>
              <a:xfrm>
                <a:off x="3593534" y="5572243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800" dirty="0" smtClean="0"/>
                  <a:t>**</a:t>
                </a:r>
                <a:endParaRPr lang="en-US" sz="800" dirty="0"/>
              </a:p>
            </p:txBody>
          </p:sp>
        </p:grpSp>
      </p:grpSp>
      <p:grpSp>
        <p:nvGrpSpPr>
          <p:cNvPr id="305" name="Group 304"/>
          <p:cNvGrpSpPr/>
          <p:nvPr/>
        </p:nvGrpSpPr>
        <p:grpSpPr>
          <a:xfrm>
            <a:off x="7410928" y="3762572"/>
            <a:ext cx="1128713" cy="2409825"/>
            <a:chOff x="7958690" y="3381360"/>
            <a:chExt cx="1128713" cy="2409825"/>
          </a:xfrm>
        </p:grpSpPr>
        <p:graphicFrame>
          <p:nvGraphicFramePr>
            <p:cNvPr id="365" name="Object 364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58163781"/>
                </p:ext>
              </p:extLst>
            </p:nvPr>
          </p:nvGraphicFramePr>
          <p:xfrm>
            <a:off x="7958690" y="3381360"/>
            <a:ext cx="1128713" cy="24098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84" name="SPW 13.0 Graph" r:id="rId27" imgW="1129279" imgH="2409357" progId="SigmaPlotGraphicObject.12">
                    <p:embed/>
                  </p:oleObj>
                </mc:Choice>
                <mc:Fallback>
                  <p:oleObj name="SPW 13.0 Graph" r:id="rId27" imgW="1129279" imgH="2409357" progId="SigmaPlotGraphicObject.12">
                    <p:embed/>
                    <p:pic>
                      <p:nvPicPr>
                        <p:cNvPr id="248" name="Object 247"/>
                        <p:cNvPicPr/>
                        <p:nvPr/>
                      </p:nvPicPr>
                      <p:blipFill>
                        <a:blip r:embed="rId28"/>
                        <a:stretch>
                          <a:fillRect/>
                        </a:stretch>
                      </p:blipFill>
                      <p:spPr>
                        <a:xfrm>
                          <a:off x="7958690" y="3381360"/>
                          <a:ext cx="1128713" cy="24098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366" name="Group 365"/>
            <p:cNvGrpSpPr/>
            <p:nvPr/>
          </p:nvGrpSpPr>
          <p:grpSpPr>
            <a:xfrm>
              <a:off x="8412536" y="3573362"/>
              <a:ext cx="292022" cy="215444"/>
              <a:chOff x="3593534" y="5572243"/>
              <a:chExt cx="292022" cy="215444"/>
            </a:xfrm>
          </p:grpSpPr>
          <p:cxnSp>
            <p:nvCxnSpPr>
              <p:cNvPr id="367" name="Straight Connector 366"/>
              <p:cNvCxnSpPr/>
              <p:nvPr/>
            </p:nvCxnSpPr>
            <p:spPr>
              <a:xfrm>
                <a:off x="3593534" y="5701843"/>
                <a:ext cx="29202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8" name="TextBox 367"/>
              <p:cNvSpPr txBox="1"/>
              <p:nvPr/>
            </p:nvSpPr>
            <p:spPr>
              <a:xfrm>
                <a:off x="3593534" y="5572243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800" dirty="0" smtClean="0"/>
                  <a:t>**</a:t>
                </a:r>
                <a:endParaRPr lang="en-US" sz="800" dirty="0"/>
              </a:p>
            </p:txBody>
          </p:sp>
        </p:grpSp>
      </p:grpSp>
      <p:grpSp>
        <p:nvGrpSpPr>
          <p:cNvPr id="306" name="Group 305"/>
          <p:cNvGrpSpPr/>
          <p:nvPr/>
        </p:nvGrpSpPr>
        <p:grpSpPr>
          <a:xfrm>
            <a:off x="9235585" y="3742708"/>
            <a:ext cx="1128713" cy="2409825"/>
            <a:chOff x="8795095" y="3381349"/>
            <a:chExt cx="1128713" cy="2409825"/>
          </a:xfrm>
        </p:grpSpPr>
        <p:graphicFrame>
          <p:nvGraphicFramePr>
            <p:cNvPr id="361" name="Object 360"/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3238875731"/>
                </p:ext>
              </p:extLst>
            </p:nvPr>
          </p:nvGraphicFramePr>
          <p:xfrm>
            <a:off x="8795095" y="3381349"/>
            <a:ext cx="1128713" cy="24098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485" name="SPW 13.0 Graph" r:id="rId29" imgW="1129279" imgH="2409357" progId="SigmaPlotGraphicObject.12">
                    <p:embed/>
                  </p:oleObj>
                </mc:Choice>
                <mc:Fallback>
                  <p:oleObj name="SPW 13.0 Graph" r:id="rId29" imgW="1129279" imgH="2409357" progId="SigmaPlotGraphicObject.12">
                    <p:embed/>
                    <p:pic>
                      <p:nvPicPr>
                        <p:cNvPr id="244" name="Object 243"/>
                        <p:cNvPicPr/>
                        <p:nvPr/>
                      </p:nvPicPr>
                      <p:blipFill>
                        <a:blip r:embed="rId30"/>
                        <a:stretch>
                          <a:fillRect/>
                        </a:stretch>
                      </p:blipFill>
                      <p:spPr>
                        <a:xfrm>
                          <a:off x="8795095" y="3381349"/>
                          <a:ext cx="1128713" cy="240982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pSp>
          <p:nvGrpSpPr>
            <p:cNvPr id="362" name="Group 361"/>
            <p:cNvGrpSpPr/>
            <p:nvPr/>
          </p:nvGrpSpPr>
          <p:grpSpPr>
            <a:xfrm>
              <a:off x="9284897" y="3573100"/>
              <a:ext cx="292022" cy="215444"/>
              <a:chOff x="3593534" y="5572243"/>
              <a:chExt cx="292022" cy="215444"/>
            </a:xfrm>
          </p:grpSpPr>
          <p:cxnSp>
            <p:nvCxnSpPr>
              <p:cNvPr id="363" name="Straight Connector 362"/>
              <p:cNvCxnSpPr/>
              <p:nvPr/>
            </p:nvCxnSpPr>
            <p:spPr>
              <a:xfrm>
                <a:off x="3593534" y="5701843"/>
                <a:ext cx="292022" cy="0"/>
              </a:xfrm>
              <a:prstGeom prst="line">
                <a:avLst/>
              </a:prstGeom>
              <a:ln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64" name="TextBox 363"/>
              <p:cNvSpPr txBox="1"/>
              <p:nvPr/>
            </p:nvSpPr>
            <p:spPr>
              <a:xfrm>
                <a:off x="3593534" y="5572243"/>
                <a:ext cx="28725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800" dirty="0" smtClean="0"/>
                  <a:t>**</a:t>
                </a:r>
                <a:endParaRPr lang="en-US" sz="800" dirty="0"/>
              </a:p>
            </p:txBody>
          </p:sp>
        </p:grpSp>
      </p:grpSp>
      <p:sp>
        <p:nvSpPr>
          <p:cNvPr id="360" name="TextBox 359"/>
          <p:cNvSpPr txBox="1"/>
          <p:nvPr/>
        </p:nvSpPr>
        <p:spPr>
          <a:xfrm>
            <a:off x="3539353" y="6172397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n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8" name="TextBox 357"/>
          <p:cNvSpPr txBox="1"/>
          <p:nvPr/>
        </p:nvSpPr>
        <p:spPr>
          <a:xfrm>
            <a:off x="5450832" y="6175999"/>
            <a:ext cx="41549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lu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6" name="TextBox 355"/>
          <p:cNvSpPr txBox="1"/>
          <p:nvPr/>
        </p:nvSpPr>
        <p:spPr>
          <a:xfrm>
            <a:off x="9252873" y="6152533"/>
            <a:ext cx="40748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a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1" name="TextBox 310"/>
          <p:cNvSpPr txBox="1"/>
          <p:nvPr/>
        </p:nvSpPr>
        <p:spPr>
          <a:xfrm>
            <a:off x="7395457" y="6181650"/>
            <a:ext cx="4171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c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12" name="Group 311"/>
          <p:cNvGrpSpPr/>
          <p:nvPr/>
        </p:nvGrpSpPr>
        <p:grpSpPr>
          <a:xfrm>
            <a:off x="2967247" y="3599243"/>
            <a:ext cx="7292614" cy="303007"/>
            <a:chOff x="2304340" y="4228857"/>
            <a:chExt cx="7292614" cy="303007"/>
          </a:xfrm>
        </p:grpSpPr>
        <p:sp>
          <p:nvSpPr>
            <p:cNvPr id="347" name="TextBox 346"/>
            <p:cNvSpPr txBox="1"/>
            <p:nvPr/>
          </p:nvSpPr>
          <p:spPr>
            <a:xfrm>
              <a:off x="6204820" y="4254865"/>
              <a:ext cx="7889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-</a:t>
              </a:r>
              <a:r>
                <a:rPr lang="nb-NO" sz="1200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  <a:r>
                <a:rPr lang="nb-NO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 Lac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8" name="TextBox 347"/>
            <p:cNvSpPr txBox="1"/>
            <p:nvPr/>
          </p:nvSpPr>
          <p:spPr>
            <a:xfrm>
              <a:off x="4213851" y="4243634"/>
              <a:ext cx="7873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r>
                <a:rPr lang="nb-NO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lang="nb-NO" sz="1200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  <a:r>
                <a:rPr lang="nb-NO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 Glu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9" name="TextBox 348"/>
            <p:cNvSpPr txBox="1"/>
            <p:nvPr/>
          </p:nvSpPr>
          <p:spPr>
            <a:xfrm>
              <a:off x="2304340" y="4245333"/>
              <a:ext cx="7873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r>
                <a:rPr lang="nb-NO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lang="nb-NO" sz="1200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  <a:r>
                <a:rPr lang="nb-NO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 </a:t>
              </a:r>
              <a:r>
                <a:rPr lang="nb-NO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n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0" name="TextBox 349"/>
            <p:cNvSpPr txBox="1"/>
            <p:nvPr/>
          </p:nvSpPr>
          <p:spPr>
            <a:xfrm>
              <a:off x="8001378" y="4228857"/>
              <a:ext cx="77091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-</a:t>
              </a:r>
              <a:r>
                <a:rPr lang="nb-NO" sz="1200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  <a:r>
                <a:rPr lang="nb-NO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 Ala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1" name="TextBox 350"/>
            <p:cNvSpPr txBox="1"/>
            <p:nvPr/>
          </p:nvSpPr>
          <p:spPr>
            <a:xfrm>
              <a:off x="5268789" y="4240887"/>
              <a:ext cx="7873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-</a:t>
              </a:r>
              <a:r>
                <a:rPr lang="nb-NO" sz="1200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  <a:r>
                <a:rPr lang="nb-NO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 Glu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2" name="TextBox 351"/>
            <p:cNvSpPr txBox="1"/>
            <p:nvPr/>
          </p:nvSpPr>
          <p:spPr>
            <a:xfrm>
              <a:off x="3197583" y="4241734"/>
              <a:ext cx="78739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-</a:t>
              </a:r>
              <a:r>
                <a:rPr lang="nb-NO" sz="1200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  <a:r>
                <a:rPr lang="nb-NO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 </a:t>
              </a:r>
              <a:r>
                <a:rPr lang="nb-NO" sz="1200" dirty="0" err="1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ln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3" name="TextBox 352"/>
            <p:cNvSpPr txBox="1"/>
            <p:nvPr/>
          </p:nvSpPr>
          <p:spPr>
            <a:xfrm>
              <a:off x="7092800" y="4238395"/>
              <a:ext cx="7889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r>
                <a:rPr lang="nb-NO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lang="nb-NO" sz="1200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  <a:r>
                <a:rPr lang="nb-NO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 Lac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4" name="TextBox 353"/>
            <p:cNvSpPr txBox="1"/>
            <p:nvPr/>
          </p:nvSpPr>
          <p:spPr>
            <a:xfrm>
              <a:off x="8827191" y="4228857"/>
              <a:ext cx="7697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12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r>
                <a:rPr lang="nb-NO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-</a:t>
              </a:r>
              <a:r>
                <a:rPr lang="nb-NO" sz="1200" baseline="300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3</a:t>
              </a:r>
              <a:r>
                <a:rPr lang="nb-NO" sz="1200" dirty="0" smtClean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 Pro</a:t>
              </a:r>
              <a:endParaRPr lang="en-US" sz="1200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313" name="TextBox 312"/>
          <p:cNvSpPr txBox="1"/>
          <p:nvPr/>
        </p:nvSpPr>
        <p:spPr>
          <a:xfrm>
            <a:off x="2778746" y="3426585"/>
            <a:ext cx="36420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nb-NO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4" name="TextBox 313"/>
          <p:cNvSpPr txBox="1"/>
          <p:nvPr/>
        </p:nvSpPr>
        <p:spPr>
          <a:xfrm>
            <a:off x="2799538" y="5996984"/>
            <a:ext cx="3770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lang="nb-NO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en-US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17" name="Group 316"/>
          <p:cNvGrpSpPr/>
          <p:nvPr/>
        </p:nvGrpSpPr>
        <p:grpSpPr>
          <a:xfrm>
            <a:off x="3243533" y="6516719"/>
            <a:ext cx="295142" cy="215444"/>
            <a:chOff x="3098269" y="3730669"/>
            <a:chExt cx="295142" cy="215444"/>
          </a:xfrm>
        </p:grpSpPr>
        <p:cxnSp>
          <p:nvCxnSpPr>
            <p:cNvPr id="333" name="Straight Connector 332"/>
            <p:cNvCxnSpPr/>
            <p:nvPr/>
          </p:nvCxnSpPr>
          <p:spPr>
            <a:xfrm>
              <a:off x="3101389" y="3873050"/>
              <a:ext cx="29202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4" name="TextBox 333"/>
            <p:cNvSpPr txBox="1"/>
            <p:nvPr/>
          </p:nvSpPr>
          <p:spPr>
            <a:xfrm>
              <a:off x="3098269" y="3730669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800" dirty="0" smtClean="0"/>
                <a:t>**</a:t>
              </a:r>
              <a:endParaRPr lang="en-US" sz="800" dirty="0"/>
            </a:p>
          </p:txBody>
        </p:sp>
      </p:grpSp>
      <p:grpSp>
        <p:nvGrpSpPr>
          <p:cNvPr id="318" name="Group 317"/>
          <p:cNvGrpSpPr/>
          <p:nvPr/>
        </p:nvGrpSpPr>
        <p:grpSpPr>
          <a:xfrm>
            <a:off x="5181486" y="6546876"/>
            <a:ext cx="721633" cy="215444"/>
            <a:chOff x="3076830" y="4906917"/>
            <a:chExt cx="721633" cy="215444"/>
          </a:xfrm>
        </p:grpSpPr>
        <p:cxnSp>
          <p:nvCxnSpPr>
            <p:cNvPr id="331" name="Straight Connector 330"/>
            <p:cNvCxnSpPr/>
            <p:nvPr/>
          </p:nvCxnSpPr>
          <p:spPr>
            <a:xfrm flipV="1">
              <a:off x="3076830" y="5056116"/>
              <a:ext cx="721633" cy="74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2" name="TextBox 331"/>
            <p:cNvSpPr txBox="1"/>
            <p:nvPr/>
          </p:nvSpPr>
          <p:spPr>
            <a:xfrm>
              <a:off x="3306270" y="4906917"/>
              <a:ext cx="30318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b-NO" sz="800" dirty="0" smtClean="0"/>
                <a:t>**</a:t>
              </a:r>
              <a:endParaRPr lang="en-US" sz="800" dirty="0"/>
            </a:p>
          </p:txBody>
        </p:sp>
      </p:grpSp>
      <p:grpSp>
        <p:nvGrpSpPr>
          <p:cNvPr id="319" name="Group 318"/>
          <p:cNvGrpSpPr/>
          <p:nvPr/>
        </p:nvGrpSpPr>
        <p:grpSpPr>
          <a:xfrm>
            <a:off x="7107813" y="6561744"/>
            <a:ext cx="301930" cy="215444"/>
            <a:chOff x="3099977" y="3756033"/>
            <a:chExt cx="301930" cy="215444"/>
          </a:xfrm>
        </p:grpSpPr>
        <p:cxnSp>
          <p:nvCxnSpPr>
            <p:cNvPr id="329" name="Straight Connector 328"/>
            <p:cNvCxnSpPr/>
            <p:nvPr/>
          </p:nvCxnSpPr>
          <p:spPr>
            <a:xfrm>
              <a:off x="3109885" y="3912486"/>
              <a:ext cx="29202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0" name="TextBox 329"/>
            <p:cNvSpPr txBox="1"/>
            <p:nvPr/>
          </p:nvSpPr>
          <p:spPr>
            <a:xfrm>
              <a:off x="3099977" y="3756033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800" dirty="0" smtClean="0"/>
                <a:t>**</a:t>
              </a:r>
              <a:endParaRPr lang="en-US" sz="800" dirty="0"/>
            </a:p>
          </p:txBody>
        </p:sp>
      </p:grpSp>
      <p:grpSp>
        <p:nvGrpSpPr>
          <p:cNvPr id="320" name="Group 319"/>
          <p:cNvGrpSpPr/>
          <p:nvPr/>
        </p:nvGrpSpPr>
        <p:grpSpPr>
          <a:xfrm>
            <a:off x="7859645" y="6534873"/>
            <a:ext cx="292022" cy="215444"/>
            <a:chOff x="3095599" y="3753658"/>
            <a:chExt cx="292022" cy="215444"/>
          </a:xfrm>
        </p:grpSpPr>
        <p:cxnSp>
          <p:nvCxnSpPr>
            <p:cNvPr id="327" name="Straight Connector 326"/>
            <p:cNvCxnSpPr/>
            <p:nvPr/>
          </p:nvCxnSpPr>
          <p:spPr>
            <a:xfrm>
              <a:off x="3095599" y="3912486"/>
              <a:ext cx="29202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8" name="TextBox 327"/>
            <p:cNvSpPr txBox="1"/>
            <p:nvPr/>
          </p:nvSpPr>
          <p:spPr>
            <a:xfrm>
              <a:off x="3125686" y="3753658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800" dirty="0" smtClean="0"/>
                <a:t>*</a:t>
              </a:r>
              <a:endParaRPr lang="en-US" sz="800" dirty="0"/>
            </a:p>
          </p:txBody>
        </p:sp>
      </p:grpSp>
      <p:grpSp>
        <p:nvGrpSpPr>
          <p:cNvPr id="321" name="Group 320"/>
          <p:cNvGrpSpPr/>
          <p:nvPr/>
        </p:nvGrpSpPr>
        <p:grpSpPr>
          <a:xfrm>
            <a:off x="8986368" y="6517400"/>
            <a:ext cx="292022" cy="215444"/>
            <a:chOff x="3145600" y="3753658"/>
            <a:chExt cx="292022" cy="215444"/>
          </a:xfrm>
        </p:grpSpPr>
        <p:cxnSp>
          <p:nvCxnSpPr>
            <p:cNvPr id="325" name="Straight Connector 324"/>
            <p:cNvCxnSpPr/>
            <p:nvPr/>
          </p:nvCxnSpPr>
          <p:spPr>
            <a:xfrm>
              <a:off x="3145600" y="3912486"/>
              <a:ext cx="29202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6" name="TextBox 325"/>
            <p:cNvSpPr txBox="1"/>
            <p:nvPr/>
          </p:nvSpPr>
          <p:spPr>
            <a:xfrm>
              <a:off x="3158552" y="3753658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800" dirty="0" smtClean="0"/>
                <a:t>*</a:t>
              </a:r>
              <a:endParaRPr lang="en-US" sz="800" dirty="0"/>
            </a:p>
          </p:txBody>
        </p:sp>
      </p:grpSp>
      <p:grpSp>
        <p:nvGrpSpPr>
          <p:cNvPr id="322" name="Group 321"/>
          <p:cNvGrpSpPr/>
          <p:nvPr/>
        </p:nvGrpSpPr>
        <p:grpSpPr>
          <a:xfrm>
            <a:off x="9749733" y="6516719"/>
            <a:ext cx="292022" cy="215444"/>
            <a:chOff x="3152755" y="3753658"/>
            <a:chExt cx="292022" cy="215444"/>
          </a:xfrm>
        </p:grpSpPr>
        <p:cxnSp>
          <p:nvCxnSpPr>
            <p:cNvPr id="323" name="Straight Connector 322"/>
            <p:cNvCxnSpPr/>
            <p:nvPr/>
          </p:nvCxnSpPr>
          <p:spPr>
            <a:xfrm>
              <a:off x="3152755" y="3912486"/>
              <a:ext cx="292022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4" name="TextBox 323"/>
            <p:cNvSpPr txBox="1"/>
            <p:nvPr/>
          </p:nvSpPr>
          <p:spPr>
            <a:xfrm>
              <a:off x="3182842" y="3753658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800" dirty="0" smtClean="0"/>
                <a:t>*</a:t>
              </a:r>
              <a:endParaRPr lang="en-US" sz="800" dirty="0"/>
            </a:p>
          </p:txBody>
        </p:sp>
      </p:grpSp>
      <p:grpSp>
        <p:nvGrpSpPr>
          <p:cNvPr id="5" name="Group 4"/>
          <p:cNvGrpSpPr/>
          <p:nvPr/>
        </p:nvGrpSpPr>
        <p:grpSpPr>
          <a:xfrm>
            <a:off x="3530791" y="6632470"/>
            <a:ext cx="745971" cy="215444"/>
            <a:chOff x="3504599" y="7251595"/>
            <a:chExt cx="745971" cy="215444"/>
          </a:xfrm>
        </p:grpSpPr>
        <p:cxnSp>
          <p:nvCxnSpPr>
            <p:cNvPr id="133" name="Straight Connector 132"/>
            <p:cNvCxnSpPr/>
            <p:nvPr/>
          </p:nvCxnSpPr>
          <p:spPr>
            <a:xfrm flipV="1">
              <a:off x="3504599" y="7396891"/>
              <a:ext cx="74597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TextBox 133"/>
            <p:cNvSpPr txBox="1"/>
            <p:nvPr/>
          </p:nvSpPr>
          <p:spPr>
            <a:xfrm>
              <a:off x="3736771" y="7251595"/>
              <a:ext cx="2872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sz="800" dirty="0" smtClean="0"/>
                <a:t>**</a:t>
              </a:r>
              <a:endParaRPr lang="en-US" sz="800" dirty="0"/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5410926" y="6680629"/>
            <a:ext cx="745971" cy="215444"/>
            <a:chOff x="5410926" y="6680629"/>
            <a:chExt cx="745971" cy="215444"/>
          </a:xfrm>
        </p:grpSpPr>
        <p:cxnSp>
          <p:nvCxnSpPr>
            <p:cNvPr id="135" name="Straight Connector 134"/>
            <p:cNvCxnSpPr/>
            <p:nvPr/>
          </p:nvCxnSpPr>
          <p:spPr>
            <a:xfrm flipV="1">
              <a:off x="5410926" y="6818828"/>
              <a:ext cx="74597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6" name="TextBox 135"/>
            <p:cNvSpPr txBox="1"/>
            <p:nvPr/>
          </p:nvSpPr>
          <p:spPr>
            <a:xfrm>
              <a:off x="5626292" y="6680629"/>
              <a:ext cx="30318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b-NO" sz="800" dirty="0" smtClean="0"/>
                <a:t>*</a:t>
              </a:r>
              <a:endParaRPr lang="en-US" sz="800" dirty="0"/>
            </a:p>
          </p:txBody>
        </p:sp>
      </p:grpSp>
      <p:grpSp>
        <p:nvGrpSpPr>
          <p:cNvPr id="138" name="Group 137"/>
          <p:cNvGrpSpPr/>
          <p:nvPr/>
        </p:nvGrpSpPr>
        <p:grpSpPr>
          <a:xfrm>
            <a:off x="7113674" y="6841034"/>
            <a:ext cx="745971" cy="215444"/>
            <a:chOff x="5288100" y="6678897"/>
            <a:chExt cx="745971" cy="215444"/>
          </a:xfrm>
        </p:grpSpPr>
        <p:cxnSp>
          <p:nvCxnSpPr>
            <p:cNvPr id="139" name="Straight Connector 138"/>
            <p:cNvCxnSpPr/>
            <p:nvPr/>
          </p:nvCxnSpPr>
          <p:spPr>
            <a:xfrm flipV="1">
              <a:off x="5288100" y="6822739"/>
              <a:ext cx="745971" cy="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0" name="TextBox 139"/>
            <p:cNvSpPr txBox="1"/>
            <p:nvPr/>
          </p:nvSpPr>
          <p:spPr>
            <a:xfrm>
              <a:off x="5560144" y="6678897"/>
              <a:ext cx="30318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b-NO" sz="800" dirty="0" smtClean="0"/>
                <a:t>*</a:t>
              </a:r>
              <a:endParaRPr lang="en-US" sz="800" dirty="0"/>
            </a:p>
          </p:txBody>
        </p:sp>
      </p:grpSp>
      <p:grpSp>
        <p:nvGrpSpPr>
          <p:cNvPr id="141" name="Group 140"/>
          <p:cNvGrpSpPr/>
          <p:nvPr/>
        </p:nvGrpSpPr>
        <p:grpSpPr>
          <a:xfrm>
            <a:off x="7372543" y="6696815"/>
            <a:ext cx="779124" cy="215444"/>
            <a:chOff x="5288100" y="6678897"/>
            <a:chExt cx="779124" cy="215444"/>
          </a:xfrm>
        </p:grpSpPr>
        <p:cxnSp>
          <p:nvCxnSpPr>
            <p:cNvPr id="142" name="Straight Connector 141"/>
            <p:cNvCxnSpPr/>
            <p:nvPr/>
          </p:nvCxnSpPr>
          <p:spPr>
            <a:xfrm>
              <a:off x="5288100" y="6822739"/>
              <a:ext cx="779124" cy="377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3" name="TextBox 142"/>
            <p:cNvSpPr txBox="1"/>
            <p:nvPr/>
          </p:nvSpPr>
          <p:spPr>
            <a:xfrm>
              <a:off x="5534744" y="6678897"/>
              <a:ext cx="30318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nb-NO" sz="800" dirty="0" smtClean="0"/>
                <a:t>**</a:t>
              </a:r>
              <a:endParaRPr lang="en-US" sz="800" dirty="0"/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3083019" y="8259347"/>
            <a:ext cx="1390086" cy="276999"/>
            <a:chOff x="3083019" y="8259347"/>
            <a:chExt cx="1390086" cy="276999"/>
          </a:xfrm>
        </p:grpSpPr>
        <p:grpSp>
          <p:nvGrpSpPr>
            <p:cNvPr id="7" name="Group 6"/>
            <p:cNvGrpSpPr/>
            <p:nvPr/>
          </p:nvGrpSpPr>
          <p:grpSpPr>
            <a:xfrm>
              <a:off x="3083019" y="8259347"/>
              <a:ext cx="625852" cy="276999"/>
              <a:chOff x="3083019" y="8259347"/>
              <a:chExt cx="625852" cy="276999"/>
            </a:xfrm>
          </p:grpSpPr>
          <p:sp>
            <p:nvSpPr>
              <p:cNvPr id="6" name="TextBox 5"/>
              <p:cNvSpPr txBox="1"/>
              <p:nvPr/>
            </p:nvSpPr>
            <p:spPr>
              <a:xfrm>
                <a:off x="3083019" y="8259347"/>
                <a:ext cx="37382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200" dirty="0" smtClean="0"/>
                  <a:t>NA</a:t>
                </a:r>
                <a:endParaRPr lang="en-US" sz="1200" dirty="0"/>
              </a:p>
            </p:txBody>
          </p:sp>
          <p:sp>
            <p:nvSpPr>
              <p:cNvPr id="146" name="TextBox 145"/>
              <p:cNvSpPr txBox="1"/>
              <p:nvPr/>
            </p:nvSpPr>
            <p:spPr>
              <a:xfrm>
                <a:off x="3339859" y="8259347"/>
                <a:ext cx="3690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200" baseline="30000" dirty="0" smtClean="0"/>
                  <a:t>13</a:t>
                </a:r>
                <a:r>
                  <a:rPr lang="nb-NO" sz="1200" dirty="0" smtClean="0"/>
                  <a:t>C</a:t>
                </a:r>
                <a:endParaRPr lang="en-US" sz="1200" dirty="0"/>
              </a:p>
            </p:txBody>
          </p:sp>
        </p:grpSp>
        <p:grpSp>
          <p:nvGrpSpPr>
            <p:cNvPr id="148" name="Group 147"/>
            <p:cNvGrpSpPr/>
            <p:nvPr/>
          </p:nvGrpSpPr>
          <p:grpSpPr>
            <a:xfrm>
              <a:off x="3847253" y="8259347"/>
              <a:ext cx="625852" cy="276999"/>
              <a:chOff x="3083019" y="8259347"/>
              <a:chExt cx="625852" cy="276999"/>
            </a:xfrm>
          </p:grpSpPr>
          <p:sp>
            <p:nvSpPr>
              <p:cNvPr id="149" name="TextBox 148"/>
              <p:cNvSpPr txBox="1"/>
              <p:nvPr/>
            </p:nvSpPr>
            <p:spPr>
              <a:xfrm>
                <a:off x="3083019" y="8259347"/>
                <a:ext cx="37382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200" dirty="0" smtClean="0"/>
                  <a:t>NA</a:t>
                </a:r>
                <a:endParaRPr lang="en-US" sz="1200" dirty="0"/>
              </a:p>
            </p:txBody>
          </p:sp>
          <p:sp>
            <p:nvSpPr>
              <p:cNvPr id="150" name="TextBox 149"/>
              <p:cNvSpPr txBox="1"/>
              <p:nvPr/>
            </p:nvSpPr>
            <p:spPr>
              <a:xfrm>
                <a:off x="3339859" y="8259347"/>
                <a:ext cx="3690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200" baseline="30000" dirty="0" smtClean="0"/>
                  <a:t>13</a:t>
                </a:r>
                <a:r>
                  <a:rPr lang="nb-NO" sz="1200" dirty="0" smtClean="0"/>
                  <a:t>C</a:t>
                </a:r>
                <a:endParaRPr lang="en-US" sz="1200" dirty="0"/>
              </a:p>
            </p:txBody>
          </p:sp>
        </p:grpSp>
      </p:grpSp>
      <p:grpSp>
        <p:nvGrpSpPr>
          <p:cNvPr id="152" name="Group 151"/>
          <p:cNvGrpSpPr/>
          <p:nvPr/>
        </p:nvGrpSpPr>
        <p:grpSpPr>
          <a:xfrm>
            <a:off x="4987350" y="8289459"/>
            <a:ext cx="1390086" cy="276999"/>
            <a:chOff x="3083019" y="8259347"/>
            <a:chExt cx="1390086" cy="276999"/>
          </a:xfrm>
        </p:grpSpPr>
        <p:grpSp>
          <p:nvGrpSpPr>
            <p:cNvPr id="153" name="Group 152"/>
            <p:cNvGrpSpPr/>
            <p:nvPr/>
          </p:nvGrpSpPr>
          <p:grpSpPr>
            <a:xfrm>
              <a:off x="3083019" y="8259347"/>
              <a:ext cx="625852" cy="276999"/>
              <a:chOff x="3083019" y="8259347"/>
              <a:chExt cx="625852" cy="276999"/>
            </a:xfrm>
          </p:grpSpPr>
          <p:sp>
            <p:nvSpPr>
              <p:cNvPr id="157" name="TextBox 156"/>
              <p:cNvSpPr txBox="1"/>
              <p:nvPr/>
            </p:nvSpPr>
            <p:spPr>
              <a:xfrm>
                <a:off x="3083019" y="8259347"/>
                <a:ext cx="37382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200" dirty="0" smtClean="0"/>
                  <a:t>NA</a:t>
                </a:r>
                <a:endParaRPr lang="en-US" sz="1200" dirty="0"/>
              </a:p>
            </p:txBody>
          </p:sp>
          <p:sp>
            <p:nvSpPr>
              <p:cNvPr id="158" name="TextBox 157"/>
              <p:cNvSpPr txBox="1"/>
              <p:nvPr/>
            </p:nvSpPr>
            <p:spPr>
              <a:xfrm>
                <a:off x="3339859" y="8259347"/>
                <a:ext cx="3690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200" baseline="30000" dirty="0" smtClean="0"/>
                  <a:t>13</a:t>
                </a:r>
                <a:r>
                  <a:rPr lang="nb-NO" sz="1200" dirty="0" smtClean="0"/>
                  <a:t>C</a:t>
                </a:r>
                <a:endParaRPr lang="en-US" sz="1200" dirty="0"/>
              </a:p>
            </p:txBody>
          </p:sp>
        </p:grpSp>
        <p:grpSp>
          <p:nvGrpSpPr>
            <p:cNvPr id="154" name="Group 153"/>
            <p:cNvGrpSpPr/>
            <p:nvPr/>
          </p:nvGrpSpPr>
          <p:grpSpPr>
            <a:xfrm>
              <a:off x="3847253" y="8259347"/>
              <a:ext cx="625852" cy="276999"/>
              <a:chOff x="3083019" y="8259347"/>
              <a:chExt cx="625852" cy="276999"/>
            </a:xfrm>
          </p:grpSpPr>
          <p:sp>
            <p:nvSpPr>
              <p:cNvPr id="155" name="TextBox 154"/>
              <p:cNvSpPr txBox="1"/>
              <p:nvPr/>
            </p:nvSpPr>
            <p:spPr>
              <a:xfrm>
                <a:off x="3083019" y="8259347"/>
                <a:ext cx="37382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200" dirty="0" smtClean="0"/>
                  <a:t>NA</a:t>
                </a:r>
                <a:endParaRPr lang="en-US" sz="1200" dirty="0"/>
              </a:p>
            </p:txBody>
          </p:sp>
          <p:sp>
            <p:nvSpPr>
              <p:cNvPr id="156" name="TextBox 155"/>
              <p:cNvSpPr txBox="1"/>
              <p:nvPr/>
            </p:nvSpPr>
            <p:spPr>
              <a:xfrm>
                <a:off x="3339859" y="8259347"/>
                <a:ext cx="3690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200" baseline="30000" dirty="0" smtClean="0"/>
                  <a:t>13</a:t>
                </a:r>
                <a:r>
                  <a:rPr lang="nb-NO" sz="1200" dirty="0" smtClean="0"/>
                  <a:t>C</a:t>
                </a:r>
                <a:endParaRPr lang="en-US" sz="1200" dirty="0"/>
              </a:p>
            </p:txBody>
          </p:sp>
        </p:grpSp>
      </p:grpSp>
      <p:grpSp>
        <p:nvGrpSpPr>
          <p:cNvPr id="159" name="Group 158"/>
          <p:cNvGrpSpPr/>
          <p:nvPr/>
        </p:nvGrpSpPr>
        <p:grpSpPr>
          <a:xfrm>
            <a:off x="6950188" y="8303899"/>
            <a:ext cx="1390086" cy="276999"/>
            <a:chOff x="3083019" y="8259347"/>
            <a:chExt cx="1390086" cy="276999"/>
          </a:xfrm>
        </p:grpSpPr>
        <p:grpSp>
          <p:nvGrpSpPr>
            <p:cNvPr id="160" name="Group 159"/>
            <p:cNvGrpSpPr/>
            <p:nvPr/>
          </p:nvGrpSpPr>
          <p:grpSpPr>
            <a:xfrm>
              <a:off x="3083019" y="8259347"/>
              <a:ext cx="625852" cy="276999"/>
              <a:chOff x="3083019" y="8259347"/>
              <a:chExt cx="625852" cy="276999"/>
            </a:xfrm>
          </p:grpSpPr>
          <p:sp>
            <p:nvSpPr>
              <p:cNvPr id="164" name="TextBox 163"/>
              <p:cNvSpPr txBox="1"/>
              <p:nvPr/>
            </p:nvSpPr>
            <p:spPr>
              <a:xfrm>
                <a:off x="3083019" y="8259347"/>
                <a:ext cx="37382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200" dirty="0" smtClean="0"/>
                  <a:t>NA</a:t>
                </a:r>
                <a:endParaRPr lang="en-US" sz="1200" dirty="0"/>
              </a:p>
            </p:txBody>
          </p:sp>
          <p:sp>
            <p:nvSpPr>
              <p:cNvPr id="165" name="TextBox 164"/>
              <p:cNvSpPr txBox="1"/>
              <p:nvPr/>
            </p:nvSpPr>
            <p:spPr>
              <a:xfrm>
                <a:off x="3339859" y="8259347"/>
                <a:ext cx="3690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200" baseline="30000" dirty="0" smtClean="0"/>
                  <a:t>13</a:t>
                </a:r>
                <a:r>
                  <a:rPr lang="nb-NO" sz="1200" dirty="0" smtClean="0"/>
                  <a:t>C</a:t>
                </a:r>
                <a:endParaRPr lang="en-US" sz="1200" dirty="0"/>
              </a:p>
            </p:txBody>
          </p:sp>
        </p:grpSp>
        <p:grpSp>
          <p:nvGrpSpPr>
            <p:cNvPr id="161" name="Group 160"/>
            <p:cNvGrpSpPr/>
            <p:nvPr/>
          </p:nvGrpSpPr>
          <p:grpSpPr>
            <a:xfrm>
              <a:off x="3847253" y="8259347"/>
              <a:ext cx="625852" cy="276999"/>
              <a:chOff x="3083019" y="8259347"/>
              <a:chExt cx="625852" cy="276999"/>
            </a:xfrm>
          </p:grpSpPr>
          <p:sp>
            <p:nvSpPr>
              <p:cNvPr id="162" name="TextBox 161"/>
              <p:cNvSpPr txBox="1"/>
              <p:nvPr/>
            </p:nvSpPr>
            <p:spPr>
              <a:xfrm>
                <a:off x="3083019" y="8259347"/>
                <a:ext cx="37382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200" dirty="0" smtClean="0"/>
                  <a:t>NA</a:t>
                </a:r>
                <a:endParaRPr lang="en-US" sz="1200" dirty="0"/>
              </a:p>
            </p:txBody>
          </p:sp>
          <p:sp>
            <p:nvSpPr>
              <p:cNvPr id="163" name="TextBox 162"/>
              <p:cNvSpPr txBox="1"/>
              <p:nvPr/>
            </p:nvSpPr>
            <p:spPr>
              <a:xfrm>
                <a:off x="3339859" y="8259347"/>
                <a:ext cx="3690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200" baseline="30000" dirty="0" smtClean="0"/>
                  <a:t>13</a:t>
                </a:r>
                <a:r>
                  <a:rPr lang="nb-NO" sz="1200" dirty="0" smtClean="0"/>
                  <a:t>C</a:t>
                </a:r>
                <a:endParaRPr lang="en-US" sz="1200" dirty="0"/>
              </a:p>
            </p:txBody>
          </p:sp>
        </p:grpSp>
      </p:grpSp>
      <p:grpSp>
        <p:nvGrpSpPr>
          <p:cNvPr id="166" name="Group 165"/>
          <p:cNvGrpSpPr/>
          <p:nvPr/>
        </p:nvGrpSpPr>
        <p:grpSpPr>
          <a:xfrm>
            <a:off x="8792587" y="8300256"/>
            <a:ext cx="1390086" cy="276999"/>
            <a:chOff x="3083019" y="8259347"/>
            <a:chExt cx="1390086" cy="276999"/>
          </a:xfrm>
        </p:grpSpPr>
        <p:grpSp>
          <p:nvGrpSpPr>
            <p:cNvPr id="167" name="Group 166"/>
            <p:cNvGrpSpPr/>
            <p:nvPr/>
          </p:nvGrpSpPr>
          <p:grpSpPr>
            <a:xfrm>
              <a:off x="3083019" y="8259347"/>
              <a:ext cx="625852" cy="276999"/>
              <a:chOff x="3083019" y="8259347"/>
              <a:chExt cx="625852" cy="276999"/>
            </a:xfrm>
          </p:grpSpPr>
          <p:sp>
            <p:nvSpPr>
              <p:cNvPr id="171" name="TextBox 170"/>
              <p:cNvSpPr txBox="1"/>
              <p:nvPr/>
            </p:nvSpPr>
            <p:spPr>
              <a:xfrm>
                <a:off x="3083019" y="8259347"/>
                <a:ext cx="37382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200" dirty="0" smtClean="0"/>
                  <a:t>NA</a:t>
                </a:r>
                <a:endParaRPr lang="en-US" sz="1200" dirty="0"/>
              </a:p>
            </p:txBody>
          </p:sp>
          <p:sp>
            <p:nvSpPr>
              <p:cNvPr id="172" name="TextBox 171"/>
              <p:cNvSpPr txBox="1"/>
              <p:nvPr/>
            </p:nvSpPr>
            <p:spPr>
              <a:xfrm>
                <a:off x="3339859" y="8259347"/>
                <a:ext cx="3690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200" baseline="30000" dirty="0" smtClean="0"/>
                  <a:t>13</a:t>
                </a:r>
                <a:r>
                  <a:rPr lang="nb-NO" sz="1200" dirty="0" smtClean="0"/>
                  <a:t>C</a:t>
                </a:r>
                <a:endParaRPr lang="en-US" sz="1200" dirty="0"/>
              </a:p>
            </p:txBody>
          </p:sp>
        </p:grpSp>
        <p:grpSp>
          <p:nvGrpSpPr>
            <p:cNvPr id="168" name="Group 167"/>
            <p:cNvGrpSpPr/>
            <p:nvPr/>
          </p:nvGrpSpPr>
          <p:grpSpPr>
            <a:xfrm>
              <a:off x="3847253" y="8259347"/>
              <a:ext cx="625852" cy="276999"/>
              <a:chOff x="3083019" y="8259347"/>
              <a:chExt cx="625852" cy="276999"/>
            </a:xfrm>
          </p:grpSpPr>
          <p:sp>
            <p:nvSpPr>
              <p:cNvPr id="169" name="TextBox 168"/>
              <p:cNvSpPr txBox="1"/>
              <p:nvPr/>
            </p:nvSpPr>
            <p:spPr>
              <a:xfrm>
                <a:off x="3083019" y="8259347"/>
                <a:ext cx="373820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200" dirty="0" smtClean="0"/>
                  <a:t>NA</a:t>
                </a:r>
                <a:endParaRPr lang="en-US" sz="1200" dirty="0"/>
              </a:p>
            </p:txBody>
          </p:sp>
          <p:sp>
            <p:nvSpPr>
              <p:cNvPr id="170" name="TextBox 169"/>
              <p:cNvSpPr txBox="1"/>
              <p:nvPr/>
            </p:nvSpPr>
            <p:spPr>
              <a:xfrm>
                <a:off x="3339859" y="8259347"/>
                <a:ext cx="36901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200" baseline="30000" dirty="0" smtClean="0"/>
                  <a:t>13</a:t>
                </a:r>
                <a:r>
                  <a:rPr lang="nb-NO" sz="1200" dirty="0" smtClean="0"/>
                  <a:t>C</a:t>
                </a:r>
                <a:endParaRPr lang="en-US" sz="1200" dirty="0"/>
              </a:p>
            </p:txBody>
          </p:sp>
        </p:grpSp>
      </p:grpSp>
      <p:grpSp>
        <p:nvGrpSpPr>
          <p:cNvPr id="202" name="Group 201"/>
          <p:cNvGrpSpPr/>
          <p:nvPr/>
        </p:nvGrpSpPr>
        <p:grpSpPr>
          <a:xfrm>
            <a:off x="-222389" y="3390137"/>
            <a:ext cx="3043198" cy="5732125"/>
            <a:chOff x="925222" y="-1048140"/>
            <a:chExt cx="3043198" cy="5732125"/>
          </a:xfrm>
        </p:grpSpPr>
        <p:grpSp>
          <p:nvGrpSpPr>
            <p:cNvPr id="203" name="Group 202"/>
            <p:cNvGrpSpPr/>
            <p:nvPr/>
          </p:nvGrpSpPr>
          <p:grpSpPr>
            <a:xfrm>
              <a:off x="925222" y="-1048140"/>
              <a:ext cx="3043198" cy="5732125"/>
              <a:chOff x="620290" y="-143172"/>
              <a:chExt cx="3043198" cy="5732125"/>
            </a:xfrm>
          </p:grpSpPr>
          <p:graphicFrame>
            <p:nvGraphicFramePr>
              <p:cNvPr id="213" name="Chart 212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70445525"/>
                  </p:ext>
                </p:extLst>
              </p:nvPr>
            </p:nvGraphicFramePr>
            <p:xfrm>
              <a:off x="620290" y="-143172"/>
              <a:ext cx="3043198" cy="573212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1"/>
              </a:graphicData>
            </a:graphic>
          </p:graphicFrame>
          <p:sp>
            <p:nvSpPr>
              <p:cNvPr id="214" name="TextBox 213"/>
              <p:cNvSpPr txBox="1"/>
              <p:nvPr/>
            </p:nvSpPr>
            <p:spPr>
              <a:xfrm>
                <a:off x="1937483" y="1436573"/>
                <a:ext cx="77457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5-</a:t>
                </a:r>
                <a:r>
                  <a:rPr lang="nb-NO" sz="10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</a:t>
                </a:r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] </a:t>
                </a:r>
                <a:r>
                  <a:rPr lang="nb-NO" sz="10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ln</a:t>
                </a:r>
                <a:endPara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5" name="TextBox 1009"/>
              <p:cNvSpPr txBox="1"/>
              <p:nvPr/>
            </p:nvSpPr>
            <p:spPr>
              <a:xfrm>
                <a:off x="1937482" y="2834169"/>
                <a:ext cx="77457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5-</a:t>
                </a:r>
                <a:r>
                  <a:rPr lang="nb-NO" sz="10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</a:t>
                </a:r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] Glu</a:t>
                </a:r>
                <a:endPara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6" name="TextBox 215"/>
              <p:cNvSpPr txBox="1"/>
              <p:nvPr/>
            </p:nvSpPr>
            <p:spPr>
              <a:xfrm>
                <a:off x="1946111" y="3289484"/>
                <a:ext cx="7601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5-</a:t>
                </a:r>
                <a:r>
                  <a:rPr lang="nb-NO" sz="10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</a:t>
                </a:r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] Pro</a:t>
                </a:r>
                <a:endPara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7" name="TextBox 1009"/>
              <p:cNvSpPr txBox="1"/>
              <p:nvPr/>
            </p:nvSpPr>
            <p:spPr>
              <a:xfrm>
                <a:off x="1947846" y="3626136"/>
                <a:ext cx="76815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1-</a:t>
                </a:r>
                <a:r>
                  <a:rPr lang="nb-NO" sz="10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</a:t>
                </a:r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] Ala</a:t>
                </a:r>
                <a:endPara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8" name="TextBox 1009"/>
              <p:cNvSpPr txBox="1"/>
              <p:nvPr/>
            </p:nvSpPr>
            <p:spPr>
              <a:xfrm>
                <a:off x="1937787" y="3968227"/>
                <a:ext cx="77617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1-</a:t>
                </a:r>
                <a:r>
                  <a:rPr lang="nb-NO" sz="10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</a:t>
                </a:r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] Lac</a:t>
                </a:r>
                <a:endPara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19" name="TextBox 218"/>
              <p:cNvSpPr txBox="1"/>
              <p:nvPr/>
            </p:nvSpPr>
            <p:spPr>
              <a:xfrm>
                <a:off x="1937787" y="4232882"/>
                <a:ext cx="77617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2-</a:t>
                </a:r>
                <a:r>
                  <a:rPr lang="nb-NO" sz="10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</a:t>
                </a:r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] Lac</a:t>
                </a:r>
                <a:endPara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0" name="TextBox 219"/>
              <p:cNvSpPr txBox="1"/>
              <p:nvPr/>
            </p:nvSpPr>
            <p:spPr>
              <a:xfrm>
                <a:off x="1947411" y="4392062"/>
                <a:ext cx="77457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1-</a:t>
                </a:r>
                <a:r>
                  <a:rPr lang="nb-NO" sz="10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</a:t>
                </a:r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] Glu</a:t>
                </a:r>
                <a:endPara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1" name="TextBox 220"/>
              <p:cNvSpPr txBox="1"/>
              <p:nvPr/>
            </p:nvSpPr>
            <p:spPr>
              <a:xfrm>
                <a:off x="1940614" y="4546852"/>
                <a:ext cx="77457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1-</a:t>
                </a:r>
                <a:r>
                  <a:rPr lang="nb-NO" sz="10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</a:t>
                </a:r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] </a:t>
                </a:r>
                <a:r>
                  <a:rPr lang="nb-NO" sz="10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ln</a:t>
                </a:r>
                <a:endPara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2" name="TextBox 221"/>
              <p:cNvSpPr txBox="1"/>
              <p:nvPr/>
            </p:nvSpPr>
            <p:spPr>
              <a:xfrm>
                <a:off x="2888917" y="1468730"/>
                <a:ext cx="77457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5-</a:t>
                </a:r>
                <a:r>
                  <a:rPr lang="nb-NO" sz="10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</a:t>
                </a:r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] </a:t>
                </a:r>
                <a:r>
                  <a:rPr lang="nb-NO" sz="1000" dirty="0" err="1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Gln</a:t>
                </a:r>
                <a:endPara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3" name="TextBox 222"/>
              <p:cNvSpPr txBox="1"/>
              <p:nvPr/>
            </p:nvSpPr>
            <p:spPr>
              <a:xfrm>
                <a:off x="2888916" y="2175608"/>
                <a:ext cx="77457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5-</a:t>
                </a:r>
                <a:r>
                  <a:rPr lang="nb-NO" sz="10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</a:t>
                </a:r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] Glu</a:t>
                </a:r>
                <a:endPara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4" name="TextBox 1009"/>
              <p:cNvSpPr txBox="1"/>
              <p:nvPr/>
            </p:nvSpPr>
            <p:spPr>
              <a:xfrm>
                <a:off x="2861925" y="2874263"/>
                <a:ext cx="768159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1-</a:t>
                </a:r>
                <a:r>
                  <a:rPr lang="nb-NO" sz="10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</a:t>
                </a:r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] Ala</a:t>
                </a:r>
                <a:endPara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5" name="TextBox 224"/>
              <p:cNvSpPr txBox="1"/>
              <p:nvPr/>
            </p:nvSpPr>
            <p:spPr>
              <a:xfrm>
                <a:off x="2869940" y="2755977"/>
                <a:ext cx="760144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5-</a:t>
                </a:r>
                <a:r>
                  <a:rPr lang="nb-NO" sz="10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</a:t>
                </a:r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] Pro</a:t>
                </a:r>
                <a:endPara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6" name="TextBox 1009"/>
              <p:cNvSpPr txBox="1"/>
              <p:nvPr/>
            </p:nvSpPr>
            <p:spPr>
              <a:xfrm>
                <a:off x="2861925" y="3406043"/>
                <a:ext cx="77617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lvl1pPr marL="0" indent="0">
                  <a:defRPr sz="1100">
                    <a:latin typeface="+mn-lt"/>
                    <a:ea typeface="+mn-ea"/>
                    <a:cs typeface="+mn-cs"/>
                  </a:defRPr>
                </a:lvl1pPr>
                <a:lvl2pPr marL="457200" indent="0">
                  <a:defRPr sz="1100">
                    <a:latin typeface="+mn-lt"/>
                    <a:ea typeface="+mn-ea"/>
                    <a:cs typeface="+mn-cs"/>
                  </a:defRPr>
                </a:lvl2pPr>
                <a:lvl3pPr marL="914400" indent="0">
                  <a:defRPr sz="1100">
                    <a:latin typeface="+mn-lt"/>
                    <a:ea typeface="+mn-ea"/>
                    <a:cs typeface="+mn-cs"/>
                  </a:defRPr>
                </a:lvl3pPr>
                <a:lvl4pPr marL="1371600" indent="0">
                  <a:defRPr sz="1100">
                    <a:latin typeface="+mn-lt"/>
                    <a:ea typeface="+mn-ea"/>
                    <a:cs typeface="+mn-cs"/>
                  </a:defRPr>
                </a:lvl4pPr>
                <a:lvl5pPr marL="1828800" indent="0">
                  <a:defRPr sz="1100">
                    <a:latin typeface="+mn-lt"/>
                    <a:ea typeface="+mn-ea"/>
                    <a:cs typeface="+mn-cs"/>
                  </a:defRPr>
                </a:lvl5pPr>
                <a:lvl6pPr marL="2286000" indent="0">
                  <a:defRPr sz="1100">
                    <a:latin typeface="+mn-lt"/>
                    <a:ea typeface="+mn-ea"/>
                    <a:cs typeface="+mn-cs"/>
                  </a:defRPr>
                </a:lvl6pPr>
                <a:lvl7pPr marL="2743200" indent="0">
                  <a:defRPr sz="1100">
                    <a:latin typeface="+mn-lt"/>
                    <a:ea typeface="+mn-ea"/>
                    <a:cs typeface="+mn-cs"/>
                  </a:defRPr>
                </a:lvl7pPr>
                <a:lvl8pPr marL="3200400" indent="0">
                  <a:defRPr sz="1100">
                    <a:latin typeface="+mn-lt"/>
                    <a:ea typeface="+mn-ea"/>
                    <a:cs typeface="+mn-cs"/>
                  </a:defRPr>
                </a:lvl8pPr>
                <a:lvl9pPr marL="3657600" indent="0">
                  <a:defRPr sz="1100"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1-</a:t>
                </a:r>
                <a:r>
                  <a:rPr lang="nb-NO" sz="10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</a:t>
                </a:r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] Lac</a:t>
                </a:r>
                <a:endPara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7" name="TextBox 226"/>
              <p:cNvSpPr txBox="1"/>
              <p:nvPr/>
            </p:nvSpPr>
            <p:spPr>
              <a:xfrm>
                <a:off x="2869990" y="4174589"/>
                <a:ext cx="77617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2-</a:t>
                </a:r>
                <a:r>
                  <a:rPr lang="nb-NO" sz="10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</a:t>
                </a:r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] Lac</a:t>
                </a:r>
                <a:endPara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8" name="TextBox 227"/>
              <p:cNvSpPr txBox="1"/>
              <p:nvPr/>
            </p:nvSpPr>
            <p:spPr>
              <a:xfrm>
                <a:off x="2871594" y="4534773"/>
                <a:ext cx="774571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[1-</a:t>
                </a:r>
                <a:r>
                  <a:rPr lang="nb-NO" sz="1000" baseline="30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3</a:t>
                </a:r>
                <a:r>
                  <a:rPr lang="nb-NO" sz="1000" dirty="0" smtClean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] Glu</a:t>
                </a:r>
                <a:endParaRPr lang="en-US" sz="10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204" name="TextBox 203"/>
            <p:cNvSpPr txBox="1"/>
            <p:nvPr/>
          </p:nvSpPr>
          <p:spPr>
            <a:xfrm>
              <a:off x="1890425" y="551728"/>
              <a:ext cx="5309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nb-NO" dirty="0" smtClean="0"/>
                <a:t>***</a:t>
              </a:r>
              <a:endParaRPr lang="en-US" dirty="0"/>
            </a:p>
          </p:txBody>
        </p:sp>
        <p:sp>
          <p:nvSpPr>
            <p:cNvPr id="205" name="TextBox 1004"/>
            <p:cNvSpPr txBox="1"/>
            <p:nvPr/>
          </p:nvSpPr>
          <p:spPr>
            <a:xfrm>
              <a:off x="1915813" y="1954782"/>
              <a:ext cx="530915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nb-NO" sz="1800" dirty="0" smtClean="0"/>
                <a:t>***</a:t>
              </a:r>
              <a:endParaRPr lang="en-US" sz="1800" dirty="0"/>
            </a:p>
          </p:txBody>
        </p:sp>
        <p:sp>
          <p:nvSpPr>
            <p:cNvPr id="206" name="TextBox 1004"/>
            <p:cNvSpPr txBox="1"/>
            <p:nvPr/>
          </p:nvSpPr>
          <p:spPr>
            <a:xfrm>
              <a:off x="2011985" y="2395366"/>
              <a:ext cx="300081" cy="3693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nb-NO" sz="1800" dirty="0" smtClean="0"/>
                <a:t>*</a:t>
              </a:r>
              <a:endParaRPr lang="en-US" sz="1800" dirty="0"/>
            </a:p>
          </p:txBody>
        </p:sp>
        <p:sp>
          <p:nvSpPr>
            <p:cNvPr id="207" name="TextBox 1004"/>
            <p:cNvSpPr txBox="1"/>
            <p:nvPr/>
          </p:nvSpPr>
          <p:spPr>
            <a:xfrm>
              <a:off x="1965502" y="2736740"/>
              <a:ext cx="41549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nb-NO" sz="1800" dirty="0" smtClean="0"/>
                <a:t>**</a:t>
              </a:r>
              <a:endParaRPr lang="en-US" sz="1800" dirty="0"/>
            </a:p>
          </p:txBody>
        </p:sp>
        <p:sp>
          <p:nvSpPr>
            <p:cNvPr id="208" name="TextBox 1004"/>
            <p:cNvSpPr txBox="1"/>
            <p:nvPr/>
          </p:nvSpPr>
          <p:spPr>
            <a:xfrm>
              <a:off x="2020743" y="3480472"/>
              <a:ext cx="300081" cy="3693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nb-NO" sz="1800" dirty="0" smtClean="0"/>
                <a:t>*</a:t>
              </a:r>
              <a:endParaRPr lang="en-US" sz="1800" dirty="0"/>
            </a:p>
          </p:txBody>
        </p:sp>
        <p:sp>
          <p:nvSpPr>
            <p:cNvPr id="209" name="TextBox 1004"/>
            <p:cNvSpPr txBox="1"/>
            <p:nvPr/>
          </p:nvSpPr>
          <p:spPr>
            <a:xfrm>
              <a:off x="2021822" y="3630922"/>
              <a:ext cx="300081" cy="3693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nb-NO" sz="1800" dirty="0" smtClean="0"/>
                <a:t>*</a:t>
              </a:r>
              <a:endParaRPr lang="en-US" sz="1800" dirty="0"/>
            </a:p>
          </p:txBody>
        </p:sp>
        <p:sp>
          <p:nvSpPr>
            <p:cNvPr id="210" name="TextBox 1004"/>
            <p:cNvSpPr txBox="1"/>
            <p:nvPr/>
          </p:nvSpPr>
          <p:spPr>
            <a:xfrm>
              <a:off x="2945977" y="3256730"/>
              <a:ext cx="300081" cy="3693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nb-NO" sz="1800" dirty="0" smtClean="0"/>
                <a:t>*</a:t>
              </a:r>
              <a:endParaRPr lang="en-US" sz="1800" dirty="0"/>
            </a:p>
          </p:txBody>
        </p:sp>
        <p:sp>
          <p:nvSpPr>
            <p:cNvPr id="211" name="TextBox 1004"/>
            <p:cNvSpPr txBox="1"/>
            <p:nvPr/>
          </p:nvSpPr>
          <p:spPr>
            <a:xfrm>
              <a:off x="2936404" y="2486316"/>
              <a:ext cx="300081" cy="3693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nb-NO" sz="1800" dirty="0" smtClean="0"/>
                <a:t>*</a:t>
              </a:r>
              <a:endParaRPr lang="en-US" sz="1800" dirty="0"/>
            </a:p>
          </p:txBody>
        </p:sp>
        <p:sp>
          <p:nvSpPr>
            <p:cNvPr id="212" name="TextBox 1004"/>
            <p:cNvSpPr txBox="1"/>
            <p:nvPr/>
          </p:nvSpPr>
          <p:spPr>
            <a:xfrm>
              <a:off x="2943061" y="1352485"/>
              <a:ext cx="300081" cy="36932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nb-NO" sz="1800" dirty="0" smtClean="0"/>
                <a:t>*</a:t>
              </a:r>
              <a:endParaRPr lang="en-US" sz="1800" dirty="0"/>
            </a:p>
          </p:txBody>
        </p:sp>
      </p:grpSp>
      <p:sp>
        <p:nvSpPr>
          <p:cNvPr id="2" name="Rectangle 1"/>
          <p:cNvSpPr/>
          <p:nvPr/>
        </p:nvSpPr>
        <p:spPr>
          <a:xfrm>
            <a:off x="846347" y="7454489"/>
            <a:ext cx="28409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^</a:t>
            </a:r>
            <a:endParaRPr lang="en-US" dirty="0"/>
          </a:p>
        </p:txBody>
      </p:sp>
      <p:sp>
        <p:nvSpPr>
          <p:cNvPr id="173" name="Rectangle 172"/>
          <p:cNvSpPr/>
          <p:nvPr/>
        </p:nvSpPr>
        <p:spPr>
          <a:xfrm>
            <a:off x="1775768" y="6359924"/>
            <a:ext cx="284099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400" dirty="0" smtClean="0">
                <a:solidFill>
                  <a:srgbClr val="000000"/>
                </a:solidFill>
                <a:latin typeface="Calibri" panose="020F0502020204030204" pitchFamily="34" charset="0"/>
              </a:rPr>
              <a:t>^</a:t>
            </a:r>
            <a:endParaRPr lang="en-US" dirty="0"/>
          </a:p>
        </p:txBody>
      </p:sp>
      <p:sp>
        <p:nvSpPr>
          <p:cNvPr id="174" name="TextBox 37"/>
          <p:cNvSpPr txBox="1"/>
          <p:nvPr/>
        </p:nvSpPr>
        <p:spPr>
          <a:xfrm>
            <a:off x="1402740" y="952538"/>
            <a:ext cx="488975" cy="4001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nb-NO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r>
              <a:rPr lang="nb-NO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</a:t>
            </a:r>
            <a:r>
              <a:rPr lang="nb-NO" sz="10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r>
              <a:rPr lang="nb-NO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lang="nb-NO" sz="10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nb-NO" sz="1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ac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5" name="TextBox 174"/>
          <p:cNvSpPr txBox="1"/>
          <p:nvPr/>
        </p:nvSpPr>
        <p:spPr>
          <a:xfrm>
            <a:off x="7696437" y="1033288"/>
            <a:ext cx="55656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b-NO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-</a:t>
            </a:r>
            <a:r>
              <a:rPr lang="nb-NO" sz="1200" baseline="300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r>
              <a:rPr lang="nb-NO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 </a:t>
            </a:r>
            <a:endParaRPr lang="nb-NO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r>
              <a:rPr lang="nb-NO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la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6" name="TextBox 9"/>
          <p:cNvSpPr txBox="1"/>
          <p:nvPr/>
        </p:nvSpPr>
        <p:spPr>
          <a:xfrm>
            <a:off x="7820477" y="1379823"/>
            <a:ext cx="24558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nb-NO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^</a:t>
            </a:r>
            <a:endParaRPr 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3" name="Straight Arrow Connector 12"/>
          <p:cNvCxnSpPr/>
          <p:nvPr/>
        </p:nvCxnSpPr>
        <p:spPr>
          <a:xfrm flipV="1">
            <a:off x="1145171" y="1827234"/>
            <a:ext cx="272294" cy="12295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3800000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64</Words>
  <Application>Microsoft Office PowerPoint</Application>
  <PresentationFormat>Custom</PresentationFormat>
  <Paragraphs>107</Paragraphs>
  <Slides>1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Office Theme</vt:lpstr>
      <vt:lpstr>SPW 13.0 Graph</vt:lpstr>
      <vt:lpstr>PowerPoint Presentation</vt:lpstr>
    </vt:vector>
  </TitlesOfParts>
  <Company>NTNU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ia Tunset Grinde</dc:creator>
  <cp:lastModifiedBy>Maria Tunset Grinde</cp:lastModifiedBy>
  <cp:revision>53</cp:revision>
  <dcterms:created xsi:type="dcterms:W3CDTF">2018-02-01T13:17:14Z</dcterms:created>
  <dcterms:modified xsi:type="dcterms:W3CDTF">2019-03-18T13:37:16Z</dcterms:modified>
</cp:coreProperties>
</file>